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showOutlineIcons="0">
    <p:restoredLeft sz="15620"/>
    <p:restoredTop sz="94660"/>
  </p:normalViewPr>
  <p:slideViewPr>
    <p:cSldViewPr snapToObjects="1">
      <p:cViewPr varScale="1">
        <p:scale>
          <a:sx n="95" d="100"/>
          <a:sy n="95" d="100"/>
        </p:scale>
        <p:origin x="-27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7BC379-32A7-2D4C-8789-809E0CD83E5C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F3568-5268-E543-A81B-272DF85E704C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4191000" y="8305800"/>
            <a:ext cx="2544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3: Le Deunff et al., 2017</a:t>
            </a:r>
          </a:p>
        </p:txBody>
      </p:sp>
      <p:sp>
        <p:nvSpPr>
          <p:cNvPr id="3" name="TextBox 3"/>
          <p:cNvSpPr txBox="1"/>
          <p:nvPr/>
        </p:nvSpPr>
        <p:spPr>
          <a:xfrm>
            <a:off x="439411" y="5562600"/>
            <a:ext cx="62061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3: </a:t>
            </a:r>
            <a:r>
              <a:rPr lang="en-GB" sz="1200" dirty="0" smtClean="0">
                <a:latin typeface="Times New Roman"/>
                <a:cs typeface="Times New Roman"/>
              </a:rPr>
              <a:t>Mean concentrations of free amino acids relative to those in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 control plants ± SE (</a:t>
            </a:r>
            <a:r>
              <a:rPr lang="en-GB" sz="1200" dirty="0" err="1" smtClean="0">
                <a:latin typeface="Times New Roman"/>
                <a:cs typeface="Times New Roman"/>
              </a:rPr>
              <a:t>n</a:t>
            </a:r>
            <a:r>
              <a:rPr lang="en-GB" sz="1200" dirty="0" smtClean="0">
                <a:latin typeface="Times New Roman"/>
                <a:cs typeface="Times New Roman"/>
              </a:rPr>
              <a:t> = 3) in the root tissues of </a:t>
            </a:r>
            <a:r>
              <a:rPr lang="en-GB" sz="1200" i="1" dirty="0" err="1" smtClean="0">
                <a:latin typeface="Times New Roman"/>
                <a:cs typeface="Times New Roman"/>
              </a:rPr>
              <a:t>Brassica</a:t>
            </a:r>
            <a:r>
              <a:rPr lang="en-GB" sz="1200" i="1" dirty="0" smtClean="0">
                <a:latin typeface="Times New Roman"/>
                <a:cs typeface="Times New Roman"/>
              </a:rPr>
              <a:t> </a:t>
            </a:r>
            <a:r>
              <a:rPr lang="en-GB" sz="1200" i="1" dirty="0" err="1" smtClean="0">
                <a:latin typeface="Times New Roman"/>
                <a:cs typeface="Times New Roman"/>
              </a:rPr>
              <a:t>napus</a:t>
            </a:r>
            <a:r>
              <a:rPr lang="en-GB" sz="1200" i="1" dirty="0" smtClean="0">
                <a:latin typeface="Times New Roman"/>
                <a:cs typeface="Times New Roman"/>
              </a:rPr>
              <a:t> </a:t>
            </a:r>
            <a:r>
              <a:rPr lang="en-GB" sz="1200" dirty="0" smtClean="0">
                <a:latin typeface="Times New Roman"/>
                <a:cs typeface="Times New Roman"/>
              </a:rPr>
              <a:t>seedlings treated over 5 days with 10 </a:t>
            </a:r>
            <a:r>
              <a:rPr lang="en-GB" sz="1200" dirty="0" err="1" smtClean="0">
                <a:latin typeface="Symbol" charset="2"/>
                <a:cs typeface="Symbol" charset="2"/>
              </a:rPr>
              <a:t>m</a:t>
            </a:r>
            <a:r>
              <a:rPr lang="en-GB" sz="1200" dirty="0" err="1" smtClean="0">
                <a:latin typeface="Times New Roman"/>
                <a:cs typeface="Times New Roman"/>
              </a:rPr>
              <a:t>M</a:t>
            </a:r>
            <a:r>
              <a:rPr lang="en-GB" sz="1200" dirty="0" smtClean="0">
                <a:latin typeface="Times New Roman"/>
                <a:cs typeface="Times New Roman"/>
              </a:rPr>
              <a:t> AVG and 10 </a:t>
            </a:r>
            <a:r>
              <a:rPr lang="en-GB" sz="1200" dirty="0" err="1" smtClean="0">
                <a:latin typeface="Symbol" charset="2"/>
                <a:cs typeface="Symbol" charset="2"/>
              </a:rPr>
              <a:t>m</a:t>
            </a:r>
            <a:r>
              <a:rPr lang="en-GB" sz="1200" dirty="0" err="1" smtClean="0">
                <a:latin typeface="Times New Roman"/>
                <a:cs typeface="Times New Roman"/>
              </a:rPr>
              <a:t>M</a:t>
            </a:r>
            <a:r>
              <a:rPr lang="en-GB" sz="1200" dirty="0" smtClean="0">
                <a:latin typeface="Times New Roman"/>
                <a:cs typeface="Times New Roman"/>
              </a:rPr>
              <a:t> AVG + 1mM Glutamate on agar plates under homogeneous feeding of 1 </a:t>
            </a:r>
            <a:r>
              <a:rPr lang="en-GB" sz="1200" dirty="0" err="1" smtClean="0">
                <a:latin typeface="Times New Roman"/>
                <a:cs typeface="Times New Roman"/>
              </a:rPr>
              <a:t>mM</a:t>
            </a:r>
            <a:r>
              <a:rPr lang="en-GB" sz="1200" dirty="0" smtClean="0">
                <a:latin typeface="Times New Roman"/>
                <a:cs typeface="Times New Roman"/>
              </a:rPr>
              <a:t>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. A significant difference in amino acid concentration (P&lt;0.05 after </a:t>
            </a:r>
            <a:r>
              <a:rPr lang="en-GB" sz="1200" dirty="0" err="1" smtClean="0">
                <a:latin typeface="Times New Roman"/>
                <a:cs typeface="Times New Roman"/>
              </a:rPr>
              <a:t>Benjamini</a:t>
            </a:r>
            <a:r>
              <a:rPr lang="en-GB" sz="1200" dirty="0" smtClean="0">
                <a:latin typeface="Times New Roman"/>
                <a:cs typeface="Times New Roman"/>
              </a:rPr>
              <a:t> and Hochberg correction for multiple </a:t>
            </a:r>
            <a:r>
              <a:rPr lang="en-GB" sz="1200" dirty="0" err="1" smtClean="0">
                <a:latin typeface="Times New Roman"/>
                <a:cs typeface="Times New Roman"/>
              </a:rPr>
              <a:t>t</a:t>
            </a:r>
            <a:r>
              <a:rPr lang="en-GB" sz="1200" dirty="0" smtClean="0">
                <a:latin typeface="Times New Roman"/>
                <a:cs typeface="Times New Roman"/>
              </a:rPr>
              <a:t>-test analyses with a false discovery rate of 0.05) between the treatments and KNO</a:t>
            </a:r>
            <a:r>
              <a:rPr lang="en-GB" sz="1200" baseline="-25000" dirty="0" smtClean="0">
                <a:latin typeface="Times New Roman"/>
                <a:cs typeface="Times New Roman"/>
              </a:rPr>
              <a:t>3</a:t>
            </a:r>
            <a:r>
              <a:rPr lang="en-GB" sz="1200" dirty="0" smtClean="0">
                <a:latin typeface="Times New Roman"/>
                <a:cs typeface="Times New Roman"/>
              </a:rPr>
              <a:t> control plants is indicated by *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4" name="Freeform 148"/>
          <p:cNvSpPr>
            <a:spLocks noEditPoints="1"/>
          </p:cNvSpPr>
          <p:nvPr/>
        </p:nvSpPr>
        <p:spPr bwMode="auto">
          <a:xfrm>
            <a:off x="1264637" y="2646228"/>
            <a:ext cx="4711531" cy="1680352"/>
          </a:xfrm>
          <a:custGeom>
            <a:avLst/>
            <a:gdLst>
              <a:gd name="T0" fmla="*/ 48 w 3571"/>
              <a:gd name="T1" fmla="*/ 0 h 1413"/>
              <a:gd name="T2" fmla="*/ 0 w 3571"/>
              <a:gd name="T3" fmla="*/ 1413 h 1413"/>
              <a:gd name="T4" fmla="*/ 168 w 3571"/>
              <a:gd name="T5" fmla="*/ 109 h 1413"/>
              <a:gd name="T6" fmla="*/ 216 w 3571"/>
              <a:gd name="T7" fmla="*/ 1413 h 1413"/>
              <a:gd name="T8" fmla="*/ 168 w 3571"/>
              <a:gd name="T9" fmla="*/ 109 h 1413"/>
              <a:gd name="T10" fmla="*/ 383 w 3571"/>
              <a:gd name="T11" fmla="*/ 235 h 1413"/>
              <a:gd name="T12" fmla="*/ 335 w 3571"/>
              <a:gd name="T13" fmla="*/ 1413 h 1413"/>
              <a:gd name="T14" fmla="*/ 503 w 3571"/>
              <a:gd name="T15" fmla="*/ 399 h 1413"/>
              <a:gd name="T16" fmla="*/ 551 w 3571"/>
              <a:gd name="T17" fmla="*/ 1413 h 1413"/>
              <a:gd name="T18" fmla="*/ 503 w 3571"/>
              <a:gd name="T19" fmla="*/ 399 h 1413"/>
              <a:gd name="T20" fmla="*/ 719 w 3571"/>
              <a:gd name="T21" fmla="*/ 462 h 1413"/>
              <a:gd name="T22" fmla="*/ 671 w 3571"/>
              <a:gd name="T23" fmla="*/ 1413 h 1413"/>
              <a:gd name="T24" fmla="*/ 839 w 3571"/>
              <a:gd name="T25" fmla="*/ 469 h 1413"/>
              <a:gd name="T26" fmla="*/ 886 w 3571"/>
              <a:gd name="T27" fmla="*/ 1413 h 1413"/>
              <a:gd name="T28" fmla="*/ 839 w 3571"/>
              <a:gd name="T29" fmla="*/ 469 h 1413"/>
              <a:gd name="T30" fmla="*/ 1054 w 3571"/>
              <a:gd name="T31" fmla="*/ 555 h 1413"/>
              <a:gd name="T32" fmla="*/ 1006 w 3571"/>
              <a:gd name="T33" fmla="*/ 1413 h 1413"/>
              <a:gd name="T34" fmla="*/ 1174 w 3571"/>
              <a:gd name="T35" fmla="*/ 561 h 1413"/>
              <a:gd name="T36" fmla="*/ 1222 w 3571"/>
              <a:gd name="T37" fmla="*/ 1413 h 1413"/>
              <a:gd name="T38" fmla="*/ 1174 w 3571"/>
              <a:gd name="T39" fmla="*/ 561 h 1413"/>
              <a:gd name="T40" fmla="*/ 1390 w 3571"/>
              <a:gd name="T41" fmla="*/ 613 h 1413"/>
              <a:gd name="T42" fmla="*/ 1342 w 3571"/>
              <a:gd name="T43" fmla="*/ 1413 h 1413"/>
              <a:gd name="T44" fmla="*/ 1509 w 3571"/>
              <a:gd name="T45" fmla="*/ 666 h 1413"/>
              <a:gd name="T46" fmla="*/ 1557 w 3571"/>
              <a:gd name="T47" fmla="*/ 1413 h 1413"/>
              <a:gd name="T48" fmla="*/ 1509 w 3571"/>
              <a:gd name="T49" fmla="*/ 666 h 1413"/>
              <a:gd name="T50" fmla="*/ 1725 w 3571"/>
              <a:gd name="T51" fmla="*/ 746 h 1413"/>
              <a:gd name="T52" fmla="*/ 1677 w 3571"/>
              <a:gd name="T53" fmla="*/ 1413 h 1413"/>
              <a:gd name="T54" fmla="*/ 1845 w 3571"/>
              <a:gd name="T55" fmla="*/ 757 h 1413"/>
              <a:gd name="T56" fmla="*/ 1893 w 3571"/>
              <a:gd name="T57" fmla="*/ 1413 h 1413"/>
              <a:gd name="T58" fmla="*/ 1845 w 3571"/>
              <a:gd name="T59" fmla="*/ 757 h 1413"/>
              <a:gd name="T60" fmla="*/ 2061 w 3571"/>
              <a:gd name="T61" fmla="*/ 759 h 1413"/>
              <a:gd name="T62" fmla="*/ 2013 w 3571"/>
              <a:gd name="T63" fmla="*/ 1413 h 1413"/>
              <a:gd name="T64" fmla="*/ 2180 w 3571"/>
              <a:gd name="T65" fmla="*/ 771 h 1413"/>
              <a:gd name="T66" fmla="*/ 2228 w 3571"/>
              <a:gd name="T67" fmla="*/ 1413 h 1413"/>
              <a:gd name="T68" fmla="*/ 2180 w 3571"/>
              <a:gd name="T69" fmla="*/ 771 h 1413"/>
              <a:gd name="T70" fmla="*/ 2396 w 3571"/>
              <a:gd name="T71" fmla="*/ 788 h 1413"/>
              <a:gd name="T72" fmla="*/ 2348 w 3571"/>
              <a:gd name="T73" fmla="*/ 1413 h 1413"/>
              <a:gd name="T74" fmla="*/ 2516 w 3571"/>
              <a:gd name="T75" fmla="*/ 818 h 1413"/>
              <a:gd name="T76" fmla="*/ 2564 w 3571"/>
              <a:gd name="T77" fmla="*/ 1413 h 1413"/>
              <a:gd name="T78" fmla="*/ 2516 w 3571"/>
              <a:gd name="T79" fmla="*/ 818 h 1413"/>
              <a:gd name="T80" fmla="*/ 2731 w 3571"/>
              <a:gd name="T81" fmla="*/ 845 h 1413"/>
              <a:gd name="T82" fmla="*/ 2683 w 3571"/>
              <a:gd name="T83" fmla="*/ 1413 h 1413"/>
              <a:gd name="T84" fmla="*/ 2851 w 3571"/>
              <a:gd name="T85" fmla="*/ 877 h 1413"/>
              <a:gd name="T86" fmla="*/ 2899 w 3571"/>
              <a:gd name="T87" fmla="*/ 1413 h 1413"/>
              <a:gd name="T88" fmla="*/ 2851 w 3571"/>
              <a:gd name="T89" fmla="*/ 877 h 1413"/>
              <a:gd name="T90" fmla="*/ 3067 w 3571"/>
              <a:gd name="T91" fmla="*/ 889 h 1413"/>
              <a:gd name="T92" fmla="*/ 3019 w 3571"/>
              <a:gd name="T93" fmla="*/ 1413 h 1413"/>
              <a:gd name="T94" fmla="*/ 3187 w 3571"/>
              <a:gd name="T95" fmla="*/ 942 h 1413"/>
              <a:gd name="T96" fmla="*/ 3235 w 3571"/>
              <a:gd name="T97" fmla="*/ 1413 h 1413"/>
              <a:gd name="T98" fmla="*/ 3187 w 3571"/>
              <a:gd name="T99" fmla="*/ 942 h 1413"/>
              <a:gd name="T100" fmla="*/ 3403 w 3571"/>
              <a:gd name="T101" fmla="*/ 1085 h 1413"/>
              <a:gd name="T102" fmla="*/ 3355 w 3571"/>
              <a:gd name="T103" fmla="*/ 1413 h 1413"/>
              <a:gd name="T104" fmla="*/ 3523 w 3571"/>
              <a:gd name="T105" fmla="*/ 839 h 1413"/>
              <a:gd name="T106" fmla="*/ 3571 w 3571"/>
              <a:gd name="T107" fmla="*/ 1413 h 1413"/>
              <a:gd name="T108" fmla="*/ 3523 w 3571"/>
              <a:gd name="T109" fmla="*/ 839 h 14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3571" h="1413">
                <a:moveTo>
                  <a:pt x="0" y="0"/>
                </a:moveTo>
                <a:lnTo>
                  <a:pt x="48" y="0"/>
                </a:lnTo>
                <a:lnTo>
                  <a:pt x="48" y="1413"/>
                </a:lnTo>
                <a:lnTo>
                  <a:pt x="0" y="1413"/>
                </a:lnTo>
                <a:lnTo>
                  <a:pt x="0" y="0"/>
                </a:lnTo>
                <a:close/>
                <a:moveTo>
                  <a:pt x="168" y="109"/>
                </a:moveTo>
                <a:lnTo>
                  <a:pt x="216" y="109"/>
                </a:lnTo>
                <a:lnTo>
                  <a:pt x="216" y="1413"/>
                </a:lnTo>
                <a:lnTo>
                  <a:pt x="168" y="1413"/>
                </a:lnTo>
                <a:lnTo>
                  <a:pt x="168" y="109"/>
                </a:lnTo>
                <a:close/>
                <a:moveTo>
                  <a:pt x="335" y="235"/>
                </a:moveTo>
                <a:lnTo>
                  <a:pt x="383" y="235"/>
                </a:lnTo>
                <a:lnTo>
                  <a:pt x="383" y="1413"/>
                </a:lnTo>
                <a:lnTo>
                  <a:pt x="335" y="1413"/>
                </a:lnTo>
                <a:lnTo>
                  <a:pt x="335" y="235"/>
                </a:lnTo>
                <a:close/>
                <a:moveTo>
                  <a:pt x="503" y="399"/>
                </a:moveTo>
                <a:lnTo>
                  <a:pt x="551" y="399"/>
                </a:lnTo>
                <a:lnTo>
                  <a:pt x="551" y="1413"/>
                </a:lnTo>
                <a:lnTo>
                  <a:pt x="503" y="1413"/>
                </a:lnTo>
                <a:lnTo>
                  <a:pt x="503" y="399"/>
                </a:lnTo>
                <a:close/>
                <a:moveTo>
                  <a:pt x="671" y="462"/>
                </a:moveTo>
                <a:lnTo>
                  <a:pt x="719" y="462"/>
                </a:lnTo>
                <a:lnTo>
                  <a:pt x="719" y="1413"/>
                </a:lnTo>
                <a:lnTo>
                  <a:pt x="671" y="1413"/>
                </a:lnTo>
                <a:lnTo>
                  <a:pt x="671" y="462"/>
                </a:lnTo>
                <a:close/>
                <a:moveTo>
                  <a:pt x="839" y="469"/>
                </a:moveTo>
                <a:lnTo>
                  <a:pt x="886" y="469"/>
                </a:lnTo>
                <a:lnTo>
                  <a:pt x="886" y="1413"/>
                </a:lnTo>
                <a:lnTo>
                  <a:pt x="839" y="1413"/>
                </a:lnTo>
                <a:lnTo>
                  <a:pt x="839" y="469"/>
                </a:lnTo>
                <a:close/>
                <a:moveTo>
                  <a:pt x="1006" y="555"/>
                </a:moveTo>
                <a:lnTo>
                  <a:pt x="1054" y="555"/>
                </a:lnTo>
                <a:lnTo>
                  <a:pt x="1054" y="1413"/>
                </a:lnTo>
                <a:lnTo>
                  <a:pt x="1006" y="1413"/>
                </a:lnTo>
                <a:lnTo>
                  <a:pt x="1006" y="555"/>
                </a:lnTo>
                <a:close/>
                <a:moveTo>
                  <a:pt x="1174" y="561"/>
                </a:moveTo>
                <a:lnTo>
                  <a:pt x="1222" y="561"/>
                </a:lnTo>
                <a:lnTo>
                  <a:pt x="1222" y="1413"/>
                </a:lnTo>
                <a:lnTo>
                  <a:pt x="1174" y="1413"/>
                </a:lnTo>
                <a:lnTo>
                  <a:pt x="1174" y="561"/>
                </a:lnTo>
                <a:close/>
                <a:moveTo>
                  <a:pt x="1342" y="613"/>
                </a:moveTo>
                <a:lnTo>
                  <a:pt x="1390" y="613"/>
                </a:lnTo>
                <a:lnTo>
                  <a:pt x="1390" y="1413"/>
                </a:lnTo>
                <a:lnTo>
                  <a:pt x="1342" y="1413"/>
                </a:lnTo>
                <a:lnTo>
                  <a:pt x="1342" y="613"/>
                </a:lnTo>
                <a:close/>
                <a:moveTo>
                  <a:pt x="1509" y="666"/>
                </a:moveTo>
                <a:lnTo>
                  <a:pt x="1557" y="666"/>
                </a:lnTo>
                <a:lnTo>
                  <a:pt x="1557" y="1413"/>
                </a:lnTo>
                <a:lnTo>
                  <a:pt x="1509" y="1413"/>
                </a:lnTo>
                <a:lnTo>
                  <a:pt x="1509" y="666"/>
                </a:lnTo>
                <a:close/>
                <a:moveTo>
                  <a:pt x="1677" y="746"/>
                </a:moveTo>
                <a:lnTo>
                  <a:pt x="1725" y="746"/>
                </a:lnTo>
                <a:lnTo>
                  <a:pt x="1725" y="1413"/>
                </a:lnTo>
                <a:lnTo>
                  <a:pt x="1677" y="1413"/>
                </a:lnTo>
                <a:lnTo>
                  <a:pt x="1677" y="746"/>
                </a:lnTo>
                <a:close/>
                <a:moveTo>
                  <a:pt x="1845" y="757"/>
                </a:moveTo>
                <a:lnTo>
                  <a:pt x="1893" y="757"/>
                </a:lnTo>
                <a:lnTo>
                  <a:pt x="1893" y="1413"/>
                </a:lnTo>
                <a:lnTo>
                  <a:pt x="1845" y="1413"/>
                </a:lnTo>
                <a:lnTo>
                  <a:pt x="1845" y="757"/>
                </a:lnTo>
                <a:close/>
                <a:moveTo>
                  <a:pt x="2013" y="759"/>
                </a:moveTo>
                <a:lnTo>
                  <a:pt x="2061" y="759"/>
                </a:lnTo>
                <a:lnTo>
                  <a:pt x="2061" y="1413"/>
                </a:lnTo>
                <a:lnTo>
                  <a:pt x="2013" y="1413"/>
                </a:lnTo>
                <a:lnTo>
                  <a:pt x="2013" y="759"/>
                </a:lnTo>
                <a:close/>
                <a:moveTo>
                  <a:pt x="2180" y="771"/>
                </a:moveTo>
                <a:lnTo>
                  <a:pt x="2228" y="771"/>
                </a:lnTo>
                <a:lnTo>
                  <a:pt x="2228" y="1413"/>
                </a:lnTo>
                <a:lnTo>
                  <a:pt x="2180" y="1413"/>
                </a:lnTo>
                <a:lnTo>
                  <a:pt x="2180" y="771"/>
                </a:lnTo>
                <a:close/>
                <a:moveTo>
                  <a:pt x="2348" y="788"/>
                </a:moveTo>
                <a:lnTo>
                  <a:pt x="2396" y="788"/>
                </a:lnTo>
                <a:lnTo>
                  <a:pt x="2396" y="1413"/>
                </a:lnTo>
                <a:lnTo>
                  <a:pt x="2348" y="1413"/>
                </a:lnTo>
                <a:lnTo>
                  <a:pt x="2348" y="788"/>
                </a:lnTo>
                <a:close/>
                <a:moveTo>
                  <a:pt x="2516" y="818"/>
                </a:moveTo>
                <a:lnTo>
                  <a:pt x="2564" y="818"/>
                </a:lnTo>
                <a:lnTo>
                  <a:pt x="2564" y="1413"/>
                </a:lnTo>
                <a:lnTo>
                  <a:pt x="2516" y="1413"/>
                </a:lnTo>
                <a:lnTo>
                  <a:pt x="2516" y="818"/>
                </a:lnTo>
                <a:close/>
                <a:moveTo>
                  <a:pt x="2683" y="845"/>
                </a:moveTo>
                <a:lnTo>
                  <a:pt x="2731" y="845"/>
                </a:lnTo>
                <a:lnTo>
                  <a:pt x="2731" y="1413"/>
                </a:lnTo>
                <a:lnTo>
                  <a:pt x="2683" y="1413"/>
                </a:lnTo>
                <a:lnTo>
                  <a:pt x="2683" y="845"/>
                </a:lnTo>
                <a:close/>
                <a:moveTo>
                  <a:pt x="2851" y="877"/>
                </a:moveTo>
                <a:lnTo>
                  <a:pt x="2899" y="877"/>
                </a:lnTo>
                <a:lnTo>
                  <a:pt x="2899" y="1413"/>
                </a:lnTo>
                <a:lnTo>
                  <a:pt x="2851" y="1413"/>
                </a:lnTo>
                <a:lnTo>
                  <a:pt x="2851" y="877"/>
                </a:lnTo>
                <a:close/>
                <a:moveTo>
                  <a:pt x="3019" y="889"/>
                </a:moveTo>
                <a:lnTo>
                  <a:pt x="3067" y="889"/>
                </a:lnTo>
                <a:lnTo>
                  <a:pt x="3067" y="1413"/>
                </a:lnTo>
                <a:lnTo>
                  <a:pt x="3019" y="1413"/>
                </a:lnTo>
                <a:lnTo>
                  <a:pt x="3019" y="889"/>
                </a:lnTo>
                <a:close/>
                <a:moveTo>
                  <a:pt x="3187" y="942"/>
                </a:moveTo>
                <a:lnTo>
                  <a:pt x="3235" y="942"/>
                </a:lnTo>
                <a:lnTo>
                  <a:pt x="3235" y="1413"/>
                </a:lnTo>
                <a:lnTo>
                  <a:pt x="3187" y="1413"/>
                </a:lnTo>
                <a:lnTo>
                  <a:pt x="3187" y="942"/>
                </a:lnTo>
                <a:close/>
                <a:moveTo>
                  <a:pt x="3355" y="1085"/>
                </a:moveTo>
                <a:lnTo>
                  <a:pt x="3403" y="1085"/>
                </a:lnTo>
                <a:lnTo>
                  <a:pt x="3403" y="1413"/>
                </a:lnTo>
                <a:lnTo>
                  <a:pt x="3355" y="1413"/>
                </a:lnTo>
                <a:lnTo>
                  <a:pt x="3355" y="1085"/>
                </a:lnTo>
                <a:close/>
                <a:moveTo>
                  <a:pt x="3523" y="839"/>
                </a:moveTo>
                <a:lnTo>
                  <a:pt x="3571" y="839"/>
                </a:lnTo>
                <a:lnTo>
                  <a:pt x="3571" y="1413"/>
                </a:lnTo>
                <a:lnTo>
                  <a:pt x="3523" y="1413"/>
                </a:lnTo>
                <a:lnTo>
                  <a:pt x="3523" y="83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5" name="Rectangle 149"/>
          <p:cNvSpPr>
            <a:spLocks noChangeArrowheads="1"/>
          </p:cNvSpPr>
          <p:nvPr/>
        </p:nvSpPr>
        <p:spPr bwMode="auto">
          <a:xfrm>
            <a:off x="1327968" y="3333591"/>
            <a:ext cx="63331" cy="992990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6" name="Freeform 150"/>
          <p:cNvSpPr>
            <a:spLocks noEditPoints="1"/>
          </p:cNvSpPr>
          <p:nvPr/>
        </p:nvSpPr>
        <p:spPr bwMode="auto">
          <a:xfrm>
            <a:off x="1325329" y="3331212"/>
            <a:ext cx="68608" cy="997746"/>
          </a:xfrm>
          <a:custGeom>
            <a:avLst/>
            <a:gdLst>
              <a:gd name="T0" fmla="*/ 0 w 864"/>
              <a:gd name="T1" fmla="*/ 32 h 13984"/>
              <a:gd name="T2" fmla="*/ 32 w 864"/>
              <a:gd name="T3" fmla="*/ 0 h 13984"/>
              <a:gd name="T4" fmla="*/ 832 w 864"/>
              <a:gd name="T5" fmla="*/ 0 h 13984"/>
              <a:gd name="T6" fmla="*/ 864 w 864"/>
              <a:gd name="T7" fmla="*/ 32 h 13984"/>
              <a:gd name="T8" fmla="*/ 864 w 864"/>
              <a:gd name="T9" fmla="*/ 13952 h 13984"/>
              <a:gd name="T10" fmla="*/ 832 w 864"/>
              <a:gd name="T11" fmla="*/ 13984 h 13984"/>
              <a:gd name="T12" fmla="*/ 32 w 864"/>
              <a:gd name="T13" fmla="*/ 13984 h 13984"/>
              <a:gd name="T14" fmla="*/ 0 w 864"/>
              <a:gd name="T15" fmla="*/ 13952 h 13984"/>
              <a:gd name="T16" fmla="*/ 0 w 864"/>
              <a:gd name="T17" fmla="*/ 32 h 13984"/>
              <a:gd name="T18" fmla="*/ 64 w 864"/>
              <a:gd name="T19" fmla="*/ 13952 h 13984"/>
              <a:gd name="T20" fmla="*/ 32 w 864"/>
              <a:gd name="T21" fmla="*/ 13920 h 13984"/>
              <a:gd name="T22" fmla="*/ 832 w 864"/>
              <a:gd name="T23" fmla="*/ 13920 h 13984"/>
              <a:gd name="T24" fmla="*/ 800 w 864"/>
              <a:gd name="T25" fmla="*/ 13952 h 13984"/>
              <a:gd name="T26" fmla="*/ 800 w 864"/>
              <a:gd name="T27" fmla="*/ 32 h 13984"/>
              <a:gd name="T28" fmla="*/ 832 w 864"/>
              <a:gd name="T29" fmla="*/ 64 h 13984"/>
              <a:gd name="T30" fmla="*/ 32 w 864"/>
              <a:gd name="T31" fmla="*/ 64 h 13984"/>
              <a:gd name="T32" fmla="*/ 64 w 864"/>
              <a:gd name="T33" fmla="*/ 32 h 13984"/>
              <a:gd name="T34" fmla="*/ 64 w 864"/>
              <a:gd name="T35" fmla="*/ 13952 h 139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13984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13952"/>
                </a:lnTo>
                <a:cubicBezTo>
                  <a:pt x="864" y="13970"/>
                  <a:pt x="850" y="13984"/>
                  <a:pt x="832" y="13984"/>
                </a:cubicBezTo>
                <a:lnTo>
                  <a:pt x="32" y="13984"/>
                </a:lnTo>
                <a:cubicBezTo>
                  <a:pt x="15" y="13984"/>
                  <a:pt x="0" y="13970"/>
                  <a:pt x="0" y="13952"/>
                </a:cubicBezTo>
                <a:lnTo>
                  <a:pt x="0" y="32"/>
                </a:lnTo>
                <a:close/>
                <a:moveTo>
                  <a:pt x="64" y="13952"/>
                </a:moveTo>
                <a:lnTo>
                  <a:pt x="32" y="13920"/>
                </a:lnTo>
                <a:lnTo>
                  <a:pt x="832" y="13920"/>
                </a:lnTo>
                <a:lnTo>
                  <a:pt x="800" y="13952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1395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7" name="Rectangle 151"/>
          <p:cNvSpPr>
            <a:spLocks noChangeArrowheads="1"/>
          </p:cNvSpPr>
          <p:nvPr/>
        </p:nvSpPr>
        <p:spPr bwMode="auto">
          <a:xfrm>
            <a:off x="1549625" y="3728408"/>
            <a:ext cx="63331" cy="598172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8" name="Freeform 152"/>
          <p:cNvSpPr>
            <a:spLocks noEditPoints="1"/>
          </p:cNvSpPr>
          <p:nvPr/>
        </p:nvSpPr>
        <p:spPr bwMode="auto">
          <a:xfrm>
            <a:off x="1546986" y="3726029"/>
            <a:ext cx="68608" cy="602929"/>
          </a:xfrm>
          <a:custGeom>
            <a:avLst/>
            <a:gdLst>
              <a:gd name="T0" fmla="*/ 0 w 864"/>
              <a:gd name="T1" fmla="*/ 32 h 8448"/>
              <a:gd name="T2" fmla="*/ 32 w 864"/>
              <a:gd name="T3" fmla="*/ 0 h 8448"/>
              <a:gd name="T4" fmla="*/ 832 w 864"/>
              <a:gd name="T5" fmla="*/ 0 h 8448"/>
              <a:gd name="T6" fmla="*/ 864 w 864"/>
              <a:gd name="T7" fmla="*/ 32 h 8448"/>
              <a:gd name="T8" fmla="*/ 864 w 864"/>
              <a:gd name="T9" fmla="*/ 8416 h 8448"/>
              <a:gd name="T10" fmla="*/ 832 w 864"/>
              <a:gd name="T11" fmla="*/ 8448 h 8448"/>
              <a:gd name="T12" fmla="*/ 32 w 864"/>
              <a:gd name="T13" fmla="*/ 8448 h 8448"/>
              <a:gd name="T14" fmla="*/ 0 w 864"/>
              <a:gd name="T15" fmla="*/ 8416 h 8448"/>
              <a:gd name="T16" fmla="*/ 0 w 864"/>
              <a:gd name="T17" fmla="*/ 32 h 8448"/>
              <a:gd name="T18" fmla="*/ 64 w 864"/>
              <a:gd name="T19" fmla="*/ 8416 h 8448"/>
              <a:gd name="T20" fmla="*/ 32 w 864"/>
              <a:gd name="T21" fmla="*/ 8384 h 8448"/>
              <a:gd name="T22" fmla="*/ 832 w 864"/>
              <a:gd name="T23" fmla="*/ 8384 h 8448"/>
              <a:gd name="T24" fmla="*/ 800 w 864"/>
              <a:gd name="T25" fmla="*/ 8416 h 8448"/>
              <a:gd name="T26" fmla="*/ 800 w 864"/>
              <a:gd name="T27" fmla="*/ 32 h 8448"/>
              <a:gd name="T28" fmla="*/ 832 w 864"/>
              <a:gd name="T29" fmla="*/ 64 h 8448"/>
              <a:gd name="T30" fmla="*/ 32 w 864"/>
              <a:gd name="T31" fmla="*/ 64 h 8448"/>
              <a:gd name="T32" fmla="*/ 64 w 864"/>
              <a:gd name="T33" fmla="*/ 32 h 8448"/>
              <a:gd name="T34" fmla="*/ 64 w 864"/>
              <a:gd name="T35" fmla="*/ 8416 h 84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8448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8416"/>
                </a:lnTo>
                <a:cubicBezTo>
                  <a:pt x="864" y="8434"/>
                  <a:pt x="850" y="8448"/>
                  <a:pt x="832" y="8448"/>
                </a:cubicBezTo>
                <a:lnTo>
                  <a:pt x="32" y="8448"/>
                </a:lnTo>
                <a:cubicBezTo>
                  <a:pt x="15" y="8448"/>
                  <a:pt x="0" y="8434"/>
                  <a:pt x="0" y="8416"/>
                </a:cubicBezTo>
                <a:lnTo>
                  <a:pt x="0" y="32"/>
                </a:lnTo>
                <a:close/>
                <a:moveTo>
                  <a:pt x="64" y="8416"/>
                </a:moveTo>
                <a:lnTo>
                  <a:pt x="32" y="8384"/>
                </a:lnTo>
                <a:lnTo>
                  <a:pt x="832" y="8384"/>
                </a:lnTo>
                <a:lnTo>
                  <a:pt x="800" y="8416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841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9" name="Rectangle 153"/>
          <p:cNvSpPr>
            <a:spLocks noChangeArrowheads="1"/>
          </p:cNvSpPr>
          <p:nvPr/>
        </p:nvSpPr>
        <p:spPr bwMode="auto">
          <a:xfrm>
            <a:off x="1769963" y="3660623"/>
            <a:ext cx="63331" cy="66595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0" name="Freeform 154"/>
          <p:cNvSpPr>
            <a:spLocks noEditPoints="1"/>
          </p:cNvSpPr>
          <p:nvPr/>
        </p:nvSpPr>
        <p:spPr bwMode="auto">
          <a:xfrm>
            <a:off x="1767324" y="3658244"/>
            <a:ext cx="68608" cy="670714"/>
          </a:xfrm>
          <a:custGeom>
            <a:avLst/>
            <a:gdLst>
              <a:gd name="T0" fmla="*/ 0 w 864"/>
              <a:gd name="T1" fmla="*/ 32 h 9408"/>
              <a:gd name="T2" fmla="*/ 32 w 864"/>
              <a:gd name="T3" fmla="*/ 0 h 9408"/>
              <a:gd name="T4" fmla="*/ 832 w 864"/>
              <a:gd name="T5" fmla="*/ 0 h 9408"/>
              <a:gd name="T6" fmla="*/ 864 w 864"/>
              <a:gd name="T7" fmla="*/ 32 h 9408"/>
              <a:gd name="T8" fmla="*/ 864 w 864"/>
              <a:gd name="T9" fmla="*/ 9376 h 9408"/>
              <a:gd name="T10" fmla="*/ 832 w 864"/>
              <a:gd name="T11" fmla="*/ 9408 h 9408"/>
              <a:gd name="T12" fmla="*/ 32 w 864"/>
              <a:gd name="T13" fmla="*/ 9408 h 9408"/>
              <a:gd name="T14" fmla="*/ 0 w 864"/>
              <a:gd name="T15" fmla="*/ 9376 h 9408"/>
              <a:gd name="T16" fmla="*/ 0 w 864"/>
              <a:gd name="T17" fmla="*/ 32 h 9408"/>
              <a:gd name="T18" fmla="*/ 64 w 864"/>
              <a:gd name="T19" fmla="*/ 9376 h 9408"/>
              <a:gd name="T20" fmla="*/ 32 w 864"/>
              <a:gd name="T21" fmla="*/ 9344 h 9408"/>
              <a:gd name="T22" fmla="*/ 832 w 864"/>
              <a:gd name="T23" fmla="*/ 9344 h 9408"/>
              <a:gd name="T24" fmla="*/ 800 w 864"/>
              <a:gd name="T25" fmla="*/ 9376 h 9408"/>
              <a:gd name="T26" fmla="*/ 800 w 864"/>
              <a:gd name="T27" fmla="*/ 32 h 9408"/>
              <a:gd name="T28" fmla="*/ 832 w 864"/>
              <a:gd name="T29" fmla="*/ 64 h 9408"/>
              <a:gd name="T30" fmla="*/ 32 w 864"/>
              <a:gd name="T31" fmla="*/ 64 h 9408"/>
              <a:gd name="T32" fmla="*/ 64 w 864"/>
              <a:gd name="T33" fmla="*/ 32 h 9408"/>
              <a:gd name="T34" fmla="*/ 64 w 864"/>
              <a:gd name="T35" fmla="*/ 9376 h 9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9408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9376"/>
                </a:lnTo>
                <a:cubicBezTo>
                  <a:pt x="864" y="9394"/>
                  <a:pt x="850" y="9408"/>
                  <a:pt x="832" y="9408"/>
                </a:cubicBezTo>
                <a:lnTo>
                  <a:pt x="32" y="9408"/>
                </a:lnTo>
                <a:cubicBezTo>
                  <a:pt x="15" y="9408"/>
                  <a:pt x="0" y="9394"/>
                  <a:pt x="0" y="9376"/>
                </a:cubicBezTo>
                <a:lnTo>
                  <a:pt x="0" y="32"/>
                </a:lnTo>
                <a:close/>
                <a:moveTo>
                  <a:pt x="64" y="9376"/>
                </a:moveTo>
                <a:lnTo>
                  <a:pt x="32" y="9344"/>
                </a:lnTo>
                <a:lnTo>
                  <a:pt x="832" y="9344"/>
                </a:lnTo>
                <a:lnTo>
                  <a:pt x="800" y="9376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937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1" name="Rectangle 155"/>
          <p:cNvSpPr>
            <a:spLocks noChangeArrowheads="1"/>
          </p:cNvSpPr>
          <p:nvPr/>
        </p:nvSpPr>
        <p:spPr bwMode="auto">
          <a:xfrm>
            <a:off x="1991620" y="3645163"/>
            <a:ext cx="63331" cy="68141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2" name="Freeform 156"/>
          <p:cNvSpPr>
            <a:spLocks noEditPoints="1"/>
          </p:cNvSpPr>
          <p:nvPr/>
        </p:nvSpPr>
        <p:spPr bwMode="auto">
          <a:xfrm>
            <a:off x="1988981" y="3642785"/>
            <a:ext cx="68608" cy="686174"/>
          </a:xfrm>
          <a:custGeom>
            <a:avLst/>
            <a:gdLst>
              <a:gd name="T0" fmla="*/ 0 w 864"/>
              <a:gd name="T1" fmla="*/ 32 h 9616"/>
              <a:gd name="T2" fmla="*/ 32 w 864"/>
              <a:gd name="T3" fmla="*/ 0 h 9616"/>
              <a:gd name="T4" fmla="*/ 832 w 864"/>
              <a:gd name="T5" fmla="*/ 0 h 9616"/>
              <a:gd name="T6" fmla="*/ 864 w 864"/>
              <a:gd name="T7" fmla="*/ 32 h 9616"/>
              <a:gd name="T8" fmla="*/ 864 w 864"/>
              <a:gd name="T9" fmla="*/ 9584 h 9616"/>
              <a:gd name="T10" fmla="*/ 832 w 864"/>
              <a:gd name="T11" fmla="*/ 9616 h 9616"/>
              <a:gd name="T12" fmla="*/ 32 w 864"/>
              <a:gd name="T13" fmla="*/ 9616 h 9616"/>
              <a:gd name="T14" fmla="*/ 0 w 864"/>
              <a:gd name="T15" fmla="*/ 9584 h 9616"/>
              <a:gd name="T16" fmla="*/ 0 w 864"/>
              <a:gd name="T17" fmla="*/ 32 h 9616"/>
              <a:gd name="T18" fmla="*/ 64 w 864"/>
              <a:gd name="T19" fmla="*/ 9584 h 9616"/>
              <a:gd name="T20" fmla="*/ 32 w 864"/>
              <a:gd name="T21" fmla="*/ 9552 h 9616"/>
              <a:gd name="T22" fmla="*/ 832 w 864"/>
              <a:gd name="T23" fmla="*/ 9552 h 9616"/>
              <a:gd name="T24" fmla="*/ 800 w 864"/>
              <a:gd name="T25" fmla="*/ 9584 h 9616"/>
              <a:gd name="T26" fmla="*/ 800 w 864"/>
              <a:gd name="T27" fmla="*/ 32 h 9616"/>
              <a:gd name="T28" fmla="*/ 832 w 864"/>
              <a:gd name="T29" fmla="*/ 64 h 9616"/>
              <a:gd name="T30" fmla="*/ 32 w 864"/>
              <a:gd name="T31" fmla="*/ 64 h 9616"/>
              <a:gd name="T32" fmla="*/ 64 w 864"/>
              <a:gd name="T33" fmla="*/ 32 h 9616"/>
              <a:gd name="T34" fmla="*/ 64 w 864"/>
              <a:gd name="T35" fmla="*/ 9584 h 96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9616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9584"/>
                </a:lnTo>
                <a:cubicBezTo>
                  <a:pt x="864" y="9602"/>
                  <a:pt x="850" y="9616"/>
                  <a:pt x="832" y="9616"/>
                </a:cubicBezTo>
                <a:lnTo>
                  <a:pt x="32" y="9616"/>
                </a:lnTo>
                <a:cubicBezTo>
                  <a:pt x="15" y="9616"/>
                  <a:pt x="0" y="9602"/>
                  <a:pt x="0" y="9584"/>
                </a:cubicBezTo>
                <a:lnTo>
                  <a:pt x="0" y="32"/>
                </a:lnTo>
                <a:close/>
                <a:moveTo>
                  <a:pt x="64" y="9584"/>
                </a:moveTo>
                <a:lnTo>
                  <a:pt x="32" y="9552"/>
                </a:lnTo>
                <a:lnTo>
                  <a:pt x="832" y="9552"/>
                </a:lnTo>
                <a:lnTo>
                  <a:pt x="800" y="9584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958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3" name="Rectangle 157"/>
          <p:cNvSpPr>
            <a:spLocks noChangeArrowheads="1"/>
          </p:cNvSpPr>
          <p:nvPr/>
        </p:nvSpPr>
        <p:spPr bwMode="auto">
          <a:xfrm>
            <a:off x="2213277" y="3334779"/>
            <a:ext cx="63331" cy="991800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4" name="Freeform 158"/>
          <p:cNvSpPr>
            <a:spLocks noEditPoints="1"/>
          </p:cNvSpPr>
          <p:nvPr/>
        </p:nvSpPr>
        <p:spPr bwMode="auto">
          <a:xfrm>
            <a:off x="2210638" y="3332401"/>
            <a:ext cx="68608" cy="996557"/>
          </a:xfrm>
          <a:custGeom>
            <a:avLst/>
            <a:gdLst>
              <a:gd name="T0" fmla="*/ 0 w 864"/>
              <a:gd name="T1" fmla="*/ 32 h 13968"/>
              <a:gd name="T2" fmla="*/ 32 w 864"/>
              <a:gd name="T3" fmla="*/ 0 h 13968"/>
              <a:gd name="T4" fmla="*/ 832 w 864"/>
              <a:gd name="T5" fmla="*/ 0 h 13968"/>
              <a:gd name="T6" fmla="*/ 864 w 864"/>
              <a:gd name="T7" fmla="*/ 32 h 13968"/>
              <a:gd name="T8" fmla="*/ 864 w 864"/>
              <a:gd name="T9" fmla="*/ 13936 h 13968"/>
              <a:gd name="T10" fmla="*/ 832 w 864"/>
              <a:gd name="T11" fmla="*/ 13968 h 13968"/>
              <a:gd name="T12" fmla="*/ 32 w 864"/>
              <a:gd name="T13" fmla="*/ 13968 h 13968"/>
              <a:gd name="T14" fmla="*/ 0 w 864"/>
              <a:gd name="T15" fmla="*/ 13936 h 13968"/>
              <a:gd name="T16" fmla="*/ 0 w 864"/>
              <a:gd name="T17" fmla="*/ 32 h 13968"/>
              <a:gd name="T18" fmla="*/ 64 w 864"/>
              <a:gd name="T19" fmla="*/ 13936 h 13968"/>
              <a:gd name="T20" fmla="*/ 32 w 864"/>
              <a:gd name="T21" fmla="*/ 13904 h 13968"/>
              <a:gd name="T22" fmla="*/ 832 w 864"/>
              <a:gd name="T23" fmla="*/ 13904 h 13968"/>
              <a:gd name="T24" fmla="*/ 800 w 864"/>
              <a:gd name="T25" fmla="*/ 13936 h 13968"/>
              <a:gd name="T26" fmla="*/ 800 w 864"/>
              <a:gd name="T27" fmla="*/ 32 h 13968"/>
              <a:gd name="T28" fmla="*/ 832 w 864"/>
              <a:gd name="T29" fmla="*/ 64 h 13968"/>
              <a:gd name="T30" fmla="*/ 32 w 864"/>
              <a:gd name="T31" fmla="*/ 64 h 13968"/>
              <a:gd name="T32" fmla="*/ 64 w 864"/>
              <a:gd name="T33" fmla="*/ 32 h 13968"/>
              <a:gd name="T34" fmla="*/ 64 w 864"/>
              <a:gd name="T35" fmla="*/ 13936 h 139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13968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13936"/>
                </a:lnTo>
                <a:cubicBezTo>
                  <a:pt x="864" y="13954"/>
                  <a:pt x="850" y="13968"/>
                  <a:pt x="832" y="13968"/>
                </a:cubicBezTo>
                <a:lnTo>
                  <a:pt x="32" y="13968"/>
                </a:lnTo>
                <a:cubicBezTo>
                  <a:pt x="15" y="13968"/>
                  <a:pt x="0" y="13954"/>
                  <a:pt x="0" y="13936"/>
                </a:cubicBezTo>
                <a:lnTo>
                  <a:pt x="0" y="32"/>
                </a:lnTo>
                <a:close/>
                <a:moveTo>
                  <a:pt x="64" y="13936"/>
                </a:moveTo>
                <a:lnTo>
                  <a:pt x="32" y="13904"/>
                </a:lnTo>
                <a:lnTo>
                  <a:pt x="832" y="13904"/>
                </a:lnTo>
                <a:lnTo>
                  <a:pt x="800" y="13936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1393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5" name="Rectangle 159"/>
          <p:cNvSpPr>
            <a:spLocks noChangeArrowheads="1"/>
          </p:cNvSpPr>
          <p:nvPr/>
        </p:nvSpPr>
        <p:spPr bwMode="auto">
          <a:xfrm>
            <a:off x="2433614" y="3837815"/>
            <a:ext cx="63331" cy="488765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6" name="Freeform 160"/>
          <p:cNvSpPr>
            <a:spLocks noEditPoints="1"/>
          </p:cNvSpPr>
          <p:nvPr/>
        </p:nvSpPr>
        <p:spPr bwMode="auto">
          <a:xfrm>
            <a:off x="2430975" y="3835437"/>
            <a:ext cx="68608" cy="493522"/>
          </a:xfrm>
          <a:custGeom>
            <a:avLst/>
            <a:gdLst>
              <a:gd name="T0" fmla="*/ 0 w 864"/>
              <a:gd name="T1" fmla="*/ 32 h 6928"/>
              <a:gd name="T2" fmla="*/ 32 w 864"/>
              <a:gd name="T3" fmla="*/ 0 h 6928"/>
              <a:gd name="T4" fmla="*/ 832 w 864"/>
              <a:gd name="T5" fmla="*/ 0 h 6928"/>
              <a:gd name="T6" fmla="*/ 864 w 864"/>
              <a:gd name="T7" fmla="*/ 32 h 6928"/>
              <a:gd name="T8" fmla="*/ 864 w 864"/>
              <a:gd name="T9" fmla="*/ 6896 h 6928"/>
              <a:gd name="T10" fmla="*/ 832 w 864"/>
              <a:gd name="T11" fmla="*/ 6928 h 6928"/>
              <a:gd name="T12" fmla="*/ 32 w 864"/>
              <a:gd name="T13" fmla="*/ 6928 h 6928"/>
              <a:gd name="T14" fmla="*/ 0 w 864"/>
              <a:gd name="T15" fmla="*/ 6896 h 6928"/>
              <a:gd name="T16" fmla="*/ 0 w 864"/>
              <a:gd name="T17" fmla="*/ 32 h 6928"/>
              <a:gd name="T18" fmla="*/ 64 w 864"/>
              <a:gd name="T19" fmla="*/ 6896 h 6928"/>
              <a:gd name="T20" fmla="*/ 32 w 864"/>
              <a:gd name="T21" fmla="*/ 6864 h 6928"/>
              <a:gd name="T22" fmla="*/ 832 w 864"/>
              <a:gd name="T23" fmla="*/ 6864 h 6928"/>
              <a:gd name="T24" fmla="*/ 800 w 864"/>
              <a:gd name="T25" fmla="*/ 6896 h 6928"/>
              <a:gd name="T26" fmla="*/ 800 w 864"/>
              <a:gd name="T27" fmla="*/ 32 h 6928"/>
              <a:gd name="T28" fmla="*/ 832 w 864"/>
              <a:gd name="T29" fmla="*/ 64 h 6928"/>
              <a:gd name="T30" fmla="*/ 32 w 864"/>
              <a:gd name="T31" fmla="*/ 64 h 6928"/>
              <a:gd name="T32" fmla="*/ 64 w 864"/>
              <a:gd name="T33" fmla="*/ 32 h 6928"/>
              <a:gd name="T34" fmla="*/ 64 w 864"/>
              <a:gd name="T35" fmla="*/ 6896 h 69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6928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6896"/>
                </a:lnTo>
                <a:cubicBezTo>
                  <a:pt x="864" y="6914"/>
                  <a:pt x="850" y="6928"/>
                  <a:pt x="832" y="6928"/>
                </a:cubicBezTo>
                <a:lnTo>
                  <a:pt x="32" y="6928"/>
                </a:lnTo>
                <a:cubicBezTo>
                  <a:pt x="15" y="6928"/>
                  <a:pt x="0" y="6914"/>
                  <a:pt x="0" y="6896"/>
                </a:cubicBezTo>
                <a:lnTo>
                  <a:pt x="0" y="32"/>
                </a:lnTo>
                <a:close/>
                <a:moveTo>
                  <a:pt x="64" y="6896"/>
                </a:moveTo>
                <a:lnTo>
                  <a:pt x="32" y="6864"/>
                </a:lnTo>
                <a:lnTo>
                  <a:pt x="832" y="6864"/>
                </a:lnTo>
                <a:lnTo>
                  <a:pt x="800" y="6896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689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7" name="Rectangle 161"/>
          <p:cNvSpPr>
            <a:spLocks noChangeArrowheads="1"/>
          </p:cNvSpPr>
          <p:nvPr/>
        </p:nvSpPr>
        <p:spPr bwMode="auto">
          <a:xfrm>
            <a:off x="2655271" y="3661812"/>
            <a:ext cx="63331" cy="664768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8" name="Freeform 162"/>
          <p:cNvSpPr>
            <a:spLocks noEditPoints="1"/>
          </p:cNvSpPr>
          <p:nvPr/>
        </p:nvSpPr>
        <p:spPr bwMode="auto">
          <a:xfrm>
            <a:off x="2652632" y="3659434"/>
            <a:ext cx="68608" cy="669525"/>
          </a:xfrm>
          <a:custGeom>
            <a:avLst/>
            <a:gdLst>
              <a:gd name="T0" fmla="*/ 0 w 864"/>
              <a:gd name="T1" fmla="*/ 32 h 9392"/>
              <a:gd name="T2" fmla="*/ 32 w 864"/>
              <a:gd name="T3" fmla="*/ 0 h 9392"/>
              <a:gd name="T4" fmla="*/ 832 w 864"/>
              <a:gd name="T5" fmla="*/ 0 h 9392"/>
              <a:gd name="T6" fmla="*/ 864 w 864"/>
              <a:gd name="T7" fmla="*/ 32 h 9392"/>
              <a:gd name="T8" fmla="*/ 864 w 864"/>
              <a:gd name="T9" fmla="*/ 9360 h 9392"/>
              <a:gd name="T10" fmla="*/ 832 w 864"/>
              <a:gd name="T11" fmla="*/ 9392 h 9392"/>
              <a:gd name="T12" fmla="*/ 32 w 864"/>
              <a:gd name="T13" fmla="*/ 9392 h 9392"/>
              <a:gd name="T14" fmla="*/ 0 w 864"/>
              <a:gd name="T15" fmla="*/ 9360 h 9392"/>
              <a:gd name="T16" fmla="*/ 0 w 864"/>
              <a:gd name="T17" fmla="*/ 32 h 9392"/>
              <a:gd name="T18" fmla="*/ 64 w 864"/>
              <a:gd name="T19" fmla="*/ 9360 h 9392"/>
              <a:gd name="T20" fmla="*/ 32 w 864"/>
              <a:gd name="T21" fmla="*/ 9328 h 9392"/>
              <a:gd name="T22" fmla="*/ 832 w 864"/>
              <a:gd name="T23" fmla="*/ 9328 h 9392"/>
              <a:gd name="T24" fmla="*/ 800 w 864"/>
              <a:gd name="T25" fmla="*/ 9360 h 9392"/>
              <a:gd name="T26" fmla="*/ 800 w 864"/>
              <a:gd name="T27" fmla="*/ 32 h 9392"/>
              <a:gd name="T28" fmla="*/ 832 w 864"/>
              <a:gd name="T29" fmla="*/ 64 h 9392"/>
              <a:gd name="T30" fmla="*/ 32 w 864"/>
              <a:gd name="T31" fmla="*/ 64 h 9392"/>
              <a:gd name="T32" fmla="*/ 64 w 864"/>
              <a:gd name="T33" fmla="*/ 32 h 9392"/>
              <a:gd name="T34" fmla="*/ 64 w 864"/>
              <a:gd name="T35" fmla="*/ 9360 h 93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9392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9360"/>
                </a:lnTo>
                <a:cubicBezTo>
                  <a:pt x="864" y="9378"/>
                  <a:pt x="850" y="9392"/>
                  <a:pt x="832" y="9392"/>
                </a:cubicBezTo>
                <a:lnTo>
                  <a:pt x="32" y="9392"/>
                </a:lnTo>
                <a:cubicBezTo>
                  <a:pt x="15" y="9392"/>
                  <a:pt x="0" y="9378"/>
                  <a:pt x="0" y="9360"/>
                </a:cubicBezTo>
                <a:lnTo>
                  <a:pt x="0" y="32"/>
                </a:lnTo>
                <a:close/>
                <a:moveTo>
                  <a:pt x="64" y="9360"/>
                </a:moveTo>
                <a:lnTo>
                  <a:pt x="32" y="9328"/>
                </a:lnTo>
                <a:lnTo>
                  <a:pt x="832" y="9328"/>
                </a:lnTo>
                <a:lnTo>
                  <a:pt x="800" y="9360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936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9" name="Rectangle 163"/>
          <p:cNvSpPr>
            <a:spLocks noChangeArrowheads="1"/>
          </p:cNvSpPr>
          <p:nvPr/>
        </p:nvSpPr>
        <p:spPr bwMode="auto">
          <a:xfrm>
            <a:off x="2876928" y="3724840"/>
            <a:ext cx="63331" cy="601740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0" name="Freeform 164"/>
          <p:cNvSpPr>
            <a:spLocks noEditPoints="1"/>
          </p:cNvSpPr>
          <p:nvPr/>
        </p:nvSpPr>
        <p:spPr bwMode="auto">
          <a:xfrm>
            <a:off x="2874289" y="3723651"/>
            <a:ext cx="68608" cy="605308"/>
          </a:xfrm>
          <a:custGeom>
            <a:avLst/>
            <a:gdLst>
              <a:gd name="T0" fmla="*/ 0 w 864"/>
              <a:gd name="T1" fmla="*/ 32 h 8496"/>
              <a:gd name="T2" fmla="*/ 32 w 864"/>
              <a:gd name="T3" fmla="*/ 0 h 8496"/>
              <a:gd name="T4" fmla="*/ 832 w 864"/>
              <a:gd name="T5" fmla="*/ 0 h 8496"/>
              <a:gd name="T6" fmla="*/ 864 w 864"/>
              <a:gd name="T7" fmla="*/ 32 h 8496"/>
              <a:gd name="T8" fmla="*/ 864 w 864"/>
              <a:gd name="T9" fmla="*/ 8464 h 8496"/>
              <a:gd name="T10" fmla="*/ 832 w 864"/>
              <a:gd name="T11" fmla="*/ 8496 h 8496"/>
              <a:gd name="T12" fmla="*/ 32 w 864"/>
              <a:gd name="T13" fmla="*/ 8496 h 8496"/>
              <a:gd name="T14" fmla="*/ 0 w 864"/>
              <a:gd name="T15" fmla="*/ 8464 h 8496"/>
              <a:gd name="T16" fmla="*/ 0 w 864"/>
              <a:gd name="T17" fmla="*/ 32 h 8496"/>
              <a:gd name="T18" fmla="*/ 64 w 864"/>
              <a:gd name="T19" fmla="*/ 8464 h 8496"/>
              <a:gd name="T20" fmla="*/ 32 w 864"/>
              <a:gd name="T21" fmla="*/ 8432 h 8496"/>
              <a:gd name="T22" fmla="*/ 832 w 864"/>
              <a:gd name="T23" fmla="*/ 8432 h 8496"/>
              <a:gd name="T24" fmla="*/ 800 w 864"/>
              <a:gd name="T25" fmla="*/ 8464 h 8496"/>
              <a:gd name="T26" fmla="*/ 800 w 864"/>
              <a:gd name="T27" fmla="*/ 32 h 8496"/>
              <a:gd name="T28" fmla="*/ 832 w 864"/>
              <a:gd name="T29" fmla="*/ 64 h 8496"/>
              <a:gd name="T30" fmla="*/ 32 w 864"/>
              <a:gd name="T31" fmla="*/ 64 h 8496"/>
              <a:gd name="T32" fmla="*/ 64 w 864"/>
              <a:gd name="T33" fmla="*/ 32 h 8496"/>
              <a:gd name="T34" fmla="*/ 64 w 864"/>
              <a:gd name="T35" fmla="*/ 8464 h 8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8496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8464"/>
                </a:lnTo>
                <a:cubicBezTo>
                  <a:pt x="864" y="8482"/>
                  <a:pt x="850" y="8496"/>
                  <a:pt x="832" y="8496"/>
                </a:cubicBezTo>
                <a:lnTo>
                  <a:pt x="32" y="8496"/>
                </a:lnTo>
                <a:cubicBezTo>
                  <a:pt x="15" y="8496"/>
                  <a:pt x="0" y="8482"/>
                  <a:pt x="0" y="8464"/>
                </a:cubicBezTo>
                <a:lnTo>
                  <a:pt x="0" y="32"/>
                </a:lnTo>
                <a:close/>
                <a:moveTo>
                  <a:pt x="64" y="8464"/>
                </a:moveTo>
                <a:lnTo>
                  <a:pt x="32" y="8432"/>
                </a:lnTo>
                <a:lnTo>
                  <a:pt x="832" y="8432"/>
                </a:lnTo>
                <a:lnTo>
                  <a:pt x="800" y="8464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846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1" name="Rectangle 165"/>
          <p:cNvSpPr>
            <a:spLocks noChangeArrowheads="1"/>
          </p:cNvSpPr>
          <p:nvPr/>
        </p:nvSpPr>
        <p:spPr bwMode="auto">
          <a:xfrm>
            <a:off x="3098585" y="3522674"/>
            <a:ext cx="63331" cy="803905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2" name="Freeform 166"/>
          <p:cNvSpPr>
            <a:spLocks noEditPoints="1"/>
          </p:cNvSpPr>
          <p:nvPr/>
        </p:nvSpPr>
        <p:spPr bwMode="auto">
          <a:xfrm>
            <a:off x="3095946" y="3520296"/>
            <a:ext cx="68608" cy="808662"/>
          </a:xfrm>
          <a:custGeom>
            <a:avLst/>
            <a:gdLst>
              <a:gd name="T0" fmla="*/ 0 w 864"/>
              <a:gd name="T1" fmla="*/ 32 h 11344"/>
              <a:gd name="T2" fmla="*/ 32 w 864"/>
              <a:gd name="T3" fmla="*/ 0 h 11344"/>
              <a:gd name="T4" fmla="*/ 832 w 864"/>
              <a:gd name="T5" fmla="*/ 0 h 11344"/>
              <a:gd name="T6" fmla="*/ 864 w 864"/>
              <a:gd name="T7" fmla="*/ 32 h 11344"/>
              <a:gd name="T8" fmla="*/ 864 w 864"/>
              <a:gd name="T9" fmla="*/ 11312 h 11344"/>
              <a:gd name="T10" fmla="*/ 832 w 864"/>
              <a:gd name="T11" fmla="*/ 11344 h 11344"/>
              <a:gd name="T12" fmla="*/ 32 w 864"/>
              <a:gd name="T13" fmla="*/ 11344 h 11344"/>
              <a:gd name="T14" fmla="*/ 0 w 864"/>
              <a:gd name="T15" fmla="*/ 11312 h 11344"/>
              <a:gd name="T16" fmla="*/ 0 w 864"/>
              <a:gd name="T17" fmla="*/ 32 h 11344"/>
              <a:gd name="T18" fmla="*/ 64 w 864"/>
              <a:gd name="T19" fmla="*/ 11312 h 11344"/>
              <a:gd name="T20" fmla="*/ 32 w 864"/>
              <a:gd name="T21" fmla="*/ 11280 h 11344"/>
              <a:gd name="T22" fmla="*/ 832 w 864"/>
              <a:gd name="T23" fmla="*/ 11280 h 11344"/>
              <a:gd name="T24" fmla="*/ 800 w 864"/>
              <a:gd name="T25" fmla="*/ 11312 h 11344"/>
              <a:gd name="T26" fmla="*/ 800 w 864"/>
              <a:gd name="T27" fmla="*/ 32 h 11344"/>
              <a:gd name="T28" fmla="*/ 832 w 864"/>
              <a:gd name="T29" fmla="*/ 64 h 11344"/>
              <a:gd name="T30" fmla="*/ 32 w 864"/>
              <a:gd name="T31" fmla="*/ 64 h 11344"/>
              <a:gd name="T32" fmla="*/ 64 w 864"/>
              <a:gd name="T33" fmla="*/ 32 h 11344"/>
              <a:gd name="T34" fmla="*/ 64 w 864"/>
              <a:gd name="T35" fmla="*/ 11312 h 113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864" h="11344">
                <a:moveTo>
                  <a:pt x="0" y="32"/>
                </a:moveTo>
                <a:cubicBezTo>
                  <a:pt x="0" y="15"/>
                  <a:pt x="15" y="0"/>
                  <a:pt x="32" y="0"/>
                </a:cubicBezTo>
                <a:lnTo>
                  <a:pt x="832" y="0"/>
                </a:lnTo>
                <a:cubicBezTo>
                  <a:pt x="850" y="0"/>
                  <a:pt x="864" y="15"/>
                  <a:pt x="864" y="32"/>
                </a:cubicBezTo>
                <a:lnTo>
                  <a:pt x="864" y="11312"/>
                </a:lnTo>
                <a:cubicBezTo>
                  <a:pt x="864" y="11330"/>
                  <a:pt x="850" y="11344"/>
                  <a:pt x="832" y="11344"/>
                </a:cubicBezTo>
                <a:lnTo>
                  <a:pt x="32" y="11344"/>
                </a:lnTo>
                <a:cubicBezTo>
                  <a:pt x="15" y="11344"/>
                  <a:pt x="0" y="11330"/>
                  <a:pt x="0" y="11312"/>
                </a:cubicBezTo>
                <a:lnTo>
                  <a:pt x="0" y="32"/>
                </a:lnTo>
                <a:close/>
                <a:moveTo>
                  <a:pt x="64" y="11312"/>
                </a:moveTo>
                <a:lnTo>
                  <a:pt x="32" y="11280"/>
                </a:lnTo>
                <a:lnTo>
                  <a:pt x="832" y="11280"/>
                </a:lnTo>
                <a:lnTo>
                  <a:pt x="800" y="11312"/>
                </a:lnTo>
                <a:lnTo>
                  <a:pt x="800" y="32"/>
                </a:lnTo>
                <a:lnTo>
                  <a:pt x="832" y="64"/>
                </a:lnTo>
                <a:lnTo>
                  <a:pt x="32" y="64"/>
                </a:lnTo>
                <a:lnTo>
                  <a:pt x="64" y="32"/>
                </a:lnTo>
                <a:lnTo>
                  <a:pt x="64" y="1131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3" name="Rectangle 167"/>
          <p:cNvSpPr>
            <a:spLocks noChangeArrowheads="1"/>
          </p:cNvSpPr>
          <p:nvPr/>
        </p:nvSpPr>
        <p:spPr bwMode="auto">
          <a:xfrm>
            <a:off x="3318923" y="3286022"/>
            <a:ext cx="63331" cy="1040558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4" name="Freeform 168"/>
          <p:cNvSpPr>
            <a:spLocks noEditPoints="1"/>
          </p:cNvSpPr>
          <p:nvPr/>
        </p:nvSpPr>
        <p:spPr bwMode="auto">
          <a:xfrm>
            <a:off x="3316284" y="3283644"/>
            <a:ext cx="68608" cy="1045315"/>
          </a:xfrm>
          <a:custGeom>
            <a:avLst/>
            <a:gdLst>
              <a:gd name="T0" fmla="*/ 0 w 432"/>
              <a:gd name="T1" fmla="*/ 16 h 7328"/>
              <a:gd name="T2" fmla="*/ 16 w 432"/>
              <a:gd name="T3" fmla="*/ 0 h 7328"/>
              <a:gd name="T4" fmla="*/ 416 w 432"/>
              <a:gd name="T5" fmla="*/ 0 h 7328"/>
              <a:gd name="T6" fmla="*/ 432 w 432"/>
              <a:gd name="T7" fmla="*/ 16 h 7328"/>
              <a:gd name="T8" fmla="*/ 432 w 432"/>
              <a:gd name="T9" fmla="*/ 7312 h 7328"/>
              <a:gd name="T10" fmla="*/ 416 w 432"/>
              <a:gd name="T11" fmla="*/ 7328 h 7328"/>
              <a:gd name="T12" fmla="*/ 16 w 432"/>
              <a:gd name="T13" fmla="*/ 7328 h 7328"/>
              <a:gd name="T14" fmla="*/ 0 w 432"/>
              <a:gd name="T15" fmla="*/ 7312 h 7328"/>
              <a:gd name="T16" fmla="*/ 0 w 432"/>
              <a:gd name="T17" fmla="*/ 16 h 7328"/>
              <a:gd name="T18" fmla="*/ 32 w 432"/>
              <a:gd name="T19" fmla="*/ 7312 h 7328"/>
              <a:gd name="T20" fmla="*/ 16 w 432"/>
              <a:gd name="T21" fmla="*/ 7296 h 7328"/>
              <a:gd name="T22" fmla="*/ 416 w 432"/>
              <a:gd name="T23" fmla="*/ 7296 h 7328"/>
              <a:gd name="T24" fmla="*/ 400 w 432"/>
              <a:gd name="T25" fmla="*/ 7312 h 7328"/>
              <a:gd name="T26" fmla="*/ 400 w 432"/>
              <a:gd name="T27" fmla="*/ 16 h 7328"/>
              <a:gd name="T28" fmla="*/ 416 w 432"/>
              <a:gd name="T29" fmla="*/ 32 h 7328"/>
              <a:gd name="T30" fmla="*/ 16 w 432"/>
              <a:gd name="T31" fmla="*/ 32 h 7328"/>
              <a:gd name="T32" fmla="*/ 32 w 432"/>
              <a:gd name="T33" fmla="*/ 16 h 7328"/>
              <a:gd name="T34" fmla="*/ 32 w 432"/>
              <a:gd name="T35" fmla="*/ 7312 h 73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7328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7312"/>
                </a:lnTo>
                <a:cubicBezTo>
                  <a:pt x="432" y="7321"/>
                  <a:pt x="425" y="7328"/>
                  <a:pt x="416" y="7328"/>
                </a:cubicBezTo>
                <a:lnTo>
                  <a:pt x="16" y="7328"/>
                </a:lnTo>
                <a:cubicBezTo>
                  <a:pt x="8" y="7328"/>
                  <a:pt x="0" y="7321"/>
                  <a:pt x="0" y="7312"/>
                </a:cubicBezTo>
                <a:lnTo>
                  <a:pt x="0" y="16"/>
                </a:lnTo>
                <a:close/>
                <a:moveTo>
                  <a:pt x="32" y="7312"/>
                </a:moveTo>
                <a:lnTo>
                  <a:pt x="16" y="7296"/>
                </a:lnTo>
                <a:lnTo>
                  <a:pt x="416" y="7296"/>
                </a:lnTo>
                <a:lnTo>
                  <a:pt x="400" y="7312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731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5" name="Rectangle 169"/>
          <p:cNvSpPr>
            <a:spLocks noChangeArrowheads="1"/>
          </p:cNvSpPr>
          <p:nvPr/>
        </p:nvSpPr>
        <p:spPr bwMode="auto">
          <a:xfrm>
            <a:off x="3540580" y="3780733"/>
            <a:ext cx="63331" cy="54584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6" name="Freeform 170"/>
          <p:cNvSpPr>
            <a:spLocks noEditPoints="1"/>
          </p:cNvSpPr>
          <p:nvPr/>
        </p:nvSpPr>
        <p:spPr bwMode="auto">
          <a:xfrm>
            <a:off x="3537941" y="3778355"/>
            <a:ext cx="68608" cy="550604"/>
          </a:xfrm>
          <a:custGeom>
            <a:avLst/>
            <a:gdLst>
              <a:gd name="T0" fmla="*/ 0 w 432"/>
              <a:gd name="T1" fmla="*/ 16 h 3864"/>
              <a:gd name="T2" fmla="*/ 16 w 432"/>
              <a:gd name="T3" fmla="*/ 0 h 3864"/>
              <a:gd name="T4" fmla="*/ 416 w 432"/>
              <a:gd name="T5" fmla="*/ 0 h 3864"/>
              <a:gd name="T6" fmla="*/ 432 w 432"/>
              <a:gd name="T7" fmla="*/ 16 h 3864"/>
              <a:gd name="T8" fmla="*/ 432 w 432"/>
              <a:gd name="T9" fmla="*/ 3848 h 3864"/>
              <a:gd name="T10" fmla="*/ 416 w 432"/>
              <a:gd name="T11" fmla="*/ 3864 h 3864"/>
              <a:gd name="T12" fmla="*/ 16 w 432"/>
              <a:gd name="T13" fmla="*/ 3864 h 3864"/>
              <a:gd name="T14" fmla="*/ 0 w 432"/>
              <a:gd name="T15" fmla="*/ 3848 h 3864"/>
              <a:gd name="T16" fmla="*/ 0 w 432"/>
              <a:gd name="T17" fmla="*/ 16 h 3864"/>
              <a:gd name="T18" fmla="*/ 32 w 432"/>
              <a:gd name="T19" fmla="*/ 3848 h 3864"/>
              <a:gd name="T20" fmla="*/ 16 w 432"/>
              <a:gd name="T21" fmla="*/ 3832 h 3864"/>
              <a:gd name="T22" fmla="*/ 416 w 432"/>
              <a:gd name="T23" fmla="*/ 3832 h 3864"/>
              <a:gd name="T24" fmla="*/ 400 w 432"/>
              <a:gd name="T25" fmla="*/ 3848 h 3864"/>
              <a:gd name="T26" fmla="*/ 400 w 432"/>
              <a:gd name="T27" fmla="*/ 16 h 3864"/>
              <a:gd name="T28" fmla="*/ 416 w 432"/>
              <a:gd name="T29" fmla="*/ 32 h 3864"/>
              <a:gd name="T30" fmla="*/ 16 w 432"/>
              <a:gd name="T31" fmla="*/ 32 h 3864"/>
              <a:gd name="T32" fmla="*/ 32 w 432"/>
              <a:gd name="T33" fmla="*/ 16 h 3864"/>
              <a:gd name="T34" fmla="*/ 32 w 432"/>
              <a:gd name="T35" fmla="*/ 3848 h 38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3864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3848"/>
                </a:lnTo>
                <a:cubicBezTo>
                  <a:pt x="432" y="3857"/>
                  <a:pt x="425" y="3864"/>
                  <a:pt x="416" y="3864"/>
                </a:cubicBezTo>
                <a:lnTo>
                  <a:pt x="16" y="3864"/>
                </a:lnTo>
                <a:cubicBezTo>
                  <a:pt x="8" y="3864"/>
                  <a:pt x="0" y="3857"/>
                  <a:pt x="0" y="3848"/>
                </a:cubicBezTo>
                <a:lnTo>
                  <a:pt x="0" y="16"/>
                </a:lnTo>
                <a:close/>
                <a:moveTo>
                  <a:pt x="32" y="3848"/>
                </a:moveTo>
                <a:lnTo>
                  <a:pt x="16" y="3832"/>
                </a:lnTo>
                <a:lnTo>
                  <a:pt x="416" y="3832"/>
                </a:lnTo>
                <a:lnTo>
                  <a:pt x="400" y="3848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384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7" name="Rectangle 171"/>
          <p:cNvSpPr>
            <a:spLocks noChangeArrowheads="1"/>
          </p:cNvSpPr>
          <p:nvPr/>
        </p:nvSpPr>
        <p:spPr bwMode="auto">
          <a:xfrm>
            <a:off x="3762237" y="3885383"/>
            <a:ext cx="63331" cy="44119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8" name="Freeform 172"/>
          <p:cNvSpPr>
            <a:spLocks noEditPoints="1"/>
          </p:cNvSpPr>
          <p:nvPr/>
        </p:nvSpPr>
        <p:spPr bwMode="auto">
          <a:xfrm>
            <a:off x="3759598" y="3883005"/>
            <a:ext cx="68608" cy="445954"/>
          </a:xfrm>
          <a:custGeom>
            <a:avLst/>
            <a:gdLst>
              <a:gd name="T0" fmla="*/ 0 w 432"/>
              <a:gd name="T1" fmla="*/ 16 h 3128"/>
              <a:gd name="T2" fmla="*/ 16 w 432"/>
              <a:gd name="T3" fmla="*/ 0 h 3128"/>
              <a:gd name="T4" fmla="*/ 416 w 432"/>
              <a:gd name="T5" fmla="*/ 0 h 3128"/>
              <a:gd name="T6" fmla="*/ 432 w 432"/>
              <a:gd name="T7" fmla="*/ 16 h 3128"/>
              <a:gd name="T8" fmla="*/ 432 w 432"/>
              <a:gd name="T9" fmla="*/ 3112 h 3128"/>
              <a:gd name="T10" fmla="*/ 416 w 432"/>
              <a:gd name="T11" fmla="*/ 3128 h 3128"/>
              <a:gd name="T12" fmla="*/ 16 w 432"/>
              <a:gd name="T13" fmla="*/ 3128 h 3128"/>
              <a:gd name="T14" fmla="*/ 0 w 432"/>
              <a:gd name="T15" fmla="*/ 3112 h 3128"/>
              <a:gd name="T16" fmla="*/ 0 w 432"/>
              <a:gd name="T17" fmla="*/ 16 h 3128"/>
              <a:gd name="T18" fmla="*/ 32 w 432"/>
              <a:gd name="T19" fmla="*/ 3112 h 3128"/>
              <a:gd name="T20" fmla="*/ 16 w 432"/>
              <a:gd name="T21" fmla="*/ 3096 h 3128"/>
              <a:gd name="T22" fmla="*/ 416 w 432"/>
              <a:gd name="T23" fmla="*/ 3096 h 3128"/>
              <a:gd name="T24" fmla="*/ 400 w 432"/>
              <a:gd name="T25" fmla="*/ 3112 h 3128"/>
              <a:gd name="T26" fmla="*/ 400 w 432"/>
              <a:gd name="T27" fmla="*/ 16 h 3128"/>
              <a:gd name="T28" fmla="*/ 416 w 432"/>
              <a:gd name="T29" fmla="*/ 32 h 3128"/>
              <a:gd name="T30" fmla="*/ 16 w 432"/>
              <a:gd name="T31" fmla="*/ 32 h 3128"/>
              <a:gd name="T32" fmla="*/ 32 w 432"/>
              <a:gd name="T33" fmla="*/ 16 h 3128"/>
              <a:gd name="T34" fmla="*/ 32 w 432"/>
              <a:gd name="T35" fmla="*/ 3112 h 3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3128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3112"/>
                </a:lnTo>
                <a:cubicBezTo>
                  <a:pt x="432" y="3121"/>
                  <a:pt x="425" y="3128"/>
                  <a:pt x="416" y="3128"/>
                </a:cubicBezTo>
                <a:lnTo>
                  <a:pt x="16" y="3128"/>
                </a:lnTo>
                <a:cubicBezTo>
                  <a:pt x="8" y="3128"/>
                  <a:pt x="0" y="3121"/>
                  <a:pt x="0" y="3112"/>
                </a:cubicBezTo>
                <a:lnTo>
                  <a:pt x="0" y="16"/>
                </a:lnTo>
                <a:close/>
                <a:moveTo>
                  <a:pt x="32" y="3112"/>
                </a:moveTo>
                <a:lnTo>
                  <a:pt x="16" y="3096"/>
                </a:lnTo>
                <a:lnTo>
                  <a:pt x="416" y="3096"/>
                </a:lnTo>
                <a:lnTo>
                  <a:pt x="400" y="3112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311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9" name="Rectangle 173"/>
          <p:cNvSpPr>
            <a:spLocks noChangeArrowheads="1"/>
          </p:cNvSpPr>
          <p:nvPr/>
        </p:nvSpPr>
        <p:spPr bwMode="auto">
          <a:xfrm>
            <a:off x="3983894" y="3751002"/>
            <a:ext cx="62012" cy="57557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0" name="Freeform 174"/>
          <p:cNvSpPr>
            <a:spLocks noEditPoints="1"/>
          </p:cNvSpPr>
          <p:nvPr/>
        </p:nvSpPr>
        <p:spPr bwMode="auto">
          <a:xfrm>
            <a:off x="3981255" y="3748624"/>
            <a:ext cx="67289" cy="580334"/>
          </a:xfrm>
          <a:custGeom>
            <a:avLst/>
            <a:gdLst>
              <a:gd name="T0" fmla="*/ 0 w 424"/>
              <a:gd name="T1" fmla="*/ 16 h 4072"/>
              <a:gd name="T2" fmla="*/ 16 w 424"/>
              <a:gd name="T3" fmla="*/ 0 h 4072"/>
              <a:gd name="T4" fmla="*/ 408 w 424"/>
              <a:gd name="T5" fmla="*/ 0 h 4072"/>
              <a:gd name="T6" fmla="*/ 424 w 424"/>
              <a:gd name="T7" fmla="*/ 16 h 4072"/>
              <a:gd name="T8" fmla="*/ 424 w 424"/>
              <a:gd name="T9" fmla="*/ 4056 h 4072"/>
              <a:gd name="T10" fmla="*/ 408 w 424"/>
              <a:gd name="T11" fmla="*/ 4072 h 4072"/>
              <a:gd name="T12" fmla="*/ 16 w 424"/>
              <a:gd name="T13" fmla="*/ 4072 h 4072"/>
              <a:gd name="T14" fmla="*/ 0 w 424"/>
              <a:gd name="T15" fmla="*/ 4056 h 4072"/>
              <a:gd name="T16" fmla="*/ 0 w 424"/>
              <a:gd name="T17" fmla="*/ 16 h 4072"/>
              <a:gd name="T18" fmla="*/ 32 w 424"/>
              <a:gd name="T19" fmla="*/ 4056 h 4072"/>
              <a:gd name="T20" fmla="*/ 16 w 424"/>
              <a:gd name="T21" fmla="*/ 4040 h 4072"/>
              <a:gd name="T22" fmla="*/ 408 w 424"/>
              <a:gd name="T23" fmla="*/ 4040 h 4072"/>
              <a:gd name="T24" fmla="*/ 392 w 424"/>
              <a:gd name="T25" fmla="*/ 4056 h 4072"/>
              <a:gd name="T26" fmla="*/ 392 w 424"/>
              <a:gd name="T27" fmla="*/ 16 h 4072"/>
              <a:gd name="T28" fmla="*/ 408 w 424"/>
              <a:gd name="T29" fmla="*/ 32 h 4072"/>
              <a:gd name="T30" fmla="*/ 16 w 424"/>
              <a:gd name="T31" fmla="*/ 32 h 4072"/>
              <a:gd name="T32" fmla="*/ 32 w 424"/>
              <a:gd name="T33" fmla="*/ 16 h 4072"/>
              <a:gd name="T34" fmla="*/ 32 w 424"/>
              <a:gd name="T35" fmla="*/ 4056 h 40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24" h="4072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08" y="0"/>
                </a:lnTo>
                <a:cubicBezTo>
                  <a:pt x="417" y="0"/>
                  <a:pt x="424" y="8"/>
                  <a:pt x="424" y="16"/>
                </a:cubicBezTo>
                <a:lnTo>
                  <a:pt x="424" y="4056"/>
                </a:lnTo>
                <a:cubicBezTo>
                  <a:pt x="424" y="4065"/>
                  <a:pt x="417" y="4072"/>
                  <a:pt x="408" y="4072"/>
                </a:cubicBezTo>
                <a:lnTo>
                  <a:pt x="16" y="4072"/>
                </a:lnTo>
                <a:cubicBezTo>
                  <a:pt x="8" y="4072"/>
                  <a:pt x="0" y="4065"/>
                  <a:pt x="0" y="4056"/>
                </a:cubicBezTo>
                <a:lnTo>
                  <a:pt x="0" y="16"/>
                </a:lnTo>
                <a:close/>
                <a:moveTo>
                  <a:pt x="32" y="4056"/>
                </a:moveTo>
                <a:lnTo>
                  <a:pt x="16" y="4040"/>
                </a:lnTo>
                <a:lnTo>
                  <a:pt x="408" y="4040"/>
                </a:lnTo>
                <a:lnTo>
                  <a:pt x="392" y="4056"/>
                </a:lnTo>
                <a:lnTo>
                  <a:pt x="392" y="16"/>
                </a:lnTo>
                <a:lnTo>
                  <a:pt x="408" y="32"/>
                </a:lnTo>
                <a:lnTo>
                  <a:pt x="16" y="32"/>
                </a:lnTo>
                <a:lnTo>
                  <a:pt x="32" y="16"/>
                </a:lnTo>
                <a:lnTo>
                  <a:pt x="32" y="405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1" name="Rectangle 175"/>
          <p:cNvSpPr>
            <a:spLocks noChangeArrowheads="1"/>
          </p:cNvSpPr>
          <p:nvPr/>
        </p:nvSpPr>
        <p:spPr bwMode="auto">
          <a:xfrm>
            <a:off x="4204231" y="3717705"/>
            <a:ext cx="63331" cy="608875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2" name="Freeform 176"/>
          <p:cNvSpPr>
            <a:spLocks noEditPoints="1"/>
          </p:cNvSpPr>
          <p:nvPr/>
        </p:nvSpPr>
        <p:spPr bwMode="auto">
          <a:xfrm>
            <a:off x="4202912" y="3715326"/>
            <a:ext cx="67289" cy="613632"/>
          </a:xfrm>
          <a:custGeom>
            <a:avLst/>
            <a:gdLst>
              <a:gd name="T0" fmla="*/ 0 w 432"/>
              <a:gd name="T1" fmla="*/ 16 h 4304"/>
              <a:gd name="T2" fmla="*/ 16 w 432"/>
              <a:gd name="T3" fmla="*/ 0 h 4304"/>
              <a:gd name="T4" fmla="*/ 416 w 432"/>
              <a:gd name="T5" fmla="*/ 0 h 4304"/>
              <a:gd name="T6" fmla="*/ 432 w 432"/>
              <a:gd name="T7" fmla="*/ 16 h 4304"/>
              <a:gd name="T8" fmla="*/ 432 w 432"/>
              <a:gd name="T9" fmla="*/ 4288 h 4304"/>
              <a:gd name="T10" fmla="*/ 416 w 432"/>
              <a:gd name="T11" fmla="*/ 4304 h 4304"/>
              <a:gd name="T12" fmla="*/ 16 w 432"/>
              <a:gd name="T13" fmla="*/ 4304 h 4304"/>
              <a:gd name="T14" fmla="*/ 0 w 432"/>
              <a:gd name="T15" fmla="*/ 4288 h 4304"/>
              <a:gd name="T16" fmla="*/ 0 w 432"/>
              <a:gd name="T17" fmla="*/ 16 h 4304"/>
              <a:gd name="T18" fmla="*/ 32 w 432"/>
              <a:gd name="T19" fmla="*/ 4288 h 4304"/>
              <a:gd name="T20" fmla="*/ 16 w 432"/>
              <a:gd name="T21" fmla="*/ 4272 h 4304"/>
              <a:gd name="T22" fmla="*/ 416 w 432"/>
              <a:gd name="T23" fmla="*/ 4272 h 4304"/>
              <a:gd name="T24" fmla="*/ 400 w 432"/>
              <a:gd name="T25" fmla="*/ 4288 h 4304"/>
              <a:gd name="T26" fmla="*/ 400 w 432"/>
              <a:gd name="T27" fmla="*/ 16 h 4304"/>
              <a:gd name="T28" fmla="*/ 416 w 432"/>
              <a:gd name="T29" fmla="*/ 32 h 4304"/>
              <a:gd name="T30" fmla="*/ 16 w 432"/>
              <a:gd name="T31" fmla="*/ 32 h 4304"/>
              <a:gd name="T32" fmla="*/ 32 w 432"/>
              <a:gd name="T33" fmla="*/ 16 h 4304"/>
              <a:gd name="T34" fmla="*/ 32 w 432"/>
              <a:gd name="T35" fmla="*/ 4288 h 43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4304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4288"/>
                </a:lnTo>
                <a:cubicBezTo>
                  <a:pt x="432" y="4297"/>
                  <a:pt x="425" y="4304"/>
                  <a:pt x="416" y="4304"/>
                </a:cubicBezTo>
                <a:lnTo>
                  <a:pt x="16" y="4304"/>
                </a:lnTo>
                <a:cubicBezTo>
                  <a:pt x="8" y="4304"/>
                  <a:pt x="0" y="4297"/>
                  <a:pt x="0" y="4288"/>
                </a:cubicBezTo>
                <a:lnTo>
                  <a:pt x="0" y="16"/>
                </a:lnTo>
                <a:close/>
                <a:moveTo>
                  <a:pt x="32" y="4288"/>
                </a:moveTo>
                <a:lnTo>
                  <a:pt x="16" y="4272"/>
                </a:lnTo>
                <a:lnTo>
                  <a:pt x="416" y="4272"/>
                </a:lnTo>
                <a:lnTo>
                  <a:pt x="400" y="4288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428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3" name="Rectangle 177"/>
          <p:cNvSpPr>
            <a:spLocks noChangeArrowheads="1"/>
          </p:cNvSpPr>
          <p:nvPr/>
        </p:nvSpPr>
        <p:spPr bwMode="auto">
          <a:xfrm>
            <a:off x="4425888" y="3624946"/>
            <a:ext cx="63331" cy="701633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4" name="Freeform 178"/>
          <p:cNvSpPr>
            <a:spLocks noEditPoints="1"/>
          </p:cNvSpPr>
          <p:nvPr/>
        </p:nvSpPr>
        <p:spPr bwMode="auto">
          <a:xfrm>
            <a:off x="4424569" y="3622568"/>
            <a:ext cx="67289" cy="706390"/>
          </a:xfrm>
          <a:custGeom>
            <a:avLst/>
            <a:gdLst>
              <a:gd name="T0" fmla="*/ 0 w 432"/>
              <a:gd name="T1" fmla="*/ 16 h 4952"/>
              <a:gd name="T2" fmla="*/ 16 w 432"/>
              <a:gd name="T3" fmla="*/ 0 h 4952"/>
              <a:gd name="T4" fmla="*/ 416 w 432"/>
              <a:gd name="T5" fmla="*/ 0 h 4952"/>
              <a:gd name="T6" fmla="*/ 432 w 432"/>
              <a:gd name="T7" fmla="*/ 16 h 4952"/>
              <a:gd name="T8" fmla="*/ 432 w 432"/>
              <a:gd name="T9" fmla="*/ 4936 h 4952"/>
              <a:gd name="T10" fmla="*/ 416 w 432"/>
              <a:gd name="T11" fmla="*/ 4952 h 4952"/>
              <a:gd name="T12" fmla="*/ 16 w 432"/>
              <a:gd name="T13" fmla="*/ 4952 h 4952"/>
              <a:gd name="T14" fmla="*/ 0 w 432"/>
              <a:gd name="T15" fmla="*/ 4936 h 4952"/>
              <a:gd name="T16" fmla="*/ 0 w 432"/>
              <a:gd name="T17" fmla="*/ 16 h 4952"/>
              <a:gd name="T18" fmla="*/ 32 w 432"/>
              <a:gd name="T19" fmla="*/ 4936 h 4952"/>
              <a:gd name="T20" fmla="*/ 16 w 432"/>
              <a:gd name="T21" fmla="*/ 4920 h 4952"/>
              <a:gd name="T22" fmla="*/ 416 w 432"/>
              <a:gd name="T23" fmla="*/ 4920 h 4952"/>
              <a:gd name="T24" fmla="*/ 400 w 432"/>
              <a:gd name="T25" fmla="*/ 4936 h 4952"/>
              <a:gd name="T26" fmla="*/ 400 w 432"/>
              <a:gd name="T27" fmla="*/ 16 h 4952"/>
              <a:gd name="T28" fmla="*/ 416 w 432"/>
              <a:gd name="T29" fmla="*/ 32 h 4952"/>
              <a:gd name="T30" fmla="*/ 16 w 432"/>
              <a:gd name="T31" fmla="*/ 32 h 4952"/>
              <a:gd name="T32" fmla="*/ 32 w 432"/>
              <a:gd name="T33" fmla="*/ 16 h 4952"/>
              <a:gd name="T34" fmla="*/ 32 w 432"/>
              <a:gd name="T35" fmla="*/ 4936 h 49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4952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4936"/>
                </a:lnTo>
                <a:cubicBezTo>
                  <a:pt x="432" y="4945"/>
                  <a:pt x="425" y="4952"/>
                  <a:pt x="416" y="4952"/>
                </a:cubicBezTo>
                <a:lnTo>
                  <a:pt x="16" y="4952"/>
                </a:lnTo>
                <a:cubicBezTo>
                  <a:pt x="8" y="4952"/>
                  <a:pt x="0" y="4945"/>
                  <a:pt x="0" y="4936"/>
                </a:cubicBezTo>
                <a:lnTo>
                  <a:pt x="0" y="16"/>
                </a:lnTo>
                <a:close/>
                <a:moveTo>
                  <a:pt x="32" y="4936"/>
                </a:moveTo>
                <a:lnTo>
                  <a:pt x="16" y="4920"/>
                </a:lnTo>
                <a:lnTo>
                  <a:pt x="416" y="4920"/>
                </a:lnTo>
                <a:lnTo>
                  <a:pt x="400" y="4936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493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5" name="Rectangle 179"/>
          <p:cNvSpPr>
            <a:spLocks noChangeArrowheads="1"/>
          </p:cNvSpPr>
          <p:nvPr/>
        </p:nvSpPr>
        <p:spPr bwMode="auto">
          <a:xfrm>
            <a:off x="4647545" y="3649920"/>
            <a:ext cx="63331" cy="676660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6" name="Freeform 180"/>
          <p:cNvSpPr>
            <a:spLocks noEditPoints="1"/>
          </p:cNvSpPr>
          <p:nvPr/>
        </p:nvSpPr>
        <p:spPr bwMode="auto">
          <a:xfrm>
            <a:off x="4646226" y="3647542"/>
            <a:ext cx="67289" cy="681417"/>
          </a:xfrm>
          <a:custGeom>
            <a:avLst/>
            <a:gdLst>
              <a:gd name="T0" fmla="*/ 0 w 432"/>
              <a:gd name="T1" fmla="*/ 16 h 4776"/>
              <a:gd name="T2" fmla="*/ 16 w 432"/>
              <a:gd name="T3" fmla="*/ 0 h 4776"/>
              <a:gd name="T4" fmla="*/ 416 w 432"/>
              <a:gd name="T5" fmla="*/ 0 h 4776"/>
              <a:gd name="T6" fmla="*/ 432 w 432"/>
              <a:gd name="T7" fmla="*/ 16 h 4776"/>
              <a:gd name="T8" fmla="*/ 432 w 432"/>
              <a:gd name="T9" fmla="*/ 4760 h 4776"/>
              <a:gd name="T10" fmla="*/ 416 w 432"/>
              <a:gd name="T11" fmla="*/ 4776 h 4776"/>
              <a:gd name="T12" fmla="*/ 16 w 432"/>
              <a:gd name="T13" fmla="*/ 4776 h 4776"/>
              <a:gd name="T14" fmla="*/ 0 w 432"/>
              <a:gd name="T15" fmla="*/ 4760 h 4776"/>
              <a:gd name="T16" fmla="*/ 0 w 432"/>
              <a:gd name="T17" fmla="*/ 16 h 4776"/>
              <a:gd name="T18" fmla="*/ 32 w 432"/>
              <a:gd name="T19" fmla="*/ 4760 h 4776"/>
              <a:gd name="T20" fmla="*/ 16 w 432"/>
              <a:gd name="T21" fmla="*/ 4744 h 4776"/>
              <a:gd name="T22" fmla="*/ 416 w 432"/>
              <a:gd name="T23" fmla="*/ 4744 h 4776"/>
              <a:gd name="T24" fmla="*/ 400 w 432"/>
              <a:gd name="T25" fmla="*/ 4760 h 4776"/>
              <a:gd name="T26" fmla="*/ 400 w 432"/>
              <a:gd name="T27" fmla="*/ 16 h 4776"/>
              <a:gd name="T28" fmla="*/ 416 w 432"/>
              <a:gd name="T29" fmla="*/ 32 h 4776"/>
              <a:gd name="T30" fmla="*/ 16 w 432"/>
              <a:gd name="T31" fmla="*/ 32 h 4776"/>
              <a:gd name="T32" fmla="*/ 32 w 432"/>
              <a:gd name="T33" fmla="*/ 16 h 4776"/>
              <a:gd name="T34" fmla="*/ 32 w 432"/>
              <a:gd name="T35" fmla="*/ 4760 h 47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4776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4760"/>
                </a:lnTo>
                <a:cubicBezTo>
                  <a:pt x="432" y="4769"/>
                  <a:pt x="425" y="4776"/>
                  <a:pt x="416" y="4776"/>
                </a:cubicBezTo>
                <a:lnTo>
                  <a:pt x="16" y="4776"/>
                </a:lnTo>
                <a:cubicBezTo>
                  <a:pt x="8" y="4776"/>
                  <a:pt x="0" y="4769"/>
                  <a:pt x="0" y="4760"/>
                </a:cubicBezTo>
                <a:lnTo>
                  <a:pt x="0" y="16"/>
                </a:lnTo>
                <a:close/>
                <a:moveTo>
                  <a:pt x="32" y="4760"/>
                </a:moveTo>
                <a:lnTo>
                  <a:pt x="16" y="4744"/>
                </a:lnTo>
                <a:lnTo>
                  <a:pt x="416" y="4744"/>
                </a:lnTo>
                <a:lnTo>
                  <a:pt x="400" y="4760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476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7" name="Rectangle 181"/>
          <p:cNvSpPr>
            <a:spLocks noChangeArrowheads="1"/>
          </p:cNvSpPr>
          <p:nvPr/>
        </p:nvSpPr>
        <p:spPr bwMode="auto">
          <a:xfrm>
            <a:off x="4867883" y="3777165"/>
            <a:ext cx="63331" cy="549414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8" name="Freeform 182"/>
          <p:cNvSpPr>
            <a:spLocks noEditPoints="1"/>
          </p:cNvSpPr>
          <p:nvPr/>
        </p:nvSpPr>
        <p:spPr bwMode="auto">
          <a:xfrm>
            <a:off x="4866563" y="3774787"/>
            <a:ext cx="67289" cy="554171"/>
          </a:xfrm>
          <a:custGeom>
            <a:avLst/>
            <a:gdLst>
              <a:gd name="T0" fmla="*/ 0 w 432"/>
              <a:gd name="T1" fmla="*/ 16 h 3888"/>
              <a:gd name="T2" fmla="*/ 16 w 432"/>
              <a:gd name="T3" fmla="*/ 0 h 3888"/>
              <a:gd name="T4" fmla="*/ 416 w 432"/>
              <a:gd name="T5" fmla="*/ 0 h 3888"/>
              <a:gd name="T6" fmla="*/ 432 w 432"/>
              <a:gd name="T7" fmla="*/ 16 h 3888"/>
              <a:gd name="T8" fmla="*/ 432 w 432"/>
              <a:gd name="T9" fmla="*/ 3872 h 3888"/>
              <a:gd name="T10" fmla="*/ 416 w 432"/>
              <a:gd name="T11" fmla="*/ 3888 h 3888"/>
              <a:gd name="T12" fmla="*/ 16 w 432"/>
              <a:gd name="T13" fmla="*/ 3888 h 3888"/>
              <a:gd name="T14" fmla="*/ 0 w 432"/>
              <a:gd name="T15" fmla="*/ 3872 h 3888"/>
              <a:gd name="T16" fmla="*/ 0 w 432"/>
              <a:gd name="T17" fmla="*/ 16 h 3888"/>
              <a:gd name="T18" fmla="*/ 32 w 432"/>
              <a:gd name="T19" fmla="*/ 3872 h 3888"/>
              <a:gd name="T20" fmla="*/ 16 w 432"/>
              <a:gd name="T21" fmla="*/ 3856 h 3888"/>
              <a:gd name="T22" fmla="*/ 416 w 432"/>
              <a:gd name="T23" fmla="*/ 3856 h 3888"/>
              <a:gd name="T24" fmla="*/ 400 w 432"/>
              <a:gd name="T25" fmla="*/ 3872 h 3888"/>
              <a:gd name="T26" fmla="*/ 400 w 432"/>
              <a:gd name="T27" fmla="*/ 16 h 3888"/>
              <a:gd name="T28" fmla="*/ 416 w 432"/>
              <a:gd name="T29" fmla="*/ 32 h 3888"/>
              <a:gd name="T30" fmla="*/ 16 w 432"/>
              <a:gd name="T31" fmla="*/ 32 h 3888"/>
              <a:gd name="T32" fmla="*/ 32 w 432"/>
              <a:gd name="T33" fmla="*/ 16 h 3888"/>
              <a:gd name="T34" fmla="*/ 32 w 432"/>
              <a:gd name="T35" fmla="*/ 3872 h 38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3888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3872"/>
                </a:lnTo>
                <a:cubicBezTo>
                  <a:pt x="432" y="3881"/>
                  <a:pt x="425" y="3888"/>
                  <a:pt x="416" y="3888"/>
                </a:cubicBezTo>
                <a:lnTo>
                  <a:pt x="16" y="3888"/>
                </a:lnTo>
                <a:cubicBezTo>
                  <a:pt x="8" y="3888"/>
                  <a:pt x="0" y="3881"/>
                  <a:pt x="0" y="3872"/>
                </a:cubicBezTo>
                <a:lnTo>
                  <a:pt x="0" y="16"/>
                </a:lnTo>
                <a:close/>
                <a:moveTo>
                  <a:pt x="32" y="3872"/>
                </a:moveTo>
                <a:lnTo>
                  <a:pt x="16" y="3856"/>
                </a:lnTo>
                <a:lnTo>
                  <a:pt x="416" y="3856"/>
                </a:lnTo>
                <a:lnTo>
                  <a:pt x="400" y="3872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387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9" name="Rectangle 183"/>
          <p:cNvSpPr>
            <a:spLocks noChangeArrowheads="1"/>
          </p:cNvSpPr>
          <p:nvPr/>
        </p:nvSpPr>
        <p:spPr bwMode="auto">
          <a:xfrm>
            <a:off x="5089540" y="3724840"/>
            <a:ext cx="63331" cy="601740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0" name="Freeform 184"/>
          <p:cNvSpPr>
            <a:spLocks noEditPoints="1"/>
          </p:cNvSpPr>
          <p:nvPr/>
        </p:nvSpPr>
        <p:spPr bwMode="auto">
          <a:xfrm>
            <a:off x="5088220" y="3722461"/>
            <a:ext cx="67289" cy="606496"/>
          </a:xfrm>
          <a:custGeom>
            <a:avLst/>
            <a:gdLst>
              <a:gd name="T0" fmla="*/ 0 w 432"/>
              <a:gd name="T1" fmla="*/ 16 h 4256"/>
              <a:gd name="T2" fmla="*/ 16 w 432"/>
              <a:gd name="T3" fmla="*/ 0 h 4256"/>
              <a:gd name="T4" fmla="*/ 416 w 432"/>
              <a:gd name="T5" fmla="*/ 0 h 4256"/>
              <a:gd name="T6" fmla="*/ 432 w 432"/>
              <a:gd name="T7" fmla="*/ 16 h 4256"/>
              <a:gd name="T8" fmla="*/ 432 w 432"/>
              <a:gd name="T9" fmla="*/ 4240 h 4256"/>
              <a:gd name="T10" fmla="*/ 416 w 432"/>
              <a:gd name="T11" fmla="*/ 4256 h 4256"/>
              <a:gd name="T12" fmla="*/ 16 w 432"/>
              <a:gd name="T13" fmla="*/ 4256 h 4256"/>
              <a:gd name="T14" fmla="*/ 0 w 432"/>
              <a:gd name="T15" fmla="*/ 4240 h 4256"/>
              <a:gd name="T16" fmla="*/ 0 w 432"/>
              <a:gd name="T17" fmla="*/ 16 h 4256"/>
              <a:gd name="T18" fmla="*/ 32 w 432"/>
              <a:gd name="T19" fmla="*/ 4240 h 4256"/>
              <a:gd name="T20" fmla="*/ 16 w 432"/>
              <a:gd name="T21" fmla="*/ 4224 h 4256"/>
              <a:gd name="T22" fmla="*/ 416 w 432"/>
              <a:gd name="T23" fmla="*/ 4224 h 4256"/>
              <a:gd name="T24" fmla="*/ 400 w 432"/>
              <a:gd name="T25" fmla="*/ 4240 h 4256"/>
              <a:gd name="T26" fmla="*/ 400 w 432"/>
              <a:gd name="T27" fmla="*/ 16 h 4256"/>
              <a:gd name="T28" fmla="*/ 416 w 432"/>
              <a:gd name="T29" fmla="*/ 32 h 4256"/>
              <a:gd name="T30" fmla="*/ 16 w 432"/>
              <a:gd name="T31" fmla="*/ 32 h 4256"/>
              <a:gd name="T32" fmla="*/ 32 w 432"/>
              <a:gd name="T33" fmla="*/ 16 h 4256"/>
              <a:gd name="T34" fmla="*/ 32 w 432"/>
              <a:gd name="T35" fmla="*/ 4240 h 42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4256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4240"/>
                </a:lnTo>
                <a:cubicBezTo>
                  <a:pt x="432" y="4249"/>
                  <a:pt x="425" y="4256"/>
                  <a:pt x="416" y="4256"/>
                </a:cubicBezTo>
                <a:lnTo>
                  <a:pt x="16" y="4256"/>
                </a:lnTo>
                <a:cubicBezTo>
                  <a:pt x="8" y="4256"/>
                  <a:pt x="0" y="4249"/>
                  <a:pt x="0" y="4240"/>
                </a:cubicBezTo>
                <a:lnTo>
                  <a:pt x="0" y="16"/>
                </a:lnTo>
                <a:close/>
                <a:moveTo>
                  <a:pt x="32" y="4240"/>
                </a:moveTo>
                <a:lnTo>
                  <a:pt x="16" y="4224"/>
                </a:lnTo>
                <a:lnTo>
                  <a:pt x="416" y="4224"/>
                </a:lnTo>
                <a:lnTo>
                  <a:pt x="400" y="4240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424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1" name="Rectangle 185"/>
          <p:cNvSpPr>
            <a:spLocks noChangeArrowheads="1"/>
          </p:cNvSpPr>
          <p:nvPr/>
        </p:nvSpPr>
        <p:spPr bwMode="auto">
          <a:xfrm>
            <a:off x="5311197" y="3840193"/>
            <a:ext cx="63331" cy="486387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2" name="Freeform 186"/>
          <p:cNvSpPr>
            <a:spLocks noEditPoints="1"/>
          </p:cNvSpPr>
          <p:nvPr/>
        </p:nvSpPr>
        <p:spPr bwMode="auto">
          <a:xfrm>
            <a:off x="5309877" y="3839004"/>
            <a:ext cx="67289" cy="489954"/>
          </a:xfrm>
          <a:custGeom>
            <a:avLst/>
            <a:gdLst>
              <a:gd name="T0" fmla="*/ 0 w 432"/>
              <a:gd name="T1" fmla="*/ 16 h 3440"/>
              <a:gd name="T2" fmla="*/ 16 w 432"/>
              <a:gd name="T3" fmla="*/ 0 h 3440"/>
              <a:gd name="T4" fmla="*/ 416 w 432"/>
              <a:gd name="T5" fmla="*/ 0 h 3440"/>
              <a:gd name="T6" fmla="*/ 432 w 432"/>
              <a:gd name="T7" fmla="*/ 16 h 3440"/>
              <a:gd name="T8" fmla="*/ 432 w 432"/>
              <a:gd name="T9" fmla="*/ 3424 h 3440"/>
              <a:gd name="T10" fmla="*/ 416 w 432"/>
              <a:gd name="T11" fmla="*/ 3440 h 3440"/>
              <a:gd name="T12" fmla="*/ 16 w 432"/>
              <a:gd name="T13" fmla="*/ 3440 h 3440"/>
              <a:gd name="T14" fmla="*/ 0 w 432"/>
              <a:gd name="T15" fmla="*/ 3424 h 3440"/>
              <a:gd name="T16" fmla="*/ 0 w 432"/>
              <a:gd name="T17" fmla="*/ 16 h 3440"/>
              <a:gd name="T18" fmla="*/ 32 w 432"/>
              <a:gd name="T19" fmla="*/ 3424 h 3440"/>
              <a:gd name="T20" fmla="*/ 16 w 432"/>
              <a:gd name="T21" fmla="*/ 3408 h 3440"/>
              <a:gd name="T22" fmla="*/ 416 w 432"/>
              <a:gd name="T23" fmla="*/ 3408 h 3440"/>
              <a:gd name="T24" fmla="*/ 400 w 432"/>
              <a:gd name="T25" fmla="*/ 3424 h 3440"/>
              <a:gd name="T26" fmla="*/ 400 w 432"/>
              <a:gd name="T27" fmla="*/ 16 h 3440"/>
              <a:gd name="T28" fmla="*/ 416 w 432"/>
              <a:gd name="T29" fmla="*/ 32 h 3440"/>
              <a:gd name="T30" fmla="*/ 16 w 432"/>
              <a:gd name="T31" fmla="*/ 32 h 3440"/>
              <a:gd name="T32" fmla="*/ 32 w 432"/>
              <a:gd name="T33" fmla="*/ 16 h 3440"/>
              <a:gd name="T34" fmla="*/ 32 w 432"/>
              <a:gd name="T35" fmla="*/ 3424 h 3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32" h="3440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16" y="0"/>
                </a:lnTo>
                <a:cubicBezTo>
                  <a:pt x="425" y="0"/>
                  <a:pt x="432" y="8"/>
                  <a:pt x="432" y="16"/>
                </a:cubicBezTo>
                <a:lnTo>
                  <a:pt x="432" y="3424"/>
                </a:lnTo>
                <a:cubicBezTo>
                  <a:pt x="432" y="3433"/>
                  <a:pt x="425" y="3440"/>
                  <a:pt x="416" y="3440"/>
                </a:cubicBezTo>
                <a:lnTo>
                  <a:pt x="16" y="3440"/>
                </a:lnTo>
                <a:cubicBezTo>
                  <a:pt x="8" y="3440"/>
                  <a:pt x="0" y="3433"/>
                  <a:pt x="0" y="3424"/>
                </a:cubicBezTo>
                <a:lnTo>
                  <a:pt x="0" y="16"/>
                </a:lnTo>
                <a:close/>
                <a:moveTo>
                  <a:pt x="32" y="3424"/>
                </a:moveTo>
                <a:lnTo>
                  <a:pt x="16" y="3408"/>
                </a:lnTo>
                <a:lnTo>
                  <a:pt x="416" y="3408"/>
                </a:lnTo>
                <a:lnTo>
                  <a:pt x="400" y="3424"/>
                </a:lnTo>
                <a:lnTo>
                  <a:pt x="400" y="16"/>
                </a:lnTo>
                <a:lnTo>
                  <a:pt x="416" y="32"/>
                </a:lnTo>
                <a:lnTo>
                  <a:pt x="16" y="32"/>
                </a:lnTo>
                <a:lnTo>
                  <a:pt x="32" y="16"/>
                </a:lnTo>
                <a:lnTo>
                  <a:pt x="32" y="342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3" name="Rectangle 187"/>
          <p:cNvSpPr>
            <a:spLocks noChangeArrowheads="1"/>
          </p:cNvSpPr>
          <p:nvPr/>
        </p:nvSpPr>
        <p:spPr bwMode="auto">
          <a:xfrm>
            <a:off x="5532854" y="3915113"/>
            <a:ext cx="63331" cy="411466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4" name="Freeform 188"/>
          <p:cNvSpPr>
            <a:spLocks noEditPoints="1"/>
          </p:cNvSpPr>
          <p:nvPr/>
        </p:nvSpPr>
        <p:spPr bwMode="auto">
          <a:xfrm>
            <a:off x="5531534" y="3912735"/>
            <a:ext cx="65969" cy="416223"/>
          </a:xfrm>
          <a:custGeom>
            <a:avLst/>
            <a:gdLst>
              <a:gd name="T0" fmla="*/ 0 w 424"/>
              <a:gd name="T1" fmla="*/ 16 h 2920"/>
              <a:gd name="T2" fmla="*/ 16 w 424"/>
              <a:gd name="T3" fmla="*/ 0 h 2920"/>
              <a:gd name="T4" fmla="*/ 408 w 424"/>
              <a:gd name="T5" fmla="*/ 0 h 2920"/>
              <a:gd name="T6" fmla="*/ 424 w 424"/>
              <a:gd name="T7" fmla="*/ 16 h 2920"/>
              <a:gd name="T8" fmla="*/ 424 w 424"/>
              <a:gd name="T9" fmla="*/ 2904 h 2920"/>
              <a:gd name="T10" fmla="*/ 408 w 424"/>
              <a:gd name="T11" fmla="*/ 2920 h 2920"/>
              <a:gd name="T12" fmla="*/ 16 w 424"/>
              <a:gd name="T13" fmla="*/ 2920 h 2920"/>
              <a:gd name="T14" fmla="*/ 0 w 424"/>
              <a:gd name="T15" fmla="*/ 2904 h 2920"/>
              <a:gd name="T16" fmla="*/ 0 w 424"/>
              <a:gd name="T17" fmla="*/ 16 h 2920"/>
              <a:gd name="T18" fmla="*/ 32 w 424"/>
              <a:gd name="T19" fmla="*/ 2904 h 2920"/>
              <a:gd name="T20" fmla="*/ 16 w 424"/>
              <a:gd name="T21" fmla="*/ 2888 h 2920"/>
              <a:gd name="T22" fmla="*/ 408 w 424"/>
              <a:gd name="T23" fmla="*/ 2888 h 2920"/>
              <a:gd name="T24" fmla="*/ 392 w 424"/>
              <a:gd name="T25" fmla="*/ 2904 h 2920"/>
              <a:gd name="T26" fmla="*/ 392 w 424"/>
              <a:gd name="T27" fmla="*/ 16 h 2920"/>
              <a:gd name="T28" fmla="*/ 408 w 424"/>
              <a:gd name="T29" fmla="*/ 32 h 2920"/>
              <a:gd name="T30" fmla="*/ 16 w 424"/>
              <a:gd name="T31" fmla="*/ 32 h 2920"/>
              <a:gd name="T32" fmla="*/ 32 w 424"/>
              <a:gd name="T33" fmla="*/ 16 h 2920"/>
              <a:gd name="T34" fmla="*/ 32 w 424"/>
              <a:gd name="T35" fmla="*/ 2904 h 29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424" h="2920">
                <a:moveTo>
                  <a:pt x="0" y="16"/>
                </a:moveTo>
                <a:cubicBezTo>
                  <a:pt x="0" y="8"/>
                  <a:pt x="8" y="0"/>
                  <a:pt x="16" y="0"/>
                </a:cubicBezTo>
                <a:lnTo>
                  <a:pt x="408" y="0"/>
                </a:lnTo>
                <a:cubicBezTo>
                  <a:pt x="417" y="0"/>
                  <a:pt x="424" y="8"/>
                  <a:pt x="424" y="16"/>
                </a:cubicBezTo>
                <a:lnTo>
                  <a:pt x="424" y="2904"/>
                </a:lnTo>
                <a:cubicBezTo>
                  <a:pt x="424" y="2913"/>
                  <a:pt x="417" y="2920"/>
                  <a:pt x="408" y="2920"/>
                </a:cubicBezTo>
                <a:lnTo>
                  <a:pt x="16" y="2920"/>
                </a:lnTo>
                <a:cubicBezTo>
                  <a:pt x="8" y="2920"/>
                  <a:pt x="0" y="2913"/>
                  <a:pt x="0" y="2904"/>
                </a:cubicBezTo>
                <a:lnTo>
                  <a:pt x="0" y="16"/>
                </a:lnTo>
                <a:close/>
                <a:moveTo>
                  <a:pt x="32" y="2904"/>
                </a:moveTo>
                <a:lnTo>
                  <a:pt x="16" y="2888"/>
                </a:lnTo>
                <a:lnTo>
                  <a:pt x="408" y="2888"/>
                </a:lnTo>
                <a:lnTo>
                  <a:pt x="392" y="2904"/>
                </a:lnTo>
                <a:lnTo>
                  <a:pt x="392" y="16"/>
                </a:lnTo>
                <a:lnTo>
                  <a:pt x="408" y="32"/>
                </a:lnTo>
                <a:lnTo>
                  <a:pt x="16" y="32"/>
                </a:lnTo>
                <a:lnTo>
                  <a:pt x="32" y="16"/>
                </a:lnTo>
                <a:lnTo>
                  <a:pt x="32" y="2904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5" name="Rectangle 189"/>
          <p:cNvSpPr>
            <a:spLocks noChangeArrowheads="1"/>
          </p:cNvSpPr>
          <p:nvPr/>
        </p:nvSpPr>
        <p:spPr bwMode="auto">
          <a:xfrm>
            <a:off x="5976168" y="3639217"/>
            <a:ext cx="63331" cy="687363"/>
          </a:xfrm>
          <a:prstGeom prst="rect">
            <a:avLst/>
          </a:prstGeom>
          <a:solidFill>
            <a:srgbClr val="BFBFBF"/>
          </a:solidFill>
          <a:ln>
            <a:noFill/>
          </a:ln>
          <a:extLs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6" name="Freeform 190"/>
          <p:cNvSpPr>
            <a:spLocks noEditPoints="1"/>
          </p:cNvSpPr>
          <p:nvPr/>
        </p:nvSpPr>
        <p:spPr bwMode="auto">
          <a:xfrm>
            <a:off x="5973529" y="3636838"/>
            <a:ext cx="67289" cy="692119"/>
          </a:xfrm>
          <a:custGeom>
            <a:avLst/>
            <a:gdLst>
              <a:gd name="T0" fmla="*/ 0 w 216"/>
              <a:gd name="T1" fmla="*/ 8 h 2428"/>
              <a:gd name="T2" fmla="*/ 8 w 216"/>
              <a:gd name="T3" fmla="*/ 0 h 2428"/>
              <a:gd name="T4" fmla="*/ 208 w 216"/>
              <a:gd name="T5" fmla="*/ 0 h 2428"/>
              <a:gd name="T6" fmla="*/ 216 w 216"/>
              <a:gd name="T7" fmla="*/ 8 h 2428"/>
              <a:gd name="T8" fmla="*/ 216 w 216"/>
              <a:gd name="T9" fmla="*/ 2420 h 2428"/>
              <a:gd name="T10" fmla="*/ 208 w 216"/>
              <a:gd name="T11" fmla="*/ 2428 h 2428"/>
              <a:gd name="T12" fmla="*/ 8 w 216"/>
              <a:gd name="T13" fmla="*/ 2428 h 2428"/>
              <a:gd name="T14" fmla="*/ 0 w 216"/>
              <a:gd name="T15" fmla="*/ 2420 h 2428"/>
              <a:gd name="T16" fmla="*/ 0 w 216"/>
              <a:gd name="T17" fmla="*/ 8 h 2428"/>
              <a:gd name="T18" fmla="*/ 16 w 216"/>
              <a:gd name="T19" fmla="*/ 2420 h 2428"/>
              <a:gd name="T20" fmla="*/ 8 w 216"/>
              <a:gd name="T21" fmla="*/ 2412 h 2428"/>
              <a:gd name="T22" fmla="*/ 208 w 216"/>
              <a:gd name="T23" fmla="*/ 2412 h 2428"/>
              <a:gd name="T24" fmla="*/ 200 w 216"/>
              <a:gd name="T25" fmla="*/ 2420 h 2428"/>
              <a:gd name="T26" fmla="*/ 200 w 216"/>
              <a:gd name="T27" fmla="*/ 8 h 2428"/>
              <a:gd name="T28" fmla="*/ 208 w 216"/>
              <a:gd name="T29" fmla="*/ 16 h 2428"/>
              <a:gd name="T30" fmla="*/ 8 w 216"/>
              <a:gd name="T31" fmla="*/ 16 h 2428"/>
              <a:gd name="T32" fmla="*/ 16 w 216"/>
              <a:gd name="T33" fmla="*/ 8 h 2428"/>
              <a:gd name="T34" fmla="*/ 16 w 216"/>
              <a:gd name="T35" fmla="*/ 2420 h 24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16" h="2428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208" y="0"/>
                </a:lnTo>
                <a:cubicBezTo>
                  <a:pt x="213" y="0"/>
                  <a:pt x="216" y="4"/>
                  <a:pt x="216" y="8"/>
                </a:cubicBezTo>
                <a:lnTo>
                  <a:pt x="216" y="2420"/>
                </a:lnTo>
                <a:cubicBezTo>
                  <a:pt x="216" y="2425"/>
                  <a:pt x="213" y="2428"/>
                  <a:pt x="208" y="2428"/>
                </a:cubicBezTo>
                <a:lnTo>
                  <a:pt x="8" y="2428"/>
                </a:lnTo>
                <a:cubicBezTo>
                  <a:pt x="4" y="2428"/>
                  <a:pt x="0" y="2425"/>
                  <a:pt x="0" y="2420"/>
                </a:cubicBezTo>
                <a:lnTo>
                  <a:pt x="0" y="8"/>
                </a:lnTo>
                <a:close/>
                <a:moveTo>
                  <a:pt x="16" y="2420"/>
                </a:moveTo>
                <a:lnTo>
                  <a:pt x="8" y="2412"/>
                </a:lnTo>
                <a:lnTo>
                  <a:pt x="208" y="2412"/>
                </a:lnTo>
                <a:lnTo>
                  <a:pt x="200" y="2420"/>
                </a:lnTo>
                <a:lnTo>
                  <a:pt x="200" y="8"/>
                </a:lnTo>
                <a:lnTo>
                  <a:pt x="208" y="16"/>
                </a:lnTo>
                <a:lnTo>
                  <a:pt x="8" y="16"/>
                </a:lnTo>
                <a:lnTo>
                  <a:pt x="16" y="8"/>
                </a:lnTo>
                <a:lnTo>
                  <a:pt x="16" y="242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7" name="Freeform 191"/>
          <p:cNvSpPr>
            <a:spLocks noEditPoints="1"/>
          </p:cNvSpPr>
          <p:nvPr/>
        </p:nvSpPr>
        <p:spPr bwMode="auto">
          <a:xfrm>
            <a:off x="1272554" y="2553470"/>
            <a:ext cx="47498" cy="187895"/>
          </a:xfrm>
          <a:custGeom>
            <a:avLst/>
            <a:gdLst>
              <a:gd name="T0" fmla="*/ 15 w 36"/>
              <a:gd name="T1" fmla="*/ 155 h 158"/>
              <a:gd name="T2" fmla="*/ 15 w 36"/>
              <a:gd name="T3" fmla="*/ 78 h 158"/>
              <a:gd name="T4" fmla="*/ 15 w 36"/>
              <a:gd name="T5" fmla="*/ 3 h 158"/>
              <a:gd name="T6" fmla="*/ 21 w 36"/>
              <a:gd name="T7" fmla="*/ 3 h 158"/>
              <a:gd name="T8" fmla="*/ 21 w 36"/>
              <a:gd name="T9" fmla="*/ 78 h 158"/>
              <a:gd name="T10" fmla="*/ 21 w 36"/>
              <a:gd name="T11" fmla="*/ 155 h 158"/>
              <a:gd name="T12" fmla="*/ 15 w 36"/>
              <a:gd name="T13" fmla="*/ 155 h 158"/>
              <a:gd name="T14" fmla="*/ 0 w 36"/>
              <a:gd name="T15" fmla="*/ 152 h 158"/>
              <a:gd name="T16" fmla="*/ 36 w 36"/>
              <a:gd name="T17" fmla="*/ 152 h 158"/>
              <a:gd name="T18" fmla="*/ 36 w 36"/>
              <a:gd name="T19" fmla="*/ 158 h 158"/>
              <a:gd name="T20" fmla="*/ 0 w 36"/>
              <a:gd name="T21" fmla="*/ 158 h 158"/>
              <a:gd name="T22" fmla="*/ 0 w 36"/>
              <a:gd name="T23" fmla="*/ 152 h 158"/>
              <a:gd name="T24" fmla="*/ 0 w 36"/>
              <a:gd name="T25" fmla="*/ 0 h 158"/>
              <a:gd name="T26" fmla="*/ 36 w 36"/>
              <a:gd name="T27" fmla="*/ 0 h 158"/>
              <a:gd name="T28" fmla="*/ 36 w 36"/>
              <a:gd name="T29" fmla="*/ 6 h 158"/>
              <a:gd name="T30" fmla="*/ 0 w 36"/>
              <a:gd name="T31" fmla="*/ 6 h 158"/>
              <a:gd name="T32" fmla="*/ 0 w 36"/>
              <a:gd name="T33" fmla="*/ 0 h 1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58">
                <a:moveTo>
                  <a:pt x="15" y="155"/>
                </a:moveTo>
                <a:lnTo>
                  <a:pt x="15" y="78"/>
                </a:lnTo>
                <a:lnTo>
                  <a:pt x="15" y="3"/>
                </a:lnTo>
                <a:lnTo>
                  <a:pt x="21" y="3"/>
                </a:lnTo>
                <a:lnTo>
                  <a:pt x="21" y="78"/>
                </a:lnTo>
                <a:lnTo>
                  <a:pt x="21" y="155"/>
                </a:lnTo>
                <a:lnTo>
                  <a:pt x="15" y="155"/>
                </a:lnTo>
                <a:close/>
                <a:moveTo>
                  <a:pt x="0" y="152"/>
                </a:moveTo>
                <a:lnTo>
                  <a:pt x="36" y="152"/>
                </a:lnTo>
                <a:lnTo>
                  <a:pt x="36" y="158"/>
                </a:lnTo>
                <a:lnTo>
                  <a:pt x="0" y="158"/>
                </a:lnTo>
                <a:lnTo>
                  <a:pt x="0" y="15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8" name="Freeform 192"/>
          <p:cNvSpPr>
            <a:spLocks noEditPoints="1"/>
          </p:cNvSpPr>
          <p:nvPr/>
        </p:nvSpPr>
        <p:spPr bwMode="auto">
          <a:xfrm>
            <a:off x="1494210" y="2645038"/>
            <a:ext cx="47498" cy="260437"/>
          </a:xfrm>
          <a:custGeom>
            <a:avLst/>
            <a:gdLst>
              <a:gd name="T0" fmla="*/ 15 w 36"/>
              <a:gd name="T1" fmla="*/ 216 h 219"/>
              <a:gd name="T2" fmla="*/ 15 w 36"/>
              <a:gd name="T3" fmla="*/ 110 h 219"/>
              <a:gd name="T4" fmla="*/ 15 w 36"/>
              <a:gd name="T5" fmla="*/ 2 h 219"/>
              <a:gd name="T6" fmla="*/ 21 w 36"/>
              <a:gd name="T7" fmla="*/ 2 h 219"/>
              <a:gd name="T8" fmla="*/ 21 w 36"/>
              <a:gd name="T9" fmla="*/ 110 h 219"/>
              <a:gd name="T10" fmla="*/ 21 w 36"/>
              <a:gd name="T11" fmla="*/ 216 h 219"/>
              <a:gd name="T12" fmla="*/ 15 w 36"/>
              <a:gd name="T13" fmla="*/ 216 h 219"/>
              <a:gd name="T14" fmla="*/ 0 w 36"/>
              <a:gd name="T15" fmla="*/ 214 h 219"/>
              <a:gd name="T16" fmla="*/ 36 w 36"/>
              <a:gd name="T17" fmla="*/ 214 h 219"/>
              <a:gd name="T18" fmla="*/ 36 w 36"/>
              <a:gd name="T19" fmla="*/ 219 h 219"/>
              <a:gd name="T20" fmla="*/ 0 w 36"/>
              <a:gd name="T21" fmla="*/ 219 h 219"/>
              <a:gd name="T22" fmla="*/ 0 w 36"/>
              <a:gd name="T23" fmla="*/ 214 h 219"/>
              <a:gd name="T24" fmla="*/ 0 w 36"/>
              <a:gd name="T25" fmla="*/ 0 h 219"/>
              <a:gd name="T26" fmla="*/ 36 w 36"/>
              <a:gd name="T27" fmla="*/ 0 h 219"/>
              <a:gd name="T28" fmla="*/ 36 w 36"/>
              <a:gd name="T29" fmla="*/ 5 h 219"/>
              <a:gd name="T30" fmla="*/ 0 w 36"/>
              <a:gd name="T31" fmla="*/ 5 h 219"/>
              <a:gd name="T32" fmla="*/ 0 w 36"/>
              <a:gd name="T33" fmla="*/ 0 h 2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19">
                <a:moveTo>
                  <a:pt x="15" y="216"/>
                </a:moveTo>
                <a:lnTo>
                  <a:pt x="15" y="110"/>
                </a:lnTo>
                <a:lnTo>
                  <a:pt x="15" y="2"/>
                </a:lnTo>
                <a:lnTo>
                  <a:pt x="21" y="2"/>
                </a:lnTo>
                <a:lnTo>
                  <a:pt x="21" y="110"/>
                </a:lnTo>
                <a:lnTo>
                  <a:pt x="21" y="216"/>
                </a:lnTo>
                <a:lnTo>
                  <a:pt x="15" y="216"/>
                </a:lnTo>
                <a:close/>
                <a:moveTo>
                  <a:pt x="0" y="214"/>
                </a:moveTo>
                <a:lnTo>
                  <a:pt x="36" y="214"/>
                </a:lnTo>
                <a:lnTo>
                  <a:pt x="36" y="219"/>
                </a:lnTo>
                <a:lnTo>
                  <a:pt x="0" y="219"/>
                </a:lnTo>
                <a:lnTo>
                  <a:pt x="0" y="21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9" name="Freeform 193"/>
          <p:cNvSpPr>
            <a:spLocks noEditPoints="1"/>
          </p:cNvSpPr>
          <p:nvPr/>
        </p:nvSpPr>
        <p:spPr bwMode="auto">
          <a:xfrm>
            <a:off x="1715867" y="2836501"/>
            <a:ext cx="47498" cy="178381"/>
          </a:xfrm>
          <a:custGeom>
            <a:avLst/>
            <a:gdLst>
              <a:gd name="T0" fmla="*/ 14 w 36"/>
              <a:gd name="T1" fmla="*/ 147 h 150"/>
              <a:gd name="T2" fmla="*/ 14 w 36"/>
              <a:gd name="T3" fmla="*/ 75 h 150"/>
              <a:gd name="T4" fmla="*/ 14 w 36"/>
              <a:gd name="T5" fmla="*/ 3 h 150"/>
              <a:gd name="T6" fmla="*/ 20 w 36"/>
              <a:gd name="T7" fmla="*/ 3 h 150"/>
              <a:gd name="T8" fmla="*/ 20 w 36"/>
              <a:gd name="T9" fmla="*/ 75 h 150"/>
              <a:gd name="T10" fmla="*/ 20 w 36"/>
              <a:gd name="T11" fmla="*/ 147 h 150"/>
              <a:gd name="T12" fmla="*/ 14 w 36"/>
              <a:gd name="T13" fmla="*/ 147 h 150"/>
              <a:gd name="T14" fmla="*/ 0 w 36"/>
              <a:gd name="T15" fmla="*/ 144 h 150"/>
              <a:gd name="T16" fmla="*/ 36 w 36"/>
              <a:gd name="T17" fmla="*/ 144 h 150"/>
              <a:gd name="T18" fmla="*/ 36 w 36"/>
              <a:gd name="T19" fmla="*/ 150 h 150"/>
              <a:gd name="T20" fmla="*/ 0 w 36"/>
              <a:gd name="T21" fmla="*/ 150 h 150"/>
              <a:gd name="T22" fmla="*/ 0 w 36"/>
              <a:gd name="T23" fmla="*/ 144 h 150"/>
              <a:gd name="T24" fmla="*/ 0 w 36"/>
              <a:gd name="T25" fmla="*/ 0 h 150"/>
              <a:gd name="T26" fmla="*/ 36 w 36"/>
              <a:gd name="T27" fmla="*/ 0 h 150"/>
              <a:gd name="T28" fmla="*/ 36 w 36"/>
              <a:gd name="T29" fmla="*/ 6 h 150"/>
              <a:gd name="T30" fmla="*/ 0 w 36"/>
              <a:gd name="T31" fmla="*/ 6 h 150"/>
              <a:gd name="T32" fmla="*/ 0 w 36"/>
              <a:gd name="T33" fmla="*/ 0 h 1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50">
                <a:moveTo>
                  <a:pt x="14" y="147"/>
                </a:moveTo>
                <a:lnTo>
                  <a:pt x="14" y="75"/>
                </a:lnTo>
                <a:lnTo>
                  <a:pt x="14" y="3"/>
                </a:lnTo>
                <a:lnTo>
                  <a:pt x="20" y="3"/>
                </a:lnTo>
                <a:lnTo>
                  <a:pt x="20" y="75"/>
                </a:lnTo>
                <a:lnTo>
                  <a:pt x="20" y="147"/>
                </a:lnTo>
                <a:lnTo>
                  <a:pt x="14" y="147"/>
                </a:lnTo>
                <a:close/>
                <a:moveTo>
                  <a:pt x="0" y="144"/>
                </a:moveTo>
                <a:lnTo>
                  <a:pt x="36" y="144"/>
                </a:lnTo>
                <a:lnTo>
                  <a:pt x="36" y="150"/>
                </a:lnTo>
                <a:lnTo>
                  <a:pt x="0" y="150"/>
                </a:lnTo>
                <a:lnTo>
                  <a:pt x="0" y="14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0" name="Freeform 194"/>
          <p:cNvSpPr>
            <a:spLocks noEditPoints="1"/>
          </p:cNvSpPr>
          <p:nvPr/>
        </p:nvSpPr>
        <p:spPr bwMode="auto">
          <a:xfrm>
            <a:off x="1936205" y="3046991"/>
            <a:ext cx="48818" cy="146273"/>
          </a:xfrm>
          <a:custGeom>
            <a:avLst/>
            <a:gdLst>
              <a:gd name="T0" fmla="*/ 15 w 37"/>
              <a:gd name="T1" fmla="*/ 120 h 123"/>
              <a:gd name="T2" fmla="*/ 15 w 37"/>
              <a:gd name="T3" fmla="*/ 62 h 123"/>
              <a:gd name="T4" fmla="*/ 15 w 37"/>
              <a:gd name="T5" fmla="*/ 3 h 123"/>
              <a:gd name="T6" fmla="*/ 21 w 37"/>
              <a:gd name="T7" fmla="*/ 3 h 123"/>
              <a:gd name="T8" fmla="*/ 21 w 37"/>
              <a:gd name="T9" fmla="*/ 62 h 123"/>
              <a:gd name="T10" fmla="*/ 21 w 37"/>
              <a:gd name="T11" fmla="*/ 120 h 123"/>
              <a:gd name="T12" fmla="*/ 15 w 37"/>
              <a:gd name="T13" fmla="*/ 120 h 123"/>
              <a:gd name="T14" fmla="*/ 0 w 37"/>
              <a:gd name="T15" fmla="*/ 117 h 123"/>
              <a:gd name="T16" fmla="*/ 37 w 37"/>
              <a:gd name="T17" fmla="*/ 117 h 123"/>
              <a:gd name="T18" fmla="*/ 37 w 37"/>
              <a:gd name="T19" fmla="*/ 123 h 123"/>
              <a:gd name="T20" fmla="*/ 0 w 37"/>
              <a:gd name="T21" fmla="*/ 123 h 123"/>
              <a:gd name="T22" fmla="*/ 0 w 37"/>
              <a:gd name="T23" fmla="*/ 117 h 123"/>
              <a:gd name="T24" fmla="*/ 0 w 37"/>
              <a:gd name="T25" fmla="*/ 0 h 123"/>
              <a:gd name="T26" fmla="*/ 37 w 37"/>
              <a:gd name="T27" fmla="*/ 0 h 123"/>
              <a:gd name="T28" fmla="*/ 37 w 37"/>
              <a:gd name="T29" fmla="*/ 6 h 123"/>
              <a:gd name="T30" fmla="*/ 0 w 37"/>
              <a:gd name="T31" fmla="*/ 6 h 123"/>
              <a:gd name="T32" fmla="*/ 0 w 37"/>
              <a:gd name="T33" fmla="*/ 0 h 1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23">
                <a:moveTo>
                  <a:pt x="15" y="120"/>
                </a:moveTo>
                <a:lnTo>
                  <a:pt x="15" y="62"/>
                </a:lnTo>
                <a:lnTo>
                  <a:pt x="15" y="3"/>
                </a:lnTo>
                <a:lnTo>
                  <a:pt x="21" y="3"/>
                </a:lnTo>
                <a:lnTo>
                  <a:pt x="21" y="62"/>
                </a:lnTo>
                <a:lnTo>
                  <a:pt x="21" y="120"/>
                </a:lnTo>
                <a:lnTo>
                  <a:pt x="15" y="120"/>
                </a:lnTo>
                <a:close/>
                <a:moveTo>
                  <a:pt x="0" y="117"/>
                </a:moveTo>
                <a:lnTo>
                  <a:pt x="37" y="117"/>
                </a:lnTo>
                <a:lnTo>
                  <a:pt x="37" y="123"/>
                </a:lnTo>
                <a:lnTo>
                  <a:pt x="0" y="123"/>
                </a:lnTo>
                <a:lnTo>
                  <a:pt x="0" y="117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1" name="Freeform 195"/>
          <p:cNvSpPr>
            <a:spLocks noEditPoints="1"/>
          </p:cNvSpPr>
          <p:nvPr/>
        </p:nvSpPr>
        <p:spPr bwMode="auto">
          <a:xfrm>
            <a:off x="2157862" y="3089802"/>
            <a:ext cx="48818" cy="212869"/>
          </a:xfrm>
          <a:custGeom>
            <a:avLst/>
            <a:gdLst>
              <a:gd name="T0" fmla="*/ 15 w 37"/>
              <a:gd name="T1" fmla="*/ 176 h 179"/>
              <a:gd name="T2" fmla="*/ 15 w 37"/>
              <a:gd name="T3" fmla="*/ 89 h 179"/>
              <a:gd name="T4" fmla="*/ 15 w 37"/>
              <a:gd name="T5" fmla="*/ 3 h 179"/>
              <a:gd name="T6" fmla="*/ 21 w 37"/>
              <a:gd name="T7" fmla="*/ 3 h 179"/>
              <a:gd name="T8" fmla="*/ 21 w 37"/>
              <a:gd name="T9" fmla="*/ 89 h 179"/>
              <a:gd name="T10" fmla="*/ 21 w 37"/>
              <a:gd name="T11" fmla="*/ 176 h 179"/>
              <a:gd name="T12" fmla="*/ 15 w 37"/>
              <a:gd name="T13" fmla="*/ 176 h 179"/>
              <a:gd name="T14" fmla="*/ 0 w 37"/>
              <a:gd name="T15" fmla="*/ 174 h 179"/>
              <a:gd name="T16" fmla="*/ 37 w 37"/>
              <a:gd name="T17" fmla="*/ 174 h 179"/>
              <a:gd name="T18" fmla="*/ 37 w 37"/>
              <a:gd name="T19" fmla="*/ 179 h 179"/>
              <a:gd name="T20" fmla="*/ 0 w 37"/>
              <a:gd name="T21" fmla="*/ 179 h 179"/>
              <a:gd name="T22" fmla="*/ 0 w 37"/>
              <a:gd name="T23" fmla="*/ 174 h 179"/>
              <a:gd name="T24" fmla="*/ 0 w 37"/>
              <a:gd name="T25" fmla="*/ 0 h 179"/>
              <a:gd name="T26" fmla="*/ 37 w 37"/>
              <a:gd name="T27" fmla="*/ 0 h 179"/>
              <a:gd name="T28" fmla="*/ 37 w 37"/>
              <a:gd name="T29" fmla="*/ 6 h 179"/>
              <a:gd name="T30" fmla="*/ 0 w 37"/>
              <a:gd name="T31" fmla="*/ 6 h 179"/>
              <a:gd name="T32" fmla="*/ 0 w 37"/>
              <a:gd name="T33" fmla="*/ 0 h 1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79">
                <a:moveTo>
                  <a:pt x="15" y="176"/>
                </a:moveTo>
                <a:lnTo>
                  <a:pt x="15" y="89"/>
                </a:lnTo>
                <a:lnTo>
                  <a:pt x="15" y="3"/>
                </a:lnTo>
                <a:lnTo>
                  <a:pt x="21" y="3"/>
                </a:lnTo>
                <a:lnTo>
                  <a:pt x="21" y="89"/>
                </a:lnTo>
                <a:lnTo>
                  <a:pt x="21" y="176"/>
                </a:lnTo>
                <a:lnTo>
                  <a:pt x="15" y="176"/>
                </a:lnTo>
                <a:close/>
                <a:moveTo>
                  <a:pt x="0" y="174"/>
                </a:moveTo>
                <a:lnTo>
                  <a:pt x="37" y="174"/>
                </a:lnTo>
                <a:lnTo>
                  <a:pt x="37" y="179"/>
                </a:lnTo>
                <a:lnTo>
                  <a:pt x="0" y="179"/>
                </a:lnTo>
                <a:lnTo>
                  <a:pt x="0" y="174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2" name="Freeform 196"/>
          <p:cNvSpPr>
            <a:spLocks noEditPoints="1"/>
          </p:cNvSpPr>
          <p:nvPr/>
        </p:nvSpPr>
        <p:spPr bwMode="auto">
          <a:xfrm>
            <a:off x="2379519" y="3138560"/>
            <a:ext cx="47498" cy="130813"/>
          </a:xfrm>
          <a:custGeom>
            <a:avLst/>
            <a:gdLst>
              <a:gd name="T0" fmla="*/ 15 w 36"/>
              <a:gd name="T1" fmla="*/ 107 h 110"/>
              <a:gd name="T2" fmla="*/ 15 w 36"/>
              <a:gd name="T3" fmla="*/ 55 h 110"/>
              <a:gd name="T4" fmla="*/ 15 w 36"/>
              <a:gd name="T5" fmla="*/ 3 h 110"/>
              <a:gd name="T6" fmla="*/ 21 w 36"/>
              <a:gd name="T7" fmla="*/ 3 h 110"/>
              <a:gd name="T8" fmla="*/ 21 w 36"/>
              <a:gd name="T9" fmla="*/ 55 h 110"/>
              <a:gd name="T10" fmla="*/ 21 w 36"/>
              <a:gd name="T11" fmla="*/ 107 h 110"/>
              <a:gd name="T12" fmla="*/ 15 w 36"/>
              <a:gd name="T13" fmla="*/ 107 h 110"/>
              <a:gd name="T14" fmla="*/ 0 w 36"/>
              <a:gd name="T15" fmla="*/ 104 h 110"/>
              <a:gd name="T16" fmla="*/ 36 w 36"/>
              <a:gd name="T17" fmla="*/ 104 h 110"/>
              <a:gd name="T18" fmla="*/ 36 w 36"/>
              <a:gd name="T19" fmla="*/ 110 h 110"/>
              <a:gd name="T20" fmla="*/ 0 w 36"/>
              <a:gd name="T21" fmla="*/ 110 h 110"/>
              <a:gd name="T22" fmla="*/ 0 w 36"/>
              <a:gd name="T23" fmla="*/ 104 h 110"/>
              <a:gd name="T24" fmla="*/ 0 w 36"/>
              <a:gd name="T25" fmla="*/ 0 h 110"/>
              <a:gd name="T26" fmla="*/ 36 w 36"/>
              <a:gd name="T27" fmla="*/ 0 h 110"/>
              <a:gd name="T28" fmla="*/ 36 w 36"/>
              <a:gd name="T29" fmla="*/ 6 h 110"/>
              <a:gd name="T30" fmla="*/ 0 w 36"/>
              <a:gd name="T31" fmla="*/ 6 h 110"/>
              <a:gd name="T32" fmla="*/ 0 w 36"/>
              <a:gd name="T33" fmla="*/ 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10">
                <a:moveTo>
                  <a:pt x="15" y="107"/>
                </a:moveTo>
                <a:lnTo>
                  <a:pt x="15" y="55"/>
                </a:lnTo>
                <a:lnTo>
                  <a:pt x="15" y="3"/>
                </a:lnTo>
                <a:lnTo>
                  <a:pt x="21" y="3"/>
                </a:lnTo>
                <a:lnTo>
                  <a:pt x="21" y="55"/>
                </a:lnTo>
                <a:lnTo>
                  <a:pt x="21" y="107"/>
                </a:lnTo>
                <a:lnTo>
                  <a:pt x="15" y="107"/>
                </a:lnTo>
                <a:close/>
                <a:moveTo>
                  <a:pt x="0" y="104"/>
                </a:moveTo>
                <a:lnTo>
                  <a:pt x="36" y="104"/>
                </a:lnTo>
                <a:lnTo>
                  <a:pt x="36" y="110"/>
                </a:lnTo>
                <a:lnTo>
                  <a:pt x="0" y="110"/>
                </a:lnTo>
                <a:lnTo>
                  <a:pt x="0" y="10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3" name="Freeform 197"/>
          <p:cNvSpPr>
            <a:spLocks noEditPoints="1"/>
          </p:cNvSpPr>
          <p:nvPr/>
        </p:nvSpPr>
        <p:spPr bwMode="auto">
          <a:xfrm>
            <a:off x="2599857" y="3288401"/>
            <a:ext cx="48818" cy="36866"/>
          </a:xfrm>
          <a:custGeom>
            <a:avLst/>
            <a:gdLst>
              <a:gd name="T0" fmla="*/ 15 w 37"/>
              <a:gd name="T1" fmla="*/ 28 h 31"/>
              <a:gd name="T2" fmla="*/ 15 w 37"/>
              <a:gd name="T3" fmla="*/ 15 h 31"/>
              <a:gd name="T4" fmla="*/ 15 w 37"/>
              <a:gd name="T5" fmla="*/ 3 h 31"/>
              <a:gd name="T6" fmla="*/ 21 w 37"/>
              <a:gd name="T7" fmla="*/ 3 h 31"/>
              <a:gd name="T8" fmla="*/ 21 w 37"/>
              <a:gd name="T9" fmla="*/ 15 h 31"/>
              <a:gd name="T10" fmla="*/ 21 w 37"/>
              <a:gd name="T11" fmla="*/ 28 h 31"/>
              <a:gd name="T12" fmla="*/ 15 w 37"/>
              <a:gd name="T13" fmla="*/ 28 h 31"/>
              <a:gd name="T14" fmla="*/ 0 w 37"/>
              <a:gd name="T15" fmla="*/ 25 h 31"/>
              <a:gd name="T16" fmla="*/ 37 w 37"/>
              <a:gd name="T17" fmla="*/ 25 h 31"/>
              <a:gd name="T18" fmla="*/ 37 w 37"/>
              <a:gd name="T19" fmla="*/ 31 h 31"/>
              <a:gd name="T20" fmla="*/ 0 w 37"/>
              <a:gd name="T21" fmla="*/ 31 h 31"/>
              <a:gd name="T22" fmla="*/ 0 w 37"/>
              <a:gd name="T23" fmla="*/ 25 h 31"/>
              <a:gd name="T24" fmla="*/ 0 w 37"/>
              <a:gd name="T25" fmla="*/ 0 h 31"/>
              <a:gd name="T26" fmla="*/ 37 w 37"/>
              <a:gd name="T27" fmla="*/ 0 h 31"/>
              <a:gd name="T28" fmla="*/ 37 w 37"/>
              <a:gd name="T29" fmla="*/ 6 h 31"/>
              <a:gd name="T30" fmla="*/ 0 w 37"/>
              <a:gd name="T31" fmla="*/ 6 h 31"/>
              <a:gd name="T32" fmla="*/ 0 w 37"/>
              <a:gd name="T33" fmla="*/ 0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31">
                <a:moveTo>
                  <a:pt x="15" y="28"/>
                </a:moveTo>
                <a:lnTo>
                  <a:pt x="15" y="15"/>
                </a:lnTo>
                <a:lnTo>
                  <a:pt x="15" y="3"/>
                </a:lnTo>
                <a:lnTo>
                  <a:pt x="21" y="3"/>
                </a:lnTo>
                <a:lnTo>
                  <a:pt x="21" y="15"/>
                </a:lnTo>
                <a:lnTo>
                  <a:pt x="21" y="28"/>
                </a:lnTo>
                <a:lnTo>
                  <a:pt x="15" y="28"/>
                </a:lnTo>
                <a:close/>
                <a:moveTo>
                  <a:pt x="0" y="25"/>
                </a:moveTo>
                <a:lnTo>
                  <a:pt x="37" y="25"/>
                </a:lnTo>
                <a:lnTo>
                  <a:pt x="37" y="31"/>
                </a:lnTo>
                <a:lnTo>
                  <a:pt x="0" y="31"/>
                </a:lnTo>
                <a:lnTo>
                  <a:pt x="0" y="25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4" name="Freeform 198"/>
          <p:cNvSpPr>
            <a:spLocks noEditPoints="1"/>
          </p:cNvSpPr>
          <p:nvPr/>
        </p:nvSpPr>
        <p:spPr bwMode="auto">
          <a:xfrm>
            <a:off x="2821514" y="3270562"/>
            <a:ext cx="48818" cy="85623"/>
          </a:xfrm>
          <a:custGeom>
            <a:avLst/>
            <a:gdLst>
              <a:gd name="T0" fmla="*/ 15 w 37"/>
              <a:gd name="T1" fmla="*/ 70 h 72"/>
              <a:gd name="T2" fmla="*/ 15 w 37"/>
              <a:gd name="T3" fmla="*/ 36 h 72"/>
              <a:gd name="T4" fmla="*/ 15 w 37"/>
              <a:gd name="T5" fmla="*/ 3 h 72"/>
              <a:gd name="T6" fmla="*/ 21 w 37"/>
              <a:gd name="T7" fmla="*/ 3 h 72"/>
              <a:gd name="T8" fmla="*/ 21 w 37"/>
              <a:gd name="T9" fmla="*/ 36 h 72"/>
              <a:gd name="T10" fmla="*/ 21 w 37"/>
              <a:gd name="T11" fmla="*/ 70 h 72"/>
              <a:gd name="T12" fmla="*/ 15 w 37"/>
              <a:gd name="T13" fmla="*/ 70 h 72"/>
              <a:gd name="T14" fmla="*/ 0 w 37"/>
              <a:gd name="T15" fmla="*/ 67 h 72"/>
              <a:gd name="T16" fmla="*/ 37 w 37"/>
              <a:gd name="T17" fmla="*/ 67 h 72"/>
              <a:gd name="T18" fmla="*/ 37 w 37"/>
              <a:gd name="T19" fmla="*/ 72 h 72"/>
              <a:gd name="T20" fmla="*/ 0 w 37"/>
              <a:gd name="T21" fmla="*/ 72 h 72"/>
              <a:gd name="T22" fmla="*/ 0 w 37"/>
              <a:gd name="T23" fmla="*/ 67 h 72"/>
              <a:gd name="T24" fmla="*/ 0 w 37"/>
              <a:gd name="T25" fmla="*/ 0 h 72"/>
              <a:gd name="T26" fmla="*/ 37 w 37"/>
              <a:gd name="T27" fmla="*/ 0 h 72"/>
              <a:gd name="T28" fmla="*/ 37 w 37"/>
              <a:gd name="T29" fmla="*/ 6 h 72"/>
              <a:gd name="T30" fmla="*/ 0 w 37"/>
              <a:gd name="T31" fmla="*/ 6 h 72"/>
              <a:gd name="T32" fmla="*/ 0 w 37"/>
              <a:gd name="T33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72">
                <a:moveTo>
                  <a:pt x="15" y="70"/>
                </a:moveTo>
                <a:lnTo>
                  <a:pt x="15" y="36"/>
                </a:lnTo>
                <a:lnTo>
                  <a:pt x="15" y="3"/>
                </a:lnTo>
                <a:lnTo>
                  <a:pt x="21" y="3"/>
                </a:lnTo>
                <a:lnTo>
                  <a:pt x="21" y="36"/>
                </a:lnTo>
                <a:lnTo>
                  <a:pt x="21" y="70"/>
                </a:lnTo>
                <a:lnTo>
                  <a:pt x="15" y="70"/>
                </a:lnTo>
                <a:close/>
                <a:moveTo>
                  <a:pt x="0" y="67"/>
                </a:moveTo>
                <a:lnTo>
                  <a:pt x="37" y="67"/>
                </a:lnTo>
                <a:lnTo>
                  <a:pt x="37" y="72"/>
                </a:lnTo>
                <a:lnTo>
                  <a:pt x="0" y="72"/>
                </a:lnTo>
                <a:lnTo>
                  <a:pt x="0" y="67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5" name="Freeform 199"/>
          <p:cNvSpPr>
            <a:spLocks noEditPoints="1"/>
          </p:cNvSpPr>
          <p:nvPr/>
        </p:nvSpPr>
        <p:spPr bwMode="auto">
          <a:xfrm>
            <a:off x="3043171" y="3344293"/>
            <a:ext cx="47498" cy="61839"/>
          </a:xfrm>
          <a:custGeom>
            <a:avLst/>
            <a:gdLst>
              <a:gd name="T0" fmla="*/ 15 w 36"/>
              <a:gd name="T1" fmla="*/ 49 h 52"/>
              <a:gd name="T2" fmla="*/ 15 w 36"/>
              <a:gd name="T3" fmla="*/ 26 h 52"/>
              <a:gd name="T4" fmla="*/ 15 w 36"/>
              <a:gd name="T5" fmla="*/ 3 h 52"/>
              <a:gd name="T6" fmla="*/ 21 w 36"/>
              <a:gd name="T7" fmla="*/ 3 h 52"/>
              <a:gd name="T8" fmla="*/ 21 w 36"/>
              <a:gd name="T9" fmla="*/ 26 h 52"/>
              <a:gd name="T10" fmla="*/ 21 w 36"/>
              <a:gd name="T11" fmla="*/ 49 h 52"/>
              <a:gd name="T12" fmla="*/ 15 w 36"/>
              <a:gd name="T13" fmla="*/ 49 h 52"/>
              <a:gd name="T14" fmla="*/ 0 w 36"/>
              <a:gd name="T15" fmla="*/ 46 h 52"/>
              <a:gd name="T16" fmla="*/ 36 w 36"/>
              <a:gd name="T17" fmla="*/ 46 h 52"/>
              <a:gd name="T18" fmla="*/ 36 w 36"/>
              <a:gd name="T19" fmla="*/ 52 h 52"/>
              <a:gd name="T20" fmla="*/ 0 w 36"/>
              <a:gd name="T21" fmla="*/ 52 h 52"/>
              <a:gd name="T22" fmla="*/ 0 w 36"/>
              <a:gd name="T23" fmla="*/ 46 h 52"/>
              <a:gd name="T24" fmla="*/ 0 w 36"/>
              <a:gd name="T25" fmla="*/ 0 h 52"/>
              <a:gd name="T26" fmla="*/ 36 w 36"/>
              <a:gd name="T27" fmla="*/ 0 h 52"/>
              <a:gd name="T28" fmla="*/ 36 w 36"/>
              <a:gd name="T29" fmla="*/ 6 h 52"/>
              <a:gd name="T30" fmla="*/ 0 w 36"/>
              <a:gd name="T31" fmla="*/ 6 h 52"/>
              <a:gd name="T32" fmla="*/ 0 w 36"/>
              <a:gd name="T33" fmla="*/ 0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2">
                <a:moveTo>
                  <a:pt x="15" y="49"/>
                </a:moveTo>
                <a:lnTo>
                  <a:pt x="15" y="26"/>
                </a:lnTo>
                <a:lnTo>
                  <a:pt x="15" y="3"/>
                </a:lnTo>
                <a:lnTo>
                  <a:pt x="21" y="3"/>
                </a:lnTo>
                <a:lnTo>
                  <a:pt x="21" y="26"/>
                </a:lnTo>
                <a:lnTo>
                  <a:pt x="21" y="49"/>
                </a:lnTo>
                <a:lnTo>
                  <a:pt x="15" y="49"/>
                </a:lnTo>
                <a:close/>
                <a:moveTo>
                  <a:pt x="0" y="46"/>
                </a:moveTo>
                <a:lnTo>
                  <a:pt x="36" y="46"/>
                </a:lnTo>
                <a:lnTo>
                  <a:pt x="36" y="52"/>
                </a:lnTo>
                <a:lnTo>
                  <a:pt x="0" y="52"/>
                </a:lnTo>
                <a:lnTo>
                  <a:pt x="0" y="4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6" name="Freeform 200"/>
          <p:cNvSpPr>
            <a:spLocks noEditPoints="1"/>
          </p:cNvSpPr>
          <p:nvPr/>
        </p:nvSpPr>
        <p:spPr bwMode="auto">
          <a:xfrm>
            <a:off x="3264828" y="3398997"/>
            <a:ext cx="47498" cy="77299"/>
          </a:xfrm>
          <a:custGeom>
            <a:avLst/>
            <a:gdLst>
              <a:gd name="T0" fmla="*/ 15 w 36"/>
              <a:gd name="T1" fmla="*/ 62 h 65"/>
              <a:gd name="T2" fmla="*/ 15 w 36"/>
              <a:gd name="T3" fmla="*/ 33 h 65"/>
              <a:gd name="T4" fmla="*/ 15 w 36"/>
              <a:gd name="T5" fmla="*/ 3 h 65"/>
              <a:gd name="T6" fmla="*/ 20 w 36"/>
              <a:gd name="T7" fmla="*/ 3 h 65"/>
              <a:gd name="T8" fmla="*/ 20 w 36"/>
              <a:gd name="T9" fmla="*/ 33 h 65"/>
              <a:gd name="T10" fmla="*/ 20 w 36"/>
              <a:gd name="T11" fmla="*/ 62 h 65"/>
              <a:gd name="T12" fmla="*/ 15 w 36"/>
              <a:gd name="T13" fmla="*/ 62 h 65"/>
              <a:gd name="T14" fmla="*/ 0 w 36"/>
              <a:gd name="T15" fmla="*/ 59 h 65"/>
              <a:gd name="T16" fmla="*/ 36 w 36"/>
              <a:gd name="T17" fmla="*/ 59 h 65"/>
              <a:gd name="T18" fmla="*/ 36 w 36"/>
              <a:gd name="T19" fmla="*/ 65 h 65"/>
              <a:gd name="T20" fmla="*/ 0 w 36"/>
              <a:gd name="T21" fmla="*/ 65 h 65"/>
              <a:gd name="T22" fmla="*/ 0 w 36"/>
              <a:gd name="T23" fmla="*/ 59 h 65"/>
              <a:gd name="T24" fmla="*/ 0 w 36"/>
              <a:gd name="T25" fmla="*/ 0 h 65"/>
              <a:gd name="T26" fmla="*/ 36 w 36"/>
              <a:gd name="T27" fmla="*/ 0 h 65"/>
              <a:gd name="T28" fmla="*/ 36 w 36"/>
              <a:gd name="T29" fmla="*/ 6 h 65"/>
              <a:gd name="T30" fmla="*/ 0 w 36"/>
              <a:gd name="T31" fmla="*/ 6 h 65"/>
              <a:gd name="T32" fmla="*/ 0 w 36"/>
              <a:gd name="T33" fmla="*/ 0 h 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65">
                <a:moveTo>
                  <a:pt x="15" y="62"/>
                </a:moveTo>
                <a:lnTo>
                  <a:pt x="15" y="33"/>
                </a:lnTo>
                <a:lnTo>
                  <a:pt x="15" y="3"/>
                </a:lnTo>
                <a:lnTo>
                  <a:pt x="20" y="3"/>
                </a:lnTo>
                <a:lnTo>
                  <a:pt x="20" y="33"/>
                </a:lnTo>
                <a:lnTo>
                  <a:pt x="20" y="62"/>
                </a:lnTo>
                <a:lnTo>
                  <a:pt x="15" y="62"/>
                </a:lnTo>
                <a:close/>
                <a:moveTo>
                  <a:pt x="0" y="59"/>
                </a:moveTo>
                <a:lnTo>
                  <a:pt x="36" y="59"/>
                </a:lnTo>
                <a:lnTo>
                  <a:pt x="36" y="65"/>
                </a:lnTo>
                <a:lnTo>
                  <a:pt x="0" y="65"/>
                </a:lnTo>
                <a:lnTo>
                  <a:pt x="0" y="5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7" name="Freeform 201"/>
          <p:cNvSpPr>
            <a:spLocks noEditPoints="1"/>
          </p:cNvSpPr>
          <p:nvPr/>
        </p:nvSpPr>
        <p:spPr bwMode="auto">
          <a:xfrm>
            <a:off x="3485166" y="3447755"/>
            <a:ext cx="48818" cy="172436"/>
          </a:xfrm>
          <a:custGeom>
            <a:avLst/>
            <a:gdLst>
              <a:gd name="T0" fmla="*/ 16 w 37"/>
              <a:gd name="T1" fmla="*/ 142 h 145"/>
              <a:gd name="T2" fmla="*/ 16 w 37"/>
              <a:gd name="T3" fmla="*/ 72 h 145"/>
              <a:gd name="T4" fmla="*/ 16 w 37"/>
              <a:gd name="T5" fmla="*/ 3 h 145"/>
              <a:gd name="T6" fmla="*/ 21 w 37"/>
              <a:gd name="T7" fmla="*/ 3 h 145"/>
              <a:gd name="T8" fmla="*/ 21 w 37"/>
              <a:gd name="T9" fmla="*/ 72 h 145"/>
              <a:gd name="T10" fmla="*/ 21 w 37"/>
              <a:gd name="T11" fmla="*/ 142 h 145"/>
              <a:gd name="T12" fmla="*/ 16 w 37"/>
              <a:gd name="T13" fmla="*/ 142 h 145"/>
              <a:gd name="T14" fmla="*/ 0 w 37"/>
              <a:gd name="T15" fmla="*/ 139 h 145"/>
              <a:gd name="T16" fmla="*/ 37 w 37"/>
              <a:gd name="T17" fmla="*/ 139 h 145"/>
              <a:gd name="T18" fmla="*/ 37 w 37"/>
              <a:gd name="T19" fmla="*/ 145 h 145"/>
              <a:gd name="T20" fmla="*/ 0 w 37"/>
              <a:gd name="T21" fmla="*/ 145 h 145"/>
              <a:gd name="T22" fmla="*/ 0 w 37"/>
              <a:gd name="T23" fmla="*/ 139 h 145"/>
              <a:gd name="T24" fmla="*/ 0 w 37"/>
              <a:gd name="T25" fmla="*/ 0 h 145"/>
              <a:gd name="T26" fmla="*/ 37 w 37"/>
              <a:gd name="T27" fmla="*/ 0 h 145"/>
              <a:gd name="T28" fmla="*/ 37 w 37"/>
              <a:gd name="T29" fmla="*/ 6 h 145"/>
              <a:gd name="T30" fmla="*/ 0 w 37"/>
              <a:gd name="T31" fmla="*/ 6 h 145"/>
              <a:gd name="T32" fmla="*/ 0 w 37"/>
              <a:gd name="T33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45">
                <a:moveTo>
                  <a:pt x="16" y="142"/>
                </a:moveTo>
                <a:lnTo>
                  <a:pt x="16" y="72"/>
                </a:lnTo>
                <a:lnTo>
                  <a:pt x="16" y="3"/>
                </a:lnTo>
                <a:lnTo>
                  <a:pt x="21" y="3"/>
                </a:lnTo>
                <a:lnTo>
                  <a:pt x="21" y="72"/>
                </a:lnTo>
                <a:lnTo>
                  <a:pt x="21" y="142"/>
                </a:lnTo>
                <a:lnTo>
                  <a:pt x="16" y="142"/>
                </a:lnTo>
                <a:close/>
                <a:moveTo>
                  <a:pt x="0" y="139"/>
                </a:moveTo>
                <a:lnTo>
                  <a:pt x="37" y="139"/>
                </a:lnTo>
                <a:lnTo>
                  <a:pt x="37" y="145"/>
                </a:lnTo>
                <a:lnTo>
                  <a:pt x="0" y="145"/>
                </a:lnTo>
                <a:lnTo>
                  <a:pt x="0" y="139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8" name="Freeform 202"/>
          <p:cNvSpPr>
            <a:spLocks noEditPoints="1"/>
          </p:cNvSpPr>
          <p:nvPr/>
        </p:nvSpPr>
        <p:spPr bwMode="auto">
          <a:xfrm>
            <a:off x="3706823" y="3498890"/>
            <a:ext cx="48818" cy="93948"/>
          </a:xfrm>
          <a:custGeom>
            <a:avLst/>
            <a:gdLst>
              <a:gd name="T0" fmla="*/ 16 w 37"/>
              <a:gd name="T1" fmla="*/ 76 h 79"/>
              <a:gd name="T2" fmla="*/ 16 w 37"/>
              <a:gd name="T3" fmla="*/ 40 h 79"/>
              <a:gd name="T4" fmla="*/ 16 w 37"/>
              <a:gd name="T5" fmla="*/ 3 h 79"/>
              <a:gd name="T6" fmla="*/ 21 w 37"/>
              <a:gd name="T7" fmla="*/ 3 h 79"/>
              <a:gd name="T8" fmla="*/ 21 w 37"/>
              <a:gd name="T9" fmla="*/ 40 h 79"/>
              <a:gd name="T10" fmla="*/ 21 w 37"/>
              <a:gd name="T11" fmla="*/ 76 h 79"/>
              <a:gd name="T12" fmla="*/ 16 w 37"/>
              <a:gd name="T13" fmla="*/ 76 h 79"/>
              <a:gd name="T14" fmla="*/ 0 w 37"/>
              <a:gd name="T15" fmla="*/ 73 h 79"/>
              <a:gd name="T16" fmla="*/ 37 w 37"/>
              <a:gd name="T17" fmla="*/ 73 h 79"/>
              <a:gd name="T18" fmla="*/ 37 w 37"/>
              <a:gd name="T19" fmla="*/ 79 h 79"/>
              <a:gd name="T20" fmla="*/ 0 w 37"/>
              <a:gd name="T21" fmla="*/ 79 h 79"/>
              <a:gd name="T22" fmla="*/ 0 w 37"/>
              <a:gd name="T23" fmla="*/ 73 h 79"/>
              <a:gd name="T24" fmla="*/ 0 w 37"/>
              <a:gd name="T25" fmla="*/ 0 h 79"/>
              <a:gd name="T26" fmla="*/ 37 w 37"/>
              <a:gd name="T27" fmla="*/ 0 h 79"/>
              <a:gd name="T28" fmla="*/ 37 w 37"/>
              <a:gd name="T29" fmla="*/ 6 h 79"/>
              <a:gd name="T30" fmla="*/ 0 w 37"/>
              <a:gd name="T31" fmla="*/ 6 h 79"/>
              <a:gd name="T32" fmla="*/ 0 w 37"/>
              <a:gd name="T33" fmla="*/ 0 h 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79">
                <a:moveTo>
                  <a:pt x="16" y="76"/>
                </a:moveTo>
                <a:lnTo>
                  <a:pt x="16" y="40"/>
                </a:lnTo>
                <a:lnTo>
                  <a:pt x="16" y="3"/>
                </a:lnTo>
                <a:lnTo>
                  <a:pt x="21" y="3"/>
                </a:lnTo>
                <a:lnTo>
                  <a:pt x="21" y="40"/>
                </a:lnTo>
                <a:lnTo>
                  <a:pt x="21" y="76"/>
                </a:lnTo>
                <a:lnTo>
                  <a:pt x="16" y="76"/>
                </a:lnTo>
                <a:close/>
                <a:moveTo>
                  <a:pt x="0" y="73"/>
                </a:moveTo>
                <a:lnTo>
                  <a:pt x="37" y="73"/>
                </a:lnTo>
                <a:lnTo>
                  <a:pt x="37" y="79"/>
                </a:lnTo>
                <a:lnTo>
                  <a:pt x="0" y="79"/>
                </a:lnTo>
                <a:lnTo>
                  <a:pt x="0" y="7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9" name="Freeform 203"/>
          <p:cNvSpPr>
            <a:spLocks noEditPoints="1"/>
          </p:cNvSpPr>
          <p:nvPr/>
        </p:nvSpPr>
        <p:spPr bwMode="auto">
          <a:xfrm>
            <a:off x="3928480" y="3489377"/>
            <a:ext cx="47498" cy="118921"/>
          </a:xfrm>
          <a:custGeom>
            <a:avLst/>
            <a:gdLst>
              <a:gd name="T0" fmla="*/ 16 w 36"/>
              <a:gd name="T1" fmla="*/ 97 h 100"/>
              <a:gd name="T2" fmla="*/ 16 w 36"/>
              <a:gd name="T3" fmla="*/ 50 h 100"/>
              <a:gd name="T4" fmla="*/ 16 w 36"/>
              <a:gd name="T5" fmla="*/ 3 h 100"/>
              <a:gd name="T6" fmla="*/ 21 w 36"/>
              <a:gd name="T7" fmla="*/ 3 h 100"/>
              <a:gd name="T8" fmla="*/ 21 w 36"/>
              <a:gd name="T9" fmla="*/ 50 h 100"/>
              <a:gd name="T10" fmla="*/ 21 w 36"/>
              <a:gd name="T11" fmla="*/ 97 h 100"/>
              <a:gd name="T12" fmla="*/ 16 w 36"/>
              <a:gd name="T13" fmla="*/ 97 h 100"/>
              <a:gd name="T14" fmla="*/ 0 w 36"/>
              <a:gd name="T15" fmla="*/ 94 h 100"/>
              <a:gd name="T16" fmla="*/ 36 w 36"/>
              <a:gd name="T17" fmla="*/ 94 h 100"/>
              <a:gd name="T18" fmla="*/ 36 w 36"/>
              <a:gd name="T19" fmla="*/ 100 h 100"/>
              <a:gd name="T20" fmla="*/ 0 w 36"/>
              <a:gd name="T21" fmla="*/ 100 h 100"/>
              <a:gd name="T22" fmla="*/ 0 w 36"/>
              <a:gd name="T23" fmla="*/ 94 h 100"/>
              <a:gd name="T24" fmla="*/ 0 w 36"/>
              <a:gd name="T25" fmla="*/ 0 h 100"/>
              <a:gd name="T26" fmla="*/ 36 w 36"/>
              <a:gd name="T27" fmla="*/ 0 h 100"/>
              <a:gd name="T28" fmla="*/ 36 w 36"/>
              <a:gd name="T29" fmla="*/ 6 h 100"/>
              <a:gd name="T30" fmla="*/ 0 w 36"/>
              <a:gd name="T31" fmla="*/ 6 h 100"/>
              <a:gd name="T32" fmla="*/ 0 w 36"/>
              <a:gd name="T33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00">
                <a:moveTo>
                  <a:pt x="16" y="97"/>
                </a:moveTo>
                <a:lnTo>
                  <a:pt x="16" y="50"/>
                </a:lnTo>
                <a:lnTo>
                  <a:pt x="16" y="3"/>
                </a:lnTo>
                <a:lnTo>
                  <a:pt x="21" y="3"/>
                </a:lnTo>
                <a:lnTo>
                  <a:pt x="21" y="50"/>
                </a:lnTo>
                <a:lnTo>
                  <a:pt x="21" y="97"/>
                </a:lnTo>
                <a:lnTo>
                  <a:pt x="16" y="97"/>
                </a:lnTo>
                <a:close/>
                <a:moveTo>
                  <a:pt x="0" y="94"/>
                </a:moveTo>
                <a:lnTo>
                  <a:pt x="36" y="94"/>
                </a:lnTo>
                <a:lnTo>
                  <a:pt x="36" y="100"/>
                </a:lnTo>
                <a:lnTo>
                  <a:pt x="0" y="100"/>
                </a:lnTo>
                <a:lnTo>
                  <a:pt x="0" y="9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0" name="Freeform 204"/>
          <p:cNvSpPr>
            <a:spLocks noEditPoints="1"/>
          </p:cNvSpPr>
          <p:nvPr/>
        </p:nvSpPr>
        <p:spPr bwMode="auto">
          <a:xfrm>
            <a:off x="4150137" y="3504837"/>
            <a:ext cx="47498" cy="115354"/>
          </a:xfrm>
          <a:custGeom>
            <a:avLst/>
            <a:gdLst>
              <a:gd name="T0" fmla="*/ 15 w 36"/>
              <a:gd name="T1" fmla="*/ 94 h 97"/>
              <a:gd name="T2" fmla="*/ 15 w 36"/>
              <a:gd name="T3" fmla="*/ 49 h 97"/>
              <a:gd name="T4" fmla="*/ 15 w 36"/>
              <a:gd name="T5" fmla="*/ 3 h 97"/>
              <a:gd name="T6" fmla="*/ 20 w 36"/>
              <a:gd name="T7" fmla="*/ 3 h 97"/>
              <a:gd name="T8" fmla="*/ 20 w 36"/>
              <a:gd name="T9" fmla="*/ 49 h 97"/>
              <a:gd name="T10" fmla="*/ 20 w 36"/>
              <a:gd name="T11" fmla="*/ 94 h 97"/>
              <a:gd name="T12" fmla="*/ 15 w 36"/>
              <a:gd name="T13" fmla="*/ 94 h 97"/>
              <a:gd name="T14" fmla="*/ 0 w 36"/>
              <a:gd name="T15" fmla="*/ 91 h 97"/>
              <a:gd name="T16" fmla="*/ 36 w 36"/>
              <a:gd name="T17" fmla="*/ 91 h 97"/>
              <a:gd name="T18" fmla="*/ 36 w 36"/>
              <a:gd name="T19" fmla="*/ 97 h 97"/>
              <a:gd name="T20" fmla="*/ 0 w 36"/>
              <a:gd name="T21" fmla="*/ 97 h 97"/>
              <a:gd name="T22" fmla="*/ 0 w 36"/>
              <a:gd name="T23" fmla="*/ 91 h 97"/>
              <a:gd name="T24" fmla="*/ 0 w 36"/>
              <a:gd name="T25" fmla="*/ 0 h 97"/>
              <a:gd name="T26" fmla="*/ 36 w 36"/>
              <a:gd name="T27" fmla="*/ 0 h 97"/>
              <a:gd name="T28" fmla="*/ 36 w 36"/>
              <a:gd name="T29" fmla="*/ 6 h 97"/>
              <a:gd name="T30" fmla="*/ 0 w 36"/>
              <a:gd name="T31" fmla="*/ 6 h 97"/>
              <a:gd name="T32" fmla="*/ 0 w 36"/>
              <a:gd name="T33" fmla="*/ 0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97">
                <a:moveTo>
                  <a:pt x="15" y="94"/>
                </a:moveTo>
                <a:lnTo>
                  <a:pt x="15" y="49"/>
                </a:lnTo>
                <a:lnTo>
                  <a:pt x="15" y="3"/>
                </a:lnTo>
                <a:lnTo>
                  <a:pt x="20" y="3"/>
                </a:lnTo>
                <a:lnTo>
                  <a:pt x="20" y="49"/>
                </a:lnTo>
                <a:lnTo>
                  <a:pt x="20" y="94"/>
                </a:lnTo>
                <a:lnTo>
                  <a:pt x="15" y="94"/>
                </a:lnTo>
                <a:close/>
                <a:moveTo>
                  <a:pt x="0" y="91"/>
                </a:moveTo>
                <a:lnTo>
                  <a:pt x="36" y="91"/>
                </a:lnTo>
                <a:lnTo>
                  <a:pt x="36" y="97"/>
                </a:lnTo>
                <a:lnTo>
                  <a:pt x="0" y="97"/>
                </a:lnTo>
                <a:lnTo>
                  <a:pt x="0" y="9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1" name="Freeform 205"/>
          <p:cNvSpPr>
            <a:spLocks noEditPoints="1"/>
          </p:cNvSpPr>
          <p:nvPr/>
        </p:nvSpPr>
        <p:spPr bwMode="auto">
          <a:xfrm>
            <a:off x="4370474" y="3510782"/>
            <a:ext cx="48818" cy="145083"/>
          </a:xfrm>
          <a:custGeom>
            <a:avLst/>
            <a:gdLst>
              <a:gd name="T0" fmla="*/ 16 w 37"/>
              <a:gd name="T1" fmla="*/ 119 h 122"/>
              <a:gd name="T2" fmla="*/ 16 w 37"/>
              <a:gd name="T3" fmla="*/ 61 h 122"/>
              <a:gd name="T4" fmla="*/ 16 w 37"/>
              <a:gd name="T5" fmla="*/ 3 h 122"/>
              <a:gd name="T6" fmla="*/ 21 w 37"/>
              <a:gd name="T7" fmla="*/ 3 h 122"/>
              <a:gd name="T8" fmla="*/ 21 w 37"/>
              <a:gd name="T9" fmla="*/ 61 h 122"/>
              <a:gd name="T10" fmla="*/ 21 w 37"/>
              <a:gd name="T11" fmla="*/ 119 h 122"/>
              <a:gd name="T12" fmla="*/ 16 w 37"/>
              <a:gd name="T13" fmla="*/ 119 h 122"/>
              <a:gd name="T14" fmla="*/ 0 w 37"/>
              <a:gd name="T15" fmla="*/ 116 h 122"/>
              <a:gd name="T16" fmla="*/ 37 w 37"/>
              <a:gd name="T17" fmla="*/ 116 h 122"/>
              <a:gd name="T18" fmla="*/ 37 w 37"/>
              <a:gd name="T19" fmla="*/ 122 h 122"/>
              <a:gd name="T20" fmla="*/ 0 w 37"/>
              <a:gd name="T21" fmla="*/ 122 h 122"/>
              <a:gd name="T22" fmla="*/ 0 w 37"/>
              <a:gd name="T23" fmla="*/ 116 h 122"/>
              <a:gd name="T24" fmla="*/ 0 w 37"/>
              <a:gd name="T25" fmla="*/ 0 h 122"/>
              <a:gd name="T26" fmla="*/ 37 w 37"/>
              <a:gd name="T27" fmla="*/ 0 h 122"/>
              <a:gd name="T28" fmla="*/ 37 w 37"/>
              <a:gd name="T29" fmla="*/ 6 h 122"/>
              <a:gd name="T30" fmla="*/ 0 w 37"/>
              <a:gd name="T31" fmla="*/ 6 h 122"/>
              <a:gd name="T32" fmla="*/ 0 w 37"/>
              <a:gd name="T33" fmla="*/ 0 h 1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22">
                <a:moveTo>
                  <a:pt x="16" y="119"/>
                </a:moveTo>
                <a:lnTo>
                  <a:pt x="16" y="61"/>
                </a:lnTo>
                <a:lnTo>
                  <a:pt x="16" y="3"/>
                </a:lnTo>
                <a:lnTo>
                  <a:pt x="21" y="3"/>
                </a:lnTo>
                <a:lnTo>
                  <a:pt x="21" y="61"/>
                </a:lnTo>
                <a:lnTo>
                  <a:pt x="21" y="119"/>
                </a:lnTo>
                <a:lnTo>
                  <a:pt x="16" y="119"/>
                </a:lnTo>
                <a:close/>
                <a:moveTo>
                  <a:pt x="0" y="116"/>
                </a:moveTo>
                <a:lnTo>
                  <a:pt x="37" y="116"/>
                </a:lnTo>
                <a:lnTo>
                  <a:pt x="37" y="122"/>
                </a:lnTo>
                <a:lnTo>
                  <a:pt x="0" y="122"/>
                </a:lnTo>
                <a:lnTo>
                  <a:pt x="0" y="116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2" name="Freeform 206"/>
          <p:cNvSpPr>
            <a:spLocks noEditPoints="1"/>
          </p:cNvSpPr>
          <p:nvPr/>
        </p:nvSpPr>
        <p:spPr bwMode="auto">
          <a:xfrm>
            <a:off x="4592131" y="3536945"/>
            <a:ext cx="47498" cy="164111"/>
          </a:xfrm>
          <a:custGeom>
            <a:avLst/>
            <a:gdLst>
              <a:gd name="T0" fmla="*/ 16 w 36"/>
              <a:gd name="T1" fmla="*/ 135 h 138"/>
              <a:gd name="T2" fmla="*/ 16 w 36"/>
              <a:gd name="T3" fmla="*/ 69 h 138"/>
              <a:gd name="T4" fmla="*/ 16 w 36"/>
              <a:gd name="T5" fmla="*/ 3 h 138"/>
              <a:gd name="T6" fmla="*/ 21 w 36"/>
              <a:gd name="T7" fmla="*/ 3 h 138"/>
              <a:gd name="T8" fmla="*/ 21 w 36"/>
              <a:gd name="T9" fmla="*/ 69 h 138"/>
              <a:gd name="T10" fmla="*/ 21 w 36"/>
              <a:gd name="T11" fmla="*/ 135 h 138"/>
              <a:gd name="T12" fmla="*/ 16 w 36"/>
              <a:gd name="T13" fmla="*/ 135 h 138"/>
              <a:gd name="T14" fmla="*/ 0 w 36"/>
              <a:gd name="T15" fmla="*/ 133 h 138"/>
              <a:gd name="T16" fmla="*/ 36 w 36"/>
              <a:gd name="T17" fmla="*/ 133 h 138"/>
              <a:gd name="T18" fmla="*/ 36 w 36"/>
              <a:gd name="T19" fmla="*/ 138 h 138"/>
              <a:gd name="T20" fmla="*/ 0 w 36"/>
              <a:gd name="T21" fmla="*/ 138 h 138"/>
              <a:gd name="T22" fmla="*/ 0 w 36"/>
              <a:gd name="T23" fmla="*/ 133 h 138"/>
              <a:gd name="T24" fmla="*/ 0 w 36"/>
              <a:gd name="T25" fmla="*/ 0 h 138"/>
              <a:gd name="T26" fmla="*/ 36 w 36"/>
              <a:gd name="T27" fmla="*/ 0 h 138"/>
              <a:gd name="T28" fmla="*/ 36 w 36"/>
              <a:gd name="T29" fmla="*/ 6 h 138"/>
              <a:gd name="T30" fmla="*/ 0 w 36"/>
              <a:gd name="T31" fmla="*/ 6 h 138"/>
              <a:gd name="T32" fmla="*/ 0 w 36"/>
              <a:gd name="T33" fmla="*/ 0 h 1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38">
                <a:moveTo>
                  <a:pt x="16" y="135"/>
                </a:moveTo>
                <a:lnTo>
                  <a:pt x="16" y="69"/>
                </a:lnTo>
                <a:lnTo>
                  <a:pt x="16" y="3"/>
                </a:lnTo>
                <a:lnTo>
                  <a:pt x="21" y="3"/>
                </a:lnTo>
                <a:lnTo>
                  <a:pt x="21" y="69"/>
                </a:lnTo>
                <a:lnTo>
                  <a:pt x="21" y="135"/>
                </a:lnTo>
                <a:lnTo>
                  <a:pt x="16" y="135"/>
                </a:lnTo>
                <a:close/>
                <a:moveTo>
                  <a:pt x="0" y="133"/>
                </a:moveTo>
                <a:lnTo>
                  <a:pt x="36" y="133"/>
                </a:lnTo>
                <a:lnTo>
                  <a:pt x="36" y="138"/>
                </a:lnTo>
                <a:lnTo>
                  <a:pt x="0" y="138"/>
                </a:lnTo>
                <a:lnTo>
                  <a:pt x="0" y="133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3" name="Freeform 207"/>
          <p:cNvSpPr>
            <a:spLocks noEditPoints="1"/>
          </p:cNvSpPr>
          <p:nvPr/>
        </p:nvSpPr>
        <p:spPr bwMode="auto">
          <a:xfrm>
            <a:off x="4813788" y="3583324"/>
            <a:ext cx="47498" cy="137948"/>
          </a:xfrm>
          <a:custGeom>
            <a:avLst/>
            <a:gdLst>
              <a:gd name="T0" fmla="*/ 15 w 36"/>
              <a:gd name="T1" fmla="*/ 113 h 116"/>
              <a:gd name="T2" fmla="*/ 15 w 36"/>
              <a:gd name="T3" fmla="*/ 57 h 116"/>
              <a:gd name="T4" fmla="*/ 15 w 36"/>
              <a:gd name="T5" fmla="*/ 2 h 116"/>
              <a:gd name="T6" fmla="*/ 20 w 36"/>
              <a:gd name="T7" fmla="*/ 2 h 116"/>
              <a:gd name="T8" fmla="*/ 20 w 36"/>
              <a:gd name="T9" fmla="*/ 57 h 116"/>
              <a:gd name="T10" fmla="*/ 20 w 36"/>
              <a:gd name="T11" fmla="*/ 113 h 116"/>
              <a:gd name="T12" fmla="*/ 15 w 36"/>
              <a:gd name="T13" fmla="*/ 113 h 116"/>
              <a:gd name="T14" fmla="*/ 0 w 36"/>
              <a:gd name="T15" fmla="*/ 110 h 116"/>
              <a:gd name="T16" fmla="*/ 36 w 36"/>
              <a:gd name="T17" fmla="*/ 110 h 116"/>
              <a:gd name="T18" fmla="*/ 36 w 36"/>
              <a:gd name="T19" fmla="*/ 116 h 116"/>
              <a:gd name="T20" fmla="*/ 0 w 36"/>
              <a:gd name="T21" fmla="*/ 116 h 116"/>
              <a:gd name="T22" fmla="*/ 0 w 36"/>
              <a:gd name="T23" fmla="*/ 110 h 116"/>
              <a:gd name="T24" fmla="*/ 0 w 36"/>
              <a:gd name="T25" fmla="*/ 0 h 116"/>
              <a:gd name="T26" fmla="*/ 36 w 36"/>
              <a:gd name="T27" fmla="*/ 0 h 116"/>
              <a:gd name="T28" fmla="*/ 36 w 36"/>
              <a:gd name="T29" fmla="*/ 5 h 116"/>
              <a:gd name="T30" fmla="*/ 0 w 36"/>
              <a:gd name="T31" fmla="*/ 5 h 116"/>
              <a:gd name="T32" fmla="*/ 0 w 36"/>
              <a:gd name="T33" fmla="*/ 0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16">
                <a:moveTo>
                  <a:pt x="15" y="113"/>
                </a:moveTo>
                <a:lnTo>
                  <a:pt x="15" y="57"/>
                </a:lnTo>
                <a:lnTo>
                  <a:pt x="15" y="2"/>
                </a:lnTo>
                <a:lnTo>
                  <a:pt x="20" y="2"/>
                </a:lnTo>
                <a:lnTo>
                  <a:pt x="20" y="57"/>
                </a:lnTo>
                <a:lnTo>
                  <a:pt x="20" y="113"/>
                </a:lnTo>
                <a:lnTo>
                  <a:pt x="15" y="113"/>
                </a:lnTo>
                <a:close/>
                <a:moveTo>
                  <a:pt x="0" y="110"/>
                </a:moveTo>
                <a:lnTo>
                  <a:pt x="36" y="110"/>
                </a:lnTo>
                <a:lnTo>
                  <a:pt x="36" y="116"/>
                </a:lnTo>
                <a:lnTo>
                  <a:pt x="0" y="116"/>
                </a:lnTo>
                <a:lnTo>
                  <a:pt x="0" y="11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4" name="Freeform 208"/>
          <p:cNvSpPr>
            <a:spLocks noEditPoints="1"/>
          </p:cNvSpPr>
          <p:nvPr/>
        </p:nvSpPr>
        <p:spPr bwMode="auto">
          <a:xfrm>
            <a:off x="5034126" y="3660623"/>
            <a:ext cx="48818" cy="58272"/>
          </a:xfrm>
          <a:custGeom>
            <a:avLst/>
            <a:gdLst>
              <a:gd name="T0" fmla="*/ 16 w 37"/>
              <a:gd name="T1" fmla="*/ 46 h 49"/>
              <a:gd name="T2" fmla="*/ 16 w 37"/>
              <a:gd name="T3" fmla="*/ 24 h 49"/>
              <a:gd name="T4" fmla="*/ 16 w 37"/>
              <a:gd name="T5" fmla="*/ 3 h 49"/>
              <a:gd name="T6" fmla="*/ 21 w 37"/>
              <a:gd name="T7" fmla="*/ 3 h 49"/>
              <a:gd name="T8" fmla="*/ 21 w 37"/>
              <a:gd name="T9" fmla="*/ 24 h 49"/>
              <a:gd name="T10" fmla="*/ 21 w 37"/>
              <a:gd name="T11" fmla="*/ 46 h 49"/>
              <a:gd name="T12" fmla="*/ 16 w 37"/>
              <a:gd name="T13" fmla="*/ 46 h 49"/>
              <a:gd name="T14" fmla="*/ 0 w 37"/>
              <a:gd name="T15" fmla="*/ 43 h 49"/>
              <a:gd name="T16" fmla="*/ 37 w 37"/>
              <a:gd name="T17" fmla="*/ 43 h 49"/>
              <a:gd name="T18" fmla="*/ 37 w 37"/>
              <a:gd name="T19" fmla="*/ 49 h 49"/>
              <a:gd name="T20" fmla="*/ 0 w 37"/>
              <a:gd name="T21" fmla="*/ 49 h 49"/>
              <a:gd name="T22" fmla="*/ 0 w 37"/>
              <a:gd name="T23" fmla="*/ 43 h 49"/>
              <a:gd name="T24" fmla="*/ 0 w 37"/>
              <a:gd name="T25" fmla="*/ 0 h 49"/>
              <a:gd name="T26" fmla="*/ 37 w 37"/>
              <a:gd name="T27" fmla="*/ 0 h 49"/>
              <a:gd name="T28" fmla="*/ 37 w 37"/>
              <a:gd name="T29" fmla="*/ 6 h 49"/>
              <a:gd name="T30" fmla="*/ 0 w 37"/>
              <a:gd name="T31" fmla="*/ 6 h 49"/>
              <a:gd name="T32" fmla="*/ 0 w 37"/>
              <a:gd name="T33" fmla="*/ 0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49">
                <a:moveTo>
                  <a:pt x="16" y="46"/>
                </a:moveTo>
                <a:lnTo>
                  <a:pt x="16" y="24"/>
                </a:lnTo>
                <a:lnTo>
                  <a:pt x="16" y="3"/>
                </a:lnTo>
                <a:lnTo>
                  <a:pt x="21" y="3"/>
                </a:lnTo>
                <a:lnTo>
                  <a:pt x="21" y="24"/>
                </a:lnTo>
                <a:lnTo>
                  <a:pt x="21" y="46"/>
                </a:lnTo>
                <a:lnTo>
                  <a:pt x="16" y="46"/>
                </a:lnTo>
                <a:close/>
                <a:moveTo>
                  <a:pt x="0" y="43"/>
                </a:moveTo>
                <a:lnTo>
                  <a:pt x="37" y="43"/>
                </a:lnTo>
                <a:lnTo>
                  <a:pt x="37" y="49"/>
                </a:lnTo>
                <a:lnTo>
                  <a:pt x="0" y="49"/>
                </a:lnTo>
                <a:lnTo>
                  <a:pt x="0" y="4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5" name="Freeform 209"/>
          <p:cNvSpPr>
            <a:spLocks noEditPoints="1"/>
          </p:cNvSpPr>
          <p:nvPr/>
        </p:nvSpPr>
        <p:spPr bwMode="auto">
          <a:xfrm>
            <a:off x="5255783" y="3640406"/>
            <a:ext cx="48818" cy="124867"/>
          </a:xfrm>
          <a:custGeom>
            <a:avLst/>
            <a:gdLst>
              <a:gd name="T0" fmla="*/ 16 w 37"/>
              <a:gd name="T1" fmla="*/ 102 h 105"/>
              <a:gd name="T2" fmla="*/ 16 w 37"/>
              <a:gd name="T3" fmla="*/ 53 h 105"/>
              <a:gd name="T4" fmla="*/ 16 w 37"/>
              <a:gd name="T5" fmla="*/ 3 h 105"/>
              <a:gd name="T6" fmla="*/ 21 w 37"/>
              <a:gd name="T7" fmla="*/ 3 h 105"/>
              <a:gd name="T8" fmla="*/ 21 w 37"/>
              <a:gd name="T9" fmla="*/ 53 h 105"/>
              <a:gd name="T10" fmla="*/ 21 w 37"/>
              <a:gd name="T11" fmla="*/ 102 h 105"/>
              <a:gd name="T12" fmla="*/ 16 w 37"/>
              <a:gd name="T13" fmla="*/ 102 h 105"/>
              <a:gd name="T14" fmla="*/ 0 w 37"/>
              <a:gd name="T15" fmla="*/ 99 h 105"/>
              <a:gd name="T16" fmla="*/ 37 w 37"/>
              <a:gd name="T17" fmla="*/ 99 h 105"/>
              <a:gd name="T18" fmla="*/ 37 w 37"/>
              <a:gd name="T19" fmla="*/ 105 h 105"/>
              <a:gd name="T20" fmla="*/ 0 w 37"/>
              <a:gd name="T21" fmla="*/ 105 h 105"/>
              <a:gd name="T22" fmla="*/ 0 w 37"/>
              <a:gd name="T23" fmla="*/ 99 h 105"/>
              <a:gd name="T24" fmla="*/ 0 w 37"/>
              <a:gd name="T25" fmla="*/ 0 h 105"/>
              <a:gd name="T26" fmla="*/ 37 w 37"/>
              <a:gd name="T27" fmla="*/ 0 h 105"/>
              <a:gd name="T28" fmla="*/ 37 w 37"/>
              <a:gd name="T29" fmla="*/ 6 h 105"/>
              <a:gd name="T30" fmla="*/ 0 w 37"/>
              <a:gd name="T31" fmla="*/ 6 h 105"/>
              <a:gd name="T32" fmla="*/ 0 w 37"/>
              <a:gd name="T33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05">
                <a:moveTo>
                  <a:pt x="16" y="102"/>
                </a:moveTo>
                <a:lnTo>
                  <a:pt x="16" y="53"/>
                </a:lnTo>
                <a:lnTo>
                  <a:pt x="16" y="3"/>
                </a:lnTo>
                <a:lnTo>
                  <a:pt x="21" y="3"/>
                </a:lnTo>
                <a:lnTo>
                  <a:pt x="21" y="53"/>
                </a:lnTo>
                <a:lnTo>
                  <a:pt x="21" y="102"/>
                </a:lnTo>
                <a:lnTo>
                  <a:pt x="16" y="102"/>
                </a:lnTo>
                <a:close/>
                <a:moveTo>
                  <a:pt x="0" y="99"/>
                </a:moveTo>
                <a:lnTo>
                  <a:pt x="37" y="99"/>
                </a:lnTo>
                <a:lnTo>
                  <a:pt x="37" y="105"/>
                </a:lnTo>
                <a:lnTo>
                  <a:pt x="0" y="105"/>
                </a:lnTo>
                <a:lnTo>
                  <a:pt x="0" y="99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6" name="Freeform 210"/>
          <p:cNvSpPr>
            <a:spLocks noEditPoints="1"/>
          </p:cNvSpPr>
          <p:nvPr/>
        </p:nvSpPr>
        <p:spPr bwMode="auto">
          <a:xfrm>
            <a:off x="5477440" y="3749814"/>
            <a:ext cx="47498" cy="32109"/>
          </a:xfrm>
          <a:custGeom>
            <a:avLst/>
            <a:gdLst>
              <a:gd name="T0" fmla="*/ 16 w 36"/>
              <a:gd name="T1" fmla="*/ 25 h 27"/>
              <a:gd name="T2" fmla="*/ 16 w 36"/>
              <a:gd name="T3" fmla="*/ 14 h 27"/>
              <a:gd name="T4" fmla="*/ 16 w 36"/>
              <a:gd name="T5" fmla="*/ 3 h 27"/>
              <a:gd name="T6" fmla="*/ 21 w 36"/>
              <a:gd name="T7" fmla="*/ 3 h 27"/>
              <a:gd name="T8" fmla="*/ 21 w 36"/>
              <a:gd name="T9" fmla="*/ 14 h 27"/>
              <a:gd name="T10" fmla="*/ 21 w 36"/>
              <a:gd name="T11" fmla="*/ 25 h 27"/>
              <a:gd name="T12" fmla="*/ 16 w 36"/>
              <a:gd name="T13" fmla="*/ 25 h 27"/>
              <a:gd name="T14" fmla="*/ 0 w 36"/>
              <a:gd name="T15" fmla="*/ 22 h 27"/>
              <a:gd name="T16" fmla="*/ 36 w 36"/>
              <a:gd name="T17" fmla="*/ 22 h 27"/>
              <a:gd name="T18" fmla="*/ 36 w 36"/>
              <a:gd name="T19" fmla="*/ 27 h 27"/>
              <a:gd name="T20" fmla="*/ 0 w 36"/>
              <a:gd name="T21" fmla="*/ 27 h 27"/>
              <a:gd name="T22" fmla="*/ 0 w 36"/>
              <a:gd name="T23" fmla="*/ 22 h 27"/>
              <a:gd name="T24" fmla="*/ 0 w 36"/>
              <a:gd name="T25" fmla="*/ 0 h 27"/>
              <a:gd name="T26" fmla="*/ 36 w 36"/>
              <a:gd name="T27" fmla="*/ 0 h 27"/>
              <a:gd name="T28" fmla="*/ 36 w 36"/>
              <a:gd name="T29" fmla="*/ 5 h 27"/>
              <a:gd name="T30" fmla="*/ 0 w 36"/>
              <a:gd name="T31" fmla="*/ 5 h 27"/>
              <a:gd name="T32" fmla="*/ 0 w 36"/>
              <a:gd name="T33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7">
                <a:moveTo>
                  <a:pt x="16" y="25"/>
                </a:moveTo>
                <a:lnTo>
                  <a:pt x="16" y="14"/>
                </a:lnTo>
                <a:lnTo>
                  <a:pt x="16" y="3"/>
                </a:lnTo>
                <a:lnTo>
                  <a:pt x="21" y="3"/>
                </a:lnTo>
                <a:lnTo>
                  <a:pt x="21" y="14"/>
                </a:lnTo>
                <a:lnTo>
                  <a:pt x="21" y="25"/>
                </a:lnTo>
                <a:lnTo>
                  <a:pt x="16" y="25"/>
                </a:lnTo>
                <a:close/>
                <a:moveTo>
                  <a:pt x="0" y="22"/>
                </a:moveTo>
                <a:lnTo>
                  <a:pt x="36" y="22"/>
                </a:lnTo>
                <a:lnTo>
                  <a:pt x="36" y="27"/>
                </a:lnTo>
                <a:lnTo>
                  <a:pt x="0" y="27"/>
                </a:lnTo>
                <a:lnTo>
                  <a:pt x="0" y="2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7" name="Freeform 211"/>
          <p:cNvSpPr>
            <a:spLocks noEditPoints="1"/>
          </p:cNvSpPr>
          <p:nvPr/>
        </p:nvSpPr>
        <p:spPr bwMode="auto">
          <a:xfrm>
            <a:off x="5699097" y="3904411"/>
            <a:ext cx="47498" cy="65407"/>
          </a:xfrm>
          <a:custGeom>
            <a:avLst/>
            <a:gdLst>
              <a:gd name="T0" fmla="*/ 15 w 36"/>
              <a:gd name="T1" fmla="*/ 52 h 55"/>
              <a:gd name="T2" fmla="*/ 15 w 36"/>
              <a:gd name="T3" fmla="*/ 27 h 55"/>
              <a:gd name="T4" fmla="*/ 15 w 36"/>
              <a:gd name="T5" fmla="*/ 3 h 55"/>
              <a:gd name="T6" fmla="*/ 20 w 36"/>
              <a:gd name="T7" fmla="*/ 3 h 55"/>
              <a:gd name="T8" fmla="*/ 20 w 36"/>
              <a:gd name="T9" fmla="*/ 27 h 55"/>
              <a:gd name="T10" fmla="*/ 20 w 36"/>
              <a:gd name="T11" fmla="*/ 52 h 55"/>
              <a:gd name="T12" fmla="*/ 15 w 36"/>
              <a:gd name="T13" fmla="*/ 52 h 55"/>
              <a:gd name="T14" fmla="*/ 0 w 36"/>
              <a:gd name="T15" fmla="*/ 49 h 55"/>
              <a:gd name="T16" fmla="*/ 36 w 36"/>
              <a:gd name="T17" fmla="*/ 49 h 55"/>
              <a:gd name="T18" fmla="*/ 36 w 36"/>
              <a:gd name="T19" fmla="*/ 55 h 55"/>
              <a:gd name="T20" fmla="*/ 0 w 36"/>
              <a:gd name="T21" fmla="*/ 55 h 55"/>
              <a:gd name="T22" fmla="*/ 0 w 36"/>
              <a:gd name="T23" fmla="*/ 49 h 55"/>
              <a:gd name="T24" fmla="*/ 0 w 36"/>
              <a:gd name="T25" fmla="*/ 0 h 55"/>
              <a:gd name="T26" fmla="*/ 36 w 36"/>
              <a:gd name="T27" fmla="*/ 0 h 55"/>
              <a:gd name="T28" fmla="*/ 36 w 36"/>
              <a:gd name="T29" fmla="*/ 6 h 55"/>
              <a:gd name="T30" fmla="*/ 0 w 36"/>
              <a:gd name="T31" fmla="*/ 6 h 55"/>
              <a:gd name="T32" fmla="*/ 0 w 36"/>
              <a:gd name="T33" fmla="*/ 0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5">
                <a:moveTo>
                  <a:pt x="15" y="52"/>
                </a:moveTo>
                <a:lnTo>
                  <a:pt x="15" y="27"/>
                </a:lnTo>
                <a:lnTo>
                  <a:pt x="15" y="3"/>
                </a:lnTo>
                <a:lnTo>
                  <a:pt x="20" y="3"/>
                </a:lnTo>
                <a:lnTo>
                  <a:pt x="20" y="27"/>
                </a:lnTo>
                <a:lnTo>
                  <a:pt x="20" y="52"/>
                </a:lnTo>
                <a:lnTo>
                  <a:pt x="15" y="52"/>
                </a:lnTo>
                <a:close/>
                <a:moveTo>
                  <a:pt x="0" y="49"/>
                </a:moveTo>
                <a:lnTo>
                  <a:pt x="36" y="49"/>
                </a:lnTo>
                <a:lnTo>
                  <a:pt x="36" y="55"/>
                </a:lnTo>
                <a:lnTo>
                  <a:pt x="0" y="55"/>
                </a:lnTo>
                <a:lnTo>
                  <a:pt x="0" y="4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8" name="Freeform 212"/>
          <p:cNvSpPr>
            <a:spLocks noEditPoints="1"/>
          </p:cNvSpPr>
          <p:nvPr/>
        </p:nvSpPr>
        <p:spPr bwMode="auto">
          <a:xfrm>
            <a:off x="5919434" y="3603541"/>
            <a:ext cx="48818" cy="80866"/>
          </a:xfrm>
          <a:custGeom>
            <a:avLst/>
            <a:gdLst>
              <a:gd name="T0" fmla="*/ 16 w 37"/>
              <a:gd name="T1" fmla="*/ 65 h 68"/>
              <a:gd name="T2" fmla="*/ 16 w 37"/>
              <a:gd name="T3" fmla="*/ 34 h 68"/>
              <a:gd name="T4" fmla="*/ 16 w 37"/>
              <a:gd name="T5" fmla="*/ 3 h 68"/>
              <a:gd name="T6" fmla="*/ 21 w 37"/>
              <a:gd name="T7" fmla="*/ 3 h 68"/>
              <a:gd name="T8" fmla="*/ 21 w 37"/>
              <a:gd name="T9" fmla="*/ 34 h 68"/>
              <a:gd name="T10" fmla="*/ 21 w 37"/>
              <a:gd name="T11" fmla="*/ 65 h 68"/>
              <a:gd name="T12" fmla="*/ 16 w 37"/>
              <a:gd name="T13" fmla="*/ 65 h 68"/>
              <a:gd name="T14" fmla="*/ 0 w 37"/>
              <a:gd name="T15" fmla="*/ 62 h 68"/>
              <a:gd name="T16" fmla="*/ 37 w 37"/>
              <a:gd name="T17" fmla="*/ 62 h 68"/>
              <a:gd name="T18" fmla="*/ 37 w 37"/>
              <a:gd name="T19" fmla="*/ 68 h 68"/>
              <a:gd name="T20" fmla="*/ 0 w 37"/>
              <a:gd name="T21" fmla="*/ 68 h 68"/>
              <a:gd name="T22" fmla="*/ 0 w 37"/>
              <a:gd name="T23" fmla="*/ 62 h 68"/>
              <a:gd name="T24" fmla="*/ 0 w 37"/>
              <a:gd name="T25" fmla="*/ 0 h 68"/>
              <a:gd name="T26" fmla="*/ 37 w 37"/>
              <a:gd name="T27" fmla="*/ 0 h 68"/>
              <a:gd name="T28" fmla="*/ 37 w 37"/>
              <a:gd name="T29" fmla="*/ 6 h 68"/>
              <a:gd name="T30" fmla="*/ 0 w 37"/>
              <a:gd name="T31" fmla="*/ 6 h 68"/>
              <a:gd name="T32" fmla="*/ 0 w 37"/>
              <a:gd name="T33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68">
                <a:moveTo>
                  <a:pt x="16" y="65"/>
                </a:moveTo>
                <a:lnTo>
                  <a:pt x="16" y="34"/>
                </a:lnTo>
                <a:lnTo>
                  <a:pt x="16" y="3"/>
                </a:lnTo>
                <a:lnTo>
                  <a:pt x="21" y="3"/>
                </a:lnTo>
                <a:lnTo>
                  <a:pt x="21" y="34"/>
                </a:lnTo>
                <a:lnTo>
                  <a:pt x="21" y="65"/>
                </a:lnTo>
                <a:lnTo>
                  <a:pt x="16" y="65"/>
                </a:lnTo>
                <a:close/>
                <a:moveTo>
                  <a:pt x="0" y="62"/>
                </a:moveTo>
                <a:lnTo>
                  <a:pt x="37" y="62"/>
                </a:lnTo>
                <a:lnTo>
                  <a:pt x="37" y="68"/>
                </a:lnTo>
                <a:lnTo>
                  <a:pt x="0" y="68"/>
                </a:lnTo>
                <a:lnTo>
                  <a:pt x="0" y="62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9" name="Freeform 213"/>
          <p:cNvSpPr>
            <a:spLocks noEditPoints="1"/>
          </p:cNvSpPr>
          <p:nvPr/>
        </p:nvSpPr>
        <p:spPr bwMode="auto">
          <a:xfrm>
            <a:off x="1335884" y="3242021"/>
            <a:ext cx="47498" cy="184328"/>
          </a:xfrm>
          <a:custGeom>
            <a:avLst/>
            <a:gdLst>
              <a:gd name="T0" fmla="*/ 15 w 36"/>
              <a:gd name="T1" fmla="*/ 152 h 155"/>
              <a:gd name="T2" fmla="*/ 15 w 36"/>
              <a:gd name="T3" fmla="*/ 77 h 155"/>
              <a:gd name="T4" fmla="*/ 15 w 36"/>
              <a:gd name="T5" fmla="*/ 3 h 155"/>
              <a:gd name="T6" fmla="*/ 21 w 36"/>
              <a:gd name="T7" fmla="*/ 3 h 155"/>
              <a:gd name="T8" fmla="*/ 21 w 36"/>
              <a:gd name="T9" fmla="*/ 77 h 155"/>
              <a:gd name="T10" fmla="*/ 21 w 36"/>
              <a:gd name="T11" fmla="*/ 152 h 155"/>
              <a:gd name="T12" fmla="*/ 15 w 36"/>
              <a:gd name="T13" fmla="*/ 152 h 155"/>
              <a:gd name="T14" fmla="*/ 0 w 36"/>
              <a:gd name="T15" fmla="*/ 149 h 155"/>
              <a:gd name="T16" fmla="*/ 36 w 36"/>
              <a:gd name="T17" fmla="*/ 149 h 155"/>
              <a:gd name="T18" fmla="*/ 36 w 36"/>
              <a:gd name="T19" fmla="*/ 155 h 155"/>
              <a:gd name="T20" fmla="*/ 0 w 36"/>
              <a:gd name="T21" fmla="*/ 155 h 155"/>
              <a:gd name="T22" fmla="*/ 0 w 36"/>
              <a:gd name="T23" fmla="*/ 149 h 155"/>
              <a:gd name="T24" fmla="*/ 0 w 36"/>
              <a:gd name="T25" fmla="*/ 0 h 155"/>
              <a:gd name="T26" fmla="*/ 36 w 36"/>
              <a:gd name="T27" fmla="*/ 0 h 155"/>
              <a:gd name="T28" fmla="*/ 36 w 36"/>
              <a:gd name="T29" fmla="*/ 6 h 155"/>
              <a:gd name="T30" fmla="*/ 0 w 36"/>
              <a:gd name="T31" fmla="*/ 6 h 155"/>
              <a:gd name="T32" fmla="*/ 0 w 36"/>
              <a:gd name="T33" fmla="*/ 0 h 1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55">
                <a:moveTo>
                  <a:pt x="15" y="152"/>
                </a:moveTo>
                <a:lnTo>
                  <a:pt x="15" y="77"/>
                </a:lnTo>
                <a:lnTo>
                  <a:pt x="15" y="3"/>
                </a:lnTo>
                <a:lnTo>
                  <a:pt x="21" y="3"/>
                </a:lnTo>
                <a:lnTo>
                  <a:pt x="21" y="77"/>
                </a:lnTo>
                <a:lnTo>
                  <a:pt x="21" y="152"/>
                </a:lnTo>
                <a:lnTo>
                  <a:pt x="15" y="152"/>
                </a:lnTo>
                <a:close/>
                <a:moveTo>
                  <a:pt x="0" y="149"/>
                </a:moveTo>
                <a:lnTo>
                  <a:pt x="36" y="149"/>
                </a:lnTo>
                <a:lnTo>
                  <a:pt x="36" y="155"/>
                </a:lnTo>
                <a:lnTo>
                  <a:pt x="0" y="155"/>
                </a:lnTo>
                <a:lnTo>
                  <a:pt x="0" y="14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0" name="Freeform 214"/>
          <p:cNvSpPr>
            <a:spLocks noEditPoints="1"/>
          </p:cNvSpPr>
          <p:nvPr/>
        </p:nvSpPr>
        <p:spPr bwMode="auto">
          <a:xfrm>
            <a:off x="1557541" y="3671326"/>
            <a:ext cx="47498" cy="114164"/>
          </a:xfrm>
          <a:custGeom>
            <a:avLst/>
            <a:gdLst>
              <a:gd name="T0" fmla="*/ 15 w 36"/>
              <a:gd name="T1" fmla="*/ 93 h 96"/>
              <a:gd name="T2" fmla="*/ 15 w 36"/>
              <a:gd name="T3" fmla="*/ 48 h 96"/>
              <a:gd name="T4" fmla="*/ 15 w 36"/>
              <a:gd name="T5" fmla="*/ 3 h 96"/>
              <a:gd name="T6" fmla="*/ 21 w 36"/>
              <a:gd name="T7" fmla="*/ 3 h 96"/>
              <a:gd name="T8" fmla="*/ 21 w 36"/>
              <a:gd name="T9" fmla="*/ 48 h 96"/>
              <a:gd name="T10" fmla="*/ 21 w 36"/>
              <a:gd name="T11" fmla="*/ 93 h 96"/>
              <a:gd name="T12" fmla="*/ 15 w 36"/>
              <a:gd name="T13" fmla="*/ 93 h 96"/>
              <a:gd name="T14" fmla="*/ 0 w 36"/>
              <a:gd name="T15" fmla="*/ 91 h 96"/>
              <a:gd name="T16" fmla="*/ 36 w 36"/>
              <a:gd name="T17" fmla="*/ 91 h 96"/>
              <a:gd name="T18" fmla="*/ 36 w 36"/>
              <a:gd name="T19" fmla="*/ 96 h 96"/>
              <a:gd name="T20" fmla="*/ 0 w 36"/>
              <a:gd name="T21" fmla="*/ 96 h 96"/>
              <a:gd name="T22" fmla="*/ 0 w 36"/>
              <a:gd name="T23" fmla="*/ 91 h 96"/>
              <a:gd name="T24" fmla="*/ 0 w 36"/>
              <a:gd name="T25" fmla="*/ 0 h 96"/>
              <a:gd name="T26" fmla="*/ 36 w 36"/>
              <a:gd name="T27" fmla="*/ 0 h 96"/>
              <a:gd name="T28" fmla="*/ 36 w 36"/>
              <a:gd name="T29" fmla="*/ 6 h 96"/>
              <a:gd name="T30" fmla="*/ 0 w 36"/>
              <a:gd name="T31" fmla="*/ 6 h 96"/>
              <a:gd name="T32" fmla="*/ 0 w 36"/>
              <a:gd name="T33" fmla="*/ 0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96">
                <a:moveTo>
                  <a:pt x="15" y="93"/>
                </a:moveTo>
                <a:lnTo>
                  <a:pt x="15" y="48"/>
                </a:lnTo>
                <a:lnTo>
                  <a:pt x="15" y="3"/>
                </a:lnTo>
                <a:lnTo>
                  <a:pt x="21" y="3"/>
                </a:lnTo>
                <a:lnTo>
                  <a:pt x="21" y="48"/>
                </a:lnTo>
                <a:lnTo>
                  <a:pt x="21" y="93"/>
                </a:lnTo>
                <a:lnTo>
                  <a:pt x="15" y="93"/>
                </a:lnTo>
                <a:close/>
                <a:moveTo>
                  <a:pt x="0" y="91"/>
                </a:moveTo>
                <a:lnTo>
                  <a:pt x="36" y="91"/>
                </a:lnTo>
                <a:lnTo>
                  <a:pt x="36" y="96"/>
                </a:lnTo>
                <a:lnTo>
                  <a:pt x="0" y="96"/>
                </a:lnTo>
                <a:lnTo>
                  <a:pt x="0" y="91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1" name="Freeform 215"/>
          <p:cNvSpPr>
            <a:spLocks noEditPoints="1"/>
          </p:cNvSpPr>
          <p:nvPr/>
        </p:nvSpPr>
        <p:spPr bwMode="auto">
          <a:xfrm>
            <a:off x="1779198" y="3603541"/>
            <a:ext cx="47498" cy="112975"/>
          </a:xfrm>
          <a:custGeom>
            <a:avLst/>
            <a:gdLst>
              <a:gd name="T0" fmla="*/ 14 w 36"/>
              <a:gd name="T1" fmla="*/ 92 h 95"/>
              <a:gd name="T2" fmla="*/ 14 w 36"/>
              <a:gd name="T3" fmla="*/ 48 h 95"/>
              <a:gd name="T4" fmla="*/ 14 w 36"/>
              <a:gd name="T5" fmla="*/ 3 h 95"/>
              <a:gd name="T6" fmla="*/ 20 w 36"/>
              <a:gd name="T7" fmla="*/ 3 h 95"/>
              <a:gd name="T8" fmla="*/ 20 w 36"/>
              <a:gd name="T9" fmla="*/ 48 h 95"/>
              <a:gd name="T10" fmla="*/ 20 w 36"/>
              <a:gd name="T11" fmla="*/ 92 h 95"/>
              <a:gd name="T12" fmla="*/ 14 w 36"/>
              <a:gd name="T13" fmla="*/ 92 h 95"/>
              <a:gd name="T14" fmla="*/ 0 w 36"/>
              <a:gd name="T15" fmla="*/ 89 h 95"/>
              <a:gd name="T16" fmla="*/ 36 w 36"/>
              <a:gd name="T17" fmla="*/ 89 h 95"/>
              <a:gd name="T18" fmla="*/ 36 w 36"/>
              <a:gd name="T19" fmla="*/ 95 h 95"/>
              <a:gd name="T20" fmla="*/ 0 w 36"/>
              <a:gd name="T21" fmla="*/ 95 h 95"/>
              <a:gd name="T22" fmla="*/ 0 w 36"/>
              <a:gd name="T23" fmla="*/ 89 h 95"/>
              <a:gd name="T24" fmla="*/ 0 w 36"/>
              <a:gd name="T25" fmla="*/ 0 h 95"/>
              <a:gd name="T26" fmla="*/ 36 w 36"/>
              <a:gd name="T27" fmla="*/ 0 h 95"/>
              <a:gd name="T28" fmla="*/ 36 w 36"/>
              <a:gd name="T29" fmla="*/ 6 h 95"/>
              <a:gd name="T30" fmla="*/ 0 w 36"/>
              <a:gd name="T31" fmla="*/ 6 h 95"/>
              <a:gd name="T32" fmla="*/ 0 w 36"/>
              <a:gd name="T33" fmla="*/ 0 h 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95">
                <a:moveTo>
                  <a:pt x="14" y="92"/>
                </a:moveTo>
                <a:lnTo>
                  <a:pt x="14" y="48"/>
                </a:lnTo>
                <a:lnTo>
                  <a:pt x="14" y="3"/>
                </a:lnTo>
                <a:lnTo>
                  <a:pt x="20" y="3"/>
                </a:lnTo>
                <a:lnTo>
                  <a:pt x="20" y="48"/>
                </a:lnTo>
                <a:lnTo>
                  <a:pt x="20" y="92"/>
                </a:lnTo>
                <a:lnTo>
                  <a:pt x="14" y="92"/>
                </a:lnTo>
                <a:close/>
                <a:moveTo>
                  <a:pt x="0" y="89"/>
                </a:moveTo>
                <a:lnTo>
                  <a:pt x="36" y="89"/>
                </a:lnTo>
                <a:lnTo>
                  <a:pt x="36" y="95"/>
                </a:lnTo>
                <a:lnTo>
                  <a:pt x="0" y="95"/>
                </a:lnTo>
                <a:lnTo>
                  <a:pt x="0" y="8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2" name="Freeform 216"/>
          <p:cNvSpPr>
            <a:spLocks noEditPoints="1"/>
          </p:cNvSpPr>
          <p:nvPr/>
        </p:nvSpPr>
        <p:spPr bwMode="auto">
          <a:xfrm>
            <a:off x="1999536" y="3604730"/>
            <a:ext cx="48818" cy="82056"/>
          </a:xfrm>
          <a:custGeom>
            <a:avLst/>
            <a:gdLst>
              <a:gd name="T0" fmla="*/ 15 w 37"/>
              <a:gd name="T1" fmla="*/ 66 h 69"/>
              <a:gd name="T2" fmla="*/ 15 w 37"/>
              <a:gd name="T3" fmla="*/ 34 h 69"/>
              <a:gd name="T4" fmla="*/ 15 w 37"/>
              <a:gd name="T5" fmla="*/ 3 h 69"/>
              <a:gd name="T6" fmla="*/ 21 w 37"/>
              <a:gd name="T7" fmla="*/ 3 h 69"/>
              <a:gd name="T8" fmla="*/ 21 w 37"/>
              <a:gd name="T9" fmla="*/ 34 h 69"/>
              <a:gd name="T10" fmla="*/ 21 w 37"/>
              <a:gd name="T11" fmla="*/ 66 h 69"/>
              <a:gd name="T12" fmla="*/ 15 w 37"/>
              <a:gd name="T13" fmla="*/ 66 h 69"/>
              <a:gd name="T14" fmla="*/ 0 w 37"/>
              <a:gd name="T15" fmla="*/ 63 h 69"/>
              <a:gd name="T16" fmla="*/ 37 w 37"/>
              <a:gd name="T17" fmla="*/ 63 h 69"/>
              <a:gd name="T18" fmla="*/ 37 w 37"/>
              <a:gd name="T19" fmla="*/ 69 h 69"/>
              <a:gd name="T20" fmla="*/ 0 w 37"/>
              <a:gd name="T21" fmla="*/ 69 h 69"/>
              <a:gd name="T22" fmla="*/ 0 w 37"/>
              <a:gd name="T23" fmla="*/ 63 h 69"/>
              <a:gd name="T24" fmla="*/ 0 w 37"/>
              <a:gd name="T25" fmla="*/ 0 h 69"/>
              <a:gd name="T26" fmla="*/ 37 w 37"/>
              <a:gd name="T27" fmla="*/ 0 h 69"/>
              <a:gd name="T28" fmla="*/ 37 w 37"/>
              <a:gd name="T29" fmla="*/ 6 h 69"/>
              <a:gd name="T30" fmla="*/ 0 w 37"/>
              <a:gd name="T31" fmla="*/ 6 h 69"/>
              <a:gd name="T32" fmla="*/ 0 w 37"/>
              <a:gd name="T33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69">
                <a:moveTo>
                  <a:pt x="15" y="66"/>
                </a:moveTo>
                <a:lnTo>
                  <a:pt x="15" y="34"/>
                </a:lnTo>
                <a:lnTo>
                  <a:pt x="15" y="3"/>
                </a:lnTo>
                <a:lnTo>
                  <a:pt x="21" y="3"/>
                </a:lnTo>
                <a:lnTo>
                  <a:pt x="21" y="34"/>
                </a:lnTo>
                <a:lnTo>
                  <a:pt x="21" y="66"/>
                </a:lnTo>
                <a:lnTo>
                  <a:pt x="15" y="66"/>
                </a:lnTo>
                <a:close/>
                <a:moveTo>
                  <a:pt x="0" y="63"/>
                </a:moveTo>
                <a:lnTo>
                  <a:pt x="37" y="63"/>
                </a:lnTo>
                <a:lnTo>
                  <a:pt x="37" y="69"/>
                </a:lnTo>
                <a:lnTo>
                  <a:pt x="0" y="69"/>
                </a:lnTo>
                <a:lnTo>
                  <a:pt x="0" y="6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3" name="Freeform 217"/>
          <p:cNvSpPr>
            <a:spLocks noEditPoints="1"/>
          </p:cNvSpPr>
          <p:nvPr/>
        </p:nvSpPr>
        <p:spPr bwMode="auto">
          <a:xfrm>
            <a:off x="2221193" y="3271752"/>
            <a:ext cx="47498" cy="126056"/>
          </a:xfrm>
          <a:custGeom>
            <a:avLst/>
            <a:gdLst>
              <a:gd name="T0" fmla="*/ 15 w 36"/>
              <a:gd name="T1" fmla="*/ 103 h 106"/>
              <a:gd name="T2" fmla="*/ 15 w 36"/>
              <a:gd name="T3" fmla="*/ 53 h 106"/>
              <a:gd name="T4" fmla="*/ 15 w 36"/>
              <a:gd name="T5" fmla="*/ 3 h 106"/>
              <a:gd name="T6" fmla="*/ 21 w 36"/>
              <a:gd name="T7" fmla="*/ 3 h 106"/>
              <a:gd name="T8" fmla="*/ 21 w 36"/>
              <a:gd name="T9" fmla="*/ 53 h 106"/>
              <a:gd name="T10" fmla="*/ 21 w 36"/>
              <a:gd name="T11" fmla="*/ 103 h 106"/>
              <a:gd name="T12" fmla="*/ 15 w 36"/>
              <a:gd name="T13" fmla="*/ 103 h 106"/>
              <a:gd name="T14" fmla="*/ 0 w 36"/>
              <a:gd name="T15" fmla="*/ 100 h 106"/>
              <a:gd name="T16" fmla="*/ 36 w 36"/>
              <a:gd name="T17" fmla="*/ 100 h 106"/>
              <a:gd name="T18" fmla="*/ 36 w 36"/>
              <a:gd name="T19" fmla="*/ 106 h 106"/>
              <a:gd name="T20" fmla="*/ 0 w 36"/>
              <a:gd name="T21" fmla="*/ 106 h 106"/>
              <a:gd name="T22" fmla="*/ 0 w 36"/>
              <a:gd name="T23" fmla="*/ 100 h 106"/>
              <a:gd name="T24" fmla="*/ 0 w 36"/>
              <a:gd name="T25" fmla="*/ 0 h 106"/>
              <a:gd name="T26" fmla="*/ 36 w 36"/>
              <a:gd name="T27" fmla="*/ 0 h 106"/>
              <a:gd name="T28" fmla="*/ 36 w 36"/>
              <a:gd name="T29" fmla="*/ 6 h 106"/>
              <a:gd name="T30" fmla="*/ 0 w 36"/>
              <a:gd name="T31" fmla="*/ 6 h 106"/>
              <a:gd name="T32" fmla="*/ 0 w 36"/>
              <a:gd name="T33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06">
                <a:moveTo>
                  <a:pt x="15" y="103"/>
                </a:moveTo>
                <a:lnTo>
                  <a:pt x="15" y="53"/>
                </a:lnTo>
                <a:lnTo>
                  <a:pt x="15" y="3"/>
                </a:lnTo>
                <a:lnTo>
                  <a:pt x="21" y="3"/>
                </a:lnTo>
                <a:lnTo>
                  <a:pt x="21" y="53"/>
                </a:lnTo>
                <a:lnTo>
                  <a:pt x="21" y="103"/>
                </a:lnTo>
                <a:lnTo>
                  <a:pt x="15" y="103"/>
                </a:lnTo>
                <a:close/>
                <a:moveTo>
                  <a:pt x="0" y="100"/>
                </a:moveTo>
                <a:lnTo>
                  <a:pt x="36" y="100"/>
                </a:lnTo>
                <a:lnTo>
                  <a:pt x="36" y="106"/>
                </a:lnTo>
                <a:lnTo>
                  <a:pt x="0" y="106"/>
                </a:lnTo>
                <a:lnTo>
                  <a:pt x="0" y="10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4" name="Freeform 218"/>
          <p:cNvSpPr>
            <a:spLocks noEditPoints="1"/>
          </p:cNvSpPr>
          <p:nvPr/>
        </p:nvSpPr>
        <p:spPr bwMode="auto">
          <a:xfrm>
            <a:off x="2442850" y="3810463"/>
            <a:ext cx="47498" cy="54704"/>
          </a:xfrm>
          <a:custGeom>
            <a:avLst/>
            <a:gdLst>
              <a:gd name="T0" fmla="*/ 14 w 36"/>
              <a:gd name="T1" fmla="*/ 43 h 46"/>
              <a:gd name="T2" fmla="*/ 14 w 36"/>
              <a:gd name="T3" fmla="*/ 23 h 46"/>
              <a:gd name="T4" fmla="*/ 14 w 36"/>
              <a:gd name="T5" fmla="*/ 2 h 46"/>
              <a:gd name="T6" fmla="*/ 20 w 36"/>
              <a:gd name="T7" fmla="*/ 2 h 46"/>
              <a:gd name="T8" fmla="*/ 20 w 36"/>
              <a:gd name="T9" fmla="*/ 23 h 46"/>
              <a:gd name="T10" fmla="*/ 20 w 36"/>
              <a:gd name="T11" fmla="*/ 43 h 46"/>
              <a:gd name="T12" fmla="*/ 14 w 36"/>
              <a:gd name="T13" fmla="*/ 43 h 46"/>
              <a:gd name="T14" fmla="*/ 0 w 36"/>
              <a:gd name="T15" fmla="*/ 40 h 46"/>
              <a:gd name="T16" fmla="*/ 36 w 36"/>
              <a:gd name="T17" fmla="*/ 40 h 46"/>
              <a:gd name="T18" fmla="*/ 36 w 36"/>
              <a:gd name="T19" fmla="*/ 46 h 46"/>
              <a:gd name="T20" fmla="*/ 0 w 36"/>
              <a:gd name="T21" fmla="*/ 46 h 46"/>
              <a:gd name="T22" fmla="*/ 0 w 36"/>
              <a:gd name="T23" fmla="*/ 40 h 46"/>
              <a:gd name="T24" fmla="*/ 0 w 36"/>
              <a:gd name="T25" fmla="*/ 0 h 46"/>
              <a:gd name="T26" fmla="*/ 36 w 36"/>
              <a:gd name="T27" fmla="*/ 0 h 46"/>
              <a:gd name="T28" fmla="*/ 36 w 36"/>
              <a:gd name="T29" fmla="*/ 5 h 46"/>
              <a:gd name="T30" fmla="*/ 0 w 36"/>
              <a:gd name="T31" fmla="*/ 5 h 46"/>
              <a:gd name="T32" fmla="*/ 0 w 36"/>
              <a:gd name="T33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46">
                <a:moveTo>
                  <a:pt x="14" y="43"/>
                </a:moveTo>
                <a:lnTo>
                  <a:pt x="14" y="23"/>
                </a:lnTo>
                <a:lnTo>
                  <a:pt x="14" y="2"/>
                </a:lnTo>
                <a:lnTo>
                  <a:pt x="20" y="2"/>
                </a:lnTo>
                <a:lnTo>
                  <a:pt x="20" y="23"/>
                </a:lnTo>
                <a:lnTo>
                  <a:pt x="20" y="43"/>
                </a:lnTo>
                <a:lnTo>
                  <a:pt x="14" y="43"/>
                </a:lnTo>
                <a:close/>
                <a:moveTo>
                  <a:pt x="0" y="40"/>
                </a:moveTo>
                <a:lnTo>
                  <a:pt x="36" y="40"/>
                </a:lnTo>
                <a:lnTo>
                  <a:pt x="36" y="46"/>
                </a:lnTo>
                <a:lnTo>
                  <a:pt x="0" y="46"/>
                </a:lnTo>
                <a:lnTo>
                  <a:pt x="0" y="4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5" name="Freeform 219"/>
          <p:cNvSpPr>
            <a:spLocks noEditPoints="1"/>
          </p:cNvSpPr>
          <p:nvPr/>
        </p:nvSpPr>
        <p:spPr bwMode="auto">
          <a:xfrm>
            <a:off x="2663187" y="3634460"/>
            <a:ext cx="48818" cy="55893"/>
          </a:xfrm>
          <a:custGeom>
            <a:avLst/>
            <a:gdLst>
              <a:gd name="T0" fmla="*/ 15 w 37"/>
              <a:gd name="T1" fmla="*/ 44 h 47"/>
              <a:gd name="T2" fmla="*/ 15 w 37"/>
              <a:gd name="T3" fmla="*/ 23 h 47"/>
              <a:gd name="T4" fmla="*/ 15 w 37"/>
              <a:gd name="T5" fmla="*/ 3 h 47"/>
              <a:gd name="T6" fmla="*/ 21 w 37"/>
              <a:gd name="T7" fmla="*/ 3 h 47"/>
              <a:gd name="T8" fmla="*/ 21 w 37"/>
              <a:gd name="T9" fmla="*/ 23 h 47"/>
              <a:gd name="T10" fmla="*/ 21 w 37"/>
              <a:gd name="T11" fmla="*/ 44 h 47"/>
              <a:gd name="T12" fmla="*/ 15 w 37"/>
              <a:gd name="T13" fmla="*/ 44 h 47"/>
              <a:gd name="T14" fmla="*/ 0 w 37"/>
              <a:gd name="T15" fmla="*/ 41 h 47"/>
              <a:gd name="T16" fmla="*/ 37 w 37"/>
              <a:gd name="T17" fmla="*/ 41 h 47"/>
              <a:gd name="T18" fmla="*/ 37 w 37"/>
              <a:gd name="T19" fmla="*/ 47 h 47"/>
              <a:gd name="T20" fmla="*/ 0 w 37"/>
              <a:gd name="T21" fmla="*/ 47 h 47"/>
              <a:gd name="T22" fmla="*/ 0 w 37"/>
              <a:gd name="T23" fmla="*/ 41 h 47"/>
              <a:gd name="T24" fmla="*/ 0 w 37"/>
              <a:gd name="T25" fmla="*/ 0 h 47"/>
              <a:gd name="T26" fmla="*/ 37 w 37"/>
              <a:gd name="T27" fmla="*/ 0 h 47"/>
              <a:gd name="T28" fmla="*/ 37 w 37"/>
              <a:gd name="T29" fmla="*/ 5 h 47"/>
              <a:gd name="T30" fmla="*/ 0 w 37"/>
              <a:gd name="T31" fmla="*/ 5 h 47"/>
              <a:gd name="T32" fmla="*/ 0 w 37"/>
              <a:gd name="T33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47">
                <a:moveTo>
                  <a:pt x="15" y="44"/>
                </a:moveTo>
                <a:lnTo>
                  <a:pt x="15" y="23"/>
                </a:lnTo>
                <a:lnTo>
                  <a:pt x="15" y="3"/>
                </a:lnTo>
                <a:lnTo>
                  <a:pt x="21" y="3"/>
                </a:lnTo>
                <a:lnTo>
                  <a:pt x="21" y="23"/>
                </a:lnTo>
                <a:lnTo>
                  <a:pt x="21" y="44"/>
                </a:lnTo>
                <a:lnTo>
                  <a:pt x="15" y="44"/>
                </a:lnTo>
                <a:close/>
                <a:moveTo>
                  <a:pt x="0" y="41"/>
                </a:moveTo>
                <a:lnTo>
                  <a:pt x="37" y="41"/>
                </a:lnTo>
                <a:lnTo>
                  <a:pt x="37" y="47"/>
                </a:lnTo>
                <a:lnTo>
                  <a:pt x="0" y="47"/>
                </a:lnTo>
                <a:lnTo>
                  <a:pt x="0" y="41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5"/>
                </a:lnTo>
                <a:lnTo>
                  <a:pt x="0" y="5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6" name="Freeform 220"/>
          <p:cNvSpPr>
            <a:spLocks noEditPoints="1"/>
          </p:cNvSpPr>
          <p:nvPr/>
        </p:nvSpPr>
        <p:spPr bwMode="auto">
          <a:xfrm>
            <a:off x="2884844" y="3716516"/>
            <a:ext cx="48818" cy="17839"/>
          </a:xfrm>
          <a:custGeom>
            <a:avLst/>
            <a:gdLst>
              <a:gd name="T0" fmla="*/ 15 w 37"/>
              <a:gd name="T1" fmla="*/ 12 h 15"/>
              <a:gd name="T2" fmla="*/ 15 w 37"/>
              <a:gd name="T3" fmla="*/ 7 h 15"/>
              <a:gd name="T4" fmla="*/ 15 w 37"/>
              <a:gd name="T5" fmla="*/ 3 h 15"/>
              <a:gd name="T6" fmla="*/ 21 w 37"/>
              <a:gd name="T7" fmla="*/ 3 h 15"/>
              <a:gd name="T8" fmla="*/ 21 w 37"/>
              <a:gd name="T9" fmla="*/ 7 h 15"/>
              <a:gd name="T10" fmla="*/ 21 w 37"/>
              <a:gd name="T11" fmla="*/ 12 h 15"/>
              <a:gd name="T12" fmla="*/ 15 w 37"/>
              <a:gd name="T13" fmla="*/ 12 h 15"/>
              <a:gd name="T14" fmla="*/ 0 w 37"/>
              <a:gd name="T15" fmla="*/ 9 h 15"/>
              <a:gd name="T16" fmla="*/ 37 w 37"/>
              <a:gd name="T17" fmla="*/ 9 h 15"/>
              <a:gd name="T18" fmla="*/ 37 w 37"/>
              <a:gd name="T19" fmla="*/ 15 h 15"/>
              <a:gd name="T20" fmla="*/ 0 w 37"/>
              <a:gd name="T21" fmla="*/ 15 h 15"/>
              <a:gd name="T22" fmla="*/ 0 w 37"/>
              <a:gd name="T23" fmla="*/ 9 h 15"/>
              <a:gd name="T24" fmla="*/ 0 w 37"/>
              <a:gd name="T25" fmla="*/ 0 h 15"/>
              <a:gd name="T26" fmla="*/ 37 w 37"/>
              <a:gd name="T27" fmla="*/ 0 h 15"/>
              <a:gd name="T28" fmla="*/ 37 w 37"/>
              <a:gd name="T29" fmla="*/ 6 h 15"/>
              <a:gd name="T30" fmla="*/ 0 w 37"/>
              <a:gd name="T31" fmla="*/ 6 h 15"/>
              <a:gd name="T32" fmla="*/ 0 w 37"/>
              <a:gd name="T33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5">
                <a:moveTo>
                  <a:pt x="15" y="12"/>
                </a:moveTo>
                <a:lnTo>
                  <a:pt x="15" y="7"/>
                </a:lnTo>
                <a:lnTo>
                  <a:pt x="15" y="3"/>
                </a:lnTo>
                <a:lnTo>
                  <a:pt x="21" y="3"/>
                </a:lnTo>
                <a:lnTo>
                  <a:pt x="21" y="7"/>
                </a:lnTo>
                <a:lnTo>
                  <a:pt x="21" y="12"/>
                </a:lnTo>
                <a:lnTo>
                  <a:pt x="15" y="12"/>
                </a:lnTo>
                <a:close/>
                <a:moveTo>
                  <a:pt x="0" y="9"/>
                </a:moveTo>
                <a:lnTo>
                  <a:pt x="37" y="9"/>
                </a:lnTo>
                <a:lnTo>
                  <a:pt x="37" y="15"/>
                </a:lnTo>
                <a:lnTo>
                  <a:pt x="0" y="15"/>
                </a:lnTo>
                <a:lnTo>
                  <a:pt x="0" y="9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7" name="Freeform 221"/>
          <p:cNvSpPr>
            <a:spLocks noEditPoints="1"/>
          </p:cNvSpPr>
          <p:nvPr/>
        </p:nvSpPr>
        <p:spPr bwMode="auto">
          <a:xfrm>
            <a:off x="3106501" y="3507215"/>
            <a:ext cx="47498" cy="29731"/>
          </a:xfrm>
          <a:custGeom>
            <a:avLst/>
            <a:gdLst>
              <a:gd name="T0" fmla="*/ 15 w 36"/>
              <a:gd name="T1" fmla="*/ 22 h 25"/>
              <a:gd name="T2" fmla="*/ 15 w 36"/>
              <a:gd name="T3" fmla="*/ 13 h 25"/>
              <a:gd name="T4" fmla="*/ 15 w 36"/>
              <a:gd name="T5" fmla="*/ 3 h 25"/>
              <a:gd name="T6" fmla="*/ 21 w 36"/>
              <a:gd name="T7" fmla="*/ 3 h 25"/>
              <a:gd name="T8" fmla="*/ 21 w 36"/>
              <a:gd name="T9" fmla="*/ 13 h 25"/>
              <a:gd name="T10" fmla="*/ 21 w 36"/>
              <a:gd name="T11" fmla="*/ 22 h 25"/>
              <a:gd name="T12" fmla="*/ 15 w 36"/>
              <a:gd name="T13" fmla="*/ 22 h 25"/>
              <a:gd name="T14" fmla="*/ 0 w 36"/>
              <a:gd name="T15" fmla="*/ 19 h 25"/>
              <a:gd name="T16" fmla="*/ 36 w 36"/>
              <a:gd name="T17" fmla="*/ 19 h 25"/>
              <a:gd name="T18" fmla="*/ 36 w 36"/>
              <a:gd name="T19" fmla="*/ 25 h 25"/>
              <a:gd name="T20" fmla="*/ 0 w 36"/>
              <a:gd name="T21" fmla="*/ 25 h 25"/>
              <a:gd name="T22" fmla="*/ 0 w 36"/>
              <a:gd name="T23" fmla="*/ 19 h 25"/>
              <a:gd name="T24" fmla="*/ 0 w 36"/>
              <a:gd name="T25" fmla="*/ 0 h 25"/>
              <a:gd name="T26" fmla="*/ 36 w 36"/>
              <a:gd name="T27" fmla="*/ 0 h 25"/>
              <a:gd name="T28" fmla="*/ 36 w 36"/>
              <a:gd name="T29" fmla="*/ 6 h 25"/>
              <a:gd name="T30" fmla="*/ 0 w 36"/>
              <a:gd name="T31" fmla="*/ 6 h 25"/>
              <a:gd name="T32" fmla="*/ 0 w 36"/>
              <a:gd name="T33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25">
                <a:moveTo>
                  <a:pt x="15" y="22"/>
                </a:moveTo>
                <a:lnTo>
                  <a:pt x="15" y="13"/>
                </a:lnTo>
                <a:lnTo>
                  <a:pt x="15" y="3"/>
                </a:lnTo>
                <a:lnTo>
                  <a:pt x="21" y="3"/>
                </a:lnTo>
                <a:lnTo>
                  <a:pt x="21" y="13"/>
                </a:lnTo>
                <a:lnTo>
                  <a:pt x="21" y="22"/>
                </a:lnTo>
                <a:lnTo>
                  <a:pt x="15" y="22"/>
                </a:lnTo>
                <a:close/>
                <a:moveTo>
                  <a:pt x="0" y="19"/>
                </a:moveTo>
                <a:lnTo>
                  <a:pt x="36" y="19"/>
                </a:lnTo>
                <a:lnTo>
                  <a:pt x="36" y="25"/>
                </a:lnTo>
                <a:lnTo>
                  <a:pt x="0" y="25"/>
                </a:lnTo>
                <a:lnTo>
                  <a:pt x="0" y="19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8" name="Freeform 222"/>
          <p:cNvSpPr>
            <a:spLocks noEditPoints="1"/>
          </p:cNvSpPr>
          <p:nvPr/>
        </p:nvSpPr>
        <p:spPr bwMode="auto">
          <a:xfrm>
            <a:off x="3328158" y="3243211"/>
            <a:ext cx="47498" cy="84434"/>
          </a:xfrm>
          <a:custGeom>
            <a:avLst/>
            <a:gdLst>
              <a:gd name="T0" fmla="*/ 15 w 36"/>
              <a:gd name="T1" fmla="*/ 69 h 71"/>
              <a:gd name="T2" fmla="*/ 15 w 36"/>
              <a:gd name="T3" fmla="*/ 36 h 71"/>
              <a:gd name="T4" fmla="*/ 15 w 36"/>
              <a:gd name="T5" fmla="*/ 3 h 71"/>
              <a:gd name="T6" fmla="*/ 20 w 36"/>
              <a:gd name="T7" fmla="*/ 3 h 71"/>
              <a:gd name="T8" fmla="*/ 20 w 36"/>
              <a:gd name="T9" fmla="*/ 36 h 71"/>
              <a:gd name="T10" fmla="*/ 20 w 36"/>
              <a:gd name="T11" fmla="*/ 69 h 71"/>
              <a:gd name="T12" fmla="*/ 15 w 36"/>
              <a:gd name="T13" fmla="*/ 69 h 71"/>
              <a:gd name="T14" fmla="*/ 0 w 36"/>
              <a:gd name="T15" fmla="*/ 66 h 71"/>
              <a:gd name="T16" fmla="*/ 36 w 36"/>
              <a:gd name="T17" fmla="*/ 66 h 71"/>
              <a:gd name="T18" fmla="*/ 36 w 36"/>
              <a:gd name="T19" fmla="*/ 71 h 71"/>
              <a:gd name="T20" fmla="*/ 0 w 36"/>
              <a:gd name="T21" fmla="*/ 71 h 71"/>
              <a:gd name="T22" fmla="*/ 0 w 36"/>
              <a:gd name="T23" fmla="*/ 66 h 71"/>
              <a:gd name="T24" fmla="*/ 0 w 36"/>
              <a:gd name="T25" fmla="*/ 0 h 71"/>
              <a:gd name="T26" fmla="*/ 36 w 36"/>
              <a:gd name="T27" fmla="*/ 0 h 71"/>
              <a:gd name="T28" fmla="*/ 36 w 36"/>
              <a:gd name="T29" fmla="*/ 6 h 71"/>
              <a:gd name="T30" fmla="*/ 0 w 36"/>
              <a:gd name="T31" fmla="*/ 6 h 71"/>
              <a:gd name="T32" fmla="*/ 0 w 36"/>
              <a:gd name="T33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71">
                <a:moveTo>
                  <a:pt x="15" y="69"/>
                </a:moveTo>
                <a:lnTo>
                  <a:pt x="15" y="36"/>
                </a:lnTo>
                <a:lnTo>
                  <a:pt x="15" y="3"/>
                </a:lnTo>
                <a:lnTo>
                  <a:pt x="20" y="3"/>
                </a:lnTo>
                <a:lnTo>
                  <a:pt x="20" y="36"/>
                </a:lnTo>
                <a:lnTo>
                  <a:pt x="20" y="69"/>
                </a:lnTo>
                <a:lnTo>
                  <a:pt x="15" y="69"/>
                </a:lnTo>
                <a:close/>
                <a:moveTo>
                  <a:pt x="0" y="66"/>
                </a:moveTo>
                <a:lnTo>
                  <a:pt x="36" y="66"/>
                </a:lnTo>
                <a:lnTo>
                  <a:pt x="36" y="71"/>
                </a:lnTo>
                <a:lnTo>
                  <a:pt x="0" y="71"/>
                </a:lnTo>
                <a:lnTo>
                  <a:pt x="0" y="6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9" name="Freeform 223"/>
          <p:cNvSpPr>
            <a:spLocks noEditPoints="1"/>
          </p:cNvSpPr>
          <p:nvPr/>
        </p:nvSpPr>
        <p:spPr bwMode="auto">
          <a:xfrm>
            <a:off x="3548496" y="3764084"/>
            <a:ext cx="48818" cy="33298"/>
          </a:xfrm>
          <a:custGeom>
            <a:avLst/>
            <a:gdLst>
              <a:gd name="T0" fmla="*/ 16 w 37"/>
              <a:gd name="T1" fmla="*/ 25 h 28"/>
              <a:gd name="T2" fmla="*/ 16 w 37"/>
              <a:gd name="T3" fmla="*/ 14 h 28"/>
              <a:gd name="T4" fmla="*/ 16 w 37"/>
              <a:gd name="T5" fmla="*/ 3 h 28"/>
              <a:gd name="T6" fmla="*/ 21 w 37"/>
              <a:gd name="T7" fmla="*/ 3 h 28"/>
              <a:gd name="T8" fmla="*/ 21 w 37"/>
              <a:gd name="T9" fmla="*/ 14 h 28"/>
              <a:gd name="T10" fmla="*/ 21 w 37"/>
              <a:gd name="T11" fmla="*/ 25 h 28"/>
              <a:gd name="T12" fmla="*/ 16 w 37"/>
              <a:gd name="T13" fmla="*/ 25 h 28"/>
              <a:gd name="T14" fmla="*/ 0 w 37"/>
              <a:gd name="T15" fmla="*/ 22 h 28"/>
              <a:gd name="T16" fmla="*/ 37 w 37"/>
              <a:gd name="T17" fmla="*/ 22 h 28"/>
              <a:gd name="T18" fmla="*/ 37 w 37"/>
              <a:gd name="T19" fmla="*/ 28 h 28"/>
              <a:gd name="T20" fmla="*/ 0 w 37"/>
              <a:gd name="T21" fmla="*/ 28 h 28"/>
              <a:gd name="T22" fmla="*/ 0 w 37"/>
              <a:gd name="T23" fmla="*/ 22 h 28"/>
              <a:gd name="T24" fmla="*/ 0 w 37"/>
              <a:gd name="T25" fmla="*/ 0 h 28"/>
              <a:gd name="T26" fmla="*/ 37 w 37"/>
              <a:gd name="T27" fmla="*/ 0 h 28"/>
              <a:gd name="T28" fmla="*/ 37 w 37"/>
              <a:gd name="T29" fmla="*/ 6 h 28"/>
              <a:gd name="T30" fmla="*/ 0 w 37"/>
              <a:gd name="T31" fmla="*/ 6 h 28"/>
              <a:gd name="T32" fmla="*/ 0 w 37"/>
              <a:gd name="T33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28">
                <a:moveTo>
                  <a:pt x="16" y="25"/>
                </a:moveTo>
                <a:lnTo>
                  <a:pt x="16" y="14"/>
                </a:lnTo>
                <a:lnTo>
                  <a:pt x="16" y="3"/>
                </a:lnTo>
                <a:lnTo>
                  <a:pt x="21" y="3"/>
                </a:lnTo>
                <a:lnTo>
                  <a:pt x="21" y="14"/>
                </a:lnTo>
                <a:lnTo>
                  <a:pt x="21" y="25"/>
                </a:lnTo>
                <a:lnTo>
                  <a:pt x="16" y="25"/>
                </a:lnTo>
                <a:close/>
                <a:moveTo>
                  <a:pt x="0" y="22"/>
                </a:moveTo>
                <a:lnTo>
                  <a:pt x="37" y="22"/>
                </a:lnTo>
                <a:lnTo>
                  <a:pt x="37" y="28"/>
                </a:lnTo>
                <a:lnTo>
                  <a:pt x="0" y="28"/>
                </a:lnTo>
                <a:lnTo>
                  <a:pt x="0" y="22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0" name="Freeform 224"/>
          <p:cNvSpPr>
            <a:spLocks noEditPoints="1"/>
          </p:cNvSpPr>
          <p:nvPr/>
        </p:nvSpPr>
        <p:spPr bwMode="auto">
          <a:xfrm>
            <a:off x="3770153" y="3791436"/>
            <a:ext cx="48818" cy="187895"/>
          </a:xfrm>
          <a:custGeom>
            <a:avLst/>
            <a:gdLst>
              <a:gd name="T0" fmla="*/ 16 w 37"/>
              <a:gd name="T1" fmla="*/ 155 h 158"/>
              <a:gd name="T2" fmla="*/ 16 w 37"/>
              <a:gd name="T3" fmla="*/ 79 h 158"/>
              <a:gd name="T4" fmla="*/ 16 w 37"/>
              <a:gd name="T5" fmla="*/ 3 h 158"/>
              <a:gd name="T6" fmla="*/ 21 w 37"/>
              <a:gd name="T7" fmla="*/ 3 h 158"/>
              <a:gd name="T8" fmla="*/ 21 w 37"/>
              <a:gd name="T9" fmla="*/ 79 h 158"/>
              <a:gd name="T10" fmla="*/ 21 w 37"/>
              <a:gd name="T11" fmla="*/ 155 h 158"/>
              <a:gd name="T12" fmla="*/ 16 w 37"/>
              <a:gd name="T13" fmla="*/ 155 h 158"/>
              <a:gd name="T14" fmla="*/ 0 w 37"/>
              <a:gd name="T15" fmla="*/ 152 h 158"/>
              <a:gd name="T16" fmla="*/ 37 w 37"/>
              <a:gd name="T17" fmla="*/ 152 h 158"/>
              <a:gd name="T18" fmla="*/ 37 w 37"/>
              <a:gd name="T19" fmla="*/ 158 h 158"/>
              <a:gd name="T20" fmla="*/ 0 w 37"/>
              <a:gd name="T21" fmla="*/ 158 h 158"/>
              <a:gd name="T22" fmla="*/ 0 w 37"/>
              <a:gd name="T23" fmla="*/ 152 h 158"/>
              <a:gd name="T24" fmla="*/ 0 w 37"/>
              <a:gd name="T25" fmla="*/ 0 h 158"/>
              <a:gd name="T26" fmla="*/ 37 w 37"/>
              <a:gd name="T27" fmla="*/ 0 h 158"/>
              <a:gd name="T28" fmla="*/ 37 w 37"/>
              <a:gd name="T29" fmla="*/ 6 h 158"/>
              <a:gd name="T30" fmla="*/ 0 w 37"/>
              <a:gd name="T31" fmla="*/ 6 h 158"/>
              <a:gd name="T32" fmla="*/ 0 w 37"/>
              <a:gd name="T33" fmla="*/ 0 h 1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58">
                <a:moveTo>
                  <a:pt x="16" y="155"/>
                </a:moveTo>
                <a:lnTo>
                  <a:pt x="16" y="79"/>
                </a:lnTo>
                <a:lnTo>
                  <a:pt x="16" y="3"/>
                </a:lnTo>
                <a:lnTo>
                  <a:pt x="21" y="3"/>
                </a:lnTo>
                <a:lnTo>
                  <a:pt x="21" y="79"/>
                </a:lnTo>
                <a:lnTo>
                  <a:pt x="21" y="155"/>
                </a:lnTo>
                <a:lnTo>
                  <a:pt x="16" y="155"/>
                </a:lnTo>
                <a:close/>
                <a:moveTo>
                  <a:pt x="0" y="152"/>
                </a:moveTo>
                <a:lnTo>
                  <a:pt x="37" y="152"/>
                </a:lnTo>
                <a:lnTo>
                  <a:pt x="37" y="158"/>
                </a:lnTo>
                <a:lnTo>
                  <a:pt x="0" y="158"/>
                </a:lnTo>
                <a:lnTo>
                  <a:pt x="0" y="152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1" name="Freeform 225"/>
          <p:cNvSpPr>
            <a:spLocks noEditPoints="1"/>
          </p:cNvSpPr>
          <p:nvPr/>
        </p:nvSpPr>
        <p:spPr bwMode="auto">
          <a:xfrm>
            <a:off x="3991810" y="3743867"/>
            <a:ext cx="47498" cy="13082"/>
          </a:xfrm>
          <a:custGeom>
            <a:avLst/>
            <a:gdLst>
              <a:gd name="T0" fmla="*/ 15 w 36"/>
              <a:gd name="T1" fmla="*/ 8 h 11"/>
              <a:gd name="T2" fmla="*/ 15 w 36"/>
              <a:gd name="T3" fmla="*/ 6 h 11"/>
              <a:gd name="T4" fmla="*/ 15 w 36"/>
              <a:gd name="T5" fmla="*/ 3 h 11"/>
              <a:gd name="T6" fmla="*/ 20 w 36"/>
              <a:gd name="T7" fmla="*/ 3 h 11"/>
              <a:gd name="T8" fmla="*/ 20 w 36"/>
              <a:gd name="T9" fmla="*/ 6 h 11"/>
              <a:gd name="T10" fmla="*/ 20 w 36"/>
              <a:gd name="T11" fmla="*/ 8 h 11"/>
              <a:gd name="T12" fmla="*/ 15 w 36"/>
              <a:gd name="T13" fmla="*/ 8 h 11"/>
              <a:gd name="T14" fmla="*/ 0 w 36"/>
              <a:gd name="T15" fmla="*/ 6 h 11"/>
              <a:gd name="T16" fmla="*/ 36 w 36"/>
              <a:gd name="T17" fmla="*/ 6 h 11"/>
              <a:gd name="T18" fmla="*/ 36 w 36"/>
              <a:gd name="T19" fmla="*/ 11 h 11"/>
              <a:gd name="T20" fmla="*/ 0 w 36"/>
              <a:gd name="T21" fmla="*/ 11 h 11"/>
              <a:gd name="T22" fmla="*/ 0 w 36"/>
              <a:gd name="T23" fmla="*/ 6 h 11"/>
              <a:gd name="T24" fmla="*/ 0 w 36"/>
              <a:gd name="T25" fmla="*/ 0 h 11"/>
              <a:gd name="T26" fmla="*/ 36 w 36"/>
              <a:gd name="T27" fmla="*/ 0 h 11"/>
              <a:gd name="T28" fmla="*/ 36 w 36"/>
              <a:gd name="T29" fmla="*/ 6 h 11"/>
              <a:gd name="T30" fmla="*/ 0 w 36"/>
              <a:gd name="T31" fmla="*/ 6 h 11"/>
              <a:gd name="T32" fmla="*/ 0 w 36"/>
              <a:gd name="T33" fmla="*/ 0 h 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11">
                <a:moveTo>
                  <a:pt x="15" y="8"/>
                </a:moveTo>
                <a:lnTo>
                  <a:pt x="15" y="6"/>
                </a:lnTo>
                <a:lnTo>
                  <a:pt x="15" y="3"/>
                </a:lnTo>
                <a:lnTo>
                  <a:pt x="20" y="3"/>
                </a:lnTo>
                <a:lnTo>
                  <a:pt x="20" y="6"/>
                </a:lnTo>
                <a:lnTo>
                  <a:pt x="20" y="8"/>
                </a:lnTo>
                <a:lnTo>
                  <a:pt x="15" y="8"/>
                </a:lnTo>
                <a:close/>
                <a:moveTo>
                  <a:pt x="0" y="6"/>
                </a:moveTo>
                <a:lnTo>
                  <a:pt x="36" y="6"/>
                </a:lnTo>
                <a:lnTo>
                  <a:pt x="36" y="11"/>
                </a:lnTo>
                <a:lnTo>
                  <a:pt x="0" y="11"/>
                </a:lnTo>
                <a:lnTo>
                  <a:pt x="0" y="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2" name="Freeform 226"/>
          <p:cNvSpPr>
            <a:spLocks noEditPoints="1"/>
          </p:cNvSpPr>
          <p:nvPr/>
        </p:nvSpPr>
        <p:spPr bwMode="auto">
          <a:xfrm>
            <a:off x="4212147" y="3696299"/>
            <a:ext cx="48818" cy="40433"/>
          </a:xfrm>
          <a:custGeom>
            <a:avLst/>
            <a:gdLst>
              <a:gd name="T0" fmla="*/ 16 w 37"/>
              <a:gd name="T1" fmla="*/ 31 h 34"/>
              <a:gd name="T2" fmla="*/ 16 w 37"/>
              <a:gd name="T3" fmla="*/ 18 h 34"/>
              <a:gd name="T4" fmla="*/ 16 w 37"/>
              <a:gd name="T5" fmla="*/ 3 h 34"/>
              <a:gd name="T6" fmla="*/ 21 w 37"/>
              <a:gd name="T7" fmla="*/ 3 h 34"/>
              <a:gd name="T8" fmla="*/ 21 w 37"/>
              <a:gd name="T9" fmla="*/ 18 h 34"/>
              <a:gd name="T10" fmla="*/ 21 w 37"/>
              <a:gd name="T11" fmla="*/ 31 h 34"/>
              <a:gd name="T12" fmla="*/ 16 w 37"/>
              <a:gd name="T13" fmla="*/ 31 h 34"/>
              <a:gd name="T14" fmla="*/ 0 w 37"/>
              <a:gd name="T15" fmla="*/ 28 h 34"/>
              <a:gd name="T16" fmla="*/ 37 w 37"/>
              <a:gd name="T17" fmla="*/ 28 h 34"/>
              <a:gd name="T18" fmla="*/ 37 w 37"/>
              <a:gd name="T19" fmla="*/ 34 h 34"/>
              <a:gd name="T20" fmla="*/ 0 w 37"/>
              <a:gd name="T21" fmla="*/ 34 h 34"/>
              <a:gd name="T22" fmla="*/ 0 w 37"/>
              <a:gd name="T23" fmla="*/ 28 h 34"/>
              <a:gd name="T24" fmla="*/ 0 w 37"/>
              <a:gd name="T25" fmla="*/ 0 h 34"/>
              <a:gd name="T26" fmla="*/ 37 w 37"/>
              <a:gd name="T27" fmla="*/ 0 h 34"/>
              <a:gd name="T28" fmla="*/ 37 w 37"/>
              <a:gd name="T29" fmla="*/ 6 h 34"/>
              <a:gd name="T30" fmla="*/ 0 w 37"/>
              <a:gd name="T31" fmla="*/ 6 h 34"/>
              <a:gd name="T32" fmla="*/ 0 w 37"/>
              <a:gd name="T33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34">
                <a:moveTo>
                  <a:pt x="16" y="31"/>
                </a:moveTo>
                <a:lnTo>
                  <a:pt x="16" y="18"/>
                </a:lnTo>
                <a:lnTo>
                  <a:pt x="16" y="3"/>
                </a:lnTo>
                <a:lnTo>
                  <a:pt x="21" y="3"/>
                </a:lnTo>
                <a:lnTo>
                  <a:pt x="21" y="18"/>
                </a:lnTo>
                <a:lnTo>
                  <a:pt x="21" y="31"/>
                </a:lnTo>
                <a:lnTo>
                  <a:pt x="16" y="31"/>
                </a:lnTo>
                <a:close/>
                <a:moveTo>
                  <a:pt x="0" y="28"/>
                </a:moveTo>
                <a:lnTo>
                  <a:pt x="37" y="28"/>
                </a:lnTo>
                <a:lnTo>
                  <a:pt x="37" y="34"/>
                </a:lnTo>
                <a:lnTo>
                  <a:pt x="0" y="34"/>
                </a:lnTo>
                <a:lnTo>
                  <a:pt x="0" y="28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3" name="Freeform 227"/>
          <p:cNvSpPr>
            <a:spLocks noEditPoints="1"/>
          </p:cNvSpPr>
          <p:nvPr/>
        </p:nvSpPr>
        <p:spPr bwMode="auto">
          <a:xfrm>
            <a:off x="4433804" y="3614244"/>
            <a:ext cx="48818" cy="21406"/>
          </a:xfrm>
          <a:custGeom>
            <a:avLst/>
            <a:gdLst>
              <a:gd name="T0" fmla="*/ 16 w 37"/>
              <a:gd name="T1" fmla="*/ 15 h 18"/>
              <a:gd name="T2" fmla="*/ 16 w 37"/>
              <a:gd name="T3" fmla="*/ 9 h 18"/>
              <a:gd name="T4" fmla="*/ 16 w 37"/>
              <a:gd name="T5" fmla="*/ 3 h 18"/>
              <a:gd name="T6" fmla="*/ 21 w 37"/>
              <a:gd name="T7" fmla="*/ 3 h 18"/>
              <a:gd name="T8" fmla="*/ 21 w 37"/>
              <a:gd name="T9" fmla="*/ 9 h 18"/>
              <a:gd name="T10" fmla="*/ 21 w 37"/>
              <a:gd name="T11" fmla="*/ 15 h 18"/>
              <a:gd name="T12" fmla="*/ 16 w 37"/>
              <a:gd name="T13" fmla="*/ 15 h 18"/>
              <a:gd name="T14" fmla="*/ 0 w 37"/>
              <a:gd name="T15" fmla="*/ 12 h 18"/>
              <a:gd name="T16" fmla="*/ 37 w 37"/>
              <a:gd name="T17" fmla="*/ 12 h 18"/>
              <a:gd name="T18" fmla="*/ 37 w 37"/>
              <a:gd name="T19" fmla="*/ 18 h 18"/>
              <a:gd name="T20" fmla="*/ 0 w 37"/>
              <a:gd name="T21" fmla="*/ 18 h 18"/>
              <a:gd name="T22" fmla="*/ 0 w 37"/>
              <a:gd name="T23" fmla="*/ 12 h 18"/>
              <a:gd name="T24" fmla="*/ 0 w 37"/>
              <a:gd name="T25" fmla="*/ 0 h 18"/>
              <a:gd name="T26" fmla="*/ 37 w 37"/>
              <a:gd name="T27" fmla="*/ 0 h 18"/>
              <a:gd name="T28" fmla="*/ 37 w 37"/>
              <a:gd name="T29" fmla="*/ 6 h 18"/>
              <a:gd name="T30" fmla="*/ 0 w 37"/>
              <a:gd name="T31" fmla="*/ 6 h 18"/>
              <a:gd name="T32" fmla="*/ 0 w 37"/>
              <a:gd name="T33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8">
                <a:moveTo>
                  <a:pt x="16" y="15"/>
                </a:moveTo>
                <a:lnTo>
                  <a:pt x="16" y="9"/>
                </a:lnTo>
                <a:lnTo>
                  <a:pt x="16" y="3"/>
                </a:lnTo>
                <a:lnTo>
                  <a:pt x="21" y="3"/>
                </a:lnTo>
                <a:lnTo>
                  <a:pt x="21" y="9"/>
                </a:lnTo>
                <a:lnTo>
                  <a:pt x="21" y="15"/>
                </a:lnTo>
                <a:lnTo>
                  <a:pt x="16" y="15"/>
                </a:lnTo>
                <a:close/>
                <a:moveTo>
                  <a:pt x="0" y="12"/>
                </a:moveTo>
                <a:lnTo>
                  <a:pt x="37" y="12"/>
                </a:lnTo>
                <a:lnTo>
                  <a:pt x="37" y="18"/>
                </a:lnTo>
                <a:lnTo>
                  <a:pt x="0" y="18"/>
                </a:lnTo>
                <a:lnTo>
                  <a:pt x="0" y="12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4" name="Freeform 228"/>
          <p:cNvSpPr>
            <a:spLocks noEditPoints="1"/>
          </p:cNvSpPr>
          <p:nvPr/>
        </p:nvSpPr>
        <p:spPr bwMode="auto">
          <a:xfrm>
            <a:off x="4655461" y="3628514"/>
            <a:ext cx="47498" cy="44001"/>
          </a:xfrm>
          <a:custGeom>
            <a:avLst/>
            <a:gdLst>
              <a:gd name="T0" fmla="*/ 16 w 36"/>
              <a:gd name="T1" fmla="*/ 34 h 37"/>
              <a:gd name="T2" fmla="*/ 16 w 36"/>
              <a:gd name="T3" fmla="*/ 18 h 37"/>
              <a:gd name="T4" fmla="*/ 16 w 36"/>
              <a:gd name="T5" fmla="*/ 3 h 37"/>
              <a:gd name="T6" fmla="*/ 21 w 36"/>
              <a:gd name="T7" fmla="*/ 3 h 37"/>
              <a:gd name="T8" fmla="*/ 21 w 36"/>
              <a:gd name="T9" fmla="*/ 18 h 37"/>
              <a:gd name="T10" fmla="*/ 21 w 36"/>
              <a:gd name="T11" fmla="*/ 34 h 37"/>
              <a:gd name="T12" fmla="*/ 16 w 36"/>
              <a:gd name="T13" fmla="*/ 34 h 37"/>
              <a:gd name="T14" fmla="*/ 0 w 36"/>
              <a:gd name="T15" fmla="*/ 32 h 37"/>
              <a:gd name="T16" fmla="*/ 36 w 36"/>
              <a:gd name="T17" fmla="*/ 32 h 37"/>
              <a:gd name="T18" fmla="*/ 36 w 36"/>
              <a:gd name="T19" fmla="*/ 37 h 37"/>
              <a:gd name="T20" fmla="*/ 0 w 36"/>
              <a:gd name="T21" fmla="*/ 37 h 37"/>
              <a:gd name="T22" fmla="*/ 0 w 36"/>
              <a:gd name="T23" fmla="*/ 32 h 37"/>
              <a:gd name="T24" fmla="*/ 0 w 36"/>
              <a:gd name="T25" fmla="*/ 0 h 37"/>
              <a:gd name="T26" fmla="*/ 36 w 36"/>
              <a:gd name="T27" fmla="*/ 0 h 37"/>
              <a:gd name="T28" fmla="*/ 36 w 36"/>
              <a:gd name="T29" fmla="*/ 6 h 37"/>
              <a:gd name="T30" fmla="*/ 0 w 36"/>
              <a:gd name="T31" fmla="*/ 6 h 37"/>
              <a:gd name="T32" fmla="*/ 0 w 36"/>
              <a:gd name="T33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37">
                <a:moveTo>
                  <a:pt x="16" y="34"/>
                </a:moveTo>
                <a:lnTo>
                  <a:pt x="16" y="18"/>
                </a:lnTo>
                <a:lnTo>
                  <a:pt x="16" y="3"/>
                </a:lnTo>
                <a:lnTo>
                  <a:pt x="21" y="3"/>
                </a:lnTo>
                <a:lnTo>
                  <a:pt x="21" y="18"/>
                </a:lnTo>
                <a:lnTo>
                  <a:pt x="21" y="34"/>
                </a:lnTo>
                <a:lnTo>
                  <a:pt x="16" y="34"/>
                </a:lnTo>
                <a:close/>
                <a:moveTo>
                  <a:pt x="0" y="32"/>
                </a:moveTo>
                <a:lnTo>
                  <a:pt x="36" y="32"/>
                </a:lnTo>
                <a:lnTo>
                  <a:pt x="36" y="37"/>
                </a:lnTo>
                <a:lnTo>
                  <a:pt x="0" y="37"/>
                </a:lnTo>
                <a:lnTo>
                  <a:pt x="0" y="3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5" name="Freeform 229"/>
          <p:cNvSpPr>
            <a:spLocks noEditPoints="1"/>
          </p:cNvSpPr>
          <p:nvPr/>
        </p:nvSpPr>
        <p:spPr bwMode="auto">
          <a:xfrm>
            <a:off x="4877118" y="3743867"/>
            <a:ext cx="47498" cy="66596"/>
          </a:xfrm>
          <a:custGeom>
            <a:avLst/>
            <a:gdLst>
              <a:gd name="T0" fmla="*/ 15 w 36"/>
              <a:gd name="T1" fmla="*/ 53 h 56"/>
              <a:gd name="T2" fmla="*/ 15 w 36"/>
              <a:gd name="T3" fmla="*/ 28 h 56"/>
              <a:gd name="T4" fmla="*/ 15 w 36"/>
              <a:gd name="T5" fmla="*/ 3 h 56"/>
              <a:gd name="T6" fmla="*/ 20 w 36"/>
              <a:gd name="T7" fmla="*/ 3 h 56"/>
              <a:gd name="T8" fmla="*/ 20 w 36"/>
              <a:gd name="T9" fmla="*/ 28 h 56"/>
              <a:gd name="T10" fmla="*/ 20 w 36"/>
              <a:gd name="T11" fmla="*/ 53 h 56"/>
              <a:gd name="T12" fmla="*/ 15 w 36"/>
              <a:gd name="T13" fmla="*/ 53 h 56"/>
              <a:gd name="T14" fmla="*/ 0 w 36"/>
              <a:gd name="T15" fmla="*/ 50 h 56"/>
              <a:gd name="T16" fmla="*/ 36 w 36"/>
              <a:gd name="T17" fmla="*/ 50 h 56"/>
              <a:gd name="T18" fmla="*/ 36 w 36"/>
              <a:gd name="T19" fmla="*/ 56 h 56"/>
              <a:gd name="T20" fmla="*/ 0 w 36"/>
              <a:gd name="T21" fmla="*/ 56 h 56"/>
              <a:gd name="T22" fmla="*/ 0 w 36"/>
              <a:gd name="T23" fmla="*/ 50 h 56"/>
              <a:gd name="T24" fmla="*/ 0 w 36"/>
              <a:gd name="T25" fmla="*/ 0 h 56"/>
              <a:gd name="T26" fmla="*/ 36 w 36"/>
              <a:gd name="T27" fmla="*/ 0 h 56"/>
              <a:gd name="T28" fmla="*/ 36 w 36"/>
              <a:gd name="T29" fmla="*/ 6 h 56"/>
              <a:gd name="T30" fmla="*/ 0 w 36"/>
              <a:gd name="T31" fmla="*/ 6 h 56"/>
              <a:gd name="T32" fmla="*/ 0 w 36"/>
              <a:gd name="T33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56">
                <a:moveTo>
                  <a:pt x="15" y="53"/>
                </a:moveTo>
                <a:lnTo>
                  <a:pt x="15" y="28"/>
                </a:lnTo>
                <a:lnTo>
                  <a:pt x="15" y="3"/>
                </a:lnTo>
                <a:lnTo>
                  <a:pt x="20" y="3"/>
                </a:lnTo>
                <a:lnTo>
                  <a:pt x="20" y="28"/>
                </a:lnTo>
                <a:lnTo>
                  <a:pt x="20" y="53"/>
                </a:lnTo>
                <a:lnTo>
                  <a:pt x="15" y="53"/>
                </a:lnTo>
                <a:close/>
                <a:moveTo>
                  <a:pt x="0" y="50"/>
                </a:moveTo>
                <a:lnTo>
                  <a:pt x="36" y="50"/>
                </a:lnTo>
                <a:lnTo>
                  <a:pt x="36" y="56"/>
                </a:lnTo>
                <a:lnTo>
                  <a:pt x="0" y="56"/>
                </a:lnTo>
                <a:lnTo>
                  <a:pt x="0" y="5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6" name="Freeform 230"/>
          <p:cNvSpPr>
            <a:spLocks noEditPoints="1"/>
          </p:cNvSpPr>
          <p:nvPr/>
        </p:nvSpPr>
        <p:spPr bwMode="auto">
          <a:xfrm>
            <a:off x="5097456" y="3647542"/>
            <a:ext cx="48818" cy="153408"/>
          </a:xfrm>
          <a:custGeom>
            <a:avLst/>
            <a:gdLst>
              <a:gd name="T0" fmla="*/ 16 w 37"/>
              <a:gd name="T1" fmla="*/ 126 h 129"/>
              <a:gd name="T2" fmla="*/ 16 w 37"/>
              <a:gd name="T3" fmla="*/ 65 h 129"/>
              <a:gd name="T4" fmla="*/ 16 w 37"/>
              <a:gd name="T5" fmla="*/ 3 h 129"/>
              <a:gd name="T6" fmla="*/ 21 w 37"/>
              <a:gd name="T7" fmla="*/ 3 h 129"/>
              <a:gd name="T8" fmla="*/ 21 w 37"/>
              <a:gd name="T9" fmla="*/ 65 h 129"/>
              <a:gd name="T10" fmla="*/ 21 w 37"/>
              <a:gd name="T11" fmla="*/ 126 h 129"/>
              <a:gd name="T12" fmla="*/ 16 w 37"/>
              <a:gd name="T13" fmla="*/ 126 h 129"/>
              <a:gd name="T14" fmla="*/ 0 w 37"/>
              <a:gd name="T15" fmla="*/ 123 h 129"/>
              <a:gd name="T16" fmla="*/ 37 w 37"/>
              <a:gd name="T17" fmla="*/ 123 h 129"/>
              <a:gd name="T18" fmla="*/ 37 w 37"/>
              <a:gd name="T19" fmla="*/ 129 h 129"/>
              <a:gd name="T20" fmla="*/ 0 w 37"/>
              <a:gd name="T21" fmla="*/ 129 h 129"/>
              <a:gd name="T22" fmla="*/ 0 w 37"/>
              <a:gd name="T23" fmla="*/ 123 h 129"/>
              <a:gd name="T24" fmla="*/ 0 w 37"/>
              <a:gd name="T25" fmla="*/ 0 h 129"/>
              <a:gd name="T26" fmla="*/ 37 w 37"/>
              <a:gd name="T27" fmla="*/ 0 h 129"/>
              <a:gd name="T28" fmla="*/ 37 w 37"/>
              <a:gd name="T29" fmla="*/ 6 h 129"/>
              <a:gd name="T30" fmla="*/ 0 w 37"/>
              <a:gd name="T31" fmla="*/ 6 h 129"/>
              <a:gd name="T32" fmla="*/ 0 w 37"/>
              <a:gd name="T33" fmla="*/ 0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129">
                <a:moveTo>
                  <a:pt x="16" y="126"/>
                </a:moveTo>
                <a:lnTo>
                  <a:pt x="16" y="65"/>
                </a:lnTo>
                <a:lnTo>
                  <a:pt x="16" y="3"/>
                </a:lnTo>
                <a:lnTo>
                  <a:pt x="21" y="3"/>
                </a:lnTo>
                <a:lnTo>
                  <a:pt x="21" y="65"/>
                </a:lnTo>
                <a:lnTo>
                  <a:pt x="21" y="126"/>
                </a:lnTo>
                <a:lnTo>
                  <a:pt x="16" y="126"/>
                </a:lnTo>
                <a:close/>
                <a:moveTo>
                  <a:pt x="0" y="123"/>
                </a:moveTo>
                <a:lnTo>
                  <a:pt x="37" y="123"/>
                </a:lnTo>
                <a:lnTo>
                  <a:pt x="37" y="129"/>
                </a:lnTo>
                <a:lnTo>
                  <a:pt x="0" y="129"/>
                </a:lnTo>
                <a:lnTo>
                  <a:pt x="0" y="123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7" name="Freeform 231"/>
          <p:cNvSpPr>
            <a:spLocks noEditPoints="1"/>
          </p:cNvSpPr>
          <p:nvPr/>
        </p:nvSpPr>
        <p:spPr bwMode="auto">
          <a:xfrm>
            <a:off x="5319113" y="3802139"/>
            <a:ext cx="48818" cy="77299"/>
          </a:xfrm>
          <a:custGeom>
            <a:avLst/>
            <a:gdLst>
              <a:gd name="T0" fmla="*/ 16 w 37"/>
              <a:gd name="T1" fmla="*/ 62 h 65"/>
              <a:gd name="T2" fmla="*/ 16 w 37"/>
              <a:gd name="T3" fmla="*/ 32 h 65"/>
              <a:gd name="T4" fmla="*/ 16 w 37"/>
              <a:gd name="T5" fmla="*/ 3 h 65"/>
              <a:gd name="T6" fmla="*/ 21 w 37"/>
              <a:gd name="T7" fmla="*/ 3 h 65"/>
              <a:gd name="T8" fmla="*/ 21 w 37"/>
              <a:gd name="T9" fmla="*/ 32 h 65"/>
              <a:gd name="T10" fmla="*/ 21 w 37"/>
              <a:gd name="T11" fmla="*/ 62 h 65"/>
              <a:gd name="T12" fmla="*/ 16 w 37"/>
              <a:gd name="T13" fmla="*/ 62 h 65"/>
              <a:gd name="T14" fmla="*/ 0 w 37"/>
              <a:gd name="T15" fmla="*/ 59 h 65"/>
              <a:gd name="T16" fmla="*/ 37 w 37"/>
              <a:gd name="T17" fmla="*/ 59 h 65"/>
              <a:gd name="T18" fmla="*/ 37 w 37"/>
              <a:gd name="T19" fmla="*/ 65 h 65"/>
              <a:gd name="T20" fmla="*/ 0 w 37"/>
              <a:gd name="T21" fmla="*/ 65 h 65"/>
              <a:gd name="T22" fmla="*/ 0 w 37"/>
              <a:gd name="T23" fmla="*/ 59 h 65"/>
              <a:gd name="T24" fmla="*/ 0 w 37"/>
              <a:gd name="T25" fmla="*/ 0 h 65"/>
              <a:gd name="T26" fmla="*/ 37 w 37"/>
              <a:gd name="T27" fmla="*/ 0 h 65"/>
              <a:gd name="T28" fmla="*/ 37 w 37"/>
              <a:gd name="T29" fmla="*/ 6 h 65"/>
              <a:gd name="T30" fmla="*/ 0 w 37"/>
              <a:gd name="T31" fmla="*/ 6 h 65"/>
              <a:gd name="T32" fmla="*/ 0 w 37"/>
              <a:gd name="T33" fmla="*/ 0 h 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65">
                <a:moveTo>
                  <a:pt x="16" y="62"/>
                </a:moveTo>
                <a:lnTo>
                  <a:pt x="16" y="32"/>
                </a:lnTo>
                <a:lnTo>
                  <a:pt x="16" y="3"/>
                </a:lnTo>
                <a:lnTo>
                  <a:pt x="21" y="3"/>
                </a:lnTo>
                <a:lnTo>
                  <a:pt x="21" y="32"/>
                </a:lnTo>
                <a:lnTo>
                  <a:pt x="21" y="62"/>
                </a:lnTo>
                <a:lnTo>
                  <a:pt x="16" y="62"/>
                </a:lnTo>
                <a:close/>
                <a:moveTo>
                  <a:pt x="0" y="59"/>
                </a:moveTo>
                <a:lnTo>
                  <a:pt x="37" y="59"/>
                </a:lnTo>
                <a:lnTo>
                  <a:pt x="37" y="65"/>
                </a:lnTo>
                <a:lnTo>
                  <a:pt x="0" y="65"/>
                </a:lnTo>
                <a:lnTo>
                  <a:pt x="0" y="59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8" name="Freeform 232"/>
          <p:cNvSpPr>
            <a:spLocks noEditPoints="1"/>
          </p:cNvSpPr>
          <p:nvPr/>
        </p:nvSpPr>
        <p:spPr bwMode="auto">
          <a:xfrm>
            <a:off x="5540770" y="3910356"/>
            <a:ext cx="47498" cy="9514"/>
          </a:xfrm>
          <a:custGeom>
            <a:avLst/>
            <a:gdLst>
              <a:gd name="T0" fmla="*/ 16 w 36"/>
              <a:gd name="T1" fmla="*/ 5 h 8"/>
              <a:gd name="T2" fmla="*/ 16 w 36"/>
              <a:gd name="T3" fmla="*/ 4 h 8"/>
              <a:gd name="T4" fmla="*/ 16 w 36"/>
              <a:gd name="T5" fmla="*/ 3 h 8"/>
              <a:gd name="T6" fmla="*/ 21 w 36"/>
              <a:gd name="T7" fmla="*/ 3 h 8"/>
              <a:gd name="T8" fmla="*/ 21 w 36"/>
              <a:gd name="T9" fmla="*/ 4 h 8"/>
              <a:gd name="T10" fmla="*/ 21 w 36"/>
              <a:gd name="T11" fmla="*/ 5 h 8"/>
              <a:gd name="T12" fmla="*/ 16 w 36"/>
              <a:gd name="T13" fmla="*/ 5 h 8"/>
              <a:gd name="T14" fmla="*/ 0 w 36"/>
              <a:gd name="T15" fmla="*/ 2 h 8"/>
              <a:gd name="T16" fmla="*/ 36 w 36"/>
              <a:gd name="T17" fmla="*/ 2 h 8"/>
              <a:gd name="T18" fmla="*/ 36 w 36"/>
              <a:gd name="T19" fmla="*/ 8 h 8"/>
              <a:gd name="T20" fmla="*/ 0 w 36"/>
              <a:gd name="T21" fmla="*/ 8 h 8"/>
              <a:gd name="T22" fmla="*/ 0 w 36"/>
              <a:gd name="T23" fmla="*/ 2 h 8"/>
              <a:gd name="T24" fmla="*/ 0 w 36"/>
              <a:gd name="T25" fmla="*/ 0 h 8"/>
              <a:gd name="T26" fmla="*/ 36 w 36"/>
              <a:gd name="T27" fmla="*/ 0 h 8"/>
              <a:gd name="T28" fmla="*/ 36 w 36"/>
              <a:gd name="T29" fmla="*/ 6 h 8"/>
              <a:gd name="T30" fmla="*/ 0 w 36"/>
              <a:gd name="T31" fmla="*/ 6 h 8"/>
              <a:gd name="T32" fmla="*/ 0 w 36"/>
              <a:gd name="T33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6" h="8">
                <a:moveTo>
                  <a:pt x="16" y="5"/>
                </a:moveTo>
                <a:lnTo>
                  <a:pt x="16" y="4"/>
                </a:lnTo>
                <a:lnTo>
                  <a:pt x="16" y="3"/>
                </a:lnTo>
                <a:lnTo>
                  <a:pt x="21" y="3"/>
                </a:lnTo>
                <a:lnTo>
                  <a:pt x="21" y="4"/>
                </a:lnTo>
                <a:lnTo>
                  <a:pt x="21" y="5"/>
                </a:lnTo>
                <a:lnTo>
                  <a:pt x="16" y="5"/>
                </a:lnTo>
                <a:close/>
                <a:moveTo>
                  <a:pt x="0" y="2"/>
                </a:moveTo>
                <a:lnTo>
                  <a:pt x="36" y="2"/>
                </a:lnTo>
                <a:lnTo>
                  <a:pt x="36" y="8"/>
                </a:lnTo>
                <a:lnTo>
                  <a:pt x="0" y="8"/>
                </a:lnTo>
                <a:lnTo>
                  <a:pt x="0" y="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9" name="Freeform 233"/>
          <p:cNvSpPr>
            <a:spLocks noEditPoints="1"/>
          </p:cNvSpPr>
          <p:nvPr/>
        </p:nvSpPr>
        <p:spPr bwMode="auto">
          <a:xfrm>
            <a:off x="5982764" y="3598784"/>
            <a:ext cx="48818" cy="79677"/>
          </a:xfrm>
          <a:custGeom>
            <a:avLst/>
            <a:gdLst>
              <a:gd name="T0" fmla="*/ 16 w 37"/>
              <a:gd name="T1" fmla="*/ 64 h 67"/>
              <a:gd name="T2" fmla="*/ 16 w 37"/>
              <a:gd name="T3" fmla="*/ 34 h 67"/>
              <a:gd name="T4" fmla="*/ 16 w 37"/>
              <a:gd name="T5" fmla="*/ 3 h 67"/>
              <a:gd name="T6" fmla="*/ 21 w 37"/>
              <a:gd name="T7" fmla="*/ 3 h 67"/>
              <a:gd name="T8" fmla="*/ 21 w 37"/>
              <a:gd name="T9" fmla="*/ 34 h 67"/>
              <a:gd name="T10" fmla="*/ 21 w 37"/>
              <a:gd name="T11" fmla="*/ 64 h 67"/>
              <a:gd name="T12" fmla="*/ 16 w 37"/>
              <a:gd name="T13" fmla="*/ 64 h 67"/>
              <a:gd name="T14" fmla="*/ 0 w 37"/>
              <a:gd name="T15" fmla="*/ 61 h 67"/>
              <a:gd name="T16" fmla="*/ 37 w 37"/>
              <a:gd name="T17" fmla="*/ 61 h 67"/>
              <a:gd name="T18" fmla="*/ 37 w 37"/>
              <a:gd name="T19" fmla="*/ 67 h 67"/>
              <a:gd name="T20" fmla="*/ 0 w 37"/>
              <a:gd name="T21" fmla="*/ 67 h 67"/>
              <a:gd name="T22" fmla="*/ 0 w 37"/>
              <a:gd name="T23" fmla="*/ 61 h 67"/>
              <a:gd name="T24" fmla="*/ 0 w 37"/>
              <a:gd name="T25" fmla="*/ 0 h 67"/>
              <a:gd name="T26" fmla="*/ 37 w 37"/>
              <a:gd name="T27" fmla="*/ 0 h 67"/>
              <a:gd name="T28" fmla="*/ 37 w 37"/>
              <a:gd name="T29" fmla="*/ 6 h 67"/>
              <a:gd name="T30" fmla="*/ 0 w 37"/>
              <a:gd name="T31" fmla="*/ 6 h 67"/>
              <a:gd name="T32" fmla="*/ 0 w 37"/>
              <a:gd name="T33" fmla="*/ 0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7" h="67">
                <a:moveTo>
                  <a:pt x="16" y="64"/>
                </a:moveTo>
                <a:lnTo>
                  <a:pt x="16" y="34"/>
                </a:lnTo>
                <a:lnTo>
                  <a:pt x="16" y="3"/>
                </a:lnTo>
                <a:lnTo>
                  <a:pt x="21" y="3"/>
                </a:lnTo>
                <a:lnTo>
                  <a:pt x="21" y="34"/>
                </a:lnTo>
                <a:lnTo>
                  <a:pt x="21" y="64"/>
                </a:lnTo>
                <a:lnTo>
                  <a:pt x="16" y="64"/>
                </a:lnTo>
                <a:close/>
                <a:moveTo>
                  <a:pt x="0" y="61"/>
                </a:moveTo>
                <a:lnTo>
                  <a:pt x="37" y="61"/>
                </a:lnTo>
                <a:lnTo>
                  <a:pt x="37" y="67"/>
                </a:lnTo>
                <a:lnTo>
                  <a:pt x="0" y="67"/>
                </a:lnTo>
                <a:lnTo>
                  <a:pt x="0" y="61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1" name="Freeform 235"/>
          <p:cNvSpPr>
            <a:spLocks noEditPoints="1"/>
          </p:cNvSpPr>
          <p:nvPr/>
        </p:nvSpPr>
        <p:spPr bwMode="auto">
          <a:xfrm>
            <a:off x="1184155" y="2376277"/>
            <a:ext cx="34304" cy="1951492"/>
          </a:xfrm>
          <a:custGeom>
            <a:avLst/>
            <a:gdLst>
              <a:gd name="T0" fmla="*/ 0 w 26"/>
              <a:gd name="T1" fmla="*/ 1639 h 1641"/>
              <a:gd name="T2" fmla="*/ 26 w 26"/>
              <a:gd name="T3" fmla="*/ 1639 h 1641"/>
              <a:gd name="T4" fmla="*/ 26 w 26"/>
              <a:gd name="T5" fmla="*/ 1641 h 1641"/>
              <a:gd name="T6" fmla="*/ 0 w 26"/>
              <a:gd name="T7" fmla="*/ 1641 h 1641"/>
              <a:gd name="T8" fmla="*/ 0 w 26"/>
              <a:gd name="T9" fmla="*/ 1639 h 1641"/>
              <a:gd name="T10" fmla="*/ 0 w 26"/>
              <a:gd name="T11" fmla="*/ 1366 h 1641"/>
              <a:gd name="T12" fmla="*/ 26 w 26"/>
              <a:gd name="T13" fmla="*/ 1366 h 1641"/>
              <a:gd name="T14" fmla="*/ 26 w 26"/>
              <a:gd name="T15" fmla="*/ 1368 h 1641"/>
              <a:gd name="T16" fmla="*/ 0 w 26"/>
              <a:gd name="T17" fmla="*/ 1368 h 1641"/>
              <a:gd name="T18" fmla="*/ 0 w 26"/>
              <a:gd name="T19" fmla="*/ 1366 h 1641"/>
              <a:gd name="T20" fmla="*/ 0 w 26"/>
              <a:gd name="T21" fmla="*/ 1093 h 1641"/>
              <a:gd name="T22" fmla="*/ 26 w 26"/>
              <a:gd name="T23" fmla="*/ 1093 h 1641"/>
              <a:gd name="T24" fmla="*/ 26 w 26"/>
              <a:gd name="T25" fmla="*/ 1095 h 1641"/>
              <a:gd name="T26" fmla="*/ 0 w 26"/>
              <a:gd name="T27" fmla="*/ 1095 h 1641"/>
              <a:gd name="T28" fmla="*/ 0 w 26"/>
              <a:gd name="T29" fmla="*/ 1093 h 1641"/>
              <a:gd name="T30" fmla="*/ 0 w 26"/>
              <a:gd name="T31" fmla="*/ 820 h 1641"/>
              <a:gd name="T32" fmla="*/ 26 w 26"/>
              <a:gd name="T33" fmla="*/ 820 h 1641"/>
              <a:gd name="T34" fmla="*/ 26 w 26"/>
              <a:gd name="T35" fmla="*/ 822 h 1641"/>
              <a:gd name="T36" fmla="*/ 0 w 26"/>
              <a:gd name="T37" fmla="*/ 822 h 1641"/>
              <a:gd name="T38" fmla="*/ 0 w 26"/>
              <a:gd name="T39" fmla="*/ 820 h 1641"/>
              <a:gd name="T40" fmla="*/ 0 w 26"/>
              <a:gd name="T41" fmla="*/ 546 h 1641"/>
              <a:gd name="T42" fmla="*/ 26 w 26"/>
              <a:gd name="T43" fmla="*/ 546 h 1641"/>
              <a:gd name="T44" fmla="*/ 26 w 26"/>
              <a:gd name="T45" fmla="*/ 548 h 1641"/>
              <a:gd name="T46" fmla="*/ 0 w 26"/>
              <a:gd name="T47" fmla="*/ 548 h 1641"/>
              <a:gd name="T48" fmla="*/ 0 w 26"/>
              <a:gd name="T49" fmla="*/ 546 h 1641"/>
              <a:gd name="T50" fmla="*/ 0 w 26"/>
              <a:gd name="T51" fmla="*/ 274 h 1641"/>
              <a:gd name="T52" fmla="*/ 26 w 26"/>
              <a:gd name="T53" fmla="*/ 274 h 1641"/>
              <a:gd name="T54" fmla="*/ 26 w 26"/>
              <a:gd name="T55" fmla="*/ 275 h 1641"/>
              <a:gd name="T56" fmla="*/ 0 w 26"/>
              <a:gd name="T57" fmla="*/ 275 h 1641"/>
              <a:gd name="T58" fmla="*/ 0 w 26"/>
              <a:gd name="T59" fmla="*/ 274 h 1641"/>
              <a:gd name="T60" fmla="*/ 0 w 26"/>
              <a:gd name="T61" fmla="*/ 0 h 1641"/>
              <a:gd name="T62" fmla="*/ 26 w 26"/>
              <a:gd name="T63" fmla="*/ 0 h 1641"/>
              <a:gd name="T64" fmla="*/ 26 w 26"/>
              <a:gd name="T65" fmla="*/ 2 h 1641"/>
              <a:gd name="T66" fmla="*/ 0 w 26"/>
              <a:gd name="T67" fmla="*/ 2 h 1641"/>
              <a:gd name="T68" fmla="*/ 0 w 26"/>
              <a:gd name="T69" fmla="*/ 0 h 16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26" h="1641">
                <a:moveTo>
                  <a:pt x="0" y="1639"/>
                </a:moveTo>
                <a:lnTo>
                  <a:pt x="26" y="1639"/>
                </a:lnTo>
                <a:lnTo>
                  <a:pt x="26" y="1641"/>
                </a:lnTo>
                <a:lnTo>
                  <a:pt x="0" y="1641"/>
                </a:lnTo>
                <a:lnTo>
                  <a:pt x="0" y="1639"/>
                </a:lnTo>
                <a:close/>
                <a:moveTo>
                  <a:pt x="0" y="1366"/>
                </a:moveTo>
                <a:lnTo>
                  <a:pt x="26" y="1366"/>
                </a:lnTo>
                <a:lnTo>
                  <a:pt x="26" y="1368"/>
                </a:lnTo>
                <a:lnTo>
                  <a:pt x="0" y="1368"/>
                </a:lnTo>
                <a:lnTo>
                  <a:pt x="0" y="1366"/>
                </a:lnTo>
                <a:close/>
                <a:moveTo>
                  <a:pt x="0" y="1093"/>
                </a:moveTo>
                <a:lnTo>
                  <a:pt x="26" y="1093"/>
                </a:lnTo>
                <a:lnTo>
                  <a:pt x="26" y="1095"/>
                </a:lnTo>
                <a:lnTo>
                  <a:pt x="0" y="1095"/>
                </a:lnTo>
                <a:lnTo>
                  <a:pt x="0" y="1093"/>
                </a:lnTo>
                <a:close/>
                <a:moveTo>
                  <a:pt x="0" y="820"/>
                </a:moveTo>
                <a:lnTo>
                  <a:pt x="26" y="820"/>
                </a:lnTo>
                <a:lnTo>
                  <a:pt x="26" y="822"/>
                </a:lnTo>
                <a:lnTo>
                  <a:pt x="0" y="822"/>
                </a:lnTo>
                <a:lnTo>
                  <a:pt x="0" y="820"/>
                </a:lnTo>
                <a:close/>
                <a:moveTo>
                  <a:pt x="0" y="546"/>
                </a:moveTo>
                <a:lnTo>
                  <a:pt x="26" y="546"/>
                </a:lnTo>
                <a:lnTo>
                  <a:pt x="26" y="548"/>
                </a:lnTo>
                <a:lnTo>
                  <a:pt x="0" y="548"/>
                </a:lnTo>
                <a:lnTo>
                  <a:pt x="0" y="546"/>
                </a:lnTo>
                <a:close/>
                <a:moveTo>
                  <a:pt x="0" y="274"/>
                </a:moveTo>
                <a:lnTo>
                  <a:pt x="26" y="274"/>
                </a:lnTo>
                <a:lnTo>
                  <a:pt x="26" y="275"/>
                </a:lnTo>
                <a:lnTo>
                  <a:pt x="0" y="275"/>
                </a:lnTo>
                <a:lnTo>
                  <a:pt x="0" y="274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3" name="Freeform 237"/>
          <p:cNvSpPr>
            <a:spLocks noEditPoints="1"/>
          </p:cNvSpPr>
          <p:nvPr/>
        </p:nvSpPr>
        <p:spPr bwMode="auto">
          <a:xfrm>
            <a:off x="1217139" y="4326579"/>
            <a:ext cx="4869857" cy="29731"/>
          </a:xfrm>
          <a:custGeom>
            <a:avLst/>
            <a:gdLst>
              <a:gd name="T0" fmla="*/ 2 w 3691"/>
              <a:gd name="T1" fmla="*/ 25 h 25"/>
              <a:gd name="T2" fmla="*/ 0 w 3691"/>
              <a:gd name="T3" fmla="*/ 0 h 25"/>
              <a:gd name="T4" fmla="*/ 169 w 3691"/>
              <a:gd name="T5" fmla="*/ 0 h 25"/>
              <a:gd name="T6" fmla="*/ 167 w 3691"/>
              <a:gd name="T7" fmla="*/ 25 h 25"/>
              <a:gd name="T8" fmla="*/ 169 w 3691"/>
              <a:gd name="T9" fmla="*/ 0 h 25"/>
              <a:gd name="T10" fmla="*/ 337 w 3691"/>
              <a:gd name="T11" fmla="*/ 25 h 25"/>
              <a:gd name="T12" fmla="*/ 335 w 3691"/>
              <a:gd name="T13" fmla="*/ 0 h 25"/>
              <a:gd name="T14" fmla="*/ 505 w 3691"/>
              <a:gd name="T15" fmla="*/ 0 h 25"/>
              <a:gd name="T16" fmla="*/ 503 w 3691"/>
              <a:gd name="T17" fmla="*/ 25 h 25"/>
              <a:gd name="T18" fmla="*/ 505 w 3691"/>
              <a:gd name="T19" fmla="*/ 0 h 25"/>
              <a:gd name="T20" fmla="*/ 672 w 3691"/>
              <a:gd name="T21" fmla="*/ 25 h 25"/>
              <a:gd name="T22" fmla="*/ 670 w 3691"/>
              <a:gd name="T23" fmla="*/ 0 h 25"/>
              <a:gd name="T24" fmla="*/ 840 w 3691"/>
              <a:gd name="T25" fmla="*/ 0 h 25"/>
              <a:gd name="T26" fmla="*/ 838 w 3691"/>
              <a:gd name="T27" fmla="*/ 25 h 25"/>
              <a:gd name="T28" fmla="*/ 840 w 3691"/>
              <a:gd name="T29" fmla="*/ 0 h 25"/>
              <a:gd name="T30" fmla="*/ 1008 w 3691"/>
              <a:gd name="T31" fmla="*/ 25 h 25"/>
              <a:gd name="T32" fmla="*/ 1006 w 3691"/>
              <a:gd name="T33" fmla="*/ 0 h 25"/>
              <a:gd name="T34" fmla="*/ 1176 w 3691"/>
              <a:gd name="T35" fmla="*/ 0 h 25"/>
              <a:gd name="T36" fmla="*/ 1174 w 3691"/>
              <a:gd name="T37" fmla="*/ 25 h 25"/>
              <a:gd name="T38" fmla="*/ 1176 w 3691"/>
              <a:gd name="T39" fmla="*/ 0 h 25"/>
              <a:gd name="T40" fmla="*/ 1343 w 3691"/>
              <a:gd name="T41" fmla="*/ 25 h 25"/>
              <a:gd name="T42" fmla="*/ 1341 w 3691"/>
              <a:gd name="T43" fmla="*/ 0 h 25"/>
              <a:gd name="T44" fmla="*/ 1511 w 3691"/>
              <a:gd name="T45" fmla="*/ 0 h 25"/>
              <a:gd name="T46" fmla="*/ 1509 w 3691"/>
              <a:gd name="T47" fmla="*/ 25 h 25"/>
              <a:gd name="T48" fmla="*/ 1511 w 3691"/>
              <a:gd name="T49" fmla="*/ 0 h 25"/>
              <a:gd name="T50" fmla="*/ 1679 w 3691"/>
              <a:gd name="T51" fmla="*/ 25 h 25"/>
              <a:gd name="T52" fmla="*/ 1677 w 3691"/>
              <a:gd name="T53" fmla="*/ 0 h 25"/>
              <a:gd name="T54" fmla="*/ 1846 w 3691"/>
              <a:gd name="T55" fmla="*/ 0 h 25"/>
              <a:gd name="T56" fmla="*/ 1844 w 3691"/>
              <a:gd name="T57" fmla="*/ 25 h 25"/>
              <a:gd name="T58" fmla="*/ 1846 w 3691"/>
              <a:gd name="T59" fmla="*/ 0 h 25"/>
              <a:gd name="T60" fmla="*/ 2014 w 3691"/>
              <a:gd name="T61" fmla="*/ 25 h 25"/>
              <a:gd name="T62" fmla="*/ 2012 w 3691"/>
              <a:gd name="T63" fmla="*/ 0 h 25"/>
              <a:gd name="T64" fmla="*/ 2182 w 3691"/>
              <a:gd name="T65" fmla="*/ 0 h 25"/>
              <a:gd name="T66" fmla="*/ 2180 w 3691"/>
              <a:gd name="T67" fmla="*/ 25 h 25"/>
              <a:gd name="T68" fmla="*/ 2182 w 3691"/>
              <a:gd name="T69" fmla="*/ 0 h 25"/>
              <a:gd name="T70" fmla="*/ 2350 w 3691"/>
              <a:gd name="T71" fmla="*/ 25 h 25"/>
              <a:gd name="T72" fmla="*/ 2348 w 3691"/>
              <a:gd name="T73" fmla="*/ 0 h 25"/>
              <a:gd name="T74" fmla="*/ 2517 w 3691"/>
              <a:gd name="T75" fmla="*/ 0 h 25"/>
              <a:gd name="T76" fmla="*/ 2515 w 3691"/>
              <a:gd name="T77" fmla="*/ 25 h 25"/>
              <a:gd name="T78" fmla="*/ 2517 w 3691"/>
              <a:gd name="T79" fmla="*/ 0 h 25"/>
              <a:gd name="T80" fmla="*/ 2685 w 3691"/>
              <a:gd name="T81" fmla="*/ 25 h 25"/>
              <a:gd name="T82" fmla="*/ 2683 w 3691"/>
              <a:gd name="T83" fmla="*/ 0 h 25"/>
              <a:gd name="T84" fmla="*/ 2853 w 3691"/>
              <a:gd name="T85" fmla="*/ 0 h 25"/>
              <a:gd name="T86" fmla="*/ 2851 w 3691"/>
              <a:gd name="T87" fmla="*/ 25 h 25"/>
              <a:gd name="T88" fmla="*/ 2853 w 3691"/>
              <a:gd name="T89" fmla="*/ 0 h 25"/>
              <a:gd name="T90" fmla="*/ 3020 w 3691"/>
              <a:gd name="T91" fmla="*/ 25 h 25"/>
              <a:gd name="T92" fmla="*/ 3018 w 3691"/>
              <a:gd name="T93" fmla="*/ 0 h 25"/>
              <a:gd name="T94" fmla="*/ 3188 w 3691"/>
              <a:gd name="T95" fmla="*/ 0 h 25"/>
              <a:gd name="T96" fmla="*/ 3186 w 3691"/>
              <a:gd name="T97" fmla="*/ 25 h 25"/>
              <a:gd name="T98" fmla="*/ 3188 w 3691"/>
              <a:gd name="T99" fmla="*/ 0 h 25"/>
              <a:gd name="T100" fmla="*/ 3356 w 3691"/>
              <a:gd name="T101" fmla="*/ 25 h 25"/>
              <a:gd name="T102" fmla="*/ 3354 w 3691"/>
              <a:gd name="T103" fmla="*/ 0 h 25"/>
              <a:gd name="T104" fmla="*/ 3524 w 3691"/>
              <a:gd name="T105" fmla="*/ 0 h 25"/>
              <a:gd name="T106" fmla="*/ 3522 w 3691"/>
              <a:gd name="T107" fmla="*/ 25 h 25"/>
              <a:gd name="T108" fmla="*/ 3524 w 3691"/>
              <a:gd name="T109" fmla="*/ 0 h 25"/>
              <a:gd name="T110" fmla="*/ 3691 w 3691"/>
              <a:gd name="T111" fmla="*/ 25 h 25"/>
              <a:gd name="T112" fmla="*/ 3689 w 3691"/>
              <a:gd name="T113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3691" h="25">
                <a:moveTo>
                  <a:pt x="2" y="0"/>
                </a:moveTo>
                <a:lnTo>
                  <a:pt x="2" y="25"/>
                </a:lnTo>
                <a:lnTo>
                  <a:pt x="0" y="25"/>
                </a:lnTo>
                <a:lnTo>
                  <a:pt x="0" y="0"/>
                </a:lnTo>
                <a:lnTo>
                  <a:pt x="2" y="0"/>
                </a:lnTo>
                <a:close/>
                <a:moveTo>
                  <a:pt x="169" y="0"/>
                </a:moveTo>
                <a:lnTo>
                  <a:pt x="169" y="25"/>
                </a:lnTo>
                <a:lnTo>
                  <a:pt x="167" y="25"/>
                </a:lnTo>
                <a:lnTo>
                  <a:pt x="167" y="0"/>
                </a:lnTo>
                <a:lnTo>
                  <a:pt x="169" y="0"/>
                </a:lnTo>
                <a:close/>
                <a:moveTo>
                  <a:pt x="337" y="0"/>
                </a:moveTo>
                <a:lnTo>
                  <a:pt x="337" y="25"/>
                </a:lnTo>
                <a:lnTo>
                  <a:pt x="335" y="25"/>
                </a:lnTo>
                <a:lnTo>
                  <a:pt x="335" y="0"/>
                </a:lnTo>
                <a:lnTo>
                  <a:pt x="337" y="0"/>
                </a:lnTo>
                <a:close/>
                <a:moveTo>
                  <a:pt x="505" y="0"/>
                </a:moveTo>
                <a:lnTo>
                  <a:pt x="505" y="25"/>
                </a:lnTo>
                <a:lnTo>
                  <a:pt x="503" y="25"/>
                </a:lnTo>
                <a:lnTo>
                  <a:pt x="503" y="0"/>
                </a:lnTo>
                <a:lnTo>
                  <a:pt x="505" y="0"/>
                </a:lnTo>
                <a:close/>
                <a:moveTo>
                  <a:pt x="672" y="0"/>
                </a:moveTo>
                <a:lnTo>
                  <a:pt x="672" y="25"/>
                </a:lnTo>
                <a:lnTo>
                  <a:pt x="670" y="25"/>
                </a:lnTo>
                <a:lnTo>
                  <a:pt x="670" y="0"/>
                </a:lnTo>
                <a:lnTo>
                  <a:pt x="672" y="0"/>
                </a:lnTo>
                <a:close/>
                <a:moveTo>
                  <a:pt x="840" y="0"/>
                </a:moveTo>
                <a:lnTo>
                  <a:pt x="840" y="25"/>
                </a:lnTo>
                <a:lnTo>
                  <a:pt x="838" y="25"/>
                </a:lnTo>
                <a:lnTo>
                  <a:pt x="838" y="0"/>
                </a:lnTo>
                <a:lnTo>
                  <a:pt x="840" y="0"/>
                </a:lnTo>
                <a:close/>
                <a:moveTo>
                  <a:pt x="1008" y="0"/>
                </a:moveTo>
                <a:lnTo>
                  <a:pt x="1008" y="25"/>
                </a:lnTo>
                <a:lnTo>
                  <a:pt x="1006" y="25"/>
                </a:lnTo>
                <a:lnTo>
                  <a:pt x="1006" y="0"/>
                </a:lnTo>
                <a:lnTo>
                  <a:pt x="1008" y="0"/>
                </a:lnTo>
                <a:close/>
                <a:moveTo>
                  <a:pt x="1176" y="0"/>
                </a:moveTo>
                <a:lnTo>
                  <a:pt x="1176" y="25"/>
                </a:lnTo>
                <a:lnTo>
                  <a:pt x="1174" y="25"/>
                </a:lnTo>
                <a:lnTo>
                  <a:pt x="1174" y="0"/>
                </a:lnTo>
                <a:lnTo>
                  <a:pt x="1176" y="0"/>
                </a:lnTo>
                <a:close/>
                <a:moveTo>
                  <a:pt x="1343" y="0"/>
                </a:moveTo>
                <a:lnTo>
                  <a:pt x="1343" y="25"/>
                </a:lnTo>
                <a:lnTo>
                  <a:pt x="1341" y="25"/>
                </a:lnTo>
                <a:lnTo>
                  <a:pt x="1341" y="0"/>
                </a:lnTo>
                <a:lnTo>
                  <a:pt x="1343" y="0"/>
                </a:lnTo>
                <a:close/>
                <a:moveTo>
                  <a:pt x="1511" y="0"/>
                </a:moveTo>
                <a:lnTo>
                  <a:pt x="1511" y="25"/>
                </a:lnTo>
                <a:lnTo>
                  <a:pt x="1509" y="25"/>
                </a:lnTo>
                <a:lnTo>
                  <a:pt x="1509" y="0"/>
                </a:lnTo>
                <a:lnTo>
                  <a:pt x="1511" y="0"/>
                </a:lnTo>
                <a:close/>
                <a:moveTo>
                  <a:pt x="1679" y="0"/>
                </a:moveTo>
                <a:lnTo>
                  <a:pt x="1679" y="25"/>
                </a:lnTo>
                <a:lnTo>
                  <a:pt x="1677" y="25"/>
                </a:lnTo>
                <a:lnTo>
                  <a:pt x="1677" y="0"/>
                </a:lnTo>
                <a:lnTo>
                  <a:pt x="1679" y="0"/>
                </a:lnTo>
                <a:close/>
                <a:moveTo>
                  <a:pt x="1846" y="0"/>
                </a:moveTo>
                <a:lnTo>
                  <a:pt x="1846" y="25"/>
                </a:lnTo>
                <a:lnTo>
                  <a:pt x="1844" y="25"/>
                </a:lnTo>
                <a:lnTo>
                  <a:pt x="1844" y="0"/>
                </a:lnTo>
                <a:lnTo>
                  <a:pt x="1846" y="0"/>
                </a:lnTo>
                <a:close/>
                <a:moveTo>
                  <a:pt x="2014" y="0"/>
                </a:moveTo>
                <a:lnTo>
                  <a:pt x="2014" y="25"/>
                </a:lnTo>
                <a:lnTo>
                  <a:pt x="2012" y="25"/>
                </a:lnTo>
                <a:lnTo>
                  <a:pt x="2012" y="0"/>
                </a:lnTo>
                <a:lnTo>
                  <a:pt x="2014" y="0"/>
                </a:lnTo>
                <a:close/>
                <a:moveTo>
                  <a:pt x="2182" y="0"/>
                </a:moveTo>
                <a:lnTo>
                  <a:pt x="2182" y="25"/>
                </a:lnTo>
                <a:lnTo>
                  <a:pt x="2180" y="25"/>
                </a:lnTo>
                <a:lnTo>
                  <a:pt x="2180" y="0"/>
                </a:lnTo>
                <a:lnTo>
                  <a:pt x="2182" y="0"/>
                </a:lnTo>
                <a:close/>
                <a:moveTo>
                  <a:pt x="2350" y="0"/>
                </a:moveTo>
                <a:lnTo>
                  <a:pt x="2350" y="25"/>
                </a:lnTo>
                <a:lnTo>
                  <a:pt x="2348" y="25"/>
                </a:lnTo>
                <a:lnTo>
                  <a:pt x="2348" y="0"/>
                </a:lnTo>
                <a:lnTo>
                  <a:pt x="2350" y="0"/>
                </a:lnTo>
                <a:close/>
                <a:moveTo>
                  <a:pt x="2517" y="0"/>
                </a:moveTo>
                <a:lnTo>
                  <a:pt x="2517" y="25"/>
                </a:lnTo>
                <a:lnTo>
                  <a:pt x="2515" y="25"/>
                </a:lnTo>
                <a:lnTo>
                  <a:pt x="2515" y="0"/>
                </a:lnTo>
                <a:lnTo>
                  <a:pt x="2517" y="0"/>
                </a:lnTo>
                <a:close/>
                <a:moveTo>
                  <a:pt x="2685" y="0"/>
                </a:moveTo>
                <a:lnTo>
                  <a:pt x="2685" y="25"/>
                </a:lnTo>
                <a:lnTo>
                  <a:pt x="2683" y="25"/>
                </a:lnTo>
                <a:lnTo>
                  <a:pt x="2683" y="0"/>
                </a:lnTo>
                <a:lnTo>
                  <a:pt x="2685" y="0"/>
                </a:lnTo>
                <a:close/>
                <a:moveTo>
                  <a:pt x="2853" y="0"/>
                </a:moveTo>
                <a:lnTo>
                  <a:pt x="2853" y="25"/>
                </a:lnTo>
                <a:lnTo>
                  <a:pt x="2851" y="25"/>
                </a:lnTo>
                <a:lnTo>
                  <a:pt x="2851" y="0"/>
                </a:lnTo>
                <a:lnTo>
                  <a:pt x="2853" y="0"/>
                </a:lnTo>
                <a:close/>
                <a:moveTo>
                  <a:pt x="3020" y="0"/>
                </a:moveTo>
                <a:lnTo>
                  <a:pt x="3020" y="25"/>
                </a:lnTo>
                <a:lnTo>
                  <a:pt x="3018" y="25"/>
                </a:lnTo>
                <a:lnTo>
                  <a:pt x="3018" y="0"/>
                </a:lnTo>
                <a:lnTo>
                  <a:pt x="3020" y="0"/>
                </a:lnTo>
                <a:close/>
                <a:moveTo>
                  <a:pt x="3188" y="0"/>
                </a:moveTo>
                <a:lnTo>
                  <a:pt x="3188" y="25"/>
                </a:lnTo>
                <a:lnTo>
                  <a:pt x="3186" y="25"/>
                </a:lnTo>
                <a:lnTo>
                  <a:pt x="3186" y="0"/>
                </a:lnTo>
                <a:lnTo>
                  <a:pt x="3188" y="0"/>
                </a:lnTo>
                <a:close/>
                <a:moveTo>
                  <a:pt x="3356" y="0"/>
                </a:moveTo>
                <a:lnTo>
                  <a:pt x="3356" y="25"/>
                </a:lnTo>
                <a:lnTo>
                  <a:pt x="3354" y="25"/>
                </a:lnTo>
                <a:lnTo>
                  <a:pt x="3354" y="0"/>
                </a:lnTo>
                <a:lnTo>
                  <a:pt x="3356" y="0"/>
                </a:lnTo>
                <a:close/>
                <a:moveTo>
                  <a:pt x="3524" y="0"/>
                </a:moveTo>
                <a:lnTo>
                  <a:pt x="3524" y="25"/>
                </a:lnTo>
                <a:lnTo>
                  <a:pt x="3522" y="25"/>
                </a:lnTo>
                <a:lnTo>
                  <a:pt x="3522" y="0"/>
                </a:lnTo>
                <a:lnTo>
                  <a:pt x="3524" y="0"/>
                </a:lnTo>
                <a:close/>
                <a:moveTo>
                  <a:pt x="3691" y="0"/>
                </a:moveTo>
                <a:lnTo>
                  <a:pt x="3691" y="25"/>
                </a:lnTo>
                <a:lnTo>
                  <a:pt x="3689" y="25"/>
                </a:lnTo>
                <a:lnTo>
                  <a:pt x="3689" y="0"/>
                </a:lnTo>
                <a:lnTo>
                  <a:pt x="3691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4" name="Grouper 129"/>
          <p:cNvGrpSpPr/>
          <p:nvPr/>
        </p:nvGrpSpPr>
        <p:grpSpPr>
          <a:xfrm>
            <a:off x="935282" y="2291400"/>
            <a:ext cx="192360" cy="2052000"/>
            <a:chOff x="434974" y="2262186"/>
            <a:chExt cx="192360" cy="2786578"/>
          </a:xfrm>
        </p:grpSpPr>
        <p:sp>
          <p:nvSpPr>
            <p:cNvPr id="354" name="Rectangle 238"/>
            <p:cNvSpPr>
              <a:spLocks noChangeArrowheads="1"/>
            </p:cNvSpPr>
            <p:nvPr/>
          </p:nvSpPr>
          <p:spPr bwMode="auto">
            <a:xfrm>
              <a:off x="434974" y="486409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5" name="Rectangle 239"/>
            <p:cNvSpPr>
              <a:spLocks noChangeArrowheads="1"/>
            </p:cNvSpPr>
            <p:nvPr/>
          </p:nvSpPr>
          <p:spPr bwMode="auto">
            <a:xfrm>
              <a:off x="434974" y="442912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5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6" name="Rectangle 240"/>
            <p:cNvSpPr>
              <a:spLocks noChangeArrowheads="1"/>
            </p:cNvSpPr>
            <p:nvPr/>
          </p:nvSpPr>
          <p:spPr bwMode="auto">
            <a:xfrm>
              <a:off x="434974" y="399573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0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7" name="Rectangle 241"/>
            <p:cNvSpPr>
              <a:spLocks noChangeArrowheads="1"/>
            </p:cNvSpPr>
            <p:nvPr/>
          </p:nvSpPr>
          <p:spPr bwMode="auto">
            <a:xfrm>
              <a:off x="434974" y="356234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5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8" name="Rectangle 242"/>
            <p:cNvSpPr>
              <a:spLocks noChangeArrowheads="1"/>
            </p:cNvSpPr>
            <p:nvPr/>
          </p:nvSpPr>
          <p:spPr bwMode="auto">
            <a:xfrm>
              <a:off x="434974" y="312896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59" name="Rectangle 243"/>
            <p:cNvSpPr>
              <a:spLocks noChangeArrowheads="1"/>
            </p:cNvSpPr>
            <p:nvPr/>
          </p:nvSpPr>
          <p:spPr bwMode="auto">
            <a:xfrm>
              <a:off x="434974" y="269557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5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360" name="Rectangle 244"/>
            <p:cNvSpPr>
              <a:spLocks noChangeArrowheads="1"/>
            </p:cNvSpPr>
            <p:nvPr/>
          </p:nvSpPr>
          <p:spPr bwMode="auto">
            <a:xfrm>
              <a:off x="434974" y="226218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sp>
        <p:nvSpPr>
          <p:cNvPr id="361" name="Freeform 245"/>
          <p:cNvSpPr>
            <a:spLocks noEditPoints="1"/>
          </p:cNvSpPr>
          <p:nvPr/>
        </p:nvSpPr>
        <p:spPr bwMode="auto">
          <a:xfrm>
            <a:off x="1010167" y="4418880"/>
            <a:ext cx="301008" cy="341313"/>
          </a:xfrm>
          <a:custGeom>
            <a:avLst/>
            <a:gdLst>
              <a:gd name="T0" fmla="*/ 479 w 1894"/>
              <a:gd name="T1" fmla="*/ 1616 h 1796"/>
              <a:gd name="T2" fmla="*/ 327 w 1894"/>
              <a:gd name="T3" fmla="*/ 1754 h 1796"/>
              <a:gd name="T4" fmla="*/ 297 w 1894"/>
              <a:gd name="T5" fmla="*/ 1795 h 1796"/>
              <a:gd name="T6" fmla="*/ 6 w 1894"/>
              <a:gd name="T7" fmla="*/ 1492 h 1796"/>
              <a:gd name="T8" fmla="*/ 161 w 1894"/>
              <a:gd name="T9" fmla="*/ 1588 h 1796"/>
              <a:gd name="T10" fmla="*/ 190 w 1894"/>
              <a:gd name="T11" fmla="*/ 1307 h 1796"/>
              <a:gd name="T12" fmla="*/ 616 w 1894"/>
              <a:gd name="T13" fmla="*/ 1466 h 1796"/>
              <a:gd name="T14" fmla="*/ 587 w 1894"/>
              <a:gd name="T15" fmla="*/ 1505 h 1796"/>
              <a:gd name="T16" fmla="*/ 374 w 1894"/>
              <a:gd name="T17" fmla="*/ 1281 h 1796"/>
              <a:gd name="T18" fmla="*/ 616 w 1894"/>
              <a:gd name="T19" fmla="*/ 1466 h 1796"/>
              <a:gd name="T20" fmla="*/ 284 w 1894"/>
              <a:gd name="T21" fmla="*/ 1210 h 1796"/>
              <a:gd name="T22" fmla="*/ 785 w 1894"/>
              <a:gd name="T23" fmla="*/ 1282 h 1796"/>
              <a:gd name="T24" fmla="*/ 667 w 1894"/>
              <a:gd name="T25" fmla="*/ 1401 h 1796"/>
              <a:gd name="T26" fmla="*/ 635 w 1894"/>
              <a:gd name="T27" fmla="*/ 1366 h 1796"/>
              <a:gd name="T28" fmla="*/ 737 w 1894"/>
              <a:gd name="T29" fmla="*/ 1288 h 1796"/>
              <a:gd name="T30" fmla="*/ 632 w 1894"/>
              <a:gd name="T31" fmla="*/ 1262 h 1796"/>
              <a:gd name="T32" fmla="*/ 494 w 1894"/>
              <a:gd name="T33" fmla="*/ 1191 h 1796"/>
              <a:gd name="T34" fmla="*/ 596 w 1894"/>
              <a:gd name="T35" fmla="*/ 1080 h 1796"/>
              <a:gd name="T36" fmla="*/ 628 w 1894"/>
              <a:gd name="T37" fmla="*/ 1104 h 1796"/>
              <a:gd name="T38" fmla="*/ 561 w 1894"/>
              <a:gd name="T39" fmla="*/ 1146 h 1796"/>
              <a:gd name="T40" fmla="*/ 595 w 1894"/>
              <a:gd name="T41" fmla="*/ 1223 h 1796"/>
              <a:gd name="T42" fmla="*/ 759 w 1894"/>
              <a:gd name="T43" fmla="*/ 1211 h 1796"/>
              <a:gd name="T44" fmla="*/ 961 w 1894"/>
              <a:gd name="T45" fmla="*/ 1139 h 1796"/>
              <a:gd name="T46" fmla="*/ 700 w 1894"/>
              <a:gd name="T47" fmla="*/ 1020 h 1796"/>
              <a:gd name="T48" fmla="*/ 637 w 1894"/>
              <a:gd name="T49" fmla="*/ 1021 h 1796"/>
              <a:gd name="T50" fmla="*/ 622 w 1894"/>
              <a:gd name="T51" fmla="*/ 923 h 1796"/>
              <a:gd name="T52" fmla="*/ 706 w 1894"/>
              <a:gd name="T53" fmla="*/ 951 h 1796"/>
              <a:gd name="T54" fmla="*/ 793 w 1894"/>
              <a:gd name="T55" fmla="*/ 920 h 1796"/>
              <a:gd name="T56" fmla="*/ 933 w 1894"/>
              <a:gd name="T57" fmla="*/ 1101 h 1796"/>
              <a:gd name="T58" fmla="*/ 957 w 1894"/>
              <a:gd name="T59" fmla="*/ 1081 h 1796"/>
              <a:gd name="T60" fmla="*/ 1056 w 1894"/>
              <a:gd name="T61" fmla="*/ 1040 h 1796"/>
              <a:gd name="T62" fmla="*/ 822 w 1894"/>
              <a:gd name="T63" fmla="*/ 841 h 1796"/>
              <a:gd name="T64" fmla="*/ 858 w 1894"/>
              <a:gd name="T65" fmla="*/ 805 h 1796"/>
              <a:gd name="T66" fmla="*/ 773 w 1894"/>
              <a:gd name="T67" fmla="*/ 793 h 1796"/>
              <a:gd name="T68" fmla="*/ 1314 w 1894"/>
              <a:gd name="T69" fmla="*/ 767 h 1796"/>
              <a:gd name="T70" fmla="*/ 1290 w 1894"/>
              <a:gd name="T71" fmla="*/ 802 h 1796"/>
              <a:gd name="T72" fmla="*/ 1171 w 1894"/>
              <a:gd name="T73" fmla="*/ 913 h 1796"/>
              <a:gd name="T74" fmla="*/ 967 w 1894"/>
              <a:gd name="T75" fmla="*/ 698 h 1796"/>
              <a:gd name="T76" fmla="*/ 970 w 1894"/>
              <a:gd name="T77" fmla="*/ 490 h 1796"/>
              <a:gd name="T78" fmla="*/ 1009 w 1894"/>
              <a:gd name="T79" fmla="*/ 462 h 1796"/>
              <a:gd name="T80" fmla="*/ 1017 w 1894"/>
              <a:gd name="T81" fmla="*/ 746 h 1796"/>
              <a:gd name="T82" fmla="*/ 1193 w 1894"/>
              <a:gd name="T83" fmla="*/ 844 h 1796"/>
              <a:gd name="T84" fmla="*/ 1419 w 1894"/>
              <a:gd name="T85" fmla="*/ 663 h 1796"/>
              <a:gd name="T86" fmla="*/ 1390 w 1894"/>
              <a:gd name="T87" fmla="*/ 702 h 1796"/>
              <a:gd name="T88" fmla="*/ 1178 w 1894"/>
              <a:gd name="T89" fmla="*/ 478 h 1796"/>
              <a:gd name="T90" fmla="*/ 1419 w 1894"/>
              <a:gd name="T91" fmla="*/ 663 h 1796"/>
              <a:gd name="T92" fmla="*/ 1088 w 1894"/>
              <a:gd name="T93" fmla="*/ 406 h 1796"/>
              <a:gd name="T94" fmla="*/ 1673 w 1894"/>
              <a:gd name="T95" fmla="*/ 419 h 1796"/>
              <a:gd name="T96" fmla="*/ 1634 w 1894"/>
              <a:gd name="T97" fmla="*/ 447 h 1796"/>
              <a:gd name="T98" fmla="*/ 1388 w 1894"/>
              <a:gd name="T99" fmla="*/ 346 h 1796"/>
              <a:gd name="T100" fmla="*/ 1520 w 1894"/>
              <a:gd name="T101" fmla="*/ 576 h 1796"/>
              <a:gd name="T102" fmla="*/ 1285 w 1894"/>
              <a:gd name="T103" fmla="*/ 377 h 1796"/>
              <a:gd name="T104" fmla="*/ 1318 w 1894"/>
              <a:gd name="T105" fmla="*/ 345 h 1796"/>
              <a:gd name="T106" fmla="*/ 1465 w 1894"/>
              <a:gd name="T107" fmla="*/ 235 h 1796"/>
              <a:gd name="T108" fmla="*/ 1803 w 1894"/>
              <a:gd name="T109" fmla="*/ 87 h 1796"/>
              <a:gd name="T110" fmla="*/ 1834 w 1894"/>
              <a:gd name="T111" fmla="*/ 202 h 1796"/>
              <a:gd name="T112" fmla="*/ 1876 w 1894"/>
              <a:gd name="T113" fmla="*/ 149 h 1796"/>
              <a:gd name="T114" fmla="*/ 1891 w 1894"/>
              <a:gd name="T115" fmla="*/ 186 h 1796"/>
              <a:gd name="T116" fmla="*/ 1677 w 1894"/>
              <a:gd name="T117" fmla="*/ 298 h 1796"/>
              <a:gd name="T118" fmla="*/ 1655 w 1894"/>
              <a:gd name="T119" fmla="*/ 9 h 1796"/>
              <a:gd name="T120" fmla="*/ 1692 w 1894"/>
              <a:gd name="T121" fmla="*/ 49 h 1796"/>
              <a:gd name="T122" fmla="*/ 1752 w 1894"/>
              <a:gd name="T123" fmla="*/ 83 h 17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894" h="1796">
                <a:moveTo>
                  <a:pt x="501" y="1580"/>
                </a:moveTo>
                <a:cubicBezTo>
                  <a:pt x="503" y="1581"/>
                  <a:pt x="503" y="1582"/>
                  <a:pt x="504" y="1584"/>
                </a:cubicBezTo>
                <a:cubicBezTo>
                  <a:pt x="504" y="1585"/>
                  <a:pt x="504" y="1587"/>
                  <a:pt x="503" y="1589"/>
                </a:cubicBezTo>
                <a:cubicBezTo>
                  <a:pt x="502" y="1591"/>
                  <a:pt x="500" y="1594"/>
                  <a:pt x="498" y="1597"/>
                </a:cubicBezTo>
                <a:cubicBezTo>
                  <a:pt x="496" y="1600"/>
                  <a:pt x="493" y="1603"/>
                  <a:pt x="489" y="1606"/>
                </a:cubicBezTo>
                <a:cubicBezTo>
                  <a:pt x="485" y="1610"/>
                  <a:pt x="482" y="1613"/>
                  <a:pt x="479" y="1616"/>
                </a:cubicBezTo>
                <a:cubicBezTo>
                  <a:pt x="476" y="1618"/>
                  <a:pt x="474" y="1619"/>
                  <a:pt x="472" y="1620"/>
                </a:cubicBezTo>
                <a:cubicBezTo>
                  <a:pt x="470" y="1621"/>
                  <a:pt x="468" y="1621"/>
                  <a:pt x="466" y="1621"/>
                </a:cubicBezTo>
                <a:cubicBezTo>
                  <a:pt x="465" y="1621"/>
                  <a:pt x="463" y="1620"/>
                  <a:pt x="462" y="1619"/>
                </a:cubicBezTo>
                <a:lnTo>
                  <a:pt x="331" y="1487"/>
                </a:lnTo>
                <a:lnTo>
                  <a:pt x="196" y="1622"/>
                </a:lnTo>
                <a:lnTo>
                  <a:pt x="327" y="1754"/>
                </a:lnTo>
                <a:cubicBezTo>
                  <a:pt x="328" y="1755"/>
                  <a:pt x="329" y="1756"/>
                  <a:pt x="329" y="1758"/>
                </a:cubicBezTo>
                <a:cubicBezTo>
                  <a:pt x="330" y="1760"/>
                  <a:pt x="329" y="1761"/>
                  <a:pt x="328" y="1763"/>
                </a:cubicBezTo>
                <a:cubicBezTo>
                  <a:pt x="327" y="1765"/>
                  <a:pt x="326" y="1768"/>
                  <a:pt x="324" y="1771"/>
                </a:cubicBezTo>
                <a:cubicBezTo>
                  <a:pt x="322" y="1774"/>
                  <a:pt x="319" y="1777"/>
                  <a:pt x="315" y="1781"/>
                </a:cubicBezTo>
                <a:cubicBezTo>
                  <a:pt x="311" y="1785"/>
                  <a:pt x="308" y="1788"/>
                  <a:pt x="305" y="1790"/>
                </a:cubicBezTo>
                <a:cubicBezTo>
                  <a:pt x="302" y="1792"/>
                  <a:pt x="299" y="1794"/>
                  <a:pt x="297" y="1795"/>
                </a:cubicBezTo>
                <a:cubicBezTo>
                  <a:pt x="295" y="1796"/>
                  <a:pt x="293" y="1796"/>
                  <a:pt x="292" y="1796"/>
                </a:cubicBezTo>
                <a:cubicBezTo>
                  <a:pt x="290" y="1795"/>
                  <a:pt x="289" y="1795"/>
                  <a:pt x="288" y="1793"/>
                </a:cubicBezTo>
                <a:lnTo>
                  <a:pt x="3" y="1509"/>
                </a:lnTo>
                <a:cubicBezTo>
                  <a:pt x="2" y="1507"/>
                  <a:pt x="1" y="1506"/>
                  <a:pt x="1" y="1504"/>
                </a:cubicBezTo>
                <a:cubicBezTo>
                  <a:pt x="0" y="1503"/>
                  <a:pt x="1" y="1501"/>
                  <a:pt x="2" y="1499"/>
                </a:cubicBezTo>
                <a:cubicBezTo>
                  <a:pt x="3" y="1497"/>
                  <a:pt x="4" y="1494"/>
                  <a:pt x="6" y="1492"/>
                </a:cubicBezTo>
                <a:cubicBezTo>
                  <a:pt x="9" y="1489"/>
                  <a:pt x="12" y="1485"/>
                  <a:pt x="15" y="1482"/>
                </a:cubicBezTo>
                <a:cubicBezTo>
                  <a:pt x="19" y="1478"/>
                  <a:pt x="22" y="1475"/>
                  <a:pt x="25" y="1473"/>
                </a:cubicBezTo>
                <a:cubicBezTo>
                  <a:pt x="28" y="1470"/>
                  <a:pt x="31" y="1469"/>
                  <a:pt x="33" y="1468"/>
                </a:cubicBezTo>
                <a:cubicBezTo>
                  <a:pt x="35" y="1467"/>
                  <a:pt x="37" y="1467"/>
                  <a:pt x="38" y="1467"/>
                </a:cubicBezTo>
                <a:cubicBezTo>
                  <a:pt x="40" y="1467"/>
                  <a:pt x="41" y="1468"/>
                  <a:pt x="42" y="1469"/>
                </a:cubicBezTo>
                <a:lnTo>
                  <a:pt x="161" y="1588"/>
                </a:lnTo>
                <a:lnTo>
                  <a:pt x="296" y="1453"/>
                </a:lnTo>
                <a:lnTo>
                  <a:pt x="177" y="1334"/>
                </a:lnTo>
                <a:cubicBezTo>
                  <a:pt x="176" y="1333"/>
                  <a:pt x="175" y="1332"/>
                  <a:pt x="175" y="1330"/>
                </a:cubicBezTo>
                <a:cubicBezTo>
                  <a:pt x="175" y="1328"/>
                  <a:pt x="175" y="1327"/>
                  <a:pt x="176" y="1325"/>
                </a:cubicBezTo>
                <a:cubicBezTo>
                  <a:pt x="177" y="1323"/>
                  <a:pt x="179" y="1320"/>
                  <a:pt x="181" y="1317"/>
                </a:cubicBezTo>
                <a:cubicBezTo>
                  <a:pt x="183" y="1314"/>
                  <a:pt x="186" y="1311"/>
                  <a:pt x="190" y="1307"/>
                </a:cubicBezTo>
                <a:cubicBezTo>
                  <a:pt x="193" y="1303"/>
                  <a:pt x="197" y="1300"/>
                  <a:pt x="200" y="1298"/>
                </a:cubicBezTo>
                <a:cubicBezTo>
                  <a:pt x="203" y="1296"/>
                  <a:pt x="205" y="1295"/>
                  <a:pt x="207" y="1294"/>
                </a:cubicBezTo>
                <a:cubicBezTo>
                  <a:pt x="209" y="1293"/>
                  <a:pt x="211" y="1292"/>
                  <a:pt x="212" y="1293"/>
                </a:cubicBezTo>
                <a:cubicBezTo>
                  <a:pt x="214" y="1293"/>
                  <a:pt x="215" y="1294"/>
                  <a:pt x="217" y="1295"/>
                </a:cubicBezTo>
                <a:lnTo>
                  <a:pt x="501" y="1580"/>
                </a:lnTo>
                <a:close/>
                <a:moveTo>
                  <a:pt x="616" y="1466"/>
                </a:moveTo>
                <a:cubicBezTo>
                  <a:pt x="617" y="1467"/>
                  <a:pt x="617" y="1468"/>
                  <a:pt x="618" y="1470"/>
                </a:cubicBezTo>
                <a:cubicBezTo>
                  <a:pt x="618" y="1471"/>
                  <a:pt x="618" y="1473"/>
                  <a:pt x="617" y="1475"/>
                </a:cubicBezTo>
                <a:cubicBezTo>
                  <a:pt x="616" y="1477"/>
                  <a:pt x="615" y="1479"/>
                  <a:pt x="613" y="1482"/>
                </a:cubicBezTo>
                <a:cubicBezTo>
                  <a:pt x="610" y="1485"/>
                  <a:pt x="607" y="1488"/>
                  <a:pt x="604" y="1492"/>
                </a:cubicBezTo>
                <a:cubicBezTo>
                  <a:pt x="600" y="1496"/>
                  <a:pt x="597" y="1499"/>
                  <a:pt x="594" y="1501"/>
                </a:cubicBezTo>
                <a:cubicBezTo>
                  <a:pt x="591" y="1503"/>
                  <a:pt x="589" y="1504"/>
                  <a:pt x="587" y="1505"/>
                </a:cubicBezTo>
                <a:cubicBezTo>
                  <a:pt x="585" y="1506"/>
                  <a:pt x="583" y="1506"/>
                  <a:pt x="582" y="1506"/>
                </a:cubicBezTo>
                <a:cubicBezTo>
                  <a:pt x="580" y="1506"/>
                  <a:pt x="579" y="1505"/>
                  <a:pt x="578" y="1504"/>
                </a:cubicBezTo>
                <a:lnTo>
                  <a:pt x="371" y="1297"/>
                </a:lnTo>
                <a:cubicBezTo>
                  <a:pt x="370" y="1296"/>
                  <a:pt x="370" y="1295"/>
                  <a:pt x="369" y="1294"/>
                </a:cubicBezTo>
                <a:cubicBezTo>
                  <a:pt x="369" y="1292"/>
                  <a:pt x="369" y="1290"/>
                  <a:pt x="370" y="1288"/>
                </a:cubicBezTo>
                <a:cubicBezTo>
                  <a:pt x="371" y="1286"/>
                  <a:pt x="372" y="1284"/>
                  <a:pt x="374" y="1281"/>
                </a:cubicBezTo>
                <a:cubicBezTo>
                  <a:pt x="376" y="1278"/>
                  <a:pt x="379" y="1275"/>
                  <a:pt x="383" y="1272"/>
                </a:cubicBezTo>
                <a:cubicBezTo>
                  <a:pt x="387" y="1268"/>
                  <a:pt x="390" y="1265"/>
                  <a:pt x="393" y="1263"/>
                </a:cubicBezTo>
                <a:cubicBezTo>
                  <a:pt x="396" y="1260"/>
                  <a:pt x="398" y="1259"/>
                  <a:pt x="400" y="1258"/>
                </a:cubicBezTo>
                <a:cubicBezTo>
                  <a:pt x="402" y="1257"/>
                  <a:pt x="404" y="1257"/>
                  <a:pt x="405" y="1258"/>
                </a:cubicBezTo>
                <a:cubicBezTo>
                  <a:pt x="407" y="1258"/>
                  <a:pt x="408" y="1259"/>
                  <a:pt x="409" y="1260"/>
                </a:cubicBezTo>
                <a:lnTo>
                  <a:pt x="616" y="1466"/>
                </a:lnTo>
                <a:close/>
                <a:moveTo>
                  <a:pt x="344" y="1186"/>
                </a:moveTo>
                <a:cubicBezTo>
                  <a:pt x="353" y="1194"/>
                  <a:pt x="357" y="1202"/>
                  <a:pt x="357" y="1209"/>
                </a:cubicBezTo>
                <a:cubicBezTo>
                  <a:pt x="357" y="1215"/>
                  <a:pt x="352" y="1223"/>
                  <a:pt x="343" y="1232"/>
                </a:cubicBezTo>
                <a:cubicBezTo>
                  <a:pt x="334" y="1241"/>
                  <a:pt x="327" y="1245"/>
                  <a:pt x="320" y="1246"/>
                </a:cubicBezTo>
                <a:cubicBezTo>
                  <a:pt x="314" y="1246"/>
                  <a:pt x="306" y="1241"/>
                  <a:pt x="298" y="1233"/>
                </a:cubicBezTo>
                <a:cubicBezTo>
                  <a:pt x="289" y="1224"/>
                  <a:pt x="284" y="1216"/>
                  <a:pt x="284" y="1210"/>
                </a:cubicBezTo>
                <a:cubicBezTo>
                  <a:pt x="285" y="1203"/>
                  <a:pt x="289" y="1195"/>
                  <a:pt x="298" y="1186"/>
                </a:cubicBezTo>
                <a:cubicBezTo>
                  <a:pt x="307" y="1177"/>
                  <a:pt x="315" y="1173"/>
                  <a:pt x="321" y="1173"/>
                </a:cubicBezTo>
                <a:cubicBezTo>
                  <a:pt x="328" y="1173"/>
                  <a:pt x="335" y="1177"/>
                  <a:pt x="344" y="1186"/>
                </a:cubicBezTo>
                <a:close/>
                <a:moveTo>
                  <a:pt x="759" y="1211"/>
                </a:moveTo>
                <a:cubicBezTo>
                  <a:pt x="769" y="1221"/>
                  <a:pt x="777" y="1232"/>
                  <a:pt x="781" y="1245"/>
                </a:cubicBezTo>
                <a:cubicBezTo>
                  <a:pt x="785" y="1257"/>
                  <a:pt x="787" y="1269"/>
                  <a:pt x="785" y="1282"/>
                </a:cubicBezTo>
                <a:cubicBezTo>
                  <a:pt x="784" y="1295"/>
                  <a:pt x="779" y="1308"/>
                  <a:pt x="772" y="1321"/>
                </a:cubicBezTo>
                <a:cubicBezTo>
                  <a:pt x="765" y="1333"/>
                  <a:pt x="756" y="1346"/>
                  <a:pt x="744" y="1358"/>
                </a:cubicBezTo>
                <a:cubicBezTo>
                  <a:pt x="737" y="1365"/>
                  <a:pt x="729" y="1372"/>
                  <a:pt x="721" y="1377"/>
                </a:cubicBezTo>
                <a:cubicBezTo>
                  <a:pt x="713" y="1383"/>
                  <a:pt x="706" y="1387"/>
                  <a:pt x="699" y="1391"/>
                </a:cubicBezTo>
                <a:cubicBezTo>
                  <a:pt x="692" y="1394"/>
                  <a:pt x="686" y="1397"/>
                  <a:pt x="680" y="1398"/>
                </a:cubicBezTo>
                <a:cubicBezTo>
                  <a:pt x="674" y="1400"/>
                  <a:pt x="670" y="1401"/>
                  <a:pt x="667" y="1401"/>
                </a:cubicBezTo>
                <a:cubicBezTo>
                  <a:pt x="664" y="1401"/>
                  <a:pt x="660" y="1401"/>
                  <a:pt x="657" y="1399"/>
                </a:cubicBezTo>
                <a:cubicBezTo>
                  <a:pt x="653" y="1397"/>
                  <a:pt x="649" y="1393"/>
                  <a:pt x="644" y="1388"/>
                </a:cubicBezTo>
                <a:cubicBezTo>
                  <a:pt x="641" y="1386"/>
                  <a:pt x="639" y="1383"/>
                  <a:pt x="637" y="1381"/>
                </a:cubicBezTo>
                <a:cubicBezTo>
                  <a:pt x="636" y="1378"/>
                  <a:pt x="635" y="1376"/>
                  <a:pt x="634" y="1375"/>
                </a:cubicBezTo>
                <a:cubicBezTo>
                  <a:pt x="633" y="1373"/>
                  <a:pt x="633" y="1372"/>
                  <a:pt x="633" y="1370"/>
                </a:cubicBezTo>
                <a:cubicBezTo>
                  <a:pt x="633" y="1369"/>
                  <a:pt x="634" y="1368"/>
                  <a:pt x="635" y="1366"/>
                </a:cubicBezTo>
                <a:cubicBezTo>
                  <a:pt x="637" y="1365"/>
                  <a:pt x="640" y="1363"/>
                  <a:pt x="646" y="1362"/>
                </a:cubicBezTo>
                <a:cubicBezTo>
                  <a:pt x="651" y="1361"/>
                  <a:pt x="657" y="1359"/>
                  <a:pt x="665" y="1357"/>
                </a:cubicBezTo>
                <a:cubicBezTo>
                  <a:pt x="672" y="1354"/>
                  <a:pt x="680" y="1351"/>
                  <a:pt x="688" y="1346"/>
                </a:cubicBezTo>
                <a:cubicBezTo>
                  <a:pt x="697" y="1342"/>
                  <a:pt x="706" y="1335"/>
                  <a:pt x="714" y="1327"/>
                </a:cubicBezTo>
                <a:cubicBezTo>
                  <a:pt x="721" y="1320"/>
                  <a:pt x="726" y="1314"/>
                  <a:pt x="730" y="1307"/>
                </a:cubicBezTo>
                <a:cubicBezTo>
                  <a:pt x="733" y="1301"/>
                  <a:pt x="736" y="1294"/>
                  <a:pt x="737" y="1288"/>
                </a:cubicBezTo>
                <a:cubicBezTo>
                  <a:pt x="738" y="1281"/>
                  <a:pt x="738" y="1275"/>
                  <a:pt x="736" y="1269"/>
                </a:cubicBezTo>
                <a:cubicBezTo>
                  <a:pt x="734" y="1262"/>
                  <a:pt x="730" y="1257"/>
                  <a:pt x="724" y="1251"/>
                </a:cubicBezTo>
                <a:cubicBezTo>
                  <a:pt x="718" y="1245"/>
                  <a:pt x="712" y="1242"/>
                  <a:pt x="705" y="1241"/>
                </a:cubicBezTo>
                <a:cubicBezTo>
                  <a:pt x="698" y="1240"/>
                  <a:pt x="691" y="1240"/>
                  <a:pt x="683" y="1242"/>
                </a:cubicBezTo>
                <a:cubicBezTo>
                  <a:pt x="675" y="1244"/>
                  <a:pt x="666" y="1247"/>
                  <a:pt x="658" y="1250"/>
                </a:cubicBezTo>
                <a:cubicBezTo>
                  <a:pt x="650" y="1254"/>
                  <a:pt x="641" y="1258"/>
                  <a:pt x="632" y="1262"/>
                </a:cubicBezTo>
                <a:cubicBezTo>
                  <a:pt x="623" y="1266"/>
                  <a:pt x="613" y="1269"/>
                  <a:pt x="604" y="1272"/>
                </a:cubicBezTo>
                <a:cubicBezTo>
                  <a:pt x="594" y="1275"/>
                  <a:pt x="585" y="1276"/>
                  <a:pt x="575" y="1277"/>
                </a:cubicBezTo>
                <a:cubicBezTo>
                  <a:pt x="565" y="1277"/>
                  <a:pt x="556" y="1275"/>
                  <a:pt x="546" y="1271"/>
                </a:cubicBezTo>
                <a:cubicBezTo>
                  <a:pt x="537" y="1268"/>
                  <a:pt x="527" y="1261"/>
                  <a:pt x="518" y="1252"/>
                </a:cubicBezTo>
                <a:cubicBezTo>
                  <a:pt x="510" y="1244"/>
                  <a:pt x="504" y="1235"/>
                  <a:pt x="500" y="1224"/>
                </a:cubicBezTo>
                <a:cubicBezTo>
                  <a:pt x="495" y="1214"/>
                  <a:pt x="494" y="1203"/>
                  <a:pt x="494" y="1191"/>
                </a:cubicBezTo>
                <a:cubicBezTo>
                  <a:pt x="495" y="1179"/>
                  <a:pt x="498" y="1167"/>
                  <a:pt x="504" y="1154"/>
                </a:cubicBezTo>
                <a:cubicBezTo>
                  <a:pt x="510" y="1141"/>
                  <a:pt x="520" y="1128"/>
                  <a:pt x="532" y="1116"/>
                </a:cubicBezTo>
                <a:cubicBezTo>
                  <a:pt x="538" y="1110"/>
                  <a:pt x="544" y="1105"/>
                  <a:pt x="550" y="1101"/>
                </a:cubicBezTo>
                <a:cubicBezTo>
                  <a:pt x="557" y="1096"/>
                  <a:pt x="563" y="1092"/>
                  <a:pt x="568" y="1089"/>
                </a:cubicBezTo>
                <a:cubicBezTo>
                  <a:pt x="574" y="1086"/>
                  <a:pt x="580" y="1084"/>
                  <a:pt x="584" y="1082"/>
                </a:cubicBezTo>
                <a:cubicBezTo>
                  <a:pt x="589" y="1081"/>
                  <a:pt x="593" y="1080"/>
                  <a:pt x="596" y="1080"/>
                </a:cubicBezTo>
                <a:cubicBezTo>
                  <a:pt x="598" y="1079"/>
                  <a:pt x="601" y="1079"/>
                  <a:pt x="602" y="1080"/>
                </a:cubicBezTo>
                <a:cubicBezTo>
                  <a:pt x="604" y="1080"/>
                  <a:pt x="605" y="1081"/>
                  <a:pt x="606" y="1081"/>
                </a:cubicBezTo>
                <a:cubicBezTo>
                  <a:pt x="608" y="1082"/>
                  <a:pt x="609" y="1084"/>
                  <a:pt x="611" y="1085"/>
                </a:cubicBezTo>
                <a:cubicBezTo>
                  <a:pt x="613" y="1087"/>
                  <a:pt x="615" y="1088"/>
                  <a:pt x="618" y="1091"/>
                </a:cubicBezTo>
                <a:cubicBezTo>
                  <a:pt x="620" y="1093"/>
                  <a:pt x="623" y="1096"/>
                  <a:pt x="624" y="1098"/>
                </a:cubicBezTo>
                <a:cubicBezTo>
                  <a:pt x="626" y="1100"/>
                  <a:pt x="627" y="1102"/>
                  <a:pt x="628" y="1104"/>
                </a:cubicBezTo>
                <a:cubicBezTo>
                  <a:pt x="628" y="1106"/>
                  <a:pt x="629" y="1107"/>
                  <a:pt x="628" y="1108"/>
                </a:cubicBezTo>
                <a:cubicBezTo>
                  <a:pt x="628" y="1110"/>
                  <a:pt x="628" y="1111"/>
                  <a:pt x="627" y="1112"/>
                </a:cubicBezTo>
                <a:cubicBezTo>
                  <a:pt x="625" y="1113"/>
                  <a:pt x="623" y="1114"/>
                  <a:pt x="618" y="1115"/>
                </a:cubicBezTo>
                <a:cubicBezTo>
                  <a:pt x="614" y="1116"/>
                  <a:pt x="609" y="1118"/>
                  <a:pt x="603" y="1120"/>
                </a:cubicBezTo>
                <a:cubicBezTo>
                  <a:pt x="597" y="1122"/>
                  <a:pt x="590" y="1125"/>
                  <a:pt x="583" y="1129"/>
                </a:cubicBezTo>
                <a:cubicBezTo>
                  <a:pt x="576" y="1133"/>
                  <a:pt x="568" y="1139"/>
                  <a:pt x="561" y="1146"/>
                </a:cubicBezTo>
                <a:cubicBezTo>
                  <a:pt x="555" y="1152"/>
                  <a:pt x="550" y="1158"/>
                  <a:pt x="546" y="1165"/>
                </a:cubicBezTo>
                <a:cubicBezTo>
                  <a:pt x="543" y="1171"/>
                  <a:pt x="541" y="1177"/>
                  <a:pt x="541" y="1183"/>
                </a:cubicBezTo>
                <a:cubicBezTo>
                  <a:pt x="540" y="1189"/>
                  <a:pt x="541" y="1194"/>
                  <a:pt x="543" y="1200"/>
                </a:cubicBezTo>
                <a:cubicBezTo>
                  <a:pt x="545" y="1205"/>
                  <a:pt x="548" y="1210"/>
                  <a:pt x="552" y="1214"/>
                </a:cubicBezTo>
                <a:cubicBezTo>
                  <a:pt x="558" y="1220"/>
                  <a:pt x="565" y="1223"/>
                  <a:pt x="572" y="1224"/>
                </a:cubicBezTo>
                <a:cubicBezTo>
                  <a:pt x="579" y="1225"/>
                  <a:pt x="587" y="1225"/>
                  <a:pt x="595" y="1223"/>
                </a:cubicBezTo>
                <a:cubicBezTo>
                  <a:pt x="603" y="1221"/>
                  <a:pt x="611" y="1219"/>
                  <a:pt x="620" y="1215"/>
                </a:cubicBezTo>
                <a:cubicBezTo>
                  <a:pt x="628" y="1211"/>
                  <a:pt x="637" y="1207"/>
                  <a:pt x="646" y="1203"/>
                </a:cubicBezTo>
                <a:cubicBezTo>
                  <a:pt x="655" y="1199"/>
                  <a:pt x="665" y="1196"/>
                  <a:pt x="674" y="1193"/>
                </a:cubicBezTo>
                <a:cubicBezTo>
                  <a:pt x="684" y="1189"/>
                  <a:pt x="693" y="1188"/>
                  <a:pt x="703" y="1187"/>
                </a:cubicBezTo>
                <a:cubicBezTo>
                  <a:pt x="712" y="1187"/>
                  <a:pt x="722" y="1189"/>
                  <a:pt x="731" y="1192"/>
                </a:cubicBezTo>
                <a:cubicBezTo>
                  <a:pt x="741" y="1196"/>
                  <a:pt x="750" y="1202"/>
                  <a:pt x="759" y="1211"/>
                </a:cubicBezTo>
                <a:close/>
                <a:moveTo>
                  <a:pt x="964" y="1087"/>
                </a:moveTo>
                <a:cubicBezTo>
                  <a:pt x="968" y="1092"/>
                  <a:pt x="972" y="1095"/>
                  <a:pt x="974" y="1099"/>
                </a:cubicBezTo>
                <a:cubicBezTo>
                  <a:pt x="976" y="1102"/>
                  <a:pt x="977" y="1105"/>
                  <a:pt x="977" y="1107"/>
                </a:cubicBezTo>
                <a:cubicBezTo>
                  <a:pt x="977" y="1110"/>
                  <a:pt x="976" y="1113"/>
                  <a:pt x="975" y="1116"/>
                </a:cubicBezTo>
                <a:cubicBezTo>
                  <a:pt x="973" y="1120"/>
                  <a:pt x="971" y="1123"/>
                  <a:pt x="969" y="1127"/>
                </a:cubicBezTo>
                <a:cubicBezTo>
                  <a:pt x="966" y="1131"/>
                  <a:pt x="964" y="1135"/>
                  <a:pt x="961" y="1139"/>
                </a:cubicBezTo>
                <a:cubicBezTo>
                  <a:pt x="958" y="1143"/>
                  <a:pt x="954" y="1146"/>
                  <a:pt x="951" y="1150"/>
                </a:cubicBezTo>
                <a:cubicBezTo>
                  <a:pt x="940" y="1161"/>
                  <a:pt x="929" y="1168"/>
                  <a:pt x="919" y="1173"/>
                </a:cubicBezTo>
                <a:cubicBezTo>
                  <a:pt x="908" y="1178"/>
                  <a:pt x="898" y="1180"/>
                  <a:pt x="887" y="1179"/>
                </a:cubicBezTo>
                <a:cubicBezTo>
                  <a:pt x="877" y="1178"/>
                  <a:pt x="866" y="1175"/>
                  <a:pt x="855" y="1168"/>
                </a:cubicBezTo>
                <a:cubicBezTo>
                  <a:pt x="844" y="1162"/>
                  <a:pt x="832" y="1152"/>
                  <a:pt x="820" y="1140"/>
                </a:cubicBezTo>
                <a:lnTo>
                  <a:pt x="700" y="1020"/>
                </a:lnTo>
                <a:lnTo>
                  <a:pt x="671" y="1049"/>
                </a:lnTo>
                <a:cubicBezTo>
                  <a:pt x="669" y="1051"/>
                  <a:pt x="666" y="1052"/>
                  <a:pt x="662" y="1050"/>
                </a:cubicBezTo>
                <a:cubicBezTo>
                  <a:pt x="658" y="1049"/>
                  <a:pt x="653" y="1046"/>
                  <a:pt x="648" y="1041"/>
                </a:cubicBezTo>
                <a:cubicBezTo>
                  <a:pt x="645" y="1038"/>
                  <a:pt x="643" y="1035"/>
                  <a:pt x="641" y="1033"/>
                </a:cubicBezTo>
                <a:cubicBezTo>
                  <a:pt x="639" y="1030"/>
                  <a:pt x="638" y="1028"/>
                  <a:pt x="638" y="1026"/>
                </a:cubicBezTo>
                <a:cubicBezTo>
                  <a:pt x="637" y="1024"/>
                  <a:pt x="637" y="1023"/>
                  <a:pt x="637" y="1021"/>
                </a:cubicBezTo>
                <a:cubicBezTo>
                  <a:pt x="638" y="1020"/>
                  <a:pt x="639" y="1018"/>
                  <a:pt x="640" y="1017"/>
                </a:cubicBezTo>
                <a:lnTo>
                  <a:pt x="668" y="988"/>
                </a:lnTo>
                <a:lnTo>
                  <a:pt x="619" y="939"/>
                </a:lnTo>
                <a:cubicBezTo>
                  <a:pt x="618" y="938"/>
                  <a:pt x="618" y="937"/>
                  <a:pt x="617" y="936"/>
                </a:cubicBezTo>
                <a:cubicBezTo>
                  <a:pt x="617" y="934"/>
                  <a:pt x="617" y="932"/>
                  <a:pt x="618" y="930"/>
                </a:cubicBezTo>
                <a:cubicBezTo>
                  <a:pt x="619" y="928"/>
                  <a:pt x="620" y="926"/>
                  <a:pt x="622" y="923"/>
                </a:cubicBezTo>
                <a:cubicBezTo>
                  <a:pt x="624" y="920"/>
                  <a:pt x="627" y="917"/>
                  <a:pt x="631" y="913"/>
                </a:cubicBezTo>
                <a:cubicBezTo>
                  <a:pt x="635" y="909"/>
                  <a:pt x="638" y="906"/>
                  <a:pt x="641" y="904"/>
                </a:cubicBezTo>
                <a:cubicBezTo>
                  <a:pt x="644" y="902"/>
                  <a:pt x="646" y="901"/>
                  <a:pt x="648" y="900"/>
                </a:cubicBezTo>
                <a:cubicBezTo>
                  <a:pt x="650" y="899"/>
                  <a:pt x="652" y="899"/>
                  <a:pt x="653" y="899"/>
                </a:cubicBezTo>
                <a:cubicBezTo>
                  <a:pt x="655" y="900"/>
                  <a:pt x="656" y="900"/>
                  <a:pt x="657" y="901"/>
                </a:cubicBezTo>
                <a:lnTo>
                  <a:pt x="706" y="951"/>
                </a:lnTo>
                <a:lnTo>
                  <a:pt x="759" y="898"/>
                </a:lnTo>
                <a:cubicBezTo>
                  <a:pt x="761" y="896"/>
                  <a:pt x="762" y="896"/>
                  <a:pt x="763" y="895"/>
                </a:cubicBezTo>
                <a:cubicBezTo>
                  <a:pt x="765" y="895"/>
                  <a:pt x="766" y="895"/>
                  <a:pt x="768" y="896"/>
                </a:cubicBezTo>
                <a:cubicBezTo>
                  <a:pt x="770" y="896"/>
                  <a:pt x="773" y="897"/>
                  <a:pt x="775" y="899"/>
                </a:cubicBezTo>
                <a:cubicBezTo>
                  <a:pt x="777" y="901"/>
                  <a:pt x="780" y="903"/>
                  <a:pt x="783" y="906"/>
                </a:cubicBezTo>
                <a:cubicBezTo>
                  <a:pt x="788" y="911"/>
                  <a:pt x="791" y="916"/>
                  <a:pt x="793" y="920"/>
                </a:cubicBezTo>
                <a:cubicBezTo>
                  <a:pt x="794" y="924"/>
                  <a:pt x="793" y="927"/>
                  <a:pt x="791" y="929"/>
                </a:cubicBezTo>
                <a:lnTo>
                  <a:pt x="738" y="982"/>
                </a:lnTo>
                <a:lnTo>
                  <a:pt x="853" y="1097"/>
                </a:lnTo>
                <a:cubicBezTo>
                  <a:pt x="867" y="1111"/>
                  <a:pt x="880" y="1120"/>
                  <a:pt x="891" y="1123"/>
                </a:cubicBezTo>
                <a:cubicBezTo>
                  <a:pt x="903" y="1126"/>
                  <a:pt x="914" y="1122"/>
                  <a:pt x="925" y="1111"/>
                </a:cubicBezTo>
                <a:cubicBezTo>
                  <a:pt x="928" y="1108"/>
                  <a:pt x="931" y="1104"/>
                  <a:pt x="933" y="1101"/>
                </a:cubicBezTo>
                <a:cubicBezTo>
                  <a:pt x="935" y="1097"/>
                  <a:pt x="937" y="1094"/>
                  <a:pt x="938" y="1091"/>
                </a:cubicBezTo>
                <a:cubicBezTo>
                  <a:pt x="940" y="1088"/>
                  <a:pt x="941" y="1086"/>
                  <a:pt x="942" y="1084"/>
                </a:cubicBezTo>
                <a:cubicBezTo>
                  <a:pt x="942" y="1081"/>
                  <a:pt x="944" y="1080"/>
                  <a:pt x="945" y="1078"/>
                </a:cubicBezTo>
                <a:cubicBezTo>
                  <a:pt x="946" y="1078"/>
                  <a:pt x="946" y="1077"/>
                  <a:pt x="948" y="1077"/>
                </a:cubicBezTo>
                <a:cubicBezTo>
                  <a:pt x="949" y="1077"/>
                  <a:pt x="950" y="1077"/>
                  <a:pt x="951" y="1077"/>
                </a:cubicBezTo>
                <a:cubicBezTo>
                  <a:pt x="953" y="1078"/>
                  <a:pt x="955" y="1079"/>
                  <a:pt x="957" y="1081"/>
                </a:cubicBezTo>
                <a:cubicBezTo>
                  <a:pt x="959" y="1082"/>
                  <a:pt x="961" y="1084"/>
                  <a:pt x="964" y="1087"/>
                </a:cubicBezTo>
                <a:close/>
                <a:moveTo>
                  <a:pt x="1068" y="1013"/>
                </a:moveTo>
                <a:cubicBezTo>
                  <a:pt x="1069" y="1015"/>
                  <a:pt x="1070" y="1016"/>
                  <a:pt x="1070" y="1017"/>
                </a:cubicBezTo>
                <a:cubicBezTo>
                  <a:pt x="1070" y="1019"/>
                  <a:pt x="1070" y="1021"/>
                  <a:pt x="1069" y="1023"/>
                </a:cubicBezTo>
                <a:cubicBezTo>
                  <a:pt x="1069" y="1025"/>
                  <a:pt x="1067" y="1027"/>
                  <a:pt x="1065" y="1030"/>
                </a:cubicBezTo>
                <a:cubicBezTo>
                  <a:pt x="1063" y="1032"/>
                  <a:pt x="1060" y="1036"/>
                  <a:pt x="1056" y="1040"/>
                </a:cubicBezTo>
                <a:cubicBezTo>
                  <a:pt x="1052" y="1043"/>
                  <a:pt x="1049" y="1046"/>
                  <a:pt x="1047" y="1048"/>
                </a:cubicBezTo>
                <a:cubicBezTo>
                  <a:pt x="1044" y="1050"/>
                  <a:pt x="1041" y="1052"/>
                  <a:pt x="1039" y="1053"/>
                </a:cubicBezTo>
                <a:cubicBezTo>
                  <a:pt x="1037" y="1054"/>
                  <a:pt x="1036" y="1054"/>
                  <a:pt x="1034" y="1053"/>
                </a:cubicBezTo>
                <a:cubicBezTo>
                  <a:pt x="1033" y="1053"/>
                  <a:pt x="1031" y="1052"/>
                  <a:pt x="1030" y="1051"/>
                </a:cubicBezTo>
                <a:lnTo>
                  <a:pt x="824" y="845"/>
                </a:lnTo>
                <a:cubicBezTo>
                  <a:pt x="823" y="844"/>
                  <a:pt x="822" y="843"/>
                  <a:pt x="822" y="841"/>
                </a:cubicBezTo>
                <a:cubicBezTo>
                  <a:pt x="821" y="840"/>
                  <a:pt x="822" y="838"/>
                  <a:pt x="822" y="836"/>
                </a:cubicBezTo>
                <a:cubicBezTo>
                  <a:pt x="823" y="834"/>
                  <a:pt x="825" y="831"/>
                  <a:pt x="827" y="829"/>
                </a:cubicBezTo>
                <a:cubicBezTo>
                  <a:pt x="829" y="826"/>
                  <a:pt x="832" y="823"/>
                  <a:pt x="836" y="819"/>
                </a:cubicBezTo>
                <a:cubicBezTo>
                  <a:pt x="839" y="815"/>
                  <a:pt x="843" y="812"/>
                  <a:pt x="845" y="810"/>
                </a:cubicBezTo>
                <a:cubicBezTo>
                  <a:pt x="848" y="808"/>
                  <a:pt x="851" y="806"/>
                  <a:pt x="853" y="806"/>
                </a:cubicBezTo>
                <a:cubicBezTo>
                  <a:pt x="855" y="805"/>
                  <a:pt x="856" y="805"/>
                  <a:pt x="858" y="805"/>
                </a:cubicBezTo>
                <a:cubicBezTo>
                  <a:pt x="859" y="805"/>
                  <a:pt x="861" y="806"/>
                  <a:pt x="862" y="807"/>
                </a:cubicBezTo>
                <a:lnTo>
                  <a:pt x="1068" y="1013"/>
                </a:lnTo>
                <a:close/>
                <a:moveTo>
                  <a:pt x="796" y="733"/>
                </a:moveTo>
                <a:cubicBezTo>
                  <a:pt x="805" y="742"/>
                  <a:pt x="810" y="750"/>
                  <a:pt x="809" y="756"/>
                </a:cubicBezTo>
                <a:cubicBezTo>
                  <a:pt x="809" y="763"/>
                  <a:pt x="805" y="771"/>
                  <a:pt x="796" y="780"/>
                </a:cubicBezTo>
                <a:cubicBezTo>
                  <a:pt x="787" y="788"/>
                  <a:pt x="779" y="793"/>
                  <a:pt x="773" y="793"/>
                </a:cubicBezTo>
                <a:cubicBezTo>
                  <a:pt x="766" y="793"/>
                  <a:pt x="759" y="789"/>
                  <a:pt x="750" y="780"/>
                </a:cubicBezTo>
                <a:cubicBezTo>
                  <a:pt x="741" y="771"/>
                  <a:pt x="737" y="764"/>
                  <a:pt x="737" y="757"/>
                </a:cubicBezTo>
                <a:cubicBezTo>
                  <a:pt x="737" y="750"/>
                  <a:pt x="742" y="743"/>
                  <a:pt x="751" y="734"/>
                </a:cubicBezTo>
                <a:cubicBezTo>
                  <a:pt x="760" y="725"/>
                  <a:pt x="767" y="720"/>
                  <a:pt x="774" y="720"/>
                </a:cubicBezTo>
                <a:cubicBezTo>
                  <a:pt x="780" y="720"/>
                  <a:pt x="788" y="724"/>
                  <a:pt x="796" y="733"/>
                </a:cubicBezTo>
                <a:close/>
                <a:moveTo>
                  <a:pt x="1314" y="767"/>
                </a:moveTo>
                <a:cubicBezTo>
                  <a:pt x="1316" y="768"/>
                  <a:pt x="1317" y="770"/>
                  <a:pt x="1317" y="771"/>
                </a:cubicBezTo>
                <a:cubicBezTo>
                  <a:pt x="1317" y="772"/>
                  <a:pt x="1317" y="774"/>
                  <a:pt x="1316" y="776"/>
                </a:cubicBezTo>
                <a:cubicBezTo>
                  <a:pt x="1316" y="778"/>
                  <a:pt x="1314" y="780"/>
                  <a:pt x="1312" y="782"/>
                </a:cubicBezTo>
                <a:cubicBezTo>
                  <a:pt x="1311" y="785"/>
                  <a:pt x="1308" y="788"/>
                  <a:pt x="1305" y="791"/>
                </a:cubicBezTo>
                <a:cubicBezTo>
                  <a:pt x="1302" y="794"/>
                  <a:pt x="1299" y="796"/>
                  <a:pt x="1297" y="798"/>
                </a:cubicBezTo>
                <a:cubicBezTo>
                  <a:pt x="1294" y="800"/>
                  <a:pt x="1292" y="801"/>
                  <a:pt x="1290" y="802"/>
                </a:cubicBezTo>
                <a:cubicBezTo>
                  <a:pt x="1288" y="803"/>
                  <a:pt x="1286" y="803"/>
                  <a:pt x="1285" y="803"/>
                </a:cubicBezTo>
                <a:cubicBezTo>
                  <a:pt x="1283" y="803"/>
                  <a:pt x="1282" y="802"/>
                  <a:pt x="1281" y="801"/>
                </a:cubicBezTo>
                <a:lnTo>
                  <a:pt x="1253" y="773"/>
                </a:lnTo>
                <a:cubicBezTo>
                  <a:pt x="1254" y="796"/>
                  <a:pt x="1252" y="816"/>
                  <a:pt x="1247" y="835"/>
                </a:cubicBezTo>
                <a:cubicBezTo>
                  <a:pt x="1242" y="853"/>
                  <a:pt x="1233" y="869"/>
                  <a:pt x="1219" y="883"/>
                </a:cubicBezTo>
                <a:cubicBezTo>
                  <a:pt x="1204" y="898"/>
                  <a:pt x="1188" y="908"/>
                  <a:pt x="1171" y="913"/>
                </a:cubicBezTo>
                <a:cubicBezTo>
                  <a:pt x="1154" y="918"/>
                  <a:pt x="1138" y="918"/>
                  <a:pt x="1121" y="915"/>
                </a:cubicBezTo>
                <a:cubicBezTo>
                  <a:pt x="1105" y="912"/>
                  <a:pt x="1088" y="905"/>
                  <a:pt x="1071" y="894"/>
                </a:cubicBezTo>
                <a:cubicBezTo>
                  <a:pt x="1055" y="884"/>
                  <a:pt x="1039" y="871"/>
                  <a:pt x="1024" y="856"/>
                </a:cubicBezTo>
                <a:cubicBezTo>
                  <a:pt x="1006" y="838"/>
                  <a:pt x="992" y="820"/>
                  <a:pt x="982" y="802"/>
                </a:cubicBezTo>
                <a:cubicBezTo>
                  <a:pt x="971" y="784"/>
                  <a:pt x="965" y="766"/>
                  <a:pt x="962" y="749"/>
                </a:cubicBezTo>
                <a:cubicBezTo>
                  <a:pt x="960" y="731"/>
                  <a:pt x="961" y="714"/>
                  <a:pt x="967" y="698"/>
                </a:cubicBezTo>
                <a:cubicBezTo>
                  <a:pt x="972" y="681"/>
                  <a:pt x="982" y="666"/>
                  <a:pt x="997" y="651"/>
                </a:cubicBezTo>
                <a:cubicBezTo>
                  <a:pt x="1009" y="639"/>
                  <a:pt x="1023" y="631"/>
                  <a:pt x="1038" y="626"/>
                </a:cubicBezTo>
                <a:cubicBezTo>
                  <a:pt x="1053" y="621"/>
                  <a:pt x="1071" y="619"/>
                  <a:pt x="1091" y="620"/>
                </a:cubicBezTo>
                <a:lnTo>
                  <a:pt x="971" y="500"/>
                </a:lnTo>
                <a:cubicBezTo>
                  <a:pt x="970" y="499"/>
                  <a:pt x="969" y="497"/>
                  <a:pt x="969" y="496"/>
                </a:cubicBezTo>
                <a:cubicBezTo>
                  <a:pt x="968" y="494"/>
                  <a:pt x="969" y="492"/>
                  <a:pt x="970" y="490"/>
                </a:cubicBezTo>
                <a:cubicBezTo>
                  <a:pt x="971" y="488"/>
                  <a:pt x="972" y="486"/>
                  <a:pt x="974" y="483"/>
                </a:cubicBezTo>
                <a:cubicBezTo>
                  <a:pt x="976" y="480"/>
                  <a:pt x="979" y="477"/>
                  <a:pt x="983" y="474"/>
                </a:cubicBezTo>
                <a:cubicBezTo>
                  <a:pt x="986" y="470"/>
                  <a:pt x="990" y="467"/>
                  <a:pt x="992" y="465"/>
                </a:cubicBezTo>
                <a:cubicBezTo>
                  <a:pt x="995" y="463"/>
                  <a:pt x="998" y="461"/>
                  <a:pt x="1000" y="460"/>
                </a:cubicBezTo>
                <a:cubicBezTo>
                  <a:pt x="1002" y="459"/>
                  <a:pt x="1003" y="459"/>
                  <a:pt x="1005" y="460"/>
                </a:cubicBezTo>
                <a:cubicBezTo>
                  <a:pt x="1007" y="460"/>
                  <a:pt x="1008" y="461"/>
                  <a:pt x="1009" y="462"/>
                </a:cubicBezTo>
                <a:lnTo>
                  <a:pt x="1314" y="767"/>
                </a:lnTo>
                <a:close/>
                <a:moveTo>
                  <a:pt x="1131" y="660"/>
                </a:moveTo>
                <a:cubicBezTo>
                  <a:pt x="1108" y="657"/>
                  <a:pt x="1089" y="658"/>
                  <a:pt x="1073" y="661"/>
                </a:cubicBezTo>
                <a:cubicBezTo>
                  <a:pt x="1056" y="663"/>
                  <a:pt x="1043" y="670"/>
                  <a:pt x="1033" y="681"/>
                </a:cubicBezTo>
                <a:cubicBezTo>
                  <a:pt x="1023" y="690"/>
                  <a:pt x="1017" y="701"/>
                  <a:pt x="1015" y="712"/>
                </a:cubicBezTo>
                <a:cubicBezTo>
                  <a:pt x="1013" y="723"/>
                  <a:pt x="1014" y="735"/>
                  <a:pt x="1017" y="746"/>
                </a:cubicBezTo>
                <a:cubicBezTo>
                  <a:pt x="1020" y="758"/>
                  <a:pt x="1025" y="770"/>
                  <a:pt x="1033" y="781"/>
                </a:cubicBezTo>
                <a:cubicBezTo>
                  <a:pt x="1041" y="792"/>
                  <a:pt x="1049" y="803"/>
                  <a:pt x="1059" y="813"/>
                </a:cubicBezTo>
                <a:cubicBezTo>
                  <a:pt x="1069" y="823"/>
                  <a:pt x="1080" y="833"/>
                  <a:pt x="1092" y="841"/>
                </a:cubicBezTo>
                <a:cubicBezTo>
                  <a:pt x="1104" y="849"/>
                  <a:pt x="1115" y="855"/>
                  <a:pt x="1127" y="859"/>
                </a:cubicBezTo>
                <a:cubicBezTo>
                  <a:pt x="1139" y="863"/>
                  <a:pt x="1150" y="864"/>
                  <a:pt x="1161" y="862"/>
                </a:cubicBezTo>
                <a:cubicBezTo>
                  <a:pt x="1172" y="860"/>
                  <a:pt x="1183" y="854"/>
                  <a:pt x="1193" y="844"/>
                </a:cubicBezTo>
                <a:cubicBezTo>
                  <a:pt x="1198" y="839"/>
                  <a:pt x="1202" y="833"/>
                  <a:pt x="1205" y="827"/>
                </a:cubicBezTo>
                <a:cubicBezTo>
                  <a:pt x="1209" y="821"/>
                  <a:pt x="1211" y="814"/>
                  <a:pt x="1213" y="806"/>
                </a:cubicBezTo>
                <a:cubicBezTo>
                  <a:pt x="1215" y="798"/>
                  <a:pt x="1216" y="789"/>
                  <a:pt x="1216" y="778"/>
                </a:cubicBezTo>
                <a:cubicBezTo>
                  <a:pt x="1216" y="768"/>
                  <a:pt x="1215" y="756"/>
                  <a:pt x="1214" y="742"/>
                </a:cubicBezTo>
                <a:lnTo>
                  <a:pt x="1131" y="660"/>
                </a:lnTo>
                <a:close/>
                <a:moveTo>
                  <a:pt x="1419" y="663"/>
                </a:moveTo>
                <a:cubicBezTo>
                  <a:pt x="1420" y="664"/>
                  <a:pt x="1421" y="665"/>
                  <a:pt x="1421" y="667"/>
                </a:cubicBezTo>
                <a:cubicBezTo>
                  <a:pt x="1421" y="668"/>
                  <a:pt x="1421" y="670"/>
                  <a:pt x="1420" y="672"/>
                </a:cubicBezTo>
                <a:cubicBezTo>
                  <a:pt x="1419" y="674"/>
                  <a:pt x="1418" y="676"/>
                  <a:pt x="1416" y="679"/>
                </a:cubicBezTo>
                <a:cubicBezTo>
                  <a:pt x="1414" y="682"/>
                  <a:pt x="1411" y="685"/>
                  <a:pt x="1407" y="689"/>
                </a:cubicBezTo>
                <a:cubicBezTo>
                  <a:pt x="1403" y="692"/>
                  <a:pt x="1400" y="695"/>
                  <a:pt x="1397" y="697"/>
                </a:cubicBezTo>
                <a:cubicBezTo>
                  <a:pt x="1394" y="700"/>
                  <a:pt x="1392" y="701"/>
                  <a:pt x="1390" y="702"/>
                </a:cubicBezTo>
                <a:cubicBezTo>
                  <a:pt x="1388" y="703"/>
                  <a:pt x="1386" y="703"/>
                  <a:pt x="1385" y="703"/>
                </a:cubicBezTo>
                <a:cubicBezTo>
                  <a:pt x="1383" y="702"/>
                  <a:pt x="1382" y="702"/>
                  <a:pt x="1381" y="700"/>
                </a:cubicBezTo>
                <a:lnTo>
                  <a:pt x="1175" y="494"/>
                </a:lnTo>
                <a:cubicBezTo>
                  <a:pt x="1174" y="493"/>
                  <a:pt x="1173" y="492"/>
                  <a:pt x="1172" y="490"/>
                </a:cubicBezTo>
                <a:cubicBezTo>
                  <a:pt x="1172" y="489"/>
                  <a:pt x="1172" y="487"/>
                  <a:pt x="1173" y="485"/>
                </a:cubicBezTo>
                <a:cubicBezTo>
                  <a:pt x="1174" y="483"/>
                  <a:pt x="1175" y="481"/>
                  <a:pt x="1178" y="478"/>
                </a:cubicBezTo>
                <a:cubicBezTo>
                  <a:pt x="1180" y="475"/>
                  <a:pt x="1183" y="472"/>
                  <a:pt x="1186" y="468"/>
                </a:cubicBezTo>
                <a:cubicBezTo>
                  <a:pt x="1190" y="464"/>
                  <a:pt x="1193" y="461"/>
                  <a:pt x="1196" y="459"/>
                </a:cubicBezTo>
                <a:cubicBezTo>
                  <a:pt x="1199" y="457"/>
                  <a:pt x="1201" y="456"/>
                  <a:pt x="1203" y="455"/>
                </a:cubicBezTo>
                <a:cubicBezTo>
                  <a:pt x="1205" y="454"/>
                  <a:pt x="1207" y="454"/>
                  <a:pt x="1209" y="454"/>
                </a:cubicBezTo>
                <a:cubicBezTo>
                  <a:pt x="1210" y="455"/>
                  <a:pt x="1211" y="455"/>
                  <a:pt x="1212" y="456"/>
                </a:cubicBezTo>
                <a:lnTo>
                  <a:pt x="1419" y="663"/>
                </a:lnTo>
                <a:close/>
                <a:moveTo>
                  <a:pt x="1147" y="382"/>
                </a:moveTo>
                <a:cubicBezTo>
                  <a:pt x="1156" y="391"/>
                  <a:pt x="1160" y="399"/>
                  <a:pt x="1160" y="405"/>
                </a:cubicBezTo>
                <a:cubicBezTo>
                  <a:pt x="1160" y="412"/>
                  <a:pt x="1155" y="420"/>
                  <a:pt x="1146" y="429"/>
                </a:cubicBezTo>
                <a:cubicBezTo>
                  <a:pt x="1138" y="438"/>
                  <a:pt x="1130" y="442"/>
                  <a:pt x="1124" y="442"/>
                </a:cubicBezTo>
                <a:cubicBezTo>
                  <a:pt x="1117" y="442"/>
                  <a:pt x="1110" y="438"/>
                  <a:pt x="1101" y="429"/>
                </a:cubicBezTo>
                <a:cubicBezTo>
                  <a:pt x="1092" y="421"/>
                  <a:pt x="1088" y="413"/>
                  <a:pt x="1088" y="406"/>
                </a:cubicBezTo>
                <a:cubicBezTo>
                  <a:pt x="1088" y="400"/>
                  <a:pt x="1092" y="392"/>
                  <a:pt x="1102" y="383"/>
                </a:cubicBezTo>
                <a:cubicBezTo>
                  <a:pt x="1110" y="374"/>
                  <a:pt x="1118" y="370"/>
                  <a:pt x="1124" y="369"/>
                </a:cubicBezTo>
                <a:cubicBezTo>
                  <a:pt x="1131" y="369"/>
                  <a:pt x="1138" y="374"/>
                  <a:pt x="1147" y="382"/>
                </a:cubicBezTo>
                <a:close/>
                <a:moveTo>
                  <a:pt x="1672" y="410"/>
                </a:moveTo>
                <a:cubicBezTo>
                  <a:pt x="1673" y="411"/>
                  <a:pt x="1674" y="412"/>
                  <a:pt x="1674" y="414"/>
                </a:cubicBezTo>
                <a:cubicBezTo>
                  <a:pt x="1674" y="415"/>
                  <a:pt x="1674" y="417"/>
                  <a:pt x="1673" y="419"/>
                </a:cubicBezTo>
                <a:cubicBezTo>
                  <a:pt x="1672" y="421"/>
                  <a:pt x="1671" y="423"/>
                  <a:pt x="1669" y="426"/>
                </a:cubicBezTo>
                <a:cubicBezTo>
                  <a:pt x="1667" y="429"/>
                  <a:pt x="1664" y="432"/>
                  <a:pt x="1660" y="436"/>
                </a:cubicBezTo>
                <a:cubicBezTo>
                  <a:pt x="1656" y="439"/>
                  <a:pt x="1653" y="442"/>
                  <a:pt x="1650" y="445"/>
                </a:cubicBezTo>
                <a:cubicBezTo>
                  <a:pt x="1647" y="447"/>
                  <a:pt x="1645" y="448"/>
                  <a:pt x="1643" y="449"/>
                </a:cubicBezTo>
                <a:cubicBezTo>
                  <a:pt x="1641" y="450"/>
                  <a:pt x="1639" y="450"/>
                  <a:pt x="1638" y="450"/>
                </a:cubicBezTo>
                <a:cubicBezTo>
                  <a:pt x="1637" y="449"/>
                  <a:pt x="1635" y="449"/>
                  <a:pt x="1634" y="447"/>
                </a:cubicBezTo>
                <a:lnTo>
                  <a:pt x="1513" y="327"/>
                </a:lnTo>
                <a:cubicBezTo>
                  <a:pt x="1501" y="315"/>
                  <a:pt x="1491" y="306"/>
                  <a:pt x="1482" y="301"/>
                </a:cubicBezTo>
                <a:cubicBezTo>
                  <a:pt x="1473" y="296"/>
                  <a:pt x="1464" y="292"/>
                  <a:pt x="1455" y="290"/>
                </a:cubicBezTo>
                <a:cubicBezTo>
                  <a:pt x="1447" y="289"/>
                  <a:pt x="1438" y="289"/>
                  <a:pt x="1430" y="292"/>
                </a:cubicBezTo>
                <a:cubicBezTo>
                  <a:pt x="1421" y="295"/>
                  <a:pt x="1414" y="300"/>
                  <a:pt x="1406" y="307"/>
                </a:cubicBezTo>
                <a:cubicBezTo>
                  <a:pt x="1397" y="317"/>
                  <a:pt x="1391" y="330"/>
                  <a:pt x="1388" y="346"/>
                </a:cubicBezTo>
                <a:cubicBezTo>
                  <a:pt x="1385" y="362"/>
                  <a:pt x="1385" y="382"/>
                  <a:pt x="1388" y="405"/>
                </a:cubicBezTo>
                <a:lnTo>
                  <a:pt x="1532" y="550"/>
                </a:lnTo>
                <a:cubicBezTo>
                  <a:pt x="1533" y="551"/>
                  <a:pt x="1534" y="552"/>
                  <a:pt x="1534" y="554"/>
                </a:cubicBezTo>
                <a:cubicBezTo>
                  <a:pt x="1534" y="555"/>
                  <a:pt x="1534" y="557"/>
                  <a:pt x="1533" y="559"/>
                </a:cubicBezTo>
                <a:cubicBezTo>
                  <a:pt x="1533" y="561"/>
                  <a:pt x="1531" y="563"/>
                  <a:pt x="1529" y="566"/>
                </a:cubicBezTo>
                <a:cubicBezTo>
                  <a:pt x="1527" y="569"/>
                  <a:pt x="1524" y="572"/>
                  <a:pt x="1520" y="576"/>
                </a:cubicBezTo>
                <a:cubicBezTo>
                  <a:pt x="1516" y="579"/>
                  <a:pt x="1513" y="582"/>
                  <a:pt x="1510" y="584"/>
                </a:cubicBezTo>
                <a:cubicBezTo>
                  <a:pt x="1508" y="586"/>
                  <a:pt x="1505" y="588"/>
                  <a:pt x="1503" y="589"/>
                </a:cubicBezTo>
                <a:cubicBezTo>
                  <a:pt x="1501" y="590"/>
                  <a:pt x="1499" y="590"/>
                  <a:pt x="1498" y="590"/>
                </a:cubicBezTo>
                <a:cubicBezTo>
                  <a:pt x="1497" y="589"/>
                  <a:pt x="1495" y="589"/>
                  <a:pt x="1494" y="587"/>
                </a:cubicBezTo>
                <a:lnTo>
                  <a:pt x="1288" y="381"/>
                </a:lnTo>
                <a:cubicBezTo>
                  <a:pt x="1287" y="380"/>
                  <a:pt x="1286" y="379"/>
                  <a:pt x="1285" y="377"/>
                </a:cubicBezTo>
                <a:cubicBezTo>
                  <a:pt x="1285" y="376"/>
                  <a:pt x="1285" y="374"/>
                  <a:pt x="1286" y="372"/>
                </a:cubicBezTo>
                <a:cubicBezTo>
                  <a:pt x="1287" y="370"/>
                  <a:pt x="1288" y="368"/>
                  <a:pt x="1290" y="366"/>
                </a:cubicBezTo>
                <a:cubicBezTo>
                  <a:pt x="1292" y="363"/>
                  <a:pt x="1294" y="360"/>
                  <a:pt x="1298" y="357"/>
                </a:cubicBezTo>
                <a:cubicBezTo>
                  <a:pt x="1301" y="353"/>
                  <a:pt x="1304" y="351"/>
                  <a:pt x="1307" y="349"/>
                </a:cubicBezTo>
                <a:cubicBezTo>
                  <a:pt x="1309" y="347"/>
                  <a:pt x="1311" y="345"/>
                  <a:pt x="1313" y="345"/>
                </a:cubicBezTo>
                <a:cubicBezTo>
                  <a:pt x="1315" y="344"/>
                  <a:pt x="1317" y="344"/>
                  <a:pt x="1318" y="345"/>
                </a:cubicBezTo>
                <a:cubicBezTo>
                  <a:pt x="1319" y="345"/>
                  <a:pt x="1321" y="346"/>
                  <a:pt x="1322" y="347"/>
                </a:cubicBezTo>
                <a:lnTo>
                  <a:pt x="1349" y="374"/>
                </a:lnTo>
                <a:cubicBezTo>
                  <a:pt x="1348" y="350"/>
                  <a:pt x="1350" y="328"/>
                  <a:pt x="1355" y="311"/>
                </a:cubicBezTo>
                <a:cubicBezTo>
                  <a:pt x="1361" y="293"/>
                  <a:pt x="1370" y="279"/>
                  <a:pt x="1381" y="267"/>
                </a:cubicBezTo>
                <a:cubicBezTo>
                  <a:pt x="1395" y="253"/>
                  <a:pt x="1409" y="244"/>
                  <a:pt x="1423" y="239"/>
                </a:cubicBezTo>
                <a:cubicBezTo>
                  <a:pt x="1437" y="234"/>
                  <a:pt x="1451" y="233"/>
                  <a:pt x="1465" y="235"/>
                </a:cubicBezTo>
                <a:cubicBezTo>
                  <a:pt x="1478" y="237"/>
                  <a:pt x="1491" y="242"/>
                  <a:pt x="1504" y="250"/>
                </a:cubicBezTo>
                <a:cubicBezTo>
                  <a:pt x="1517" y="258"/>
                  <a:pt x="1531" y="269"/>
                  <a:pt x="1546" y="284"/>
                </a:cubicBezTo>
                <a:lnTo>
                  <a:pt x="1672" y="410"/>
                </a:lnTo>
                <a:close/>
                <a:moveTo>
                  <a:pt x="1801" y="56"/>
                </a:moveTo>
                <a:cubicBezTo>
                  <a:pt x="1807" y="62"/>
                  <a:pt x="1810" y="68"/>
                  <a:pt x="1810" y="73"/>
                </a:cubicBezTo>
                <a:cubicBezTo>
                  <a:pt x="1809" y="79"/>
                  <a:pt x="1807" y="83"/>
                  <a:pt x="1803" y="87"/>
                </a:cubicBezTo>
                <a:lnTo>
                  <a:pt x="1667" y="223"/>
                </a:lnTo>
                <a:cubicBezTo>
                  <a:pt x="1679" y="235"/>
                  <a:pt x="1690" y="244"/>
                  <a:pt x="1702" y="251"/>
                </a:cubicBezTo>
                <a:cubicBezTo>
                  <a:pt x="1713" y="257"/>
                  <a:pt x="1725" y="261"/>
                  <a:pt x="1737" y="263"/>
                </a:cubicBezTo>
                <a:cubicBezTo>
                  <a:pt x="1749" y="264"/>
                  <a:pt x="1761" y="262"/>
                  <a:pt x="1773" y="257"/>
                </a:cubicBezTo>
                <a:cubicBezTo>
                  <a:pt x="1785" y="252"/>
                  <a:pt x="1797" y="243"/>
                  <a:pt x="1810" y="231"/>
                </a:cubicBezTo>
                <a:cubicBezTo>
                  <a:pt x="1819" y="221"/>
                  <a:pt x="1827" y="211"/>
                  <a:pt x="1834" y="202"/>
                </a:cubicBezTo>
                <a:cubicBezTo>
                  <a:pt x="1840" y="193"/>
                  <a:pt x="1844" y="184"/>
                  <a:pt x="1848" y="177"/>
                </a:cubicBezTo>
                <a:cubicBezTo>
                  <a:pt x="1852" y="169"/>
                  <a:pt x="1854" y="163"/>
                  <a:pt x="1856" y="157"/>
                </a:cubicBezTo>
                <a:cubicBezTo>
                  <a:pt x="1858" y="152"/>
                  <a:pt x="1860" y="149"/>
                  <a:pt x="1862" y="147"/>
                </a:cubicBezTo>
                <a:cubicBezTo>
                  <a:pt x="1863" y="146"/>
                  <a:pt x="1865" y="145"/>
                  <a:pt x="1866" y="145"/>
                </a:cubicBezTo>
                <a:cubicBezTo>
                  <a:pt x="1867" y="144"/>
                  <a:pt x="1869" y="144"/>
                  <a:pt x="1870" y="145"/>
                </a:cubicBezTo>
                <a:cubicBezTo>
                  <a:pt x="1872" y="146"/>
                  <a:pt x="1874" y="147"/>
                  <a:pt x="1876" y="149"/>
                </a:cubicBezTo>
                <a:cubicBezTo>
                  <a:pt x="1878" y="150"/>
                  <a:pt x="1880" y="152"/>
                  <a:pt x="1883" y="155"/>
                </a:cubicBezTo>
                <a:cubicBezTo>
                  <a:pt x="1885" y="157"/>
                  <a:pt x="1887" y="159"/>
                  <a:pt x="1888" y="161"/>
                </a:cubicBezTo>
                <a:cubicBezTo>
                  <a:pt x="1889" y="162"/>
                  <a:pt x="1890" y="164"/>
                  <a:pt x="1891" y="165"/>
                </a:cubicBezTo>
                <a:cubicBezTo>
                  <a:pt x="1892" y="166"/>
                  <a:pt x="1893" y="168"/>
                  <a:pt x="1893" y="169"/>
                </a:cubicBezTo>
                <a:cubicBezTo>
                  <a:pt x="1894" y="171"/>
                  <a:pt x="1894" y="172"/>
                  <a:pt x="1894" y="174"/>
                </a:cubicBezTo>
                <a:cubicBezTo>
                  <a:pt x="1894" y="176"/>
                  <a:pt x="1893" y="180"/>
                  <a:pt x="1891" y="186"/>
                </a:cubicBezTo>
                <a:cubicBezTo>
                  <a:pt x="1888" y="192"/>
                  <a:pt x="1885" y="199"/>
                  <a:pt x="1880" y="207"/>
                </a:cubicBezTo>
                <a:cubicBezTo>
                  <a:pt x="1875" y="216"/>
                  <a:pt x="1869" y="225"/>
                  <a:pt x="1862" y="235"/>
                </a:cubicBezTo>
                <a:cubicBezTo>
                  <a:pt x="1855" y="245"/>
                  <a:pt x="1847" y="255"/>
                  <a:pt x="1837" y="265"/>
                </a:cubicBezTo>
                <a:cubicBezTo>
                  <a:pt x="1820" y="282"/>
                  <a:pt x="1803" y="294"/>
                  <a:pt x="1785" y="302"/>
                </a:cubicBezTo>
                <a:cubicBezTo>
                  <a:pt x="1768" y="310"/>
                  <a:pt x="1750" y="314"/>
                  <a:pt x="1732" y="313"/>
                </a:cubicBezTo>
                <a:cubicBezTo>
                  <a:pt x="1714" y="313"/>
                  <a:pt x="1696" y="308"/>
                  <a:pt x="1677" y="298"/>
                </a:cubicBezTo>
                <a:cubicBezTo>
                  <a:pt x="1659" y="288"/>
                  <a:pt x="1640" y="274"/>
                  <a:pt x="1621" y="256"/>
                </a:cubicBezTo>
                <a:cubicBezTo>
                  <a:pt x="1604" y="238"/>
                  <a:pt x="1590" y="220"/>
                  <a:pt x="1580" y="201"/>
                </a:cubicBezTo>
                <a:cubicBezTo>
                  <a:pt x="1571" y="182"/>
                  <a:pt x="1565" y="164"/>
                  <a:pt x="1564" y="145"/>
                </a:cubicBezTo>
                <a:cubicBezTo>
                  <a:pt x="1563" y="127"/>
                  <a:pt x="1566" y="109"/>
                  <a:pt x="1573" y="91"/>
                </a:cubicBezTo>
                <a:cubicBezTo>
                  <a:pt x="1580" y="74"/>
                  <a:pt x="1591" y="57"/>
                  <a:pt x="1606" y="42"/>
                </a:cubicBezTo>
                <a:cubicBezTo>
                  <a:pt x="1622" y="26"/>
                  <a:pt x="1639" y="15"/>
                  <a:pt x="1655" y="9"/>
                </a:cubicBezTo>
                <a:cubicBezTo>
                  <a:pt x="1672" y="2"/>
                  <a:pt x="1688" y="0"/>
                  <a:pt x="1704" y="1"/>
                </a:cubicBezTo>
                <a:cubicBezTo>
                  <a:pt x="1720" y="3"/>
                  <a:pt x="1736" y="8"/>
                  <a:pt x="1751" y="16"/>
                </a:cubicBezTo>
                <a:cubicBezTo>
                  <a:pt x="1767" y="25"/>
                  <a:pt x="1781" y="36"/>
                  <a:pt x="1794" y="49"/>
                </a:cubicBezTo>
                <a:lnTo>
                  <a:pt x="1801" y="56"/>
                </a:lnTo>
                <a:close/>
                <a:moveTo>
                  <a:pt x="1752" y="83"/>
                </a:moveTo>
                <a:cubicBezTo>
                  <a:pt x="1733" y="62"/>
                  <a:pt x="1713" y="51"/>
                  <a:pt x="1692" y="49"/>
                </a:cubicBezTo>
                <a:cubicBezTo>
                  <a:pt x="1671" y="47"/>
                  <a:pt x="1652" y="55"/>
                  <a:pt x="1634" y="74"/>
                </a:cubicBezTo>
                <a:cubicBezTo>
                  <a:pt x="1624" y="83"/>
                  <a:pt x="1618" y="93"/>
                  <a:pt x="1614" y="104"/>
                </a:cubicBezTo>
                <a:cubicBezTo>
                  <a:pt x="1611" y="114"/>
                  <a:pt x="1609" y="125"/>
                  <a:pt x="1610" y="135"/>
                </a:cubicBezTo>
                <a:cubicBezTo>
                  <a:pt x="1611" y="146"/>
                  <a:pt x="1615" y="156"/>
                  <a:pt x="1620" y="167"/>
                </a:cubicBezTo>
                <a:cubicBezTo>
                  <a:pt x="1625" y="177"/>
                  <a:pt x="1631" y="187"/>
                  <a:pt x="1639" y="195"/>
                </a:cubicBezTo>
                <a:lnTo>
                  <a:pt x="175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2" name="Freeform 246"/>
          <p:cNvSpPr>
            <a:spLocks noEditPoints="1"/>
          </p:cNvSpPr>
          <p:nvPr/>
        </p:nvSpPr>
        <p:spPr bwMode="auto">
          <a:xfrm>
            <a:off x="1183877" y="4417292"/>
            <a:ext cx="351397" cy="384175"/>
          </a:xfrm>
          <a:custGeom>
            <a:avLst/>
            <a:gdLst>
              <a:gd name="T0" fmla="*/ 159 w 2205"/>
              <a:gd name="T1" fmla="*/ 1718 h 2017"/>
              <a:gd name="T2" fmla="*/ 394 w 2205"/>
              <a:gd name="T3" fmla="*/ 2011 h 2017"/>
              <a:gd name="T4" fmla="*/ 32 w 2205"/>
              <a:gd name="T5" fmla="*/ 1843 h 2017"/>
              <a:gd name="T6" fmla="*/ 0 w 2205"/>
              <a:gd name="T7" fmla="*/ 1812 h 2017"/>
              <a:gd name="T8" fmla="*/ 234 w 2205"/>
              <a:gd name="T9" fmla="*/ 1610 h 2017"/>
              <a:gd name="T10" fmla="*/ 706 w 2205"/>
              <a:gd name="T11" fmla="*/ 1700 h 2017"/>
              <a:gd name="T12" fmla="*/ 511 w 2205"/>
              <a:gd name="T13" fmla="*/ 1546 h 2017"/>
              <a:gd name="T14" fmla="*/ 590 w 2205"/>
              <a:gd name="T15" fmla="*/ 1809 h 2017"/>
              <a:gd name="T16" fmla="*/ 553 w 2205"/>
              <a:gd name="T17" fmla="*/ 1845 h 2017"/>
              <a:gd name="T18" fmla="*/ 255 w 2205"/>
              <a:gd name="T19" fmla="*/ 1510 h 2017"/>
              <a:gd name="T20" fmla="*/ 412 w 2205"/>
              <a:gd name="T21" fmla="*/ 1564 h 2017"/>
              <a:gd name="T22" fmla="*/ 727 w 2205"/>
              <a:gd name="T23" fmla="*/ 1665 h 2017"/>
              <a:gd name="T24" fmla="*/ 727 w 2205"/>
              <a:gd name="T25" fmla="*/ 1313 h 2017"/>
              <a:gd name="T26" fmla="*/ 688 w 2205"/>
              <a:gd name="T27" fmla="*/ 1390 h 2017"/>
              <a:gd name="T28" fmla="*/ 819 w 2205"/>
              <a:gd name="T29" fmla="*/ 1588 h 2017"/>
              <a:gd name="T30" fmla="*/ 584 w 2205"/>
              <a:gd name="T31" fmla="*/ 1389 h 2017"/>
              <a:gd name="T32" fmla="*/ 617 w 2205"/>
              <a:gd name="T33" fmla="*/ 1357 h 2017"/>
              <a:gd name="T34" fmla="*/ 667 w 2205"/>
              <a:gd name="T35" fmla="*/ 1292 h 2017"/>
              <a:gd name="T36" fmla="*/ 707 w 2205"/>
              <a:gd name="T37" fmla="*/ 1274 h 2017"/>
              <a:gd name="T38" fmla="*/ 887 w 2205"/>
              <a:gd name="T39" fmla="*/ 1314 h 2017"/>
              <a:gd name="T40" fmla="*/ 1068 w 2205"/>
              <a:gd name="T41" fmla="*/ 1268 h 2017"/>
              <a:gd name="T42" fmla="*/ 1103 w 2205"/>
              <a:gd name="T43" fmla="*/ 1246 h 2017"/>
              <a:gd name="T44" fmla="*/ 1100 w 2205"/>
              <a:gd name="T45" fmla="*/ 1299 h 2017"/>
              <a:gd name="T46" fmla="*/ 841 w 2205"/>
              <a:gd name="T47" fmla="*/ 1347 h 2017"/>
              <a:gd name="T48" fmla="*/ 924 w 2205"/>
              <a:gd name="T49" fmla="*/ 1093 h 2017"/>
              <a:gd name="T50" fmla="*/ 853 w 2205"/>
              <a:gd name="T51" fmla="*/ 1165 h 2017"/>
              <a:gd name="T52" fmla="*/ 1281 w 2205"/>
              <a:gd name="T53" fmla="*/ 900 h 2017"/>
              <a:gd name="T54" fmla="*/ 1185 w 2205"/>
              <a:gd name="T55" fmla="*/ 1168 h 2017"/>
              <a:gd name="T56" fmla="*/ 1069 w 2205"/>
              <a:gd name="T57" fmla="*/ 890 h 2017"/>
              <a:gd name="T58" fmla="*/ 1209 w 2205"/>
              <a:gd name="T59" fmla="*/ 914 h 2017"/>
              <a:gd name="T60" fmla="*/ 1087 w 2205"/>
              <a:gd name="T61" fmla="*/ 1033 h 2017"/>
              <a:gd name="T62" fmla="*/ 1284 w 2205"/>
              <a:gd name="T63" fmla="*/ 1053 h 2017"/>
              <a:gd name="T64" fmla="*/ 1622 w 2205"/>
              <a:gd name="T65" fmla="*/ 780 h 2017"/>
              <a:gd name="T66" fmla="*/ 1583 w 2205"/>
              <a:gd name="T67" fmla="*/ 809 h 2017"/>
              <a:gd name="T68" fmla="*/ 1337 w 2205"/>
              <a:gd name="T69" fmla="*/ 707 h 2017"/>
              <a:gd name="T70" fmla="*/ 1469 w 2205"/>
              <a:gd name="T71" fmla="*/ 937 h 2017"/>
              <a:gd name="T72" fmla="*/ 1235 w 2205"/>
              <a:gd name="T73" fmla="*/ 739 h 2017"/>
              <a:gd name="T74" fmla="*/ 1267 w 2205"/>
              <a:gd name="T75" fmla="*/ 706 h 2017"/>
              <a:gd name="T76" fmla="*/ 1414 w 2205"/>
              <a:gd name="T77" fmla="*/ 597 h 2017"/>
              <a:gd name="T78" fmla="*/ 1731 w 2205"/>
              <a:gd name="T79" fmla="*/ 671 h 2017"/>
              <a:gd name="T80" fmla="*/ 1692 w 2205"/>
              <a:gd name="T81" fmla="*/ 700 h 2017"/>
              <a:gd name="T82" fmla="*/ 1507 w 2205"/>
              <a:gd name="T83" fmla="*/ 459 h 2017"/>
              <a:gd name="T84" fmla="*/ 1471 w 2205"/>
              <a:gd name="T85" fmla="*/ 405 h 2017"/>
              <a:gd name="T86" fmla="*/ 1436 w 2205"/>
              <a:gd name="T87" fmla="*/ 369 h 2017"/>
              <a:gd name="T88" fmla="*/ 1966 w 2205"/>
              <a:gd name="T89" fmla="*/ 441 h 2017"/>
              <a:gd name="T90" fmla="*/ 1788 w 2205"/>
              <a:gd name="T91" fmla="*/ 306 h 2017"/>
              <a:gd name="T92" fmla="*/ 1838 w 2205"/>
              <a:gd name="T93" fmla="*/ 555 h 2017"/>
              <a:gd name="T94" fmla="*/ 1809 w 2205"/>
              <a:gd name="T95" fmla="*/ 594 h 2017"/>
              <a:gd name="T96" fmla="*/ 1595 w 2205"/>
              <a:gd name="T97" fmla="*/ 371 h 2017"/>
              <a:gd name="T98" fmla="*/ 1655 w 2205"/>
              <a:gd name="T99" fmla="*/ 379 h 2017"/>
              <a:gd name="T100" fmla="*/ 1851 w 2205"/>
              <a:gd name="T101" fmla="*/ 289 h 2017"/>
              <a:gd name="T102" fmla="*/ 2013 w 2205"/>
              <a:gd name="T103" fmla="*/ 250 h 2017"/>
              <a:gd name="T104" fmla="*/ 2168 w 2205"/>
              <a:gd name="T105" fmla="*/ 157 h 2017"/>
              <a:gd name="T106" fmla="*/ 2199 w 2205"/>
              <a:gd name="T107" fmla="*/ 160 h 2017"/>
              <a:gd name="T108" fmla="*/ 2174 w 2205"/>
              <a:gd name="T109" fmla="*/ 234 h 2017"/>
              <a:gd name="T110" fmla="*/ 1892 w 2205"/>
              <a:gd name="T111" fmla="*/ 200 h 2017"/>
              <a:gd name="T112" fmla="*/ 2063 w 2205"/>
              <a:gd name="T113" fmla="*/ 16 h 2017"/>
              <a:gd name="T114" fmla="*/ 1925 w 2205"/>
              <a:gd name="T115" fmla="*/ 103 h 20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2205" h="2017">
                <a:moveTo>
                  <a:pt x="234" y="1610"/>
                </a:moveTo>
                <a:cubicBezTo>
                  <a:pt x="237" y="1613"/>
                  <a:pt x="239" y="1616"/>
                  <a:pt x="241" y="1618"/>
                </a:cubicBezTo>
                <a:cubicBezTo>
                  <a:pt x="243" y="1621"/>
                  <a:pt x="244" y="1623"/>
                  <a:pt x="245" y="1625"/>
                </a:cubicBezTo>
                <a:cubicBezTo>
                  <a:pt x="245" y="1627"/>
                  <a:pt x="245" y="1629"/>
                  <a:pt x="245" y="1630"/>
                </a:cubicBezTo>
                <a:cubicBezTo>
                  <a:pt x="245" y="1632"/>
                  <a:pt x="244" y="1633"/>
                  <a:pt x="243" y="1635"/>
                </a:cubicBezTo>
                <a:lnTo>
                  <a:pt x="159" y="1718"/>
                </a:lnTo>
                <a:lnTo>
                  <a:pt x="416" y="1975"/>
                </a:lnTo>
                <a:cubicBezTo>
                  <a:pt x="418" y="1977"/>
                  <a:pt x="418" y="1978"/>
                  <a:pt x="419" y="1979"/>
                </a:cubicBezTo>
                <a:cubicBezTo>
                  <a:pt x="419" y="1981"/>
                  <a:pt x="419" y="1983"/>
                  <a:pt x="418" y="1985"/>
                </a:cubicBezTo>
                <a:cubicBezTo>
                  <a:pt x="417" y="1987"/>
                  <a:pt x="415" y="1989"/>
                  <a:pt x="413" y="1992"/>
                </a:cubicBezTo>
                <a:cubicBezTo>
                  <a:pt x="411" y="1995"/>
                  <a:pt x="408" y="1999"/>
                  <a:pt x="404" y="2002"/>
                </a:cubicBezTo>
                <a:cubicBezTo>
                  <a:pt x="400" y="2006"/>
                  <a:pt x="397" y="2009"/>
                  <a:pt x="394" y="2011"/>
                </a:cubicBezTo>
                <a:cubicBezTo>
                  <a:pt x="391" y="2013"/>
                  <a:pt x="389" y="2015"/>
                  <a:pt x="386" y="2016"/>
                </a:cubicBezTo>
                <a:cubicBezTo>
                  <a:pt x="384" y="2017"/>
                  <a:pt x="383" y="2017"/>
                  <a:pt x="381" y="2017"/>
                </a:cubicBezTo>
                <a:cubicBezTo>
                  <a:pt x="380" y="2017"/>
                  <a:pt x="378" y="2016"/>
                  <a:pt x="377" y="2015"/>
                </a:cubicBezTo>
                <a:lnTo>
                  <a:pt x="120" y="1758"/>
                </a:lnTo>
                <a:lnTo>
                  <a:pt x="36" y="1841"/>
                </a:lnTo>
                <a:cubicBezTo>
                  <a:pt x="35" y="1842"/>
                  <a:pt x="34" y="1843"/>
                  <a:pt x="32" y="1843"/>
                </a:cubicBezTo>
                <a:cubicBezTo>
                  <a:pt x="30" y="1844"/>
                  <a:pt x="29" y="1844"/>
                  <a:pt x="27" y="1843"/>
                </a:cubicBezTo>
                <a:cubicBezTo>
                  <a:pt x="25" y="1842"/>
                  <a:pt x="23" y="1841"/>
                  <a:pt x="20" y="1839"/>
                </a:cubicBezTo>
                <a:cubicBezTo>
                  <a:pt x="18" y="1838"/>
                  <a:pt x="15" y="1835"/>
                  <a:pt x="12" y="1832"/>
                </a:cubicBezTo>
                <a:cubicBezTo>
                  <a:pt x="9" y="1829"/>
                  <a:pt x="7" y="1827"/>
                  <a:pt x="5" y="1824"/>
                </a:cubicBezTo>
                <a:cubicBezTo>
                  <a:pt x="3" y="1821"/>
                  <a:pt x="2" y="1819"/>
                  <a:pt x="1" y="1817"/>
                </a:cubicBezTo>
                <a:cubicBezTo>
                  <a:pt x="0" y="1815"/>
                  <a:pt x="0" y="1813"/>
                  <a:pt x="0" y="1812"/>
                </a:cubicBezTo>
                <a:cubicBezTo>
                  <a:pt x="1" y="1810"/>
                  <a:pt x="2" y="1809"/>
                  <a:pt x="3" y="1808"/>
                </a:cubicBezTo>
                <a:lnTo>
                  <a:pt x="209" y="1601"/>
                </a:lnTo>
                <a:cubicBezTo>
                  <a:pt x="210" y="1600"/>
                  <a:pt x="212" y="1599"/>
                  <a:pt x="213" y="1599"/>
                </a:cubicBezTo>
                <a:cubicBezTo>
                  <a:pt x="215" y="1598"/>
                  <a:pt x="217" y="1599"/>
                  <a:pt x="219" y="1599"/>
                </a:cubicBezTo>
                <a:cubicBezTo>
                  <a:pt x="221" y="1600"/>
                  <a:pt x="223" y="1601"/>
                  <a:pt x="226" y="1603"/>
                </a:cubicBezTo>
                <a:cubicBezTo>
                  <a:pt x="228" y="1605"/>
                  <a:pt x="231" y="1607"/>
                  <a:pt x="234" y="1610"/>
                </a:cubicBezTo>
                <a:close/>
                <a:moveTo>
                  <a:pt x="727" y="1665"/>
                </a:moveTo>
                <a:cubicBezTo>
                  <a:pt x="728" y="1666"/>
                  <a:pt x="729" y="1668"/>
                  <a:pt x="729" y="1669"/>
                </a:cubicBezTo>
                <a:cubicBezTo>
                  <a:pt x="730" y="1670"/>
                  <a:pt x="729" y="1672"/>
                  <a:pt x="729" y="1674"/>
                </a:cubicBezTo>
                <a:cubicBezTo>
                  <a:pt x="728" y="1676"/>
                  <a:pt x="726" y="1679"/>
                  <a:pt x="724" y="1681"/>
                </a:cubicBezTo>
                <a:cubicBezTo>
                  <a:pt x="722" y="1684"/>
                  <a:pt x="719" y="1687"/>
                  <a:pt x="716" y="1691"/>
                </a:cubicBezTo>
                <a:cubicBezTo>
                  <a:pt x="712" y="1695"/>
                  <a:pt x="708" y="1698"/>
                  <a:pt x="706" y="1700"/>
                </a:cubicBezTo>
                <a:cubicBezTo>
                  <a:pt x="703" y="1702"/>
                  <a:pt x="701" y="1703"/>
                  <a:pt x="699" y="1704"/>
                </a:cubicBezTo>
                <a:cubicBezTo>
                  <a:pt x="697" y="1705"/>
                  <a:pt x="695" y="1705"/>
                  <a:pt x="693" y="1705"/>
                </a:cubicBezTo>
                <a:cubicBezTo>
                  <a:pt x="692" y="1705"/>
                  <a:pt x="691" y="1704"/>
                  <a:pt x="689" y="1703"/>
                </a:cubicBezTo>
                <a:lnTo>
                  <a:pt x="569" y="1582"/>
                </a:lnTo>
                <a:cubicBezTo>
                  <a:pt x="557" y="1570"/>
                  <a:pt x="546" y="1562"/>
                  <a:pt x="537" y="1556"/>
                </a:cubicBezTo>
                <a:cubicBezTo>
                  <a:pt x="528" y="1551"/>
                  <a:pt x="519" y="1547"/>
                  <a:pt x="511" y="1546"/>
                </a:cubicBezTo>
                <a:cubicBezTo>
                  <a:pt x="502" y="1544"/>
                  <a:pt x="494" y="1545"/>
                  <a:pt x="485" y="1548"/>
                </a:cubicBezTo>
                <a:cubicBezTo>
                  <a:pt x="477" y="1550"/>
                  <a:pt x="469" y="1555"/>
                  <a:pt x="462" y="1563"/>
                </a:cubicBezTo>
                <a:cubicBezTo>
                  <a:pt x="452" y="1572"/>
                  <a:pt x="446" y="1585"/>
                  <a:pt x="443" y="1601"/>
                </a:cubicBezTo>
                <a:cubicBezTo>
                  <a:pt x="441" y="1617"/>
                  <a:pt x="441" y="1637"/>
                  <a:pt x="443" y="1661"/>
                </a:cubicBezTo>
                <a:lnTo>
                  <a:pt x="587" y="1805"/>
                </a:lnTo>
                <a:cubicBezTo>
                  <a:pt x="589" y="1806"/>
                  <a:pt x="589" y="1807"/>
                  <a:pt x="590" y="1809"/>
                </a:cubicBezTo>
                <a:cubicBezTo>
                  <a:pt x="590" y="1810"/>
                  <a:pt x="589" y="1812"/>
                  <a:pt x="589" y="1814"/>
                </a:cubicBezTo>
                <a:cubicBezTo>
                  <a:pt x="588" y="1816"/>
                  <a:pt x="587" y="1818"/>
                  <a:pt x="584" y="1821"/>
                </a:cubicBezTo>
                <a:cubicBezTo>
                  <a:pt x="582" y="1824"/>
                  <a:pt x="579" y="1827"/>
                  <a:pt x="575" y="1831"/>
                </a:cubicBezTo>
                <a:cubicBezTo>
                  <a:pt x="572" y="1835"/>
                  <a:pt x="569" y="1838"/>
                  <a:pt x="566" y="1840"/>
                </a:cubicBezTo>
                <a:cubicBezTo>
                  <a:pt x="563" y="1842"/>
                  <a:pt x="561" y="1843"/>
                  <a:pt x="559" y="1844"/>
                </a:cubicBezTo>
                <a:cubicBezTo>
                  <a:pt x="557" y="1845"/>
                  <a:pt x="555" y="1845"/>
                  <a:pt x="553" y="1845"/>
                </a:cubicBezTo>
                <a:cubicBezTo>
                  <a:pt x="552" y="1845"/>
                  <a:pt x="551" y="1844"/>
                  <a:pt x="550" y="1843"/>
                </a:cubicBezTo>
                <a:lnTo>
                  <a:pt x="243" y="1536"/>
                </a:lnTo>
                <a:cubicBezTo>
                  <a:pt x="242" y="1535"/>
                  <a:pt x="241" y="1534"/>
                  <a:pt x="241" y="1532"/>
                </a:cubicBezTo>
                <a:cubicBezTo>
                  <a:pt x="240" y="1531"/>
                  <a:pt x="241" y="1529"/>
                  <a:pt x="242" y="1527"/>
                </a:cubicBezTo>
                <a:cubicBezTo>
                  <a:pt x="242" y="1525"/>
                  <a:pt x="244" y="1523"/>
                  <a:pt x="246" y="1520"/>
                </a:cubicBezTo>
                <a:cubicBezTo>
                  <a:pt x="248" y="1517"/>
                  <a:pt x="251" y="1514"/>
                  <a:pt x="255" y="1510"/>
                </a:cubicBezTo>
                <a:cubicBezTo>
                  <a:pt x="259" y="1506"/>
                  <a:pt x="262" y="1503"/>
                  <a:pt x="265" y="1501"/>
                </a:cubicBezTo>
                <a:cubicBezTo>
                  <a:pt x="267" y="1499"/>
                  <a:pt x="270" y="1498"/>
                  <a:pt x="272" y="1497"/>
                </a:cubicBezTo>
                <a:cubicBezTo>
                  <a:pt x="274" y="1496"/>
                  <a:pt x="275" y="1496"/>
                  <a:pt x="277" y="1496"/>
                </a:cubicBezTo>
                <a:cubicBezTo>
                  <a:pt x="278" y="1497"/>
                  <a:pt x="280" y="1497"/>
                  <a:pt x="281" y="1499"/>
                </a:cubicBezTo>
                <a:lnTo>
                  <a:pt x="405" y="1622"/>
                </a:lnTo>
                <a:cubicBezTo>
                  <a:pt x="404" y="1600"/>
                  <a:pt x="406" y="1580"/>
                  <a:pt x="412" y="1564"/>
                </a:cubicBezTo>
                <a:cubicBezTo>
                  <a:pt x="417" y="1547"/>
                  <a:pt x="426" y="1533"/>
                  <a:pt x="437" y="1522"/>
                </a:cubicBezTo>
                <a:cubicBezTo>
                  <a:pt x="450" y="1508"/>
                  <a:pt x="464" y="1499"/>
                  <a:pt x="478" y="1494"/>
                </a:cubicBezTo>
                <a:cubicBezTo>
                  <a:pt x="493" y="1490"/>
                  <a:pt x="506" y="1488"/>
                  <a:pt x="520" y="1490"/>
                </a:cubicBezTo>
                <a:cubicBezTo>
                  <a:pt x="534" y="1492"/>
                  <a:pt x="547" y="1497"/>
                  <a:pt x="560" y="1505"/>
                </a:cubicBezTo>
                <a:cubicBezTo>
                  <a:pt x="573" y="1513"/>
                  <a:pt x="587" y="1525"/>
                  <a:pt x="602" y="1539"/>
                </a:cubicBezTo>
                <a:lnTo>
                  <a:pt x="727" y="1665"/>
                </a:lnTo>
                <a:close/>
                <a:moveTo>
                  <a:pt x="721" y="1286"/>
                </a:moveTo>
                <a:cubicBezTo>
                  <a:pt x="724" y="1289"/>
                  <a:pt x="727" y="1292"/>
                  <a:pt x="729" y="1295"/>
                </a:cubicBezTo>
                <a:cubicBezTo>
                  <a:pt x="731" y="1297"/>
                  <a:pt x="732" y="1299"/>
                  <a:pt x="733" y="1301"/>
                </a:cubicBezTo>
                <a:cubicBezTo>
                  <a:pt x="734" y="1303"/>
                  <a:pt x="735" y="1304"/>
                  <a:pt x="735" y="1306"/>
                </a:cubicBezTo>
                <a:cubicBezTo>
                  <a:pt x="735" y="1307"/>
                  <a:pt x="734" y="1308"/>
                  <a:pt x="733" y="1310"/>
                </a:cubicBezTo>
                <a:cubicBezTo>
                  <a:pt x="731" y="1311"/>
                  <a:pt x="730" y="1312"/>
                  <a:pt x="727" y="1313"/>
                </a:cubicBezTo>
                <a:cubicBezTo>
                  <a:pt x="725" y="1314"/>
                  <a:pt x="722" y="1315"/>
                  <a:pt x="719" y="1317"/>
                </a:cubicBezTo>
                <a:cubicBezTo>
                  <a:pt x="716" y="1319"/>
                  <a:pt x="713" y="1320"/>
                  <a:pt x="710" y="1322"/>
                </a:cubicBezTo>
                <a:cubicBezTo>
                  <a:pt x="706" y="1325"/>
                  <a:pt x="703" y="1327"/>
                  <a:pt x="700" y="1331"/>
                </a:cubicBezTo>
                <a:cubicBezTo>
                  <a:pt x="696" y="1334"/>
                  <a:pt x="693" y="1339"/>
                  <a:pt x="691" y="1344"/>
                </a:cubicBezTo>
                <a:cubicBezTo>
                  <a:pt x="689" y="1349"/>
                  <a:pt x="687" y="1356"/>
                  <a:pt x="687" y="1363"/>
                </a:cubicBezTo>
                <a:cubicBezTo>
                  <a:pt x="686" y="1371"/>
                  <a:pt x="687" y="1380"/>
                  <a:pt x="688" y="1390"/>
                </a:cubicBezTo>
                <a:cubicBezTo>
                  <a:pt x="690" y="1400"/>
                  <a:pt x="692" y="1412"/>
                  <a:pt x="695" y="1426"/>
                </a:cubicBezTo>
                <a:lnTo>
                  <a:pt x="831" y="1562"/>
                </a:lnTo>
                <a:cubicBezTo>
                  <a:pt x="832" y="1563"/>
                  <a:pt x="833" y="1564"/>
                  <a:pt x="833" y="1566"/>
                </a:cubicBezTo>
                <a:cubicBezTo>
                  <a:pt x="833" y="1567"/>
                  <a:pt x="833" y="1569"/>
                  <a:pt x="832" y="1571"/>
                </a:cubicBezTo>
                <a:cubicBezTo>
                  <a:pt x="831" y="1573"/>
                  <a:pt x="830" y="1575"/>
                  <a:pt x="828" y="1578"/>
                </a:cubicBezTo>
                <a:cubicBezTo>
                  <a:pt x="825" y="1581"/>
                  <a:pt x="822" y="1584"/>
                  <a:pt x="819" y="1588"/>
                </a:cubicBezTo>
                <a:cubicBezTo>
                  <a:pt x="815" y="1591"/>
                  <a:pt x="812" y="1594"/>
                  <a:pt x="809" y="1596"/>
                </a:cubicBezTo>
                <a:cubicBezTo>
                  <a:pt x="806" y="1599"/>
                  <a:pt x="804" y="1600"/>
                  <a:pt x="802" y="1601"/>
                </a:cubicBezTo>
                <a:cubicBezTo>
                  <a:pt x="800" y="1602"/>
                  <a:pt x="798" y="1602"/>
                  <a:pt x="797" y="1602"/>
                </a:cubicBezTo>
                <a:cubicBezTo>
                  <a:pt x="795" y="1601"/>
                  <a:pt x="794" y="1601"/>
                  <a:pt x="793" y="1599"/>
                </a:cubicBezTo>
                <a:lnTo>
                  <a:pt x="586" y="1393"/>
                </a:lnTo>
                <a:cubicBezTo>
                  <a:pt x="585" y="1392"/>
                  <a:pt x="584" y="1391"/>
                  <a:pt x="584" y="1389"/>
                </a:cubicBezTo>
                <a:cubicBezTo>
                  <a:pt x="584" y="1388"/>
                  <a:pt x="584" y="1386"/>
                  <a:pt x="584" y="1384"/>
                </a:cubicBezTo>
                <a:cubicBezTo>
                  <a:pt x="585" y="1382"/>
                  <a:pt x="586" y="1380"/>
                  <a:pt x="588" y="1378"/>
                </a:cubicBezTo>
                <a:cubicBezTo>
                  <a:pt x="590" y="1375"/>
                  <a:pt x="593" y="1372"/>
                  <a:pt x="597" y="1369"/>
                </a:cubicBezTo>
                <a:cubicBezTo>
                  <a:pt x="600" y="1365"/>
                  <a:pt x="603" y="1363"/>
                  <a:pt x="605" y="1361"/>
                </a:cubicBezTo>
                <a:cubicBezTo>
                  <a:pt x="608" y="1359"/>
                  <a:pt x="610" y="1358"/>
                  <a:pt x="612" y="1357"/>
                </a:cubicBezTo>
                <a:cubicBezTo>
                  <a:pt x="614" y="1356"/>
                  <a:pt x="615" y="1356"/>
                  <a:pt x="617" y="1357"/>
                </a:cubicBezTo>
                <a:cubicBezTo>
                  <a:pt x="618" y="1357"/>
                  <a:pt x="619" y="1358"/>
                  <a:pt x="621" y="1359"/>
                </a:cubicBezTo>
                <a:lnTo>
                  <a:pt x="651" y="1389"/>
                </a:lnTo>
                <a:cubicBezTo>
                  <a:pt x="648" y="1375"/>
                  <a:pt x="647" y="1363"/>
                  <a:pt x="646" y="1353"/>
                </a:cubicBezTo>
                <a:cubicBezTo>
                  <a:pt x="646" y="1343"/>
                  <a:pt x="647" y="1334"/>
                  <a:pt x="648" y="1327"/>
                </a:cubicBezTo>
                <a:cubicBezTo>
                  <a:pt x="650" y="1319"/>
                  <a:pt x="652" y="1313"/>
                  <a:pt x="655" y="1307"/>
                </a:cubicBezTo>
                <a:cubicBezTo>
                  <a:pt x="658" y="1302"/>
                  <a:pt x="662" y="1297"/>
                  <a:pt x="667" y="1292"/>
                </a:cubicBezTo>
                <a:cubicBezTo>
                  <a:pt x="669" y="1290"/>
                  <a:pt x="671" y="1288"/>
                  <a:pt x="674" y="1286"/>
                </a:cubicBezTo>
                <a:cubicBezTo>
                  <a:pt x="677" y="1284"/>
                  <a:pt x="680" y="1281"/>
                  <a:pt x="683" y="1279"/>
                </a:cubicBezTo>
                <a:cubicBezTo>
                  <a:pt x="686" y="1277"/>
                  <a:pt x="689" y="1275"/>
                  <a:pt x="692" y="1274"/>
                </a:cubicBezTo>
                <a:cubicBezTo>
                  <a:pt x="695" y="1272"/>
                  <a:pt x="698" y="1272"/>
                  <a:pt x="699" y="1271"/>
                </a:cubicBezTo>
                <a:cubicBezTo>
                  <a:pt x="701" y="1271"/>
                  <a:pt x="702" y="1271"/>
                  <a:pt x="703" y="1272"/>
                </a:cubicBezTo>
                <a:cubicBezTo>
                  <a:pt x="704" y="1272"/>
                  <a:pt x="706" y="1273"/>
                  <a:pt x="707" y="1274"/>
                </a:cubicBezTo>
                <a:cubicBezTo>
                  <a:pt x="708" y="1274"/>
                  <a:pt x="710" y="1276"/>
                  <a:pt x="712" y="1278"/>
                </a:cubicBezTo>
                <a:cubicBezTo>
                  <a:pt x="714" y="1280"/>
                  <a:pt x="717" y="1283"/>
                  <a:pt x="721" y="1286"/>
                </a:cubicBezTo>
                <a:close/>
                <a:moveTo>
                  <a:pt x="1021" y="1147"/>
                </a:moveTo>
                <a:cubicBezTo>
                  <a:pt x="1027" y="1153"/>
                  <a:pt x="1029" y="1159"/>
                  <a:pt x="1029" y="1164"/>
                </a:cubicBezTo>
                <a:cubicBezTo>
                  <a:pt x="1029" y="1170"/>
                  <a:pt x="1026" y="1175"/>
                  <a:pt x="1023" y="1178"/>
                </a:cubicBezTo>
                <a:lnTo>
                  <a:pt x="887" y="1314"/>
                </a:lnTo>
                <a:cubicBezTo>
                  <a:pt x="898" y="1326"/>
                  <a:pt x="910" y="1335"/>
                  <a:pt x="921" y="1342"/>
                </a:cubicBezTo>
                <a:cubicBezTo>
                  <a:pt x="933" y="1349"/>
                  <a:pt x="944" y="1353"/>
                  <a:pt x="956" y="1354"/>
                </a:cubicBezTo>
                <a:cubicBezTo>
                  <a:pt x="968" y="1355"/>
                  <a:pt x="980" y="1353"/>
                  <a:pt x="992" y="1348"/>
                </a:cubicBezTo>
                <a:cubicBezTo>
                  <a:pt x="1004" y="1343"/>
                  <a:pt x="1017" y="1334"/>
                  <a:pt x="1029" y="1322"/>
                </a:cubicBezTo>
                <a:cubicBezTo>
                  <a:pt x="1039" y="1312"/>
                  <a:pt x="1047" y="1302"/>
                  <a:pt x="1053" y="1293"/>
                </a:cubicBezTo>
                <a:cubicBezTo>
                  <a:pt x="1059" y="1284"/>
                  <a:pt x="1064" y="1275"/>
                  <a:pt x="1068" y="1268"/>
                </a:cubicBezTo>
                <a:cubicBezTo>
                  <a:pt x="1071" y="1260"/>
                  <a:pt x="1074" y="1254"/>
                  <a:pt x="1076" y="1249"/>
                </a:cubicBezTo>
                <a:cubicBezTo>
                  <a:pt x="1078" y="1243"/>
                  <a:pt x="1080" y="1240"/>
                  <a:pt x="1082" y="1238"/>
                </a:cubicBezTo>
                <a:cubicBezTo>
                  <a:pt x="1083" y="1237"/>
                  <a:pt x="1084" y="1236"/>
                  <a:pt x="1085" y="1236"/>
                </a:cubicBezTo>
                <a:cubicBezTo>
                  <a:pt x="1087" y="1236"/>
                  <a:pt x="1088" y="1236"/>
                  <a:pt x="1090" y="1236"/>
                </a:cubicBezTo>
                <a:cubicBezTo>
                  <a:pt x="1091" y="1237"/>
                  <a:pt x="1093" y="1238"/>
                  <a:pt x="1095" y="1240"/>
                </a:cubicBezTo>
                <a:cubicBezTo>
                  <a:pt x="1097" y="1242"/>
                  <a:pt x="1100" y="1244"/>
                  <a:pt x="1103" y="1246"/>
                </a:cubicBezTo>
                <a:cubicBezTo>
                  <a:pt x="1105" y="1248"/>
                  <a:pt x="1106" y="1250"/>
                  <a:pt x="1108" y="1252"/>
                </a:cubicBezTo>
                <a:cubicBezTo>
                  <a:pt x="1109" y="1253"/>
                  <a:pt x="1110" y="1255"/>
                  <a:pt x="1111" y="1256"/>
                </a:cubicBezTo>
                <a:cubicBezTo>
                  <a:pt x="1112" y="1258"/>
                  <a:pt x="1112" y="1259"/>
                  <a:pt x="1113" y="1261"/>
                </a:cubicBezTo>
                <a:cubicBezTo>
                  <a:pt x="1113" y="1262"/>
                  <a:pt x="1113" y="1264"/>
                  <a:pt x="1113" y="1265"/>
                </a:cubicBezTo>
                <a:cubicBezTo>
                  <a:pt x="1113" y="1267"/>
                  <a:pt x="1112" y="1271"/>
                  <a:pt x="1110" y="1277"/>
                </a:cubicBezTo>
                <a:cubicBezTo>
                  <a:pt x="1108" y="1283"/>
                  <a:pt x="1104" y="1290"/>
                  <a:pt x="1100" y="1299"/>
                </a:cubicBezTo>
                <a:cubicBezTo>
                  <a:pt x="1095" y="1307"/>
                  <a:pt x="1089" y="1316"/>
                  <a:pt x="1082" y="1326"/>
                </a:cubicBezTo>
                <a:cubicBezTo>
                  <a:pt x="1075" y="1336"/>
                  <a:pt x="1066" y="1346"/>
                  <a:pt x="1056" y="1356"/>
                </a:cubicBezTo>
                <a:cubicBezTo>
                  <a:pt x="1039" y="1373"/>
                  <a:pt x="1022" y="1386"/>
                  <a:pt x="1005" y="1394"/>
                </a:cubicBezTo>
                <a:cubicBezTo>
                  <a:pt x="987" y="1402"/>
                  <a:pt x="969" y="1405"/>
                  <a:pt x="951" y="1405"/>
                </a:cubicBezTo>
                <a:cubicBezTo>
                  <a:pt x="933" y="1404"/>
                  <a:pt x="915" y="1399"/>
                  <a:pt x="897" y="1389"/>
                </a:cubicBezTo>
                <a:cubicBezTo>
                  <a:pt x="878" y="1380"/>
                  <a:pt x="859" y="1366"/>
                  <a:pt x="841" y="1347"/>
                </a:cubicBezTo>
                <a:cubicBezTo>
                  <a:pt x="823" y="1329"/>
                  <a:pt x="809" y="1311"/>
                  <a:pt x="800" y="1292"/>
                </a:cubicBezTo>
                <a:cubicBezTo>
                  <a:pt x="790" y="1273"/>
                  <a:pt x="785" y="1255"/>
                  <a:pt x="784" y="1236"/>
                </a:cubicBezTo>
                <a:cubicBezTo>
                  <a:pt x="783" y="1218"/>
                  <a:pt x="785" y="1200"/>
                  <a:pt x="792" y="1182"/>
                </a:cubicBezTo>
                <a:cubicBezTo>
                  <a:pt x="799" y="1165"/>
                  <a:pt x="810" y="1149"/>
                  <a:pt x="825" y="1133"/>
                </a:cubicBezTo>
                <a:cubicBezTo>
                  <a:pt x="842" y="1117"/>
                  <a:pt x="858" y="1106"/>
                  <a:pt x="875" y="1100"/>
                </a:cubicBezTo>
                <a:cubicBezTo>
                  <a:pt x="891" y="1094"/>
                  <a:pt x="908" y="1091"/>
                  <a:pt x="924" y="1093"/>
                </a:cubicBezTo>
                <a:cubicBezTo>
                  <a:pt x="940" y="1094"/>
                  <a:pt x="956" y="1099"/>
                  <a:pt x="971" y="1108"/>
                </a:cubicBezTo>
                <a:cubicBezTo>
                  <a:pt x="986" y="1116"/>
                  <a:pt x="1000" y="1127"/>
                  <a:pt x="1014" y="1140"/>
                </a:cubicBezTo>
                <a:lnTo>
                  <a:pt x="1021" y="1147"/>
                </a:lnTo>
                <a:close/>
                <a:moveTo>
                  <a:pt x="971" y="1174"/>
                </a:moveTo>
                <a:cubicBezTo>
                  <a:pt x="952" y="1154"/>
                  <a:pt x="932" y="1143"/>
                  <a:pt x="911" y="1141"/>
                </a:cubicBezTo>
                <a:cubicBezTo>
                  <a:pt x="891" y="1139"/>
                  <a:pt x="871" y="1147"/>
                  <a:pt x="853" y="1165"/>
                </a:cubicBezTo>
                <a:cubicBezTo>
                  <a:pt x="844" y="1174"/>
                  <a:pt x="837" y="1184"/>
                  <a:pt x="834" y="1195"/>
                </a:cubicBezTo>
                <a:cubicBezTo>
                  <a:pt x="830" y="1206"/>
                  <a:pt x="829" y="1216"/>
                  <a:pt x="830" y="1227"/>
                </a:cubicBezTo>
                <a:cubicBezTo>
                  <a:pt x="831" y="1237"/>
                  <a:pt x="834" y="1248"/>
                  <a:pt x="839" y="1258"/>
                </a:cubicBezTo>
                <a:cubicBezTo>
                  <a:pt x="844" y="1268"/>
                  <a:pt x="851" y="1278"/>
                  <a:pt x="859" y="1287"/>
                </a:cubicBezTo>
                <a:lnTo>
                  <a:pt x="971" y="1174"/>
                </a:lnTo>
                <a:close/>
                <a:moveTo>
                  <a:pt x="1281" y="900"/>
                </a:moveTo>
                <a:cubicBezTo>
                  <a:pt x="1298" y="917"/>
                  <a:pt x="1311" y="935"/>
                  <a:pt x="1321" y="954"/>
                </a:cubicBezTo>
                <a:cubicBezTo>
                  <a:pt x="1330" y="972"/>
                  <a:pt x="1336" y="991"/>
                  <a:pt x="1337" y="1010"/>
                </a:cubicBezTo>
                <a:cubicBezTo>
                  <a:pt x="1339" y="1029"/>
                  <a:pt x="1336" y="1048"/>
                  <a:pt x="1328" y="1067"/>
                </a:cubicBezTo>
                <a:cubicBezTo>
                  <a:pt x="1321" y="1086"/>
                  <a:pt x="1308" y="1104"/>
                  <a:pt x="1291" y="1121"/>
                </a:cubicBezTo>
                <a:cubicBezTo>
                  <a:pt x="1274" y="1138"/>
                  <a:pt x="1257" y="1151"/>
                  <a:pt x="1239" y="1158"/>
                </a:cubicBezTo>
                <a:cubicBezTo>
                  <a:pt x="1221" y="1166"/>
                  <a:pt x="1203" y="1169"/>
                  <a:pt x="1185" y="1168"/>
                </a:cubicBezTo>
                <a:cubicBezTo>
                  <a:pt x="1167" y="1167"/>
                  <a:pt x="1149" y="1161"/>
                  <a:pt x="1132" y="1151"/>
                </a:cubicBezTo>
                <a:cubicBezTo>
                  <a:pt x="1114" y="1142"/>
                  <a:pt x="1096" y="1128"/>
                  <a:pt x="1079" y="1111"/>
                </a:cubicBezTo>
                <a:cubicBezTo>
                  <a:pt x="1062" y="1094"/>
                  <a:pt x="1049" y="1076"/>
                  <a:pt x="1039" y="1058"/>
                </a:cubicBezTo>
                <a:cubicBezTo>
                  <a:pt x="1029" y="1039"/>
                  <a:pt x="1023" y="1021"/>
                  <a:pt x="1022" y="1002"/>
                </a:cubicBezTo>
                <a:cubicBezTo>
                  <a:pt x="1020" y="983"/>
                  <a:pt x="1023" y="964"/>
                  <a:pt x="1031" y="945"/>
                </a:cubicBezTo>
                <a:cubicBezTo>
                  <a:pt x="1038" y="926"/>
                  <a:pt x="1051" y="908"/>
                  <a:pt x="1069" y="890"/>
                </a:cubicBezTo>
                <a:cubicBezTo>
                  <a:pt x="1086" y="873"/>
                  <a:pt x="1103" y="861"/>
                  <a:pt x="1120" y="854"/>
                </a:cubicBezTo>
                <a:cubicBezTo>
                  <a:pt x="1138" y="846"/>
                  <a:pt x="1156" y="843"/>
                  <a:pt x="1174" y="844"/>
                </a:cubicBezTo>
                <a:cubicBezTo>
                  <a:pt x="1192" y="845"/>
                  <a:pt x="1210" y="851"/>
                  <a:pt x="1228" y="860"/>
                </a:cubicBezTo>
                <a:cubicBezTo>
                  <a:pt x="1246" y="870"/>
                  <a:pt x="1264" y="883"/>
                  <a:pt x="1281" y="900"/>
                </a:cubicBezTo>
                <a:close/>
                <a:moveTo>
                  <a:pt x="1244" y="942"/>
                </a:moveTo>
                <a:cubicBezTo>
                  <a:pt x="1233" y="931"/>
                  <a:pt x="1221" y="922"/>
                  <a:pt x="1209" y="914"/>
                </a:cubicBezTo>
                <a:cubicBezTo>
                  <a:pt x="1197" y="906"/>
                  <a:pt x="1185" y="901"/>
                  <a:pt x="1173" y="898"/>
                </a:cubicBezTo>
                <a:cubicBezTo>
                  <a:pt x="1161" y="895"/>
                  <a:pt x="1148" y="896"/>
                  <a:pt x="1136" y="899"/>
                </a:cubicBezTo>
                <a:cubicBezTo>
                  <a:pt x="1123" y="903"/>
                  <a:pt x="1111" y="911"/>
                  <a:pt x="1099" y="923"/>
                </a:cubicBezTo>
                <a:cubicBezTo>
                  <a:pt x="1087" y="935"/>
                  <a:pt x="1080" y="946"/>
                  <a:pt x="1076" y="958"/>
                </a:cubicBezTo>
                <a:cubicBezTo>
                  <a:pt x="1071" y="971"/>
                  <a:pt x="1070" y="983"/>
                  <a:pt x="1072" y="995"/>
                </a:cubicBezTo>
                <a:cubicBezTo>
                  <a:pt x="1074" y="1008"/>
                  <a:pt x="1079" y="1020"/>
                  <a:pt x="1087" y="1033"/>
                </a:cubicBezTo>
                <a:cubicBezTo>
                  <a:pt x="1094" y="1045"/>
                  <a:pt x="1104" y="1057"/>
                  <a:pt x="1115" y="1069"/>
                </a:cubicBezTo>
                <a:cubicBezTo>
                  <a:pt x="1127" y="1081"/>
                  <a:pt x="1138" y="1090"/>
                  <a:pt x="1150" y="1098"/>
                </a:cubicBezTo>
                <a:cubicBezTo>
                  <a:pt x="1162" y="1106"/>
                  <a:pt x="1174" y="1111"/>
                  <a:pt x="1187" y="1114"/>
                </a:cubicBezTo>
                <a:cubicBezTo>
                  <a:pt x="1199" y="1116"/>
                  <a:pt x="1211" y="1115"/>
                  <a:pt x="1224" y="1112"/>
                </a:cubicBezTo>
                <a:cubicBezTo>
                  <a:pt x="1236" y="1108"/>
                  <a:pt x="1249" y="1100"/>
                  <a:pt x="1261" y="1088"/>
                </a:cubicBezTo>
                <a:cubicBezTo>
                  <a:pt x="1272" y="1077"/>
                  <a:pt x="1280" y="1065"/>
                  <a:pt x="1284" y="1053"/>
                </a:cubicBezTo>
                <a:cubicBezTo>
                  <a:pt x="1288" y="1041"/>
                  <a:pt x="1289" y="1028"/>
                  <a:pt x="1287" y="1016"/>
                </a:cubicBezTo>
                <a:cubicBezTo>
                  <a:pt x="1285" y="1003"/>
                  <a:pt x="1281" y="991"/>
                  <a:pt x="1273" y="979"/>
                </a:cubicBezTo>
                <a:cubicBezTo>
                  <a:pt x="1266" y="966"/>
                  <a:pt x="1256" y="954"/>
                  <a:pt x="1244" y="942"/>
                </a:cubicBezTo>
                <a:close/>
                <a:moveTo>
                  <a:pt x="1621" y="771"/>
                </a:moveTo>
                <a:cubicBezTo>
                  <a:pt x="1622" y="772"/>
                  <a:pt x="1623" y="774"/>
                  <a:pt x="1623" y="775"/>
                </a:cubicBezTo>
                <a:cubicBezTo>
                  <a:pt x="1623" y="777"/>
                  <a:pt x="1623" y="778"/>
                  <a:pt x="1622" y="780"/>
                </a:cubicBezTo>
                <a:cubicBezTo>
                  <a:pt x="1622" y="782"/>
                  <a:pt x="1620" y="785"/>
                  <a:pt x="1618" y="788"/>
                </a:cubicBezTo>
                <a:cubicBezTo>
                  <a:pt x="1616" y="790"/>
                  <a:pt x="1613" y="793"/>
                  <a:pt x="1609" y="797"/>
                </a:cubicBezTo>
                <a:cubicBezTo>
                  <a:pt x="1605" y="801"/>
                  <a:pt x="1602" y="804"/>
                  <a:pt x="1599" y="806"/>
                </a:cubicBezTo>
                <a:cubicBezTo>
                  <a:pt x="1597" y="808"/>
                  <a:pt x="1594" y="810"/>
                  <a:pt x="1592" y="810"/>
                </a:cubicBezTo>
                <a:cubicBezTo>
                  <a:pt x="1590" y="811"/>
                  <a:pt x="1589" y="811"/>
                  <a:pt x="1587" y="811"/>
                </a:cubicBezTo>
                <a:cubicBezTo>
                  <a:pt x="1586" y="811"/>
                  <a:pt x="1584" y="810"/>
                  <a:pt x="1583" y="809"/>
                </a:cubicBezTo>
                <a:lnTo>
                  <a:pt x="1462" y="688"/>
                </a:lnTo>
                <a:cubicBezTo>
                  <a:pt x="1451" y="676"/>
                  <a:pt x="1440" y="668"/>
                  <a:pt x="1431" y="663"/>
                </a:cubicBezTo>
                <a:cubicBezTo>
                  <a:pt x="1422" y="657"/>
                  <a:pt x="1413" y="654"/>
                  <a:pt x="1405" y="652"/>
                </a:cubicBezTo>
                <a:cubicBezTo>
                  <a:pt x="1396" y="650"/>
                  <a:pt x="1387" y="651"/>
                  <a:pt x="1379" y="654"/>
                </a:cubicBezTo>
                <a:cubicBezTo>
                  <a:pt x="1371" y="657"/>
                  <a:pt x="1363" y="662"/>
                  <a:pt x="1355" y="669"/>
                </a:cubicBezTo>
                <a:cubicBezTo>
                  <a:pt x="1346" y="678"/>
                  <a:pt x="1340" y="691"/>
                  <a:pt x="1337" y="707"/>
                </a:cubicBezTo>
                <a:cubicBezTo>
                  <a:pt x="1334" y="724"/>
                  <a:pt x="1334" y="743"/>
                  <a:pt x="1337" y="767"/>
                </a:cubicBezTo>
                <a:lnTo>
                  <a:pt x="1481" y="911"/>
                </a:lnTo>
                <a:cubicBezTo>
                  <a:pt x="1482" y="912"/>
                  <a:pt x="1483" y="914"/>
                  <a:pt x="1483" y="915"/>
                </a:cubicBezTo>
                <a:cubicBezTo>
                  <a:pt x="1484" y="917"/>
                  <a:pt x="1483" y="918"/>
                  <a:pt x="1483" y="920"/>
                </a:cubicBezTo>
                <a:cubicBezTo>
                  <a:pt x="1482" y="922"/>
                  <a:pt x="1480" y="925"/>
                  <a:pt x="1478" y="927"/>
                </a:cubicBezTo>
                <a:cubicBezTo>
                  <a:pt x="1476" y="930"/>
                  <a:pt x="1473" y="933"/>
                  <a:pt x="1469" y="937"/>
                </a:cubicBezTo>
                <a:cubicBezTo>
                  <a:pt x="1466" y="941"/>
                  <a:pt x="1462" y="944"/>
                  <a:pt x="1460" y="946"/>
                </a:cubicBezTo>
                <a:cubicBezTo>
                  <a:pt x="1457" y="948"/>
                  <a:pt x="1454" y="950"/>
                  <a:pt x="1452" y="950"/>
                </a:cubicBezTo>
                <a:cubicBezTo>
                  <a:pt x="1450" y="951"/>
                  <a:pt x="1449" y="952"/>
                  <a:pt x="1447" y="951"/>
                </a:cubicBezTo>
                <a:cubicBezTo>
                  <a:pt x="1446" y="951"/>
                  <a:pt x="1445" y="950"/>
                  <a:pt x="1443" y="949"/>
                </a:cubicBezTo>
                <a:lnTo>
                  <a:pt x="1237" y="743"/>
                </a:lnTo>
                <a:cubicBezTo>
                  <a:pt x="1236" y="741"/>
                  <a:pt x="1235" y="740"/>
                  <a:pt x="1235" y="739"/>
                </a:cubicBezTo>
                <a:cubicBezTo>
                  <a:pt x="1234" y="737"/>
                  <a:pt x="1234" y="736"/>
                  <a:pt x="1235" y="734"/>
                </a:cubicBezTo>
                <a:cubicBezTo>
                  <a:pt x="1236" y="732"/>
                  <a:pt x="1237" y="729"/>
                  <a:pt x="1239" y="727"/>
                </a:cubicBezTo>
                <a:cubicBezTo>
                  <a:pt x="1241" y="725"/>
                  <a:pt x="1244" y="722"/>
                  <a:pt x="1247" y="718"/>
                </a:cubicBezTo>
                <a:cubicBezTo>
                  <a:pt x="1250" y="715"/>
                  <a:pt x="1253" y="712"/>
                  <a:pt x="1256" y="710"/>
                </a:cubicBezTo>
                <a:cubicBezTo>
                  <a:pt x="1258" y="708"/>
                  <a:pt x="1260" y="707"/>
                  <a:pt x="1262" y="706"/>
                </a:cubicBezTo>
                <a:cubicBezTo>
                  <a:pt x="1264" y="706"/>
                  <a:pt x="1266" y="706"/>
                  <a:pt x="1267" y="706"/>
                </a:cubicBezTo>
                <a:cubicBezTo>
                  <a:pt x="1269" y="706"/>
                  <a:pt x="1270" y="707"/>
                  <a:pt x="1271" y="708"/>
                </a:cubicBezTo>
                <a:lnTo>
                  <a:pt x="1298" y="736"/>
                </a:lnTo>
                <a:cubicBezTo>
                  <a:pt x="1297" y="711"/>
                  <a:pt x="1299" y="690"/>
                  <a:pt x="1305" y="672"/>
                </a:cubicBezTo>
                <a:cubicBezTo>
                  <a:pt x="1310" y="655"/>
                  <a:pt x="1319" y="640"/>
                  <a:pt x="1331" y="628"/>
                </a:cubicBezTo>
                <a:cubicBezTo>
                  <a:pt x="1344" y="615"/>
                  <a:pt x="1358" y="605"/>
                  <a:pt x="1372" y="601"/>
                </a:cubicBezTo>
                <a:cubicBezTo>
                  <a:pt x="1386" y="596"/>
                  <a:pt x="1400" y="595"/>
                  <a:pt x="1414" y="597"/>
                </a:cubicBezTo>
                <a:cubicBezTo>
                  <a:pt x="1427" y="599"/>
                  <a:pt x="1441" y="603"/>
                  <a:pt x="1454" y="611"/>
                </a:cubicBezTo>
                <a:cubicBezTo>
                  <a:pt x="1467" y="619"/>
                  <a:pt x="1480" y="631"/>
                  <a:pt x="1495" y="645"/>
                </a:cubicBezTo>
                <a:lnTo>
                  <a:pt x="1621" y="771"/>
                </a:lnTo>
                <a:close/>
                <a:moveTo>
                  <a:pt x="1730" y="662"/>
                </a:moveTo>
                <a:cubicBezTo>
                  <a:pt x="1731" y="663"/>
                  <a:pt x="1732" y="665"/>
                  <a:pt x="1732" y="666"/>
                </a:cubicBezTo>
                <a:cubicBezTo>
                  <a:pt x="1732" y="668"/>
                  <a:pt x="1732" y="669"/>
                  <a:pt x="1731" y="671"/>
                </a:cubicBezTo>
                <a:cubicBezTo>
                  <a:pt x="1731" y="673"/>
                  <a:pt x="1729" y="676"/>
                  <a:pt x="1727" y="678"/>
                </a:cubicBezTo>
                <a:cubicBezTo>
                  <a:pt x="1725" y="681"/>
                  <a:pt x="1722" y="684"/>
                  <a:pt x="1718" y="688"/>
                </a:cubicBezTo>
                <a:cubicBezTo>
                  <a:pt x="1714" y="692"/>
                  <a:pt x="1711" y="695"/>
                  <a:pt x="1708" y="697"/>
                </a:cubicBezTo>
                <a:cubicBezTo>
                  <a:pt x="1706" y="699"/>
                  <a:pt x="1703" y="701"/>
                  <a:pt x="1701" y="701"/>
                </a:cubicBezTo>
                <a:cubicBezTo>
                  <a:pt x="1699" y="702"/>
                  <a:pt x="1697" y="703"/>
                  <a:pt x="1696" y="702"/>
                </a:cubicBezTo>
                <a:cubicBezTo>
                  <a:pt x="1695" y="702"/>
                  <a:pt x="1693" y="701"/>
                  <a:pt x="1692" y="700"/>
                </a:cubicBezTo>
                <a:lnTo>
                  <a:pt x="1486" y="494"/>
                </a:lnTo>
                <a:cubicBezTo>
                  <a:pt x="1485" y="493"/>
                  <a:pt x="1484" y="491"/>
                  <a:pt x="1484" y="490"/>
                </a:cubicBezTo>
                <a:cubicBezTo>
                  <a:pt x="1483" y="488"/>
                  <a:pt x="1484" y="487"/>
                  <a:pt x="1484" y="485"/>
                </a:cubicBezTo>
                <a:cubicBezTo>
                  <a:pt x="1485" y="483"/>
                  <a:pt x="1487" y="480"/>
                  <a:pt x="1489" y="477"/>
                </a:cubicBezTo>
                <a:cubicBezTo>
                  <a:pt x="1491" y="475"/>
                  <a:pt x="1494" y="471"/>
                  <a:pt x="1498" y="468"/>
                </a:cubicBezTo>
                <a:cubicBezTo>
                  <a:pt x="1501" y="464"/>
                  <a:pt x="1505" y="461"/>
                  <a:pt x="1507" y="459"/>
                </a:cubicBezTo>
                <a:cubicBezTo>
                  <a:pt x="1510" y="457"/>
                  <a:pt x="1513" y="455"/>
                  <a:pt x="1515" y="454"/>
                </a:cubicBezTo>
                <a:cubicBezTo>
                  <a:pt x="1517" y="454"/>
                  <a:pt x="1518" y="453"/>
                  <a:pt x="1520" y="454"/>
                </a:cubicBezTo>
                <a:cubicBezTo>
                  <a:pt x="1521" y="454"/>
                  <a:pt x="1523" y="455"/>
                  <a:pt x="1524" y="456"/>
                </a:cubicBezTo>
                <a:lnTo>
                  <a:pt x="1730" y="662"/>
                </a:lnTo>
                <a:close/>
                <a:moveTo>
                  <a:pt x="1458" y="382"/>
                </a:moveTo>
                <a:cubicBezTo>
                  <a:pt x="1467" y="391"/>
                  <a:pt x="1472" y="398"/>
                  <a:pt x="1471" y="405"/>
                </a:cubicBezTo>
                <a:cubicBezTo>
                  <a:pt x="1471" y="412"/>
                  <a:pt x="1467" y="419"/>
                  <a:pt x="1458" y="428"/>
                </a:cubicBezTo>
                <a:cubicBezTo>
                  <a:pt x="1449" y="437"/>
                  <a:pt x="1441" y="442"/>
                  <a:pt x="1435" y="442"/>
                </a:cubicBezTo>
                <a:cubicBezTo>
                  <a:pt x="1428" y="442"/>
                  <a:pt x="1421" y="438"/>
                  <a:pt x="1412" y="429"/>
                </a:cubicBezTo>
                <a:cubicBezTo>
                  <a:pt x="1403" y="420"/>
                  <a:pt x="1399" y="412"/>
                  <a:pt x="1399" y="406"/>
                </a:cubicBezTo>
                <a:cubicBezTo>
                  <a:pt x="1399" y="399"/>
                  <a:pt x="1404" y="391"/>
                  <a:pt x="1413" y="382"/>
                </a:cubicBezTo>
                <a:cubicBezTo>
                  <a:pt x="1422" y="374"/>
                  <a:pt x="1429" y="369"/>
                  <a:pt x="1436" y="369"/>
                </a:cubicBezTo>
                <a:cubicBezTo>
                  <a:pt x="1442" y="369"/>
                  <a:pt x="1450" y="373"/>
                  <a:pt x="1458" y="382"/>
                </a:cubicBezTo>
                <a:close/>
                <a:moveTo>
                  <a:pt x="1977" y="415"/>
                </a:moveTo>
                <a:cubicBezTo>
                  <a:pt x="1979" y="416"/>
                  <a:pt x="1979" y="417"/>
                  <a:pt x="1980" y="419"/>
                </a:cubicBezTo>
                <a:cubicBezTo>
                  <a:pt x="1980" y="420"/>
                  <a:pt x="1980" y="422"/>
                  <a:pt x="1979" y="424"/>
                </a:cubicBezTo>
                <a:cubicBezTo>
                  <a:pt x="1978" y="426"/>
                  <a:pt x="1977" y="428"/>
                  <a:pt x="1974" y="431"/>
                </a:cubicBezTo>
                <a:cubicBezTo>
                  <a:pt x="1972" y="434"/>
                  <a:pt x="1969" y="437"/>
                  <a:pt x="1966" y="441"/>
                </a:cubicBezTo>
                <a:cubicBezTo>
                  <a:pt x="1962" y="445"/>
                  <a:pt x="1959" y="448"/>
                  <a:pt x="1956" y="450"/>
                </a:cubicBezTo>
                <a:cubicBezTo>
                  <a:pt x="1953" y="452"/>
                  <a:pt x="1951" y="453"/>
                  <a:pt x="1949" y="454"/>
                </a:cubicBezTo>
                <a:cubicBezTo>
                  <a:pt x="1947" y="455"/>
                  <a:pt x="1945" y="455"/>
                  <a:pt x="1944" y="455"/>
                </a:cubicBezTo>
                <a:cubicBezTo>
                  <a:pt x="1942" y="455"/>
                  <a:pt x="1941" y="454"/>
                  <a:pt x="1940" y="453"/>
                </a:cubicBezTo>
                <a:lnTo>
                  <a:pt x="1819" y="332"/>
                </a:lnTo>
                <a:cubicBezTo>
                  <a:pt x="1807" y="320"/>
                  <a:pt x="1797" y="312"/>
                  <a:pt x="1788" y="306"/>
                </a:cubicBezTo>
                <a:cubicBezTo>
                  <a:pt x="1779" y="301"/>
                  <a:pt x="1770" y="297"/>
                  <a:pt x="1761" y="296"/>
                </a:cubicBezTo>
                <a:cubicBezTo>
                  <a:pt x="1752" y="294"/>
                  <a:pt x="1744" y="295"/>
                  <a:pt x="1735" y="297"/>
                </a:cubicBezTo>
                <a:cubicBezTo>
                  <a:pt x="1727" y="300"/>
                  <a:pt x="1719" y="305"/>
                  <a:pt x="1712" y="313"/>
                </a:cubicBezTo>
                <a:cubicBezTo>
                  <a:pt x="1702" y="322"/>
                  <a:pt x="1696" y="335"/>
                  <a:pt x="1694" y="351"/>
                </a:cubicBezTo>
                <a:cubicBezTo>
                  <a:pt x="1691" y="367"/>
                  <a:pt x="1691" y="387"/>
                  <a:pt x="1693" y="410"/>
                </a:cubicBezTo>
                <a:lnTo>
                  <a:pt x="1838" y="555"/>
                </a:lnTo>
                <a:cubicBezTo>
                  <a:pt x="1839" y="556"/>
                  <a:pt x="1839" y="557"/>
                  <a:pt x="1840" y="559"/>
                </a:cubicBezTo>
                <a:cubicBezTo>
                  <a:pt x="1840" y="560"/>
                  <a:pt x="1840" y="562"/>
                  <a:pt x="1839" y="564"/>
                </a:cubicBezTo>
                <a:cubicBezTo>
                  <a:pt x="1838" y="566"/>
                  <a:pt x="1837" y="568"/>
                  <a:pt x="1835" y="571"/>
                </a:cubicBezTo>
                <a:cubicBezTo>
                  <a:pt x="1832" y="574"/>
                  <a:pt x="1829" y="577"/>
                  <a:pt x="1826" y="581"/>
                </a:cubicBezTo>
                <a:cubicBezTo>
                  <a:pt x="1822" y="584"/>
                  <a:pt x="1819" y="587"/>
                  <a:pt x="1816" y="590"/>
                </a:cubicBezTo>
                <a:cubicBezTo>
                  <a:pt x="1813" y="592"/>
                  <a:pt x="1811" y="593"/>
                  <a:pt x="1809" y="594"/>
                </a:cubicBezTo>
                <a:cubicBezTo>
                  <a:pt x="1807" y="595"/>
                  <a:pt x="1805" y="595"/>
                  <a:pt x="1804" y="595"/>
                </a:cubicBezTo>
                <a:cubicBezTo>
                  <a:pt x="1802" y="595"/>
                  <a:pt x="1801" y="594"/>
                  <a:pt x="1800" y="593"/>
                </a:cubicBezTo>
                <a:lnTo>
                  <a:pt x="1593" y="386"/>
                </a:lnTo>
                <a:cubicBezTo>
                  <a:pt x="1592" y="385"/>
                  <a:pt x="1591" y="384"/>
                  <a:pt x="1591" y="382"/>
                </a:cubicBezTo>
                <a:cubicBezTo>
                  <a:pt x="1591" y="381"/>
                  <a:pt x="1591" y="379"/>
                  <a:pt x="1591" y="377"/>
                </a:cubicBezTo>
                <a:cubicBezTo>
                  <a:pt x="1592" y="375"/>
                  <a:pt x="1593" y="373"/>
                  <a:pt x="1595" y="371"/>
                </a:cubicBezTo>
                <a:cubicBezTo>
                  <a:pt x="1597" y="368"/>
                  <a:pt x="1600" y="365"/>
                  <a:pt x="1603" y="362"/>
                </a:cubicBezTo>
                <a:cubicBezTo>
                  <a:pt x="1607" y="359"/>
                  <a:pt x="1610" y="356"/>
                  <a:pt x="1612" y="354"/>
                </a:cubicBezTo>
                <a:cubicBezTo>
                  <a:pt x="1615" y="352"/>
                  <a:pt x="1617" y="351"/>
                  <a:pt x="1619" y="350"/>
                </a:cubicBezTo>
                <a:cubicBezTo>
                  <a:pt x="1621" y="350"/>
                  <a:pt x="1622" y="349"/>
                  <a:pt x="1624" y="350"/>
                </a:cubicBezTo>
                <a:cubicBezTo>
                  <a:pt x="1625" y="350"/>
                  <a:pt x="1626" y="351"/>
                  <a:pt x="1628" y="352"/>
                </a:cubicBezTo>
                <a:lnTo>
                  <a:pt x="1655" y="379"/>
                </a:lnTo>
                <a:cubicBezTo>
                  <a:pt x="1653" y="355"/>
                  <a:pt x="1655" y="334"/>
                  <a:pt x="1661" y="316"/>
                </a:cubicBezTo>
                <a:cubicBezTo>
                  <a:pt x="1666" y="298"/>
                  <a:pt x="1675" y="284"/>
                  <a:pt x="1687" y="272"/>
                </a:cubicBezTo>
                <a:cubicBezTo>
                  <a:pt x="1701" y="258"/>
                  <a:pt x="1715" y="249"/>
                  <a:pt x="1729" y="244"/>
                </a:cubicBezTo>
                <a:cubicBezTo>
                  <a:pt x="1743" y="240"/>
                  <a:pt x="1757" y="238"/>
                  <a:pt x="1770" y="240"/>
                </a:cubicBezTo>
                <a:cubicBezTo>
                  <a:pt x="1784" y="242"/>
                  <a:pt x="1797" y="247"/>
                  <a:pt x="1810" y="255"/>
                </a:cubicBezTo>
                <a:cubicBezTo>
                  <a:pt x="1823" y="263"/>
                  <a:pt x="1837" y="274"/>
                  <a:pt x="1851" y="289"/>
                </a:cubicBezTo>
                <a:lnTo>
                  <a:pt x="1977" y="415"/>
                </a:lnTo>
                <a:close/>
                <a:moveTo>
                  <a:pt x="2113" y="55"/>
                </a:moveTo>
                <a:cubicBezTo>
                  <a:pt x="2119" y="61"/>
                  <a:pt x="2121" y="67"/>
                  <a:pt x="2121" y="73"/>
                </a:cubicBezTo>
                <a:cubicBezTo>
                  <a:pt x="2120" y="78"/>
                  <a:pt x="2118" y="83"/>
                  <a:pt x="2114" y="87"/>
                </a:cubicBezTo>
                <a:lnTo>
                  <a:pt x="1978" y="223"/>
                </a:lnTo>
                <a:cubicBezTo>
                  <a:pt x="1990" y="234"/>
                  <a:pt x="2001" y="243"/>
                  <a:pt x="2013" y="250"/>
                </a:cubicBezTo>
                <a:cubicBezTo>
                  <a:pt x="2024" y="257"/>
                  <a:pt x="2036" y="261"/>
                  <a:pt x="2048" y="262"/>
                </a:cubicBezTo>
                <a:cubicBezTo>
                  <a:pt x="2060" y="263"/>
                  <a:pt x="2072" y="261"/>
                  <a:pt x="2084" y="256"/>
                </a:cubicBezTo>
                <a:cubicBezTo>
                  <a:pt x="2096" y="251"/>
                  <a:pt x="2108" y="242"/>
                  <a:pt x="2121" y="230"/>
                </a:cubicBezTo>
                <a:cubicBezTo>
                  <a:pt x="2131" y="220"/>
                  <a:pt x="2139" y="211"/>
                  <a:pt x="2145" y="201"/>
                </a:cubicBezTo>
                <a:cubicBezTo>
                  <a:pt x="2151" y="192"/>
                  <a:pt x="2156" y="184"/>
                  <a:pt x="2159" y="176"/>
                </a:cubicBezTo>
                <a:cubicBezTo>
                  <a:pt x="2163" y="168"/>
                  <a:pt x="2166" y="162"/>
                  <a:pt x="2168" y="157"/>
                </a:cubicBezTo>
                <a:cubicBezTo>
                  <a:pt x="2170" y="152"/>
                  <a:pt x="2172" y="148"/>
                  <a:pt x="2174" y="146"/>
                </a:cubicBezTo>
                <a:cubicBezTo>
                  <a:pt x="2175" y="145"/>
                  <a:pt x="2176" y="144"/>
                  <a:pt x="2177" y="144"/>
                </a:cubicBezTo>
                <a:cubicBezTo>
                  <a:pt x="2179" y="144"/>
                  <a:pt x="2180" y="144"/>
                  <a:pt x="2182" y="145"/>
                </a:cubicBezTo>
                <a:cubicBezTo>
                  <a:pt x="2183" y="145"/>
                  <a:pt x="2185" y="146"/>
                  <a:pt x="2187" y="148"/>
                </a:cubicBezTo>
                <a:cubicBezTo>
                  <a:pt x="2189" y="150"/>
                  <a:pt x="2192" y="152"/>
                  <a:pt x="2194" y="155"/>
                </a:cubicBezTo>
                <a:cubicBezTo>
                  <a:pt x="2196" y="157"/>
                  <a:pt x="2198" y="158"/>
                  <a:pt x="2199" y="160"/>
                </a:cubicBezTo>
                <a:cubicBezTo>
                  <a:pt x="2201" y="162"/>
                  <a:pt x="2202" y="163"/>
                  <a:pt x="2203" y="165"/>
                </a:cubicBezTo>
                <a:cubicBezTo>
                  <a:pt x="2204" y="166"/>
                  <a:pt x="2204" y="167"/>
                  <a:pt x="2205" y="169"/>
                </a:cubicBezTo>
                <a:cubicBezTo>
                  <a:pt x="2205" y="170"/>
                  <a:pt x="2205" y="172"/>
                  <a:pt x="2205" y="174"/>
                </a:cubicBezTo>
                <a:cubicBezTo>
                  <a:pt x="2205" y="175"/>
                  <a:pt x="2204" y="179"/>
                  <a:pt x="2202" y="185"/>
                </a:cubicBezTo>
                <a:cubicBezTo>
                  <a:pt x="2200" y="191"/>
                  <a:pt x="2196" y="198"/>
                  <a:pt x="2191" y="207"/>
                </a:cubicBezTo>
                <a:cubicBezTo>
                  <a:pt x="2187" y="215"/>
                  <a:pt x="2181" y="224"/>
                  <a:pt x="2174" y="234"/>
                </a:cubicBezTo>
                <a:cubicBezTo>
                  <a:pt x="2166" y="245"/>
                  <a:pt x="2158" y="255"/>
                  <a:pt x="2148" y="264"/>
                </a:cubicBezTo>
                <a:cubicBezTo>
                  <a:pt x="2131" y="281"/>
                  <a:pt x="2114" y="294"/>
                  <a:pt x="2096" y="302"/>
                </a:cubicBezTo>
                <a:cubicBezTo>
                  <a:pt x="2079" y="310"/>
                  <a:pt x="2061" y="314"/>
                  <a:pt x="2043" y="313"/>
                </a:cubicBezTo>
                <a:cubicBezTo>
                  <a:pt x="2025" y="312"/>
                  <a:pt x="2007" y="307"/>
                  <a:pt x="1988" y="298"/>
                </a:cubicBezTo>
                <a:cubicBezTo>
                  <a:pt x="1970" y="288"/>
                  <a:pt x="1951" y="274"/>
                  <a:pt x="1933" y="255"/>
                </a:cubicBezTo>
                <a:cubicBezTo>
                  <a:pt x="1915" y="237"/>
                  <a:pt x="1901" y="219"/>
                  <a:pt x="1892" y="200"/>
                </a:cubicBezTo>
                <a:cubicBezTo>
                  <a:pt x="1882" y="182"/>
                  <a:pt x="1877" y="163"/>
                  <a:pt x="1875" y="145"/>
                </a:cubicBezTo>
                <a:cubicBezTo>
                  <a:pt x="1874" y="126"/>
                  <a:pt x="1877" y="108"/>
                  <a:pt x="1884" y="91"/>
                </a:cubicBezTo>
                <a:cubicBezTo>
                  <a:pt x="1891" y="73"/>
                  <a:pt x="1902" y="57"/>
                  <a:pt x="1917" y="42"/>
                </a:cubicBezTo>
                <a:cubicBezTo>
                  <a:pt x="1933" y="25"/>
                  <a:pt x="1950" y="14"/>
                  <a:pt x="1966" y="8"/>
                </a:cubicBezTo>
                <a:cubicBezTo>
                  <a:pt x="1983" y="2"/>
                  <a:pt x="1999" y="0"/>
                  <a:pt x="2015" y="1"/>
                </a:cubicBezTo>
                <a:cubicBezTo>
                  <a:pt x="2032" y="2"/>
                  <a:pt x="2047" y="7"/>
                  <a:pt x="2063" y="16"/>
                </a:cubicBezTo>
                <a:cubicBezTo>
                  <a:pt x="2078" y="24"/>
                  <a:pt x="2092" y="35"/>
                  <a:pt x="2106" y="49"/>
                </a:cubicBezTo>
                <a:lnTo>
                  <a:pt x="2113" y="55"/>
                </a:lnTo>
                <a:close/>
                <a:moveTo>
                  <a:pt x="2063" y="82"/>
                </a:moveTo>
                <a:cubicBezTo>
                  <a:pt x="2044" y="62"/>
                  <a:pt x="2024" y="51"/>
                  <a:pt x="2003" y="49"/>
                </a:cubicBezTo>
                <a:cubicBezTo>
                  <a:pt x="1983" y="47"/>
                  <a:pt x="1963" y="55"/>
                  <a:pt x="1945" y="73"/>
                </a:cubicBezTo>
                <a:cubicBezTo>
                  <a:pt x="1935" y="83"/>
                  <a:pt x="1929" y="93"/>
                  <a:pt x="1925" y="103"/>
                </a:cubicBezTo>
                <a:cubicBezTo>
                  <a:pt x="1922" y="114"/>
                  <a:pt x="1921" y="124"/>
                  <a:pt x="1922" y="135"/>
                </a:cubicBezTo>
                <a:cubicBezTo>
                  <a:pt x="1923" y="145"/>
                  <a:pt x="1926" y="156"/>
                  <a:pt x="1931" y="166"/>
                </a:cubicBezTo>
                <a:cubicBezTo>
                  <a:pt x="1936" y="177"/>
                  <a:pt x="1943" y="186"/>
                  <a:pt x="1951" y="195"/>
                </a:cubicBezTo>
                <a:lnTo>
                  <a:pt x="2063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3" name="Freeform 247"/>
          <p:cNvSpPr>
            <a:spLocks noEditPoints="1"/>
          </p:cNvSpPr>
          <p:nvPr/>
        </p:nvSpPr>
        <p:spPr bwMode="auto">
          <a:xfrm>
            <a:off x="1414605" y="4418880"/>
            <a:ext cx="342115" cy="392113"/>
          </a:xfrm>
          <a:custGeom>
            <a:avLst/>
            <a:gdLst>
              <a:gd name="T0" fmla="*/ 173 w 2154"/>
              <a:gd name="T1" fmla="*/ 1674 h 2060"/>
              <a:gd name="T2" fmla="*/ 169 w 2154"/>
              <a:gd name="T3" fmla="*/ 1987 h 2060"/>
              <a:gd name="T4" fmla="*/ 220 w 2154"/>
              <a:gd name="T5" fmla="*/ 1872 h 2060"/>
              <a:gd name="T6" fmla="*/ 282 w 2154"/>
              <a:gd name="T7" fmla="*/ 1746 h 2060"/>
              <a:gd name="T8" fmla="*/ 433 w 2154"/>
              <a:gd name="T9" fmla="*/ 1889 h 2060"/>
              <a:gd name="T10" fmla="*/ 144 w 2154"/>
              <a:gd name="T11" fmla="*/ 2041 h 2060"/>
              <a:gd name="T12" fmla="*/ 133 w 2154"/>
              <a:gd name="T13" fmla="*/ 1638 h 2060"/>
              <a:gd name="T14" fmla="*/ 565 w 2154"/>
              <a:gd name="T15" fmla="*/ 1786 h 2060"/>
              <a:gd name="T16" fmla="*/ 220 w 2154"/>
              <a:gd name="T17" fmla="*/ 1509 h 2060"/>
              <a:gd name="T18" fmla="*/ 254 w 2154"/>
              <a:gd name="T19" fmla="*/ 1468 h 2060"/>
              <a:gd name="T20" fmla="*/ 800 w 2154"/>
              <a:gd name="T21" fmla="*/ 1555 h 2060"/>
              <a:gd name="T22" fmla="*/ 716 w 2154"/>
              <a:gd name="T23" fmla="*/ 1645 h 2060"/>
              <a:gd name="T24" fmla="*/ 425 w 2154"/>
              <a:gd name="T25" fmla="*/ 1493 h 2060"/>
              <a:gd name="T26" fmla="*/ 584 w 2154"/>
              <a:gd name="T27" fmla="*/ 1584 h 2060"/>
              <a:gd name="T28" fmla="*/ 566 w 2154"/>
              <a:gd name="T29" fmla="*/ 1362 h 2060"/>
              <a:gd name="T30" fmla="*/ 600 w 2154"/>
              <a:gd name="T31" fmla="*/ 1322 h 2060"/>
              <a:gd name="T32" fmla="*/ 980 w 2154"/>
              <a:gd name="T33" fmla="*/ 1376 h 2060"/>
              <a:gd name="T34" fmla="*/ 711 w 2154"/>
              <a:gd name="T35" fmla="*/ 1269 h 2060"/>
              <a:gd name="T36" fmla="*/ 651 w 2154"/>
              <a:gd name="T37" fmla="*/ 1266 h 2060"/>
              <a:gd name="T38" fmla="*/ 651 w 2154"/>
              <a:gd name="T39" fmla="*/ 1153 h 2060"/>
              <a:gd name="T40" fmla="*/ 779 w 2154"/>
              <a:gd name="T41" fmla="*/ 1144 h 2060"/>
              <a:gd name="T42" fmla="*/ 902 w 2154"/>
              <a:gd name="T43" fmla="*/ 1372 h 2060"/>
              <a:gd name="T44" fmla="*/ 962 w 2154"/>
              <a:gd name="T45" fmla="*/ 1326 h 2060"/>
              <a:gd name="T46" fmla="*/ 1171 w 2154"/>
              <a:gd name="T47" fmla="*/ 1182 h 2060"/>
              <a:gd name="T48" fmla="*/ 1034 w 2154"/>
              <a:gd name="T49" fmla="*/ 1294 h 2060"/>
              <a:gd name="T50" fmla="*/ 1032 w 2154"/>
              <a:gd name="T51" fmla="*/ 1067 h 2060"/>
              <a:gd name="T52" fmla="*/ 886 w 2154"/>
              <a:gd name="T53" fmla="*/ 1104 h 2060"/>
              <a:gd name="T54" fmla="*/ 844 w 2154"/>
              <a:gd name="T55" fmla="*/ 1120 h 2060"/>
              <a:gd name="T56" fmla="*/ 976 w 2154"/>
              <a:gd name="T57" fmla="*/ 972 h 2060"/>
              <a:gd name="T58" fmla="*/ 991 w 2154"/>
              <a:gd name="T59" fmla="*/ 1183 h 2060"/>
              <a:gd name="T60" fmla="*/ 1059 w 2154"/>
              <a:gd name="T61" fmla="*/ 1094 h 2060"/>
              <a:gd name="T62" fmla="*/ 1539 w 2154"/>
              <a:gd name="T63" fmla="*/ 813 h 2060"/>
              <a:gd name="T64" fmla="*/ 1305 w 2154"/>
              <a:gd name="T65" fmla="*/ 668 h 2060"/>
              <a:gd name="T66" fmla="*/ 1422 w 2154"/>
              <a:gd name="T67" fmla="*/ 934 h 2060"/>
              <a:gd name="T68" fmla="*/ 1218 w 2154"/>
              <a:gd name="T69" fmla="*/ 788 h 2060"/>
              <a:gd name="T70" fmla="*/ 1301 w 2154"/>
              <a:gd name="T71" fmla="*/ 1051 h 2060"/>
              <a:gd name="T72" fmla="*/ 1055 w 2154"/>
              <a:gd name="T73" fmla="*/ 873 h 2060"/>
              <a:gd name="T74" fmla="*/ 1085 w 2154"/>
              <a:gd name="T75" fmla="*/ 837 h 2060"/>
              <a:gd name="T76" fmla="*/ 1225 w 2154"/>
              <a:gd name="T77" fmla="*/ 732 h 2060"/>
              <a:gd name="T78" fmla="*/ 1361 w 2154"/>
              <a:gd name="T79" fmla="*/ 598 h 2060"/>
              <a:gd name="T80" fmla="*/ 1675 w 2154"/>
              <a:gd name="T81" fmla="*/ 679 h 2060"/>
              <a:gd name="T82" fmla="*/ 1432 w 2154"/>
              <a:gd name="T83" fmla="*/ 490 h 2060"/>
              <a:gd name="T84" fmla="*/ 1472 w 2154"/>
              <a:gd name="T85" fmla="*/ 456 h 2060"/>
              <a:gd name="T86" fmla="*/ 1347 w 2154"/>
              <a:gd name="T87" fmla="*/ 406 h 2060"/>
              <a:gd name="T88" fmla="*/ 1923 w 2154"/>
              <a:gd name="T89" fmla="*/ 432 h 2060"/>
              <a:gd name="T90" fmla="*/ 1736 w 2154"/>
              <a:gd name="T91" fmla="*/ 307 h 2060"/>
              <a:gd name="T92" fmla="*/ 1788 w 2154"/>
              <a:gd name="T93" fmla="*/ 559 h 2060"/>
              <a:gd name="T94" fmla="*/ 1748 w 2154"/>
              <a:gd name="T95" fmla="*/ 593 h 2060"/>
              <a:gd name="T96" fmla="*/ 1567 w 2154"/>
              <a:gd name="T97" fmla="*/ 350 h 2060"/>
              <a:gd name="T98" fmla="*/ 1718 w 2154"/>
              <a:gd name="T99" fmla="*/ 241 h 2060"/>
              <a:gd name="T100" fmla="*/ 1927 w 2154"/>
              <a:gd name="T101" fmla="*/ 223 h 2060"/>
              <a:gd name="T102" fmla="*/ 2116 w 2154"/>
              <a:gd name="T103" fmla="*/ 157 h 2060"/>
              <a:gd name="T104" fmla="*/ 2151 w 2154"/>
              <a:gd name="T105" fmla="*/ 165 h 2060"/>
              <a:gd name="T106" fmla="*/ 2045 w 2154"/>
              <a:gd name="T107" fmla="*/ 302 h 2060"/>
              <a:gd name="T108" fmla="*/ 1866 w 2154"/>
              <a:gd name="T109" fmla="*/ 42 h 2060"/>
              <a:gd name="T110" fmla="*/ 1952 w 2154"/>
              <a:gd name="T111" fmla="*/ 49 h 20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154" h="2060">
                <a:moveTo>
                  <a:pt x="203" y="1637"/>
                </a:moveTo>
                <a:cubicBezTo>
                  <a:pt x="206" y="1640"/>
                  <a:pt x="208" y="1642"/>
                  <a:pt x="210" y="1645"/>
                </a:cubicBezTo>
                <a:cubicBezTo>
                  <a:pt x="212" y="1648"/>
                  <a:pt x="213" y="1650"/>
                  <a:pt x="214" y="1652"/>
                </a:cubicBezTo>
                <a:cubicBezTo>
                  <a:pt x="215" y="1654"/>
                  <a:pt x="215" y="1656"/>
                  <a:pt x="215" y="1657"/>
                </a:cubicBezTo>
                <a:cubicBezTo>
                  <a:pt x="215" y="1659"/>
                  <a:pt x="214" y="1660"/>
                  <a:pt x="213" y="1661"/>
                </a:cubicBezTo>
                <a:cubicBezTo>
                  <a:pt x="211" y="1663"/>
                  <a:pt x="207" y="1665"/>
                  <a:pt x="200" y="1666"/>
                </a:cubicBezTo>
                <a:cubicBezTo>
                  <a:pt x="192" y="1667"/>
                  <a:pt x="183" y="1670"/>
                  <a:pt x="173" y="1674"/>
                </a:cubicBezTo>
                <a:cubicBezTo>
                  <a:pt x="162" y="1677"/>
                  <a:pt x="150" y="1683"/>
                  <a:pt x="137" y="1690"/>
                </a:cubicBezTo>
                <a:cubicBezTo>
                  <a:pt x="124" y="1697"/>
                  <a:pt x="111" y="1707"/>
                  <a:pt x="97" y="1721"/>
                </a:cubicBezTo>
                <a:cubicBezTo>
                  <a:pt x="81" y="1737"/>
                  <a:pt x="69" y="1755"/>
                  <a:pt x="62" y="1774"/>
                </a:cubicBezTo>
                <a:cubicBezTo>
                  <a:pt x="55" y="1793"/>
                  <a:pt x="52" y="1812"/>
                  <a:pt x="54" y="1832"/>
                </a:cubicBezTo>
                <a:cubicBezTo>
                  <a:pt x="55" y="1851"/>
                  <a:pt x="61" y="1871"/>
                  <a:pt x="71" y="1890"/>
                </a:cubicBezTo>
                <a:cubicBezTo>
                  <a:pt x="81" y="1909"/>
                  <a:pt x="94" y="1928"/>
                  <a:pt x="111" y="1945"/>
                </a:cubicBezTo>
                <a:cubicBezTo>
                  <a:pt x="130" y="1963"/>
                  <a:pt x="149" y="1978"/>
                  <a:pt x="169" y="1987"/>
                </a:cubicBezTo>
                <a:cubicBezTo>
                  <a:pt x="189" y="1996"/>
                  <a:pt x="209" y="2002"/>
                  <a:pt x="228" y="2002"/>
                </a:cubicBezTo>
                <a:cubicBezTo>
                  <a:pt x="248" y="2003"/>
                  <a:pt x="266" y="2000"/>
                  <a:pt x="284" y="1992"/>
                </a:cubicBezTo>
                <a:cubicBezTo>
                  <a:pt x="303" y="1984"/>
                  <a:pt x="319" y="1973"/>
                  <a:pt x="335" y="1957"/>
                </a:cubicBezTo>
                <a:cubicBezTo>
                  <a:pt x="344" y="1948"/>
                  <a:pt x="352" y="1938"/>
                  <a:pt x="359" y="1926"/>
                </a:cubicBezTo>
                <a:cubicBezTo>
                  <a:pt x="367" y="1914"/>
                  <a:pt x="372" y="1902"/>
                  <a:pt x="376" y="1890"/>
                </a:cubicBezTo>
                <a:lnTo>
                  <a:pt x="289" y="1803"/>
                </a:lnTo>
                <a:lnTo>
                  <a:pt x="220" y="1872"/>
                </a:lnTo>
                <a:cubicBezTo>
                  <a:pt x="218" y="1875"/>
                  <a:pt x="215" y="1875"/>
                  <a:pt x="211" y="1874"/>
                </a:cubicBezTo>
                <a:cubicBezTo>
                  <a:pt x="207" y="1873"/>
                  <a:pt x="202" y="1869"/>
                  <a:pt x="197" y="1864"/>
                </a:cubicBezTo>
                <a:cubicBezTo>
                  <a:pt x="194" y="1861"/>
                  <a:pt x="191" y="1858"/>
                  <a:pt x="190" y="1856"/>
                </a:cubicBezTo>
                <a:cubicBezTo>
                  <a:pt x="188" y="1854"/>
                  <a:pt x="187" y="1851"/>
                  <a:pt x="186" y="1849"/>
                </a:cubicBezTo>
                <a:cubicBezTo>
                  <a:pt x="185" y="1847"/>
                  <a:pt x="185" y="1846"/>
                  <a:pt x="186" y="1844"/>
                </a:cubicBezTo>
                <a:cubicBezTo>
                  <a:pt x="186" y="1843"/>
                  <a:pt x="187" y="1841"/>
                  <a:pt x="188" y="1840"/>
                </a:cubicBezTo>
                <a:lnTo>
                  <a:pt x="282" y="1746"/>
                </a:lnTo>
                <a:cubicBezTo>
                  <a:pt x="284" y="1744"/>
                  <a:pt x="286" y="1742"/>
                  <a:pt x="288" y="1741"/>
                </a:cubicBezTo>
                <a:cubicBezTo>
                  <a:pt x="291" y="1740"/>
                  <a:pt x="293" y="1740"/>
                  <a:pt x="296" y="1740"/>
                </a:cubicBezTo>
                <a:cubicBezTo>
                  <a:pt x="298" y="1739"/>
                  <a:pt x="301" y="1740"/>
                  <a:pt x="304" y="1741"/>
                </a:cubicBezTo>
                <a:cubicBezTo>
                  <a:pt x="307" y="1743"/>
                  <a:pt x="310" y="1745"/>
                  <a:pt x="312" y="1748"/>
                </a:cubicBezTo>
                <a:lnTo>
                  <a:pt x="425" y="1861"/>
                </a:lnTo>
                <a:cubicBezTo>
                  <a:pt x="429" y="1865"/>
                  <a:pt x="432" y="1869"/>
                  <a:pt x="434" y="1873"/>
                </a:cubicBezTo>
                <a:cubicBezTo>
                  <a:pt x="435" y="1877"/>
                  <a:pt x="435" y="1883"/>
                  <a:pt x="433" y="1889"/>
                </a:cubicBezTo>
                <a:cubicBezTo>
                  <a:pt x="430" y="1896"/>
                  <a:pt x="427" y="1904"/>
                  <a:pt x="423" y="1914"/>
                </a:cubicBezTo>
                <a:cubicBezTo>
                  <a:pt x="418" y="1923"/>
                  <a:pt x="413" y="1933"/>
                  <a:pt x="407" y="1942"/>
                </a:cubicBezTo>
                <a:cubicBezTo>
                  <a:pt x="402" y="1952"/>
                  <a:pt x="396" y="1960"/>
                  <a:pt x="389" y="1969"/>
                </a:cubicBezTo>
                <a:cubicBezTo>
                  <a:pt x="382" y="1978"/>
                  <a:pt x="375" y="1986"/>
                  <a:pt x="368" y="1993"/>
                </a:cubicBezTo>
                <a:cubicBezTo>
                  <a:pt x="345" y="2016"/>
                  <a:pt x="321" y="2033"/>
                  <a:pt x="295" y="2044"/>
                </a:cubicBezTo>
                <a:cubicBezTo>
                  <a:pt x="270" y="2055"/>
                  <a:pt x="245" y="2060"/>
                  <a:pt x="219" y="2059"/>
                </a:cubicBezTo>
                <a:cubicBezTo>
                  <a:pt x="194" y="2059"/>
                  <a:pt x="169" y="2052"/>
                  <a:pt x="144" y="2041"/>
                </a:cubicBezTo>
                <a:cubicBezTo>
                  <a:pt x="119" y="2029"/>
                  <a:pt x="95" y="2012"/>
                  <a:pt x="72" y="1989"/>
                </a:cubicBezTo>
                <a:cubicBezTo>
                  <a:pt x="49" y="1965"/>
                  <a:pt x="31" y="1941"/>
                  <a:pt x="19" y="1914"/>
                </a:cubicBezTo>
                <a:cubicBezTo>
                  <a:pt x="7" y="1888"/>
                  <a:pt x="1" y="1862"/>
                  <a:pt x="0" y="1836"/>
                </a:cubicBezTo>
                <a:cubicBezTo>
                  <a:pt x="0" y="1809"/>
                  <a:pt x="5" y="1783"/>
                  <a:pt x="15" y="1758"/>
                </a:cubicBezTo>
                <a:cubicBezTo>
                  <a:pt x="26" y="1732"/>
                  <a:pt x="42" y="1708"/>
                  <a:pt x="65" y="1686"/>
                </a:cubicBezTo>
                <a:cubicBezTo>
                  <a:pt x="76" y="1675"/>
                  <a:pt x="87" y="1665"/>
                  <a:pt x="99" y="1657"/>
                </a:cubicBezTo>
                <a:cubicBezTo>
                  <a:pt x="111" y="1650"/>
                  <a:pt x="122" y="1643"/>
                  <a:pt x="133" y="1638"/>
                </a:cubicBezTo>
                <a:cubicBezTo>
                  <a:pt x="143" y="1633"/>
                  <a:pt x="153" y="1629"/>
                  <a:pt x="161" y="1627"/>
                </a:cubicBezTo>
                <a:cubicBezTo>
                  <a:pt x="169" y="1625"/>
                  <a:pt x="176" y="1624"/>
                  <a:pt x="180" y="1624"/>
                </a:cubicBezTo>
                <a:cubicBezTo>
                  <a:pt x="184" y="1624"/>
                  <a:pt x="187" y="1625"/>
                  <a:pt x="191" y="1627"/>
                </a:cubicBezTo>
                <a:cubicBezTo>
                  <a:pt x="194" y="1629"/>
                  <a:pt x="198" y="1632"/>
                  <a:pt x="203" y="1637"/>
                </a:cubicBezTo>
                <a:close/>
                <a:moveTo>
                  <a:pt x="564" y="1777"/>
                </a:moveTo>
                <a:cubicBezTo>
                  <a:pt x="565" y="1778"/>
                  <a:pt x="566" y="1780"/>
                  <a:pt x="566" y="1781"/>
                </a:cubicBezTo>
                <a:cubicBezTo>
                  <a:pt x="566" y="1782"/>
                  <a:pt x="566" y="1784"/>
                  <a:pt x="565" y="1786"/>
                </a:cubicBezTo>
                <a:cubicBezTo>
                  <a:pt x="565" y="1788"/>
                  <a:pt x="563" y="1791"/>
                  <a:pt x="561" y="1793"/>
                </a:cubicBezTo>
                <a:cubicBezTo>
                  <a:pt x="559" y="1796"/>
                  <a:pt x="556" y="1799"/>
                  <a:pt x="552" y="1803"/>
                </a:cubicBezTo>
                <a:cubicBezTo>
                  <a:pt x="548" y="1807"/>
                  <a:pt x="545" y="1810"/>
                  <a:pt x="542" y="1812"/>
                </a:cubicBezTo>
                <a:cubicBezTo>
                  <a:pt x="540" y="1814"/>
                  <a:pt x="537" y="1815"/>
                  <a:pt x="535" y="1816"/>
                </a:cubicBezTo>
                <a:cubicBezTo>
                  <a:pt x="533" y="1817"/>
                  <a:pt x="531" y="1817"/>
                  <a:pt x="530" y="1817"/>
                </a:cubicBezTo>
                <a:cubicBezTo>
                  <a:pt x="529" y="1817"/>
                  <a:pt x="527" y="1816"/>
                  <a:pt x="526" y="1815"/>
                </a:cubicBezTo>
                <a:lnTo>
                  <a:pt x="220" y="1509"/>
                </a:lnTo>
                <a:cubicBezTo>
                  <a:pt x="219" y="1507"/>
                  <a:pt x="218" y="1506"/>
                  <a:pt x="217" y="1505"/>
                </a:cubicBezTo>
                <a:cubicBezTo>
                  <a:pt x="217" y="1503"/>
                  <a:pt x="217" y="1501"/>
                  <a:pt x="218" y="1499"/>
                </a:cubicBezTo>
                <a:cubicBezTo>
                  <a:pt x="219" y="1497"/>
                  <a:pt x="220" y="1495"/>
                  <a:pt x="223" y="1492"/>
                </a:cubicBezTo>
                <a:cubicBezTo>
                  <a:pt x="225" y="1489"/>
                  <a:pt x="228" y="1486"/>
                  <a:pt x="231" y="1482"/>
                </a:cubicBezTo>
                <a:cubicBezTo>
                  <a:pt x="235" y="1479"/>
                  <a:pt x="238" y="1476"/>
                  <a:pt x="241" y="1473"/>
                </a:cubicBezTo>
                <a:cubicBezTo>
                  <a:pt x="244" y="1471"/>
                  <a:pt x="246" y="1470"/>
                  <a:pt x="248" y="1469"/>
                </a:cubicBezTo>
                <a:cubicBezTo>
                  <a:pt x="250" y="1468"/>
                  <a:pt x="252" y="1468"/>
                  <a:pt x="254" y="1468"/>
                </a:cubicBezTo>
                <a:cubicBezTo>
                  <a:pt x="255" y="1469"/>
                  <a:pt x="256" y="1469"/>
                  <a:pt x="258" y="1471"/>
                </a:cubicBezTo>
                <a:lnTo>
                  <a:pt x="564" y="1777"/>
                </a:lnTo>
                <a:close/>
                <a:moveTo>
                  <a:pt x="810" y="1531"/>
                </a:moveTo>
                <a:cubicBezTo>
                  <a:pt x="812" y="1532"/>
                  <a:pt x="812" y="1533"/>
                  <a:pt x="813" y="1534"/>
                </a:cubicBezTo>
                <a:cubicBezTo>
                  <a:pt x="813" y="1536"/>
                  <a:pt x="813" y="1538"/>
                  <a:pt x="812" y="1540"/>
                </a:cubicBezTo>
                <a:cubicBezTo>
                  <a:pt x="811" y="1541"/>
                  <a:pt x="810" y="1544"/>
                  <a:pt x="808" y="1546"/>
                </a:cubicBezTo>
                <a:cubicBezTo>
                  <a:pt x="806" y="1549"/>
                  <a:pt x="804" y="1552"/>
                  <a:pt x="800" y="1555"/>
                </a:cubicBezTo>
                <a:cubicBezTo>
                  <a:pt x="797" y="1558"/>
                  <a:pt x="794" y="1561"/>
                  <a:pt x="791" y="1563"/>
                </a:cubicBezTo>
                <a:cubicBezTo>
                  <a:pt x="789" y="1565"/>
                  <a:pt x="787" y="1566"/>
                  <a:pt x="785" y="1567"/>
                </a:cubicBezTo>
                <a:cubicBezTo>
                  <a:pt x="783" y="1568"/>
                  <a:pt x="781" y="1568"/>
                  <a:pt x="780" y="1567"/>
                </a:cubicBezTo>
                <a:cubicBezTo>
                  <a:pt x="779" y="1567"/>
                  <a:pt x="777" y="1566"/>
                  <a:pt x="776" y="1565"/>
                </a:cubicBezTo>
                <a:lnTo>
                  <a:pt x="749" y="1538"/>
                </a:lnTo>
                <a:cubicBezTo>
                  <a:pt x="750" y="1562"/>
                  <a:pt x="748" y="1584"/>
                  <a:pt x="742" y="1601"/>
                </a:cubicBezTo>
                <a:cubicBezTo>
                  <a:pt x="737" y="1618"/>
                  <a:pt x="728" y="1633"/>
                  <a:pt x="716" y="1645"/>
                </a:cubicBezTo>
                <a:cubicBezTo>
                  <a:pt x="703" y="1658"/>
                  <a:pt x="689" y="1668"/>
                  <a:pt x="675" y="1673"/>
                </a:cubicBezTo>
                <a:cubicBezTo>
                  <a:pt x="661" y="1677"/>
                  <a:pt x="647" y="1679"/>
                  <a:pt x="633" y="1677"/>
                </a:cubicBezTo>
                <a:cubicBezTo>
                  <a:pt x="620" y="1675"/>
                  <a:pt x="606" y="1670"/>
                  <a:pt x="593" y="1662"/>
                </a:cubicBezTo>
                <a:cubicBezTo>
                  <a:pt x="580" y="1654"/>
                  <a:pt x="566" y="1642"/>
                  <a:pt x="551" y="1627"/>
                </a:cubicBezTo>
                <a:lnTo>
                  <a:pt x="426" y="1502"/>
                </a:lnTo>
                <a:cubicBezTo>
                  <a:pt x="425" y="1501"/>
                  <a:pt x="424" y="1500"/>
                  <a:pt x="424" y="1498"/>
                </a:cubicBezTo>
                <a:cubicBezTo>
                  <a:pt x="424" y="1497"/>
                  <a:pt x="424" y="1495"/>
                  <a:pt x="425" y="1493"/>
                </a:cubicBezTo>
                <a:cubicBezTo>
                  <a:pt x="426" y="1491"/>
                  <a:pt x="427" y="1488"/>
                  <a:pt x="429" y="1486"/>
                </a:cubicBezTo>
                <a:cubicBezTo>
                  <a:pt x="431" y="1483"/>
                  <a:pt x="434" y="1480"/>
                  <a:pt x="438" y="1476"/>
                </a:cubicBezTo>
                <a:cubicBezTo>
                  <a:pt x="442" y="1472"/>
                  <a:pt x="445" y="1469"/>
                  <a:pt x="448" y="1467"/>
                </a:cubicBezTo>
                <a:cubicBezTo>
                  <a:pt x="450" y="1465"/>
                  <a:pt x="453" y="1463"/>
                  <a:pt x="455" y="1463"/>
                </a:cubicBezTo>
                <a:cubicBezTo>
                  <a:pt x="457" y="1462"/>
                  <a:pt x="459" y="1462"/>
                  <a:pt x="460" y="1462"/>
                </a:cubicBezTo>
                <a:cubicBezTo>
                  <a:pt x="462" y="1462"/>
                  <a:pt x="463" y="1463"/>
                  <a:pt x="464" y="1464"/>
                </a:cubicBezTo>
                <a:lnTo>
                  <a:pt x="584" y="1584"/>
                </a:lnTo>
                <a:cubicBezTo>
                  <a:pt x="596" y="1596"/>
                  <a:pt x="607" y="1605"/>
                  <a:pt x="616" y="1611"/>
                </a:cubicBezTo>
                <a:cubicBezTo>
                  <a:pt x="625" y="1616"/>
                  <a:pt x="634" y="1620"/>
                  <a:pt x="643" y="1621"/>
                </a:cubicBezTo>
                <a:cubicBezTo>
                  <a:pt x="651" y="1623"/>
                  <a:pt x="660" y="1622"/>
                  <a:pt x="668" y="1619"/>
                </a:cubicBezTo>
                <a:cubicBezTo>
                  <a:pt x="676" y="1617"/>
                  <a:pt x="684" y="1612"/>
                  <a:pt x="692" y="1604"/>
                </a:cubicBezTo>
                <a:cubicBezTo>
                  <a:pt x="701" y="1595"/>
                  <a:pt x="707" y="1582"/>
                  <a:pt x="710" y="1566"/>
                </a:cubicBezTo>
                <a:cubicBezTo>
                  <a:pt x="713" y="1550"/>
                  <a:pt x="713" y="1530"/>
                  <a:pt x="710" y="1506"/>
                </a:cubicBezTo>
                <a:lnTo>
                  <a:pt x="566" y="1362"/>
                </a:lnTo>
                <a:cubicBezTo>
                  <a:pt x="565" y="1361"/>
                  <a:pt x="564" y="1360"/>
                  <a:pt x="564" y="1358"/>
                </a:cubicBezTo>
                <a:cubicBezTo>
                  <a:pt x="563" y="1357"/>
                  <a:pt x="564" y="1355"/>
                  <a:pt x="565" y="1353"/>
                </a:cubicBezTo>
                <a:cubicBezTo>
                  <a:pt x="565" y="1351"/>
                  <a:pt x="567" y="1348"/>
                  <a:pt x="569" y="1346"/>
                </a:cubicBezTo>
                <a:cubicBezTo>
                  <a:pt x="571" y="1343"/>
                  <a:pt x="574" y="1340"/>
                  <a:pt x="578" y="1336"/>
                </a:cubicBezTo>
                <a:cubicBezTo>
                  <a:pt x="582" y="1332"/>
                  <a:pt x="585" y="1330"/>
                  <a:pt x="587" y="1327"/>
                </a:cubicBezTo>
                <a:cubicBezTo>
                  <a:pt x="590" y="1325"/>
                  <a:pt x="593" y="1324"/>
                  <a:pt x="595" y="1323"/>
                </a:cubicBezTo>
                <a:cubicBezTo>
                  <a:pt x="597" y="1322"/>
                  <a:pt x="598" y="1322"/>
                  <a:pt x="600" y="1322"/>
                </a:cubicBezTo>
                <a:cubicBezTo>
                  <a:pt x="601" y="1322"/>
                  <a:pt x="603" y="1323"/>
                  <a:pt x="604" y="1324"/>
                </a:cubicBezTo>
                <a:lnTo>
                  <a:pt x="810" y="1531"/>
                </a:lnTo>
                <a:close/>
                <a:moveTo>
                  <a:pt x="975" y="1336"/>
                </a:moveTo>
                <a:cubicBezTo>
                  <a:pt x="979" y="1340"/>
                  <a:pt x="982" y="1344"/>
                  <a:pt x="984" y="1347"/>
                </a:cubicBezTo>
                <a:cubicBezTo>
                  <a:pt x="986" y="1351"/>
                  <a:pt x="987" y="1354"/>
                  <a:pt x="987" y="1356"/>
                </a:cubicBezTo>
                <a:cubicBezTo>
                  <a:pt x="987" y="1358"/>
                  <a:pt x="987" y="1361"/>
                  <a:pt x="985" y="1365"/>
                </a:cubicBezTo>
                <a:cubicBezTo>
                  <a:pt x="984" y="1368"/>
                  <a:pt x="982" y="1372"/>
                  <a:pt x="980" y="1376"/>
                </a:cubicBezTo>
                <a:cubicBezTo>
                  <a:pt x="977" y="1380"/>
                  <a:pt x="974" y="1384"/>
                  <a:pt x="971" y="1388"/>
                </a:cubicBezTo>
                <a:cubicBezTo>
                  <a:pt x="968" y="1392"/>
                  <a:pt x="965" y="1395"/>
                  <a:pt x="961" y="1399"/>
                </a:cubicBezTo>
                <a:cubicBezTo>
                  <a:pt x="951" y="1410"/>
                  <a:pt x="940" y="1417"/>
                  <a:pt x="930" y="1422"/>
                </a:cubicBezTo>
                <a:cubicBezTo>
                  <a:pt x="919" y="1427"/>
                  <a:pt x="909" y="1429"/>
                  <a:pt x="898" y="1428"/>
                </a:cubicBezTo>
                <a:cubicBezTo>
                  <a:pt x="887" y="1427"/>
                  <a:pt x="877" y="1424"/>
                  <a:pt x="866" y="1417"/>
                </a:cubicBezTo>
                <a:cubicBezTo>
                  <a:pt x="855" y="1410"/>
                  <a:pt x="843" y="1401"/>
                  <a:pt x="831" y="1389"/>
                </a:cubicBezTo>
                <a:lnTo>
                  <a:pt x="711" y="1269"/>
                </a:lnTo>
                <a:lnTo>
                  <a:pt x="682" y="1297"/>
                </a:lnTo>
                <a:cubicBezTo>
                  <a:pt x="679" y="1300"/>
                  <a:pt x="676" y="1300"/>
                  <a:pt x="673" y="1299"/>
                </a:cubicBezTo>
                <a:cubicBezTo>
                  <a:pt x="669" y="1298"/>
                  <a:pt x="664" y="1295"/>
                  <a:pt x="659" y="1289"/>
                </a:cubicBezTo>
                <a:cubicBezTo>
                  <a:pt x="656" y="1287"/>
                  <a:pt x="653" y="1284"/>
                  <a:pt x="652" y="1282"/>
                </a:cubicBezTo>
                <a:cubicBezTo>
                  <a:pt x="650" y="1279"/>
                  <a:pt x="649" y="1277"/>
                  <a:pt x="648" y="1275"/>
                </a:cubicBezTo>
                <a:cubicBezTo>
                  <a:pt x="648" y="1273"/>
                  <a:pt x="648" y="1272"/>
                  <a:pt x="648" y="1270"/>
                </a:cubicBezTo>
                <a:cubicBezTo>
                  <a:pt x="648" y="1268"/>
                  <a:pt x="649" y="1267"/>
                  <a:pt x="651" y="1266"/>
                </a:cubicBezTo>
                <a:lnTo>
                  <a:pt x="679" y="1237"/>
                </a:lnTo>
                <a:lnTo>
                  <a:pt x="630" y="1188"/>
                </a:lnTo>
                <a:cubicBezTo>
                  <a:pt x="629" y="1187"/>
                  <a:pt x="628" y="1186"/>
                  <a:pt x="628" y="1184"/>
                </a:cubicBezTo>
                <a:cubicBezTo>
                  <a:pt x="628" y="1183"/>
                  <a:pt x="628" y="1181"/>
                  <a:pt x="629" y="1179"/>
                </a:cubicBezTo>
                <a:cubicBezTo>
                  <a:pt x="629" y="1177"/>
                  <a:pt x="631" y="1174"/>
                  <a:pt x="633" y="1172"/>
                </a:cubicBezTo>
                <a:cubicBezTo>
                  <a:pt x="635" y="1169"/>
                  <a:pt x="638" y="1166"/>
                  <a:pt x="642" y="1162"/>
                </a:cubicBezTo>
                <a:cubicBezTo>
                  <a:pt x="645" y="1158"/>
                  <a:pt x="649" y="1155"/>
                  <a:pt x="651" y="1153"/>
                </a:cubicBezTo>
                <a:cubicBezTo>
                  <a:pt x="654" y="1151"/>
                  <a:pt x="657" y="1150"/>
                  <a:pt x="659" y="1149"/>
                </a:cubicBezTo>
                <a:cubicBezTo>
                  <a:pt x="661" y="1148"/>
                  <a:pt x="663" y="1148"/>
                  <a:pt x="664" y="1148"/>
                </a:cubicBezTo>
                <a:cubicBezTo>
                  <a:pt x="666" y="1149"/>
                  <a:pt x="667" y="1149"/>
                  <a:pt x="668" y="1150"/>
                </a:cubicBezTo>
                <a:lnTo>
                  <a:pt x="717" y="1199"/>
                </a:lnTo>
                <a:lnTo>
                  <a:pt x="770" y="1146"/>
                </a:lnTo>
                <a:cubicBezTo>
                  <a:pt x="771" y="1145"/>
                  <a:pt x="773" y="1144"/>
                  <a:pt x="774" y="1144"/>
                </a:cubicBezTo>
                <a:cubicBezTo>
                  <a:pt x="775" y="1144"/>
                  <a:pt x="777" y="1144"/>
                  <a:pt x="779" y="1144"/>
                </a:cubicBezTo>
                <a:cubicBezTo>
                  <a:pt x="781" y="1145"/>
                  <a:pt x="783" y="1146"/>
                  <a:pt x="786" y="1148"/>
                </a:cubicBezTo>
                <a:cubicBezTo>
                  <a:pt x="788" y="1149"/>
                  <a:pt x="790" y="1152"/>
                  <a:pt x="793" y="1155"/>
                </a:cubicBezTo>
                <a:cubicBezTo>
                  <a:pt x="799" y="1160"/>
                  <a:pt x="802" y="1165"/>
                  <a:pt x="803" y="1169"/>
                </a:cubicBezTo>
                <a:cubicBezTo>
                  <a:pt x="804" y="1172"/>
                  <a:pt x="804" y="1176"/>
                  <a:pt x="801" y="1178"/>
                </a:cubicBezTo>
                <a:lnTo>
                  <a:pt x="748" y="1231"/>
                </a:lnTo>
                <a:lnTo>
                  <a:pt x="864" y="1346"/>
                </a:lnTo>
                <a:cubicBezTo>
                  <a:pt x="878" y="1360"/>
                  <a:pt x="891" y="1369"/>
                  <a:pt x="902" y="1372"/>
                </a:cubicBezTo>
                <a:cubicBezTo>
                  <a:pt x="914" y="1375"/>
                  <a:pt x="925" y="1371"/>
                  <a:pt x="936" y="1360"/>
                </a:cubicBezTo>
                <a:cubicBezTo>
                  <a:pt x="939" y="1357"/>
                  <a:pt x="942" y="1353"/>
                  <a:pt x="944" y="1350"/>
                </a:cubicBezTo>
                <a:cubicBezTo>
                  <a:pt x="946" y="1346"/>
                  <a:pt x="948" y="1343"/>
                  <a:pt x="949" y="1340"/>
                </a:cubicBezTo>
                <a:cubicBezTo>
                  <a:pt x="950" y="1337"/>
                  <a:pt x="952" y="1335"/>
                  <a:pt x="952" y="1332"/>
                </a:cubicBezTo>
                <a:cubicBezTo>
                  <a:pt x="953" y="1330"/>
                  <a:pt x="954" y="1329"/>
                  <a:pt x="955" y="1327"/>
                </a:cubicBezTo>
                <a:cubicBezTo>
                  <a:pt x="956" y="1327"/>
                  <a:pt x="957" y="1326"/>
                  <a:pt x="958" y="1326"/>
                </a:cubicBezTo>
                <a:cubicBezTo>
                  <a:pt x="959" y="1325"/>
                  <a:pt x="961" y="1326"/>
                  <a:pt x="962" y="1326"/>
                </a:cubicBezTo>
                <a:cubicBezTo>
                  <a:pt x="963" y="1327"/>
                  <a:pt x="965" y="1328"/>
                  <a:pt x="967" y="1330"/>
                </a:cubicBezTo>
                <a:cubicBezTo>
                  <a:pt x="970" y="1331"/>
                  <a:pt x="972" y="1333"/>
                  <a:pt x="975" y="1336"/>
                </a:cubicBezTo>
                <a:close/>
                <a:moveTo>
                  <a:pt x="1191" y="1150"/>
                </a:moveTo>
                <a:cubicBezTo>
                  <a:pt x="1193" y="1152"/>
                  <a:pt x="1194" y="1154"/>
                  <a:pt x="1193" y="1156"/>
                </a:cubicBezTo>
                <a:cubicBezTo>
                  <a:pt x="1193" y="1159"/>
                  <a:pt x="1192" y="1161"/>
                  <a:pt x="1190" y="1164"/>
                </a:cubicBezTo>
                <a:cubicBezTo>
                  <a:pt x="1189" y="1166"/>
                  <a:pt x="1186" y="1170"/>
                  <a:pt x="1182" y="1174"/>
                </a:cubicBezTo>
                <a:cubicBezTo>
                  <a:pt x="1178" y="1178"/>
                  <a:pt x="1174" y="1181"/>
                  <a:pt x="1171" y="1182"/>
                </a:cubicBezTo>
                <a:cubicBezTo>
                  <a:pt x="1169" y="1184"/>
                  <a:pt x="1166" y="1185"/>
                  <a:pt x="1164" y="1186"/>
                </a:cubicBezTo>
                <a:cubicBezTo>
                  <a:pt x="1162" y="1186"/>
                  <a:pt x="1160" y="1185"/>
                  <a:pt x="1158" y="1183"/>
                </a:cubicBezTo>
                <a:lnTo>
                  <a:pt x="1138" y="1162"/>
                </a:lnTo>
                <a:cubicBezTo>
                  <a:pt x="1138" y="1181"/>
                  <a:pt x="1136" y="1199"/>
                  <a:pt x="1130" y="1215"/>
                </a:cubicBezTo>
                <a:cubicBezTo>
                  <a:pt x="1124" y="1231"/>
                  <a:pt x="1115" y="1246"/>
                  <a:pt x="1103" y="1258"/>
                </a:cubicBezTo>
                <a:cubicBezTo>
                  <a:pt x="1092" y="1269"/>
                  <a:pt x="1081" y="1277"/>
                  <a:pt x="1069" y="1283"/>
                </a:cubicBezTo>
                <a:cubicBezTo>
                  <a:pt x="1058" y="1289"/>
                  <a:pt x="1046" y="1293"/>
                  <a:pt x="1034" y="1294"/>
                </a:cubicBezTo>
                <a:cubicBezTo>
                  <a:pt x="1023" y="1294"/>
                  <a:pt x="1012" y="1293"/>
                  <a:pt x="1000" y="1288"/>
                </a:cubicBezTo>
                <a:cubicBezTo>
                  <a:pt x="989" y="1284"/>
                  <a:pt x="979" y="1277"/>
                  <a:pt x="969" y="1267"/>
                </a:cubicBezTo>
                <a:cubicBezTo>
                  <a:pt x="957" y="1255"/>
                  <a:pt x="949" y="1243"/>
                  <a:pt x="945" y="1230"/>
                </a:cubicBezTo>
                <a:cubicBezTo>
                  <a:pt x="942" y="1216"/>
                  <a:pt x="941" y="1202"/>
                  <a:pt x="945" y="1188"/>
                </a:cubicBezTo>
                <a:cubicBezTo>
                  <a:pt x="948" y="1173"/>
                  <a:pt x="954" y="1158"/>
                  <a:pt x="964" y="1143"/>
                </a:cubicBezTo>
                <a:cubicBezTo>
                  <a:pt x="974" y="1127"/>
                  <a:pt x="987" y="1111"/>
                  <a:pt x="1003" y="1095"/>
                </a:cubicBezTo>
                <a:lnTo>
                  <a:pt x="1032" y="1067"/>
                </a:lnTo>
                <a:lnTo>
                  <a:pt x="1016" y="1051"/>
                </a:lnTo>
                <a:cubicBezTo>
                  <a:pt x="1008" y="1043"/>
                  <a:pt x="1000" y="1036"/>
                  <a:pt x="992" y="1032"/>
                </a:cubicBezTo>
                <a:cubicBezTo>
                  <a:pt x="984" y="1028"/>
                  <a:pt x="977" y="1025"/>
                  <a:pt x="969" y="1025"/>
                </a:cubicBezTo>
                <a:cubicBezTo>
                  <a:pt x="961" y="1025"/>
                  <a:pt x="953" y="1026"/>
                  <a:pt x="945" y="1030"/>
                </a:cubicBezTo>
                <a:cubicBezTo>
                  <a:pt x="937" y="1034"/>
                  <a:pt x="929" y="1040"/>
                  <a:pt x="920" y="1049"/>
                </a:cubicBezTo>
                <a:cubicBezTo>
                  <a:pt x="911" y="1058"/>
                  <a:pt x="903" y="1068"/>
                  <a:pt x="898" y="1078"/>
                </a:cubicBezTo>
                <a:cubicBezTo>
                  <a:pt x="893" y="1087"/>
                  <a:pt x="889" y="1096"/>
                  <a:pt x="886" y="1104"/>
                </a:cubicBezTo>
                <a:cubicBezTo>
                  <a:pt x="883" y="1113"/>
                  <a:pt x="881" y="1120"/>
                  <a:pt x="879" y="1126"/>
                </a:cubicBezTo>
                <a:cubicBezTo>
                  <a:pt x="878" y="1132"/>
                  <a:pt x="876" y="1136"/>
                  <a:pt x="874" y="1137"/>
                </a:cubicBezTo>
                <a:cubicBezTo>
                  <a:pt x="873" y="1139"/>
                  <a:pt x="872" y="1139"/>
                  <a:pt x="870" y="1140"/>
                </a:cubicBezTo>
                <a:cubicBezTo>
                  <a:pt x="869" y="1140"/>
                  <a:pt x="867" y="1140"/>
                  <a:pt x="865" y="1139"/>
                </a:cubicBezTo>
                <a:cubicBezTo>
                  <a:pt x="863" y="1139"/>
                  <a:pt x="861" y="1138"/>
                  <a:pt x="859" y="1136"/>
                </a:cubicBezTo>
                <a:cubicBezTo>
                  <a:pt x="857" y="1135"/>
                  <a:pt x="854" y="1133"/>
                  <a:pt x="852" y="1130"/>
                </a:cubicBezTo>
                <a:cubicBezTo>
                  <a:pt x="848" y="1126"/>
                  <a:pt x="846" y="1123"/>
                  <a:pt x="844" y="1120"/>
                </a:cubicBezTo>
                <a:cubicBezTo>
                  <a:pt x="842" y="1118"/>
                  <a:pt x="841" y="1114"/>
                  <a:pt x="841" y="1110"/>
                </a:cubicBezTo>
                <a:cubicBezTo>
                  <a:pt x="842" y="1106"/>
                  <a:pt x="843" y="1100"/>
                  <a:pt x="845" y="1093"/>
                </a:cubicBezTo>
                <a:cubicBezTo>
                  <a:pt x="847" y="1085"/>
                  <a:pt x="851" y="1077"/>
                  <a:pt x="855" y="1068"/>
                </a:cubicBezTo>
                <a:cubicBezTo>
                  <a:pt x="860" y="1059"/>
                  <a:pt x="865" y="1050"/>
                  <a:pt x="871" y="1041"/>
                </a:cubicBezTo>
                <a:cubicBezTo>
                  <a:pt x="878" y="1032"/>
                  <a:pt x="885" y="1023"/>
                  <a:pt x="893" y="1015"/>
                </a:cubicBezTo>
                <a:cubicBezTo>
                  <a:pt x="908" y="1000"/>
                  <a:pt x="922" y="989"/>
                  <a:pt x="936" y="982"/>
                </a:cubicBezTo>
                <a:cubicBezTo>
                  <a:pt x="949" y="975"/>
                  <a:pt x="963" y="972"/>
                  <a:pt x="976" y="972"/>
                </a:cubicBezTo>
                <a:cubicBezTo>
                  <a:pt x="988" y="972"/>
                  <a:pt x="1001" y="975"/>
                  <a:pt x="1014" y="982"/>
                </a:cubicBezTo>
                <a:cubicBezTo>
                  <a:pt x="1026" y="989"/>
                  <a:pt x="1039" y="998"/>
                  <a:pt x="1052" y="1011"/>
                </a:cubicBezTo>
                <a:lnTo>
                  <a:pt x="1191" y="1150"/>
                </a:lnTo>
                <a:close/>
                <a:moveTo>
                  <a:pt x="1059" y="1094"/>
                </a:moveTo>
                <a:lnTo>
                  <a:pt x="1027" y="1126"/>
                </a:lnTo>
                <a:cubicBezTo>
                  <a:pt x="1016" y="1137"/>
                  <a:pt x="1008" y="1146"/>
                  <a:pt x="1002" y="1156"/>
                </a:cubicBezTo>
                <a:cubicBezTo>
                  <a:pt x="997" y="1165"/>
                  <a:pt x="993" y="1174"/>
                  <a:pt x="991" y="1183"/>
                </a:cubicBezTo>
                <a:cubicBezTo>
                  <a:pt x="990" y="1191"/>
                  <a:pt x="990" y="1199"/>
                  <a:pt x="992" y="1206"/>
                </a:cubicBezTo>
                <a:cubicBezTo>
                  <a:pt x="995" y="1213"/>
                  <a:pt x="999" y="1220"/>
                  <a:pt x="1005" y="1226"/>
                </a:cubicBezTo>
                <a:cubicBezTo>
                  <a:pt x="1016" y="1237"/>
                  <a:pt x="1028" y="1242"/>
                  <a:pt x="1041" y="1242"/>
                </a:cubicBezTo>
                <a:cubicBezTo>
                  <a:pt x="1054" y="1241"/>
                  <a:pt x="1067" y="1235"/>
                  <a:pt x="1079" y="1223"/>
                </a:cubicBezTo>
                <a:cubicBezTo>
                  <a:pt x="1089" y="1213"/>
                  <a:pt x="1096" y="1201"/>
                  <a:pt x="1099" y="1188"/>
                </a:cubicBezTo>
                <a:cubicBezTo>
                  <a:pt x="1103" y="1174"/>
                  <a:pt x="1104" y="1157"/>
                  <a:pt x="1103" y="1138"/>
                </a:cubicBezTo>
                <a:lnTo>
                  <a:pt x="1059" y="1094"/>
                </a:lnTo>
                <a:close/>
                <a:moveTo>
                  <a:pt x="1568" y="773"/>
                </a:moveTo>
                <a:cubicBezTo>
                  <a:pt x="1569" y="775"/>
                  <a:pt x="1570" y="776"/>
                  <a:pt x="1570" y="777"/>
                </a:cubicBezTo>
                <a:cubicBezTo>
                  <a:pt x="1570" y="779"/>
                  <a:pt x="1570" y="781"/>
                  <a:pt x="1569" y="783"/>
                </a:cubicBezTo>
                <a:cubicBezTo>
                  <a:pt x="1568" y="785"/>
                  <a:pt x="1567" y="787"/>
                  <a:pt x="1565" y="790"/>
                </a:cubicBezTo>
                <a:cubicBezTo>
                  <a:pt x="1563" y="792"/>
                  <a:pt x="1560" y="796"/>
                  <a:pt x="1556" y="799"/>
                </a:cubicBezTo>
                <a:cubicBezTo>
                  <a:pt x="1552" y="803"/>
                  <a:pt x="1549" y="806"/>
                  <a:pt x="1546" y="808"/>
                </a:cubicBezTo>
                <a:cubicBezTo>
                  <a:pt x="1543" y="810"/>
                  <a:pt x="1541" y="812"/>
                  <a:pt x="1539" y="813"/>
                </a:cubicBezTo>
                <a:cubicBezTo>
                  <a:pt x="1537" y="814"/>
                  <a:pt x="1535" y="814"/>
                  <a:pt x="1534" y="814"/>
                </a:cubicBezTo>
                <a:cubicBezTo>
                  <a:pt x="1532" y="813"/>
                  <a:pt x="1531" y="813"/>
                  <a:pt x="1530" y="811"/>
                </a:cubicBezTo>
                <a:lnTo>
                  <a:pt x="1404" y="686"/>
                </a:lnTo>
                <a:cubicBezTo>
                  <a:pt x="1395" y="677"/>
                  <a:pt x="1387" y="670"/>
                  <a:pt x="1378" y="664"/>
                </a:cubicBezTo>
                <a:cubicBezTo>
                  <a:pt x="1369" y="659"/>
                  <a:pt x="1361" y="655"/>
                  <a:pt x="1352" y="653"/>
                </a:cubicBezTo>
                <a:cubicBezTo>
                  <a:pt x="1344" y="651"/>
                  <a:pt x="1335" y="652"/>
                  <a:pt x="1327" y="654"/>
                </a:cubicBezTo>
                <a:cubicBezTo>
                  <a:pt x="1319" y="657"/>
                  <a:pt x="1312" y="661"/>
                  <a:pt x="1305" y="668"/>
                </a:cubicBezTo>
                <a:cubicBezTo>
                  <a:pt x="1296" y="677"/>
                  <a:pt x="1291" y="689"/>
                  <a:pt x="1289" y="705"/>
                </a:cubicBezTo>
                <a:cubicBezTo>
                  <a:pt x="1287" y="720"/>
                  <a:pt x="1287" y="740"/>
                  <a:pt x="1289" y="763"/>
                </a:cubicBezTo>
                <a:lnTo>
                  <a:pt x="1434" y="907"/>
                </a:lnTo>
                <a:cubicBezTo>
                  <a:pt x="1435" y="909"/>
                  <a:pt x="1435" y="910"/>
                  <a:pt x="1436" y="911"/>
                </a:cubicBezTo>
                <a:cubicBezTo>
                  <a:pt x="1436" y="913"/>
                  <a:pt x="1436" y="915"/>
                  <a:pt x="1435" y="917"/>
                </a:cubicBezTo>
                <a:cubicBezTo>
                  <a:pt x="1434" y="919"/>
                  <a:pt x="1432" y="921"/>
                  <a:pt x="1430" y="924"/>
                </a:cubicBezTo>
                <a:cubicBezTo>
                  <a:pt x="1428" y="927"/>
                  <a:pt x="1425" y="930"/>
                  <a:pt x="1422" y="934"/>
                </a:cubicBezTo>
                <a:cubicBezTo>
                  <a:pt x="1418" y="937"/>
                  <a:pt x="1415" y="940"/>
                  <a:pt x="1412" y="942"/>
                </a:cubicBezTo>
                <a:cubicBezTo>
                  <a:pt x="1409" y="944"/>
                  <a:pt x="1407" y="946"/>
                  <a:pt x="1405" y="947"/>
                </a:cubicBezTo>
                <a:cubicBezTo>
                  <a:pt x="1403" y="948"/>
                  <a:pt x="1401" y="948"/>
                  <a:pt x="1400" y="948"/>
                </a:cubicBezTo>
                <a:cubicBezTo>
                  <a:pt x="1398" y="947"/>
                  <a:pt x="1397" y="947"/>
                  <a:pt x="1396" y="945"/>
                </a:cubicBezTo>
                <a:lnTo>
                  <a:pt x="1270" y="820"/>
                </a:lnTo>
                <a:cubicBezTo>
                  <a:pt x="1262" y="811"/>
                  <a:pt x="1253" y="804"/>
                  <a:pt x="1244" y="799"/>
                </a:cubicBezTo>
                <a:cubicBezTo>
                  <a:pt x="1235" y="793"/>
                  <a:pt x="1226" y="789"/>
                  <a:pt x="1218" y="788"/>
                </a:cubicBezTo>
                <a:cubicBezTo>
                  <a:pt x="1209" y="786"/>
                  <a:pt x="1201" y="786"/>
                  <a:pt x="1193" y="788"/>
                </a:cubicBezTo>
                <a:cubicBezTo>
                  <a:pt x="1185" y="791"/>
                  <a:pt x="1178" y="795"/>
                  <a:pt x="1171" y="802"/>
                </a:cubicBezTo>
                <a:cubicBezTo>
                  <a:pt x="1162" y="811"/>
                  <a:pt x="1157" y="823"/>
                  <a:pt x="1155" y="839"/>
                </a:cubicBezTo>
                <a:cubicBezTo>
                  <a:pt x="1152" y="855"/>
                  <a:pt x="1153" y="874"/>
                  <a:pt x="1155" y="897"/>
                </a:cubicBezTo>
                <a:lnTo>
                  <a:pt x="1299" y="1042"/>
                </a:lnTo>
                <a:cubicBezTo>
                  <a:pt x="1301" y="1043"/>
                  <a:pt x="1301" y="1044"/>
                  <a:pt x="1302" y="1046"/>
                </a:cubicBezTo>
                <a:cubicBezTo>
                  <a:pt x="1302" y="1047"/>
                  <a:pt x="1302" y="1049"/>
                  <a:pt x="1301" y="1051"/>
                </a:cubicBezTo>
                <a:cubicBezTo>
                  <a:pt x="1300" y="1053"/>
                  <a:pt x="1299" y="1055"/>
                  <a:pt x="1296" y="1058"/>
                </a:cubicBezTo>
                <a:cubicBezTo>
                  <a:pt x="1294" y="1061"/>
                  <a:pt x="1291" y="1064"/>
                  <a:pt x="1287" y="1068"/>
                </a:cubicBezTo>
                <a:cubicBezTo>
                  <a:pt x="1284" y="1071"/>
                  <a:pt x="1281" y="1074"/>
                  <a:pt x="1278" y="1076"/>
                </a:cubicBezTo>
                <a:cubicBezTo>
                  <a:pt x="1275" y="1079"/>
                  <a:pt x="1273" y="1080"/>
                  <a:pt x="1271" y="1081"/>
                </a:cubicBezTo>
                <a:cubicBezTo>
                  <a:pt x="1269" y="1082"/>
                  <a:pt x="1267" y="1082"/>
                  <a:pt x="1265" y="1082"/>
                </a:cubicBezTo>
                <a:cubicBezTo>
                  <a:pt x="1264" y="1081"/>
                  <a:pt x="1263" y="1081"/>
                  <a:pt x="1262" y="1079"/>
                </a:cubicBezTo>
                <a:lnTo>
                  <a:pt x="1055" y="873"/>
                </a:lnTo>
                <a:cubicBezTo>
                  <a:pt x="1054" y="872"/>
                  <a:pt x="1053" y="871"/>
                  <a:pt x="1053" y="869"/>
                </a:cubicBezTo>
                <a:cubicBezTo>
                  <a:pt x="1052" y="868"/>
                  <a:pt x="1053" y="866"/>
                  <a:pt x="1053" y="864"/>
                </a:cubicBezTo>
                <a:cubicBezTo>
                  <a:pt x="1054" y="862"/>
                  <a:pt x="1055" y="860"/>
                  <a:pt x="1057" y="858"/>
                </a:cubicBezTo>
                <a:cubicBezTo>
                  <a:pt x="1059" y="855"/>
                  <a:pt x="1062" y="852"/>
                  <a:pt x="1065" y="849"/>
                </a:cubicBezTo>
                <a:cubicBezTo>
                  <a:pt x="1069" y="845"/>
                  <a:pt x="1072" y="843"/>
                  <a:pt x="1074" y="841"/>
                </a:cubicBezTo>
                <a:cubicBezTo>
                  <a:pt x="1076" y="839"/>
                  <a:pt x="1079" y="838"/>
                  <a:pt x="1081" y="837"/>
                </a:cubicBezTo>
                <a:cubicBezTo>
                  <a:pt x="1082" y="836"/>
                  <a:pt x="1084" y="836"/>
                  <a:pt x="1085" y="837"/>
                </a:cubicBezTo>
                <a:cubicBezTo>
                  <a:pt x="1087" y="837"/>
                  <a:pt x="1088" y="838"/>
                  <a:pt x="1089" y="839"/>
                </a:cubicBezTo>
                <a:lnTo>
                  <a:pt x="1117" y="866"/>
                </a:lnTo>
                <a:cubicBezTo>
                  <a:pt x="1115" y="842"/>
                  <a:pt x="1117" y="821"/>
                  <a:pt x="1122" y="804"/>
                </a:cubicBezTo>
                <a:cubicBezTo>
                  <a:pt x="1127" y="787"/>
                  <a:pt x="1135" y="773"/>
                  <a:pt x="1146" y="762"/>
                </a:cubicBezTo>
                <a:cubicBezTo>
                  <a:pt x="1155" y="753"/>
                  <a:pt x="1163" y="746"/>
                  <a:pt x="1172" y="742"/>
                </a:cubicBezTo>
                <a:cubicBezTo>
                  <a:pt x="1181" y="737"/>
                  <a:pt x="1190" y="734"/>
                  <a:pt x="1198" y="732"/>
                </a:cubicBezTo>
                <a:cubicBezTo>
                  <a:pt x="1207" y="730"/>
                  <a:pt x="1216" y="730"/>
                  <a:pt x="1225" y="732"/>
                </a:cubicBezTo>
                <a:cubicBezTo>
                  <a:pt x="1233" y="733"/>
                  <a:pt x="1242" y="735"/>
                  <a:pt x="1250" y="739"/>
                </a:cubicBezTo>
                <a:cubicBezTo>
                  <a:pt x="1250" y="725"/>
                  <a:pt x="1250" y="712"/>
                  <a:pt x="1251" y="700"/>
                </a:cubicBezTo>
                <a:cubicBezTo>
                  <a:pt x="1252" y="689"/>
                  <a:pt x="1254" y="679"/>
                  <a:pt x="1256" y="670"/>
                </a:cubicBezTo>
                <a:cubicBezTo>
                  <a:pt x="1259" y="661"/>
                  <a:pt x="1262" y="653"/>
                  <a:pt x="1266" y="646"/>
                </a:cubicBezTo>
                <a:cubicBezTo>
                  <a:pt x="1270" y="639"/>
                  <a:pt x="1275" y="633"/>
                  <a:pt x="1280" y="628"/>
                </a:cubicBezTo>
                <a:cubicBezTo>
                  <a:pt x="1293" y="614"/>
                  <a:pt x="1307" y="605"/>
                  <a:pt x="1321" y="601"/>
                </a:cubicBezTo>
                <a:cubicBezTo>
                  <a:pt x="1334" y="597"/>
                  <a:pt x="1348" y="596"/>
                  <a:pt x="1361" y="598"/>
                </a:cubicBezTo>
                <a:cubicBezTo>
                  <a:pt x="1375" y="600"/>
                  <a:pt x="1388" y="605"/>
                  <a:pt x="1400" y="613"/>
                </a:cubicBezTo>
                <a:cubicBezTo>
                  <a:pt x="1413" y="621"/>
                  <a:pt x="1426" y="631"/>
                  <a:pt x="1437" y="643"/>
                </a:cubicBezTo>
                <a:lnTo>
                  <a:pt x="1568" y="773"/>
                </a:lnTo>
                <a:close/>
                <a:moveTo>
                  <a:pt x="1678" y="663"/>
                </a:moveTo>
                <a:cubicBezTo>
                  <a:pt x="1680" y="664"/>
                  <a:pt x="1680" y="665"/>
                  <a:pt x="1681" y="667"/>
                </a:cubicBezTo>
                <a:cubicBezTo>
                  <a:pt x="1681" y="668"/>
                  <a:pt x="1681" y="670"/>
                  <a:pt x="1680" y="672"/>
                </a:cubicBezTo>
                <a:cubicBezTo>
                  <a:pt x="1679" y="674"/>
                  <a:pt x="1678" y="676"/>
                  <a:pt x="1675" y="679"/>
                </a:cubicBezTo>
                <a:cubicBezTo>
                  <a:pt x="1673" y="682"/>
                  <a:pt x="1670" y="685"/>
                  <a:pt x="1666" y="689"/>
                </a:cubicBezTo>
                <a:cubicBezTo>
                  <a:pt x="1663" y="692"/>
                  <a:pt x="1660" y="695"/>
                  <a:pt x="1657" y="697"/>
                </a:cubicBezTo>
                <a:cubicBezTo>
                  <a:pt x="1654" y="700"/>
                  <a:pt x="1652" y="701"/>
                  <a:pt x="1650" y="702"/>
                </a:cubicBezTo>
                <a:cubicBezTo>
                  <a:pt x="1648" y="703"/>
                  <a:pt x="1646" y="703"/>
                  <a:pt x="1644" y="703"/>
                </a:cubicBezTo>
                <a:cubicBezTo>
                  <a:pt x="1643" y="702"/>
                  <a:pt x="1642" y="702"/>
                  <a:pt x="1641" y="700"/>
                </a:cubicBezTo>
                <a:lnTo>
                  <a:pt x="1434" y="494"/>
                </a:lnTo>
                <a:cubicBezTo>
                  <a:pt x="1433" y="493"/>
                  <a:pt x="1432" y="492"/>
                  <a:pt x="1432" y="490"/>
                </a:cubicBezTo>
                <a:cubicBezTo>
                  <a:pt x="1432" y="489"/>
                  <a:pt x="1432" y="487"/>
                  <a:pt x="1433" y="485"/>
                </a:cubicBezTo>
                <a:cubicBezTo>
                  <a:pt x="1434" y="483"/>
                  <a:pt x="1435" y="481"/>
                  <a:pt x="1437" y="478"/>
                </a:cubicBezTo>
                <a:cubicBezTo>
                  <a:pt x="1439" y="475"/>
                  <a:pt x="1442" y="472"/>
                  <a:pt x="1446" y="468"/>
                </a:cubicBezTo>
                <a:cubicBezTo>
                  <a:pt x="1450" y="464"/>
                  <a:pt x="1453" y="461"/>
                  <a:pt x="1456" y="459"/>
                </a:cubicBezTo>
                <a:cubicBezTo>
                  <a:pt x="1459" y="457"/>
                  <a:pt x="1461" y="456"/>
                  <a:pt x="1463" y="455"/>
                </a:cubicBezTo>
                <a:cubicBezTo>
                  <a:pt x="1465" y="454"/>
                  <a:pt x="1467" y="454"/>
                  <a:pt x="1468" y="454"/>
                </a:cubicBezTo>
                <a:cubicBezTo>
                  <a:pt x="1470" y="454"/>
                  <a:pt x="1471" y="455"/>
                  <a:pt x="1472" y="456"/>
                </a:cubicBezTo>
                <a:lnTo>
                  <a:pt x="1678" y="663"/>
                </a:lnTo>
                <a:close/>
                <a:moveTo>
                  <a:pt x="1407" y="382"/>
                </a:moveTo>
                <a:cubicBezTo>
                  <a:pt x="1416" y="391"/>
                  <a:pt x="1420" y="399"/>
                  <a:pt x="1420" y="405"/>
                </a:cubicBezTo>
                <a:cubicBezTo>
                  <a:pt x="1420" y="412"/>
                  <a:pt x="1415" y="420"/>
                  <a:pt x="1406" y="429"/>
                </a:cubicBezTo>
                <a:cubicBezTo>
                  <a:pt x="1397" y="438"/>
                  <a:pt x="1390" y="442"/>
                  <a:pt x="1383" y="442"/>
                </a:cubicBezTo>
                <a:cubicBezTo>
                  <a:pt x="1377" y="442"/>
                  <a:pt x="1369" y="438"/>
                  <a:pt x="1360" y="429"/>
                </a:cubicBezTo>
                <a:cubicBezTo>
                  <a:pt x="1352" y="421"/>
                  <a:pt x="1347" y="413"/>
                  <a:pt x="1347" y="406"/>
                </a:cubicBezTo>
                <a:cubicBezTo>
                  <a:pt x="1348" y="400"/>
                  <a:pt x="1352" y="392"/>
                  <a:pt x="1361" y="383"/>
                </a:cubicBezTo>
                <a:cubicBezTo>
                  <a:pt x="1370" y="374"/>
                  <a:pt x="1378" y="370"/>
                  <a:pt x="1384" y="369"/>
                </a:cubicBezTo>
                <a:cubicBezTo>
                  <a:pt x="1390" y="369"/>
                  <a:pt x="1398" y="373"/>
                  <a:pt x="1407" y="382"/>
                </a:cubicBezTo>
                <a:close/>
                <a:moveTo>
                  <a:pt x="1926" y="415"/>
                </a:moveTo>
                <a:cubicBezTo>
                  <a:pt x="1927" y="416"/>
                  <a:pt x="1928" y="418"/>
                  <a:pt x="1928" y="419"/>
                </a:cubicBezTo>
                <a:cubicBezTo>
                  <a:pt x="1928" y="421"/>
                  <a:pt x="1928" y="422"/>
                  <a:pt x="1927" y="424"/>
                </a:cubicBezTo>
                <a:cubicBezTo>
                  <a:pt x="1926" y="426"/>
                  <a:pt x="1925" y="429"/>
                  <a:pt x="1923" y="432"/>
                </a:cubicBezTo>
                <a:cubicBezTo>
                  <a:pt x="1921" y="434"/>
                  <a:pt x="1918" y="437"/>
                  <a:pt x="1914" y="441"/>
                </a:cubicBezTo>
                <a:cubicBezTo>
                  <a:pt x="1910" y="445"/>
                  <a:pt x="1907" y="448"/>
                  <a:pt x="1904" y="450"/>
                </a:cubicBezTo>
                <a:cubicBezTo>
                  <a:pt x="1901" y="452"/>
                  <a:pt x="1899" y="454"/>
                  <a:pt x="1897" y="454"/>
                </a:cubicBezTo>
                <a:cubicBezTo>
                  <a:pt x="1895" y="455"/>
                  <a:pt x="1893" y="455"/>
                  <a:pt x="1892" y="455"/>
                </a:cubicBezTo>
                <a:cubicBezTo>
                  <a:pt x="1890" y="455"/>
                  <a:pt x="1889" y="454"/>
                  <a:pt x="1888" y="453"/>
                </a:cubicBezTo>
                <a:lnTo>
                  <a:pt x="1767" y="332"/>
                </a:lnTo>
                <a:cubicBezTo>
                  <a:pt x="1755" y="320"/>
                  <a:pt x="1745" y="312"/>
                  <a:pt x="1736" y="307"/>
                </a:cubicBezTo>
                <a:cubicBezTo>
                  <a:pt x="1727" y="301"/>
                  <a:pt x="1718" y="298"/>
                  <a:pt x="1709" y="296"/>
                </a:cubicBezTo>
                <a:cubicBezTo>
                  <a:pt x="1701" y="294"/>
                  <a:pt x="1692" y="295"/>
                  <a:pt x="1684" y="298"/>
                </a:cubicBezTo>
                <a:cubicBezTo>
                  <a:pt x="1675" y="301"/>
                  <a:pt x="1668" y="306"/>
                  <a:pt x="1660" y="313"/>
                </a:cubicBezTo>
                <a:cubicBezTo>
                  <a:pt x="1651" y="322"/>
                  <a:pt x="1645" y="335"/>
                  <a:pt x="1642" y="352"/>
                </a:cubicBezTo>
                <a:cubicBezTo>
                  <a:pt x="1639" y="368"/>
                  <a:pt x="1639" y="388"/>
                  <a:pt x="1642" y="411"/>
                </a:cubicBezTo>
                <a:lnTo>
                  <a:pt x="1786" y="555"/>
                </a:lnTo>
                <a:cubicBezTo>
                  <a:pt x="1787" y="556"/>
                  <a:pt x="1788" y="558"/>
                  <a:pt x="1788" y="559"/>
                </a:cubicBezTo>
                <a:cubicBezTo>
                  <a:pt x="1788" y="561"/>
                  <a:pt x="1788" y="562"/>
                  <a:pt x="1787" y="564"/>
                </a:cubicBezTo>
                <a:cubicBezTo>
                  <a:pt x="1786" y="566"/>
                  <a:pt x="1785" y="569"/>
                  <a:pt x="1783" y="571"/>
                </a:cubicBezTo>
                <a:cubicBezTo>
                  <a:pt x="1781" y="574"/>
                  <a:pt x="1778" y="577"/>
                  <a:pt x="1774" y="581"/>
                </a:cubicBezTo>
                <a:cubicBezTo>
                  <a:pt x="1770" y="585"/>
                  <a:pt x="1767" y="588"/>
                  <a:pt x="1764" y="590"/>
                </a:cubicBezTo>
                <a:cubicBezTo>
                  <a:pt x="1762" y="592"/>
                  <a:pt x="1759" y="594"/>
                  <a:pt x="1757" y="594"/>
                </a:cubicBezTo>
                <a:cubicBezTo>
                  <a:pt x="1755" y="595"/>
                  <a:pt x="1753" y="596"/>
                  <a:pt x="1752" y="595"/>
                </a:cubicBezTo>
                <a:cubicBezTo>
                  <a:pt x="1751" y="595"/>
                  <a:pt x="1749" y="594"/>
                  <a:pt x="1748" y="593"/>
                </a:cubicBezTo>
                <a:lnTo>
                  <a:pt x="1542" y="387"/>
                </a:lnTo>
                <a:cubicBezTo>
                  <a:pt x="1541" y="385"/>
                  <a:pt x="1540" y="384"/>
                  <a:pt x="1539" y="383"/>
                </a:cubicBezTo>
                <a:cubicBezTo>
                  <a:pt x="1539" y="382"/>
                  <a:pt x="1539" y="380"/>
                  <a:pt x="1540" y="378"/>
                </a:cubicBezTo>
                <a:cubicBezTo>
                  <a:pt x="1540" y="376"/>
                  <a:pt x="1542" y="373"/>
                  <a:pt x="1544" y="371"/>
                </a:cubicBezTo>
                <a:cubicBezTo>
                  <a:pt x="1546" y="369"/>
                  <a:pt x="1548" y="366"/>
                  <a:pt x="1552" y="362"/>
                </a:cubicBezTo>
                <a:cubicBezTo>
                  <a:pt x="1555" y="359"/>
                  <a:pt x="1558" y="356"/>
                  <a:pt x="1561" y="354"/>
                </a:cubicBezTo>
                <a:cubicBezTo>
                  <a:pt x="1563" y="352"/>
                  <a:pt x="1565" y="351"/>
                  <a:pt x="1567" y="350"/>
                </a:cubicBezTo>
                <a:cubicBezTo>
                  <a:pt x="1569" y="350"/>
                  <a:pt x="1571" y="350"/>
                  <a:pt x="1572" y="350"/>
                </a:cubicBezTo>
                <a:cubicBezTo>
                  <a:pt x="1573" y="350"/>
                  <a:pt x="1575" y="351"/>
                  <a:pt x="1576" y="352"/>
                </a:cubicBezTo>
                <a:lnTo>
                  <a:pt x="1603" y="380"/>
                </a:lnTo>
                <a:cubicBezTo>
                  <a:pt x="1602" y="355"/>
                  <a:pt x="1604" y="334"/>
                  <a:pt x="1609" y="316"/>
                </a:cubicBezTo>
                <a:cubicBezTo>
                  <a:pt x="1615" y="299"/>
                  <a:pt x="1623" y="284"/>
                  <a:pt x="1635" y="272"/>
                </a:cubicBezTo>
                <a:cubicBezTo>
                  <a:pt x="1649" y="259"/>
                  <a:pt x="1663" y="249"/>
                  <a:pt x="1677" y="245"/>
                </a:cubicBezTo>
                <a:cubicBezTo>
                  <a:pt x="1691" y="240"/>
                  <a:pt x="1705" y="239"/>
                  <a:pt x="1718" y="241"/>
                </a:cubicBezTo>
                <a:cubicBezTo>
                  <a:pt x="1732" y="243"/>
                  <a:pt x="1745" y="248"/>
                  <a:pt x="1758" y="255"/>
                </a:cubicBezTo>
                <a:cubicBezTo>
                  <a:pt x="1771" y="263"/>
                  <a:pt x="1785" y="275"/>
                  <a:pt x="1800" y="289"/>
                </a:cubicBezTo>
                <a:lnTo>
                  <a:pt x="1926" y="415"/>
                </a:lnTo>
                <a:close/>
                <a:moveTo>
                  <a:pt x="2061" y="56"/>
                </a:moveTo>
                <a:cubicBezTo>
                  <a:pt x="2067" y="62"/>
                  <a:pt x="2070" y="68"/>
                  <a:pt x="2069" y="73"/>
                </a:cubicBezTo>
                <a:cubicBezTo>
                  <a:pt x="2069" y="79"/>
                  <a:pt x="2067" y="83"/>
                  <a:pt x="2063" y="87"/>
                </a:cubicBezTo>
                <a:lnTo>
                  <a:pt x="1927" y="223"/>
                </a:lnTo>
                <a:cubicBezTo>
                  <a:pt x="1938" y="234"/>
                  <a:pt x="1950" y="244"/>
                  <a:pt x="1961" y="250"/>
                </a:cubicBezTo>
                <a:cubicBezTo>
                  <a:pt x="1973" y="257"/>
                  <a:pt x="1984" y="261"/>
                  <a:pt x="1996" y="263"/>
                </a:cubicBezTo>
                <a:cubicBezTo>
                  <a:pt x="2008" y="264"/>
                  <a:pt x="2020" y="262"/>
                  <a:pt x="2032" y="257"/>
                </a:cubicBezTo>
                <a:cubicBezTo>
                  <a:pt x="2045" y="252"/>
                  <a:pt x="2057" y="243"/>
                  <a:pt x="2069" y="230"/>
                </a:cubicBezTo>
                <a:cubicBezTo>
                  <a:pt x="2079" y="221"/>
                  <a:pt x="2087" y="211"/>
                  <a:pt x="2093" y="202"/>
                </a:cubicBezTo>
                <a:cubicBezTo>
                  <a:pt x="2099" y="192"/>
                  <a:pt x="2104" y="184"/>
                  <a:pt x="2108" y="176"/>
                </a:cubicBezTo>
                <a:cubicBezTo>
                  <a:pt x="2111" y="169"/>
                  <a:pt x="2114" y="162"/>
                  <a:pt x="2116" y="157"/>
                </a:cubicBezTo>
                <a:cubicBezTo>
                  <a:pt x="2118" y="152"/>
                  <a:pt x="2120" y="149"/>
                  <a:pt x="2122" y="147"/>
                </a:cubicBezTo>
                <a:cubicBezTo>
                  <a:pt x="2123" y="146"/>
                  <a:pt x="2124" y="145"/>
                  <a:pt x="2126" y="145"/>
                </a:cubicBezTo>
                <a:cubicBezTo>
                  <a:pt x="2127" y="144"/>
                  <a:pt x="2128" y="144"/>
                  <a:pt x="2130" y="145"/>
                </a:cubicBezTo>
                <a:cubicBezTo>
                  <a:pt x="2131" y="146"/>
                  <a:pt x="2133" y="147"/>
                  <a:pt x="2135" y="148"/>
                </a:cubicBezTo>
                <a:cubicBezTo>
                  <a:pt x="2138" y="150"/>
                  <a:pt x="2140" y="152"/>
                  <a:pt x="2143" y="155"/>
                </a:cubicBezTo>
                <a:cubicBezTo>
                  <a:pt x="2145" y="157"/>
                  <a:pt x="2146" y="159"/>
                  <a:pt x="2148" y="161"/>
                </a:cubicBezTo>
                <a:cubicBezTo>
                  <a:pt x="2149" y="162"/>
                  <a:pt x="2150" y="164"/>
                  <a:pt x="2151" y="165"/>
                </a:cubicBezTo>
                <a:cubicBezTo>
                  <a:pt x="2152" y="166"/>
                  <a:pt x="2153" y="168"/>
                  <a:pt x="2153" y="169"/>
                </a:cubicBezTo>
                <a:cubicBezTo>
                  <a:pt x="2153" y="171"/>
                  <a:pt x="2154" y="172"/>
                  <a:pt x="2154" y="174"/>
                </a:cubicBezTo>
                <a:cubicBezTo>
                  <a:pt x="2154" y="176"/>
                  <a:pt x="2152" y="179"/>
                  <a:pt x="2150" y="185"/>
                </a:cubicBezTo>
                <a:cubicBezTo>
                  <a:pt x="2148" y="192"/>
                  <a:pt x="2145" y="199"/>
                  <a:pt x="2140" y="207"/>
                </a:cubicBezTo>
                <a:cubicBezTo>
                  <a:pt x="2135" y="216"/>
                  <a:pt x="2129" y="225"/>
                  <a:pt x="2122" y="235"/>
                </a:cubicBezTo>
                <a:cubicBezTo>
                  <a:pt x="2115" y="245"/>
                  <a:pt x="2106" y="255"/>
                  <a:pt x="2096" y="265"/>
                </a:cubicBezTo>
                <a:cubicBezTo>
                  <a:pt x="2079" y="282"/>
                  <a:pt x="2062" y="294"/>
                  <a:pt x="2045" y="302"/>
                </a:cubicBezTo>
                <a:cubicBezTo>
                  <a:pt x="2027" y="310"/>
                  <a:pt x="2009" y="314"/>
                  <a:pt x="1991" y="313"/>
                </a:cubicBezTo>
                <a:cubicBezTo>
                  <a:pt x="1973" y="313"/>
                  <a:pt x="1955" y="308"/>
                  <a:pt x="1937" y="298"/>
                </a:cubicBezTo>
                <a:cubicBezTo>
                  <a:pt x="1918" y="288"/>
                  <a:pt x="1900" y="274"/>
                  <a:pt x="1881" y="256"/>
                </a:cubicBezTo>
                <a:cubicBezTo>
                  <a:pt x="1863" y="238"/>
                  <a:pt x="1850" y="220"/>
                  <a:pt x="1840" y="201"/>
                </a:cubicBezTo>
                <a:cubicBezTo>
                  <a:pt x="1830" y="182"/>
                  <a:pt x="1825" y="164"/>
                  <a:pt x="1824" y="145"/>
                </a:cubicBezTo>
                <a:cubicBezTo>
                  <a:pt x="1823" y="127"/>
                  <a:pt x="1826" y="109"/>
                  <a:pt x="1832" y="91"/>
                </a:cubicBezTo>
                <a:cubicBezTo>
                  <a:pt x="1839" y="74"/>
                  <a:pt x="1850" y="57"/>
                  <a:pt x="1866" y="42"/>
                </a:cubicBezTo>
                <a:cubicBezTo>
                  <a:pt x="1882" y="26"/>
                  <a:pt x="1898" y="15"/>
                  <a:pt x="1915" y="9"/>
                </a:cubicBezTo>
                <a:cubicBezTo>
                  <a:pt x="1931" y="2"/>
                  <a:pt x="1948" y="0"/>
                  <a:pt x="1964" y="1"/>
                </a:cubicBezTo>
                <a:cubicBezTo>
                  <a:pt x="1980" y="3"/>
                  <a:pt x="1996" y="8"/>
                  <a:pt x="2011" y="16"/>
                </a:cubicBezTo>
                <a:cubicBezTo>
                  <a:pt x="2026" y="25"/>
                  <a:pt x="2041" y="36"/>
                  <a:pt x="2054" y="49"/>
                </a:cubicBezTo>
                <a:lnTo>
                  <a:pt x="2061" y="56"/>
                </a:lnTo>
                <a:close/>
                <a:moveTo>
                  <a:pt x="2012" y="83"/>
                </a:moveTo>
                <a:cubicBezTo>
                  <a:pt x="1992" y="62"/>
                  <a:pt x="1972" y="51"/>
                  <a:pt x="1952" y="49"/>
                </a:cubicBezTo>
                <a:cubicBezTo>
                  <a:pt x="1931" y="47"/>
                  <a:pt x="1912" y="55"/>
                  <a:pt x="1893" y="74"/>
                </a:cubicBezTo>
                <a:cubicBezTo>
                  <a:pt x="1884" y="83"/>
                  <a:pt x="1877" y="93"/>
                  <a:pt x="1874" y="104"/>
                </a:cubicBezTo>
                <a:cubicBezTo>
                  <a:pt x="1870" y="114"/>
                  <a:pt x="1869" y="125"/>
                  <a:pt x="1870" y="135"/>
                </a:cubicBezTo>
                <a:cubicBezTo>
                  <a:pt x="1871" y="146"/>
                  <a:pt x="1874" y="156"/>
                  <a:pt x="1879" y="167"/>
                </a:cubicBezTo>
                <a:cubicBezTo>
                  <a:pt x="1884" y="177"/>
                  <a:pt x="1891" y="187"/>
                  <a:pt x="1899" y="195"/>
                </a:cubicBezTo>
                <a:lnTo>
                  <a:pt x="201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4" name="Freeform 248"/>
          <p:cNvSpPr>
            <a:spLocks noEditPoints="1"/>
          </p:cNvSpPr>
          <p:nvPr/>
        </p:nvSpPr>
        <p:spPr bwMode="auto">
          <a:xfrm>
            <a:off x="1618813" y="4417292"/>
            <a:ext cx="360679" cy="433388"/>
          </a:xfrm>
          <a:custGeom>
            <a:avLst/>
            <a:gdLst>
              <a:gd name="T0" fmla="*/ 403 w 2269"/>
              <a:gd name="T1" fmla="*/ 2059 h 2274"/>
              <a:gd name="T2" fmla="*/ 210 w 2269"/>
              <a:gd name="T3" fmla="*/ 2260 h 2274"/>
              <a:gd name="T4" fmla="*/ 8 w 2269"/>
              <a:gd name="T5" fmla="*/ 1864 h 2274"/>
              <a:gd name="T6" fmla="*/ 59 w 2269"/>
              <a:gd name="T7" fmla="*/ 1894 h 2274"/>
              <a:gd name="T8" fmla="*/ 542 w 2269"/>
              <a:gd name="T9" fmla="*/ 1934 h 2274"/>
              <a:gd name="T10" fmla="*/ 432 w 2269"/>
              <a:gd name="T11" fmla="*/ 1951 h 2274"/>
              <a:gd name="T12" fmla="*/ 535 w 2269"/>
              <a:gd name="T13" fmla="*/ 1864 h 2274"/>
              <a:gd name="T14" fmla="*/ 373 w 2269"/>
              <a:gd name="T15" fmla="*/ 1853 h 2274"/>
              <a:gd name="T16" fmla="*/ 366 w 2269"/>
              <a:gd name="T17" fmla="*/ 1666 h 2274"/>
              <a:gd name="T18" fmla="*/ 426 w 2269"/>
              <a:gd name="T19" fmla="*/ 1680 h 2274"/>
              <a:gd name="T20" fmla="*/ 338 w 2269"/>
              <a:gd name="T21" fmla="*/ 1760 h 2274"/>
              <a:gd name="T22" fmla="*/ 501 w 2269"/>
              <a:gd name="T23" fmla="*/ 1764 h 2274"/>
              <a:gd name="T24" fmla="*/ 761 w 2269"/>
              <a:gd name="T25" fmla="*/ 1711 h 2274"/>
              <a:gd name="T26" fmla="*/ 778 w 2269"/>
              <a:gd name="T27" fmla="*/ 1856 h 2274"/>
              <a:gd name="T28" fmla="*/ 465 w 2269"/>
              <a:gd name="T29" fmla="*/ 1564 h 2274"/>
              <a:gd name="T30" fmla="*/ 531 w 2269"/>
              <a:gd name="T31" fmla="*/ 1510 h 2274"/>
              <a:gd name="T32" fmla="*/ 685 w 2269"/>
              <a:gd name="T33" fmla="*/ 1505 h 2274"/>
              <a:gd name="T34" fmla="*/ 646 w 2269"/>
              <a:gd name="T35" fmla="*/ 1687 h 2274"/>
              <a:gd name="T36" fmla="*/ 1076 w 2269"/>
              <a:gd name="T37" fmla="*/ 1388 h 2274"/>
              <a:gd name="T38" fmla="*/ 986 w 2269"/>
              <a:gd name="T39" fmla="*/ 1490 h 2274"/>
              <a:gd name="T40" fmla="*/ 887 w 2269"/>
              <a:gd name="T41" fmla="*/ 1327 h 2274"/>
              <a:gd name="T42" fmla="*/ 769 w 2269"/>
              <a:gd name="T43" fmla="*/ 1336 h 2274"/>
              <a:gd name="T44" fmla="*/ 725 w 2269"/>
              <a:gd name="T45" fmla="*/ 1342 h 2274"/>
              <a:gd name="T46" fmla="*/ 935 w 2269"/>
              <a:gd name="T47" fmla="*/ 1243 h 2274"/>
              <a:gd name="T48" fmla="*/ 924 w 2269"/>
              <a:gd name="T49" fmla="*/ 1473 h 2274"/>
              <a:gd name="T50" fmla="*/ 1087 w 2269"/>
              <a:gd name="T51" fmla="*/ 1017 h 2274"/>
              <a:gd name="T52" fmla="*/ 1040 w 2269"/>
              <a:gd name="T53" fmla="*/ 1101 h 2274"/>
              <a:gd name="T54" fmla="*/ 1154 w 2269"/>
              <a:gd name="T55" fmla="*/ 1312 h 2274"/>
              <a:gd name="T56" fmla="*/ 957 w 2269"/>
              <a:gd name="T57" fmla="*/ 1072 h 2274"/>
              <a:gd name="T58" fmla="*/ 1019 w 2269"/>
              <a:gd name="T59" fmla="*/ 1004 h 2274"/>
              <a:gd name="T60" fmla="*/ 1073 w 2269"/>
              <a:gd name="T61" fmla="*/ 998 h 2274"/>
              <a:gd name="T62" fmla="*/ 1411 w 2269"/>
              <a:gd name="T63" fmla="*/ 1004 h 2274"/>
              <a:gd name="T64" fmla="*/ 1218 w 2269"/>
              <a:gd name="T65" fmla="*/ 1029 h 2274"/>
              <a:gd name="T66" fmla="*/ 1194 w 2269"/>
              <a:gd name="T67" fmla="*/ 890 h 2274"/>
              <a:gd name="T68" fmla="*/ 1126 w 2269"/>
              <a:gd name="T69" fmla="*/ 972 h 2274"/>
              <a:gd name="T70" fmla="*/ 1249 w 2269"/>
              <a:gd name="T71" fmla="*/ 813 h 2274"/>
              <a:gd name="T72" fmla="*/ 1266 w 2269"/>
              <a:gd name="T73" fmla="*/ 1047 h 2274"/>
              <a:gd name="T74" fmla="*/ 1514 w 2269"/>
              <a:gd name="T75" fmla="*/ 571 h 2274"/>
              <a:gd name="T76" fmla="*/ 1531 w 2269"/>
              <a:gd name="T77" fmla="*/ 788 h 2274"/>
              <a:gd name="T78" fmla="*/ 1624 w 2269"/>
              <a:gd name="T79" fmla="*/ 765 h 2274"/>
              <a:gd name="T80" fmla="*/ 1642 w 2269"/>
              <a:gd name="T81" fmla="*/ 984 h 2274"/>
              <a:gd name="T82" fmla="*/ 1487 w 2269"/>
              <a:gd name="T83" fmla="*/ 903 h 2274"/>
              <a:gd name="T84" fmla="*/ 1356 w 2269"/>
              <a:gd name="T85" fmla="*/ 678 h 2274"/>
              <a:gd name="T86" fmla="*/ 1456 w 2269"/>
              <a:gd name="T87" fmla="*/ 649 h 2274"/>
              <a:gd name="T88" fmla="*/ 1517 w 2269"/>
              <a:gd name="T89" fmla="*/ 736 h 2274"/>
              <a:gd name="T90" fmla="*/ 1558 w 2269"/>
              <a:gd name="T91" fmla="*/ 902 h 2274"/>
              <a:gd name="T92" fmla="*/ 1694 w 2269"/>
              <a:gd name="T93" fmla="*/ 833 h 2274"/>
              <a:gd name="T94" fmla="*/ 1765 w 2269"/>
              <a:gd name="T95" fmla="*/ 701 h 2274"/>
              <a:gd name="T96" fmla="*/ 1571 w 2269"/>
              <a:gd name="T97" fmla="*/ 459 h 2274"/>
              <a:gd name="T98" fmla="*/ 1498 w 2269"/>
              <a:gd name="T99" fmla="*/ 442 h 2274"/>
              <a:gd name="T100" fmla="*/ 2042 w 2269"/>
              <a:gd name="T101" fmla="*/ 424 h 2274"/>
              <a:gd name="T102" fmla="*/ 1851 w 2269"/>
              <a:gd name="T103" fmla="*/ 306 h 2274"/>
              <a:gd name="T104" fmla="*/ 1902 w 2269"/>
              <a:gd name="T105" fmla="*/ 564 h 2274"/>
              <a:gd name="T106" fmla="*/ 1654 w 2269"/>
              <a:gd name="T107" fmla="*/ 382 h 2274"/>
              <a:gd name="T108" fmla="*/ 1718 w 2269"/>
              <a:gd name="T109" fmla="*/ 379 h 2274"/>
              <a:gd name="T110" fmla="*/ 2176 w 2269"/>
              <a:gd name="T111" fmla="*/ 55 h 2274"/>
              <a:gd name="T112" fmla="*/ 2208 w 2269"/>
              <a:gd name="T113" fmla="*/ 201 h 2274"/>
              <a:gd name="T114" fmla="*/ 2263 w 2269"/>
              <a:gd name="T115" fmla="*/ 160 h 2274"/>
              <a:gd name="T116" fmla="*/ 2160 w 2269"/>
              <a:gd name="T117" fmla="*/ 302 h 2274"/>
              <a:gd name="T118" fmla="*/ 2030 w 2269"/>
              <a:gd name="T119" fmla="*/ 8 h 2274"/>
              <a:gd name="T120" fmla="*/ 1989 w 2269"/>
              <a:gd name="T121" fmla="*/ 103 h 22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269" h="2274">
                <a:moveTo>
                  <a:pt x="430" y="2010"/>
                </a:moveTo>
                <a:cubicBezTo>
                  <a:pt x="434" y="2012"/>
                  <a:pt x="438" y="2014"/>
                  <a:pt x="440" y="2016"/>
                </a:cubicBezTo>
                <a:cubicBezTo>
                  <a:pt x="442" y="2018"/>
                  <a:pt x="443" y="2020"/>
                  <a:pt x="443" y="2022"/>
                </a:cubicBezTo>
                <a:cubicBezTo>
                  <a:pt x="443" y="2024"/>
                  <a:pt x="441" y="2027"/>
                  <a:pt x="439" y="2030"/>
                </a:cubicBezTo>
                <a:cubicBezTo>
                  <a:pt x="436" y="2033"/>
                  <a:pt x="433" y="2037"/>
                  <a:pt x="428" y="2042"/>
                </a:cubicBezTo>
                <a:cubicBezTo>
                  <a:pt x="423" y="2047"/>
                  <a:pt x="419" y="2051"/>
                  <a:pt x="416" y="2053"/>
                </a:cubicBezTo>
                <a:cubicBezTo>
                  <a:pt x="413" y="2056"/>
                  <a:pt x="411" y="2057"/>
                  <a:pt x="409" y="2058"/>
                </a:cubicBezTo>
                <a:cubicBezTo>
                  <a:pt x="407" y="2059"/>
                  <a:pt x="405" y="2060"/>
                  <a:pt x="403" y="2059"/>
                </a:cubicBezTo>
                <a:cubicBezTo>
                  <a:pt x="402" y="2059"/>
                  <a:pt x="400" y="2059"/>
                  <a:pt x="398" y="2058"/>
                </a:cubicBezTo>
                <a:lnTo>
                  <a:pt x="300" y="2011"/>
                </a:lnTo>
                <a:lnTo>
                  <a:pt x="177" y="2135"/>
                </a:lnTo>
                <a:lnTo>
                  <a:pt x="224" y="2230"/>
                </a:lnTo>
                <a:cubicBezTo>
                  <a:pt x="225" y="2232"/>
                  <a:pt x="225" y="2234"/>
                  <a:pt x="226" y="2235"/>
                </a:cubicBezTo>
                <a:cubicBezTo>
                  <a:pt x="226" y="2237"/>
                  <a:pt x="225" y="2239"/>
                  <a:pt x="225" y="2241"/>
                </a:cubicBezTo>
                <a:cubicBezTo>
                  <a:pt x="224" y="2243"/>
                  <a:pt x="222" y="2246"/>
                  <a:pt x="220" y="2249"/>
                </a:cubicBezTo>
                <a:cubicBezTo>
                  <a:pt x="218" y="2252"/>
                  <a:pt x="214" y="2256"/>
                  <a:pt x="210" y="2260"/>
                </a:cubicBezTo>
                <a:cubicBezTo>
                  <a:pt x="206" y="2264"/>
                  <a:pt x="202" y="2268"/>
                  <a:pt x="199" y="2270"/>
                </a:cubicBezTo>
                <a:cubicBezTo>
                  <a:pt x="195" y="2273"/>
                  <a:pt x="193" y="2274"/>
                  <a:pt x="190" y="2274"/>
                </a:cubicBezTo>
                <a:cubicBezTo>
                  <a:pt x="188" y="2274"/>
                  <a:pt x="186" y="2273"/>
                  <a:pt x="184" y="2271"/>
                </a:cubicBezTo>
                <a:cubicBezTo>
                  <a:pt x="182" y="2269"/>
                  <a:pt x="180" y="2265"/>
                  <a:pt x="178" y="2261"/>
                </a:cubicBezTo>
                <a:lnTo>
                  <a:pt x="2" y="1886"/>
                </a:lnTo>
                <a:cubicBezTo>
                  <a:pt x="1" y="1883"/>
                  <a:pt x="0" y="1881"/>
                  <a:pt x="0" y="1879"/>
                </a:cubicBezTo>
                <a:cubicBezTo>
                  <a:pt x="0" y="1877"/>
                  <a:pt x="1" y="1875"/>
                  <a:pt x="2" y="1872"/>
                </a:cubicBezTo>
                <a:cubicBezTo>
                  <a:pt x="3" y="1870"/>
                  <a:pt x="5" y="1867"/>
                  <a:pt x="8" y="1864"/>
                </a:cubicBezTo>
                <a:cubicBezTo>
                  <a:pt x="11" y="1861"/>
                  <a:pt x="14" y="1857"/>
                  <a:pt x="19" y="1852"/>
                </a:cubicBezTo>
                <a:cubicBezTo>
                  <a:pt x="24" y="1847"/>
                  <a:pt x="28" y="1843"/>
                  <a:pt x="32" y="1840"/>
                </a:cubicBezTo>
                <a:cubicBezTo>
                  <a:pt x="35" y="1837"/>
                  <a:pt x="38" y="1835"/>
                  <a:pt x="41" y="1834"/>
                </a:cubicBezTo>
                <a:cubicBezTo>
                  <a:pt x="43" y="1832"/>
                  <a:pt x="46" y="1832"/>
                  <a:pt x="48" y="1832"/>
                </a:cubicBezTo>
                <a:cubicBezTo>
                  <a:pt x="50" y="1832"/>
                  <a:pt x="52" y="1832"/>
                  <a:pt x="55" y="1833"/>
                </a:cubicBezTo>
                <a:lnTo>
                  <a:pt x="430" y="2010"/>
                </a:lnTo>
                <a:close/>
                <a:moveTo>
                  <a:pt x="59" y="1894"/>
                </a:moveTo>
                <a:lnTo>
                  <a:pt x="59" y="1894"/>
                </a:lnTo>
                <a:lnTo>
                  <a:pt x="155" y="2093"/>
                </a:lnTo>
                <a:lnTo>
                  <a:pt x="258" y="1990"/>
                </a:lnTo>
                <a:lnTo>
                  <a:pt x="59" y="1894"/>
                </a:lnTo>
                <a:close/>
                <a:moveTo>
                  <a:pt x="556" y="1787"/>
                </a:moveTo>
                <a:cubicBezTo>
                  <a:pt x="567" y="1798"/>
                  <a:pt x="574" y="1809"/>
                  <a:pt x="579" y="1821"/>
                </a:cubicBezTo>
                <a:cubicBezTo>
                  <a:pt x="583" y="1833"/>
                  <a:pt x="584" y="1846"/>
                  <a:pt x="583" y="1859"/>
                </a:cubicBezTo>
                <a:cubicBezTo>
                  <a:pt x="581" y="1871"/>
                  <a:pt x="577" y="1884"/>
                  <a:pt x="570" y="1897"/>
                </a:cubicBezTo>
                <a:cubicBezTo>
                  <a:pt x="563" y="1910"/>
                  <a:pt x="554" y="1922"/>
                  <a:pt x="542" y="1934"/>
                </a:cubicBezTo>
                <a:cubicBezTo>
                  <a:pt x="534" y="1942"/>
                  <a:pt x="527" y="1948"/>
                  <a:pt x="519" y="1954"/>
                </a:cubicBezTo>
                <a:cubicBezTo>
                  <a:pt x="511" y="1959"/>
                  <a:pt x="504" y="1964"/>
                  <a:pt x="497" y="1967"/>
                </a:cubicBezTo>
                <a:cubicBezTo>
                  <a:pt x="490" y="1971"/>
                  <a:pt x="483" y="1973"/>
                  <a:pt x="478" y="1975"/>
                </a:cubicBezTo>
                <a:cubicBezTo>
                  <a:pt x="472" y="1977"/>
                  <a:pt x="468" y="1978"/>
                  <a:pt x="465" y="1978"/>
                </a:cubicBezTo>
                <a:cubicBezTo>
                  <a:pt x="461" y="1978"/>
                  <a:pt x="458" y="1977"/>
                  <a:pt x="455" y="1975"/>
                </a:cubicBezTo>
                <a:cubicBezTo>
                  <a:pt x="451" y="1973"/>
                  <a:pt x="447" y="1970"/>
                  <a:pt x="442" y="1965"/>
                </a:cubicBezTo>
                <a:cubicBezTo>
                  <a:pt x="439" y="1962"/>
                  <a:pt x="437" y="1959"/>
                  <a:pt x="435" y="1957"/>
                </a:cubicBezTo>
                <a:cubicBezTo>
                  <a:pt x="434" y="1955"/>
                  <a:pt x="432" y="1953"/>
                  <a:pt x="432" y="1951"/>
                </a:cubicBezTo>
                <a:cubicBezTo>
                  <a:pt x="431" y="1950"/>
                  <a:pt x="431" y="1948"/>
                  <a:pt x="431" y="1947"/>
                </a:cubicBezTo>
                <a:cubicBezTo>
                  <a:pt x="431" y="1945"/>
                  <a:pt x="432" y="1944"/>
                  <a:pt x="433" y="1943"/>
                </a:cubicBezTo>
                <a:cubicBezTo>
                  <a:pt x="435" y="1941"/>
                  <a:pt x="438" y="1940"/>
                  <a:pt x="444" y="1939"/>
                </a:cubicBezTo>
                <a:cubicBezTo>
                  <a:pt x="449" y="1937"/>
                  <a:pt x="455" y="1936"/>
                  <a:pt x="462" y="1933"/>
                </a:cubicBezTo>
                <a:cubicBezTo>
                  <a:pt x="470" y="1931"/>
                  <a:pt x="478" y="1927"/>
                  <a:pt x="486" y="1923"/>
                </a:cubicBezTo>
                <a:cubicBezTo>
                  <a:pt x="495" y="1918"/>
                  <a:pt x="504" y="1912"/>
                  <a:pt x="512" y="1903"/>
                </a:cubicBezTo>
                <a:cubicBezTo>
                  <a:pt x="518" y="1897"/>
                  <a:pt x="524" y="1890"/>
                  <a:pt x="527" y="1884"/>
                </a:cubicBezTo>
                <a:cubicBezTo>
                  <a:pt x="531" y="1877"/>
                  <a:pt x="534" y="1871"/>
                  <a:pt x="535" y="1864"/>
                </a:cubicBezTo>
                <a:cubicBezTo>
                  <a:pt x="536" y="1858"/>
                  <a:pt x="536" y="1851"/>
                  <a:pt x="534" y="1845"/>
                </a:cubicBezTo>
                <a:cubicBezTo>
                  <a:pt x="531" y="1839"/>
                  <a:pt x="528" y="1833"/>
                  <a:pt x="522" y="1827"/>
                </a:cubicBezTo>
                <a:cubicBezTo>
                  <a:pt x="516" y="1822"/>
                  <a:pt x="510" y="1818"/>
                  <a:pt x="503" y="1817"/>
                </a:cubicBezTo>
                <a:cubicBezTo>
                  <a:pt x="496" y="1816"/>
                  <a:pt x="488" y="1817"/>
                  <a:pt x="480" y="1818"/>
                </a:cubicBezTo>
                <a:cubicBezTo>
                  <a:pt x="472" y="1820"/>
                  <a:pt x="464" y="1823"/>
                  <a:pt x="456" y="1827"/>
                </a:cubicBezTo>
                <a:cubicBezTo>
                  <a:pt x="447" y="1831"/>
                  <a:pt x="439" y="1834"/>
                  <a:pt x="429" y="1838"/>
                </a:cubicBezTo>
                <a:cubicBezTo>
                  <a:pt x="420" y="1842"/>
                  <a:pt x="411" y="1846"/>
                  <a:pt x="402" y="1849"/>
                </a:cubicBezTo>
                <a:cubicBezTo>
                  <a:pt x="392" y="1851"/>
                  <a:pt x="383" y="1853"/>
                  <a:pt x="373" y="1853"/>
                </a:cubicBezTo>
                <a:cubicBezTo>
                  <a:pt x="363" y="1853"/>
                  <a:pt x="354" y="1852"/>
                  <a:pt x="344" y="1848"/>
                </a:cubicBezTo>
                <a:cubicBezTo>
                  <a:pt x="335" y="1844"/>
                  <a:pt x="325" y="1838"/>
                  <a:pt x="316" y="1829"/>
                </a:cubicBezTo>
                <a:cubicBezTo>
                  <a:pt x="308" y="1821"/>
                  <a:pt x="302" y="1811"/>
                  <a:pt x="297" y="1801"/>
                </a:cubicBezTo>
                <a:cubicBezTo>
                  <a:pt x="293" y="1790"/>
                  <a:pt x="291" y="1779"/>
                  <a:pt x="292" y="1767"/>
                </a:cubicBezTo>
                <a:cubicBezTo>
                  <a:pt x="293" y="1755"/>
                  <a:pt x="296" y="1743"/>
                  <a:pt x="302" y="1730"/>
                </a:cubicBezTo>
                <a:cubicBezTo>
                  <a:pt x="308" y="1718"/>
                  <a:pt x="318" y="1705"/>
                  <a:pt x="330" y="1692"/>
                </a:cubicBezTo>
                <a:cubicBezTo>
                  <a:pt x="336" y="1687"/>
                  <a:pt x="341" y="1682"/>
                  <a:pt x="348" y="1677"/>
                </a:cubicBezTo>
                <a:cubicBezTo>
                  <a:pt x="354" y="1673"/>
                  <a:pt x="360" y="1669"/>
                  <a:pt x="366" y="1666"/>
                </a:cubicBezTo>
                <a:cubicBezTo>
                  <a:pt x="372" y="1663"/>
                  <a:pt x="377" y="1660"/>
                  <a:pt x="382" y="1659"/>
                </a:cubicBezTo>
                <a:cubicBezTo>
                  <a:pt x="387" y="1657"/>
                  <a:pt x="391" y="1656"/>
                  <a:pt x="393" y="1656"/>
                </a:cubicBezTo>
                <a:cubicBezTo>
                  <a:pt x="396" y="1656"/>
                  <a:pt x="398" y="1656"/>
                  <a:pt x="400" y="1656"/>
                </a:cubicBezTo>
                <a:cubicBezTo>
                  <a:pt x="401" y="1656"/>
                  <a:pt x="403" y="1657"/>
                  <a:pt x="404" y="1658"/>
                </a:cubicBezTo>
                <a:cubicBezTo>
                  <a:pt x="405" y="1659"/>
                  <a:pt x="407" y="1660"/>
                  <a:pt x="409" y="1662"/>
                </a:cubicBezTo>
                <a:cubicBezTo>
                  <a:pt x="411" y="1663"/>
                  <a:pt x="413" y="1665"/>
                  <a:pt x="416" y="1667"/>
                </a:cubicBezTo>
                <a:cubicBezTo>
                  <a:pt x="418" y="1670"/>
                  <a:pt x="420" y="1672"/>
                  <a:pt x="422" y="1675"/>
                </a:cubicBezTo>
                <a:cubicBezTo>
                  <a:pt x="424" y="1677"/>
                  <a:pt x="425" y="1679"/>
                  <a:pt x="426" y="1680"/>
                </a:cubicBezTo>
                <a:cubicBezTo>
                  <a:pt x="426" y="1682"/>
                  <a:pt x="426" y="1684"/>
                  <a:pt x="426" y="1685"/>
                </a:cubicBezTo>
                <a:cubicBezTo>
                  <a:pt x="426" y="1686"/>
                  <a:pt x="425" y="1687"/>
                  <a:pt x="424" y="1688"/>
                </a:cubicBezTo>
                <a:cubicBezTo>
                  <a:pt x="423" y="1690"/>
                  <a:pt x="420" y="1691"/>
                  <a:pt x="416" y="1692"/>
                </a:cubicBezTo>
                <a:cubicBezTo>
                  <a:pt x="412" y="1693"/>
                  <a:pt x="407" y="1694"/>
                  <a:pt x="401" y="1696"/>
                </a:cubicBezTo>
                <a:cubicBezTo>
                  <a:pt x="394" y="1699"/>
                  <a:pt x="388" y="1702"/>
                  <a:pt x="381" y="1706"/>
                </a:cubicBezTo>
                <a:cubicBezTo>
                  <a:pt x="373" y="1709"/>
                  <a:pt x="366" y="1715"/>
                  <a:pt x="359" y="1722"/>
                </a:cubicBezTo>
                <a:cubicBezTo>
                  <a:pt x="353" y="1729"/>
                  <a:pt x="348" y="1735"/>
                  <a:pt x="344" y="1741"/>
                </a:cubicBezTo>
                <a:cubicBezTo>
                  <a:pt x="341" y="1748"/>
                  <a:pt x="339" y="1754"/>
                  <a:pt x="338" y="1760"/>
                </a:cubicBezTo>
                <a:cubicBezTo>
                  <a:pt x="338" y="1765"/>
                  <a:pt x="339" y="1771"/>
                  <a:pt x="341" y="1776"/>
                </a:cubicBezTo>
                <a:cubicBezTo>
                  <a:pt x="343" y="1781"/>
                  <a:pt x="346" y="1786"/>
                  <a:pt x="350" y="1791"/>
                </a:cubicBezTo>
                <a:cubicBezTo>
                  <a:pt x="356" y="1796"/>
                  <a:pt x="363" y="1800"/>
                  <a:pt x="370" y="1801"/>
                </a:cubicBezTo>
                <a:cubicBezTo>
                  <a:pt x="377" y="1802"/>
                  <a:pt x="384" y="1802"/>
                  <a:pt x="392" y="1800"/>
                </a:cubicBezTo>
                <a:cubicBezTo>
                  <a:pt x="400" y="1798"/>
                  <a:pt x="409" y="1795"/>
                  <a:pt x="417" y="1791"/>
                </a:cubicBezTo>
                <a:cubicBezTo>
                  <a:pt x="426" y="1787"/>
                  <a:pt x="435" y="1784"/>
                  <a:pt x="444" y="1780"/>
                </a:cubicBezTo>
                <a:cubicBezTo>
                  <a:pt x="453" y="1776"/>
                  <a:pt x="463" y="1772"/>
                  <a:pt x="472" y="1769"/>
                </a:cubicBezTo>
                <a:cubicBezTo>
                  <a:pt x="482" y="1766"/>
                  <a:pt x="491" y="1764"/>
                  <a:pt x="501" y="1764"/>
                </a:cubicBezTo>
                <a:cubicBezTo>
                  <a:pt x="510" y="1764"/>
                  <a:pt x="520" y="1765"/>
                  <a:pt x="529" y="1769"/>
                </a:cubicBezTo>
                <a:cubicBezTo>
                  <a:pt x="538" y="1772"/>
                  <a:pt x="547" y="1778"/>
                  <a:pt x="556" y="1787"/>
                </a:cubicBezTo>
                <a:close/>
                <a:moveTo>
                  <a:pt x="753" y="1490"/>
                </a:moveTo>
                <a:cubicBezTo>
                  <a:pt x="771" y="1508"/>
                  <a:pt x="785" y="1526"/>
                  <a:pt x="796" y="1544"/>
                </a:cubicBezTo>
                <a:cubicBezTo>
                  <a:pt x="806" y="1563"/>
                  <a:pt x="813" y="1581"/>
                  <a:pt x="815" y="1598"/>
                </a:cubicBezTo>
                <a:cubicBezTo>
                  <a:pt x="818" y="1616"/>
                  <a:pt x="816" y="1633"/>
                  <a:pt x="810" y="1649"/>
                </a:cubicBezTo>
                <a:cubicBezTo>
                  <a:pt x="805" y="1666"/>
                  <a:pt x="794" y="1681"/>
                  <a:pt x="780" y="1696"/>
                </a:cubicBezTo>
                <a:cubicBezTo>
                  <a:pt x="774" y="1702"/>
                  <a:pt x="768" y="1707"/>
                  <a:pt x="761" y="1711"/>
                </a:cubicBezTo>
                <a:cubicBezTo>
                  <a:pt x="755" y="1715"/>
                  <a:pt x="748" y="1718"/>
                  <a:pt x="740" y="1720"/>
                </a:cubicBezTo>
                <a:cubicBezTo>
                  <a:pt x="733" y="1723"/>
                  <a:pt x="725" y="1724"/>
                  <a:pt x="716" y="1725"/>
                </a:cubicBezTo>
                <a:cubicBezTo>
                  <a:pt x="707" y="1726"/>
                  <a:pt x="697" y="1727"/>
                  <a:pt x="686" y="1727"/>
                </a:cubicBezTo>
                <a:lnTo>
                  <a:pt x="789" y="1830"/>
                </a:lnTo>
                <a:cubicBezTo>
                  <a:pt x="791" y="1831"/>
                  <a:pt x="791" y="1833"/>
                  <a:pt x="792" y="1834"/>
                </a:cubicBezTo>
                <a:cubicBezTo>
                  <a:pt x="792" y="1836"/>
                  <a:pt x="792" y="1838"/>
                  <a:pt x="791" y="1840"/>
                </a:cubicBezTo>
                <a:cubicBezTo>
                  <a:pt x="790" y="1842"/>
                  <a:pt x="789" y="1844"/>
                  <a:pt x="787" y="1847"/>
                </a:cubicBezTo>
                <a:cubicBezTo>
                  <a:pt x="784" y="1849"/>
                  <a:pt x="781" y="1853"/>
                  <a:pt x="778" y="1856"/>
                </a:cubicBezTo>
                <a:cubicBezTo>
                  <a:pt x="774" y="1860"/>
                  <a:pt x="771" y="1863"/>
                  <a:pt x="768" y="1865"/>
                </a:cubicBezTo>
                <a:cubicBezTo>
                  <a:pt x="765" y="1867"/>
                  <a:pt x="763" y="1869"/>
                  <a:pt x="761" y="1870"/>
                </a:cubicBezTo>
                <a:cubicBezTo>
                  <a:pt x="759" y="1871"/>
                  <a:pt x="757" y="1871"/>
                  <a:pt x="755" y="1870"/>
                </a:cubicBezTo>
                <a:cubicBezTo>
                  <a:pt x="754" y="1870"/>
                  <a:pt x="753" y="1869"/>
                  <a:pt x="751" y="1868"/>
                </a:cubicBezTo>
                <a:lnTo>
                  <a:pt x="463" y="1580"/>
                </a:lnTo>
                <a:cubicBezTo>
                  <a:pt x="462" y="1578"/>
                  <a:pt x="461" y="1577"/>
                  <a:pt x="461" y="1576"/>
                </a:cubicBezTo>
                <a:cubicBezTo>
                  <a:pt x="460" y="1574"/>
                  <a:pt x="460" y="1573"/>
                  <a:pt x="461" y="1571"/>
                </a:cubicBezTo>
                <a:cubicBezTo>
                  <a:pt x="462" y="1569"/>
                  <a:pt x="463" y="1567"/>
                  <a:pt x="465" y="1564"/>
                </a:cubicBezTo>
                <a:cubicBezTo>
                  <a:pt x="467" y="1562"/>
                  <a:pt x="470" y="1559"/>
                  <a:pt x="473" y="1556"/>
                </a:cubicBezTo>
                <a:cubicBezTo>
                  <a:pt x="476" y="1553"/>
                  <a:pt x="479" y="1550"/>
                  <a:pt x="481" y="1549"/>
                </a:cubicBezTo>
                <a:cubicBezTo>
                  <a:pt x="483" y="1547"/>
                  <a:pt x="485" y="1545"/>
                  <a:pt x="487" y="1545"/>
                </a:cubicBezTo>
                <a:cubicBezTo>
                  <a:pt x="489" y="1544"/>
                  <a:pt x="491" y="1544"/>
                  <a:pt x="492" y="1544"/>
                </a:cubicBezTo>
                <a:cubicBezTo>
                  <a:pt x="494" y="1544"/>
                  <a:pt x="495" y="1545"/>
                  <a:pt x="497" y="1547"/>
                </a:cubicBezTo>
                <a:lnTo>
                  <a:pt x="524" y="1574"/>
                </a:lnTo>
                <a:cubicBezTo>
                  <a:pt x="524" y="1562"/>
                  <a:pt x="525" y="1550"/>
                  <a:pt x="526" y="1539"/>
                </a:cubicBezTo>
                <a:cubicBezTo>
                  <a:pt x="527" y="1529"/>
                  <a:pt x="529" y="1519"/>
                  <a:pt x="531" y="1510"/>
                </a:cubicBezTo>
                <a:cubicBezTo>
                  <a:pt x="534" y="1501"/>
                  <a:pt x="538" y="1493"/>
                  <a:pt x="542" y="1485"/>
                </a:cubicBezTo>
                <a:cubicBezTo>
                  <a:pt x="547" y="1477"/>
                  <a:pt x="553" y="1470"/>
                  <a:pt x="560" y="1463"/>
                </a:cubicBezTo>
                <a:cubicBezTo>
                  <a:pt x="575" y="1448"/>
                  <a:pt x="590" y="1438"/>
                  <a:pt x="607" y="1433"/>
                </a:cubicBezTo>
                <a:cubicBezTo>
                  <a:pt x="623" y="1429"/>
                  <a:pt x="639" y="1428"/>
                  <a:pt x="656" y="1431"/>
                </a:cubicBezTo>
                <a:cubicBezTo>
                  <a:pt x="673" y="1435"/>
                  <a:pt x="690" y="1442"/>
                  <a:pt x="706" y="1452"/>
                </a:cubicBezTo>
                <a:cubicBezTo>
                  <a:pt x="722" y="1462"/>
                  <a:pt x="738" y="1475"/>
                  <a:pt x="753" y="1490"/>
                </a:cubicBezTo>
                <a:close/>
                <a:moveTo>
                  <a:pt x="718" y="1533"/>
                </a:moveTo>
                <a:cubicBezTo>
                  <a:pt x="708" y="1523"/>
                  <a:pt x="697" y="1514"/>
                  <a:pt x="685" y="1505"/>
                </a:cubicBezTo>
                <a:cubicBezTo>
                  <a:pt x="674" y="1497"/>
                  <a:pt x="662" y="1491"/>
                  <a:pt x="651" y="1487"/>
                </a:cubicBezTo>
                <a:cubicBezTo>
                  <a:pt x="639" y="1484"/>
                  <a:pt x="628" y="1483"/>
                  <a:pt x="617" y="1485"/>
                </a:cubicBezTo>
                <a:cubicBezTo>
                  <a:pt x="605" y="1487"/>
                  <a:pt x="595" y="1493"/>
                  <a:pt x="585" y="1503"/>
                </a:cubicBezTo>
                <a:cubicBezTo>
                  <a:pt x="580" y="1508"/>
                  <a:pt x="576" y="1513"/>
                  <a:pt x="573" y="1519"/>
                </a:cubicBezTo>
                <a:cubicBezTo>
                  <a:pt x="569" y="1526"/>
                  <a:pt x="567" y="1533"/>
                  <a:pt x="565" y="1541"/>
                </a:cubicBezTo>
                <a:cubicBezTo>
                  <a:pt x="563" y="1549"/>
                  <a:pt x="562" y="1558"/>
                  <a:pt x="562" y="1569"/>
                </a:cubicBezTo>
                <a:cubicBezTo>
                  <a:pt x="562" y="1579"/>
                  <a:pt x="562" y="1591"/>
                  <a:pt x="564" y="1605"/>
                </a:cubicBezTo>
                <a:lnTo>
                  <a:pt x="646" y="1687"/>
                </a:lnTo>
                <a:cubicBezTo>
                  <a:pt x="669" y="1689"/>
                  <a:pt x="689" y="1689"/>
                  <a:pt x="705" y="1686"/>
                </a:cubicBezTo>
                <a:cubicBezTo>
                  <a:pt x="721" y="1683"/>
                  <a:pt x="734" y="1677"/>
                  <a:pt x="744" y="1667"/>
                </a:cubicBezTo>
                <a:cubicBezTo>
                  <a:pt x="754" y="1657"/>
                  <a:pt x="760" y="1647"/>
                  <a:pt x="762" y="1635"/>
                </a:cubicBezTo>
                <a:cubicBezTo>
                  <a:pt x="764" y="1624"/>
                  <a:pt x="764" y="1612"/>
                  <a:pt x="760" y="1600"/>
                </a:cubicBezTo>
                <a:cubicBezTo>
                  <a:pt x="757" y="1588"/>
                  <a:pt x="751" y="1577"/>
                  <a:pt x="744" y="1565"/>
                </a:cubicBezTo>
                <a:cubicBezTo>
                  <a:pt x="736" y="1554"/>
                  <a:pt x="728" y="1543"/>
                  <a:pt x="718" y="1533"/>
                </a:cubicBezTo>
                <a:close/>
                <a:moveTo>
                  <a:pt x="1074" y="1382"/>
                </a:moveTo>
                <a:cubicBezTo>
                  <a:pt x="1076" y="1384"/>
                  <a:pt x="1077" y="1386"/>
                  <a:pt x="1076" y="1388"/>
                </a:cubicBezTo>
                <a:cubicBezTo>
                  <a:pt x="1076" y="1390"/>
                  <a:pt x="1075" y="1392"/>
                  <a:pt x="1074" y="1395"/>
                </a:cubicBezTo>
                <a:cubicBezTo>
                  <a:pt x="1072" y="1398"/>
                  <a:pt x="1069" y="1401"/>
                  <a:pt x="1065" y="1405"/>
                </a:cubicBezTo>
                <a:cubicBezTo>
                  <a:pt x="1061" y="1409"/>
                  <a:pt x="1057" y="1412"/>
                  <a:pt x="1055" y="1414"/>
                </a:cubicBezTo>
                <a:cubicBezTo>
                  <a:pt x="1052" y="1416"/>
                  <a:pt x="1049" y="1417"/>
                  <a:pt x="1047" y="1417"/>
                </a:cubicBezTo>
                <a:cubicBezTo>
                  <a:pt x="1045" y="1417"/>
                  <a:pt x="1043" y="1416"/>
                  <a:pt x="1042" y="1415"/>
                </a:cubicBezTo>
                <a:lnTo>
                  <a:pt x="1021" y="1394"/>
                </a:lnTo>
                <a:cubicBezTo>
                  <a:pt x="1022" y="1413"/>
                  <a:pt x="1019" y="1430"/>
                  <a:pt x="1013" y="1447"/>
                </a:cubicBezTo>
                <a:cubicBezTo>
                  <a:pt x="1008" y="1463"/>
                  <a:pt x="999" y="1477"/>
                  <a:pt x="986" y="1490"/>
                </a:cubicBezTo>
                <a:cubicBezTo>
                  <a:pt x="975" y="1501"/>
                  <a:pt x="964" y="1509"/>
                  <a:pt x="952" y="1515"/>
                </a:cubicBezTo>
                <a:cubicBezTo>
                  <a:pt x="941" y="1521"/>
                  <a:pt x="929" y="1524"/>
                  <a:pt x="918" y="1525"/>
                </a:cubicBezTo>
                <a:cubicBezTo>
                  <a:pt x="906" y="1526"/>
                  <a:pt x="895" y="1524"/>
                  <a:pt x="884" y="1520"/>
                </a:cubicBezTo>
                <a:cubicBezTo>
                  <a:pt x="872" y="1516"/>
                  <a:pt x="862" y="1508"/>
                  <a:pt x="852" y="1498"/>
                </a:cubicBezTo>
                <a:cubicBezTo>
                  <a:pt x="840" y="1487"/>
                  <a:pt x="832" y="1474"/>
                  <a:pt x="829" y="1461"/>
                </a:cubicBezTo>
                <a:cubicBezTo>
                  <a:pt x="825" y="1448"/>
                  <a:pt x="825" y="1434"/>
                  <a:pt x="828" y="1419"/>
                </a:cubicBezTo>
                <a:cubicBezTo>
                  <a:pt x="831" y="1405"/>
                  <a:pt x="838" y="1390"/>
                  <a:pt x="848" y="1374"/>
                </a:cubicBezTo>
                <a:cubicBezTo>
                  <a:pt x="858" y="1358"/>
                  <a:pt x="871" y="1343"/>
                  <a:pt x="887" y="1327"/>
                </a:cubicBezTo>
                <a:lnTo>
                  <a:pt x="915" y="1298"/>
                </a:lnTo>
                <a:lnTo>
                  <a:pt x="899" y="1282"/>
                </a:lnTo>
                <a:cubicBezTo>
                  <a:pt x="891" y="1274"/>
                  <a:pt x="883" y="1268"/>
                  <a:pt x="875" y="1263"/>
                </a:cubicBezTo>
                <a:cubicBezTo>
                  <a:pt x="868" y="1259"/>
                  <a:pt x="860" y="1257"/>
                  <a:pt x="852" y="1256"/>
                </a:cubicBezTo>
                <a:cubicBezTo>
                  <a:pt x="844" y="1256"/>
                  <a:pt x="836" y="1258"/>
                  <a:pt x="828" y="1262"/>
                </a:cubicBezTo>
                <a:cubicBezTo>
                  <a:pt x="820" y="1266"/>
                  <a:pt x="812" y="1272"/>
                  <a:pt x="803" y="1281"/>
                </a:cubicBezTo>
                <a:cubicBezTo>
                  <a:pt x="794" y="1290"/>
                  <a:pt x="787" y="1299"/>
                  <a:pt x="781" y="1309"/>
                </a:cubicBezTo>
                <a:cubicBezTo>
                  <a:pt x="776" y="1319"/>
                  <a:pt x="772" y="1328"/>
                  <a:pt x="769" y="1336"/>
                </a:cubicBezTo>
                <a:cubicBezTo>
                  <a:pt x="766" y="1344"/>
                  <a:pt x="764" y="1351"/>
                  <a:pt x="763" y="1357"/>
                </a:cubicBezTo>
                <a:cubicBezTo>
                  <a:pt x="761" y="1363"/>
                  <a:pt x="759" y="1367"/>
                  <a:pt x="758" y="1369"/>
                </a:cubicBezTo>
                <a:cubicBezTo>
                  <a:pt x="756" y="1370"/>
                  <a:pt x="755" y="1371"/>
                  <a:pt x="753" y="1371"/>
                </a:cubicBezTo>
                <a:cubicBezTo>
                  <a:pt x="752" y="1372"/>
                  <a:pt x="750" y="1371"/>
                  <a:pt x="748" y="1371"/>
                </a:cubicBezTo>
                <a:cubicBezTo>
                  <a:pt x="746" y="1370"/>
                  <a:pt x="744" y="1369"/>
                  <a:pt x="742" y="1368"/>
                </a:cubicBezTo>
                <a:cubicBezTo>
                  <a:pt x="740" y="1366"/>
                  <a:pt x="738" y="1364"/>
                  <a:pt x="735" y="1362"/>
                </a:cubicBezTo>
                <a:cubicBezTo>
                  <a:pt x="732" y="1358"/>
                  <a:pt x="729" y="1355"/>
                  <a:pt x="727" y="1352"/>
                </a:cubicBezTo>
                <a:cubicBezTo>
                  <a:pt x="725" y="1349"/>
                  <a:pt x="725" y="1346"/>
                  <a:pt x="725" y="1342"/>
                </a:cubicBezTo>
                <a:cubicBezTo>
                  <a:pt x="725" y="1338"/>
                  <a:pt x="726" y="1332"/>
                  <a:pt x="728" y="1324"/>
                </a:cubicBezTo>
                <a:cubicBezTo>
                  <a:pt x="731" y="1316"/>
                  <a:pt x="734" y="1308"/>
                  <a:pt x="738" y="1299"/>
                </a:cubicBezTo>
                <a:cubicBezTo>
                  <a:pt x="743" y="1291"/>
                  <a:pt x="748" y="1282"/>
                  <a:pt x="754" y="1272"/>
                </a:cubicBezTo>
                <a:cubicBezTo>
                  <a:pt x="761" y="1263"/>
                  <a:pt x="768" y="1254"/>
                  <a:pt x="776" y="1247"/>
                </a:cubicBezTo>
                <a:cubicBezTo>
                  <a:pt x="791" y="1232"/>
                  <a:pt x="805" y="1221"/>
                  <a:pt x="819" y="1214"/>
                </a:cubicBezTo>
                <a:cubicBezTo>
                  <a:pt x="833" y="1207"/>
                  <a:pt x="846" y="1203"/>
                  <a:pt x="859" y="1203"/>
                </a:cubicBezTo>
                <a:cubicBezTo>
                  <a:pt x="872" y="1203"/>
                  <a:pt x="884" y="1207"/>
                  <a:pt x="897" y="1213"/>
                </a:cubicBezTo>
                <a:cubicBezTo>
                  <a:pt x="910" y="1220"/>
                  <a:pt x="922" y="1230"/>
                  <a:pt x="935" y="1243"/>
                </a:cubicBezTo>
                <a:lnTo>
                  <a:pt x="1074" y="1382"/>
                </a:lnTo>
                <a:close/>
                <a:moveTo>
                  <a:pt x="942" y="1325"/>
                </a:moveTo>
                <a:lnTo>
                  <a:pt x="910" y="1358"/>
                </a:lnTo>
                <a:cubicBezTo>
                  <a:pt x="900" y="1368"/>
                  <a:pt x="892" y="1378"/>
                  <a:pt x="886" y="1387"/>
                </a:cubicBezTo>
                <a:cubicBezTo>
                  <a:pt x="880" y="1397"/>
                  <a:pt x="876" y="1406"/>
                  <a:pt x="874" y="1414"/>
                </a:cubicBezTo>
                <a:cubicBezTo>
                  <a:pt x="873" y="1423"/>
                  <a:pt x="873" y="1431"/>
                  <a:pt x="876" y="1438"/>
                </a:cubicBezTo>
                <a:cubicBezTo>
                  <a:pt x="878" y="1445"/>
                  <a:pt x="882" y="1452"/>
                  <a:pt x="889" y="1458"/>
                </a:cubicBezTo>
                <a:cubicBezTo>
                  <a:pt x="899" y="1469"/>
                  <a:pt x="911" y="1474"/>
                  <a:pt x="924" y="1473"/>
                </a:cubicBezTo>
                <a:cubicBezTo>
                  <a:pt x="938" y="1473"/>
                  <a:pt x="950" y="1466"/>
                  <a:pt x="963" y="1454"/>
                </a:cubicBezTo>
                <a:cubicBezTo>
                  <a:pt x="972" y="1444"/>
                  <a:pt x="979" y="1433"/>
                  <a:pt x="983" y="1419"/>
                </a:cubicBezTo>
                <a:cubicBezTo>
                  <a:pt x="986" y="1406"/>
                  <a:pt x="987" y="1389"/>
                  <a:pt x="986" y="1369"/>
                </a:cubicBezTo>
                <a:lnTo>
                  <a:pt x="942" y="1325"/>
                </a:lnTo>
                <a:close/>
                <a:moveTo>
                  <a:pt x="1073" y="998"/>
                </a:moveTo>
                <a:cubicBezTo>
                  <a:pt x="1076" y="1001"/>
                  <a:pt x="1079" y="1004"/>
                  <a:pt x="1081" y="1006"/>
                </a:cubicBezTo>
                <a:cubicBezTo>
                  <a:pt x="1083" y="1009"/>
                  <a:pt x="1084" y="1011"/>
                  <a:pt x="1085" y="1013"/>
                </a:cubicBezTo>
                <a:cubicBezTo>
                  <a:pt x="1086" y="1014"/>
                  <a:pt x="1087" y="1016"/>
                  <a:pt x="1087" y="1017"/>
                </a:cubicBezTo>
                <a:cubicBezTo>
                  <a:pt x="1087" y="1019"/>
                  <a:pt x="1086" y="1020"/>
                  <a:pt x="1085" y="1021"/>
                </a:cubicBezTo>
                <a:cubicBezTo>
                  <a:pt x="1084" y="1022"/>
                  <a:pt x="1082" y="1024"/>
                  <a:pt x="1079" y="1025"/>
                </a:cubicBezTo>
                <a:cubicBezTo>
                  <a:pt x="1077" y="1026"/>
                  <a:pt x="1074" y="1027"/>
                  <a:pt x="1071" y="1028"/>
                </a:cubicBezTo>
                <a:cubicBezTo>
                  <a:pt x="1068" y="1030"/>
                  <a:pt x="1065" y="1032"/>
                  <a:pt x="1062" y="1034"/>
                </a:cubicBezTo>
                <a:cubicBezTo>
                  <a:pt x="1058" y="1036"/>
                  <a:pt x="1055" y="1039"/>
                  <a:pt x="1052" y="1042"/>
                </a:cubicBezTo>
                <a:cubicBezTo>
                  <a:pt x="1048" y="1046"/>
                  <a:pt x="1045" y="1050"/>
                  <a:pt x="1043" y="1056"/>
                </a:cubicBezTo>
                <a:cubicBezTo>
                  <a:pt x="1041" y="1061"/>
                  <a:pt x="1040" y="1067"/>
                  <a:pt x="1039" y="1075"/>
                </a:cubicBezTo>
                <a:cubicBezTo>
                  <a:pt x="1038" y="1082"/>
                  <a:pt x="1039" y="1091"/>
                  <a:pt x="1040" y="1101"/>
                </a:cubicBezTo>
                <a:cubicBezTo>
                  <a:pt x="1042" y="1112"/>
                  <a:pt x="1044" y="1124"/>
                  <a:pt x="1047" y="1137"/>
                </a:cubicBezTo>
                <a:lnTo>
                  <a:pt x="1183" y="1273"/>
                </a:lnTo>
                <a:cubicBezTo>
                  <a:pt x="1184" y="1274"/>
                  <a:pt x="1185" y="1276"/>
                  <a:pt x="1185" y="1277"/>
                </a:cubicBezTo>
                <a:cubicBezTo>
                  <a:pt x="1185" y="1279"/>
                  <a:pt x="1185" y="1280"/>
                  <a:pt x="1184" y="1282"/>
                </a:cubicBezTo>
                <a:cubicBezTo>
                  <a:pt x="1183" y="1284"/>
                  <a:pt x="1182" y="1287"/>
                  <a:pt x="1180" y="1289"/>
                </a:cubicBezTo>
                <a:cubicBezTo>
                  <a:pt x="1178" y="1292"/>
                  <a:pt x="1175" y="1295"/>
                  <a:pt x="1171" y="1299"/>
                </a:cubicBezTo>
                <a:cubicBezTo>
                  <a:pt x="1167" y="1303"/>
                  <a:pt x="1164" y="1306"/>
                  <a:pt x="1161" y="1308"/>
                </a:cubicBezTo>
                <a:cubicBezTo>
                  <a:pt x="1158" y="1310"/>
                  <a:pt x="1156" y="1312"/>
                  <a:pt x="1154" y="1312"/>
                </a:cubicBezTo>
                <a:cubicBezTo>
                  <a:pt x="1152" y="1313"/>
                  <a:pt x="1150" y="1314"/>
                  <a:pt x="1149" y="1313"/>
                </a:cubicBezTo>
                <a:cubicBezTo>
                  <a:pt x="1147" y="1313"/>
                  <a:pt x="1146" y="1312"/>
                  <a:pt x="1145" y="1311"/>
                </a:cubicBezTo>
                <a:lnTo>
                  <a:pt x="938" y="1105"/>
                </a:lnTo>
                <a:cubicBezTo>
                  <a:pt x="937" y="1103"/>
                  <a:pt x="936" y="1102"/>
                  <a:pt x="936" y="1101"/>
                </a:cubicBezTo>
                <a:cubicBezTo>
                  <a:pt x="936" y="1100"/>
                  <a:pt x="936" y="1098"/>
                  <a:pt x="937" y="1096"/>
                </a:cubicBezTo>
                <a:cubicBezTo>
                  <a:pt x="937" y="1094"/>
                  <a:pt x="939" y="1091"/>
                  <a:pt x="940" y="1089"/>
                </a:cubicBezTo>
                <a:cubicBezTo>
                  <a:pt x="942" y="1087"/>
                  <a:pt x="945" y="1084"/>
                  <a:pt x="949" y="1080"/>
                </a:cubicBezTo>
                <a:cubicBezTo>
                  <a:pt x="952" y="1077"/>
                  <a:pt x="955" y="1074"/>
                  <a:pt x="957" y="1072"/>
                </a:cubicBezTo>
                <a:cubicBezTo>
                  <a:pt x="960" y="1070"/>
                  <a:pt x="962" y="1069"/>
                  <a:pt x="964" y="1068"/>
                </a:cubicBezTo>
                <a:cubicBezTo>
                  <a:pt x="966" y="1068"/>
                  <a:pt x="967" y="1068"/>
                  <a:pt x="969" y="1068"/>
                </a:cubicBezTo>
                <a:cubicBezTo>
                  <a:pt x="970" y="1068"/>
                  <a:pt x="971" y="1069"/>
                  <a:pt x="973" y="1070"/>
                </a:cubicBezTo>
                <a:lnTo>
                  <a:pt x="1003" y="1100"/>
                </a:lnTo>
                <a:cubicBezTo>
                  <a:pt x="1000" y="1087"/>
                  <a:pt x="999" y="1075"/>
                  <a:pt x="998" y="1064"/>
                </a:cubicBezTo>
                <a:cubicBezTo>
                  <a:pt x="998" y="1054"/>
                  <a:pt x="999" y="1045"/>
                  <a:pt x="1000" y="1038"/>
                </a:cubicBezTo>
                <a:cubicBezTo>
                  <a:pt x="1002" y="1031"/>
                  <a:pt x="1004" y="1024"/>
                  <a:pt x="1007" y="1019"/>
                </a:cubicBezTo>
                <a:cubicBezTo>
                  <a:pt x="1010" y="1013"/>
                  <a:pt x="1014" y="1008"/>
                  <a:pt x="1019" y="1004"/>
                </a:cubicBezTo>
                <a:cubicBezTo>
                  <a:pt x="1021" y="1002"/>
                  <a:pt x="1023" y="1000"/>
                  <a:pt x="1026" y="997"/>
                </a:cubicBezTo>
                <a:cubicBezTo>
                  <a:pt x="1029" y="995"/>
                  <a:pt x="1032" y="993"/>
                  <a:pt x="1035" y="991"/>
                </a:cubicBezTo>
                <a:cubicBezTo>
                  <a:pt x="1038" y="989"/>
                  <a:pt x="1042" y="987"/>
                  <a:pt x="1045" y="985"/>
                </a:cubicBezTo>
                <a:cubicBezTo>
                  <a:pt x="1047" y="984"/>
                  <a:pt x="1050" y="983"/>
                  <a:pt x="1051" y="983"/>
                </a:cubicBezTo>
                <a:cubicBezTo>
                  <a:pt x="1053" y="983"/>
                  <a:pt x="1055" y="983"/>
                  <a:pt x="1056" y="983"/>
                </a:cubicBezTo>
                <a:cubicBezTo>
                  <a:pt x="1057" y="984"/>
                  <a:pt x="1058" y="984"/>
                  <a:pt x="1059" y="985"/>
                </a:cubicBezTo>
                <a:cubicBezTo>
                  <a:pt x="1060" y="986"/>
                  <a:pt x="1062" y="987"/>
                  <a:pt x="1064" y="989"/>
                </a:cubicBezTo>
                <a:cubicBezTo>
                  <a:pt x="1066" y="991"/>
                  <a:pt x="1069" y="994"/>
                  <a:pt x="1073" y="998"/>
                </a:cubicBezTo>
                <a:close/>
                <a:moveTo>
                  <a:pt x="1465" y="992"/>
                </a:moveTo>
                <a:cubicBezTo>
                  <a:pt x="1466" y="994"/>
                  <a:pt x="1467" y="996"/>
                  <a:pt x="1467" y="998"/>
                </a:cubicBezTo>
                <a:cubicBezTo>
                  <a:pt x="1467" y="1000"/>
                  <a:pt x="1466" y="1002"/>
                  <a:pt x="1464" y="1005"/>
                </a:cubicBezTo>
                <a:cubicBezTo>
                  <a:pt x="1462" y="1007"/>
                  <a:pt x="1459" y="1011"/>
                  <a:pt x="1455" y="1015"/>
                </a:cubicBezTo>
                <a:cubicBezTo>
                  <a:pt x="1451" y="1019"/>
                  <a:pt x="1448" y="1022"/>
                  <a:pt x="1445" y="1024"/>
                </a:cubicBezTo>
                <a:cubicBezTo>
                  <a:pt x="1442" y="1026"/>
                  <a:pt x="1440" y="1027"/>
                  <a:pt x="1438" y="1027"/>
                </a:cubicBezTo>
                <a:cubicBezTo>
                  <a:pt x="1436" y="1027"/>
                  <a:pt x="1434" y="1026"/>
                  <a:pt x="1432" y="1024"/>
                </a:cubicBezTo>
                <a:lnTo>
                  <a:pt x="1411" y="1004"/>
                </a:lnTo>
                <a:cubicBezTo>
                  <a:pt x="1412" y="1022"/>
                  <a:pt x="1409" y="1040"/>
                  <a:pt x="1404" y="1056"/>
                </a:cubicBezTo>
                <a:cubicBezTo>
                  <a:pt x="1398" y="1073"/>
                  <a:pt x="1389" y="1087"/>
                  <a:pt x="1376" y="1099"/>
                </a:cubicBezTo>
                <a:cubicBezTo>
                  <a:pt x="1366" y="1110"/>
                  <a:pt x="1354" y="1119"/>
                  <a:pt x="1343" y="1125"/>
                </a:cubicBezTo>
                <a:cubicBezTo>
                  <a:pt x="1331" y="1131"/>
                  <a:pt x="1320" y="1134"/>
                  <a:pt x="1308" y="1135"/>
                </a:cubicBezTo>
                <a:cubicBezTo>
                  <a:pt x="1297" y="1136"/>
                  <a:pt x="1285" y="1134"/>
                  <a:pt x="1274" y="1130"/>
                </a:cubicBezTo>
                <a:cubicBezTo>
                  <a:pt x="1263" y="1125"/>
                  <a:pt x="1252" y="1118"/>
                  <a:pt x="1242" y="1108"/>
                </a:cubicBezTo>
                <a:cubicBezTo>
                  <a:pt x="1231" y="1097"/>
                  <a:pt x="1223" y="1084"/>
                  <a:pt x="1219" y="1071"/>
                </a:cubicBezTo>
                <a:cubicBezTo>
                  <a:pt x="1215" y="1057"/>
                  <a:pt x="1215" y="1044"/>
                  <a:pt x="1218" y="1029"/>
                </a:cubicBezTo>
                <a:cubicBezTo>
                  <a:pt x="1221" y="1015"/>
                  <a:pt x="1228" y="999"/>
                  <a:pt x="1238" y="984"/>
                </a:cubicBezTo>
                <a:cubicBezTo>
                  <a:pt x="1248" y="968"/>
                  <a:pt x="1261" y="952"/>
                  <a:pt x="1277" y="936"/>
                </a:cubicBezTo>
                <a:lnTo>
                  <a:pt x="1305" y="908"/>
                </a:lnTo>
                <a:lnTo>
                  <a:pt x="1289" y="892"/>
                </a:lnTo>
                <a:cubicBezTo>
                  <a:pt x="1281" y="884"/>
                  <a:pt x="1274" y="878"/>
                  <a:pt x="1266" y="873"/>
                </a:cubicBezTo>
                <a:cubicBezTo>
                  <a:pt x="1258" y="869"/>
                  <a:pt x="1250" y="866"/>
                  <a:pt x="1242" y="866"/>
                </a:cubicBezTo>
                <a:cubicBezTo>
                  <a:pt x="1235" y="866"/>
                  <a:pt x="1227" y="868"/>
                  <a:pt x="1219" y="871"/>
                </a:cubicBezTo>
                <a:cubicBezTo>
                  <a:pt x="1211" y="875"/>
                  <a:pt x="1202" y="882"/>
                  <a:pt x="1194" y="890"/>
                </a:cubicBezTo>
                <a:cubicBezTo>
                  <a:pt x="1184" y="900"/>
                  <a:pt x="1177" y="909"/>
                  <a:pt x="1172" y="919"/>
                </a:cubicBezTo>
                <a:cubicBezTo>
                  <a:pt x="1167" y="928"/>
                  <a:pt x="1163" y="937"/>
                  <a:pt x="1160" y="946"/>
                </a:cubicBezTo>
                <a:cubicBezTo>
                  <a:pt x="1157" y="954"/>
                  <a:pt x="1154" y="961"/>
                  <a:pt x="1153" y="967"/>
                </a:cubicBezTo>
                <a:cubicBezTo>
                  <a:pt x="1151" y="973"/>
                  <a:pt x="1150" y="977"/>
                  <a:pt x="1148" y="979"/>
                </a:cubicBezTo>
                <a:cubicBezTo>
                  <a:pt x="1147" y="980"/>
                  <a:pt x="1145" y="981"/>
                  <a:pt x="1144" y="981"/>
                </a:cubicBezTo>
                <a:cubicBezTo>
                  <a:pt x="1142" y="981"/>
                  <a:pt x="1141" y="981"/>
                  <a:pt x="1139" y="981"/>
                </a:cubicBezTo>
                <a:cubicBezTo>
                  <a:pt x="1137" y="980"/>
                  <a:pt x="1135" y="979"/>
                  <a:pt x="1132" y="977"/>
                </a:cubicBezTo>
                <a:cubicBezTo>
                  <a:pt x="1130" y="976"/>
                  <a:pt x="1128" y="974"/>
                  <a:pt x="1126" y="972"/>
                </a:cubicBezTo>
                <a:cubicBezTo>
                  <a:pt x="1122" y="968"/>
                  <a:pt x="1119" y="964"/>
                  <a:pt x="1117" y="962"/>
                </a:cubicBezTo>
                <a:cubicBezTo>
                  <a:pt x="1116" y="959"/>
                  <a:pt x="1115" y="955"/>
                  <a:pt x="1115" y="951"/>
                </a:cubicBezTo>
                <a:cubicBezTo>
                  <a:pt x="1115" y="947"/>
                  <a:pt x="1116" y="942"/>
                  <a:pt x="1119" y="934"/>
                </a:cubicBezTo>
                <a:cubicBezTo>
                  <a:pt x="1121" y="926"/>
                  <a:pt x="1124" y="918"/>
                  <a:pt x="1129" y="909"/>
                </a:cubicBezTo>
                <a:cubicBezTo>
                  <a:pt x="1133" y="900"/>
                  <a:pt x="1138" y="891"/>
                  <a:pt x="1145" y="882"/>
                </a:cubicBezTo>
                <a:cubicBezTo>
                  <a:pt x="1151" y="873"/>
                  <a:pt x="1158" y="864"/>
                  <a:pt x="1166" y="856"/>
                </a:cubicBezTo>
                <a:cubicBezTo>
                  <a:pt x="1181" y="841"/>
                  <a:pt x="1195" y="830"/>
                  <a:pt x="1209" y="823"/>
                </a:cubicBezTo>
                <a:cubicBezTo>
                  <a:pt x="1223" y="816"/>
                  <a:pt x="1236" y="813"/>
                  <a:pt x="1249" y="813"/>
                </a:cubicBezTo>
                <a:cubicBezTo>
                  <a:pt x="1262" y="813"/>
                  <a:pt x="1275" y="816"/>
                  <a:pt x="1287" y="823"/>
                </a:cubicBezTo>
                <a:cubicBezTo>
                  <a:pt x="1300" y="830"/>
                  <a:pt x="1313" y="840"/>
                  <a:pt x="1325" y="853"/>
                </a:cubicBezTo>
                <a:lnTo>
                  <a:pt x="1465" y="992"/>
                </a:lnTo>
                <a:close/>
                <a:moveTo>
                  <a:pt x="1333" y="935"/>
                </a:moveTo>
                <a:lnTo>
                  <a:pt x="1300" y="967"/>
                </a:lnTo>
                <a:cubicBezTo>
                  <a:pt x="1290" y="978"/>
                  <a:pt x="1282" y="988"/>
                  <a:pt x="1276" y="997"/>
                </a:cubicBezTo>
                <a:cubicBezTo>
                  <a:pt x="1270" y="1006"/>
                  <a:pt x="1266" y="1015"/>
                  <a:pt x="1265" y="1024"/>
                </a:cubicBezTo>
                <a:cubicBezTo>
                  <a:pt x="1263" y="1032"/>
                  <a:pt x="1264" y="1040"/>
                  <a:pt x="1266" y="1047"/>
                </a:cubicBezTo>
                <a:cubicBezTo>
                  <a:pt x="1268" y="1055"/>
                  <a:pt x="1273" y="1061"/>
                  <a:pt x="1279" y="1068"/>
                </a:cubicBezTo>
                <a:cubicBezTo>
                  <a:pt x="1290" y="1078"/>
                  <a:pt x="1302" y="1083"/>
                  <a:pt x="1315" y="1083"/>
                </a:cubicBezTo>
                <a:cubicBezTo>
                  <a:pt x="1328" y="1082"/>
                  <a:pt x="1341" y="1076"/>
                  <a:pt x="1353" y="1064"/>
                </a:cubicBezTo>
                <a:cubicBezTo>
                  <a:pt x="1363" y="1054"/>
                  <a:pt x="1369" y="1042"/>
                  <a:pt x="1373" y="1029"/>
                </a:cubicBezTo>
                <a:cubicBezTo>
                  <a:pt x="1376" y="1015"/>
                  <a:pt x="1378" y="999"/>
                  <a:pt x="1376" y="979"/>
                </a:cubicBezTo>
                <a:lnTo>
                  <a:pt x="1333" y="935"/>
                </a:lnTo>
                <a:close/>
                <a:moveTo>
                  <a:pt x="1505" y="557"/>
                </a:moveTo>
                <a:cubicBezTo>
                  <a:pt x="1510" y="562"/>
                  <a:pt x="1513" y="567"/>
                  <a:pt x="1514" y="571"/>
                </a:cubicBezTo>
                <a:cubicBezTo>
                  <a:pt x="1515" y="575"/>
                  <a:pt x="1515" y="578"/>
                  <a:pt x="1512" y="580"/>
                </a:cubicBezTo>
                <a:lnTo>
                  <a:pt x="1483" y="609"/>
                </a:lnTo>
                <a:cubicBezTo>
                  <a:pt x="1494" y="610"/>
                  <a:pt x="1503" y="612"/>
                  <a:pt x="1512" y="616"/>
                </a:cubicBezTo>
                <a:cubicBezTo>
                  <a:pt x="1521" y="621"/>
                  <a:pt x="1529" y="627"/>
                  <a:pt x="1536" y="634"/>
                </a:cubicBezTo>
                <a:cubicBezTo>
                  <a:pt x="1548" y="646"/>
                  <a:pt x="1557" y="658"/>
                  <a:pt x="1562" y="671"/>
                </a:cubicBezTo>
                <a:cubicBezTo>
                  <a:pt x="1567" y="684"/>
                  <a:pt x="1570" y="698"/>
                  <a:pt x="1569" y="711"/>
                </a:cubicBezTo>
                <a:cubicBezTo>
                  <a:pt x="1568" y="724"/>
                  <a:pt x="1565" y="738"/>
                  <a:pt x="1558" y="751"/>
                </a:cubicBezTo>
                <a:cubicBezTo>
                  <a:pt x="1552" y="764"/>
                  <a:pt x="1543" y="777"/>
                  <a:pt x="1531" y="788"/>
                </a:cubicBezTo>
                <a:cubicBezTo>
                  <a:pt x="1522" y="797"/>
                  <a:pt x="1513" y="804"/>
                  <a:pt x="1503" y="809"/>
                </a:cubicBezTo>
                <a:cubicBezTo>
                  <a:pt x="1494" y="814"/>
                  <a:pt x="1485" y="818"/>
                  <a:pt x="1477" y="818"/>
                </a:cubicBezTo>
                <a:cubicBezTo>
                  <a:pt x="1477" y="824"/>
                  <a:pt x="1478" y="829"/>
                  <a:pt x="1480" y="834"/>
                </a:cubicBezTo>
                <a:cubicBezTo>
                  <a:pt x="1482" y="840"/>
                  <a:pt x="1485" y="845"/>
                  <a:pt x="1490" y="849"/>
                </a:cubicBezTo>
                <a:cubicBezTo>
                  <a:pt x="1495" y="855"/>
                  <a:pt x="1502" y="857"/>
                  <a:pt x="1510" y="855"/>
                </a:cubicBezTo>
                <a:cubicBezTo>
                  <a:pt x="1519" y="854"/>
                  <a:pt x="1527" y="849"/>
                  <a:pt x="1536" y="841"/>
                </a:cubicBezTo>
                <a:lnTo>
                  <a:pt x="1592" y="789"/>
                </a:lnTo>
                <a:cubicBezTo>
                  <a:pt x="1603" y="779"/>
                  <a:pt x="1613" y="771"/>
                  <a:pt x="1624" y="765"/>
                </a:cubicBezTo>
                <a:cubicBezTo>
                  <a:pt x="1636" y="759"/>
                  <a:pt x="1647" y="756"/>
                  <a:pt x="1658" y="754"/>
                </a:cubicBezTo>
                <a:cubicBezTo>
                  <a:pt x="1668" y="752"/>
                  <a:pt x="1679" y="753"/>
                  <a:pt x="1689" y="757"/>
                </a:cubicBezTo>
                <a:cubicBezTo>
                  <a:pt x="1700" y="760"/>
                  <a:pt x="1709" y="766"/>
                  <a:pt x="1718" y="775"/>
                </a:cubicBezTo>
                <a:cubicBezTo>
                  <a:pt x="1728" y="784"/>
                  <a:pt x="1735" y="795"/>
                  <a:pt x="1739" y="808"/>
                </a:cubicBezTo>
                <a:cubicBezTo>
                  <a:pt x="1744" y="821"/>
                  <a:pt x="1746" y="834"/>
                  <a:pt x="1744" y="849"/>
                </a:cubicBezTo>
                <a:cubicBezTo>
                  <a:pt x="1742" y="863"/>
                  <a:pt x="1737" y="879"/>
                  <a:pt x="1728" y="895"/>
                </a:cubicBezTo>
                <a:cubicBezTo>
                  <a:pt x="1719" y="912"/>
                  <a:pt x="1706" y="929"/>
                  <a:pt x="1689" y="946"/>
                </a:cubicBezTo>
                <a:cubicBezTo>
                  <a:pt x="1672" y="963"/>
                  <a:pt x="1656" y="975"/>
                  <a:pt x="1642" y="984"/>
                </a:cubicBezTo>
                <a:cubicBezTo>
                  <a:pt x="1627" y="993"/>
                  <a:pt x="1614" y="999"/>
                  <a:pt x="1601" y="1001"/>
                </a:cubicBezTo>
                <a:cubicBezTo>
                  <a:pt x="1589" y="1004"/>
                  <a:pt x="1578" y="1004"/>
                  <a:pt x="1568" y="1000"/>
                </a:cubicBezTo>
                <a:cubicBezTo>
                  <a:pt x="1557" y="997"/>
                  <a:pt x="1548" y="991"/>
                  <a:pt x="1540" y="983"/>
                </a:cubicBezTo>
                <a:cubicBezTo>
                  <a:pt x="1535" y="978"/>
                  <a:pt x="1531" y="973"/>
                  <a:pt x="1528" y="967"/>
                </a:cubicBezTo>
                <a:cubicBezTo>
                  <a:pt x="1524" y="961"/>
                  <a:pt x="1521" y="954"/>
                  <a:pt x="1520" y="947"/>
                </a:cubicBezTo>
                <a:cubicBezTo>
                  <a:pt x="1518" y="941"/>
                  <a:pt x="1517" y="933"/>
                  <a:pt x="1517" y="926"/>
                </a:cubicBezTo>
                <a:cubicBezTo>
                  <a:pt x="1517" y="918"/>
                  <a:pt x="1517" y="910"/>
                  <a:pt x="1518" y="901"/>
                </a:cubicBezTo>
                <a:cubicBezTo>
                  <a:pt x="1507" y="905"/>
                  <a:pt x="1497" y="906"/>
                  <a:pt x="1487" y="903"/>
                </a:cubicBezTo>
                <a:cubicBezTo>
                  <a:pt x="1478" y="901"/>
                  <a:pt x="1470" y="897"/>
                  <a:pt x="1463" y="890"/>
                </a:cubicBezTo>
                <a:cubicBezTo>
                  <a:pt x="1454" y="881"/>
                  <a:pt x="1447" y="870"/>
                  <a:pt x="1444" y="859"/>
                </a:cubicBezTo>
                <a:cubicBezTo>
                  <a:pt x="1440" y="848"/>
                  <a:pt x="1438" y="837"/>
                  <a:pt x="1438" y="825"/>
                </a:cubicBezTo>
                <a:cubicBezTo>
                  <a:pt x="1428" y="824"/>
                  <a:pt x="1418" y="822"/>
                  <a:pt x="1408" y="817"/>
                </a:cubicBezTo>
                <a:cubicBezTo>
                  <a:pt x="1398" y="813"/>
                  <a:pt x="1388" y="806"/>
                  <a:pt x="1378" y="796"/>
                </a:cubicBezTo>
                <a:cubicBezTo>
                  <a:pt x="1366" y="784"/>
                  <a:pt x="1358" y="772"/>
                  <a:pt x="1352" y="758"/>
                </a:cubicBezTo>
                <a:cubicBezTo>
                  <a:pt x="1347" y="745"/>
                  <a:pt x="1345" y="732"/>
                  <a:pt x="1345" y="718"/>
                </a:cubicBezTo>
                <a:cubicBezTo>
                  <a:pt x="1346" y="705"/>
                  <a:pt x="1349" y="691"/>
                  <a:pt x="1356" y="678"/>
                </a:cubicBezTo>
                <a:cubicBezTo>
                  <a:pt x="1362" y="665"/>
                  <a:pt x="1371" y="652"/>
                  <a:pt x="1383" y="641"/>
                </a:cubicBezTo>
                <a:cubicBezTo>
                  <a:pt x="1389" y="634"/>
                  <a:pt x="1395" y="629"/>
                  <a:pt x="1401" y="624"/>
                </a:cubicBezTo>
                <a:cubicBezTo>
                  <a:pt x="1407" y="619"/>
                  <a:pt x="1413" y="615"/>
                  <a:pt x="1419" y="612"/>
                </a:cubicBezTo>
                <a:lnTo>
                  <a:pt x="1482" y="549"/>
                </a:lnTo>
                <a:cubicBezTo>
                  <a:pt x="1484" y="547"/>
                  <a:pt x="1488" y="546"/>
                  <a:pt x="1491" y="547"/>
                </a:cubicBezTo>
                <a:cubicBezTo>
                  <a:pt x="1495" y="549"/>
                  <a:pt x="1500" y="552"/>
                  <a:pt x="1505" y="557"/>
                </a:cubicBezTo>
                <a:close/>
                <a:moveTo>
                  <a:pt x="1500" y="670"/>
                </a:moveTo>
                <a:cubicBezTo>
                  <a:pt x="1486" y="656"/>
                  <a:pt x="1471" y="649"/>
                  <a:pt x="1456" y="649"/>
                </a:cubicBezTo>
                <a:cubicBezTo>
                  <a:pt x="1440" y="649"/>
                  <a:pt x="1425" y="656"/>
                  <a:pt x="1411" y="670"/>
                </a:cubicBezTo>
                <a:cubicBezTo>
                  <a:pt x="1404" y="678"/>
                  <a:pt x="1398" y="685"/>
                  <a:pt x="1395" y="693"/>
                </a:cubicBezTo>
                <a:cubicBezTo>
                  <a:pt x="1392" y="701"/>
                  <a:pt x="1391" y="709"/>
                  <a:pt x="1392" y="717"/>
                </a:cubicBezTo>
                <a:cubicBezTo>
                  <a:pt x="1393" y="724"/>
                  <a:pt x="1395" y="732"/>
                  <a:pt x="1399" y="739"/>
                </a:cubicBezTo>
                <a:cubicBezTo>
                  <a:pt x="1403" y="747"/>
                  <a:pt x="1408" y="753"/>
                  <a:pt x="1414" y="760"/>
                </a:cubicBezTo>
                <a:cubicBezTo>
                  <a:pt x="1427" y="773"/>
                  <a:pt x="1442" y="780"/>
                  <a:pt x="1457" y="780"/>
                </a:cubicBezTo>
                <a:cubicBezTo>
                  <a:pt x="1473" y="780"/>
                  <a:pt x="1488" y="773"/>
                  <a:pt x="1501" y="759"/>
                </a:cubicBezTo>
                <a:cubicBezTo>
                  <a:pt x="1509" y="752"/>
                  <a:pt x="1514" y="744"/>
                  <a:pt x="1517" y="736"/>
                </a:cubicBezTo>
                <a:cubicBezTo>
                  <a:pt x="1521" y="728"/>
                  <a:pt x="1522" y="721"/>
                  <a:pt x="1521" y="713"/>
                </a:cubicBezTo>
                <a:cubicBezTo>
                  <a:pt x="1521" y="705"/>
                  <a:pt x="1518" y="698"/>
                  <a:pt x="1515" y="690"/>
                </a:cubicBezTo>
                <a:cubicBezTo>
                  <a:pt x="1511" y="683"/>
                  <a:pt x="1506" y="676"/>
                  <a:pt x="1500" y="670"/>
                </a:cubicBezTo>
                <a:close/>
                <a:moveTo>
                  <a:pt x="1683" y="815"/>
                </a:moveTo>
                <a:cubicBezTo>
                  <a:pt x="1674" y="806"/>
                  <a:pt x="1663" y="803"/>
                  <a:pt x="1651" y="805"/>
                </a:cubicBezTo>
                <a:cubicBezTo>
                  <a:pt x="1639" y="808"/>
                  <a:pt x="1627" y="815"/>
                  <a:pt x="1614" y="827"/>
                </a:cubicBezTo>
                <a:lnTo>
                  <a:pt x="1559" y="879"/>
                </a:lnTo>
                <a:cubicBezTo>
                  <a:pt x="1558" y="887"/>
                  <a:pt x="1557" y="895"/>
                  <a:pt x="1558" y="902"/>
                </a:cubicBezTo>
                <a:cubicBezTo>
                  <a:pt x="1558" y="908"/>
                  <a:pt x="1559" y="914"/>
                  <a:pt x="1560" y="919"/>
                </a:cubicBezTo>
                <a:cubicBezTo>
                  <a:pt x="1561" y="924"/>
                  <a:pt x="1563" y="928"/>
                  <a:pt x="1566" y="932"/>
                </a:cubicBezTo>
                <a:cubicBezTo>
                  <a:pt x="1568" y="936"/>
                  <a:pt x="1571" y="939"/>
                  <a:pt x="1574" y="942"/>
                </a:cubicBezTo>
                <a:cubicBezTo>
                  <a:pt x="1584" y="952"/>
                  <a:pt x="1596" y="955"/>
                  <a:pt x="1612" y="950"/>
                </a:cubicBezTo>
                <a:cubicBezTo>
                  <a:pt x="1627" y="945"/>
                  <a:pt x="1643" y="933"/>
                  <a:pt x="1662" y="915"/>
                </a:cubicBezTo>
                <a:cubicBezTo>
                  <a:pt x="1673" y="904"/>
                  <a:pt x="1681" y="893"/>
                  <a:pt x="1687" y="883"/>
                </a:cubicBezTo>
                <a:cubicBezTo>
                  <a:pt x="1692" y="873"/>
                  <a:pt x="1696" y="864"/>
                  <a:pt x="1697" y="856"/>
                </a:cubicBezTo>
                <a:cubicBezTo>
                  <a:pt x="1698" y="847"/>
                  <a:pt x="1697" y="840"/>
                  <a:pt x="1694" y="833"/>
                </a:cubicBezTo>
                <a:cubicBezTo>
                  <a:pt x="1692" y="826"/>
                  <a:pt x="1688" y="820"/>
                  <a:pt x="1683" y="815"/>
                </a:cubicBezTo>
                <a:close/>
                <a:moveTo>
                  <a:pt x="1794" y="662"/>
                </a:moveTo>
                <a:cubicBezTo>
                  <a:pt x="1795" y="663"/>
                  <a:pt x="1796" y="665"/>
                  <a:pt x="1796" y="666"/>
                </a:cubicBezTo>
                <a:cubicBezTo>
                  <a:pt x="1796" y="668"/>
                  <a:pt x="1796" y="669"/>
                  <a:pt x="1795" y="671"/>
                </a:cubicBezTo>
                <a:cubicBezTo>
                  <a:pt x="1794" y="673"/>
                  <a:pt x="1793" y="676"/>
                  <a:pt x="1791" y="678"/>
                </a:cubicBezTo>
                <a:cubicBezTo>
                  <a:pt x="1788" y="681"/>
                  <a:pt x="1785" y="684"/>
                  <a:pt x="1782" y="688"/>
                </a:cubicBezTo>
                <a:cubicBezTo>
                  <a:pt x="1778" y="692"/>
                  <a:pt x="1775" y="695"/>
                  <a:pt x="1772" y="697"/>
                </a:cubicBezTo>
                <a:cubicBezTo>
                  <a:pt x="1769" y="699"/>
                  <a:pt x="1767" y="701"/>
                  <a:pt x="1765" y="701"/>
                </a:cubicBezTo>
                <a:cubicBezTo>
                  <a:pt x="1763" y="702"/>
                  <a:pt x="1761" y="703"/>
                  <a:pt x="1760" y="702"/>
                </a:cubicBezTo>
                <a:cubicBezTo>
                  <a:pt x="1758" y="702"/>
                  <a:pt x="1757" y="701"/>
                  <a:pt x="1756" y="700"/>
                </a:cubicBezTo>
                <a:lnTo>
                  <a:pt x="1549" y="494"/>
                </a:lnTo>
                <a:cubicBezTo>
                  <a:pt x="1548" y="493"/>
                  <a:pt x="1548" y="491"/>
                  <a:pt x="1547" y="490"/>
                </a:cubicBezTo>
                <a:cubicBezTo>
                  <a:pt x="1547" y="488"/>
                  <a:pt x="1547" y="487"/>
                  <a:pt x="1548" y="485"/>
                </a:cubicBezTo>
                <a:cubicBezTo>
                  <a:pt x="1549" y="483"/>
                  <a:pt x="1550" y="480"/>
                  <a:pt x="1552" y="477"/>
                </a:cubicBezTo>
                <a:cubicBezTo>
                  <a:pt x="1555" y="475"/>
                  <a:pt x="1557" y="471"/>
                  <a:pt x="1561" y="468"/>
                </a:cubicBezTo>
                <a:cubicBezTo>
                  <a:pt x="1565" y="464"/>
                  <a:pt x="1568" y="461"/>
                  <a:pt x="1571" y="459"/>
                </a:cubicBezTo>
                <a:cubicBezTo>
                  <a:pt x="1574" y="457"/>
                  <a:pt x="1576" y="455"/>
                  <a:pt x="1578" y="454"/>
                </a:cubicBezTo>
                <a:cubicBezTo>
                  <a:pt x="1580" y="454"/>
                  <a:pt x="1582" y="453"/>
                  <a:pt x="1583" y="454"/>
                </a:cubicBezTo>
                <a:cubicBezTo>
                  <a:pt x="1585" y="454"/>
                  <a:pt x="1586" y="455"/>
                  <a:pt x="1587" y="456"/>
                </a:cubicBezTo>
                <a:lnTo>
                  <a:pt x="1794" y="662"/>
                </a:lnTo>
                <a:close/>
                <a:moveTo>
                  <a:pt x="1522" y="382"/>
                </a:moveTo>
                <a:cubicBezTo>
                  <a:pt x="1531" y="391"/>
                  <a:pt x="1535" y="398"/>
                  <a:pt x="1535" y="405"/>
                </a:cubicBezTo>
                <a:cubicBezTo>
                  <a:pt x="1535" y="412"/>
                  <a:pt x="1530" y="419"/>
                  <a:pt x="1521" y="428"/>
                </a:cubicBezTo>
                <a:cubicBezTo>
                  <a:pt x="1512" y="437"/>
                  <a:pt x="1505" y="442"/>
                  <a:pt x="1498" y="442"/>
                </a:cubicBezTo>
                <a:cubicBezTo>
                  <a:pt x="1492" y="442"/>
                  <a:pt x="1484" y="438"/>
                  <a:pt x="1476" y="429"/>
                </a:cubicBezTo>
                <a:cubicBezTo>
                  <a:pt x="1467" y="420"/>
                  <a:pt x="1462" y="412"/>
                  <a:pt x="1463" y="406"/>
                </a:cubicBezTo>
                <a:cubicBezTo>
                  <a:pt x="1463" y="399"/>
                  <a:pt x="1467" y="391"/>
                  <a:pt x="1476" y="382"/>
                </a:cubicBezTo>
                <a:cubicBezTo>
                  <a:pt x="1485" y="374"/>
                  <a:pt x="1493" y="369"/>
                  <a:pt x="1499" y="369"/>
                </a:cubicBezTo>
                <a:cubicBezTo>
                  <a:pt x="1506" y="369"/>
                  <a:pt x="1513" y="373"/>
                  <a:pt x="1522" y="382"/>
                </a:cubicBezTo>
                <a:close/>
                <a:moveTo>
                  <a:pt x="2041" y="415"/>
                </a:moveTo>
                <a:cubicBezTo>
                  <a:pt x="2042" y="416"/>
                  <a:pt x="2043" y="417"/>
                  <a:pt x="2043" y="419"/>
                </a:cubicBezTo>
                <a:cubicBezTo>
                  <a:pt x="2043" y="420"/>
                  <a:pt x="2043" y="422"/>
                  <a:pt x="2042" y="424"/>
                </a:cubicBezTo>
                <a:cubicBezTo>
                  <a:pt x="2042" y="426"/>
                  <a:pt x="2040" y="428"/>
                  <a:pt x="2038" y="431"/>
                </a:cubicBezTo>
                <a:cubicBezTo>
                  <a:pt x="2036" y="434"/>
                  <a:pt x="2033" y="437"/>
                  <a:pt x="2029" y="441"/>
                </a:cubicBezTo>
                <a:cubicBezTo>
                  <a:pt x="2025" y="445"/>
                  <a:pt x="2022" y="448"/>
                  <a:pt x="2019" y="450"/>
                </a:cubicBezTo>
                <a:cubicBezTo>
                  <a:pt x="2017" y="452"/>
                  <a:pt x="2014" y="453"/>
                  <a:pt x="2012" y="454"/>
                </a:cubicBezTo>
                <a:cubicBezTo>
                  <a:pt x="2010" y="455"/>
                  <a:pt x="2009" y="455"/>
                  <a:pt x="2007" y="455"/>
                </a:cubicBezTo>
                <a:cubicBezTo>
                  <a:pt x="2006" y="455"/>
                  <a:pt x="2004" y="454"/>
                  <a:pt x="2003" y="453"/>
                </a:cubicBezTo>
                <a:lnTo>
                  <a:pt x="1882" y="332"/>
                </a:lnTo>
                <a:cubicBezTo>
                  <a:pt x="1870" y="320"/>
                  <a:pt x="1860" y="312"/>
                  <a:pt x="1851" y="306"/>
                </a:cubicBezTo>
                <a:cubicBezTo>
                  <a:pt x="1842" y="301"/>
                  <a:pt x="1833" y="297"/>
                  <a:pt x="1824" y="296"/>
                </a:cubicBezTo>
                <a:cubicBezTo>
                  <a:pt x="1816" y="294"/>
                  <a:pt x="1807" y="295"/>
                  <a:pt x="1799" y="297"/>
                </a:cubicBezTo>
                <a:cubicBezTo>
                  <a:pt x="1791" y="300"/>
                  <a:pt x="1783" y="305"/>
                  <a:pt x="1775" y="313"/>
                </a:cubicBezTo>
                <a:cubicBezTo>
                  <a:pt x="1766" y="322"/>
                  <a:pt x="1760" y="335"/>
                  <a:pt x="1757" y="351"/>
                </a:cubicBezTo>
                <a:cubicBezTo>
                  <a:pt x="1754" y="367"/>
                  <a:pt x="1754" y="387"/>
                  <a:pt x="1757" y="410"/>
                </a:cubicBezTo>
                <a:lnTo>
                  <a:pt x="1901" y="555"/>
                </a:lnTo>
                <a:cubicBezTo>
                  <a:pt x="1902" y="556"/>
                  <a:pt x="1903" y="557"/>
                  <a:pt x="1903" y="559"/>
                </a:cubicBezTo>
                <a:cubicBezTo>
                  <a:pt x="1903" y="560"/>
                  <a:pt x="1903" y="562"/>
                  <a:pt x="1902" y="564"/>
                </a:cubicBezTo>
                <a:cubicBezTo>
                  <a:pt x="1902" y="566"/>
                  <a:pt x="1900" y="568"/>
                  <a:pt x="1898" y="571"/>
                </a:cubicBezTo>
                <a:cubicBezTo>
                  <a:pt x="1896" y="574"/>
                  <a:pt x="1893" y="577"/>
                  <a:pt x="1889" y="581"/>
                </a:cubicBezTo>
                <a:cubicBezTo>
                  <a:pt x="1885" y="584"/>
                  <a:pt x="1882" y="587"/>
                  <a:pt x="1880" y="590"/>
                </a:cubicBezTo>
                <a:cubicBezTo>
                  <a:pt x="1877" y="592"/>
                  <a:pt x="1874" y="593"/>
                  <a:pt x="1872" y="594"/>
                </a:cubicBezTo>
                <a:cubicBezTo>
                  <a:pt x="1870" y="595"/>
                  <a:pt x="1868" y="595"/>
                  <a:pt x="1867" y="595"/>
                </a:cubicBezTo>
                <a:cubicBezTo>
                  <a:pt x="1866" y="595"/>
                  <a:pt x="1864" y="594"/>
                  <a:pt x="1863" y="593"/>
                </a:cubicBezTo>
                <a:lnTo>
                  <a:pt x="1657" y="386"/>
                </a:lnTo>
                <a:cubicBezTo>
                  <a:pt x="1656" y="385"/>
                  <a:pt x="1655" y="384"/>
                  <a:pt x="1654" y="382"/>
                </a:cubicBezTo>
                <a:cubicBezTo>
                  <a:pt x="1654" y="381"/>
                  <a:pt x="1654" y="379"/>
                  <a:pt x="1655" y="377"/>
                </a:cubicBezTo>
                <a:cubicBezTo>
                  <a:pt x="1656" y="375"/>
                  <a:pt x="1657" y="373"/>
                  <a:pt x="1659" y="371"/>
                </a:cubicBezTo>
                <a:cubicBezTo>
                  <a:pt x="1661" y="368"/>
                  <a:pt x="1663" y="365"/>
                  <a:pt x="1667" y="362"/>
                </a:cubicBezTo>
                <a:cubicBezTo>
                  <a:pt x="1670" y="359"/>
                  <a:pt x="1673" y="356"/>
                  <a:pt x="1676" y="354"/>
                </a:cubicBezTo>
                <a:cubicBezTo>
                  <a:pt x="1678" y="352"/>
                  <a:pt x="1680" y="351"/>
                  <a:pt x="1682" y="350"/>
                </a:cubicBezTo>
                <a:cubicBezTo>
                  <a:pt x="1684" y="350"/>
                  <a:pt x="1686" y="349"/>
                  <a:pt x="1687" y="350"/>
                </a:cubicBezTo>
                <a:cubicBezTo>
                  <a:pt x="1689" y="350"/>
                  <a:pt x="1690" y="351"/>
                  <a:pt x="1691" y="352"/>
                </a:cubicBezTo>
                <a:lnTo>
                  <a:pt x="1718" y="379"/>
                </a:lnTo>
                <a:cubicBezTo>
                  <a:pt x="1717" y="355"/>
                  <a:pt x="1719" y="334"/>
                  <a:pt x="1725" y="316"/>
                </a:cubicBezTo>
                <a:cubicBezTo>
                  <a:pt x="1730" y="298"/>
                  <a:pt x="1739" y="284"/>
                  <a:pt x="1750" y="272"/>
                </a:cubicBezTo>
                <a:cubicBezTo>
                  <a:pt x="1764" y="258"/>
                  <a:pt x="1778" y="249"/>
                  <a:pt x="1792" y="244"/>
                </a:cubicBezTo>
                <a:cubicBezTo>
                  <a:pt x="1806" y="240"/>
                  <a:pt x="1820" y="238"/>
                  <a:pt x="1834" y="240"/>
                </a:cubicBezTo>
                <a:cubicBezTo>
                  <a:pt x="1847" y="242"/>
                  <a:pt x="1861" y="247"/>
                  <a:pt x="1874" y="255"/>
                </a:cubicBezTo>
                <a:cubicBezTo>
                  <a:pt x="1887" y="263"/>
                  <a:pt x="1900" y="274"/>
                  <a:pt x="1915" y="289"/>
                </a:cubicBezTo>
                <a:lnTo>
                  <a:pt x="2041" y="415"/>
                </a:lnTo>
                <a:close/>
                <a:moveTo>
                  <a:pt x="2176" y="55"/>
                </a:moveTo>
                <a:cubicBezTo>
                  <a:pt x="2182" y="61"/>
                  <a:pt x="2185" y="67"/>
                  <a:pt x="2184" y="73"/>
                </a:cubicBezTo>
                <a:cubicBezTo>
                  <a:pt x="2184" y="78"/>
                  <a:pt x="2182" y="83"/>
                  <a:pt x="2178" y="87"/>
                </a:cubicBezTo>
                <a:lnTo>
                  <a:pt x="2042" y="223"/>
                </a:lnTo>
                <a:cubicBezTo>
                  <a:pt x="2053" y="234"/>
                  <a:pt x="2065" y="243"/>
                  <a:pt x="2076" y="250"/>
                </a:cubicBezTo>
                <a:cubicBezTo>
                  <a:pt x="2088" y="257"/>
                  <a:pt x="2100" y="261"/>
                  <a:pt x="2112" y="262"/>
                </a:cubicBezTo>
                <a:cubicBezTo>
                  <a:pt x="2123" y="263"/>
                  <a:pt x="2135" y="261"/>
                  <a:pt x="2148" y="256"/>
                </a:cubicBezTo>
                <a:cubicBezTo>
                  <a:pt x="2160" y="251"/>
                  <a:pt x="2172" y="242"/>
                  <a:pt x="2184" y="230"/>
                </a:cubicBezTo>
                <a:cubicBezTo>
                  <a:pt x="2194" y="220"/>
                  <a:pt x="2202" y="211"/>
                  <a:pt x="2208" y="201"/>
                </a:cubicBezTo>
                <a:cubicBezTo>
                  <a:pt x="2214" y="192"/>
                  <a:pt x="2219" y="184"/>
                  <a:pt x="2223" y="176"/>
                </a:cubicBezTo>
                <a:cubicBezTo>
                  <a:pt x="2226" y="168"/>
                  <a:pt x="2229" y="162"/>
                  <a:pt x="2231" y="157"/>
                </a:cubicBezTo>
                <a:cubicBezTo>
                  <a:pt x="2233" y="152"/>
                  <a:pt x="2235" y="148"/>
                  <a:pt x="2237" y="146"/>
                </a:cubicBezTo>
                <a:cubicBezTo>
                  <a:pt x="2238" y="145"/>
                  <a:pt x="2239" y="144"/>
                  <a:pt x="2241" y="144"/>
                </a:cubicBezTo>
                <a:cubicBezTo>
                  <a:pt x="2242" y="144"/>
                  <a:pt x="2244" y="144"/>
                  <a:pt x="2245" y="145"/>
                </a:cubicBezTo>
                <a:cubicBezTo>
                  <a:pt x="2247" y="145"/>
                  <a:pt x="2248" y="146"/>
                  <a:pt x="2251" y="148"/>
                </a:cubicBezTo>
                <a:cubicBezTo>
                  <a:pt x="2253" y="150"/>
                  <a:pt x="2255" y="152"/>
                  <a:pt x="2258" y="155"/>
                </a:cubicBezTo>
                <a:cubicBezTo>
                  <a:pt x="2260" y="157"/>
                  <a:pt x="2262" y="158"/>
                  <a:pt x="2263" y="160"/>
                </a:cubicBezTo>
                <a:cubicBezTo>
                  <a:pt x="2264" y="162"/>
                  <a:pt x="2265" y="163"/>
                  <a:pt x="2266" y="165"/>
                </a:cubicBezTo>
                <a:cubicBezTo>
                  <a:pt x="2267" y="166"/>
                  <a:pt x="2268" y="167"/>
                  <a:pt x="2268" y="169"/>
                </a:cubicBezTo>
                <a:cubicBezTo>
                  <a:pt x="2269" y="170"/>
                  <a:pt x="2269" y="172"/>
                  <a:pt x="2269" y="174"/>
                </a:cubicBezTo>
                <a:cubicBezTo>
                  <a:pt x="2269" y="175"/>
                  <a:pt x="2268" y="179"/>
                  <a:pt x="2265" y="185"/>
                </a:cubicBezTo>
                <a:cubicBezTo>
                  <a:pt x="2263" y="191"/>
                  <a:pt x="2260" y="198"/>
                  <a:pt x="2255" y="207"/>
                </a:cubicBezTo>
                <a:cubicBezTo>
                  <a:pt x="2250" y="215"/>
                  <a:pt x="2244" y="224"/>
                  <a:pt x="2237" y="234"/>
                </a:cubicBezTo>
                <a:cubicBezTo>
                  <a:pt x="2230" y="245"/>
                  <a:pt x="2221" y="255"/>
                  <a:pt x="2212" y="264"/>
                </a:cubicBezTo>
                <a:cubicBezTo>
                  <a:pt x="2195" y="281"/>
                  <a:pt x="2177" y="294"/>
                  <a:pt x="2160" y="302"/>
                </a:cubicBezTo>
                <a:cubicBezTo>
                  <a:pt x="2142" y="310"/>
                  <a:pt x="2125" y="314"/>
                  <a:pt x="2107" y="313"/>
                </a:cubicBezTo>
                <a:cubicBezTo>
                  <a:pt x="2089" y="312"/>
                  <a:pt x="2070" y="307"/>
                  <a:pt x="2052" y="298"/>
                </a:cubicBezTo>
                <a:cubicBezTo>
                  <a:pt x="2033" y="288"/>
                  <a:pt x="2015" y="274"/>
                  <a:pt x="1996" y="255"/>
                </a:cubicBezTo>
                <a:cubicBezTo>
                  <a:pt x="1978" y="237"/>
                  <a:pt x="1965" y="219"/>
                  <a:pt x="1955" y="200"/>
                </a:cubicBezTo>
                <a:cubicBezTo>
                  <a:pt x="1946" y="182"/>
                  <a:pt x="1940" y="163"/>
                  <a:pt x="1939" y="145"/>
                </a:cubicBezTo>
                <a:cubicBezTo>
                  <a:pt x="1938" y="126"/>
                  <a:pt x="1941" y="108"/>
                  <a:pt x="1948" y="91"/>
                </a:cubicBezTo>
                <a:cubicBezTo>
                  <a:pt x="1955" y="73"/>
                  <a:pt x="1966" y="57"/>
                  <a:pt x="1981" y="42"/>
                </a:cubicBezTo>
                <a:cubicBezTo>
                  <a:pt x="1997" y="25"/>
                  <a:pt x="2013" y="14"/>
                  <a:pt x="2030" y="8"/>
                </a:cubicBezTo>
                <a:cubicBezTo>
                  <a:pt x="2047" y="2"/>
                  <a:pt x="2063" y="0"/>
                  <a:pt x="2079" y="1"/>
                </a:cubicBezTo>
                <a:cubicBezTo>
                  <a:pt x="2095" y="2"/>
                  <a:pt x="2111" y="7"/>
                  <a:pt x="2126" y="16"/>
                </a:cubicBezTo>
                <a:cubicBezTo>
                  <a:pt x="2141" y="24"/>
                  <a:pt x="2156" y="35"/>
                  <a:pt x="2169" y="49"/>
                </a:cubicBezTo>
                <a:lnTo>
                  <a:pt x="2176" y="55"/>
                </a:lnTo>
                <a:close/>
                <a:moveTo>
                  <a:pt x="2127" y="82"/>
                </a:moveTo>
                <a:cubicBezTo>
                  <a:pt x="2107" y="62"/>
                  <a:pt x="2087" y="51"/>
                  <a:pt x="2067" y="49"/>
                </a:cubicBezTo>
                <a:cubicBezTo>
                  <a:pt x="2046" y="47"/>
                  <a:pt x="2027" y="55"/>
                  <a:pt x="2008" y="73"/>
                </a:cubicBezTo>
                <a:cubicBezTo>
                  <a:pt x="1999" y="83"/>
                  <a:pt x="1993" y="93"/>
                  <a:pt x="1989" y="103"/>
                </a:cubicBezTo>
                <a:cubicBezTo>
                  <a:pt x="1985" y="114"/>
                  <a:pt x="1984" y="124"/>
                  <a:pt x="1985" y="135"/>
                </a:cubicBezTo>
                <a:cubicBezTo>
                  <a:pt x="1986" y="145"/>
                  <a:pt x="1989" y="156"/>
                  <a:pt x="1994" y="166"/>
                </a:cubicBezTo>
                <a:cubicBezTo>
                  <a:pt x="2000" y="177"/>
                  <a:pt x="2006" y="186"/>
                  <a:pt x="2014" y="195"/>
                </a:cubicBezTo>
                <a:lnTo>
                  <a:pt x="2127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5" name="Freeform 249"/>
          <p:cNvSpPr>
            <a:spLocks noEditPoints="1"/>
          </p:cNvSpPr>
          <p:nvPr/>
        </p:nvSpPr>
        <p:spPr bwMode="auto">
          <a:xfrm>
            <a:off x="1796501" y="4418880"/>
            <a:ext cx="404438" cy="466725"/>
          </a:xfrm>
          <a:custGeom>
            <a:avLst/>
            <a:gdLst>
              <a:gd name="T0" fmla="*/ 471 w 2544"/>
              <a:gd name="T1" fmla="*/ 2271 h 2447"/>
              <a:gd name="T2" fmla="*/ 328 w 2544"/>
              <a:gd name="T3" fmla="*/ 2414 h 2447"/>
              <a:gd name="T4" fmla="*/ 2 w 2544"/>
              <a:gd name="T5" fmla="*/ 2159 h 2447"/>
              <a:gd name="T6" fmla="*/ 38 w 2544"/>
              <a:gd name="T7" fmla="*/ 2118 h 2447"/>
              <a:gd name="T8" fmla="*/ 180 w 2544"/>
              <a:gd name="T9" fmla="*/ 1968 h 2447"/>
              <a:gd name="T10" fmla="*/ 663 w 2544"/>
              <a:gd name="T11" fmla="*/ 1857 h 2447"/>
              <a:gd name="T12" fmla="*/ 514 w 2544"/>
              <a:gd name="T13" fmla="*/ 2108 h 2447"/>
              <a:gd name="T14" fmla="*/ 557 w 2544"/>
              <a:gd name="T15" fmla="*/ 1801 h 2447"/>
              <a:gd name="T16" fmla="*/ 481 w 2544"/>
              <a:gd name="T17" fmla="*/ 1880 h 2447"/>
              <a:gd name="T18" fmla="*/ 607 w 2544"/>
              <a:gd name="T19" fmla="*/ 2068 h 2447"/>
              <a:gd name="T20" fmla="*/ 1134 w 2544"/>
              <a:gd name="T21" fmla="*/ 1604 h 2447"/>
              <a:gd name="T22" fmla="*/ 1094 w 2544"/>
              <a:gd name="T23" fmla="*/ 1638 h 2447"/>
              <a:gd name="T24" fmla="*/ 854 w 2544"/>
              <a:gd name="T25" fmla="*/ 1589 h 2447"/>
              <a:gd name="T26" fmla="*/ 969 w 2544"/>
              <a:gd name="T27" fmla="*/ 1773 h 2447"/>
              <a:gd name="T28" fmla="*/ 735 w 2544"/>
              <a:gd name="T29" fmla="*/ 1629 h 2447"/>
              <a:gd name="T30" fmla="*/ 852 w 2544"/>
              <a:gd name="T31" fmla="*/ 1894 h 2447"/>
              <a:gd name="T32" fmla="*/ 618 w 2544"/>
              <a:gd name="T33" fmla="*/ 1690 h 2447"/>
              <a:gd name="T34" fmla="*/ 681 w 2544"/>
              <a:gd name="T35" fmla="*/ 1692 h 2447"/>
              <a:gd name="T36" fmla="*/ 815 w 2544"/>
              <a:gd name="T37" fmla="*/ 1527 h 2447"/>
              <a:gd name="T38" fmla="*/ 1002 w 2544"/>
              <a:gd name="T39" fmla="*/ 1469 h 2447"/>
              <a:gd name="T40" fmla="*/ 1244 w 2544"/>
              <a:gd name="T41" fmla="*/ 1493 h 2447"/>
              <a:gd name="T42" fmla="*/ 1073 w 2544"/>
              <a:gd name="T43" fmla="*/ 1225 h 2447"/>
              <a:gd name="T44" fmla="*/ 1178 w 2544"/>
              <a:gd name="T45" fmla="*/ 1232 h 2447"/>
              <a:gd name="T46" fmla="*/ 1155 w 2544"/>
              <a:gd name="T47" fmla="*/ 1432 h 2447"/>
              <a:gd name="T48" fmla="*/ 1249 w 2544"/>
              <a:gd name="T49" fmla="*/ 1277 h 2447"/>
              <a:gd name="T50" fmla="*/ 1462 w 2544"/>
              <a:gd name="T51" fmla="*/ 1278 h 2447"/>
              <a:gd name="T52" fmla="*/ 1396 w 2544"/>
              <a:gd name="T53" fmla="*/ 1257 h 2447"/>
              <a:gd name="T54" fmla="*/ 1500 w 2544"/>
              <a:gd name="T55" fmla="*/ 1175 h 2447"/>
              <a:gd name="T56" fmla="*/ 1367 w 2544"/>
              <a:gd name="T57" fmla="*/ 1159 h 2447"/>
              <a:gd name="T58" fmla="*/ 1295 w 2544"/>
              <a:gd name="T59" fmla="*/ 1003 h 2447"/>
              <a:gd name="T60" fmla="*/ 1374 w 2544"/>
              <a:gd name="T61" fmla="*/ 972 h 2447"/>
              <a:gd name="T62" fmla="*/ 1366 w 2544"/>
              <a:gd name="T63" fmla="*/ 1007 h 2447"/>
              <a:gd name="T64" fmla="*/ 1335 w 2544"/>
              <a:gd name="T65" fmla="*/ 1112 h 2447"/>
              <a:gd name="T66" fmla="*/ 1522 w 2544"/>
              <a:gd name="T67" fmla="*/ 1098 h 2447"/>
              <a:gd name="T68" fmla="*/ 1670 w 2544"/>
              <a:gd name="T69" fmla="*/ 1009 h 2447"/>
              <a:gd name="T70" fmla="*/ 1768 w 2544"/>
              <a:gd name="T71" fmla="*/ 898 h 2447"/>
              <a:gd name="T72" fmla="*/ 1788 w 2544"/>
              <a:gd name="T73" fmla="*/ 938 h 2447"/>
              <a:gd name="T74" fmla="*/ 1519 w 2544"/>
              <a:gd name="T75" fmla="*/ 1008 h 2447"/>
              <a:gd name="T76" fmla="*/ 1649 w 2544"/>
              <a:gd name="T77" fmla="*/ 769 h 2447"/>
              <a:gd name="T78" fmla="*/ 1508 w 2544"/>
              <a:gd name="T79" fmla="*/ 888 h 2447"/>
              <a:gd name="T80" fmla="*/ 1809 w 2544"/>
              <a:gd name="T81" fmla="*/ 571 h 2447"/>
              <a:gd name="T82" fmla="*/ 1761 w 2544"/>
              <a:gd name="T83" fmla="*/ 629 h 2447"/>
              <a:gd name="T84" fmla="*/ 1893 w 2544"/>
              <a:gd name="T85" fmla="*/ 853 h 2447"/>
              <a:gd name="T86" fmla="*/ 1658 w 2544"/>
              <a:gd name="T87" fmla="*/ 650 h 2447"/>
              <a:gd name="T88" fmla="*/ 1725 w 2544"/>
              <a:gd name="T89" fmla="*/ 654 h 2447"/>
              <a:gd name="T90" fmla="*/ 1766 w 2544"/>
              <a:gd name="T91" fmla="*/ 539 h 2447"/>
              <a:gd name="T92" fmla="*/ 2076 w 2544"/>
              <a:gd name="T93" fmla="*/ 661 h 2447"/>
              <a:gd name="T94" fmla="*/ 2036 w 2544"/>
              <a:gd name="T95" fmla="*/ 695 h 2447"/>
              <a:gd name="T96" fmla="*/ 1859 w 2544"/>
              <a:gd name="T97" fmla="*/ 450 h 2447"/>
              <a:gd name="T98" fmla="*/ 1779 w 2544"/>
              <a:gd name="T99" fmla="*/ 437 h 2447"/>
              <a:gd name="T100" fmla="*/ 2324 w 2544"/>
              <a:gd name="T101" fmla="*/ 414 h 2447"/>
              <a:gd name="T102" fmla="*/ 2284 w 2544"/>
              <a:gd name="T103" fmla="*/ 448 h 2447"/>
              <a:gd name="T104" fmla="*/ 2038 w 2544"/>
              <a:gd name="T105" fmla="*/ 406 h 2447"/>
              <a:gd name="T106" fmla="*/ 2153 w 2544"/>
              <a:gd name="T107" fmla="*/ 589 h 2447"/>
              <a:gd name="T108" fmla="*/ 1948 w 2544"/>
              <a:gd name="T109" fmla="*/ 357 h 2447"/>
              <a:gd name="T110" fmla="*/ 2031 w 2544"/>
              <a:gd name="T111" fmla="*/ 267 h 2447"/>
              <a:gd name="T112" fmla="*/ 2459 w 2544"/>
              <a:gd name="T113" fmla="*/ 73 h 2447"/>
              <a:gd name="T114" fmla="*/ 2483 w 2544"/>
              <a:gd name="T115" fmla="*/ 202 h 2447"/>
              <a:gd name="T116" fmla="*/ 2533 w 2544"/>
              <a:gd name="T117" fmla="*/ 155 h 2447"/>
              <a:gd name="T118" fmla="*/ 2512 w 2544"/>
              <a:gd name="T119" fmla="*/ 235 h 2447"/>
              <a:gd name="T120" fmla="*/ 2214 w 2544"/>
              <a:gd name="T121" fmla="*/ 145 h 2447"/>
              <a:gd name="T122" fmla="*/ 2451 w 2544"/>
              <a:gd name="T123" fmla="*/ 56 h 2447"/>
              <a:gd name="T124" fmla="*/ 2289 w 2544"/>
              <a:gd name="T125" fmla="*/ 196 h 24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544" h="2447">
                <a:moveTo>
                  <a:pt x="501" y="2230"/>
                </a:moveTo>
                <a:cubicBezTo>
                  <a:pt x="502" y="2232"/>
                  <a:pt x="503" y="2233"/>
                  <a:pt x="503" y="2235"/>
                </a:cubicBezTo>
                <a:cubicBezTo>
                  <a:pt x="503" y="2236"/>
                  <a:pt x="503" y="2238"/>
                  <a:pt x="502" y="2240"/>
                </a:cubicBezTo>
                <a:cubicBezTo>
                  <a:pt x="501" y="2242"/>
                  <a:pt x="499" y="2244"/>
                  <a:pt x="497" y="2247"/>
                </a:cubicBezTo>
                <a:cubicBezTo>
                  <a:pt x="495" y="2250"/>
                  <a:pt x="492" y="2254"/>
                  <a:pt x="488" y="2257"/>
                </a:cubicBezTo>
                <a:cubicBezTo>
                  <a:pt x="485" y="2261"/>
                  <a:pt x="481" y="2264"/>
                  <a:pt x="478" y="2266"/>
                </a:cubicBezTo>
                <a:cubicBezTo>
                  <a:pt x="475" y="2268"/>
                  <a:pt x="473" y="2270"/>
                  <a:pt x="471" y="2271"/>
                </a:cubicBezTo>
                <a:cubicBezTo>
                  <a:pt x="469" y="2272"/>
                  <a:pt x="467" y="2272"/>
                  <a:pt x="466" y="2272"/>
                </a:cubicBezTo>
                <a:cubicBezTo>
                  <a:pt x="464" y="2272"/>
                  <a:pt x="463" y="2271"/>
                  <a:pt x="461" y="2270"/>
                </a:cubicBezTo>
                <a:lnTo>
                  <a:pt x="330" y="2138"/>
                </a:lnTo>
                <a:lnTo>
                  <a:pt x="195" y="2273"/>
                </a:lnTo>
                <a:lnTo>
                  <a:pt x="326" y="2405"/>
                </a:lnTo>
                <a:cubicBezTo>
                  <a:pt x="328" y="2406"/>
                  <a:pt x="328" y="2407"/>
                  <a:pt x="329" y="2409"/>
                </a:cubicBezTo>
                <a:cubicBezTo>
                  <a:pt x="329" y="2410"/>
                  <a:pt x="329" y="2412"/>
                  <a:pt x="328" y="2414"/>
                </a:cubicBezTo>
                <a:cubicBezTo>
                  <a:pt x="327" y="2416"/>
                  <a:pt x="325" y="2419"/>
                  <a:pt x="323" y="2422"/>
                </a:cubicBezTo>
                <a:cubicBezTo>
                  <a:pt x="321" y="2425"/>
                  <a:pt x="318" y="2428"/>
                  <a:pt x="314" y="2432"/>
                </a:cubicBezTo>
                <a:cubicBezTo>
                  <a:pt x="310" y="2435"/>
                  <a:pt x="307" y="2438"/>
                  <a:pt x="304" y="2441"/>
                </a:cubicBezTo>
                <a:cubicBezTo>
                  <a:pt x="301" y="2443"/>
                  <a:pt x="299" y="2444"/>
                  <a:pt x="296" y="2445"/>
                </a:cubicBezTo>
                <a:cubicBezTo>
                  <a:pt x="294" y="2446"/>
                  <a:pt x="293" y="2447"/>
                  <a:pt x="291" y="2446"/>
                </a:cubicBezTo>
                <a:cubicBezTo>
                  <a:pt x="290" y="2446"/>
                  <a:pt x="288" y="2445"/>
                  <a:pt x="287" y="2444"/>
                </a:cubicBezTo>
                <a:lnTo>
                  <a:pt x="2" y="2159"/>
                </a:lnTo>
                <a:cubicBezTo>
                  <a:pt x="1" y="2158"/>
                  <a:pt x="0" y="2157"/>
                  <a:pt x="0" y="2155"/>
                </a:cubicBezTo>
                <a:cubicBezTo>
                  <a:pt x="0" y="2154"/>
                  <a:pt x="0" y="2152"/>
                  <a:pt x="1" y="2150"/>
                </a:cubicBezTo>
                <a:cubicBezTo>
                  <a:pt x="2" y="2148"/>
                  <a:pt x="4" y="2145"/>
                  <a:pt x="6" y="2142"/>
                </a:cubicBezTo>
                <a:cubicBezTo>
                  <a:pt x="8" y="2139"/>
                  <a:pt x="11" y="2136"/>
                  <a:pt x="15" y="2132"/>
                </a:cubicBezTo>
                <a:cubicBezTo>
                  <a:pt x="18" y="2128"/>
                  <a:pt x="22" y="2126"/>
                  <a:pt x="25" y="2123"/>
                </a:cubicBezTo>
                <a:cubicBezTo>
                  <a:pt x="28" y="2121"/>
                  <a:pt x="30" y="2120"/>
                  <a:pt x="32" y="2119"/>
                </a:cubicBezTo>
                <a:cubicBezTo>
                  <a:pt x="34" y="2118"/>
                  <a:pt x="36" y="2117"/>
                  <a:pt x="38" y="2118"/>
                </a:cubicBezTo>
                <a:cubicBezTo>
                  <a:pt x="39" y="2118"/>
                  <a:pt x="40" y="2119"/>
                  <a:pt x="42" y="2120"/>
                </a:cubicBezTo>
                <a:lnTo>
                  <a:pt x="160" y="2239"/>
                </a:lnTo>
                <a:lnTo>
                  <a:pt x="295" y="2104"/>
                </a:lnTo>
                <a:lnTo>
                  <a:pt x="177" y="1985"/>
                </a:lnTo>
                <a:cubicBezTo>
                  <a:pt x="175" y="1984"/>
                  <a:pt x="175" y="1982"/>
                  <a:pt x="174" y="1981"/>
                </a:cubicBezTo>
                <a:cubicBezTo>
                  <a:pt x="174" y="1979"/>
                  <a:pt x="174" y="1977"/>
                  <a:pt x="175" y="1975"/>
                </a:cubicBezTo>
                <a:cubicBezTo>
                  <a:pt x="176" y="1973"/>
                  <a:pt x="178" y="1971"/>
                  <a:pt x="180" y="1968"/>
                </a:cubicBezTo>
                <a:cubicBezTo>
                  <a:pt x="182" y="1965"/>
                  <a:pt x="185" y="1962"/>
                  <a:pt x="189" y="1958"/>
                </a:cubicBezTo>
                <a:cubicBezTo>
                  <a:pt x="193" y="1954"/>
                  <a:pt x="196" y="1951"/>
                  <a:pt x="199" y="1949"/>
                </a:cubicBezTo>
                <a:cubicBezTo>
                  <a:pt x="202" y="1947"/>
                  <a:pt x="204" y="1945"/>
                  <a:pt x="206" y="1944"/>
                </a:cubicBezTo>
                <a:cubicBezTo>
                  <a:pt x="208" y="1943"/>
                  <a:pt x="210" y="1943"/>
                  <a:pt x="212" y="1943"/>
                </a:cubicBezTo>
                <a:cubicBezTo>
                  <a:pt x="213" y="1944"/>
                  <a:pt x="215" y="1944"/>
                  <a:pt x="216" y="1946"/>
                </a:cubicBezTo>
                <a:lnTo>
                  <a:pt x="501" y="2230"/>
                </a:lnTo>
                <a:close/>
                <a:moveTo>
                  <a:pt x="663" y="1857"/>
                </a:moveTo>
                <a:cubicBezTo>
                  <a:pt x="680" y="1874"/>
                  <a:pt x="693" y="1892"/>
                  <a:pt x="703" y="1910"/>
                </a:cubicBezTo>
                <a:cubicBezTo>
                  <a:pt x="713" y="1929"/>
                  <a:pt x="718" y="1948"/>
                  <a:pt x="720" y="1967"/>
                </a:cubicBezTo>
                <a:cubicBezTo>
                  <a:pt x="721" y="1986"/>
                  <a:pt x="718" y="2005"/>
                  <a:pt x="711" y="2024"/>
                </a:cubicBezTo>
                <a:cubicBezTo>
                  <a:pt x="703" y="2043"/>
                  <a:pt x="691" y="2061"/>
                  <a:pt x="674" y="2078"/>
                </a:cubicBezTo>
                <a:cubicBezTo>
                  <a:pt x="657" y="2095"/>
                  <a:pt x="639" y="2107"/>
                  <a:pt x="622" y="2115"/>
                </a:cubicBezTo>
                <a:cubicBezTo>
                  <a:pt x="604" y="2123"/>
                  <a:pt x="586" y="2126"/>
                  <a:pt x="568" y="2124"/>
                </a:cubicBezTo>
                <a:cubicBezTo>
                  <a:pt x="550" y="2123"/>
                  <a:pt x="532" y="2118"/>
                  <a:pt x="514" y="2108"/>
                </a:cubicBezTo>
                <a:cubicBezTo>
                  <a:pt x="496" y="2099"/>
                  <a:pt x="479" y="2085"/>
                  <a:pt x="461" y="2068"/>
                </a:cubicBezTo>
                <a:cubicBezTo>
                  <a:pt x="444" y="2051"/>
                  <a:pt x="431" y="2033"/>
                  <a:pt x="421" y="2015"/>
                </a:cubicBezTo>
                <a:cubicBezTo>
                  <a:pt x="412" y="1996"/>
                  <a:pt x="406" y="1977"/>
                  <a:pt x="404" y="1958"/>
                </a:cubicBezTo>
                <a:cubicBezTo>
                  <a:pt x="403" y="1939"/>
                  <a:pt x="406" y="1920"/>
                  <a:pt x="414" y="1902"/>
                </a:cubicBezTo>
                <a:cubicBezTo>
                  <a:pt x="421" y="1883"/>
                  <a:pt x="434" y="1865"/>
                  <a:pt x="451" y="1847"/>
                </a:cubicBezTo>
                <a:cubicBezTo>
                  <a:pt x="468" y="1830"/>
                  <a:pt x="485" y="1818"/>
                  <a:pt x="503" y="1810"/>
                </a:cubicBezTo>
                <a:cubicBezTo>
                  <a:pt x="521" y="1803"/>
                  <a:pt x="539" y="1800"/>
                  <a:pt x="557" y="1801"/>
                </a:cubicBezTo>
                <a:cubicBezTo>
                  <a:pt x="575" y="1802"/>
                  <a:pt x="593" y="1807"/>
                  <a:pt x="611" y="1817"/>
                </a:cubicBezTo>
                <a:cubicBezTo>
                  <a:pt x="629" y="1826"/>
                  <a:pt x="646" y="1840"/>
                  <a:pt x="663" y="1857"/>
                </a:cubicBezTo>
                <a:close/>
                <a:moveTo>
                  <a:pt x="627" y="1899"/>
                </a:moveTo>
                <a:cubicBezTo>
                  <a:pt x="616" y="1888"/>
                  <a:pt x="604" y="1878"/>
                  <a:pt x="592" y="1870"/>
                </a:cubicBezTo>
                <a:cubicBezTo>
                  <a:pt x="580" y="1863"/>
                  <a:pt x="568" y="1857"/>
                  <a:pt x="556" y="1855"/>
                </a:cubicBezTo>
                <a:cubicBezTo>
                  <a:pt x="543" y="1852"/>
                  <a:pt x="531" y="1852"/>
                  <a:pt x="518" y="1856"/>
                </a:cubicBezTo>
                <a:cubicBezTo>
                  <a:pt x="506" y="1860"/>
                  <a:pt x="493" y="1868"/>
                  <a:pt x="481" y="1880"/>
                </a:cubicBezTo>
                <a:cubicBezTo>
                  <a:pt x="470" y="1891"/>
                  <a:pt x="462" y="1903"/>
                  <a:pt x="458" y="1915"/>
                </a:cubicBezTo>
                <a:cubicBezTo>
                  <a:pt x="454" y="1927"/>
                  <a:pt x="453" y="1940"/>
                  <a:pt x="455" y="1952"/>
                </a:cubicBezTo>
                <a:cubicBezTo>
                  <a:pt x="457" y="1965"/>
                  <a:pt x="462" y="1977"/>
                  <a:pt x="469" y="1990"/>
                </a:cubicBezTo>
                <a:cubicBezTo>
                  <a:pt x="477" y="2002"/>
                  <a:pt x="486" y="2014"/>
                  <a:pt x="498" y="2026"/>
                </a:cubicBezTo>
                <a:cubicBezTo>
                  <a:pt x="509" y="2037"/>
                  <a:pt x="521" y="2047"/>
                  <a:pt x="533" y="2055"/>
                </a:cubicBezTo>
                <a:cubicBezTo>
                  <a:pt x="545" y="2063"/>
                  <a:pt x="557" y="2068"/>
                  <a:pt x="569" y="2070"/>
                </a:cubicBezTo>
                <a:cubicBezTo>
                  <a:pt x="582" y="2073"/>
                  <a:pt x="594" y="2072"/>
                  <a:pt x="607" y="2068"/>
                </a:cubicBezTo>
                <a:cubicBezTo>
                  <a:pt x="619" y="2065"/>
                  <a:pt x="631" y="2057"/>
                  <a:pt x="644" y="2044"/>
                </a:cubicBezTo>
                <a:cubicBezTo>
                  <a:pt x="655" y="2033"/>
                  <a:pt x="662" y="2022"/>
                  <a:pt x="667" y="2009"/>
                </a:cubicBezTo>
                <a:cubicBezTo>
                  <a:pt x="671" y="1997"/>
                  <a:pt x="672" y="1985"/>
                  <a:pt x="670" y="1973"/>
                </a:cubicBezTo>
                <a:cubicBezTo>
                  <a:pt x="668" y="1960"/>
                  <a:pt x="663" y="1948"/>
                  <a:pt x="656" y="1935"/>
                </a:cubicBezTo>
                <a:cubicBezTo>
                  <a:pt x="648" y="1923"/>
                  <a:pt x="639" y="1911"/>
                  <a:pt x="627" y="1899"/>
                </a:cubicBezTo>
                <a:close/>
                <a:moveTo>
                  <a:pt x="1132" y="1600"/>
                </a:moveTo>
                <a:cubicBezTo>
                  <a:pt x="1133" y="1601"/>
                  <a:pt x="1134" y="1602"/>
                  <a:pt x="1134" y="1604"/>
                </a:cubicBezTo>
                <a:cubicBezTo>
                  <a:pt x="1134" y="1605"/>
                  <a:pt x="1134" y="1607"/>
                  <a:pt x="1133" y="1609"/>
                </a:cubicBezTo>
                <a:cubicBezTo>
                  <a:pt x="1133" y="1611"/>
                  <a:pt x="1131" y="1613"/>
                  <a:pt x="1129" y="1616"/>
                </a:cubicBezTo>
                <a:cubicBezTo>
                  <a:pt x="1127" y="1619"/>
                  <a:pt x="1124" y="1622"/>
                  <a:pt x="1120" y="1625"/>
                </a:cubicBezTo>
                <a:cubicBezTo>
                  <a:pt x="1116" y="1629"/>
                  <a:pt x="1113" y="1632"/>
                  <a:pt x="1110" y="1634"/>
                </a:cubicBezTo>
                <a:cubicBezTo>
                  <a:pt x="1108" y="1637"/>
                  <a:pt x="1105" y="1638"/>
                  <a:pt x="1103" y="1639"/>
                </a:cubicBezTo>
                <a:cubicBezTo>
                  <a:pt x="1101" y="1640"/>
                  <a:pt x="1099" y="1640"/>
                  <a:pt x="1098" y="1640"/>
                </a:cubicBezTo>
                <a:cubicBezTo>
                  <a:pt x="1096" y="1640"/>
                  <a:pt x="1095" y="1639"/>
                  <a:pt x="1094" y="1638"/>
                </a:cubicBezTo>
                <a:lnTo>
                  <a:pt x="968" y="1512"/>
                </a:lnTo>
                <a:cubicBezTo>
                  <a:pt x="960" y="1504"/>
                  <a:pt x="951" y="1496"/>
                  <a:pt x="942" y="1491"/>
                </a:cubicBezTo>
                <a:cubicBezTo>
                  <a:pt x="934" y="1485"/>
                  <a:pt x="925" y="1481"/>
                  <a:pt x="916" y="1479"/>
                </a:cubicBezTo>
                <a:cubicBezTo>
                  <a:pt x="908" y="1478"/>
                  <a:pt x="900" y="1478"/>
                  <a:pt x="892" y="1480"/>
                </a:cubicBezTo>
                <a:cubicBezTo>
                  <a:pt x="884" y="1483"/>
                  <a:pt x="876" y="1488"/>
                  <a:pt x="869" y="1495"/>
                </a:cubicBezTo>
                <a:cubicBezTo>
                  <a:pt x="861" y="1503"/>
                  <a:pt x="855" y="1515"/>
                  <a:pt x="853" y="1531"/>
                </a:cubicBezTo>
                <a:cubicBezTo>
                  <a:pt x="851" y="1546"/>
                  <a:pt x="851" y="1566"/>
                  <a:pt x="854" y="1589"/>
                </a:cubicBezTo>
                <a:lnTo>
                  <a:pt x="998" y="1734"/>
                </a:lnTo>
                <a:cubicBezTo>
                  <a:pt x="999" y="1735"/>
                  <a:pt x="1000" y="1736"/>
                  <a:pt x="1000" y="1738"/>
                </a:cubicBezTo>
                <a:cubicBezTo>
                  <a:pt x="1000" y="1739"/>
                  <a:pt x="1000" y="1741"/>
                  <a:pt x="999" y="1743"/>
                </a:cubicBezTo>
                <a:cubicBezTo>
                  <a:pt x="998" y="1745"/>
                  <a:pt x="997" y="1747"/>
                  <a:pt x="995" y="1750"/>
                </a:cubicBezTo>
                <a:cubicBezTo>
                  <a:pt x="992" y="1753"/>
                  <a:pt x="990" y="1756"/>
                  <a:pt x="986" y="1760"/>
                </a:cubicBezTo>
                <a:cubicBezTo>
                  <a:pt x="982" y="1763"/>
                  <a:pt x="979" y="1766"/>
                  <a:pt x="976" y="1768"/>
                </a:cubicBezTo>
                <a:cubicBezTo>
                  <a:pt x="974" y="1771"/>
                  <a:pt x="971" y="1772"/>
                  <a:pt x="969" y="1773"/>
                </a:cubicBezTo>
                <a:cubicBezTo>
                  <a:pt x="967" y="1774"/>
                  <a:pt x="965" y="1774"/>
                  <a:pt x="964" y="1774"/>
                </a:cubicBezTo>
                <a:cubicBezTo>
                  <a:pt x="963" y="1773"/>
                  <a:pt x="961" y="1773"/>
                  <a:pt x="960" y="1772"/>
                </a:cubicBezTo>
                <a:lnTo>
                  <a:pt x="835" y="1646"/>
                </a:lnTo>
                <a:cubicBezTo>
                  <a:pt x="826" y="1637"/>
                  <a:pt x="817" y="1630"/>
                  <a:pt x="808" y="1625"/>
                </a:cubicBezTo>
                <a:cubicBezTo>
                  <a:pt x="799" y="1619"/>
                  <a:pt x="791" y="1616"/>
                  <a:pt x="782" y="1614"/>
                </a:cubicBezTo>
                <a:cubicBezTo>
                  <a:pt x="774" y="1612"/>
                  <a:pt x="765" y="1612"/>
                  <a:pt x="757" y="1615"/>
                </a:cubicBezTo>
                <a:cubicBezTo>
                  <a:pt x="750" y="1617"/>
                  <a:pt x="742" y="1622"/>
                  <a:pt x="735" y="1629"/>
                </a:cubicBezTo>
                <a:cubicBezTo>
                  <a:pt x="726" y="1637"/>
                  <a:pt x="721" y="1650"/>
                  <a:pt x="719" y="1665"/>
                </a:cubicBezTo>
                <a:cubicBezTo>
                  <a:pt x="717" y="1681"/>
                  <a:pt x="717" y="1700"/>
                  <a:pt x="720" y="1724"/>
                </a:cubicBezTo>
                <a:lnTo>
                  <a:pt x="864" y="1868"/>
                </a:lnTo>
                <a:cubicBezTo>
                  <a:pt x="865" y="1869"/>
                  <a:pt x="866" y="1870"/>
                  <a:pt x="866" y="1872"/>
                </a:cubicBezTo>
                <a:cubicBezTo>
                  <a:pt x="866" y="1873"/>
                  <a:pt x="866" y="1875"/>
                  <a:pt x="865" y="1877"/>
                </a:cubicBezTo>
                <a:cubicBezTo>
                  <a:pt x="864" y="1879"/>
                  <a:pt x="863" y="1881"/>
                  <a:pt x="861" y="1884"/>
                </a:cubicBezTo>
                <a:cubicBezTo>
                  <a:pt x="859" y="1887"/>
                  <a:pt x="856" y="1890"/>
                  <a:pt x="852" y="1894"/>
                </a:cubicBezTo>
                <a:cubicBezTo>
                  <a:pt x="848" y="1898"/>
                  <a:pt x="845" y="1901"/>
                  <a:pt x="842" y="1903"/>
                </a:cubicBezTo>
                <a:cubicBezTo>
                  <a:pt x="839" y="1905"/>
                  <a:pt x="837" y="1906"/>
                  <a:pt x="835" y="1907"/>
                </a:cubicBezTo>
                <a:cubicBezTo>
                  <a:pt x="833" y="1908"/>
                  <a:pt x="831" y="1908"/>
                  <a:pt x="830" y="1908"/>
                </a:cubicBezTo>
                <a:cubicBezTo>
                  <a:pt x="828" y="1908"/>
                  <a:pt x="827" y="1907"/>
                  <a:pt x="826" y="1906"/>
                </a:cubicBezTo>
                <a:lnTo>
                  <a:pt x="620" y="1699"/>
                </a:lnTo>
                <a:cubicBezTo>
                  <a:pt x="618" y="1698"/>
                  <a:pt x="618" y="1697"/>
                  <a:pt x="617" y="1696"/>
                </a:cubicBezTo>
                <a:cubicBezTo>
                  <a:pt x="617" y="1694"/>
                  <a:pt x="617" y="1693"/>
                  <a:pt x="618" y="1690"/>
                </a:cubicBezTo>
                <a:cubicBezTo>
                  <a:pt x="618" y="1688"/>
                  <a:pt x="620" y="1686"/>
                  <a:pt x="622" y="1684"/>
                </a:cubicBezTo>
                <a:cubicBezTo>
                  <a:pt x="623" y="1681"/>
                  <a:pt x="626" y="1679"/>
                  <a:pt x="630" y="1675"/>
                </a:cubicBezTo>
                <a:cubicBezTo>
                  <a:pt x="633" y="1672"/>
                  <a:pt x="636" y="1669"/>
                  <a:pt x="638" y="1667"/>
                </a:cubicBezTo>
                <a:cubicBezTo>
                  <a:pt x="641" y="1665"/>
                  <a:pt x="643" y="1664"/>
                  <a:pt x="645" y="1663"/>
                </a:cubicBezTo>
                <a:cubicBezTo>
                  <a:pt x="647" y="1663"/>
                  <a:pt x="648" y="1663"/>
                  <a:pt x="650" y="1663"/>
                </a:cubicBezTo>
                <a:cubicBezTo>
                  <a:pt x="651" y="1663"/>
                  <a:pt x="652" y="1664"/>
                  <a:pt x="654" y="1665"/>
                </a:cubicBezTo>
                <a:lnTo>
                  <a:pt x="681" y="1692"/>
                </a:lnTo>
                <a:cubicBezTo>
                  <a:pt x="680" y="1668"/>
                  <a:pt x="681" y="1647"/>
                  <a:pt x="686" y="1630"/>
                </a:cubicBezTo>
                <a:cubicBezTo>
                  <a:pt x="691" y="1613"/>
                  <a:pt x="699" y="1599"/>
                  <a:pt x="710" y="1588"/>
                </a:cubicBezTo>
                <a:cubicBezTo>
                  <a:pt x="719" y="1579"/>
                  <a:pt x="728" y="1573"/>
                  <a:pt x="736" y="1568"/>
                </a:cubicBezTo>
                <a:cubicBezTo>
                  <a:pt x="745" y="1563"/>
                  <a:pt x="754" y="1560"/>
                  <a:pt x="763" y="1558"/>
                </a:cubicBezTo>
                <a:cubicBezTo>
                  <a:pt x="772" y="1557"/>
                  <a:pt x="780" y="1556"/>
                  <a:pt x="789" y="1558"/>
                </a:cubicBezTo>
                <a:cubicBezTo>
                  <a:pt x="798" y="1559"/>
                  <a:pt x="806" y="1562"/>
                  <a:pt x="815" y="1565"/>
                </a:cubicBezTo>
                <a:cubicBezTo>
                  <a:pt x="814" y="1551"/>
                  <a:pt x="814" y="1538"/>
                  <a:pt x="815" y="1527"/>
                </a:cubicBezTo>
                <a:cubicBezTo>
                  <a:pt x="816" y="1515"/>
                  <a:pt x="818" y="1505"/>
                  <a:pt x="821" y="1496"/>
                </a:cubicBezTo>
                <a:cubicBezTo>
                  <a:pt x="823" y="1487"/>
                  <a:pt x="826" y="1479"/>
                  <a:pt x="830" y="1472"/>
                </a:cubicBezTo>
                <a:cubicBezTo>
                  <a:pt x="834" y="1465"/>
                  <a:pt x="839" y="1459"/>
                  <a:pt x="844" y="1454"/>
                </a:cubicBezTo>
                <a:cubicBezTo>
                  <a:pt x="858" y="1440"/>
                  <a:pt x="871" y="1432"/>
                  <a:pt x="885" y="1427"/>
                </a:cubicBezTo>
                <a:cubicBezTo>
                  <a:pt x="899" y="1423"/>
                  <a:pt x="912" y="1422"/>
                  <a:pt x="926" y="1424"/>
                </a:cubicBezTo>
                <a:cubicBezTo>
                  <a:pt x="939" y="1426"/>
                  <a:pt x="952" y="1431"/>
                  <a:pt x="965" y="1440"/>
                </a:cubicBezTo>
                <a:cubicBezTo>
                  <a:pt x="978" y="1448"/>
                  <a:pt x="990" y="1458"/>
                  <a:pt x="1002" y="1469"/>
                </a:cubicBezTo>
                <a:lnTo>
                  <a:pt x="1132" y="1600"/>
                </a:lnTo>
                <a:close/>
                <a:moveTo>
                  <a:pt x="1286" y="1235"/>
                </a:moveTo>
                <a:cubicBezTo>
                  <a:pt x="1302" y="1252"/>
                  <a:pt x="1316" y="1269"/>
                  <a:pt x="1325" y="1288"/>
                </a:cubicBezTo>
                <a:cubicBezTo>
                  <a:pt x="1335" y="1307"/>
                  <a:pt x="1341" y="1325"/>
                  <a:pt x="1342" y="1344"/>
                </a:cubicBezTo>
                <a:cubicBezTo>
                  <a:pt x="1344" y="1363"/>
                  <a:pt x="1341" y="1382"/>
                  <a:pt x="1333" y="1401"/>
                </a:cubicBezTo>
                <a:cubicBezTo>
                  <a:pt x="1326" y="1420"/>
                  <a:pt x="1313" y="1439"/>
                  <a:pt x="1296" y="1456"/>
                </a:cubicBezTo>
                <a:cubicBezTo>
                  <a:pt x="1279" y="1473"/>
                  <a:pt x="1261" y="1485"/>
                  <a:pt x="1244" y="1493"/>
                </a:cubicBezTo>
                <a:cubicBezTo>
                  <a:pt x="1226" y="1500"/>
                  <a:pt x="1208" y="1503"/>
                  <a:pt x="1190" y="1502"/>
                </a:cubicBezTo>
                <a:cubicBezTo>
                  <a:pt x="1172" y="1501"/>
                  <a:pt x="1154" y="1496"/>
                  <a:pt x="1136" y="1486"/>
                </a:cubicBezTo>
                <a:cubicBezTo>
                  <a:pt x="1119" y="1476"/>
                  <a:pt x="1101" y="1463"/>
                  <a:pt x="1083" y="1445"/>
                </a:cubicBezTo>
                <a:cubicBezTo>
                  <a:pt x="1067" y="1429"/>
                  <a:pt x="1053" y="1411"/>
                  <a:pt x="1044" y="1392"/>
                </a:cubicBezTo>
                <a:cubicBezTo>
                  <a:pt x="1034" y="1374"/>
                  <a:pt x="1028" y="1355"/>
                  <a:pt x="1027" y="1336"/>
                </a:cubicBezTo>
                <a:cubicBezTo>
                  <a:pt x="1025" y="1317"/>
                  <a:pt x="1028" y="1298"/>
                  <a:pt x="1036" y="1279"/>
                </a:cubicBezTo>
                <a:cubicBezTo>
                  <a:pt x="1043" y="1261"/>
                  <a:pt x="1056" y="1242"/>
                  <a:pt x="1073" y="1225"/>
                </a:cubicBezTo>
                <a:cubicBezTo>
                  <a:pt x="1090" y="1208"/>
                  <a:pt x="1108" y="1196"/>
                  <a:pt x="1125" y="1188"/>
                </a:cubicBezTo>
                <a:cubicBezTo>
                  <a:pt x="1143" y="1180"/>
                  <a:pt x="1161" y="1177"/>
                  <a:pt x="1179" y="1179"/>
                </a:cubicBezTo>
                <a:cubicBezTo>
                  <a:pt x="1197" y="1180"/>
                  <a:pt x="1215" y="1185"/>
                  <a:pt x="1233" y="1195"/>
                </a:cubicBezTo>
                <a:cubicBezTo>
                  <a:pt x="1251" y="1204"/>
                  <a:pt x="1268" y="1218"/>
                  <a:pt x="1286" y="1235"/>
                </a:cubicBezTo>
                <a:close/>
                <a:moveTo>
                  <a:pt x="1249" y="1277"/>
                </a:moveTo>
                <a:cubicBezTo>
                  <a:pt x="1238" y="1265"/>
                  <a:pt x="1226" y="1256"/>
                  <a:pt x="1214" y="1248"/>
                </a:cubicBezTo>
                <a:cubicBezTo>
                  <a:pt x="1202" y="1240"/>
                  <a:pt x="1190" y="1235"/>
                  <a:pt x="1178" y="1232"/>
                </a:cubicBezTo>
                <a:cubicBezTo>
                  <a:pt x="1166" y="1230"/>
                  <a:pt x="1153" y="1230"/>
                  <a:pt x="1141" y="1234"/>
                </a:cubicBezTo>
                <a:cubicBezTo>
                  <a:pt x="1128" y="1238"/>
                  <a:pt x="1116" y="1246"/>
                  <a:pt x="1104" y="1258"/>
                </a:cubicBezTo>
                <a:cubicBezTo>
                  <a:pt x="1092" y="1269"/>
                  <a:pt x="1085" y="1281"/>
                  <a:pt x="1080" y="1293"/>
                </a:cubicBezTo>
                <a:cubicBezTo>
                  <a:pt x="1076" y="1305"/>
                  <a:pt x="1075" y="1317"/>
                  <a:pt x="1077" y="1330"/>
                </a:cubicBezTo>
                <a:cubicBezTo>
                  <a:pt x="1079" y="1342"/>
                  <a:pt x="1084" y="1355"/>
                  <a:pt x="1091" y="1367"/>
                </a:cubicBezTo>
                <a:cubicBezTo>
                  <a:pt x="1099" y="1380"/>
                  <a:pt x="1108" y="1392"/>
                  <a:pt x="1120" y="1404"/>
                </a:cubicBezTo>
                <a:cubicBezTo>
                  <a:pt x="1131" y="1415"/>
                  <a:pt x="1143" y="1425"/>
                  <a:pt x="1155" y="1432"/>
                </a:cubicBezTo>
                <a:cubicBezTo>
                  <a:pt x="1167" y="1440"/>
                  <a:pt x="1179" y="1445"/>
                  <a:pt x="1192" y="1448"/>
                </a:cubicBezTo>
                <a:cubicBezTo>
                  <a:pt x="1204" y="1451"/>
                  <a:pt x="1216" y="1450"/>
                  <a:pt x="1229" y="1446"/>
                </a:cubicBezTo>
                <a:cubicBezTo>
                  <a:pt x="1241" y="1442"/>
                  <a:pt x="1254" y="1434"/>
                  <a:pt x="1266" y="1422"/>
                </a:cubicBezTo>
                <a:cubicBezTo>
                  <a:pt x="1277" y="1411"/>
                  <a:pt x="1285" y="1399"/>
                  <a:pt x="1289" y="1387"/>
                </a:cubicBezTo>
                <a:cubicBezTo>
                  <a:pt x="1293" y="1375"/>
                  <a:pt x="1294" y="1363"/>
                  <a:pt x="1292" y="1350"/>
                </a:cubicBezTo>
                <a:cubicBezTo>
                  <a:pt x="1290" y="1338"/>
                  <a:pt x="1286" y="1326"/>
                  <a:pt x="1278" y="1313"/>
                </a:cubicBezTo>
                <a:cubicBezTo>
                  <a:pt x="1271" y="1301"/>
                  <a:pt x="1261" y="1289"/>
                  <a:pt x="1249" y="1277"/>
                </a:cubicBezTo>
                <a:close/>
                <a:moveTo>
                  <a:pt x="1522" y="1098"/>
                </a:moveTo>
                <a:cubicBezTo>
                  <a:pt x="1532" y="1108"/>
                  <a:pt x="1540" y="1120"/>
                  <a:pt x="1544" y="1132"/>
                </a:cubicBezTo>
                <a:cubicBezTo>
                  <a:pt x="1548" y="1144"/>
                  <a:pt x="1550" y="1156"/>
                  <a:pt x="1548" y="1169"/>
                </a:cubicBezTo>
                <a:cubicBezTo>
                  <a:pt x="1547" y="1182"/>
                  <a:pt x="1542" y="1195"/>
                  <a:pt x="1535" y="1208"/>
                </a:cubicBezTo>
                <a:cubicBezTo>
                  <a:pt x="1528" y="1221"/>
                  <a:pt x="1519" y="1233"/>
                  <a:pt x="1507" y="1245"/>
                </a:cubicBezTo>
                <a:cubicBezTo>
                  <a:pt x="1500" y="1252"/>
                  <a:pt x="1492" y="1259"/>
                  <a:pt x="1484" y="1264"/>
                </a:cubicBezTo>
                <a:cubicBezTo>
                  <a:pt x="1476" y="1270"/>
                  <a:pt x="1469" y="1274"/>
                  <a:pt x="1462" y="1278"/>
                </a:cubicBezTo>
                <a:cubicBezTo>
                  <a:pt x="1455" y="1281"/>
                  <a:pt x="1449" y="1284"/>
                  <a:pt x="1443" y="1286"/>
                </a:cubicBezTo>
                <a:cubicBezTo>
                  <a:pt x="1437" y="1287"/>
                  <a:pt x="1433" y="1288"/>
                  <a:pt x="1430" y="1288"/>
                </a:cubicBezTo>
                <a:cubicBezTo>
                  <a:pt x="1427" y="1289"/>
                  <a:pt x="1423" y="1288"/>
                  <a:pt x="1420" y="1286"/>
                </a:cubicBezTo>
                <a:cubicBezTo>
                  <a:pt x="1416" y="1284"/>
                  <a:pt x="1412" y="1280"/>
                  <a:pt x="1407" y="1276"/>
                </a:cubicBezTo>
                <a:cubicBezTo>
                  <a:pt x="1404" y="1273"/>
                  <a:pt x="1402" y="1270"/>
                  <a:pt x="1400" y="1268"/>
                </a:cubicBezTo>
                <a:cubicBezTo>
                  <a:pt x="1399" y="1265"/>
                  <a:pt x="1398" y="1264"/>
                  <a:pt x="1397" y="1262"/>
                </a:cubicBezTo>
                <a:cubicBezTo>
                  <a:pt x="1396" y="1260"/>
                  <a:pt x="1396" y="1259"/>
                  <a:pt x="1396" y="1257"/>
                </a:cubicBezTo>
                <a:cubicBezTo>
                  <a:pt x="1396" y="1256"/>
                  <a:pt x="1397" y="1255"/>
                  <a:pt x="1398" y="1254"/>
                </a:cubicBezTo>
                <a:cubicBezTo>
                  <a:pt x="1400" y="1252"/>
                  <a:pt x="1403" y="1250"/>
                  <a:pt x="1409" y="1249"/>
                </a:cubicBezTo>
                <a:cubicBezTo>
                  <a:pt x="1414" y="1248"/>
                  <a:pt x="1420" y="1246"/>
                  <a:pt x="1428" y="1244"/>
                </a:cubicBezTo>
                <a:cubicBezTo>
                  <a:pt x="1435" y="1241"/>
                  <a:pt x="1443" y="1238"/>
                  <a:pt x="1451" y="1234"/>
                </a:cubicBezTo>
                <a:cubicBezTo>
                  <a:pt x="1460" y="1229"/>
                  <a:pt x="1469" y="1222"/>
                  <a:pt x="1477" y="1214"/>
                </a:cubicBezTo>
                <a:cubicBezTo>
                  <a:pt x="1484" y="1207"/>
                  <a:pt x="1489" y="1201"/>
                  <a:pt x="1493" y="1194"/>
                </a:cubicBezTo>
                <a:cubicBezTo>
                  <a:pt x="1496" y="1188"/>
                  <a:pt x="1499" y="1181"/>
                  <a:pt x="1500" y="1175"/>
                </a:cubicBezTo>
                <a:cubicBezTo>
                  <a:pt x="1501" y="1168"/>
                  <a:pt x="1501" y="1162"/>
                  <a:pt x="1499" y="1156"/>
                </a:cubicBezTo>
                <a:cubicBezTo>
                  <a:pt x="1497" y="1150"/>
                  <a:pt x="1493" y="1144"/>
                  <a:pt x="1487" y="1138"/>
                </a:cubicBezTo>
                <a:cubicBezTo>
                  <a:pt x="1481" y="1132"/>
                  <a:pt x="1475" y="1129"/>
                  <a:pt x="1468" y="1128"/>
                </a:cubicBezTo>
                <a:cubicBezTo>
                  <a:pt x="1461" y="1127"/>
                  <a:pt x="1454" y="1127"/>
                  <a:pt x="1446" y="1129"/>
                </a:cubicBezTo>
                <a:cubicBezTo>
                  <a:pt x="1438" y="1131"/>
                  <a:pt x="1429" y="1134"/>
                  <a:pt x="1421" y="1137"/>
                </a:cubicBezTo>
                <a:cubicBezTo>
                  <a:pt x="1412" y="1141"/>
                  <a:pt x="1404" y="1145"/>
                  <a:pt x="1395" y="1149"/>
                </a:cubicBezTo>
                <a:cubicBezTo>
                  <a:pt x="1386" y="1153"/>
                  <a:pt x="1376" y="1156"/>
                  <a:pt x="1367" y="1159"/>
                </a:cubicBezTo>
                <a:cubicBezTo>
                  <a:pt x="1357" y="1162"/>
                  <a:pt x="1348" y="1164"/>
                  <a:pt x="1338" y="1164"/>
                </a:cubicBezTo>
                <a:cubicBezTo>
                  <a:pt x="1328" y="1164"/>
                  <a:pt x="1319" y="1162"/>
                  <a:pt x="1309" y="1159"/>
                </a:cubicBezTo>
                <a:cubicBezTo>
                  <a:pt x="1300" y="1155"/>
                  <a:pt x="1290" y="1149"/>
                  <a:pt x="1281" y="1139"/>
                </a:cubicBezTo>
                <a:cubicBezTo>
                  <a:pt x="1273" y="1131"/>
                  <a:pt x="1267" y="1122"/>
                  <a:pt x="1263" y="1111"/>
                </a:cubicBezTo>
                <a:cubicBezTo>
                  <a:pt x="1258" y="1101"/>
                  <a:pt x="1257" y="1090"/>
                  <a:pt x="1257" y="1078"/>
                </a:cubicBezTo>
                <a:cubicBezTo>
                  <a:pt x="1258" y="1066"/>
                  <a:pt x="1261" y="1054"/>
                  <a:pt x="1267" y="1041"/>
                </a:cubicBezTo>
                <a:cubicBezTo>
                  <a:pt x="1273" y="1028"/>
                  <a:pt x="1283" y="1016"/>
                  <a:pt x="1295" y="1003"/>
                </a:cubicBezTo>
                <a:cubicBezTo>
                  <a:pt x="1301" y="997"/>
                  <a:pt x="1307" y="992"/>
                  <a:pt x="1313" y="988"/>
                </a:cubicBezTo>
                <a:cubicBezTo>
                  <a:pt x="1320" y="983"/>
                  <a:pt x="1326" y="979"/>
                  <a:pt x="1331" y="976"/>
                </a:cubicBezTo>
                <a:cubicBezTo>
                  <a:pt x="1337" y="973"/>
                  <a:pt x="1343" y="971"/>
                  <a:pt x="1347" y="970"/>
                </a:cubicBezTo>
                <a:cubicBezTo>
                  <a:pt x="1352" y="968"/>
                  <a:pt x="1356" y="967"/>
                  <a:pt x="1359" y="967"/>
                </a:cubicBezTo>
                <a:cubicBezTo>
                  <a:pt x="1361" y="966"/>
                  <a:pt x="1364" y="966"/>
                  <a:pt x="1365" y="967"/>
                </a:cubicBezTo>
                <a:cubicBezTo>
                  <a:pt x="1366" y="967"/>
                  <a:pt x="1368" y="968"/>
                  <a:pt x="1369" y="969"/>
                </a:cubicBezTo>
                <a:cubicBezTo>
                  <a:pt x="1371" y="970"/>
                  <a:pt x="1372" y="971"/>
                  <a:pt x="1374" y="972"/>
                </a:cubicBezTo>
                <a:cubicBezTo>
                  <a:pt x="1376" y="974"/>
                  <a:pt x="1378" y="976"/>
                  <a:pt x="1381" y="978"/>
                </a:cubicBezTo>
                <a:cubicBezTo>
                  <a:pt x="1383" y="981"/>
                  <a:pt x="1385" y="983"/>
                  <a:pt x="1387" y="985"/>
                </a:cubicBezTo>
                <a:cubicBezTo>
                  <a:pt x="1389" y="987"/>
                  <a:pt x="1390" y="989"/>
                  <a:pt x="1391" y="991"/>
                </a:cubicBezTo>
                <a:cubicBezTo>
                  <a:pt x="1391" y="993"/>
                  <a:pt x="1392" y="994"/>
                  <a:pt x="1391" y="996"/>
                </a:cubicBezTo>
                <a:cubicBezTo>
                  <a:pt x="1391" y="997"/>
                  <a:pt x="1391" y="998"/>
                  <a:pt x="1390" y="999"/>
                </a:cubicBezTo>
                <a:cubicBezTo>
                  <a:pt x="1388" y="1000"/>
                  <a:pt x="1385" y="1001"/>
                  <a:pt x="1381" y="1002"/>
                </a:cubicBezTo>
                <a:cubicBezTo>
                  <a:pt x="1377" y="1003"/>
                  <a:pt x="1372" y="1005"/>
                  <a:pt x="1366" y="1007"/>
                </a:cubicBezTo>
                <a:cubicBezTo>
                  <a:pt x="1360" y="1009"/>
                  <a:pt x="1353" y="1012"/>
                  <a:pt x="1346" y="1016"/>
                </a:cubicBezTo>
                <a:cubicBezTo>
                  <a:pt x="1339" y="1020"/>
                  <a:pt x="1331" y="1026"/>
                  <a:pt x="1324" y="1033"/>
                </a:cubicBezTo>
                <a:cubicBezTo>
                  <a:pt x="1318" y="1039"/>
                  <a:pt x="1313" y="1046"/>
                  <a:pt x="1309" y="1052"/>
                </a:cubicBezTo>
                <a:cubicBezTo>
                  <a:pt x="1306" y="1058"/>
                  <a:pt x="1304" y="1064"/>
                  <a:pt x="1303" y="1070"/>
                </a:cubicBezTo>
                <a:cubicBezTo>
                  <a:pt x="1303" y="1076"/>
                  <a:pt x="1304" y="1082"/>
                  <a:pt x="1306" y="1087"/>
                </a:cubicBezTo>
                <a:cubicBezTo>
                  <a:pt x="1308" y="1092"/>
                  <a:pt x="1311" y="1097"/>
                  <a:pt x="1315" y="1101"/>
                </a:cubicBezTo>
                <a:cubicBezTo>
                  <a:pt x="1321" y="1107"/>
                  <a:pt x="1328" y="1111"/>
                  <a:pt x="1335" y="1112"/>
                </a:cubicBezTo>
                <a:cubicBezTo>
                  <a:pt x="1342" y="1113"/>
                  <a:pt x="1350" y="1112"/>
                  <a:pt x="1358" y="1110"/>
                </a:cubicBezTo>
                <a:cubicBezTo>
                  <a:pt x="1366" y="1108"/>
                  <a:pt x="1374" y="1106"/>
                  <a:pt x="1383" y="1102"/>
                </a:cubicBezTo>
                <a:cubicBezTo>
                  <a:pt x="1391" y="1098"/>
                  <a:pt x="1400" y="1094"/>
                  <a:pt x="1409" y="1090"/>
                </a:cubicBezTo>
                <a:cubicBezTo>
                  <a:pt x="1418" y="1086"/>
                  <a:pt x="1428" y="1083"/>
                  <a:pt x="1437" y="1080"/>
                </a:cubicBezTo>
                <a:cubicBezTo>
                  <a:pt x="1447" y="1077"/>
                  <a:pt x="1456" y="1075"/>
                  <a:pt x="1466" y="1075"/>
                </a:cubicBezTo>
                <a:cubicBezTo>
                  <a:pt x="1475" y="1074"/>
                  <a:pt x="1485" y="1076"/>
                  <a:pt x="1494" y="1079"/>
                </a:cubicBezTo>
                <a:cubicBezTo>
                  <a:pt x="1504" y="1083"/>
                  <a:pt x="1513" y="1089"/>
                  <a:pt x="1522" y="1098"/>
                </a:cubicBezTo>
                <a:close/>
                <a:moveTo>
                  <a:pt x="1699" y="809"/>
                </a:moveTo>
                <a:cubicBezTo>
                  <a:pt x="1705" y="814"/>
                  <a:pt x="1707" y="820"/>
                  <a:pt x="1707" y="826"/>
                </a:cubicBezTo>
                <a:cubicBezTo>
                  <a:pt x="1707" y="831"/>
                  <a:pt x="1704" y="836"/>
                  <a:pt x="1701" y="840"/>
                </a:cubicBezTo>
                <a:lnTo>
                  <a:pt x="1565" y="976"/>
                </a:lnTo>
                <a:cubicBezTo>
                  <a:pt x="1576" y="987"/>
                  <a:pt x="1588" y="996"/>
                  <a:pt x="1599" y="1003"/>
                </a:cubicBezTo>
                <a:cubicBezTo>
                  <a:pt x="1611" y="1010"/>
                  <a:pt x="1622" y="1014"/>
                  <a:pt x="1634" y="1015"/>
                </a:cubicBezTo>
                <a:cubicBezTo>
                  <a:pt x="1646" y="1016"/>
                  <a:pt x="1658" y="1014"/>
                  <a:pt x="1670" y="1009"/>
                </a:cubicBezTo>
                <a:cubicBezTo>
                  <a:pt x="1682" y="1004"/>
                  <a:pt x="1695" y="996"/>
                  <a:pt x="1707" y="983"/>
                </a:cubicBezTo>
                <a:cubicBezTo>
                  <a:pt x="1717" y="973"/>
                  <a:pt x="1725" y="964"/>
                  <a:pt x="1731" y="954"/>
                </a:cubicBezTo>
                <a:cubicBezTo>
                  <a:pt x="1737" y="945"/>
                  <a:pt x="1742" y="937"/>
                  <a:pt x="1746" y="929"/>
                </a:cubicBezTo>
                <a:cubicBezTo>
                  <a:pt x="1749" y="922"/>
                  <a:pt x="1752" y="915"/>
                  <a:pt x="1754" y="910"/>
                </a:cubicBezTo>
                <a:cubicBezTo>
                  <a:pt x="1756" y="905"/>
                  <a:pt x="1758" y="901"/>
                  <a:pt x="1760" y="899"/>
                </a:cubicBezTo>
                <a:cubicBezTo>
                  <a:pt x="1761" y="898"/>
                  <a:pt x="1762" y="898"/>
                  <a:pt x="1763" y="897"/>
                </a:cubicBezTo>
                <a:cubicBezTo>
                  <a:pt x="1765" y="897"/>
                  <a:pt x="1766" y="897"/>
                  <a:pt x="1768" y="898"/>
                </a:cubicBezTo>
                <a:cubicBezTo>
                  <a:pt x="1769" y="898"/>
                  <a:pt x="1771" y="899"/>
                  <a:pt x="1773" y="901"/>
                </a:cubicBezTo>
                <a:cubicBezTo>
                  <a:pt x="1775" y="903"/>
                  <a:pt x="1778" y="905"/>
                  <a:pt x="1781" y="908"/>
                </a:cubicBezTo>
                <a:cubicBezTo>
                  <a:pt x="1783" y="910"/>
                  <a:pt x="1784" y="912"/>
                  <a:pt x="1786" y="913"/>
                </a:cubicBezTo>
                <a:cubicBezTo>
                  <a:pt x="1787" y="915"/>
                  <a:pt x="1788" y="916"/>
                  <a:pt x="1789" y="918"/>
                </a:cubicBezTo>
                <a:cubicBezTo>
                  <a:pt x="1790" y="919"/>
                  <a:pt x="1790" y="920"/>
                  <a:pt x="1791" y="922"/>
                </a:cubicBezTo>
                <a:cubicBezTo>
                  <a:pt x="1791" y="923"/>
                  <a:pt x="1791" y="925"/>
                  <a:pt x="1791" y="927"/>
                </a:cubicBezTo>
                <a:cubicBezTo>
                  <a:pt x="1791" y="928"/>
                  <a:pt x="1790" y="932"/>
                  <a:pt x="1788" y="938"/>
                </a:cubicBezTo>
                <a:cubicBezTo>
                  <a:pt x="1786" y="944"/>
                  <a:pt x="1782" y="951"/>
                  <a:pt x="1778" y="960"/>
                </a:cubicBezTo>
                <a:cubicBezTo>
                  <a:pt x="1773" y="968"/>
                  <a:pt x="1767" y="977"/>
                  <a:pt x="1760" y="988"/>
                </a:cubicBezTo>
                <a:cubicBezTo>
                  <a:pt x="1753" y="998"/>
                  <a:pt x="1744" y="1008"/>
                  <a:pt x="1734" y="1017"/>
                </a:cubicBezTo>
                <a:cubicBezTo>
                  <a:pt x="1717" y="1034"/>
                  <a:pt x="1700" y="1047"/>
                  <a:pt x="1683" y="1055"/>
                </a:cubicBezTo>
                <a:cubicBezTo>
                  <a:pt x="1665" y="1063"/>
                  <a:pt x="1647" y="1067"/>
                  <a:pt x="1629" y="1066"/>
                </a:cubicBezTo>
                <a:cubicBezTo>
                  <a:pt x="1611" y="1065"/>
                  <a:pt x="1593" y="1060"/>
                  <a:pt x="1575" y="1051"/>
                </a:cubicBezTo>
                <a:cubicBezTo>
                  <a:pt x="1556" y="1041"/>
                  <a:pt x="1537" y="1027"/>
                  <a:pt x="1519" y="1008"/>
                </a:cubicBezTo>
                <a:cubicBezTo>
                  <a:pt x="1501" y="990"/>
                  <a:pt x="1487" y="972"/>
                  <a:pt x="1478" y="954"/>
                </a:cubicBezTo>
                <a:cubicBezTo>
                  <a:pt x="1468" y="935"/>
                  <a:pt x="1463" y="916"/>
                  <a:pt x="1462" y="898"/>
                </a:cubicBezTo>
                <a:cubicBezTo>
                  <a:pt x="1461" y="879"/>
                  <a:pt x="1463" y="861"/>
                  <a:pt x="1470" y="844"/>
                </a:cubicBezTo>
                <a:cubicBezTo>
                  <a:pt x="1477" y="826"/>
                  <a:pt x="1488" y="810"/>
                  <a:pt x="1503" y="795"/>
                </a:cubicBezTo>
                <a:cubicBezTo>
                  <a:pt x="1520" y="779"/>
                  <a:pt x="1536" y="767"/>
                  <a:pt x="1553" y="761"/>
                </a:cubicBezTo>
                <a:cubicBezTo>
                  <a:pt x="1569" y="755"/>
                  <a:pt x="1586" y="753"/>
                  <a:pt x="1602" y="754"/>
                </a:cubicBezTo>
                <a:cubicBezTo>
                  <a:pt x="1618" y="756"/>
                  <a:pt x="1634" y="760"/>
                  <a:pt x="1649" y="769"/>
                </a:cubicBezTo>
                <a:cubicBezTo>
                  <a:pt x="1664" y="777"/>
                  <a:pt x="1678" y="788"/>
                  <a:pt x="1692" y="802"/>
                </a:cubicBezTo>
                <a:lnTo>
                  <a:pt x="1699" y="809"/>
                </a:lnTo>
                <a:close/>
                <a:moveTo>
                  <a:pt x="1649" y="835"/>
                </a:moveTo>
                <a:cubicBezTo>
                  <a:pt x="1630" y="815"/>
                  <a:pt x="1610" y="804"/>
                  <a:pt x="1589" y="802"/>
                </a:cubicBezTo>
                <a:cubicBezTo>
                  <a:pt x="1569" y="800"/>
                  <a:pt x="1549" y="808"/>
                  <a:pt x="1531" y="826"/>
                </a:cubicBezTo>
                <a:cubicBezTo>
                  <a:pt x="1522" y="836"/>
                  <a:pt x="1515" y="846"/>
                  <a:pt x="1512" y="856"/>
                </a:cubicBezTo>
                <a:cubicBezTo>
                  <a:pt x="1508" y="867"/>
                  <a:pt x="1507" y="877"/>
                  <a:pt x="1508" y="888"/>
                </a:cubicBezTo>
                <a:cubicBezTo>
                  <a:pt x="1509" y="899"/>
                  <a:pt x="1512" y="909"/>
                  <a:pt x="1517" y="919"/>
                </a:cubicBezTo>
                <a:cubicBezTo>
                  <a:pt x="1522" y="930"/>
                  <a:pt x="1529" y="939"/>
                  <a:pt x="1537" y="948"/>
                </a:cubicBezTo>
                <a:lnTo>
                  <a:pt x="1649" y="835"/>
                </a:lnTo>
                <a:close/>
                <a:moveTo>
                  <a:pt x="1795" y="551"/>
                </a:moveTo>
                <a:cubicBezTo>
                  <a:pt x="1798" y="555"/>
                  <a:pt x="1801" y="558"/>
                  <a:pt x="1803" y="560"/>
                </a:cubicBezTo>
                <a:cubicBezTo>
                  <a:pt x="1805" y="563"/>
                  <a:pt x="1806" y="565"/>
                  <a:pt x="1807" y="566"/>
                </a:cubicBezTo>
                <a:cubicBezTo>
                  <a:pt x="1808" y="568"/>
                  <a:pt x="1809" y="570"/>
                  <a:pt x="1809" y="571"/>
                </a:cubicBezTo>
                <a:cubicBezTo>
                  <a:pt x="1809" y="572"/>
                  <a:pt x="1808" y="574"/>
                  <a:pt x="1807" y="575"/>
                </a:cubicBezTo>
                <a:cubicBezTo>
                  <a:pt x="1805" y="576"/>
                  <a:pt x="1804" y="577"/>
                  <a:pt x="1801" y="578"/>
                </a:cubicBezTo>
                <a:cubicBezTo>
                  <a:pt x="1799" y="579"/>
                  <a:pt x="1796" y="581"/>
                  <a:pt x="1793" y="582"/>
                </a:cubicBezTo>
                <a:cubicBezTo>
                  <a:pt x="1790" y="584"/>
                  <a:pt x="1787" y="586"/>
                  <a:pt x="1784" y="588"/>
                </a:cubicBezTo>
                <a:cubicBezTo>
                  <a:pt x="1780" y="590"/>
                  <a:pt x="1777" y="593"/>
                  <a:pt x="1774" y="596"/>
                </a:cubicBezTo>
                <a:cubicBezTo>
                  <a:pt x="1770" y="600"/>
                  <a:pt x="1767" y="604"/>
                  <a:pt x="1765" y="609"/>
                </a:cubicBezTo>
                <a:cubicBezTo>
                  <a:pt x="1763" y="615"/>
                  <a:pt x="1761" y="621"/>
                  <a:pt x="1761" y="629"/>
                </a:cubicBezTo>
                <a:cubicBezTo>
                  <a:pt x="1760" y="636"/>
                  <a:pt x="1761" y="645"/>
                  <a:pt x="1762" y="655"/>
                </a:cubicBezTo>
                <a:cubicBezTo>
                  <a:pt x="1764" y="665"/>
                  <a:pt x="1766" y="677"/>
                  <a:pt x="1769" y="691"/>
                </a:cubicBezTo>
                <a:lnTo>
                  <a:pt x="1905" y="827"/>
                </a:lnTo>
                <a:cubicBezTo>
                  <a:pt x="1906" y="828"/>
                  <a:pt x="1907" y="829"/>
                  <a:pt x="1907" y="831"/>
                </a:cubicBezTo>
                <a:cubicBezTo>
                  <a:pt x="1907" y="832"/>
                  <a:pt x="1907" y="834"/>
                  <a:pt x="1906" y="836"/>
                </a:cubicBezTo>
                <a:cubicBezTo>
                  <a:pt x="1905" y="838"/>
                  <a:pt x="1904" y="840"/>
                  <a:pt x="1902" y="843"/>
                </a:cubicBezTo>
                <a:cubicBezTo>
                  <a:pt x="1899" y="846"/>
                  <a:pt x="1896" y="849"/>
                  <a:pt x="1893" y="853"/>
                </a:cubicBezTo>
                <a:cubicBezTo>
                  <a:pt x="1889" y="857"/>
                  <a:pt x="1886" y="860"/>
                  <a:pt x="1883" y="862"/>
                </a:cubicBezTo>
                <a:cubicBezTo>
                  <a:pt x="1880" y="864"/>
                  <a:pt x="1878" y="865"/>
                  <a:pt x="1876" y="866"/>
                </a:cubicBezTo>
                <a:cubicBezTo>
                  <a:pt x="1874" y="867"/>
                  <a:pt x="1872" y="867"/>
                  <a:pt x="1871" y="867"/>
                </a:cubicBezTo>
                <a:cubicBezTo>
                  <a:pt x="1869" y="867"/>
                  <a:pt x="1868" y="866"/>
                  <a:pt x="1867" y="865"/>
                </a:cubicBezTo>
                <a:lnTo>
                  <a:pt x="1660" y="658"/>
                </a:lnTo>
                <a:cubicBezTo>
                  <a:pt x="1659" y="657"/>
                  <a:pt x="1658" y="656"/>
                  <a:pt x="1658" y="655"/>
                </a:cubicBezTo>
                <a:cubicBezTo>
                  <a:pt x="1658" y="653"/>
                  <a:pt x="1658" y="652"/>
                  <a:pt x="1658" y="650"/>
                </a:cubicBezTo>
                <a:cubicBezTo>
                  <a:pt x="1659" y="648"/>
                  <a:pt x="1660" y="645"/>
                  <a:pt x="1662" y="643"/>
                </a:cubicBezTo>
                <a:cubicBezTo>
                  <a:pt x="1664" y="641"/>
                  <a:pt x="1667" y="638"/>
                  <a:pt x="1671" y="634"/>
                </a:cubicBezTo>
                <a:cubicBezTo>
                  <a:pt x="1674" y="631"/>
                  <a:pt x="1677" y="628"/>
                  <a:pt x="1679" y="626"/>
                </a:cubicBezTo>
                <a:cubicBezTo>
                  <a:pt x="1682" y="624"/>
                  <a:pt x="1684" y="623"/>
                  <a:pt x="1686" y="622"/>
                </a:cubicBezTo>
                <a:cubicBezTo>
                  <a:pt x="1688" y="622"/>
                  <a:pt x="1689" y="622"/>
                  <a:pt x="1691" y="622"/>
                </a:cubicBezTo>
                <a:cubicBezTo>
                  <a:pt x="1692" y="622"/>
                  <a:pt x="1693" y="623"/>
                  <a:pt x="1695" y="624"/>
                </a:cubicBezTo>
                <a:lnTo>
                  <a:pt x="1725" y="654"/>
                </a:lnTo>
                <a:cubicBezTo>
                  <a:pt x="1722" y="640"/>
                  <a:pt x="1721" y="628"/>
                  <a:pt x="1720" y="618"/>
                </a:cubicBezTo>
                <a:cubicBezTo>
                  <a:pt x="1720" y="608"/>
                  <a:pt x="1721" y="599"/>
                  <a:pt x="1722" y="592"/>
                </a:cubicBezTo>
                <a:cubicBezTo>
                  <a:pt x="1724" y="584"/>
                  <a:pt x="1726" y="578"/>
                  <a:pt x="1729" y="572"/>
                </a:cubicBezTo>
                <a:cubicBezTo>
                  <a:pt x="1732" y="567"/>
                  <a:pt x="1736" y="562"/>
                  <a:pt x="1741" y="558"/>
                </a:cubicBezTo>
                <a:cubicBezTo>
                  <a:pt x="1743" y="556"/>
                  <a:pt x="1745" y="553"/>
                  <a:pt x="1748" y="551"/>
                </a:cubicBezTo>
                <a:cubicBezTo>
                  <a:pt x="1751" y="549"/>
                  <a:pt x="1754" y="547"/>
                  <a:pt x="1757" y="544"/>
                </a:cubicBezTo>
                <a:cubicBezTo>
                  <a:pt x="1760" y="542"/>
                  <a:pt x="1763" y="541"/>
                  <a:pt x="1766" y="539"/>
                </a:cubicBezTo>
                <a:cubicBezTo>
                  <a:pt x="1769" y="538"/>
                  <a:pt x="1772" y="537"/>
                  <a:pt x="1773" y="537"/>
                </a:cubicBezTo>
                <a:cubicBezTo>
                  <a:pt x="1775" y="537"/>
                  <a:pt x="1776" y="537"/>
                  <a:pt x="1777" y="537"/>
                </a:cubicBezTo>
                <a:cubicBezTo>
                  <a:pt x="1778" y="537"/>
                  <a:pt x="1780" y="538"/>
                  <a:pt x="1781" y="539"/>
                </a:cubicBezTo>
                <a:cubicBezTo>
                  <a:pt x="1782" y="540"/>
                  <a:pt x="1784" y="541"/>
                  <a:pt x="1786" y="543"/>
                </a:cubicBezTo>
                <a:cubicBezTo>
                  <a:pt x="1788" y="545"/>
                  <a:pt x="1791" y="548"/>
                  <a:pt x="1795" y="551"/>
                </a:cubicBezTo>
                <a:close/>
                <a:moveTo>
                  <a:pt x="2074" y="657"/>
                </a:moveTo>
                <a:cubicBezTo>
                  <a:pt x="2076" y="658"/>
                  <a:pt x="2076" y="660"/>
                  <a:pt x="2076" y="661"/>
                </a:cubicBezTo>
                <a:cubicBezTo>
                  <a:pt x="2077" y="663"/>
                  <a:pt x="2076" y="664"/>
                  <a:pt x="2076" y="666"/>
                </a:cubicBezTo>
                <a:cubicBezTo>
                  <a:pt x="2075" y="668"/>
                  <a:pt x="2073" y="671"/>
                  <a:pt x="2071" y="674"/>
                </a:cubicBezTo>
                <a:cubicBezTo>
                  <a:pt x="2069" y="676"/>
                  <a:pt x="2066" y="680"/>
                  <a:pt x="2062" y="683"/>
                </a:cubicBezTo>
                <a:cubicBezTo>
                  <a:pt x="2059" y="687"/>
                  <a:pt x="2055" y="690"/>
                  <a:pt x="2053" y="692"/>
                </a:cubicBezTo>
                <a:cubicBezTo>
                  <a:pt x="2050" y="694"/>
                  <a:pt x="2048" y="696"/>
                  <a:pt x="2046" y="697"/>
                </a:cubicBezTo>
                <a:cubicBezTo>
                  <a:pt x="2043" y="697"/>
                  <a:pt x="2042" y="698"/>
                  <a:pt x="2040" y="697"/>
                </a:cubicBezTo>
                <a:cubicBezTo>
                  <a:pt x="2039" y="697"/>
                  <a:pt x="2038" y="696"/>
                  <a:pt x="2036" y="695"/>
                </a:cubicBezTo>
                <a:lnTo>
                  <a:pt x="1830" y="489"/>
                </a:lnTo>
                <a:cubicBezTo>
                  <a:pt x="1829" y="488"/>
                  <a:pt x="1828" y="486"/>
                  <a:pt x="1828" y="485"/>
                </a:cubicBezTo>
                <a:cubicBezTo>
                  <a:pt x="1828" y="483"/>
                  <a:pt x="1828" y="482"/>
                  <a:pt x="1829" y="480"/>
                </a:cubicBezTo>
                <a:cubicBezTo>
                  <a:pt x="1829" y="478"/>
                  <a:pt x="1831" y="475"/>
                  <a:pt x="1833" y="472"/>
                </a:cubicBezTo>
                <a:cubicBezTo>
                  <a:pt x="1835" y="470"/>
                  <a:pt x="1838" y="466"/>
                  <a:pt x="1842" y="463"/>
                </a:cubicBezTo>
                <a:cubicBezTo>
                  <a:pt x="1846" y="459"/>
                  <a:pt x="1849" y="456"/>
                  <a:pt x="1852" y="454"/>
                </a:cubicBezTo>
                <a:cubicBezTo>
                  <a:pt x="1854" y="452"/>
                  <a:pt x="1857" y="450"/>
                  <a:pt x="1859" y="450"/>
                </a:cubicBezTo>
                <a:cubicBezTo>
                  <a:pt x="1861" y="449"/>
                  <a:pt x="1863" y="449"/>
                  <a:pt x="1864" y="449"/>
                </a:cubicBezTo>
                <a:cubicBezTo>
                  <a:pt x="1866" y="449"/>
                  <a:pt x="1867" y="450"/>
                  <a:pt x="1868" y="451"/>
                </a:cubicBezTo>
                <a:lnTo>
                  <a:pt x="2074" y="657"/>
                </a:lnTo>
                <a:close/>
                <a:moveTo>
                  <a:pt x="1803" y="377"/>
                </a:moveTo>
                <a:cubicBezTo>
                  <a:pt x="1811" y="386"/>
                  <a:pt x="1816" y="393"/>
                  <a:pt x="1816" y="400"/>
                </a:cubicBezTo>
                <a:cubicBezTo>
                  <a:pt x="1816" y="407"/>
                  <a:pt x="1811" y="414"/>
                  <a:pt x="1802" y="423"/>
                </a:cubicBezTo>
                <a:cubicBezTo>
                  <a:pt x="1793" y="432"/>
                  <a:pt x="1785" y="437"/>
                  <a:pt x="1779" y="437"/>
                </a:cubicBezTo>
                <a:cubicBezTo>
                  <a:pt x="1773" y="437"/>
                  <a:pt x="1765" y="433"/>
                  <a:pt x="1756" y="424"/>
                </a:cubicBezTo>
                <a:cubicBezTo>
                  <a:pt x="1747" y="415"/>
                  <a:pt x="1743" y="407"/>
                  <a:pt x="1743" y="401"/>
                </a:cubicBezTo>
                <a:cubicBezTo>
                  <a:pt x="1743" y="394"/>
                  <a:pt x="1748" y="387"/>
                  <a:pt x="1757" y="378"/>
                </a:cubicBezTo>
                <a:cubicBezTo>
                  <a:pt x="1766" y="369"/>
                  <a:pt x="1774" y="364"/>
                  <a:pt x="1780" y="364"/>
                </a:cubicBezTo>
                <a:cubicBezTo>
                  <a:pt x="1786" y="364"/>
                  <a:pt x="1794" y="368"/>
                  <a:pt x="1803" y="377"/>
                </a:cubicBezTo>
                <a:close/>
                <a:moveTo>
                  <a:pt x="2322" y="410"/>
                </a:moveTo>
                <a:cubicBezTo>
                  <a:pt x="2323" y="411"/>
                  <a:pt x="2324" y="412"/>
                  <a:pt x="2324" y="414"/>
                </a:cubicBezTo>
                <a:cubicBezTo>
                  <a:pt x="2324" y="415"/>
                  <a:pt x="2324" y="417"/>
                  <a:pt x="2323" y="419"/>
                </a:cubicBezTo>
                <a:cubicBezTo>
                  <a:pt x="2322" y="421"/>
                  <a:pt x="2321" y="423"/>
                  <a:pt x="2319" y="426"/>
                </a:cubicBezTo>
                <a:cubicBezTo>
                  <a:pt x="2316" y="429"/>
                  <a:pt x="2314" y="432"/>
                  <a:pt x="2310" y="436"/>
                </a:cubicBezTo>
                <a:cubicBezTo>
                  <a:pt x="2306" y="440"/>
                  <a:pt x="2303" y="443"/>
                  <a:pt x="2300" y="445"/>
                </a:cubicBezTo>
                <a:cubicBezTo>
                  <a:pt x="2297" y="447"/>
                  <a:pt x="2295" y="448"/>
                  <a:pt x="2293" y="449"/>
                </a:cubicBezTo>
                <a:cubicBezTo>
                  <a:pt x="2291" y="450"/>
                  <a:pt x="2289" y="450"/>
                  <a:pt x="2288" y="450"/>
                </a:cubicBezTo>
                <a:cubicBezTo>
                  <a:pt x="2286" y="450"/>
                  <a:pt x="2285" y="449"/>
                  <a:pt x="2284" y="448"/>
                </a:cubicBezTo>
                <a:lnTo>
                  <a:pt x="2163" y="327"/>
                </a:lnTo>
                <a:cubicBezTo>
                  <a:pt x="2151" y="315"/>
                  <a:pt x="2141" y="307"/>
                  <a:pt x="2132" y="301"/>
                </a:cubicBezTo>
                <a:cubicBezTo>
                  <a:pt x="2123" y="296"/>
                  <a:pt x="2114" y="292"/>
                  <a:pt x="2105" y="291"/>
                </a:cubicBezTo>
                <a:cubicBezTo>
                  <a:pt x="2096" y="289"/>
                  <a:pt x="2088" y="290"/>
                  <a:pt x="2080" y="292"/>
                </a:cubicBezTo>
                <a:cubicBezTo>
                  <a:pt x="2071" y="295"/>
                  <a:pt x="2063" y="300"/>
                  <a:pt x="2056" y="308"/>
                </a:cubicBezTo>
                <a:cubicBezTo>
                  <a:pt x="2047" y="317"/>
                  <a:pt x="2041" y="330"/>
                  <a:pt x="2038" y="346"/>
                </a:cubicBezTo>
                <a:cubicBezTo>
                  <a:pt x="2035" y="362"/>
                  <a:pt x="2035" y="382"/>
                  <a:pt x="2038" y="406"/>
                </a:cubicBezTo>
                <a:lnTo>
                  <a:pt x="2182" y="550"/>
                </a:lnTo>
                <a:cubicBezTo>
                  <a:pt x="2183" y="551"/>
                  <a:pt x="2184" y="552"/>
                  <a:pt x="2184" y="554"/>
                </a:cubicBezTo>
                <a:cubicBezTo>
                  <a:pt x="2184" y="555"/>
                  <a:pt x="2184" y="557"/>
                  <a:pt x="2183" y="559"/>
                </a:cubicBezTo>
                <a:cubicBezTo>
                  <a:pt x="2182" y="561"/>
                  <a:pt x="2181" y="563"/>
                  <a:pt x="2179" y="566"/>
                </a:cubicBezTo>
                <a:cubicBezTo>
                  <a:pt x="2177" y="569"/>
                  <a:pt x="2174" y="572"/>
                  <a:pt x="2170" y="576"/>
                </a:cubicBezTo>
                <a:cubicBezTo>
                  <a:pt x="2166" y="580"/>
                  <a:pt x="2163" y="582"/>
                  <a:pt x="2160" y="585"/>
                </a:cubicBezTo>
                <a:cubicBezTo>
                  <a:pt x="2157" y="587"/>
                  <a:pt x="2155" y="588"/>
                  <a:pt x="2153" y="589"/>
                </a:cubicBezTo>
                <a:cubicBezTo>
                  <a:pt x="2151" y="590"/>
                  <a:pt x="2149" y="590"/>
                  <a:pt x="2148" y="590"/>
                </a:cubicBezTo>
                <a:cubicBezTo>
                  <a:pt x="2146" y="590"/>
                  <a:pt x="2145" y="589"/>
                  <a:pt x="2144" y="588"/>
                </a:cubicBezTo>
                <a:lnTo>
                  <a:pt x="1938" y="381"/>
                </a:lnTo>
                <a:cubicBezTo>
                  <a:pt x="1936" y="380"/>
                  <a:pt x="1936" y="379"/>
                  <a:pt x="1935" y="377"/>
                </a:cubicBezTo>
                <a:cubicBezTo>
                  <a:pt x="1935" y="376"/>
                  <a:pt x="1935" y="374"/>
                  <a:pt x="1936" y="372"/>
                </a:cubicBezTo>
                <a:cubicBezTo>
                  <a:pt x="1936" y="370"/>
                  <a:pt x="1938" y="368"/>
                  <a:pt x="1940" y="366"/>
                </a:cubicBezTo>
                <a:cubicBezTo>
                  <a:pt x="1941" y="363"/>
                  <a:pt x="1944" y="360"/>
                  <a:pt x="1948" y="357"/>
                </a:cubicBezTo>
                <a:cubicBezTo>
                  <a:pt x="1951" y="354"/>
                  <a:pt x="1954" y="351"/>
                  <a:pt x="1956" y="349"/>
                </a:cubicBezTo>
                <a:cubicBezTo>
                  <a:pt x="1959" y="347"/>
                  <a:pt x="1961" y="346"/>
                  <a:pt x="1963" y="345"/>
                </a:cubicBezTo>
                <a:cubicBezTo>
                  <a:pt x="1965" y="345"/>
                  <a:pt x="1966" y="344"/>
                  <a:pt x="1968" y="345"/>
                </a:cubicBezTo>
                <a:cubicBezTo>
                  <a:pt x="1969" y="345"/>
                  <a:pt x="1971" y="346"/>
                  <a:pt x="1972" y="347"/>
                </a:cubicBezTo>
                <a:lnTo>
                  <a:pt x="1999" y="374"/>
                </a:lnTo>
                <a:cubicBezTo>
                  <a:pt x="1998" y="350"/>
                  <a:pt x="2000" y="329"/>
                  <a:pt x="2005" y="311"/>
                </a:cubicBezTo>
                <a:cubicBezTo>
                  <a:pt x="2011" y="294"/>
                  <a:pt x="2019" y="279"/>
                  <a:pt x="2031" y="267"/>
                </a:cubicBezTo>
                <a:cubicBezTo>
                  <a:pt x="2045" y="253"/>
                  <a:pt x="2059" y="244"/>
                  <a:pt x="2073" y="239"/>
                </a:cubicBezTo>
                <a:cubicBezTo>
                  <a:pt x="2087" y="235"/>
                  <a:pt x="2101" y="233"/>
                  <a:pt x="2114" y="235"/>
                </a:cubicBezTo>
                <a:cubicBezTo>
                  <a:pt x="2128" y="237"/>
                  <a:pt x="2141" y="242"/>
                  <a:pt x="2154" y="250"/>
                </a:cubicBezTo>
                <a:cubicBezTo>
                  <a:pt x="2167" y="258"/>
                  <a:pt x="2181" y="269"/>
                  <a:pt x="2196" y="284"/>
                </a:cubicBezTo>
                <a:lnTo>
                  <a:pt x="2322" y="410"/>
                </a:lnTo>
                <a:close/>
                <a:moveTo>
                  <a:pt x="2451" y="56"/>
                </a:moveTo>
                <a:cubicBezTo>
                  <a:pt x="2457" y="62"/>
                  <a:pt x="2460" y="68"/>
                  <a:pt x="2459" y="73"/>
                </a:cubicBezTo>
                <a:cubicBezTo>
                  <a:pt x="2459" y="79"/>
                  <a:pt x="2457" y="84"/>
                  <a:pt x="2453" y="87"/>
                </a:cubicBezTo>
                <a:lnTo>
                  <a:pt x="2317" y="223"/>
                </a:lnTo>
                <a:cubicBezTo>
                  <a:pt x="2328" y="235"/>
                  <a:pt x="2340" y="244"/>
                  <a:pt x="2351" y="251"/>
                </a:cubicBezTo>
                <a:cubicBezTo>
                  <a:pt x="2363" y="258"/>
                  <a:pt x="2375" y="262"/>
                  <a:pt x="2387" y="263"/>
                </a:cubicBezTo>
                <a:cubicBezTo>
                  <a:pt x="2399" y="264"/>
                  <a:pt x="2411" y="262"/>
                  <a:pt x="2423" y="257"/>
                </a:cubicBezTo>
                <a:cubicBezTo>
                  <a:pt x="2435" y="252"/>
                  <a:pt x="2447" y="243"/>
                  <a:pt x="2459" y="231"/>
                </a:cubicBezTo>
                <a:cubicBezTo>
                  <a:pt x="2469" y="221"/>
                  <a:pt x="2477" y="211"/>
                  <a:pt x="2483" y="202"/>
                </a:cubicBezTo>
                <a:cubicBezTo>
                  <a:pt x="2489" y="193"/>
                  <a:pt x="2494" y="184"/>
                  <a:pt x="2498" y="177"/>
                </a:cubicBezTo>
                <a:cubicBezTo>
                  <a:pt x="2502" y="169"/>
                  <a:pt x="2504" y="163"/>
                  <a:pt x="2506" y="158"/>
                </a:cubicBezTo>
                <a:cubicBezTo>
                  <a:pt x="2508" y="152"/>
                  <a:pt x="2510" y="149"/>
                  <a:pt x="2512" y="147"/>
                </a:cubicBezTo>
                <a:cubicBezTo>
                  <a:pt x="2513" y="146"/>
                  <a:pt x="2514" y="145"/>
                  <a:pt x="2516" y="145"/>
                </a:cubicBezTo>
                <a:cubicBezTo>
                  <a:pt x="2517" y="145"/>
                  <a:pt x="2519" y="145"/>
                  <a:pt x="2520" y="145"/>
                </a:cubicBezTo>
                <a:cubicBezTo>
                  <a:pt x="2522" y="146"/>
                  <a:pt x="2524" y="147"/>
                  <a:pt x="2526" y="149"/>
                </a:cubicBezTo>
                <a:cubicBezTo>
                  <a:pt x="2528" y="150"/>
                  <a:pt x="2530" y="153"/>
                  <a:pt x="2533" y="155"/>
                </a:cubicBezTo>
                <a:cubicBezTo>
                  <a:pt x="2535" y="157"/>
                  <a:pt x="2537" y="159"/>
                  <a:pt x="2538" y="161"/>
                </a:cubicBezTo>
                <a:cubicBezTo>
                  <a:pt x="2539" y="162"/>
                  <a:pt x="2540" y="164"/>
                  <a:pt x="2541" y="165"/>
                </a:cubicBezTo>
                <a:cubicBezTo>
                  <a:pt x="2542" y="167"/>
                  <a:pt x="2543" y="168"/>
                  <a:pt x="2543" y="170"/>
                </a:cubicBezTo>
                <a:cubicBezTo>
                  <a:pt x="2544" y="171"/>
                  <a:pt x="2544" y="173"/>
                  <a:pt x="2544" y="174"/>
                </a:cubicBezTo>
                <a:cubicBezTo>
                  <a:pt x="2544" y="176"/>
                  <a:pt x="2543" y="180"/>
                  <a:pt x="2540" y="186"/>
                </a:cubicBezTo>
                <a:cubicBezTo>
                  <a:pt x="2538" y="192"/>
                  <a:pt x="2535" y="199"/>
                  <a:pt x="2530" y="207"/>
                </a:cubicBezTo>
                <a:cubicBezTo>
                  <a:pt x="2525" y="216"/>
                  <a:pt x="2519" y="225"/>
                  <a:pt x="2512" y="235"/>
                </a:cubicBezTo>
                <a:cubicBezTo>
                  <a:pt x="2505" y="245"/>
                  <a:pt x="2496" y="255"/>
                  <a:pt x="2487" y="265"/>
                </a:cubicBezTo>
                <a:cubicBezTo>
                  <a:pt x="2470" y="282"/>
                  <a:pt x="2452" y="294"/>
                  <a:pt x="2435" y="302"/>
                </a:cubicBezTo>
                <a:cubicBezTo>
                  <a:pt x="2417" y="311"/>
                  <a:pt x="2400" y="314"/>
                  <a:pt x="2382" y="314"/>
                </a:cubicBezTo>
                <a:cubicBezTo>
                  <a:pt x="2364" y="313"/>
                  <a:pt x="2345" y="308"/>
                  <a:pt x="2327" y="298"/>
                </a:cubicBezTo>
                <a:cubicBezTo>
                  <a:pt x="2308" y="289"/>
                  <a:pt x="2290" y="274"/>
                  <a:pt x="2271" y="256"/>
                </a:cubicBezTo>
                <a:cubicBezTo>
                  <a:pt x="2253" y="238"/>
                  <a:pt x="2240" y="220"/>
                  <a:pt x="2230" y="201"/>
                </a:cubicBezTo>
                <a:cubicBezTo>
                  <a:pt x="2221" y="182"/>
                  <a:pt x="2215" y="164"/>
                  <a:pt x="2214" y="145"/>
                </a:cubicBezTo>
                <a:cubicBezTo>
                  <a:pt x="2213" y="127"/>
                  <a:pt x="2216" y="109"/>
                  <a:pt x="2223" y="91"/>
                </a:cubicBezTo>
                <a:cubicBezTo>
                  <a:pt x="2230" y="74"/>
                  <a:pt x="2241" y="58"/>
                  <a:pt x="2256" y="42"/>
                </a:cubicBezTo>
                <a:cubicBezTo>
                  <a:pt x="2272" y="26"/>
                  <a:pt x="2288" y="15"/>
                  <a:pt x="2305" y="9"/>
                </a:cubicBezTo>
                <a:cubicBezTo>
                  <a:pt x="2322" y="3"/>
                  <a:pt x="2338" y="0"/>
                  <a:pt x="2354" y="2"/>
                </a:cubicBezTo>
                <a:cubicBezTo>
                  <a:pt x="2370" y="3"/>
                  <a:pt x="2386" y="8"/>
                  <a:pt x="2401" y="16"/>
                </a:cubicBezTo>
                <a:cubicBezTo>
                  <a:pt x="2416" y="25"/>
                  <a:pt x="2431" y="36"/>
                  <a:pt x="2444" y="49"/>
                </a:cubicBezTo>
                <a:lnTo>
                  <a:pt x="2451" y="56"/>
                </a:lnTo>
                <a:close/>
                <a:moveTo>
                  <a:pt x="2402" y="83"/>
                </a:moveTo>
                <a:cubicBezTo>
                  <a:pt x="2382" y="63"/>
                  <a:pt x="2362" y="51"/>
                  <a:pt x="2342" y="49"/>
                </a:cubicBezTo>
                <a:cubicBezTo>
                  <a:pt x="2321" y="47"/>
                  <a:pt x="2302" y="56"/>
                  <a:pt x="2283" y="74"/>
                </a:cubicBezTo>
                <a:cubicBezTo>
                  <a:pt x="2274" y="83"/>
                  <a:pt x="2268" y="93"/>
                  <a:pt x="2264" y="104"/>
                </a:cubicBezTo>
                <a:cubicBezTo>
                  <a:pt x="2260" y="114"/>
                  <a:pt x="2259" y="125"/>
                  <a:pt x="2260" y="136"/>
                </a:cubicBezTo>
                <a:cubicBezTo>
                  <a:pt x="2261" y="146"/>
                  <a:pt x="2264" y="157"/>
                  <a:pt x="2269" y="167"/>
                </a:cubicBezTo>
                <a:cubicBezTo>
                  <a:pt x="2275" y="177"/>
                  <a:pt x="2281" y="187"/>
                  <a:pt x="2289" y="196"/>
                </a:cubicBezTo>
                <a:lnTo>
                  <a:pt x="2402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6" name="Freeform 250"/>
          <p:cNvSpPr>
            <a:spLocks noEditPoints="1"/>
          </p:cNvSpPr>
          <p:nvPr/>
        </p:nvSpPr>
        <p:spPr bwMode="auto">
          <a:xfrm>
            <a:off x="2203591" y="4417292"/>
            <a:ext cx="221447" cy="252413"/>
          </a:xfrm>
          <a:custGeom>
            <a:avLst/>
            <a:gdLst>
              <a:gd name="T0" fmla="*/ 335 w 1392"/>
              <a:gd name="T1" fmla="*/ 1265 h 1318"/>
              <a:gd name="T2" fmla="*/ 225 w 1392"/>
              <a:gd name="T3" fmla="*/ 1315 h 1318"/>
              <a:gd name="T4" fmla="*/ 202 w 1392"/>
              <a:gd name="T5" fmla="*/ 1280 h 1318"/>
              <a:gd name="T6" fmla="*/ 323 w 1392"/>
              <a:gd name="T7" fmla="*/ 1202 h 1318"/>
              <a:gd name="T8" fmla="*/ 253 w 1392"/>
              <a:gd name="T9" fmla="*/ 1105 h 1318"/>
              <a:gd name="T10" fmla="*/ 70 w 1392"/>
              <a:gd name="T11" fmla="*/ 1136 h 1318"/>
              <a:gd name="T12" fmla="*/ 45 w 1392"/>
              <a:gd name="T13" fmla="*/ 943 h 1318"/>
              <a:gd name="T14" fmla="*/ 133 w 1392"/>
              <a:gd name="T15" fmla="*/ 899 h 1318"/>
              <a:gd name="T16" fmla="*/ 162 w 1392"/>
              <a:gd name="T17" fmla="*/ 926 h 1318"/>
              <a:gd name="T18" fmla="*/ 104 w 1392"/>
              <a:gd name="T19" fmla="*/ 957 h 1318"/>
              <a:gd name="T20" fmla="*/ 69 w 1392"/>
              <a:gd name="T21" fmla="*/ 1067 h 1318"/>
              <a:gd name="T22" fmla="*/ 236 w 1392"/>
              <a:gd name="T23" fmla="*/ 1049 h 1318"/>
              <a:gd name="T24" fmla="*/ 549 w 1392"/>
              <a:gd name="T25" fmla="*/ 831 h 1318"/>
              <a:gd name="T26" fmla="*/ 512 w 1392"/>
              <a:gd name="T27" fmla="*/ 1015 h 1318"/>
              <a:gd name="T28" fmla="*/ 602 w 1392"/>
              <a:gd name="T29" fmla="*/ 905 h 1318"/>
              <a:gd name="T30" fmla="*/ 628 w 1392"/>
              <a:gd name="T31" fmla="*/ 919 h 1318"/>
              <a:gd name="T32" fmla="*/ 620 w 1392"/>
              <a:gd name="T33" fmla="*/ 965 h 1318"/>
              <a:gd name="T34" fmla="*/ 417 w 1392"/>
              <a:gd name="T35" fmla="*/ 1056 h 1318"/>
              <a:gd name="T36" fmla="*/ 346 w 1392"/>
              <a:gd name="T37" fmla="*/ 800 h 1318"/>
              <a:gd name="T38" fmla="*/ 541 w 1392"/>
              <a:gd name="T39" fmla="*/ 814 h 1318"/>
              <a:gd name="T40" fmla="*/ 350 w 1392"/>
              <a:gd name="T41" fmla="*/ 894 h 1318"/>
              <a:gd name="T42" fmla="*/ 651 w 1392"/>
              <a:gd name="T43" fmla="*/ 560 h 1318"/>
              <a:gd name="T44" fmla="*/ 641 w 1392"/>
              <a:gd name="T45" fmla="*/ 582 h 1318"/>
              <a:gd name="T46" fmla="*/ 610 w 1392"/>
              <a:gd name="T47" fmla="*/ 655 h 1318"/>
              <a:gd name="T48" fmla="*/ 749 w 1392"/>
              <a:gd name="T49" fmla="*/ 843 h 1318"/>
              <a:gd name="T50" fmla="*/ 715 w 1392"/>
              <a:gd name="T51" fmla="*/ 865 h 1318"/>
              <a:gd name="T52" fmla="*/ 518 w 1392"/>
              <a:gd name="T53" fmla="*/ 634 h 1318"/>
              <a:gd name="T54" fmla="*/ 572 w 1392"/>
              <a:gd name="T55" fmla="*/ 654 h 1318"/>
              <a:gd name="T56" fmla="*/ 596 w 1392"/>
              <a:gd name="T57" fmla="*/ 551 h 1318"/>
              <a:gd name="T58" fmla="*/ 629 w 1392"/>
              <a:gd name="T59" fmla="*/ 539 h 1318"/>
              <a:gd name="T60" fmla="*/ 918 w 1392"/>
              <a:gd name="T61" fmla="*/ 672 h 1318"/>
              <a:gd name="T62" fmla="*/ 882 w 1392"/>
              <a:gd name="T63" fmla="*/ 703 h 1318"/>
              <a:gd name="T64" fmla="*/ 675 w 1392"/>
              <a:gd name="T65" fmla="*/ 478 h 1318"/>
              <a:gd name="T66" fmla="*/ 710 w 1392"/>
              <a:gd name="T67" fmla="*/ 457 h 1318"/>
              <a:gd name="T68" fmla="*/ 621 w 1392"/>
              <a:gd name="T69" fmla="*/ 443 h 1318"/>
              <a:gd name="T70" fmla="*/ 645 w 1392"/>
              <a:gd name="T71" fmla="*/ 382 h 1318"/>
              <a:gd name="T72" fmla="*/ 1152 w 1392"/>
              <a:gd name="T73" fmla="*/ 441 h 1318"/>
              <a:gd name="T74" fmla="*/ 1005 w 1392"/>
              <a:gd name="T75" fmla="*/ 333 h 1318"/>
              <a:gd name="T76" fmla="*/ 880 w 1392"/>
              <a:gd name="T77" fmla="*/ 352 h 1318"/>
              <a:gd name="T78" fmla="*/ 1021 w 1392"/>
              <a:gd name="T79" fmla="*/ 572 h 1318"/>
              <a:gd name="T80" fmla="*/ 986 w 1392"/>
              <a:gd name="T81" fmla="*/ 593 h 1318"/>
              <a:gd name="T82" fmla="*/ 790 w 1392"/>
              <a:gd name="T83" fmla="*/ 363 h 1318"/>
              <a:gd name="T84" fmla="*/ 841 w 1392"/>
              <a:gd name="T85" fmla="*/ 380 h 1318"/>
              <a:gd name="T86" fmla="*/ 996 w 1392"/>
              <a:gd name="T87" fmla="*/ 256 h 1318"/>
              <a:gd name="T88" fmla="*/ 1301 w 1392"/>
              <a:gd name="T89" fmla="*/ 87 h 1318"/>
              <a:gd name="T90" fmla="*/ 1307 w 1392"/>
              <a:gd name="T91" fmla="*/ 231 h 1318"/>
              <a:gd name="T92" fmla="*/ 1364 w 1392"/>
              <a:gd name="T93" fmla="*/ 145 h 1318"/>
              <a:gd name="T94" fmla="*/ 1389 w 1392"/>
              <a:gd name="T95" fmla="*/ 165 h 1318"/>
              <a:gd name="T96" fmla="*/ 1360 w 1392"/>
              <a:gd name="T97" fmla="*/ 235 h 1318"/>
              <a:gd name="T98" fmla="*/ 1119 w 1392"/>
              <a:gd name="T99" fmla="*/ 256 h 1318"/>
              <a:gd name="T100" fmla="*/ 1153 w 1392"/>
              <a:gd name="T101" fmla="*/ 9 h 1318"/>
              <a:gd name="T102" fmla="*/ 1250 w 1392"/>
              <a:gd name="T103" fmla="*/ 83 h 1318"/>
              <a:gd name="T104" fmla="*/ 1117 w 1392"/>
              <a:gd name="T105" fmla="*/ 167 h 13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>
              <a:path w="1392" h="1318">
                <a:moveTo>
                  <a:pt x="348" y="1076"/>
                </a:moveTo>
                <a:cubicBezTo>
                  <a:pt x="362" y="1090"/>
                  <a:pt x="372" y="1105"/>
                  <a:pt x="378" y="1121"/>
                </a:cubicBezTo>
                <a:cubicBezTo>
                  <a:pt x="383" y="1137"/>
                  <a:pt x="385" y="1153"/>
                  <a:pt x="384" y="1170"/>
                </a:cubicBezTo>
                <a:cubicBezTo>
                  <a:pt x="382" y="1187"/>
                  <a:pt x="377" y="1203"/>
                  <a:pt x="369" y="1219"/>
                </a:cubicBezTo>
                <a:cubicBezTo>
                  <a:pt x="360" y="1235"/>
                  <a:pt x="349" y="1250"/>
                  <a:pt x="335" y="1265"/>
                </a:cubicBezTo>
                <a:cubicBezTo>
                  <a:pt x="325" y="1275"/>
                  <a:pt x="315" y="1283"/>
                  <a:pt x="305" y="1290"/>
                </a:cubicBezTo>
                <a:cubicBezTo>
                  <a:pt x="295" y="1296"/>
                  <a:pt x="285" y="1302"/>
                  <a:pt x="276" y="1306"/>
                </a:cubicBezTo>
                <a:cubicBezTo>
                  <a:pt x="267" y="1310"/>
                  <a:pt x="259" y="1313"/>
                  <a:pt x="252" y="1315"/>
                </a:cubicBezTo>
                <a:cubicBezTo>
                  <a:pt x="244" y="1317"/>
                  <a:pt x="239" y="1318"/>
                  <a:pt x="236" y="1318"/>
                </a:cubicBezTo>
                <a:cubicBezTo>
                  <a:pt x="232" y="1318"/>
                  <a:pt x="228" y="1317"/>
                  <a:pt x="225" y="1315"/>
                </a:cubicBezTo>
                <a:cubicBezTo>
                  <a:pt x="221" y="1313"/>
                  <a:pt x="217" y="1310"/>
                  <a:pt x="212" y="1305"/>
                </a:cubicBezTo>
                <a:cubicBezTo>
                  <a:pt x="209" y="1302"/>
                  <a:pt x="206" y="1299"/>
                  <a:pt x="204" y="1296"/>
                </a:cubicBezTo>
                <a:cubicBezTo>
                  <a:pt x="202" y="1294"/>
                  <a:pt x="201" y="1291"/>
                  <a:pt x="200" y="1289"/>
                </a:cubicBezTo>
                <a:cubicBezTo>
                  <a:pt x="199" y="1287"/>
                  <a:pt x="199" y="1286"/>
                  <a:pt x="200" y="1284"/>
                </a:cubicBezTo>
                <a:cubicBezTo>
                  <a:pt x="200" y="1283"/>
                  <a:pt x="201" y="1281"/>
                  <a:pt x="202" y="1280"/>
                </a:cubicBezTo>
                <a:cubicBezTo>
                  <a:pt x="204" y="1278"/>
                  <a:pt x="208" y="1276"/>
                  <a:pt x="215" y="1275"/>
                </a:cubicBezTo>
                <a:cubicBezTo>
                  <a:pt x="221" y="1274"/>
                  <a:pt x="229" y="1272"/>
                  <a:pt x="238" y="1268"/>
                </a:cubicBezTo>
                <a:cubicBezTo>
                  <a:pt x="248" y="1265"/>
                  <a:pt x="258" y="1261"/>
                  <a:pt x="269" y="1255"/>
                </a:cubicBezTo>
                <a:cubicBezTo>
                  <a:pt x="280" y="1249"/>
                  <a:pt x="292" y="1240"/>
                  <a:pt x="303" y="1229"/>
                </a:cubicBezTo>
                <a:cubicBezTo>
                  <a:pt x="312" y="1220"/>
                  <a:pt x="318" y="1211"/>
                  <a:pt x="323" y="1202"/>
                </a:cubicBezTo>
                <a:cubicBezTo>
                  <a:pt x="328" y="1193"/>
                  <a:pt x="331" y="1183"/>
                  <a:pt x="332" y="1174"/>
                </a:cubicBezTo>
                <a:cubicBezTo>
                  <a:pt x="333" y="1165"/>
                  <a:pt x="331" y="1156"/>
                  <a:pt x="328" y="1147"/>
                </a:cubicBezTo>
                <a:cubicBezTo>
                  <a:pt x="325" y="1138"/>
                  <a:pt x="319" y="1130"/>
                  <a:pt x="311" y="1122"/>
                </a:cubicBezTo>
                <a:cubicBezTo>
                  <a:pt x="303" y="1113"/>
                  <a:pt x="294" y="1108"/>
                  <a:pt x="284" y="1106"/>
                </a:cubicBezTo>
                <a:cubicBezTo>
                  <a:pt x="274" y="1104"/>
                  <a:pt x="264" y="1104"/>
                  <a:pt x="253" y="1105"/>
                </a:cubicBezTo>
                <a:cubicBezTo>
                  <a:pt x="242" y="1107"/>
                  <a:pt x="231" y="1110"/>
                  <a:pt x="219" y="1114"/>
                </a:cubicBezTo>
                <a:cubicBezTo>
                  <a:pt x="208" y="1119"/>
                  <a:pt x="196" y="1123"/>
                  <a:pt x="183" y="1128"/>
                </a:cubicBezTo>
                <a:cubicBezTo>
                  <a:pt x="171" y="1132"/>
                  <a:pt x="158" y="1136"/>
                  <a:pt x="146" y="1139"/>
                </a:cubicBezTo>
                <a:cubicBezTo>
                  <a:pt x="133" y="1142"/>
                  <a:pt x="120" y="1144"/>
                  <a:pt x="108" y="1144"/>
                </a:cubicBezTo>
                <a:cubicBezTo>
                  <a:pt x="95" y="1144"/>
                  <a:pt x="82" y="1141"/>
                  <a:pt x="70" y="1136"/>
                </a:cubicBezTo>
                <a:cubicBezTo>
                  <a:pt x="57" y="1132"/>
                  <a:pt x="45" y="1123"/>
                  <a:pt x="33" y="1111"/>
                </a:cubicBezTo>
                <a:cubicBezTo>
                  <a:pt x="21" y="1099"/>
                  <a:pt x="12" y="1086"/>
                  <a:pt x="7" y="1071"/>
                </a:cubicBezTo>
                <a:cubicBezTo>
                  <a:pt x="1" y="1057"/>
                  <a:pt x="0" y="1043"/>
                  <a:pt x="1" y="1028"/>
                </a:cubicBezTo>
                <a:cubicBezTo>
                  <a:pt x="2" y="1013"/>
                  <a:pt x="7" y="999"/>
                  <a:pt x="15" y="984"/>
                </a:cubicBezTo>
                <a:cubicBezTo>
                  <a:pt x="22" y="970"/>
                  <a:pt x="32" y="956"/>
                  <a:pt x="45" y="943"/>
                </a:cubicBezTo>
                <a:cubicBezTo>
                  <a:pt x="52" y="937"/>
                  <a:pt x="59" y="931"/>
                  <a:pt x="67" y="925"/>
                </a:cubicBezTo>
                <a:cubicBezTo>
                  <a:pt x="75" y="920"/>
                  <a:pt x="82" y="915"/>
                  <a:pt x="90" y="911"/>
                </a:cubicBezTo>
                <a:cubicBezTo>
                  <a:pt x="98" y="907"/>
                  <a:pt x="105" y="904"/>
                  <a:pt x="112" y="902"/>
                </a:cubicBezTo>
                <a:cubicBezTo>
                  <a:pt x="119" y="900"/>
                  <a:pt x="124" y="898"/>
                  <a:pt x="127" y="898"/>
                </a:cubicBezTo>
                <a:cubicBezTo>
                  <a:pt x="130" y="898"/>
                  <a:pt x="132" y="899"/>
                  <a:pt x="133" y="899"/>
                </a:cubicBezTo>
                <a:cubicBezTo>
                  <a:pt x="135" y="899"/>
                  <a:pt x="136" y="900"/>
                  <a:pt x="138" y="901"/>
                </a:cubicBezTo>
                <a:cubicBezTo>
                  <a:pt x="139" y="902"/>
                  <a:pt x="141" y="903"/>
                  <a:pt x="143" y="905"/>
                </a:cubicBezTo>
                <a:cubicBezTo>
                  <a:pt x="145" y="907"/>
                  <a:pt x="148" y="909"/>
                  <a:pt x="151" y="912"/>
                </a:cubicBezTo>
                <a:cubicBezTo>
                  <a:pt x="153" y="915"/>
                  <a:pt x="156" y="917"/>
                  <a:pt x="158" y="920"/>
                </a:cubicBezTo>
                <a:cubicBezTo>
                  <a:pt x="159" y="922"/>
                  <a:pt x="161" y="924"/>
                  <a:pt x="162" y="926"/>
                </a:cubicBezTo>
                <a:cubicBezTo>
                  <a:pt x="163" y="928"/>
                  <a:pt x="163" y="930"/>
                  <a:pt x="163" y="931"/>
                </a:cubicBezTo>
                <a:cubicBezTo>
                  <a:pt x="163" y="933"/>
                  <a:pt x="162" y="934"/>
                  <a:pt x="161" y="935"/>
                </a:cubicBezTo>
                <a:cubicBezTo>
                  <a:pt x="160" y="937"/>
                  <a:pt x="156" y="938"/>
                  <a:pt x="150" y="940"/>
                </a:cubicBezTo>
                <a:cubicBezTo>
                  <a:pt x="144" y="941"/>
                  <a:pt x="138" y="943"/>
                  <a:pt x="130" y="946"/>
                </a:cubicBezTo>
                <a:cubicBezTo>
                  <a:pt x="122" y="948"/>
                  <a:pt x="113" y="952"/>
                  <a:pt x="104" y="957"/>
                </a:cubicBezTo>
                <a:cubicBezTo>
                  <a:pt x="95" y="962"/>
                  <a:pt x="86" y="969"/>
                  <a:pt x="77" y="978"/>
                </a:cubicBezTo>
                <a:cubicBezTo>
                  <a:pt x="68" y="986"/>
                  <a:pt x="62" y="994"/>
                  <a:pt x="59" y="1002"/>
                </a:cubicBezTo>
                <a:cubicBezTo>
                  <a:pt x="55" y="1011"/>
                  <a:pt x="53" y="1019"/>
                  <a:pt x="52" y="1026"/>
                </a:cubicBezTo>
                <a:cubicBezTo>
                  <a:pt x="52" y="1034"/>
                  <a:pt x="53" y="1041"/>
                  <a:pt x="56" y="1048"/>
                </a:cubicBezTo>
                <a:cubicBezTo>
                  <a:pt x="59" y="1055"/>
                  <a:pt x="64" y="1062"/>
                  <a:pt x="69" y="1067"/>
                </a:cubicBezTo>
                <a:cubicBezTo>
                  <a:pt x="78" y="1076"/>
                  <a:pt x="87" y="1081"/>
                  <a:pt x="96" y="1083"/>
                </a:cubicBezTo>
                <a:cubicBezTo>
                  <a:pt x="106" y="1085"/>
                  <a:pt x="117" y="1085"/>
                  <a:pt x="128" y="1084"/>
                </a:cubicBezTo>
                <a:cubicBezTo>
                  <a:pt x="138" y="1082"/>
                  <a:pt x="150" y="1079"/>
                  <a:pt x="162" y="1075"/>
                </a:cubicBezTo>
                <a:cubicBezTo>
                  <a:pt x="174" y="1070"/>
                  <a:pt x="186" y="1066"/>
                  <a:pt x="198" y="1061"/>
                </a:cubicBezTo>
                <a:cubicBezTo>
                  <a:pt x="210" y="1057"/>
                  <a:pt x="223" y="1053"/>
                  <a:pt x="236" y="1049"/>
                </a:cubicBezTo>
                <a:cubicBezTo>
                  <a:pt x="248" y="1046"/>
                  <a:pt x="261" y="1044"/>
                  <a:pt x="274" y="1044"/>
                </a:cubicBezTo>
                <a:cubicBezTo>
                  <a:pt x="287" y="1044"/>
                  <a:pt x="299" y="1047"/>
                  <a:pt x="312" y="1051"/>
                </a:cubicBezTo>
                <a:cubicBezTo>
                  <a:pt x="324" y="1056"/>
                  <a:pt x="336" y="1064"/>
                  <a:pt x="348" y="1076"/>
                </a:cubicBezTo>
                <a:close/>
                <a:moveTo>
                  <a:pt x="541" y="814"/>
                </a:moveTo>
                <a:cubicBezTo>
                  <a:pt x="547" y="820"/>
                  <a:pt x="550" y="826"/>
                  <a:pt x="549" y="831"/>
                </a:cubicBezTo>
                <a:cubicBezTo>
                  <a:pt x="549" y="837"/>
                  <a:pt x="547" y="842"/>
                  <a:pt x="543" y="845"/>
                </a:cubicBezTo>
                <a:lnTo>
                  <a:pt x="407" y="981"/>
                </a:lnTo>
                <a:cubicBezTo>
                  <a:pt x="418" y="993"/>
                  <a:pt x="430" y="1002"/>
                  <a:pt x="441" y="1009"/>
                </a:cubicBezTo>
                <a:cubicBezTo>
                  <a:pt x="453" y="1016"/>
                  <a:pt x="464" y="1020"/>
                  <a:pt x="476" y="1021"/>
                </a:cubicBezTo>
                <a:cubicBezTo>
                  <a:pt x="488" y="1022"/>
                  <a:pt x="500" y="1020"/>
                  <a:pt x="512" y="1015"/>
                </a:cubicBezTo>
                <a:cubicBezTo>
                  <a:pt x="525" y="1010"/>
                  <a:pt x="537" y="1001"/>
                  <a:pt x="549" y="989"/>
                </a:cubicBezTo>
                <a:cubicBezTo>
                  <a:pt x="559" y="979"/>
                  <a:pt x="567" y="969"/>
                  <a:pt x="573" y="960"/>
                </a:cubicBezTo>
                <a:cubicBezTo>
                  <a:pt x="579" y="951"/>
                  <a:pt x="584" y="942"/>
                  <a:pt x="588" y="935"/>
                </a:cubicBezTo>
                <a:cubicBezTo>
                  <a:pt x="591" y="927"/>
                  <a:pt x="594" y="921"/>
                  <a:pt x="596" y="916"/>
                </a:cubicBezTo>
                <a:cubicBezTo>
                  <a:pt x="598" y="910"/>
                  <a:pt x="600" y="907"/>
                  <a:pt x="602" y="905"/>
                </a:cubicBezTo>
                <a:cubicBezTo>
                  <a:pt x="603" y="904"/>
                  <a:pt x="604" y="903"/>
                  <a:pt x="606" y="903"/>
                </a:cubicBezTo>
                <a:cubicBezTo>
                  <a:pt x="607" y="903"/>
                  <a:pt x="608" y="903"/>
                  <a:pt x="610" y="903"/>
                </a:cubicBezTo>
                <a:cubicBezTo>
                  <a:pt x="611" y="904"/>
                  <a:pt x="613" y="905"/>
                  <a:pt x="615" y="907"/>
                </a:cubicBezTo>
                <a:cubicBezTo>
                  <a:pt x="618" y="908"/>
                  <a:pt x="620" y="911"/>
                  <a:pt x="623" y="913"/>
                </a:cubicBezTo>
                <a:cubicBezTo>
                  <a:pt x="625" y="915"/>
                  <a:pt x="626" y="917"/>
                  <a:pt x="628" y="919"/>
                </a:cubicBezTo>
                <a:cubicBezTo>
                  <a:pt x="629" y="920"/>
                  <a:pt x="630" y="922"/>
                  <a:pt x="631" y="923"/>
                </a:cubicBezTo>
                <a:cubicBezTo>
                  <a:pt x="632" y="925"/>
                  <a:pt x="633" y="926"/>
                  <a:pt x="633" y="928"/>
                </a:cubicBezTo>
                <a:cubicBezTo>
                  <a:pt x="633" y="929"/>
                  <a:pt x="634" y="931"/>
                  <a:pt x="634" y="932"/>
                </a:cubicBezTo>
                <a:cubicBezTo>
                  <a:pt x="634" y="934"/>
                  <a:pt x="632" y="938"/>
                  <a:pt x="630" y="944"/>
                </a:cubicBezTo>
                <a:cubicBezTo>
                  <a:pt x="628" y="950"/>
                  <a:pt x="625" y="957"/>
                  <a:pt x="620" y="965"/>
                </a:cubicBezTo>
                <a:cubicBezTo>
                  <a:pt x="615" y="974"/>
                  <a:pt x="609" y="983"/>
                  <a:pt x="602" y="993"/>
                </a:cubicBezTo>
                <a:cubicBezTo>
                  <a:pt x="595" y="1003"/>
                  <a:pt x="586" y="1013"/>
                  <a:pt x="576" y="1023"/>
                </a:cubicBezTo>
                <a:cubicBezTo>
                  <a:pt x="559" y="1040"/>
                  <a:pt x="542" y="1052"/>
                  <a:pt x="525" y="1061"/>
                </a:cubicBezTo>
                <a:cubicBezTo>
                  <a:pt x="507" y="1069"/>
                  <a:pt x="489" y="1072"/>
                  <a:pt x="471" y="1072"/>
                </a:cubicBezTo>
                <a:cubicBezTo>
                  <a:pt x="453" y="1071"/>
                  <a:pt x="435" y="1066"/>
                  <a:pt x="417" y="1056"/>
                </a:cubicBezTo>
                <a:cubicBezTo>
                  <a:pt x="398" y="1047"/>
                  <a:pt x="380" y="1032"/>
                  <a:pt x="361" y="1014"/>
                </a:cubicBezTo>
                <a:cubicBezTo>
                  <a:pt x="343" y="996"/>
                  <a:pt x="330" y="978"/>
                  <a:pt x="320" y="959"/>
                </a:cubicBezTo>
                <a:cubicBezTo>
                  <a:pt x="310" y="940"/>
                  <a:pt x="305" y="922"/>
                  <a:pt x="304" y="903"/>
                </a:cubicBezTo>
                <a:cubicBezTo>
                  <a:pt x="303" y="885"/>
                  <a:pt x="305" y="867"/>
                  <a:pt x="312" y="849"/>
                </a:cubicBezTo>
                <a:cubicBezTo>
                  <a:pt x="319" y="832"/>
                  <a:pt x="330" y="816"/>
                  <a:pt x="346" y="800"/>
                </a:cubicBezTo>
                <a:cubicBezTo>
                  <a:pt x="362" y="784"/>
                  <a:pt x="378" y="773"/>
                  <a:pt x="395" y="767"/>
                </a:cubicBezTo>
                <a:cubicBezTo>
                  <a:pt x="411" y="761"/>
                  <a:pt x="428" y="758"/>
                  <a:pt x="444" y="760"/>
                </a:cubicBezTo>
                <a:cubicBezTo>
                  <a:pt x="460" y="761"/>
                  <a:pt x="476" y="766"/>
                  <a:pt x="491" y="775"/>
                </a:cubicBezTo>
                <a:cubicBezTo>
                  <a:pt x="506" y="783"/>
                  <a:pt x="521" y="794"/>
                  <a:pt x="534" y="807"/>
                </a:cubicBezTo>
                <a:lnTo>
                  <a:pt x="541" y="814"/>
                </a:lnTo>
                <a:close/>
                <a:moveTo>
                  <a:pt x="492" y="841"/>
                </a:moveTo>
                <a:cubicBezTo>
                  <a:pt x="472" y="821"/>
                  <a:pt x="452" y="809"/>
                  <a:pt x="432" y="807"/>
                </a:cubicBezTo>
                <a:cubicBezTo>
                  <a:pt x="411" y="805"/>
                  <a:pt x="392" y="814"/>
                  <a:pt x="373" y="832"/>
                </a:cubicBezTo>
                <a:cubicBezTo>
                  <a:pt x="364" y="841"/>
                  <a:pt x="357" y="851"/>
                  <a:pt x="354" y="862"/>
                </a:cubicBezTo>
                <a:cubicBezTo>
                  <a:pt x="350" y="872"/>
                  <a:pt x="349" y="883"/>
                  <a:pt x="350" y="894"/>
                </a:cubicBezTo>
                <a:cubicBezTo>
                  <a:pt x="351" y="904"/>
                  <a:pt x="354" y="915"/>
                  <a:pt x="359" y="925"/>
                </a:cubicBezTo>
                <a:cubicBezTo>
                  <a:pt x="364" y="935"/>
                  <a:pt x="371" y="945"/>
                  <a:pt x="379" y="954"/>
                </a:cubicBezTo>
                <a:lnTo>
                  <a:pt x="492" y="841"/>
                </a:lnTo>
                <a:close/>
                <a:moveTo>
                  <a:pt x="642" y="551"/>
                </a:moveTo>
                <a:cubicBezTo>
                  <a:pt x="646" y="555"/>
                  <a:pt x="648" y="558"/>
                  <a:pt x="651" y="560"/>
                </a:cubicBezTo>
                <a:cubicBezTo>
                  <a:pt x="653" y="563"/>
                  <a:pt x="654" y="565"/>
                  <a:pt x="655" y="566"/>
                </a:cubicBezTo>
                <a:cubicBezTo>
                  <a:pt x="656" y="568"/>
                  <a:pt x="656" y="570"/>
                  <a:pt x="656" y="571"/>
                </a:cubicBezTo>
                <a:cubicBezTo>
                  <a:pt x="656" y="572"/>
                  <a:pt x="656" y="574"/>
                  <a:pt x="654" y="575"/>
                </a:cubicBezTo>
                <a:cubicBezTo>
                  <a:pt x="653" y="576"/>
                  <a:pt x="651" y="577"/>
                  <a:pt x="649" y="578"/>
                </a:cubicBezTo>
                <a:cubicBezTo>
                  <a:pt x="647" y="579"/>
                  <a:pt x="644" y="581"/>
                  <a:pt x="641" y="582"/>
                </a:cubicBezTo>
                <a:cubicBezTo>
                  <a:pt x="638" y="584"/>
                  <a:pt x="635" y="586"/>
                  <a:pt x="632" y="588"/>
                </a:cubicBezTo>
                <a:cubicBezTo>
                  <a:pt x="628" y="590"/>
                  <a:pt x="625" y="593"/>
                  <a:pt x="622" y="596"/>
                </a:cubicBezTo>
                <a:cubicBezTo>
                  <a:pt x="618" y="600"/>
                  <a:pt x="615" y="604"/>
                  <a:pt x="613" y="609"/>
                </a:cubicBezTo>
                <a:cubicBezTo>
                  <a:pt x="611" y="615"/>
                  <a:pt x="609" y="621"/>
                  <a:pt x="609" y="629"/>
                </a:cubicBezTo>
                <a:cubicBezTo>
                  <a:pt x="608" y="636"/>
                  <a:pt x="609" y="645"/>
                  <a:pt x="610" y="655"/>
                </a:cubicBezTo>
                <a:cubicBezTo>
                  <a:pt x="611" y="665"/>
                  <a:pt x="614" y="677"/>
                  <a:pt x="617" y="691"/>
                </a:cubicBezTo>
                <a:lnTo>
                  <a:pt x="752" y="827"/>
                </a:lnTo>
                <a:cubicBezTo>
                  <a:pt x="754" y="828"/>
                  <a:pt x="754" y="829"/>
                  <a:pt x="755" y="831"/>
                </a:cubicBezTo>
                <a:cubicBezTo>
                  <a:pt x="755" y="832"/>
                  <a:pt x="755" y="834"/>
                  <a:pt x="754" y="836"/>
                </a:cubicBezTo>
                <a:cubicBezTo>
                  <a:pt x="753" y="838"/>
                  <a:pt x="752" y="840"/>
                  <a:pt x="749" y="843"/>
                </a:cubicBezTo>
                <a:cubicBezTo>
                  <a:pt x="747" y="846"/>
                  <a:pt x="744" y="849"/>
                  <a:pt x="740" y="853"/>
                </a:cubicBezTo>
                <a:cubicBezTo>
                  <a:pt x="737" y="857"/>
                  <a:pt x="734" y="860"/>
                  <a:pt x="731" y="862"/>
                </a:cubicBezTo>
                <a:cubicBezTo>
                  <a:pt x="728" y="864"/>
                  <a:pt x="726" y="865"/>
                  <a:pt x="724" y="866"/>
                </a:cubicBezTo>
                <a:cubicBezTo>
                  <a:pt x="722" y="867"/>
                  <a:pt x="720" y="867"/>
                  <a:pt x="718" y="867"/>
                </a:cubicBezTo>
                <a:cubicBezTo>
                  <a:pt x="717" y="867"/>
                  <a:pt x="716" y="866"/>
                  <a:pt x="715" y="865"/>
                </a:cubicBezTo>
                <a:lnTo>
                  <a:pt x="508" y="658"/>
                </a:lnTo>
                <a:cubicBezTo>
                  <a:pt x="507" y="657"/>
                  <a:pt x="506" y="656"/>
                  <a:pt x="506" y="655"/>
                </a:cubicBezTo>
                <a:cubicBezTo>
                  <a:pt x="505" y="653"/>
                  <a:pt x="506" y="652"/>
                  <a:pt x="506" y="650"/>
                </a:cubicBezTo>
                <a:cubicBezTo>
                  <a:pt x="507" y="648"/>
                  <a:pt x="508" y="645"/>
                  <a:pt x="510" y="643"/>
                </a:cubicBezTo>
                <a:cubicBezTo>
                  <a:pt x="512" y="641"/>
                  <a:pt x="515" y="638"/>
                  <a:pt x="518" y="634"/>
                </a:cubicBezTo>
                <a:cubicBezTo>
                  <a:pt x="522" y="631"/>
                  <a:pt x="525" y="628"/>
                  <a:pt x="527" y="626"/>
                </a:cubicBezTo>
                <a:cubicBezTo>
                  <a:pt x="529" y="624"/>
                  <a:pt x="532" y="623"/>
                  <a:pt x="534" y="622"/>
                </a:cubicBezTo>
                <a:cubicBezTo>
                  <a:pt x="535" y="622"/>
                  <a:pt x="537" y="622"/>
                  <a:pt x="538" y="622"/>
                </a:cubicBezTo>
                <a:cubicBezTo>
                  <a:pt x="540" y="622"/>
                  <a:pt x="541" y="623"/>
                  <a:pt x="542" y="624"/>
                </a:cubicBezTo>
                <a:lnTo>
                  <a:pt x="572" y="654"/>
                </a:lnTo>
                <a:cubicBezTo>
                  <a:pt x="570" y="640"/>
                  <a:pt x="568" y="628"/>
                  <a:pt x="568" y="618"/>
                </a:cubicBezTo>
                <a:cubicBezTo>
                  <a:pt x="568" y="608"/>
                  <a:pt x="569" y="599"/>
                  <a:pt x="570" y="592"/>
                </a:cubicBezTo>
                <a:cubicBezTo>
                  <a:pt x="571" y="584"/>
                  <a:pt x="574" y="578"/>
                  <a:pt x="577" y="572"/>
                </a:cubicBezTo>
                <a:cubicBezTo>
                  <a:pt x="580" y="567"/>
                  <a:pt x="584" y="562"/>
                  <a:pt x="588" y="558"/>
                </a:cubicBezTo>
                <a:cubicBezTo>
                  <a:pt x="590" y="556"/>
                  <a:pt x="593" y="553"/>
                  <a:pt x="596" y="551"/>
                </a:cubicBezTo>
                <a:cubicBezTo>
                  <a:pt x="598" y="549"/>
                  <a:pt x="601" y="547"/>
                  <a:pt x="605" y="544"/>
                </a:cubicBezTo>
                <a:cubicBezTo>
                  <a:pt x="608" y="542"/>
                  <a:pt x="611" y="541"/>
                  <a:pt x="614" y="539"/>
                </a:cubicBezTo>
                <a:cubicBezTo>
                  <a:pt x="617" y="538"/>
                  <a:pt x="620" y="537"/>
                  <a:pt x="621" y="537"/>
                </a:cubicBezTo>
                <a:cubicBezTo>
                  <a:pt x="623" y="537"/>
                  <a:pt x="624" y="537"/>
                  <a:pt x="625" y="537"/>
                </a:cubicBezTo>
                <a:cubicBezTo>
                  <a:pt x="626" y="537"/>
                  <a:pt x="627" y="538"/>
                  <a:pt x="629" y="539"/>
                </a:cubicBezTo>
                <a:cubicBezTo>
                  <a:pt x="630" y="540"/>
                  <a:pt x="632" y="541"/>
                  <a:pt x="634" y="543"/>
                </a:cubicBezTo>
                <a:cubicBezTo>
                  <a:pt x="636" y="545"/>
                  <a:pt x="639" y="548"/>
                  <a:pt x="642" y="551"/>
                </a:cubicBezTo>
                <a:close/>
                <a:moveTo>
                  <a:pt x="916" y="663"/>
                </a:moveTo>
                <a:cubicBezTo>
                  <a:pt x="918" y="664"/>
                  <a:pt x="918" y="665"/>
                  <a:pt x="919" y="667"/>
                </a:cubicBezTo>
                <a:cubicBezTo>
                  <a:pt x="919" y="668"/>
                  <a:pt x="919" y="670"/>
                  <a:pt x="918" y="672"/>
                </a:cubicBezTo>
                <a:cubicBezTo>
                  <a:pt x="917" y="674"/>
                  <a:pt x="916" y="676"/>
                  <a:pt x="913" y="679"/>
                </a:cubicBezTo>
                <a:cubicBezTo>
                  <a:pt x="911" y="682"/>
                  <a:pt x="908" y="685"/>
                  <a:pt x="904" y="689"/>
                </a:cubicBezTo>
                <a:cubicBezTo>
                  <a:pt x="901" y="693"/>
                  <a:pt x="898" y="696"/>
                  <a:pt x="895" y="698"/>
                </a:cubicBezTo>
                <a:cubicBezTo>
                  <a:pt x="892" y="700"/>
                  <a:pt x="890" y="701"/>
                  <a:pt x="888" y="702"/>
                </a:cubicBezTo>
                <a:cubicBezTo>
                  <a:pt x="886" y="703"/>
                  <a:pt x="884" y="703"/>
                  <a:pt x="882" y="703"/>
                </a:cubicBezTo>
                <a:cubicBezTo>
                  <a:pt x="881" y="703"/>
                  <a:pt x="880" y="702"/>
                  <a:pt x="879" y="701"/>
                </a:cubicBezTo>
                <a:lnTo>
                  <a:pt x="672" y="494"/>
                </a:lnTo>
                <a:cubicBezTo>
                  <a:pt x="671" y="493"/>
                  <a:pt x="670" y="492"/>
                  <a:pt x="670" y="491"/>
                </a:cubicBezTo>
                <a:cubicBezTo>
                  <a:pt x="670" y="489"/>
                  <a:pt x="670" y="487"/>
                  <a:pt x="671" y="485"/>
                </a:cubicBezTo>
                <a:cubicBezTo>
                  <a:pt x="672" y="483"/>
                  <a:pt x="673" y="481"/>
                  <a:pt x="675" y="478"/>
                </a:cubicBezTo>
                <a:cubicBezTo>
                  <a:pt x="677" y="475"/>
                  <a:pt x="680" y="472"/>
                  <a:pt x="684" y="468"/>
                </a:cubicBezTo>
                <a:cubicBezTo>
                  <a:pt x="688" y="465"/>
                  <a:pt x="691" y="462"/>
                  <a:pt x="694" y="460"/>
                </a:cubicBezTo>
                <a:cubicBezTo>
                  <a:pt x="697" y="457"/>
                  <a:pt x="699" y="456"/>
                  <a:pt x="701" y="455"/>
                </a:cubicBezTo>
                <a:cubicBezTo>
                  <a:pt x="703" y="454"/>
                  <a:pt x="705" y="454"/>
                  <a:pt x="706" y="454"/>
                </a:cubicBezTo>
                <a:cubicBezTo>
                  <a:pt x="708" y="455"/>
                  <a:pt x="709" y="455"/>
                  <a:pt x="710" y="457"/>
                </a:cubicBezTo>
                <a:lnTo>
                  <a:pt x="916" y="663"/>
                </a:lnTo>
                <a:close/>
                <a:moveTo>
                  <a:pt x="645" y="382"/>
                </a:moveTo>
                <a:cubicBezTo>
                  <a:pt x="654" y="391"/>
                  <a:pt x="658" y="399"/>
                  <a:pt x="658" y="406"/>
                </a:cubicBezTo>
                <a:cubicBezTo>
                  <a:pt x="658" y="412"/>
                  <a:pt x="653" y="420"/>
                  <a:pt x="644" y="429"/>
                </a:cubicBezTo>
                <a:cubicBezTo>
                  <a:pt x="635" y="438"/>
                  <a:pt x="628" y="442"/>
                  <a:pt x="621" y="443"/>
                </a:cubicBezTo>
                <a:cubicBezTo>
                  <a:pt x="615" y="443"/>
                  <a:pt x="607" y="438"/>
                  <a:pt x="598" y="430"/>
                </a:cubicBezTo>
                <a:cubicBezTo>
                  <a:pt x="590" y="421"/>
                  <a:pt x="585" y="413"/>
                  <a:pt x="585" y="407"/>
                </a:cubicBezTo>
                <a:cubicBezTo>
                  <a:pt x="586" y="400"/>
                  <a:pt x="590" y="392"/>
                  <a:pt x="599" y="383"/>
                </a:cubicBezTo>
                <a:cubicBezTo>
                  <a:pt x="608" y="374"/>
                  <a:pt x="616" y="370"/>
                  <a:pt x="622" y="370"/>
                </a:cubicBezTo>
                <a:cubicBezTo>
                  <a:pt x="628" y="370"/>
                  <a:pt x="636" y="374"/>
                  <a:pt x="645" y="382"/>
                </a:cubicBezTo>
                <a:close/>
                <a:moveTo>
                  <a:pt x="1164" y="416"/>
                </a:moveTo>
                <a:cubicBezTo>
                  <a:pt x="1165" y="417"/>
                  <a:pt x="1166" y="418"/>
                  <a:pt x="1166" y="420"/>
                </a:cubicBezTo>
                <a:cubicBezTo>
                  <a:pt x="1166" y="421"/>
                  <a:pt x="1166" y="423"/>
                  <a:pt x="1165" y="425"/>
                </a:cubicBezTo>
                <a:cubicBezTo>
                  <a:pt x="1164" y="427"/>
                  <a:pt x="1163" y="429"/>
                  <a:pt x="1161" y="432"/>
                </a:cubicBezTo>
                <a:cubicBezTo>
                  <a:pt x="1159" y="435"/>
                  <a:pt x="1156" y="438"/>
                  <a:pt x="1152" y="441"/>
                </a:cubicBezTo>
                <a:cubicBezTo>
                  <a:pt x="1148" y="445"/>
                  <a:pt x="1145" y="448"/>
                  <a:pt x="1142" y="450"/>
                </a:cubicBezTo>
                <a:cubicBezTo>
                  <a:pt x="1139" y="453"/>
                  <a:pt x="1137" y="454"/>
                  <a:pt x="1135" y="455"/>
                </a:cubicBezTo>
                <a:cubicBezTo>
                  <a:pt x="1133" y="456"/>
                  <a:pt x="1131" y="456"/>
                  <a:pt x="1130" y="456"/>
                </a:cubicBezTo>
                <a:cubicBezTo>
                  <a:pt x="1128" y="455"/>
                  <a:pt x="1127" y="455"/>
                  <a:pt x="1126" y="453"/>
                </a:cubicBezTo>
                <a:lnTo>
                  <a:pt x="1005" y="333"/>
                </a:lnTo>
                <a:cubicBezTo>
                  <a:pt x="993" y="321"/>
                  <a:pt x="983" y="312"/>
                  <a:pt x="974" y="307"/>
                </a:cubicBezTo>
                <a:cubicBezTo>
                  <a:pt x="965" y="302"/>
                  <a:pt x="956" y="298"/>
                  <a:pt x="947" y="296"/>
                </a:cubicBezTo>
                <a:cubicBezTo>
                  <a:pt x="939" y="295"/>
                  <a:pt x="930" y="295"/>
                  <a:pt x="922" y="298"/>
                </a:cubicBezTo>
                <a:cubicBezTo>
                  <a:pt x="913" y="301"/>
                  <a:pt x="906" y="306"/>
                  <a:pt x="898" y="313"/>
                </a:cubicBezTo>
                <a:cubicBezTo>
                  <a:pt x="889" y="323"/>
                  <a:pt x="883" y="336"/>
                  <a:pt x="880" y="352"/>
                </a:cubicBezTo>
                <a:cubicBezTo>
                  <a:pt x="877" y="368"/>
                  <a:pt x="877" y="388"/>
                  <a:pt x="880" y="411"/>
                </a:cubicBezTo>
                <a:lnTo>
                  <a:pt x="1024" y="555"/>
                </a:lnTo>
                <a:cubicBezTo>
                  <a:pt x="1025" y="557"/>
                  <a:pt x="1026" y="558"/>
                  <a:pt x="1026" y="559"/>
                </a:cubicBezTo>
                <a:cubicBezTo>
                  <a:pt x="1026" y="561"/>
                  <a:pt x="1026" y="563"/>
                  <a:pt x="1025" y="565"/>
                </a:cubicBezTo>
                <a:cubicBezTo>
                  <a:pt x="1025" y="567"/>
                  <a:pt x="1023" y="569"/>
                  <a:pt x="1021" y="572"/>
                </a:cubicBezTo>
                <a:cubicBezTo>
                  <a:pt x="1019" y="574"/>
                  <a:pt x="1016" y="578"/>
                  <a:pt x="1012" y="582"/>
                </a:cubicBezTo>
                <a:cubicBezTo>
                  <a:pt x="1008" y="585"/>
                  <a:pt x="1005" y="588"/>
                  <a:pt x="1002" y="590"/>
                </a:cubicBezTo>
                <a:cubicBezTo>
                  <a:pt x="1000" y="592"/>
                  <a:pt x="997" y="594"/>
                  <a:pt x="995" y="595"/>
                </a:cubicBezTo>
                <a:cubicBezTo>
                  <a:pt x="993" y="596"/>
                  <a:pt x="991" y="596"/>
                  <a:pt x="990" y="596"/>
                </a:cubicBezTo>
                <a:cubicBezTo>
                  <a:pt x="989" y="595"/>
                  <a:pt x="987" y="594"/>
                  <a:pt x="986" y="593"/>
                </a:cubicBezTo>
                <a:lnTo>
                  <a:pt x="780" y="387"/>
                </a:lnTo>
                <a:cubicBezTo>
                  <a:pt x="779" y="386"/>
                  <a:pt x="778" y="384"/>
                  <a:pt x="777" y="383"/>
                </a:cubicBezTo>
                <a:cubicBezTo>
                  <a:pt x="777" y="382"/>
                  <a:pt x="777" y="380"/>
                  <a:pt x="778" y="378"/>
                </a:cubicBezTo>
                <a:cubicBezTo>
                  <a:pt x="778" y="376"/>
                  <a:pt x="780" y="374"/>
                  <a:pt x="782" y="371"/>
                </a:cubicBezTo>
                <a:cubicBezTo>
                  <a:pt x="784" y="369"/>
                  <a:pt x="786" y="366"/>
                  <a:pt x="790" y="363"/>
                </a:cubicBezTo>
                <a:cubicBezTo>
                  <a:pt x="793" y="359"/>
                  <a:pt x="796" y="357"/>
                  <a:pt x="799" y="355"/>
                </a:cubicBezTo>
                <a:cubicBezTo>
                  <a:pt x="801" y="353"/>
                  <a:pt x="803" y="351"/>
                  <a:pt x="805" y="351"/>
                </a:cubicBezTo>
                <a:cubicBezTo>
                  <a:pt x="807" y="350"/>
                  <a:pt x="809" y="350"/>
                  <a:pt x="810" y="350"/>
                </a:cubicBezTo>
                <a:cubicBezTo>
                  <a:pt x="811" y="351"/>
                  <a:pt x="813" y="352"/>
                  <a:pt x="814" y="353"/>
                </a:cubicBezTo>
                <a:lnTo>
                  <a:pt x="841" y="380"/>
                </a:lnTo>
                <a:cubicBezTo>
                  <a:pt x="840" y="355"/>
                  <a:pt x="842" y="334"/>
                  <a:pt x="847" y="317"/>
                </a:cubicBezTo>
                <a:cubicBezTo>
                  <a:pt x="853" y="299"/>
                  <a:pt x="861" y="284"/>
                  <a:pt x="873" y="273"/>
                </a:cubicBezTo>
                <a:cubicBezTo>
                  <a:pt x="887" y="259"/>
                  <a:pt x="901" y="250"/>
                  <a:pt x="915" y="245"/>
                </a:cubicBezTo>
                <a:cubicBezTo>
                  <a:pt x="929" y="240"/>
                  <a:pt x="943" y="239"/>
                  <a:pt x="956" y="241"/>
                </a:cubicBezTo>
                <a:cubicBezTo>
                  <a:pt x="970" y="243"/>
                  <a:pt x="983" y="248"/>
                  <a:pt x="996" y="256"/>
                </a:cubicBezTo>
                <a:cubicBezTo>
                  <a:pt x="1009" y="264"/>
                  <a:pt x="1023" y="275"/>
                  <a:pt x="1038" y="290"/>
                </a:cubicBezTo>
                <a:lnTo>
                  <a:pt x="1164" y="416"/>
                </a:lnTo>
                <a:close/>
                <a:moveTo>
                  <a:pt x="1299" y="56"/>
                </a:moveTo>
                <a:cubicBezTo>
                  <a:pt x="1305" y="62"/>
                  <a:pt x="1308" y="68"/>
                  <a:pt x="1307" y="73"/>
                </a:cubicBezTo>
                <a:cubicBezTo>
                  <a:pt x="1307" y="79"/>
                  <a:pt x="1305" y="84"/>
                  <a:pt x="1301" y="87"/>
                </a:cubicBezTo>
                <a:lnTo>
                  <a:pt x="1165" y="223"/>
                </a:lnTo>
                <a:cubicBezTo>
                  <a:pt x="1176" y="235"/>
                  <a:pt x="1188" y="244"/>
                  <a:pt x="1199" y="251"/>
                </a:cubicBezTo>
                <a:cubicBezTo>
                  <a:pt x="1211" y="258"/>
                  <a:pt x="1222" y="262"/>
                  <a:pt x="1234" y="263"/>
                </a:cubicBezTo>
                <a:cubicBezTo>
                  <a:pt x="1246" y="264"/>
                  <a:pt x="1258" y="262"/>
                  <a:pt x="1270" y="257"/>
                </a:cubicBezTo>
                <a:cubicBezTo>
                  <a:pt x="1283" y="252"/>
                  <a:pt x="1295" y="243"/>
                  <a:pt x="1307" y="231"/>
                </a:cubicBezTo>
                <a:cubicBezTo>
                  <a:pt x="1317" y="221"/>
                  <a:pt x="1325" y="211"/>
                  <a:pt x="1331" y="202"/>
                </a:cubicBezTo>
                <a:cubicBezTo>
                  <a:pt x="1337" y="193"/>
                  <a:pt x="1342" y="184"/>
                  <a:pt x="1346" y="177"/>
                </a:cubicBezTo>
                <a:cubicBezTo>
                  <a:pt x="1349" y="169"/>
                  <a:pt x="1352" y="163"/>
                  <a:pt x="1354" y="158"/>
                </a:cubicBezTo>
                <a:cubicBezTo>
                  <a:pt x="1356" y="152"/>
                  <a:pt x="1358" y="149"/>
                  <a:pt x="1360" y="147"/>
                </a:cubicBezTo>
                <a:cubicBezTo>
                  <a:pt x="1361" y="146"/>
                  <a:pt x="1362" y="145"/>
                  <a:pt x="1364" y="145"/>
                </a:cubicBezTo>
                <a:cubicBezTo>
                  <a:pt x="1365" y="145"/>
                  <a:pt x="1366" y="145"/>
                  <a:pt x="1368" y="145"/>
                </a:cubicBezTo>
                <a:cubicBezTo>
                  <a:pt x="1369" y="146"/>
                  <a:pt x="1371" y="147"/>
                  <a:pt x="1373" y="149"/>
                </a:cubicBezTo>
                <a:cubicBezTo>
                  <a:pt x="1376" y="150"/>
                  <a:pt x="1378" y="153"/>
                  <a:pt x="1381" y="155"/>
                </a:cubicBezTo>
                <a:cubicBezTo>
                  <a:pt x="1383" y="157"/>
                  <a:pt x="1384" y="159"/>
                  <a:pt x="1386" y="161"/>
                </a:cubicBezTo>
                <a:cubicBezTo>
                  <a:pt x="1387" y="162"/>
                  <a:pt x="1388" y="164"/>
                  <a:pt x="1389" y="165"/>
                </a:cubicBezTo>
                <a:cubicBezTo>
                  <a:pt x="1390" y="167"/>
                  <a:pt x="1391" y="168"/>
                  <a:pt x="1391" y="170"/>
                </a:cubicBezTo>
                <a:cubicBezTo>
                  <a:pt x="1391" y="171"/>
                  <a:pt x="1392" y="173"/>
                  <a:pt x="1392" y="174"/>
                </a:cubicBezTo>
                <a:cubicBezTo>
                  <a:pt x="1392" y="176"/>
                  <a:pt x="1390" y="180"/>
                  <a:pt x="1388" y="186"/>
                </a:cubicBezTo>
                <a:cubicBezTo>
                  <a:pt x="1386" y="192"/>
                  <a:pt x="1383" y="199"/>
                  <a:pt x="1378" y="207"/>
                </a:cubicBezTo>
                <a:cubicBezTo>
                  <a:pt x="1373" y="216"/>
                  <a:pt x="1367" y="225"/>
                  <a:pt x="1360" y="235"/>
                </a:cubicBezTo>
                <a:cubicBezTo>
                  <a:pt x="1353" y="245"/>
                  <a:pt x="1344" y="255"/>
                  <a:pt x="1334" y="265"/>
                </a:cubicBezTo>
                <a:cubicBezTo>
                  <a:pt x="1317" y="282"/>
                  <a:pt x="1300" y="294"/>
                  <a:pt x="1283" y="302"/>
                </a:cubicBezTo>
                <a:cubicBezTo>
                  <a:pt x="1265" y="311"/>
                  <a:pt x="1247" y="314"/>
                  <a:pt x="1229" y="314"/>
                </a:cubicBezTo>
                <a:cubicBezTo>
                  <a:pt x="1211" y="313"/>
                  <a:pt x="1193" y="308"/>
                  <a:pt x="1175" y="298"/>
                </a:cubicBezTo>
                <a:cubicBezTo>
                  <a:pt x="1156" y="289"/>
                  <a:pt x="1138" y="274"/>
                  <a:pt x="1119" y="256"/>
                </a:cubicBezTo>
                <a:cubicBezTo>
                  <a:pt x="1101" y="238"/>
                  <a:pt x="1088" y="220"/>
                  <a:pt x="1078" y="201"/>
                </a:cubicBezTo>
                <a:cubicBezTo>
                  <a:pt x="1068" y="182"/>
                  <a:pt x="1063" y="164"/>
                  <a:pt x="1062" y="145"/>
                </a:cubicBezTo>
                <a:cubicBezTo>
                  <a:pt x="1061" y="127"/>
                  <a:pt x="1064" y="109"/>
                  <a:pt x="1070" y="91"/>
                </a:cubicBezTo>
                <a:cubicBezTo>
                  <a:pt x="1077" y="74"/>
                  <a:pt x="1088" y="58"/>
                  <a:pt x="1104" y="42"/>
                </a:cubicBezTo>
                <a:cubicBezTo>
                  <a:pt x="1120" y="26"/>
                  <a:pt x="1136" y="15"/>
                  <a:pt x="1153" y="9"/>
                </a:cubicBezTo>
                <a:cubicBezTo>
                  <a:pt x="1169" y="3"/>
                  <a:pt x="1186" y="0"/>
                  <a:pt x="1202" y="2"/>
                </a:cubicBezTo>
                <a:cubicBezTo>
                  <a:pt x="1218" y="3"/>
                  <a:pt x="1234" y="8"/>
                  <a:pt x="1249" y="16"/>
                </a:cubicBezTo>
                <a:cubicBezTo>
                  <a:pt x="1264" y="25"/>
                  <a:pt x="1279" y="36"/>
                  <a:pt x="1292" y="49"/>
                </a:cubicBezTo>
                <a:lnTo>
                  <a:pt x="1299" y="56"/>
                </a:lnTo>
                <a:close/>
                <a:moveTo>
                  <a:pt x="1250" y="83"/>
                </a:moveTo>
                <a:cubicBezTo>
                  <a:pt x="1230" y="63"/>
                  <a:pt x="1210" y="51"/>
                  <a:pt x="1190" y="49"/>
                </a:cubicBezTo>
                <a:cubicBezTo>
                  <a:pt x="1169" y="47"/>
                  <a:pt x="1150" y="56"/>
                  <a:pt x="1131" y="74"/>
                </a:cubicBezTo>
                <a:cubicBezTo>
                  <a:pt x="1122" y="83"/>
                  <a:pt x="1115" y="93"/>
                  <a:pt x="1112" y="104"/>
                </a:cubicBezTo>
                <a:cubicBezTo>
                  <a:pt x="1108" y="114"/>
                  <a:pt x="1107" y="125"/>
                  <a:pt x="1108" y="136"/>
                </a:cubicBezTo>
                <a:cubicBezTo>
                  <a:pt x="1109" y="146"/>
                  <a:pt x="1112" y="157"/>
                  <a:pt x="1117" y="167"/>
                </a:cubicBezTo>
                <a:cubicBezTo>
                  <a:pt x="1122" y="177"/>
                  <a:pt x="1129" y="187"/>
                  <a:pt x="1137" y="196"/>
                </a:cubicBezTo>
                <a:lnTo>
                  <a:pt x="1250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7" name="Freeform 251"/>
          <p:cNvSpPr>
            <a:spLocks noEditPoints="1"/>
          </p:cNvSpPr>
          <p:nvPr/>
        </p:nvSpPr>
        <p:spPr bwMode="auto">
          <a:xfrm>
            <a:off x="2257958" y="4418880"/>
            <a:ext cx="388526" cy="446088"/>
          </a:xfrm>
          <a:custGeom>
            <a:avLst/>
            <a:gdLst>
              <a:gd name="T0" fmla="*/ 575 w 2437"/>
              <a:gd name="T1" fmla="*/ 2060 h 2345"/>
              <a:gd name="T2" fmla="*/ 461 w 2437"/>
              <a:gd name="T3" fmla="*/ 2175 h 2345"/>
              <a:gd name="T4" fmla="*/ 64 w 2437"/>
              <a:gd name="T5" fmla="*/ 2044 h 2345"/>
              <a:gd name="T6" fmla="*/ 299 w 2437"/>
              <a:gd name="T7" fmla="*/ 2339 h 2345"/>
              <a:gd name="T8" fmla="*/ 33 w 2437"/>
              <a:gd name="T9" fmla="*/ 2011 h 2345"/>
              <a:gd name="T10" fmla="*/ 266 w 2437"/>
              <a:gd name="T11" fmla="*/ 1826 h 2345"/>
              <a:gd name="T12" fmla="*/ 314 w 2437"/>
              <a:gd name="T13" fmla="*/ 1738 h 2345"/>
              <a:gd name="T14" fmla="*/ 610 w 2437"/>
              <a:gd name="T15" fmla="*/ 1824 h 2345"/>
              <a:gd name="T16" fmla="*/ 799 w 2437"/>
              <a:gd name="T17" fmla="*/ 1758 h 2345"/>
              <a:gd name="T18" fmla="*/ 834 w 2437"/>
              <a:gd name="T19" fmla="*/ 1766 h 2345"/>
              <a:gd name="T20" fmla="*/ 728 w 2437"/>
              <a:gd name="T21" fmla="*/ 1903 h 2345"/>
              <a:gd name="T22" fmla="*/ 549 w 2437"/>
              <a:gd name="T23" fmla="*/ 1643 h 2345"/>
              <a:gd name="T24" fmla="*/ 635 w 2437"/>
              <a:gd name="T25" fmla="*/ 1650 h 2345"/>
              <a:gd name="T26" fmla="*/ 1010 w 2437"/>
              <a:gd name="T27" fmla="*/ 1585 h 2345"/>
              <a:gd name="T28" fmla="*/ 965 w 2437"/>
              <a:gd name="T29" fmla="*/ 1671 h 2345"/>
              <a:gd name="T30" fmla="*/ 694 w 2437"/>
              <a:gd name="T31" fmla="*/ 1538 h 2345"/>
              <a:gd name="T32" fmla="*/ 663 w 2437"/>
              <a:gd name="T33" fmla="*/ 1433 h 2345"/>
              <a:gd name="T34" fmla="*/ 703 w 2437"/>
              <a:gd name="T35" fmla="*/ 1399 h 2345"/>
              <a:gd name="T36" fmla="*/ 838 w 2437"/>
              <a:gd name="T37" fmla="*/ 1418 h 2345"/>
              <a:gd name="T38" fmla="*/ 984 w 2437"/>
              <a:gd name="T39" fmla="*/ 1589 h 2345"/>
              <a:gd name="T40" fmla="*/ 1254 w 2437"/>
              <a:gd name="T41" fmla="*/ 1371 h 2345"/>
              <a:gd name="T42" fmla="*/ 1220 w 2437"/>
              <a:gd name="T43" fmla="*/ 1411 h 2345"/>
              <a:gd name="T44" fmla="*/ 970 w 2437"/>
              <a:gd name="T45" fmla="*/ 1308 h 2345"/>
              <a:gd name="T46" fmla="*/ 1092 w 2437"/>
              <a:gd name="T47" fmla="*/ 1546 h 2345"/>
              <a:gd name="T48" fmla="*/ 772 w 2437"/>
              <a:gd name="T49" fmla="*/ 1226 h 2345"/>
              <a:gd name="T50" fmla="*/ 938 w 2437"/>
              <a:gd name="T51" fmla="*/ 1270 h 2345"/>
              <a:gd name="T52" fmla="*/ 1357 w 2437"/>
              <a:gd name="T53" fmla="*/ 1268 h 2345"/>
              <a:gd name="T54" fmla="*/ 1323 w 2437"/>
              <a:gd name="T55" fmla="*/ 1308 h 2345"/>
              <a:gd name="T56" fmla="*/ 1134 w 2437"/>
              <a:gd name="T57" fmla="*/ 1065 h 2345"/>
              <a:gd name="T58" fmla="*/ 1085 w 2437"/>
              <a:gd name="T59" fmla="*/ 1034 h 2345"/>
              <a:gd name="T60" fmla="*/ 1519 w 2437"/>
              <a:gd name="T61" fmla="*/ 895 h 2345"/>
              <a:gd name="T62" fmla="*/ 1370 w 2437"/>
              <a:gd name="T63" fmla="*/ 1146 h 2345"/>
              <a:gd name="T64" fmla="*/ 1412 w 2437"/>
              <a:gd name="T65" fmla="*/ 839 h 2345"/>
              <a:gd name="T66" fmla="*/ 1337 w 2437"/>
              <a:gd name="T67" fmla="*/ 918 h 2345"/>
              <a:gd name="T68" fmla="*/ 1462 w 2437"/>
              <a:gd name="T69" fmla="*/ 1107 h 2345"/>
              <a:gd name="T70" fmla="*/ 1861 w 2437"/>
              <a:gd name="T71" fmla="*/ 770 h 2345"/>
              <a:gd name="T72" fmla="*/ 1821 w 2437"/>
              <a:gd name="T73" fmla="*/ 804 h 2345"/>
              <a:gd name="T74" fmla="*/ 1575 w 2437"/>
              <a:gd name="T75" fmla="*/ 762 h 2345"/>
              <a:gd name="T76" fmla="*/ 1690 w 2437"/>
              <a:gd name="T77" fmla="*/ 945 h 2345"/>
              <a:gd name="T78" fmla="*/ 1485 w 2437"/>
              <a:gd name="T79" fmla="*/ 713 h 2345"/>
              <a:gd name="T80" fmla="*/ 1568 w 2437"/>
              <a:gd name="T81" fmla="*/ 623 h 2345"/>
              <a:gd name="T82" fmla="*/ 1965 w 2437"/>
              <a:gd name="T83" fmla="*/ 667 h 2345"/>
              <a:gd name="T84" fmla="*/ 1925 w 2437"/>
              <a:gd name="T85" fmla="*/ 701 h 2345"/>
              <a:gd name="T86" fmla="*/ 1747 w 2437"/>
              <a:gd name="T87" fmla="*/ 455 h 2345"/>
              <a:gd name="T88" fmla="*/ 1667 w 2437"/>
              <a:gd name="T89" fmla="*/ 442 h 2345"/>
              <a:gd name="T90" fmla="*/ 2212 w 2437"/>
              <a:gd name="T91" fmla="*/ 419 h 2345"/>
              <a:gd name="T92" fmla="*/ 2172 w 2437"/>
              <a:gd name="T93" fmla="*/ 453 h 2345"/>
              <a:gd name="T94" fmla="*/ 1926 w 2437"/>
              <a:gd name="T95" fmla="*/ 411 h 2345"/>
              <a:gd name="T96" fmla="*/ 2041 w 2437"/>
              <a:gd name="T97" fmla="*/ 595 h 2345"/>
              <a:gd name="T98" fmla="*/ 1836 w 2437"/>
              <a:gd name="T99" fmla="*/ 362 h 2345"/>
              <a:gd name="T100" fmla="*/ 1919 w 2437"/>
              <a:gd name="T101" fmla="*/ 273 h 2345"/>
              <a:gd name="T102" fmla="*/ 2353 w 2437"/>
              <a:gd name="T103" fmla="*/ 73 h 2345"/>
              <a:gd name="T104" fmla="*/ 2377 w 2437"/>
              <a:gd name="T105" fmla="*/ 202 h 2345"/>
              <a:gd name="T106" fmla="*/ 2427 w 2437"/>
              <a:gd name="T107" fmla="*/ 155 h 2345"/>
              <a:gd name="T108" fmla="*/ 2406 w 2437"/>
              <a:gd name="T109" fmla="*/ 235 h 2345"/>
              <a:gd name="T110" fmla="*/ 2108 w 2437"/>
              <a:gd name="T111" fmla="*/ 145 h 2345"/>
              <a:gd name="T112" fmla="*/ 2345 w 2437"/>
              <a:gd name="T113" fmla="*/ 56 h 2345"/>
              <a:gd name="T114" fmla="*/ 2183 w 2437"/>
              <a:gd name="T115" fmla="*/ 195 h 23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2437" h="2345">
                <a:moveTo>
                  <a:pt x="605" y="2020"/>
                </a:moveTo>
                <a:cubicBezTo>
                  <a:pt x="606" y="2021"/>
                  <a:pt x="607" y="2022"/>
                  <a:pt x="607" y="2024"/>
                </a:cubicBezTo>
                <a:cubicBezTo>
                  <a:pt x="608" y="2025"/>
                  <a:pt x="607" y="2027"/>
                  <a:pt x="606" y="2029"/>
                </a:cubicBezTo>
                <a:cubicBezTo>
                  <a:pt x="605" y="2031"/>
                  <a:pt x="604" y="2034"/>
                  <a:pt x="602" y="2037"/>
                </a:cubicBezTo>
                <a:cubicBezTo>
                  <a:pt x="599" y="2039"/>
                  <a:pt x="596" y="2043"/>
                  <a:pt x="593" y="2047"/>
                </a:cubicBezTo>
                <a:cubicBezTo>
                  <a:pt x="589" y="2050"/>
                  <a:pt x="586" y="2053"/>
                  <a:pt x="583" y="2055"/>
                </a:cubicBezTo>
                <a:cubicBezTo>
                  <a:pt x="580" y="2058"/>
                  <a:pt x="577" y="2059"/>
                  <a:pt x="575" y="2060"/>
                </a:cubicBezTo>
                <a:cubicBezTo>
                  <a:pt x="573" y="2061"/>
                  <a:pt x="571" y="2062"/>
                  <a:pt x="570" y="2061"/>
                </a:cubicBezTo>
                <a:cubicBezTo>
                  <a:pt x="568" y="2061"/>
                  <a:pt x="567" y="2060"/>
                  <a:pt x="566" y="2059"/>
                </a:cubicBezTo>
                <a:lnTo>
                  <a:pt x="307" y="1801"/>
                </a:lnTo>
                <a:lnTo>
                  <a:pt x="307" y="1801"/>
                </a:lnTo>
                <a:lnTo>
                  <a:pt x="462" y="2165"/>
                </a:lnTo>
                <a:cubicBezTo>
                  <a:pt x="462" y="2167"/>
                  <a:pt x="463" y="2168"/>
                  <a:pt x="463" y="2170"/>
                </a:cubicBezTo>
                <a:cubicBezTo>
                  <a:pt x="463" y="2171"/>
                  <a:pt x="462" y="2173"/>
                  <a:pt x="461" y="2175"/>
                </a:cubicBezTo>
                <a:cubicBezTo>
                  <a:pt x="460" y="2178"/>
                  <a:pt x="458" y="2180"/>
                  <a:pt x="456" y="2182"/>
                </a:cubicBezTo>
                <a:cubicBezTo>
                  <a:pt x="454" y="2185"/>
                  <a:pt x="452" y="2187"/>
                  <a:pt x="449" y="2191"/>
                </a:cubicBezTo>
                <a:cubicBezTo>
                  <a:pt x="445" y="2194"/>
                  <a:pt x="443" y="2196"/>
                  <a:pt x="440" y="2198"/>
                </a:cubicBezTo>
                <a:cubicBezTo>
                  <a:pt x="437" y="2200"/>
                  <a:pt x="435" y="2202"/>
                  <a:pt x="433" y="2203"/>
                </a:cubicBezTo>
                <a:cubicBezTo>
                  <a:pt x="431" y="2204"/>
                  <a:pt x="429" y="2204"/>
                  <a:pt x="428" y="2204"/>
                </a:cubicBezTo>
                <a:cubicBezTo>
                  <a:pt x="426" y="2204"/>
                  <a:pt x="424" y="2204"/>
                  <a:pt x="423" y="2204"/>
                </a:cubicBezTo>
                <a:lnTo>
                  <a:pt x="64" y="2044"/>
                </a:lnTo>
                <a:lnTo>
                  <a:pt x="64" y="2044"/>
                </a:lnTo>
                <a:lnTo>
                  <a:pt x="322" y="2303"/>
                </a:lnTo>
                <a:cubicBezTo>
                  <a:pt x="323" y="2304"/>
                  <a:pt x="324" y="2305"/>
                  <a:pt x="324" y="2307"/>
                </a:cubicBezTo>
                <a:cubicBezTo>
                  <a:pt x="324" y="2308"/>
                  <a:pt x="324" y="2310"/>
                  <a:pt x="323" y="2312"/>
                </a:cubicBezTo>
                <a:cubicBezTo>
                  <a:pt x="322" y="2314"/>
                  <a:pt x="320" y="2317"/>
                  <a:pt x="318" y="2320"/>
                </a:cubicBezTo>
                <a:cubicBezTo>
                  <a:pt x="316" y="2323"/>
                  <a:pt x="313" y="2326"/>
                  <a:pt x="309" y="2330"/>
                </a:cubicBezTo>
                <a:cubicBezTo>
                  <a:pt x="305" y="2334"/>
                  <a:pt x="302" y="2337"/>
                  <a:pt x="299" y="2339"/>
                </a:cubicBezTo>
                <a:cubicBezTo>
                  <a:pt x="296" y="2341"/>
                  <a:pt x="294" y="2343"/>
                  <a:pt x="292" y="2344"/>
                </a:cubicBezTo>
                <a:cubicBezTo>
                  <a:pt x="290" y="2345"/>
                  <a:pt x="288" y="2345"/>
                  <a:pt x="287" y="2344"/>
                </a:cubicBezTo>
                <a:cubicBezTo>
                  <a:pt x="285" y="2344"/>
                  <a:pt x="284" y="2343"/>
                  <a:pt x="282" y="2342"/>
                </a:cubicBezTo>
                <a:lnTo>
                  <a:pt x="10" y="2069"/>
                </a:lnTo>
                <a:cubicBezTo>
                  <a:pt x="3" y="2063"/>
                  <a:pt x="0" y="2057"/>
                  <a:pt x="1" y="2050"/>
                </a:cubicBezTo>
                <a:cubicBezTo>
                  <a:pt x="2" y="2044"/>
                  <a:pt x="4" y="2039"/>
                  <a:pt x="8" y="2035"/>
                </a:cubicBezTo>
                <a:lnTo>
                  <a:pt x="33" y="2011"/>
                </a:lnTo>
                <a:cubicBezTo>
                  <a:pt x="38" y="2006"/>
                  <a:pt x="42" y="2002"/>
                  <a:pt x="47" y="1999"/>
                </a:cubicBezTo>
                <a:cubicBezTo>
                  <a:pt x="52" y="1996"/>
                  <a:pt x="56" y="1994"/>
                  <a:pt x="61" y="1994"/>
                </a:cubicBezTo>
                <a:cubicBezTo>
                  <a:pt x="66" y="1993"/>
                  <a:pt x="71" y="1993"/>
                  <a:pt x="76" y="1994"/>
                </a:cubicBezTo>
                <a:cubicBezTo>
                  <a:pt x="81" y="1995"/>
                  <a:pt x="86" y="1997"/>
                  <a:pt x="91" y="2000"/>
                </a:cubicBezTo>
                <a:lnTo>
                  <a:pt x="391" y="2130"/>
                </a:lnTo>
                <a:lnTo>
                  <a:pt x="392" y="2129"/>
                </a:lnTo>
                <a:lnTo>
                  <a:pt x="266" y="1826"/>
                </a:lnTo>
                <a:cubicBezTo>
                  <a:pt x="263" y="1820"/>
                  <a:pt x="261" y="1814"/>
                  <a:pt x="260" y="1809"/>
                </a:cubicBezTo>
                <a:cubicBezTo>
                  <a:pt x="259" y="1804"/>
                  <a:pt x="259" y="1799"/>
                  <a:pt x="259" y="1795"/>
                </a:cubicBezTo>
                <a:cubicBezTo>
                  <a:pt x="260" y="1791"/>
                  <a:pt x="261" y="1787"/>
                  <a:pt x="263" y="1783"/>
                </a:cubicBezTo>
                <a:cubicBezTo>
                  <a:pt x="265" y="1779"/>
                  <a:pt x="268" y="1775"/>
                  <a:pt x="272" y="1771"/>
                </a:cubicBezTo>
                <a:lnTo>
                  <a:pt x="297" y="1746"/>
                </a:lnTo>
                <a:cubicBezTo>
                  <a:pt x="300" y="1744"/>
                  <a:pt x="302" y="1742"/>
                  <a:pt x="305" y="1740"/>
                </a:cubicBezTo>
                <a:cubicBezTo>
                  <a:pt x="308" y="1739"/>
                  <a:pt x="311" y="1738"/>
                  <a:pt x="314" y="1738"/>
                </a:cubicBezTo>
                <a:cubicBezTo>
                  <a:pt x="317" y="1738"/>
                  <a:pt x="320" y="1739"/>
                  <a:pt x="323" y="1740"/>
                </a:cubicBezTo>
                <a:cubicBezTo>
                  <a:pt x="326" y="1741"/>
                  <a:pt x="329" y="1744"/>
                  <a:pt x="332" y="1747"/>
                </a:cubicBezTo>
                <a:lnTo>
                  <a:pt x="605" y="2020"/>
                </a:lnTo>
                <a:close/>
                <a:moveTo>
                  <a:pt x="744" y="1657"/>
                </a:moveTo>
                <a:cubicBezTo>
                  <a:pt x="750" y="1663"/>
                  <a:pt x="753" y="1669"/>
                  <a:pt x="752" y="1674"/>
                </a:cubicBezTo>
                <a:cubicBezTo>
                  <a:pt x="752" y="1680"/>
                  <a:pt x="750" y="1684"/>
                  <a:pt x="746" y="1688"/>
                </a:cubicBezTo>
                <a:lnTo>
                  <a:pt x="610" y="1824"/>
                </a:lnTo>
                <a:cubicBezTo>
                  <a:pt x="621" y="1835"/>
                  <a:pt x="633" y="1845"/>
                  <a:pt x="644" y="1851"/>
                </a:cubicBezTo>
                <a:cubicBezTo>
                  <a:pt x="656" y="1858"/>
                  <a:pt x="667" y="1862"/>
                  <a:pt x="679" y="1864"/>
                </a:cubicBezTo>
                <a:cubicBezTo>
                  <a:pt x="691" y="1865"/>
                  <a:pt x="703" y="1863"/>
                  <a:pt x="715" y="1858"/>
                </a:cubicBezTo>
                <a:cubicBezTo>
                  <a:pt x="728" y="1853"/>
                  <a:pt x="740" y="1844"/>
                  <a:pt x="752" y="1831"/>
                </a:cubicBezTo>
                <a:cubicBezTo>
                  <a:pt x="762" y="1822"/>
                  <a:pt x="770" y="1812"/>
                  <a:pt x="776" y="1803"/>
                </a:cubicBezTo>
                <a:cubicBezTo>
                  <a:pt x="782" y="1794"/>
                  <a:pt x="787" y="1785"/>
                  <a:pt x="791" y="1777"/>
                </a:cubicBezTo>
                <a:cubicBezTo>
                  <a:pt x="794" y="1770"/>
                  <a:pt x="797" y="1763"/>
                  <a:pt x="799" y="1758"/>
                </a:cubicBezTo>
                <a:cubicBezTo>
                  <a:pt x="801" y="1753"/>
                  <a:pt x="803" y="1750"/>
                  <a:pt x="805" y="1748"/>
                </a:cubicBezTo>
                <a:cubicBezTo>
                  <a:pt x="806" y="1747"/>
                  <a:pt x="807" y="1746"/>
                  <a:pt x="809" y="1746"/>
                </a:cubicBezTo>
                <a:cubicBezTo>
                  <a:pt x="810" y="1745"/>
                  <a:pt x="811" y="1745"/>
                  <a:pt x="813" y="1746"/>
                </a:cubicBezTo>
                <a:cubicBezTo>
                  <a:pt x="814" y="1747"/>
                  <a:pt x="816" y="1748"/>
                  <a:pt x="818" y="1749"/>
                </a:cubicBezTo>
                <a:cubicBezTo>
                  <a:pt x="821" y="1751"/>
                  <a:pt x="823" y="1753"/>
                  <a:pt x="826" y="1756"/>
                </a:cubicBezTo>
                <a:cubicBezTo>
                  <a:pt x="828" y="1758"/>
                  <a:pt x="829" y="1760"/>
                  <a:pt x="831" y="1762"/>
                </a:cubicBezTo>
                <a:cubicBezTo>
                  <a:pt x="832" y="1763"/>
                  <a:pt x="833" y="1765"/>
                  <a:pt x="834" y="1766"/>
                </a:cubicBezTo>
                <a:cubicBezTo>
                  <a:pt x="835" y="1767"/>
                  <a:pt x="836" y="1769"/>
                  <a:pt x="836" y="1770"/>
                </a:cubicBezTo>
                <a:cubicBezTo>
                  <a:pt x="836" y="1772"/>
                  <a:pt x="837" y="1773"/>
                  <a:pt x="837" y="1775"/>
                </a:cubicBezTo>
                <a:cubicBezTo>
                  <a:pt x="837" y="1777"/>
                  <a:pt x="835" y="1780"/>
                  <a:pt x="833" y="1787"/>
                </a:cubicBezTo>
                <a:cubicBezTo>
                  <a:pt x="831" y="1793"/>
                  <a:pt x="828" y="1800"/>
                  <a:pt x="823" y="1808"/>
                </a:cubicBezTo>
                <a:cubicBezTo>
                  <a:pt x="818" y="1817"/>
                  <a:pt x="812" y="1826"/>
                  <a:pt x="805" y="1836"/>
                </a:cubicBezTo>
                <a:cubicBezTo>
                  <a:pt x="798" y="1846"/>
                  <a:pt x="789" y="1856"/>
                  <a:pt x="780" y="1866"/>
                </a:cubicBezTo>
                <a:cubicBezTo>
                  <a:pt x="763" y="1883"/>
                  <a:pt x="745" y="1895"/>
                  <a:pt x="728" y="1903"/>
                </a:cubicBezTo>
                <a:cubicBezTo>
                  <a:pt x="710" y="1911"/>
                  <a:pt x="693" y="1915"/>
                  <a:pt x="675" y="1914"/>
                </a:cubicBezTo>
                <a:cubicBezTo>
                  <a:pt x="656" y="1914"/>
                  <a:pt x="638" y="1909"/>
                  <a:pt x="620" y="1899"/>
                </a:cubicBezTo>
                <a:cubicBezTo>
                  <a:pt x="601" y="1889"/>
                  <a:pt x="583" y="1875"/>
                  <a:pt x="564" y="1857"/>
                </a:cubicBezTo>
                <a:cubicBezTo>
                  <a:pt x="546" y="1839"/>
                  <a:pt x="533" y="1821"/>
                  <a:pt x="523" y="1802"/>
                </a:cubicBezTo>
                <a:cubicBezTo>
                  <a:pt x="514" y="1783"/>
                  <a:pt x="508" y="1765"/>
                  <a:pt x="507" y="1746"/>
                </a:cubicBezTo>
                <a:cubicBezTo>
                  <a:pt x="506" y="1728"/>
                  <a:pt x="509" y="1710"/>
                  <a:pt x="516" y="1692"/>
                </a:cubicBezTo>
                <a:cubicBezTo>
                  <a:pt x="522" y="1675"/>
                  <a:pt x="534" y="1658"/>
                  <a:pt x="549" y="1643"/>
                </a:cubicBezTo>
                <a:cubicBezTo>
                  <a:pt x="565" y="1627"/>
                  <a:pt x="581" y="1616"/>
                  <a:pt x="598" y="1610"/>
                </a:cubicBezTo>
                <a:cubicBezTo>
                  <a:pt x="614" y="1603"/>
                  <a:pt x="631" y="1601"/>
                  <a:pt x="647" y="1602"/>
                </a:cubicBezTo>
                <a:cubicBezTo>
                  <a:pt x="663" y="1604"/>
                  <a:pt x="679" y="1609"/>
                  <a:pt x="694" y="1617"/>
                </a:cubicBezTo>
                <a:cubicBezTo>
                  <a:pt x="709" y="1626"/>
                  <a:pt x="724" y="1637"/>
                  <a:pt x="737" y="1650"/>
                </a:cubicBezTo>
                <a:lnTo>
                  <a:pt x="744" y="1657"/>
                </a:lnTo>
                <a:close/>
                <a:moveTo>
                  <a:pt x="695" y="1684"/>
                </a:moveTo>
                <a:cubicBezTo>
                  <a:pt x="675" y="1663"/>
                  <a:pt x="655" y="1652"/>
                  <a:pt x="635" y="1650"/>
                </a:cubicBezTo>
                <a:cubicBezTo>
                  <a:pt x="614" y="1648"/>
                  <a:pt x="595" y="1656"/>
                  <a:pt x="576" y="1675"/>
                </a:cubicBezTo>
                <a:cubicBezTo>
                  <a:pt x="567" y="1684"/>
                  <a:pt x="560" y="1694"/>
                  <a:pt x="557" y="1705"/>
                </a:cubicBezTo>
                <a:cubicBezTo>
                  <a:pt x="553" y="1715"/>
                  <a:pt x="552" y="1726"/>
                  <a:pt x="553" y="1736"/>
                </a:cubicBezTo>
                <a:cubicBezTo>
                  <a:pt x="554" y="1747"/>
                  <a:pt x="557" y="1757"/>
                  <a:pt x="562" y="1768"/>
                </a:cubicBezTo>
                <a:cubicBezTo>
                  <a:pt x="567" y="1778"/>
                  <a:pt x="574" y="1788"/>
                  <a:pt x="582" y="1796"/>
                </a:cubicBezTo>
                <a:lnTo>
                  <a:pt x="695" y="1684"/>
                </a:lnTo>
                <a:close/>
                <a:moveTo>
                  <a:pt x="1010" y="1585"/>
                </a:moveTo>
                <a:cubicBezTo>
                  <a:pt x="1014" y="1589"/>
                  <a:pt x="1017" y="1593"/>
                  <a:pt x="1019" y="1596"/>
                </a:cubicBezTo>
                <a:cubicBezTo>
                  <a:pt x="1021" y="1600"/>
                  <a:pt x="1022" y="1603"/>
                  <a:pt x="1022" y="1605"/>
                </a:cubicBezTo>
                <a:cubicBezTo>
                  <a:pt x="1022" y="1607"/>
                  <a:pt x="1022" y="1610"/>
                  <a:pt x="1020" y="1614"/>
                </a:cubicBezTo>
                <a:cubicBezTo>
                  <a:pt x="1019" y="1617"/>
                  <a:pt x="1017" y="1621"/>
                  <a:pt x="1015" y="1625"/>
                </a:cubicBezTo>
                <a:cubicBezTo>
                  <a:pt x="1012" y="1629"/>
                  <a:pt x="1009" y="1633"/>
                  <a:pt x="1006" y="1637"/>
                </a:cubicBezTo>
                <a:cubicBezTo>
                  <a:pt x="1003" y="1641"/>
                  <a:pt x="1000" y="1644"/>
                  <a:pt x="996" y="1648"/>
                </a:cubicBezTo>
                <a:cubicBezTo>
                  <a:pt x="986" y="1659"/>
                  <a:pt x="975" y="1666"/>
                  <a:pt x="965" y="1671"/>
                </a:cubicBezTo>
                <a:cubicBezTo>
                  <a:pt x="954" y="1676"/>
                  <a:pt x="944" y="1678"/>
                  <a:pt x="933" y="1677"/>
                </a:cubicBezTo>
                <a:cubicBezTo>
                  <a:pt x="922" y="1676"/>
                  <a:pt x="912" y="1673"/>
                  <a:pt x="901" y="1666"/>
                </a:cubicBezTo>
                <a:cubicBezTo>
                  <a:pt x="890" y="1659"/>
                  <a:pt x="878" y="1650"/>
                  <a:pt x="866" y="1638"/>
                </a:cubicBezTo>
                <a:lnTo>
                  <a:pt x="746" y="1518"/>
                </a:lnTo>
                <a:lnTo>
                  <a:pt x="717" y="1547"/>
                </a:lnTo>
                <a:cubicBezTo>
                  <a:pt x="714" y="1549"/>
                  <a:pt x="711" y="1549"/>
                  <a:pt x="708" y="1548"/>
                </a:cubicBezTo>
                <a:cubicBezTo>
                  <a:pt x="704" y="1547"/>
                  <a:pt x="699" y="1544"/>
                  <a:pt x="694" y="1538"/>
                </a:cubicBezTo>
                <a:cubicBezTo>
                  <a:pt x="691" y="1536"/>
                  <a:pt x="688" y="1533"/>
                  <a:pt x="687" y="1531"/>
                </a:cubicBezTo>
                <a:cubicBezTo>
                  <a:pt x="685" y="1528"/>
                  <a:pt x="684" y="1526"/>
                  <a:pt x="683" y="1524"/>
                </a:cubicBezTo>
                <a:cubicBezTo>
                  <a:pt x="683" y="1522"/>
                  <a:pt x="683" y="1521"/>
                  <a:pt x="683" y="1519"/>
                </a:cubicBezTo>
                <a:cubicBezTo>
                  <a:pt x="684" y="1517"/>
                  <a:pt x="684" y="1516"/>
                  <a:pt x="686" y="1515"/>
                </a:cubicBezTo>
                <a:lnTo>
                  <a:pt x="714" y="1486"/>
                </a:lnTo>
                <a:lnTo>
                  <a:pt x="665" y="1437"/>
                </a:lnTo>
                <a:cubicBezTo>
                  <a:pt x="664" y="1436"/>
                  <a:pt x="663" y="1435"/>
                  <a:pt x="663" y="1433"/>
                </a:cubicBezTo>
                <a:cubicBezTo>
                  <a:pt x="663" y="1432"/>
                  <a:pt x="663" y="1430"/>
                  <a:pt x="664" y="1428"/>
                </a:cubicBezTo>
                <a:cubicBezTo>
                  <a:pt x="664" y="1426"/>
                  <a:pt x="666" y="1423"/>
                  <a:pt x="668" y="1421"/>
                </a:cubicBezTo>
                <a:cubicBezTo>
                  <a:pt x="670" y="1418"/>
                  <a:pt x="673" y="1415"/>
                  <a:pt x="677" y="1411"/>
                </a:cubicBezTo>
                <a:cubicBezTo>
                  <a:pt x="680" y="1407"/>
                  <a:pt x="684" y="1404"/>
                  <a:pt x="687" y="1402"/>
                </a:cubicBezTo>
                <a:cubicBezTo>
                  <a:pt x="689" y="1400"/>
                  <a:pt x="692" y="1399"/>
                  <a:pt x="694" y="1398"/>
                </a:cubicBezTo>
                <a:cubicBezTo>
                  <a:pt x="696" y="1397"/>
                  <a:pt x="698" y="1397"/>
                  <a:pt x="699" y="1397"/>
                </a:cubicBezTo>
                <a:cubicBezTo>
                  <a:pt x="701" y="1398"/>
                  <a:pt x="702" y="1398"/>
                  <a:pt x="703" y="1399"/>
                </a:cubicBezTo>
                <a:lnTo>
                  <a:pt x="752" y="1448"/>
                </a:lnTo>
                <a:lnTo>
                  <a:pt x="805" y="1395"/>
                </a:lnTo>
                <a:cubicBezTo>
                  <a:pt x="806" y="1394"/>
                  <a:pt x="808" y="1393"/>
                  <a:pt x="809" y="1393"/>
                </a:cubicBezTo>
                <a:cubicBezTo>
                  <a:pt x="810" y="1393"/>
                  <a:pt x="812" y="1393"/>
                  <a:pt x="814" y="1393"/>
                </a:cubicBezTo>
                <a:cubicBezTo>
                  <a:pt x="816" y="1394"/>
                  <a:pt x="818" y="1395"/>
                  <a:pt x="821" y="1397"/>
                </a:cubicBezTo>
                <a:cubicBezTo>
                  <a:pt x="823" y="1398"/>
                  <a:pt x="826" y="1401"/>
                  <a:pt x="828" y="1404"/>
                </a:cubicBezTo>
                <a:cubicBezTo>
                  <a:pt x="834" y="1409"/>
                  <a:pt x="837" y="1414"/>
                  <a:pt x="838" y="1418"/>
                </a:cubicBezTo>
                <a:cubicBezTo>
                  <a:pt x="839" y="1421"/>
                  <a:pt x="839" y="1425"/>
                  <a:pt x="836" y="1427"/>
                </a:cubicBezTo>
                <a:lnTo>
                  <a:pt x="783" y="1480"/>
                </a:lnTo>
                <a:lnTo>
                  <a:pt x="899" y="1595"/>
                </a:lnTo>
                <a:cubicBezTo>
                  <a:pt x="913" y="1609"/>
                  <a:pt x="926" y="1618"/>
                  <a:pt x="937" y="1621"/>
                </a:cubicBezTo>
                <a:cubicBezTo>
                  <a:pt x="949" y="1624"/>
                  <a:pt x="960" y="1620"/>
                  <a:pt x="971" y="1609"/>
                </a:cubicBezTo>
                <a:cubicBezTo>
                  <a:pt x="974" y="1606"/>
                  <a:pt x="977" y="1602"/>
                  <a:pt x="979" y="1599"/>
                </a:cubicBezTo>
                <a:cubicBezTo>
                  <a:pt x="981" y="1595"/>
                  <a:pt x="983" y="1592"/>
                  <a:pt x="984" y="1589"/>
                </a:cubicBezTo>
                <a:cubicBezTo>
                  <a:pt x="985" y="1586"/>
                  <a:pt x="987" y="1584"/>
                  <a:pt x="987" y="1581"/>
                </a:cubicBezTo>
                <a:cubicBezTo>
                  <a:pt x="988" y="1579"/>
                  <a:pt x="989" y="1578"/>
                  <a:pt x="990" y="1576"/>
                </a:cubicBezTo>
                <a:cubicBezTo>
                  <a:pt x="991" y="1576"/>
                  <a:pt x="992" y="1575"/>
                  <a:pt x="993" y="1575"/>
                </a:cubicBezTo>
                <a:cubicBezTo>
                  <a:pt x="994" y="1574"/>
                  <a:pt x="996" y="1575"/>
                  <a:pt x="997" y="1575"/>
                </a:cubicBezTo>
                <a:cubicBezTo>
                  <a:pt x="998" y="1576"/>
                  <a:pt x="1000" y="1577"/>
                  <a:pt x="1002" y="1579"/>
                </a:cubicBezTo>
                <a:cubicBezTo>
                  <a:pt x="1005" y="1580"/>
                  <a:pt x="1007" y="1582"/>
                  <a:pt x="1010" y="1585"/>
                </a:cubicBezTo>
                <a:close/>
                <a:moveTo>
                  <a:pt x="1254" y="1371"/>
                </a:moveTo>
                <a:cubicBezTo>
                  <a:pt x="1255" y="1373"/>
                  <a:pt x="1256" y="1374"/>
                  <a:pt x="1256" y="1375"/>
                </a:cubicBezTo>
                <a:cubicBezTo>
                  <a:pt x="1256" y="1377"/>
                  <a:pt x="1256" y="1379"/>
                  <a:pt x="1255" y="1381"/>
                </a:cubicBezTo>
                <a:cubicBezTo>
                  <a:pt x="1254" y="1383"/>
                  <a:pt x="1253" y="1385"/>
                  <a:pt x="1251" y="1388"/>
                </a:cubicBezTo>
                <a:cubicBezTo>
                  <a:pt x="1249" y="1390"/>
                  <a:pt x="1246" y="1394"/>
                  <a:pt x="1242" y="1397"/>
                </a:cubicBezTo>
                <a:cubicBezTo>
                  <a:pt x="1238" y="1401"/>
                  <a:pt x="1235" y="1404"/>
                  <a:pt x="1232" y="1406"/>
                </a:cubicBezTo>
                <a:cubicBezTo>
                  <a:pt x="1229" y="1408"/>
                  <a:pt x="1227" y="1410"/>
                  <a:pt x="1225" y="1411"/>
                </a:cubicBezTo>
                <a:cubicBezTo>
                  <a:pt x="1223" y="1411"/>
                  <a:pt x="1221" y="1412"/>
                  <a:pt x="1220" y="1411"/>
                </a:cubicBezTo>
                <a:cubicBezTo>
                  <a:pt x="1218" y="1411"/>
                  <a:pt x="1217" y="1410"/>
                  <a:pt x="1216" y="1409"/>
                </a:cubicBezTo>
                <a:lnTo>
                  <a:pt x="1095" y="1288"/>
                </a:lnTo>
                <a:cubicBezTo>
                  <a:pt x="1083" y="1277"/>
                  <a:pt x="1073" y="1268"/>
                  <a:pt x="1064" y="1263"/>
                </a:cubicBezTo>
                <a:cubicBezTo>
                  <a:pt x="1055" y="1257"/>
                  <a:pt x="1046" y="1254"/>
                  <a:pt x="1037" y="1252"/>
                </a:cubicBezTo>
                <a:cubicBezTo>
                  <a:pt x="1029" y="1250"/>
                  <a:pt x="1020" y="1251"/>
                  <a:pt x="1012" y="1254"/>
                </a:cubicBezTo>
                <a:cubicBezTo>
                  <a:pt x="1003" y="1257"/>
                  <a:pt x="996" y="1262"/>
                  <a:pt x="988" y="1269"/>
                </a:cubicBezTo>
                <a:cubicBezTo>
                  <a:pt x="979" y="1279"/>
                  <a:pt x="973" y="1291"/>
                  <a:pt x="970" y="1308"/>
                </a:cubicBezTo>
                <a:cubicBezTo>
                  <a:pt x="967" y="1324"/>
                  <a:pt x="967" y="1344"/>
                  <a:pt x="970" y="1367"/>
                </a:cubicBezTo>
                <a:lnTo>
                  <a:pt x="1114" y="1511"/>
                </a:lnTo>
                <a:cubicBezTo>
                  <a:pt x="1115" y="1512"/>
                  <a:pt x="1116" y="1514"/>
                  <a:pt x="1116" y="1515"/>
                </a:cubicBezTo>
                <a:cubicBezTo>
                  <a:pt x="1116" y="1517"/>
                  <a:pt x="1116" y="1518"/>
                  <a:pt x="1115" y="1520"/>
                </a:cubicBezTo>
                <a:cubicBezTo>
                  <a:pt x="1114" y="1522"/>
                  <a:pt x="1113" y="1525"/>
                  <a:pt x="1111" y="1528"/>
                </a:cubicBezTo>
                <a:cubicBezTo>
                  <a:pt x="1109" y="1530"/>
                  <a:pt x="1106" y="1534"/>
                  <a:pt x="1102" y="1537"/>
                </a:cubicBezTo>
                <a:cubicBezTo>
                  <a:pt x="1098" y="1541"/>
                  <a:pt x="1095" y="1544"/>
                  <a:pt x="1092" y="1546"/>
                </a:cubicBezTo>
                <a:cubicBezTo>
                  <a:pt x="1090" y="1548"/>
                  <a:pt x="1087" y="1550"/>
                  <a:pt x="1085" y="1551"/>
                </a:cubicBezTo>
                <a:cubicBezTo>
                  <a:pt x="1083" y="1551"/>
                  <a:pt x="1081" y="1552"/>
                  <a:pt x="1080" y="1551"/>
                </a:cubicBezTo>
                <a:cubicBezTo>
                  <a:pt x="1079" y="1551"/>
                  <a:pt x="1077" y="1550"/>
                  <a:pt x="1076" y="1549"/>
                </a:cubicBezTo>
                <a:lnTo>
                  <a:pt x="770" y="1243"/>
                </a:lnTo>
                <a:cubicBezTo>
                  <a:pt x="768" y="1242"/>
                  <a:pt x="768" y="1240"/>
                  <a:pt x="767" y="1239"/>
                </a:cubicBezTo>
                <a:cubicBezTo>
                  <a:pt x="767" y="1237"/>
                  <a:pt x="767" y="1236"/>
                  <a:pt x="768" y="1233"/>
                </a:cubicBezTo>
                <a:cubicBezTo>
                  <a:pt x="769" y="1231"/>
                  <a:pt x="770" y="1229"/>
                  <a:pt x="772" y="1226"/>
                </a:cubicBezTo>
                <a:cubicBezTo>
                  <a:pt x="775" y="1224"/>
                  <a:pt x="777" y="1220"/>
                  <a:pt x="781" y="1217"/>
                </a:cubicBezTo>
                <a:cubicBezTo>
                  <a:pt x="785" y="1213"/>
                  <a:pt x="788" y="1210"/>
                  <a:pt x="791" y="1208"/>
                </a:cubicBezTo>
                <a:cubicBezTo>
                  <a:pt x="794" y="1206"/>
                  <a:pt x="796" y="1204"/>
                  <a:pt x="798" y="1203"/>
                </a:cubicBezTo>
                <a:cubicBezTo>
                  <a:pt x="800" y="1203"/>
                  <a:pt x="802" y="1202"/>
                  <a:pt x="803" y="1203"/>
                </a:cubicBezTo>
                <a:cubicBezTo>
                  <a:pt x="805" y="1203"/>
                  <a:pt x="806" y="1204"/>
                  <a:pt x="808" y="1205"/>
                </a:cubicBezTo>
                <a:lnTo>
                  <a:pt x="931" y="1329"/>
                </a:lnTo>
                <a:cubicBezTo>
                  <a:pt x="930" y="1306"/>
                  <a:pt x="933" y="1287"/>
                  <a:pt x="938" y="1270"/>
                </a:cubicBezTo>
                <a:cubicBezTo>
                  <a:pt x="944" y="1254"/>
                  <a:pt x="952" y="1240"/>
                  <a:pt x="963" y="1229"/>
                </a:cubicBezTo>
                <a:cubicBezTo>
                  <a:pt x="977" y="1215"/>
                  <a:pt x="991" y="1206"/>
                  <a:pt x="1005" y="1201"/>
                </a:cubicBezTo>
                <a:cubicBezTo>
                  <a:pt x="1019" y="1196"/>
                  <a:pt x="1033" y="1195"/>
                  <a:pt x="1046" y="1197"/>
                </a:cubicBezTo>
                <a:cubicBezTo>
                  <a:pt x="1060" y="1199"/>
                  <a:pt x="1073" y="1204"/>
                  <a:pt x="1086" y="1212"/>
                </a:cubicBezTo>
                <a:cubicBezTo>
                  <a:pt x="1099" y="1220"/>
                  <a:pt x="1113" y="1231"/>
                  <a:pt x="1128" y="1246"/>
                </a:cubicBezTo>
                <a:lnTo>
                  <a:pt x="1254" y="1371"/>
                </a:lnTo>
                <a:close/>
                <a:moveTo>
                  <a:pt x="1357" y="1268"/>
                </a:moveTo>
                <a:cubicBezTo>
                  <a:pt x="1358" y="1269"/>
                  <a:pt x="1359" y="1271"/>
                  <a:pt x="1359" y="1272"/>
                </a:cubicBezTo>
                <a:cubicBezTo>
                  <a:pt x="1359" y="1273"/>
                  <a:pt x="1359" y="1275"/>
                  <a:pt x="1358" y="1277"/>
                </a:cubicBezTo>
                <a:cubicBezTo>
                  <a:pt x="1358" y="1279"/>
                  <a:pt x="1356" y="1282"/>
                  <a:pt x="1354" y="1284"/>
                </a:cubicBezTo>
                <a:cubicBezTo>
                  <a:pt x="1352" y="1287"/>
                  <a:pt x="1349" y="1290"/>
                  <a:pt x="1345" y="1294"/>
                </a:cubicBezTo>
                <a:cubicBezTo>
                  <a:pt x="1341" y="1298"/>
                  <a:pt x="1338" y="1301"/>
                  <a:pt x="1336" y="1303"/>
                </a:cubicBezTo>
                <a:cubicBezTo>
                  <a:pt x="1333" y="1305"/>
                  <a:pt x="1330" y="1306"/>
                  <a:pt x="1328" y="1307"/>
                </a:cubicBezTo>
                <a:cubicBezTo>
                  <a:pt x="1326" y="1308"/>
                  <a:pt x="1325" y="1308"/>
                  <a:pt x="1323" y="1308"/>
                </a:cubicBezTo>
                <a:cubicBezTo>
                  <a:pt x="1322" y="1308"/>
                  <a:pt x="1320" y="1307"/>
                  <a:pt x="1319" y="1306"/>
                </a:cubicBezTo>
                <a:lnTo>
                  <a:pt x="1113" y="1099"/>
                </a:lnTo>
                <a:cubicBezTo>
                  <a:pt x="1112" y="1098"/>
                  <a:pt x="1111" y="1097"/>
                  <a:pt x="1111" y="1096"/>
                </a:cubicBezTo>
                <a:cubicBezTo>
                  <a:pt x="1110" y="1094"/>
                  <a:pt x="1111" y="1092"/>
                  <a:pt x="1111" y="1090"/>
                </a:cubicBezTo>
                <a:cubicBezTo>
                  <a:pt x="1112" y="1088"/>
                  <a:pt x="1114" y="1086"/>
                  <a:pt x="1116" y="1083"/>
                </a:cubicBezTo>
                <a:cubicBezTo>
                  <a:pt x="1118" y="1080"/>
                  <a:pt x="1121" y="1077"/>
                  <a:pt x="1125" y="1074"/>
                </a:cubicBezTo>
                <a:cubicBezTo>
                  <a:pt x="1128" y="1070"/>
                  <a:pt x="1132" y="1067"/>
                  <a:pt x="1134" y="1065"/>
                </a:cubicBezTo>
                <a:cubicBezTo>
                  <a:pt x="1137" y="1062"/>
                  <a:pt x="1140" y="1061"/>
                  <a:pt x="1142" y="1060"/>
                </a:cubicBezTo>
                <a:cubicBezTo>
                  <a:pt x="1144" y="1060"/>
                  <a:pt x="1145" y="1059"/>
                  <a:pt x="1147" y="1060"/>
                </a:cubicBezTo>
                <a:cubicBezTo>
                  <a:pt x="1148" y="1060"/>
                  <a:pt x="1150" y="1061"/>
                  <a:pt x="1151" y="1062"/>
                </a:cubicBezTo>
                <a:lnTo>
                  <a:pt x="1357" y="1268"/>
                </a:lnTo>
                <a:close/>
                <a:moveTo>
                  <a:pt x="1085" y="988"/>
                </a:moveTo>
                <a:cubicBezTo>
                  <a:pt x="1094" y="996"/>
                  <a:pt x="1099" y="1004"/>
                  <a:pt x="1098" y="1011"/>
                </a:cubicBezTo>
                <a:cubicBezTo>
                  <a:pt x="1098" y="1017"/>
                  <a:pt x="1094" y="1025"/>
                  <a:pt x="1085" y="1034"/>
                </a:cubicBezTo>
                <a:cubicBezTo>
                  <a:pt x="1076" y="1043"/>
                  <a:pt x="1068" y="1048"/>
                  <a:pt x="1062" y="1048"/>
                </a:cubicBezTo>
                <a:cubicBezTo>
                  <a:pt x="1055" y="1048"/>
                  <a:pt x="1048" y="1044"/>
                  <a:pt x="1039" y="1035"/>
                </a:cubicBezTo>
                <a:cubicBezTo>
                  <a:pt x="1030" y="1026"/>
                  <a:pt x="1026" y="1018"/>
                  <a:pt x="1026" y="1012"/>
                </a:cubicBezTo>
                <a:cubicBezTo>
                  <a:pt x="1026" y="1005"/>
                  <a:pt x="1031" y="997"/>
                  <a:pt x="1040" y="988"/>
                </a:cubicBezTo>
                <a:cubicBezTo>
                  <a:pt x="1049" y="979"/>
                  <a:pt x="1056" y="975"/>
                  <a:pt x="1063" y="975"/>
                </a:cubicBezTo>
                <a:cubicBezTo>
                  <a:pt x="1069" y="975"/>
                  <a:pt x="1077" y="979"/>
                  <a:pt x="1085" y="988"/>
                </a:cubicBezTo>
                <a:close/>
                <a:moveTo>
                  <a:pt x="1519" y="895"/>
                </a:moveTo>
                <a:cubicBezTo>
                  <a:pt x="1536" y="912"/>
                  <a:pt x="1549" y="930"/>
                  <a:pt x="1559" y="948"/>
                </a:cubicBezTo>
                <a:cubicBezTo>
                  <a:pt x="1568" y="967"/>
                  <a:pt x="1574" y="986"/>
                  <a:pt x="1575" y="1005"/>
                </a:cubicBezTo>
                <a:cubicBezTo>
                  <a:pt x="1577" y="1024"/>
                  <a:pt x="1574" y="1043"/>
                  <a:pt x="1566" y="1062"/>
                </a:cubicBezTo>
                <a:cubicBezTo>
                  <a:pt x="1559" y="1081"/>
                  <a:pt x="1546" y="1099"/>
                  <a:pt x="1529" y="1116"/>
                </a:cubicBezTo>
                <a:cubicBezTo>
                  <a:pt x="1512" y="1133"/>
                  <a:pt x="1495" y="1146"/>
                  <a:pt x="1477" y="1153"/>
                </a:cubicBezTo>
                <a:cubicBezTo>
                  <a:pt x="1459" y="1161"/>
                  <a:pt x="1441" y="1164"/>
                  <a:pt x="1423" y="1163"/>
                </a:cubicBezTo>
                <a:cubicBezTo>
                  <a:pt x="1405" y="1161"/>
                  <a:pt x="1387" y="1156"/>
                  <a:pt x="1370" y="1146"/>
                </a:cubicBezTo>
                <a:cubicBezTo>
                  <a:pt x="1352" y="1137"/>
                  <a:pt x="1334" y="1123"/>
                  <a:pt x="1317" y="1106"/>
                </a:cubicBezTo>
                <a:cubicBezTo>
                  <a:pt x="1300" y="1089"/>
                  <a:pt x="1286" y="1071"/>
                  <a:pt x="1277" y="1053"/>
                </a:cubicBezTo>
                <a:cubicBezTo>
                  <a:pt x="1267" y="1034"/>
                  <a:pt x="1261" y="1016"/>
                  <a:pt x="1260" y="997"/>
                </a:cubicBezTo>
                <a:cubicBezTo>
                  <a:pt x="1258" y="978"/>
                  <a:pt x="1261" y="959"/>
                  <a:pt x="1269" y="940"/>
                </a:cubicBezTo>
                <a:cubicBezTo>
                  <a:pt x="1276" y="921"/>
                  <a:pt x="1289" y="903"/>
                  <a:pt x="1307" y="885"/>
                </a:cubicBezTo>
                <a:cubicBezTo>
                  <a:pt x="1323" y="868"/>
                  <a:pt x="1341" y="856"/>
                  <a:pt x="1358" y="848"/>
                </a:cubicBezTo>
                <a:cubicBezTo>
                  <a:pt x="1376" y="841"/>
                  <a:pt x="1394" y="838"/>
                  <a:pt x="1412" y="839"/>
                </a:cubicBezTo>
                <a:cubicBezTo>
                  <a:pt x="1430" y="840"/>
                  <a:pt x="1448" y="846"/>
                  <a:pt x="1466" y="855"/>
                </a:cubicBezTo>
                <a:cubicBezTo>
                  <a:pt x="1484" y="865"/>
                  <a:pt x="1502" y="878"/>
                  <a:pt x="1519" y="895"/>
                </a:cubicBezTo>
                <a:close/>
                <a:moveTo>
                  <a:pt x="1482" y="937"/>
                </a:moveTo>
                <a:cubicBezTo>
                  <a:pt x="1471" y="926"/>
                  <a:pt x="1459" y="916"/>
                  <a:pt x="1447" y="909"/>
                </a:cubicBezTo>
                <a:cubicBezTo>
                  <a:pt x="1435" y="901"/>
                  <a:pt x="1423" y="895"/>
                  <a:pt x="1411" y="893"/>
                </a:cubicBezTo>
                <a:cubicBezTo>
                  <a:pt x="1399" y="890"/>
                  <a:pt x="1386" y="891"/>
                  <a:pt x="1374" y="894"/>
                </a:cubicBezTo>
                <a:cubicBezTo>
                  <a:pt x="1361" y="898"/>
                  <a:pt x="1349" y="906"/>
                  <a:pt x="1337" y="918"/>
                </a:cubicBezTo>
                <a:cubicBezTo>
                  <a:pt x="1325" y="930"/>
                  <a:pt x="1318" y="941"/>
                  <a:pt x="1314" y="953"/>
                </a:cubicBezTo>
                <a:cubicBezTo>
                  <a:pt x="1309" y="965"/>
                  <a:pt x="1308" y="978"/>
                  <a:pt x="1310" y="990"/>
                </a:cubicBezTo>
                <a:cubicBezTo>
                  <a:pt x="1312" y="1003"/>
                  <a:pt x="1317" y="1015"/>
                  <a:pt x="1325" y="1028"/>
                </a:cubicBezTo>
                <a:cubicBezTo>
                  <a:pt x="1332" y="1040"/>
                  <a:pt x="1342" y="1052"/>
                  <a:pt x="1353" y="1064"/>
                </a:cubicBezTo>
                <a:cubicBezTo>
                  <a:pt x="1365" y="1075"/>
                  <a:pt x="1376" y="1085"/>
                  <a:pt x="1388" y="1093"/>
                </a:cubicBezTo>
                <a:cubicBezTo>
                  <a:pt x="1400" y="1101"/>
                  <a:pt x="1412" y="1106"/>
                  <a:pt x="1425" y="1108"/>
                </a:cubicBezTo>
                <a:cubicBezTo>
                  <a:pt x="1437" y="1111"/>
                  <a:pt x="1449" y="1110"/>
                  <a:pt x="1462" y="1107"/>
                </a:cubicBezTo>
                <a:cubicBezTo>
                  <a:pt x="1474" y="1103"/>
                  <a:pt x="1487" y="1095"/>
                  <a:pt x="1499" y="1083"/>
                </a:cubicBezTo>
                <a:cubicBezTo>
                  <a:pt x="1510" y="1071"/>
                  <a:pt x="1518" y="1060"/>
                  <a:pt x="1522" y="1048"/>
                </a:cubicBezTo>
                <a:cubicBezTo>
                  <a:pt x="1526" y="1036"/>
                  <a:pt x="1527" y="1023"/>
                  <a:pt x="1525" y="1011"/>
                </a:cubicBezTo>
                <a:cubicBezTo>
                  <a:pt x="1523" y="998"/>
                  <a:pt x="1519" y="986"/>
                  <a:pt x="1511" y="974"/>
                </a:cubicBezTo>
                <a:cubicBezTo>
                  <a:pt x="1504" y="961"/>
                  <a:pt x="1494" y="949"/>
                  <a:pt x="1482" y="937"/>
                </a:cubicBezTo>
                <a:close/>
                <a:moveTo>
                  <a:pt x="1859" y="766"/>
                </a:moveTo>
                <a:cubicBezTo>
                  <a:pt x="1860" y="767"/>
                  <a:pt x="1861" y="769"/>
                  <a:pt x="1861" y="770"/>
                </a:cubicBezTo>
                <a:cubicBezTo>
                  <a:pt x="1861" y="772"/>
                  <a:pt x="1861" y="773"/>
                  <a:pt x="1860" y="775"/>
                </a:cubicBezTo>
                <a:cubicBezTo>
                  <a:pt x="1860" y="777"/>
                  <a:pt x="1858" y="780"/>
                  <a:pt x="1856" y="782"/>
                </a:cubicBezTo>
                <a:cubicBezTo>
                  <a:pt x="1854" y="785"/>
                  <a:pt x="1851" y="788"/>
                  <a:pt x="1847" y="792"/>
                </a:cubicBezTo>
                <a:cubicBezTo>
                  <a:pt x="1843" y="796"/>
                  <a:pt x="1840" y="799"/>
                  <a:pt x="1837" y="801"/>
                </a:cubicBezTo>
                <a:cubicBezTo>
                  <a:pt x="1835" y="803"/>
                  <a:pt x="1832" y="805"/>
                  <a:pt x="1830" y="805"/>
                </a:cubicBezTo>
                <a:cubicBezTo>
                  <a:pt x="1828" y="806"/>
                  <a:pt x="1827" y="806"/>
                  <a:pt x="1825" y="806"/>
                </a:cubicBezTo>
                <a:cubicBezTo>
                  <a:pt x="1824" y="806"/>
                  <a:pt x="1822" y="805"/>
                  <a:pt x="1821" y="804"/>
                </a:cubicBezTo>
                <a:lnTo>
                  <a:pt x="1700" y="683"/>
                </a:lnTo>
                <a:cubicBezTo>
                  <a:pt x="1689" y="671"/>
                  <a:pt x="1678" y="663"/>
                  <a:pt x="1669" y="657"/>
                </a:cubicBezTo>
                <a:cubicBezTo>
                  <a:pt x="1660" y="652"/>
                  <a:pt x="1651" y="649"/>
                  <a:pt x="1643" y="647"/>
                </a:cubicBezTo>
                <a:cubicBezTo>
                  <a:pt x="1634" y="645"/>
                  <a:pt x="1625" y="646"/>
                  <a:pt x="1617" y="649"/>
                </a:cubicBezTo>
                <a:cubicBezTo>
                  <a:pt x="1609" y="651"/>
                  <a:pt x="1601" y="657"/>
                  <a:pt x="1593" y="664"/>
                </a:cubicBezTo>
                <a:cubicBezTo>
                  <a:pt x="1584" y="673"/>
                  <a:pt x="1578" y="686"/>
                  <a:pt x="1575" y="702"/>
                </a:cubicBezTo>
                <a:cubicBezTo>
                  <a:pt x="1572" y="719"/>
                  <a:pt x="1572" y="738"/>
                  <a:pt x="1575" y="762"/>
                </a:cubicBezTo>
                <a:lnTo>
                  <a:pt x="1719" y="906"/>
                </a:lnTo>
                <a:cubicBezTo>
                  <a:pt x="1720" y="907"/>
                  <a:pt x="1721" y="909"/>
                  <a:pt x="1721" y="910"/>
                </a:cubicBezTo>
                <a:cubicBezTo>
                  <a:pt x="1722" y="911"/>
                  <a:pt x="1721" y="913"/>
                  <a:pt x="1720" y="915"/>
                </a:cubicBezTo>
                <a:cubicBezTo>
                  <a:pt x="1720" y="917"/>
                  <a:pt x="1718" y="919"/>
                  <a:pt x="1716" y="922"/>
                </a:cubicBezTo>
                <a:cubicBezTo>
                  <a:pt x="1714" y="925"/>
                  <a:pt x="1711" y="928"/>
                  <a:pt x="1707" y="932"/>
                </a:cubicBezTo>
                <a:cubicBezTo>
                  <a:pt x="1704" y="936"/>
                  <a:pt x="1700" y="939"/>
                  <a:pt x="1698" y="941"/>
                </a:cubicBezTo>
                <a:cubicBezTo>
                  <a:pt x="1695" y="943"/>
                  <a:pt x="1692" y="944"/>
                  <a:pt x="1690" y="945"/>
                </a:cubicBezTo>
                <a:cubicBezTo>
                  <a:pt x="1688" y="946"/>
                  <a:pt x="1687" y="946"/>
                  <a:pt x="1685" y="946"/>
                </a:cubicBezTo>
                <a:cubicBezTo>
                  <a:pt x="1684" y="946"/>
                  <a:pt x="1682" y="945"/>
                  <a:pt x="1681" y="944"/>
                </a:cubicBezTo>
                <a:lnTo>
                  <a:pt x="1475" y="737"/>
                </a:lnTo>
                <a:cubicBezTo>
                  <a:pt x="1474" y="736"/>
                  <a:pt x="1473" y="735"/>
                  <a:pt x="1473" y="734"/>
                </a:cubicBezTo>
                <a:cubicBezTo>
                  <a:pt x="1472" y="732"/>
                  <a:pt x="1472" y="731"/>
                  <a:pt x="1473" y="729"/>
                </a:cubicBezTo>
                <a:cubicBezTo>
                  <a:pt x="1474" y="727"/>
                  <a:pt x="1475" y="724"/>
                  <a:pt x="1477" y="722"/>
                </a:cubicBezTo>
                <a:cubicBezTo>
                  <a:pt x="1479" y="720"/>
                  <a:pt x="1482" y="717"/>
                  <a:pt x="1485" y="713"/>
                </a:cubicBezTo>
                <a:cubicBezTo>
                  <a:pt x="1488" y="710"/>
                  <a:pt x="1491" y="707"/>
                  <a:pt x="1494" y="705"/>
                </a:cubicBezTo>
                <a:cubicBezTo>
                  <a:pt x="1496" y="703"/>
                  <a:pt x="1498" y="702"/>
                  <a:pt x="1500" y="701"/>
                </a:cubicBezTo>
                <a:cubicBezTo>
                  <a:pt x="1502" y="701"/>
                  <a:pt x="1504" y="701"/>
                  <a:pt x="1505" y="701"/>
                </a:cubicBezTo>
                <a:cubicBezTo>
                  <a:pt x="1507" y="701"/>
                  <a:pt x="1508" y="702"/>
                  <a:pt x="1509" y="703"/>
                </a:cubicBezTo>
                <a:lnTo>
                  <a:pt x="1536" y="731"/>
                </a:lnTo>
                <a:cubicBezTo>
                  <a:pt x="1535" y="706"/>
                  <a:pt x="1537" y="685"/>
                  <a:pt x="1543" y="667"/>
                </a:cubicBezTo>
                <a:cubicBezTo>
                  <a:pt x="1548" y="650"/>
                  <a:pt x="1557" y="635"/>
                  <a:pt x="1568" y="623"/>
                </a:cubicBezTo>
                <a:cubicBezTo>
                  <a:pt x="1582" y="610"/>
                  <a:pt x="1596" y="600"/>
                  <a:pt x="1610" y="596"/>
                </a:cubicBezTo>
                <a:cubicBezTo>
                  <a:pt x="1624" y="591"/>
                  <a:pt x="1638" y="589"/>
                  <a:pt x="1652" y="591"/>
                </a:cubicBezTo>
                <a:cubicBezTo>
                  <a:pt x="1665" y="593"/>
                  <a:pt x="1679" y="598"/>
                  <a:pt x="1692" y="606"/>
                </a:cubicBezTo>
                <a:cubicBezTo>
                  <a:pt x="1705" y="614"/>
                  <a:pt x="1718" y="626"/>
                  <a:pt x="1733" y="640"/>
                </a:cubicBezTo>
                <a:lnTo>
                  <a:pt x="1859" y="766"/>
                </a:lnTo>
                <a:close/>
                <a:moveTo>
                  <a:pt x="1962" y="663"/>
                </a:moveTo>
                <a:cubicBezTo>
                  <a:pt x="1964" y="664"/>
                  <a:pt x="1964" y="665"/>
                  <a:pt x="1965" y="667"/>
                </a:cubicBezTo>
                <a:cubicBezTo>
                  <a:pt x="1965" y="668"/>
                  <a:pt x="1964" y="670"/>
                  <a:pt x="1964" y="672"/>
                </a:cubicBezTo>
                <a:cubicBezTo>
                  <a:pt x="1963" y="674"/>
                  <a:pt x="1962" y="676"/>
                  <a:pt x="1959" y="679"/>
                </a:cubicBezTo>
                <a:cubicBezTo>
                  <a:pt x="1957" y="682"/>
                  <a:pt x="1954" y="685"/>
                  <a:pt x="1950" y="689"/>
                </a:cubicBezTo>
                <a:cubicBezTo>
                  <a:pt x="1947" y="693"/>
                  <a:pt x="1944" y="695"/>
                  <a:pt x="1941" y="698"/>
                </a:cubicBezTo>
                <a:cubicBezTo>
                  <a:pt x="1938" y="700"/>
                  <a:pt x="1936" y="701"/>
                  <a:pt x="1934" y="702"/>
                </a:cubicBezTo>
                <a:cubicBezTo>
                  <a:pt x="1932" y="703"/>
                  <a:pt x="1930" y="703"/>
                  <a:pt x="1928" y="703"/>
                </a:cubicBezTo>
                <a:cubicBezTo>
                  <a:pt x="1927" y="703"/>
                  <a:pt x="1926" y="702"/>
                  <a:pt x="1925" y="701"/>
                </a:cubicBezTo>
                <a:lnTo>
                  <a:pt x="1718" y="494"/>
                </a:lnTo>
                <a:cubicBezTo>
                  <a:pt x="1717" y="493"/>
                  <a:pt x="1716" y="492"/>
                  <a:pt x="1716" y="490"/>
                </a:cubicBezTo>
                <a:cubicBezTo>
                  <a:pt x="1716" y="489"/>
                  <a:pt x="1716" y="487"/>
                  <a:pt x="1717" y="485"/>
                </a:cubicBezTo>
                <a:cubicBezTo>
                  <a:pt x="1718" y="483"/>
                  <a:pt x="1719" y="481"/>
                  <a:pt x="1721" y="478"/>
                </a:cubicBezTo>
                <a:cubicBezTo>
                  <a:pt x="1723" y="475"/>
                  <a:pt x="1726" y="472"/>
                  <a:pt x="1730" y="468"/>
                </a:cubicBezTo>
                <a:cubicBezTo>
                  <a:pt x="1734" y="464"/>
                  <a:pt x="1737" y="461"/>
                  <a:pt x="1740" y="459"/>
                </a:cubicBezTo>
                <a:cubicBezTo>
                  <a:pt x="1742" y="457"/>
                  <a:pt x="1745" y="456"/>
                  <a:pt x="1747" y="455"/>
                </a:cubicBezTo>
                <a:cubicBezTo>
                  <a:pt x="1749" y="454"/>
                  <a:pt x="1751" y="454"/>
                  <a:pt x="1752" y="454"/>
                </a:cubicBezTo>
                <a:cubicBezTo>
                  <a:pt x="1754" y="455"/>
                  <a:pt x="1755" y="455"/>
                  <a:pt x="1756" y="456"/>
                </a:cubicBezTo>
                <a:lnTo>
                  <a:pt x="1962" y="663"/>
                </a:lnTo>
                <a:close/>
                <a:moveTo>
                  <a:pt x="1691" y="382"/>
                </a:moveTo>
                <a:cubicBezTo>
                  <a:pt x="1700" y="391"/>
                  <a:pt x="1704" y="399"/>
                  <a:pt x="1704" y="405"/>
                </a:cubicBezTo>
                <a:cubicBezTo>
                  <a:pt x="1704" y="412"/>
                  <a:pt x="1699" y="420"/>
                  <a:pt x="1690" y="429"/>
                </a:cubicBezTo>
                <a:cubicBezTo>
                  <a:pt x="1681" y="438"/>
                  <a:pt x="1673" y="442"/>
                  <a:pt x="1667" y="442"/>
                </a:cubicBezTo>
                <a:cubicBezTo>
                  <a:pt x="1661" y="443"/>
                  <a:pt x="1653" y="438"/>
                  <a:pt x="1644" y="430"/>
                </a:cubicBezTo>
                <a:cubicBezTo>
                  <a:pt x="1635" y="421"/>
                  <a:pt x="1631" y="413"/>
                  <a:pt x="1631" y="406"/>
                </a:cubicBezTo>
                <a:cubicBezTo>
                  <a:pt x="1631" y="400"/>
                  <a:pt x="1636" y="392"/>
                  <a:pt x="1645" y="383"/>
                </a:cubicBezTo>
                <a:cubicBezTo>
                  <a:pt x="1654" y="374"/>
                  <a:pt x="1662" y="370"/>
                  <a:pt x="1668" y="369"/>
                </a:cubicBezTo>
                <a:cubicBezTo>
                  <a:pt x="1674" y="369"/>
                  <a:pt x="1682" y="374"/>
                  <a:pt x="1691" y="382"/>
                </a:cubicBezTo>
                <a:close/>
                <a:moveTo>
                  <a:pt x="2210" y="415"/>
                </a:moveTo>
                <a:cubicBezTo>
                  <a:pt x="2211" y="417"/>
                  <a:pt x="2212" y="418"/>
                  <a:pt x="2212" y="419"/>
                </a:cubicBezTo>
                <a:cubicBezTo>
                  <a:pt x="2212" y="421"/>
                  <a:pt x="2212" y="423"/>
                  <a:pt x="2211" y="425"/>
                </a:cubicBezTo>
                <a:cubicBezTo>
                  <a:pt x="2210" y="427"/>
                  <a:pt x="2209" y="429"/>
                  <a:pt x="2207" y="432"/>
                </a:cubicBezTo>
                <a:cubicBezTo>
                  <a:pt x="2205" y="434"/>
                  <a:pt x="2202" y="438"/>
                  <a:pt x="2198" y="441"/>
                </a:cubicBezTo>
                <a:cubicBezTo>
                  <a:pt x="2194" y="445"/>
                  <a:pt x="2191" y="448"/>
                  <a:pt x="2188" y="450"/>
                </a:cubicBezTo>
                <a:cubicBezTo>
                  <a:pt x="2185" y="452"/>
                  <a:pt x="2183" y="454"/>
                  <a:pt x="2181" y="455"/>
                </a:cubicBezTo>
                <a:cubicBezTo>
                  <a:pt x="2179" y="455"/>
                  <a:pt x="2177" y="456"/>
                  <a:pt x="2176" y="455"/>
                </a:cubicBezTo>
                <a:cubicBezTo>
                  <a:pt x="2174" y="455"/>
                  <a:pt x="2173" y="454"/>
                  <a:pt x="2172" y="453"/>
                </a:cubicBezTo>
                <a:lnTo>
                  <a:pt x="2051" y="332"/>
                </a:lnTo>
                <a:cubicBezTo>
                  <a:pt x="2039" y="321"/>
                  <a:pt x="2029" y="312"/>
                  <a:pt x="2020" y="307"/>
                </a:cubicBezTo>
                <a:cubicBezTo>
                  <a:pt x="2011" y="301"/>
                  <a:pt x="2002" y="298"/>
                  <a:pt x="1993" y="296"/>
                </a:cubicBezTo>
                <a:cubicBezTo>
                  <a:pt x="1985" y="294"/>
                  <a:pt x="1976" y="295"/>
                  <a:pt x="1968" y="298"/>
                </a:cubicBezTo>
                <a:cubicBezTo>
                  <a:pt x="1959" y="301"/>
                  <a:pt x="1952" y="306"/>
                  <a:pt x="1944" y="313"/>
                </a:cubicBezTo>
                <a:cubicBezTo>
                  <a:pt x="1935" y="323"/>
                  <a:pt x="1929" y="335"/>
                  <a:pt x="1926" y="352"/>
                </a:cubicBezTo>
                <a:cubicBezTo>
                  <a:pt x="1923" y="368"/>
                  <a:pt x="1923" y="388"/>
                  <a:pt x="1926" y="411"/>
                </a:cubicBezTo>
                <a:lnTo>
                  <a:pt x="2070" y="555"/>
                </a:lnTo>
                <a:cubicBezTo>
                  <a:pt x="2071" y="556"/>
                  <a:pt x="2072" y="558"/>
                  <a:pt x="2072" y="559"/>
                </a:cubicBezTo>
                <a:cubicBezTo>
                  <a:pt x="2072" y="561"/>
                  <a:pt x="2072" y="562"/>
                  <a:pt x="2071" y="564"/>
                </a:cubicBezTo>
                <a:cubicBezTo>
                  <a:pt x="2070" y="566"/>
                  <a:pt x="2069" y="569"/>
                  <a:pt x="2067" y="572"/>
                </a:cubicBezTo>
                <a:cubicBezTo>
                  <a:pt x="2065" y="574"/>
                  <a:pt x="2062" y="578"/>
                  <a:pt x="2058" y="581"/>
                </a:cubicBezTo>
                <a:cubicBezTo>
                  <a:pt x="2054" y="585"/>
                  <a:pt x="2051" y="588"/>
                  <a:pt x="2048" y="590"/>
                </a:cubicBezTo>
                <a:cubicBezTo>
                  <a:pt x="2046" y="592"/>
                  <a:pt x="2043" y="594"/>
                  <a:pt x="2041" y="595"/>
                </a:cubicBezTo>
                <a:cubicBezTo>
                  <a:pt x="2039" y="595"/>
                  <a:pt x="2037" y="596"/>
                  <a:pt x="2036" y="595"/>
                </a:cubicBezTo>
                <a:cubicBezTo>
                  <a:pt x="2035" y="595"/>
                  <a:pt x="2033" y="594"/>
                  <a:pt x="2032" y="593"/>
                </a:cubicBezTo>
                <a:lnTo>
                  <a:pt x="1826" y="387"/>
                </a:lnTo>
                <a:cubicBezTo>
                  <a:pt x="1824" y="385"/>
                  <a:pt x="1824" y="384"/>
                  <a:pt x="1823" y="383"/>
                </a:cubicBezTo>
                <a:cubicBezTo>
                  <a:pt x="1823" y="382"/>
                  <a:pt x="1823" y="380"/>
                  <a:pt x="1824" y="378"/>
                </a:cubicBezTo>
                <a:cubicBezTo>
                  <a:pt x="1824" y="376"/>
                  <a:pt x="1826" y="374"/>
                  <a:pt x="1828" y="371"/>
                </a:cubicBezTo>
                <a:cubicBezTo>
                  <a:pt x="1830" y="369"/>
                  <a:pt x="1832" y="366"/>
                  <a:pt x="1836" y="362"/>
                </a:cubicBezTo>
                <a:cubicBezTo>
                  <a:pt x="1839" y="359"/>
                  <a:pt x="1842" y="356"/>
                  <a:pt x="1844" y="354"/>
                </a:cubicBezTo>
                <a:cubicBezTo>
                  <a:pt x="1847" y="352"/>
                  <a:pt x="1849" y="351"/>
                  <a:pt x="1851" y="351"/>
                </a:cubicBezTo>
                <a:cubicBezTo>
                  <a:pt x="1853" y="350"/>
                  <a:pt x="1855" y="350"/>
                  <a:pt x="1856" y="350"/>
                </a:cubicBezTo>
                <a:cubicBezTo>
                  <a:pt x="1857" y="351"/>
                  <a:pt x="1859" y="351"/>
                  <a:pt x="1860" y="353"/>
                </a:cubicBezTo>
                <a:lnTo>
                  <a:pt x="1887" y="380"/>
                </a:lnTo>
                <a:cubicBezTo>
                  <a:pt x="1886" y="355"/>
                  <a:pt x="1888" y="334"/>
                  <a:pt x="1893" y="317"/>
                </a:cubicBezTo>
                <a:cubicBezTo>
                  <a:pt x="1899" y="299"/>
                  <a:pt x="1907" y="284"/>
                  <a:pt x="1919" y="273"/>
                </a:cubicBezTo>
                <a:cubicBezTo>
                  <a:pt x="1933" y="259"/>
                  <a:pt x="1947" y="250"/>
                  <a:pt x="1961" y="245"/>
                </a:cubicBezTo>
                <a:cubicBezTo>
                  <a:pt x="1975" y="240"/>
                  <a:pt x="1989" y="239"/>
                  <a:pt x="2002" y="241"/>
                </a:cubicBezTo>
                <a:cubicBezTo>
                  <a:pt x="2016" y="243"/>
                  <a:pt x="2029" y="248"/>
                  <a:pt x="2042" y="256"/>
                </a:cubicBezTo>
                <a:cubicBezTo>
                  <a:pt x="2055" y="264"/>
                  <a:pt x="2069" y="275"/>
                  <a:pt x="2084" y="290"/>
                </a:cubicBezTo>
                <a:lnTo>
                  <a:pt x="2210" y="415"/>
                </a:lnTo>
                <a:close/>
                <a:moveTo>
                  <a:pt x="2345" y="56"/>
                </a:moveTo>
                <a:cubicBezTo>
                  <a:pt x="2351" y="62"/>
                  <a:pt x="2354" y="68"/>
                  <a:pt x="2353" y="73"/>
                </a:cubicBezTo>
                <a:cubicBezTo>
                  <a:pt x="2353" y="79"/>
                  <a:pt x="2350" y="83"/>
                  <a:pt x="2347" y="87"/>
                </a:cubicBezTo>
                <a:lnTo>
                  <a:pt x="2211" y="223"/>
                </a:lnTo>
                <a:cubicBezTo>
                  <a:pt x="2222" y="235"/>
                  <a:pt x="2234" y="244"/>
                  <a:pt x="2245" y="251"/>
                </a:cubicBezTo>
                <a:cubicBezTo>
                  <a:pt x="2257" y="257"/>
                  <a:pt x="2268" y="261"/>
                  <a:pt x="2280" y="263"/>
                </a:cubicBezTo>
                <a:cubicBezTo>
                  <a:pt x="2292" y="264"/>
                  <a:pt x="2304" y="262"/>
                  <a:pt x="2316" y="257"/>
                </a:cubicBezTo>
                <a:cubicBezTo>
                  <a:pt x="2328" y="252"/>
                  <a:pt x="2341" y="243"/>
                  <a:pt x="2353" y="231"/>
                </a:cubicBezTo>
                <a:cubicBezTo>
                  <a:pt x="2363" y="221"/>
                  <a:pt x="2371" y="211"/>
                  <a:pt x="2377" y="202"/>
                </a:cubicBezTo>
                <a:cubicBezTo>
                  <a:pt x="2383" y="193"/>
                  <a:pt x="2388" y="184"/>
                  <a:pt x="2392" y="177"/>
                </a:cubicBezTo>
                <a:cubicBezTo>
                  <a:pt x="2395" y="169"/>
                  <a:pt x="2398" y="163"/>
                  <a:pt x="2400" y="157"/>
                </a:cubicBezTo>
                <a:cubicBezTo>
                  <a:pt x="2402" y="152"/>
                  <a:pt x="2404" y="149"/>
                  <a:pt x="2406" y="147"/>
                </a:cubicBezTo>
                <a:cubicBezTo>
                  <a:pt x="2407" y="146"/>
                  <a:pt x="2408" y="145"/>
                  <a:pt x="2409" y="145"/>
                </a:cubicBezTo>
                <a:cubicBezTo>
                  <a:pt x="2411" y="144"/>
                  <a:pt x="2412" y="145"/>
                  <a:pt x="2414" y="145"/>
                </a:cubicBezTo>
                <a:cubicBezTo>
                  <a:pt x="2415" y="146"/>
                  <a:pt x="2417" y="147"/>
                  <a:pt x="2419" y="149"/>
                </a:cubicBezTo>
                <a:cubicBezTo>
                  <a:pt x="2422" y="150"/>
                  <a:pt x="2424" y="152"/>
                  <a:pt x="2427" y="155"/>
                </a:cubicBezTo>
                <a:cubicBezTo>
                  <a:pt x="2429" y="157"/>
                  <a:pt x="2430" y="159"/>
                  <a:pt x="2432" y="161"/>
                </a:cubicBezTo>
                <a:cubicBezTo>
                  <a:pt x="2433" y="162"/>
                  <a:pt x="2434" y="164"/>
                  <a:pt x="2435" y="165"/>
                </a:cubicBezTo>
                <a:cubicBezTo>
                  <a:pt x="2436" y="166"/>
                  <a:pt x="2437" y="168"/>
                  <a:pt x="2437" y="169"/>
                </a:cubicBezTo>
                <a:cubicBezTo>
                  <a:pt x="2437" y="171"/>
                  <a:pt x="2437" y="172"/>
                  <a:pt x="2437" y="174"/>
                </a:cubicBezTo>
                <a:cubicBezTo>
                  <a:pt x="2437" y="176"/>
                  <a:pt x="2436" y="180"/>
                  <a:pt x="2434" y="186"/>
                </a:cubicBezTo>
                <a:cubicBezTo>
                  <a:pt x="2432" y="192"/>
                  <a:pt x="2428" y="199"/>
                  <a:pt x="2424" y="207"/>
                </a:cubicBezTo>
                <a:cubicBezTo>
                  <a:pt x="2419" y="216"/>
                  <a:pt x="2413" y="225"/>
                  <a:pt x="2406" y="235"/>
                </a:cubicBezTo>
                <a:cubicBezTo>
                  <a:pt x="2399" y="245"/>
                  <a:pt x="2390" y="255"/>
                  <a:pt x="2380" y="265"/>
                </a:cubicBezTo>
                <a:cubicBezTo>
                  <a:pt x="2363" y="282"/>
                  <a:pt x="2346" y="294"/>
                  <a:pt x="2329" y="302"/>
                </a:cubicBezTo>
                <a:cubicBezTo>
                  <a:pt x="2311" y="310"/>
                  <a:pt x="2293" y="314"/>
                  <a:pt x="2275" y="313"/>
                </a:cubicBezTo>
                <a:cubicBezTo>
                  <a:pt x="2257" y="313"/>
                  <a:pt x="2239" y="308"/>
                  <a:pt x="2221" y="298"/>
                </a:cubicBezTo>
                <a:cubicBezTo>
                  <a:pt x="2202" y="288"/>
                  <a:pt x="2184" y="274"/>
                  <a:pt x="2165" y="256"/>
                </a:cubicBezTo>
                <a:cubicBezTo>
                  <a:pt x="2147" y="238"/>
                  <a:pt x="2134" y="220"/>
                  <a:pt x="2124" y="201"/>
                </a:cubicBezTo>
                <a:cubicBezTo>
                  <a:pt x="2114" y="182"/>
                  <a:pt x="2109" y="164"/>
                  <a:pt x="2108" y="145"/>
                </a:cubicBezTo>
                <a:cubicBezTo>
                  <a:pt x="2107" y="127"/>
                  <a:pt x="2109" y="109"/>
                  <a:pt x="2116" y="91"/>
                </a:cubicBezTo>
                <a:cubicBezTo>
                  <a:pt x="2123" y="74"/>
                  <a:pt x="2134" y="57"/>
                  <a:pt x="2150" y="42"/>
                </a:cubicBezTo>
                <a:cubicBezTo>
                  <a:pt x="2166" y="26"/>
                  <a:pt x="2182" y="15"/>
                  <a:pt x="2199" y="9"/>
                </a:cubicBezTo>
                <a:cubicBezTo>
                  <a:pt x="2215" y="2"/>
                  <a:pt x="2232" y="0"/>
                  <a:pt x="2248" y="2"/>
                </a:cubicBezTo>
                <a:cubicBezTo>
                  <a:pt x="2264" y="3"/>
                  <a:pt x="2280" y="8"/>
                  <a:pt x="2295" y="16"/>
                </a:cubicBezTo>
                <a:cubicBezTo>
                  <a:pt x="2310" y="25"/>
                  <a:pt x="2325" y="36"/>
                  <a:pt x="2338" y="49"/>
                </a:cubicBezTo>
                <a:lnTo>
                  <a:pt x="2345" y="56"/>
                </a:lnTo>
                <a:close/>
                <a:moveTo>
                  <a:pt x="2296" y="83"/>
                </a:moveTo>
                <a:cubicBezTo>
                  <a:pt x="2276" y="62"/>
                  <a:pt x="2256" y="51"/>
                  <a:pt x="2236" y="49"/>
                </a:cubicBezTo>
                <a:cubicBezTo>
                  <a:pt x="2215" y="47"/>
                  <a:pt x="2195" y="55"/>
                  <a:pt x="2177" y="74"/>
                </a:cubicBezTo>
                <a:cubicBezTo>
                  <a:pt x="2168" y="83"/>
                  <a:pt x="2161" y="93"/>
                  <a:pt x="2158" y="104"/>
                </a:cubicBezTo>
                <a:cubicBezTo>
                  <a:pt x="2154" y="114"/>
                  <a:pt x="2153" y="125"/>
                  <a:pt x="2154" y="135"/>
                </a:cubicBezTo>
                <a:cubicBezTo>
                  <a:pt x="2155" y="146"/>
                  <a:pt x="2158" y="156"/>
                  <a:pt x="2163" y="167"/>
                </a:cubicBezTo>
                <a:cubicBezTo>
                  <a:pt x="2168" y="177"/>
                  <a:pt x="2175" y="187"/>
                  <a:pt x="2183" y="195"/>
                </a:cubicBezTo>
                <a:lnTo>
                  <a:pt x="2296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8" name="Freeform 252"/>
          <p:cNvSpPr>
            <a:spLocks noEditPoints="1"/>
          </p:cNvSpPr>
          <p:nvPr/>
        </p:nvSpPr>
        <p:spPr bwMode="auto">
          <a:xfrm>
            <a:off x="2444927" y="4418880"/>
            <a:ext cx="424328" cy="488950"/>
          </a:xfrm>
          <a:custGeom>
            <a:avLst/>
            <a:gdLst>
              <a:gd name="T0" fmla="*/ 304 w 2665"/>
              <a:gd name="T1" fmla="*/ 2560 h 2567"/>
              <a:gd name="T2" fmla="*/ 167 w 2665"/>
              <a:gd name="T3" fmla="*/ 2144 h 2567"/>
              <a:gd name="T4" fmla="*/ 333 w 2665"/>
              <a:gd name="T5" fmla="*/ 2261 h 2567"/>
              <a:gd name="T6" fmla="*/ 64 w 2665"/>
              <a:gd name="T7" fmla="*/ 2271 h 2567"/>
              <a:gd name="T8" fmla="*/ 333 w 2665"/>
              <a:gd name="T9" fmla="*/ 2319 h 2567"/>
              <a:gd name="T10" fmla="*/ 382 w 2665"/>
              <a:gd name="T11" fmla="*/ 2392 h 2567"/>
              <a:gd name="T12" fmla="*/ 534 w 2665"/>
              <a:gd name="T13" fmla="*/ 2237 h 2567"/>
              <a:gd name="T14" fmla="*/ 667 w 2665"/>
              <a:gd name="T15" fmla="*/ 2120 h 2567"/>
              <a:gd name="T16" fmla="*/ 677 w 2665"/>
              <a:gd name="T17" fmla="*/ 2182 h 2567"/>
              <a:gd name="T18" fmla="*/ 361 w 2665"/>
              <a:gd name="T19" fmla="*/ 2120 h 2567"/>
              <a:gd name="T20" fmla="*/ 549 w 2665"/>
              <a:gd name="T21" fmla="*/ 2057 h 2567"/>
              <a:gd name="T22" fmla="*/ 864 w 2665"/>
              <a:gd name="T23" fmla="*/ 1959 h 2567"/>
              <a:gd name="T24" fmla="*/ 787 w 2665"/>
              <a:gd name="T25" fmla="*/ 2051 h 2567"/>
              <a:gd name="T26" fmla="*/ 538 w 2665"/>
              <a:gd name="T27" fmla="*/ 1898 h 2567"/>
              <a:gd name="T28" fmla="*/ 531 w 2665"/>
              <a:gd name="T29" fmla="*/ 1785 h 2567"/>
              <a:gd name="T30" fmla="*/ 668 w 2665"/>
              <a:gd name="T31" fmla="*/ 1767 h 2567"/>
              <a:gd name="T32" fmla="*/ 825 w 2665"/>
              <a:gd name="T33" fmla="*/ 1983 h 2567"/>
              <a:gd name="T34" fmla="*/ 864 w 2665"/>
              <a:gd name="T35" fmla="*/ 1959 h 2567"/>
              <a:gd name="T36" fmla="*/ 1033 w 2665"/>
              <a:gd name="T37" fmla="*/ 1779 h 2567"/>
              <a:gd name="T38" fmla="*/ 839 w 2665"/>
              <a:gd name="T39" fmla="*/ 1805 h 2567"/>
              <a:gd name="T40" fmla="*/ 815 w 2665"/>
              <a:gd name="T41" fmla="*/ 1666 h 2567"/>
              <a:gd name="T42" fmla="*/ 747 w 2665"/>
              <a:gd name="T43" fmla="*/ 1747 h 2567"/>
              <a:gd name="T44" fmla="*/ 870 w 2665"/>
              <a:gd name="T45" fmla="*/ 1589 h 2567"/>
              <a:gd name="T46" fmla="*/ 887 w 2665"/>
              <a:gd name="T47" fmla="*/ 1823 h 2567"/>
              <a:gd name="T48" fmla="*/ 1150 w 2665"/>
              <a:gd name="T49" fmla="*/ 1508 h 2567"/>
              <a:gd name="T50" fmla="*/ 1120 w 2665"/>
              <a:gd name="T51" fmla="*/ 1483 h 2567"/>
              <a:gd name="T52" fmla="*/ 1514 w 2665"/>
              <a:gd name="T53" fmla="*/ 1353 h 2567"/>
              <a:gd name="T54" fmla="*/ 1312 w 2665"/>
              <a:gd name="T55" fmla="*/ 1546 h 2567"/>
              <a:gd name="T56" fmla="*/ 1088 w 2665"/>
              <a:gd name="T57" fmla="*/ 1196 h 2567"/>
              <a:gd name="T58" fmla="*/ 1141 w 2665"/>
              <a:gd name="T59" fmla="*/ 1144 h 2567"/>
              <a:gd name="T60" fmla="*/ 1609 w 2665"/>
              <a:gd name="T61" fmla="*/ 1250 h 2567"/>
              <a:gd name="T62" fmla="*/ 1263 w 2665"/>
              <a:gd name="T63" fmla="*/ 977 h 2567"/>
              <a:gd name="T64" fmla="*/ 1301 w 2665"/>
              <a:gd name="T65" fmla="*/ 939 h 2567"/>
              <a:gd name="T66" fmla="*/ 1800 w 2665"/>
              <a:gd name="T67" fmla="*/ 1053 h 2567"/>
              <a:gd name="T68" fmla="*/ 1587 w 2665"/>
              <a:gd name="T69" fmla="*/ 1100 h 2567"/>
              <a:gd name="T70" fmla="*/ 1587 w 2665"/>
              <a:gd name="T71" fmla="*/ 901 h 2567"/>
              <a:gd name="T72" fmla="*/ 1500 w 2665"/>
              <a:gd name="T73" fmla="*/ 1006 h 2567"/>
              <a:gd name="T74" fmla="*/ 1577 w 2665"/>
              <a:gd name="T75" fmla="*/ 853 h 2567"/>
              <a:gd name="T76" fmla="*/ 1633 w 2665"/>
              <a:gd name="T77" fmla="*/ 1053 h 2567"/>
              <a:gd name="T78" fmla="*/ 2081 w 2665"/>
              <a:gd name="T79" fmla="*/ 772 h 2567"/>
              <a:gd name="T80" fmla="*/ 2043 w 2665"/>
              <a:gd name="T81" fmla="*/ 810 h 2567"/>
              <a:gd name="T82" fmla="*/ 1941 w 2665"/>
              <a:gd name="T83" fmla="*/ 912 h 2567"/>
              <a:gd name="T84" fmla="*/ 1903 w 2665"/>
              <a:gd name="T85" fmla="*/ 950 h 2567"/>
              <a:gd name="T86" fmla="*/ 1727 w 2665"/>
              <a:gd name="T87" fmla="*/ 707 h 2567"/>
              <a:gd name="T88" fmla="*/ 1955 w 2665"/>
              <a:gd name="T89" fmla="*/ 646 h 2567"/>
              <a:gd name="T90" fmla="*/ 2161 w 2665"/>
              <a:gd name="T91" fmla="*/ 702 h 2567"/>
              <a:gd name="T92" fmla="*/ 1967 w 2665"/>
              <a:gd name="T93" fmla="*/ 460 h 2567"/>
              <a:gd name="T94" fmla="*/ 1895 w 2665"/>
              <a:gd name="T95" fmla="*/ 443 h 2567"/>
              <a:gd name="T96" fmla="*/ 2439 w 2665"/>
              <a:gd name="T97" fmla="*/ 425 h 2567"/>
              <a:gd name="T98" fmla="*/ 2247 w 2665"/>
              <a:gd name="T99" fmla="*/ 307 h 2567"/>
              <a:gd name="T100" fmla="*/ 2299 w 2665"/>
              <a:gd name="T101" fmla="*/ 565 h 2567"/>
              <a:gd name="T102" fmla="*/ 2051 w 2665"/>
              <a:gd name="T103" fmla="*/ 383 h 2567"/>
              <a:gd name="T104" fmla="*/ 2115 w 2665"/>
              <a:gd name="T105" fmla="*/ 380 h 2567"/>
              <a:gd name="T106" fmla="*/ 2572 w 2665"/>
              <a:gd name="T107" fmla="*/ 56 h 2567"/>
              <a:gd name="T108" fmla="*/ 2605 w 2665"/>
              <a:gd name="T109" fmla="*/ 202 h 2567"/>
              <a:gd name="T110" fmla="*/ 2659 w 2665"/>
              <a:gd name="T111" fmla="*/ 161 h 2567"/>
              <a:gd name="T112" fmla="*/ 2556 w 2665"/>
              <a:gd name="T113" fmla="*/ 303 h 2567"/>
              <a:gd name="T114" fmla="*/ 2426 w 2665"/>
              <a:gd name="T115" fmla="*/ 9 h 2567"/>
              <a:gd name="T116" fmla="*/ 2385 w 2665"/>
              <a:gd name="T117" fmla="*/ 104 h 25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2665" h="2567">
                <a:moveTo>
                  <a:pt x="400" y="2294"/>
                </a:moveTo>
                <a:cubicBezTo>
                  <a:pt x="409" y="2303"/>
                  <a:pt x="417" y="2313"/>
                  <a:pt x="422" y="2323"/>
                </a:cubicBezTo>
                <a:cubicBezTo>
                  <a:pt x="428" y="2334"/>
                  <a:pt x="432" y="2344"/>
                  <a:pt x="434" y="2355"/>
                </a:cubicBezTo>
                <a:cubicBezTo>
                  <a:pt x="436" y="2365"/>
                  <a:pt x="436" y="2376"/>
                  <a:pt x="435" y="2387"/>
                </a:cubicBezTo>
                <a:cubicBezTo>
                  <a:pt x="433" y="2397"/>
                  <a:pt x="431" y="2408"/>
                  <a:pt x="426" y="2419"/>
                </a:cubicBezTo>
                <a:cubicBezTo>
                  <a:pt x="422" y="2430"/>
                  <a:pt x="416" y="2440"/>
                  <a:pt x="409" y="2450"/>
                </a:cubicBezTo>
                <a:cubicBezTo>
                  <a:pt x="402" y="2461"/>
                  <a:pt x="393" y="2471"/>
                  <a:pt x="382" y="2482"/>
                </a:cubicBezTo>
                <a:lnTo>
                  <a:pt x="304" y="2560"/>
                </a:lnTo>
                <a:cubicBezTo>
                  <a:pt x="301" y="2563"/>
                  <a:pt x="296" y="2566"/>
                  <a:pt x="291" y="2566"/>
                </a:cubicBezTo>
                <a:cubicBezTo>
                  <a:pt x="285" y="2567"/>
                  <a:pt x="280" y="2565"/>
                  <a:pt x="274" y="2559"/>
                </a:cubicBezTo>
                <a:lnTo>
                  <a:pt x="9" y="2294"/>
                </a:lnTo>
                <a:cubicBezTo>
                  <a:pt x="3" y="2288"/>
                  <a:pt x="0" y="2282"/>
                  <a:pt x="1" y="2277"/>
                </a:cubicBezTo>
                <a:cubicBezTo>
                  <a:pt x="2" y="2271"/>
                  <a:pt x="4" y="2267"/>
                  <a:pt x="8" y="2263"/>
                </a:cubicBezTo>
                <a:lnTo>
                  <a:pt x="75" y="2196"/>
                </a:lnTo>
                <a:cubicBezTo>
                  <a:pt x="93" y="2178"/>
                  <a:pt x="109" y="2165"/>
                  <a:pt x="124" y="2157"/>
                </a:cubicBezTo>
                <a:cubicBezTo>
                  <a:pt x="138" y="2149"/>
                  <a:pt x="153" y="2145"/>
                  <a:pt x="167" y="2144"/>
                </a:cubicBezTo>
                <a:cubicBezTo>
                  <a:pt x="181" y="2143"/>
                  <a:pt x="194" y="2145"/>
                  <a:pt x="207" y="2150"/>
                </a:cubicBezTo>
                <a:cubicBezTo>
                  <a:pt x="221" y="2156"/>
                  <a:pt x="233" y="2164"/>
                  <a:pt x="245" y="2176"/>
                </a:cubicBezTo>
                <a:cubicBezTo>
                  <a:pt x="252" y="2183"/>
                  <a:pt x="258" y="2191"/>
                  <a:pt x="262" y="2199"/>
                </a:cubicBezTo>
                <a:cubicBezTo>
                  <a:pt x="267" y="2207"/>
                  <a:pt x="271" y="2215"/>
                  <a:pt x="273" y="2224"/>
                </a:cubicBezTo>
                <a:cubicBezTo>
                  <a:pt x="275" y="2233"/>
                  <a:pt x="276" y="2242"/>
                  <a:pt x="275" y="2251"/>
                </a:cubicBezTo>
                <a:cubicBezTo>
                  <a:pt x="274" y="2260"/>
                  <a:pt x="272" y="2269"/>
                  <a:pt x="268" y="2279"/>
                </a:cubicBezTo>
                <a:cubicBezTo>
                  <a:pt x="278" y="2272"/>
                  <a:pt x="288" y="2267"/>
                  <a:pt x="299" y="2264"/>
                </a:cubicBezTo>
                <a:cubicBezTo>
                  <a:pt x="310" y="2261"/>
                  <a:pt x="322" y="2260"/>
                  <a:pt x="333" y="2261"/>
                </a:cubicBezTo>
                <a:cubicBezTo>
                  <a:pt x="345" y="2262"/>
                  <a:pt x="356" y="2266"/>
                  <a:pt x="368" y="2271"/>
                </a:cubicBezTo>
                <a:cubicBezTo>
                  <a:pt x="379" y="2276"/>
                  <a:pt x="390" y="2284"/>
                  <a:pt x="400" y="2294"/>
                </a:cubicBezTo>
                <a:close/>
                <a:moveTo>
                  <a:pt x="208" y="2221"/>
                </a:moveTo>
                <a:cubicBezTo>
                  <a:pt x="201" y="2213"/>
                  <a:pt x="193" y="2208"/>
                  <a:pt x="186" y="2204"/>
                </a:cubicBezTo>
                <a:cubicBezTo>
                  <a:pt x="178" y="2200"/>
                  <a:pt x="170" y="2199"/>
                  <a:pt x="161" y="2199"/>
                </a:cubicBezTo>
                <a:cubicBezTo>
                  <a:pt x="153" y="2199"/>
                  <a:pt x="144" y="2201"/>
                  <a:pt x="135" y="2206"/>
                </a:cubicBezTo>
                <a:cubicBezTo>
                  <a:pt x="126" y="2211"/>
                  <a:pt x="116" y="2219"/>
                  <a:pt x="105" y="2230"/>
                </a:cubicBezTo>
                <a:lnTo>
                  <a:pt x="64" y="2271"/>
                </a:lnTo>
                <a:lnTo>
                  <a:pt x="160" y="2367"/>
                </a:lnTo>
                <a:lnTo>
                  <a:pt x="205" y="2322"/>
                </a:lnTo>
                <a:cubicBezTo>
                  <a:pt x="215" y="2312"/>
                  <a:pt x="222" y="2302"/>
                  <a:pt x="226" y="2293"/>
                </a:cubicBezTo>
                <a:cubicBezTo>
                  <a:pt x="229" y="2284"/>
                  <a:pt x="231" y="2276"/>
                  <a:pt x="231" y="2267"/>
                </a:cubicBezTo>
                <a:cubicBezTo>
                  <a:pt x="230" y="2258"/>
                  <a:pt x="228" y="2250"/>
                  <a:pt x="224" y="2242"/>
                </a:cubicBezTo>
                <a:cubicBezTo>
                  <a:pt x="220" y="2234"/>
                  <a:pt x="214" y="2227"/>
                  <a:pt x="208" y="2221"/>
                </a:cubicBezTo>
                <a:close/>
                <a:moveTo>
                  <a:pt x="361" y="2338"/>
                </a:moveTo>
                <a:cubicBezTo>
                  <a:pt x="352" y="2329"/>
                  <a:pt x="343" y="2323"/>
                  <a:pt x="333" y="2319"/>
                </a:cubicBezTo>
                <a:cubicBezTo>
                  <a:pt x="324" y="2315"/>
                  <a:pt x="314" y="2313"/>
                  <a:pt x="304" y="2314"/>
                </a:cubicBezTo>
                <a:cubicBezTo>
                  <a:pt x="294" y="2315"/>
                  <a:pt x="284" y="2318"/>
                  <a:pt x="273" y="2324"/>
                </a:cubicBezTo>
                <a:cubicBezTo>
                  <a:pt x="263" y="2330"/>
                  <a:pt x="251" y="2339"/>
                  <a:pt x="239" y="2351"/>
                </a:cubicBezTo>
                <a:lnTo>
                  <a:pt x="192" y="2398"/>
                </a:lnTo>
                <a:lnTo>
                  <a:pt x="296" y="2503"/>
                </a:lnTo>
                <a:lnTo>
                  <a:pt x="354" y="2446"/>
                </a:lnTo>
                <a:cubicBezTo>
                  <a:pt x="363" y="2437"/>
                  <a:pt x="369" y="2428"/>
                  <a:pt x="374" y="2419"/>
                </a:cubicBezTo>
                <a:cubicBezTo>
                  <a:pt x="378" y="2410"/>
                  <a:pt x="381" y="2401"/>
                  <a:pt x="382" y="2392"/>
                </a:cubicBezTo>
                <a:cubicBezTo>
                  <a:pt x="383" y="2382"/>
                  <a:pt x="382" y="2373"/>
                  <a:pt x="378" y="2364"/>
                </a:cubicBezTo>
                <a:cubicBezTo>
                  <a:pt x="375" y="2355"/>
                  <a:pt x="369" y="2346"/>
                  <a:pt x="361" y="2338"/>
                </a:cubicBezTo>
                <a:close/>
                <a:moveTo>
                  <a:pt x="598" y="2031"/>
                </a:moveTo>
                <a:cubicBezTo>
                  <a:pt x="604" y="2036"/>
                  <a:pt x="607" y="2042"/>
                  <a:pt x="606" y="2048"/>
                </a:cubicBezTo>
                <a:cubicBezTo>
                  <a:pt x="606" y="2053"/>
                  <a:pt x="604" y="2058"/>
                  <a:pt x="600" y="2062"/>
                </a:cubicBezTo>
                <a:lnTo>
                  <a:pt x="464" y="2198"/>
                </a:lnTo>
                <a:cubicBezTo>
                  <a:pt x="475" y="2209"/>
                  <a:pt x="487" y="2218"/>
                  <a:pt x="498" y="2225"/>
                </a:cubicBezTo>
                <a:cubicBezTo>
                  <a:pt x="510" y="2232"/>
                  <a:pt x="522" y="2236"/>
                  <a:pt x="534" y="2237"/>
                </a:cubicBezTo>
                <a:cubicBezTo>
                  <a:pt x="545" y="2238"/>
                  <a:pt x="557" y="2236"/>
                  <a:pt x="570" y="2231"/>
                </a:cubicBezTo>
                <a:cubicBezTo>
                  <a:pt x="582" y="2226"/>
                  <a:pt x="594" y="2218"/>
                  <a:pt x="606" y="2205"/>
                </a:cubicBezTo>
                <a:cubicBezTo>
                  <a:pt x="616" y="2195"/>
                  <a:pt x="624" y="2186"/>
                  <a:pt x="630" y="2176"/>
                </a:cubicBezTo>
                <a:cubicBezTo>
                  <a:pt x="636" y="2167"/>
                  <a:pt x="641" y="2159"/>
                  <a:pt x="645" y="2151"/>
                </a:cubicBezTo>
                <a:cubicBezTo>
                  <a:pt x="648" y="2144"/>
                  <a:pt x="651" y="2137"/>
                  <a:pt x="653" y="2132"/>
                </a:cubicBezTo>
                <a:cubicBezTo>
                  <a:pt x="655" y="2127"/>
                  <a:pt x="657" y="2123"/>
                  <a:pt x="659" y="2121"/>
                </a:cubicBezTo>
                <a:cubicBezTo>
                  <a:pt x="660" y="2120"/>
                  <a:pt x="661" y="2120"/>
                  <a:pt x="663" y="2119"/>
                </a:cubicBezTo>
                <a:cubicBezTo>
                  <a:pt x="664" y="2119"/>
                  <a:pt x="666" y="2119"/>
                  <a:pt x="667" y="2120"/>
                </a:cubicBezTo>
                <a:cubicBezTo>
                  <a:pt x="669" y="2120"/>
                  <a:pt x="670" y="2121"/>
                  <a:pt x="673" y="2123"/>
                </a:cubicBezTo>
                <a:cubicBezTo>
                  <a:pt x="675" y="2125"/>
                  <a:pt x="677" y="2127"/>
                  <a:pt x="680" y="2130"/>
                </a:cubicBezTo>
                <a:cubicBezTo>
                  <a:pt x="682" y="2132"/>
                  <a:pt x="684" y="2134"/>
                  <a:pt x="685" y="2135"/>
                </a:cubicBezTo>
                <a:cubicBezTo>
                  <a:pt x="686" y="2137"/>
                  <a:pt x="687" y="2138"/>
                  <a:pt x="688" y="2140"/>
                </a:cubicBezTo>
                <a:cubicBezTo>
                  <a:pt x="689" y="2141"/>
                  <a:pt x="690" y="2142"/>
                  <a:pt x="690" y="2144"/>
                </a:cubicBezTo>
                <a:cubicBezTo>
                  <a:pt x="691" y="2145"/>
                  <a:pt x="691" y="2147"/>
                  <a:pt x="691" y="2149"/>
                </a:cubicBezTo>
                <a:cubicBezTo>
                  <a:pt x="691" y="2150"/>
                  <a:pt x="690" y="2154"/>
                  <a:pt x="687" y="2160"/>
                </a:cubicBezTo>
                <a:cubicBezTo>
                  <a:pt x="685" y="2166"/>
                  <a:pt x="682" y="2173"/>
                  <a:pt x="677" y="2182"/>
                </a:cubicBezTo>
                <a:cubicBezTo>
                  <a:pt x="672" y="2190"/>
                  <a:pt x="666" y="2199"/>
                  <a:pt x="659" y="2210"/>
                </a:cubicBezTo>
                <a:cubicBezTo>
                  <a:pt x="652" y="2220"/>
                  <a:pt x="643" y="2230"/>
                  <a:pt x="634" y="2239"/>
                </a:cubicBezTo>
                <a:cubicBezTo>
                  <a:pt x="617" y="2256"/>
                  <a:pt x="599" y="2269"/>
                  <a:pt x="582" y="2277"/>
                </a:cubicBezTo>
                <a:cubicBezTo>
                  <a:pt x="564" y="2285"/>
                  <a:pt x="547" y="2289"/>
                  <a:pt x="529" y="2288"/>
                </a:cubicBezTo>
                <a:cubicBezTo>
                  <a:pt x="511" y="2287"/>
                  <a:pt x="492" y="2282"/>
                  <a:pt x="474" y="2273"/>
                </a:cubicBezTo>
                <a:cubicBezTo>
                  <a:pt x="455" y="2263"/>
                  <a:pt x="437" y="2249"/>
                  <a:pt x="418" y="2230"/>
                </a:cubicBezTo>
                <a:cubicBezTo>
                  <a:pt x="400" y="2212"/>
                  <a:pt x="387" y="2194"/>
                  <a:pt x="377" y="2176"/>
                </a:cubicBezTo>
                <a:cubicBezTo>
                  <a:pt x="368" y="2157"/>
                  <a:pt x="362" y="2138"/>
                  <a:pt x="361" y="2120"/>
                </a:cubicBezTo>
                <a:cubicBezTo>
                  <a:pt x="360" y="2101"/>
                  <a:pt x="363" y="2083"/>
                  <a:pt x="370" y="2066"/>
                </a:cubicBezTo>
                <a:cubicBezTo>
                  <a:pt x="377" y="2048"/>
                  <a:pt x="388" y="2032"/>
                  <a:pt x="403" y="2017"/>
                </a:cubicBezTo>
                <a:cubicBezTo>
                  <a:pt x="419" y="2001"/>
                  <a:pt x="435" y="1989"/>
                  <a:pt x="452" y="1983"/>
                </a:cubicBezTo>
                <a:cubicBezTo>
                  <a:pt x="469" y="1977"/>
                  <a:pt x="485" y="1975"/>
                  <a:pt x="501" y="1976"/>
                </a:cubicBezTo>
                <a:cubicBezTo>
                  <a:pt x="517" y="1978"/>
                  <a:pt x="533" y="1982"/>
                  <a:pt x="548" y="1991"/>
                </a:cubicBezTo>
                <a:cubicBezTo>
                  <a:pt x="563" y="1999"/>
                  <a:pt x="578" y="2010"/>
                  <a:pt x="591" y="2024"/>
                </a:cubicBezTo>
                <a:lnTo>
                  <a:pt x="598" y="2031"/>
                </a:lnTo>
                <a:close/>
                <a:moveTo>
                  <a:pt x="549" y="2057"/>
                </a:moveTo>
                <a:cubicBezTo>
                  <a:pt x="529" y="2037"/>
                  <a:pt x="509" y="2026"/>
                  <a:pt x="489" y="2024"/>
                </a:cubicBezTo>
                <a:cubicBezTo>
                  <a:pt x="468" y="2022"/>
                  <a:pt x="449" y="2030"/>
                  <a:pt x="430" y="2048"/>
                </a:cubicBezTo>
                <a:cubicBezTo>
                  <a:pt x="421" y="2058"/>
                  <a:pt x="415" y="2068"/>
                  <a:pt x="411" y="2078"/>
                </a:cubicBezTo>
                <a:cubicBezTo>
                  <a:pt x="407" y="2089"/>
                  <a:pt x="406" y="2099"/>
                  <a:pt x="407" y="2110"/>
                </a:cubicBezTo>
                <a:cubicBezTo>
                  <a:pt x="408" y="2121"/>
                  <a:pt x="411" y="2131"/>
                  <a:pt x="416" y="2141"/>
                </a:cubicBezTo>
                <a:cubicBezTo>
                  <a:pt x="422" y="2152"/>
                  <a:pt x="428" y="2161"/>
                  <a:pt x="436" y="2170"/>
                </a:cubicBezTo>
                <a:lnTo>
                  <a:pt x="549" y="2057"/>
                </a:lnTo>
                <a:close/>
                <a:moveTo>
                  <a:pt x="864" y="1959"/>
                </a:moveTo>
                <a:cubicBezTo>
                  <a:pt x="868" y="1963"/>
                  <a:pt x="872" y="1967"/>
                  <a:pt x="874" y="1970"/>
                </a:cubicBezTo>
                <a:cubicBezTo>
                  <a:pt x="875" y="1973"/>
                  <a:pt x="876" y="1976"/>
                  <a:pt x="876" y="1979"/>
                </a:cubicBezTo>
                <a:cubicBezTo>
                  <a:pt x="876" y="1981"/>
                  <a:pt x="876" y="1984"/>
                  <a:pt x="874" y="1988"/>
                </a:cubicBezTo>
                <a:cubicBezTo>
                  <a:pt x="873" y="1991"/>
                  <a:pt x="871" y="1995"/>
                  <a:pt x="869" y="1999"/>
                </a:cubicBezTo>
                <a:cubicBezTo>
                  <a:pt x="866" y="2002"/>
                  <a:pt x="864" y="2006"/>
                  <a:pt x="860" y="2010"/>
                </a:cubicBezTo>
                <a:cubicBezTo>
                  <a:pt x="857" y="2014"/>
                  <a:pt x="854" y="2018"/>
                  <a:pt x="851" y="2021"/>
                </a:cubicBezTo>
                <a:cubicBezTo>
                  <a:pt x="840" y="2032"/>
                  <a:pt x="829" y="2040"/>
                  <a:pt x="819" y="2045"/>
                </a:cubicBezTo>
                <a:cubicBezTo>
                  <a:pt x="808" y="2050"/>
                  <a:pt x="798" y="2052"/>
                  <a:pt x="787" y="2051"/>
                </a:cubicBezTo>
                <a:cubicBezTo>
                  <a:pt x="777" y="2050"/>
                  <a:pt x="766" y="2046"/>
                  <a:pt x="755" y="2040"/>
                </a:cubicBezTo>
                <a:cubicBezTo>
                  <a:pt x="744" y="2033"/>
                  <a:pt x="732" y="2024"/>
                  <a:pt x="720" y="2012"/>
                </a:cubicBezTo>
                <a:lnTo>
                  <a:pt x="600" y="1891"/>
                </a:lnTo>
                <a:lnTo>
                  <a:pt x="571" y="1920"/>
                </a:lnTo>
                <a:cubicBezTo>
                  <a:pt x="569" y="1922"/>
                  <a:pt x="566" y="1923"/>
                  <a:pt x="562" y="1922"/>
                </a:cubicBezTo>
                <a:cubicBezTo>
                  <a:pt x="558" y="1921"/>
                  <a:pt x="553" y="1918"/>
                  <a:pt x="548" y="1912"/>
                </a:cubicBezTo>
                <a:cubicBezTo>
                  <a:pt x="545" y="1909"/>
                  <a:pt x="543" y="1907"/>
                  <a:pt x="541" y="1904"/>
                </a:cubicBezTo>
                <a:cubicBezTo>
                  <a:pt x="539" y="1902"/>
                  <a:pt x="538" y="1900"/>
                  <a:pt x="538" y="1898"/>
                </a:cubicBezTo>
                <a:cubicBezTo>
                  <a:pt x="537" y="1896"/>
                  <a:pt x="537" y="1894"/>
                  <a:pt x="537" y="1893"/>
                </a:cubicBezTo>
                <a:cubicBezTo>
                  <a:pt x="538" y="1891"/>
                  <a:pt x="538" y="1890"/>
                  <a:pt x="540" y="1889"/>
                </a:cubicBezTo>
                <a:lnTo>
                  <a:pt x="568" y="1860"/>
                </a:lnTo>
                <a:lnTo>
                  <a:pt x="519" y="1811"/>
                </a:lnTo>
                <a:cubicBezTo>
                  <a:pt x="518" y="1810"/>
                  <a:pt x="518" y="1808"/>
                  <a:pt x="517" y="1807"/>
                </a:cubicBezTo>
                <a:cubicBezTo>
                  <a:pt x="517" y="1806"/>
                  <a:pt x="517" y="1804"/>
                  <a:pt x="518" y="1802"/>
                </a:cubicBezTo>
                <a:cubicBezTo>
                  <a:pt x="518" y="1799"/>
                  <a:pt x="520" y="1797"/>
                  <a:pt x="522" y="1794"/>
                </a:cubicBezTo>
                <a:cubicBezTo>
                  <a:pt x="524" y="1792"/>
                  <a:pt x="527" y="1788"/>
                  <a:pt x="531" y="1785"/>
                </a:cubicBezTo>
                <a:cubicBezTo>
                  <a:pt x="535" y="1781"/>
                  <a:pt x="538" y="1778"/>
                  <a:pt x="541" y="1776"/>
                </a:cubicBezTo>
                <a:cubicBezTo>
                  <a:pt x="543" y="1774"/>
                  <a:pt x="546" y="1772"/>
                  <a:pt x="548" y="1771"/>
                </a:cubicBezTo>
                <a:cubicBezTo>
                  <a:pt x="550" y="1771"/>
                  <a:pt x="552" y="1771"/>
                  <a:pt x="553" y="1771"/>
                </a:cubicBezTo>
                <a:cubicBezTo>
                  <a:pt x="555" y="1771"/>
                  <a:pt x="556" y="1772"/>
                  <a:pt x="557" y="1773"/>
                </a:cubicBezTo>
                <a:lnTo>
                  <a:pt x="606" y="1822"/>
                </a:lnTo>
                <a:lnTo>
                  <a:pt x="659" y="1769"/>
                </a:lnTo>
                <a:cubicBezTo>
                  <a:pt x="660" y="1768"/>
                  <a:pt x="662" y="1767"/>
                  <a:pt x="663" y="1767"/>
                </a:cubicBezTo>
                <a:cubicBezTo>
                  <a:pt x="665" y="1766"/>
                  <a:pt x="666" y="1766"/>
                  <a:pt x="668" y="1767"/>
                </a:cubicBezTo>
                <a:cubicBezTo>
                  <a:pt x="670" y="1768"/>
                  <a:pt x="672" y="1769"/>
                  <a:pt x="675" y="1770"/>
                </a:cubicBezTo>
                <a:cubicBezTo>
                  <a:pt x="677" y="1772"/>
                  <a:pt x="680" y="1774"/>
                  <a:pt x="683" y="1777"/>
                </a:cubicBezTo>
                <a:cubicBezTo>
                  <a:pt x="688" y="1783"/>
                  <a:pt x="691" y="1787"/>
                  <a:pt x="692" y="1791"/>
                </a:cubicBezTo>
                <a:cubicBezTo>
                  <a:pt x="693" y="1795"/>
                  <a:pt x="693" y="1798"/>
                  <a:pt x="691" y="1800"/>
                </a:cubicBezTo>
                <a:lnTo>
                  <a:pt x="638" y="1853"/>
                </a:lnTo>
                <a:lnTo>
                  <a:pt x="753" y="1969"/>
                </a:lnTo>
                <a:cubicBezTo>
                  <a:pt x="767" y="1983"/>
                  <a:pt x="780" y="1991"/>
                  <a:pt x="791" y="1994"/>
                </a:cubicBezTo>
                <a:cubicBezTo>
                  <a:pt x="803" y="1997"/>
                  <a:pt x="814" y="1994"/>
                  <a:pt x="825" y="1983"/>
                </a:cubicBezTo>
                <a:cubicBezTo>
                  <a:pt x="828" y="1979"/>
                  <a:pt x="831" y="1976"/>
                  <a:pt x="833" y="1972"/>
                </a:cubicBezTo>
                <a:cubicBezTo>
                  <a:pt x="835" y="1969"/>
                  <a:pt x="837" y="1966"/>
                  <a:pt x="838" y="1963"/>
                </a:cubicBezTo>
                <a:cubicBezTo>
                  <a:pt x="840" y="1960"/>
                  <a:pt x="841" y="1957"/>
                  <a:pt x="842" y="1955"/>
                </a:cubicBezTo>
                <a:cubicBezTo>
                  <a:pt x="842" y="1953"/>
                  <a:pt x="843" y="1951"/>
                  <a:pt x="845" y="1950"/>
                </a:cubicBezTo>
                <a:cubicBezTo>
                  <a:pt x="845" y="1949"/>
                  <a:pt x="846" y="1949"/>
                  <a:pt x="847" y="1948"/>
                </a:cubicBezTo>
                <a:cubicBezTo>
                  <a:pt x="848" y="1948"/>
                  <a:pt x="850" y="1948"/>
                  <a:pt x="851" y="1949"/>
                </a:cubicBezTo>
                <a:cubicBezTo>
                  <a:pt x="853" y="1950"/>
                  <a:pt x="854" y="1951"/>
                  <a:pt x="857" y="1952"/>
                </a:cubicBezTo>
                <a:cubicBezTo>
                  <a:pt x="859" y="1954"/>
                  <a:pt x="861" y="1956"/>
                  <a:pt x="864" y="1959"/>
                </a:cubicBezTo>
                <a:close/>
                <a:moveTo>
                  <a:pt x="1086" y="1768"/>
                </a:moveTo>
                <a:cubicBezTo>
                  <a:pt x="1088" y="1769"/>
                  <a:pt x="1088" y="1771"/>
                  <a:pt x="1088" y="1773"/>
                </a:cubicBezTo>
                <a:cubicBezTo>
                  <a:pt x="1088" y="1776"/>
                  <a:pt x="1087" y="1778"/>
                  <a:pt x="1085" y="1781"/>
                </a:cubicBezTo>
                <a:cubicBezTo>
                  <a:pt x="1083" y="1783"/>
                  <a:pt x="1081" y="1787"/>
                  <a:pt x="1076" y="1791"/>
                </a:cubicBezTo>
                <a:cubicBezTo>
                  <a:pt x="1072" y="1795"/>
                  <a:pt x="1069" y="1798"/>
                  <a:pt x="1066" y="1799"/>
                </a:cubicBezTo>
                <a:cubicBezTo>
                  <a:pt x="1063" y="1801"/>
                  <a:pt x="1061" y="1802"/>
                  <a:pt x="1059" y="1803"/>
                </a:cubicBezTo>
                <a:cubicBezTo>
                  <a:pt x="1057" y="1803"/>
                  <a:pt x="1055" y="1802"/>
                  <a:pt x="1053" y="1800"/>
                </a:cubicBezTo>
                <a:lnTo>
                  <a:pt x="1033" y="1779"/>
                </a:lnTo>
                <a:cubicBezTo>
                  <a:pt x="1033" y="1798"/>
                  <a:pt x="1031" y="1816"/>
                  <a:pt x="1025" y="1832"/>
                </a:cubicBezTo>
                <a:cubicBezTo>
                  <a:pt x="1019" y="1848"/>
                  <a:pt x="1010" y="1863"/>
                  <a:pt x="998" y="1875"/>
                </a:cubicBezTo>
                <a:cubicBezTo>
                  <a:pt x="987" y="1886"/>
                  <a:pt x="976" y="1895"/>
                  <a:pt x="964" y="1900"/>
                </a:cubicBezTo>
                <a:cubicBezTo>
                  <a:pt x="952" y="1906"/>
                  <a:pt x="941" y="1910"/>
                  <a:pt x="929" y="1911"/>
                </a:cubicBezTo>
                <a:cubicBezTo>
                  <a:pt x="918" y="1912"/>
                  <a:pt x="906" y="1910"/>
                  <a:pt x="895" y="1905"/>
                </a:cubicBezTo>
                <a:cubicBezTo>
                  <a:pt x="884" y="1901"/>
                  <a:pt x="873" y="1894"/>
                  <a:pt x="863" y="1884"/>
                </a:cubicBezTo>
                <a:cubicBezTo>
                  <a:pt x="852" y="1872"/>
                  <a:pt x="844" y="1860"/>
                  <a:pt x="840" y="1847"/>
                </a:cubicBezTo>
                <a:cubicBezTo>
                  <a:pt x="836" y="1833"/>
                  <a:pt x="836" y="1819"/>
                  <a:pt x="839" y="1805"/>
                </a:cubicBezTo>
                <a:cubicBezTo>
                  <a:pt x="843" y="1790"/>
                  <a:pt x="849" y="1775"/>
                  <a:pt x="859" y="1760"/>
                </a:cubicBezTo>
                <a:cubicBezTo>
                  <a:pt x="869" y="1744"/>
                  <a:pt x="882" y="1728"/>
                  <a:pt x="898" y="1712"/>
                </a:cubicBezTo>
                <a:lnTo>
                  <a:pt x="927" y="1684"/>
                </a:lnTo>
                <a:lnTo>
                  <a:pt x="911" y="1668"/>
                </a:lnTo>
                <a:cubicBezTo>
                  <a:pt x="903" y="1660"/>
                  <a:pt x="895" y="1653"/>
                  <a:pt x="887" y="1649"/>
                </a:cubicBezTo>
                <a:cubicBezTo>
                  <a:pt x="879" y="1645"/>
                  <a:pt x="871" y="1642"/>
                  <a:pt x="864" y="1642"/>
                </a:cubicBezTo>
                <a:cubicBezTo>
                  <a:pt x="856" y="1642"/>
                  <a:pt x="848" y="1643"/>
                  <a:pt x="840" y="1647"/>
                </a:cubicBezTo>
                <a:cubicBezTo>
                  <a:pt x="832" y="1651"/>
                  <a:pt x="824" y="1657"/>
                  <a:pt x="815" y="1666"/>
                </a:cubicBezTo>
                <a:cubicBezTo>
                  <a:pt x="805" y="1675"/>
                  <a:pt x="798" y="1685"/>
                  <a:pt x="793" y="1695"/>
                </a:cubicBezTo>
                <a:cubicBezTo>
                  <a:pt x="788" y="1704"/>
                  <a:pt x="784" y="1713"/>
                  <a:pt x="781" y="1721"/>
                </a:cubicBezTo>
                <a:cubicBezTo>
                  <a:pt x="778" y="1730"/>
                  <a:pt x="776" y="1737"/>
                  <a:pt x="774" y="1743"/>
                </a:cubicBezTo>
                <a:cubicBezTo>
                  <a:pt x="773" y="1749"/>
                  <a:pt x="771" y="1753"/>
                  <a:pt x="769" y="1754"/>
                </a:cubicBezTo>
                <a:cubicBezTo>
                  <a:pt x="768" y="1756"/>
                  <a:pt x="767" y="1756"/>
                  <a:pt x="765" y="1757"/>
                </a:cubicBezTo>
                <a:cubicBezTo>
                  <a:pt x="764" y="1757"/>
                  <a:pt x="762" y="1757"/>
                  <a:pt x="760" y="1756"/>
                </a:cubicBezTo>
                <a:cubicBezTo>
                  <a:pt x="758" y="1756"/>
                  <a:pt x="756" y="1755"/>
                  <a:pt x="754" y="1753"/>
                </a:cubicBezTo>
                <a:cubicBezTo>
                  <a:pt x="751" y="1752"/>
                  <a:pt x="749" y="1750"/>
                  <a:pt x="747" y="1747"/>
                </a:cubicBezTo>
                <a:cubicBezTo>
                  <a:pt x="743" y="1744"/>
                  <a:pt x="740" y="1740"/>
                  <a:pt x="739" y="1737"/>
                </a:cubicBezTo>
                <a:cubicBezTo>
                  <a:pt x="737" y="1735"/>
                  <a:pt x="736" y="1731"/>
                  <a:pt x="736" y="1727"/>
                </a:cubicBezTo>
                <a:cubicBezTo>
                  <a:pt x="736" y="1723"/>
                  <a:pt x="738" y="1717"/>
                  <a:pt x="740" y="1710"/>
                </a:cubicBezTo>
                <a:cubicBezTo>
                  <a:pt x="742" y="1702"/>
                  <a:pt x="746" y="1694"/>
                  <a:pt x="750" y="1685"/>
                </a:cubicBezTo>
                <a:cubicBezTo>
                  <a:pt x="754" y="1676"/>
                  <a:pt x="760" y="1667"/>
                  <a:pt x="766" y="1658"/>
                </a:cubicBezTo>
                <a:cubicBezTo>
                  <a:pt x="772" y="1649"/>
                  <a:pt x="780" y="1640"/>
                  <a:pt x="788" y="1632"/>
                </a:cubicBezTo>
                <a:cubicBezTo>
                  <a:pt x="802" y="1617"/>
                  <a:pt x="817" y="1606"/>
                  <a:pt x="830" y="1599"/>
                </a:cubicBezTo>
                <a:cubicBezTo>
                  <a:pt x="844" y="1592"/>
                  <a:pt x="857" y="1589"/>
                  <a:pt x="870" y="1589"/>
                </a:cubicBezTo>
                <a:cubicBezTo>
                  <a:pt x="883" y="1589"/>
                  <a:pt x="896" y="1592"/>
                  <a:pt x="909" y="1599"/>
                </a:cubicBezTo>
                <a:cubicBezTo>
                  <a:pt x="921" y="1606"/>
                  <a:pt x="934" y="1616"/>
                  <a:pt x="947" y="1628"/>
                </a:cubicBezTo>
                <a:lnTo>
                  <a:pt x="1086" y="1768"/>
                </a:lnTo>
                <a:close/>
                <a:moveTo>
                  <a:pt x="954" y="1711"/>
                </a:moveTo>
                <a:lnTo>
                  <a:pt x="922" y="1743"/>
                </a:lnTo>
                <a:cubicBezTo>
                  <a:pt x="911" y="1754"/>
                  <a:pt x="903" y="1763"/>
                  <a:pt x="897" y="1773"/>
                </a:cubicBezTo>
                <a:cubicBezTo>
                  <a:pt x="891" y="1782"/>
                  <a:pt x="888" y="1791"/>
                  <a:pt x="886" y="1800"/>
                </a:cubicBezTo>
                <a:cubicBezTo>
                  <a:pt x="884" y="1808"/>
                  <a:pt x="885" y="1816"/>
                  <a:pt x="887" y="1823"/>
                </a:cubicBezTo>
                <a:cubicBezTo>
                  <a:pt x="890" y="1830"/>
                  <a:pt x="894" y="1837"/>
                  <a:pt x="900" y="1843"/>
                </a:cubicBezTo>
                <a:cubicBezTo>
                  <a:pt x="911" y="1854"/>
                  <a:pt x="923" y="1859"/>
                  <a:pt x="936" y="1859"/>
                </a:cubicBezTo>
                <a:cubicBezTo>
                  <a:pt x="949" y="1858"/>
                  <a:pt x="962" y="1852"/>
                  <a:pt x="974" y="1840"/>
                </a:cubicBezTo>
                <a:cubicBezTo>
                  <a:pt x="984" y="1830"/>
                  <a:pt x="991" y="1818"/>
                  <a:pt x="994" y="1805"/>
                </a:cubicBezTo>
                <a:cubicBezTo>
                  <a:pt x="998" y="1791"/>
                  <a:pt x="999" y="1774"/>
                  <a:pt x="998" y="1755"/>
                </a:cubicBezTo>
                <a:lnTo>
                  <a:pt x="954" y="1711"/>
                </a:lnTo>
                <a:close/>
                <a:moveTo>
                  <a:pt x="1139" y="1494"/>
                </a:moveTo>
                <a:cubicBezTo>
                  <a:pt x="1145" y="1500"/>
                  <a:pt x="1149" y="1504"/>
                  <a:pt x="1150" y="1508"/>
                </a:cubicBezTo>
                <a:cubicBezTo>
                  <a:pt x="1150" y="1512"/>
                  <a:pt x="1150" y="1515"/>
                  <a:pt x="1147" y="1517"/>
                </a:cubicBezTo>
                <a:lnTo>
                  <a:pt x="1051" y="1613"/>
                </a:lnTo>
                <a:cubicBezTo>
                  <a:pt x="1048" y="1616"/>
                  <a:pt x="1045" y="1617"/>
                  <a:pt x="1041" y="1616"/>
                </a:cubicBezTo>
                <a:cubicBezTo>
                  <a:pt x="1038" y="1615"/>
                  <a:pt x="1033" y="1611"/>
                  <a:pt x="1027" y="1606"/>
                </a:cubicBezTo>
                <a:cubicBezTo>
                  <a:pt x="1021" y="1600"/>
                  <a:pt x="1018" y="1595"/>
                  <a:pt x="1017" y="1591"/>
                </a:cubicBezTo>
                <a:cubicBezTo>
                  <a:pt x="1016" y="1588"/>
                  <a:pt x="1017" y="1585"/>
                  <a:pt x="1020" y="1582"/>
                </a:cubicBezTo>
                <a:lnTo>
                  <a:pt x="1116" y="1486"/>
                </a:lnTo>
                <a:cubicBezTo>
                  <a:pt x="1117" y="1485"/>
                  <a:pt x="1118" y="1484"/>
                  <a:pt x="1120" y="1483"/>
                </a:cubicBezTo>
                <a:cubicBezTo>
                  <a:pt x="1121" y="1483"/>
                  <a:pt x="1123" y="1483"/>
                  <a:pt x="1125" y="1483"/>
                </a:cubicBezTo>
                <a:cubicBezTo>
                  <a:pt x="1127" y="1484"/>
                  <a:pt x="1129" y="1485"/>
                  <a:pt x="1131" y="1487"/>
                </a:cubicBezTo>
                <a:cubicBezTo>
                  <a:pt x="1134" y="1488"/>
                  <a:pt x="1136" y="1491"/>
                  <a:pt x="1139" y="1494"/>
                </a:cubicBezTo>
                <a:close/>
                <a:moveTo>
                  <a:pt x="1516" y="1320"/>
                </a:moveTo>
                <a:cubicBezTo>
                  <a:pt x="1521" y="1322"/>
                  <a:pt x="1524" y="1324"/>
                  <a:pt x="1526" y="1326"/>
                </a:cubicBezTo>
                <a:cubicBezTo>
                  <a:pt x="1528" y="1328"/>
                  <a:pt x="1529" y="1331"/>
                  <a:pt x="1529" y="1333"/>
                </a:cubicBezTo>
                <a:cubicBezTo>
                  <a:pt x="1529" y="1335"/>
                  <a:pt x="1528" y="1338"/>
                  <a:pt x="1525" y="1341"/>
                </a:cubicBezTo>
                <a:cubicBezTo>
                  <a:pt x="1523" y="1344"/>
                  <a:pt x="1519" y="1348"/>
                  <a:pt x="1514" y="1353"/>
                </a:cubicBezTo>
                <a:cubicBezTo>
                  <a:pt x="1509" y="1358"/>
                  <a:pt x="1506" y="1361"/>
                  <a:pt x="1503" y="1364"/>
                </a:cubicBezTo>
                <a:cubicBezTo>
                  <a:pt x="1499" y="1366"/>
                  <a:pt x="1497" y="1368"/>
                  <a:pt x="1495" y="1369"/>
                </a:cubicBezTo>
                <a:cubicBezTo>
                  <a:pt x="1493" y="1370"/>
                  <a:pt x="1491" y="1370"/>
                  <a:pt x="1490" y="1370"/>
                </a:cubicBezTo>
                <a:cubicBezTo>
                  <a:pt x="1488" y="1370"/>
                  <a:pt x="1486" y="1369"/>
                  <a:pt x="1484" y="1369"/>
                </a:cubicBezTo>
                <a:lnTo>
                  <a:pt x="1387" y="1322"/>
                </a:lnTo>
                <a:lnTo>
                  <a:pt x="1263" y="1445"/>
                </a:lnTo>
                <a:lnTo>
                  <a:pt x="1310" y="1541"/>
                </a:lnTo>
                <a:cubicBezTo>
                  <a:pt x="1311" y="1543"/>
                  <a:pt x="1312" y="1544"/>
                  <a:pt x="1312" y="1546"/>
                </a:cubicBezTo>
                <a:cubicBezTo>
                  <a:pt x="1312" y="1548"/>
                  <a:pt x="1312" y="1550"/>
                  <a:pt x="1311" y="1552"/>
                </a:cubicBezTo>
                <a:cubicBezTo>
                  <a:pt x="1310" y="1554"/>
                  <a:pt x="1309" y="1557"/>
                  <a:pt x="1306" y="1560"/>
                </a:cubicBezTo>
                <a:cubicBezTo>
                  <a:pt x="1304" y="1563"/>
                  <a:pt x="1301" y="1566"/>
                  <a:pt x="1296" y="1571"/>
                </a:cubicBezTo>
                <a:cubicBezTo>
                  <a:pt x="1292" y="1575"/>
                  <a:pt x="1288" y="1578"/>
                  <a:pt x="1285" y="1581"/>
                </a:cubicBezTo>
                <a:cubicBezTo>
                  <a:pt x="1282" y="1583"/>
                  <a:pt x="1279" y="1585"/>
                  <a:pt x="1277" y="1585"/>
                </a:cubicBezTo>
                <a:cubicBezTo>
                  <a:pt x="1275" y="1585"/>
                  <a:pt x="1273" y="1584"/>
                  <a:pt x="1271" y="1582"/>
                </a:cubicBezTo>
                <a:cubicBezTo>
                  <a:pt x="1269" y="1579"/>
                  <a:pt x="1266" y="1576"/>
                  <a:pt x="1264" y="1572"/>
                </a:cubicBezTo>
                <a:lnTo>
                  <a:pt x="1088" y="1196"/>
                </a:lnTo>
                <a:cubicBezTo>
                  <a:pt x="1087" y="1194"/>
                  <a:pt x="1087" y="1192"/>
                  <a:pt x="1087" y="1190"/>
                </a:cubicBezTo>
                <a:cubicBezTo>
                  <a:pt x="1086" y="1188"/>
                  <a:pt x="1087" y="1186"/>
                  <a:pt x="1088" y="1183"/>
                </a:cubicBezTo>
                <a:cubicBezTo>
                  <a:pt x="1090" y="1181"/>
                  <a:pt x="1092" y="1178"/>
                  <a:pt x="1094" y="1174"/>
                </a:cubicBezTo>
                <a:cubicBezTo>
                  <a:pt x="1097" y="1171"/>
                  <a:pt x="1101" y="1167"/>
                  <a:pt x="1105" y="1163"/>
                </a:cubicBezTo>
                <a:cubicBezTo>
                  <a:pt x="1110" y="1158"/>
                  <a:pt x="1115" y="1154"/>
                  <a:pt x="1118" y="1151"/>
                </a:cubicBezTo>
                <a:cubicBezTo>
                  <a:pt x="1121" y="1148"/>
                  <a:pt x="1124" y="1146"/>
                  <a:pt x="1127" y="1144"/>
                </a:cubicBezTo>
                <a:cubicBezTo>
                  <a:pt x="1130" y="1143"/>
                  <a:pt x="1132" y="1142"/>
                  <a:pt x="1134" y="1142"/>
                </a:cubicBezTo>
                <a:cubicBezTo>
                  <a:pt x="1136" y="1143"/>
                  <a:pt x="1139" y="1143"/>
                  <a:pt x="1141" y="1144"/>
                </a:cubicBezTo>
                <a:lnTo>
                  <a:pt x="1516" y="1320"/>
                </a:lnTo>
                <a:close/>
                <a:moveTo>
                  <a:pt x="1145" y="1205"/>
                </a:moveTo>
                <a:lnTo>
                  <a:pt x="1145" y="1205"/>
                </a:lnTo>
                <a:lnTo>
                  <a:pt x="1242" y="1404"/>
                </a:lnTo>
                <a:lnTo>
                  <a:pt x="1345" y="1301"/>
                </a:lnTo>
                <a:lnTo>
                  <a:pt x="1145" y="1205"/>
                </a:lnTo>
                <a:close/>
                <a:moveTo>
                  <a:pt x="1607" y="1246"/>
                </a:moveTo>
                <a:cubicBezTo>
                  <a:pt x="1608" y="1247"/>
                  <a:pt x="1609" y="1248"/>
                  <a:pt x="1609" y="1250"/>
                </a:cubicBezTo>
                <a:cubicBezTo>
                  <a:pt x="1610" y="1251"/>
                  <a:pt x="1609" y="1253"/>
                  <a:pt x="1609" y="1255"/>
                </a:cubicBezTo>
                <a:cubicBezTo>
                  <a:pt x="1608" y="1257"/>
                  <a:pt x="1606" y="1259"/>
                  <a:pt x="1604" y="1262"/>
                </a:cubicBezTo>
                <a:cubicBezTo>
                  <a:pt x="1602" y="1265"/>
                  <a:pt x="1599" y="1268"/>
                  <a:pt x="1595" y="1272"/>
                </a:cubicBezTo>
                <a:cubicBezTo>
                  <a:pt x="1592" y="1275"/>
                  <a:pt x="1588" y="1278"/>
                  <a:pt x="1586" y="1281"/>
                </a:cubicBezTo>
                <a:cubicBezTo>
                  <a:pt x="1583" y="1283"/>
                  <a:pt x="1580" y="1284"/>
                  <a:pt x="1578" y="1285"/>
                </a:cubicBezTo>
                <a:cubicBezTo>
                  <a:pt x="1576" y="1286"/>
                  <a:pt x="1575" y="1286"/>
                  <a:pt x="1573" y="1286"/>
                </a:cubicBezTo>
                <a:cubicBezTo>
                  <a:pt x="1572" y="1285"/>
                  <a:pt x="1571" y="1285"/>
                  <a:pt x="1569" y="1283"/>
                </a:cubicBezTo>
                <a:lnTo>
                  <a:pt x="1263" y="977"/>
                </a:lnTo>
                <a:cubicBezTo>
                  <a:pt x="1262" y="976"/>
                  <a:pt x="1261" y="975"/>
                  <a:pt x="1261" y="973"/>
                </a:cubicBezTo>
                <a:cubicBezTo>
                  <a:pt x="1260" y="972"/>
                  <a:pt x="1260" y="970"/>
                  <a:pt x="1261" y="968"/>
                </a:cubicBezTo>
                <a:cubicBezTo>
                  <a:pt x="1262" y="966"/>
                  <a:pt x="1264" y="963"/>
                  <a:pt x="1266" y="961"/>
                </a:cubicBezTo>
                <a:cubicBezTo>
                  <a:pt x="1268" y="958"/>
                  <a:pt x="1271" y="955"/>
                  <a:pt x="1275" y="951"/>
                </a:cubicBezTo>
                <a:cubicBezTo>
                  <a:pt x="1278" y="947"/>
                  <a:pt x="1282" y="944"/>
                  <a:pt x="1284" y="942"/>
                </a:cubicBezTo>
                <a:cubicBezTo>
                  <a:pt x="1287" y="940"/>
                  <a:pt x="1289" y="939"/>
                  <a:pt x="1291" y="938"/>
                </a:cubicBezTo>
                <a:cubicBezTo>
                  <a:pt x="1293" y="937"/>
                  <a:pt x="1295" y="937"/>
                  <a:pt x="1297" y="937"/>
                </a:cubicBezTo>
                <a:cubicBezTo>
                  <a:pt x="1298" y="937"/>
                  <a:pt x="1300" y="938"/>
                  <a:pt x="1301" y="939"/>
                </a:cubicBezTo>
                <a:lnTo>
                  <a:pt x="1607" y="1246"/>
                </a:lnTo>
                <a:close/>
                <a:moveTo>
                  <a:pt x="1832" y="1021"/>
                </a:moveTo>
                <a:cubicBezTo>
                  <a:pt x="1834" y="1023"/>
                  <a:pt x="1835" y="1025"/>
                  <a:pt x="1835" y="1027"/>
                </a:cubicBezTo>
                <a:cubicBezTo>
                  <a:pt x="1834" y="1029"/>
                  <a:pt x="1833" y="1031"/>
                  <a:pt x="1832" y="1034"/>
                </a:cubicBezTo>
                <a:cubicBezTo>
                  <a:pt x="1830" y="1036"/>
                  <a:pt x="1827" y="1040"/>
                  <a:pt x="1823" y="1044"/>
                </a:cubicBezTo>
                <a:cubicBezTo>
                  <a:pt x="1819" y="1048"/>
                  <a:pt x="1816" y="1051"/>
                  <a:pt x="1813" y="1053"/>
                </a:cubicBezTo>
                <a:cubicBezTo>
                  <a:pt x="1810" y="1055"/>
                  <a:pt x="1808" y="1056"/>
                  <a:pt x="1806" y="1056"/>
                </a:cubicBezTo>
                <a:cubicBezTo>
                  <a:pt x="1804" y="1056"/>
                  <a:pt x="1802" y="1055"/>
                  <a:pt x="1800" y="1053"/>
                </a:cubicBezTo>
                <a:lnTo>
                  <a:pt x="1779" y="1033"/>
                </a:lnTo>
                <a:cubicBezTo>
                  <a:pt x="1780" y="1051"/>
                  <a:pt x="1777" y="1069"/>
                  <a:pt x="1772" y="1085"/>
                </a:cubicBezTo>
                <a:cubicBezTo>
                  <a:pt x="1766" y="1102"/>
                  <a:pt x="1757" y="1116"/>
                  <a:pt x="1744" y="1129"/>
                </a:cubicBezTo>
                <a:cubicBezTo>
                  <a:pt x="1734" y="1139"/>
                  <a:pt x="1722" y="1148"/>
                  <a:pt x="1711" y="1154"/>
                </a:cubicBezTo>
                <a:cubicBezTo>
                  <a:pt x="1699" y="1160"/>
                  <a:pt x="1688" y="1163"/>
                  <a:pt x="1676" y="1164"/>
                </a:cubicBezTo>
                <a:cubicBezTo>
                  <a:pt x="1664" y="1165"/>
                  <a:pt x="1653" y="1163"/>
                  <a:pt x="1642" y="1159"/>
                </a:cubicBezTo>
                <a:cubicBezTo>
                  <a:pt x="1631" y="1154"/>
                  <a:pt x="1620" y="1147"/>
                  <a:pt x="1610" y="1137"/>
                </a:cubicBezTo>
                <a:cubicBezTo>
                  <a:pt x="1598" y="1126"/>
                  <a:pt x="1591" y="1113"/>
                  <a:pt x="1587" y="1100"/>
                </a:cubicBezTo>
                <a:cubicBezTo>
                  <a:pt x="1583" y="1087"/>
                  <a:pt x="1583" y="1073"/>
                  <a:pt x="1586" y="1058"/>
                </a:cubicBezTo>
                <a:cubicBezTo>
                  <a:pt x="1589" y="1044"/>
                  <a:pt x="1596" y="1029"/>
                  <a:pt x="1606" y="1013"/>
                </a:cubicBezTo>
                <a:cubicBezTo>
                  <a:pt x="1616" y="997"/>
                  <a:pt x="1629" y="981"/>
                  <a:pt x="1645" y="965"/>
                </a:cubicBezTo>
                <a:lnTo>
                  <a:pt x="1673" y="937"/>
                </a:lnTo>
                <a:lnTo>
                  <a:pt x="1657" y="921"/>
                </a:lnTo>
                <a:cubicBezTo>
                  <a:pt x="1649" y="913"/>
                  <a:pt x="1642" y="907"/>
                  <a:pt x="1634" y="902"/>
                </a:cubicBezTo>
                <a:cubicBezTo>
                  <a:pt x="1626" y="898"/>
                  <a:pt x="1618" y="895"/>
                  <a:pt x="1610" y="895"/>
                </a:cubicBezTo>
                <a:cubicBezTo>
                  <a:pt x="1603" y="895"/>
                  <a:pt x="1595" y="897"/>
                  <a:pt x="1587" y="901"/>
                </a:cubicBezTo>
                <a:cubicBezTo>
                  <a:pt x="1579" y="904"/>
                  <a:pt x="1570" y="911"/>
                  <a:pt x="1562" y="919"/>
                </a:cubicBezTo>
                <a:cubicBezTo>
                  <a:pt x="1552" y="929"/>
                  <a:pt x="1545" y="938"/>
                  <a:pt x="1540" y="948"/>
                </a:cubicBezTo>
                <a:cubicBezTo>
                  <a:pt x="1535" y="958"/>
                  <a:pt x="1530" y="966"/>
                  <a:pt x="1528" y="975"/>
                </a:cubicBezTo>
                <a:cubicBezTo>
                  <a:pt x="1525" y="983"/>
                  <a:pt x="1522" y="990"/>
                  <a:pt x="1521" y="996"/>
                </a:cubicBezTo>
                <a:cubicBezTo>
                  <a:pt x="1519" y="1002"/>
                  <a:pt x="1518" y="1006"/>
                  <a:pt x="1516" y="1008"/>
                </a:cubicBezTo>
                <a:cubicBezTo>
                  <a:pt x="1515" y="1009"/>
                  <a:pt x="1513" y="1010"/>
                  <a:pt x="1512" y="1010"/>
                </a:cubicBezTo>
                <a:cubicBezTo>
                  <a:pt x="1510" y="1010"/>
                  <a:pt x="1509" y="1010"/>
                  <a:pt x="1507" y="1010"/>
                </a:cubicBezTo>
                <a:cubicBezTo>
                  <a:pt x="1505" y="1009"/>
                  <a:pt x="1503" y="1008"/>
                  <a:pt x="1500" y="1006"/>
                </a:cubicBezTo>
                <a:cubicBezTo>
                  <a:pt x="1498" y="1005"/>
                  <a:pt x="1496" y="1003"/>
                  <a:pt x="1494" y="1001"/>
                </a:cubicBezTo>
                <a:cubicBezTo>
                  <a:pt x="1490" y="997"/>
                  <a:pt x="1487" y="994"/>
                  <a:pt x="1485" y="991"/>
                </a:cubicBezTo>
                <a:cubicBezTo>
                  <a:pt x="1484" y="988"/>
                  <a:pt x="1483" y="985"/>
                  <a:pt x="1483" y="981"/>
                </a:cubicBezTo>
                <a:cubicBezTo>
                  <a:pt x="1483" y="977"/>
                  <a:pt x="1484" y="971"/>
                  <a:pt x="1487" y="963"/>
                </a:cubicBezTo>
                <a:cubicBezTo>
                  <a:pt x="1489" y="955"/>
                  <a:pt x="1492" y="947"/>
                  <a:pt x="1497" y="938"/>
                </a:cubicBezTo>
                <a:cubicBezTo>
                  <a:pt x="1501" y="929"/>
                  <a:pt x="1506" y="920"/>
                  <a:pt x="1513" y="911"/>
                </a:cubicBezTo>
                <a:cubicBezTo>
                  <a:pt x="1519" y="902"/>
                  <a:pt x="1526" y="893"/>
                  <a:pt x="1534" y="885"/>
                </a:cubicBezTo>
                <a:cubicBezTo>
                  <a:pt x="1549" y="870"/>
                  <a:pt x="1563" y="860"/>
                  <a:pt x="1577" y="853"/>
                </a:cubicBezTo>
                <a:cubicBezTo>
                  <a:pt x="1591" y="845"/>
                  <a:pt x="1604" y="842"/>
                  <a:pt x="1617" y="842"/>
                </a:cubicBezTo>
                <a:cubicBezTo>
                  <a:pt x="1630" y="842"/>
                  <a:pt x="1643" y="846"/>
                  <a:pt x="1655" y="852"/>
                </a:cubicBezTo>
                <a:cubicBezTo>
                  <a:pt x="1668" y="859"/>
                  <a:pt x="1680" y="869"/>
                  <a:pt x="1693" y="882"/>
                </a:cubicBezTo>
                <a:lnTo>
                  <a:pt x="1832" y="1021"/>
                </a:lnTo>
                <a:close/>
                <a:moveTo>
                  <a:pt x="1701" y="964"/>
                </a:moveTo>
                <a:lnTo>
                  <a:pt x="1668" y="996"/>
                </a:lnTo>
                <a:cubicBezTo>
                  <a:pt x="1658" y="1007"/>
                  <a:pt x="1650" y="1017"/>
                  <a:pt x="1644" y="1026"/>
                </a:cubicBezTo>
                <a:cubicBezTo>
                  <a:pt x="1638" y="1036"/>
                  <a:pt x="1634" y="1045"/>
                  <a:pt x="1633" y="1053"/>
                </a:cubicBezTo>
                <a:cubicBezTo>
                  <a:pt x="1631" y="1061"/>
                  <a:pt x="1632" y="1069"/>
                  <a:pt x="1634" y="1077"/>
                </a:cubicBezTo>
                <a:cubicBezTo>
                  <a:pt x="1636" y="1084"/>
                  <a:pt x="1641" y="1090"/>
                  <a:pt x="1647" y="1097"/>
                </a:cubicBezTo>
                <a:cubicBezTo>
                  <a:pt x="1658" y="1107"/>
                  <a:pt x="1670" y="1113"/>
                  <a:pt x="1683" y="1112"/>
                </a:cubicBezTo>
                <a:cubicBezTo>
                  <a:pt x="1696" y="1112"/>
                  <a:pt x="1709" y="1105"/>
                  <a:pt x="1721" y="1093"/>
                </a:cubicBezTo>
                <a:cubicBezTo>
                  <a:pt x="1731" y="1083"/>
                  <a:pt x="1737" y="1071"/>
                  <a:pt x="1741" y="1058"/>
                </a:cubicBezTo>
                <a:cubicBezTo>
                  <a:pt x="1744" y="1044"/>
                  <a:pt x="1746" y="1028"/>
                  <a:pt x="1744" y="1008"/>
                </a:cubicBezTo>
                <a:lnTo>
                  <a:pt x="1701" y="964"/>
                </a:lnTo>
                <a:close/>
                <a:moveTo>
                  <a:pt x="2081" y="772"/>
                </a:moveTo>
                <a:cubicBezTo>
                  <a:pt x="2082" y="773"/>
                  <a:pt x="2083" y="775"/>
                  <a:pt x="2083" y="776"/>
                </a:cubicBezTo>
                <a:cubicBezTo>
                  <a:pt x="2083" y="778"/>
                  <a:pt x="2083" y="779"/>
                  <a:pt x="2082" y="781"/>
                </a:cubicBezTo>
                <a:cubicBezTo>
                  <a:pt x="2081" y="783"/>
                  <a:pt x="2080" y="786"/>
                  <a:pt x="2078" y="788"/>
                </a:cubicBezTo>
                <a:cubicBezTo>
                  <a:pt x="2076" y="791"/>
                  <a:pt x="2073" y="794"/>
                  <a:pt x="2069" y="798"/>
                </a:cubicBezTo>
                <a:cubicBezTo>
                  <a:pt x="2065" y="802"/>
                  <a:pt x="2062" y="805"/>
                  <a:pt x="2059" y="807"/>
                </a:cubicBezTo>
                <a:cubicBezTo>
                  <a:pt x="2056" y="809"/>
                  <a:pt x="2054" y="810"/>
                  <a:pt x="2052" y="811"/>
                </a:cubicBezTo>
                <a:cubicBezTo>
                  <a:pt x="2050" y="812"/>
                  <a:pt x="2048" y="812"/>
                  <a:pt x="2047" y="812"/>
                </a:cubicBezTo>
                <a:cubicBezTo>
                  <a:pt x="2045" y="812"/>
                  <a:pt x="2044" y="811"/>
                  <a:pt x="2043" y="810"/>
                </a:cubicBezTo>
                <a:lnTo>
                  <a:pt x="1922" y="689"/>
                </a:lnTo>
                <a:cubicBezTo>
                  <a:pt x="1910" y="677"/>
                  <a:pt x="1900" y="669"/>
                  <a:pt x="1891" y="663"/>
                </a:cubicBezTo>
                <a:cubicBezTo>
                  <a:pt x="1882" y="658"/>
                  <a:pt x="1873" y="655"/>
                  <a:pt x="1864" y="653"/>
                </a:cubicBezTo>
                <a:cubicBezTo>
                  <a:pt x="1856" y="651"/>
                  <a:pt x="1847" y="652"/>
                  <a:pt x="1839" y="655"/>
                </a:cubicBezTo>
                <a:cubicBezTo>
                  <a:pt x="1830" y="657"/>
                  <a:pt x="1823" y="662"/>
                  <a:pt x="1815" y="670"/>
                </a:cubicBezTo>
                <a:cubicBezTo>
                  <a:pt x="1806" y="679"/>
                  <a:pt x="1800" y="692"/>
                  <a:pt x="1797" y="708"/>
                </a:cubicBezTo>
                <a:cubicBezTo>
                  <a:pt x="1794" y="725"/>
                  <a:pt x="1794" y="744"/>
                  <a:pt x="1797" y="768"/>
                </a:cubicBezTo>
                <a:lnTo>
                  <a:pt x="1941" y="912"/>
                </a:lnTo>
                <a:cubicBezTo>
                  <a:pt x="1942" y="913"/>
                  <a:pt x="1943" y="914"/>
                  <a:pt x="1943" y="916"/>
                </a:cubicBezTo>
                <a:cubicBezTo>
                  <a:pt x="1943" y="917"/>
                  <a:pt x="1943" y="919"/>
                  <a:pt x="1942" y="921"/>
                </a:cubicBezTo>
                <a:cubicBezTo>
                  <a:pt x="1942" y="923"/>
                  <a:pt x="1940" y="925"/>
                  <a:pt x="1938" y="928"/>
                </a:cubicBezTo>
                <a:cubicBezTo>
                  <a:pt x="1936" y="931"/>
                  <a:pt x="1933" y="934"/>
                  <a:pt x="1929" y="938"/>
                </a:cubicBezTo>
                <a:cubicBezTo>
                  <a:pt x="1925" y="942"/>
                  <a:pt x="1922" y="945"/>
                  <a:pt x="1919" y="947"/>
                </a:cubicBezTo>
                <a:cubicBezTo>
                  <a:pt x="1917" y="949"/>
                  <a:pt x="1914" y="950"/>
                  <a:pt x="1912" y="951"/>
                </a:cubicBezTo>
                <a:cubicBezTo>
                  <a:pt x="1910" y="952"/>
                  <a:pt x="1908" y="952"/>
                  <a:pt x="1907" y="952"/>
                </a:cubicBezTo>
                <a:cubicBezTo>
                  <a:pt x="1906" y="952"/>
                  <a:pt x="1904" y="951"/>
                  <a:pt x="1903" y="950"/>
                </a:cubicBezTo>
                <a:lnTo>
                  <a:pt x="1697" y="743"/>
                </a:lnTo>
                <a:cubicBezTo>
                  <a:pt x="1696" y="742"/>
                  <a:pt x="1695" y="741"/>
                  <a:pt x="1694" y="740"/>
                </a:cubicBezTo>
                <a:cubicBezTo>
                  <a:pt x="1694" y="738"/>
                  <a:pt x="1694" y="737"/>
                  <a:pt x="1695" y="735"/>
                </a:cubicBezTo>
                <a:cubicBezTo>
                  <a:pt x="1695" y="733"/>
                  <a:pt x="1697" y="730"/>
                  <a:pt x="1699" y="728"/>
                </a:cubicBezTo>
                <a:cubicBezTo>
                  <a:pt x="1701" y="726"/>
                  <a:pt x="1703" y="723"/>
                  <a:pt x="1707" y="719"/>
                </a:cubicBezTo>
                <a:cubicBezTo>
                  <a:pt x="1710" y="716"/>
                  <a:pt x="1713" y="713"/>
                  <a:pt x="1716" y="711"/>
                </a:cubicBezTo>
                <a:cubicBezTo>
                  <a:pt x="1718" y="709"/>
                  <a:pt x="1720" y="708"/>
                  <a:pt x="1722" y="707"/>
                </a:cubicBezTo>
                <a:cubicBezTo>
                  <a:pt x="1724" y="707"/>
                  <a:pt x="1726" y="707"/>
                  <a:pt x="1727" y="707"/>
                </a:cubicBezTo>
                <a:cubicBezTo>
                  <a:pt x="1728" y="707"/>
                  <a:pt x="1730" y="708"/>
                  <a:pt x="1731" y="709"/>
                </a:cubicBezTo>
                <a:lnTo>
                  <a:pt x="1758" y="737"/>
                </a:lnTo>
                <a:cubicBezTo>
                  <a:pt x="1757" y="712"/>
                  <a:pt x="1759" y="691"/>
                  <a:pt x="1764" y="673"/>
                </a:cubicBezTo>
                <a:cubicBezTo>
                  <a:pt x="1770" y="656"/>
                  <a:pt x="1779" y="641"/>
                  <a:pt x="1790" y="629"/>
                </a:cubicBezTo>
                <a:cubicBezTo>
                  <a:pt x="1804" y="615"/>
                  <a:pt x="1818" y="606"/>
                  <a:pt x="1832" y="601"/>
                </a:cubicBezTo>
                <a:cubicBezTo>
                  <a:pt x="1846" y="597"/>
                  <a:pt x="1860" y="595"/>
                  <a:pt x="1874" y="597"/>
                </a:cubicBezTo>
                <a:cubicBezTo>
                  <a:pt x="1887" y="599"/>
                  <a:pt x="1900" y="604"/>
                  <a:pt x="1913" y="612"/>
                </a:cubicBezTo>
                <a:cubicBezTo>
                  <a:pt x="1926" y="620"/>
                  <a:pt x="1940" y="632"/>
                  <a:pt x="1955" y="646"/>
                </a:cubicBezTo>
                <a:lnTo>
                  <a:pt x="2081" y="772"/>
                </a:lnTo>
                <a:close/>
                <a:moveTo>
                  <a:pt x="2190" y="663"/>
                </a:moveTo>
                <a:cubicBezTo>
                  <a:pt x="2191" y="664"/>
                  <a:pt x="2192" y="666"/>
                  <a:pt x="2192" y="667"/>
                </a:cubicBezTo>
                <a:cubicBezTo>
                  <a:pt x="2192" y="668"/>
                  <a:pt x="2192" y="670"/>
                  <a:pt x="2191" y="672"/>
                </a:cubicBezTo>
                <a:cubicBezTo>
                  <a:pt x="2190" y="674"/>
                  <a:pt x="2189" y="677"/>
                  <a:pt x="2187" y="679"/>
                </a:cubicBezTo>
                <a:cubicBezTo>
                  <a:pt x="2185" y="682"/>
                  <a:pt x="2182" y="685"/>
                  <a:pt x="2178" y="689"/>
                </a:cubicBezTo>
                <a:cubicBezTo>
                  <a:pt x="2174" y="693"/>
                  <a:pt x="2171" y="696"/>
                  <a:pt x="2168" y="698"/>
                </a:cubicBezTo>
                <a:cubicBezTo>
                  <a:pt x="2166" y="700"/>
                  <a:pt x="2163" y="701"/>
                  <a:pt x="2161" y="702"/>
                </a:cubicBezTo>
                <a:cubicBezTo>
                  <a:pt x="2159" y="703"/>
                  <a:pt x="2157" y="703"/>
                  <a:pt x="2156" y="703"/>
                </a:cubicBezTo>
                <a:cubicBezTo>
                  <a:pt x="2155" y="703"/>
                  <a:pt x="2153" y="702"/>
                  <a:pt x="2152" y="701"/>
                </a:cubicBezTo>
                <a:lnTo>
                  <a:pt x="1946" y="494"/>
                </a:lnTo>
                <a:cubicBezTo>
                  <a:pt x="1945" y="493"/>
                  <a:pt x="1944" y="492"/>
                  <a:pt x="1943" y="491"/>
                </a:cubicBezTo>
                <a:cubicBezTo>
                  <a:pt x="1943" y="489"/>
                  <a:pt x="1943" y="488"/>
                  <a:pt x="1944" y="485"/>
                </a:cubicBezTo>
                <a:cubicBezTo>
                  <a:pt x="1945" y="483"/>
                  <a:pt x="1947" y="481"/>
                  <a:pt x="1949" y="478"/>
                </a:cubicBezTo>
                <a:cubicBezTo>
                  <a:pt x="1951" y="475"/>
                  <a:pt x="1954" y="472"/>
                  <a:pt x="1957" y="469"/>
                </a:cubicBezTo>
                <a:cubicBezTo>
                  <a:pt x="1961" y="465"/>
                  <a:pt x="1964" y="462"/>
                  <a:pt x="1967" y="460"/>
                </a:cubicBezTo>
                <a:cubicBezTo>
                  <a:pt x="1970" y="458"/>
                  <a:pt x="1972" y="456"/>
                  <a:pt x="1974" y="455"/>
                </a:cubicBezTo>
                <a:cubicBezTo>
                  <a:pt x="1976" y="455"/>
                  <a:pt x="1978" y="454"/>
                  <a:pt x="1980" y="455"/>
                </a:cubicBezTo>
                <a:cubicBezTo>
                  <a:pt x="1981" y="455"/>
                  <a:pt x="1982" y="456"/>
                  <a:pt x="1983" y="457"/>
                </a:cubicBezTo>
                <a:lnTo>
                  <a:pt x="2190" y="663"/>
                </a:lnTo>
                <a:close/>
                <a:moveTo>
                  <a:pt x="1918" y="383"/>
                </a:moveTo>
                <a:cubicBezTo>
                  <a:pt x="1927" y="391"/>
                  <a:pt x="1931" y="399"/>
                  <a:pt x="1931" y="406"/>
                </a:cubicBezTo>
                <a:cubicBezTo>
                  <a:pt x="1931" y="412"/>
                  <a:pt x="1926" y="420"/>
                  <a:pt x="1917" y="429"/>
                </a:cubicBezTo>
                <a:cubicBezTo>
                  <a:pt x="1909" y="438"/>
                  <a:pt x="1901" y="443"/>
                  <a:pt x="1895" y="443"/>
                </a:cubicBezTo>
                <a:cubicBezTo>
                  <a:pt x="1888" y="443"/>
                  <a:pt x="1881" y="439"/>
                  <a:pt x="1872" y="430"/>
                </a:cubicBezTo>
                <a:cubicBezTo>
                  <a:pt x="1863" y="421"/>
                  <a:pt x="1859" y="413"/>
                  <a:pt x="1859" y="407"/>
                </a:cubicBezTo>
                <a:cubicBezTo>
                  <a:pt x="1859" y="400"/>
                  <a:pt x="1864" y="392"/>
                  <a:pt x="1873" y="383"/>
                </a:cubicBezTo>
                <a:cubicBezTo>
                  <a:pt x="1881" y="374"/>
                  <a:pt x="1889" y="370"/>
                  <a:pt x="1895" y="370"/>
                </a:cubicBezTo>
                <a:cubicBezTo>
                  <a:pt x="1902" y="370"/>
                  <a:pt x="1909" y="374"/>
                  <a:pt x="1918" y="383"/>
                </a:cubicBezTo>
                <a:close/>
                <a:moveTo>
                  <a:pt x="2437" y="416"/>
                </a:moveTo>
                <a:cubicBezTo>
                  <a:pt x="2438" y="417"/>
                  <a:pt x="2439" y="418"/>
                  <a:pt x="2439" y="420"/>
                </a:cubicBezTo>
                <a:cubicBezTo>
                  <a:pt x="2440" y="421"/>
                  <a:pt x="2439" y="423"/>
                  <a:pt x="2439" y="425"/>
                </a:cubicBezTo>
                <a:cubicBezTo>
                  <a:pt x="2438" y="427"/>
                  <a:pt x="2436" y="429"/>
                  <a:pt x="2434" y="432"/>
                </a:cubicBezTo>
                <a:cubicBezTo>
                  <a:pt x="2432" y="435"/>
                  <a:pt x="2429" y="438"/>
                  <a:pt x="2425" y="442"/>
                </a:cubicBezTo>
                <a:cubicBezTo>
                  <a:pt x="2422" y="445"/>
                  <a:pt x="2418" y="448"/>
                  <a:pt x="2416" y="451"/>
                </a:cubicBezTo>
                <a:cubicBezTo>
                  <a:pt x="2413" y="453"/>
                  <a:pt x="2410" y="454"/>
                  <a:pt x="2408" y="455"/>
                </a:cubicBezTo>
                <a:cubicBezTo>
                  <a:pt x="2407" y="456"/>
                  <a:pt x="2405" y="456"/>
                  <a:pt x="2403" y="456"/>
                </a:cubicBezTo>
                <a:cubicBezTo>
                  <a:pt x="2402" y="455"/>
                  <a:pt x="2401" y="455"/>
                  <a:pt x="2399" y="454"/>
                </a:cubicBezTo>
                <a:lnTo>
                  <a:pt x="2279" y="333"/>
                </a:lnTo>
                <a:cubicBezTo>
                  <a:pt x="2267" y="321"/>
                  <a:pt x="2256" y="312"/>
                  <a:pt x="2247" y="307"/>
                </a:cubicBezTo>
                <a:cubicBezTo>
                  <a:pt x="2238" y="302"/>
                  <a:pt x="2229" y="298"/>
                  <a:pt x="2221" y="296"/>
                </a:cubicBezTo>
                <a:cubicBezTo>
                  <a:pt x="2212" y="295"/>
                  <a:pt x="2203" y="295"/>
                  <a:pt x="2195" y="298"/>
                </a:cubicBezTo>
                <a:cubicBezTo>
                  <a:pt x="2187" y="301"/>
                  <a:pt x="2179" y="306"/>
                  <a:pt x="2172" y="313"/>
                </a:cubicBezTo>
                <a:cubicBezTo>
                  <a:pt x="2162" y="323"/>
                  <a:pt x="2156" y="336"/>
                  <a:pt x="2153" y="352"/>
                </a:cubicBezTo>
                <a:cubicBezTo>
                  <a:pt x="2151" y="368"/>
                  <a:pt x="2151" y="388"/>
                  <a:pt x="2153" y="411"/>
                </a:cubicBezTo>
                <a:lnTo>
                  <a:pt x="2297" y="556"/>
                </a:lnTo>
                <a:cubicBezTo>
                  <a:pt x="2299" y="557"/>
                  <a:pt x="2299" y="558"/>
                  <a:pt x="2299" y="560"/>
                </a:cubicBezTo>
                <a:cubicBezTo>
                  <a:pt x="2300" y="561"/>
                  <a:pt x="2299" y="563"/>
                  <a:pt x="2299" y="565"/>
                </a:cubicBezTo>
                <a:cubicBezTo>
                  <a:pt x="2298" y="567"/>
                  <a:pt x="2296" y="569"/>
                  <a:pt x="2294" y="572"/>
                </a:cubicBezTo>
                <a:cubicBezTo>
                  <a:pt x="2292" y="575"/>
                  <a:pt x="2289" y="578"/>
                  <a:pt x="2285" y="582"/>
                </a:cubicBezTo>
                <a:cubicBezTo>
                  <a:pt x="2282" y="585"/>
                  <a:pt x="2279" y="588"/>
                  <a:pt x="2276" y="590"/>
                </a:cubicBezTo>
                <a:cubicBezTo>
                  <a:pt x="2273" y="593"/>
                  <a:pt x="2271" y="594"/>
                  <a:pt x="2269" y="595"/>
                </a:cubicBezTo>
                <a:cubicBezTo>
                  <a:pt x="2266" y="596"/>
                  <a:pt x="2265" y="596"/>
                  <a:pt x="2263" y="596"/>
                </a:cubicBezTo>
                <a:cubicBezTo>
                  <a:pt x="2262" y="595"/>
                  <a:pt x="2261" y="595"/>
                  <a:pt x="2259" y="593"/>
                </a:cubicBezTo>
                <a:lnTo>
                  <a:pt x="2053" y="387"/>
                </a:lnTo>
                <a:cubicBezTo>
                  <a:pt x="2052" y="386"/>
                  <a:pt x="2051" y="385"/>
                  <a:pt x="2051" y="383"/>
                </a:cubicBezTo>
                <a:cubicBezTo>
                  <a:pt x="2050" y="382"/>
                  <a:pt x="2051" y="380"/>
                  <a:pt x="2051" y="378"/>
                </a:cubicBezTo>
                <a:cubicBezTo>
                  <a:pt x="2052" y="376"/>
                  <a:pt x="2053" y="374"/>
                  <a:pt x="2055" y="372"/>
                </a:cubicBezTo>
                <a:cubicBezTo>
                  <a:pt x="2057" y="369"/>
                  <a:pt x="2060" y="366"/>
                  <a:pt x="2063" y="363"/>
                </a:cubicBezTo>
                <a:cubicBezTo>
                  <a:pt x="2067" y="359"/>
                  <a:pt x="2069" y="357"/>
                  <a:pt x="2072" y="355"/>
                </a:cubicBezTo>
                <a:cubicBezTo>
                  <a:pt x="2074" y="353"/>
                  <a:pt x="2077" y="351"/>
                  <a:pt x="2078" y="351"/>
                </a:cubicBezTo>
                <a:cubicBezTo>
                  <a:pt x="2080" y="350"/>
                  <a:pt x="2082" y="350"/>
                  <a:pt x="2083" y="351"/>
                </a:cubicBezTo>
                <a:cubicBezTo>
                  <a:pt x="2085" y="351"/>
                  <a:pt x="2086" y="352"/>
                  <a:pt x="2087" y="353"/>
                </a:cubicBezTo>
                <a:lnTo>
                  <a:pt x="2115" y="380"/>
                </a:lnTo>
                <a:cubicBezTo>
                  <a:pt x="2113" y="356"/>
                  <a:pt x="2115" y="334"/>
                  <a:pt x="2121" y="317"/>
                </a:cubicBezTo>
                <a:cubicBezTo>
                  <a:pt x="2126" y="299"/>
                  <a:pt x="2135" y="285"/>
                  <a:pt x="2147" y="273"/>
                </a:cubicBezTo>
                <a:cubicBezTo>
                  <a:pt x="2160" y="259"/>
                  <a:pt x="2174" y="250"/>
                  <a:pt x="2188" y="245"/>
                </a:cubicBezTo>
                <a:cubicBezTo>
                  <a:pt x="2202" y="240"/>
                  <a:pt x="2216" y="239"/>
                  <a:pt x="2230" y="241"/>
                </a:cubicBezTo>
                <a:cubicBezTo>
                  <a:pt x="2244" y="243"/>
                  <a:pt x="2257" y="248"/>
                  <a:pt x="2270" y="256"/>
                </a:cubicBezTo>
                <a:cubicBezTo>
                  <a:pt x="2283" y="264"/>
                  <a:pt x="2297" y="275"/>
                  <a:pt x="2311" y="290"/>
                </a:cubicBezTo>
                <a:lnTo>
                  <a:pt x="2437" y="416"/>
                </a:lnTo>
                <a:close/>
                <a:moveTo>
                  <a:pt x="2572" y="56"/>
                </a:moveTo>
                <a:cubicBezTo>
                  <a:pt x="2578" y="62"/>
                  <a:pt x="2581" y="68"/>
                  <a:pt x="2581" y="73"/>
                </a:cubicBezTo>
                <a:cubicBezTo>
                  <a:pt x="2580" y="79"/>
                  <a:pt x="2578" y="84"/>
                  <a:pt x="2574" y="88"/>
                </a:cubicBezTo>
                <a:lnTo>
                  <a:pt x="2438" y="223"/>
                </a:lnTo>
                <a:cubicBezTo>
                  <a:pt x="2450" y="235"/>
                  <a:pt x="2461" y="244"/>
                  <a:pt x="2473" y="251"/>
                </a:cubicBezTo>
                <a:cubicBezTo>
                  <a:pt x="2484" y="258"/>
                  <a:pt x="2496" y="262"/>
                  <a:pt x="2508" y="263"/>
                </a:cubicBezTo>
                <a:cubicBezTo>
                  <a:pt x="2520" y="264"/>
                  <a:pt x="2532" y="262"/>
                  <a:pt x="2544" y="257"/>
                </a:cubicBezTo>
                <a:cubicBezTo>
                  <a:pt x="2556" y="252"/>
                  <a:pt x="2568" y="243"/>
                  <a:pt x="2581" y="231"/>
                </a:cubicBezTo>
                <a:cubicBezTo>
                  <a:pt x="2591" y="221"/>
                  <a:pt x="2598" y="211"/>
                  <a:pt x="2605" y="202"/>
                </a:cubicBezTo>
                <a:cubicBezTo>
                  <a:pt x="2611" y="193"/>
                  <a:pt x="2615" y="184"/>
                  <a:pt x="2619" y="177"/>
                </a:cubicBezTo>
                <a:cubicBezTo>
                  <a:pt x="2623" y="169"/>
                  <a:pt x="2626" y="163"/>
                  <a:pt x="2628" y="158"/>
                </a:cubicBezTo>
                <a:cubicBezTo>
                  <a:pt x="2630" y="152"/>
                  <a:pt x="2631" y="149"/>
                  <a:pt x="2633" y="147"/>
                </a:cubicBezTo>
                <a:cubicBezTo>
                  <a:pt x="2634" y="146"/>
                  <a:pt x="2636" y="145"/>
                  <a:pt x="2637" y="145"/>
                </a:cubicBezTo>
                <a:cubicBezTo>
                  <a:pt x="2638" y="145"/>
                  <a:pt x="2640" y="145"/>
                  <a:pt x="2641" y="145"/>
                </a:cubicBezTo>
                <a:cubicBezTo>
                  <a:pt x="2643" y="146"/>
                  <a:pt x="2645" y="147"/>
                  <a:pt x="2647" y="149"/>
                </a:cubicBezTo>
                <a:cubicBezTo>
                  <a:pt x="2649" y="151"/>
                  <a:pt x="2651" y="153"/>
                  <a:pt x="2654" y="156"/>
                </a:cubicBezTo>
                <a:cubicBezTo>
                  <a:pt x="2656" y="158"/>
                  <a:pt x="2658" y="159"/>
                  <a:pt x="2659" y="161"/>
                </a:cubicBezTo>
                <a:cubicBezTo>
                  <a:pt x="2660" y="163"/>
                  <a:pt x="2662" y="164"/>
                  <a:pt x="2662" y="165"/>
                </a:cubicBezTo>
                <a:cubicBezTo>
                  <a:pt x="2663" y="167"/>
                  <a:pt x="2664" y="168"/>
                  <a:pt x="2664" y="170"/>
                </a:cubicBezTo>
                <a:cubicBezTo>
                  <a:pt x="2665" y="171"/>
                  <a:pt x="2665" y="173"/>
                  <a:pt x="2665" y="174"/>
                </a:cubicBezTo>
                <a:cubicBezTo>
                  <a:pt x="2665" y="176"/>
                  <a:pt x="2664" y="180"/>
                  <a:pt x="2662" y="186"/>
                </a:cubicBezTo>
                <a:cubicBezTo>
                  <a:pt x="2659" y="192"/>
                  <a:pt x="2656" y="199"/>
                  <a:pt x="2651" y="208"/>
                </a:cubicBezTo>
                <a:cubicBezTo>
                  <a:pt x="2646" y="216"/>
                  <a:pt x="2641" y="225"/>
                  <a:pt x="2633" y="235"/>
                </a:cubicBezTo>
                <a:cubicBezTo>
                  <a:pt x="2626" y="245"/>
                  <a:pt x="2618" y="255"/>
                  <a:pt x="2608" y="265"/>
                </a:cubicBezTo>
                <a:cubicBezTo>
                  <a:pt x="2591" y="282"/>
                  <a:pt x="2574" y="295"/>
                  <a:pt x="2556" y="303"/>
                </a:cubicBezTo>
                <a:cubicBezTo>
                  <a:pt x="2539" y="311"/>
                  <a:pt x="2521" y="314"/>
                  <a:pt x="2503" y="314"/>
                </a:cubicBezTo>
                <a:cubicBezTo>
                  <a:pt x="2485" y="313"/>
                  <a:pt x="2467" y="308"/>
                  <a:pt x="2448" y="298"/>
                </a:cubicBezTo>
                <a:cubicBezTo>
                  <a:pt x="2430" y="289"/>
                  <a:pt x="2411" y="275"/>
                  <a:pt x="2392" y="256"/>
                </a:cubicBezTo>
                <a:cubicBezTo>
                  <a:pt x="2375" y="238"/>
                  <a:pt x="2361" y="220"/>
                  <a:pt x="2351" y="201"/>
                </a:cubicBezTo>
                <a:cubicBezTo>
                  <a:pt x="2342" y="183"/>
                  <a:pt x="2337" y="164"/>
                  <a:pt x="2335" y="145"/>
                </a:cubicBezTo>
                <a:cubicBezTo>
                  <a:pt x="2334" y="127"/>
                  <a:pt x="2337" y="109"/>
                  <a:pt x="2344" y="91"/>
                </a:cubicBezTo>
                <a:cubicBezTo>
                  <a:pt x="2351" y="74"/>
                  <a:pt x="2362" y="58"/>
                  <a:pt x="2377" y="43"/>
                </a:cubicBezTo>
                <a:cubicBezTo>
                  <a:pt x="2393" y="26"/>
                  <a:pt x="2410" y="15"/>
                  <a:pt x="2426" y="9"/>
                </a:cubicBezTo>
                <a:cubicBezTo>
                  <a:pt x="2443" y="3"/>
                  <a:pt x="2459" y="0"/>
                  <a:pt x="2475" y="2"/>
                </a:cubicBezTo>
                <a:cubicBezTo>
                  <a:pt x="2491" y="3"/>
                  <a:pt x="2507" y="8"/>
                  <a:pt x="2522" y="17"/>
                </a:cubicBezTo>
                <a:cubicBezTo>
                  <a:pt x="2538" y="25"/>
                  <a:pt x="2552" y="36"/>
                  <a:pt x="2565" y="49"/>
                </a:cubicBezTo>
                <a:lnTo>
                  <a:pt x="2572" y="56"/>
                </a:lnTo>
                <a:close/>
                <a:moveTo>
                  <a:pt x="2523" y="83"/>
                </a:moveTo>
                <a:cubicBezTo>
                  <a:pt x="2504" y="63"/>
                  <a:pt x="2484" y="52"/>
                  <a:pt x="2463" y="50"/>
                </a:cubicBezTo>
                <a:cubicBezTo>
                  <a:pt x="2442" y="48"/>
                  <a:pt x="2423" y="56"/>
                  <a:pt x="2405" y="74"/>
                </a:cubicBezTo>
                <a:cubicBezTo>
                  <a:pt x="2395" y="83"/>
                  <a:pt x="2389" y="93"/>
                  <a:pt x="2385" y="104"/>
                </a:cubicBezTo>
                <a:cubicBezTo>
                  <a:pt x="2382" y="115"/>
                  <a:pt x="2380" y="125"/>
                  <a:pt x="2381" y="136"/>
                </a:cubicBezTo>
                <a:cubicBezTo>
                  <a:pt x="2383" y="146"/>
                  <a:pt x="2386" y="157"/>
                  <a:pt x="2391" y="167"/>
                </a:cubicBezTo>
                <a:cubicBezTo>
                  <a:pt x="2396" y="177"/>
                  <a:pt x="2402" y="187"/>
                  <a:pt x="2410" y="196"/>
                </a:cubicBezTo>
                <a:lnTo>
                  <a:pt x="2523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69" name="Freeform 253"/>
          <p:cNvSpPr>
            <a:spLocks noEditPoints="1"/>
          </p:cNvSpPr>
          <p:nvPr/>
        </p:nvSpPr>
        <p:spPr bwMode="auto">
          <a:xfrm>
            <a:off x="2744609" y="4417292"/>
            <a:ext cx="347419" cy="398463"/>
          </a:xfrm>
          <a:custGeom>
            <a:avLst/>
            <a:gdLst>
              <a:gd name="T0" fmla="*/ 174 w 2183"/>
              <a:gd name="T1" fmla="*/ 1702 h 2089"/>
              <a:gd name="T2" fmla="*/ 170 w 2183"/>
              <a:gd name="T3" fmla="*/ 2016 h 2089"/>
              <a:gd name="T4" fmla="*/ 221 w 2183"/>
              <a:gd name="T5" fmla="*/ 1901 h 2089"/>
              <a:gd name="T6" fmla="*/ 283 w 2183"/>
              <a:gd name="T7" fmla="*/ 1774 h 2089"/>
              <a:gd name="T8" fmla="*/ 433 w 2183"/>
              <a:gd name="T9" fmla="*/ 1918 h 2089"/>
              <a:gd name="T10" fmla="*/ 144 w 2183"/>
              <a:gd name="T11" fmla="*/ 2069 h 2089"/>
              <a:gd name="T12" fmla="*/ 134 w 2183"/>
              <a:gd name="T13" fmla="*/ 1667 h 2089"/>
              <a:gd name="T14" fmla="*/ 566 w 2183"/>
              <a:gd name="T15" fmla="*/ 1815 h 2089"/>
              <a:gd name="T16" fmla="*/ 221 w 2183"/>
              <a:gd name="T17" fmla="*/ 1537 h 2089"/>
              <a:gd name="T18" fmla="*/ 254 w 2183"/>
              <a:gd name="T19" fmla="*/ 1497 h 2089"/>
              <a:gd name="T20" fmla="*/ 801 w 2183"/>
              <a:gd name="T21" fmla="*/ 1584 h 2089"/>
              <a:gd name="T22" fmla="*/ 717 w 2183"/>
              <a:gd name="T23" fmla="*/ 1674 h 2089"/>
              <a:gd name="T24" fmla="*/ 425 w 2183"/>
              <a:gd name="T25" fmla="*/ 1522 h 2089"/>
              <a:gd name="T26" fmla="*/ 585 w 2183"/>
              <a:gd name="T27" fmla="*/ 1613 h 2089"/>
              <a:gd name="T28" fmla="*/ 567 w 2183"/>
              <a:gd name="T29" fmla="*/ 1391 h 2089"/>
              <a:gd name="T30" fmla="*/ 601 w 2183"/>
              <a:gd name="T31" fmla="*/ 1351 h 2089"/>
              <a:gd name="T32" fmla="*/ 980 w 2183"/>
              <a:gd name="T33" fmla="*/ 1405 h 2089"/>
              <a:gd name="T34" fmla="*/ 711 w 2183"/>
              <a:gd name="T35" fmla="*/ 1297 h 2089"/>
              <a:gd name="T36" fmla="*/ 651 w 2183"/>
              <a:gd name="T37" fmla="*/ 1295 h 2089"/>
              <a:gd name="T38" fmla="*/ 652 w 2183"/>
              <a:gd name="T39" fmla="*/ 1182 h 2089"/>
              <a:gd name="T40" fmla="*/ 780 w 2183"/>
              <a:gd name="T41" fmla="*/ 1173 h 2089"/>
              <a:gd name="T42" fmla="*/ 903 w 2183"/>
              <a:gd name="T43" fmla="*/ 1401 h 2089"/>
              <a:gd name="T44" fmla="*/ 963 w 2183"/>
              <a:gd name="T45" fmla="*/ 1355 h 2089"/>
              <a:gd name="T46" fmla="*/ 1172 w 2183"/>
              <a:gd name="T47" fmla="*/ 1211 h 2089"/>
              <a:gd name="T48" fmla="*/ 1035 w 2183"/>
              <a:gd name="T49" fmla="*/ 1322 h 2089"/>
              <a:gd name="T50" fmla="*/ 1033 w 2183"/>
              <a:gd name="T51" fmla="*/ 1095 h 2089"/>
              <a:gd name="T52" fmla="*/ 887 w 2183"/>
              <a:gd name="T53" fmla="*/ 1133 h 2089"/>
              <a:gd name="T54" fmla="*/ 845 w 2183"/>
              <a:gd name="T55" fmla="*/ 1149 h 2089"/>
              <a:gd name="T56" fmla="*/ 976 w 2183"/>
              <a:gd name="T57" fmla="*/ 1001 h 2089"/>
              <a:gd name="T58" fmla="*/ 992 w 2183"/>
              <a:gd name="T59" fmla="*/ 1212 h 2089"/>
              <a:gd name="T60" fmla="*/ 1060 w 2183"/>
              <a:gd name="T61" fmla="*/ 1123 h 2089"/>
              <a:gd name="T62" fmla="*/ 1540 w 2183"/>
              <a:gd name="T63" fmla="*/ 841 h 2089"/>
              <a:gd name="T64" fmla="*/ 1306 w 2183"/>
              <a:gd name="T65" fmla="*/ 697 h 2089"/>
              <a:gd name="T66" fmla="*/ 1422 w 2183"/>
              <a:gd name="T67" fmla="*/ 962 h 2089"/>
              <a:gd name="T68" fmla="*/ 1219 w 2183"/>
              <a:gd name="T69" fmla="*/ 816 h 2089"/>
              <a:gd name="T70" fmla="*/ 1302 w 2183"/>
              <a:gd name="T71" fmla="*/ 1080 h 2089"/>
              <a:gd name="T72" fmla="*/ 1056 w 2183"/>
              <a:gd name="T73" fmla="*/ 902 h 2089"/>
              <a:gd name="T74" fmla="*/ 1086 w 2183"/>
              <a:gd name="T75" fmla="*/ 865 h 2089"/>
              <a:gd name="T76" fmla="*/ 1225 w 2183"/>
              <a:gd name="T77" fmla="*/ 760 h 2089"/>
              <a:gd name="T78" fmla="*/ 1362 w 2183"/>
              <a:gd name="T79" fmla="*/ 627 h 2089"/>
              <a:gd name="T80" fmla="*/ 1788 w 2183"/>
              <a:gd name="T81" fmla="*/ 597 h 2089"/>
              <a:gd name="T82" fmla="*/ 1675 w 2183"/>
              <a:gd name="T83" fmla="*/ 707 h 2089"/>
              <a:gd name="T84" fmla="*/ 1610 w 2183"/>
              <a:gd name="T85" fmla="*/ 519 h 2089"/>
              <a:gd name="T86" fmla="*/ 1504 w 2183"/>
              <a:gd name="T87" fmla="*/ 501 h 2089"/>
              <a:gd name="T88" fmla="*/ 1458 w 2183"/>
              <a:gd name="T89" fmla="*/ 554 h 2089"/>
              <a:gd name="T90" fmla="*/ 1542 w 2183"/>
              <a:gd name="T91" fmla="*/ 406 h 2089"/>
              <a:gd name="T92" fmla="*/ 1608 w 2183"/>
              <a:gd name="T93" fmla="*/ 579 h 2089"/>
              <a:gd name="T94" fmla="*/ 1709 w 2183"/>
              <a:gd name="T95" fmla="*/ 561 h 2089"/>
              <a:gd name="T96" fmla="*/ 1956 w 2183"/>
              <a:gd name="T97" fmla="*/ 432 h 2089"/>
              <a:gd name="T98" fmla="*/ 1667 w 2183"/>
              <a:gd name="T99" fmla="*/ 342 h 2089"/>
              <a:gd name="T100" fmla="*/ 1664 w 2183"/>
              <a:gd name="T101" fmla="*/ 282 h 2089"/>
              <a:gd name="T102" fmla="*/ 1644 w 2183"/>
              <a:gd name="T103" fmla="*/ 193 h 2089"/>
              <a:gd name="T104" fmla="*/ 1771 w 2183"/>
              <a:gd name="T105" fmla="*/ 192 h 2089"/>
              <a:gd name="T106" fmla="*/ 1921 w 2183"/>
              <a:gd name="T107" fmla="*/ 405 h 2089"/>
              <a:gd name="T108" fmla="*/ 1952 w 2183"/>
              <a:gd name="T109" fmla="*/ 374 h 2089"/>
              <a:gd name="T110" fmla="*/ 2025 w 2183"/>
              <a:gd name="T111" fmla="*/ 263 h 2089"/>
              <a:gd name="T112" fmla="*/ 2155 w 2183"/>
              <a:gd name="T113" fmla="*/ 145 h 2089"/>
              <a:gd name="T114" fmla="*/ 2183 w 2183"/>
              <a:gd name="T115" fmla="*/ 174 h 2089"/>
              <a:gd name="T116" fmla="*/ 1966 w 2183"/>
              <a:gd name="T117" fmla="*/ 298 h 2089"/>
              <a:gd name="T118" fmla="*/ 1993 w 2183"/>
              <a:gd name="T119" fmla="*/ 2 h 2089"/>
              <a:gd name="T120" fmla="*/ 1903 w 2183"/>
              <a:gd name="T121" fmla="*/ 104 h 20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2183" h="2089">
                <a:moveTo>
                  <a:pt x="204" y="1666"/>
                </a:moveTo>
                <a:cubicBezTo>
                  <a:pt x="207" y="1669"/>
                  <a:pt x="209" y="1671"/>
                  <a:pt x="211" y="1674"/>
                </a:cubicBezTo>
                <a:cubicBezTo>
                  <a:pt x="213" y="1676"/>
                  <a:pt x="214" y="1679"/>
                  <a:pt x="215" y="1681"/>
                </a:cubicBezTo>
                <a:cubicBezTo>
                  <a:pt x="216" y="1683"/>
                  <a:pt x="216" y="1685"/>
                  <a:pt x="216" y="1686"/>
                </a:cubicBezTo>
                <a:cubicBezTo>
                  <a:pt x="216" y="1688"/>
                  <a:pt x="215" y="1689"/>
                  <a:pt x="214" y="1690"/>
                </a:cubicBezTo>
                <a:cubicBezTo>
                  <a:pt x="212" y="1692"/>
                  <a:pt x="208" y="1693"/>
                  <a:pt x="200" y="1695"/>
                </a:cubicBezTo>
                <a:cubicBezTo>
                  <a:pt x="193" y="1696"/>
                  <a:pt x="184" y="1699"/>
                  <a:pt x="174" y="1702"/>
                </a:cubicBezTo>
                <a:cubicBezTo>
                  <a:pt x="163" y="1706"/>
                  <a:pt x="151" y="1711"/>
                  <a:pt x="138" y="1719"/>
                </a:cubicBezTo>
                <a:cubicBezTo>
                  <a:pt x="125" y="1726"/>
                  <a:pt x="112" y="1736"/>
                  <a:pt x="98" y="1750"/>
                </a:cubicBezTo>
                <a:cubicBezTo>
                  <a:pt x="82" y="1766"/>
                  <a:pt x="70" y="1784"/>
                  <a:pt x="63" y="1803"/>
                </a:cubicBezTo>
                <a:cubicBezTo>
                  <a:pt x="56" y="1822"/>
                  <a:pt x="53" y="1841"/>
                  <a:pt x="55" y="1861"/>
                </a:cubicBezTo>
                <a:cubicBezTo>
                  <a:pt x="56" y="1880"/>
                  <a:pt x="62" y="1900"/>
                  <a:pt x="72" y="1919"/>
                </a:cubicBezTo>
                <a:cubicBezTo>
                  <a:pt x="81" y="1938"/>
                  <a:pt x="95" y="1956"/>
                  <a:pt x="112" y="1973"/>
                </a:cubicBezTo>
                <a:cubicBezTo>
                  <a:pt x="131" y="1992"/>
                  <a:pt x="150" y="2006"/>
                  <a:pt x="170" y="2016"/>
                </a:cubicBezTo>
                <a:cubicBezTo>
                  <a:pt x="190" y="2025"/>
                  <a:pt x="210" y="2030"/>
                  <a:pt x="229" y="2031"/>
                </a:cubicBezTo>
                <a:cubicBezTo>
                  <a:pt x="248" y="2032"/>
                  <a:pt x="267" y="2028"/>
                  <a:pt x="285" y="2021"/>
                </a:cubicBezTo>
                <a:cubicBezTo>
                  <a:pt x="303" y="2013"/>
                  <a:pt x="320" y="2001"/>
                  <a:pt x="336" y="1986"/>
                </a:cubicBezTo>
                <a:cubicBezTo>
                  <a:pt x="345" y="1977"/>
                  <a:pt x="353" y="1966"/>
                  <a:pt x="360" y="1955"/>
                </a:cubicBezTo>
                <a:cubicBezTo>
                  <a:pt x="367" y="1943"/>
                  <a:pt x="373" y="1931"/>
                  <a:pt x="376" y="1919"/>
                </a:cubicBezTo>
                <a:lnTo>
                  <a:pt x="290" y="1832"/>
                </a:lnTo>
                <a:lnTo>
                  <a:pt x="221" y="1901"/>
                </a:lnTo>
                <a:cubicBezTo>
                  <a:pt x="219" y="1903"/>
                  <a:pt x="215" y="1904"/>
                  <a:pt x="211" y="1903"/>
                </a:cubicBezTo>
                <a:cubicBezTo>
                  <a:pt x="208" y="1902"/>
                  <a:pt x="203" y="1898"/>
                  <a:pt x="197" y="1893"/>
                </a:cubicBezTo>
                <a:cubicBezTo>
                  <a:pt x="194" y="1890"/>
                  <a:pt x="192" y="1887"/>
                  <a:pt x="190" y="1885"/>
                </a:cubicBezTo>
                <a:cubicBezTo>
                  <a:pt x="189" y="1882"/>
                  <a:pt x="187" y="1880"/>
                  <a:pt x="187" y="1878"/>
                </a:cubicBezTo>
                <a:cubicBezTo>
                  <a:pt x="186" y="1876"/>
                  <a:pt x="186" y="1874"/>
                  <a:pt x="186" y="1873"/>
                </a:cubicBezTo>
                <a:cubicBezTo>
                  <a:pt x="187" y="1871"/>
                  <a:pt x="187" y="1870"/>
                  <a:pt x="189" y="1869"/>
                </a:cubicBezTo>
                <a:lnTo>
                  <a:pt x="283" y="1774"/>
                </a:lnTo>
                <a:cubicBezTo>
                  <a:pt x="285" y="1773"/>
                  <a:pt x="287" y="1771"/>
                  <a:pt x="289" y="1770"/>
                </a:cubicBezTo>
                <a:cubicBezTo>
                  <a:pt x="291" y="1769"/>
                  <a:pt x="294" y="1769"/>
                  <a:pt x="296" y="1768"/>
                </a:cubicBezTo>
                <a:cubicBezTo>
                  <a:pt x="299" y="1768"/>
                  <a:pt x="302" y="1769"/>
                  <a:pt x="305" y="1770"/>
                </a:cubicBezTo>
                <a:cubicBezTo>
                  <a:pt x="308" y="1772"/>
                  <a:pt x="310" y="1774"/>
                  <a:pt x="313" y="1776"/>
                </a:cubicBezTo>
                <a:lnTo>
                  <a:pt x="426" y="1889"/>
                </a:lnTo>
                <a:cubicBezTo>
                  <a:pt x="430" y="1893"/>
                  <a:pt x="433" y="1898"/>
                  <a:pt x="434" y="1902"/>
                </a:cubicBezTo>
                <a:cubicBezTo>
                  <a:pt x="436" y="1906"/>
                  <a:pt x="436" y="1912"/>
                  <a:pt x="433" y="1918"/>
                </a:cubicBezTo>
                <a:cubicBezTo>
                  <a:pt x="431" y="1925"/>
                  <a:pt x="428" y="1933"/>
                  <a:pt x="423" y="1943"/>
                </a:cubicBezTo>
                <a:cubicBezTo>
                  <a:pt x="419" y="1952"/>
                  <a:pt x="414" y="1962"/>
                  <a:pt x="408" y="1971"/>
                </a:cubicBezTo>
                <a:cubicBezTo>
                  <a:pt x="403" y="1980"/>
                  <a:pt x="396" y="1989"/>
                  <a:pt x="390" y="1998"/>
                </a:cubicBezTo>
                <a:cubicBezTo>
                  <a:pt x="383" y="2006"/>
                  <a:pt x="376" y="2014"/>
                  <a:pt x="368" y="2022"/>
                </a:cubicBezTo>
                <a:cubicBezTo>
                  <a:pt x="345" y="2045"/>
                  <a:pt x="321" y="2062"/>
                  <a:pt x="296" y="2073"/>
                </a:cubicBezTo>
                <a:cubicBezTo>
                  <a:pt x="271" y="2084"/>
                  <a:pt x="246" y="2089"/>
                  <a:pt x="220" y="2088"/>
                </a:cubicBezTo>
                <a:cubicBezTo>
                  <a:pt x="195" y="2087"/>
                  <a:pt x="169" y="2081"/>
                  <a:pt x="144" y="2069"/>
                </a:cubicBezTo>
                <a:cubicBezTo>
                  <a:pt x="119" y="2058"/>
                  <a:pt x="96" y="2040"/>
                  <a:pt x="73" y="2018"/>
                </a:cubicBezTo>
                <a:cubicBezTo>
                  <a:pt x="50" y="1994"/>
                  <a:pt x="32" y="1969"/>
                  <a:pt x="20" y="1943"/>
                </a:cubicBezTo>
                <a:cubicBezTo>
                  <a:pt x="8" y="1917"/>
                  <a:pt x="2" y="1891"/>
                  <a:pt x="1" y="1864"/>
                </a:cubicBezTo>
                <a:cubicBezTo>
                  <a:pt x="0" y="1838"/>
                  <a:pt x="6" y="1812"/>
                  <a:pt x="16" y="1786"/>
                </a:cubicBezTo>
                <a:cubicBezTo>
                  <a:pt x="27" y="1761"/>
                  <a:pt x="43" y="1737"/>
                  <a:pt x="65" y="1715"/>
                </a:cubicBezTo>
                <a:cubicBezTo>
                  <a:pt x="77" y="1704"/>
                  <a:pt x="88" y="1694"/>
                  <a:pt x="100" y="1686"/>
                </a:cubicBezTo>
                <a:cubicBezTo>
                  <a:pt x="112" y="1678"/>
                  <a:pt x="123" y="1672"/>
                  <a:pt x="134" y="1667"/>
                </a:cubicBezTo>
                <a:cubicBezTo>
                  <a:pt x="144" y="1662"/>
                  <a:pt x="153" y="1658"/>
                  <a:pt x="162" y="1656"/>
                </a:cubicBezTo>
                <a:cubicBezTo>
                  <a:pt x="170" y="1654"/>
                  <a:pt x="176" y="1653"/>
                  <a:pt x="180" y="1653"/>
                </a:cubicBezTo>
                <a:cubicBezTo>
                  <a:pt x="184" y="1653"/>
                  <a:pt x="188" y="1654"/>
                  <a:pt x="191" y="1656"/>
                </a:cubicBezTo>
                <a:cubicBezTo>
                  <a:pt x="195" y="1657"/>
                  <a:pt x="199" y="1661"/>
                  <a:pt x="204" y="1666"/>
                </a:cubicBezTo>
                <a:close/>
                <a:moveTo>
                  <a:pt x="565" y="1806"/>
                </a:moveTo>
                <a:cubicBezTo>
                  <a:pt x="566" y="1807"/>
                  <a:pt x="567" y="1808"/>
                  <a:pt x="567" y="1810"/>
                </a:cubicBezTo>
                <a:cubicBezTo>
                  <a:pt x="567" y="1811"/>
                  <a:pt x="567" y="1813"/>
                  <a:pt x="566" y="1815"/>
                </a:cubicBezTo>
                <a:cubicBezTo>
                  <a:pt x="565" y="1817"/>
                  <a:pt x="564" y="1819"/>
                  <a:pt x="562" y="1822"/>
                </a:cubicBezTo>
                <a:cubicBezTo>
                  <a:pt x="560" y="1825"/>
                  <a:pt x="557" y="1828"/>
                  <a:pt x="553" y="1832"/>
                </a:cubicBezTo>
                <a:cubicBezTo>
                  <a:pt x="549" y="1836"/>
                  <a:pt x="546" y="1838"/>
                  <a:pt x="543" y="1841"/>
                </a:cubicBezTo>
                <a:cubicBezTo>
                  <a:pt x="540" y="1843"/>
                  <a:pt x="538" y="1844"/>
                  <a:pt x="536" y="1845"/>
                </a:cubicBezTo>
                <a:cubicBezTo>
                  <a:pt x="534" y="1846"/>
                  <a:pt x="532" y="1846"/>
                  <a:pt x="531" y="1846"/>
                </a:cubicBezTo>
                <a:cubicBezTo>
                  <a:pt x="529" y="1846"/>
                  <a:pt x="528" y="1845"/>
                  <a:pt x="527" y="1844"/>
                </a:cubicBezTo>
                <a:lnTo>
                  <a:pt x="221" y="1537"/>
                </a:lnTo>
                <a:cubicBezTo>
                  <a:pt x="219" y="1536"/>
                  <a:pt x="219" y="1535"/>
                  <a:pt x="218" y="1533"/>
                </a:cubicBezTo>
                <a:cubicBezTo>
                  <a:pt x="218" y="1532"/>
                  <a:pt x="218" y="1530"/>
                  <a:pt x="219" y="1528"/>
                </a:cubicBezTo>
                <a:cubicBezTo>
                  <a:pt x="220" y="1526"/>
                  <a:pt x="221" y="1524"/>
                  <a:pt x="223" y="1521"/>
                </a:cubicBezTo>
                <a:cubicBezTo>
                  <a:pt x="226" y="1518"/>
                  <a:pt x="228" y="1515"/>
                  <a:pt x="232" y="1511"/>
                </a:cubicBezTo>
                <a:cubicBezTo>
                  <a:pt x="236" y="1507"/>
                  <a:pt x="239" y="1504"/>
                  <a:pt x="242" y="1502"/>
                </a:cubicBezTo>
                <a:cubicBezTo>
                  <a:pt x="245" y="1500"/>
                  <a:pt x="247" y="1499"/>
                  <a:pt x="249" y="1498"/>
                </a:cubicBezTo>
                <a:cubicBezTo>
                  <a:pt x="251" y="1497"/>
                  <a:pt x="253" y="1497"/>
                  <a:pt x="254" y="1497"/>
                </a:cubicBezTo>
                <a:cubicBezTo>
                  <a:pt x="256" y="1498"/>
                  <a:pt x="257" y="1498"/>
                  <a:pt x="259" y="1500"/>
                </a:cubicBezTo>
                <a:lnTo>
                  <a:pt x="565" y="1806"/>
                </a:lnTo>
                <a:close/>
                <a:moveTo>
                  <a:pt x="811" y="1559"/>
                </a:moveTo>
                <a:cubicBezTo>
                  <a:pt x="812" y="1561"/>
                  <a:pt x="813" y="1562"/>
                  <a:pt x="813" y="1563"/>
                </a:cubicBezTo>
                <a:cubicBezTo>
                  <a:pt x="814" y="1565"/>
                  <a:pt x="814" y="1566"/>
                  <a:pt x="813" y="1568"/>
                </a:cubicBezTo>
                <a:cubicBezTo>
                  <a:pt x="812" y="1570"/>
                  <a:pt x="811" y="1573"/>
                  <a:pt x="809" y="1575"/>
                </a:cubicBezTo>
                <a:cubicBezTo>
                  <a:pt x="807" y="1578"/>
                  <a:pt x="804" y="1580"/>
                  <a:pt x="801" y="1584"/>
                </a:cubicBezTo>
                <a:cubicBezTo>
                  <a:pt x="798" y="1587"/>
                  <a:pt x="795" y="1590"/>
                  <a:pt x="792" y="1592"/>
                </a:cubicBezTo>
                <a:cubicBezTo>
                  <a:pt x="790" y="1594"/>
                  <a:pt x="787" y="1595"/>
                  <a:pt x="785" y="1596"/>
                </a:cubicBezTo>
                <a:cubicBezTo>
                  <a:pt x="784" y="1596"/>
                  <a:pt x="782" y="1597"/>
                  <a:pt x="781" y="1596"/>
                </a:cubicBezTo>
                <a:cubicBezTo>
                  <a:pt x="779" y="1596"/>
                  <a:pt x="778" y="1595"/>
                  <a:pt x="777" y="1594"/>
                </a:cubicBezTo>
                <a:lnTo>
                  <a:pt x="750" y="1566"/>
                </a:lnTo>
                <a:cubicBezTo>
                  <a:pt x="751" y="1591"/>
                  <a:pt x="749" y="1612"/>
                  <a:pt x="743" y="1630"/>
                </a:cubicBezTo>
                <a:cubicBezTo>
                  <a:pt x="738" y="1647"/>
                  <a:pt x="729" y="1662"/>
                  <a:pt x="717" y="1674"/>
                </a:cubicBezTo>
                <a:cubicBezTo>
                  <a:pt x="703" y="1687"/>
                  <a:pt x="690" y="1697"/>
                  <a:pt x="676" y="1701"/>
                </a:cubicBezTo>
                <a:cubicBezTo>
                  <a:pt x="662" y="1706"/>
                  <a:pt x="648" y="1708"/>
                  <a:pt x="634" y="1706"/>
                </a:cubicBezTo>
                <a:cubicBezTo>
                  <a:pt x="620" y="1703"/>
                  <a:pt x="607" y="1698"/>
                  <a:pt x="594" y="1691"/>
                </a:cubicBezTo>
                <a:cubicBezTo>
                  <a:pt x="581" y="1683"/>
                  <a:pt x="567" y="1671"/>
                  <a:pt x="552" y="1656"/>
                </a:cubicBezTo>
                <a:lnTo>
                  <a:pt x="427" y="1531"/>
                </a:lnTo>
                <a:cubicBezTo>
                  <a:pt x="426" y="1530"/>
                  <a:pt x="425" y="1528"/>
                  <a:pt x="425" y="1527"/>
                </a:cubicBezTo>
                <a:cubicBezTo>
                  <a:pt x="424" y="1526"/>
                  <a:pt x="425" y="1524"/>
                  <a:pt x="425" y="1522"/>
                </a:cubicBezTo>
                <a:cubicBezTo>
                  <a:pt x="426" y="1519"/>
                  <a:pt x="428" y="1517"/>
                  <a:pt x="430" y="1514"/>
                </a:cubicBezTo>
                <a:cubicBezTo>
                  <a:pt x="432" y="1512"/>
                  <a:pt x="435" y="1508"/>
                  <a:pt x="439" y="1505"/>
                </a:cubicBezTo>
                <a:cubicBezTo>
                  <a:pt x="443" y="1501"/>
                  <a:pt x="446" y="1498"/>
                  <a:pt x="448" y="1496"/>
                </a:cubicBezTo>
                <a:cubicBezTo>
                  <a:pt x="451" y="1494"/>
                  <a:pt x="453" y="1492"/>
                  <a:pt x="456" y="1492"/>
                </a:cubicBezTo>
                <a:cubicBezTo>
                  <a:pt x="458" y="1491"/>
                  <a:pt x="460" y="1490"/>
                  <a:pt x="461" y="1491"/>
                </a:cubicBezTo>
                <a:cubicBezTo>
                  <a:pt x="462" y="1491"/>
                  <a:pt x="464" y="1492"/>
                  <a:pt x="465" y="1493"/>
                </a:cubicBezTo>
                <a:lnTo>
                  <a:pt x="585" y="1613"/>
                </a:lnTo>
                <a:cubicBezTo>
                  <a:pt x="597" y="1625"/>
                  <a:pt x="608" y="1634"/>
                  <a:pt x="617" y="1639"/>
                </a:cubicBezTo>
                <a:cubicBezTo>
                  <a:pt x="626" y="1645"/>
                  <a:pt x="635" y="1648"/>
                  <a:pt x="643" y="1650"/>
                </a:cubicBezTo>
                <a:cubicBezTo>
                  <a:pt x="652" y="1651"/>
                  <a:pt x="661" y="1651"/>
                  <a:pt x="669" y="1648"/>
                </a:cubicBezTo>
                <a:cubicBezTo>
                  <a:pt x="677" y="1646"/>
                  <a:pt x="685" y="1641"/>
                  <a:pt x="692" y="1633"/>
                </a:cubicBezTo>
                <a:cubicBezTo>
                  <a:pt x="702" y="1624"/>
                  <a:pt x="708" y="1611"/>
                  <a:pt x="711" y="1595"/>
                </a:cubicBezTo>
                <a:cubicBezTo>
                  <a:pt x="713" y="1579"/>
                  <a:pt x="713" y="1559"/>
                  <a:pt x="711" y="1535"/>
                </a:cubicBezTo>
                <a:lnTo>
                  <a:pt x="567" y="1391"/>
                </a:lnTo>
                <a:cubicBezTo>
                  <a:pt x="566" y="1390"/>
                  <a:pt x="565" y="1389"/>
                  <a:pt x="565" y="1387"/>
                </a:cubicBezTo>
                <a:cubicBezTo>
                  <a:pt x="564" y="1386"/>
                  <a:pt x="564" y="1384"/>
                  <a:pt x="565" y="1382"/>
                </a:cubicBezTo>
                <a:cubicBezTo>
                  <a:pt x="566" y="1380"/>
                  <a:pt x="568" y="1377"/>
                  <a:pt x="570" y="1375"/>
                </a:cubicBezTo>
                <a:cubicBezTo>
                  <a:pt x="572" y="1372"/>
                  <a:pt x="575" y="1369"/>
                  <a:pt x="579" y="1365"/>
                </a:cubicBezTo>
                <a:cubicBezTo>
                  <a:pt x="582" y="1361"/>
                  <a:pt x="586" y="1358"/>
                  <a:pt x="588" y="1356"/>
                </a:cubicBezTo>
                <a:cubicBezTo>
                  <a:pt x="591" y="1354"/>
                  <a:pt x="593" y="1352"/>
                  <a:pt x="595" y="1352"/>
                </a:cubicBezTo>
                <a:cubicBezTo>
                  <a:pt x="597" y="1351"/>
                  <a:pt x="599" y="1351"/>
                  <a:pt x="601" y="1351"/>
                </a:cubicBezTo>
                <a:cubicBezTo>
                  <a:pt x="602" y="1351"/>
                  <a:pt x="604" y="1352"/>
                  <a:pt x="605" y="1353"/>
                </a:cubicBezTo>
                <a:lnTo>
                  <a:pt x="811" y="1559"/>
                </a:lnTo>
                <a:close/>
                <a:moveTo>
                  <a:pt x="976" y="1365"/>
                </a:moveTo>
                <a:cubicBezTo>
                  <a:pt x="980" y="1369"/>
                  <a:pt x="983" y="1373"/>
                  <a:pt x="985" y="1376"/>
                </a:cubicBezTo>
                <a:cubicBezTo>
                  <a:pt x="987" y="1379"/>
                  <a:pt x="988" y="1382"/>
                  <a:pt x="988" y="1385"/>
                </a:cubicBezTo>
                <a:cubicBezTo>
                  <a:pt x="988" y="1387"/>
                  <a:pt x="987" y="1390"/>
                  <a:pt x="986" y="1394"/>
                </a:cubicBezTo>
                <a:cubicBezTo>
                  <a:pt x="985" y="1397"/>
                  <a:pt x="983" y="1401"/>
                  <a:pt x="980" y="1405"/>
                </a:cubicBezTo>
                <a:cubicBezTo>
                  <a:pt x="978" y="1409"/>
                  <a:pt x="975" y="1412"/>
                  <a:pt x="972" y="1416"/>
                </a:cubicBezTo>
                <a:cubicBezTo>
                  <a:pt x="969" y="1420"/>
                  <a:pt x="966" y="1424"/>
                  <a:pt x="962" y="1428"/>
                </a:cubicBezTo>
                <a:cubicBezTo>
                  <a:pt x="952" y="1438"/>
                  <a:pt x="941" y="1446"/>
                  <a:pt x="930" y="1451"/>
                </a:cubicBezTo>
                <a:cubicBezTo>
                  <a:pt x="920" y="1456"/>
                  <a:pt x="909" y="1458"/>
                  <a:pt x="899" y="1457"/>
                </a:cubicBezTo>
                <a:cubicBezTo>
                  <a:pt x="888" y="1456"/>
                  <a:pt x="877" y="1452"/>
                  <a:pt x="866" y="1446"/>
                </a:cubicBezTo>
                <a:cubicBezTo>
                  <a:pt x="855" y="1439"/>
                  <a:pt x="844" y="1430"/>
                  <a:pt x="832" y="1418"/>
                </a:cubicBezTo>
                <a:lnTo>
                  <a:pt x="711" y="1297"/>
                </a:lnTo>
                <a:lnTo>
                  <a:pt x="683" y="1326"/>
                </a:lnTo>
                <a:cubicBezTo>
                  <a:pt x="680" y="1329"/>
                  <a:pt x="677" y="1329"/>
                  <a:pt x="673" y="1328"/>
                </a:cubicBezTo>
                <a:cubicBezTo>
                  <a:pt x="670" y="1327"/>
                  <a:pt x="665" y="1324"/>
                  <a:pt x="659" y="1318"/>
                </a:cubicBezTo>
                <a:cubicBezTo>
                  <a:pt x="656" y="1315"/>
                  <a:pt x="654" y="1313"/>
                  <a:pt x="653" y="1310"/>
                </a:cubicBezTo>
                <a:cubicBezTo>
                  <a:pt x="651" y="1308"/>
                  <a:pt x="650" y="1306"/>
                  <a:pt x="649" y="1304"/>
                </a:cubicBezTo>
                <a:cubicBezTo>
                  <a:pt x="648" y="1302"/>
                  <a:pt x="648" y="1300"/>
                  <a:pt x="649" y="1299"/>
                </a:cubicBezTo>
                <a:cubicBezTo>
                  <a:pt x="649" y="1297"/>
                  <a:pt x="650" y="1296"/>
                  <a:pt x="651" y="1295"/>
                </a:cubicBezTo>
                <a:lnTo>
                  <a:pt x="680" y="1266"/>
                </a:lnTo>
                <a:lnTo>
                  <a:pt x="631" y="1217"/>
                </a:lnTo>
                <a:cubicBezTo>
                  <a:pt x="630" y="1216"/>
                  <a:pt x="629" y="1215"/>
                  <a:pt x="629" y="1213"/>
                </a:cubicBezTo>
                <a:cubicBezTo>
                  <a:pt x="628" y="1212"/>
                  <a:pt x="629" y="1210"/>
                  <a:pt x="629" y="1208"/>
                </a:cubicBezTo>
                <a:cubicBezTo>
                  <a:pt x="630" y="1206"/>
                  <a:pt x="632" y="1203"/>
                  <a:pt x="634" y="1200"/>
                </a:cubicBezTo>
                <a:cubicBezTo>
                  <a:pt x="636" y="1198"/>
                  <a:pt x="639" y="1194"/>
                  <a:pt x="642" y="1191"/>
                </a:cubicBezTo>
                <a:cubicBezTo>
                  <a:pt x="646" y="1187"/>
                  <a:pt x="650" y="1184"/>
                  <a:pt x="652" y="1182"/>
                </a:cubicBezTo>
                <a:cubicBezTo>
                  <a:pt x="655" y="1180"/>
                  <a:pt x="657" y="1178"/>
                  <a:pt x="659" y="1178"/>
                </a:cubicBezTo>
                <a:cubicBezTo>
                  <a:pt x="662" y="1177"/>
                  <a:pt x="663" y="1177"/>
                  <a:pt x="665" y="1177"/>
                </a:cubicBezTo>
                <a:cubicBezTo>
                  <a:pt x="666" y="1177"/>
                  <a:pt x="668" y="1178"/>
                  <a:pt x="669" y="1179"/>
                </a:cubicBezTo>
                <a:lnTo>
                  <a:pt x="718" y="1228"/>
                </a:lnTo>
                <a:lnTo>
                  <a:pt x="771" y="1175"/>
                </a:lnTo>
                <a:cubicBezTo>
                  <a:pt x="772" y="1174"/>
                  <a:pt x="773" y="1173"/>
                  <a:pt x="775" y="1173"/>
                </a:cubicBezTo>
                <a:cubicBezTo>
                  <a:pt x="776" y="1172"/>
                  <a:pt x="778" y="1173"/>
                  <a:pt x="780" y="1173"/>
                </a:cubicBezTo>
                <a:cubicBezTo>
                  <a:pt x="782" y="1174"/>
                  <a:pt x="784" y="1175"/>
                  <a:pt x="786" y="1177"/>
                </a:cubicBezTo>
                <a:cubicBezTo>
                  <a:pt x="789" y="1178"/>
                  <a:pt x="791" y="1181"/>
                  <a:pt x="794" y="1183"/>
                </a:cubicBezTo>
                <a:cubicBezTo>
                  <a:pt x="800" y="1189"/>
                  <a:pt x="803" y="1194"/>
                  <a:pt x="804" y="1197"/>
                </a:cubicBezTo>
                <a:cubicBezTo>
                  <a:pt x="805" y="1201"/>
                  <a:pt x="804" y="1204"/>
                  <a:pt x="802" y="1207"/>
                </a:cubicBezTo>
                <a:lnTo>
                  <a:pt x="749" y="1260"/>
                </a:lnTo>
                <a:lnTo>
                  <a:pt x="864" y="1375"/>
                </a:lnTo>
                <a:cubicBezTo>
                  <a:pt x="879" y="1389"/>
                  <a:pt x="891" y="1398"/>
                  <a:pt x="903" y="1401"/>
                </a:cubicBezTo>
                <a:cubicBezTo>
                  <a:pt x="914" y="1404"/>
                  <a:pt x="925" y="1400"/>
                  <a:pt x="936" y="1389"/>
                </a:cubicBezTo>
                <a:cubicBezTo>
                  <a:pt x="940" y="1385"/>
                  <a:pt x="943" y="1382"/>
                  <a:pt x="945" y="1378"/>
                </a:cubicBezTo>
                <a:cubicBezTo>
                  <a:pt x="947" y="1375"/>
                  <a:pt x="948" y="1372"/>
                  <a:pt x="950" y="1369"/>
                </a:cubicBezTo>
                <a:cubicBezTo>
                  <a:pt x="951" y="1366"/>
                  <a:pt x="952" y="1363"/>
                  <a:pt x="953" y="1361"/>
                </a:cubicBezTo>
                <a:cubicBezTo>
                  <a:pt x="954" y="1359"/>
                  <a:pt x="955" y="1357"/>
                  <a:pt x="956" y="1356"/>
                </a:cubicBezTo>
                <a:cubicBezTo>
                  <a:pt x="957" y="1355"/>
                  <a:pt x="958" y="1355"/>
                  <a:pt x="959" y="1354"/>
                </a:cubicBezTo>
                <a:cubicBezTo>
                  <a:pt x="960" y="1354"/>
                  <a:pt x="961" y="1354"/>
                  <a:pt x="963" y="1355"/>
                </a:cubicBezTo>
                <a:cubicBezTo>
                  <a:pt x="964" y="1356"/>
                  <a:pt x="966" y="1357"/>
                  <a:pt x="968" y="1358"/>
                </a:cubicBezTo>
                <a:cubicBezTo>
                  <a:pt x="970" y="1360"/>
                  <a:pt x="973" y="1362"/>
                  <a:pt x="976" y="1365"/>
                </a:cubicBezTo>
                <a:close/>
                <a:moveTo>
                  <a:pt x="1192" y="1179"/>
                </a:moveTo>
                <a:cubicBezTo>
                  <a:pt x="1194" y="1181"/>
                  <a:pt x="1194" y="1183"/>
                  <a:pt x="1194" y="1185"/>
                </a:cubicBezTo>
                <a:cubicBezTo>
                  <a:pt x="1194" y="1187"/>
                  <a:pt x="1193" y="1190"/>
                  <a:pt x="1191" y="1192"/>
                </a:cubicBezTo>
                <a:cubicBezTo>
                  <a:pt x="1189" y="1195"/>
                  <a:pt x="1186" y="1198"/>
                  <a:pt x="1182" y="1202"/>
                </a:cubicBezTo>
                <a:cubicBezTo>
                  <a:pt x="1178" y="1206"/>
                  <a:pt x="1175" y="1209"/>
                  <a:pt x="1172" y="1211"/>
                </a:cubicBezTo>
                <a:cubicBezTo>
                  <a:pt x="1169" y="1213"/>
                  <a:pt x="1167" y="1214"/>
                  <a:pt x="1165" y="1214"/>
                </a:cubicBezTo>
                <a:cubicBezTo>
                  <a:pt x="1163" y="1215"/>
                  <a:pt x="1161" y="1214"/>
                  <a:pt x="1159" y="1212"/>
                </a:cubicBezTo>
                <a:lnTo>
                  <a:pt x="1139" y="1191"/>
                </a:lnTo>
                <a:cubicBezTo>
                  <a:pt x="1139" y="1210"/>
                  <a:pt x="1137" y="1227"/>
                  <a:pt x="1131" y="1244"/>
                </a:cubicBezTo>
                <a:cubicBezTo>
                  <a:pt x="1125" y="1260"/>
                  <a:pt x="1116" y="1275"/>
                  <a:pt x="1104" y="1287"/>
                </a:cubicBezTo>
                <a:cubicBezTo>
                  <a:pt x="1093" y="1298"/>
                  <a:pt x="1082" y="1306"/>
                  <a:pt x="1070" y="1312"/>
                </a:cubicBezTo>
                <a:cubicBezTo>
                  <a:pt x="1058" y="1318"/>
                  <a:pt x="1047" y="1322"/>
                  <a:pt x="1035" y="1322"/>
                </a:cubicBezTo>
                <a:cubicBezTo>
                  <a:pt x="1024" y="1323"/>
                  <a:pt x="1012" y="1322"/>
                  <a:pt x="1001" y="1317"/>
                </a:cubicBezTo>
                <a:cubicBezTo>
                  <a:pt x="990" y="1313"/>
                  <a:pt x="979" y="1306"/>
                  <a:pt x="969" y="1296"/>
                </a:cubicBezTo>
                <a:cubicBezTo>
                  <a:pt x="958" y="1284"/>
                  <a:pt x="950" y="1272"/>
                  <a:pt x="946" y="1258"/>
                </a:cubicBezTo>
                <a:cubicBezTo>
                  <a:pt x="942" y="1245"/>
                  <a:pt x="942" y="1231"/>
                  <a:pt x="945" y="1217"/>
                </a:cubicBezTo>
                <a:cubicBezTo>
                  <a:pt x="949" y="1202"/>
                  <a:pt x="955" y="1187"/>
                  <a:pt x="965" y="1171"/>
                </a:cubicBezTo>
                <a:cubicBezTo>
                  <a:pt x="975" y="1156"/>
                  <a:pt x="988" y="1140"/>
                  <a:pt x="1004" y="1124"/>
                </a:cubicBezTo>
                <a:lnTo>
                  <a:pt x="1033" y="1095"/>
                </a:lnTo>
                <a:lnTo>
                  <a:pt x="1017" y="1079"/>
                </a:lnTo>
                <a:cubicBezTo>
                  <a:pt x="1009" y="1071"/>
                  <a:pt x="1001" y="1065"/>
                  <a:pt x="993" y="1061"/>
                </a:cubicBezTo>
                <a:cubicBezTo>
                  <a:pt x="985" y="1056"/>
                  <a:pt x="977" y="1054"/>
                  <a:pt x="970" y="1054"/>
                </a:cubicBezTo>
                <a:cubicBezTo>
                  <a:pt x="962" y="1053"/>
                  <a:pt x="954" y="1055"/>
                  <a:pt x="946" y="1059"/>
                </a:cubicBezTo>
                <a:cubicBezTo>
                  <a:pt x="938" y="1063"/>
                  <a:pt x="929" y="1069"/>
                  <a:pt x="921" y="1078"/>
                </a:cubicBezTo>
                <a:cubicBezTo>
                  <a:pt x="911" y="1087"/>
                  <a:pt x="904" y="1097"/>
                  <a:pt x="899" y="1106"/>
                </a:cubicBezTo>
                <a:cubicBezTo>
                  <a:pt x="894" y="1116"/>
                  <a:pt x="890" y="1125"/>
                  <a:pt x="887" y="1133"/>
                </a:cubicBezTo>
                <a:cubicBezTo>
                  <a:pt x="884" y="1141"/>
                  <a:pt x="882" y="1149"/>
                  <a:pt x="880" y="1155"/>
                </a:cubicBezTo>
                <a:cubicBezTo>
                  <a:pt x="879" y="1160"/>
                  <a:pt x="877" y="1164"/>
                  <a:pt x="875" y="1166"/>
                </a:cubicBezTo>
                <a:cubicBezTo>
                  <a:pt x="874" y="1167"/>
                  <a:pt x="873" y="1168"/>
                  <a:pt x="871" y="1169"/>
                </a:cubicBezTo>
                <a:cubicBezTo>
                  <a:pt x="869" y="1169"/>
                  <a:pt x="868" y="1169"/>
                  <a:pt x="866" y="1168"/>
                </a:cubicBezTo>
                <a:cubicBezTo>
                  <a:pt x="864" y="1168"/>
                  <a:pt x="862" y="1167"/>
                  <a:pt x="860" y="1165"/>
                </a:cubicBezTo>
                <a:cubicBezTo>
                  <a:pt x="857" y="1163"/>
                  <a:pt x="855" y="1161"/>
                  <a:pt x="853" y="1159"/>
                </a:cubicBezTo>
                <a:cubicBezTo>
                  <a:pt x="849" y="1155"/>
                  <a:pt x="846" y="1152"/>
                  <a:pt x="845" y="1149"/>
                </a:cubicBezTo>
                <a:cubicBezTo>
                  <a:pt x="843" y="1147"/>
                  <a:pt x="842" y="1143"/>
                  <a:pt x="842" y="1139"/>
                </a:cubicBezTo>
                <a:cubicBezTo>
                  <a:pt x="842" y="1135"/>
                  <a:pt x="844" y="1129"/>
                  <a:pt x="846" y="1121"/>
                </a:cubicBezTo>
                <a:cubicBezTo>
                  <a:pt x="848" y="1114"/>
                  <a:pt x="852" y="1105"/>
                  <a:pt x="856" y="1097"/>
                </a:cubicBezTo>
                <a:cubicBezTo>
                  <a:pt x="860" y="1088"/>
                  <a:pt x="866" y="1079"/>
                  <a:pt x="872" y="1070"/>
                </a:cubicBezTo>
                <a:cubicBezTo>
                  <a:pt x="878" y="1060"/>
                  <a:pt x="886" y="1052"/>
                  <a:pt x="893" y="1044"/>
                </a:cubicBezTo>
                <a:cubicBezTo>
                  <a:pt x="908" y="1029"/>
                  <a:pt x="923" y="1018"/>
                  <a:pt x="936" y="1011"/>
                </a:cubicBezTo>
                <a:cubicBezTo>
                  <a:pt x="950" y="1004"/>
                  <a:pt x="963" y="1001"/>
                  <a:pt x="976" y="1001"/>
                </a:cubicBezTo>
                <a:cubicBezTo>
                  <a:pt x="989" y="1001"/>
                  <a:pt x="1002" y="1004"/>
                  <a:pt x="1015" y="1011"/>
                </a:cubicBezTo>
                <a:cubicBezTo>
                  <a:pt x="1027" y="1018"/>
                  <a:pt x="1040" y="1027"/>
                  <a:pt x="1053" y="1040"/>
                </a:cubicBezTo>
                <a:lnTo>
                  <a:pt x="1192" y="1179"/>
                </a:lnTo>
                <a:close/>
                <a:moveTo>
                  <a:pt x="1060" y="1123"/>
                </a:moveTo>
                <a:lnTo>
                  <a:pt x="1028" y="1155"/>
                </a:lnTo>
                <a:cubicBezTo>
                  <a:pt x="1017" y="1165"/>
                  <a:pt x="1009" y="1175"/>
                  <a:pt x="1003" y="1185"/>
                </a:cubicBezTo>
                <a:cubicBezTo>
                  <a:pt x="997" y="1194"/>
                  <a:pt x="994" y="1203"/>
                  <a:pt x="992" y="1212"/>
                </a:cubicBezTo>
                <a:cubicBezTo>
                  <a:pt x="990" y="1220"/>
                  <a:pt x="991" y="1228"/>
                  <a:pt x="993" y="1235"/>
                </a:cubicBezTo>
                <a:cubicBezTo>
                  <a:pt x="996" y="1242"/>
                  <a:pt x="1000" y="1249"/>
                  <a:pt x="1006" y="1255"/>
                </a:cubicBezTo>
                <a:cubicBezTo>
                  <a:pt x="1017" y="1266"/>
                  <a:pt x="1029" y="1271"/>
                  <a:pt x="1042" y="1271"/>
                </a:cubicBezTo>
                <a:cubicBezTo>
                  <a:pt x="1055" y="1270"/>
                  <a:pt x="1068" y="1264"/>
                  <a:pt x="1080" y="1252"/>
                </a:cubicBezTo>
                <a:cubicBezTo>
                  <a:pt x="1090" y="1242"/>
                  <a:pt x="1097" y="1230"/>
                  <a:pt x="1100" y="1216"/>
                </a:cubicBezTo>
                <a:cubicBezTo>
                  <a:pt x="1104" y="1203"/>
                  <a:pt x="1105" y="1186"/>
                  <a:pt x="1104" y="1166"/>
                </a:cubicBezTo>
                <a:lnTo>
                  <a:pt x="1060" y="1123"/>
                </a:lnTo>
                <a:close/>
                <a:moveTo>
                  <a:pt x="1568" y="802"/>
                </a:moveTo>
                <a:cubicBezTo>
                  <a:pt x="1570" y="803"/>
                  <a:pt x="1570" y="805"/>
                  <a:pt x="1571" y="806"/>
                </a:cubicBezTo>
                <a:cubicBezTo>
                  <a:pt x="1571" y="808"/>
                  <a:pt x="1571" y="809"/>
                  <a:pt x="1570" y="811"/>
                </a:cubicBezTo>
                <a:cubicBezTo>
                  <a:pt x="1569" y="813"/>
                  <a:pt x="1568" y="816"/>
                  <a:pt x="1565" y="818"/>
                </a:cubicBezTo>
                <a:cubicBezTo>
                  <a:pt x="1563" y="821"/>
                  <a:pt x="1560" y="824"/>
                  <a:pt x="1557" y="828"/>
                </a:cubicBezTo>
                <a:cubicBezTo>
                  <a:pt x="1553" y="832"/>
                  <a:pt x="1550" y="835"/>
                  <a:pt x="1547" y="837"/>
                </a:cubicBezTo>
                <a:cubicBezTo>
                  <a:pt x="1544" y="839"/>
                  <a:pt x="1542" y="841"/>
                  <a:pt x="1540" y="841"/>
                </a:cubicBezTo>
                <a:cubicBezTo>
                  <a:pt x="1538" y="842"/>
                  <a:pt x="1536" y="843"/>
                  <a:pt x="1534" y="842"/>
                </a:cubicBezTo>
                <a:cubicBezTo>
                  <a:pt x="1533" y="842"/>
                  <a:pt x="1532" y="841"/>
                  <a:pt x="1530" y="840"/>
                </a:cubicBezTo>
                <a:lnTo>
                  <a:pt x="1405" y="715"/>
                </a:lnTo>
                <a:cubicBezTo>
                  <a:pt x="1396" y="706"/>
                  <a:pt x="1388" y="699"/>
                  <a:pt x="1379" y="693"/>
                </a:cubicBezTo>
                <a:cubicBezTo>
                  <a:pt x="1370" y="688"/>
                  <a:pt x="1361" y="684"/>
                  <a:pt x="1353" y="682"/>
                </a:cubicBezTo>
                <a:cubicBezTo>
                  <a:pt x="1344" y="680"/>
                  <a:pt x="1336" y="681"/>
                  <a:pt x="1328" y="683"/>
                </a:cubicBezTo>
                <a:cubicBezTo>
                  <a:pt x="1320" y="685"/>
                  <a:pt x="1313" y="690"/>
                  <a:pt x="1306" y="697"/>
                </a:cubicBezTo>
                <a:cubicBezTo>
                  <a:pt x="1297" y="706"/>
                  <a:pt x="1292" y="718"/>
                  <a:pt x="1290" y="734"/>
                </a:cubicBezTo>
                <a:cubicBezTo>
                  <a:pt x="1287" y="749"/>
                  <a:pt x="1288" y="769"/>
                  <a:pt x="1290" y="792"/>
                </a:cubicBezTo>
                <a:lnTo>
                  <a:pt x="1434" y="936"/>
                </a:lnTo>
                <a:cubicBezTo>
                  <a:pt x="1436" y="938"/>
                  <a:pt x="1436" y="939"/>
                  <a:pt x="1436" y="940"/>
                </a:cubicBezTo>
                <a:cubicBezTo>
                  <a:pt x="1437" y="942"/>
                  <a:pt x="1436" y="944"/>
                  <a:pt x="1436" y="946"/>
                </a:cubicBezTo>
                <a:cubicBezTo>
                  <a:pt x="1435" y="948"/>
                  <a:pt x="1433" y="950"/>
                  <a:pt x="1431" y="953"/>
                </a:cubicBezTo>
                <a:cubicBezTo>
                  <a:pt x="1429" y="956"/>
                  <a:pt x="1426" y="959"/>
                  <a:pt x="1422" y="962"/>
                </a:cubicBezTo>
                <a:cubicBezTo>
                  <a:pt x="1419" y="966"/>
                  <a:pt x="1416" y="969"/>
                  <a:pt x="1413" y="971"/>
                </a:cubicBezTo>
                <a:cubicBezTo>
                  <a:pt x="1410" y="973"/>
                  <a:pt x="1408" y="975"/>
                  <a:pt x="1406" y="976"/>
                </a:cubicBezTo>
                <a:cubicBezTo>
                  <a:pt x="1403" y="976"/>
                  <a:pt x="1402" y="977"/>
                  <a:pt x="1400" y="976"/>
                </a:cubicBezTo>
                <a:cubicBezTo>
                  <a:pt x="1399" y="976"/>
                  <a:pt x="1398" y="975"/>
                  <a:pt x="1396" y="974"/>
                </a:cubicBezTo>
                <a:lnTo>
                  <a:pt x="1271" y="849"/>
                </a:lnTo>
                <a:cubicBezTo>
                  <a:pt x="1262" y="840"/>
                  <a:pt x="1254" y="833"/>
                  <a:pt x="1245" y="827"/>
                </a:cubicBezTo>
                <a:cubicBezTo>
                  <a:pt x="1236" y="822"/>
                  <a:pt x="1227" y="818"/>
                  <a:pt x="1219" y="816"/>
                </a:cubicBezTo>
                <a:cubicBezTo>
                  <a:pt x="1210" y="815"/>
                  <a:pt x="1202" y="815"/>
                  <a:pt x="1194" y="817"/>
                </a:cubicBezTo>
                <a:cubicBezTo>
                  <a:pt x="1186" y="820"/>
                  <a:pt x="1179" y="824"/>
                  <a:pt x="1172" y="831"/>
                </a:cubicBezTo>
                <a:cubicBezTo>
                  <a:pt x="1163" y="840"/>
                  <a:pt x="1157" y="852"/>
                  <a:pt x="1155" y="868"/>
                </a:cubicBezTo>
                <a:cubicBezTo>
                  <a:pt x="1153" y="883"/>
                  <a:pt x="1153" y="903"/>
                  <a:pt x="1156" y="926"/>
                </a:cubicBezTo>
                <a:lnTo>
                  <a:pt x="1300" y="1070"/>
                </a:lnTo>
                <a:cubicBezTo>
                  <a:pt x="1301" y="1072"/>
                  <a:pt x="1302" y="1073"/>
                  <a:pt x="1302" y="1074"/>
                </a:cubicBezTo>
                <a:cubicBezTo>
                  <a:pt x="1303" y="1076"/>
                  <a:pt x="1302" y="1078"/>
                  <a:pt x="1302" y="1080"/>
                </a:cubicBezTo>
                <a:cubicBezTo>
                  <a:pt x="1301" y="1082"/>
                  <a:pt x="1299" y="1084"/>
                  <a:pt x="1297" y="1087"/>
                </a:cubicBezTo>
                <a:cubicBezTo>
                  <a:pt x="1295" y="1089"/>
                  <a:pt x="1292" y="1093"/>
                  <a:pt x="1288" y="1097"/>
                </a:cubicBezTo>
                <a:cubicBezTo>
                  <a:pt x="1285" y="1100"/>
                  <a:pt x="1281" y="1103"/>
                  <a:pt x="1279" y="1105"/>
                </a:cubicBezTo>
                <a:cubicBezTo>
                  <a:pt x="1276" y="1107"/>
                  <a:pt x="1273" y="1109"/>
                  <a:pt x="1271" y="1110"/>
                </a:cubicBezTo>
                <a:cubicBezTo>
                  <a:pt x="1269" y="1111"/>
                  <a:pt x="1268" y="1111"/>
                  <a:pt x="1266" y="1111"/>
                </a:cubicBezTo>
                <a:cubicBezTo>
                  <a:pt x="1265" y="1110"/>
                  <a:pt x="1264" y="1109"/>
                  <a:pt x="1262" y="1108"/>
                </a:cubicBezTo>
                <a:lnTo>
                  <a:pt x="1056" y="902"/>
                </a:lnTo>
                <a:cubicBezTo>
                  <a:pt x="1055" y="901"/>
                  <a:pt x="1054" y="899"/>
                  <a:pt x="1054" y="898"/>
                </a:cubicBezTo>
                <a:cubicBezTo>
                  <a:pt x="1053" y="897"/>
                  <a:pt x="1053" y="895"/>
                  <a:pt x="1054" y="893"/>
                </a:cubicBezTo>
                <a:cubicBezTo>
                  <a:pt x="1055" y="891"/>
                  <a:pt x="1056" y="889"/>
                  <a:pt x="1058" y="886"/>
                </a:cubicBezTo>
                <a:cubicBezTo>
                  <a:pt x="1060" y="884"/>
                  <a:pt x="1063" y="881"/>
                  <a:pt x="1066" y="878"/>
                </a:cubicBezTo>
                <a:cubicBezTo>
                  <a:pt x="1069" y="874"/>
                  <a:pt x="1072" y="872"/>
                  <a:pt x="1075" y="870"/>
                </a:cubicBezTo>
                <a:cubicBezTo>
                  <a:pt x="1077" y="868"/>
                  <a:pt x="1079" y="866"/>
                  <a:pt x="1081" y="866"/>
                </a:cubicBezTo>
                <a:cubicBezTo>
                  <a:pt x="1083" y="865"/>
                  <a:pt x="1085" y="865"/>
                  <a:pt x="1086" y="865"/>
                </a:cubicBezTo>
                <a:cubicBezTo>
                  <a:pt x="1088" y="866"/>
                  <a:pt x="1089" y="867"/>
                  <a:pt x="1090" y="868"/>
                </a:cubicBezTo>
                <a:lnTo>
                  <a:pt x="1117" y="895"/>
                </a:lnTo>
                <a:cubicBezTo>
                  <a:pt x="1116" y="870"/>
                  <a:pt x="1118" y="850"/>
                  <a:pt x="1123" y="833"/>
                </a:cubicBezTo>
                <a:cubicBezTo>
                  <a:pt x="1128" y="816"/>
                  <a:pt x="1136" y="802"/>
                  <a:pt x="1147" y="790"/>
                </a:cubicBezTo>
                <a:cubicBezTo>
                  <a:pt x="1155" y="782"/>
                  <a:pt x="1164" y="775"/>
                  <a:pt x="1173" y="770"/>
                </a:cubicBezTo>
                <a:cubicBezTo>
                  <a:pt x="1182" y="766"/>
                  <a:pt x="1190" y="762"/>
                  <a:pt x="1199" y="761"/>
                </a:cubicBezTo>
                <a:cubicBezTo>
                  <a:pt x="1208" y="759"/>
                  <a:pt x="1217" y="759"/>
                  <a:pt x="1225" y="760"/>
                </a:cubicBezTo>
                <a:cubicBezTo>
                  <a:pt x="1234" y="762"/>
                  <a:pt x="1243" y="764"/>
                  <a:pt x="1251" y="768"/>
                </a:cubicBezTo>
                <a:cubicBezTo>
                  <a:pt x="1251" y="753"/>
                  <a:pt x="1251" y="741"/>
                  <a:pt x="1252" y="729"/>
                </a:cubicBezTo>
                <a:cubicBezTo>
                  <a:pt x="1253" y="718"/>
                  <a:pt x="1254" y="708"/>
                  <a:pt x="1257" y="699"/>
                </a:cubicBezTo>
                <a:cubicBezTo>
                  <a:pt x="1259" y="690"/>
                  <a:pt x="1263" y="682"/>
                  <a:pt x="1267" y="675"/>
                </a:cubicBezTo>
                <a:cubicBezTo>
                  <a:pt x="1271" y="668"/>
                  <a:pt x="1275" y="662"/>
                  <a:pt x="1281" y="656"/>
                </a:cubicBezTo>
                <a:cubicBezTo>
                  <a:pt x="1294" y="643"/>
                  <a:pt x="1308" y="634"/>
                  <a:pt x="1321" y="630"/>
                </a:cubicBezTo>
                <a:cubicBezTo>
                  <a:pt x="1335" y="626"/>
                  <a:pt x="1349" y="624"/>
                  <a:pt x="1362" y="627"/>
                </a:cubicBezTo>
                <a:cubicBezTo>
                  <a:pt x="1375" y="629"/>
                  <a:pt x="1388" y="634"/>
                  <a:pt x="1401" y="642"/>
                </a:cubicBezTo>
                <a:cubicBezTo>
                  <a:pt x="1414" y="650"/>
                  <a:pt x="1426" y="660"/>
                  <a:pt x="1438" y="672"/>
                </a:cubicBezTo>
                <a:lnTo>
                  <a:pt x="1568" y="802"/>
                </a:lnTo>
                <a:close/>
                <a:moveTo>
                  <a:pt x="1797" y="574"/>
                </a:moveTo>
                <a:cubicBezTo>
                  <a:pt x="1799" y="576"/>
                  <a:pt x="1800" y="578"/>
                  <a:pt x="1799" y="580"/>
                </a:cubicBezTo>
                <a:cubicBezTo>
                  <a:pt x="1799" y="582"/>
                  <a:pt x="1798" y="584"/>
                  <a:pt x="1796" y="587"/>
                </a:cubicBezTo>
                <a:cubicBezTo>
                  <a:pt x="1795" y="590"/>
                  <a:pt x="1792" y="593"/>
                  <a:pt x="1788" y="597"/>
                </a:cubicBezTo>
                <a:cubicBezTo>
                  <a:pt x="1784" y="601"/>
                  <a:pt x="1780" y="604"/>
                  <a:pt x="1777" y="606"/>
                </a:cubicBezTo>
                <a:cubicBezTo>
                  <a:pt x="1775" y="608"/>
                  <a:pt x="1772" y="609"/>
                  <a:pt x="1770" y="609"/>
                </a:cubicBezTo>
                <a:cubicBezTo>
                  <a:pt x="1768" y="609"/>
                  <a:pt x="1766" y="608"/>
                  <a:pt x="1764" y="607"/>
                </a:cubicBezTo>
                <a:lnTo>
                  <a:pt x="1744" y="586"/>
                </a:lnTo>
                <a:cubicBezTo>
                  <a:pt x="1744" y="605"/>
                  <a:pt x="1742" y="622"/>
                  <a:pt x="1736" y="639"/>
                </a:cubicBezTo>
                <a:cubicBezTo>
                  <a:pt x="1730" y="655"/>
                  <a:pt x="1721" y="669"/>
                  <a:pt x="1709" y="682"/>
                </a:cubicBezTo>
                <a:cubicBezTo>
                  <a:pt x="1698" y="693"/>
                  <a:pt x="1687" y="701"/>
                  <a:pt x="1675" y="707"/>
                </a:cubicBezTo>
                <a:cubicBezTo>
                  <a:pt x="1664" y="713"/>
                  <a:pt x="1652" y="716"/>
                  <a:pt x="1641" y="717"/>
                </a:cubicBezTo>
                <a:cubicBezTo>
                  <a:pt x="1629" y="718"/>
                  <a:pt x="1618" y="716"/>
                  <a:pt x="1606" y="712"/>
                </a:cubicBezTo>
                <a:cubicBezTo>
                  <a:pt x="1595" y="708"/>
                  <a:pt x="1585" y="700"/>
                  <a:pt x="1575" y="690"/>
                </a:cubicBezTo>
                <a:cubicBezTo>
                  <a:pt x="1563" y="679"/>
                  <a:pt x="1555" y="666"/>
                  <a:pt x="1552" y="653"/>
                </a:cubicBezTo>
                <a:cubicBezTo>
                  <a:pt x="1548" y="640"/>
                  <a:pt x="1547" y="626"/>
                  <a:pt x="1551" y="611"/>
                </a:cubicBezTo>
                <a:cubicBezTo>
                  <a:pt x="1554" y="597"/>
                  <a:pt x="1560" y="582"/>
                  <a:pt x="1570" y="566"/>
                </a:cubicBezTo>
                <a:cubicBezTo>
                  <a:pt x="1580" y="550"/>
                  <a:pt x="1593" y="535"/>
                  <a:pt x="1610" y="519"/>
                </a:cubicBezTo>
                <a:lnTo>
                  <a:pt x="1638" y="490"/>
                </a:lnTo>
                <a:lnTo>
                  <a:pt x="1622" y="474"/>
                </a:lnTo>
                <a:cubicBezTo>
                  <a:pt x="1614" y="466"/>
                  <a:pt x="1606" y="460"/>
                  <a:pt x="1598" y="455"/>
                </a:cubicBezTo>
                <a:cubicBezTo>
                  <a:pt x="1590" y="451"/>
                  <a:pt x="1583" y="449"/>
                  <a:pt x="1575" y="448"/>
                </a:cubicBezTo>
                <a:cubicBezTo>
                  <a:pt x="1567" y="448"/>
                  <a:pt x="1559" y="450"/>
                  <a:pt x="1551" y="454"/>
                </a:cubicBezTo>
                <a:cubicBezTo>
                  <a:pt x="1543" y="458"/>
                  <a:pt x="1535" y="464"/>
                  <a:pt x="1526" y="473"/>
                </a:cubicBezTo>
                <a:cubicBezTo>
                  <a:pt x="1517" y="482"/>
                  <a:pt x="1509" y="491"/>
                  <a:pt x="1504" y="501"/>
                </a:cubicBezTo>
                <a:cubicBezTo>
                  <a:pt x="1499" y="511"/>
                  <a:pt x="1495" y="520"/>
                  <a:pt x="1492" y="528"/>
                </a:cubicBezTo>
                <a:cubicBezTo>
                  <a:pt x="1489" y="536"/>
                  <a:pt x="1487" y="543"/>
                  <a:pt x="1485" y="549"/>
                </a:cubicBezTo>
                <a:cubicBezTo>
                  <a:pt x="1484" y="555"/>
                  <a:pt x="1482" y="559"/>
                  <a:pt x="1480" y="561"/>
                </a:cubicBezTo>
                <a:cubicBezTo>
                  <a:pt x="1479" y="562"/>
                  <a:pt x="1478" y="563"/>
                  <a:pt x="1476" y="563"/>
                </a:cubicBezTo>
                <a:cubicBezTo>
                  <a:pt x="1475" y="564"/>
                  <a:pt x="1473" y="563"/>
                  <a:pt x="1471" y="563"/>
                </a:cubicBezTo>
                <a:cubicBezTo>
                  <a:pt x="1469" y="562"/>
                  <a:pt x="1467" y="561"/>
                  <a:pt x="1465" y="560"/>
                </a:cubicBezTo>
                <a:cubicBezTo>
                  <a:pt x="1463" y="558"/>
                  <a:pt x="1460" y="556"/>
                  <a:pt x="1458" y="554"/>
                </a:cubicBezTo>
                <a:cubicBezTo>
                  <a:pt x="1454" y="550"/>
                  <a:pt x="1452" y="547"/>
                  <a:pt x="1450" y="544"/>
                </a:cubicBezTo>
                <a:cubicBezTo>
                  <a:pt x="1448" y="541"/>
                  <a:pt x="1447" y="538"/>
                  <a:pt x="1448" y="534"/>
                </a:cubicBezTo>
                <a:cubicBezTo>
                  <a:pt x="1448" y="530"/>
                  <a:pt x="1449" y="524"/>
                  <a:pt x="1451" y="516"/>
                </a:cubicBezTo>
                <a:cubicBezTo>
                  <a:pt x="1454" y="508"/>
                  <a:pt x="1457" y="500"/>
                  <a:pt x="1461" y="491"/>
                </a:cubicBezTo>
                <a:cubicBezTo>
                  <a:pt x="1466" y="483"/>
                  <a:pt x="1471" y="474"/>
                  <a:pt x="1477" y="464"/>
                </a:cubicBezTo>
                <a:cubicBezTo>
                  <a:pt x="1484" y="455"/>
                  <a:pt x="1491" y="446"/>
                  <a:pt x="1499" y="439"/>
                </a:cubicBezTo>
                <a:cubicBezTo>
                  <a:pt x="1514" y="424"/>
                  <a:pt x="1528" y="413"/>
                  <a:pt x="1542" y="406"/>
                </a:cubicBezTo>
                <a:cubicBezTo>
                  <a:pt x="1555" y="399"/>
                  <a:pt x="1569" y="395"/>
                  <a:pt x="1582" y="395"/>
                </a:cubicBezTo>
                <a:cubicBezTo>
                  <a:pt x="1595" y="395"/>
                  <a:pt x="1607" y="399"/>
                  <a:pt x="1620" y="406"/>
                </a:cubicBezTo>
                <a:cubicBezTo>
                  <a:pt x="1632" y="412"/>
                  <a:pt x="1645" y="422"/>
                  <a:pt x="1658" y="435"/>
                </a:cubicBezTo>
                <a:lnTo>
                  <a:pt x="1797" y="574"/>
                </a:lnTo>
                <a:close/>
                <a:moveTo>
                  <a:pt x="1665" y="517"/>
                </a:moveTo>
                <a:lnTo>
                  <a:pt x="1633" y="550"/>
                </a:lnTo>
                <a:cubicBezTo>
                  <a:pt x="1622" y="560"/>
                  <a:pt x="1614" y="570"/>
                  <a:pt x="1608" y="579"/>
                </a:cubicBezTo>
                <a:cubicBezTo>
                  <a:pt x="1603" y="589"/>
                  <a:pt x="1599" y="598"/>
                  <a:pt x="1597" y="606"/>
                </a:cubicBezTo>
                <a:cubicBezTo>
                  <a:pt x="1596" y="615"/>
                  <a:pt x="1596" y="623"/>
                  <a:pt x="1598" y="630"/>
                </a:cubicBezTo>
                <a:cubicBezTo>
                  <a:pt x="1601" y="637"/>
                  <a:pt x="1605" y="644"/>
                  <a:pt x="1612" y="650"/>
                </a:cubicBezTo>
                <a:cubicBezTo>
                  <a:pt x="1622" y="661"/>
                  <a:pt x="1634" y="666"/>
                  <a:pt x="1647" y="665"/>
                </a:cubicBezTo>
                <a:cubicBezTo>
                  <a:pt x="1660" y="665"/>
                  <a:pt x="1673" y="658"/>
                  <a:pt x="1685" y="646"/>
                </a:cubicBezTo>
                <a:cubicBezTo>
                  <a:pt x="1695" y="636"/>
                  <a:pt x="1702" y="625"/>
                  <a:pt x="1705" y="611"/>
                </a:cubicBezTo>
                <a:cubicBezTo>
                  <a:pt x="1709" y="598"/>
                  <a:pt x="1710" y="581"/>
                  <a:pt x="1709" y="561"/>
                </a:cubicBezTo>
                <a:lnTo>
                  <a:pt x="1665" y="517"/>
                </a:lnTo>
                <a:close/>
                <a:moveTo>
                  <a:pt x="1960" y="381"/>
                </a:moveTo>
                <a:cubicBezTo>
                  <a:pt x="1964" y="385"/>
                  <a:pt x="1967" y="389"/>
                  <a:pt x="1969" y="392"/>
                </a:cubicBezTo>
                <a:cubicBezTo>
                  <a:pt x="1971" y="395"/>
                  <a:pt x="1972" y="398"/>
                  <a:pt x="1972" y="400"/>
                </a:cubicBezTo>
                <a:cubicBezTo>
                  <a:pt x="1972" y="403"/>
                  <a:pt x="1972" y="406"/>
                  <a:pt x="1970" y="409"/>
                </a:cubicBezTo>
                <a:cubicBezTo>
                  <a:pt x="1969" y="413"/>
                  <a:pt x="1967" y="417"/>
                  <a:pt x="1965" y="420"/>
                </a:cubicBezTo>
                <a:cubicBezTo>
                  <a:pt x="1962" y="424"/>
                  <a:pt x="1959" y="428"/>
                  <a:pt x="1956" y="432"/>
                </a:cubicBezTo>
                <a:cubicBezTo>
                  <a:pt x="1953" y="436"/>
                  <a:pt x="1950" y="440"/>
                  <a:pt x="1947" y="443"/>
                </a:cubicBezTo>
                <a:cubicBezTo>
                  <a:pt x="1936" y="454"/>
                  <a:pt x="1925" y="462"/>
                  <a:pt x="1915" y="467"/>
                </a:cubicBezTo>
                <a:cubicBezTo>
                  <a:pt x="1904" y="471"/>
                  <a:pt x="1894" y="473"/>
                  <a:pt x="1883" y="473"/>
                </a:cubicBezTo>
                <a:cubicBezTo>
                  <a:pt x="1872" y="472"/>
                  <a:pt x="1862" y="468"/>
                  <a:pt x="1851" y="461"/>
                </a:cubicBezTo>
                <a:cubicBezTo>
                  <a:pt x="1840" y="455"/>
                  <a:pt x="1828" y="446"/>
                  <a:pt x="1816" y="434"/>
                </a:cubicBezTo>
                <a:lnTo>
                  <a:pt x="1696" y="313"/>
                </a:lnTo>
                <a:lnTo>
                  <a:pt x="1667" y="342"/>
                </a:lnTo>
                <a:cubicBezTo>
                  <a:pt x="1665" y="344"/>
                  <a:pt x="1661" y="345"/>
                  <a:pt x="1658" y="344"/>
                </a:cubicBezTo>
                <a:cubicBezTo>
                  <a:pt x="1654" y="343"/>
                  <a:pt x="1649" y="339"/>
                  <a:pt x="1644" y="334"/>
                </a:cubicBezTo>
                <a:cubicBezTo>
                  <a:pt x="1641" y="331"/>
                  <a:pt x="1639" y="328"/>
                  <a:pt x="1637" y="326"/>
                </a:cubicBezTo>
                <a:cubicBezTo>
                  <a:pt x="1635" y="324"/>
                  <a:pt x="1634" y="322"/>
                  <a:pt x="1633" y="320"/>
                </a:cubicBezTo>
                <a:cubicBezTo>
                  <a:pt x="1633" y="318"/>
                  <a:pt x="1633" y="316"/>
                  <a:pt x="1633" y="314"/>
                </a:cubicBezTo>
                <a:cubicBezTo>
                  <a:pt x="1634" y="313"/>
                  <a:pt x="1634" y="312"/>
                  <a:pt x="1636" y="310"/>
                </a:cubicBezTo>
                <a:lnTo>
                  <a:pt x="1664" y="282"/>
                </a:lnTo>
                <a:lnTo>
                  <a:pt x="1615" y="233"/>
                </a:lnTo>
                <a:cubicBezTo>
                  <a:pt x="1614" y="232"/>
                  <a:pt x="1613" y="230"/>
                  <a:pt x="1613" y="229"/>
                </a:cubicBezTo>
                <a:cubicBezTo>
                  <a:pt x="1613" y="227"/>
                  <a:pt x="1613" y="226"/>
                  <a:pt x="1614" y="223"/>
                </a:cubicBezTo>
                <a:cubicBezTo>
                  <a:pt x="1614" y="221"/>
                  <a:pt x="1616" y="219"/>
                  <a:pt x="1618" y="216"/>
                </a:cubicBezTo>
                <a:cubicBezTo>
                  <a:pt x="1620" y="213"/>
                  <a:pt x="1623" y="210"/>
                  <a:pt x="1627" y="207"/>
                </a:cubicBezTo>
                <a:cubicBezTo>
                  <a:pt x="1631" y="203"/>
                  <a:pt x="1634" y="200"/>
                  <a:pt x="1637" y="198"/>
                </a:cubicBezTo>
                <a:cubicBezTo>
                  <a:pt x="1639" y="195"/>
                  <a:pt x="1642" y="194"/>
                  <a:pt x="1644" y="193"/>
                </a:cubicBezTo>
                <a:cubicBezTo>
                  <a:pt x="1646" y="193"/>
                  <a:pt x="1648" y="192"/>
                  <a:pt x="1649" y="193"/>
                </a:cubicBezTo>
                <a:cubicBezTo>
                  <a:pt x="1651" y="193"/>
                  <a:pt x="1652" y="194"/>
                  <a:pt x="1653" y="195"/>
                </a:cubicBezTo>
                <a:lnTo>
                  <a:pt x="1702" y="244"/>
                </a:lnTo>
                <a:lnTo>
                  <a:pt x="1755" y="191"/>
                </a:lnTo>
                <a:cubicBezTo>
                  <a:pt x="1756" y="190"/>
                  <a:pt x="1758" y="189"/>
                  <a:pt x="1759" y="189"/>
                </a:cubicBezTo>
                <a:cubicBezTo>
                  <a:pt x="1761" y="188"/>
                  <a:pt x="1762" y="188"/>
                  <a:pt x="1764" y="189"/>
                </a:cubicBezTo>
                <a:cubicBezTo>
                  <a:pt x="1766" y="189"/>
                  <a:pt x="1768" y="191"/>
                  <a:pt x="1771" y="192"/>
                </a:cubicBezTo>
                <a:cubicBezTo>
                  <a:pt x="1773" y="194"/>
                  <a:pt x="1776" y="196"/>
                  <a:pt x="1778" y="199"/>
                </a:cubicBezTo>
                <a:cubicBezTo>
                  <a:pt x="1784" y="205"/>
                  <a:pt x="1787" y="209"/>
                  <a:pt x="1788" y="213"/>
                </a:cubicBezTo>
                <a:cubicBezTo>
                  <a:pt x="1789" y="217"/>
                  <a:pt x="1789" y="220"/>
                  <a:pt x="1786" y="222"/>
                </a:cubicBezTo>
                <a:lnTo>
                  <a:pt x="1734" y="275"/>
                </a:lnTo>
                <a:lnTo>
                  <a:pt x="1849" y="390"/>
                </a:lnTo>
                <a:cubicBezTo>
                  <a:pt x="1863" y="405"/>
                  <a:pt x="1876" y="413"/>
                  <a:pt x="1887" y="416"/>
                </a:cubicBezTo>
                <a:cubicBezTo>
                  <a:pt x="1899" y="419"/>
                  <a:pt x="1910" y="415"/>
                  <a:pt x="1921" y="405"/>
                </a:cubicBezTo>
                <a:cubicBezTo>
                  <a:pt x="1924" y="401"/>
                  <a:pt x="1927" y="398"/>
                  <a:pt x="1929" y="394"/>
                </a:cubicBezTo>
                <a:cubicBezTo>
                  <a:pt x="1931" y="391"/>
                  <a:pt x="1933" y="388"/>
                  <a:pt x="1934" y="385"/>
                </a:cubicBezTo>
                <a:cubicBezTo>
                  <a:pt x="1936" y="382"/>
                  <a:pt x="1937" y="379"/>
                  <a:pt x="1937" y="377"/>
                </a:cubicBezTo>
                <a:cubicBezTo>
                  <a:pt x="1938" y="375"/>
                  <a:pt x="1939" y="373"/>
                  <a:pt x="1941" y="372"/>
                </a:cubicBezTo>
                <a:cubicBezTo>
                  <a:pt x="1941" y="371"/>
                  <a:pt x="1942" y="371"/>
                  <a:pt x="1943" y="370"/>
                </a:cubicBezTo>
                <a:cubicBezTo>
                  <a:pt x="1944" y="370"/>
                  <a:pt x="1946" y="370"/>
                  <a:pt x="1947" y="371"/>
                </a:cubicBezTo>
                <a:cubicBezTo>
                  <a:pt x="1949" y="371"/>
                  <a:pt x="1950" y="373"/>
                  <a:pt x="1952" y="374"/>
                </a:cubicBezTo>
                <a:cubicBezTo>
                  <a:pt x="1955" y="376"/>
                  <a:pt x="1957" y="378"/>
                  <a:pt x="1960" y="381"/>
                </a:cubicBezTo>
                <a:close/>
                <a:moveTo>
                  <a:pt x="2090" y="56"/>
                </a:moveTo>
                <a:cubicBezTo>
                  <a:pt x="2096" y="62"/>
                  <a:pt x="2099" y="68"/>
                  <a:pt x="2098" y="74"/>
                </a:cubicBezTo>
                <a:cubicBezTo>
                  <a:pt x="2098" y="79"/>
                  <a:pt x="2096" y="84"/>
                  <a:pt x="2092" y="88"/>
                </a:cubicBezTo>
                <a:lnTo>
                  <a:pt x="1956" y="224"/>
                </a:lnTo>
                <a:cubicBezTo>
                  <a:pt x="1967" y="235"/>
                  <a:pt x="1979" y="244"/>
                  <a:pt x="1990" y="251"/>
                </a:cubicBezTo>
                <a:cubicBezTo>
                  <a:pt x="2002" y="258"/>
                  <a:pt x="2013" y="262"/>
                  <a:pt x="2025" y="263"/>
                </a:cubicBezTo>
                <a:cubicBezTo>
                  <a:pt x="2037" y="264"/>
                  <a:pt x="2049" y="262"/>
                  <a:pt x="2062" y="257"/>
                </a:cubicBezTo>
                <a:cubicBezTo>
                  <a:pt x="2074" y="252"/>
                  <a:pt x="2086" y="243"/>
                  <a:pt x="2098" y="231"/>
                </a:cubicBezTo>
                <a:cubicBezTo>
                  <a:pt x="2108" y="221"/>
                  <a:pt x="2116" y="212"/>
                  <a:pt x="2122" y="202"/>
                </a:cubicBezTo>
                <a:cubicBezTo>
                  <a:pt x="2128" y="193"/>
                  <a:pt x="2133" y="185"/>
                  <a:pt x="2137" y="177"/>
                </a:cubicBezTo>
                <a:cubicBezTo>
                  <a:pt x="2140" y="169"/>
                  <a:pt x="2143" y="163"/>
                  <a:pt x="2145" y="158"/>
                </a:cubicBezTo>
                <a:cubicBezTo>
                  <a:pt x="2147" y="153"/>
                  <a:pt x="2149" y="149"/>
                  <a:pt x="2151" y="147"/>
                </a:cubicBezTo>
                <a:cubicBezTo>
                  <a:pt x="2152" y="146"/>
                  <a:pt x="2153" y="145"/>
                  <a:pt x="2155" y="145"/>
                </a:cubicBezTo>
                <a:cubicBezTo>
                  <a:pt x="2156" y="145"/>
                  <a:pt x="2157" y="145"/>
                  <a:pt x="2159" y="146"/>
                </a:cubicBezTo>
                <a:cubicBezTo>
                  <a:pt x="2161" y="146"/>
                  <a:pt x="2162" y="147"/>
                  <a:pt x="2165" y="149"/>
                </a:cubicBezTo>
                <a:cubicBezTo>
                  <a:pt x="2167" y="151"/>
                  <a:pt x="2169" y="153"/>
                  <a:pt x="2172" y="156"/>
                </a:cubicBezTo>
                <a:cubicBezTo>
                  <a:pt x="2174" y="158"/>
                  <a:pt x="2175" y="159"/>
                  <a:pt x="2177" y="161"/>
                </a:cubicBezTo>
                <a:cubicBezTo>
                  <a:pt x="2178" y="163"/>
                  <a:pt x="2179" y="164"/>
                  <a:pt x="2180" y="166"/>
                </a:cubicBezTo>
                <a:cubicBezTo>
                  <a:pt x="2181" y="167"/>
                  <a:pt x="2182" y="168"/>
                  <a:pt x="2182" y="170"/>
                </a:cubicBezTo>
                <a:cubicBezTo>
                  <a:pt x="2182" y="171"/>
                  <a:pt x="2183" y="173"/>
                  <a:pt x="2183" y="174"/>
                </a:cubicBezTo>
                <a:cubicBezTo>
                  <a:pt x="2183" y="176"/>
                  <a:pt x="2182" y="180"/>
                  <a:pt x="2179" y="186"/>
                </a:cubicBezTo>
                <a:cubicBezTo>
                  <a:pt x="2177" y="192"/>
                  <a:pt x="2174" y="199"/>
                  <a:pt x="2169" y="208"/>
                </a:cubicBezTo>
                <a:cubicBezTo>
                  <a:pt x="2164" y="216"/>
                  <a:pt x="2158" y="225"/>
                  <a:pt x="2151" y="235"/>
                </a:cubicBezTo>
                <a:cubicBezTo>
                  <a:pt x="2144" y="246"/>
                  <a:pt x="2135" y="255"/>
                  <a:pt x="2126" y="265"/>
                </a:cubicBezTo>
                <a:cubicBezTo>
                  <a:pt x="2109" y="282"/>
                  <a:pt x="2091" y="295"/>
                  <a:pt x="2074" y="303"/>
                </a:cubicBezTo>
                <a:cubicBezTo>
                  <a:pt x="2056" y="311"/>
                  <a:pt x="2039" y="314"/>
                  <a:pt x="2021" y="314"/>
                </a:cubicBezTo>
                <a:cubicBezTo>
                  <a:pt x="2002" y="313"/>
                  <a:pt x="1984" y="308"/>
                  <a:pt x="1966" y="298"/>
                </a:cubicBezTo>
                <a:cubicBezTo>
                  <a:pt x="1947" y="289"/>
                  <a:pt x="1929" y="275"/>
                  <a:pt x="1910" y="256"/>
                </a:cubicBezTo>
                <a:cubicBezTo>
                  <a:pt x="1892" y="238"/>
                  <a:pt x="1879" y="220"/>
                  <a:pt x="1869" y="201"/>
                </a:cubicBezTo>
                <a:cubicBezTo>
                  <a:pt x="1860" y="183"/>
                  <a:pt x="1854" y="164"/>
                  <a:pt x="1853" y="146"/>
                </a:cubicBezTo>
                <a:cubicBezTo>
                  <a:pt x="1852" y="127"/>
                  <a:pt x="1855" y="109"/>
                  <a:pt x="1862" y="92"/>
                </a:cubicBezTo>
                <a:cubicBezTo>
                  <a:pt x="1868" y="74"/>
                  <a:pt x="1880" y="58"/>
                  <a:pt x="1895" y="43"/>
                </a:cubicBezTo>
                <a:cubicBezTo>
                  <a:pt x="1911" y="26"/>
                  <a:pt x="1927" y="15"/>
                  <a:pt x="1944" y="9"/>
                </a:cubicBezTo>
                <a:cubicBezTo>
                  <a:pt x="1960" y="3"/>
                  <a:pt x="1977" y="0"/>
                  <a:pt x="1993" y="2"/>
                </a:cubicBezTo>
                <a:cubicBezTo>
                  <a:pt x="2009" y="3"/>
                  <a:pt x="2025" y="8"/>
                  <a:pt x="2040" y="17"/>
                </a:cubicBezTo>
                <a:cubicBezTo>
                  <a:pt x="2055" y="25"/>
                  <a:pt x="2070" y="36"/>
                  <a:pt x="2083" y="49"/>
                </a:cubicBezTo>
                <a:lnTo>
                  <a:pt x="2090" y="56"/>
                </a:lnTo>
                <a:close/>
                <a:moveTo>
                  <a:pt x="2041" y="83"/>
                </a:moveTo>
                <a:cubicBezTo>
                  <a:pt x="2021" y="63"/>
                  <a:pt x="2001" y="52"/>
                  <a:pt x="1981" y="50"/>
                </a:cubicBezTo>
                <a:cubicBezTo>
                  <a:pt x="1960" y="48"/>
                  <a:pt x="1941" y="56"/>
                  <a:pt x="1922" y="74"/>
                </a:cubicBezTo>
                <a:cubicBezTo>
                  <a:pt x="1913" y="84"/>
                  <a:pt x="1906" y="93"/>
                  <a:pt x="1903" y="104"/>
                </a:cubicBezTo>
                <a:cubicBezTo>
                  <a:pt x="1899" y="115"/>
                  <a:pt x="1898" y="125"/>
                  <a:pt x="1899" y="136"/>
                </a:cubicBezTo>
                <a:cubicBezTo>
                  <a:pt x="1900" y="146"/>
                  <a:pt x="1903" y="157"/>
                  <a:pt x="1908" y="167"/>
                </a:cubicBezTo>
                <a:cubicBezTo>
                  <a:pt x="1913" y="178"/>
                  <a:pt x="1920" y="187"/>
                  <a:pt x="1928" y="196"/>
                </a:cubicBezTo>
                <a:lnTo>
                  <a:pt x="2041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0" name="Freeform 254"/>
          <p:cNvSpPr>
            <a:spLocks noEditPoints="1"/>
          </p:cNvSpPr>
          <p:nvPr/>
        </p:nvSpPr>
        <p:spPr bwMode="auto">
          <a:xfrm>
            <a:off x="2995229" y="4418880"/>
            <a:ext cx="318246" cy="382588"/>
          </a:xfrm>
          <a:custGeom>
            <a:avLst/>
            <a:gdLst>
              <a:gd name="T0" fmla="*/ 408 w 2002"/>
              <a:gd name="T1" fmla="*/ 1793 h 2008"/>
              <a:gd name="T2" fmla="*/ 224 w 2002"/>
              <a:gd name="T3" fmla="*/ 1975 h 2008"/>
              <a:gd name="T4" fmla="*/ 1 w 2002"/>
              <a:gd name="T5" fmla="*/ 1620 h 2008"/>
              <a:gd name="T6" fmla="*/ 47 w 2002"/>
              <a:gd name="T7" fmla="*/ 1566 h 2008"/>
              <a:gd name="T8" fmla="*/ 58 w 2002"/>
              <a:gd name="T9" fmla="*/ 1628 h 2008"/>
              <a:gd name="T10" fmla="*/ 496 w 2002"/>
              <a:gd name="T11" fmla="*/ 1701 h 2008"/>
              <a:gd name="T12" fmla="*/ 430 w 2002"/>
              <a:gd name="T13" fmla="*/ 1681 h 2008"/>
              <a:gd name="T14" fmla="*/ 534 w 2002"/>
              <a:gd name="T15" fmla="*/ 1598 h 2008"/>
              <a:gd name="T16" fmla="*/ 401 w 2002"/>
              <a:gd name="T17" fmla="*/ 1583 h 2008"/>
              <a:gd name="T18" fmla="*/ 330 w 2002"/>
              <a:gd name="T19" fmla="*/ 1427 h 2008"/>
              <a:gd name="T20" fmla="*/ 408 w 2002"/>
              <a:gd name="T21" fmla="*/ 1396 h 2008"/>
              <a:gd name="T22" fmla="*/ 400 w 2002"/>
              <a:gd name="T23" fmla="*/ 1431 h 2008"/>
              <a:gd name="T24" fmla="*/ 369 w 2002"/>
              <a:gd name="T25" fmla="*/ 1535 h 2008"/>
              <a:gd name="T26" fmla="*/ 556 w 2002"/>
              <a:gd name="T27" fmla="*/ 1521 h 2008"/>
              <a:gd name="T28" fmla="*/ 740 w 2002"/>
              <a:gd name="T29" fmla="*/ 1455 h 2008"/>
              <a:gd name="T30" fmla="*/ 777 w 2002"/>
              <a:gd name="T31" fmla="*/ 1591 h 2008"/>
              <a:gd name="T32" fmla="*/ 461 w 2002"/>
              <a:gd name="T33" fmla="*/ 1305 h 2008"/>
              <a:gd name="T34" fmla="*/ 524 w 2002"/>
              <a:gd name="T35" fmla="*/ 1308 h 2008"/>
              <a:gd name="T36" fmla="*/ 705 w 2002"/>
              <a:gd name="T37" fmla="*/ 1186 h 2008"/>
              <a:gd name="T38" fmla="*/ 572 w 2002"/>
              <a:gd name="T39" fmla="*/ 1253 h 2008"/>
              <a:gd name="T40" fmla="*/ 761 w 2002"/>
              <a:gd name="T41" fmla="*/ 1369 h 2008"/>
              <a:gd name="T42" fmla="*/ 1064 w 2002"/>
              <a:gd name="T43" fmla="*/ 1139 h 2008"/>
              <a:gd name="T44" fmla="*/ 952 w 2002"/>
              <a:gd name="T45" fmla="*/ 1249 h 2008"/>
              <a:gd name="T46" fmla="*/ 886 w 2002"/>
              <a:gd name="T47" fmla="*/ 1061 h 2008"/>
              <a:gd name="T48" fmla="*/ 781 w 2002"/>
              <a:gd name="T49" fmla="*/ 1043 h 2008"/>
              <a:gd name="T50" fmla="*/ 735 w 2002"/>
              <a:gd name="T51" fmla="*/ 1096 h 2008"/>
              <a:gd name="T52" fmla="*/ 818 w 2002"/>
              <a:gd name="T53" fmla="*/ 948 h 2008"/>
              <a:gd name="T54" fmla="*/ 885 w 2002"/>
              <a:gd name="T55" fmla="*/ 1122 h 2008"/>
              <a:gd name="T56" fmla="*/ 986 w 2002"/>
              <a:gd name="T57" fmla="*/ 1103 h 2008"/>
              <a:gd name="T58" fmla="*/ 1079 w 2002"/>
              <a:gd name="T59" fmla="*/ 759 h 2008"/>
              <a:gd name="T60" fmla="*/ 1046 w 2002"/>
              <a:gd name="T61" fmla="*/ 872 h 2008"/>
              <a:gd name="T62" fmla="*/ 1153 w 2002"/>
              <a:gd name="T63" fmla="*/ 1047 h 2008"/>
              <a:gd name="T64" fmla="*/ 948 w 2002"/>
              <a:gd name="T65" fmla="*/ 814 h 2008"/>
              <a:gd name="T66" fmla="*/ 1000 w 2002"/>
              <a:gd name="T67" fmla="*/ 772 h 2008"/>
              <a:gd name="T68" fmla="*/ 1055 w 2002"/>
              <a:gd name="T69" fmla="*/ 717 h 2008"/>
              <a:gd name="T70" fmla="*/ 1411 w 2002"/>
              <a:gd name="T71" fmla="*/ 787 h 2008"/>
              <a:gd name="T72" fmla="*/ 1257 w 2002"/>
              <a:gd name="T73" fmla="*/ 812 h 2008"/>
              <a:gd name="T74" fmla="*/ 1074 w 2002"/>
              <a:gd name="T75" fmla="*/ 693 h 2008"/>
              <a:gd name="T76" fmla="*/ 1067 w 2002"/>
              <a:gd name="T77" fmla="*/ 585 h 2008"/>
              <a:gd name="T78" fmla="*/ 1200 w 2002"/>
              <a:gd name="T79" fmla="*/ 567 h 2008"/>
              <a:gd name="T80" fmla="*/ 1289 w 2002"/>
              <a:gd name="T81" fmla="*/ 768 h 2008"/>
              <a:gd name="T82" fmla="*/ 1384 w 2002"/>
              <a:gd name="T83" fmla="*/ 748 h 2008"/>
              <a:gd name="T84" fmla="*/ 1607 w 2002"/>
              <a:gd name="T85" fmla="*/ 596 h 2008"/>
              <a:gd name="T86" fmla="*/ 1495 w 2002"/>
              <a:gd name="T87" fmla="*/ 706 h 2008"/>
              <a:gd name="T88" fmla="*/ 1429 w 2002"/>
              <a:gd name="T89" fmla="*/ 518 h 2008"/>
              <a:gd name="T90" fmla="*/ 1324 w 2002"/>
              <a:gd name="T91" fmla="*/ 500 h 2008"/>
              <a:gd name="T92" fmla="*/ 1278 w 2002"/>
              <a:gd name="T93" fmla="*/ 553 h 2008"/>
              <a:gd name="T94" fmla="*/ 1361 w 2002"/>
              <a:gd name="T95" fmla="*/ 405 h 2008"/>
              <a:gd name="T96" fmla="*/ 1428 w 2002"/>
              <a:gd name="T97" fmla="*/ 578 h 2008"/>
              <a:gd name="T98" fmla="*/ 1529 w 2002"/>
              <a:gd name="T99" fmla="*/ 560 h 2008"/>
              <a:gd name="T100" fmla="*/ 1776 w 2002"/>
              <a:gd name="T101" fmla="*/ 431 h 2008"/>
              <a:gd name="T102" fmla="*/ 1487 w 2002"/>
              <a:gd name="T103" fmla="*/ 341 h 2008"/>
              <a:gd name="T104" fmla="*/ 1484 w 2002"/>
              <a:gd name="T105" fmla="*/ 281 h 2008"/>
              <a:gd name="T106" fmla="*/ 1463 w 2002"/>
              <a:gd name="T107" fmla="*/ 192 h 2008"/>
              <a:gd name="T108" fmla="*/ 1590 w 2002"/>
              <a:gd name="T109" fmla="*/ 191 h 2008"/>
              <a:gd name="T110" fmla="*/ 1740 w 2002"/>
              <a:gd name="T111" fmla="*/ 404 h 2008"/>
              <a:gd name="T112" fmla="*/ 1772 w 2002"/>
              <a:gd name="T113" fmla="*/ 373 h 2008"/>
              <a:gd name="T114" fmla="*/ 1845 w 2002"/>
              <a:gd name="T115" fmla="*/ 262 h 2008"/>
              <a:gd name="T116" fmla="*/ 1974 w 2002"/>
              <a:gd name="T117" fmla="*/ 144 h 2008"/>
              <a:gd name="T118" fmla="*/ 2002 w 2002"/>
              <a:gd name="T119" fmla="*/ 174 h 2008"/>
              <a:gd name="T120" fmla="*/ 1785 w 2002"/>
              <a:gd name="T121" fmla="*/ 298 h 2008"/>
              <a:gd name="T122" fmla="*/ 1813 w 2002"/>
              <a:gd name="T123" fmla="*/ 1 h 2008"/>
              <a:gd name="T124" fmla="*/ 1723 w 2002"/>
              <a:gd name="T125" fmla="*/ 103 h 20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002" h="2008">
                <a:moveTo>
                  <a:pt x="429" y="1744"/>
                </a:moveTo>
                <a:cubicBezTo>
                  <a:pt x="434" y="1746"/>
                  <a:pt x="437" y="1748"/>
                  <a:pt x="439" y="1750"/>
                </a:cubicBezTo>
                <a:cubicBezTo>
                  <a:pt x="441" y="1752"/>
                  <a:pt x="442" y="1754"/>
                  <a:pt x="442" y="1756"/>
                </a:cubicBezTo>
                <a:cubicBezTo>
                  <a:pt x="442" y="1759"/>
                  <a:pt x="441" y="1761"/>
                  <a:pt x="438" y="1764"/>
                </a:cubicBezTo>
                <a:cubicBezTo>
                  <a:pt x="436" y="1768"/>
                  <a:pt x="432" y="1772"/>
                  <a:pt x="427" y="1776"/>
                </a:cubicBezTo>
                <a:cubicBezTo>
                  <a:pt x="423" y="1781"/>
                  <a:pt x="419" y="1785"/>
                  <a:pt x="416" y="1787"/>
                </a:cubicBezTo>
                <a:cubicBezTo>
                  <a:pt x="413" y="1790"/>
                  <a:pt x="410" y="1792"/>
                  <a:pt x="408" y="1793"/>
                </a:cubicBezTo>
                <a:cubicBezTo>
                  <a:pt x="406" y="1793"/>
                  <a:pt x="404" y="1794"/>
                  <a:pt x="403" y="1794"/>
                </a:cubicBezTo>
                <a:cubicBezTo>
                  <a:pt x="401" y="1793"/>
                  <a:pt x="399" y="1793"/>
                  <a:pt x="397" y="1792"/>
                </a:cubicBezTo>
                <a:lnTo>
                  <a:pt x="300" y="1745"/>
                </a:lnTo>
                <a:lnTo>
                  <a:pt x="176" y="1869"/>
                </a:lnTo>
                <a:lnTo>
                  <a:pt x="223" y="1964"/>
                </a:lnTo>
                <a:cubicBezTo>
                  <a:pt x="224" y="1966"/>
                  <a:pt x="225" y="1968"/>
                  <a:pt x="225" y="1970"/>
                </a:cubicBezTo>
                <a:cubicBezTo>
                  <a:pt x="225" y="1971"/>
                  <a:pt x="225" y="1973"/>
                  <a:pt x="224" y="1975"/>
                </a:cubicBezTo>
                <a:cubicBezTo>
                  <a:pt x="223" y="1978"/>
                  <a:pt x="222" y="1980"/>
                  <a:pt x="219" y="1983"/>
                </a:cubicBezTo>
                <a:cubicBezTo>
                  <a:pt x="217" y="1986"/>
                  <a:pt x="214" y="1990"/>
                  <a:pt x="210" y="1994"/>
                </a:cubicBezTo>
                <a:cubicBezTo>
                  <a:pt x="205" y="1998"/>
                  <a:pt x="201" y="2002"/>
                  <a:pt x="198" y="2004"/>
                </a:cubicBezTo>
                <a:cubicBezTo>
                  <a:pt x="195" y="2007"/>
                  <a:pt x="192" y="2008"/>
                  <a:pt x="190" y="2008"/>
                </a:cubicBezTo>
                <a:cubicBezTo>
                  <a:pt x="188" y="2008"/>
                  <a:pt x="186" y="2007"/>
                  <a:pt x="184" y="2005"/>
                </a:cubicBezTo>
                <a:cubicBezTo>
                  <a:pt x="182" y="2003"/>
                  <a:pt x="180" y="2000"/>
                  <a:pt x="177" y="1995"/>
                </a:cubicBezTo>
                <a:lnTo>
                  <a:pt x="1" y="1620"/>
                </a:lnTo>
                <a:cubicBezTo>
                  <a:pt x="0" y="1618"/>
                  <a:pt x="0" y="1615"/>
                  <a:pt x="0" y="1613"/>
                </a:cubicBezTo>
                <a:cubicBezTo>
                  <a:pt x="0" y="1611"/>
                  <a:pt x="0" y="1609"/>
                  <a:pt x="1" y="1606"/>
                </a:cubicBezTo>
                <a:cubicBezTo>
                  <a:pt x="3" y="1604"/>
                  <a:pt x="5" y="1601"/>
                  <a:pt x="8" y="1598"/>
                </a:cubicBezTo>
                <a:cubicBezTo>
                  <a:pt x="10" y="1595"/>
                  <a:pt x="14" y="1591"/>
                  <a:pt x="19" y="1586"/>
                </a:cubicBezTo>
                <a:cubicBezTo>
                  <a:pt x="23" y="1581"/>
                  <a:pt x="28" y="1577"/>
                  <a:pt x="31" y="1574"/>
                </a:cubicBezTo>
                <a:cubicBezTo>
                  <a:pt x="34" y="1571"/>
                  <a:pt x="37" y="1569"/>
                  <a:pt x="40" y="1568"/>
                </a:cubicBezTo>
                <a:cubicBezTo>
                  <a:pt x="43" y="1566"/>
                  <a:pt x="45" y="1566"/>
                  <a:pt x="47" y="1566"/>
                </a:cubicBezTo>
                <a:cubicBezTo>
                  <a:pt x="50" y="1566"/>
                  <a:pt x="52" y="1567"/>
                  <a:pt x="54" y="1568"/>
                </a:cubicBezTo>
                <a:lnTo>
                  <a:pt x="429" y="1744"/>
                </a:lnTo>
                <a:close/>
                <a:moveTo>
                  <a:pt x="58" y="1628"/>
                </a:moveTo>
                <a:lnTo>
                  <a:pt x="58" y="1628"/>
                </a:lnTo>
                <a:lnTo>
                  <a:pt x="155" y="1827"/>
                </a:lnTo>
                <a:lnTo>
                  <a:pt x="258" y="1724"/>
                </a:lnTo>
                <a:lnTo>
                  <a:pt x="58" y="1628"/>
                </a:lnTo>
                <a:close/>
                <a:moveTo>
                  <a:pt x="556" y="1521"/>
                </a:moveTo>
                <a:cubicBezTo>
                  <a:pt x="566" y="1532"/>
                  <a:pt x="574" y="1543"/>
                  <a:pt x="578" y="1555"/>
                </a:cubicBezTo>
                <a:cubicBezTo>
                  <a:pt x="582" y="1567"/>
                  <a:pt x="584" y="1580"/>
                  <a:pt x="582" y="1593"/>
                </a:cubicBezTo>
                <a:cubicBezTo>
                  <a:pt x="581" y="1606"/>
                  <a:pt x="577" y="1618"/>
                  <a:pt x="570" y="1631"/>
                </a:cubicBezTo>
                <a:cubicBezTo>
                  <a:pt x="563" y="1644"/>
                  <a:pt x="553" y="1656"/>
                  <a:pt x="541" y="1668"/>
                </a:cubicBezTo>
                <a:cubicBezTo>
                  <a:pt x="534" y="1676"/>
                  <a:pt x="526" y="1682"/>
                  <a:pt x="518" y="1688"/>
                </a:cubicBezTo>
                <a:cubicBezTo>
                  <a:pt x="511" y="1693"/>
                  <a:pt x="503" y="1698"/>
                  <a:pt x="496" y="1701"/>
                </a:cubicBezTo>
                <a:cubicBezTo>
                  <a:pt x="489" y="1705"/>
                  <a:pt x="483" y="1707"/>
                  <a:pt x="477" y="1709"/>
                </a:cubicBezTo>
                <a:cubicBezTo>
                  <a:pt x="472" y="1711"/>
                  <a:pt x="467" y="1712"/>
                  <a:pt x="464" y="1712"/>
                </a:cubicBezTo>
                <a:cubicBezTo>
                  <a:pt x="461" y="1712"/>
                  <a:pt x="458" y="1711"/>
                  <a:pt x="454" y="1709"/>
                </a:cubicBezTo>
                <a:cubicBezTo>
                  <a:pt x="450" y="1707"/>
                  <a:pt x="446" y="1704"/>
                  <a:pt x="442" y="1699"/>
                </a:cubicBezTo>
                <a:cubicBezTo>
                  <a:pt x="439" y="1696"/>
                  <a:pt x="436" y="1694"/>
                  <a:pt x="435" y="1691"/>
                </a:cubicBezTo>
                <a:cubicBezTo>
                  <a:pt x="433" y="1689"/>
                  <a:pt x="432" y="1687"/>
                  <a:pt x="431" y="1685"/>
                </a:cubicBezTo>
                <a:cubicBezTo>
                  <a:pt x="430" y="1684"/>
                  <a:pt x="430" y="1682"/>
                  <a:pt x="430" y="1681"/>
                </a:cubicBezTo>
                <a:cubicBezTo>
                  <a:pt x="431" y="1679"/>
                  <a:pt x="431" y="1678"/>
                  <a:pt x="432" y="1677"/>
                </a:cubicBezTo>
                <a:cubicBezTo>
                  <a:pt x="434" y="1675"/>
                  <a:pt x="438" y="1674"/>
                  <a:pt x="443" y="1673"/>
                </a:cubicBezTo>
                <a:cubicBezTo>
                  <a:pt x="448" y="1672"/>
                  <a:pt x="455" y="1670"/>
                  <a:pt x="462" y="1667"/>
                </a:cubicBezTo>
                <a:cubicBezTo>
                  <a:pt x="469" y="1665"/>
                  <a:pt x="477" y="1662"/>
                  <a:pt x="486" y="1657"/>
                </a:cubicBezTo>
                <a:cubicBezTo>
                  <a:pt x="494" y="1653"/>
                  <a:pt x="503" y="1646"/>
                  <a:pt x="512" y="1637"/>
                </a:cubicBezTo>
                <a:cubicBezTo>
                  <a:pt x="518" y="1631"/>
                  <a:pt x="523" y="1625"/>
                  <a:pt x="527" y="1618"/>
                </a:cubicBezTo>
                <a:cubicBezTo>
                  <a:pt x="531" y="1611"/>
                  <a:pt x="533" y="1605"/>
                  <a:pt x="534" y="1598"/>
                </a:cubicBezTo>
                <a:cubicBezTo>
                  <a:pt x="535" y="1592"/>
                  <a:pt x="535" y="1586"/>
                  <a:pt x="533" y="1579"/>
                </a:cubicBezTo>
                <a:cubicBezTo>
                  <a:pt x="531" y="1573"/>
                  <a:pt x="527" y="1567"/>
                  <a:pt x="521" y="1562"/>
                </a:cubicBezTo>
                <a:cubicBezTo>
                  <a:pt x="516" y="1556"/>
                  <a:pt x="509" y="1552"/>
                  <a:pt x="502" y="1551"/>
                </a:cubicBezTo>
                <a:cubicBezTo>
                  <a:pt x="495" y="1550"/>
                  <a:pt x="488" y="1551"/>
                  <a:pt x="480" y="1553"/>
                </a:cubicBezTo>
                <a:cubicBezTo>
                  <a:pt x="472" y="1554"/>
                  <a:pt x="464" y="1557"/>
                  <a:pt x="455" y="1561"/>
                </a:cubicBezTo>
                <a:cubicBezTo>
                  <a:pt x="447" y="1565"/>
                  <a:pt x="438" y="1569"/>
                  <a:pt x="429" y="1572"/>
                </a:cubicBezTo>
                <a:cubicBezTo>
                  <a:pt x="420" y="1576"/>
                  <a:pt x="411" y="1580"/>
                  <a:pt x="401" y="1583"/>
                </a:cubicBezTo>
                <a:cubicBezTo>
                  <a:pt x="392" y="1586"/>
                  <a:pt x="382" y="1587"/>
                  <a:pt x="372" y="1587"/>
                </a:cubicBezTo>
                <a:cubicBezTo>
                  <a:pt x="363" y="1587"/>
                  <a:pt x="353" y="1586"/>
                  <a:pt x="344" y="1582"/>
                </a:cubicBezTo>
                <a:cubicBezTo>
                  <a:pt x="334" y="1578"/>
                  <a:pt x="325" y="1572"/>
                  <a:pt x="316" y="1563"/>
                </a:cubicBezTo>
                <a:cubicBezTo>
                  <a:pt x="307" y="1555"/>
                  <a:pt x="301" y="1546"/>
                  <a:pt x="297" y="1535"/>
                </a:cubicBezTo>
                <a:cubicBezTo>
                  <a:pt x="293" y="1524"/>
                  <a:pt x="291" y="1513"/>
                  <a:pt x="292" y="1501"/>
                </a:cubicBezTo>
                <a:cubicBezTo>
                  <a:pt x="292" y="1490"/>
                  <a:pt x="296" y="1477"/>
                  <a:pt x="302" y="1464"/>
                </a:cubicBezTo>
                <a:cubicBezTo>
                  <a:pt x="308" y="1452"/>
                  <a:pt x="317" y="1439"/>
                  <a:pt x="330" y="1427"/>
                </a:cubicBezTo>
                <a:cubicBezTo>
                  <a:pt x="335" y="1421"/>
                  <a:pt x="341" y="1416"/>
                  <a:pt x="347" y="1411"/>
                </a:cubicBezTo>
                <a:cubicBezTo>
                  <a:pt x="354" y="1407"/>
                  <a:pt x="360" y="1403"/>
                  <a:pt x="366" y="1400"/>
                </a:cubicBezTo>
                <a:cubicBezTo>
                  <a:pt x="372" y="1397"/>
                  <a:pt x="377" y="1395"/>
                  <a:pt x="382" y="1393"/>
                </a:cubicBezTo>
                <a:cubicBezTo>
                  <a:pt x="386" y="1392"/>
                  <a:pt x="390" y="1391"/>
                  <a:pt x="393" y="1390"/>
                </a:cubicBezTo>
                <a:cubicBezTo>
                  <a:pt x="396" y="1390"/>
                  <a:pt x="398" y="1390"/>
                  <a:pt x="399" y="1390"/>
                </a:cubicBezTo>
                <a:cubicBezTo>
                  <a:pt x="401" y="1391"/>
                  <a:pt x="402" y="1391"/>
                  <a:pt x="404" y="1392"/>
                </a:cubicBezTo>
                <a:cubicBezTo>
                  <a:pt x="405" y="1393"/>
                  <a:pt x="407" y="1394"/>
                  <a:pt x="408" y="1396"/>
                </a:cubicBezTo>
                <a:cubicBezTo>
                  <a:pt x="410" y="1397"/>
                  <a:pt x="413" y="1399"/>
                  <a:pt x="415" y="1402"/>
                </a:cubicBezTo>
                <a:cubicBezTo>
                  <a:pt x="418" y="1404"/>
                  <a:pt x="420" y="1407"/>
                  <a:pt x="421" y="1409"/>
                </a:cubicBezTo>
                <a:cubicBezTo>
                  <a:pt x="423" y="1411"/>
                  <a:pt x="424" y="1413"/>
                  <a:pt x="425" y="1415"/>
                </a:cubicBezTo>
                <a:cubicBezTo>
                  <a:pt x="426" y="1416"/>
                  <a:pt x="426" y="1418"/>
                  <a:pt x="426" y="1419"/>
                </a:cubicBezTo>
                <a:cubicBezTo>
                  <a:pt x="425" y="1420"/>
                  <a:pt x="425" y="1421"/>
                  <a:pt x="424" y="1422"/>
                </a:cubicBezTo>
                <a:cubicBezTo>
                  <a:pt x="423" y="1424"/>
                  <a:pt x="420" y="1425"/>
                  <a:pt x="415" y="1426"/>
                </a:cubicBezTo>
                <a:cubicBezTo>
                  <a:pt x="411" y="1427"/>
                  <a:pt x="406" y="1428"/>
                  <a:pt x="400" y="1431"/>
                </a:cubicBezTo>
                <a:cubicBezTo>
                  <a:pt x="394" y="1433"/>
                  <a:pt x="387" y="1436"/>
                  <a:pt x="380" y="1440"/>
                </a:cubicBezTo>
                <a:cubicBezTo>
                  <a:pt x="373" y="1444"/>
                  <a:pt x="366" y="1449"/>
                  <a:pt x="358" y="1456"/>
                </a:cubicBezTo>
                <a:cubicBezTo>
                  <a:pt x="352" y="1463"/>
                  <a:pt x="347" y="1469"/>
                  <a:pt x="344" y="1475"/>
                </a:cubicBezTo>
                <a:cubicBezTo>
                  <a:pt x="340" y="1482"/>
                  <a:pt x="338" y="1488"/>
                  <a:pt x="338" y="1494"/>
                </a:cubicBezTo>
                <a:cubicBezTo>
                  <a:pt x="337" y="1500"/>
                  <a:pt x="338" y="1505"/>
                  <a:pt x="340" y="1510"/>
                </a:cubicBezTo>
                <a:cubicBezTo>
                  <a:pt x="342" y="1516"/>
                  <a:pt x="345" y="1520"/>
                  <a:pt x="350" y="1525"/>
                </a:cubicBezTo>
                <a:cubicBezTo>
                  <a:pt x="356" y="1531"/>
                  <a:pt x="362" y="1534"/>
                  <a:pt x="369" y="1535"/>
                </a:cubicBezTo>
                <a:cubicBezTo>
                  <a:pt x="376" y="1536"/>
                  <a:pt x="384" y="1536"/>
                  <a:pt x="392" y="1534"/>
                </a:cubicBezTo>
                <a:cubicBezTo>
                  <a:pt x="400" y="1532"/>
                  <a:pt x="408" y="1529"/>
                  <a:pt x="417" y="1525"/>
                </a:cubicBezTo>
                <a:cubicBezTo>
                  <a:pt x="426" y="1522"/>
                  <a:pt x="434" y="1518"/>
                  <a:pt x="444" y="1514"/>
                </a:cubicBezTo>
                <a:cubicBezTo>
                  <a:pt x="453" y="1510"/>
                  <a:pt x="462" y="1506"/>
                  <a:pt x="472" y="1503"/>
                </a:cubicBezTo>
                <a:cubicBezTo>
                  <a:pt x="481" y="1500"/>
                  <a:pt x="491" y="1498"/>
                  <a:pt x="500" y="1498"/>
                </a:cubicBezTo>
                <a:cubicBezTo>
                  <a:pt x="510" y="1498"/>
                  <a:pt x="519" y="1499"/>
                  <a:pt x="528" y="1503"/>
                </a:cubicBezTo>
                <a:cubicBezTo>
                  <a:pt x="538" y="1506"/>
                  <a:pt x="547" y="1512"/>
                  <a:pt x="556" y="1521"/>
                </a:cubicBezTo>
                <a:close/>
                <a:moveTo>
                  <a:pt x="753" y="1224"/>
                </a:moveTo>
                <a:cubicBezTo>
                  <a:pt x="771" y="1242"/>
                  <a:pt x="785" y="1260"/>
                  <a:pt x="795" y="1278"/>
                </a:cubicBezTo>
                <a:cubicBezTo>
                  <a:pt x="806" y="1297"/>
                  <a:pt x="812" y="1315"/>
                  <a:pt x="815" y="1332"/>
                </a:cubicBezTo>
                <a:cubicBezTo>
                  <a:pt x="817" y="1350"/>
                  <a:pt x="815" y="1367"/>
                  <a:pt x="810" y="1383"/>
                </a:cubicBezTo>
                <a:cubicBezTo>
                  <a:pt x="804" y="1400"/>
                  <a:pt x="794" y="1416"/>
                  <a:pt x="780" y="1430"/>
                </a:cubicBezTo>
                <a:cubicBezTo>
                  <a:pt x="773" y="1436"/>
                  <a:pt x="767" y="1441"/>
                  <a:pt x="761" y="1445"/>
                </a:cubicBezTo>
                <a:cubicBezTo>
                  <a:pt x="754" y="1449"/>
                  <a:pt x="747" y="1452"/>
                  <a:pt x="740" y="1455"/>
                </a:cubicBezTo>
                <a:cubicBezTo>
                  <a:pt x="732" y="1457"/>
                  <a:pt x="724" y="1459"/>
                  <a:pt x="715" y="1459"/>
                </a:cubicBezTo>
                <a:cubicBezTo>
                  <a:pt x="706" y="1460"/>
                  <a:pt x="696" y="1461"/>
                  <a:pt x="686" y="1461"/>
                </a:cubicBezTo>
                <a:lnTo>
                  <a:pt x="789" y="1564"/>
                </a:lnTo>
                <a:cubicBezTo>
                  <a:pt x="790" y="1565"/>
                  <a:pt x="791" y="1567"/>
                  <a:pt x="791" y="1568"/>
                </a:cubicBezTo>
                <a:cubicBezTo>
                  <a:pt x="791" y="1570"/>
                  <a:pt x="791" y="1572"/>
                  <a:pt x="790" y="1574"/>
                </a:cubicBezTo>
                <a:cubicBezTo>
                  <a:pt x="790" y="1576"/>
                  <a:pt x="788" y="1578"/>
                  <a:pt x="786" y="1581"/>
                </a:cubicBezTo>
                <a:cubicBezTo>
                  <a:pt x="784" y="1584"/>
                  <a:pt x="781" y="1587"/>
                  <a:pt x="777" y="1591"/>
                </a:cubicBezTo>
                <a:cubicBezTo>
                  <a:pt x="773" y="1594"/>
                  <a:pt x="770" y="1597"/>
                  <a:pt x="767" y="1599"/>
                </a:cubicBezTo>
                <a:cubicBezTo>
                  <a:pt x="765" y="1601"/>
                  <a:pt x="762" y="1603"/>
                  <a:pt x="760" y="1604"/>
                </a:cubicBezTo>
                <a:cubicBezTo>
                  <a:pt x="758" y="1605"/>
                  <a:pt x="756" y="1605"/>
                  <a:pt x="755" y="1604"/>
                </a:cubicBezTo>
                <a:cubicBezTo>
                  <a:pt x="754" y="1604"/>
                  <a:pt x="752" y="1603"/>
                  <a:pt x="751" y="1602"/>
                </a:cubicBezTo>
                <a:lnTo>
                  <a:pt x="463" y="1314"/>
                </a:lnTo>
                <a:cubicBezTo>
                  <a:pt x="461" y="1313"/>
                  <a:pt x="461" y="1311"/>
                  <a:pt x="460" y="1310"/>
                </a:cubicBezTo>
                <a:cubicBezTo>
                  <a:pt x="460" y="1309"/>
                  <a:pt x="460" y="1307"/>
                  <a:pt x="461" y="1305"/>
                </a:cubicBezTo>
                <a:cubicBezTo>
                  <a:pt x="461" y="1303"/>
                  <a:pt x="463" y="1301"/>
                  <a:pt x="465" y="1298"/>
                </a:cubicBezTo>
                <a:cubicBezTo>
                  <a:pt x="467" y="1296"/>
                  <a:pt x="469" y="1293"/>
                  <a:pt x="472" y="1290"/>
                </a:cubicBezTo>
                <a:cubicBezTo>
                  <a:pt x="475" y="1287"/>
                  <a:pt x="478" y="1285"/>
                  <a:pt x="480" y="1283"/>
                </a:cubicBezTo>
                <a:cubicBezTo>
                  <a:pt x="483" y="1281"/>
                  <a:pt x="485" y="1280"/>
                  <a:pt x="487" y="1279"/>
                </a:cubicBezTo>
                <a:cubicBezTo>
                  <a:pt x="489" y="1278"/>
                  <a:pt x="491" y="1278"/>
                  <a:pt x="492" y="1278"/>
                </a:cubicBezTo>
                <a:cubicBezTo>
                  <a:pt x="493" y="1278"/>
                  <a:pt x="495" y="1279"/>
                  <a:pt x="496" y="1281"/>
                </a:cubicBezTo>
                <a:lnTo>
                  <a:pt x="524" y="1308"/>
                </a:lnTo>
                <a:cubicBezTo>
                  <a:pt x="524" y="1296"/>
                  <a:pt x="524" y="1284"/>
                  <a:pt x="525" y="1274"/>
                </a:cubicBezTo>
                <a:cubicBezTo>
                  <a:pt x="526" y="1263"/>
                  <a:pt x="528" y="1253"/>
                  <a:pt x="531" y="1244"/>
                </a:cubicBezTo>
                <a:cubicBezTo>
                  <a:pt x="534" y="1235"/>
                  <a:pt x="537" y="1227"/>
                  <a:pt x="542" y="1219"/>
                </a:cubicBezTo>
                <a:cubicBezTo>
                  <a:pt x="546" y="1211"/>
                  <a:pt x="552" y="1204"/>
                  <a:pt x="559" y="1197"/>
                </a:cubicBezTo>
                <a:cubicBezTo>
                  <a:pt x="574" y="1182"/>
                  <a:pt x="590" y="1172"/>
                  <a:pt x="606" y="1167"/>
                </a:cubicBezTo>
                <a:cubicBezTo>
                  <a:pt x="622" y="1163"/>
                  <a:pt x="639" y="1162"/>
                  <a:pt x="656" y="1165"/>
                </a:cubicBezTo>
                <a:cubicBezTo>
                  <a:pt x="672" y="1169"/>
                  <a:pt x="689" y="1176"/>
                  <a:pt x="705" y="1186"/>
                </a:cubicBezTo>
                <a:cubicBezTo>
                  <a:pt x="722" y="1196"/>
                  <a:pt x="738" y="1209"/>
                  <a:pt x="753" y="1224"/>
                </a:cubicBezTo>
                <a:close/>
                <a:moveTo>
                  <a:pt x="718" y="1268"/>
                </a:moveTo>
                <a:cubicBezTo>
                  <a:pt x="707" y="1257"/>
                  <a:pt x="696" y="1248"/>
                  <a:pt x="685" y="1239"/>
                </a:cubicBezTo>
                <a:cubicBezTo>
                  <a:pt x="673" y="1231"/>
                  <a:pt x="662" y="1225"/>
                  <a:pt x="650" y="1221"/>
                </a:cubicBezTo>
                <a:cubicBezTo>
                  <a:pt x="639" y="1218"/>
                  <a:pt x="627" y="1217"/>
                  <a:pt x="616" y="1219"/>
                </a:cubicBezTo>
                <a:cubicBezTo>
                  <a:pt x="605" y="1221"/>
                  <a:pt x="594" y="1227"/>
                  <a:pt x="584" y="1237"/>
                </a:cubicBezTo>
                <a:cubicBezTo>
                  <a:pt x="579" y="1242"/>
                  <a:pt x="575" y="1247"/>
                  <a:pt x="572" y="1253"/>
                </a:cubicBezTo>
                <a:cubicBezTo>
                  <a:pt x="569" y="1260"/>
                  <a:pt x="566" y="1267"/>
                  <a:pt x="564" y="1275"/>
                </a:cubicBezTo>
                <a:cubicBezTo>
                  <a:pt x="563" y="1283"/>
                  <a:pt x="562" y="1292"/>
                  <a:pt x="561" y="1303"/>
                </a:cubicBezTo>
                <a:cubicBezTo>
                  <a:pt x="561" y="1313"/>
                  <a:pt x="562" y="1325"/>
                  <a:pt x="563" y="1339"/>
                </a:cubicBezTo>
                <a:lnTo>
                  <a:pt x="645" y="1421"/>
                </a:lnTo>
                <a:cubicBezTo>
                  <a:pt x="668" y="1423"/>
                  <a:pt x="688" y="1423"/>
                  <a:pt x="704" y="1420"/>
                </a:cubicBezTo>
                <a:cubicBezTo>
                  <a:pt x="720" y="1417"/>
                  <a:pt x="733" y="1411"/>
                  <a:pt x="744" y="1401"/>
                </a:cubicBezTo>
                <a:cubicBezTo>
                  <a:pt x="753" y="1391"/>
                  <a:pt x="759" y="1381"/>
                  <a:pt x="761" y="1369"/>
                </a:cubicBezTo>
                <a:cubicBezTo>
                  <a:pt x="764" y="1358"/>
                  <a:pt x="763" y="1346"/>
                  <a:pt x="760" y="1334"/>
                </a:cubicBezTo>
                <a:cubicBezTo>
                  <a:pt x="756" y="1322"/>
                  <a:pt x="751" y="1311"/>
                  <a:pt x="743" y="1299"/>
                </a:cubicBezTo>
                <a:cubicBezTo>
                  <a:pt x="736" y="1288"/>
                  <a:pt x="727" y="1277"/>
                  <a:pt x="718" y="1268"/>
                </a:cubicBezTo>
                <a:close/>
                <a:moveTo>
                  <a:pt x="1074" y="1116"/>
                </a:moveTo>
                <a:cubicBezTo>
                  <a:pt x="1076" y="1118"/>
                  <a:pt x="1076" y="1120"/>
                  <a:pt x="1076" y="1122"/>
                </a:cubicBezTo>
                <a:cubicBezTo>
                  <a:pt x="1076" y="1124"/>
                  <a:pt x="1075" y="1127"/>
                  <a:pt x="1073" y="1129"/>
                </a:cubicBezTo>
                <a:cubicBezTo>
                  <a:pt x="1071" y="1132"/>
                  <a:pt x="1068" y="1135"/>
                  <a:pt x="1064" y="1139"/>
                </a:cubicBezTo>
                <a:cubicBezTo>
                  <a:pt x="1060" y="1143"/>
                  <a:pt x="1057" y="1146"/>
                  <a:pt x="1054" y="1148"/>
                </a:cubicBezTo>
                <a:cubicBezTo>
                  <a:pt x="1051" y="1150"/>
                  <a:pt x="1049" y="1151"/>
                  <a:pt x="1047" y="1151"/>
                </a:cubicBezTo>
                <a:cubicBezTo>
                  <a:pt x="1045" y="1151"/>
                  <a:pt x="1043" y="1151"/>
                  <a:pt x="1041" y="1149"/>
                </a:cubicBezTo>
                <a:lnTo>
                  <a:pt x="1020" y="1128"/>
                </a:lnTo>
                <a:cubicBezTo>
                  <a:pt x="1021" y="1147"/>
                  <a:pt x="1019" y="1164"/>
                  <a:pt x="1013" y="1181"/>
                </a:cubicBezTo>
                <a:cubicBezTo>
                  <a:pt x="1007" y="1197"/>
                  <a:pt x="998" y="1212"/>
                  <a:pt x="986" y="1224"/>
                </a:cubicBezTo>
                <a:cubicBezTo>
                  <a:pt x="975" y="1235"/>
                  <a:pt x="964" y="1243"/>
                  <a:pt x="952" y="1249"/>
                </a:cubicBezTo>
                <a:cubicBezTo>
                  <a:pt x="940" y="1255"/>
                  <a:pt x="929" y="1258"/>
                  <a:pt x="917" y="1259"/>
                </a:cubicBezTo>
                <a:cubicBezTo>
                  <a:pt x="906" y="1260"/>
                  <a:pt x="894" y="1258"/>
                  <a:pt x="883" y="1254"/>
                </a:cubicBezTo>
                <a:cubicBezTo>
                  <a:pt x="872" y="1250"/>
                  <a:pt x="861" y="1243"/>
                  <a:pt x="851" y="1233"/>
                </a:cubicBezTo>
                <a:cubicBezTo>
                  <a:pt x="840" y="1221"/>
                  <a:pt x="832" y="1209"/>
                  <a:pt x="828" y="1195"/>
                </a:cubicBezTo>
                <a:cubicBezTo>
                  <a:pt x="824" y="1182"/>
                  <a:pt x="824" y="1168"/>
                  <a:pt x="827" y="1154"/>
                </a:cubicBezTo>
                <a:cubicBezTo>
                  <a:pt x="830" y="1139"/>
                  <a:pt x="837" y="1124"/>
                  <a:pt x="847" y="1108"/>
                </a:cubicBezTo>
                <a:cubicBezTo>
                  <a:pt x="857" y="1093"/>
                  <a:pt x="870" y="1077"/>
                  <a:pt x="886" y="1061"/>
                </a:cubicBezTo>
                <a:lnTo>
                  <a:pt x="915" y="1032"/>
                </a:lnTo>
                <a:lnTo>
                  <a:pt x="899" y="1016"/>
                </a:lnTo>
                <a:cubicBezTo>
                  <a:pt x="891" y="1008"/>
                  <a:pt x="883" y="1002"/>
                  <a:pt x="875" y="998"/>
                </a:cubicBezTo>
                <a:cubicBezTo>
                  <a:pt x="867" y="993"/>
                  <a:pt x="859" y="991"/>
                  <a:pt x="852" y="991"/>
                </a:cubicBezTo>
                <a:cubicBezTo>
                  <a:pt x="844" y="990"/>
                  <a:pt x="836" y="992"/>
                  <a:pt x="828" y="996"/>
                </a:cubicBezTo>
                <a:cubicBezTo>
                  <a:pt x="820" y="1000"/>
                  <a:pt x="811" y="1006"/>
                  <a:pt x="803" y="1015"/>
                </a:cubicBezTo>
                <a:cubicBezTo>
                  <a:pt x="793" y="1024"/>
                  <a:pt x="786" y="1034"/>
                  <a:pt x="781" y="1043"/>
                </a:cubicBezTo>
                <a:cubicBezTo>
                  <a:pt x="776" y="1053"/>
                  <a:pt x="772" y="1062"/>
                  <a:pt x="769" y="1070"/>
                </a:cubicBezTo>
                <a:cubicBezTo>
                  <a:pt x="766" y="1078"/>
                  <a:pt x="764" y="1085"/>
                  <a:pt x="762" y="1091"/>
                </a:cubicBezTo>
                <a:cubicBezTo>
                  <a:pt x="761" y="1097"/>
                  <a:pt x="759" y="1101"/>
                  <a:pt x="757" y="1103"/>
                </a:cubicBezTo>
                <a:cubicBezTo>
                  <a:pt x="756" y="1104"/>
                  <a:pt x="754" y="1105"/>
                  <a:pt x="753" y="1105"/>
                </a:cubicBezTo>
                <a:cubicBezTo>
                  <a:pt x="751" y="1106"/>
                  <a:pt x="750" y="1106"/>
                  <a:pt x="748" y="1105"/>
                </a:cubicBezTo>
                <a:cubicBezTo>
                  <a:pt x="746" y="1104"/>
                  <a:pt x="744" y="1103"/>
                  <a:pt x="742" y="1102"/>
                </a:cubicBezTo>
                <a:cubicBezTo>
                  <a:pt x="739" y="1100"/>
                  <a:pt x="737" y="1098"/>
                  <a:pt x="735" y="1096"/>
                </a:cubicBezTo>
                <a:cubicBezTo>
                  <a:pt x="731" y="1092"/>
                  <a:pt x="728" y="1089"/>
                  <a:pt x="727" y="1086"/>
                </a:cubicBezTo>
                <a:cubicBezTo>
                  <a:pt x="725" y="1083"/>
                  <a:pt x="724" y="1080"/>
                  <a:pt x="724" y="1076"/>
                </a:cubicBezTo>
                <a:cubicBezTo>
                  <a:pt x="724" y="1072"/>
                  <a:pt x="725" y="1066"/>
                  <a:pt x="728" y="1058"/>
                </a:cubicBezTo>
                <a:cubicBezTo>
                  <a:pt x="730" y="1051"/>
                  <a:pt x="734" y="1042"/>
                  <a:pt x="738" y="1033"/>
                </a:cubicBezTo>
                <a:cubicBezTo>
                  <a:pt x="742" y="1025"/>
                  <a:pt x="748" y="1016"/>
                  <a:pt x="754" y="1006"/>
                </a:cubicBezTo>
                <a:cubicBezTo>
                  <a:pt x="760" y="997"/>
                  <a:pt x="767" y="989"/>
                  <a:pt x="775" y="981"/>
                </a:cubicBezTo>
                <a:cubicBezTo>
                  <a:pt x="790" y="966"/>
                  <a:pt x="805" y="955"/>
                  <a:pt x="818" y="948"/>
                </a:cubicBezTo>
                <a:cubicBezTo>
                  <a:pt x="832" y="941"/>
                  <a:pt x="845" y="937"/>
                  <a:pt x="858" y="937"/>
                </a:cubicBezTo>
                <a:cubicBezTo>
                  <a:pt x="871" y="938"/>
                  <a:pt x="884" y="941"/>
                  <a:pt x="896" y="948"/>
                </a:cubicBezTo>
                <a:cubicBezTo>
                  <a:pt x="909" y="954"/>
                  <a:pt x="922" y="964"/>
                  <a:pt x="935" y="977"/>
                </a:cubicBezTo>
                <a:lnTo>
                  <a:pt x="1074" y="1116"/>
                </a:lnTo>
                <a:close/>
                <a:moveTo>
                  <a:pt x="942" y="1060"/>
                </a:moveTo>
                <a:lnTo>
                  <a:pt x="910" y="1092"/>
                </a:lnTo>
                <a:cubicBezTo>
                  <a:pt x="899" y="1102"/>
                  <a:pt x="891" y="1112"/>
                  <a:pt x="885" y="1122"/>
                </a:cubicBezTo>
                <a:cubicBezTo>
                  <a:pt x="879" y="1131"/>
                  <a:pt x="875" y="1140"/>
                  <a:pt x="874" y="1148"/>
                </a:cubicBezTo>
                <a:cubicBezTo>
                  <a:pt x="872" y="1157"/>
                  <a:pt x="873" y="1165"/>
                  <a:pt x="875" y="1172"/>
                </a:cubicBezTo>
                <a:cubicBezTo>
                  <a:pt x="878" y="1179"/>
                  <a:pt x="882" y="1186"/>
                  <a:pt x="888" y="1192"/>
                </a:cubicBezTo>
                <a:cubicBezTo>
                  <a:pt x="899" y="1203"/>
                  <a:pt x="911" y="1208"/>
                  <a:pt x="924" y="1207"/>
                </a:cubicBezTo>
                <a:cubicBezTo>
                  <a:pt x="937" y="1207"/>
                  <a:pt x="950" y="1201"/>
                  <a:pt x="962" y="1188"/>
                </a:cubicBezTo>
                <a:cubicBezTo>
                  <a:pt x="972" y="1178"/>
                  <a:pt x="979" y="1167"/>
                  <a:pt x="982" y="1153"/>
                </a:cubicBezTo>
                <a:cubicBezTo>
                  <a:pt x="986" y="1140"/>
                  <a:pt x="987" y="1123"/>
                  <a:pt x="986" y="1103"/>
                </a:cubicBezTo>
                <a:lnTo>
                  <a:pt x="942" y="1060"/>
                </a:lnTo>
                <a:close/>
                <a:moveTo>
                  <a:pt x="1072" y="732"/>
                </a:moveTo>
                <a:cubicBezTo>
                  <a:pt x="1075" y="735"/>
                  <a:pt x="1078" y="738"/>
                  <a:pt x="1080" y="740"/>
                </a:cubicBezTo>
                <a:cubicBezTo>
                  <a:pt x="1082" y="743"/>
                  <a:pt x="1084" y="745"/>
                  <a:pt x="1085" y="747"/>
                </a:cubicBezTo>
                <a:cubicBezTo>
                  <a:pt x="1086" y="748"/>
                  <a:pt x="1086" y="750"/>
                  <a:pt x="1086" y="751"/>
                </a:cubicBezTo>
                <a:cubicBezTo>
                  <a:pt x="1086" y="753"/>
                  <a:pt x="1085" y="754"/>
                  <a:pt x="1084" y="755"/>
                </a:cubicBezTo>
                <a:cubicBezTo>
                  <a:pt x="1083" y="757"/>
                  <a:pt x="1081" y="758"/>
                  <a:pt x="1079" y="759"/>
                </a:cubicBezTo>
                <a:cubicBezTo>
                  <a:pt x="1076" y="760"/>
                  <a:pt x="1074" y="761"/>
                  <a:pt x="1071" y="763"/>
                </a:cubicBezTo>
                <a:cubicBezTo>
                  <a:pt x="1068" y="764"/>
                  <a:pt x="1065" y="766"/>
                  <a:pt x="1061" y="768"/>
                </a:cubicBezTo>
                <a:cubicBezTo>
                  <a:pt x="1058" y="770"/>
                  <a:pt x="1055" y="773"/>
                  <a:pt x="1051" y="776"/>
                </a:cubicBezTo>
                <a:cubicBezTo>
                  <a:pt x="1048" y="780"/>
                  <a:pt x="1045" y="784"/>
                  <a:pt x="1042" y="790"/>
                </a:cubicBezTo>
                <a:cubicBezTo>
                  <a:pt x="1040" y="795"/>
                  <a:pt x="1039" y="801"/>
                  <a:pt x="1038" y="809"/>
                </a:cubicBezTo>
                <a:cubicBezTo>
                  <a:pt x="1038" y="816"/>
                  <a:pt x="1038" y="825"/>
                  <a:pt x="1040" y="836"/>
                </a:cubicBezTo>
                <a:cubicBezTo>
                  <a:pt x="1041" y="846"/>
                  <a:pt x="1043" y="858"/>
                  <a:pt x="1046" y="872"/>
                </a:cubicBezTo>
                <a:lnTo>
                  <a:pt x="1182" y="1007"/>
                </a:lnTo>
                <a:cubicBezTo>
                  <a:pt x="1183" y="1008"/>
                  <a:pt x="1184" y="1010"/>
                  <a:pt x="1184" y="1011"/>
                </a:cubicBezTo>
                <a:cubicBezTo>
                  <a:pt x="1185" y="1013"/>
                  <a:pt x="1184" y="1014"/>
                  <a:pt x="1183" y="1016"/>
                </a:cubicBezTo>
                <a:cubicBezTo>
                  <a:pt x="1183" y="1018"/>
                  <a:pt x="1181" y="1021"/>
                  <a:pt x="1179" y="1024"/>
                </a:cubicBezTo>
                <a:cubicBezTo>
                  <a:pt x="1177" y="1026"/>
                  <a:pt x="1174" y="1030"/>
                  <a:pt x="1170" y="1033"/>
                </a:cubicBezTo>
                <a:cubicBezTo>
                  <a:pt x="1167" y="1037"/>
                  <a:pt x="1163" y="1040"/>
                  <a:pt x="1161" y="1042"/>
                </a:cubicBezTo>
                <a:cubicBezTo>
                  <a:pt x="1158" y="1044"/>
                  <a:pt x="1155" y="1046"/>
                  <a:pt x="1153" y="1047"/>
                </a:cubicBezTo>
                <a:cubicBezTo>
                  <a:pt x="1151" y="1047"/>
                  <a:pt x="1150" y="1048"/>
                  <a:pt x="1148" y="1047"/>
                </a:cubicBezTo>
                <a:cubicBezTo>
                  <a:pt x="1147" y="1047"/>
                  <a:pt x="1145" y="1046"/>
                  <a:pt x="1144" y="1045"/>
                </a:cubicBezTo>
                <a:lnTo>
                  <a:pt x="938" y="839"/>
                </a:lnTo>
                <a:cubicBezTo>
                  <a:pt x="937" y="838"/>
                  <a:pt x="936" y="836"/>
                  <a:pt x="936" y="835"/>
                </a:cubicBezTo>
                <a:cubicBezTo>
                  <a:pt x="935" y="834"/>
                  <a:pt x="935" y="832"/>
                  <a:pt x="936" y="830"/>
                </a:cubicBezTo>
                <a:cubicBezTo>
                  <a:pt x="937" y="828"/>
                  <a:pt x="938" y="826"/>
                  <a:pt x="940" y="823"/>
                </a:cubicBezTo>
                <a:cubicBezTo>
                  <a:pt x="942" y="821"/>
                  <a:pt x="945" y="818"/>
                  <a:pt x="948" y="814"/>
                </a:cubicBezTo>
                <a:cubicBezTo>
                  <a:pt x="951" y="811"/>
                  <a:pt x="954" y="808"/>
                  <a:pt x="957" y="806"/>
                </a:cubicBezTo>
                <a:cubicBezTo>
                  <a:pt x="959" y="804"/>
                  <a:pt x="961" y="803"/>
                  <a:pt x="963" y="803"/>
                </a:cubicBezTo>
                <a:cubicBezTo>
                  <a:pt x="965" y="802"/>
                  <a:pt x="967" y="802"/>
                  <a:pt x="968" y="802"/>
                </a:cubicBezTo>
                <a:cubicBezTo>
                  <a:pt x="970" y="803"/>
                  <a:pt x="971" y="803"/>
                  <a:pt x="972" y="805"/>
                </a:cubicBezTo>
                <a:lnTo>
                  <a:pt x="1002" y="835"/>
                </a:lnTo>
                <a:cubicBezTo>
                  <a:pt x="1000" y="821"/>
                  <a:pt x="998" y="809"/>
                  <a:pt x="998" y="799"/>
                </a:cubicBezTo>
                <a:cubicBezTo>
                  <a:pt x="998" y="788"/>
                  <a:pt x="998" y="780"/>
                  <a:pt x="1000" y="772"/>
                </a:cubicBezTo>
                <a:cubicBezTo>
                  <a:pt x="1001" y="765"/>
                  <a:pt x="1004" y="758"/>
                  <a:pt x="1007" y="753"/>
                </a:cubicBezTo>
                <a:cubicBezTo>
                  <a:pt x="1010" y="747"/>
                  <a:pt x="1014" y="742"/>
                  <a:pt x="1018" y="738"/>
                </a:cubicBezTo>
                <a:cubicBezTo>
                  <a:pt x="1020" y="736"/>
                  <a:pt x="1023" y="734"/>
                  <a:pt x="1025" y="731"/>
                </a:cubicBezTo>
                <a:cubicBezTo>
                  <a:pt x="1028" y="729"/>
                  <a:pt x="1031" y="727"/>
                  <a:pt x="1034" y="725"/>
                </a:cubicBezTo>
                <a:cubicBezTo>
                  <a:pt x="1038" y="723"/>
                  <a:pt x="1041" y="721"/>
                  <a:pt x="1044" y="719"/>
                </a:cubicBezTo>
                <a:cubicBezTo>
                  <a:pt x="1047" y="718"/>
                  <a:pt x="1049" y="717"/>
                  <a:pt x="1051" y="717"/>
                </a:cubicBezTo>
                <a:cubicBezTo>
                  <a:pt x="1053" y="717"/>
                  <a:pt x="1054" y="717"/>
                  <a:pt x="1055" y="717"/>
                </a:cubicBezTo>
                <a:cubicBezTo>
                  <a:pt x="1056" y="718"/>
                  <a:pt x="1057" y="718"/>
                  <a:pt x="1058" y="719"/>
                </a:cubicBezTo>
                <a:cubicBezTo>
                  <a:pt x="1060" y="720"/>
                  <a:pt x="1061" y="721"/>
                  <a:pt x="1064" y="723"/>
                </a:cubicBezTo>
                <a:cubicBezTo>
                  <a:pt x="1066" y="725"/>
                  <a:pt x="1069" y="728"/>
                  <a:pt x="1072" y="732"/>
                </a:cubicBezTo>
                <a:close/>
                <a:moveTo>
                  <a:pt x="1400" y="759"/>
                </a:moveTo>
                <a:cubicBezTo>
                  <a:pt x="1405" y="763"/>
                  <a:pt x="1408" y="767"/>
                  <a:pt x="1410" y="770"/>
                </a:cubicBezTo>
                <a:cubicBezTo>
                  <a:pt x="1412" y="773"/>
                  <a:pt x="1413" y="776"/>
                  <a:pt x="1413" y="779"/>
                </a:cubicBezTo>
                <a:cubicBezTo>
                  <a:pt x="1413" y="781"/>
                  <a:pt x="1412" y="784"/>
                  <a:pt x="1411" y="787"/>
                </a:cubicBezTo>
                <a:cubicBezTo>
                  <a:pt x="1410" y="791"/>
                  <a:pt x="1408" y="795"/>
                  <a:pt x="1405" y="798"/>
                </a:cubicBezTo>
                <a:cubicBezTo>
                  <a:pt x="1403" y="802"/>
                  <a:pt x="1400" y="806"/>
                  <a:pt x="1397" y="810"/>
                </a:cubicBezTo>
                <a:cubicBezTo>
                  <a:pt x="1394" y="814"/>
                  <a:pt x="1391" y="818"/>
                  <a:pt x="1387" y="821"/>
                </a:cubicBezTo>
                <a:cubicBezTo>
                  <a:pt x="1376" y="832"/>
                  <a:pt x="1366" y="840"/>
                  <a:pt x="1355" y="845"/>
                </a:cubicBezTo>
                <a:cubicBezTo>
                  <a:pt x="1345" y="849"/>
                  <a:pt x="1334" y="851"/>
                  <a:pt x="1324" y="851"/>
                </a:cubicBezTo>
                <a:cubicBezTo>
                  <a:pt x="1313" y="850"/>
                  <a:pt x="1302" y="846"/>
                  <a:pt x="1291" y="840"/>
                </a:cubicBezTo>
                <a:cubicBezTo>
                  <a:pt x="1280" y="833"/>
                  <a:pt x="1269" y="824"/>
                  <a:pt x="1257" y="812"/>
                </a:cubicBezTo>
                <a:lnTo>
                  <a:pt x="1136" y="691"/>
                </a:lnTo>
                <a:lnTo>
                  <a:pt x="1107" y="720"/>
                </a:lnTo>
                <a:cubicBezTo>
                  <a:pt x="1105" y="722"/>
                  <a:pt x="1102" y="723"/>
                  <a:pt x="1098" y="722"/>
                </a:cubicBezTo>
                <a:cubicBezTo>
                  <a:pt x="1095" y="721"/>
                  <a:pt x="1090" y="718"/>
                  <a:pt x="1084" y="712"/>
                </a:cubicBezTo>
                <a:cubicBezTo>
                  <a:pt x="1081" y="709"/>
                  <a:pt x="1079" y="707"/>
                  <a:pt x="1078" y="704"/>
                </a:cubicBezTo>
                <a:cubicBezTo>
                  <a:pt x="1076" y="702"/>
                  <a:pt x="1075" y="700"/>
                  <a:pt x="1074" y="698"/>
                </a:cubicBezTo>
                <a:cubicBezTo>
                  <a:pt x="1073" y="696"/>
                  <a:pt x="1073" y="694"/>
                  <a:pt x="1074" y="693"/>
                </a:cubicBezTo>
                <a:cubicBezTo>
                  <a:pt x="1074" y="691"/>
                  <a:pt x="1075" y="690"/>
                  <a:pt x="1076" y="688"/>
                </a:cubicBezTo>
                <a:lnTo>
                  <a:pt x="1105" y="660"/>
                </a:lnTo>
                <a:lnTo>
                  <a:pt x="1056" y="611"/>
                </a:lnTo>
                <a:cubicBezTo>
                  <a:pt x="1055" y="610"/>
                  <a:pt x="1054" y="608"/>
                  <a:pt x="1054" y="607"/>
                </a:cubicBezTo>
                <a:cubicBezTo>
                  <a:pt x="1053" y="605"/>
                  <a:pt x="1054" y="604"/>
                  <a:pt x="1054" y="602"/>
                </a:cubicBezTo>
                <a:cubicBezTo>
                  <a:pt x="1055" y="599"/>
                  <a:pt x="1057" y="597"/>
                  <a:pt x="1059" y="594"/>
                </a:cubicBezTo>
                <a:cubicBezTo>
                  <a:pt x="1061" y="591"/>
                  <a:pt x="1064" y="588"/>
                  <a:pt x="1067" y="585"/>
                </a:cubicBezTo>
                <a:cubicBezTo>
                  <a:pt x="1071" y="581"/>
                  <a:pt x="1074" y="578"/>
                  <a:pt x="1077" y="576"/>
                </a:cubicBezTo>
                <a:cubicBezTo>
                  <a:pt x="1080" y="574"/>
                  <a:pt x="1082" y="572"/>
                  <a:pt x="1084" y="571"/>
                </a:cubicBezTo>
                <a:cubicBezTo>
                  <a:pt x="1087" y="571"/>
                  <a:pt x="1088" y="571"/>
                  <a:pt x="1090" y="571"/>
                </a:cubicBezTo>
                <a:cubicBezTo>
                  <a:pt x="1091" y="571"/>
                  <a:pt x="1093" y="572"/>
                  <a:pt x="1094" y="573"/>
                </a:cubicBezTo>
                <a:lnTo>
                  <a:pt x="1143" y="622"/>
                </a:lnTo>
                <a:lnTo>
                  <a:pt x="1196" y="569"/>
                </a:lnTo>
                <a:cubicBezTo>
                  <a:pt x="1197" y="568"/>
                  <a:pt x="1198" y="567"/>
                  <a:pt x="1200" y="567"/>
                </a:cubicBezTo>
                <a:cubicBezTo>
                  <a:pt x="1201" y="566"/>
                  <a:pt x="1203" y="566"/>
                  <a:pt x="1205" y="567"/>
                </a:cubicBezTo>
                <a:cubicBezTo>
                  <a:pt x="1207" y="568"/>
                  <a:pt x="1209" y="569"/>
                  <a:pt x="1211" y="570"/>
                </a:cubicBezTo>
                <a:cubicBezTo>
                  <a:pt x="1214" y="572"/>
                  <a:pt x="1216" y="574"/>
                  <a:pt x="1219" y="577"/>
                </a:cubicBezTo>
                <a:cubicBezTo>
                  <a:pt x="1225" y="583"/>
                  <a:pt x="1228" y="587"/>
                  <a:pt x="1229" y="591"/>
                </a:cubicBezTo>
                <a:cubicBezTo>
                  <a:pt x="1230" y="595"/>
                  <a:pt x="1229" y="598"/>
                  <a:pt x="1227" y="600"/>
                </a:cubicBezTo>
                <a:lnTo>
                  <a:pt x="1174" y="653"/>
                </a:lnTo>
                <a:lnTo>
                  <a:pt x="1289" y="768"/>
                </a:lnTo>
                <a:cubicBezTo>
                  <a:pt x="1304" y="783"/>
                  <a:pt x="1316" y="791"/>
                  <a:pt x="1328" y="794"/>
                </a:cubicBezTo>
                <a:cubicBezTo>
                  <a:pt x="1339" y="797"/>
                  <a:pt x="1350" y="794"/>
                  <a:pt x="1361" y="783"/>
                </a:cubicBezTo>
                <a:cubicBezTo>
                  <a:pt x="1365" y="779"/>
                  <a:pt x="1368" y="776"/>
                  <a:pt x="1370" y="772"/>
                </a:cubicBezTo>
                <a:cubicBezTo>
                  <a:pt x="1372" y="769"/>
                  <a:pt x="1373" y="766"/>
                  <a:pt x="1375" y="763"/>
                </a:cubicBezTo>
                <a:cubicBezTo>
                  <a:pt x="1376" y="760"/>
                  <a:pt x="1377" y="757"/>
                  <a:pt x="1378" y="755"/>
                </a:cubicBezTo>
                <a:cubicBezTo>
                  <a:pt x="1379" y="753"/>
                  <a:pt x="1380" y="751"/>
                  <a:pt x="1381" y="750"/>
                </a:cubicBezTo>
                <a:cubicBezTo>
                  <a:pt x="1382" y="749"/>
                  <a:pt x="1383" y="749"/>
                  <a:pt x="1384" y="748"/>
                </a:cubicBezTo>
                <a:cubicBezTo>
                  <a:pt x="1385" y="748"/>
                  <a:pt x="1386" y="748"/>
                  <a:pt x="1388" y="749"/>
                </a:cubicBezTo>
                <a:cubicBezTo>
                  <a:pt x="1389" y="750"/>
                  <a:pt x="1391" y="751"/>
                  <a:pt x="1393" y="752"/>
                </a:cubicBezTo>
                <a:cubicBezTo>
                  <a:pt x="1395" y="754"/>
                  <a:pt x="1398" y="756"/>
                  <a:pt x="1400" y="759"/>
                </a:cubicBezTo>
                <a:close/>
                <a:moveTo>
                  <a:pt x="1617" y="573"/>
                </a:moveTo>
                <a:cubicBezTo>
                  <a:pt x="1619" y="575"/>
                  <a:pt x="1619" y="577"/>
                  <a:pt x="1619" y="579"/>
                </a:cubicBezTo>
                <a:cubicBezTo>
                  <a:pt x="1619" y="581"/>
                  <a:pt x="1618" y="584"/>
                  <a:pt x="1616" y="586"/>
                </a:cubicBezTo>
                <a:cubicBezTo>
                  <a:pt x="1614" y="589"/>
                  <a:pt x="1611" y="592"/>
                  <a:pt x="1607" y="596"/>
                </a:cubicBezTo>
                <a:cubicBezTo>
                  <a:pt x="1603" y="600"/>
                  <a:pt x="1600" y="603"/>
                  <a:pt x="1597" y="605"/>
                </a:cubicBezTo>
                <a:cubicBezTo>
                  <a:pt x="1594" y="607"/>
                  <a:pt x="1592" y="608"/>
                  <a:pt x="1590" y="608"/>
                </a:cubicBezTo>
                <a:cubicBezTo>
                  <a:pt x="1588" y="608"/>
                  <a:pt x="1586" y="607"/>
                  <a:pt x="1584" y="606"/>
                </a:cubicBezTo>
                <a:lnTo>
                  <a:pt x="1564" y="585"/>
                </a:lnTo>
                <a:cubicBezTo>
                  <a:pt x="1564" y="604"/>
                  <a:pt x="1562" y="621"/>
                  <a:pt x="1556" y="638"/>
                </a:cubicBezTo>
                <a:cubicBezTo>
                  <a:pt x="1550" y="654"/>
                  <a:pt x="1541" y="668"/>
                  <a:pt x="1529" y="681"/>
                </a:cubicBezTo>
                <a:cubicBezTo>
                  <a:pt x="1518" y="692"/>
                  <a:pt x="1507" y="700"/>
                  <a:pt x="1495" y="706"/>
                </a:cubicBezTo>
                <a:cubicBezTo>
                  <a:pt x="1483" y="712"/>
                  <a:pt x="1472" y="715"/>
                  <a:pt x="1460" y="716"/>
                </a:cubicBezTo>
                <a:cubicBezTo>
                  <a:pt x="1449" y="717"/>
                  <a:pt x="1437" y="715"/>
                  <a:pt x="1426" y="711"/>
                </a:cubicBezTo>
                <a:cubicBezTo>
                  <a:pt x="1415" y="707"/>
                  <a:pt x="1404" y="699"/>
                  <a:pt x="1394" y="690"/>
                </a:cubicBezTo>
                <a:cubicBezTo>
                  <a:pt x="1383" y="678"/>
                  <a:pt x="1375" y="665"/>
                  <a:pt x="1371" y="652"/>
                </a:cubicBezTo>
                <a:cubicBezTo>
                  <a:pt x="1367" y="639"/>
                  <a:pt x="1367" y="625"/>
                  <a:pt x="1370" y="610"/>
                </a:cubicBezTo>
                <a:cubicBezTo>
                  <a:pt x="1373" y="596"/>
                  <a:pt x="1380" y="581"/>
                  <a:pt x="1390" y="565"/>
                </a:cubicBezTo>
                <a:cubicBezTo>
                  <a:pt x="1400" y="550"/>
                  <a:pt x="1413" y="534"/>
                  <a:pt x="1429" y="518"/>
                </a:cubicBezTo>
                <a:lnTo>
                  <a:pt x="1458" y="489"/>
                </a:lnTo>
                <a:lnTo>
                  <a:pt x="1442" y="473"/>
                </a:lnTo>
                <a:cubicBezTo>
                  <a:pt x="1434" y="465"/>
                  <a:pt x="1426" y="459"/>
                  <a:pt x="1418" y="455"/>
                </a:cubicBezTo>
                <a:cubicBezTo>
                  <a:pt x="1410" y="450"/>
                  <a:pt x="1402" y="448"/>
                  <a:pt x="1395" y="447"/>
                </a:cubicBezTo>
                <a:cubicBezTo>
                  <a:pt x="1387" y="447"/>
                  <a:pt x="1379" y="449"/>
                  <a:pt x="1371" y="453"/>
                </a:cubicBezTo>
                <a:cubicBezTo>
                  <a:pt x="1363" y="457"/>
                  <a:pt x="1354" y="463"/>
                  <a:pt x="1346" y="472"/>
                </a:cubicBezTo>
                <a:cubicBezTo>
                  <a:pt x="1336" y="481"/>
                  <a:pt x="1329" y="491"/>
                  <a:pt x="1324" y="500"/>
                </a:cubicBezTo>
                <a:cubicBezTo>
                  <a:pt x="1319" y="510"/>
                  <a:pt x="1315" y="519"/>
                  <a:pt x="1312" y="527"/>
                </a:cubicBezTo>
                <a:cubicBezTo>
                  <a:pt x="1309" y="535"/>
                  <a:pt x="1307" y="542"/>
                  <a:pt x="1305" y="548"/>
                </a:cubicBezTo>
                <a:cubicBezTo>
                  <a:pt x="1304" y="554"/>
                  <a:pt x="1302" y="558"/>
                  <a:pt x="1300" y="560"/>
                </a:cubicBezTo>
                <a:cubicBezTo>
                  <a:pt x="1299" y="561"/>
                  <a:pt x="1298" y="562"/>
                  <a:pt x="1296" y="562"/>
                </a:cubicBezTo>
                <a:cubicBezTo>
                  <a:pt x="1294" y="563"/>
                  <a:pt x="1293" y="562"/>
                  <a:pt x="1291" y="562"/>
                </a:cubicBezTo>
                <a:cubicBezTo>
                  <a:pt x="1289" y="561"/>
                  <a:pt x="1287" y="560"/>
                  <a:pt x="1285" y="559"/>
                </a:cubicBezTo>
                <a:cubicBezTo>
                  <a:pt x="1282" y="557"/>
                  <a:pt x="1280" y="555"/>
                  <a:pt x="1278" y="553"/>
                </a:cubicBezTo>
                <a:cubicBezTo>
                  <a:pt x="1274" y="549"/>
                  <a:pt x="1271" y="546"/>
                  <a:pt x="1270" y="543"/>
                </a:cubicBezTo>
                <a:cubicBezTo>
                  <a:pt x="1268" y="540"/>
                  <a:pt x="1267" y="537"/>
                  <a:pt x="1267" y="533"/>
                </a:cubicBezTo>
                <a:cubicBezTo>
                  <a:pt x="1267" y="529"/>
                  <a:pt x="1269" y="523"/>
                  <a:pt x="1271" y="515"/>
                </a:cubicBezTo>
                <a:cubicBezTo>
                  <a:pt x="1273" y="507"/>
                  <a:pt x="1277" y="499"/>
                  <a:pt x="1281" y="490"/>
                </a:cubicBezTo>
                <a:cubicBezTo>
                  <a:pt x="1285" y="482"/>
                  <a:pt x="1291" y="473"/>
                  <a:pt x="1297" y="463"/>
                </a:cubicBezTo>
                <a:cubicBezTo>
                  <a:pt x="1303" y="454"/>
                  <a:pt x="1311" y="446"/>
                  <a:pt x="1318" y="438"/>
                </a:cubicBezTo>
                <a:cubicBezTo>
                  <a:pt x="1333" y="423"/>
                  <a:pt x="1348" y="412"/>
                  <a:pt x="1361" y="405"/>
                </a:cubicBezTo>
                <a:cubicBezTo>
                  <a:pt x="1375" y="398"/>
                  <a:pt x="1388" y="394"/>
                  <a:pt x="1401" y="394"/>
                </a:cubicBezTo>
                <a:cubicBezTo>
                  <a:pt x="1414" y="394"/>
                  <a:pt x="1427" y="398"/>
                  <a:pt x="1440" y="405"/>
                </a:cubicBezTo>
                <a:cubicBezTo>
                  <a:pt x="1452" y="411"/>
                  <a:pt x="1465" y="421"/>
                  <a:pt x="1478" y="434"/>
                </a:cubicBezTo>
                <a:lnTo>
                  <a:pt x="1617" y="573"/>
                </a:lnTo>
                <a:close/>
                <a:moveTo>
                  <a:pt x="1485" y="516"/>
                </a:moveTo>
                <a:lnTo>
                  <a:pt x="1453" y="549"/>
                </a:lnTo>
                <a:cubicBezTo>
                  <a:pt x="1442" y="559"/>
                  <a:pt x="1434" y="569"/>
                  <a:pt x="1428" y="578"/>
                </a:cubicBezTo>
                <a:cubicBezTo>
                  <a:pt x="1422" y="588"/>
                  <a:pt x="1419" y="597"/>
                  <a:pt x="1417" y="605"/>
                </a:cubicBezTo>
                <a:cubicBezTo>
                  <a:pt x="1415" y="614"/>
                  <a:pt x="1416" y="622"/>
                  <a:pt x="1418" y="629"/>
                </a:cubicBezTo>
                <a:cubicBezTo>
                  <a:pt x="1421" y="636"/>
                  <a:pt x="1425" y="643"/>
                  <a:pt x="1431" y="649"/>
                </a:cubicBezTo>
                <a:cubicBezTo>
                  <a:pt x="1442" y="660"/>
                  <a:pt x="1454" y="665"/>
                  <a:pt x="1467" y="664"/>
                </a:cubicBezTo>
                <a:cubicBezTo>
                  <a:pt x="1480" y="664"/>
                  <a:pt x="1493" y="658"/>
                  <a:pt x="1505" y="645"/>
                </a:cubicBezTo>
                <a:cubicBezTo>
                  <a:pt x="1515" y="635"/>
                  <a:pt x="1522" y="624"/>
                  <a:pt x="1525" y="610"/>
                </a:cubicBezTo>
                <a:cubicBezTo>
                  <a:pt x="1529" y="597"/>
                  <a:pt x="1530" y="580"/>
                  <a:pt x="1529" y="560"/>
                </a:cubicBezTo>
                <a:lnTo>
                  <a:pt x="1485" y="516"/>
                </a:lnTo>
                <a:close/>
                <a:moveTo>
                  <a:pt x="1779" y="380"/>
                </a:moveTo>
                <a:cubicBezTo>
                  <a:pt x="1784" y="384"/>
                  <a:pt x="1787" y="388"/>
                  <a:pt x="1789" y="391"/>
                </a:cubicBezTo>
                <a:cubicBezTo>
                  <a:pt x="1791" y="394"/>
                  <a:pt x="1792" y="397"/>
                  <a:pt x="1792" y="400"/>
                </a:cubicBezTo>
                <a:cubicBezTo>
                  <a:pt x="1792" y="402"/>
                  <a:pt x="1791" y="405"/>
                  <a:pt x="1790" y="408"/>
                </a:cubicBezTo>
                <a:cubicBezTo>
                  <a:pt x="1789" y="412"/>
                  <a:pt x="1787" y="416"/>
                  <a:pt x="1784" y="419"/>
                </a:cubicBezTo>
                <a:cubicBezTo>
                  <a:pt x="1782" y="423"/>
                  <a:pt x="1779" y="427"/>
                  <a:pt x="1776" y="431"/>
                </a:cubicBezTo>
                <a:cubicBezTo>
                  <a:pt x="1773" y="435"/>
                  <a:pt x="1770" y="439"/>
                  <a:pt x="1766" y="442"/>
                </a:cubicBezTo>
                <a:cubicBezTo>
                  <a:pt x="1755" y="453"/>
                  <a:pt x="1745" y="461"/>
                  <a:pt x="1734" y="466"/>
                </a:cubicBezTo>
                <a:cubicBezTo>
                  <a:pt x="1724" y="470"/>
                  <a:pt x="1713" y="472"/>
                  <a:pt x="1703" y="472"/>
                </a:cubicBezTo>
                <a:cubicBezTo>
                  <a:pt x="1692" y="471"/>
                  <a:pt x="1681" y="467"/>
                  <a:pt x="1670" y="461"/>
                </a:cubicBezTo>
                <a:cubicBezTo>
                  <a:pt x="1659" y="454"/>
                  <a:pt x="1648" y="445"/>
                  <a:pt x="1636" y="433"/>
                </a:cubicBezTo>
                <a:lnTo>
                  <a:pt x="1515" y="312"/>
                </a:lnTo>
                <a:lnTo>
                  <a:pt x="1487" y="341"/>
                </a:lnTo>
                <a:cubicBezTo>
                  <a:pt x="1484" y="343"/>
                  <a:pt x="1481" y="344"/>
                  <a:pt x="1477" y="343"/>
                </a:cubicBezTo>
                <a:cubicBezTo>
                  <a:pt x="1474" y="342"/>
                  <a:pt x="1469" y="339"/>
                  <a:pt x="1463" y="333"/>
                </a:cubicBezTo>
                <a:cubicBezTo>
                  <a:pt x="1460" y="330"/>
                  <a:pt x="1458" y="328"/>
                  <a:pt x="1457" y="325"/>
                </a:cubicBezTo>
                <a:cubicBezTo>
                  <a:pt x="1455" y="323"/>
                  <a:pt x="1454" y="321"/>
                  <a:pt x="1453" y="319"/>
                </a:cubicBezTo>
                <a:cubicBezTo>
                  <a:pt x="1452" y="317"/>
                  <a:pt x="1452" y="315"/>
                  <a:pt x="1453" y="314"/>
                </a:cubicBezTo>
                <a:cubicBezTo>
                  <a:pt x="1453" y="312"/>
                  <a:pt x="1454" y="311"/>
                  <a:pt x="1455" y="309"/>
                </a:cubicBezTo>
                <a:lnTo>
                  <a:pt x="1484" y="281"/>
                </a:lnTo>
                <a:lnTo>
                  <a:pt x="1435" y="232"/>
                </a:lnTo>
                <a:cubicBezTo>
                  <a:pt x="1434" y="231"/>
                  <a:pt x="1433" y="229"/>
                  <a:pt x="1433" y="228"/>
                </a:cubicBezTo>
                <a:cubicBezTo>
                  <a:pt x="1432" y="226"/>
                  <a:pt x="1433" y="225"/>
                  <a:pt x="1433" y="223"/>
                </a:cubicBezTo>
                <a:cubicBezTo>
                  <a:pt x="1434" y="220"/>
                  <a:pt x="1436" y="218"/>
                  <a:pt x="1438" y="215"/>
                </a:cubicBezTo>
                <a:cubicBezTo>
                  <a:pt x="1440" y="212"/>
                  <a:pt x="1443" y="209"/>
                  <a:pt x="1446" y="206"/>
                </a:cubicBezTo>
                <a:cubicBezTo>
                  <a:pt x="1450" y="202"/>
                  <a:pt x="1453" y="199"/>
                  <a:pt x="1456" y="197"/>
                </a:cubicBezTo>
                <a:cubicBezTo>
                  <a:pt x="1459" y="194"/>
                  <a:pt x="1461" y="193"/>
                  <a:pt x="1463" y="192"/>
                </a:cubicBezTo>
                <a:cubicBezTo>
                  <a:pt x="1466" y="192"/>
                  <a:pt x="1467" y="192"/>
                  <a:pt x="1469" y="192"/>
                </a:cubicBezTo>
                <a:cubicBezTo>
                  <a:pt x="1470" y="192"/>
                  <a:pt x="1472" y="193"/>
                  <a:pt x="1473" y="194"/>
                </a:cubicBezTo>
                <a:lnTo>
                  <a:pt x="1522" y="243"/>
                </a:lnTo>
                <a:lnTo>
                  <a:pt x="1575" y="190"/>
                </a:lnTo>
                <a:cubicBezTo>
                  <a:pt x="1576" y="189"/>
                  <a:pt x="1577" y="188"/>
                  <a:pt x="1579" y="188"/>
                </a:cubicBezTo>
                <a:cubicBezTo>
                  <a:pt x="1580" y="187"/>
                  <a:pt x="1582" y="187"/>
                  <a:pt x="1584" y="188"/>
                </a:cubicBezTo>
                <a:cubicBezTo>
                  <a:pt x="1586" y="189"/>
                  <a:pt x="1588" y="190"/>
                  <a:pt x="1590" y="191"/>
                </a:cubicBezTo>
                <a:cubicBezTo>
                  <a:pt x="1593" y="193"/>
                  <a:pt x="1595" y="195"/>
                  <a:pt x="1598" y="198"/>
                </a:cubicBezTo>
                <a:cubicBezTo>
                  <a:pt x="1604" y="204"/>
                  <a:pt x="1607" y="208"/>
                  <a:pt x="1608" y="212"/>
                </a:cubicBezTo>
                <a:cubicBezTo>
                  <a:pt x="1609" y="216"/>
                  <a:pt x="1608" y="219"/>
                  <a:pt x="1606" y="221"/>
                </a:cubicBezTo>
                <a:lnTo>
                  <a:pt x="1553" y="274"/>
                </a:lnTo>
                <a:lnTo>
                  <a:pt x="1668" y="389"/>
                </a:lnTo>
                <a:cubicBezTo>
                  <a:pt x="1683" y="404"/>
                  <a:pt x="1695" y="412"/>
                  <a:pt x="1707" y="415"/>
                </a:cubicBezTo>
                <a:cubicBezTo>
                  <a:pt x="1718" y="418"/>
                  <a:pt x="1729" y="415"/>
                  <a:pt x="1740" y="404"/>
                </a:cubicBezTo>
                <a:cubicBezTo>
                  <a:pt x="1744" y="400"/>
                  <a:pt x="1747" y="397"/>
                  <a:pt x="1749" y="393"/>
                </a:cubicBezTo>
                <a:cubicBezTo>
                  <a:pt x="1751" y="390"/>
                  <a:pt x="1752" y="387"/>
                  <a:pt x="1754" y="384"/>
                </a:cubicBezTo>
                <a:cubicBezTo>
                  <a:pt x="1755" y="381"/>
                  <a:pt x="1756" y="378"/>
                  <a:pt x="1757" y="376"/>
                </a:cubicBezTo>
                <a:cubicBezTo>
                  <a:pt x="1758" y="374"/>
                  <a:pt x="1759" y="372"/>
                  <a:pt x="1760" y="371"/>
                </a:cubicBezTo>
                <a:cubicBezTo>
                  <a:pt x="1761" y="370"/>
                  <a:pt x="1762" y="370"/>
                  <a:pt x="1763" y="369"/>
                </a:cubicBezTo>
                <a:cubicBezTo>
                  <a:pt x="1764" y="369"/>
                  <a:pt x="1765" y="369"/>
                  <a:pt x="1767" y="370"/>
                </a:cubicBezTo>
                <a:cubicBezTo>
                  <a:pt x="1768" y="371"/>
                  <a:pt x="1770" y="372"/>
                  <a:pt x="1772" y="373"/>
                </a:cubicBezTo>
                <a:cubicBezTo>
                  <a:pt x="1774" y="375"/>
                  <a:pt x="1777" y="377"/>
                  <a:pt x="1779" y="380"/>
                </a:cubicBezTo>
                <a:close/>
                <a:moveTo>
                  <a:pt x="1910" y="55"/>
                </a:moveTo>
                <a:cubicBezTo>
                  <a:pt x="1916" y="61"/>
                  <a:pt x="1918" y="67"/>
                  <a:pt x="1918" y="73"/>
                </a:cubicBezTo>
                <a:cubicBezTo>
                  <a:pt x="1917" y="78"/>
                  <a:pt x="1915" y="83"/>
                  <a:pt x="1911" y="87"/>
                </a:cubicBezTo>
                <a:lnTo>
                  <a:pt x="1776" y="223"/>
                </a:lnTo>
                <a:cubicBezTo>
                  <a:pt x="1787" y="234"/>
                  <a:pt x="1799" y="243"/>
                  <a:pt x="1810" y="250"/>
                </a:cubicBezTo>
                <a:cubicBezTo>
                  <a:pt x="1821" y="257"/>
                  <a:pt x="1833" y="261"/>
                  <a:pt x="1845" y="262"/>
                </a:cubicBezTo>
                <a:cubicBezTo>
                  <a:pt x="1857" y="263"/>
                  <a:pt x="1869" y="261"/>
                  <a:pt x="1881" y="256"/>
                </a:cubicBezTo>
                <a:cubicBezTo>
                  <a:pt x="1893" y="251"/>
                  <a:pt x="1906" y="242"/>
                  <a:pt x="1918" y="230"/>
                </a:cubicBezTo>
                <a:cubicBezTo>
                  <a:pt x="1928" y="220"/>
                  <a:pt x="1936" y="211"/>
                  <a:pt x="1942" y="201"/>
                </a:cubicBezTo>
                <a:cubicBezTo>
                  <a:pt x="1948" y="192"/>
                  <a:pt x="1953" y="184"/>
                  <a:pt x="1956" y="176"/>
                </a:cubicBezTo>
                <a:cubicBezTo>
                  <a:pt x="1960" y="168"/>
                  <a:pt x="1963" y="162"/>
                  <a:pt x="1965" y="157"/>
                </a:cubicBezTo>
                <a:cubicBezTo>
                  <a:pt x="1967" y="152"/>
                  <a:pt x="1969" y="148"/>
                  <a:pt x="1971" y="146"/>
                </a:cubicBezTo>
                <a:cubicBezTo>
                  <a:pt x="1972" y="145"/>
                  <a:pt x="1973" y="144"/>
                  <a:pt x="1974" y="144"/>
                </a:cubicBezTo>
                <a:cubicBezTo>
                  <a:pt x="1976" y="144"/>
                  <a:pt x="1977" y="144"/>
                  <a:pt x="1979" y="145"/>
                </a:cubicBezTo>
                <a:cubicBezTo>
                  <a:pt x="1980" y="145"/>
                  <a:pt x="1982" y="146"/>
                  <a:pt x="1984" y="148"/>
                </a:cubicBezTo>
                <a:cubicBezTo>
                  <a:pt x="1986" y="150"/>
                  <a:pt x="1989" y="152"/>
                  <a:pt x="1992" y="155"/>
                </a:cubicBezTo>
                <a:cubicBezTo>
                  <a:pt x="1994" y="157"/>
                  <a:pt x="1995" y="158"/>
                  <a:pt x="1996" y="160"/>
                </a:cubicBezTo>
                <a:cubicBezTo>
                  <a:pt x="1998" y="162"/>
                  <a:pt x="1999" y="163"/>
                  <a:pt x="2000" y="165"/>
                </a:cubicBezTo>
                <a:cubicBezTo>
                  <a:pt x="2001" y="166"/>
                  <a:pt x="2001" y="167"/>
                  <a:pt x="2002" y="169"/>
                </a:cubicBezTo>
                <a:cubicBezTo>
                  <a:pt x="2002" y="170"/>
                  <a:pt x="2002" y="172"/>
                  <a:pt x="2002" y="174"/>
                </a:cubicBezTo>
                <a:cubicBezTo>
                  <a:pt x="2002" y="175"/>
                  <a:pt x="2001" y="179"/>
                  <a:pt x="1999" y="185"/>
                </a:cubicBezTo>
                <a:cubicBezTo>
                  <a:pt x="1997" y="191"/>
                  <a:pt x="1993" y="198"/>
                  <a:pt x="1989" y="207"/>
                </a:cubicBezTo>
                <a:cubicBezTo>
                  <a:pt x="1984" y="215"/>
                  <a:pt x="1978" y="224"/>
                  <a:pt x="1971" y="234"/>
                </a:cubicBezTo>
                <a:cubicBezTo>
                  <a:pt x="1963" y="245"/>
                  <a:pt x="1955" y="255"/>
                  <a:pt x="1945" y="264"/>
                </a:cubicBezTo>
                <a:cubicBezTo>
                  <a:pt x="1928" y="281"/>
                  <a:pt x="1911" y="294"/>
                  <a:pt x="1894" y="302"/>
                </a:cubicBezTo>
                <a:cubicBezTo>
                  <a:pt x="1876" y="310"/>
                  <a:pt x="1858" y="314"/>
                  <a:pt x="1840" y="313"/>
                </a:cubicBezTo>
                <a:cubicBezTo>
                  <a:pt x="1822" y="312"/>
                  <a:pt x="1804" y="307"/>
                  <a:pt x="1785" y="298"/>
                </a:cubicBezTo>
                <a:cubicBezTo>
                  <a:pt x="1767" y="288"/>
                  <a:pt x="1748" y="274"/>
                  <a:pt x="1730" y="255"/>
                </a:cubicBezTo>
                <a:cubicBezTo>
                  <a:pt x="1712" y="237"/>
                  <a:pt x="1698" y="219"/>
                  <a:pt x="1689" y="200"/>
                </a:cubicBezTo>
                <a:cubicBezTo>
                  <a:pt x="1679" y="182"/>
                  <a:pt x="1674" y="163"/>
                  <a:pt x="1673" y="145"/>
                </a:cubicBezTo>
                <a:cubicBezTo>
                  <a:pt x="1671" y="126"/>
                  <a:pt x="1674" y="108"/>
                  <a:pt x="1681" y="91"/>
                </a:cubicBezTo>
                <a:cubicBezTo>
                  <a:pt x="1688" y="73"/>
                  <a:pt x="1699" y="57"/>
                  <a:pt x="1714" y="42"/>
                </a:cubicBezTo>
                <a:cubicBezTo>
                  <a:pt x="1731" y="25"/>
                  <a:pt x="1747" y="14"/>
                  <a:pt x="1764" y="8"/>
                </a:cubicBezTo>
                <a:cubicBezTo>
                  <a:pt x="1780" y="2"/>
                  <a:pt x="1796" y="0"/>
                  <a:pt x="1813" y="1"/>
                </a:cubicBezTo>
                <a:cubicBezTo>
                  <a:pt x="1829" y="2"/>
                  <a:pt x="1844" y="7"/>
                  <a:pt x="1860" y="16"/>
                </a:cubicBezTo>
                <a:cubicBezTo>
                  <a:pt x="1875" y="24"/>
                  <a:pt x="1889" y="35"/>
                  <a:pt x="1903" y="49"/>
                </a:cubicBezTo>
                <a:lnTo>
                  <a:pt x="1910" y="55"/>
                </a:lnTo>
                <a:close/>
                <a:moveTo>
                  <a:pt x="1860" y="82"/>
                </a:moveTo>
                <a:cubicBezTo>
                  <a:pt x="1841" y="62"/>
                  <a:pt x="1821" y="51"/>
                  <a:pt x="1800" y="49"/>
                </a:cubicBezTo>
                <a:cubicBezTo>
                  <a:pt x="1780" y="47"/>
                  <a:pt x="1760" y="55"/>
                  <a:pt x="1742" y="73"/>
                </a:cubicBezTo>
                <a:cubicBezTo>
                  <a:pt x="1733" y="83"/>
                  <a:pt x="1726" y="93"/>
                  <a:pt x="1723" y="103"/>
                </a:cubicBezTo>
                <a:cubicBezTo>
                  <a:pt x="1719" y="114"/>
                  <a:pt x="1718" y="124"/>
                  <a:pt x="1719" y="135"/>
                </a:cubicBezTo>
                <a:cubicBezTo>
                  <a:pt x="1720" y="145"/>
                  <a:pt x="1723" y="156"/>
                  <a:pt x="1728" y="166"/>
                </a:cubicBezTo>
                <a:cubicBezTo>
                  <a:pt x="1733" y="177"/>
                  <a:pt x="1740" y="186"/>
                  <a:pt x="1748" y="195"/>
                </a:cubicBezTo>
                <a:lnTo>
                  <a:pt x="1860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1" name="Freeform 255"/>
          <p:cNvSpPr>
            <a:spLocks noEditPoints="1"/>
          </p:cNvSpPr>
          <p:nvPr/>
        </p:nvSpPr>
        <p:spPr bwMode="auto">
          <a:xfrm>
            <a:off x="3308171" y="4418880"/>
            <a:ext cx="228076" cy="233363"/>
          </a:xfrm>
          <a:custGeom>
            <a:avLst/>
            <a:gdLst>
              <a:gd name="T0" fmla="*/ 432 w 1428"/>
              <a:gd name="T1" fmla="*/ 1197 h 1229"/>
              <a:gd name="T2" fmla="*/ 400 w 1428"/>
              <a:gd name="T3" fmla="*/ 1227 h 1229"/>
              <a:gd name="T4" fmla="*/ 14 w 1428"/>
              <a:gd name="T5" fmla="*/ 1049 h 1229"/>
              <a:gd name="T6" fmla="*/ 17 w 1428"/>
              <a:gd name="T7" fmla="*/ 1014 h 1229"/>
              <a:gd name="T8" fmla="*/ 46 w 1428"/>
              <a:gd name="T9" fmla="*/ 1001 h 1229"/>
              <a:gd name="T10" fmla="*/ 212 w 1428"/>
              <a:gd name="T11" fmla="*/ 828 h 1229"/>
              <a:gd name="T12" fmla="*/ 240 w 1428"/>
              <a:gd name="T13" fmla="*/ 792 h 1229"/>
              <a:gd name="T14" fmla="*/ 439 w 1428"/>
              <a:gd name="T15" fmla="*/ 1175 h 1229"/>
              <a:gd name="T16" fmla="*/ 728 w 1428"/>
              <a:gd name="T17" fmla="*/ 902 h 1229"/>
              <a:gd name="T18" fmla="*/ 684 w 1428"/>
              <a:gd name="T19" fmla="*/ 891 h 1229"/>
              <a:gd name="T20" fmla="*/ 581 w 1428"/>
              <a:gd name="T21" fmla="*/ 1022 h 1229"/>
              <a:gd name="T22" fmla="*/ 491 w 1428"/>
              <a:gd name="T23" fmla="*/ 917 h 1229"/>
              <a:gd name="T24" fmla="*/ 562 w 1428"/>
              <a:gd name="T25" fmla="*/ 779 h 1229"/>
              <a:gd name="T26" fmla="*/ 466 w 1428"/>
              <a:gd name="T27" fmla="*/ 778 h 1229"/>
              <a:gd name="T28" fmla="*/ 421 w 1428"/>
              <a:gd name="T29" fmla="*/ 866 h 1229"/>
              <a:gd name="T30" fmla="*/ 398 w 1428"/>
              <a:gd name="T31" fmla="*/ 859 h 1229"/>
              <a:gd name="T32" fmla="*/ 402 w 1428"/>
              <a:gd name="T33" fmla="*/ 797 h 1229"/>
              <a:gd name="T34" fmla="*/ 522 w 1428"/>
              <a:gd name="T35" fmla="*/ 701 h 1229"/>
              <a:gd name="T36" fmla="*/ 605 w 1428"/>
              <a:gd name="T37" fmla="*/ 823 h 1229"/>
              <a:gd name="T38" fmla="*/ 539 w 1428"/>
              <a:gd name="T39" fmla="*/ 935 h 1229"/>
              <a:gd name="T40" fmla="*/ 646 w 1428"/>
              <a:gd name="T41" fmla="*/ 916 h 1229"/>
              <a:gd name="T42" fmla="*/ 848 w 1428"/>
              <a:gd name="T43" fmla="*/ 774 h 1229"/>
              <a:gd name="T44" fmla="*/ 824 w 1428"/>
              <a:gd name="T45" fmla="*/ 805 h 1229"/>
              <a:gd name="T46" fmla="*/ 502 w 1428"/>
              <a:gd name="T47" fmla="*/ 502 h 1229"/>
              <a:gd name="T48" fmla="*/ 513 w 1428"/>
              <a:gd name="T49" fmla="*/ 476 h 1229"/>
              <a:gd name="T50" fmla="*/ 539 w 1428"/>
              <a:gd name="T51" fmla="*/ 464 h 1229"/>
              <a:gd name="T52" fmla="*/ 955 w 1428"/>
              <a:gd name="T53" fmla="*/ 672 h 1229"/>
              <a:gd name="T54" fmla="*/ 924 w 1428"/>
              <a:gd name="T55" fmla="*/ 702 h 1229"/>
              <a:gd name="T56" fmla="*/ 707 w 1428"/>
              <a:gd name="T57" fmla="*/ 491 h 1229"/>
              <a:gd name="T58" fmla="*/ 731 w 1428"/>
              <a:gd name="T59" fmla="*/ 460 h 1229"/>
              <a:gd name="T60" fmla="*/ 953 w 1428"/>
              <a:gd name="T61" fmla="*/ 663 h 1229"/>
              <a:gd name="T62" fmla="*/ 658 w 1428"/>
              <a:gd name="T63" fmla="*/ 443 h 1229"/>
              <a:gd name="T64" fmla="*/ 659 w 1428"/>
              <a:gd name="T65" fmla="*/ 370 h 1229"/>
              <a:gd name="T66" fmla="*/ 1202 w 1428"/>
              <a:gd name="T67" fmla="*/ 425 h 1229"/>
              <a:gd name="T68" fmla="*/ 1172 w 1428"/>
              <a:gd name="T69" fmla="*/ 455 h 1229"/>
              <a:gd name="T70" fmla="*/ 1011 w 1428"/>
              <a:gd name="T71" fmla="*/ 307 h 1229"/>
              <a:gd name="T72" fmla="*/ 917 w 1428"/>
              <a:gd name="T73" fmla="*/ 352 h 1229"/>
              <a:gd name="T74" fmla="*/ 1062 w 1428"/>
              <a:gd name="T75" fmla="*/ 565 h 1229"/>
              <a:gd name="T76" fmla="*/ 1032 w 1428"/>
              <a:gd name="T77" fmla="*/ 595 h 1229"/>
              <a:gd name="T78" fmla="*/ 814 w 1428"/>
              <a:gd name="T79" fmla="*/ 383 h 1229"/>
              <a:gd name="T80" fmla="*/ 835 w 1428"/>
              <a:gd name="T81" fmla="*/ 355 h 1229"/>
              <a:gd name="T82" fmla="*/ 878 w 1428"/>
              <a:gd name="T83" fmla="*/ 380 h 1229"/>
              <a:gd name="T84" fmla="*/ 993 w 1428"/>
              <a:gd name="T85" fmla="*/ 241 h 1229"/>
              <a:gd name="T86" fmla="*/ 1336 w 1428"/>
              <a:gd name="T87" fmla="*/ 56 h 1229"/>
              <a:gd name="T88" fmla="*/ 1236 w 1428"/>
              <a:gd name="T89" fmla="*/ 251 h 1229"/>
              <a:gd name="T90" fmla="*/ 1368 w 1428"/>
              <a:gd name="T91" fmla="*/ 202 h 1229"/>
              <a:gd name="T92" fmla="*/ 1400 w 1428"/>
              <a:gd name="T93" fmla="*/ 145 h 1229"/>
              <a:gd name="T94" fmla="*/ 1422 w 1428"/>
              <a:gd name="T95" fmla="*/ 161 h 1229"/>
              <a:gd name="T96" fmla="*/ 1425 w 1428"/>
              <a:gd name="T97" fmla="*/ 186 h 1229"/>
              <a:gd name="T98" fmla="*/ 1320 w 1428"/>
              <a:gd name="T99" fmla="*/ 303 h 1229"/>
              <a:gd name="T100" fmla="*/ 1115 w 1428"/>
              <a:gd name="T101" fmla="*/ 201 h 1229"/>
              <a:gd name="T102" fmla="*/ 1190 w 1428"/>
              <a:gd name="T103" fmla="*/ 9 h 1229"/>
              <a:gd name="T104" fmla="*/ 1336 w 1428"/>
              <a:gd name="T105" fmla="*/ 56 h 1229"/>
              <a:gd name="T106" fmla="*/ 1149 w 1428"/>
              <a:gd name="T107" fmla="*/ 104 h 1229"/>
              <a:gd name="T108" fmla="*/ 1286 w 1428"/>
              <a:gd name="T109" fmla="*/ 83 h 12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1428" h="1229">
                <a:moveTo>
                  <a:pt x="439" y="1175"/>
                </a:moveTo>
                <a:cubicBezTo>
                  <a:pt x="440" y="1177"/>
                  <a:pt x="440" y="1179"/>
                  <a:pt x="440" y="1182"/>
                </a:cubicBezTo>
                <a:cubicBezTo>
                  <a:pt x="440" y="1184"/>
                  <a:pt x="440" y="1186"/>
                  <a:pt x="438" y="1189"/>
                </a:cubicBezTo>
                <a:cubicBezTo>
                  <a:pt x="437" y="1191"/>
                  <a:pt x="435" y="1194"/>
                  <a:pt x="432" y="1197"/>
                </a:cubicBezTo>
                <a:cubicBezTo>
                  <a:pt x="430" y="1200"/>
                  <a:pt x="426" y="1204"/>
                  <a:pt x="422" y="1209"/>
                </a:cubicBezTo>
                <a:cubicBezTo>
                  <a:pt x="418" y="1212"/>
                  <a:pt x="415" y="1215"/>
                  <a:pt x="413" y="1217"/>
                </a:cubicBezTo>
                <a:cubicBezTo>
                  <a:pt x="410" y="1220"/>
                  <a:pt x="408" y="1222"/>
                  <a:pt x="406" y="1223"/>
                </a:cubicBezTo>
                <a:cubicBezTo>
                  <a:pt x="403" y="1225"/>
                  <a:pt x="402" y="1226"/>
                  <a:pt x="400" y="1227"/>
                </a:cubicBezTo>
                <a:cubicBezTo>
                  <a:pt x="398" y="1228"/>
                  <a:pt x="397" y="1229"/>
                  <a:pt x="395" y="1229"/>
                </a:cubicBezTo>
                <a:cubicBezTo>
                  <a:pt x="394" y="1229"/>
                  <a:pt x="392" y="1229"/>
                  <a:pt x="391" y="1229"/>
                </a:cubicBezTo>
                <a:cubicBezTo>
                  <a:pt x="389" y="1229"/>
                  <a:pt x="388" y="1228"/>
                  <a:pt x="386" y="1227"/>
                </a:cubicBezTo>
                <a:lnTo>
                  <a:pt x="14" y="1049"/>
                </a:lnTo>
                <a:cubicBezTo>
                  <a:pt x="9" y="1047"/>
                  <a:pt x="6" y="1044"/>
                  <a:pt x="3" y="1042"/>
                </a:cubicBezTo>
                <a:cubicBezTo>
                  <a:pt x="1" y="1040"/>
                  <a:pt x="0" y="1038"/>
                  <a:pt x="1" y="1036"/>
                </a:cubicBezTo>
                <a:cubicBezTo>
                  <a:pt x="1" y="1033"/>
                  <a:pt x="3" y="1030"/>
                  <a:pt x="5" y="1027"/>
                </a:cubicBezTo>
                <a:cubicBezTo>
                  <a:pt x="8" y="1024"/>
                  <a:pt x="12" y="1019"/>
                  <a:pt x="17" y="1014"/>
                </a:cubicBezTo>
                <a:cubicBezTo>
                  <a:pt x="22" y="1010"/>
                  <a:pt x="25" y="1007"/>
                  <a:pt x="28" y="1004"/>
                </a:cubicBezTo>
                <a:cubicBezTo>
                  <a:pt x="31" y="1002"/>
                  <a:pt x="33" y="1001"/>
                  <a:pt x="35" y="1000"/>
                </a:cubicBezTo>
                <a:cubicBezTo>
                  <a:pt x="37" y="999"/>
                  <a:pt x="39" y="999"/>
                  <a:pt x="40" y="999"/>
                </a:cubicBezTo>
                <a:cubicBezTo>
                  <a:pt x="42" y="999"/>
                  <a:pt x="44" y="1000"/>
                  <a:pt x="46" y="1001"/>
                </a:cubicBezTo>
                <a:lnTo>
                  <a:pt x="381" y="1166"/>
                </a:lnTo>
                <a:lnTo>
                  <a:pt x="381" y="1165"/>
                </a:lnTo>
                <a:lnTo>
                  <a:pt x="215" y="833"/>
                </a:lnTo>
                <a:cubicBezTo>
                  <a:pt x="213" y="831"/>
                  <a:pt x="213" y="829"/>
                  <a:pt x="212" y="828"/>
                </a:cubicBezTo>
                <a:cubicBezTo>
                  <a:pt x="212" y="826"/>
                  <a:pt x="212" y="824"/>
                  <a:pt x="213" y="822"/>
                </a:cubicBezTo>
                <a:cubicBezTo>
                  <a:pt x="214" y="820"/>
                  <a:pt x="215" y="817"/>
                  <a:pt x="218" y="814"/>
                </a:cubicBezTo>
                <a:cubicBezTo>
                  <a:pt x="220" y="811"/>
                  <a:pt x="224" y="807"/>
                  <a:pt x="229" y="803"/>
                </a:cubicBezTo>
                <a:cubicBezTo>
                  <a:pt x="233" y="798"/>
                  <a:pt x="237" y="795"/>
                  <a:pt x="240" y="792"/>
                </a:cubicBezTo>
                <a:cubicBezTo>
                  <a:pt x="244" y="790"/>
                  <a:pt x="246" y="789"/>
                  <a:pt x="248" y="789"/>
                </a:cubicBezTo>
                <a:cubicBezTo>
                  <a:pt x="250" y="789"/>
                  <a:pt x="252" y="790"/>
                  <a:pt x="254" y="792"/>
                </a:cubicBezTo>
                <a:cubicBezTo>
                  <a:pt x="256" y="795"/>
                  <a:pt x="258" y="798"/>
                  <a:pt x="260" y="803"/>
                </a:cubicBezTo>
                <a:lnTo>
                  <a:pt x="439" y="1175"/>
                </a:lnTo>
                <a:close/>
                <a:moveTo>
                  <a:pt x="737" y="879"/>
                </a:moveTo>
                <a:cubicBezTo>
                  <a:pt x="739" y="881"/>
                  <a:pt x="740" y="883"/>
                  <a:pt x="740" y="885"/>
                </a:cubicBezTo>
                <a:cubicBezTo>
                  <a:pt x="739" y="887"/>
                  <a:pt x="738" y="890"/>
                  <a:pt x="737" y="892"/>
                </a:cubicBezTo>
                <a:cubicBezTo>
                  <a:pt x="735" y="895"/>
                  <a:pt x="732" y="898"/>
                  <a:pt x="728" y="902"/>
                </a:cubicBezTo>
                <a:cubicBezTo>
                  <a:pt x="724" y="906"/>
                  <a:pt x="720" y="909"/>
                  <a:pt x="718" y="911"/>
                </a:cubicBezTo>
                <a:cubicBezTo>
                  <a:pt x="715" y="913"/>
                  <a:pt x="712" y="914"/>
                  <a:pt x="710" y="914"/>
                </a:cubicBezTo>
                <a:cubicBezTo>
                  <a:pt x="708" y="915"/>
                  <a:pt x="707" y="914"/>
                  <a:pt x="705" y="912"/>
                </a:cubicBezTo>
                <a:lnTo>
                  <a:pt x="684" y="891"/>
                </a:lnTo>
                <a:cubicBezTo>
                  <a:pt x="685" y="910"/>
                  <a:pt x="682" y="927"/>
                  <a:pt x="676" y="944"/>
                </a:cubicBezTo>
                <a:cubicBezTo>
                  <a:pt x="671" y="960"/>
                  <a:pt x="662" y="975"/>
                  <a:pt x="649" y="987"/>
                </a:cubicBezTo>
                <a:cubicBezTo>
                  <a:pt x="638" y="998"/>
                  <a:pt x="627" y="1006"/>
                  <a:pt x="616" y="1012"/>
                </a:cubicBezTo>
                <a:cubicBezTo>
                  <a:pt x="604" y="1018"/>
                  <a:pt x="592" y="1022"/>
                  <a:pt x="581" y="1022"/>
                </a:cubicBezTo>
                <a:cubicBezTo>
                  <a:pt x="569" y="1023"/>
                  <a:pt x="558" y="1022"/>
                  <a:pt x="547" y="1017"/>
                </a:cubicBezTo>
                <a:cubicBezTo>
                  <a:pt x="535" y="1013"/>
                  <a:pt x="525" y="1006"/>
                  <a:pt x="515" y="996"/>
                </a:cubicBezTo>
                <a:cubicBezTo>
                  <a:pt x="503" y="984"/>
                  <a:pt x="496" y="972"/>
                  <a:pt x="492" y="958"/>
                </a:cubicBezTo>
                <a:cubicBezTo>
                  <a:pt x="488" y="945"/>
                  <a:pt x="488" y="931"/>
                  <a:pt x="491" y="917"/>
                </a:cubicBezTo>
                <a:cubicBezTo>
                  <a:pt x="494" y="902"/>
                  <a:pt x="501" y="887"/>
                  <a:pt x="511" y="871"/>
                </a:cubicBezTo>
                <a:cubicBezTo>
                  <a:pt x="521" y="856"/>
                  <a:pt x="534" y="840"/>
                  <a:pt x="550" y="824"/>
                </a:cubicBezTo>
                <a:lnTo>
                  <a:pt x="578" y="795"/>
                </a:lnTo>
                <a:lnTo>
                  <a:pt x="562" y="779"/>
                </a:lnTo>
                <a:cubicBezTo>
                  <a:pt x="554" y="771"/>
                  <a:pt x="546" y="765"/>
                  <a:pt x="539" y="761"/>
                </a:cubicBezTo>
                <a:cubicBezTo>
                  <a:pt x="531" y="756"/>
                  <a:pt x="523" y="754"/>
                  <a:pt x="515" y="754"/>
                </a:cubicBezTo>
                <a:cubicBezTo>
                  <a:pt x="507" y="753"/>
                  <a:pt x="499" y="755"/>
                  <a:pt x="491" y="759"/>
                </a:cubicBezTo>
                <a:cubicBezTo>
                  <a:pt x="483" y="763"/>
                  <a:pt x="475" y="769"/>
                  <a:pt x="466" y="778"/>
                </a:cubicBezTo>
                <a:cubicBezTo>
                  <a:pt x="457" y="787"/>
                  <a:pt x="450" y="797"/>
                  <a:pt x="445" y="806"/>
                </a:cubicBezTo>
                <a:cubicBezTo>
                  <a:pt x="439" y="816"/>
                  <a:pt x="435" y="825"/>
                  <a:pt x="432" y="833"/>
                </a:cubicBezTo>
                <a:cubicBezTo>
                  <a:pt x="429" y="841"/>
                  <a:pt x="427" y="849"/>
                  <a:pt x="426" y="855"/>
                </a:cubicBezTo>
                <a:cubicBezTo>
                  <a:pt x="424" y="861"/>
                  <a:pt x="422" y="864"/>
                  <a:pt x="421" y="866"/>
                </a:cubicBezTo>
                <a:cubicBezTo>
                  <a:pt x="419" y="867"/>
                  <a:pt x="418" y="868"/>
                  <a:pt x="417" y="869"/>
                </a:cubicBezTo>
                <a:cubicBezTo>
                  <a:pt x="415" y="869"/>
                  <a:pt x="413" y="869"/>
                  <a:pt x="411" y="868"/>
                </a:cubicBezTo>
                <a:cubicBezTo>
                  <a:pt x="409" y="868"/>
                  <a:pt x="407" y="867"/>
                  <a:pt x="405" y="865"/>
                </a:cubicBezTo>
                <a:cubicBezTo>
                  <a:pt x="403" y="863"/>
                  <a:pt x="401" y="861"/>
                  <a:pt x="398" y="859"/>
                </a:cubicBezTo>
                <a:cubicBezTo>
                  <a:pt x="395" y="855"/>
                  <a:pt x="392" y="852"/>
                  <a:pt x="390" y="849"/>
                </a:cubicBezTo>
                <a:cubicBezTo>
                  <a:pt x="388" y="847"/>
                  <a:pt x="388" y="843"/>
                  <a:pt x="388" y="839"/>
                </a:cubicBezTo>
                <a:cubicBezTo>
                  <a:pt x="388" y="835"/>
                  <a:pt x="389" y="829"/>
                  <a:pt x="391" y="821"/>
                </a:cubicBezTo>
                <a:cubicBezTo>
                  <a:pt x="394" y="814"/>
                  <a:pt x="397" y="805"/>
                  <a:pt x="402" y="797"/>
                </a:cubicBezTo>
                <a:cubicBezTo>
                  <a:pt x="406" y="788"/>
                  <a:pt x="411" y="779"/>
                  <a:pt x="418" y="770"/>
                </a:cubicBezTo>
                <a:cubicBezTo>
                  <a:pt x="424" y="760"/>
                  <a:pt x="431" y="752"/>
                  <a:pt x="439" y="744"/>
                </a:cubicBezTo>
                <a:cubicBezTo>
                  <a:pt x="454" y="729"/>
                  <a:pt x="468" y="718"/>
                  <a:pt x="482" y="711"/>
                </a:cubicBezTo>
                <a:cubicBezTo>
                  <a:pt x="496" y="704"/>
                  <a:pt x="509" y="701"/>
                  <a:pt x="522" y="701"/>
                </a:cubicBezTo>
                <a:cubicBezTo>
                  <a:pt x="535" y="701"/>
                  <a:pt x="548" y="704"/>
                  <a:pt x="560" y="711"/>
                </a:cubicBezTo>
                <a:cubicBezTo>
                  <a:pt x="573" y="718"/>
                  <a:pt x="585" y="727"/>
                  <a:pt x="598" y="740"/>
                </a:cubicBezTo>
                <a:lnTo>
                  <a:pt x="737" y="879"/>
                </a:lnTo>
                <a:close/>
                <a:moveTo>
                  <a:pt x="605" y="823"/>
                </a:moveTo>
                <a:lnTo>
                  <a:pt x="573" y="855"/>
                </a:lnTo>
                <a:cubicBezTo>
                  <a:pt x="563" y="865"/>
                  <a:pt x="555" y="875"/>
                  <a:pt x="549" y="885"/>
                </a:cubicBezTo>
                <a:cubicBezTo>
                  <a:pt x="543" y="894"/>
                  <a:pt x="539" y="903"/>
                  <a:pt x="537" y="912"/>
                </a:cubicBezTo>
                <a:cubicBezTo>
                  <a:pt x="536" y="920"/>
                  <a:pt x="536" y="928"/>
                  <a:pt x="539" y="935"/>
                </a:cubicBezTo>
                <a:cubicBezTo>
                  <a:pt x="541" y="942"/>
                  <a:pt x="546" y="949"/>
                  <a:pt x="552" y="955"/>
                </a:cubicBezTo>
                <a:cubicBezTo>
                  <a:pt x="562" y="966"/>
                  <a:pt x="574" y="971"/>
                  <a:pt x="588" y="971"/>
                </a:cubicBezTo>
                <a:cubicBezTo>
                  <a:pt x="601" y="970"/>
                  <a:pt x="613" y="964"/>
                  <a:pt x="626" y="952"/>
                </a:cubicBezTo>
                <a:cubicBezTo>
                  <a:pt x="636" y="942"/>
                  <a:pt x="642" y="930"/>
                  <a:pt x="646" y="916"/>
                </a:cubicBezTo>
                <a:cubicBezTo>
                  <a:pt x="649" y="903"/>
                  <a:pt x="650" y="886"/>
                  <a:pt x="649" y="866"/>
                </a:cubicBezTo>
                <a:lnTo>
                  <a:pt x="605" y="823"/>
                </a:lnTo>
                <a:close/>
                <a:moveTo>
                  <a:pt x="846" y="770"/>
                </a:moveTo>
                <a:cubicBezTo>
                  <a:pt x="847" y="772"/>
                  <a:pt x="848" y="773"/>
                  <a:pt x="848" y="774"/>
                </a:cubicBezTo>
                <a:cubicBezTo>
                  <a:pt x="848" y="776"/>
                  <a:pt x="848" y="778"/>
                  <a:pt x="847" y="780"/>
                </a:cubicBezTo>
                <a:cubicBezTo>
                  <a:pt x="846" y="782"/>
                  <a:pt x="845" y="784"/>
                  <a:pt x="843" y="787"/>
                </a:cubicBezTo>
                <a:cubicBezTo>
                  <a:pt x="841" y="789"/>
                  <a:pt x="838" y="793"/>
                  <a:pt x="834" y="797"/>
                </a:cubicBezTo>
                <a:cubicBezTo>
                  <a:pt x="830" y="800"/>
                  <a:pt x="827" y="803"/>
                  <a:pt x="824" y="805"/>
                </a:cubicBezTo>
                <a:cubicBezTo>
                  <a:pt x="821" y="807"/>
                  <a:pt x="819" y="809"/>
                  <a:pt x="817" y="810"/>
                </a:cubicBezTo>
                <a:cubicBezTo>
                  <a:pt x="815" y="811"/>
                  <a:pt x="813" y="811"/>
                  <a:pt x="812" y="811"/>
                </a:cubicBezTo>
                <a:cubicBezTo>
                  <a:pt x="810" y="810"/>
                  <a:pt x="809" y="809"/>
                  <a:pt x="808" y="808"/>
                </a:cubicBezTo>
                <a:lnTo>
                  <a:pt x="502" y="502"/>
                </a:lnTo>
                <a:cubicBezTo>
                  <a:pt x="500" y="501"/>
                  <a:pt x="500" y="499"/>
                  <a:pt x="499" y="498"/>
                </a:cubicBezTo>
                <a:cubicBezTo>
                  <a:pt x="499" y="496"/>
                  <a:pt x="499" y="495"/>
                  <a:pt x="500" y="493"/>
                </a:cubicBezTo>
                <a:cubicBezTo>
                  <a:pt x="501" y="491"/>
                  <a:pt x="502" y="488"/>
                  <a:pt x="504" y="485"/>
                </a:cubicBezTo>
                <a:cubicBezTo>
                  <a:pt x="506" y="483"/>
                  <a:pt x="509" y="479"/>
                  <a:pt x="513" y="476"/>
                </a:cubicBezTo>
                <a:cubicBezTo>
                  <a:pt x="517" y="472"/>
                  <a:pt x="520" y="469"/>
                  <a:pt x="523" y="467"/>
                </a:cubicBezTo>
                <a:cubicBezTo>
                  <a:pt x="526" y="465"/>
                  <a:pt x="528" y="463"/>
                  <a:pt x="530" y="463"/>
                </a:cubicBezTo>
                <a:cubicBezTo>
                  <a:pt x="532" y="462"/>
                  <a:pt x="534" y="462"/>
                  <a:pt x="535" y="462"/>
                </a:cubicBezTo>
                <a:cubicBezTo>
                  <a:pt x="537" y="462"/>
                  <a:pt x="538" y="463"/>
                  <a:pt x="539" y="464"/>
                </a:cubicBezTo>
                <a:lnTo>
                  <a:pt x="846" y="770"/>
                </a:lnTo>
                <a:close/>
                <a:moveTo>
                  <a:pt x="953" y="663"/>
                </a:moveTo>
                <a:cubicBezTo>
                  <a:pt x="954" y="664"/>
                  <a:pt x="955" y="666"/>
                  <a:pt x="955" y="667"/>
                </a:cubicBezTo>
                <a:cubicBezTo>
                  <a:pt x="956" y="668"/>
                  <a:pt x="955" y="670"/>
                  <a:pt x="955" y="672"/>
                </a:cubicBezTo>
                <a:cubicBezTo>
                  <a:pt x="954" y="674"/>
                  <a:pt x="952" y="676"/>
                  <a:pt x="950" y="679"/>
                </a:cubicBezTo>
                <a:cubicBezTo>
                  <a:pt x="948" y="682"/>
                  <a:pt x="945" y="685"/>
                  <a:pt x="941" y="689"/>
                </a:cubicBezTo>
                <a:cubicBezTo>
                  <a:pt x="938" y="693"/>
                  <a:pt x="934" y="696"/>
                  <a:pt x="932" y="698"/>
                </a:cubicBezTo>
                <a:cubicBezTo>
                  <a:pt x="929" y="700"/>
                  <a:pt x="926" y="701"/>
                  <a:pt x="924" y="702"/>
                </a:cubicBezTo>
                <a:cubicBezTo>
                  <a:pt x="922" y="703"/>
                  <a:pt x="921" y="703"/>
                  <a:pt x="919" y="703"/>
                </a:cubicBezTo>
                <a:cubicBezTo>
                  <a:pt x="918" y="703"/>
                  <a:pt x="917" y="702"/>
                  <a:pt x="915" y="701"/>
                </a:cubicBezTo>
                <a:lnTo>
                  <a:pt x="709" y="494"/>
                </a:lnTo>
                <a:cubicBezTo>
                  <a:pt x="708" y="493"/>
                  <a:pt x="707" y="492"/>
                  <a:pt x="707" y="491"/>
                </a:cubicBezTo>
                <a:cubicBezTo>
                  <a:pt x="706" y="489"/>
                  <a:pt x="707" y="487"/>
                  <a:pt x="708" y="485"/>
                </a:cubicBezTo>
                <a:cubicBezTo>
                  <a:pt x="708" y="483"/>
                  <a:pt x="710" y="481"/>
                  <a:pt x="712" y="478"/>
                </a:cubicBezTo>
                <a:cubicBezTo>
                  <a:pt x="714" y="475"/>
                  <a:pt x="717" y="472"/>
                  <a:pt x="721" y="469"/>
                </a:cubicBezTo>
                <a:cubicBezTo>
                  <a:pt x="725" y="465"/>
                  <a:pt x="728" y="462"/>
                  <a:pt x="731" y="460"/>
                </a:cubicBezTo>
                <a:cubicBezTo>
                  <a:pt x="733" y="457"/>
                  <a:pt x="736" y="456"/>
                  <a:pt x="738" y="455"/>
                </a:cubicBezTo>
                <a:cubicBezTo>
                  <a:pt x="740" y="454"/>
                  <a:pt x="741" y="454"/>
                  <a:pt x="743" y="455"/>
                </a:cubicBezTo>
                <a:cubicBezTo>
                  <a:pt x="744" y="455"/>
                  <a:pt x="746" y="456"/>
                  <a:pt x="747" y="457"/>
                </a:cubicBezTo>
                <a:lnTo>
                  <a:pt x="953" y="663"/>
                </a:lnTo>
                <a:close/>
                <a:moveTo>
                  <a:pt x="682" y="383"/>
                </a:moveTo>
                <a:cubicBezTo>
                  <a:pt x="690" y="391"/>
                  <a:pt x="695" y="399"/>
                  <a:pt x="695" y="406"/>
                </a:cubicBezTo>
                <a:cubicBezTo>
                  <a:pt x="694" y="412"/>
                  <a:pt x="690" y="420"/>
                  <a:pt x="681" y="429"/>
                </a:cubicBezTo>
                <a:cubicBezTo>
                  <a:pt x="672" y="438"/>
                  <a:pt x="664" y="442"/>
                  <a:pt x="658" y="443"/>
                </a:cubicBezTo>
                <a:cubicBezTo>
                  <a:pt x="651" y="443"/>
                  <a:pt x="644" y="438"/>
                  <a:pt x="635" y="430"/>
                </a:cubicBezTo>
                <a:cubicBezTo>
                  <a:pt x="626" y="421"/>
                  <a:pt x="622" y="413"/>
                  <a:pt x="622" y="407"/>
                </a:cubicBezTo>
                <a:cubicBezTo>
                  <a:pt x="622" y="400"/>
                  <a:pt x="627" y="392"/>
                  <a:pt x="636" y="383"/>
                </a:cubicBezTo>
                <a:cubicBezTo>
                  <a:pt x="645" y="374"/>
                  <a:pt x="652" y="370"/>
                  <a:pt x="659" y="370"/>
                </a:cubicBezTo>
                <a:cubicBezTo>
                  <a:pt x="665" y="370"/>
                  <a:pt x="673" y="374"/>
                  <a:pt x="682" y="383"/>
                </a:cubicBezTo>
                <a:close/>
                <a:moveTo>
                  <a:pt x="1201" y="416"/>
                </a:moveTo>
                <a:cubicBezTo>
                  <a:pt x="1202" y="417"/>
                  <a:pt x="1202" y="418"/>
                  <a:pt x="1203" y="420"/>
                </a:cubicBezTo>
                <a:cubicBezTo>
                  <a:pt x="1203" y="421"/>
                  <a:pt x="1203" y="423"/>
                  <a:pt x="1202" y="425"/>
                </a:cubicBezTo>
                <a:cubicBezTo>
                  <a:pt x="1201" y="427"/>
                  <a:pt x="1200" y="429"/>
                  <a:pt x="1198" y="432"/>
                </a:cubicBezTo>
                <a:cubicBezTo>
                  <a:pt x="1195" y="435"/>
                  <a:pt x="1192" y="438"/>
                  <a:pt x="1189" y="442"/>
                </a:cubicBezTo>
                <a:cubicBezTo>
                  <a:pt x="1185" y="445"/>
                  <a:pt x="1182" y="448"/>
                  <a:pt x="1179" y="450"/>
                </a:cubicBezTo>
                <a:cubicBezTo>
                  <a:pt x="1176" y="453"/>
                  <a:pt x="1174" y="454"/>
                  <a:pt x="1172" y="455"/>
                </a:cubicBezTo>
                <a:cubicBezTo>
                  <a:pt x="1170" y="456"/>
                  <a:pt x="1168" y="456"/>
                  <a:pt x="1167" y="456"/>
                </a:cubicBezTo>
                <a:cubicBezTo>
                  <a:pt x="1165" y="455"/>
                  <a:pt x="1164" y="455"/>
                  <a:pt x="1163" y="453"/>
                </a:cubicBezTo>
                <a:lnTo>
                  <a:pt x="1042" y="333"/>
                </a:lnTo>
                <a:cubicBezTo>
                  <a:pt x="1030" y="321"/>
                  <a:pt x="1020" y="312"/>
                  <a:pt x="1011" y="307"/>
                </a:cubicBezTo>
                <a:cubicBezTo>
                  <a:pt x="1002" y="302"/>
                  <a:pt x="993" y="298"/>
                  <a:pt x="984" y="296"/>
                </a:cubicBezTo>
                <a:cubicBezTo>
                  <a:pt x="975" y="295"/>
                  <a:pt x="967" y="295"/>
                  <a:pt x="959" y="298"/>
                </a:cubicBezTo>
                <a:cubicBezTo>
                  <a:pt x="950" y="301"/>
                  <a:pt x="942" y="306"/>
                  <a:pt x="935" y="313"/>
                </a:cubicBezTo>
                <a:cubicBezTo>
                  <a:pt x="926" y="323"/>
                  <a:pt x="919" y="336"/>
                  <a:pt x="917" y="352"/>
                </a:cubicBezTo>
                <a:cubicBezTo>
                  <a:pt x="914" y="368"/>
                  <a:pt x="914" y="388"/>
                  <a:pt x="916" y="411"/>
                </a:cubicBezTo>
                <a:lnTo>
                  <a:pt x="1061" y="555"/>
                </a:lnTo>
                <a:cubicBezTo>
                  <a:pt x="1062" y="557"/>
                  <a:pt x="1063" y="558"/>
                  <a:pt x="1063" y="559"/>
                </a:cubicBezTo>
                <a:cubicBezTo>
                  <a:pt x="1063" y="561"/>
                  <a:pt x="1063" y="563"/>
                  <a:pt x="1062" y="565"/>
                </a:cubicBezTo>
                <a:cubicBezTo>
                  <a:pt x="1061" y="567"/>
                  <a:pt x="1060" y="569"/>
                  <a:pt x="1058" y="572"/>
                </a:cubicBezTo>
                <a:cubicBezTo>
                  <a:pt x="1056" y="574"/>
                  <a:pt x="1053" y="578"/>
                  <a:pt x="1049" y="582"/>
                </a:cubicBezTo>
                <a:cubicBezTo>
                  <a:pt x="1045" y="585"/>
                  <a:pt x="1042" y="588"/>
                  <a:pt x="1039" y="590"/>
                </a:cubicBezTo>
                <a:cubicBezTo>
                  <a:pt x="1036" y="592"/>
                  <a:pt x="1034" y="594"/>
                  <a:pt x="1032" y="595"/>
                </a:cubicBezTo>
                <a:cubicBezTo>
                  <a:pt x="1030" y="596"/>
                  <a:pt x="1028" y="596"/>
                  <a:pt x="1027" y="596"/>
                </a:cubicBezTo>
                <a:cubicBezTo>
                  <a:pt x="1025" y="595"/>
                  <a:pt x="1024" y="595"/>
                  <a:pt x="1023" y="593"/>
                </a:cubicBezTo>
                <a:lnTo>
                  <a:pt x="817" y="387"/>
                </a:lnTo>
                <a:cubicBezTo>
                  <a:pt x="815" y="386"/>
                  <a:pt x="814" y="384"/>
                  <a:pt x="814" y="383"/>
                </a:cubicBezTo>
                <a:cubicBezTo>
                  <a:pt x="814" y="382"/>
                  <a:pt x="814" y="380"/>
                  <a:pt x="815" y="378"/>
                </a:cubicBezTo>
                <a:cubicBezTo>
                  <a:pt x="815" y="376"/>
                  <a:pt x="817" y="374"/>
                  <a:pt x="818" y="371"/>
                </a:cubicBezTo>
                <a:cubicBezTo>
                  <a:pt x="820" y="369"/>
                  <a:pt x="823" y="366"/>
                  <a:pt x="827" y="363"/>
                </a:cubicBezTo>
                <a:cubicBezTo>
                  <a:pt x="830" y="359"/>
                  <a:pt x="833" y="357"/>
                  <a:pt x="835" y="355"/>
                </a:cubicBezTo>
                <a:cubicBezTo>
                  <a:pt x="838" y="353"/>
                  <a:pt x="840" y="351"/>
                  <a:pt x="842" y="351"/>
                </a:cubicBezTo>
                <a:cubicBezTo>
                  <a:pt x="844" y="350"/>
                  <a:pt x="845" y="350"/>
                  <a:pt x="847" y="351"/>
                </a:cubicBezTo>
                <a:cubicBezTo>
                  <a:pt x="848" y="351"/>
                  <a:pt x="849" y="352"/>
                  <a:pt x="851" y="353"/>
                </a:cubicBezTo>
                <a:lnTo>
                  <a:pt x="878" y="380"/>
                </a:lnTo>
                <a:cubicBezTo>
                  <a:pt x="877" y="355"/>
                  <a:pt x="879" y="334"/>
                  <a:pt x="884" y="317"/>
                </a:cubicBezTo>
                <a:cubicBezTo>
                  <a:pt x="890" y="299"/>
                  <a:pt x="898" y="285"/>
                  <a:pt x="910" y="273"/>
                </a:cubicBezTo>
                <a:cubicBezTo>
                  <a:pt x="924" y="259"/>
                  <a:pt x="938" y="250"/>
                  <a:pt x="952" y="245"/>
                </a:cubicBezTo>
                <a:cubicBezTo>
                  <a:pt x="966" y="240"/>
                  <a:pt x="980" y="239"/>
                  <a:pt x="993" y="241"/>
                </a:cubicBezTo>
                <a:cubicBezTo>
                  <a:pt x="1007" y="243"/>
                  <a:pt x="1020" y="248"/>
                  <a:pt x="1033" y="256"/>
                </a:cubicBezTo>
                <a:cubicBezTo>
                  <a:pt x="1046" y="264"/>
                  <a:pt x="1060" y="275"/>
                  <a:pt x="1075" y="290"/>
                </a:cubicBezTo>
                <a:lnTo>
                  <a:pt x="1201" y="416"/>
                </a:lnTo>
                <a:close/>
                <a:moveTo>
                  <a:pt x="1336" y="56"/>
                </a:moveTo>
                <a:cubicBezTo>
                  <a:pt x="1342" y="62"/>
                  <a:pt x="1344" y="68"/>
                  <a:pt x="1344" y="73"/>
                </a:cubicBezTo>
                <a:cubicBezTo>
                  <a:pt x="1343" y="79"/>
                  <a:pt x="1341" y="84"/>
                  <a:pt x="1337" y="87"/>
                </a:cubicBezTo>
                <a:lnTo>
                  <a:pt x="1202" y="223"/>
                </a:lnTo>
                <a:cubicBezTo>
                  <a:pt x="1213" y="235"/>
                  <a:pt x="1225" y="244"/>
                  <a:pt x="1236" y="251"/>
                </a:cubicBezTo>
                <a:cubicBezTo>
                  <a:pt x="1247" y="258"/>
                  <a:pt x="1259" y="262"/>
                  <a:pt x="1271" y="263"/>
                </a:cubicBezTo>
                <a:cubicBezTo>
                  <a:pt x="1283" y="264"/>
                  <a:pt x="1295" y="262"/>
                  <a:pt x="1307" y="257"/>
                </a:cubicBezTo>
                <a:cubicBezTo>
                  <a:pt x="1319" y="252"/>
                  <a:pt x="1332" y="243"/>
                  <a:pt x="1344" y="231"/>
                </a:cubicBezTo>
                <a:cubicBezTo>
                  <a:pt x="1354" y="221"/>
                  <a:pt x="1362" y="211"/>
                  <a:pt x="1368" y="202"/>
                </a:cubicBezTo>
                <a:cubicBezTo>
                  <a:pt x="1374" y="193"/>
                  <a:pt x="1379" y="184"/>
                  <a:pt x="1382" y="177"/>
                </a:cubicBezTo>
                <a:cubicBezTo>
                  <a:pt x="1386" y="169"/>
                  <a:pt x="1389" y="163"/>
                  <a:pt x="1391" y="158"/>
                </a:cubicBezTo>
                <a:cubicBezTo>
                  <a:pt x="1393" y="152"/>
                  <a:pt x="1395" y="149"/>
                  <a:pt x="1397" y="147"/>
                </a:cubicBezTo>
                <a:cubicBezTo>
                  <a:pt x="1398" y="146"/>
                  <a:pt x="1399" y="145"/>
                  <a:pt x="1400" y="145"/>
                </a:cubicBezTo>
                <a:cubicBezTo>
                  <a:pt x="1402" y="145"/>
                  <a:pt x="1403" y="145"/>
                  <a:pt x="1405" y="145"/>
                </a:cubicBezTo>
                <a:cubicBezTo>
                  <a:pt x="1406" y="146"/>
                  <a:pt x="1408" y="147"/>
                  <a:pt x="1410" y="149"/>
                </a:cubicBezTo>
                <a:cubicBezTo>
                  <a:pt x="1412" y="151"/>
                  <a:pt x="1415" y="153"/>
                  <a:pt x="1418" y="155"/>
                </a:cubicBezTo>
                <a:cubicBezTo>
                  <a:pt x="1420" y="157"/>
                  <a:pt x="1421" y="159"/>
                  <a:pt x="1422" y="161"/>
                </a:cubicBezTo>
                <a:cubicBezTo>
                  <a:pt x="1424" y="162"/>
                  <a:pt x="1425" y="164"/>
                  <a:pt x="1426" y="165"/>
                </a:cubicBezTo>
                <a:cubicBezTo>
                  <a:pt x="1427" y="167"/>
                  <a:pt x="1427" y="168"/>
                  <a:pt x="1428" y="170"/>
                </a:cubicBezTo>
                <a:cubicBezTo>
                  <a:pt x="1428" y="171"/>
                  <a:pt x="1428" y="173"/>
                  <a:pt x="1428" y="174"/>
                </a:cubicBezTo>
                <a:cubicBezTo>
                  <a:pt x="1428" y="176"/>
                  <a:pt x="1427" y="180"/>
                  <a:pt x="1425" y="186"/>
                </a:cubicBezTo>
                <a:cubicBezTo>
                  <a:pt x="1423" y="192"/>
                  <a:pt x="1419" y="199"/>
                  <a:pt x="1415" y="208"/>
                </a:cubicBezTo>
                <a:cubicBezTo>
                  <a:pt x="1410" y="216"/>
                  <a:pt x="1404" y="225"/>
                  <a:pt x="1397" y="235"/>
                </a:cubicBezTo>
                <a:cubicBezTo>
                  <a:pt x="1390" y="245"/>
                  <a:pt x="1381" y="255"/>
                  <a:pt x="1371" y="265"/>
                </a:cubicBezTo>
                <a:cubicBezTo>
                  <a:pt x="1354" y="282"/>
                  <a:pt x="1337" y="295"/>
                  <a:pt x="1320" y="303"/>
                </a:cubicBezTo>
                <a:cubicBezTo>
                  <a:pt x="1302" y="311"/>
                  <a:pt x="1284" y="314"/>
                  <a:pt x="1266" y="314"/>
                </a:cubicBezTo>
                <a:cubicBezTo>
                  <a:pt x="1248" y="313"/>
                  <a:pt x="1230" y="308"/>
                  <a:pt x="1211" y="298"/>
                </a:cubicBezTo>
                <a:cubicBezTo>
                  <a:pt x="1193" y="289"/>
                  <a:pt x="1174" y="275"/>
                  <a:pt x="1156" y="256"/>
                </a:cubicBezTo>
                <a:cubicBezTo>
                  <a:pt x="1138" y="238"/>
                  <a:pt x="1124" y="220"/>
                  <a:pt x="1115" y="201"/>
                </a:cubicBezTo>
                <a:cubicBezTo>
                  <a:pt x="1105" y="182"/>
                  <a:pt x="1100" y="164"/>
                  <a:pt x="1099" y="145"/>
                </a:cubicBezTo>
                <a:cubicBezTo>
                  <a:pt x="1097" y="127"/>
                  <a:pt x="1100" y="109"/>
                  <a:pt x="1107" y="91"/>
                </a:cubicBezTo>
                <a:cubicBezTo>
                  <a:pt x="1114" y="74"/>
                  <a:pt x="1125" y="58"/>
                  <a:pt x="1140" y="42"/>
                </a:cubicBezTo>
                <a:cubicBezTo>
                  <a:pt x="1157" y="26"/>
                  <a:pt x="1173" y="15"/>
                  <a:pt x="1190" y="9"/>
                </a:cubicBezTo>
                <a:cubicBezTo>
                  <a:pt x="1206" y="3"/>
                  <a:pt x="1222" y="0"/>
                  <a:pt x="1239" y="2"/>
                </a:cubicBezTo>
                <a:cubicBezTo>
                  <a:pt x="1255" y="3"/>
                  <a:pt x="1270" y="8"/>
                  <a:pt x="1286" y="17"/>
                </a:cubicBezTo>
                <a:cubicBezTo>
                  <a:pt x="1301" y="25"/>
                  <a:pt x="1315" y="36"/>
                  <a:pt x="1329" y="49"/>
                </a:cubicBezTo>
                <a:lnTo>
                  <a:pt x="1336" y="56"/>
                </a:lnTo>
                <a:close/>
                <a:moveTo>
                  <a:pt x="1286" y="83"/>
                </a:moveTo>
                <a:cubicBezTo>
                  <a:pt x="1267" y="63"/>
                  <a:pt x="1247" y="52"/>
                  <a:pt x="1226" y="50"/>
                </a:cubicBezTo>
                <a:cubicBezTo>
                  <a:pt x="1206" y="48"/>
                  <a:pt x="1186" y="56"/>
                  <a:pt x="1168" y="74"/>
                </a:cubicBezTo>
                <a:cubicBezTo>
                  <a:pt x="1159" y="83"/>
                  <a:pt x="1152" y="93"/>
                  <a:pt x="1149" y="104"/>
                </a:cubicBezTo>
                <a:cubicBezTo>
                  <a:pt x="1145" y="115"/>
                  <a:pt x="1144" y="125"/>
                  <a:pt x="1145" y="136"/>
                </a:cubicBezTo>
                <a:cubicBezTo>
                  <a:pt x="1146" y="146"/>
                  <a:pt x="1149" y="157"/>
                  <a:pt x="1154" y="167"/>
                </a:cubicBezTo>
                <a:cubicBezTo>
                  <a:pt x="1159" y="177"/>
                  <a:pt x="1166" y="187"/>
                  <a:pt x="1174" y="196"/>
                </a:cubicBezTo>
                <a:lnTo>
                  <a:pt x="1286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2" name="Freeform 256"/>
          <p:cNvSpPr>
            <a:spLocks noEditPoints="1"/>
          </p:cNvSpPr>
          <p:nvPr/>
        </p:nvSpPr>
        <p:spPr bwMode="auto">
          <a:xfrm>
            <a:off x="3309496" y="4418880"/>
            <a:ext cx="449523" cy="538163"/>
          </a:xfrm>
          <a:custGeom>
            <a:avLst/>
            <a:gdLst>
              <a:gd name="T0" fmla="*/ 403 w 2823"/>
              <a:gd name="T1" fmla="*/ 2614 h 2828"/>
              <a:gd name="T2" fmla="*/ 210 w 2823"/>
              <a:gd name="T3" fmla="*/ 2814 h 2828"/>
              <a:gd name="T4" fmla="*/ 8 w 2823"/>
              <a:gd name="T5" fmla="*/ 2418 h 2828"/>
              <a:gd name="T6" fmla="*/ 58 w 2823"/>
              <a:gd name="T7" fmla="*/ 2449 h 2828"/>
              <a:gd name="T8" fmla="*/ 509 w 2823"/>
              <a:gd name="T9" fmla="*/ 2515 h 2828"/>
              <a:gd name="T10" fmla="*/ 179 w 2823"/>
              <a:gd name="T11" fmla="*/ 2204 h 2828"/>
              <a:gd name="T12" fmla="*/ 716 w 2823"/>
              <a:gd name="T13" fmla="*/ 2178 h 2828"/>
              <a:gd name="T14" fmla="*/ 710 w 2823"/>
              <a:gd name="T15" fmla="*/ 2464 h 2828"/>
              <a:gd name="T16" fmla="*/ 672 w 2823"/>
              <a:gd name="T17" fmla="*/ 2502 h 2828"/>
              <a:gd name="T18" fmla="*/ 413 w 2823"/>
              <a:gd name="T19" fmla="*/ 2178 h 2828"/>
              <a:gd name="T20" fmla="*/ 577 w 2823"/>
              <a:gd name="T21" fmla="*/ 2065 h 2828"/>
              <a:gd name="T22" fmla="*/ 493 w 2823"/>
              <a:gd name="T23" fmla="*/ 2153 h 2828"/>
              <a:gd name="T24" fmla="*/ 681 w 2823"/>
              <a:gd name="T25" fmla="*/ 2234 h 2828"/>
              <a:gd name="T26" fmla="*/ 995 w 2823"/>
              <a:gd name="T27" fmla="*/ 2028 h 2828"/>
              <a:gd name="T28" fmla="*/ 751 w 2823"/>
              <a:gd name="T29" fmla="*/ 1891 h 2828"/>
              <a:gd name="T30" fmla="*/ 855 w 2823"/>
              <a:gd name="T31" fmla="*/ 2168 h 2828"/>
              <a:gd name="T32" fmla="*/ 544 w 2823"/>
              <a:gd name="T33" fmla="*/ 1838 h 2828"/>
              <a:gd name="T34" fmla="*/ 768 w 2823"/>
              <a:gd name="T35" fmla="*/ 1823 h 2828"/>
              <a:gd name="T36" fmla="*/ 1234 w 2823"/>
              <a:gd name="T37" fmla="*/ 1790 h 2828"/>
              <a:gd name="T38" fmla="*/ 1087 w 2823"/>
              <a:gd name="T39" fmla="*/ 1910 h 2828"/>
              <a:gd name="T40" fmla="*/ 1069 w 2823"/>
              <a:gd name="T41" fmla="*/ 1667 h 2828"/>
              <a:gd name="T42" fmla="*/ 927 w 2823"/>
              <a:gd name="T43" fmla="*/ 1754 h 2828"/>
              <a:gd name="T44" fmla="*/ 908 w 2823"/>
              <a:gd name="T45" fmla="*/ 1684 h 2828"/>
              <a:gd name="T46" fmla="*/ 1112 w 2823"/>
              <a:gd name="T47" fmla="*/ 1710 h 2828"/>
              <a:gd name="T48" fmla="*/ 1152 w 2823"/>
              <a:gd name="T49" fmla="*/ 1804 h 2828"/>
              <a:gd name="T50" fmla="*/ 1185 w 2823"/>
              <a:gd name="T51" fmla="*/ 1605 h 2828"/>
              <a:gd name="T52" fmla="*/ 1674 w 2823"/>
              <a:gd name="T53" fmla="*/ 1319 h 2828"/>
              <a:gd name="T54" fmla="*/ 1642 w 2823"/>
              <a:gd name="T55" fmla="*/ 1368 h 2828"/>
              <a:gd name="T56" fmla="*/ 1443 w 2823"/>
              <a:gd name="T57" fmla="*/ 1580 h 2828"/>
              <a:gd name="T58" fmla="*/ 1263 w 2823"/>
              <a:gd name="T59" fmla="*/ 1162 h 2828"/>
              <a:gd name="T60" fmla="*/ 1400 w 2823"/>
              <a:gd name="T61" fmla="*/ 1403 h 2828"/>
              <a:gd name="T62" fmla="*/ 1749 w 2823"/>
              <a:gd name="T63" fmla="*/ 1274 h 2828"/>
              <a:gd name="T64" fmla="*/ 1438 w 2823"/>
              <a:gd name="T65" fmla="*/ 945 h 2828"/>
              <a:gd name="T66" fmla="*/ 1995 w 2823"/>
              <a:gd name="T67" fmla="*/ 1027 h 2828"/>
              <a:gd name="T68" fmla="*/ 1874 w 2823"/>
              <a:gd name="T69" fmla="*/ 1147 h 2828"/>
              <a:gd name="T70" fmla="*/ 1837 w 2823"/>
              <a:gd name="T71" fmla="*/ 930 h 2828"/>
              <a:gd name="T72" fmla="*/ 1684 w 2823"/>
              <a:gd name="T73" fmla="*/ 990 h 2828"/>
              <a:gd name="T74" fmla="*/ 1650 w 2823"/>
              <a:gd name="T75" fmla="*/ 956 h 2828"/>
              <a:gd name="T76" fmla="*/ 1996 w 2823"/>
              <a:gd name="T77" fmla="*/ 1014 h 2828"/>
              <a:gd name="T78" fmla="*/ 1884 w 2823"/>
              <a:gd name="T79" fmla="*/ 1087 h 2828"/>
              <a:gd name="T80" fmla="*/ 2233 w 2823"/>
              <a:gd name="T81" fmla="*/ 791 h 2828"/>
              <a:gd name="T82" fmla="*/ 2002 w 2823"/>
              <a:gd name="T83" fmla="*/ 648 h 2828"/>
              <a:gd name="T84" fmla="*/ 2093 w 2823"/>
              <a:gd name="T85" fmla="*/ 932 h 2828"/>
              <a:gd name="T86" fmla="*/ 1862 w 2823"/>
              <a:gd name="T87" fmla="*/ 721 h 2828"/>
              <a:gd name="T88" fmla="*/ 1954 w 2823"/>
              <a:gd name="T89" fmla="*/ 623 h 2828"/>
              <a:gd name="T90" fmla="*/ 2349 w 2823"/>
              <a:gd name="T91" fmla="*/ 671 h 2828"/>
              <a:gd name="T92" fmla="*/ 2101 w 2823"/>
              <a:gd name="T93" fmla="*/ 490 h 2828"/>
              <a:gd name="T94" fmla="*/ 2348 w 2823"/>
              <a:gd name="T95" fmla="*/ 662 h 2828"/>
              <a:gd name="T96" fmla="*/ 2053 w 2823"/>
              <a:gd name="T97" fmla="*/ 369 h 2828"/>
              <a:gd name="T98" fmla="*/ 2572 w 2823"/>
              <a:gd name="T99" fmla="*/ 448 h 2828"/>
              <a:gd name="T100" fmla="*/ 2317 w 2823"/>
              <a:gd name="T101" fmla="*/ 345 h 2828"/>
              <a:gd name="T102" fmla="*/ 2432 w 2823"/>
              <a:gd name="T103" fmla="*/ 588 h 2828"/>
              <a:gd name="T104" fmla="*/ 2235 w 2823"/>
              <a:gd name="T105" fmla="*/ 348 h 2828"/>
              <a:gd name="T106" fmla="*/ 2393 w 2823"/>
              <a:gd name="T107" fmla="*/ 235 h 2828"/>
              <a:gd name="T108" fmla="*/ 2631 w 2823"/>
              <a:gd name="T109" fmla="*/ 250 h 2828"/>
              <a:gd name="T110" fmla="*/ 2795 w 2823"/>
              <a:gd name="T111" fmla="*/ 144 h 2828"/>
              <a:gd name="T112" fmla="*/ 2820 w 2823"/>
              <a:gd name="T113" fmla="*/ 185 h 2828"/>
              <a:gd name="T114" fmla="*/ 2509 w 2823"/>
              <a:gd name="T115" fmla="*/ 200 h 2828"/>
              <a:gd name="T116" fmla="*/ 2730 w 2823"/>
              <a:gd name="T117" fmla="*/ 55 h 2828"/>
              <a:gd name="T118" fmla="*/ 2681 w 2823"/>
              <a:gd name="T119" fmla="*/ 82 h 28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2823" h="2828">
                <a:moveTo>
                  <a:pt x="429" y="2564"/>
                </a:moveTo>
                <a:cubicBezTo>
                  <a:pt x="434" y="2566"/>
                  <a:pt x="437" y="2568"/>
                  <a:pt x="440" y="2570"/>
                </a:cubicBezTo>
                <a:cubicBezTo>
                  <a:pt x="442" y="2572"/>
                  <a:pt x="443" y="2574"/>
                  <a:pt x="443" y="2577"/>
                </a:cubicBezTo>
                <a:cubicBezTo>
                  <a:pt x="442" y="2579"/>
                  <a:pt x="441" y="2582"/>
                  <a:pt x="438" y="2585"/>
                </a:cubicBezTo>
                <a:cubicBezTo>
                  <a:pt x="436" y="2588"/>
                  <a:pt x="432" y="2592"/>
                  <a:pt x="428" y="2596"/>
                </a:cubicBezTo>
                <a:cubicBezTo>
                  <a:pt x="423" y="2601"/>
                  <a:pt x="419" y="2605"/>
                  <a:pt x="416" y="2608"/>
                </a:cubicBezTo>
                <a:cubicBezTo>
                  <a:pt x="413" y="2610"/>
                  <a:pt x="410" y="2612"/>
                  <a:pt x="408" y="2613"/>
                </a:cubicBezTo>
                <a:cubicBezTo>
                  <a:pt x="406" y="2614"/>
                  <a:pt x="405" y="2614"/>
                  <a:pt x="403" y="2614"/>
                </a:cubicBezTo>
                <a:cubicBezTo>
                  <a:pt x="401" y="2614"/>
                  <a:pt x="400" y="2613"/>
                  <a:pt x="398" y="2612"/>
                </a:cubicBezTo>
                <a:lnTo>
                  <a:pt x="300" y="2566"/>
                </a:lnTo>
                <a:lnTo>
                  <a:pt x="177" y="2689"/>
                </a:lnTo>
                <a:lnTo>
                  <a:pt x="224" y="2784"/>
                </a:lnTo>
                <a:cubicBezTo>
                  <a:pt x="224" y="2786"/>
                  <a:pt x="225" y="2788"/>
                  <a:pt x="225" y="2790"/>
                </a:cubicBezTo>
                <a:cubicBezTo>
                  <a:pt x="226" y="2792"/>
                  <a:pt x="225" y="2794"/>
                  <a:pt x="224" y="2796"/>
                </a:cubicBezTo>
                <a:cubicBezTo>
                  <a:pt x="224" y="2798"/>
                  <a:pt x="222" y="2800"/>
                  <a:pt x="220" y="2803"/>
                </a:cubicBezTo>
                <a:cubicBezTo>
                  <a:pt x="217" y="2806"/>
                  <a:pt x="214" y="2810"/>
                  <a:pt x="210" y="2814"/>
                </a:cubicBezTo>
                <a:cubicBezTo>
                  <a:pt x="205" y="2819"/>
                  <a:pt x="202" y="2822"/>
                  <a:pt x="198" y="2825"/>
                </a:cubicBezTo>
                <a:cubicBezTo>
                  <a:pt x="195" y="2827"/>
                  <a:pt x="192" y="2828"/>
                  <a:pt x="190" y="2828"/>
                </a:cubicBezTo>
                <a:cubicBezTo>
                  <a:pt x="188" y="2828"/>
                  <a:pt x="186" y="2827"/>
                  <a:pt x="184" y="2825"/>
                </a:cubicBezTo>
                <a:cubicBezTo>
                  <a:pt x="182" y="2823"/>
                  <a:pt x="180" y="2820"/>
                  <a:pt x="178" y="2815"/>
                </a:cubicBezTo>
                <a:lnTo>
                  <a:pt x="2" y="2440"/>
                </a:lnTo>
                <a:cubicBezTo>
                  <a:pt x="1" y="2438"/>
                  <a:pt x="0" y="2436"/>
                  <a:pt x="0" y="2434"/>
                </a:cubicBezTo>
                <a:cubicBezTo>
                  <a:pt x="0" y="2432"/>
                  <a:pt x="0" y="2429"/>
                  <a:pt x="2" y="2427"/>
                </a:cubicBezTo>
                <a:cubicBezTo>
                  <a:pt x="3" y="2424"/>
                  <a:pt x="5" y="2421"/>
                  <a:pt x="8" y="2418"/>
                </a:cubicBezTo>
                <a:cubicBezTo>
                  <a:pt x="11" y="2415"/>
                  <a:pt x="14" y="2411"/>
                  <a:pt x="19" y="2406"/>
                </a:cubicBezTo>
                <a:cubicBezTo>
                  <a:pt x="24" y="2402"/>
                  <a:pt x="28" y="2398"/>
                  <a:pt x="31" y="2395"/>
                </a:cubicBezTo>
                <a:cubicBezTo>
                  <a:pt x="35" y="2392"/>
                  <a:pt x="38" y="2389"/>
                  <a:pt x="40" y="2388"/>
                </a:cubicBezTo>
                <a:cubicBezTo>
                  <a:pt x="43" y="2387"/>
                  <a:pt x="45" y="2386"/>
                  <a:pt x="48" y="2386"/>
                </a:cubicBezTo>
                <a:cubicBezTo>
                  <a:pt x="50" y="2386"/>
                  <a:pt x="52" y="2387"/>
                  <a:pt x="54" y="2388"/>
                </a:cubicBezTo>
                <a:lnTo>
                  <a:pt x="429" y="2564"/>
                </a:lnTo>
                <a:close/>
                <a:moveTo>
                  <a:pt x="58" y="2448"/>
                </a:moveTo>
                <a:lnTo>
                  <a:pt x="58" y="2449"/>
                </a:lnTo>
                <a:lnTo>
                  <a:pt x="155" y="2648"/>
                </a:lnTo>
                <a:lnTo>
                  <a:pt x="258" y="2544"/>
                </a:lnTo>
                <a:lnTo>
                  <a:pt x="58" y="2448"/>
                </a:lnTo>
                <a:close/>
                <a:moveTo>
                  <a:pt x="521" y="2489"/>
                </a:moveTo>
                <a:cubicBezTo>
                  <a:pt x="522" y="2491"/>
                  <a:pt x="522" y="2492"/>
                  <a:pt x="523" y="2493"/>
                </a:cubicBezTo>
                <a:cubicBezTo>
                  <a:pt x="523" y="2495"/>
                  <a:pt x="523" y="2497"/>
                  <a:pt x="522" y="2499"/>
                </a:cubicBezTo>
                <a:cubicBezTo>
                  <a:pt x="521" y="2501"/>
                  <a:pt x="520" y="2503"/>
                  <a:pt x="518" y="2506"/>
                </a:cubicBezTo>
                <a:cubicBezTo>
                  <a:pt x="515" y="2508"/>
                  <a:pt x="512" y="2512"/>
                  <a:pt x="509" y="2515"/>
                </a:cubicBezTo>
                <a:cubicBezTo>
                  <a:pt x="505" y="2519"/>
                  <a:pt x="502" y="2522"/>
                  <a:pt x="499" y="2524"/>
                </a:cubicBezTo>
                <a:cubicBezTo>
                  <a:pt x="496" y="2526"/>
                  <a:pt x="494" y="2528"/>
                  <a:pt x="492" y="2529"/>
                </a:cubicBezTo>
                <a:cubicBezTo>
                  <a:pt x="490" y="2530"/>
                  <a:pt x="488" y="2530"/>
                  <a:pt x="487" y="2529"/>
                </a:cubicBezTo>
                <a:cubicBezTo>
                  <a:pt x="485" y="2529"/>
                  <a:pt x="484" y="2528"/>
                  <a:pt x="483" y="2527"/>
                </a:cubicBezTo>
                <a:lnTo>
                  <a:pt x="176" y="2221"/>
                </a:lnTo>
                <a:cubicBezTo>
                  <a:pt x="175" y="2220"/>
                  <a:pt x="174" y="2218"/>
                  <a:pt x="174" y="2217"/>
                </a:cubicBezTo>
                <a:cubicBezTo>
                  <a:pt x="174" y="2215"/>
                  <a:pt x="174" y="2214"/>
                  <a:pt x="175" y="2212"/>
                </a:cubicBezTo>
                <a:cubicBezTo>
                  <a:pt x="176" y="2210"/>
                  <a:pt x="177" y="2207"/>
                  <a:pt x="179" y="2204"/>
                </a:cubicBezTo>
                <a:cubicBezTo>
                  <a:pt x="181" y="2202"/>
                  <a:pt x="184" y="2198"/>
                  <a:pt x="188" y="2195"/>
                </a:cubicBezTo>
                <a:cubicBezTo>
                  <a:pt x="192" y="2191"/>
                  <a:pt x="195" y="2188"/>
                  <a:pt x="198" y="2186"/>
                </a:cubicBezTo>
                <a:cubicBezTo>
                  <a:pt x="200" y="2184"/>
                  <a:pt x="203" y="2182"/>
                  <a:pt x="205" y="2181"/>
                </a:cubicBezTo>
                <a:cubicBezTo>
                  <a:pt x="207" y="2181"/>
                  <a:pt x="209" y="2180"/>
                  <a:pt x="210" y="2181"/>
                </a:cubicBezTo>
                <a:cubicBezTo>
                  <a:pt x="212" y="2181"/>
                  <a:pt x="213" y="2182"/>
                  <a:pt x="214" y="2183"/>
                </a:cubicBezTo>
                <a:lnTo>
                  <a:pt x="521" y="2489"/>
                </a:lnTo>
                <a:close/>
                <a:moveTo>
                  <a:pt x="674" y="2123"/>
                </a:moveTo>
                <a:cubicBezTo>
                  <a:pt x="692" y="2142"/>
                  <a:pt x="706" y="2160"/>
                  <a:pt x="716" y="2178"/>
                </a:cubicBezTo>
                <a:cubicBezTo>
                  <a:pt x="727" y="2196"/>
                  <a:pt x="733" y="2214"/>
                  <a:pt x="736" y="2232"/>
                </a:cubicBezTo>
                <a:cubicBezTo>
                  <a:pt x="738" y="2249"/>
                  <a:pt x="737" y="2266"/>
                  <a:pt x="731" y="2283"/>
                </a:cubicBezTo>
                <a:cubicBezTo>
                  <a:pt x="725" y="2300"/>
                  <a:pt x="715" y="2315"/>
                  <a:pt x="701" y="2329"/>
                </a:cubicBezTo>
                <a:cubicBezTo>
                  <a:pt x="695" y="2335"/>
                  <a:pt x="688" y="2341"/>
                  <a:pt x="682" y="2344"/>
                </a:cubicBezTo>
                <a:cubicBezTo>
                  <a:pt x="675" y="2348"/>
                  <a:pt x="668" y="2352"/>
                  <a:pt x="661" y="2354"/>
                </a:cubicBezTo>
                <a:cubicBezTo>
                  <a:pt x="653" y="2356"/>
                  <a:pt x="645" y="2358"/>
                  <a:pt x="636" y="2359"/>
                </a:cubicBezTo>
                <a:cubicBezTo>
                  <a:pt x="627" y="2360"/>
                  <a:pt x="618" y="2360"/>
                  <a:pt x="607" y="2361"/>
                </a:cubicBezTo>
                <a:lnTo>
                  <a:pt x="710" y="2464"/>
                </a:lnTo>
                <a:cubicBezTo>
                  <a:pt x="711" y="2465"/>
                  <a:pt x="712" y="2466"/>
                  <a:pt x="712" y="2468"/>
                </a:cubicBezTo>
                <a:cubicBezTo>
                  <a:pt x="712" y="2469"/>
                  <a:pt x="712" y="2471"/>
                  <a:pt x="711" y="2473"/>
                </a:cubicBezTo>
                <a:cubicBezTo>
                  <a:pt x="711" y="2475"/>
                  <a:pt x="709" y="2477"/>
                  <a:pt x="707" y="2480"/>
                </a:cubicBezTo>
                <a:cubicBezTo>
                  <a:pt x="705" y="2483"/>
                  <a:pt x="702" y="2486"/>
                  <a:pt x="698" y="2490"/>
                </a:cubicBezTo>
                <a:cubicBezTo>
                  <a:pt x="695" y="2494"/>
                  <a:pt x="691" y="2497"/>
                  <a:pt x="689" y="2499"/>
                </a:cubicBezTo>
                <a:cubicBezTo>
                  <a:pt x="686" y="2501"/>
                  <a:pt x="683" y="2502"/>
                  <a:pt x="681" y="2503"/>
                </a:cubicBezTo>
                <a:cubicBezTo>
                  <a:pt x="679" y="2504"/>
                  <a:pt x="677" y="2504"/>
                  <a:pt x="676" y="2504"/>
                </a:cubicBezTo>
                <a:cubicBezTo>
                  <a:pt x="675" y="2504"/>
                  <a:pt x="673" y="2503"/>
                  <a:pt x="672" y="2502"/>
                </a:cubicBezTo>
                <a:lnTo>
                  <a:pt x="384" y="2213"/>
                </a:lnTo>
                <a:cubicBezTo>
                  <a:pt x="382" y="2212"/>
                  <a:pt x="382" y="2211"/>
                  <a:pt x="381" y="2209"/>
                </a:cubicBezTo>
                <a:cubicBezTo>
                  <a:pt x="381" y="2208"/>
                  <a:pt x="381" y="2206"/>
                  <a:pt x="382" y="2204"/>
                </a:cubicBezTo>
                <a:cubicBezTo>
                  <a:pt x="383" y="2202"/>
                  <a:pt x="384" y="2200"/>
                  <a:pt x="386" y="2198"/>
                </a:cubicBezTo>
                <a:cubicBezTo>
                  <a:pt x="388" y="2196"/>
                  <a:pt x="390" y="2193"/>
                  <a:pt x="393" y="2190"/>
                </a:cubicBezTo>
                <a:cubicBezTo>
                  <a:pt x="396" y="2187"/>
                  <a:pt x="399" y="2184"/>
                  <a:pt x="402" y="2182"/>
                </a:cubicBezTo>
                <a:cubicBezTo>
                  <a:pt x="404" y="2180"/>
                  <a:pt x="406" y="2179"/>
                  <a:pt x="408" y="2178"/>
                </a:cubicBezTo>
                <a:cubicBezTo>
                  <a:pt x="410" y="2178"/>
                  <a:pt x="412" y="2177"/>
                  <a:pt x="413" y="2178"/>
                </a:cubicBezTo>
                <a:cubicBezTo>
                  <a:pt x="414" y="2178"/>
                  <a:pt x="416" y="2179"/>
                  <a:pt x="417" y="2180"/>
                </a:cubicBezTo>
                <a:lnTo>
                  <a:pt x="445" y="2208"/>
                </a:lnTo>
                <a:cubicBezTo>
                  <a:pt x="445" y="2195"/>
                  <a:pt x="445" y="2184"/>
                  <a:pt x="446" y="2173"/>
                </a:cubicBezTo>
                <a:cubicBezTo>
                  <a:pt x="447" y="2162"/>
                  <a:pt x="449" y="2153"/>
                  <a:pt x="452" y="2144"/>
                </a:cubicBezTo>
                <a:cubicBezTo>
                  <a:pt x="455" y="2135"/>
                  <a:pt x="458" y="2126"/>
                  <a:pt x="463" y="2118"/>
                </a:cubicBezTo>
                <a:cubicBezTo>
                  <a:pt x="468" y="2111"/>
                  <a:pt x="473" y="2103"/>
                  <a:pt x="480" y="2096"/>
                </a:cubicBezTo>
                <a:cubicBezTo>
                  <a:pt x="495" y="2081"/>
                  <a:pt x="511" y="2072"/>
                  <a:pt x="527" y="2067"/>
                </a:cubicBezTo>
                <a:cubicBezTo>
                  <a:pt x="543" y="2062"/>
                  <a:pt x="560" y="2061"/>
                  <a:pt x="577" y="2065"/>
                </a:cubicBezTo>
                <a:cubicBezTo>
                  <a:pt x="594" y="2068"/>
                  <a:pt x="610" y="2075"/>
                  <a:pt x="627" y="2086"/>
                </a:cubicBezTo>
                <a:cubicBezTo>
                  <a:pt x="643" y="2096"/>
                  <a:pt x="659" y="2109"/>
                  <a:pt x="674" y="2123"/>
                </a:cubicBezTo>
                <a:close/>
                <a:moveTo>
                  <a:pt x="639" y="2167"/>
                </a:moveTo>
                <a:cubicBezTo>
                  <a:pt x="628" y="2157"/>
                  <a:pt x="617" y="2147"/>
                  <a:pt x="606" y="2139"/>
                </a:cubicBezTo>
                <a:cubicBezTo>
                  <a:pt x="594" y="2131"/>
                  <a:pt x="583" y="2125"/>
                  <a:pt x="571" y="2121"/>
                </a:cubicBezTo>
                <a:cubicBezTo>
                  <a:pt x="560" y="2117"/>
                  <a:pt x="548" y="2116"/>
                  <a:pt x="537" y="2118"/>
                </a:cubicBezTo>
                <a:cubicBezTo>
                  <a:pt x="526" y="2120"/>
                  <a:pt x="515" y="2126"/>
                  <a:pt x="506" y="2136"/>
                </a:cubicBezTo>
                <a:cubicBezTo>
                  <a:pt x="501" y="2141"/>
                  <a:pt x="496" y="2147"/>
                  <a:pt x="493" y="2153"/>
                </a:cubicBezTo>
                <a:cubicBezTo>
                  <a:pt x="490" y="2159"/>
                  <a:pt x="487" y="2166"/>
                  <a:pt x="486" y="2174"/>
                </a:cubicBezTo>
                <a:cubicBezTo>
                  <a:pt x="484" y="2182"/>
                  <a:pt x="483" y="2192"/>
                  <a:pt x="482" y="2202"/>
                </a:cubicBezTo>
                <a:cubicBezTo>
                  <a:pt x="482" y="2213"/>
                  <a:pt x="483" y="2225"/>
                  <a:pt x="484" y="2238"/>
                </a:cubicBezTo>
                <a:lnTo>
                  <a:pt x="566" y="2320"/>
                </a:lnTo>
                <a:cubicBezTo>
                  <a:pt x="589" y="2322"/>
                  <a:pt x="609" y="2322"/>
                  <a:pt x="625" y="2320"/>
                </a:cubicBezTo>
                <a:cubicBezTo>
                  <a:pt x="641" y="2317"/>
                  <a:pt x="655" y="2310"/>
                  <a:pt x="665" y="2300"/>
                </a:cubicBezTo>
                <a:cubicBezTo>
                  <a:pt x="674" y="2291"/>
                  <a:pt x="680" y="2280"/>
                  <a:pt x="683" y="2269"/>
                </a:cubicBezTo>
                <a:cubicBezTo>
                  <a:pt x="685" y="2257"/>
                  <a:pt x="684" y="2246"/>
                  <a:pt x="681" y="2234"/>
                </a:cubicBezTo>
                <a:cubicBezTo>
                  <a:pt x="677" y="2222"/>
                  <a:pt x="672" y="2210"/>
                  <a:pt x="664" y="2199"/>
                </a:cubicBezTo>
                <a:cubicBezTo>
                  <a:pt x="657" y="2187"/>
                  <a:pt x="648" y="2177"/>
                  <a:pt x="639" y="2167"/>
                </a:cubicBezTo>
                <a:close/>
                <a:moveTo>
                  <a:pt x="1017" y="1993"/>
                </a:moveTo>
                <a:cubicBezTo>
                  <a:pt x="1018" y="1994"/>
                  <a:pt x="1019" y="1996"/>
                  <a:pt x="1019" y="1997"/>
                </a:cubicBezTo>
                <a:cubicBezTo>
                  <a:pt x="1019" y="1999"/>
                  <a:pt x="1019" y="2000"/>
                  <a:pt x="1018" y="2002"/>
                </a:cubicBezTo>
                <a:cubicBezTo>
                  <a:pt x="1017" y="2004"/>
                  <a:pt x="1016" y="2007"/>
                  <a:pt x="1014" y="2009"/>
                </a:cubicBezTo>
                <a:cubicBezTo>
                  <a:pt x="1012" y="2012"/>
                  <a:pt x="1009" y="2015"/>
                  <a:pt x="1005" y="2019"/>
                </a:cubicBezTo>
                <a:cubicBezTo>
                  <a:pt x="1001" y="2023"/>
                  <a:pt x="998" y="2026"/>
                  <a:pt x="995" y="2028"/>
                </a:cubicBezTo>
                <a:cubicBezTo>
                  <a:pt x="992" y="2030"/>
                  <a:pt x="990" y="2032"/>
                  <a:pt x="988" y="2032"/>
                </a:cubicBezTo>
                <a:cubicBezTo>
                  <a:pt x="986" y="2033"/>
                  <a:pt x="984" y="2033"/>
                  <a:pt x="983" y="2033"/>
                </a:cubicBezTo>
                <a:cubicBezTo>
                  <a:pt x="981" y="2033"/>
                  <a:pt x="980" y="2032"/>
                  <a:pt x="979" y="2031"/>
                </a:cubicBezTo>
                <a:lnTo>
                  <a:pt x="858" y="1910"/>
                </a:lnTo>
                <a:cubicBezTo>
                  <a:pt x="846" y="1898"/>
                  <a:pt x="836" y="1890"/>
                  <a:pt x="827" y="1884"/>
                </a:cubicBezTo>
                <a:cubicBezTo>
                  <a:pt x="818" y="1879"/>
                  <a:pt x="809" y="1876"/>
                  <a:pt x="800" y="1874"/>
                </a:cubicBezTo>
                <a:cubicBezTo>
                  <a:pt x="792" y="1872"/>
                  <a:pt x="783" y="1873"/>
                  <a:pt x="775" y="1876"/>
                </a:cubicBezTo>
                <a:cubicBezTo>
                  <a:pt x="766" y="1878"/>
                  <a:pt x="759" y="1884"/>
                  <a:pt x="751" y="1891"/>
                </a:cubicBezTo>
                <a:cubicBezTo>
                  <a:pt x="742" y="1900"/>
                  <a:pt x="736" y="1913"/>
                  <a:pt x="733" y="1929"/>
                </a:cubicBezTo>
                <a:cubicBezTo>
                  <a:pt x="730" y="1946"/>
                  <a:pt x="730" y="1965"/>
                  <a:pt x="733" y="1989"/>
                </a:cubicBezTo>
                <a:lnTo>
                  <a:pt x="877" y="2133"/>
                </a:lnTo>
                <a:cubicBezTo>
                  <a:pt x="878" y="2134"/>
                  <a:pt x="879" y="2136"/>
                  <a:pt x="879" y="2137"/>
                </a:cubicBezTo>
                <a:cubicBezTo>
                  <a:pt x="879" y="2138"/>
                  <a:pt x="879" y="2140"/>
                  <a:pt x="878" y="2142"/>
                </a:cubicBezTo>
                <a:cubicBezTo>
                  <a:pt x="878" y="2144"/>
                  <a:pt x="876" y="2146"/>
                  <a:pt x="874" y="2149"/>
                </a:cubicBezTo>
                <a:cubicBezTo>
                  <a:pt x="872" y="2152"/>
                  <a:pt x="869" y="2155"/>
                  <a:pt x="865" y="2159"/>
                </a:cubicBezTo>
                <a:cubicBezTo>
                  <a:pt x="861" y="2163"/>
                  <a:pt x="858" y="2166"/>
                  <a:pt x="855" y="2168"/>
                </a:cubicBezTo>
                <a:cubicBezTo>
                  <a:pt x="853" y="2170"/>
                  <a:pt x="850" y="2171"/>
                  <a:pt x="848" y="2172"/>
                </a:cubicBezTo>
                <a:cubicBezTo>
                  <a:pt x="846" y="2173"/>
                  <a:pt x="844" y="2173"/>
                  <a:pt x="843" y="2173"/>
                </a:cubicBezTo>
                <a:cubicBezTo>
                  <a:pt x="842" y="2173"/>
                  <a:pt x="840" y="2172"/>
                  <a:pt x="839" y="2171"/>
                </a:cubicBezTo>
                <a:lnTo>
                  <a:pt x="533" y="1865"/>
                </a:lnTo>
                <a:cubicBezTo>
                  <a:pt x="532" y="1863"/>
                  <a:pt x="531" y="1862"/>
                  <a:pt x="530" y="1860"/>
                </a:cubicBezTo>
                <a:cubicBezTo>
                  <a:pt x="530" y="1859"/>
                  <a:pt x="530" y="1857"/>
                  <a:pt x="531" y="1855"/>
                </a:cubicBezTo>
                <a:cubicBezTo>
                  <a:pt x="532" y="1853"/>
                  <a:pt x="533" y="1851"/>
                  <a:pt x="536" y="1848"/>
                </a:cubicBezTo>
                <a:cubicBezTo>
                  <a:pt x="538" y="1845"/>
                  <a:pt x="541" y="1842"/>
                  <a:pt x="544" y="1838"/>
                </a:cubicBezTo>
                <a:cubicBezTo>
                  <a:pt x="548" y="1835"/>
                  <a:pt x="551" y="1832"/>
                  <a:pt x="554" y="1829"/>
                </a:cubicBezTo>
                <a:cubicBezTo>
                  <a:pt x="557" y="1827"/>
                  <a:pt x="559" y="1826"/>
                  <a:pt x="561" y="1825"/>
                </a:cubicBezTo>
                <a:cubicBezTo>
                  <a:pt x="563" y="1824"/>
                  <a:pt x="565" y="1824"/>
                  <a:pt x="567" y="1824"/>
                </a:cubicBezTo>
                <a:cubicBezTo>
                  <a:pt x="568" y="1825"/>
                  <a:pt x="569" y="1825"/>
                  <a:pt x="571" y="1827"/>
                </a:cubicBezTo>
                <a:lnTo>
                  <a:pt x="694" y="1950"/>
                </a:lnTo>
                <a:cubicBezTo>
                  <a:pt x="694" y="1928"/>
                  <a:pt x="696" y="1908"/>
                  <a:pt x="701" y="1892"/>
                </a:cubicBezTo>
                <a:cubicBezTo>
                  <a:pt x="707" y="1875"/>
                  <a:pt x="715" y="1861"/>
                  <a:pt x="726" y="1850"/>
                </a:cubicBezTo>
                <a:cubicBezTo>
                  <a:pt x="740" y="1837"/>
                  <a:pt x="754" y="1827"/>
                  <a:pt x="768" y="1823"/>
                </a:cubicBezTo>
                <a:cubicBezTo>
                  <a:pt x="782" y="1818"/>
                  <a:pt x="796" y="1816"/>
                  <a:pt x="810" y="1818"/>
                </a:cubicBezTo>
                <a:cubicBezTo>
                  <a:pt x="823" y="1820"/>
                  <a:pt x="836" y="1825"/>
                  <a:pt x="849" y="1833"/>
                </a:cubicBezTo>
                <a:cubicBezTo>
                  <a:pt x="862" y="1841"/>
                  <a:pt x="876" y="1853"/>
                  <a:pt x="891" y="1867"/>
                </a:cubicBezTo>
                <a:lnTo>
                  <a:pt x="1017" y="1993"/>
                </a:lnTo>
                <a:close/>
                <a:moveTo>
                  <a:pt x="1244" y="1767"/>
                </a:moveTo>
                <a:cubicBezTo>
                  <a:pt x="1245" y="1769"/>
                  <a:pt x="1246" y="1771"/>
                  <a:pt x="1246" y="1773"/>
                </a:cubicBezTo>
                <a:cubicBezTo>
                  <a:pt x="1246" y="1775"/>
                  <a:pt x="1245" y="1777"/>
                  <a:pt x="1243" y="1780"/>
                </a:cubicBezTo>
                <a:cubicBezTo>
                  <a:pt x="1241" y="1782"/>
                  <a:pt x="1238" y="1786"/>
                  <a:pt x="1234" y="1790"/>
                </a:cubicBezTo>
                <a:cubicBezTo>
                  <a:pt x="1230" y="1794"/>
                  <a:pt x="1227" y="1797"/>
                  <a:pt x="1224" y="1799"/>
                </a:cubicBezTo>
                <a:cubicBezTo>
                  <a:pt x="1221" y="1801"/>
                  <a:pt x="1219" y="1802"/>
                  <a:pt x="1217" y="1802"/>
                </a:cubicBezTo>
                <a:cubicBezTo>
                  <a:pt x="1215" y="1802"/>
                  <a:pt x="1213" y="1801"/>
                  <a:pt x="1211" y="1799"/>
                </a:cubicBezTo>
                <a:lnTo>
                  <a:pt x="1190" y="1779"/>
                </a:lnTo>
                <a:cubicBezTo>
                  <a:pt x="1191" y="1797"/>
                  <a:pt x="1189" y="1815"/>
                  <a:pt x="1183" y="1831"/>
                </a:cubicBezTo>
                <a:cubicBezTo>
                  <a:pt x="1177" y="1848"/>
                  <a:pt x="1168" y="1862"/>
                  <a:pt x="1156" y="1874"/>
                </a:cubicBezTo>
                <a:cubicBezTo>
                  <a:pt x="1145" y="1885"/>
                  <a:pt x="1134" y="1894"/>
                  <a:pt x="1122" y="1900"/>
                </a:cubicBezTo>
                <a:cubicBezTo>
                  <a:pt x="1110" y="1906"/>
                  <a:pt x="1099" y="1909"/>
                  <a:pt x="1087" y="1910"/>
                </a:cubicBezTo>
                <a:cubicBezTo>
                  <a:pt x="1076" y="1911"/>
                  <a:pt x="1064" y="1909"/>
                  <a:pt x="1053" y="1905"/>
                </a:cubicBezTo>
                <a:cubicBezTo>
                  <a:pt x="1042" y="1900"/>
                  <a:pt x="1031" y="1893"/>
                  <a:pt x="1021" y="1883"/>
                </a:cubicBezTo>
                <a:cubicBezTo>
                  <a:pt x="1010" y="1872"/>
                  <a:pt x="1002" y="1859"/>
                  <a:pt x="998" y="1846"/>
                </a:cubicBezTo>
                <a:cubicBezTo>
                  <a:pt x="994" y="1832"/>
                  <a:pt x="994" y="1819"/>
                  <a:pt x="997" y="1804"/>
                </a:cubicBezTo>
                <a:cubicBezTo>
                  <a:pt x="1000" y="1790"/>
                  <a:pt x="1007" y="1774"/>
                  <a:pt x="1017" y="1759"/>
                </a:cubicBezTo>
                <a:cubicBezTo>
                  <a:pt x="1027" y="1743"/>
                  <a:pt x="1040" y="1727"/>
                  <a:pt x="1056" y="1711"/>
                </a:cubicBezTo>
                <a:lnTo>
                  <a:pt x="1085" y="1683"/>
                </a:lnTo>
                <a:lnTo>
                  <a:pt x="1069" y="1667"/>
                </a:lnTo>
                <a:cubicBezTo>
                  <a:pt x="1061" y="1659"/>
                  <a:pt x="1053" y="1653"/>
                  <a:pt x="1045" y="1648"/>
                </a:cubicBezTo>
                <a:cubicBezTo>
                  <a:pt x="1037" y="1644"/>
                  <a:pt x="1029" y="1641"/>
                  <a:pt x="1022" y="1641"/>
                </a:cubicBezTo>
                <a:cubicBezTo>
                  <a:pt x="1014" y="1641"/>
                  <a:pt x="1006" y="1643"/>
                  <a:pt x="998" y="1646"/>
                </a:cubicBezTo>
                <a:cubicBezTo>
                  <a:pt x="990" y="1650"/>
                  <a:pt x="981" y="1657"/>
                  <a:pt x="973" y="1665"/>
                </a:cubicBezTo>
                <a:cubicBezTo>
                  <a:pt x="963" y="1675"/>
                  <a:pt x="956" y="1684"/>
                  <a:pt x="951" y="1694"/>
                </a:cubicBezTo>
                <a:cubicBezTo>
                  <a:pt x="946" y="1703"/>
                  <a:pt x="942" y="1712"/>
                  <a:pt x="939" y="1721"/>
                </a:cubicBezTo>
                <a:cubicBezTo>
                  <a:pt x="936" y="1729"/>
                  <a:pt x="934" y="1736"/>
                  <a:pt x="932" y="1742"/>
                </a:cubicBezTo>
                <a:cubicBezTo>
                  <a:pt x="931" y="1748"/>
                  <a:pt x="929" y="1752"/>
                  <a:pt x="927" y="1754"/>
                </a:cubicBezTo>
                <a:cubicBezTo>
                  <a:pt x="926" y="1755"/>
                  <a:pt x="924" y="1756"/>
                  <a:pt x="923" y="1756"/>
                </a:cubicBezTo>
                <a:cubicBezTo>
                  <a:pt x="921" y="1756"/>
                  <a:pt x="920" y="1756"/>
                  <a:pt x="918" y="1756"/>
                </a:cubicBezTo>
                <a:cubicBezTo>
                  <a:pt x="916" y="1755"/>
                  <a:pt x="914" y="1754"/>
                  <a:pt x="912" y="1752"/>
                </a:cubicBezTo>
                <a:cubicBezTo>
                  <a:pt x="909" y="1751"/>
                  <a:pt x="907" y="1749"/>
                  <a:pt x="905" y="1747"/>
                </a:cubicBezTo>
                <a:cubicBezTo>
                  <a:pt x="901" y="1743"/>
                  <a:pt x="898" y="1739"/>
                  <a:pt x="897" y="1737"/>
                </a:cubicBezTo>
                <a:cubicBezTo>
                  <a:pt x="895" y="1734"/>
                  <a:pt x="894" y="1730"/>
                  <a:pt x="894" y="1726"/>
                </a:cubicBezTo>
                <a:cubicBezTo>
                  <a:pt x="894" y="1722"/>
                  <a:pt x="895" y="1717"/>
                  <a:pt x="898" y="1709"/>
                </a:cubicBezTo>
                <a:cubicBezTo>
                  <a:pt x="900" y="1701"/>
                  <a:pt x="904" y="1693"/>
                  <a:pt x="908" y="1684"/>
                </a:cubicBezTo>
                <a:cubicBezTo>
                  <a:pt x="912" y="1675"/>
                  <a:pt x="918" y="1666"/>
                  <a:pt x="924" y="1657"/>
                </a:cubicBezTo>
                <a:cubicBezTo>
                  <a:pt x="930" y="1648"/>
                  <a:pt x="937" y="1639"/>
                  <a:pt x="945" y="1631"/>
                </a:cubicBezTo>
                <a:cubicBezTo>
                  <a:pt x="960" y="1616"/>
                  <a:pt x="975" y="1605"/>
                  <a:pt x="988" y="1598"/>
                </a:cubicBezTo>
                <a:cubicBezTo>
                  <a:pt x="1002" y="1591"/>
                  <a:pt x="1015" y="1588"/>
                  <a:pt x="1028" y="1588"/>
                </a:cubicBezTo>
                <a:cubicBezTo>
                  <a:pt x="1041" y="1588"/>
                  <a:pt x="1054" y="1591"/>
                  <a:pt x="1066" y="1598"/>
                </a:cubicBezTo>
                <a:cubicBezTo>
                  <a:pt x="1079" y="1605"/>
                  <a:pt x="1092" y="1615"/>
                  <a:pt x="1105" y="1628"/>
                </a:cubicBezTo>
                <a:lnTo>
                  <a:pt x="1244" y="1767"/>
                </a:lnTo>
                <a:close/>
                <a:moveTo>
                  <a:pt x="1112" y="1710"/>
                </a:moveTo>
                <a:lnTo>
                  <a:pt x="1080" y="1742"/>
                </a:lnTo>
                <a:cubicBezTo>
                  <a:pt x="1069" y="1753"/>
                  <a:pt x="1061" y="1763"/>
                  <a:pt x="1055" y="1772"/>
                </a:cubicBezTo>
                <a:cubicBezTo>
                  <a:pt x="1049" y="1781"/>
                  <a:pt x="1045" y="1790"/>
                  <a:pt x="1044" y="1799"/>
                </a:cubicBezTo>
                <a:cubicBezTo>
                  <a:pt x="1042" y="1807"/>
                  <a:pt x="1043" y="1815"/>
                  <a:pt x="1045" y="1822"/>
                </a:cubicBezTo>
                <a:cubicBezTo>
                  <a:pt x="1048" y="1830"/>
                  <a:pt x="1052" y="1836"/>
                  <a:pt x="1058" y="1843"/>
                </a:cubicBezTo>
                <a:cubicBezTo>
                  <a:pt x="1069" y="1853"/>
                  <a:pt x="1081" y="1858"/>
                  <a:pt x="1094" y="1858"/>
                </a:cubicBezTo>
                <a:cubicBezTo>
                  <a:pt x="1107" y="1857"/>
                  <a:pt x="1120" y="1851"/>
                  <a:pt x="1132" y="1839"/>
                </a:cubicBezTo>
                <a:cubicBezTo>
                  <a:pt x="1142" y="1829"/>
                  <a:pt x="1149" y="1817"/>
                  <a:pt x="1152" y="1804"/>
                </a:cubicBezTo>
                <a:cubicBezTo>
                  <a:pt x="1156" y="1790"/>
                  <a:pt x="1157" y="1774"/>
                  <a:pt x="1156" y="1754"/>
                </a:cubicBezTo>
                <a:lnTo>
                  <a:pt x="1112" y="1710"/>
                </a:lnTo>
                <a:close/>
                <a:moveTo>
                  <a:pt x="1297" y="1493"/>
                </a:moveTo>
                <a:cubicBezTo>
                  <a:pt x="1303" y="1499"/>
                  <a:pt x="1306" y="1503"/>
                  <a:pt x="1307" y="1507"/>
                </a:cubicBezTo>
                <a:cubicBezTo>
                  <a:pt x="1308" y="1511"/>
                  <a:pt x="1307" y="1514"/>
                  <a:pt x="1305" y="1517"/>
                </a:cubicBezTo>
                <a:lnTo>
                  <a:pt x="1209" y="1612"/>
                </a:lnTo>
                <a:cubicBezTo>
                  <a:pt x="1206" y="1615"/>
                  <a:pt x="1203" y="1616"/>
                  <a:pt x="1199" y="1615"/>
                </a:cubicBezTo>
                <a:cubicBezTo>
                  <a:pt x="1196" y="1614"/>
                  <a:pt x="1191" y="1611"/>
                  <a:pt x="1185" y="1605"/>
                </a:cubicBezTo>
                <a:cubicBezTo>
                  <a:pt x="1179" y="1599"/>
                  <a:pt x="1176" y="1594"/>
                  <a:pt x="1175" y="1591"/>
                </a:cubicBezTo>
                <a:cubicBezTo>
                  <a:pt x="1174" y="1587"/>
                  <a:pt x="1175" y="1584"/>
                  <a:pt x="1178" y="1581"/>
                </a:cubicBezTo>
                <a:lnTo>
                  <a:pt x="1273" y="1485"/>
                </a:lnTo>
                <a:cubicBezTo>
                  <a:pt x="1275" y="1484"/>
                  <a:pt x="1276" y="1483"/>
                  <a:pt x="1277" y="1483"/>
                </a:cubicBezTo>
                <a:cubicBezTo>
                  <a:pt x="1279" y="1482"/>
                  <a:pt x="1281" y="1482"/>
                  <a:pt x="1283" y="1483"/>
                </a:cubicBezTo>
                <a:cubicBezTo>
                  <a:pt x="1285" y="1483"/>
                  <a:pt x="1287" y="1484"/>
                  <a:pt x="1289" y="1486"/>
                </a:cubicBezTo>
                <a:cubicBezTo>
                  <a:pt x="1292" y="1488"/>
                  <a:pt x="1294" y="1490"/>
                  <a:pt x="1297" y="1493"/>
                </a:cubicBezTo>
                <a:close/>
                <a:moveTo>
                  <a:pt x="1674" y="1319"/>
                </a:moveTo>
                <a:cubicBezTo>
                  <a:pt x="1679" y="1322"/>
                  <a:pt x="1682" y="1324"/>
                  <a:pt x="1684" y="1326"/>
                </a:cubicBezTo>
                <a:cubicBezTo>
                  <a:pt x="1686" y="1328"/>
                  <a:pt x="1687" y="1330"/>
                  <a:pt x="1687" y="1332"/>
                </a:cubicBezTo>
                <a:cubicBezTo>
                  <a:pt x="1687" y="1334"/>
                  <a:pt x="1686" y="1337"/>
                  <a:pt x="1683" y="1340"/>
                </a:cubicBezTo>
                <a:cubicBezTo>
                  <a:pt x="1680" y="1343"/>
                  <a:pt x="1677" y="1347"/>
                  <a:pt x="1672" y="1352"/>
                </a:cubicBezTo>
                <a:cubicBezTo>
                  <a:pt x="1667" y="1357"/>
                  <a:pt x="1663" y="1360"/>
                  <a:pt x="1660" y="1363"/>
                </a:cubicBezTo>
                <a:cubicBezTo>
                  <a:pt x="1657" y="1366"/>
                  <a:pt x="1655" y="1367"/>
                  <a:pt x="1653" y="1368"/>
                </a:cubicBezTo>
                <a:cubicBezTo>
                  <a:pt x="1651" y="1369"/>
                  <a:pt x="1649" y="1370"/>
                  <a:pt x="1647" y="1369"/>
                </a:cubicBezTo>
                <a:cubicBezTo>
                  <a:pt x="1646" y="1369"/>
                  <a:pt x="1644" y="1369"/>
                  <a:pt x="1642" y="1368"/>
                </a:cubicBezTo>
                <a:lnTo>
                  <a:pt x="1544" y="1321"/>
                </a:lnTo>
                <a:lnTo>
                  <a:pt x="1421" y="1444"/>
                </a:lnTo>
                <a:lnTo>
                  <a:pt x="1468" y="1540"/>
                </a:lnTo>
                <a:cubicBezTo>
                  <a:pt x="1469" y="1542"/>
                  <a:pt x="1470" y="1544"/>
                  <a:pt x="1470" y="1545"/>
                </a:cubicBezTo>
                <a:cubicBezTo>
                  <a:pt x="1470" y="1547"/>
                  <a:pt x="1470" y="1549"/>
                  <a:pt x="1469" y="1551"/>
                </a:cubicBezTo>
                <a:cubicBezTo>
                  <a:pt x="1468" y="1553"/>
                  <a:pt x="1467" y="1556"/>
                  <a:pt x="1464" y="1559"/>
                </a:cubicBezTo>
                <a:cubicBezTo>
                  <a:pt x="1462" y="1562"/>
                  <a:pt x="1459" y="1566"/>
                  <a:pt x="1454" y="1570"/>
                </a:cubicBezTo>
                <a:cubicBezTo>
                  <a:pt x="1450" y="1574"/>
                  <a:pt x="1446" y="1578"/>
                  <a:pt x="1443" y="1580"/>
                </a:cubicBezTo>
                <a:cubicBezTo>
                  <a:pt x="1440" y="1583"/>
                  <a:pt x="1437" y="1584"/>
                  <a:pt x="1435" y="1584"/>
                </a:cubicBezTo>
                <a:cubicBezTo>
                  <a:pt x="1432" y="1584"/>
                  <a:pt x="1430" y="1583"/>
                  <a:pt x="1428" y="1581"/>
                </a:cubicBezTo>
                <a:cubicBezTo>
                  <a:pt x="1426" y="1579"/>
                  <a:pt x="1424" y="1575"/>
                  <a:pt x="1422" y="1571"/>
                </a:cubicBezTo>
                <a:lnTo>
                  <a:pt x="1246" y="1196"/>
                </a:lnTo>
                <a:cubicBezTo>
                  <a:pt x="1245" y="1193"/>
                  <a:pt x="1245" y="1191"/>
                  <a:pt x="1244" y="1189"/>
                </a:cubicBezTo>
                <a:cubicBezTo>
                  <a:pt x="1244" y="1187"/>
                  <a:pt x="1245" y="1185"/>
                  <a:pt x="1246" y="1182"/>
                </a:cubicBezTo>
                <a:cubicBezTo>
                  <a:pt x="1248" y="1180"/>
                  <a:pt x="1250" y="1177"/>
                  <a:pt x="1252" y="1174"/>
                </a:cubicBezTo>
                <a:cubicBezTo>
                  <a:pt x="1255" y="1170"/>
                  <a:pt x="1259" y="1167"/>
                  <a:pt x="1263" y="1162"/>
                </a:cubicBezTo>
                <a:cubicBezTo>
                  <a:pt x="1268" y="1157"/>
                  <a:pt x="1272" y="1153"/>
                  <a:pt x="1276" y="1150"/>
                </a:cubicBezTo>
                <a:cubicBezTo>
                  <a:pt x="1279" y="1147"/>
                  <a:pt x="1282" y="1145"/>
                  <a:pt x="1285" y="1144"/>
                </a:cubicBezTo>
                <a:cubicBezTo>
                  <a:pt x="1287" y="1142"/>
                  <a:pt x="1290" y="1142"/>
                  <a:pt x="1292" y="1142"/>
                </a:cubicBezTo>
                <a:cubicBezTo>
                  <a:pt x="1294" y="1142"/>
                  <a:pt x="1297" y="1142"/>
                  <a:pt x="1299" y="1143"/>
                </a:cubicBezTo>
                <a:lnTo>
                  <a:pt x="1674" y="1319"/>
                </a:lnTo>
                <a:close/>
                <a:moveTo>
                  <a:pt x="1303" y="1204"/>
                </a:moveTo>
                <a:lnTo>
                  <a:pt x="1303" y="1204"/>
                </a:lnTo>
                <a:lnTo>
                  <a:pt x="1400" y="1403"/>
                </a:lnTo>
                <a:lnTo>
                  <a:pt x="1503" y="1300"/>
                </a:lnTo>
                <a:lnTo>
                  <a:pt x="1303" y="1204"/>
                </a:lnTo>
                <a:close/>
                <a:moveTo>
                  <a:pt x="1771" y="1239"/>
                </a:moveTo>
                <a:cubicBezTo>
                  <a:pt x="1772" y="1240"/>
                  <a:pt x="1773" y="1242"/>
                  <a:pt x="1773" y="1243"/>
                </a:cubicBezTo>
                <a:cubicBezTo>
                  <a:pt x="1773" y="1245"/>
                  <a:pt x="1773" y="1246"/>
                  <a:pt x="1772" y="1248"/>
                </a:cubicBezTo>
                <a:cubicBezTo>
                  <a:pt x="1771" y="1250"/>
                  <a:pt x="1770" y="1253"/>
                  <a:pt x="1768" y="1255"/>
                </a:cubicBezTo>
                <a:cubicBezTo>
                  <a:pt x="1766" y="1258"/>
                  <a:pt x="1763" y="1261"/>
                  <a:pt x="1759" y="1265"/>
                </a:cubicBezTo>
                <a:cubicBezTo>
                  <a:pt x="1755" y="1269"/>
                  <a:pt x="1752" y="1272"/>
                  <a:pt x="1749" y="1274"/>
                </a:cubicBezTo>
                <a:cubicBezTo>
                  <a:pt x="1746" y="1276"/>
                  <a:pt x="1744" y="1278"/>
                  <a:pt x="1742" y="1278"/>
                </a:cubicBezTo>
                <a:cubicBezTo>
                  <a:pt x="1740" y="1279"/>
                  <a:pt x="1738" y="1280"/>
                  <a:pt x="1737" y="1279"/>
                </a:cubicBezTo>
                <a:cubicBezTo>
                  <a:pt x="1735" y="1279"/>
                  <a:pt x="1734" y="1278"/>
                  <a:pt x="1733" y="1277"/>
                </a:cubicBezTo>
                <a:lnTo>
                  <a:pt x="1427" y="971"/>
                </a:lnTo>
                <a:cubicBezTo>
                  <a:pt x="1425" y="969"/>
                  <a:pt x="1425" y="968"/>
                  <a:pt x="1424" y="967"/>
                </a:cubicBezTo>
                <a:cubicBezTo>
                  <a:pt x="1424" y="965"/>
                  <a:pt x="1424" y="963"/>
                  <a:pt x="1425" y="961"/>
                </a:cubicBezTo>
                <a:cubicBezTo>
                  <a:pt x="1426" y="959"/>
                  <a:pt x="1427" y="957"/>
                  <a:pt x="1429" y="954"/>
                </a:cubicBezTo>
                <a:cubicBezTo>
                  <a:pt x="1431" y="951"/>
                  <a:pt x="1434" y="948"/>
                  <a:pt x="1438" y="945"/>
                </a:cubicBezTo>
                <a:cubicBezTo>
                  <a:pt x="1442" y="941"/>
                  <a:pt x="1445" y="938"/>
                  <a:pt x="1448" y="936"/>
                </a:cubicBezTo>
                <a:cubicBezTo>
                  <a:pt x="1451" y="934"/>
                  <a:pt x="1453" y="932"/>
                  <a:pt x="1455" y="931"/>
                </a:cubicBezTo>
                <a:cubicBezTo>
                  <a:pt x="1457" y="931"/>
                  <a:pt x="1459" y="930"/>
                  <a:pt x="1460" y="931"/>
                </a:cubicBezTo>
                <a:cubicBezTo>
                  <a:pt x="1462" y="931"/>
                  <a:pt x="1463" y="932"/>
                  <a:pt x="1464" y="933"/>
                </a:cubicBezTo>
                <a:lnTo>
                  <a:pt x="1771" y="1239"/>
                </a:lnTo>
                <a:close/>
                <a:moveTo>
                  <a:pt x="1996" y="1014"/>
                </a:moveTo>
                <a:cubicBezTo>
                  <a:pt x="1998" y="1016"/>
                  <a:pt x="1999" y="1018"/>
                  <a:pt x="1998" y="1020"/>
                </a:cubicBezTo>
                <a:cubicBezTo>
                  <a:pt x="1998" y="1022"/>
                  <a:pt x="1997" y="1025"/>
                  <a:pt x="1995" y="1027"/>
                </a:cubicBezTo>
                <a:cubicBezTo>
                  <a:pt x="1994" y="1030"/>
                  <a:pt x="1991" y="1033"/>
                  <a:pt x="1987" y="1037"/>
                </a:cubicBezTo>
                <a:cubicBezTo>
                  <a:pt x="1983" y="1041"/>
                  <a:pt x="1979" y="1044"/>
                  <a:pt x="1976" y="1046"/>
                </a:cubicBezTo>
                <a:cubicBezTo>
                  <a:pt x="1974" y="1048"/>
                  <a:pt x="1971" y="1049"/>
                  <a:pt x="1969" y="1049"/>
                </a:cubicBezTo>
                <a:cubicBezTo>
                  <a:pt x="1967" y="1050"/>
                  <a:pt x="1965" y="1049"/>
                  <a:pt x="1963" y="1047"/>
                </a:cubicBezTo>
                <a:lnTo>
                  <a:pt x="1943" y="1026"/>
                </a:lnTo>
                <a:cubicBezTo>
                  <a:pt x="1943" y="1045"/>
                  <a:pt x="1941" y="1062"/>
                  <a:pt x="1935" y="1079"/>
                </a:cubicBezTo>
                <a:cubicBezTo>
                  <a:pt x="1929" y="1095"/>
                  <a:pt x="1920" y="1110"/>
                  <a:pt x="1908" y="1122"/>
                </a:cubicBezTo>
                <a:cubicBezTo>
                  <a:pt x="1897" y="1133"/>
                  <a:pt x="1886" y="1141"/>
                  <a:pt x="1874" y="1147"/>
                </a:cubicBezTo>
                <a:cubicBezTo>
                  <a:pt x="1863" y="1153"/>
                  <a:pt x="1851" y="1157"/>
                  <a:pt x="1840" y="1157"/>
                </a:cubicBezTo>
                <a:cubicBezTo>
                  <a:pt x="1828" y="1158"/>
                  <a:pt x="1817" y="1157"/>
                  <a:pt x="1805" y="1152"/>
                </a:cubicBezTo>
                <a:cubicBezTo>
                  <a:pt x="1794" y="1148"/>
                  <a:pt x="1784" y="1141"/>
                  <a:pt x="1774" y="1131"/>
                </a:cubicBezTo>
                <a:cubicBezTo>
                  <a:pt x="1762" y="1119"/>
                  <a:pt x="1754" y="1107"/>
                  <a:pt x="1750" y="1093"/>
                </a:cubicBezTo>
                <a:cubicBezTo>
                  <a:pt x="1747" y="1080"/>
                  <a:pt x="1746" y="1066"/>
                  <a:pt x="1750" y="1052"/>
                </a:cubicBezTo>
                <a:cubicBezTo>
                  <a:pt x="1753" y="1037"/>
                  <a:pt x="1759" y="1022"/>
                  <a:pt x="1769" y="1006"/>
                </a:cubicBezTo>
                <a:cubicBezTo>
                  <a:pt x="1779" y="991"/>
                  <a:pt x="1792" y="975"/>
                  <a:pt x="1808" y="959"/>
                </a:cubicBezTo>
                <a:lnTo>
                  <a:pt x="1837" y="930"/>
                </a:lnTo>
                <a:lnTo>
                  <a:pt x="1821" y="914"/>
                </a:lnTo>
                <a:cubicBezTo>
                  <a:pt x="1813" y="906"/>
                  <a:pt x="1805" y="900"/>
                  <a:pt x="1797" y="896"/>
                </a:cubicBezTo>
                <a:cubicBezTo>
                  <a:pt x="1789" y="891"/>
                  <a:pt x="1782" y="889"/>
                  <a:pt x="1774" y="889"/>
                </a:cubicBezTo>
                <a:cubicBezTo>
                  <a:pt x="1766" y="888"/>
                  <a:pt x="1758" y="890"/>
                  <a:pt x="1750" y="894"/>
                </a:cubicBezTo>
                <a:cubicBezTo>
                  <a:pt x="1742" y="898"/>
                  <a:pt x="1734" y="904"/>
                  <a:pt x="1725" y="913"/>
                </a:cubicBezTo>
                <a:cubicBezTo>
                  <a:pt x="1716" y="922"/>
                  <a:pt x="1708" y="932"/>
                  <a:pt x="1703" y="941"/>
                </a:cubicBezTo>
                <a:cubicBezTo>
                  <a:pt x="1698" y="951"/>
                  <a:pt x="1694" y="960"/>
                  <a:pt x="1691" y="968"/>
                </a:cubicBezTo>
                <a:cubicBezTo>
                  <a:pt x="1688" y="976"/>
                  <a:pt x="1686" y="984"/>
                  <a:pt x="1684" y="990"/>
                </a:cubicBezTo>
                <a:cubicBezTo>
                  <a:pt x="1683" y="996"/>
                  <a:pt x="1681" y="999"/>
                  <a:pt x="1679" y="1001"/>
                </a:cubicBezTo>
                <a:cubicBezTo>
                  <a:pt x="1678" y="1002"/>
                  <a:pt x="1677" y="1003"/>
                  <a:pt x="1675" y="1004"/>
                </a:cubicBezTo>
                <a:cubicBezTo>
                  <a:pt x="1674" y="1004"/>
                  <a:pt x="1672" y="1004"/>
                  <a:pt x="1670" y="1003"/>
                </a:cubicBezTo>
                <a:cubicBezTo>
                  <a:pt x="1668" y="1003"/>
                  <a:pt x="1666" y="1002"/>
                  <a:pt x="1664" y="1000"/>
                </a:cubicBezTo>
                <a:cubicBezTo>
                  <a:pt x="1662" y="998"/>
                  <a:pt x="1659" y="996"/>
                  <a:pt x="1657" y="994"/>
                </a:cubicBezTo>
                <a:cubicBezTo>
                  <a:pt x="1653" y="990"/>
                  <a:pt x="1651" y="987"/>
                  <a:pt x="1649" y="984"/>
                </a:cubicBezTo>
                <a:cubicBezTo>
                  <a:pt x="1647" y="982"/>
                  <a:pt x="1646" y="978"/>
                  <a:pt x="1647" y="974"/>
                </a:cubicBezTo>
                <a:cubicBezTo>
                  <a:pt x="1647" y="970"/>
                  <a:pt x="1648" y="964"/>
                  <a:pt x="1650" y="956"/>
                </a:cubicBezTo>
                <a:cubicBezTo>
                  <a:pt x="1653" y="949"/>
                  <a:pt x="1656" y="940"/>
                  <a:pt x="1660" y="932"/>
                </a:cubicBezTo>
                <a:cubicBezTo>
                  <a:pt x="1665" y="923"/>
                  <a:pt x="1670" y="914"/>
                  <a:pt x="1676" y="905"/>
                </a:cubicBezTo>
                <a:cubicBezTo>
                  <a:pt x="1683" y="895"/>
                  <a:pt x="1690" y="887"/>
                  <a:pt x="1698" y="879"/>
                </a:cubicBezTo>
                <a:cubicBezTo>
                  <a:pt x="1713" y="864"/>
                  <a:pt x="1727" y="853"/>
                  <a:pt x="1741" y="846"/>
                </a:cubicBezTo>
                <a:cubicBezTo>
                  <a:pt x="1754" y="839"/>
                  <a:pt x="1768" y="836"/>
                  <a:pt x="1781" y="836"/>
                </a:cubicBezTo>
                <a:cubicBezTo>
                  <a:pt x="1794" y="836"/>
                  <a:pt x="1806" y="839"/>
                  <a:pt x="1819" y="846"/>
                </a:cubicBezTo>
                <a:cubicBezTo>
                  <a:pt x="1831" y="853"/>
                  <a:pt x="1844" y="862"/>
                  <a:pt x="1857" y="875"/>
                </a:cubicBezTo>
                <a:lnTo>
                  <a:pt x="1996" y="1014"/>
                </a:lnTo>
                <a:close/>
                <a:moveTo>
                  <a:pt x="1864" y="958"/>
                </a:moveTo>
                <a:lnTo>
                  <a:pt x="1832" y="990"/>
                </a:lnTo>
                <a:cubicBezTo>
                  <a:pt x="1821" y="1000"/>
                  <a:pt x="1813" y="1010"/>
                  <a:pt x="1807" y="1020"/>
                </a:cubicBezTo>
                <a:cubicBezTo>
                  <a:pt x="1802" y="1029"/>
                  <a:pt x="1798" y="1038"/>
                  <a:pt x="1796" y="1047"/>
                </a:cubicBezTo>
                <a:cubicBezTo>
                  <a:pt x="1795" y="1055"/>
                  <a:pt x="1795" y="1063"/>
                  <a:pt x="1797" y="1070"/>
                </a:cubicBezTo>
                <a:cubicBezTo>
                  <a:pt x="1800" y="1077"/>
                  <a:pt x="1804" y="1084"/>
                  <a:pt x="1811" y="1090"/>
                </a:cubicBezTo>
                <a:cubicBezTo>
                  <a:pt x="1821" y="1101"/>
                  <a:pt x="1833" y="1106"/>
                  <a:pt x="1846" y="1106"/>
                </a:cubicBezTo>
                <a:cubicBezTo>
                  <a:pt x="1859" y="1105"/>
                  <a:pt x="1872" y="1099"/>
                  <a:pt x="1884" y="1087"/>
                </a:cubicBezTo>
                <a:cubicBezTo>
                  <a:pt x="1894" y="1077"/>
                  <a:pt x="1901" y="1065"/>
                  <a:pt x="1904" y="1051"/>
                </a:cubicBezTo>
                <a:cubicBezTo>
                  <a:pt x="1908" y="1038"/>
                  <a:pt x="1909" y="1021"/>
                  <a:pt x="1908" y="1001"/>
                </a:cubicBezTo>
                <a:lnTo>
                  <a:pt x="1864" y="958"/>
                </a:lnTo>
                <a:close/>
                <a:moveTo>
                  <a:pt x="2244" y="766"/>
                </a:moveTo>
                <a:cubicBezTo>
                  <a:pt x="2246" y="767"/>
                  <a:pt x="2246" y="768"/>
                  <a:pt x="2246" y="770"/>
                </a:cubicBezTo>
                <a:cubicBezTo>
                  <a:pt x="2247" y="771"/>
                  <a:pt x="2246" y="773"/>
                  <a:pt x="2246" y="775"/>
                </a:cubicBezTo>
                <a:cubicBezTo>
                  <a:pt x="2245" y="777"/>
                  <a:pt x="2243" y="779"/>
                  <a:pt x="2241" y="782"/>
                </a:cubicBezTo>
                <a:cubicBezTo>
                  <a:pt x="2239" y="785"/>
                  <a:pt x="2236" y="788"/>
                  <a:pt x="2233" y="791"/>
                </a:cubicBezTo>
                <a:cubicBezTo>
                  <a:pt x="2229" y="795"/>
                  <a:pt x="2226" y="798"/>
                  <a:pt x="2223" y="800"/>
                </a:cubicBezTo>
                <a:cubicBezTo>
                  <a:pt x="2220" y="803"/>
                  <a:pt x="2218" y="804"/>
                  <a:pt x="2216" y="805"/>
                </a:cubicBezTo>
                <a:cubicBezTo>
                  <a:pt x="2214" y="806"/>
                  <a:pt x="2212" y="806"/>
                  <a:pt x="2210" y="806"/>
                </a:cubicBezTo>
                <a:cubicBezTo>
                  <a:pt x="2209" y="805"/>
                  <a:pt x="2208" y="805"/>
                  <a:pt x="2206" y="803"/>
                </a:cubicBezTo>
                <a:lnTo>
                  <a:pt x="2086" y="683"/>
                </a:lnTo>
                <a:cubicBezTo>
                  <a:pt x="2074" y="671"/>
                  <a:pt x="2063" y="662"/>
                  <a:pt x="2054" y="657"/>
                </a:cubicBezTo>
                <a:cubicBezTo>
                  <a:pt x="2045" y="652"/>
                  <a:pt x="2037" y="648"/>
                  <a:pt x="2028" y="646"/>
                </a:cubicBezTo>
                <a:cubicBezTo>
                  <a:pt x="2019" y="645"/>
                  <a:pt x="2011" y="645"/>
                  <a:pt x="2002" y="648"/>
                </a:cubicBezTo>
                <a:cubicBezTo>
                  <a:pt x="1994" y="651"/>
                  <a:pt x="1986" y="656"/>
                  <a:pt x="1979" y="663"/>
                </a:cubicBezTo>
                <a:cubicBezTo>
                  <a:pt x="1969" y="673"/>
                  <a:pt x="1963" y="686"/>
                  <a:pt x="1960" y="702"/>
                </a:cubicBezTo>
                <a:cubicBezTo>
                  <a:pt x="1958" y="718"/>
                  <a:pt x="1958" y="738"/>
                  <a:pt x="1960" y="761"/>
                </a:cubicBezTo>
                <a:lnTo>
                  <a:pt x="2104" y="905"/>
                </a:lnTo>
                <a:cubicBezTo>
                  <a:pt x="2106" y="907"/>
                  <a:pt x="2106" y="908"/>
                  <a:pt x="2107" y="909"/>
                </a:cubicBezTo>
                <a:cubicBezTo>
                  <a:pt x="2107" y="911"/>
                  <a:pt x="2107" y="913"/>
                  <a:pt x="2106" y="915"/>
                </a:cubicBezTo>
                <a:cubicBezTo>
                  <a:pt x="2105" y="917"/>
                  <a:pt x="2104" y="919"/>
                  <a:pt x="2101" y="922"/>
                </a:cubicBezTo>
                <a:cubicBezTo>
                  <a:pt x="2099" y="924"/>
                  <a:pt x="2096" y="928"/>
                  <a:pt x="2093" y="932"/>
                </a:cubicBezTo>
                <a:cubicBezTo>
                  <a:pt x="2089" y="935"/>
                  <a:pt x="2086" y="938"/>
                  <a:pt x="2083" y="940"/>
                </a:cubicBezTo>
                <a:cubicBezTo>
                  <a:pt x="2080" y="942"/>
                  <a:pt x="2078" y="944"/>
                  <a:pt x="2076" y="945"/>
                </a:cubicBezTo>
                <a:cubicBezTo>
                  <a:pt x="2074" y="946"/>
                  <a:pt x="2072" y="946"/>
                  <a:pt x="2071" y="946"/>
                </a:cubicBezTo>
                <a:cubicBezTo>
                  <a:pt x="2069" y="945"/>
                  <a:pt x="2068" y="944"/>
                  <a:pt x="2067" y="943"/>
                </a:cubicBezTo>
                <a:lnTo>
                  <a:pt x="1860" y="737"/>
                </a:lnTo>
                <a:cubicBezTo>
                  <a:pt x="1859" y="736"/>
                  <a:pt x="1858" y="734"/>
                  <a:pt x="1858" y="733"/>
                </a:cubicBezTo>
                <a:cubicBezTo>
                  <a:pt x="1858" y="732"/>
                  <a:pt x="1858" y="730"/>
                  <a:pt x="1858" y="728"/>
                </a:cubicBezTo>
                <a:cubicBezTo>
                  <a:pt x="1859" y="726"/>
                  <a:pt x="1860" y="724"/>
                  <a:pt x="1862" y="721"/>
                </a:cubicBezTo>
                <a:cubicBezTo>
                  <a:pt x="1864" y="719"/>
                  <a:pt x="1867" y="716"/>
                  <a:pt x="1870" y="713"/>
                </a:cubicBezTo>
                <a:cubicBezTo>
                  <a:pt x="1874" y="709"/>
                  <a:pt x="1877" y="707"/>
                  <a:pt x="1879" y="705"/>
                </a:cubicBezTo>
                <a:cubicBezTo>
                  <a:pt x="1882" y="703"/>
                  <a:pt x="1884" y="701"/>
                  <a:pt x="1886" y="701"/>
                </a:cubicBezTo>
                <a:cubicBezTo>
                  <a:pt x="1888" y="700"/>
                  <a:pt x="1889" y="700"/>
                  <a:pt x="1891" y="700"/>
                </a:cubicBezTo>
                <a:cubicBezTo>
                  <a:pt x="1892" y="701"/>
                  <a:pt x="1893" y="702"/>
                  <a:pt x="1894" y="703"/>
                </a:cubicBezTo>
                <a:lnTo>
                  <a:pt x="1922" y="730"/>
                </a:lnTo>
                <a:cubicBezTo>
                  <a:pt x="1920" y="705"/>
                  <a:pt x="1922" y="684"/>
                  <a:pt x="1928" y="667"/>
                </a:cubicBezTo>
                <a:cubicBezTo>
                  <a:pt x="1933" y="649"/>
                  <a:pt x="1942" y="635"/>
                  <a:pt x="1954" y="623"/>
                </a:cubicBezTo>
                <a:cubicBezTo>
                  <a:pt x="1968" y="609"/>
                  <a:pt x="1981" y="600"/>
                  <a:pt x="1996" y="595"/>
                </a:cubicBezTo>
                <a:cubicBezTo>
                  <a:pt x="2010" y="590"/>
                  <a:pt x="2023" y="589"/>
                  <a:pt x="2037" y="591"/>
                </a:cubicBezTo>
                <a:cubicBezTo>
                  <a:pt x="2051" y="593"/>
                  <a:pt x="2064" y="598"/>
                  <a:pt x="2077" y="606"/>
                </a:cubicBezTo>
                <a:cubicBezTo>
                  <a:pt x="2090" y="614"/>
                  <a:pt x="2104" y="625"/>
                  <a:pt x="2118" y="640"/>
                </a:cubicBezTo>
                <a:lnTo>
                  <a:pt x="2244" y="766"/>
                </a:lnTo>
                <a:close/>
                <a:moveTo>
                  <a:pt x="2348" y="662"/>
                </a:moveTo>
                <a:cubicBezTo>
                  <a:pt x="2349" y="663"/>
                  <a:pt x="2350" y="665"/>
                  <a:pt x="2350" y="666"/>
                </a:cubicBezTo>
                <a:cubicBezTo>
                  <a:pt x="2350" y="668"/>
                  <a:pt x="2350" y="669"/>
                  <a:pt x="2349" y="671"/>
                </a:cubicBezTo>
                <a:cubicBezTo>
                  <a:pt x="2348" y="673"/>
                  <a:pt x="2347" y="676"/>
                  <a:pt x="2345" y="678"/>
                </a:cubicBezTo>
                <a:cubicBezTo>
                  <a:pt x="2343" y="681"/>
                  <a:pt x="2340" y="684"/>
                  <a:pt x="2336" y="688"/>
                </a:cubicBezTo>
                <a:cubicBezTo>
                  <a:pt x="2332" y="692"/>
                  <a:pt x="2329" y="695"/>
                  <a:pt x="2326" y="697"/>
                </a:cubicBezTo>
                <a:cubicBezTo>
                  <a:pt x="2323" y="699"/>
                  <a:pt x="2321" y="701"/>
                  <a:pt x="2319" y="701"/>
                </a:cubicBezTo>
                <a:cubicBezTo>
                  <a:pt x="2317" y="702"/>
                  <a:pt x="2315" y="703"/>
                  <a:pt x="2314" y="702"/>
                </a:cubicBezTo>
                <a:cubicBezTo>
                  <a:pt x="2312" y="702"/>
                  <a:pt x="2311" y="701"/>
                  <a:pt x="2310" y="700"/>
                </a:cubicBezTo>
                <a:lnTo>
                  <a:pt x="2104" y="494"/>
                </a:lnTo>
                <a:cubicBezTo>
                  <a:pt x="2102" y="493"/>
                  <a:pt x="2102" y="491"/>
                  <a:pt x="2101" y="490"/>
                </a:cubicBezTo>
                <a:cubicBezTo>
                  <a:pt x="2101" y="488"/>
                  <a:pt x="2101" y="487"/>
                  <a:pt x="2102" y="485"/>
                </a:cubicBezTo>
                <a:cubicBezTo>
                  <a:pt x="2103" y="483"/>
                  <a:pt x="2104" y="480"/>
                  <a:pt x="2107" y="477"/>
                </a:cubicBezTo>
                <a:cubicBezTo>
                  <a:pt x="2109" y="475"/>
                  <a:pt x="2112" y="471"/>
                  <a:pt x="2115" y="468"/>
                </a:cubicBezTo>
                <a:cubicBezTo>
                  <a:pt x="2119" y="464"/>
                  <a:pt x="2122" y="461"/>
                  <a:pt x="2125" y="459"/>
                </a:cubicBezTo>
                <a:cubicBezTo>
                  <a:pt x="2128" y="457"/>
                  <a:pt x="2130" y="455"/>
                  <a:pt x="2132" y="454"/>
                </a:cubicBezTo>
                <a:cubicBezTo>
                  <a:pt x="2134" y="454"/>
                  <a:pt x="2136" y="453"/>
                  <a:pt x="2137" y="454"/>
                </a:cubicBezTo>
                <a:cubicBezTo>
                  <a:pt x="2139" y="454"/>
                  <a:pt x="2140" y="455"/>
                  <a:pt x="2141" y="456"/>
                </a:cubicBezTo>
                <a:lnTo>
                  <a:pt x="2348" y="662"/>
                </a:lnTo>
                <a:close/>
                <a:moveTo>
                  <a:pt x="2076" y="382"/>
                </a:moveTo>
                <a:cubicBezTo>
                  <a:pt x="2085" y="391"/>
                  <a:pt x="2089" y="398"/>
                  <a:pt x="2089" y="405"/>
                </a:cubicBezTo>
                <a:cubicBezTo>
                  <a:pt x="2089" y="412"/>
                  <a:pt x="2084" y="419"/>
                  <a:pt x="2075" y="428"/>
                </a:cubicBezTo>
                <a:cubicBezTo>
                  <a:pt x="2066" y="437"/>
                  <a:pt x="2059" y="442"/>
                  <a:pt x="2052" y="442"/>
                </a:cubicBezTo>
                <a:cubicBezTo>
                  <a:pt x="2046" y="442"/>
                  <a:pt x="2038" y="438"/>
                  <a:pt x="2030" y="429"/>
                </a:cubicBezTo>
                <a:cubicBezTo>
                  <a:pt x="2021" y="420"/>
                  <a:pt x="2017" y="412"/>
                  <a:pt x="2017" y="406"/>
                </a:cubicBezTo>
                <a:cubicBezTo>
                  <a:pt x="2017" y="399"/>
                  <a:pt x="2021" y="392"/>
                  <a:pt x="2030" y="382"/>
                </a:cubicBezTo>
                <a:cubicBezTo>
                  <a:pt x="2039" y="374"/>
                  <a:pt x="2047" y="369"/>
                  <a:pt x="2053" y="369"/>
                </a:cubicBezTo>
                <a:cubicBezTo>
                  <a:pt x="2060" y="369"/>
                  <a:pt x="2067" y="373"/>
                  <a:pt x="2076" y="382"/>
                </a:cubicBezTo>
                <a:close/>
                <a:moveTo>
                  <a:pt x="2601" y="409"/>
                </a:moveTo>
                <a:cubicBezTo>
                  <a:pt x="2602" y="410"/>
                  <a:pt x="2603" y="412"/>
                  <a:pt x="2603" y="413"/>
                </a:cubicBezTo>
                <a:cubicBezTo>
                  <a:pt x="2603" y="415"/>
                  <a:pt x="2603" y="416"/>
                  <a:pt x="2602" y="418"/>
                </a:cubicBezTo>
                <a:cubicBezTo>
                  <a:pt x="2601" y="420"/>
                  <a:pt x="2600" y="423"/>
                  <a:pt x="2598" y="425"/>
                </a:cubicBezTo>
                <a:cubicBezTo>
                  <a:pt x="2596" y="428"/>
                  <a:pt x="2593" y="431"/>
                  <a:pt x="2589" y="435"/>
                </a:cubicBezTo>
                <a:cubicBezTo>
                  <a:pt x="2585" y="439"/>
                  <a:pt x="2582" y="442"/>
                  <a:pt x="2579" y="444"/>
                </a:cubicBezTo>
                <a:cubicBezTo>
                  <a:pt x="2576" y="446"/>
                  <a:pt x="2574" y="448"/>
                  <a:pt x="2572" y="448"/>
                </a:cubicBezTo>
                <a:cubicBezTo>
                  <a:pt x="2570" y="449"/>
                  <a:pt x="2568" y="449"/>
                  <a:pt x="2567" y="449"/>
                </a:cubicBezTo>
                <a:cubicBezTo>
                  <a:pt x="2565" y="449"/>
                  <a:pt x="2564" y="448"/>
                  <a:pt x="2563" y="447"/>
                </a:cubicBezTo>
                <a:lnTo>
                  <a:pt x="2442" y="326"/>
                </a:lnTo>
                <a:cubicBezTo>
                  <a:pt x="2430" y="314"/>
                  <a:pt x="2420" y="306"/>
                  <a:pt x="2411" y="301"/>
                </a:cubicBezTo>
                <a:cubicBezTo>
                  <a:pt x="2402" y="295"/>
                  <a:pt x="2393" y="292"/>
                  <a:pt x="2384" y="290"/>
                </a:cubicBezTo>
                <a:cubicBezTo>
                  <a:pt x="2376" y="288"/>
                  <a:pt x="2367" y="289"/>
                  <a:pt x="2359" y="292"/>
                </a:cubicBezTo>
                <a:cubicBezTo>
                  <a:pt x="2350" y="295"/>
                  <a:pt x="2343" y="300"/>
                  <a:pt x="2335" y="307"/>
                </a:cubicBezTo>
                <a:cubicBezTo>
                  <a:pt x="2326" y="316"/>
                  <a:pt x="2320" y="329"/>
                  <a:pt x="2317" y="345"/>
                </a:cubicBezTo>
                <a:cubicBezTo>
                  <a:pt x="2314" y="362"/>
                  <a:pt x="2314" y="381"/>
                  <a:pt x="2317" y="405"/>
                </a:cubicBezTo>
                <a:lnTo>
                  <a:pt x="2461" y="549"/>
                </a:lnTo>
                <a:cubicBezTo>
                  <a:pt x="2462" y="550"/>
                  <a:pt x="2463" y="552"/>
                  <a:pt x="2463" y="553"/>
                </a:cubicBezTo>
                <a:cubicBezTo>
                  <a:pt x="2463" y="555"/>
                  <a:pt x="2463" y="556"/>
                  <a:pt x="2462" y="558"/>
                </a:cubicBezTo>
                <a:cubicBezTo>
                  <a:pt x="2461" y="560"/>
                  <a:pt x="2460" y="563"/>
                  <a:pt x="2458" y="565"/>
                </a:cubicBezTo>
                <a:cubicBezTo>
                  <a:pt x="2456" y="568"/>
                  <a:pt x="2453" y="571"/>
                  <a:pt x="2449" y="575"/>
                </a:cubicBezTo>
                <a:cubicBezTo>
                  <a:pt x="2445" y="579"/>
                  <a:pt x="2442" y="582"/>
                  <a:pt x="2439" y="584"/>
                </a:cubicBezTo>
                <a:cubicBezTo>
                  <a:pt x="2437" y="586"/>
                  <a:pt x="2434" y="588"/>
                  <a:pt x="2432" y="588"/>
                </a:cubicBezTo>
                <a:cubicBezTo>
                  <a:pt x="2430" y="589"/>
                  <a:pt x="2428" y="589"/>
                  <a:pt x="2427" y="589"/>
                </a:cubicBezTo>
                <a:cubicBezTo>
                  <a:pt x="2426" y="589"/>
                  <a:pt x="2424" y="588"/>
                  <a:pt x="2423" y="587"/>
                </a:cubicBezTo>
                <a:lnTo>
                  <a:pt x="2217" y="381"/>
                </a:lnTo>
                <a:cubicBezTo>
                  <a:pt x="2215" y="379"/>
                  <a:pt x="2215" y="378"/>
                  <a:pt x="2214" y="377"/>
                </a:cubicBezTo>
                <a:cubicBezTo>
                  <a:pt x="2214" y="375"/>
                  <a:pt x="2214" y="374"/>
                  <a:pt x="2215" y="372"/>
                </a:cubicBezTo>
                <a:cubicBezTo>
                  <a:pt x="2215" y="370"/>
                  <a:pt x="2217" y="367"/>
                  <a:pt x="2219" y="365"/>
                </a:cubicBezTo>
                <a:cubicBezTo>
                  <a:pt x="2221" y="363"/>
                  <a:pt x="2223" y="360"/>
                  <a:pt x="2227" y="356"/>
                </a:cubicBezTo>
                <a:cubicBezTo>
                  <a:pt x="2230" y="353"/>
                  <a:pt x="2233" y="350"/>
                  <a:pt x="2235" y="348"/>
                </a:cubicBezTo>
                <a:cubicBezTo>
                  <a:pt x="2238" y="346"/>
                  <a:pt x="2240" y="345"/>
                  <a:pt x="2242" y="344"/>
                </a:cubicBezTo>
                <a:cubicBezTo>
                  <a:pt x="2244" y="344"/>
                  <a:pt x="2246" y="344"/>
                  <a:pt x="2247" y="344"/>
                </a:cubicBezTo>
                <a:cubicBezTo>
                  <a:pt x="2248" y="344"/>
                  <a:pt x="2250" y="345"/>
                  <a:pt x="2251" y="346"/>
                </a:cubicBezTo>
                <a:lnTo>
                  <a:pt x="2278" y="374"/>
                </a:lnTo>
                <a:cubicBezTo>
                  <a:pt x="2277" y="349"/>
                  <a:pt x="2279" y="328"/>
                  <a:pt x="2284" y="310"/>
                </a:cubicBezTo>
                <a:cubicBezTo>
                  <a:pt x="2290" y="293"/>
                  <a:pt x="2298" y="278"/>
                  <a:pt x="2310" y="266"/>
                </a:cubicBezTo>
                <a:cubicBezTo>
                  <a:pt x="2324" y="253"/>
                  <a:pt x="2338" y="243"/>
                  <a:pt x="2352" y="239"/>
                </a:cubicBezTo>
                <a:cubicBezTo>
                  <a:pt x="2366" y="234"/>
                  <a:pt x="2380" y="233"/>
                  <a:pt x="2393" y="235"/>
                </a:cubicBezTo>
                <a:cubicBezTo>
                  <a:pt x="2407" y="236"/>
                  <a:pt x="2420" y="241"/>
                  <a:pt x="2433" y="249"/>
                </a:cubicBezTo>
                <a:cubicBezTo>
                  <a:pt x="2446" y="257"/>
                  <a:pt x="2460" y="269"/>
                  <a:pt x="2475" y="283"/>
                </a:cubicBezTo>
                <a:lnTo>
                  <a:pt x="2601" y="409"/>
                </a:lnTo>
                <a:close/>
                <a:moveTo>
                  <a:pt x="2730" y="55"/>
                </a:moveTo>
                <a:cubicBezTo>
                  <a:pt x="2736" y="61"/>
                  <a:pt x="2739" y="67"/>
                  <a:pt x="2738" y="73"/>
                </a:cubicBezTo>
                <a:cubicBezTo>
                  <a:pt x="2738" y="78"/>
                  <a:pt x="2736" y="83"/>
                  <a:pt x="2732" y="87"/>
                </a:cubicBezTo>
                <a:lnTo>
                  <a:pt x="2596" y="223"/>
                </a:lnTo>
                <a:cubicBezTo>
                  <a:pt x="2608" y="234"/>
                  <a:pt x="2619" y="243"/>
                  <a:pt x="2631" y="250"/>
                </a:cubicBezTo>
                <a:cubicBezTo>
                  <a:pt x="2642" y="257"/>
                  <a:pt x="2654" y="261"/>
                  <a:pt x="2666" y="262"/>
                </a:cubicBezTo>
                <a:cubicBezTo>
                  <a:pt x="2678" y="263"/>
                  <a:pt x="2690" y="261"/>
                  <a:pt x="2702" y="256"/>
                </a:cubicBezTo>
                <a:cubicBezTo>
                  <a:pt x="2714" y="251"/>
                  <a:pt x="2726" y="242"/>
                  <a:pt x="2739" y="230"/>
                </a:cubicBezTo>
                <a:cubicBezTo>
                  <a:pt x="2748" y="220"/>
                  <a:pt x="2756" y="211"/>
                  <a:pt x="2762" y="201"/>
                </a:cubicBezTo>
                <a:cubicBezTo>
                  <a:pt x="2768" y="192"/>
                  <a:pt x="2773" y="184"/>
                  <a:pt x="2777" y="176"/>
                </a:cubicBezTo>
                <a:cubicBezTo>
                  <a:pt x="2781" y="168"/>
                  <a:pt x="2783" y="162"/>
                  <a:pt x="2785" y="157"/>
                </a:cubicBezTo>
                <a:cubicBezTo>
                  <a:pt x="2787" y="152"/>
                  <a:pt x="2789" y="148"/>
                  <a:pt x="2791" y="146"/>
                </a:cubicBezTo>
                <a:cubicBezTo>
                  <a:pt x="2792" y="145"/>
                  <a:pt x="2793" y="144"/>
                  <a:pt x="2795" y="144"/>
                </a:cubicBezTo>
                <a:cubicBezTo>
                  <a:pt x="2796" y="144"/>
                  <a:pt x="2798" y="144"/>
                  <a:pt x="2799" y="145"/>
                </a:cubicBezTo>
                <a:cubicBezTo>
                  <a:pt x="2801" y="145"/>
                  <a:pt x="2803" y="146"/>
                  <a:pt x="2805" y="148"/>
                </a:cubicBezTo>
                <a:cubicBezTo>
                  <a:pt x="2807" y="150"/>
                  <a:pt x="2809" y="152"/>
                  <a:pt x="2812" y="155"/>
                </a:cubicBezTo>
                <a:cubicBezTo>
                  <a:pt x="2814" y="157"/>
                  <a:pt x="2816" y="159"/>
                  <a:pt x="2817" y="160"/>
                </a:cubicBezTo>
                <a:cubicBezTo>
                  <a:pt x="2818" y="162"/>
                  <a:pt x="2819" y="163"/>
                  <a:pt x="2820" y="165"/>
                </a:cubicBezTo>
                <a:cubicBezTo>
                  <a:pt x="2821" y="166"/>
                  <a:pt x="2822" y="167"/>
                  <a:pt x="2822" y="169"/>
                </a:cubicBezTo>
                <a:cubicBezTo>
                  <a:pt x="2823" y="170"/>
                  <a:pt x="2823" y="172"/>
                  <a:pt x="2823" y="174"/>
                </a:cubicBezTo>
                <a:cubicBezTo>
                  <a:pt x="2823" y="175"/>
                  <a:pt x="2822" y="179"/>
                  <a:pt x="2820" y="185"/>
                </a:cubicBezTo>
                <a:cubicBezTo>
                  <a:pt x="2817" y="191"/>
                  <a:pt x="2814" y="198"/>
                  <a:pt x="2809" y="207"/>
                </a:cubicBezTo>
                <a:cubicBezTo>
                  <a:pt x="2804" y="215"/>
                  <a:pt x="2798" y="224"/>
                  <a:pt x="2791" y="234"/>
                </a:cubicBezTo>
                <a:cubicBezTo>
                  <a:pt x="2784" y="245"/>
                  <a:pt x="2776" y="255"/>
                  <a:pt x="2766" y="264"/>
                </a:cubicBezTo>
                <a:cubicBezTo>
                  <a:pt x="2749" y="281"/>
                  <a:pt x="2732" y="294"/>
                  <a:pt x="2714" y="302"/>
                </a:cubicBezTo>
                <a:cubicBezTo>
                  <a:pt x="2697" y="310"/>
                  <a:pt x="2679" y="314"/>
                  <a:pt x="2661" y="313"/>
                </a:cubicBezTo>
                <a:cubicBezTo>
                  <a:pt x="2643" y="312"/>
                  <a:pt x="2624" y="307"/>
                  <a:pt x="2606" y="298"/>
                </a:cubicBezTo>
                <a:cubicBezTo>
                  <a:pt x="2587" y="288"/>
                  <a:pt x="2569" y="274"/>
                  <a:pt x="2550" y="255"/>
                </a:cubicBezTo>
                <a:cubicBezTo>
                  <a:pt x="2533" y="237"/>
                  <a:pt x="2519" y="219"/>
                  <a:pt x="2509" y="200"/>
                </a:cubicBezTo>
                <a:cubicBezTo>
                  <a:pt x="2500" y="182"/>
                  <a:pt x="2494" y="163"/>
                  <a:pt x="2493" y="145"/>
                </a:cubicBezTo>
                <a:cubicBezTo>
                  <a:pt x="2492" y="126"/>
                  <a:pt x="2495" y="108"/>
                  <a:pt x="2502" y="91"/>
                </a:cubicBezTo>
                <a:cubicBezTo>
                  <a:pt x="2509" y="73"/>
                  <a:pt x="2520" y="57"/>
                  <a:pt x="2535" y="42"/>
                </a:cubicBezTo>
                <a:cubicBezTo>
                  <a:pt x="2551" y="25"/>
                  <a:pt x="2567" y="14"/>
                  <a:pt x="2584" y="8"/>
                </a:cubicBezTo>
                <a:cubicBezTo>
                  <a:pt x="2601" y="2"/>
                  <a:pt x="2617" y="0"/>
                  <a:pt x="2633" y="1"/>
                </a:cubicBezTo>
                <a:cubicBezTo>
                  <a:pt x="2649" y="2"/>
                  <a:pt x="2665" y="7"/>
                  <a:pt x="2680" y="16"/>
                </a:cubicBezTo>
                <a:cubicBezTo>
                  <a:pt x="2696" y="24"/>
                  <a:pt x="2710" y="35"/>
                  <a:pt x="2723" y="49"/>
                </a:cubicBezTo>
                <a:lnTo>
                  <a:pt x="2730" y="55"/>
                </a:lnTo>
                <a:close/>
                <a:moveTo>
                  <a:pt x="2681" y="82"/>
                </a:moveTo>
                <a:cubicBezTo>
                  <a:pt x="2662" y="62"/>
                  <a:pt x="2642" y="51"/>
                  <a:pt x="2621" y="49"/>
                </a:cubicBezTo>
                <a:cubicBezTo>
                  <a:pt x="2600" y="47"/>
                  <a:pt x="2581" y="55"/>
                  <a:pt x="2563" y="73"/>
                </a:cubicBezTo>
                <a:cubicBezTo>
                  <a:pt x="2553" y="83"/>
                  <a:pt x="2547" y="93"/>
                  <a:pt x="2543" y="103"/>
                </a:cubicBezTo>
                <a:cubicBezTo>
                  <a:pt x="2540" y="114"/>
                  <a:pt x="2538" y="124"/>
                  <a:pt x="2539" y="135"/>
                </a:cubicBezTo>
                <a:cubicBezTo>
                  <a:pt x="2540" y="145"/>
                  <a:pt x="2543" y="156"/>
                  <a:pt x="2549" y="166"/>
                </a:cubicBezTo>
                <a:cubicBezTo>
                  <a:pt x="2554" y="177"/>
                  <a:pt x="2560" y="186"/>
                  <a:pt x="2568" y="195"/>
                </a:cubicBezTo>
                <a:lnTo>
                  <a:pt x="2681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3" name="Freeform 257"/>
          <p:cNvSpPr>
            <a:spLocks noEditPoints="1"/>
          </p:cNvSpPr>
          <p:nvPr/>
        </p:nvSpPr>
        <p:spPr bwMode="auto">
          <a:xfrm>
            <a:off x="3520335" y="4417292"/>
            <a:ext cx="461457" cy="534988"/>
          </a:xfrm>
          <a:custGeom>
            <a:avLst/>
            <a:gdLst>
              <a:gd name="T0" fmla="*/ 324 w 2896"/>
              <a:gd name="T1" fmla="*/ 2765 h 2802"/>
              <a:gd name="T2" fmla="*/ 9 w 2896"/>
              <a:gd name="T3" fmla="*/ 2526 h 2802"/>
              <a:gd name="T4" fmla="*/ 226 w 2896"/>
              <a:gd name="T5" fmla="*/ 2388 h 2802"/>
              <a:gd name="T6" fmla="*/ 183 w 2896"/>
              <a:gd name="T7" fmla="*/ 2621 h 2802"/>
              <a:gd name="T8" fmla="*/ 701 w 2896"/>
              <a:gd name="T9" fmla="*/ 2393 h 2802"/>
              <a:gd name="T10" fmla="*/ 509 w 2896"/>
              <a:gd name="T11" fmla="*/ 2275 h 2802"/>
              <a:gd name="T12" fmla="*/ 561 w 2896"/>
              <a:gd name="T13" fmla="*/ 2532 h 2802"/>
              <a:gd name="T14" fmla="*/ 213 w 2896"/>
              <a:gd name="T15" fmla="*/ 2251 h 2802"/>
              <a:gd name="T16" fmla="*/ 377 w 2896"/>
              <a:gd name="T17" fmla="*/ 2341 h 2802"/>
              <a:gd name="T18" fmla="*/ 834 w 2896"/>
              <a:gd name="T19" fmla="*/ 2024 h 2802"/>
              <a:gd name="T20" fmla="*/ 867 w 2896"/>
              <a:gd name="T21" fmla="*/ 2170 h 2802"/>
              <a:gd name="T22" fmla="*/ 921 w 2896"/>
              <a:gd name="T23" fmla="*/ 2129 h 2802"/>
              <a:gd name="T24" fmla="*/ 818 w 2896"/>
              <a:gd name="T25" fmla="*/ 2270 h 2802"/>
              <a:gd name="T26" fmla="*/ 688 w 2896"/>
              <a:gd name="T27" fmla="*/ 1977 h 2802"/>
              <a:gd name="T28" fmla="*/ 647 w 2896"/>
              <a:gd name="T29" fmla="*/ 2072 h 2802"/>
              <a:gd name="T30" fmla="*/ 1177 w 2896"/>
              <a:gd name="T31" fmla="*/ 1919 h 2802"/>
              <a:gd name="T32" fmla="*/ 964 w 2896"/>
              <a:gd name="T33" fmla="*/ 1783 h 2802"/>
              <a:gd name="T34" fmla="*/ 1037 w 2896"/>
              <a:gd name="T35" fmla="*/ 2059 h 2802"/>
              <a:gd name="T36" fmla="*/ 794 w 2896"/>
              <a:gd name="T37" fmla="*/ 1865 h 2802"/>
              <a:gd name="T38" fmla="*/ 864 w 2896"/>
              <a:gd name="T39" fmla="*/ 1804 h 2802"/>
              <a:gd name="T40" fmla="*/ 1399 w 2896"/>
              <a:gd name="T41" fmla="*/ 1847 h 2802"/>
              <a:gd name="T42" fmla="*/ 1305 w 2896"/>
              <a:gd name="T43" fmla="*/ 1783 h 2802"/>
              <a:gd name="T44" fmla="*/ 1048 w 2896"/>
              <a:gd name="T45" fmla="*/ 1611 h 2802"/>
              <a:gd name="T46" fmla="*/ 1189 w 2896"/>
              <a:gd name="T47" fmla="*/ 1467 h 2802"/>
              <a:gd name="T48" fmla="*/ 1505 w 2896"/>
              <a:gd name="T49" fmla="*/ 1588 h 2802"/>
              <a:gd name="T50" fmla="*/ 1158 w 2896"/>
              <a:gd name="T51" fmla="*/ 1306 h 2802"/>
              <a:gd name="T52" fmla="*/ 1504 w 2896"/>
              <a:gd name="T53" fmla="*/ 1579 h 2802"/>
              <a:gd name="T54" fmla="*/ 1676 w 2896"/>
              <a:gd name="T55" fmla="*/ 1366 h 2802"/>
              <a:gd name="T56" fmla="*/ 1483 w 2896"/>
              <a:gd name="T57" fmla="*/ 1391 h 2802"/>
              <a:gd name="T58" fmla="*/ 1458 w 2896"/>
              <a:gd name="T59" fmla="*/ 1252 h 2802"/>
              <a:gd name="T60" fmla="*/ 1391 w 2896"/>
              <a:gd name="T61" fmla="*/ 1334 h 2802"/>
              <a:gd name="T62" fmla="*/ 1514 w 2896"/>
              <a:gd name="T63" fmla="*/ 1175 h 2802"/>
              <a:gd name="T64" fmla="*/ 1531 w 2896"/>
              <a:gd name="T65" fmla="*/ 1409 h 2802"/>
              <a:gd name="T66" fmla="*/ 1840 w 2896"/>
              <a:gd name="T67" fmla="*/ 1249 h 2802"/>
              <a:gd name="T68" fmla="*/ 1494 w 2896"/>
              <a:gd name="T69" fmla="*/ 976 h 2802"/>
              <a:gd name="T70" fmla="*/ 1532 w 2896"/>
              <a:gd name="T71" fmla="*/ 939 h 2802"/>
              <a:gd name="T72" fmla="*/ 2031 w 2896"/>
              <a:gd name="T73" fmla="*/ 1053 h 2802"/>
              <a:gd name="T74" fmla="*/ 1818 w 2896"/>
              <a:gd name="T75" fmla="*/ 1099 h 2802"/>
              <a:gd name="T76" fmla="*/ 1817 w 2896"/>
              <a:gd name="T77" fmla="*/ 900 h 2802"/>
              <a:gd name="T78" fmla="*/ 1731 w 2896"/>
              <a:gd name="T79" fmla="*/ 1006 h 2802"/>
              <a:gd name="T80" fmla="*/ 1808 w 2896"/>
              <a:gd name="T81" fmla="*/ 852 h 2802"/>
              <a:gd name="T82" fmla="*/ 1863 w 2896"/>
              <a:gd name="T83" fmla="*/ 1052 h 2802"/>
              <a:gd name="T84" fmla="*/ 2311 w 2896"/>
              <a:gd name="T85" fmla="*/ 771 h 2802"/>
              <a:gd name="T86" fmla="*/ 2274 w 2896"/>
              <a:gd name="T87" fmla="*/ 809 h 2802"/>
              <a:gd name="T88" fmla="*/ 2172 w 2896"/>
              <a:gd name="T89" fmla="*/ 911 h 2802"/>
              <a:gd name="T90" fmla="*/ 2134 w 2896"/>
              <a:gd name="T91" fmla="*/ 949 h 2802"/>
              <a:gd name="T92" fmla="*/ 1958 w 2896"/>
              <a:gd name="T93" fmla="*/ 706 h 2802"/>
              <a:gd name="T94" fmla="*/ 2186 w 2896"/>
              <a:gd name="T95" fmla="*/ 645 h 2802"/>
              <a:gd name="T96" fmla="*/ 2392 w 2896"/>
              <a:gd name="T97" fmla="*/ 701 h 2802"/>
              <a:gd name="T98" fmla="*/ 2198 w 2896"/>
              <a:gd name="T99" fmla="*/ 459 h 2802"/>
              <a:gd name="T100" fmla="*/ 2125 w 2896"/>
              <a:gd name="T101" fmla="*/ 442 h 2802"/>
              <a:gd name="T102" fmla="*/ 2669 w 2896"/>
              <a:gd name="T103" fmla="*/ 424 h 2802"/>
              <a:gd name="T104" fmla="*/ 2478 w 2896"/>
              <a:gd name="T105" fmla="*/ 306 h 2802"/>
              <a:gd name="T106" fmla="*/ 2529 w 2896"/>
              <a:gd name="T107" fmla="*/ 564 h 2802"/>
              <a:gd name="T108" fmla="*/ 2281 w 2896"/>
              <a:gd name="T109" fmla="*/ 382 h 2802"/>
              <a:gd name="T110" fmla="*/ 2345 w 2896"/>
              <a:gd name="T111" fmla="*/ 379 h 2802"/>
              <a:gd name="T112" fmla="*/ 2803 w 2896"/>
              <a:gd name="T113" fmla="*/ 55 h 2802"/>
              <a:gd name="T114" fmla="*/ 2835 w 2896"/>
              <a:gd name="T115" fmla="*/ 201 h 2802"/>
              <a:gd name="T116" fmla="*/ 2890 w 2896"/>
              <a:gd name="T117" fmla="*/ 160 h 2802"/>
              <a:gd name="T118" fmla="*/ 2787 w 2896"/>
              <a:gd name="T119" fmla="*/ 302 h 2802"/>
              <a:gd name="T120" fmla="*/ 2657 w 2896"/>
              <a:gd name="T121" fmla="*/ 8 h 2802"/>
              <a:gd name="T122" fmla="*/ 2616 w 2896"/>
              <a:gd name="T123" fmla="*/ 103 h 2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2896" h="2802">
                <a:moveTo>
                  <a:pt x="261" y="2414"/>
                </a:moveTo>
                <a:cubicBezTo>
                  <a:pt x="276" y="2429"/>
                  <a:pt x="287" y="2444"/>
                  <a:pt x="294" y="2461"/>
                </a:cubicBezTo>
                <a:cubicBezTo>
                  <a:pt x="301" y="2478"/>
                  <a:pt x="304" y="2495"/>
                  <a:pt x="303" y="2513"/>
                </a:cubicBezTo>
                <a:cubicBezTo>
                  <a:pt x="302" y="2530"/>
                  <a:pt x="298" y="2548"/>
                  <a:pt x="289" y="2566"/>
                </a:cubicBezTo>
                <a:cubicBezTo>
                  <a:pt x="281" y="2583"/>
                  <a:pt x="267" y="2601"/>
                  <a:pt x="249" y="2620"/>
                </a:cubicBezTo>
                <a:lnTo>
                  <a:pt x="215" y="2654"/>
                </a:lnTo>
                <a:lnTo>
                  <a:pt x="322" y="2760"/>
                </a:lnTo>
                <a:cubicBezTo>
                  <a:pt x="323" y="2762"/>
                  <a:pt x="324" y="2763"/>
                  <a:pt x="324" y="2765"/>
                </a:cubicBezTo>
                <a:cubicBezTo>
                  <a:pt x="324" y="2766"/>
                  <a:pt x="324" y="2768"/>
                  <a:pt x="323" y="2770"/>
                </a:cubicBezTo>
                <a:cubicBezTo>
                  <a:pt x="322" y="2772"/>
                  <a:pt x="321" y="2774"/>
                  <a:pt x="318" y="2777"/>
                </a:cubicBezTo>
                <a:cubicBezTo>
                  <a:pt x="316" y="2780"/>
                  <a:pt x="313" y="2784"/>
                  <a:pt x="309" y="2787"/>
                </a:cubicBezTo>
                <a:cubicBezTo>
                  <a:pt x="306" y="2791"/>
                  <a:pt x="302" y="2794"/>
                  <a:pt x="299" y="2796"/>
                </a:cubicBezTo>
                <a:cubicBezTo>
                  <a:pt x="296" y="2798"/>
                  <a:pt x="294" y="2800"/>
                  <a:pt x="292" y="2801"/>
                </a:cubicBezTo>
                <a:cubicBezTo>
                  <a:pt x="290" y="2802"/>
                  <a:pt x="288" y="2802"/>
                  <a:pt x="287" y="2802"/>
                </a:cubicBezTo>
                <a:cubicBezTo>
                  <a:pt x="285" y="2802"/>
                  <a:pt x="284" y="2801"/>
                  <a:pt x="282" y="2800"/>
                </a:cubicBezTo>
                <a:lnTo>
                  <a:pt x="9" y="2526"/>
                </a:lnTo>
                <a:cubicBezTo>
                  <a:pt x="3" y="2520"/>
                  <a:pt x="0" y="2514"/>
                  <a:pt x="0" y="2508"/>
                </a:cubicBezTo>
                <a:cubicBezTo>
                  <a:pt x="1" y="2502"/>
                  <a:pt x="3" y="2497"/>
                  <a:pt x="7" y="2493"/>
                </a:cubicBezTo>
                <a:lnTo>
                  <a:pt x="71" y="2430"/>
                </a:lnTo>
                <a:cubicBezTo>
                  <a:pt x="77" y="2424"/>
                  <a:pt x="84" y="2418"/>
                  <a:pt x="90" y="2412"/>
                </a:cubicBezTo>
                <a:cubicBezTo>
                  <a:pt x="97" y="2407"/>
                  <a:pt x="105" y="2401"/>
                  <a:pt x="114" y="2395"/>
                </a:cubicBezTo>
                <a:cubicBezTo>
                  <a:pt x="124" y="2389"/>
                  <a:pt x="136" y="2384"/>
                  <a:pt x="149" y="2380"/>
                </a:cubicBezTo>
                <a:cubicBezTo>
                  <a:pt x="162" y="2377"/>
                  <a:pt x="175" y="2376"/>
                  <a:pt x="188" y="2377"/>
                </a:cubicBezTo>
                <a:cubicBezTo>
                  <a:pt x="201" y="2378"/>
                  <a:pt x="213" y="2382"/>
                  <a:pt x="226" y="2388"/>
                </a:cubicBezTo>
                <a:cubicBezTo>
                  <a:pt x="238" y="2394"/>
                  <a:pt x="250" y="2403"/>
                  <a:pt x="261" y="2414"/>
                </a:cubicBezTo>
                <a:close/>
                <a:moveTo>
                  <a:pt x="223" y="2458"/>
                </a:moveTo>
                <a:cubicBezTo>
                  <a:pt x="211" y="2446"/>
                  <a:pt x="198" y="2438"/>
                  <a:pt x="186" y="2435"/>
                </a:cubicBezTo>
                <a:cubicBezTo>
                  <a:pt x="173" y="2431"/>
                  <a:pt x="161" y="2431"/>
                  <a:pt x="151" y="2434"/>
                </a:cubicBezTo>
                <a:cubicBezTo>
                  <a:pt x="140" y="2436"/>
                  <a:pt x="131" y="2441"/>
                  <a:pt x="123" y="2447"/>
                </a:cubicBezTo>
                <a:cubicBezTo>
                  <a:pt x="114" y="2453"/>
                  <a:pt x="107" y="2459"/>
                  <a:pt x="100" y="2466"/>
                </a:cubicBezTo>
                <a:lnTo>
                  <a:pt x="64" y="2502"/>
                </a:lnTo>
                <a:lnTo>
                  <a:pt x="183" y="2621"/>
                </a:lnTo>
                <a:lnTo>
                  <a:pt x="218" y="2586"/>
                </a:lnTo>
                <a:cubicBezTo>
                  <a:pt x="230" y="2574"/>
                  <a:pt x="239" y="2562"/>
                  <a:pt x="243" y="2551"/>
                </a:cubicBezTo>
                <a:cubicBezTo>
                  <a:pt x="248" y="2540"/>
                  <a:pt x="251" y="2530"/>
                  <a:pt x="250" y="2519"/>
                </a:cubicBezTo>
                <a:cubicBezTo>
                  <a:pt x="250" y="2508"/>
                  <a:pt x="248" y="2497"/>
                  <a:pt x="243" y="2487"/>
                </a:cubicBezTo>
                <a:cubicBezTo>
                  <a:pt x="238" y="2477"/>
                  <a:pt x="231" y="2467"/>
                  <a:pt x="223" y="2458"/>
                </a:cubicBezTo>
                <a:close/>
                <a:moveTo>
                  <a:pt x="699" y="2383"/>
                </a:moveTo>
                <a:cubicBezTo>
                  <a:pt x="700" y="2385"/>
                  <a:pt x="701" y="2386"/>
                  <a:pt x="701" y="2387"/>
                </a:cubicBezTo>
                <a:cubicBezTo>
                  <a:pt x="702" y="2389"/>
                  <a:pt x="701" y="2391"/>
                  <a:pt x="701" y="2393"/>
                </a:cubicBezTo>
                <a:cubicBezTo>
                  <a:pt x="700" y="2395"/>
                  <a:pt x="698" y="2397"/>
                  <a:pt x="696" y="2400"/>
                </a:cubicBezTo>
                <a:cubicBezTo>
                  <a:pt x="694" y="2402"/>
                  <a:pt x="691" y="2406"/>
                  <a:pt x="688" y="2409"/>
                </a:cubicBezTo>
                <a:cubicBezTo>
                  <a:pt x="684" y="2413"/>
                  <a:pt x="680" y="2416"/>
                  <a:pt x="678" y="2418"/>
                </a:cubicBezTo>
                <a:cubicBezTo>
                  <a:pt x="675" y="2420"/>
                  <a:pt x="673" y="2422"/>
                  <a:pt x="671" y="2423"/>
                </a:cubicBezTo>
                <a:cubicBezTo>
                  <a:pt x="669" y="2423"/>
                  <a:pt x="667" y="2424"/>
                  <a:pt x="665" y="2423"/>
                </a:cubicBezTo>
                <a:cubicBezTo>
                  <a:pt x="664" y="2423"/>
                  <a:pt x="663" y="2422"/>
                  <a:pt x="661" y="2421"/>
                </a:cubicBezTo>
                <a:lnTo>
                  <a:pt x="541" y="2300"/>
                </a:lnTo>
                <a:cubicBezTo>
                  <a:pt x="529" y="2289"/>
                  <a:pt x="518" y="2280"/>
                  <a:pt x="509" y="2275"/>
                </a:cubicBezTo>
                <a:cubicBezTo>
                  <a:pt x="500" y="2269"/>
                  <a:pt x="492" y="2266"/>
                  <a:pt x="483" y="2264"/>
                </a:cubicBezTo>
                <a:cubicBezTo>
                  <a:pt x="474" y="2263"/>
                  <a:pt x="466" y="2263"/>
                  <a:pt x="457" y="2266"/>
                </a:cubicBezTo>
                <a:cubicBezTo>
                  <a:pt x="449" y="2269"/>
                  <a:pt x="441" y="2274"/>
                  <a:pt x="434" y="2281"/>
                </a:cubicBezTo>
                <a:cubicBezTo>
                  <a:pt x="424" y="2291"/>
                  <a:pt x="418" y="2304"/>
                  <a:pt x="415" y="2320"/>
                </a:cubicBezTo>
                <a:cubicBezTo>
                  <a:pt x="413" y="2336"/>
                  <a:pt x="413" y="2356"/>
                  <a:pt x="415" y="2379"/>
                </a:cubicBezTo>
                <a:lnTo>
                  <a:pt x="559" y="2523"/>
                </a:lnTo>
                <a:cubicBezTo>
                  <a:pt x="561" y="2525"/>
                  <a:pt x="561" y="2526"/>
                  <a:pt x="562" y="2527"/>
                </a:cubicBezTo>
                <a:cubicBezTo>
                  <a:pt x="562" y="2529"/>
                  <a:pt x="562" y="2530"/>
                  <a:pt x="561" y="2532"/>
                </a:cubicBezTo>
                <a:cubicBezTo>
                  <a:pt x="560" y="2534"/>
                  <a:pt x="559" y="2537"/>
                  <a:pt x="556" y="2540"/>
                </a:cubicBezTo>
                <a:cubicBezTo>
                  <a:pt x="554" y="2542"/>
                  <a:pt x="551" y="2546"/>
                  <a:pt x="547" y="2549"/>
                </a:cubicBezTo>
                <a:cubicBezTo>
                  <a:pt x="544" y="2553"/>
                  <a:pt x="541" y="2556"/>
                  <a:pt x="538" y="2558"/>
                </a:cubicBezTo>
                <a:cubicBezTo>
                  <a:pt x="535" y="2560"/>
                  <a:pt x="533" y="2562"/>
                  <a:pt x="531" y="2563"/>
                </a:cubicBezTo>
                <a:cubicBezTo>
                  <a:pt x="529" y="2563"/>
                  <a:pt x="527" y="2564"/>
                  <a:pt x="525" y="2563"/>
                </a:cubicBezTo>
                <a:cubicBezTo>
                  <a:pt x="524" y="2563"/>
                  <a:pt x="523" y="2562"/>
                  <a:pt x="522" y="2561"/>
                </a:cubicBezTo>
                <a:lnTo>
                  <a:pt x="215" y="2255"/>
                </a:lnTo>
                <a:cubicBezTo>
                  <a:pt x="214" y="2254"/>
                  <a:pt x="213" y="2252"/>
                  <a:pt x="213" y="2251"/>
                </a:cubicBezTo>
                <a:cubicBezTo>
                  <a:pt x="212" y="2249"/>
                  <a:pt x="213" y="2248"/>
                  <a:pt x="214" y="2246"/>
                </a:cubicBezTo>
                <a:cubicBezTo>
                  <a:pt x="214" y="2243"/>
                  <a:pt x="216" y="2241"/>
                  <a:pt x="218" y="2238"/>
                </a:cubicBezTo>
                <a:cubicBezTo>
                  <a:pt x="220" y="2236"/>
                  <a:pt x="223" y="2232"/>
                  <a:pt x="227" y="2229"/>
                </a:cubicBezTo>
                <a:cubicBezTo>
                  <a:pt x="231" y="2225"/>
                  <a:pt x="234" y="2222"/>
                  <a:pt x="237" y="2220"/>
                </a:cubicBezTo>
                <a:cubicBezTo>
                  <a:pt x="239" y="2218"/>
                  <a:pt x="242" y="2216"/>
                  <a:pt x="244" y="2215"/>
                </a:cubicBezTo>
                <a:cubicBezTo>
                  <a:pt x="246" y="2215"/>
                  <a:pt x="247" y="2214"/>
                  <a:pt x="249" y="2215"/>
                </a:cubicBezTo>
                <a:cubicBezTo>
                  <a:pt x="250" y="2215"/>
                  <a:pt x="252" y="2216"/>
                  <a:pt x="253" y="2217"/>
                </a:cubicBezTo>
                <a:lnTo>
                  <a:pt x="377" y="2341"/>
                </a:lnTo>
                <a:cubicBezTo>
                  <a:pt x="376" y="2318"/>
                  <a:pt x="378" y="2299"/>
                  <a:pt x="384" y="2282"/>
                </a:cubicBezTo>
                <a:cubicBezTo>
                  <a:pt x="389" y="2266"/>
                  <a:pt x="398" y="2252"/>
                  <a:pt x="409" y="2241"/>
                </a:cubicBezTo>
                <a:cubicBezTo>
                  <a:pt x="423" y="2227"/>
                  <a:pt x="436" y="2218"/>
                  <a:pt x="450" y="2213"/>
                </a:cubicBezTo>
                <a:cubicBezTo>
                  <a:pt x="465" y="2208"/>
                  <a:pt x="478" y="2207"/>
                  <a:pt x="492" y="2209"/>
                </a:cubicBezTo>
                <a:cubicBezTo>
                  <a:pt x="506" y="2211"/>
                  <a:pt x="519" y="2216"/>
                  <a:pt x="532" y="2224"/>
                </a:cubicBezTo>
                <a:cubicBezTo>
                  <a:pt x="545" y="2232"/>
                  <a:pt x="559" y="2243"/>
                  <a:pt x="574" y="2258"/>
                </a:cubicBezTo>
                <a:lnTo>
                  <a:pt x="699" y="2383"/>
                </a:lnTo>
                <a:close/>
                <a:moveTo>
                  <a:pt x="834" y="2024"/>
                </a:moveTo>
                <a:cubicBezTo>
                  <a:pt x="840" y="2030"/>
                  <a:pt x="843" y="2036"/>
                  <a:pt x="843" y="2041"/>
                </a:cubicBezTo>
                <a:cubicBezTo>
                  <a:pt x="842" y="2047"/>
                  <a:pt x="840" y="2051"/>
                  <a:pt x="836" y="2055"/>
                </a:cubicBezTo>
                <a:lnTo>
                  <a:pt x="700" y="2191"/>
                </a:lnTo>
                <a:cubicBezTo>
                  <a:pt x="712" y="2203"/>
                  <a:pt x="723" y="2212"/>
                  <a:pt x="735" y="2219"/>
                </a:cubicBezTo>
                <a:cubicBezTo>
                  <a:pt x="746" y="2226"/>
                  <a:pt x="758" y="2230"/>
                  <a:pt x="770" y="2231"/>
                </a:cubicBezTo>
                <a:cubicBezTo>
                  <a:pt x="782" y="2232"/>
                  <a:pt x="794" y="2230"/>
                  <a:pt x="806" y="2225"/>
                </a:cubicBezTo>
                <a:cubicBezTo>
                  <a:pt x="818" y="2220"/>
                  <a:pt x="830" y="2211"/>
                  <a:pt x="843" y="2199"/>
                </a:cubicBezTo>
                <a:cubicBezTo>
                  <a:pt x="853" y="2189"/>
                  <a:pt x="861" y="2179"/>
                  <a:pt x="867" y="2170"/>
                </a:cubicBezTo>
                <a:cubicBezTo>
                  <a:pt x="873" y="2161"/>
                  <a:pt x="878" y="2152"/>
                  <a:pt x="881" y="2145"/>
                </a:cubicBezTo>
                <a:cubicBezTo>
                  <a:pt x="885" y="2137"/>
                  <a:pt x="888" y="2131"/>
                  <a:pt x="890" y="2125"/>
                </a:cubicBezTo>
                <a:cubicBezTo>
                  <a:pt x="892" y="2120"/>
                  <a:pt x="894" y="2117"/>
                  <a:pt x="895" y="2115"/>
                </a:cubicBezTo>
                <a:cubicBezTo>
                  <a:pt x="896" y="2114"/>
                  <a:pt x="898" y="2113"/>
                  <a:pt x="899" y="2113"/>
                </a:cubicBezTo>
                <a:cubicBezTo>
                  <a:pt x="900" y="2112"/>
                  <a:pt x="902" y="2113"/>
                  <a:pt x="903" y="2113"/>
                </a:cubicBezTo>
                <a:cubicBezTo>
                  <a:pt x="905" y="2114"/>
                  <a:pt x="907" y="2115"/>
                  <a:pt x="909" y="2117"/>
                </a:cubicBezTo>
                <a:cubicBezTo>
                  <a:pt x="911" y="2118"/>
                  <a:pt x="914" y="2121"/>
                  <a:pt x="916" y="2123"/>
                </a:cubicBezTo>
                <a:cubicBezTo>
                  <a:pt x="918" y="2125"/>
                  <a:pt x="920" y="2127"/>
                  <a:pt x="921" y="2129"/>
                </a:cubicBezTo>
                <a:cubicBezTo>
                  <a:pt x="922" y="2130"/>
                  <a:pt x="924" y="2132"/>
                  <a:pt x="925" y="2133"/>
                </a:cubicBezTo>
                <a:cubicBezTo>
                  <a:pt x="925" y="2135"/>
                  <a:pt x="926" y="2136"/>
                  <a:pt x="926" y="2137"/>
                </a:cubicBezTo>
                <a:cubicBezTo>
                  <a:pt x="927" y="2139"/>
                  <a:pt x="927" y="2140"/>
                  <a:pt x="927" y="2142"/>
                </a:cubicBezTo>
                <a:cubicBezTo>
                  <a:pt x="927" y="2144"/>
                  <a:pt x="926" y="2148"/>
                  <a:pt x="924" y="2154"/>
                </a:cubicBezTo>
                <a:cubicBezTo>
                  <a:pt x="921" y="2160"/>
                  <a:pt x="918" y="2167"/>
                  <a:pt x="913" y="2175"/>
                </a:cubicBezTo>
                <a:cubicBezTo>
                  <a:pt x="909" y="2184"/>
                  <a:pt x="903" y="2193"/>
                  <a:pt x="895" y="2203"/>
                </a:cubicBezTo>
                <a:cubicBezTo>
                  <a:pt x="888" y="2213"/>
                  <a:pt x="880" y="2223"/>
                  <a:pt x="870" y="2233"/>
                </a:cubicBezTo>
                <a:cubicBezTo>
                  <a:pt x="853" y="2250"/>
                  <a:pt x="836" y="2262"/>
                  <a:pt x="818" y="2270"/>
                </a:cubicBezTo>
                <a:cubicBezTo>
                  <a:pt x="801" y="2278"/>
                  <a:pt x="783" y="2282"/>
                  <a:pt x="765" y="2281"/>
                </a:cubicBezTo>
                <a:cubicBezTo>
                  <a:pt x="747" y="2281"/>
                  <a:pt x="729" y="2276"/>
                  <a:pt x="710" y="2266"/>
                </a:cubicBezTo>
                <a:cubicBezTo>
                  <a:pt x="692" y="2256"/>
                  <a:pt x="673" y="2242"/>
                  <a:pt x="654" y="2224"/>
                </a:cubicBezTo>
                <a:cubicBezTo>
                  <a:pt x="637" y="2206"/>
                  <a:pt x="623" y="2188"/>
                  <a:pt x="614" y="2169"/>
                </a:cubicBezTo>
                <a:cubicBezTo>
                  <a:pt x="604" y="2150"/>
                  <a:pt x="599" y="2132"/>
                  <a:pt x="597" y="2113"/>
                </a:cubicBezTo>
                <a:cubicBezTo>
                  <a:pt x="596" y="2095"/>
                  <a:pt x="599" y="2077"/>
                  <a:pt x="606" y="2059"/>
                </a:cubicBezTo>
                <a:cubicBezTo>
                  <a:pt x="613" y="2042"/>
                  <a:pt x="624" y="2025"/>
                  <a:pt x="639" y="2010"/>
                </a:cubicBezTo>
                <a:cubicBezTo>
                  <a:pt x="655" y="1994"/>
                  <a:pt x="672" y="1983"/>
                  <a:pt x="688" y="1977"/>
                </a:cubicBezTo>
                <a:cubicBezTo>
                  <a:pt x="705" y="1971"/>
                  <a:pt x="721" y="1968"/>
                  <a:pt x="737" y="1970"/>
                </a:cubicBezTo>
                <a:cubicBezTo>
                  <a:pt x="753" y="1971"/>
                  <a:pt x="769" y="1976"/>
                  <a:pt x="784" y="1984"/>
                </a:cubicBezTo>
                <a:cubicBezTo>
                  <a:pt x="800" y="1993"/>
                  <a:pt x="814" y="2004"/>
                  <a:pt x="828" y="2017"/>
                </a:cubicBezTo>
                <a:lnTo>
                  <a:pt x="834" y="2024"/>
                </a:lnTo>
                <a:close/>
                <a:moveTo>
                  <a:pt x="785" y="2051"/>
                </a:moveTo>
                <a:cubicBezTo>
                  <a:pt x="766" y="2031"/>
                  <a:pt x="746" y="2019"/>
                  <a:pt x="725" y="2017"/>
                </a:cubicBezTo>
                <a:cubicBezTo>
                  <a:pt x="704" y="2015"/>
                  <a:pt x="685" y="2023"/>
                  <a:pt x="667" y="2042"/>
                </a:cubicBezTo>
                <a:cubicBezTo>
                  <a:pt x="657" y="2051"/>
                  <a:pt x="651" y="2061"/>
                  <a:pt x="647" y="2072"/>
                </a:cubicBezTo>
                <a:cubicBezTo>
                  <a:pt x="644" y="2082"/>
                  <a:pt x="642" y="2093"/>
                  <a:pt x="644" y="2103"/>
                </a:cubicBezTo>
                <a:cubicBezTo>
                  <a:pt x="645" y="2114"/>
                  <a:pt x="648" y="2125"/>
                  <a:pt x="653" y="2135"/>
                </a:cubicBezTo>
                <a:cubicBezTo>
                  <a:pt x="658" y="2145"/>
                  <a:pt x="664" y="2155"/>
                  <a:pt x="673" y="2163"/>
                </a:cubicBezTo>
                <a:lnTo>
                  <a:pt x="785" y="2051"/>
                </a:lnTo>
                <a:close/>
                <a:moveTo>
                  <a:pt x="1180" y="1903"/>
                </a:moveTo>
                <a:cubicBezTo>
                  <a:pt x="1181" y="1904"/>
                  <a:pt x="1182" y="1905"/>
                  <a:pt x="1182" y="1907"/>
                </a:cubicBezTo>
                <a:cubicBezTo>
                  <a:pt x="1182" y="1908"/>
                  <a:pt x="1182" y="1910"/>
                  <a:pt x="1181" y="1912"/>
                </a:cubicBezTo>
                <a:cubicBezTo>
                  <a:pt x="1181" y="1914"/>
                  <a:pt x="1179" y="1916"/>
                  <a:pt x="1177" y="1919"/>
                </a:cubicBezTo>
                <a:cubicBezTo>
                  <a:pt x="1175" y="1922"/>
                  <a:pt x="1172" y="1925"/>
                  <a:pt x="1168" y="1929"/>
                </a:cubicBezTo>
                <a:cubicBezTo>
                  <a:pt x="1165" y="1932"/>
                  <a:pt x="1161" y="1935"/>
                  <a:pt x="1159" y="1937"/>
                </a:cubicBezTo>
                <a:cubicBezTo>
                  <a:pt x="1156" y="1940"/>
                  <a:pt x="1153" y="1941"/>
                  <a:pt x="1151" y="1942"/>
                </a:cubicBezTo>
                <a:cubicBezTo>
                  <a:pt x="1149" y="1943"/>
                  <a:pt x="1148" y="1943"/>
                  <a:pt x="1146" y="1943"/>
                </a:cubicBezTo>
                <a:cubicBezTo>
                  <a:pt x="1145" y="1942"/>
                  <a:pt x="1143" y="1942"/>
                  <a:pt x="1142" y="1940"/>
                </a:cubicBezTo>
                <a:lnTo>
                  <a:pt x="1021" y="1820"/>
                </a:lnTo>
                <a:cubicBezTo>
                  <a:pt x="1010" y="1808"/>
                  <a:pt x="999" y="1799"/>
                  <a:pt x="990" y="1794"/>
                </a:cubicBezTo>
                <a:cubicBezTo>
                  <a:pt x="981" y="1789"/>
                  <a:pt x="972" y="1785"/>
                  <a:pt x="964" y="1783"/>
                </a:cubicBezTo>
                <a:cubicBezTo>
                  <a:pt x="955" y="1782"/>
                  <a:pt x="946" y="1782"/>
                  <a:pt x="938" y="1785"/>
                </a:cubicBezTo>
                <a:cubicBezTo>
                  <a:pt x="930" y="1788"/>
                  <a:pt x="922" y="1793"/>
                  <a:pt x="915" y="1800"/>
                </a:cubicBezTo>
                <a:cubicBezTo>
                  <a:pt x="905" y="1810"/>
                  <a:pt x="899" y="1823"/>
                  <a:pt x="896" y="1839"/>
                </a:cubicBezTo>
                <a:cubicBezTo>
                  <a:pt x="893" y="1855"/>
                  <a:pt x="893" y="1875"/>
                  <a:pt x="896" y="1898"/>
                </a:cubicBezTo>
                <a:lnTo>
                  <a:pt x="1040" y="2042"/>
                </a:lnTo>
                <a:cubicBezTo>
                  <a:pt x="1041" y="2044"/>
                  <a:pt x="1042" y="2045"/>
                  <a:pt x="1042" y="2046"/>
                </a:cubicBezTo>
                <a:cubicBezTo>
                  <a:pt x="1043" y="2048"/>
                  <a:pt x="1042" y="2050"/>
                  <a:pt x="1042" y="2052"/>
                </a:cubicBezTo>
                <a:cubicBezTo>
                  <a:pt x="1041" y="2054"/>
                  <a:pt x="1039" y="2056"/>
                  <a:pt x="1037" y="2059"/>
                </a:cubicBezTo>
                <a:cubicBezTo>
                  <a:pt x="1035" y="2061"/>
                  <a:pt x="1032" y="2065"/>
                  <a:pt x="1028" y="2069"/>
                </a:cubicBezTo>
                <a:cubicBezTo>
                  <a:pt x="1025" y="2072"/>
                  <a:pt x="1021" y="2075"/>
                  <a:pt x="1019" y="2077"/>
                </a:cubicBezTo>
                <a:cubicBezTo>
                  <a:pt x="1016" y="2079"/>
                  <a:pt x="1013" y="2081"/>
                  <a:pt x="1011" y="2082"/>
                </a:cubicBezTo>
                <a:cubicBezTo>
                  <a:pt x="1009" y="2083"/>
                  <a:pt x="1008" y="2083"/>
                  <a:pt x="1006" y="2083"/>
                </a:cubicBezTo>
                <a:cubicBezTo>
                  <a:pt x="1005" y="2082"/>
                  <a:pt x="1004" y="2082"/>
                  <a:pt x="1002" y="2080"/>
                </a:cubicBezTo>
                <a:lnTo>
                  <a:pt x="796" y="1874"/>
                </a:lnTo>
                <a:cubicBezTo>
                  <a:pt x="795" y="1873"/>
                  <a:pt x="794" y="1871"/>
                  <a:pt x="794" y="1870"/>
                </a:cubicBezTo>
                <a:cubicBezTo>
                  <a:pt x="793" y="1869"/>
                  <a:pt x="793" y="1867"/>
                  <a:pt x="794" y="1865"/>
                </a:cubicBezTo>
                <a:cubicBezTo>
                  <a:pt x="795" y="1863"/>
                  <a:pt x="796" y="1861"/>
                  <a:pt x="798" y="1858"/>
                </a:cubicBezTo>
                <a:cubicBezTo>
                  <a:pt x="800" y="1856"/>
                  <a:pt x="803" y="1853"/>
                  <a:pt x="806" y="1850"/>
                </a:cubicBezTo>
                <a:cubicBezTo>
                  <a:pt x="809" y="1846"/>
                  <a:pt x="812" y="1844"/>
                  <a:pt x="815" y="1842"/>
                </a:cubicBezTo>
                <a:cubicBezTo>
                  <a:pt x="817" y="1840"/>
                  <a:pt x="819" y="1838"/>
                  <a:pt x="821" y="1838"/>
                </a:cubicBezTo>
                <a:cubicBezTo>
                  <a:pt x="823" y="1837"/>
                  <a:pt x="825" y="1837"/>
                  <a:pt x="826" y="1837"/>
                </a:cubicBezTo>
                <a:cubicBezTo>
                  <a:pt x="828" y="1838"/>
                  <a:pt x="829" y="1839"/>
                  <a:pt x="830" y="1840"/>
                </a:cubicBezTo>
                <a:lnTo>
                  <a:pt x="857" y="1867"/>
                </a:lnTo>
                <a:cubicBezTo>
                  <a:pt x="856" y="1842"/>
                  <a:pt x="858" y="1821"/>
                  <a:pt x="864" y="1804"/>
                </a:cubicBezTo>
                <a:cubicBezTo>
                  <a:pt x="869" y="1786"/>
                  <a:pt x="878" y="1772"/>
                  <a:pt x="890" y="1760"/>
                </a:cubicBezTo>
                <a:cubicBezTo>
                  <a:pt x="903" y="1746"/>
                  <a:pt x="917" y="1737"/>
                  <a:pt x="931" y="1732"/>
                </a:cubicBezTo>
                <a:cubicBezTo>
                  <a:pt x="945" y="1727"/>
                  <a:pt x="959" y="1726"/>
                  <a:pt x="973" y="1728"/>
                </a:cubicBezTo>
                <a:cubicBezTo>
                  <a:pt x="986" y="1730"/>
                  <a:pt x="1000" y="1735"/>
                  <a:pt x="1013" y="1743"/>
                </a:cubicBezTo>
                <a:cubicBezTo>
                  <a:pt x="1026" y="1751"/>
                  <a:pt x="1040" y="1762"/>
                  <a:pt x="1054" y="1777"/>
                </a:cubicBezTo>
                <a:lnTo>
                  <a:pt x="1180" y="1903"/>
                </a:lnTo>
                <a:close/>
                <a:moveTo>
                  <a:pt x="1351" y="1743"/>
                </a:moveTo>
                <a:lnTo>
                  <a:pt x="1399" y="1847"/>
                </a:lnTo>
                <a:cubicBezTo>
                  <a:pt x="1401" y="1850"/>
                  <a:pt x="1400" y="1854"/>
                  <a:pt x="1398" y="1859"/>
                </a:cubicBezTo>
                <a:cubicBezTo>
                  <a:pt x="1396" y="1864"/>
                  <a:pt x="1391" y="1871"/>
                  <a:pt x="1383" y="1878"/>
                </a:cubicBezTo>
                <a:cubicBezTo>
                  <a:pt x="1379" y="1882"/>
                  <a:pt x="1376" y="1885"/>
                  <a:pt x="1373" y="1887"/>
                </a:cubicBezTo>
                <a:cubicBezTo>
                  <a:pt x="1370" y="1889"/>
                  <a:pt x="1367" y="1890"/>
                  <a:pt x="1365" y="1891"/>
                </a:cubicBezTo>
                <a:cubicBezTo>
                  <a:pt x="1363" y="1891"/>
                  <a:pt x="1361" y="1891"/>
                  <a:pt x="1359" y="1889"/>
                </a:cubicBezTo>
                <a:cubicBezTo>
                  <a:pt x="1358" y="1888"/>
                  <a:pt x="1356" y="1886"/>
                  <a:pt x="1355" y="1883"/>
                </a:cubicBezTo>
                <a:lnTo>
                  <a:pt x="1312" y="1783"/>
                </a:lnTo>
                <a:cubicBezTo>
                  <a:pt x="1310" y="1783"/>
                  <a:pt x="1307" y="1784"/>
                  <a:pt x="1305" y="1783"/>
                </a:cubicBezTo>
                <a:cubicBezTo>
                  <a:pt x="1302" y="1783"/>
                  <a:pt x="1300" y="1783"/>
                  <a:pt x="1298" y="1782"/>
                </a:cubicBezTo>
                <a:lnTo>
                  <a:pt x="1027" y="1658"/>
                </a:lnTo>
                <a:cubicBezTo>
                  <a:pt x="1023" y="1656"/>
                  <a:pt x="1020" y="1654"/>
                  <a:pt x="1018" y="1652"/>
                </a:cubicBezTo>
                <a:cubicBezTo>
                  <a:pt x="1016" y="1650"/>
                  <a:pt x="1015" y="1648"/>
                  <a:pt x="1015" y="1646"/>
                </a:cubicBezTo>
                <a:cubicBezTo>
                  <a:pt x="1015" y="1644"/>
                  <a:pt x="1017" y="1641"/>
                  <a:pt x="1019" y="1638"/>
                </a:cubicBezTo>
                <a:cubicBezTo>
                  <a:pt x="1021" y="1635"/>
                  <a:pt x="1025" y="1631"/>
                  <a:pt x="1029" y="1626"/>
                </a:cubicBezTo>
                <a:cubicBezTo>
                  <a:pt x="1034" y="1622"/>
                  <a:pt x="1038" y="1618"/>
                  <a:pt x="1040" y="1616"/>
                </a:cubicBezTo>
                <a:cubicBezTo>
                  <a:pt x="1043" y="1614"/>
                  <a:pt x="1046" y="1612"/>
                  <a:pt x="1048" y="1611"/>
                </a:cubicBezTo>
                <a:cubicBezTo>
                  <a:pt x="1050" y="1610"/>
                  <a:pt x="1052" y="1610"/>
                  <a:pt x="1054" y="1610"/>
                </a:cubicBezTo>
                <a:cubicBezTo>
                  <a:pt x="1056" y="1611"/>
                  <a:pt x="1058" y="1612"/>
                  <a:pt x="1061" y="1613"/>
                </a:cubicBezTo>
                <a:lnTo>
                  <a:pt x="1285" y="1719"/>
                </a:lnTo>
                <a:lnTo>
                  <a:pt x="1286" y="1719"/>
                </a:lnTo>
                <a:lnTo>
                  <a:pt x="1176" y="1496"/>
                </a:lnTo>
                <a:cubicBezTo>
                  <a:pt x="1174" y="1492"/>
                  <a:pt x="1174" y="1489"/>
                  <a:pt x="1174" y="1487"/>
                </a:cubicBezTo>
                <a:cubicBezTo>
                  <a:pt x="1174" y="1484"/>
                  <a:pt x="1176" y="1482"/>
                  <a:pt x="1178" y="1479"/>
                </a:cubicBezTo>
                <a:cubicBezTo>
                  <a:pt x="1180" y="1476"/>
                  <a:pt x="1184" y="1472"/>
                  <a:pt x="1189" y="1467"/>
                </a:cubicBezTo>
                <a:cubicBezTo>
                  <a:pt x="1193" y="1463"/>
                  <a:pt x="1197" y="1459"/>
                  <a:pt x="1200" y="1457"/>
                </a:cubicBezTo>
                <a:cubicBezTo>
                  <a:pt x="1203" y="1455"/>
                  <a:pt x="1206" y="1453"/>
                  <a:pt x="1208" y="1453"/>
                </a:cubicBezTo>
                <a:cubicBezTo>
                  <a:pt x="1210" y="1453"/>
                  <a:pt x="1213" y="1454"/>
                  <a:pt x="1214" y="1456"/>
                </a:cubicBezTo>
                <a:cubicBezTo>
                  <a:pt x="1216" y="1457"/>
                  <a:pt x="1218" y="1460"/>
                  <a:pt x="1220" y="1464"/>
                </a:cubicBezTo>
                <a:lnTo>
                  <a:pt x="1351" y="1743"/>
                </a:lnTo>
                <a:close/>
                <a:moveTo>
                  <a:pt x="1504" y="1579"/>
                </a:moveTo>
                <a:cubicBezTo>
                  <a:pt x="1505" y="1580"/>
                  <a:pt x="1506" y="1581"/>
                  <a:pt x="1506" y="1583"/>
                </a:cubicBezTo>
                <a:cubicBezTo>
                  <a:pt x="1506" y="1584"/>
                  <a:pt x="1506" y="1586"/>
                  <a:pt x="1505" y="1588"/>
                </a:cubicBezTo>
                <a:cubicBezTo>
                  <a:pt x="1505" y="1590"/>
                  <a:pt x="1503" y="1592"/>
                  <a:pt x="1501" y="1595"/>
                </a:cubicBezTo>
                <a:cubicBezTo>
                  <a:pt x="1499" y="1598"/>
                  <a:pt x="1496" y="1601"/>
                  <a:pt x="1492" y="1605"/>
                </a:cubicBezTo>
                <a:cubicBezTo>
                  <a:pt x="1488" y="1608"/>
                  <a:pt x="1485" y="1611"/>
                  <a:pt x="1483" y="1613"/>
                </a:cubicBezTo>
                <a:cubicBezTo>
                  <a:pt x="1480" y="1616"/>
                  <a:pt x="1477" y="1617"/>
                  <a:pt x="1475" y="1618"/>
                </a:cubicBezTo>
                <a:cubicBezTo>
                  <a:pt x="1473" y="1619"/>
                  <a:pt x="1472" y="1619"/>
                  <a:pt x="1470" y="1619"/>
                </a:cubicBezTo>
                <a:cubicBezTo>
                  <a:pt x="1469" y="1618"/>
                  <a:pt x="1467" y="1618"/>
                  <a:pt x="1466" y="1616"/>
                </a:cubicBezTo>
                <a:lnTo>
                  <a:pt x="1160" y="1310"/>
                </a:lnTo>
                <a:cubicBezTo>
                  <a:pt x="1159" y="1309"/>
                  <a:pt x="1158" y="1308"/>
                  <a:pt x="1158" y="1306"/>
                </a:cubicBezTo>
                <a:cubicBezTo>
                  <a:pt x="1157" y="1305"/>
                  <a:pt x="1157" y="1303"/>
                  <a:pt x="1158" y="1301"/>
                </a:cubicBezTo>
                <a:cubicBezTo>
                  <a:pt x="1159" y="1299"/>
                  <a:pt x="1161" y="1296"/>
                  <a:pt x="1163" y="1294"/>
                </a:cubicBezTo>
                <a:cubicBezTo>
                  <a:pt x="1165" y="1291"/>
                  <a:pt x="1168" y="1288"/>
                  <a:pt x="1171" y="1284"/>
                </a:cubicBezTo>
                <a:cubicBezTo>
                  <a:pt x="1175" y="1280"/>
                  <a:pt x="1179" y="1277"/>
                  <a:pt x="1181" y="1275"/>
                </a:cubicBezTo>
                <a:cubicBezTo>
                  <a:pt x="1184" y="1273"/>
                  <a:pt x="1186" y="1271"/>
                  <a:pt x="1188" y="1271"/>
                </a:cubicBezTo>
                <a:cubicBezTo>
                  <a:pt x="1190" y="1270"/>
                  <a:pt x="1192" y="1270"/>
                  <a:pt x="1194" y="1270"/>
                </a:cubicBezTo>
                <a:cubicBezTo>
                  <a:pt x="1195" y="1270"/>
                  <a:pt x="1197" y="1271"/>
                  <a:pt x="1198" y="1272"/>
                </a:cubicBezTo>
                <a:lnTo>
                  <a:pt x="1504" y="1579"/>
                </a:lnTo>
                <a:close/>
                <a:moveTo>
                  <a:pt x="1729" y="1354"/>
                </a:moveTo>
                <a:cubicBezTo>
                  <a:pt x="1731" y="1356"/>
                  <a:pt x="1732" y="1358"/>
                  <a:pt x="1732" y="1360"/>
                </a:cubicBezTo>
                <a:cubicBezTo>
                  <a:pt x="1731" y="1362"/>
                  <a:pt x="1730" y="1364"/>
                  <a:pt x="1729" y="1367"/>
                </a:cubicBezTo>
                <a:cubicBezTo>
                  <a:pt x="1727" y="1369"/>
                  <a:pt x="1724" y="1373"/>
                  <a:pt x="1720" y="1377"/>
                </a:cubicBezTo>
                <a:cubicBezTo>
                  <a:pt x="1716" y="1381"/>
                  <a:pt x="1713" y="1384"/>
                  <a:pt x="1710" y="1386"/>
                </a:cubicBezTo>
                <a:cubicBezTo>
                  <a:pt x="1707" y="1388"/>
                  <a:pt x="1705" y="1389"/>
                  <a:pt x="1703" y="1389"/>
                </a:cubicBezTo>
                <a:cubicBezTo>
                  <a:pt x="1701" y="1389"/>
                  <a:pt x="1699" y="1388"/>
                  <a:pt x="1697" y="1386"/>
                </a:cubicBezTo>
                <a:lnTo>
                  <a:pt x="1676" y="1366"/>
                </a:lnTo>
                <a:cubicBezTo>
                  <a:pt x="1677" y="1384"/>
                  <a:pt x="1674" y="1402"/>
                  <a:pt x="1669" y="1418"/>
                </a:cubicBezTo>
                <a:cubicBezTo>
                  <a:pt x="1663" y="1435"/>
                  <a:pt x="1654" y="1449"/>
                  <a:pt x="1641" y="1461"/>
                </a:cubicBezTo>
                <a:cubicBezTo>
                  <a:pt x="1631" y="1472"/>
                  <a:pt x="1619" y="1481"/>
                  <a:pt x="1608" y="1487"/>
                </a:cubicBezTo>
                <a:cubicBezTo>
                  <a:pt x="1596" y="1493"/>
                  <a:pt x="1584" y="1496"/>
                  <a:pt x="1573" y="1497"/>
                </a:cubicBezTo>
                <a:cubicBezTo>
                  <a:pt x="1561" y="1498"/>
                  <a:pt x="1550" y="1496"/>
                  <a:pt x="1539" y="1492"/>
                </a:cubicBezTo>
                <a:cubicBezTo>
                  <a:pt x="1528" y="1487"/>
                  <a:pt x="1517" y="1480"/>
                  <a:pt x="1507" y="1470"/>
                </a:cubicBezTo>
                <a:cubicBezTo>
                  <a:pt x="1495" y="1459"/>
                  <a:pt x="1488" y="1446"/>
                  <a:pt x="1484" y="1433"/>
                </a:cubicBezTo>
                <a:cubicBezTo>
                  <a:pt x="1480" y="1420"/>
                  <a:pt x="1480" y="1406"/>
                  <a:pt x="1483" y="1391"/>
                </a:cubicBezTo>
                <a:cubicBezTo>
                  <a:pt x="1486" y="1377"/>
                  <a:pt x="1493" y="1361"/>
                  <a:pt x="1503" y="1346"/>
                </a:cubicBezTo>
                <a:cubicBezTo>
                  <a:pt x="1513" y="1330"/>
                  <a:pt x="1526" y="1314"/>
                  <a:pt x="1542" y="1298"/>
                </a:cubicBezTo>
                <a:lnTo>
                  <a:pt x="1570" y="1270"/>
                </a:lnTo>
                <a:lnTo>
                  <a:pt x="1554" y="1254"/>
                </a:lnTo>
                <a:cubicBezTo>
                  <a:pt x="1546" y="1246"/>
                  <a:pt x="1538" y="1240"/>
                  <a:pt x="1531" y="1235"/>
                </a:cubicBezTo>
                <a:cubicBezTo>
                  <a:pt x="1523" y="1231"/>
                  <a:pt x="1515" y="1228"/>
                  <a:pt x="1507" y="1228"/>
                </a:cubicBezTo>
                <a:cubicBezTo>
                  <a:pt x="1499" y="1228"/>
                  <a:pt x="1492" y="1230"/>
                  <a:pt x="1484" y="1233"/>
                </a:cubicBezTo>
                <a:cubicBezTo>
                  <a:pt x="1475" y="1237"/>
                  <a:pt x="1467" y="1244"/>
                  <a:pt x="1458" y="1252"/>
                </a:cubicBezTo>
                <a:cubicBezTo>
                  <a:pt x="1449" y="1262"/>
                  <a:pt x="1442" y="1271"/>
                  <a:pt x="1437" y="1281"/>
                </a:cubicBezTo>
                <a:cubicBezTo>
                  <a:pt x="1431" y="1290"/>
                  <a:pt x="1427" y="1299"/>
                  <a:pt x="1424" y="1308"/>
                </a:cubicBezTo>
                <a:cubicBezTo>
                  <a:pt x="1422" y="1316"/>
                  <a:pt x="1419" y="1323"/>
                  <a:pt x="1418" y="1329"/>
                </a:cubicBezTo>
                <a:cubicBezTo>
                  <a:pt x="1416" y="1335"/>
                  <a:pt x="1415" y="1339"/>
                  <a:pt x="1413" y="1341"/>
                </a:cubicBezTo>
                <a:cubicBezTo>
                  <a:pt x="1412" y="1342"/>
                  <a:pt x="1410" y="1343"/>
                  <a:pt x="1409" y="1343"/>
                </a:cubicBezTo>
                <a:cubicBezTo>
                  <a:pt x="1407" y="1343"/>
                  <a:pt x="1405" y="1343"/>
                  <a:pt x="1403" y="1343"/>
                </a:cubicBezTo>
                <a:cubicBezTo>
                  <a:pt x="1402" y="1342"/>
                  <a:pt x="1400" y="1341"/>
                  <a:pt x="1397" y="1339"/>
                </a:cubicBezTo>
                <a:cubicBezTo>
                  <a:pt x="1395" y="1338"/>
                  <a:pt x="1393" y="1336"/>
                  <a:pt x="1391" y="1334"/>
                </a:cubicBezTo>
                <a:cubicBezTo>
                  <a:pt x="1387" y="1330"/>
                  <a:pt x="1384" y="1326"/>
                  <a:pt x="1382" y="1324"/>
                </a:cubicBezTo>
                <a:cubicBezTo>
                  <a:pt x="1381" y="1321"/>
                  <a:pt x="1380" y="1318"/>
                  <a:pt x="1380" y="1313"/>
                </a:cubicBezTo>
                <a:cubicBezTo>
                  <a:pt x="1380" y="1309"/>
                  <a:pt x="1381" y="1304"/>
                  <a:pt x="1384" y="1296"/>
                </a:cubicBezTo>
                <a:cubicBezTo>
                  <a:pt x="1386" y="1288"/>
                  <a:pt x="1389" y="1280"/>
                  <a:pt x="1394" y="1271"/>
                </a:cubicBezTo>
                <a:cubicBezTo>
                  <a:pt x="1398" y="1262"/>
                  <a:pt x="1403" y="1253"/>
                  <a:pt x="1410" y="1244"/>
                </a:cubicBezTo>
                <a:cubicBezTo>
                  <a:pt x="1416" y="1235"/>
                  <a:pt x="1423" y="1226"/>
                  <a:pt x="1431" y="1218"/>
                </a:cubicBezTo>
                <a:cubicBezTo>
                  <a:pt x="1446" y="1203"/>
                  <a:pt x="1460" y="1192"/>
                  <a:pt x="1474" y="1185"/>
                </a:cubicBezTo>
                <a:cubicBezTo>
                  <a:pt x="1488" y="1178"/>
                  <a:pt x="1501" y="1175"/>
                  <a:pt x="1514" y="1175"/>
                </a:cubicBezTo>
                <a:cubicBezTo>
                  <a:pt x="1527" y="1175"/>
                  <a:pt x="1540" y="1178"/>
                  <a:pt x="1552" y="1185"/>
                </a:cubicBezTo>
                <a:cubicBezTo>
                  <a:pt x="1565" y="1192"/>
                  <a:pt x="1577" y="1202"/>
                  <a:pt x="1590" y="1215"/>
                </a:cubicBezTo>
                <a:lnTo>
                  <a:pt x="1729" y="1354"/>
                </a:lnTo>
                <a:close/>
                <a:moveTo>
                  <a:pt x="1598" y="1297"/>
                </a:moveTo>
                <a:lnTo>
                  <a:pt x="1565" y="1329"/>
                </a:lnTo>
                <a:cubicBezTo>
                  <a:pt x="1555" y="1340"/>
                  <a:pt x="1547" y="1350"/>
                  <a:pt x="1541" y="1359"/>
                </a:cubicBezTo>
                <a:cubicBezTo>
                  <a:pt x="1535" y="1369"/>
                  <a:pt x="1531" y="1377"/>
                  <a:pt x="1530" y="1386"/>
                </a:cubicBezTo>
                <a:cubicBezTo>
                  <a:pt x="1528" y="1394"/>
                  <a:pt x="1528" y="1402"/>
                  <a:pt x="1531" y="1409"/>
                </a:cubicBezTo>
                <a:cubicBezTo>
                  <a:pt x="1533" y="1417"/>
                  <a:pt x="1538" y="1423"/>
                  <a:pt x="1544" y="1430"/>
                </a:cubicBezTo>
                <a:cubicBezTo>
                  <a:pt x="1555" y="1440"/>
                  <a:pt x="1567" y="1445"/>
                  <a:pt x="1580" y="1445"/>
                </a:cubicBezTo>
                <a:cubicBezTo>
                  <a:pt x="1593" y="1445"/>
                  <a:pt x="1606" y="1438"/>
                  <a:pt x="1618" y="1426"/>
                </a:cubicBezTo>
                <a:cubicBezTo>
                  <a:pt x="1628" y="1416"/>
                  <a:pt x="1634" y="1404"/>
                  <a:pt x="1638" y="1391"/>
                </a:cubicBezTo>
                <a:cubicBezTo>
                  <a:pt x="1641" y="1377"/>
                  <a:pt x="1642" y="1361"/>
                  <a:pt x="1641" y="1341"/>
                </a:cubicBezTo>
                <a:lnTo>
                  <a:pt x="1598" y="1297"/>
                </a:lnTo>
                <a:close/>
                <a:moveTo>
                  <a:pt x="1838" y="1245"/>
                </a:moveTo>
                <a:cubicBezTo>
                  <a:pt x="1839" y="1246"/>
                  <a:pt x="1840" y="1247"/>
                  <a:pt x="1840" y="1249"/>
                </a:cubicBezTo>
                <a:cubicBezTo>
                  <a:pt x="1840" y="1250"/>
                  <a:pt x="1840" y="1252"/>
                  <a:pt x="1839" y="1254"/>
                </a:cubicBezTo>
                <a:cubicBezTo>
                  <a:pt x="1838" y="1256"/>
                  <a:pt x="1837" y="1258"/>
                  <a:pt x="1835" y="1261"/>
                </a:cubicBezTo>
                <a:cubicBezTo>
                  <a:pt x="1833" y="1264"/>
                  <a:pt x="1830" y="1267"/>
                  <a:pt x="1826" y="1271"/>
                </a:cubicBezTo>
                <a:cubicBezTo>
                  <a:pt x="1822" y="1275"/>
                  <a:pt x="1819" y="1278"/>
                  <a:pt x="1816" y="1280"/>
                </a:cubicBezTo>
                <a:cubicBezTo>
                  <a:pt x="1814" y="1282"/>
                  <a:pt x="1811" y="1283"/>
                  <a:pt x="1809" y="1284"/>
                </a:cubicBezTo>
                <a:cubicBezTo>
                  <a:pt x="1807" y="1285"/>
                  <a:pt x="1805" y="1285"/>
                  <a:pt x="1804" y="1285"/>
                </a:cubicBezTo>
                <a:cubicBezTo>
                  <a:pt x="1803" y="1285"/>
                  <a:pt x="1801" y="1284"/>
                  <a:pt x="1800" y="1283"/>
                </a:cubicBezTo>
                <a:lnTo>
                  <a:pt x="1494" y="976"/>
                </a:lnTo>
                <a:cubicBezTo>
                  <a:pt x="1492" y="975"/>
                  <a:pt x="1492" y="974"/>
                  <a:pt x="1491" y="972"/>
                </a:cubicBezTo>
                <a:cubicBezTo>
                  <a:pt x="1491" y="971"/>
                  <a:pt x="1491" y="969"/>
                  <a:pt x="1492" y="967"/>
                </a:cubicBezTo>
                <a:cubicBezTo>
                  <a:pt x="1493" y="965"/>
                  <a:pt x="1494" y="963"/>
                  <a:pt x="1496" y="960"/>
                </a:cubicBezTo>
                <a:cubicBezTo>
                  <a:pt x="1499" y="957"/>
                  <a:pt x="1502" y="954"/>
                  <a:pt x="1505" y="950"/>
                </a:cubicBezTo>
                <a:cubicBezTo>
                  <a:pt x="1509" y="946"/>
                  <a:pt x="1512" y="943"/>
                  <a:pt x="1515" y="941"/>
                </a:cubicBezTo>
                <a:cubicBezTo>
                  <a:pt x="1518" y="939"/>
                  <a:pt x="1520" y="938"/>
                  <a:pt x="1522" y="937"/>
                </a:cubicBezTo>
                <a:cubicBezTo>
                  <a:pt x="1524" y="936"/>
                  <a:pt x="1526" y="936"/>
                  <a:pt x="1527" y="936"/>
                </a:cubicBezTo>
                <a:cubicBezTo>
                  <a:pt x="1529" y="937"/>
                  <a:pt x="1530" y="937"/>
                  <a:pt x="1532" y="939"/>
                </a:cubicBezTo>
                <a:lnTo>
                  <a:pt x="1838" y="1245"/>
                </a:lnTo>
                <a:close/>
                <a:moveTo>
                  <a:pt x="2063" y="1020"/>
                </a:moveTo>
                <a:cubicBezTo>
                  <a:pt x="2065" y="1022"/>
                  <a:pt x="2066" y="1024"/>
                  <a:pt x="2065" y="1026"/>
                </a:cubicBezTo>
                <a:cubicBezTo>
                  <a:pt x="2065" y="1028"/>
                  <a:pt x="2064" y="1030"/>
                  <a:pt x="2062" y="1033"/>
                </a:cubicBezTo>
                <a:cubicBezTo>
                  <a:pt x="2061" y="1036"/>
                  <a:pt x="2058" y="1039"/>
                  <a:pt x="2054" y="1043"/>
                </a:cubicBezTo>
                <a:cubicBezTo>
                  <a:pt x="2050" y="1047"/>
                  <a:pt x="2046" y="1050"/>
                  <a:pt x="2044" y="1052"/>
                </a:cubicBezTo>
                <a:cubicBezTo>
                  <a:pt x="2041" y="1054"/>
                  <a:pt x="2038" y="1055"/>
                  <a:pt x="2036" y="1055"/>
                </a:cubicBezTo>
                <a:cubicBezTo>
                  <a:pt x="2034" y="1055"/>
                  <a:pt x="2032" y="1054"/>
                  <a:pt x="2031" y="1053"/>
                </a:cubicBezTo>
                <a:lnTo>
                  <a:pt x="2010" y="1032"/>
                </a:lnTo>
                <a:cubicBezTo>
                  <a:pt x="2011" y="1051"/>
                  <a:pt x="2008" y="1068"/>
                  <a:pt x="2002" y="1085"/>
                </a:cubicBezTo>
                <a:cubicBezTo>
                  <a:pt x="1997" y="1101"/>
                  <a:pt x="1987" y="1115"/>
                  <a:pt x="1975" y="1128"/>
                </a:cubicBezTo>
                <a:cubicBezTo>
                  <a:pt x="1964" y="1139"/>
                  <a:pt x="1953" y="1147"/>
                  <a:pt x="1941" y="1153"/>
                </a:cubicBezTo>
                <a:cubicBezTo>
                  <a:pt x="1930" y="1159"/>
                  <a:pt x="1918" y="1162"/>
                  <a:pt x="1907" y="1163"/>
                </a:cubicBezTo>
                <a:cubicBezTo>
                  <a:pt x="1895" y="1164"/>
                  <a:pt x="1884" y="1162"/>
                  <a:pt x="1873" y="1158"/>
                </a:cubicBezTo>
                <a:cubicBezTo>
                  <a:pt x="1861" y="1154"/>
                  <a:pt x="1851" y="1146"/>
                  <a:pt x="1841" y="1136"/>
                </a:cubicBezTo>
                <a:cubicBezTo>
                  <a:pt x="1829" y="1125"/>
                  <a:pt x="1821" y="1112"/>
                  <a:pt x="1818" y="1099"/>
                </a:cubicBezTo>
                <a:cubicBezTo>
                  <a:pt x="1814" y="1086"/>
                  <a:pt x="1813" y="1072"/>
                  <a:pt x="1817" y="1057"/>
                </a:cubicBezTo>
                <a:cubicBezTo>
                  <a:pt x="1820" y="1043"/>
                  <a:pt x="1827" y="1028"/>
                  <a:pt x="1837" y="1012"/>
                </a:cubicBezTo>
                <a:cubicBezTo>
                  <a:pt x="1847" y="996"/>
                  <a:pt x="1860" y="981"/>
                  <a:pt x="1876" y="964"/>
                </a:cubicBezTo>
                <a:lnTo>
                  <a:pt x="1904" y="936"/>
                </a:lnTo>
                <a:lnTo>
                  <a:pt x="1888" y="920"/>
                </a:lnTo>
                <a:cubicBezTo>
                  <a:pt x="1880" y="912"/>
                  <a:pt x="1872" y="906"/>
                  <a:pt x="1864" y="901"/>
                </a:cubicBezTo>
                <a:cubicBezTo>
                  <a:pt x="1857" y="897"/>
                  <a:pt x="1849" y="895"/>
                  <a:pt x="1841" y="894"/>
                </a:cubicBezTo>
                <a:cubicBezTo>
                  <a:pt x="1833" y="894"/>
                  <a:pt x="1825" y="896"/>
                  <a:pt x="1817" y="900"/>
                </a:cubicBezTo>
                <a:cubicBezTo>
                  <a:pt x="1809" y="904"/>
                  <a:pt x="1801" y="910"/>
                  <a:pt x="1792" y="919"/>
                </a:cubicBezTo>
                <a:cubicBezTo>
                  <a:pt x="1783" y="928"/>
                  <a:pt x="1776" y="937"/>
                  <a:pt x="1770" y="947"/>
                </a:cubicBezTo>
                <a:cubicBezTo>
                  <a:pt x="1765" y="957"/>
                  <a:pt x="1761" y="966"/>
                  <a:pt x="1758" y="974"/>
                </a:cubicBezTo>
                <a:cubicBezTo>
                  <a:pt x="1755" y="982"/>
                  <a:pt x="1753" y="989"/>
                  <a:pt x="1752" y="995"/>
                </a:cubicBezTo>
                <a:cubicBezTo>
                  <a:pt x="1750" y="1001"/>
                  <a:pt x="1748" y="1005"/>
                  <a:pt x="1747" y="1007"/>
                </a:cubicBezTo>
                <a:cubicBezTo>
                  <a:pt x="1745" y="1008"/>
                  <a:pt x="1744" y="1009"/>
                  <a:pt x="1742" y="1009"/>
                </a:cubicBezTo>
                <a:cubicBezTo>
                  <a:pt x="1741" y="1010"/>
                  <a:pt x="1739" y="1009"/>
                  <a:pt x="1737" y="1009"/>
                </a:cubicBezTo>
                <a:cubicBezTo>
                  <a:pt x="1735" y="1008"/>
                  <a:pt x="1733" y="1007"/>
                  <a:pt x="1731" y="1006"/>
                </a:cubicBezTo>
                <a:cubicBezTo>
                  <a:pt x="1729" y="1004"/>
                  <a:pt x="1727" y="1002"/>
                  <a:pt x="1724" y="1000"/>
                </a:cubicBezTo>
                <a:cubicBezTo>
                  <a:pt x="1720" y="996"/>
                  <a:pt x="1718" y="993"/>
                  <a:pt x="1716" y="990"/>
                </a:cubicBezTo>
                <a:cubicBezTo>
                  <a:pt x="1714" y="987"/>
                  <a:pt x="1714" y="984"/>
                  <a:pt x="1714" y="980"/>
                </a:cubicBezTo>
                <a:cubicBezTo>
                  <a:pt x="1714" y="976"/>
                  <a:pt x="1715" y="970"/>
                  <a:pt x="1717" y="962"/>
                </a:cubicBezTo>
                <a:cubicBezTo>
                  <a:pt x="1720" y="954"/>
                  <a:pt x="1723" y="946"/>
                  <a:pt x="1727" y="937"/>
                </a:cubicBezTo>
                <a:cubicBezTo>
                  <a:pt x="1732" y="929"/>
                  <a:pt x="1737" y="920"/>
                  <a:pt x="1743" y="910"/>
                </a:cubicBezTo>
                <a:cubicBezTo>
                  <a:pt x="1750" y="901"/>
                  <a:pt x="1757" y="892"/>
                  <a:pt x="1765" y="884"/>
                </a:cubicBezTo>
                <a:cubicBezTo>
                  <a:pt x="1780" y="870"/>
                  <a:pt x="1794" y="859"/>
                  <a:pt x="1808" y="852"/>
                </a:cubicBezTo>
                <a:cubicBezTo>
                  <a:pt x="1822" y="845"/>
                  <a:pt x="1835" y="841"/>
                  <a:pt x="1848" y="841"/>
                </a:cubicBezTo>
                <a:cubicBezTo>
                  <a:pt x="1861" y="841"/>
                  <a:pt x="1873" y="845"/>
                  <a:pt x="1886" y="851"/>
                </a:cubicBezTo>
                <a:cubicBezTo>
                  <a:pt x="1898" y="858"/>
                  <a:pt x="1911" y="868"/>
                  <a:pt x="1924" y="881"/>
                </a:cubicBezTo>
                <a:lnTo>
                  <a:pt x="2063" y="1020"/>
                </a:lnTo>
                <a:close/>
                <a:moveTo>
                  <a:pt x="1931" y="963"/>
                </a:moveTo>
                <a:lnTo>
                  <a:pt x="1899" y="996"/>
                </a:lnTo>
                <a:cubicBezTo>
                  <a:pt x="1889" y="1006"/>
                  <a:pt x="1880" y="1016"/>
                  <a:pt x="1875" y="1025"/>
                </a:cubicBezTo>
                <a:cubicBezTo>
                  <a:pt x="1869" y="1035"/>
                  <a:pt x="1865" y="1044"/>
                  <a:pt x="1863" y="1052"/>
                </a:cubicBezTo>
                <a:cubicBezTo>
                  <a:pt x="1862" y="1061"/>
                  <a:pt x="1862" y="1069"/>
                  <a:pt x="1865" y="1076"/>
                </a:cubicBezTo>
                <a:cubicBezTo>
                  <a:pt x="1867" y="1083"/>
                  <a:pt x="1871" y="1090"/>
                  <a:pt x="1878" y="1096"/>
                </a:cubicBezTo>
                <a:cubicBezTo>
                  <a:pt x="1888" y="1107"/>
                  <a:pt x="1900" y="1112"/>
                  <a:pt x="1913" y="1111"/>
                </a:cubicBezTo>
                <a:cubicBezTo>
                  <a:pt x="1927" y="1111"/>
                  <a:pt x="1939" y="1104"/>
                  <a:pt x="1951" y="1092"/>
                </a:cubicBezTo>
                <a:cubicBezTo>
                  <a:pt x="1961" y="1082"/>
                  <a:pt x="1968" y="1071"/>
                  <a:pt x="1972" y="1057"/>
                </a:cubicBezTo>
                <a:cubicBezTo>
                  <a:pt x="1975" y="1043"/>
                  <a:pt x="1976" y="1027"/>
                  <a:pt x="1975" y="1007"/>
                </a:cubicBezTo>
                <a:lnTo>
                  <a:pt x="1931" y="963"/>
                </a:lnTo>
                <a:close/>
                <a:moveTo>
                  <a:pt x="2311" y="771"/>
                </a:moveTo>
                <a:cubicBezTo>
                  <a:pt x="2313" y="772"/>
                  <a:pt x="2313" y="774"/>
                  <a:pt x="2314" y="775"/>
                </a:cubicBezTo>
                <a:cubicBezTo>
                  <a:pt x="2314" y="777"/>
                  <a:pt x="2314" y="778"/>
                  <a:pt x="2313" y="780"/>
                </a:cubicBezTo>
                <a:cubicBezTo>
                  <a:pt x="2312" y="782"/>
                  <a:pt x="2311" y="785"/>
                  <a:pt x="2308" y="788"/>
                </a:cubicBezTo>
                <a:cubicBezTo>
                  <a:pt x="2306" y="790"/>
                  <a:pt x="2303" y="793"/>
                  <a:pt x="2300" y="797"/>
                </a:cubicBezTo>
                <a:cubicBezTo>
                  <a:pt x="2296" y="801"/>
                  <a:pt x="2293" y="804"/>
                  <a:pt x="2290" y="806"/>
                </a:cubicBezTo>
                <a:cubicBezTo>
                  <a:pt x="2287" y="808"/>
                  <a:pt x="2285" y="810"/>
                  <a:pt x="2283" y="810"/>
                </a:cubicBezTo>
                <a:cubicBezTo>
                  <a:pt x="2281" y="811"/>
                  <a:pt x="2279" y="811"/>
                  <a:pt x="2278" y="811"/>
                </a:cubicBezTo>
                <a:cubicBezTo>
                  <a:pt x="2276" y="811"/>
                  <a:pt x="2275" y="810"/>
                  <a:pt x="2274" y="809"/>
                </a:cubicBezTo>
                <a:lnTo>
                  <a:pt x="2153" y="688"/>
                </a:lnTo>
                <a:cubicBezTo>
                  <a:pt x="2141" y="676"/>
                  <a:pt x="2131" y="668"/>
                  <a:pt x="2122" y="663"/>
                </a:cubicBezTo>
                <a:cubicBezTo>
                  <a:pt x="2113" y="657"/>
                  <a:pt x="2104" y="654"/>
                  <a:pt x="2095" y="652"/>
                </a:cubicBezTo>
                <a:cubicBezTo>
                  <a:pt x="2086" y="650"/>
                  <a:pt x="2078" y="651"/>
                  <a:pt x="2069" y="654"/>
                </a:cubicBezTo>
                <a:cubicBezTo>
                  <a:pt x="2061" y="657"/>
                  <a:pt x="2053" y="662"/>
                  <a:pt x="2046" y="669"/>
                </a:cubicBezTo>
                <a:cubicBezTo>
                  <a:pt x="2036" y="678"/>
                  <a:pt x="2030" y="691"/>
                  <a:pt x="2028" y="707"/>
                </a:cubicBezTo>
                <a:cubicBezTo>
                  <a:pt x="2025" y="724"/>
                  <a:pt x="2025" y="743"/>
                  <a:pt x="2027" y="767"/>
                </a:cubicBezTo>
                <a:lnTo>
                  <a:pt x="2172" y="911"/>
                </a:lnTo>
                <a:cubicBezTo>
                  <a:pt x="2173" y="912"/>
                  <a:pt x="2174" y="914"/>
                  <a:pt x="2174" y="915"/>
                </a:cubicBezTo>
                <a:cubicBezTo>
                  <a:pt x="2174" y="917"/>
                  <a:pt x="2174" y="918"/>
                  <a:pt x="2173" y="920"/>
                </a:cubicBezTo>
                <a:cubicBezTo>
                  <a:pt x="2172" y="922"/>
                  <a:pt x="2171" y="925"/>
                  <a:pt x="2169" y="927"/>
                </a:cubicBezTo>
                <a:cubicBezTo>
                  <a:pt x="2166" y="930"/>
                  <a:pt x="2163" y="933"/>
                  <a:pt x="2160" y="937"/>
                </a:cubicBezTo>
                <a:cubicBezTo>
                  <a:pt x="2156" y="941"/>
                  <a:pt x="2153" y="944"/>
                  <a:pt x="2150" y="946"/>
                </a:cubicBezTo>
                <a:cubicBezTo>
                  <a:pt x="2147" y="948"/>
                  <a:pt x="2145" y="950"/>
                  <a:pt x="2143" y="950"/>
                </a:cubicBezTo>
                <a:cubicBezTo>
                  <a:pt x="2141" y="951"/>
                  <a:pt x="2139" y="952"/>
                  <a:pt x="2138" y="951"/>
                </a:cubicBezTo>
                <a:cubicBezTo>
                  <a:pt x="2136" y="951"/>
                  <a:pt x="2135" y="950"/>
                  <a:pt x="2134" y="949"/>
                </a:cubicBezTo>
                <a:lnTo>
                  <a:pt x="1927" y="743"/>
                </a:lnTo>
                <a:cubicBezTo>
                  <a:pt x="1926" y="741"/>
                  <a:pt x="1925" y="740"/>
                  <a:pt x="1925" y="739"/>
                </a:cubicBezTo>
                <a:cubicBezTo>
                  <a:pt x="1925" y="737"/>
                  <a:pt x="1925" y="736"/>
                  <a:pt x="1925" y="734"/>
                </a:cubicBezTo>
                <a:cubicBezTo>
                  <a:pt x="1926" y="732"/>
                  <a:pt x="1927" y="729"/>
                  <a:pt x="1929" y="727"/>
                </a:cubicBezTo>
                <a:cubicBezTo>
                  <a:pt x="1931" y="725"/>
                  <a:pt x="1934" y="722"/>
                  <a:pt x="1938" y="718"/>
                </a:cubicBezTo>
                <a:cubicBezTo>
                  <a:pt x="1941" y="715"/>
                  <a:pt x="1944" y="712"/>
                  <a:pt x="1946" y="710"/>
                </a:cubicBezTo>
                <a:cubicBezTo>
                  <a:pt x="1949" y="708"/>
                  <a:pt x="1951" y="707"/>
                  <a:pt x="1953" y="706"/>
                </a:cubicBezTo>
                <a:cubicBezTo>
                  <a:pt x="1955" y="706"/>
                  <a:pt x="1956" y="706"/>
                  <a:pt x="1958" y="706"/>
                </a:cubicBezTo>
                <a:cubicBezTo>
                  <a:pt x="1959" y="706"/>
                  <a:pt x="1960" y="707"/>
                  <a:pt x="1962" y="708"/>
                </a:cubicBezTo>
                <a:lnTo>
                  <a:pt x="1989" y="736"/>
                </a:lnTo>
                <a:cubicBezTo>
                  <a:pt x="1987" y="711"/>
                  <a:pt x="1990" y="690"/>
                  <a:pt x="1995" y="672"/>
                </a:cubicBezTo>
                <a:cubicBezTo>
                  <a:pt x="2001" y="655"/>
                  <a:pt x="2009" y="640"/>
                  <a:pt x="2021" y="628"/>
                </a:cubicBezTo>
                <a:cubicBezTo>
                  <a:pt x="2035" y="615"/>
                  <a:pt x="2049" y="605"/>
                  <a:pt x="2063" y="601"/>
                </a:cubicBezTo>
                <a:cubicBezTo>
                  <a:pt x="2077" y="596"/>
                  <a:pt x="2091" y="595"/>
                  <a:pt x="2104" y="597"/>
                </a:cubicBezTo>
                <a:cubicBezTo>
                  <a:pt x="2118" y="599"/>
                  <a:pt x="2131" y="603"/>
                  <a:pt x="2144" y="611"/>
                </a:cubicBezTo>
                <a:cubicBezTo>
                  <a:pt x="2157" y="619"/>
                  <a:pt x="2171" y="631"/>
                  <a:pt x="2186" y="645"/>
                </a:cubicBezTo>
                <a:lnTo>
                  <a:pt x="2311" y="771"/>
                </a:lnTo>
                <a:close/>
                <a:moveTo>
                  <a:pt x="2420" y="662"/>
                </a:moveTo>
                <a:cubicBezTo>
                  <a:pt x="2422" y="663"/>
                  <a:pt x="2422" y="665"/>
                  <a:pt x="2423" y="666"/>
                </a:cubicBezTo>
                <a:cubicBezTo>
                  <a:pt x="2423" y="668"/>
                  <a:pt x="2423" y="669"/>
                  <a:pt x="2422" y="671"/>
                </a:cubicBezTo>
                <a:cubicBezTo>
                  <a:pt x="2421" y="673"/>
                  <a:pt x="2420" y="676"/>
                  <a:pt x="2417" y="678"/>
                </a:cubicBezTo>
                <a:cubicBezTo>
                  <a:pt x="2415" y="681"/>
                  <a:pt x="2412" y="684"/>
                  <a:pt x="2409" y="688"/>
                </a:cubicBezTo>
                <a:cubicBezTo>
                  <a:pt x="2405" y="692"/>
                  <a:pt x="2402" y="695"/>
                  <a:pt x="2399" y="697"/>
                </a:cubicBezTo>
                <a:cubicBezTo>
                  <a:pt x="2396" y="699"/>
                  <a:pt x="2394" y="701"/>
                  <a:pt x="2392" y="701"/>
                </a:cubicBezTo>
                <a:cubicBezTo>
                  <a:pt x="2390" y="702"/>
                  <a:pt x="2388" y="703"/>
                  <a:pt x="2387" y="702"/>
                </a:cubicBezTo>
                <a:cubicBezTo>
                  <a:pt x="2385" y="702"/>
                  <a:pt x="2384" y="701"/>
                  <a:pt x="2383" y="700"/>
                </a:cubicBezTo>
                <a:lnTo>
                  <a:pt x="2176" y="494"/>
                </a:lnTo>
                <a:cubicBezTo>
                  <a:pt x="2175" y="493"/>
                  <a:pt x="2175" y="491"/>
                  <a:pt x="2174" y="490"/>
                </a:cubicBezTo>
                <a:cubicBezTo>
                  <a:pt x="2174" y="488"/>
                  <a:pt x="2174" y="487"/>
                  <a:pt x="2175" y="485"/>
                </a:cubicBezTo>
                <a:cubicBezTo>
                  <a:pt x="2176" y="483"/>
                  <a:pt x="2177" y="480"/>
                  <a:pt x="2179" y="477"/>
                </a:cubicBezTo>
                <a:cubicBezTo>
                  <a:pt x="2181" y="475"/>
                  <a:pt x="2184" y="471"/>
                  <a:pt x="2188" y="468"/>
                </a:cubicBezTo>
                <a:cubicBezTo>
                  <a:pt x="2192" y="464"/>
                  <a:pt x="2195" y="461"/>
                  <a:pt x="2198" y="459"/>
                </a:cubicBezTo>
                <a:cubicBezTo>
                  <a:pt x="2201" y="457"/>
                  <a:pt x="2203" y="455"/>
                  <a:pt x="2205" y="454"/>
                </a:cubicBezTo>
                <a:cubicBezTo>
                  <a:pt x="2207" y="454"/>
                  <a:pt x="2209" y="453"/>
                  <a:pt x="2210" y="454"/>
                </a:cubicBezTo>
                <a:cubicBezTo>
                  <a:pt x="2212" y="454"/>
                  <a:pt x="2213" y="455"/>
                  <a:pt x="2214" y="456"/>
                </a:cubicBezTo>
                <a:lnTo>
                  <a:pt x="2420" y="662"/>
                </a:lnTo>
                <a:close/>
                <a:moveTo>
                  <a:pt x="2149" y="382"/>
                </a:moveTo>
                <a:cubicBezTo>
                  <a:pt x="2158" y="391"/>
                  <a:pt x="2162" y="398"/>
                  <a:pt x="2162" y="405"/>
                </a:cubicBezTo>
                <a:cubicBezTo>
                  <a:pt x="2162" y="412"/>
                  <a:pt x="2157" y="419"/>
                  <a:pt x="2148" y="428"/>
                </a:cubicBezTo>
                <a:cubicBezTo>
                  <a:pt x="2139" y="437"/>
                  <a:pt x="2132" y="442"/>
                  <a:pt x="2125" y="442"/>
                </a:cubicBezTo>
                <a:cubicBezTo>
                  <a:pt x="2119" y="442"/>
                  <a:pt x="2111" y="438"/>
                  <a:pt x="2103" y="429"/>
                </a:cubicBezTo>
                <a:cubicBezTo>
                  <a:pt x="2094" y="420"/>
                  <a:pt x="2089" y="412"/>
                  <a:pt x="2089" y="406"/>
                </a:cubicBezTo>
                <a:cubicBezTo>
                  <a:pt x="2090" y="399"/>
                  <a:pt x="2094" y="392"/>
                  <a:pt x="2103" y="382"/>
                </a:cubicBezTo>
                <a:cubicBezTo>
                  <a:pt x="2112" y="374"/>
                  <a:pt x="2120" y="369"/>
                  <a:pt x="2126" y="369"/>
                </a:cubicBezTo>
                <a:cubicBezTo>
                  <a:pt x="2133" y="369"/>
                  <a:pt x="2140" y="373"/>
                  <a:pt x="2149" y="382"/>
                </a:cubicBezTo>
                <a:close/>
                <a:moveTo>
                  <a:pt x="2668" y="415"/>
                </a:moveTo>
                <a:cubicBezTo>
                  <a:pt x="2669" y="416"/>
                  <a:pt x="2670" y="417"/>
                  <a:pt x="2670" y="419"/>
                </a:cubicBezTo>
                <a:cubicBezTo>
                  <a:pt x="2670" y="420"/>
                  <a:pt x="2670" y="422"/>
                  <a:pt x="2669" y="424"/>
                </a:cubicBezTo>
                <a:cubicBezTo>
                  <a:pt x="2668" y="426"/>
                  <a:pt x="2667" y="428"/>
                  <a:pt x="2665" y="431"/>
                </a:cubicBezTo>
                <a:cubicBezTo>
                  <a:pt x="2663" y="434"/>
                  <a:pt x="2660" y="437"/>
                  <a:pt x="2656" y="441"/>
                </a:cubicBezTo>
                <a:cubicBezTo>
                  <a:pt x="2652" y="445"/>
                  <a:pt x="2649" y="448"/>
                  <a:pt x="2646" y="450"/>
                </a:cubicBezTo>
                <a:cubicBezTo>
                  <a:pt x="2644" y="452"/>
                  <a:pt x="2641" y="453"/>
                  <a:pt x="2639" y="454"/>
                </a:cubicBezTo>
                <a:cubicBezTo>
                  <a:pt x="2637" y="455"/>
                  <a:pt x="2635" y="455"/>
                  <a:pt x="2634" y="455"/>
                </a:cubicBezTo>
                <a:cubicBezTo>
                  <a:pt x="2633" y="455"/>
                  <a:pt x="2631" y="454"/>
                  <a:pt x="2630" y="453"/>
                </a:cubicBezTo>
                <a:lnTo>
                  <a:pt x="2509" y="332"/>
                </a:lnTo>
                <a:cubicBezTo>
                  <a:pt x="2497" y="320"/>
                  <a:pt x="2487" y="312"/>
                  <a:pt x="2478" y="306"/>
                </a:cubicBezTo>
                <a:cubicBezTo>
                  <a:pt x="2469" y="301"/>
                  <a:pt x="2460" y="297"/>
                  <a:pt x="2451" y="296"/>
                </a:cubicBezTo>
                <a:cubicBezTo>
                  <a:pt x="2443" y="294"/>
                  <a:pt x="2434" y="295"/>
                  <a:pt x="2426" y="297"/>
                </a:cubicBezTo>
                <a:cubicBezTo>
                  <a:pt x="2417" y="300"/>
                  <a:pt x="2410" y="305"/>
                  <a:pt x="2402" y="313"/>
                </a:cubicBezTo>
                <a:cubicBezTo>
                  <a:pt x="2393" y="322"/>
                  <a:pt x="2387" y="335"/>
                  <a:pt x="2384" y="351"/>
                </a:cubicBezTo>
                <a:cubicBezTo>
                  <a:pt x="2381" y="367"/>
                  <a:pt x="2381" y="387"/>
                  <a:pt x="2384" y="410"/>
                </a:cubicBezTo>
                <a:lnTo>
                  <a:pt x="2528" y="555"/>
                </a:lnTo>
                <a:cubicBezTo>
                  <a:pt x="2529" y="556"/>
                  <a:pt x="2530" y="557"/>
                  <a:pt x="2530" y="559"/>
                </a:cubicBezTo>
                <a:cubicBezTo>
                  <a:pt x="2530" y="560"/>
                  <a:pt x="2530" y="562"/>
                  <a:pt x="2529" y="564"/>
                </a:cubicBezTo>
                <a:cubicBezTo>
                  <a:pt x="2529" y="566"/>
                  <a:pt x="2527" y="568"/>
                  <a:pt x="2525" y="571"/>
                </a:cubicBezTo>
                <a:cubicBezTo>
                  <a:pt x="2523" y="574"/>
                  <a:pt x="2520" y="577"/>
                  <a:pt x="2516" y="581"/>
                </a:cubicBezTo>
                <a:cubicBezTo>
                  <a:pt x="2512" y="585"/>
                  <a:pt x="2509" y="587"/>
                  <a:pt x="2506" y="590"/>
                </a:cubicBezTo>
                <a:cubicBezTo>
                  <a:pt x="2504" y="592"/>
                  <a:pt x="2501" y="593"/>
                  <a:pt x="2499" y="594"/>
                </a:cubicBezTo>
                <a:cubicBezTo>
                  <a:pt x="2497" y="595"/>
                  <a:pt x="2495" y="595"/>
                  <a:pt x="2494" y="595"/>
                </a:cubicBezTo>
                <a:cubicBezTo>
                  <a:pt x="2493" y="595"/>
                  <a:pt x="2491" y="594"/>
                  <a:pt x="2490" y="593"/>
                </a:cubicBezTo>
                <a:lnTo>
                  <a:pt x="2284" y="386"/>
                </a:lnTo>
                <a:cubicBezTo>
                  <a:pt x="2283" y="385"/>
                  <a:pt x="2282" y="384"/>
                  <a:pt x="2281" y="382"/>
                </a:cubicBezTo>
                <a:cubicBezTo>
                  <a:pt x="2281" y="381"/>
                  <a:pt x="2281" y="379"/>
                  <a:pt x="2282" y="377"/>
                </a:cubicBezTo>
                <a:cubicBezTo>
                  <a:pt x="2283" y="375"/>
                  <a:pt x="2284" y="373"/>
                  <a:pt x="2286" y="371"/>
                </a:cubicBezTo>
                <a:cubicBezTo>
                  <a:pt x="2288" y="368"/>
                  <a:pt x="2290" y="365"/>
                  <a:pt x="2294" y="362"/>
                </a:cubicBezTo>
                <a:cubicBezTo>
                  <a:pt x="2297" y="359"/>
                  <a:pt x="2300" y="356"/>
                  <a:pt x="2303" y="354"/>
                </a:cubicBezTo>
                <a:cubicBezTo>
                  <a:pt x="2305" y="352"/>
                  <a:pt x="2307" y="351"/>
                  <a:pt x="2309" y="350"/>
                </a:cubicBezTo>
                <a:cubicBezTo>
                  <a:pt x="2311" y="350"/>
                  <a:pt x="2313" y="349"/>
                  <a:pt x="2314" y="350"/>
                </a:cubicBezTo>
                <a:cubicBezTo>
                  <a:pt x="2315" y="350"/>
                  <a:pt x="2317" y="351"/>
                  <a:pt x="2318" y="352"/>
                </a:cubicBezTo>
                <a:lnTo>
                  <a:pt x="2345" y="379"/>
                </a:lnTo>
                <a:cubicBezTo>
                  <a:pt x="2344" y="355"/>
                  <a:pt x="2346" y="334"/>
                  <a:pt x="2351" y="316"/>
                </a:cubicBezTo>
                <a:cubicBezTo>
                  <a:pt x="2357" y="298"/>
                  <a:pt x="2366" y="284"/>
                  <a:pt x="2377" y="272"/>
                </a:cubicBezTo>
                <a:cubicBezTo>
                  <a:pt x="2391" y="258"/>
                  <a:pt x="2405" y="249"/>
                  <a:pt x="2419" y="244"/>
                </a:cubicBezTo>
                <a:cubicBezTo>
                  <a:pt x="2433" y="240"/>
                  <a:pt x="2447" y="238"/>
                  <a:pt x="2461" y="240"/>
                </a:cubicBezTo>
                <a:cubicBezTo>
                  <a:pt x="2474" y="242"/>
                  <a:pt x="2487" y="247"/>
                  <a:pt x="2500" y="255"/>
                </a:cubicBezTo>
                <a:cubicBezTo>
                  <a:pt x="2513" y="263"/>
                  <a:pt x="2527" y="274"/>
                  <a:pt x="2542" y="289"/>
                </a:cubicBezTo>
                <a:lnTo>
                  <a:pt x="2668" y="415"/>
                </a:lnTo>
                <a:close/>
                <a:moveTo>
                  <a:pt x="2803" y="55"/>
                </a:moveTo>
                <a:cubicBezTo>
                  <a:pt x="2809" y="61"/>
                  <a:pt x="2812" y="67"/>
                  <a:pt x="2811" y="73"/>
                </a:cubicBezTo>
                <a:cubicBezTo>
                  <a:pt x="2811" y="78"/>
                  <a:pt x="2809" y="83"/>
                  <a:pt x="2805" y="87"/>
                </a:cubicBezTo>
                <a:lnTo>
                  <a:pt x="2669" y="223"/>
                </a:lnTo>
                <a:cubicBezTo>
                  <a:pt x="2680" y="234"/>
                  <a:pt x="2692" y="243"/>
                  <a:pt x="2703" y="250"/>
                </a:cubicBezTo>
                <a:cubicBezTo>
                  <a:pt x="2715" y="257"/>
                  <a:pt x="2726" y="261"/>
                  <a:pt x="2738" y="262"/>
                </a:cubicBezTo>
                <a:cubicBezTo>
                  <a:pt x="2750" y="263"/>
                  <a:pt x="2762" y="261"/>
                  <a:pt x="2775" y="256"/>
                </a:cubicBezTo>
                <a:cubicBezTo>
                  <a:pt x="2787" y="251"/>
                  <a:pt x="2799" y="242"/>
                  <a:pt x="2811" y="230"/>
                </a:cubicBezTo>
                <a:cubicBezTo>
                  <a:pt x="2821" y="220"/>
                  <a:pt x="2829" y="211"/>
                  <a:pt x="2835" y="201"/>
                </a:cubicBezTo>
                <a:cubicBezTo>
                  <a:pt x="2841" y="192"/>
                  <a:pt x="2846" y="184"/>
                  <a:pt x="2850" y="176"/>
                </a:cubicBezTo>
                <a:cubicBezTo>
                  <a:pt x="2853" y="168"/>
                  <a:pt x="2856" y="162"/>
                  <a:pt x="2858" y="157"/>
                </a:cubicBezTo>
                <a:cubicBezTo>
                  <a:pt x="2860" y="152"/>
                  <a:pt x="2862" y="148"/>
                  <a:pt x="2864" y="146"/>
                </a:cubicBezTo>
                <a:cubicBezTo>
                  <a:pt x="2865" y="145"/>
                  <a:pt x="2866" y="144"/>
                  <a:pt x="2868" y="144"/>
                </a:cubicBezTo>
                <a:cubicBezTo>
                  <a:pt x="2869" y="144"/>
                  <a:pt x="2870" y="144"/>
                  <a:pt x="2872" y="145"/>
                </a:cubicBezTo>
                <a:cubicBezTo>
                  <a:pt x="2874" y="145"/>
                  <a:pt x="2875" y="146"/>
                  <a:pt x="2878" y="148"/>
                </a:cubicBezTo>
                <a:cubicBezTo>
                  <a:pt x="2880" y="150"/>
                  <a:pt x="2882" y="152"/>
                  <a:pt x="2885" y="155"/>
                </a:cubicBezTo>
                <a:cubicBezTo>
                  <a:pt x="2887" y="157"/>
                  <a:pt x="2888" y="158"/>
                  <a:pt x="2890" y="160"/>
                </a:cubicBezTo>
                <a:cubicBezTo>
                  <a:pt x="2891" y="162"/>
                  <a:pt x="2892" y="163"/>
                  <a:pt x="2893" y="165"/>
                </a:cubicBezTo>
                <a:cubicBezTo>
                  <a:pt x="2894" y="166"/>
                  <a:pt x="2895" y="167"/>
                  <a:pt x="2895" y="169"/>
                </a:cubicBezTo>
                <a:cubicBezTo>
                  <a:pt x="2895" y="170"/>
                  <a:pt x="2896" y="172"/>
                  <a:pt x="2896" y="174"/>
                </a:cubicBezTo>
                <a:cubicBezTo>
                  <a:pt x="2896" y="175"/>
                  <a:pt x="2895" y="179"/>
                  <a:pt x="2892" y="185"/>
                </a:cubicBezTo>
                <a:cubicBezTo>
                  <a:pt x="2890" y="191"/>
                  <a:pt x="2887" y="198"/>
                  <a:pt x="2882" y="207"/>
                </a:cubicBezTo>
                <a:cubicBezTo>
                  <a:pt x="2877" y="215"/>
                  <a:pt x="2871" y="224"/>
                  <a:pt x="2864" y="234"/>
                </a:cubicBezTo>
                <a:cubicBezTo>
                  <a:pt x="2857" y="245"/>
                  <a:pt x="2848" y="255"/>
                  <a:pt x="2839" y="264"/>
                </a:cubicBezTo>
                <a:cubicBezTo>
                  <a:pt x="2822" y="281"/>
                  <a:pt x="2804" y="294"/>
                  <a:pt x="2787" y="302"/>
                </a:cubicBezTo>
                <a:cubicBezTo>
                  <a:pt x="2769" y="310"/>
                  <a:pt x="2752" y="314"/>
                  <a:pt x="2734" y="313"/>
                </a:cubicBezTo>
                <a:cubicBezTo>
                  <a:pt x="2715" y="312"/>
                  <a:pt x="2697" y="307"/>
                  <a:pt x="2679" y="298"/>
                </a:cubicBezTo>
                <a:cubicBezTo>
                  <a:pt x="2660" y="288"/>
                  <a:pt x="2642" y="274"/>
                  <a:pt x="2623" y="255"/>
                </a:cubicBezTo>
                <a:cubicBezTo>
                  <a:pt x="2605" y="237"/>
                  <a:pt x="2592" y="219"/>
                  <a:pt x="2582" y="200"/>
                </a:cubicBezTo>
                <a:cubicBezTo>
                  <a:pt x="2573" y="182"/>
                  <a:pt x="2567" y="163"/>
                  <a:pt x="2566" y="145"/>
                </a:cubicBezTo>
                <a:cubicBezTo>
                  <a:pt x="2565" y="126"/>
                  <a:pt x="2568" y="108"/>
                  <a:pt x="2575" y="91"/>
                </a:cubicBezTo>
                <a:cubicBezTo>
                  <a:pt x="2581" y="73"/>
                  <a:pt x="2593" y="57"/>
                  <a:pt x="2608" y="42"/>
                </a:cubicBezTo>
                <a:cubicBezTo>
                  <a:pt x="2624" y="25"/>
                  <a:pt x="2640" y="14"/>
                  <a:pt x="2657" y="8"/>
                </a:cubicBezTo>
                <a:cubicBezTo>
                  <a:pt x="2673" y="2"/>
                  <a:pt x="2690" y="0"/>
                  <a:pt x="2706" y="1"/>
                </a:cubicBezTo>
                <a:cubicBezTo>
                  <a:pt x="2722" y="2"/>
                  <a:pt x="2738" y="7"/>
                  <a:pt x="2753" y="16"/>
                </a:cubicBezTo>
                <a:cubicBezTo>
                  <a:pt x="2768" y="24"/>
                  <a:pt x="2783" y="35"/>
                  <a:pt x="2796" y="49"/>
                </a:cubicBezTo>
                <a:lnTo>
                  <a:pt x="2803" y="55"/>
                </a:lnTo>
                <a:close/>
                <a:moveTo>
                  <a:pt x="2754" y="82"/>
                </a:moveTo>
                <a:cubicBezTo>
                  <a:pt x="2734" y="62"/>
                  <a:pt x="2714" y="51"/>
                  <a:pt x="2694" y="49"/>
                </a:cubicBezTo>
                <a:cubicBezTo>
                  <a:pt x="2673" y="47"/>
                  <a:pt x="2654" y="55"/>
                  <a:pt x="2635" y="73"/>
                </a:cubicBezTo>
                <a:cubicBezTo>
                  <a:pt x="2626" y="83"/>
                  <a:pt x="2619" y="93"/>
                  <a:pt x="2616" y="103"/>
                </a:cubicBezTo>
                <a:cubicBezTo>
                  <a:pt x="2612" y="114"/>
                  <a:pt x="2611" y="124"/>
                  <a:pt x="2612" y="135"/>
                </a:cubicBezTo>
                <a:cubicBezTo>
                  <a:pt x="2613" y="145"/>
                  <a:pt x="2616" y="156"/>
                  <a:pt x="2621" y="166"/>
                </a:cubicBezTo>
                <a:cubicBezTo>
                  <a:pt x="2626" y="177"/>
                  <a:pt x="2633" y="186"/>
                  <a:pt x="2641" y="195"/>
                </a:cubicBezTo>
                <a:lnTo>
                  <a:pt x="2754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4" name="Freeform 258"/>
          <p:cNvSpPr>
            <a:spLocks noEditPoints="1"/>
          </p:cNvSpPr>
          <p:nvPr/>
        </p:nvSpPr>
        <p:spPr bwMode="auto">
          <a:xfrm>
            <a:off x="3955271" y="4417292"/>
            <a:ext cx="249293" cy="279400"/>
          </a:xfrm>
          <a:custGeom>
            <a:avLst/>
            <a:gdLst>
              <a:gd name="T0" fmla="*/ 214 w 1560"/>
              <a:gd name="T1" fmla="*/ 1067 h 1466"/>
              <a:gd name="T2" fmla="*/ 63 w 1560"/>
              <a:gd name="T3" fmla="*/ 1180 h 1466"/>
              <a:gd name="T4" fmla="*/ 229 w 1560"/>
              <a:gd name="T5" fmla="*/ 1408 h 1466"/>
              <a:gd name="T6" fmla="*/ 290 w 1560"/>
              <a:gd name="T7" fmla="*/ 1209 h 1466"/>
              <a:gd name="T8" fmla="*/ 187 w 1560"/>
              <a:gd name="T9" fmla="*/ 1255 h 1466"/>
              <a:gd name="T10" fmla="*/ 296 w 1560"/>
              <a:gd name="T11" fmla="*/ 1145 h 1466"/>
              <a:gd name="T12" fmla="*/ 433 w 1560"/>
              <a:gd name="T13" fmla="*/ 1295 h 1466"/>
              <a:gd name="T14" fmla="*/ 296 w 1560"/>
              <a:gd name="T15" fmla="*/ 1450 h 1466"/>
              <a:gd name="T16" fmla="*/ 1 w 1560"/>
              <a:gd name="T17" fmla="*/ 1241 h 1466"/>
              <a:gd name="T18" fmla="*/ 162 w 1560"/>
              <a:gd name="T19" fmla="*/ 1033 h 1466"/>
              <a:gd name="T20" fmla="*/ 567 w 1560"/>
              <a:gd name="T21" fmla="*/ 1187 h 1466"/>
              <a:gd name="T22" fmla="*/ 536 w 1560"/>
              <a:gd name="T23" fmla="*/ 1222 h 1466"/>
              <a:gd name="T24" fmla="*/ 219 w 1560"/>
              <a:gd name="T25" fmla="*/ 905 h 1466"/>
              <a:gd name="T26" fmla="*/ 254 w 1560"/>
              <a:gd name="T27" fmla="*/ 874 h 1466"/>
              <a:gd name="T28" fmla="*/ 781 w 1560"/>
              <a:gd name="T29" fmla="*/ 1141 h 1466"/>
              <a:gd name="T30" fmla="*/ 738 w 1560"/>
              <a:gd name="T31" fmla="*/ 1164 h 1466"/>
              <a:gd name="T32" fmla="*/ 401 w 1560"/>
              <a:gd name="T33" fmla="*/ 934 h 1466"/>
              <a:gd name="T34" fmla="*/ 431 w 1560"/>
              <a:gd name="T35" fmla="*/ 893 h 1466"/>
              <a:gd name="T36" fmla="*/ 560 w 1560"/>
              <a:gd name="T37" fmla="*/ 777 h 1466"/>
              <a:gd name="T38" fmla="*/ 591 w 1560"/>
              <a:gd name="T39" fmla="*/ 735 h 1466"/>
              <a:gd name="T40" fmla="*/ 967 w 1560"/>
              <a:gd name="T41" fmla="*/ 731 h 1466"/>
              <a:gd name="T42" fmla="*/ 963 w 1560"/>
              <a:gd name="T43" fmla="*/ 789 h 1466"/>
              <a:gd name="T44" fmla="*/ 782 w 1560"/>
              <a:gd name="T45" fmla="*/ 859 h 1466"/>
              <a:gd name="T46" fmla="*/ 709 w 1560"/>
              <a:gd name="T47" fmla="*/ 605 h 1466"/>
              <a:gd name="T48" fmla="*/ 796 w 1560"/>
              <a:gd name="T49" fmla="*/ 567 h 1466"/>
              <a:gd name="T50" fmla="*/ 824 w 1560"/>
              <a:gd name="T51" fmla="*/ 603 h 1466"/>
              <a:gd name="T52" fmla="*/ 720 w 1560"/>
              <a:gd name="T53" fmla="*/ 701 h 1466"/>
              <a:gd name="T54" fmla="*/ 903 w 1560"/>
              <a:gd name="T55" fmla="*/ 799 h 1466"/>
              <a:gd name="T56" fmla="*/ 941 w 1560"/>
              <a:gd name="T57" fmla="*/ 711 h 1466"/>
              <a:gd name="T58" fmla="*/ 1087 w 1560"/>
              <a:gd name="T59" fmla="*/ 666 h 1466"/>
              <a:gd name="T60" fmla="*/ 1056 w 1560"/>
              <a:gd name="T61" fmla="*/ 701 h 1466"/>
              <a:gd name="T62" fmla="*/ 840 w 1560"/>
              <a:gd name="T63" fmla="*/ 485 h 1466"/>
              <a:gd name="T64" fmla="*/ 875 w 1560"/>
              <a:gd name="T65" fmla="*/ 454 h 1466"/>
              <a:gd name="T66" fmla="*/ 813 w 1560"/>
              <a:gd name="T67" fmla="*/ 428 h 1466"/>
              <a:gd name="T68" fmla="*/ 791 w 1560"/>
              <a:gd name="T69" fmla="*/ 369 h 1466"/>
              <a:gd name="T70" fmla="*/ 1330 w 1560"/>
              <a:gd name="T71" fmla="*/ 431 h 1466"/>
              <a:gd name="T72" fmla="*/ 1295 w 1560"/>
              <a:gd name="T73" fmla="*/ 453 h 1466"/>
              <a:gd name="T74" fmla="*/ 1067 w 1560"/>
              <a:gd name="T75" fmla="*/ 313 h 1466"/>
              <a:gd name="T76" fmla="*/ 1194 w 1560"/>
              <a:gd name="T77" fmla="*/ 564 h 1466"/>
              <a:gd name="T78" fmla="*/ 1159 w 1560"/>
              <a:gd name="T79" fmla="*/ 595 h 1466"/>
              <a:gd name="T80" fmla="*/ 951 w 1560"/>
              <a:gd name="T81" fmla="*/ 371 h 1466"/>
              <a:gd name="T82" fmla="*/ 983 w 1560"/>
              <a:gd name="T83" fmla="*/ 352 h 1466"/>
              <a:gd name="T84" fmla="*/ 1125 w 1560"/>
              <a:gd name="T85" fmla="*/ 240 h 1466"/>
              <a:gd name="T86" fmla="*/ 1476 w 1560"/>
              <a:gd name="T87" fmla="*/ 73 h 1466"/>
              <a:gd name="T88" fmla="*/ 1439 w 1560"/>
              <a:gd name="T89" fmla="*/ 256 h 1466"/>
              <a:gd name="T90" fmla="*/ 1529 w 1560"/>
              <a:gd name="T91" fmla="*/ 146 h 1466"/>
              <a:gd name="T92" fmla="*/ 1555 w 1560"/>
              <a:gd name="T93" fmla="*/ 160 h 1466"/>
              <a:gd name="T94" fmla="*/ 1547 w 1560"/>
              <a:gd name="T95" fmla="*/ 207 h 1466"/>
              <a:gd name="T96" fmla="*/ 1344 w 1560"/>
              <a:gd name="T97" fmla="*/ 298 h 1466"/>
              <a:gd name="T98" fmla="*/ 1272 w 1560"/>
              <a:gd name="T99" fmla="*/ 42 h 1466"/>
              <a:gd name="T100" fmla="*/ 1468 w 1560"/>
              <a:gd name="T101" fmla="*/ 55 h 1466"/>
              <a:gd name="T102" fmla="*/ 1277 w 1560"/>
              <a:gd name="T103" fmla="*/ 135 h 1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</a:cxnLst>
            <a:rect l="0" t="0" r="r" b="b"/>
            <a:pathLst>
              <a:path w="1560" h="1466">
                <a:moveTo>
                  <a:pt x="204" y="1042"/>
                </a:moveTo>
                <a:cubicBezTo>
                  <a:pt x="207" y="1045"/>
                  <a:pt x="209" y="1048"/>
                  <a:pt x="211" y="1051"/>
                </a:cubicBezTo>
                <a:cubicBezTo>
                  <a:pt x="213" y="1053"/>
                  <a:pt x="214" y="1055"/>
                  <a:pt x="215" y="1057"/>
                </a:cubicBezTo>
                <a:cubicBezTo>
                  <a:pt x="216" y="1060"/>
                  <a:pt x="216" y="1061"/>
                  <a:pt x="216" y="1063"/>
                </a:cubicBezTo>
                <a:cubicBezTo>
                  <a:pt x="216" y="1064"/>
                  <a:pt x="215" y="1066"/>
                  <a:pt x="214" y="1067"/>
                </a:cubicBezTo>
                <a:cubicBezTo>
                  <a:pt x="212" y="1069"/>
                  <a:pt x="208" y="1070"/>
                  <a:pt x="200" y="1072"/>
                </a:cubicBezTo>
                <a:cubicBezTo>
                  <a:pt x="193" y="1073"/>
                  <a:pt x="184" y="1075"/>
                  <a:pt x="174" y="1079"/>
                </a:cubicBezTo>
                <a:cubicBezTo>
                  <a:pt x="163" y="1083"/>
                  <a:pt x="151" y="1088"/>
                  <a:pt x="138" y="1095"/>
                </a:cubicBezTo>
                <a:cubicBezTo>
                  <a:pt x="125" y="1102"/>
                  <a:pt x="112" y="1113"/>
                  <a:pt x="98" y="1127"/>
                </a:cubicBezTo>
                <a:cubicBezTo>
                  <a:pt x="82" y="1143"/>
                  <a:pt x="70" y="1161"/>
                  <a:pt x="63" y="1180"/>
                </a:cubicBezTo>
                <a:cubicBezTo>
                  <a:pt x="56" y="1199"/>
                  <a:pt x="53" y="1218"/>
                  <a:pt x="55" y="1237"/>
                </a:cubicBezTo>
                <a:cubicBezTo>
                  <a:pt x="56" y="1257"/>
                  <a:pt x="62" y="1276"/>
                  <a:pt x="72" y="1296"/>
                </a:cubicBezTo>
                <a:cubicBezTo>
                  <a:pt x="81" y="1315"/>
                  <a:pt x="95" y="1333"/>
                  <a:pt x="112" y="1350"/>
                </a:cubicBezTo>
                <a:cubicBezTo>
                  <a:pt x="131" y="1369"/>
                  <a:pt x="150" y="1383"/>
                  <a:pt x="170" y="1393"/>
                </a:cubicBezTo>
                <a:cubicBezTo>
                  <a:pt x="190" y="1402"/>
                  <a:pt x="210" y="1407"/>
                  <a:pt x="229" y="1408"/>
                </a:cubicBezTo>
                <a:cubicBezTo>
                  <a:pt x="248" y="1409"/>
                  <a:pt x="267" y="1405"/>
                  <a:pt x="285" y="1397"/>
                </a:cubicBezTo>
                <a:cubicBezTo>
                  <a:pt x="303" y="1390"/>
                  <a:pt x="320" y="1378"/>
                  <a:pt x="336" y="1363"/>
                </a:cubicBezTo>
                <a:cubicBezTo>
                  <a:pt x="345" y="1354"/>
                  <a:pt x="353" y="1343"/>
                  <a:pt x="360" y="1332"/>
                </a:cubicBezTo>
                <a:cubicBezTo>
                  <a:pt x="367" y="1320"/>
                  <a:pt x="373" y="1308"/>
                  <a:pt x="376" y="1295"/>
                </a:cubicBezTo>
                <a:lnTo>
                  <a:pt x="290" y="1209"/>
                </a:lnTo>
                <a:lnTo>
                  <a:pt x="221" y="1278"/>
                </a:lnTo>
                <a:cubicBezTo>
                  <a:pt x="219" y="1280"/>
                  <a:pt x="215" y="1281"/>
                  <a:pt x="211" y="1280"/>
                </a:cubicBezTo>
                <a:cubicBezTo>
                  <a:pt x="208" y="1278"/>
                  <a:pt x="203" y="1275"/>
                  <a:pt x="197" y="1269"/>
                </a:cubicBezTo>
                <a:cubicBezTo>
                  <a:pt x="194" y="1267"/>
                  <a:pt x="192" y="1264"/>
                  <a:pt x="190" y="1262"/>
                </a:cubicBezTo>
                <a:cubicBezTo>
                  <a:pt x="189" y="1259"/>
                  <a:pt x="187" y="1257"/>
                  <a:pt x="187" y="1255"/>
                </a:cubicBezTo>
                <a:cubicBezTo>
                  <a:pt x="186" y="1253"/>
                  <a:pt x="186" y="1251"/>
                  <a:pt x="186" y="1250"/>
                </a:cubicBezTo>
                <a:cubicBezTo>
                  <a:pt x="187" y="1248"/>
                  <a:pt x="188" y="1247"/>
                  <a:pt x="189" y="1245"/>
                </a:cubicBezTo>
                <a:lnTo>
                  <a:pt x="283" y="1151"/>
                </a:lnTo>
                <a:cubicBezTo>
                  <a:pt x="285" y="1149"/>
                  <a:pt x="287" y="1148"/>
                  <a:pt x="289" y="1147"/>
                </a:cubicBezTo>
                <a:cubicBezTo>
                  <a:pt x="291" y="1146"/>
                  <a:pt x="294" y="1145"/>
                  <a:pt x="296" y="1145"/>
                </a:cubicBezTo>
                <a:cubicBezTo>
                  <a:pt x="299" y="1145"/>
                  <a:pt x="302" y="1146"/>
                  <a:pt x="305" y="1147"/>
                </a:cubicBezTo>
                <a:cubicBezTo>
                  <a:pt x="308" y="1148"/>
                  <a:pt x="310" y="1150"/>
                  <a:pt x="313" y="1153"/>
                </a:cubicBezTo>
                <a:lnTo>
                  <a:pt x="426" y="1266"/>
                </a:lnTo>
                <a:cubicBezTo>
                  <a:pt x="430" y="1270"/>
                  <a:pt x="433" y="1274"/>
                  <a:pt x="434" y="1279"/>
                </a:cubicBezTo>
                <a:cubicBezTo>
                  <a:pt x="436" y="1283"/>
                  <a:pt x="436" y="1288"/>
                  <a:pt x="433" y="1295"/>
                </a:cubicBezTo>
                <a:cubicBezTo>
                  <a:pt x="431" y="1302"/>
                  <a:pt x="428" y="1310"/>
                  <a:pt x="423" y="1319"/>
                </a:cubicBezTo>
                <a:cubicBezTo>
                  <a:pt x="419" y="1329"/>
                  <a:pt x="414" y="1339"/>
                  <a:pt x="408" y="1348"/>
                </a:cubicBezTo>
                <a:cubicBezTo>
                  <a:pt x="403" y="1357"/>
                  <a:pt x="396" y="1366"/>
                  <a:pt x="390" y="1375"/>
                </a:cubicBezTo>
                <a:cubicBezTo>
                  <a:pt x="383" y="1383"/>
                  <a:pt x="376" y="1391"/>
                  <a:pt x="368" y="1399"/>
                </a:cubicBezTo>
                <a:cubicBezTo>
                  <a:pt x="345" y="1422"/>
                  <a:pt x="321" y="1439"/>
                  <a:pt x="296" y="1450"/>
                </a:cubicBezTo>
                <a:cubicBezTo>
                  <a:pt x="271" y="1460"/>
                  <a:pt x="246" y="1466"/>
                  <a:pt x="220" y="1465"/>
                </a:cubicBezTo>
                <a:cubicBezTo>
                  <a:pt x="195" y="1464"/>
                  <a:pt x="169" y="1458"/>
                  <a:pt x="144" y="1446"/>
                </a:cubicBezTo>
                <a:cubicBezTo>
                  <a:pt x="120" y="1434"/>
                  <a:pt x="96" y="1417"/>
                  <a:pt x="73" y="1395"/>
                </a:cubicBezTo>
                <a:cubicBezTo>
                  <a:pt x="50" y="1371"/>
                  <a:pt x="32" y="1346"/>
                  <a:pt x="20" y="1320"/>
                </a:cubicBezTo>
                <a:cubicBezTo>
                  <a:pt x="8" y="1294"/>
                  <a:pt x="2" y="1267"/>
                  <a:pt x="1" y="1241"/>
                </a:cubicBezTo>
                <a:cubicBezTo>
                  <a:pt x="0" y="1215"/>
                  <a:pt x="6" y="1189"/>
                  <a:pt x="16" y="1163"/>
                </a:cubicBezTo>
                <a:cubicBezTo>
                  <a:pt x="27" y="1138"/>
                  <a:pt x="43" y="1114"/>
                  <a:pt x="65" y="1092"/>
                </a:cubicBezTo>
                <a:cubicBezTo>
                  <a:pt x="77" y="1081"/>
                  <a:pt x="88" y="1071"/>
                  <a:pt x="100" y="1063"/>
                </a:cubicBezTo>
                <a:cubicBezTo>
                  <a:pt x="112" y="1055"/>
                  <a:pt x="123" y="1049"/>
                  <a:pt x="134" y="1044"/>
                </a:cubicBezTo>
                <a:cubicBezTo>
                  <a:pt x="144" y="1039"/>
                  <a:pt x="153" y="1035"/>
                  <a:pt x="162" y="1033"/>
                </a:cubicBezTo>
                <a:cubicBezTo>
                  <a:pt x="170" y="1031"/>
                  <a:pt x="176" y="1030"/>
                  <a:pt x="180" y="1030"/>
                </a:cubicBezTo>
                <a:cubicBezTo>
                  <a:pt x="184" y="1030"/>
                  <a:pt x="188" y="1031"/>
                  <a:pt x="191" y="1032"/>
                </a:cubicBezTo>
                <a:cubicBezTo>
                  <a:pt x="195" y="1034"/>
                  <a:pt x="199" y="1038"/>
                  <a:pt x="204" y="1042"/>
                </a:cubicBezTo>
                <a:close/>
                <a:moveTo>
                  <a:pt x="565" y="1183"/>
                </a:moveTo>
                <a:cubicBezTo>
                  <a:pt x="566" y="1184"/>
                  <a:pt x="567" y="1185"/>
                  <a:pt x="567" y="1187"/>
                </a:cubicBezTo>
                <a:cubicBezTo>
                  <a:pt x="567" y="1188"/>
                  <a:pt x="567" y="1190"/>
                  <a:pt x="566" y="1192"/>
                </a:cubicBezTo>
                <a:cubicBezTo>
                  <a:pt x="565" y="1194"/>
                  <a:pt x="564" y="1196"/>
                  <a:pt x="562" y="1199"/>
                </a:cubicBezTo>
                <a:cubicBezTo>
                  <a:pt x="560" y="1202"/>
                  <a:pt x="557" y="1205"/>
                  <a:pt x="553" y="1209"/>
                </a:cubicBezTo>
                <a:cubicBezTo>
                  <a:pt x="549" y="1212"/>
                  <a:pt x="546" y="1215"/>
                  <a:pt x="543" y="1217"/>
                </a:cubicBezTo>
                <a:cubicBezTo>
                  <a:pt x="541" y="1220"/>
                  <a:pt x="538" y="1221"/>
                  <a:pt x="536" y="1222"/>
                </a:cubicBezTo>
                <a:cubicBezTo>
                  <a:pt x="534" y="1223"/>
                  <a:pt x="532" y="1223"/>
                  <a:pt x="531" y="1223"/>
                </a:cubicBezTo>
                <a:cubicBezTo>
                  <a:pt x="530" y="1222"/>
                  <a:pt x="528" y="1222"/>
                  <a:pt x="527" y="1220"/>
                </a:cubicBezTo>
                <a:lnTo>
                  <a:pt x="221" y="914"/>
                </a:lnTo>
                <a:cubicBezTo>
                  <a:pt x="219" y="913"/>
                  <a:pt x="219" y="912"/>
                  <a:pt x="218" y="910"/>
                </a:cubicBezTo>
                <a:cubicBezTo>
                  <a:pt x="218" y="909"/>
                  <a:pt x="218" y="907"/>
                  <a:pt x="219" y="905"/>
                </a:cubicBezTo>
                <a:cubicBezTo>
                  <a:pt x="220" y="903"/>
                  <a:pt x="221" y="900"/>
                  <a:pt x="223" y="898"/>
                </a:cubicBezTo>
                <a:cubicBezTo>
                  <a:pt x="226" y="895"/>
                  <a:pt x="229" y="892"/>
                  <a:pt x="232" y="888"/>
                </a:cubicBezTo>
                <a:cubicBezTo>
                  <a:pt x="236" y="884"/>
                  <a:pt x="239" y="881"/>
                  <a:pt x="242" y="879"/>
                </a:cubicBezTo>
                <a:cubicBezTo>
                  <a:pt x="245" y="877"/>
                  <a:pt x="247" y="875"/>
                  <a:pt x="249" y="875"/>
                </a:cubicBezTo>
                <a:cubicBezTo>
                  <a:pt x="251" y="874"/>
                  <a:pt x="253" y="874"/>
                  <a:pt x="254" y="874"/>
                </a:cubicBezTo>
                <a:cubicBezTo>
                  <a:pt x="256" y="874"/>
                  <a:pt x="257" y="875"/>
                  <a:pt x="259" y="876"/>
                </a:cubicBezTo>
                <a:lnTo>
                  <a:pt x="565" y="1183"/>
                </a:lnTo>
                <a:close/>
                <a:moveTo>
                  <a:pt x="734" y="1025"/>
                </a:moveTo>
                <a:lnTo>
                  <a:pt x="783" y="1128"/>
                </a:lnTo>
                <a:cubicBezTo>
                  <a:pt x="784" y="1131"/>
                  <a:pt x="784" y="1136"/>
                  <a:pt x="781" y="1141"/>
                </a:cubicBezTo>
                <a:cubicBezTo>
                  <a:pt x="779" y="1146"/>
                  <a:pt x="774" y="1152"/>
                  <a:pt x="766" y="1160"/>
                </a:cubicBezTo>
                <a:cubicBezTo>
                  <a:pt x="762" y="1164"/>
                  <a:pt x="759" y="1167"/>
                  <a:pt x="756" y="1169"/>
                </a:cubicBezTo>
                <a:cubicBezTo>
                  <a:pt x="753" y="1171"/>
                  <a:pt x="751" y="1172"/>
                  <a:pt x="748" y="1172"/>
                </a:cubicBezTo>
                <a:cubicBezTo>
                  <a:pt x="746" y="1173"/>
                  <a:pt x="744" y="1172"/>
                  <a:pt x="742" y="1171"/>
                </a:cubicBezTo>
                <a:cubicBezTo>
                  <a:pt x="741" y="1170"/>
                  <a:pt x="739" y="1167"/>
                  <a:pt x="738" y="1164"/>
                </a:cubicBezTo>
                <a:lnTo>
                  <a:pt x="695" y="1064"/>
                </a:lnTo>
                <a:cubicBezTo>
                  <a:pt x="693" y="1065"/>
                  <a:pt x="690" y="1065"/>
                  <a:pt x="688" y="1065"/>
                </a:cubicBezTo>
                <a:cubicBezTo>
                  <a:pt x="685" y="1065"/>
                  <a:pt x="683" y="1064"/>
                  <a:pt x="681" y="1063"/>
                </a:cubicBezTo>
                <a:lnTo>
                  <a:pt x="410" y="940"/>
                </a:lnTo>
                <a:cubicBezTo>
                  <a:pt x="406" y="938"/>
                  <a:pt x="403" y="936"/>
                  <a:pt x="401" y="934"/>
                </a:cubicBezTo>
                <a:cubicBezTo>
                  <a:pt x="399" y="932"/>
                  <a:pt x="398" y="930"/>
                  <a:pt x="398" y="928"/>
                </a:cubicBezTo>
                <a:cubicBezTo>
                  <a:pt x="398" y="925"/>
                  <a:pt x="400" y="923"/>
                  <a:pt x="402" y="920"/>
                </a:cubicBezTo>
                <a:cubicBezTo>
                  <a:pt x="404" y="916"/>
                  <a:pt x="408" y="913"/>
                  <a:pt x="413" y="908"/>
                </a:cubicBezTo>
                <a:cubicBezTo>
                  <a:pt x="417" y="903"/>
                  <a:pt x="421" y="900"/>
                  <a:pt x="424" y="898"/>
                </a:cubicBezTo>
                <a:cubicBezTo>
                  <a:pt x="427" y="895"/>
                  <a:pt x="429" y="894"/>
                  <a:pt x="431" y="893"/>
                </a:cubicBezTo>
                <a:cubicBezTo>
                  <a:pt x="433" y="892"/>
                  <a:pt x="435" y="891"/>
                  <a:pt x="437" y="892"/>
                </a:cubicBezTo>
                <a:cubicBezTo>
                  <a:pt x="439" y="892"/>
                  <a:pt x="441" y="893"/>
                  <a:pt x="444" y="894"/>
                </a:cubicBezTo>
                <a:lnTo>
                  <a:pt x="668" y="1001"/>
                </a:lnTo>
                <a:lnTo>
                  <a:pt x="669" y="1000"/>
                </a:lnTo>
                <a:lnTo>
                  <a:pt x="560" y="777"/>
                </a:lnTo>
                <a:cubicBezTo>
                  <a:pt x="558" y="773"/>
                  <a:pt x="557" y="770"/>
                  <a:pt x="557" y="768"/>
                </a:cubicBezTo>
                <a:cubicBezTo>
                  <a:pt x="558" y="766"/>
                  <a:pt x="559" y="763"/>
                  <a:pt x="561" y="760"/>
                </a:cubicBezTo>
                <a:cubicBezTo>
                  <a:pt x="563" y="757"/>
                  <a:pt x="567" y="754"/>
                  <a:pt x="572" y="749"/>
                </a:cubicBezTo>
                <a:cubicBezTo>
                  <a:pt x="576" y="744"/>
                  <a:pt x="580" y="741"/>
                  <a:pt x="583" y="739"/>
                </a:cubicBezTo>
                <a:cubicBezTo>
                  <a:pt x="586" y="736"/>
                  <a:pt x="589" y="735"/>
                  <a:pt x="591" y="735"/>
                </a:cubicBezTo>
                <a:cubicBezTo>
                  <a:pt x="594" y="735"/>
                  <a:pt x="596" y="735"/>
                  <a:pt x="598" y="737"/>
                </a:cubicBezTo>
                <a:cubicBezTo>
                  <a:pt x="599" y="739"/>
                  <a:pt x="601" y="742"/>
                  <a:pt x="603" y="745"/>
                </a:cubicBezTo>
                <a:lnTo>
                  <a:pt x="734" y="1025"/>
                </a:lnTo>
                <a:close/>
                <a:moveTo>
                  <a:pt x="961" y="724"/>
                </a:moveTo>
                <a:cubicBezTo>
                  <a:pt x="963" y="727"/>
                  <a:pt x="965" y="729"/>
                  <a:pt x="967" y="731"/>
                </a:cubicBezTo>
                <a:cubicBezTo>
                  <a:pt x="969" y="733"/>
                  <a:pt x="970" y="735"/>
                  <a:pt x="971" y="737"/>
                </a:cubicBezTo>
                <a:cubicBezTo>
                  <a:pt x="972" y="738"/>
                  <a:pt x="973" y="740"/>
                  <a:pt x="973" y="741"/>
                </a:cubicBezTo>
                <a:cubicBezTo>
                  <a:pt x="974" y="743"/>
                  <a:pt x="974" y="746"/>
                  <a:pt x="974" y="749"/>
                </a:cubicBezTo>
                <a:cubicBezTo>
                  <a:pt x="974" y="753"/>
                  <a:pt x="973" y="759"/>
                  <a:pt x="971" y="766"/>
                </a:cubicBezTo>
                <a:cubicBezTo>
                  <a:pt x="970" y="774"/>
                  <a:pt x="967" y="781"/>
                  <a:pt x="963" y="789"/>
                </a:cubicBezTo>
                <a:cubicBezTo>
                  <a:pt x="960" y="797"/>
                  <a:pt x="956" y="805"/>
                  <a:pt x="950" y="813"/>
                </a:cubicBezTo>
                <a:cubicBezTo>
                  <a:pt x="945" y="821"/>
                  <a:pt x="939" y="829"/>
                  <a:pt x="931" y="836"/>
                </a:cubicBezTo>
                <a:cubicBezTo>
                  <a:pt x="917" y="851"/>
                  <a:pt x="901" y="862"/>
                  <a:pt x="885" y="868"/>
                </a:cubicBezTo>
                <a:cubicBezTo>
                  <a:pt x="868" y="875"/>
                  <a:pt x="851" y="877"/>
                  <a:pt x="834" y="876"/>
                </a:cubicBezTo>
                <a:cubicBezTo>
                  <a:pt x="817" y="874"/>
                  <a:pt x="800" y="868"/>
                  <a:pt x="782" y="859"/>
                </a:cubicBezTo>
                <a:cubicBezTo>
                  <a:pt x="764" y="849"/>
                  <a:pt x="747" y="835"/>
                  <a:pt x="729" y="817"/>
                </a:cubicBezTo>
                <a:cubicBezTo>
                  <a:pt x="708" y="797"/>
                  <a:pt x="693" y="777"/>
                  <a:pt x="684" y="758"/>
                </a:cubicBezTo>
                <a:cubicBezTo>
                  <a:pt x="674" y="738"/>
                  <a:pt x="669" y="719"/>
                  <a:pt x="668" y="701"/>
                </a:cubicBezTo>
                <a:cubicBezTo>
                  <a:pt x="668" y="683"/>
                  <a:pt x="671" y="666"/>
                  <a:pt x="678" y="650"/>
                </a:cubicBezTo>
                <a:cubicBezTo>
                  <a:pt x="685" y="634"/>
                  <a:pt x="696" y="619"/>
                  <a:pt x="709" y="605"/>
                </a:cubicBezTo>
                <a:cubicBezTo>
                  <a:pt x="716" y="599"/>
                  <a:pt x="723" y="593"/>
                  <a:pt x="730" y="588"/>
                </a:cubicBezTo>
                <a:cubicBezTo>
                  <a:pt x="738" y="583"/>
                  <a:pt x="745" y="579"/>
                  <a:pt x="752" y="576"/>
                </a:cubicBezTo>
                <a:cubicBezTo>
                  <a:pt x="759" y="573"/>
                  <a:pt x="766" y="570"/>
                  <a:pt x="773" y="569"/>
                </a:cubicBezTo>
                <a:cubicBezTo>
                  <a:pt x="779" y="567"/>
                  <a:pt x="785" y="567"/>
                  <a:pt x="788" y="567"/>
                </a:cubicBezTo>
                <a:cubicBezTo>
                  <a:pt x="792" y="567"/>
                  <a:pt x="795" y="567"/>
                  <a:pt x="796" y="567"/>
                </a:cubicBezTo>
                <a:cubicBezTo>
                  <a:pt x="798" y="568"/>
                  <a:pt x="800" y="568"/>
                  <a:pt x="802" y="569"/>
                </a:cubicBezTo>
                <a:cubicBezTo>
                  <a:pt x="804" y="570"/>
                  <a:pt x="806" y="572"/>
                  <a:pt x="808" y="573"/>
                </a:cubicBezTo>
                <a:cubicBezTo>
                  <a:pt x="810" y="575"/>
                  <a:pt x="812" y="577"/>
                  <a:pt x="815" y="580"/>
                </a:cubicBezTo>
                <a:cubicBezTo>
                  <a:pt x="821" y="586"/>
                  <a:pt x="824" y="591"/>
                  <a:pt x="825" y="594"/>
                </a:cubicBezTo>
                <a:cubicBezTo>
                  <a:pt x="826" y="598"/>
                  <a:pt x="826" y="601"/>
                  <a:pt x="824" y="603"/>
                </a:cubicBezTo>
                <a:cubicBezTo>
                  <a:pt x="822" y="605"/>
                  <a:pt x="818" y="607"/>
                  <a:pt x="812" y="607"/>
                </a:cubicBezTo>
                <a:cubicBezTo>
                  <a:pt x="807" y="608"/>
                  <a:pt x="800" y="609"/>
                  <a:pt x="792" y="610"/>
                </a:cubicBezTo>
                <a:cubicBezTo>
                  <a:pt x="785" y="612"/>
                  <a:pt x="776" y="614"/>
                  <a:pt x="767" y="618"/>
                </a:cubicBezTo>
                <a:cubicBezTo>
                  <a:pt x="758" y="622"/>
                  <a:pt x="749" y="629"/>
                  <a:pt x="741" y="638"/>
                </a:cubicBezTo>
                <a:cubicBezTo>
                  <a:pt x="722" y="656"/>
                  <a:pt x="715" y="677"/>
                  <a:pt x="720" y="701"/>
                </a:cubicBezTo>
                <a:cubicBezTo>
                  <a:pt x="724" y="724"/>
                  <a:pt x="739" y="749"/>
                  <a:pt x="766" y="776"/>
                </a:cubicBezTo>
                <a:cubicBezTo>
                  <a:pt x="779" y="789"/>
                  <a:pt x="792" y="800"/>
                  <a:pt x="805" y="807"/>
                </a:cubicBezTo>
                <a:cubicBezTo>
                  <a:pt x="817" y="815"/>
                  <a:pt x="829" y="819"/>
                  <a:pt x="841" y="821"/>
                </a:cubicBezTo>
                <a:cubicBezTo>
                  <a:pt x="853" y="823"/>
                  <a:pt x="864" y="822"/>
                  <a:pt x="874" y="818"/>
                </a:cubicBezTo>
                <a:cubicBezTo>
                  <a:pt x="884" y="814"/>
                  <a:pt x="894" y="808"/>
                  <a:pt x="903" y="799"/>
                </a:cubicBezTo>
                <a:cubicBezTo>
                  <a:pt x="912" y="790"/>
                  <a:pt x="918" y="781"/>
                  <a:pt x="922" y="772"/>
                </a:cubicBezTo>
                <a:cubicBezTo>
                  <a:pt x="926" y="762"/>
                  <a:pt x="929" y="754"/>
                  <a:pt x="930" y="745"/>
                </a:cubicBezTo>
                <a:cubicBezTo>
                  <a:pt x="932" y="737"/>
                  <a:pt x="933" y="730"/>
                  <a:pt x="933" y="724"/>
                </a:cubicBezTo>
                <a:cubicBezTo>
                  <a:pt x="934" y="718"/>
                  <a:pt x="935" y="715"/>
                  <a:pt x="937" y="713"/>
                </a:cubicBezTo>
                <a:cubicBezTo>
                  <a:pt x="938" y="712"/>
                  <a:pt x="939" y="711"/>
                  <a:pt x="941" y="711"/>
                </a:cubicBezTo>
                <a:cubicBezTo>
                  <a:pt x="942" y="711"/>
                  <a:pt x="944" y="711"/>
                  <a:pt x="946" y="712"/>
                </a:cubicBezTo>
                <a:cubicBezTo>
                  <a:pt x="948" y="713"/>
                  <a:pt x="950" y="714"/>
                  <a:pt x="952" y="716"/>
                </a:cubicBezTo>
                <a:cubicBezTo>
                  <a:pt x="955" y="718"/>
                  <a:pt x="958" y="721"/>
                  <a:pt x="961" y="724"/>
                </a:cubicBezTo>
                <a:close/>
                <a:moveTo>
                  <a:pt x="1085" y="662"/>
                </a:moveTo>
                <a:cubicBezTo>
                  <a:pt x="1086" y="663"/>
                  <a:pt x="1087" y="665"/>
                  <a:pt x="1087" y="666"/>
                </a:cubicBezTo>
                <a:cubicBezTo>
                  <a:pt x="1088" y="668"/>
                  <a:pt x="1087" y="669"/>
                  <a:pt x="1087" y="671"/>
                </a:cubicBezTo>
                <a:cubicBezTo>
                  <a:pt x="1086" y="673"/>
                  <a:pt x="1084" y="676"/>
                  <a:pt x="1082" y="678"/>
                </a:cubicBezTo>
                <a:cubicBezTo>
                  <a:pt x="1080" y="681"/>
                  <a:pt x="1077" y="684"/>
                  <a:pt x="1073" y="688"/>
                </a:cubicBezTo>
                <a:cubicBezTo>
                  <a:pt x="1070" y="692"/>
                  <a:pt x="1066" y="695"/>
                  <a:pt x="1064" y="697"/>
                </a:cubicBezTo>
                <a:cubicBezTo>
                  <a:pt x="1061" y="699"/>
                  <a:pt x="1059" y="701"/>
                  <a:pt x="1056" y="701"/>
                </a:cubicBezTo>
                <a:cubicBezTo>
                  <a:pt x="1054" y="702"/>
                  <a:pt x="1053" y="703"/>
                  <a:pt x="1051" y="702"/>
                </a:cubicBezTo>
                <a:cubicBezTo>
                  <a:pt x="1050" y="702"/>
                  <a:pt x="1049" y="701"/>
                  <a:pt x="1047" y="700"/>
                </a:cubicBezTo>
                <a:lnTo>
                  <a:pt x="841" y="494"/>
                </a:lnTo>
                <a:cubicBezTo>
                  <a:pt x="840" y="493"/>
                  <a:pt x="839" y="491"/>
                  <a:pt x="839" y="490"/>
                </a:cubicBezTo>
                <a:cubicBezTo>
                  <a:pt x="839" y="488"/>
                  <a:pt x="839" y="487"/>
                  <a:pt x="840" y="485"/>
                </a:cubicBezTo>
                <a:cubicBezTo>
                  <a:pt x="840" y="483"/>
                  <a:pt x="842" y="480"/>
                  <a:pt x="844" y="477"/>
                </a:cubicBezTo>
                <a:cubicBezTo>
                  <a:pt x="846" y="475"/>
                  <a:pt x="849" y="471"/>
                  <a:pt x="853" y="468"/>
                </a:cubicBezTo>
                <a:cubicBezTo>
                  <a:pt x="857" y="464"/>
                  <a:pt x="860" y="461"/>
                  <a:pt x="863" y="459"/>
                </a:cubicBezTo>
                <a:cubicBezTo>
                  <a:pt x="865" y="457"/>
                  <a:pt x="868" y="455"/>
                  <a:pt x="870" y="454"/>
                </a:cubicBezTo>
                <a:cubicBezTo>
                  <a:pt x="872" y="454"/>
                  <a:pt x="873" y="453"/>
                  <a:pt x="875" y="454"/>
                </a:cubicBezTo>
                <a:cubicBezTo>
                  <a:pt x="877" y="454"/>
                  <a:pt x="878" y="455"/>
                  <a:pt x="879" y="456"/>
                </a:cubicBezTo>
                <a:lnTo>
                  <a:pt x="1085" y="662"/>
                </a:lnTo>
                <a:close/>
                <a:moveTo>
                  <a:pt x="814" y="382"/>
                </a:moveTo>
                <a:cubicBezTo>
                  <a:pt x="822" y="391"/>
                  <a:pt x="827" y="398"/>
                  <a:pt x="827" y="405"/>
                </a:cubicBezTo>
                <a:cubicBezTo>
                  <a:pt x="826" y="412"/>
                  <a:pt x="822" y="419"/>
                  <a:pt x="813" y="428"/>
                </a:cubicBezTo>
                <a:cubicBezTo>
                  <a:pt x="804" y="437"/>
                  <a:pt x="796" y="442"/>
                  <a:pt x="790" y="442"/>
                </a:cubicBezTo>
                <a:cubicBezTo>
                  <a:pt x="784" y="442"/>
                  <a:pt x="776" y="438"/>
                  <a:pt x="767" y="429"/>
                </a:cubicBezTo>
                <a:cubicBezTo>
                  <a:pt x="758" y="420"/>
                  <a:pt x="754" y="412"/>
                  <a:pt x="754" y="406"/>
                </a:cubicBezTo>
                <a:cubicBezTo>
                  <a:pt x="754" y="399"/>
                  <a:pt x="759" y="391"/>
                  <a:pt x="768" y="382"/>
                </a:cubicBezTo>
                <a:cubicBezTo>
                  <a:pt x="777" y="374"/>
                  <a:pt x="784" y="369"/>
                  <a:pt x="791" y="369"/>
                </a:cubicBezTo>
                <a:cubicBezTo>
                  <a:pt x="797" y="369"/>
                  <a:pt x="805" y="373"/>
                  <a:pt x="814" y="382"/>
                </a:cubicBezTo>
                <a:close/>
                <a:moveTo>
                  <a:pt x="1333" y="415"/>
                </a:moveTo>
                <a:cubicBezTo>
                  <a:pt x="1334" y="416"/>
                  <a:pt x="1335" y="417"/>
                  <a:pt x="1335" y="419"/>
                </a:cubicBezTo>
                <a:cubicBezTo>
                  <a:pt x="1335" y="420"/>
                  <a:pt x="1335" y="422"/>
                  <a:pt x="1334" y="424"/>
                </a:cubicBezTo>
                <a:cubicBezTo>
                  <a:pt x="1333" y="426"/>
                  <a:pt x="1332" y="428"/>
                  <a:pt x="1330" y="431"/>
                </a:cubicBezTo>
                <a:cubicBezTo>
                  <a:pt x="1327" y="434"/>
                  <a:pt x="1325" y="437"/>
                  <a:pt x="1321" y="441"/>
                </a:cubicBezTo>
                <a:cubicBezTo>
                  <a:pt x="1317" y="445"/>
                  <a:pt x="1314" y="448"/>
                  <a:pt x="1311" y="450"/>
                </a:cubicBezTo>
                <a:cubicBezTo>
                  <a:pt x="1308" y="452"/>
                  <a:pt x="1306" y="453"/>
                  <a:pt x="1304" y="454"/>
                </a:cubicBezTo>
                <a:cubicBezTo>
                  <a:pt x="1302" y="455"/>
                  <a:pt x="1300" y="455"/>
                  <a:pt x="1299" y="455"/>
                </a:cubicBezTo>
                <a:cubicBezTo>
                  <a:pt x="1297" y="455"/>
                  <a:pt x="1296" y="454"/>
                  <a:pt x="1295" y="453"/>
                </a:cubicBezTo>
                <a:lnTo>
                  <a:pt x="1174" y="332"/>
                </a:lnTo>
                <a:cubicBezTo>
                  <a:pt x="1162" y="320"/>
                  <a:pt x="1152" y="312"/>
                  <a:pt x="1143" y="306"/>
                </a:cubicBezTo>
                <a:cubicBezTo>
                  <a:pt x="1134" y="301"/>
                  <a:pt x="1125" y="297"/>
                  <a:pt x="1116" y="296"/>
                </a:cubicBezTo>
                <a:cubicBezTo>
                  <a:pt x="1107" y="294"/>
                  <a:pt x="1099" y="295"/>
                  <a:pt x="1091" y="297"/>
                </a:cubicBezTo>
                <a:cubicBezTo>
                  <a:pt x="1082" y="300"/>
                  <a:pt x="1074" y="305"/>
                  <a:pt x="1067" y="313"/>
                </a:cubicBezTo>
                <a:cubicBezTo>
                  <a:pt x="1058" y="322"/>
                  <a:pt x="1052" y="335"/>
                  <a:pt x="1049" y="351"/>
                </a:cubicBezTo>
                <a:cubicBezTo>
                  <a:pt x="1046" y="367"/>
                  <a:pt x="1046" y="387"/>
                  <a:pt x="1049" y="410"/>
                </a:cubicBezTo>
                <a:lnTo>
                  <a:pt x="1193" y="555"/>
                </a:lnTo>
                <a:cubicBezTo>
                  <a:pt x="1194" y="556"/>
                  <a:pt x="1195" y="557"/>
                  <a:pt x="1195" y="559"/>
                </a:cubicBezTo>
                <a:cubicBezTo>
                  <a:pt x="1195" y="560"/>
                  <a:pt x="1195" y="562"/>
                  <a:pt x="1194" y="564"/>
                </a:cubicBezTo>
                <a:cubicBezTo>
                  <a:pt x="1193" y="566"/>
                  <a:pt x="1192" y="568"/>
                  <a:pt x="1190" y="571"/>
                </a:cubicBezTo>
                <a:cubicBezTo>
                  <a:pt x="1188" y="574"/>
                  <a:pt x="1185" y="577"/>
                  <a:pt x="1181" y="581"/>
                </a:cubicBezTo>
                <a:cubicBezTo>
                  <a:pt x="1177" y="584"/>
                  <a:pt x="1174" y="587"/>
                  <a:pt x="1171" y="590"/>
                </a:cubicBezTo>
                <a:cubicBezTo>
                  <a:pt x="1168" y="592"/>
                  <a:pt x="1166" y="593"/>
                  <a:pt x="1164" y="594"/>
                </a:cubicBezTo>
                <a:cubicBezTo>
                  <a:pt x="1162" y="595"/>
                  <a:pt x="1160" y="595"/>
                  <a:pt x="1159" y="595"/>
                </a:cubicBezTo>
                <a:cubicBezTo>
                  <a:pt x="1157" y="595"/>
                  <a:pt x="1156" y="594"/>
                  <a:pt x="1155" y="593"/>
                </a:cubicBezTo>
                <a:lnTo>
                  <a:pt x="949" y="386"/>
                </a:lnTo>
                <a:cubicBezTo>
                  <a:pt x="947" y="385"/>
                  <a:pt x="947" y="384"/>
                  <a:pt x="946" y="382"/>
                </a:cubicBezTo>
                <a:cubicBezTo>
                  <a:pt x="946" y="381"/>
                  <a:pt x="946" y="379"/>
                  <a:pt x="947" y="377"/>
                </a:cubicBezTo>
                <a:cubicBezTo>
                  <a:pt x="947" y="375"/>
                  <a:pt x="949" y="373"/>
                  <a:pt x="951" y="371"/>
                </a:cubicBezTo>
                <a:cubicBezTo>
                  <a:pt x="952" y="368"/>
                  <a:pt x="955" y="365"/>
                  <a:pt x="959" y="362"/>
                </a:cubicBezTo>
                <a:cubicBezTo>
                  <a:pt x="962" y="359"/>
                  <a:pt x="965" y="356"/>
                  <a:pt x="967" y="354"/>
                </a:cubicBezTo>
                <a:cubicBezTo>
                  <a:pt x="970" y="352"/>
                  <a:pt x="972" y="351"/>
                  <a:pt x="974" y="350"/>
                </a:cubicBezTo>
                <a:cubicBezTo>
                  <a:pt x="976" y="350"/>
                  <a:pt x="977" y="349"/>
                  <a:pt x="979" y="350"/>
                </a:cubicBezTo>
                <a:cubicBezTo>
                  <a:pt x="980" y="350"/>
                  <a:pt x="982" y="351"/>
                  <a:pt x="983" y="352"/>
                </a:cubicBezTo>
                <a:lnTo>
                  <a:pt x="1010" y="379"/>
                </a:lnTo>
                <a:cubicBezTo>
                  <a:pt x="1009" y="355"/>
                  <a:pt x="1011" y="334"/>
                  <a:pt x="1016" y="316"/>
                </a:cubicBezTo>
                <a:cubicBezTo>
                  <a:pt x="1022" y="298"/>
                  <a:pt x="1030" y="284"/>
                  <a:pt x="1042" y="272"/>
                </a:cubicBezTo>
                <a:cubicBezTo>
                  <a:pt x="1056" y="258"/>
                  <a:pt x="1070" y="249"/>
                  <a:pt x="1084" y="244"/>
                </a:cubicBezTo>
                <a:cubicBezTo>
                  <a:pt x="1098" y="240"/>
                  <a:pt x="1112" y="238"/>
                  <a:pt x="1125" y="240"/>
                </a:cubicBezTo>
                <a:cubicBezTo>
                  <a:pt x="1139" y="242"/>
                  <a:pt x="1152" y="247"/>
                  <a:pt x="1165" y="255"/>
                </a:cubicBezTo>
                <a:cubicBezTo>
                  <a:pt x="1178" y="263"/>
                  <a:pt x="1192" y="274"/>
                  <a:pt x="1207" y="289"/>
                </a:cubicBezTo>
                <a:lnTo>
                  <a:pt x="1333" y="415"/>
                </a:lnTo>
                <a:close/>
                <a:moveTo>
                  <a:pt x="1468" y="55"/>
                </a:moveTo>
                <a:cubicBezTo>
                  <a:pt x="1474" y="61"/>
                  <a:pt x="1476" y="67"/>
                  <a:pt x="1476" y="73"/>
                </a:cubicBezTo>
                <a:cubicBezTo>
                  <a:pt x="1476" y="78"/>
                  <a:pt x="1473" y="83"/>
                  <a:pt x="1470" y="87"/>
                </a:cubicBezTo>
                <a:lnTo>
                  <a:pt x="1334" y="223"/>
                </a:lnTo>
                <a:cubicBezTo>
                  <a:pt x="1345" y="234"/>
                  <a:pt x="1357" y="243"/>
                  <a:pt x="1368" y="250"/>
                </a:cubicBezTo>
                <a:cubicBezTo>
                  <a:pt x="1380" y="257"/>
                  <a:pt x="1391" y="261"/>
                  <a:pt x="1403" y="262"/>
                </a:cubicBezTo>
                <a:cubicBezTo>
                  <a:pt x="1415" y="263"/>
                  <a:pt x="1427" y="261"/>
                  <a:pt x="1439" y="256"/>
                </a:cubicBezTo>
                <a:cubicBezTo>
                  <a:pt x="1451" y="251"/>
                  <a:pt x="1464" y="242"/>
                  <a:pt x="1476" y="230"/>
                </a:cubicBezTo>
                <a:cubicBezTo>
                  <a:pt x="1486" y="220"/>
                  <a:pt x="1494" y="211"/>
                  <a:pt x="1500" y="201"/>
                </a:cubicBezTo>
                <a:cubicBezTo>
                  <a:pt x="1506" y="192"/>
                  <a:pt x="1511" y="184"/>
                  <a:pt x="1515" y="176"/>
                </a:cubicBezTo>
                <a:cubicBezTo>
                  <a:pt x="1518" y="168"/>
                  <a:pt x="1521" y="162"/>
                  <a:pt x="1523" y="157"/>
                </a:cubicBezTo>
                <a:cubicBezTo>
                  <a:pt x="1525" y="152"/>
                  <a:pt x="1527" y="148"/>
                  <a:pt x="1529" y="146"/>
                </a:cubicBezTo>
                <a:cubicBezTo>
                  <a:pt x="1530" y="145"/>
                  <a:pt x="1531" y="144"/>
                  <a:pt x="1532" y="144"/>
                </a:cubicBezTo>
                <a:cubicBezTo>
                  <a:pt x="1534" y="144"/>
                  <a:pt x="1535" y="144"/>
                  <a:pt x="1537" y="145"/>
                </a:cubicBezTo>
                <a:cubicBezTo>
                  <a:pt x="1538" y="145"/>
                  <a:pt x="1540" y="146"/>
                  <a:pt x="1542" y="148"/>
                </a:cubicBezTo>
                <a:cubicBezTo>
                  <a:pt x="1544" y="150"/>
                  <a:pt x="1547" y="152"/>
                  <a:pt x="1550" y="155"/>
                </a:cubicBezTo>
                <a:cubicBezTo>
                  <a:pt x="1552" y="157"/>
                  <a:pt x="1553" y="158"/>
                  <a:pt x="1555" y="160"/>
                </a:cubicBezTo>
                <a:cubicBezTo>
                  <a:pt x="1556" y="162"/>
                  <a:pt x="1557" y="163"/>
                  <a:pt x="1558" y="165"/>
                </a:cubicBezTo>
                <a:cubicBezTo>
                  <a:pt x="1559" y="166"/>
                  <a:pt x="1559" y="167"/>
                  <a:pt x="1560" y="169"/>
                </a:cubicBezTo>
                <a:cubicBezTo>
                  <a:pt x="1560" y="170"/>
                  <a:pt x="1560" y="172"/>
                  <a:pt x="1560" y="174"/>
                </a:cubicBezTo>
                <a:cubicBezTo>
                  <a:pt x="1560" y="175"/>
                  <a:pt x="1559" y="179"/>
                  <a:pt x="1557" y="185"/>
                </a:cubicBezTo>
                <a:cubicBezTo>
                  <a:pt x="1555" y="191"/>
                  <a:pt x="1551" y="198"/>
                  <a:pt x="1547" y="207"/>
                </a:cubicBezTo>
                <a:cubicBezTo>
                  <a:pt x="1542" y="215"/>
                  <a:pt x="1536" y="224"/>
                  <a:pt x="1529" y="234"/>
                </a:cubicBezTo>
                <a:cubicBezTo>
                  <a:pt x="1522" y="245"/>
                  <a:pt x="1513" y="255"/>
                  <a:pt x="1503" y="264"/>
                </a:cubicBezTo>
                <a:cubicBezTo>
                  <a:pt x="1486" y="281"/>
                  <a:pt x="1469" y="294"/>
                  <a:pt x="1452" y="302"/>
                </a:cubicBezTo>
                <a:cubicBezTo>
                  <a:pt x="1434" y="310"/>
                  <a:pt x="1416" y="314"/>
                  <a:pt x="1398" y="313"/>
                </a:cubicBezTo>
                <a:cubicBezTo>
                  <a:pt x="1380" y="312"/>
                  <a:pt x="1362" y="307"/>
                  <a:pt x="1344" y="298"/>
                </a:cubicBezTo>
                <a:cubicBezTo>
                  <a:pt x="1325" y="288"/>
                  <a:pt x="1306" y="274"/>
                  <a:pt x="1288" y="255"/>
                </a:cubicBezTo>
                <a:cubicBezTo>
                  <a:pt x="1270" y="237"/>
                  <a:pt x="1256" y="219"/>
                  <a:pt x="1247" y="200"/>
                </a:cubicBezTo>
                <a:cubicBezTo>
                  <a:pt x="1237" y="182"/>
                  <a:pt x="1232" y="163"/>
                  <a:pt x="1231" y="145"/>
                </a:cubicBezTo>
                <a:cubicBezTo>
                  <a:pt x="1229" y="126"/>
                  <a:pt x="1232" y="108"/>
                  <a:pt x="1239" y="91"/>
                </a:cubicBezTo>
                <a:cubicBezTo>
                  <a:pt x="1246" y="73"/>
                  <a:pt x="1257" y="57"/>
                  <a:pt x="1272" y="42"/>
                </a:cubicBezTo>
                <a:cubicBezTo>
                  <a:pt x="1289" y="25"/>
                  <a:pt x="1305" y="14"/>
                  <a:pt x="1322" y="8"/>
                </a:cubicBezTo>
                <a:cubicBezTo>
                  <a:pt x="1338" y="2"/>
                  <a:pt x="1355" y="0"/>
                  <a:pt x="1371" y="1"/>
                </a:cubicBezTo>
                <a:cubicBezTo>
                  <a:pt x="1387" y="2"/>
                  <a:pt x="1403" y="7"/>
                  <a:pt x="1418" y="16"/>
                </a:cubicBezTo>
                <a:cubicBezTo>
                  <a:pt x="1433" y="24"/>
                  <a:pt x="1447" y="35"/>
                  <a:pt x="1461" y="49"/>
                </a:cubicBezTo>
                <a:lnTo>
                  <a:pt x="1468" y="55"/>
                </a:lnTo>
                <a:close/>
                <a:moveTo>
                  <a:pt x="1418" y="82"/>
                </a:moveTo>
                <a:cubicBezTo>
                  <a:pt x="1399" y="62"/>
                  <a:pt x="1379" y="51"/>
                  <a:pt x="1358" y="49"/>
                </a:cubicBezTo>
                <a:cubicBezTo>
                  <a:pt x="1338" y="47"/>
                  <a:pt x="1318" y="55"/>
                  <a:pt x="1300" y="73"/>
                </a:cubicBezTo>
                <a:cubicBezTo>
                  <a:pt x="1291" y="83"/>
                  <a:pt x="1284" y="93"/>
                  <a:pt x="1281" y="103"/>
                </a:cubicBezTo>
                <a:cubicBezTo>
                  <a:pt x="1277" y="114"/>
                  <a:pt x="1276" y="124"/>
                  <a:pt x="1277" y="135"/>
                </a:cubicBezTo>
                <a:cubicBezTo>
                  <a:pt x="1278" y="145"/>
                  <a:pt x="1281" y="156"/>
                  <a:pt x="1286" y="166"/>
                </a:cubicBezTo>
                <a:cubicBezTo>
                  <a:pt x="1291" y="177"/>
                  <a:pt x="1298" y="186"/>
                  <a:pt x="1306" y="195"/>
                </a:cubicBezTo>
                <a:lnTo>
                  <a:pt x="1418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5" name="Freeform 259"/>
          <p:cNvSpPr>
            <a:spLocks noEditPoints="1"/>
          </p:cNvSpPr>
          <p:nvPr/>
        </p:nvSpPr>
        <p:spPr bwMode="auto">
          <a:xfrm>
            <a:off x="4204564" y="4418880"/>
            <a:ext cx="221447" cy="244475"/>
          </a:xfrm>
          <a:custGeom>
            <a:avLst/>
            <a:gdLst>
              <a:gd name="T0" fmla="*/ 442 w 1390"/>
              <a:gd name="T1" fmla="*/ 1146 h 1289"/>
              <a:gd name="T2" fmla="*/ 277 w 1390"/>
              <a:gd name="T3" fmla="*/ 1280 h 1289"/>
              <a:gd name="T4" fmla="*/ 6 w 1390"/>
              <a:gd name="T5" fmla="*/ 988 h 1289"/>
              <a:gd name="T6" fmla="*/ 38 w 1390"/>
              <a:gd name="T7" fmla="*/ 964 h 1289"/>
              <a:gd name="T8" fmla="*/ 410 w 1390"/>
              <a:gd name="T9" fmla="*/ 1114 h 1289"/>
              <a:gd name="T10" fmla="*/ 581 w 1390"/>
              <a:gd name="T11" fmla="*/ 1008 h 1289"/>
              <a:gd name="T12" fmla="*/ 603 w 1390"/>
              <a:gd name="T13" fmla="*/ 1153 h 1289"/>
              <a:gd name="T14" fmla="*/ 542 w 1390"/>
              <a:gd name="T15" fmla="*/ 1048 h 1289"/>
              <a:gd name="T16" fmla="*/ 248 w 1390"/>
              <a:gd name="T17" fmla="*/ 918 h 1289"/>
              <a:gd name="T18" fmla="*/ 271 w 1390"/>
              <a:gd name="T19" fmla="*/ 881 h 1289"/>
              <a:gd name="T20" fmla="*/ 515 w 1390"/>
              <a:gd name="T21" fmla="*/ 985 h 1289"/>
              <a:gd name="T22" fmla="*/ 408 w 1390"/>
              <a:gd name="T23" fmla="*/ 744 h 1289"/>
              <a:gd name="T24" fmla="*/ 445 w 1390"/>
              <a:gd name="T25" fmla="*/ 721 h 1289"/>
              <a:gd name="T26" fmla="*/ 792 w 1390"/>
              <a:gd name="T27" fmla="*/ 730 h 1289"/>
              <a:gd name="T28" fmla="*/ 732 w 1390"/>
              <a:gd name="T29" fmla="*/ 863 h 1289"/>
              <a:gd name="T30" fmla="*/ 668 w 1390"/>
              <a:gd name="T31" fmla="*/ 884 h 1289"/>
              <a:gd name="T32" fmla="*/ 644 w 1390"/>
              <a:gd name="T33" fmla="*/ 856 h 1289"/>
              <a:gd name="T34" fmla="*/ 700 w 1390"/>
              <a:gd name="T35" fmla="*/ 832 h 1289"/>
              <a:gd name="T36" fmla="*/ 747 w 1390"/>
              <a:gd name="T37" fmla="*/ 754 h 1289"/>
              <a:gd name="T38" fmla="*/ 669 w 1390"/>
              <a:gd name="T39" fmla="*/ 736 h 1289"/>
              <a:gd name="T40" fmla="*/ 558 w 1390"/>
              <a:gd name="T41" fmla="*/ 757 h 1289"/>
              <a:gd name="T42" fmla="*/ 516 w 1390"/>
              <a:gd name="T43" fmla="*/ 639 h 1289"/>
              <a:gd name="T44" fmla="*/ 596 w 1390"/>
              <a:gd name="T45" fmla="*/ 568 h 1289"/>
              <a:gd name="T46" fmla="*/ 622 w 1390"/>
              <a:gd name="T47" fmla="*/ 571 h 1289"/>
              <a:gd name="T48" fmla="*/ 640 w 1390"/>
              <a:gd name="T49" fmla="*/ 594 h 1289"/>
              <a:gd name="T50" fmla="*/ 594 w 1390"/>
              <a:gd name="T51" fmla="*/ 615 h 1289"/>
              <a:gd name="T52" fmla="*/ 554 w 1390"/>
              <a:gd name="T53" fmla="*/ 685 h 1289"/>
              <a:gd name="T54" fmla="*/ 631 w 1390"/>
              <a:gd name="T55" fmla="*/ 700 h 1289"/>
              <a:gd name="T56" fmla="*/ 742 w 1390"/>
              <a:gd name="T57" fmla="*/ 678 h 1289"/>
              <a:gd name="T58" fmla="*/ 917 w 1390"/>
              <a:gd name="T59" fmla="*/ 672 h 1289"/>
              <a:gd name="T60" fmla="*/ 886 w 1390"/>
              <a:gd name="T61" fmla="*/ 702 h 1289"/>
              <a:gd name="T62" fmla="*/ 669 w 1390"/>
              <a:gd name="T63" fmla="*/ 491 h 1289"/>
              <a:gd name="T64" fmla="*/ 693 w 1390"/>
              <a:gd name="T65" fmla="*/ 460 h 1289"/>
              <a:gd name="T66" fmla="*/ 915 w 1390"/>
              <a:gd name="T67" fmla="*/ 663 h 1289"/>
              <a:gd name="T68" fmla="*/ 620 w 1390"/>
              <a:gd name="T69" fmla="*/ 443 h 1289"/>
              <a:gd name="T70" fmla="*/ 621 w 1390"/>
              <a:gd name="T71" fmla="*/ 370 h 1289"/>
              <a:gd name="T72" fmla="*/ 1164 w 1390"/>
              <a:gd name="T73" fmla="*/ 425 h 1289"/>
              <a:gd name="T74" fmla="*/ 1134 w 1390"/>
              <a:gd name="T75" fmla="*/ 455 h 1289"/>
              <a:gd name="T76" fmla="*/ 973 w 1390"/>
              <a:gd name="T77" fmla="*/ 307 h 1289"/>
              <a:gd name="T78" fmla="*/ 879 w 1390"/>
              <a:gd name="T79" fmla="*/ 352 h 1289"/>
              <a:gd name="T80" fmla="*/ 1024 w 1390"/>
              <a:gd name="T81" fmla="*/ 565 h 1289"/>
              <a:gd name="T82" fmla="*/ 994 w 1390"/>
              <a:gd name="T83" fmla="*/ 595 h 1289"/>
              <a:gd name="T84" fmla="*/ 776 w 1390"/>
              <a:gd name="T85" fmla="*/ 383 h 1289"/>
              <a:gd name="T86" fmla="*/ 797 w 1390"/>
              <a:gd name="T87" fmla="*/ 355 h 1289"/>
              <a:gd name="T88" fmla="*/ 840 w 1390"/>
              <a:gd name="T89" fmla="*/ 380 h 1289"/>
              <a:gd name="T90" fmla="*/ 955 w 1390"/>
              <a:gd name="T91" fmla="*/ 241 h 1289"/>
              <a:gd name="T92" fmla="*/ 1298 w 1390"/>
              <a:gd name="T93" fmla="*/ 56 h 1289"/>
              <a:gd name="T94" fmla="*/ 1198 w 1390"/>
              <a:gd name="T95" fmla="*/ 251 h 1289"/>
              <a:gd name="T96" fmla="*/ 1330 w 1390"/>
              <a:gd name="T97" fmla="*/ 202 h 1289"/>
              <a:gd name="T98" fmla="*/ 1362 w 1390"/>
              <a:gd name="T99" fmla="*/ 145 h 1289"/>
              <a:gd name="T100" fmla="*/ 1385 w 1390"/>
              <a:gd name="T101" fmla="*/ 161 h 1289"/>
              <a:gd name="T102" fmla="*/ 1387 w 1390"/>
              <a:gd name="T103" fmla="*/ 186 h 1289"/>
              <a:gd name="T104" fmla="*/ 1282 w 1390"/>
              <a:gd name="T105" fmla="*/ 303 h 1289"/>
              <a:gd name="T106" fmla="*/ 1077 w 1390"/>
              <a:gd name="T107" fmla="*/ 201 h 1289"/>
              <a:gd name="T108" fmla="*/ 1152 w 1390"/>
              <a:gd name="T109" fmla="*/ 9 h 1289"/>
              <a:gd name="T110" fmla="*/ 1298 w 1390"/>
              <a:gd name="T111" fmla="*/ 56 h 1289"/>
              <a:gd name="T112" fmla="*/ 1111 w 1390"/>
              <a:gd name="T113" fmla="*/ 104 h 1289"/>
              <a:gd name="T114" fmla="*/ 1248 w 1390"/>
              <a:gd name="T115" fmla="*/ 83 h 12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390" h="1289">
                <a:moveTo>
                  <a:pt x="430" y="1125"/>
                </a:moveTo>
                <a:cubicBezTo>
                  <a:pt x="433" y="1128"/>
                  <a:pt x="436" y="1131"/>
                  <a:pt x="437" y="1133"/>
                </a:cubicBezTo>
                <a:cubicBezTo>
                  <a:pt x="439" y="1136"/>
                  <a:pt x="440" y="1138"/>
                  <a:pt x="441" y="1140"/>
                </a:cubicBezTo>
                <a:cubicBezTo>
                  <a:pt x="442" y="1142"/>
                  <a:pt x="442" y="1144"/>
                  <a:pt x="442" y="1146"/>
                </a:cubicBezTo>
                <a:cubicBezTo>
                  <a:pt x="442" y="1147"/>
                  <a:pt x="441" y="1149"/>
                  <a:pt x="439" y="1150"/>
                </a:cubicBezTo>
                <a:lnTo>
                  <a:pt x="308" y="1281"/>
                </a:lnTo>
                <a:cubicBezTo>
                  <a:pt x="305" y="1285"/>
                  <a:pt x="300" y="1287"/>
                  <a:pt x="295" y="1288"/>
                </a:cubicBezTo>
                <a:cubicBezTo>
                  <a:pt x="289" y="1289"/>
                  <a:pt x="283" y="1286"/>
                  <a:pt x="277" y="1280"/>
                </a:cubicBezTo>
                <a:lnTo>
                  <a:pt x="3" y="1005"/>
                </a:lnTo>
                <a:cubicBezTo>
                  <a:pt x="2" y="1004"/>
                  <a:pt x="1" y="1003"/>
                  <a:pt x="1" y="1001"/>
                </a:cubicBezTo>
                <a:cubicBezTo>
                  <a:pt x="0" y="1000"/>
                  <a:pt x="1" y="998"/>
                  <a:pt x="2" y="996"/>
                </a:cubicBezTo>
                <a:cubicBezTo>
                  <a:pt x="3" y="994"/>
                  <a:pt x="4" y="991"/>
                  <a:pt x="6" y="988"/>
                </a:cubicBezTo>
                <a:cubicBezTo>
                  <a:pt x="9" y="985"/>
                  <a:pt x="12" y="982"/>
                  <a:pt x="15" y="978"/>
                </a:cubicBezTo>
                <a:cubicBezTo>
                  <a:pt x="19" y="975"/>
                  <a:pt x="22" y="972"/>
                  <a:pt x="25" y="969"/>
                </a:cubicBezTo>
                <a:cubicBezTo>
                  <a:pt x="28" y="967"/>
                  <a:pt x="31" y="966"/>
                  <a:pt x="33" y="965"/>
                </a:cubicBezTo>
                <a:cubicBezTo>
                  <a:pt x="35" y="964"/>
                  <a:pt x="37" y="963"/>
                  <a:pt x="38" y="964"/>
                </a:cubicBezTo>
                <a:cubicBezTo>
                  <a:pt x="40" y="964"/>
                  <a:pt x="41" y="965"/>
                  <a:pt x="42" y="966"/>
                </a:cubicBezTo>
                <a:lnTo>
                  <a:pt x="299" y="1223"/>
                </a:lnTo>
                <a:lnTo>
                  <a:pt x="405" y="1116"/>
                </a:lnTo>
                <a:cubicBezTo>
                  <a:pt x="407" y="1115"/>
                  <a:pt x="408" y="1114"/>
                  <a:pt x="410" y="1114"/>
                </a:cubicBezTo>
                <a:cubicBezTo>
                  <a:pt x="411" y="1113"/>
                  <a:pt x="413" y="1113"/>
                  <a:pt x="415" y="1114"/>
                </a:cubicBezTo>
                <a:cubicBezTo>
                  <a:pt x="417" y="1115"/>
                  <a:pt x="419" y="1116"/>
                  <a:pt x="422" y="1118"/>
                </a:cubicBezTo>
                <a:cubicBezTo>
                  <a:pt x="424" y="1120"/>
                  <a:pt x="427" y="1122"/>
                  <a:pt x="430" y="1125"/>
                </a:cubicBezTo>
                <a:close/>
                <a:moveTo>
                  <a:pt x="581" y="1008"/>
                </a:moveTo>
                <a:lnTo>
                  <a:pt x="630" y="1112"/>
                </a:lnTo>
                <a:cubicBezTo>
                  <a:pt x="631" y="1115"/>
                  <a:pt x="631" y="1119"/>
                  <a:pt x="628" y="1124"/>
                </a:cubicBezTo>
                <a:cubicBezTo>
                  <a:pt x="626" y="1130"/>
                  <a:pt x="621" y="1136"/>
                  <a:pt x="613" y="1144"/>
                </a:cubicBezTo>
                <a:cubicBezTo>
                  <a:pt x="609" y="1147"/>
                  <a:pt x="606" y="1151"/>
                  <a:pt x="603" y="1153"/>
                </a:cubicBezTo>
                <a:cubicBezTo>
                  <a:pt x="600" y="1155"/>
                  <a:pt x="597" y="1156"/>
                  <a:pt x="595" y="1156"/>
                </a:cubicBezTo>
                <a:cubicBezTo>
                  <a:pt x="593" y="1157"/>
                  <a:pt x="591" y="1156"/>
                  <a:pt x="589" y="1155"/>
                </a:cubicBezTo>
                <a:cubicBezTo>
                  <a:pt x="588" y="1153"/>
                  <a:pt x="586" y="1151"/>
                  <a:pt x="585" y="1148"/>
                </a:cubicBezTo>
                <a:lnTo>
                  <a:pt x="542" y="1048"/>
                </a:lnTo>
                <a:cubicBezTo>
                  <a:pt x="540" y="1049"/>
                  <a:pt x="537" y="1049"/>
                  <a:pt x="535" y="1049"/>
                </a:cubicBezTo>
                <a:cubicBezTo>
                  <a:pt x="532" y="1049"/>
                  <a:pt x="530" y="1048"/>
                  <a:pt x="528" y="1047"/>
                </a:cubicBezTo>
                <a:lnTo>
                  <a:pt x="257" y="923"/>
                </a:lnTo>
                <a:cubicBezTo>
                  <a:pt x="253" y="921"/>
                  <a:pt x="250" y="920"/>
                  <a:pt x="248" y="918"/>
                </a:cubicBezTo>
                <a:cubicBezTo>
                  <a:pt x="246" y="916"/>
                  <a:pt x="245" y="914"/>
                  <a:pt x="245" y="912"/>
                </a:cubicBezTo>
                <a:cubicBezTo>
                  <a:pt x="245" y="909"/>
                  <a:pt x="247" y="907"/>
                  <a:pt x="249" y="903"/>
                </a:cubicBezTo>
                <a:cubicBezTo>
                  <a:pt x="251" y="900"/>
                  <a:pt x="255" y="896"/>
                  <a:pt x="260" y="892"/>
                </a:cubicBezTo>
                <a:cubicBezTo>
                  <a:pt x="264" y="887"/>
                  <a:pt x="268" y="884"/>
                  <a:pt x="271" y="881"/>
                </a:cubicBezTo>
                <a:cubicBezTo>
                  <a:pt x="273" y="879"/>
                  <a:pt x="276" y="877"/>
                  <a:pt x="278" y="876"/>
                </a:cubicBezTo>
                <a:cubicBezTo>
                  <a:pt x="280" y="876"/>
                  <a:pt x="282" y="875"/>
                  <a:pt x="284" y="876"/>
                </a:cubicBezTo>
                <a:cubicBezTo>
                  <a:pt x="286" y="876"/>
                  <a:pt x="288" y="877"/>
                  <a:pt x="291" y="878"/>
                </a:cubicBezTo>
                <a:lnTo>
                  <a:pt x="515" y="985"/>
                </a:lnTo>
                <a:lnTo>
                  <a:pt x="516" y="984"/>
                </a:lnTo>
                <a:lnTo>
                  <a:pt x="406" y="761"/>
                </a:lnTo>
                <a:cubicBezTo>
                  <a:pt x="404" y="757"/>
                  <a:pt x="404" y="754"/>
                  <a:pt x="404" y="752"/>
                </a:cubicBezTo>
                <a:cubicBezTo>
                  <a:pt x="405" y="750"/>
                  <a:pt x="406" y="747"/>
                  <a:pt x="408" y="744"/>
                </a:cubicBezTo>
                <a:cubicBezTo>
                  <a:pt x="410" y="741"/>
                  <a:pt x="414" y="737"/>
                  <a:pt x="419" y="732"/>
                </a:cubicBezTo>
                <a:cubicBezTo>
                  <a:pt x="423" y="728"/>
                  <a:pt x="427" y="725"/>
                  <a:pt x="430" y="722"/>
                </a:cubicBezTo>
                <a:cubicBezTo>
                  <a:pt x="433" y="720"/>
                  <a:pt x="436" y="719"/>
                  <a:pt x="438" y="719"/>
                </a:cubicBezTo>
                <a:cubicBezTo>
                  <a:pt x="441" y="718"/>
                  <a:pt x="443" y="719"/>
                  <a:pt x="445" y="721"/>
                </a:cubicBezTo>
                <a:cubicBezTo>
                  <a:pt x="446" y="723"/>
                  <a:pt x="448" y="726"/>
                  <a:pt x="450" y="729"/>
                </a:cubicBezTo>
                <a:lnTo>
                  <a:pt x="581" y="1008"/>
                </a:lnTo>
                <a:close/>
                <a:moveTo>
                  <a:pt x="770" y="696"/>
                </a:moveTo>
                <a:cubicBezTo>
                  <a:pt x="780" y="707"/>
                  <a:pt x="788" y="718"/>
                  <a:pt x="792" y="730"/>
                </a:cubicBezTo>
                <a:cubicBezTo>
                  <a:pt x="796" y="742"/>
                  <a:pt x="798" y="755"/>
                  <a:pt x="796" y="768"/>
                </a:cubicBezTo>
                <a:cubicBezTo>
                  <a:pt x="795" y="780"/>
                  <a:pt x="791" y="793"/>
                  <a:pt x="784" y="806"/>
                </a:cubicBezTo>
                <a:cubicBezTo>
                  <a:pt x="776" y="819"/>
                  <a:pt x="767" y="831"/>
                  <a:pt x="755" y="843"/>
                </a:cubicBezTo>
                <a:cubicBezTo>
                  <a:pt x="748" y="851"/>
                  <a:pt x="740" y="857"/>
                  <a:pt x="732" y="863"/>
                </a:cubicBezTo>
                <a:cubicBezTo>
                  <a:pt x="725" y="868"/>
                  <a:pt x="717" y="873"/>
                  <a:pt x="710" y="876"/>
                </a:cubicBezTo>
                <a:cubicBezTo>
                  <a:pt x="703" y="880"/>
                  <a:pt x="697" y="882"/>
                  <a:pt x="691" y="884"/>
                </a:cubicBezTo>
                <a:cubicBezTo>
                  <a:pt x="686" y="886"/>
                  <a:pt x="681" y="887"/>
                  <a:pt x="678" y="887"/>
                </a:cubicBezTo>
                <a:cubicBezTo>
                  <a:pt x="675" y="887"/>
                  <a:pt x="671" y="886"/>
                  <a:pt x="668" y="884"/>
                </a:cubicBezTo>
                <a:cubicBezTo>
                  <a:pt x="664" y="882"/>
                  <a:pt x="660" y="879"/>
                  <a:pt x="656" y="874"/>
                </a:cubicBezTo>
                <a:cubicBezTo>
                  <a:pt x="653" y="871"/>
                  <a:pt x="650" y="868"/>
                  <a:pt x="649" y="866"/>
                </a:cubicBezTo>
                <a:cubicBezTo>
                  <a:pt x="647" y="864"/>
                  <a:pt x="646" y="862"/>
                  <a:pt x="645" y="860"/>
                </a:cubicBezTo>
                <a:cubicBezTo>
                  <a:pt x="644" y="859"/>
                  <a:pt x="644" y="857"/>
                  <a:pt x="644" y="856"/>
                </a:cubicBezTo>
                <a:cubicBezTo>
                  <a:pt x="645" y="854"/>
                  <a:pt x="645" y="853"/>
                  <a:pt x="646" y="852"/>
                </a:cubicBezTo>
                <a:cubicBezTo>
                  <a:pt x="648" y="850"/>
                  <a:pt x="652" y="849"/>
                  <a:pt x="657" y="848"/>
                </a:cubicBezTo>
                <a:cubicBezTo>
                  <a:pt x="662" y="846"/>
                  <a:pt x="669" y="845"/>
                  <a:pt x="676" y="842"/>
                </a:cubicBezTo>
                <a:cubicBezTo>
                  <a:pt x="683" y="840"/>
                  <a:pt x="691" y="836"/>
                  <a:pt x="700" y="832"/>
                </a:cubicBezTo>
                <a:cubicBezTo>
                  <a:pt x="708" y="827"/>
                  <a:pt x="717" y="821"/>
                  <a:pt x="726" y="812"/>
                </a:cubicBezTo>
                <a:cubicBezTo>
                  <a:pt x="732" y="806"/>
                  <a:pt x="737" y="799"/>
                  <a:pt x="741" y="793"/>
                </a:cubicBezTo>
                <a:cubicBezTo>
                  <a:pt x="745" y="786"/>
                  <a:pt x="747" y="780"/>
                  <a:pt x="748" y="773"/>
                </a:cubicBezTo>
                <a:cubicBezTo>
                  <a:pt x="749" y="767"/>
                  <a:pt x="749" y="760"/>
                  <a:pt x="747" y="754"/>
                </a:cubicBezTo>
                <a:cubicBezTo>
                  <a:pt x="745" y="748"/>
                  <a:pt x="741" y="742"/>
                  <a:pt x="735" y="736"/>
                </a:cubicBezTo>
                <a:cubicBezTo>
                  <a:pt x="730" y="731"/>
                  <a:pt x="723" y="727"/>
                  <a:pt x="716" y="726"/>
                </a:cubicBezTo>
                <a:cubicBezTo>
                  <a:pt x="709" y="725"/>
                  <a:pt x="702" y="726"/>
                  <a:pt x="694" y="727"/>
                </a:cubicBezTo>
                <a:cubicBezTo>
                  <a:pt x="686" y="729"/>
                  <a:pt x="678" y="732"/>
                  <a:pt x="669" y="736"/>
                </a:cubicBezTo>
                <a:cubicBezTo>
                  <a:pt x="661" y="740"/>
                  <a:pt x="652" y="743"/>
                  <a:pt x="643" y="747"/>
                </a:cubicBezTo>
                <a:cubicBezTo>
                  <a:pt x="634" y="751"/>
                  <a:pt x="624" y="755"/>
                  <a:pt x="615" y="758"/>
                </a:cubicBezTo>
                <a:cubicBezTo>
                  <a:pt x="606" y="760"/>
                  <a:pt x="596" y="762"/>
                  <a:pt x="586" y="762"/>
                </a:cubicBezTo>
                <a:cubicBezTo>
                  <a:pt x="577" y="762"/>
                  <a:pt x="567" y="761"/>
                  <a:pt x="558" y="757"/>
                </a:cubicBezTo>
                <a:cubicBezTo>
                  <a:pt x="548" y="753"/>
                  <a:pt x="539" y="747"/>
                  <a:pt x="530" y="738"/>
                </a:cubicBezTo>
                <a:cubicBezTo>
                  <a:pt x="521" y="730"/>
                  <a:pt x="515" y="720"/>
                  <a:pt x="511" y="710"/>
                </a:cubicBezTo>
                <a:cubicBezTo>
                  <a:pt x="507" y="699"/>
                  <a:pt x="505" y="688"/>
                  <a:pt x="506" y="676"/>
                </a:cubicBezTo>
                <a:cubicBezTo>
                  <a:pt x="506" y="664"/>
                  <a:pt x="510" y="652"/>
                  <a:pt x="516" y="639"/>
                </a:cubicBezTo>
                <a:cubicBezTo>
                  <a:pt x="522" y="627"/>
                  <a:pt x="531" y="614"/>
                  <a:pt x="543" y="601"/>
                </a:cubicBezTo>
                <a:cubicBezTo>
                  <a:pt x="549" y="596"/>
                  <a:pt x="555" y="591"/>
                  <a:pt x="561" y="586"/>
                </a:cubicBezTo>
                <a:cubicBezTo>
                  <a:pt x="568" y="582"/>
                  <a:pt x="574" y="578"/>
                  <a:pt x="580" y="575"/>
                </a:cubicBezTo>
                <a:cubicBezTo>
                  <a:pt x="586" y="572"/>
                  <a:pt x="591" y="569"/>
                  <a:pt x="596" y="568"/>
                </a:cubicBezTo>
                <a:cubicBezTo>
                  <a:pt x="600" y="566"/>
                  <a:pt x="604" y="565"/>
                  <a:pt x="607" y="565"/>
                </a:cubicBezTo>
                <a:cubicBezTo>
                  <a:pt x="610" y="565"/>
                  <a:pt x="612" y="565"/>
                  <a:pt x="613" y="565"/>
                </a:cubicBezTo>
                <a:cubicBezTo>
                  <a:pt x="615" y="565"/>
                  <a:pt x="616" y="566"/>
                  <a:pt x="618" y="567"/>
                </a:cubicBezTo>
                <a:cubicBezTo>
                  <a:pt x="619" y="568"/>
                  <a:pt x="621" y="569"/>
                  <a:pt x="622" y="571"/>
                </a:cubicBezTo>
                <a:cubicBezTo>
                  <a:pt x="624" y="572"/>
                  <a:pt x="627" y="574"/>
                  <a:pt x="629" y="576"/>
                </a:cubicBezTo>
                <a:cubicBezTo>
                  <a:pt x="632" y="579"/>
                  <a:pt x="634" y="581"/>
                  <a:pt x="635" y="584"/>
                </a:cubicBezTo>
                <a:cubicBezTo>
                  <a:pt x="637" y="586"/>
                  <a:pt x="638" y="588"/>
                  <a:pt x="639" y="589"/>
                </a:cubicBezTo>
                <a:cubicBezTo>
                  <a:pt x="640" y="591"/>
                  <a:pt x="640" y="593"/>
                  <a:pt x="640" y="594"/>
                </a:cubicBezTo>
                <a:cubicBezTo>
                  <a:pt x="639" y="595"/>
                  <a:pt x="639" y="596"/>
                  <a:pt x="638" y="597"/>
                </a:cubicBezTo>
                <a:cubicBezTo>
                  <a:pt x="637" y="599"/>
                  <a:pt x="634" y="600"/>
                  <a:pt x="629" y="601"/>
                </a:cubicBezTo>
                <a:cubicBezTo>
                  <a:pt x="625" y="602"/>
                  <a:pt x="620" y="603"/>
                  <a:pt x="614" y="605"/>
                </a:cubicBezTo>
                <a:cubicBezTo>
                  <a:pt x="608" y="608"/>
                  <a:pt x="601" y="611"/>
                  <a:pt x="594" y="615"/>
                </a:cubicBezTo>
                <a:cubicBezTo>
                  <a:pt x="587" y="618"/>
                  <a:pt x="580" y="624"/>
                  <a:pt x="572" y="631"/>
                </a:cubicBezTo>
                <a:cubicBezTo>
                  <a:pt x="566" y="638"/>
                  <a:pt x="561" y="644"/>
                  <a:pt x="558" y="650"/>
                </a:cubicBezTo>
                <a:cubicBezTo>
                  <a:pt x="554" y="657"/>
                  <a:pt x="552" y="663"/>
                  <a:pt x="552" y="669"/>
                </a:cubicBezTo>
                <a:cubicBezTo>
                  <a:pt x="551" y="674"/>
                  <a:pt x="552" y="680"/>
                  <a:pt x="554" y="685"/>
                </a:cubicBezTo>
                <a:cubicBezTo>
                  <a:pt x="556" y="690"/>
                  <a:pt x="559" y="695"/>
                  <a:pt x="564" y="700"/>
                </a:cubicBezTo>
                <a:cubicBezTo>
                  <a:pt x="570" y="705"/>
                  <a:pt x="576" y="709"/>
                  <a:pt x="583" y="710"/>
                </a:cubicBezTo>
                <a:cubicBezTo>
                  <a:pt x="590" y="711"/>
                  <a:pt x="598" y="711"/>
                  <a:pt x="606" y="709"/>
                </a:cubicBezTo>
                <a:cubicBezTo>
                  <a:pt x="614" y="707"/>
                  <a:pt x="622" y="704"/>
                  <a:pt x="631" y="700"/>
                </a:cubicBezTo>
                <a:cubicBezTo>
                  <a:pt x="640" y="696"/>
                  <a:pt x="648" y="693"/>
                  <a:pt x="658" y="689"/>
                </a:cubicBezTo>
                <a:cubicBezTo>
                  <a:pt x="667" y="685"/>
                  <a:pt x="676" y="681"/>
                  <a:pt x="686" y="678"/>
                </a:cubicBezTo>
                <a:cubicBezTo>
                  <a:pt x="695" y="675"/>
                  <a:pt x="705" y="673"/>
                  <a:pt x="714" y="673"/>
                </a:cubicBezTo>
                <a:cubicBezTo>
                  <a:pt x="724" y="673"/>
                  <a:pt x="733" y="674"/>
                  <a:pt x="742" y="678"/>
                </a:cubicBezTo>
                <a:cubicBezTo>
                  <a:pt x="752" y="681"/>
                  <a:pt x="761" y="687"/>
                  <a:pt x="770" y="696"/>
                </a:cubicBezTo>
                <a:close/>
                <a:moveTo>
                  <a:pt x="915" y="663"/>
                </a:moveTo>
                <a:cubicBezTo>
                  <a:pt x="916" y="664"/>
                  <a:pt x="917" y="665"/>
                  <a:pt x="917" y="667"/>
                </a:cubicBezTo>
                <a:cubicBezTo>
                  <a:pt x="918" y="668"/>
                  <a:pt x="917" y="670"/>
                  <a:pt x="917" y="672"/>
                </a:cubicBezTo>
                <a:cubicBezTo>
                  <a:pt x="916" y="674"/>
                  <a:pt x="914" y="676"/>
                  <a:pt x="912" y="679"/>
                </a:cubicBezTo>
                <a:cubicBezTo>
                  <a:pt x="910" y="682"/>
                  <a:pt x="907" y="685"/>
                  <a:pt x="903" y="689"/>
                </a:cubicBezTo>
                <a:cubicBezTo>
                  <a:pt x="900" y="693"/>
                  <a:pt x="896" y="696"/>
                  <a:pt x="894" y="698"/>
                </a:cubicBezTo>
                <a:cubicBezTo>
                  <a:pt x="891" y="700"/>
                  <a:pt x="889" y="701"/>
                  <a:pt x="886" y="702"/>
                </a:cubicBezTo>
                <a:cubicBezTo>
                  <a:pt x="884" y="703"/>
                  <a:pt x="883" y="703"/>
                  <a:pt x="881" y="703"/>
                </a:cubicBezTo>
                <a:cubicBezTo>
                  <a:pt x="880" y="703"/>
                  <a:pt x="879" y="702"/>
                  <a:pt x="877" y="701"/>
                </a:cubicBezTo>
                <a:lnTo>
                  <a:pt x="671" y="494"/>
                </a:lnTo>
                <a:cubicBezTo>
                  <a:pt x="670" y="493"/>
                  <a:pt x="669" y="492"/>
                  <a:pt x="669" y="491"/>
                </a:cubicBezTo>
                <a:cubicBezTo>
                  <a:pt x="669" y="489"/>
                  <a:pt x="669" y="487"/>
                  <a:pt x="670" y="485"/>
                </a:cubicBezTo>
                <a:cubicBezTo>
                  <a:pt x="670" y="483"/>
                  <a:pt x="672" y="481"/>
                  <a:pt x="674" y="478"/>
                </a:cubicBezTo>
                <a:cubicBezTo>
                  <a:pt x="676" y="475"/>
                  <a:pt x="679" y="472"/>
                  <a:pt x="683" y="469"/>
                </a:cubicBezTo>
                <a:cubicBezTo>
                  <a:pt x="687" y="465"/>
                  <a:pt x="690" y="462"/>
                  <a:pt x="693" y="460"/>
                </a:cubicBezTo>
                <a:cubicBezTo>
                  <a:pt x="695" y="457"/>
                  <a:pt x="698" y="456"/>
                  <a:pt x="700" y="455"/>
                </a:cubicBezTo>
                <a:cubicBezTo>
                  <a:pt x="702" y="454"/>
                  <a:pt x="703" y="454"/>
                  <a:pt x="705" y="455"/>
                </a:cubicBezTo>
                <a:cubicBezTo>
                  <a:pt x="707" y="455"/>
                  <a:pt x="708" y="456"/>
                  <a:pt x="709" y="457"/>
                </a:cubicBezTo>
                <a:lnTo>
                  <a:pt x="915" y="663"/>
                </a:lnTo>
                <a:close/>
                <a:moveTo>
                  <a:pt x="644" y="383"/>
                </a:moveTo>
                <a:cubicBezTo>
                  <a:pt x="652" y="391"/>
                  <a:pt x="657" y="399"/>
                  <a:pt x="657" y="406"/>
                </a:cubicBezTo>
                <a:cubicBezTo>
                  <a:pt x="656" y="412"/>
                  <a:pt x="652" y="420"/>
                  <a:pt x="643" y="429"/>
                </a:cubicBezTo>
                <a:cubicBezTo>
                  <a:pt x="634" y="438"/>
                  <a:pt x="626" y="442"/>
                  <a:pt x="620" y="443"/>
                </a:cubicBezTo>
                <a:cubicBezTo>
                  <a:pt x="614" y="443"/>
                  <a:pt x="606" y="438"/>
                  <a:pt x="597" y="430"/>
                </a:cubicBezTo>
                <a:cubicBezTo>
                  <a:pt x="588" y="421"/>
                  <a:pt x="584" y="413"/>
                  <a:pt x="584" y="407"/>
                </a:cubicBezTo>
                <a:cubicBezTo>
                  <a:pt x="584" y="400"/>
                  <a:pt x="589" y="392"/>
                  <a:pt x="598" y="383"/>
                </a:cubicBezTo>
                <a:cubicBezTo>
                  <a:pt x="607" y="374"/>
                  <a:pt x="614" y="370"/>
                  <a:pt x="621" y="370"/>
                </a:cubicBezTo>
                <a:cubicBezTo>
                  <a:pt x="627" y="370"/>
                  <a:pt x="635" y="374"/>
                  <a:pt x="644" y="383"/>
                </a:cubicBezTo>
                <a:close/>
                <a:moveTo>
                  <a:pt x="1163" y="416"/>
                </a:moveTo>
                <a:cubicBezTo>
                  <a:pt x="1164" y="417"/>
                  <a:pt x="1165" y="418"/>
                  <a:pt x="1165" y="420"/>
                </a:cubicBezTo>
                <a:cubicBezTo>
                  <a:pt x="1165" y="421"/>
                  <a:pt x="1165" y="423"/>
                  <a:pt x="1164" y="425"/>
                </a:cubicBezTo>
                <a:cubicBezTo>
                  <a:pt x="1163" y="427"/>
                  <a:pt x="1162" y="429"/>
                  <a:pt x="1160" y="432"/>
                </a:cubicBezTo>
                <a:cubicBezTo>
                  <a:pt x="1157" y="435"/>
                  <a:pt x="1155" y="438"/>
                  <a:pt x="1151" y="442"/>
                </a:cubicBezTo>
                <a:cubicBezTo>
                  <a:pt x="1147" y="445"/>
                  <a:pt x="1144" y="448"/>
                  <a:pt x="1141" y="450"/>
                </a:cubicBezTo>
                <a:cubicBezTo>
                  <a:pt x="1138" y="453"/>
                  <a:pt x="1136" y="454"/>
                  <a:pt x="1134" y="455"/>
                </a:cubicBezTo>
                <a:cubicBezTo>
                  <a:pt x="1132" y="456"/>
                  <a:pt x="1130" y="456"/>
                  <a:pt x="1129" y="456"/>
                </a:cubicBezTo>
                <a:cubicBezTo>
                  <a:pt x="1127" y="455"/>
                  <a:pt x="1126" y="455"/>
                  <a:pt x="1125" y="453"/>
                </a:cubicBezTo>
                <a:lnTo>
                  <a:pt x="1004" y="333"/>
                </a:lnTo>
                <a:cubicBezTo>
                  <a:pt x="992" y="321"/>
                  <a:pt x="982" y="312"/>
                  <a:pt x="973" y="307"/>
                </a:cubicBezTo>
                <a:cubicBezTo>
                  <a:pt x="964" y="302"/>
                  <a:pt x="955" y="298"/>
                  <a:pt x="946" y="296"/>
                </a:cubicBezTo>
                <a:cubicBezTo>
                  <a:pt x="937" y="295"/>
                  <a:pt x="929" y="295"/>
                  <a:pt x="921" y="298"/>
                </a:cubicBezTo>
                <a:cubicBezTo>
                  <a:pt x="912" y="301"/>
                  <a:pt x="904" y="306"/>
                  <a:pt x="897" y="313"/>
                </a:cubicBezTo>
                <a:cubicBezTo>
                  <a:pt x="888" y="323"/>
                  <a:pt x="882" y="336"/>
                  <a:pt x="879" y="352"/>
                </a:cubicBezTo>
                <a:cubicBezTo>
                  <a:pt x="876" y="368"/>
                  <a:pt x="876" y="388"/>
                  <a:pt x="879" y="411"/>
                </a:cubicBezTo>
                <a:lnTo>
                  <a:pt x="1023" y="555"/>
                </a:lnTo>
                <a:cubicBezTo>
                  <a:pt x="1024" y="557"/>
                  <a:pt x="1025" y="558"/>
                  <a:pt x="1025" y="559"/>
                </a:cubicBezTo>
                <a:cubicBezTo>
                  <a:pt x="1025" y="561"/>
                  <a:pt x="1025" y="563"/>
                  <a:pt x="1024" y="565"/>
                </a:cubicBezTo>
                <a:cubicBezTo>
                  <a:pt x="1023" y="567"/>
                  <a:pt x="1022" y="569"/>
                  <a:pt x="1020" y="572"/>
                </a:cubicBezTo>
                <a:cubicBezTo>
                  <a:pt x="1018" y="574"/>
                  <a:pt x="1015" y="578"/>
                  <a:pt x="1011" y="582"/>
                </a:cubicBezTo>
                <a:cubicBezTo>
                  <a:pt x="1007" y="585"/>
                  <a:pt x="1004" y="588"/>
                  <a:pt x="1001" y="590"/>
                </a:cubicBezTo>
                <a:cubicBezTo>
                  <a:pt x="998" y="592"/>
                  <a:pt x="996" y="594"/>
                  <a:pt x="994" y="595"/>
                </a:cubicBezTo>
                <a:cubicBezTo>
                  <a:pt x="992" y="596"/>
                  <a:pt x="990" y="596"/>
                  <a:pt x="989" y="596"/>
                </a:cubicBezTo>
                <a:cubicBezTo>
                  <a:pt x="987" y="595"/>
                  <a:pt x="986" y="595"/>
                  <a:pt x="985" y="593"/>
                </a:cubicBezTo>
                <a:lnTo>
                  <a:pt x="779" y="387"/>
                </a:lnTo>
                <a:cubicBezTo>
                  <a:pt x="777" y="386"/>
                  <a:pt x="777" y="384"/>
                  <a:pt x="776" y="383"/>
                </a:cubicBezTo>
                <a:cubicBezTo>
                  <a:pt x="776" y="382"/>
                  <a:pt x="776" y="380"/>
                  <a:pt x="777" y="378"/>
                </a:cubicBezTo>
                <a:cubicBezTo>
                  <a:pt x="777" y="376"/>
                  <a:pt x="779" y="374"/>
                  <a:pt x="781" y="371"/>
                </a:cubicBezTo>
                <a:cubicBezTo>
                  <a:pt x="782" y="369"/>
                  <a:pt x="785" y="366"/>
                  <a:pt x="789" y="363"/>
                </a:cubicBezTo>
                <a:cubicBezTo>
                  <a:pt x="792" y="359"/>
                  <a:pt x="795" y="357"/>
                  <a:pt x="797" y="355"/>
                </a:cubicBezTo>
                <a:cubicBezTo>
                  <a:pt x="800" y="353"/>
                  <a:pt x="802" y="351"/>
                  <a:pt x="804" y="351"/>
                </a:cubicBezTo>
                <a:cubicBezTo>
                  <a:pt x="806" y="350"/>
                  <a:pt x="807" y="350"/>
                  <a:pt x="809" y="351"/>
                </a:cubicBezTo>
                <a:cubicBezTo>
                  <a:pt x="810" y="351"/>
                  <a:pt x="812" y="352"/>
                  <a:pt x="813" y="353"/>
                </a:cubicBezTo>
                <a:lnTo>
                  <a:pt x="840" y="380"/>
                </a:lnTo>
                <a:cubicBezTo>
                  <a:pt x="839" y="355"/>
                  <a:pt x="841" y="334"/>
                  <a:pt x="846" y="317"/>
                </a:cubicBezTo>
                <a:cubicBezTo>
                  <a:pt x="852" y="299"/>
                  <a:pt x="860" y="285"/>
                  <a:pt x="872" y="273"/>
                </a:cubicBezTo>
                <a:cubicBezTo>
                  <a:pt x="886" y="259"/>
                  <a:pt x="900" y="250"/>
                  <a:pt x="914" y="245"/>
                </a:cubicBezTo>
                <a:cubicBezTo>
                  <a:pt x="928" y="240"/>
                  <a:pt x="942" y="239"/>
                  <a:pt x="955" y="241"/>
                </a:cubicBezTo>
                <a:cubicBezTo>
                  <a:pt x="969" y="243"/>
                  <a:pt x="982" y="248"/>
                  <a:pt x="995" y="256"/>
                </a:cubicBezTo>
                <a:cubicBezTo>
                  <a:pt x="1008" y="264"/>
                  <a:pt x="1022" y="275"/>
                  <a:pt x="1037" y="290"/>
                </a:cubicBezTo>
                <a:lnTo>
                  <a:pt x="1163" y="416"/>
                </a:lnTo>
                <a:close/>
                <a:moveTo>
                  <a:pt x="1298" y="56"/>
                </a:moveTo>
                <a:cubicBezTo>
                  <a:pt x="1304" y="62"/>
                  <a:pt x="1306" y="68"/>
                  <a:pt x="1306" y="73"/>
                </a:cubicBezTo>
                <a:cubicBezTo>
                  <a:pt x="1306" y="79"/>
                  <a:pt x="1303" y="84"/>
                  <a:pt x="1300" y="87"/>
                </a:cubicBezTo>
                <a:lnTo>
                  <a:pt x="1164" y="223"/>
                </a:lnTo>
                <a:cubicBezTo>
                  <a:pt x="1175" y="235"/>
                  <a:pt x="1187" y="244"/>
                  <a:pt x="1198" y="251"/>
                </a:cubicBezTo>
                <a:cubicBezTo>
                  <a:pt x="1210" y="258"/>
                  <a:pt x="1221" y="262"/>
                  <a:pt x="1233" y="263"/>
                </a:cubicBezTo>
                <a:cubicBezTo>
                  <a:pt x="1245" y="264"/>
                  <a:pt x="1257" y="262"/>
                  <a:pt x="1269" y="257"/>
                </a:cubicBezTo>
                <a:cubicBezTo>
                  <a:pt x="1281" y="252"/>
                  <a:pt x="1294" y="243"/>
                  <a:pt x="1306" y="231"/>
                </a:cubicBezTo>
                <a:cubicBezTo>
                  <a:pt x="1316" y="221"/>
                  <a:pt x="1324" y="211"/>
                  <a:pt x="1330" y="202"/>
                </a:cubicBezTo>
                <a:cubicBezTo>
                  <a:pt x="1336" y="193"/>
                  <a:pt x="1341" y="184"/>
                  <a:pt x="1345" y="177"/>
                </a:cubicBezTo>
                <a:cubicBezTo>
                  <a:pt x="1348" y="169"/>
                  <a:pt x="1351" y="163"/>
                  <a:pt x="1353" y="158"/>
                </a:cubicBezTo>
                <a:cubicBezTo>
                  <a:pt x="1355" y="152"/>
                  <a:pt x="1357" y="149"/>
                  <a:pt x="1359" y="147"/>
                </a:cubicBezTo>
                <a:cubicBezTo>
                  <a:pt x="1360" y="146"/>
                  <a:pt x="1361" y="145"/>
                  <a:pt x="1362" y="145"/>
                </a:cubicBezTo>
                <a:cubicBezTo>
                  <a:pt x="1364" y="145"/>
                  <a:pt x="1365" y="145"/>
                  <a:pt x="1367" y="145"/>
                </a:cubicBezTo>
                <a:cubicBezTo>
                  <a:pt x="1368" y="146"/>
                  <a:pt x="1370" y="147"/>
                  <a:pt x="1372" y="149"/>
                </a:cubicBezTo>
                <a:cubicBezTo>
                  <a:pt x="1374" y="151"/>
                  <a:pt x="1377" y="153"/>
                  <a:pt x="1380" y="155"/>
                </a:cubicBezTo>
                <a:cubicBezTo>
                  <a:pt x="1382" y="157"/>
                  <a:pt x="1383" y="159"/>
                  <a:pt x="1385" y="161"/>
                </a:cubicBezTo>
                <a:cubicBezTo>
                  <a:pt x="1386" y="162"/>
                  <a:pt x="1387" y="164"/>
                  <a:pt x="1388" y="165"/>
                </a:cubicBezTo>
                <a:cubicBezTo>
                  <a:pt x="1389" y="167"/>
                  <a:pt x="1389" y="168"/>
                  <a:pt x="1390" y="170"/>
                </a:cubicBezTo>
                <a:cubicBezTo>
                  <a:pt x="1390" y="171"/>
                  <a:pt x="1390" y="173"/>
                  <a:pt x="1390" y="174"/>
                </a:cubicBezTo>
                <a:cubicBezTo>
                  <a:pt x="1390" y="176"/>
                  <a:pt x="1389" y="180"/>
                  <a:pt x="1387" y="186"/>
                </a:cubicBezTo>
                <a:cubicBezTo>
                  <a:pt x="1385" y="192"/>
                  <a:pt x="1381" y="199"/>
                  <a:pt x="1377" y="208"/>
                </a:cubicBezTo>
                <a:cubicBezTo>
                  <a:pt x="1372" y="216"/>
                  <a:pt x="1366" y="225"/>
                  <a:pt x="1359" y="235"/>
                </a:cubicBezTo>
                <a:cubicBezTo>
                  <a:pt x="1352" y="245"/>
                  <a:pt x="1343" y="255"/>
                  <a:pt x="1333" y="265"/>
                </a:cubicBezTo>
                <a:cubicBezTo>
                  <a:pt x="1316" y="282"/>
                  <a:pt x="1299" y="295"/>
                  <a:pt x="1282" y="303"/>
                </a:cubicBezTo>
                <a:cubicBezTo>
                  <a:pt x="1264" y="311"/>
                  <a:pt x="1246" y="314"/>
                  <a:pt x="1228" y="314"/>
                </a:cubicBezTo>
                <a:cubicBezTo>
                  <a:pt x="1210" y="313"/>
                  <a:pt x="1192" y="308"/>
                  <a:pt x="1174" y="298"/>
                </a:cubicBezTo>
                <a:cubicBezTo>
                  <a:pt x="1155" y="289"/>
                  <a:pt x="1136" y="275"/>
                  <a:pt x="1118" y="256"/>
                </a:cubicBezTo>
                <a:cubicBezTo>
                  <a:pt x="1100" y="238"/>
                  <a:pt x="1086" y="220"/>
                  <a:pt x="1077" y="201"/>
                </a:cubicBezTo>
                <a:cubicBezTo>
                  <a:pt x="1067" y="182"/>
                  <a:pt x="1062" y="164"/>
                  <a:pt x="1061" y="145"/>
                </a:cubicBezTo>
                <a:cubicBezTo>
                  <a:pt x="1059" y="127"/>
                  <a:pt x="1062" y="109"/>
                  <a:pt x="1069" y="91"/>
                </a:cubicBezTo>
                <a:cubicBezTo>
                  <a:pt x="1076" y="74"/>
                  <a:pt x="1087" y="58"/>
                  <a:pt x="1102" y="42"/>
                </a:cubicBezTo>
                <a:cubicBezTo>
                  <a:pt x="1119" y="26"/>
                  <a:pt x="1135" y="15"/>
                  <a:pt x="1152" y="9"/>
                </a:cubicBezTo>
                <a:cubicBezTo>
                  <a:pt x="1168" y="3"/>
                  <a:pt x="1185" y="0"/>
                  <a:pt x="1201" y="2"/>
                </a:cubicBezTo>
                <a:cubicBezTo>
                  <a:pt x="1217" y="3"/>
                  <a:pt x="1233" y="8"/>
                  <a:pt x="1248" y="17"/>
                </a:cubicBezTo>
                <a:cubicBezTo>
                  <a:pt x="1263" y="25"/>
                  <a:pt x="1277" y="36"/>
                  <a:pt x="1291" y="49"/>
                </a:cubicBezTo>
                <a:lnTo>
                  <a:pt x="1298" y="56"/>
                </a:lnTo>
                <a:close/>
                <a:moveTo>
                  <a:pt x="1248" y="83"/>
                </a:moveTo>
                <a:cubicBezTo>
                  <a:pt x="1229" y="63"/>
                  <a:pt x="1209" y="52"/>
                  <a:pt x="1188" y="50"/>
                </a:cubicBezTo>
                <a:cubicBezTo>
                  <a:pt x="1168" y="48"/>
                  <a:pt x="1148" y="56"/>
                  <a:pt x="1130" y="74"/>
                </a:cubicBezTo>
                <a:cubicBezTo>
                  <a:pt x="1121" y="83"/>
                  <a:pt x="1114" y="93"/>
                  <a:pt x="1111" y="104"/>
                </a:cubicBezTo>
                <a:cubicBezTo>
                  <a:pt x="1107" y="115"/>
                  <a:pt x="1106" y="125"/>
                  <a:pt x="1107" y="136"/>
                </a:cubicBezTo>
                <a:cubicBezTo>
                  <a:pt x="1108" y="146"/>
                  <a:pt x="1111" y="157"/>
                  <a:pt x="1116" y="167"/>
                </a:cubicBezTo>
                <a:cubicBezTo>
                  <a:pt x="1121" y="177"/>
                  <a:pt x="1128" y="187"/>
                  <a:pt x="1136" y="196"/>
                </a:cubicBezTo>
                <a:lnTo>
                  <a:pt x="1248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6" name="Freeform 260"/>
          <p:cNvSpPr>
            <a:spLocks noEditPoints="1"/>
          </p:cNvSpPr>
          <p:nvPr/>
        </p:nvSpPr>
        <p:spPr bwMode="auto">
          <a:xfrm>
            <a:off x="4382252" y="4418880"/>
            <a:ext cx="265205" cy="300038"/>
          </a:xfrm>
          <a:custGeom>
            <a:avLst/>
            <a:gdLst>
              <a:gd name="T0" fmla="*/ 439 w 1673"/>
              <a:gd name="T1" fmla="*/ 1433 h 1572"/>
              <a:gd name="T2" fmla="*/ 0 w 1673"/>
              <a:gd name="T3" fmla="*/ 1284 h 1572"/>
              <a:gd name="T4" fmla="*/ 33 w 1673"/>
              <a:gd name="T5" fmla="*/ 1248 h 1572"/>
              <a:gd name="T6" fmla="*/ 410 w 1673"/>
              <a:gd name="T7" fmla="*/ 1397 h 1572"/>
              <a:gd name="T8" fmla="*/ 553 w 1673"/>
              <a:gd name="T9" fmla="*/ 1109 h 1572"/>
              <a:gd name="T10" fmla="*/ 517 w 1673"/>
              <a:gd name="T11" fmla="*/ 1292 h 1572"/>
              <a:gd name="T12" fmla="*/ 606 w 1673"/>
              <a:gd name="T13" fmla="*/ 1182 h 1572"/>
              <a:gd name="T14" fmla="*/ 632 w 1673"/>
              <a:gd name="T15" fmla="*/ 1196 h 1572"/>
              <a:gd name="T16" fmla="*/ 624 w 1673"/>
              <a:gd name="T17" fmla="*/ 1243 h 1572"/>
              <a:gd name="T18" fmla="*/ 421 w 1673"/>
              <a:gd name="T19" fmla="*/ 1334 h 1572"/>
              <a:gd name="T20" fmla="*/ 350 w 1673"/>
              <a:gd name="T21" fmla="*/ 1078 h 1572"/>
              <a:gd name="T22" fmla="*/ 545 w 1673"/>
              <a:gd name="T23" fmla="*/ 1092 h 1572"/>
              <a:gd name="T24" fmla="*/ 354 w 1673"/>
              <a:gd name="T25" fmla="*/ 1171 h 1572"/>
              <a:gd name="T26" fmla="*/ 898 w 1673"/>
              <a:gd name="T27" fmla="*/ 969 h 1572"/>
              <a:gd name="T28" fmla="*/ 870 w 1673"/>
              <a:gd name="T29" fmla="*/ 1002 h 1572"/>
              <a:gd name="T30" fmla="*/ 802 w 1673"/>
              <a:gd name="T31" fmla="*/ 1080 h 1572"/>
              <a:gd name="T32" fmla="*/ 511 w 1673"/>
              <a:gd name="T33" fmla="*/ 937 h 1572"/>
              <a:gd name="T34" fmla="*/ 533 w 1673"/>
              <a:gd name="T35" fmla="*/ 902 h 1572"/>
              <a:gd name="T36" fmla="*/ 701 w 1673"/>
              <a:gd name="T37" fmla="*/ 1045 h 1572"/>
              <a:gd name="T38" fmla="*/ 795 w 1673"/>
              <a:gd name="T39" fmla="*/ 941 h 1572"/>
              <a:gd name="T40" fmla="*/ 663 w 1673"/>
              <a:gd name="T41" fmla="*/ 771 h 1572"/>
              <a:gd name="T42" fmla="*/ 896 w 1673"/>
              <a:gd name="T43" fmla="*/ 965 h 1572"/>
              <a:gd name="T44" fmla="*/ 1092 w 1673"/>
              <a:gd name="T45" fmla="*/ 745 h 1572"/>
              <a:gd name="T46" fmla="*/ 1003 w 1673"/>
              <a:gd name="T47" fmla="*/ 864 h 1572"/>
              <a:gd name="T48" fmla="*/ 787 w 1673"/>
              <a:gd name="T49" fmla="*/ 697 h 1572"/>
              <a:gd name="T50" fmla="*/ 891 w 1673"/>
              <a:gd name="T51" fmla="*/ 564 h 1572"/>
              <a:gd name="T52" fmla="*/ 933 w 1673"/>
              <a:gd name="T53" fmla="*/ 575 h 1572"/>
              <a:gd name="T54" fmla="*/ 886 w 1673"/>
              <a:gd name="T55" fmla="*/ 614 h 1572"/>
              <a:gd name="T56" fmla="*/ 959 w 1673"/>
              <a:gd name="T57" fmla="*/ 816 h 1572"/>
              <a:gd name="T58" fmla="*/ 1052 w 1673"/>
              <a:gd name="T59" fmla="*/ 720 h 1572"/>
              <a:gd name="T60" fmla="*/ 1079 w 1673"/>
              <a:gd name="T61" fmla="*/ 719 h 1572"/>
              <a:gd name="T62" fmla="*/ 1192 w 1673"/>
              <a:gd name="T63" fmla="*/ 684 h 1572"/>
              <a:gd name="T64" fmla="*/ 959 w 1673"/>
              <a:gd name="T65" fmla="*/ 489 h 1572"/>
              <a:gd name="T66" fmla="*/ 981 w 1673"/>
              <a:gd name="T67" fmla="*/ 454 h 1572"/>
              <a:gd name="T68" fmla="*/ 932 w 1673"/>
              <a:gd name="T69" fmla="*/ 377 h 1572"/>
              <a:gd name="T70" fmla="*/ 872 w 1673"/>
              <a:gd name="T71" fmla="*/ 401 h 1572"/>
              <a:gd name="T72" fmla="*/ 1453 w 1673"/>
              <a:gd name="T73" fmla="*/ 414 h 1572"/>
              <a:gd name="T74" fmla="*/ 1422 w 1673"/>
              <a:gd name="T75" fmla="*/ 449 h 1572"/>
              <a:gd name="T76" fmla="*/ 1234 w 1673"/>
              <a:gd name="T77" fmla="*/ 291 h 1572"/>
              <a:gd name="T78" fmla="*/ 1311 w 1673"/>
              <a:gd name="T79" fmla="*/ 550 h 1572"/>
              <a:gd name="T80" fmla="*/ 1289 w 1673"/>
              <a:gd name="T81" fmla="*/ 585 h 1572"/>
              <a:gd name="T82" fmla="*/ 1064 w 1673"/>
              <a:gd name="T83" fmla="*/ 378 h 1572"/>
              <a:gd name="T84" fmla="*/ 1092 w 1673"/>
              <a:gd name="T85" fmla="*/ 345 h 1572"/>
              <a:gd name="T86" fmla="*/ 1160 w 1673"/>
              <a:gd name="T87" fmla="*/ 267 h 1572"/>
              <a:gd name="T88" fmla="*/ 1451 w 1673"/>
              <a:gd name="T89" fmla="*/ 410 h 1572"/>
              <a:gd name="T90" fmla="*/ 1481 w 1673"/>
              <a:gd name="T91" fmla="*/ 251 h 1572"/>
              <a:gd name="T92" fmla="*/ 1627 w 1673"/>
              <a:gd name="T93" fmla="*/ 177 h 1572"/>
              <a:gd name="T94" fmla="*/ 1655 w 1673"/>
              <a:gd name="T95" fmla="*/ 149 h 1572"/>
              <a:gd name="T96" fmla="*/ 1673 w 1673"/>
              <a:gd name="T97" fmla="*/ 174 h 1572"/>
              <a:gd name="T98" fmla="*/ 1564 w 1673"/>
              <a:gd name="T99" fmla="*/ 303 h 1572"/>
              <a:gd name="T100" fmla="*/ 1343 w 1673"/>
              <a:gd name="T101" fmla="*/ 146 h 1572"/>
              <a:gd name="T102" fmla="*/ 1530 w 1673"/>
              <a:gd name="T103" fmla="*/ 17 h 1572"/>
              <a:gd name="T104" fmla="*/ 1413 w 1673"/>
              <a:gd name="T105" fmla="*/ 74 h 1572"/>
              <a:gd name="T106" fmla="*/ 1531 w 1673"/>
              <a:gd name="T107" fmla="*/ 83 h 1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673" h="1572">
                <a:moveTo>
                  <a:pt x="430" y="1408"/>
                </a:moveTo>
                <a:cubicBezTo>
                  <a:pt x="433" y="1411"/>
                  <a:pt x="435" y="1414"/>
                  <a:pt x="437" y="1416"/>
                </a:cubicBezTo>
                <a:cubicBezTo>
                  <a:pt x="439" y="1419"/>
                  <a:pt x="440" y="1421"/>
                  <a:pt x="441" y="1423"/>
                </a:cubicBezTo>
                <a:cubicBezTo>
                  <a:pt x="442" y="1425"/>
                  <a:pt x="442" y="1427"/>
                  <a:pt x="442" y="1429"/>
                </a:cubicBezTo>
                <a:cubicBezTo>
                  <a:pt x="441" y="1430"/>
                  <a:pt x="440" y="1432"/>
                  <a:pt x="439" y="1433"/>
                </a:cubicBezTo>
                <a:lnTo>
                  <a:pt x="308" y="1564"/>
                </a:lnTo>
                <a:cubicBezTo>
                  <a:pt x="304" y="1568"/>
                  <a:pt x="300" y="1570"/>
                  <a:pt x="294" y="1571"/>
                </a:cubicBezTo>
                <a:cubicBezTo>
                  <a:pt x="289" y="1572"/>
                  <a:pt x="283" y="1569"/>
                  <a:pt x="277" y="1563"/>
                </a:cubicBezTo>
                <a:lnTo>
                  <a:pt x="3" y="1288"/>
                </a:lnTo>
                <a:cubicBezTo>
                  <a:pt x="1" y="1287"/>
                  <a:pt x="1" y="1286"/>
                  <a:pt x="0" y="1284"/>
                </a:cubicBezTo>
                <a:cubicBezTo>
                  <a:pt x="0" y="1283"/>
                  <a:pt x="0" y="1281"/>
                  <a:pt x="1" y="1279"/>
                </a:cubicBezTo>
                <a:cubicBezTo>
                  <a:pt x="2" y="1277"/>
                  <a:pt x="4" y="1274"/>
                  <a:pt x="6" y="1271"/>
                </a:cubicBezTo>
                <a:cubicBezTo>
                  <a:pt x="8" y="1268"/>
                  <a:pt x="11" y="1265"/>
                  <a:pt x="15" y="1261"/>
                </a:cubicBezTo>
                <a:cubicBezTo>
                  <a:pt x="19" y="1258"/>
                  <a:pt x="22" y="1255"/>
                  <a:pt x="25" y="1252"/>
                </a:cubicBezTo>
                <a:cubicBezTo>
                  <a:pt x="28" y="1250"/>
                  <a:pt x="30" y="1249"/>
                  <a:pt x="33" y="1248"/>
                </a:cubicBezTo>
                <a:cubicBezTo>
                  <a:pt x="35" y="1247"/>
                  <a:pt x="36" y="1246"/>
                  <a:pt x="38" y="1247"/>
                </a:cubicBezTo>
                <a:cubicBezTo>
                  <a:pt x="39" y="1247"/>
                  <a:pt x="41" y="1248"/>
                  <a:pt x="42" y="1249"/>
                </a:cubicBezTo>
                <a:lnTo>
                  <a:pt x="299" y="1506"/>
                </a:lnTo>
                <a:lnTo>
                  <a:pt x="405" y="1399"/>
                </a:lnTo>
                <a:cubicBezTo>
                  <a:pt x="406" y="1398"/>
                  <a:pt x="408" y="1397"/>
                  <a:pt x="410" y="1397"/>
                </a:cubicBezTo>
                <a:cubicBezTo>
                  <a:pt x="411" y="1396"/>
                  <a:pt x="413" y="1396"/>
                  <a:pt x="415" y="1397"/>
                </a:cubicBezTo>
                <a:cubicBezTo>
                  <a:pt x="417" y="1398"/>
                  <a:pt x="419" y="1399"/>
                  <a:pt x="422" y="1401"/>
                </a:cubicBezTo>
                <a:cubicBezTo>
                  <a:pt x="424" y="1403"/>
                  <a:pt x="427" y="1405"/>
                  <a:pt x="430" y="1408"/>
                </a:cubicBezTo>
                <a:close/>
                <a:moveTo>
                  <a:pt x="545" y="1092"/>
                </a:moveTo>
                <a:cubicBezTo>
                  <a:pt x="551" y="1098"/>
                  <a:pt x="554" y="1103"/>
                  <a:pt x="553" y="1109"/>
                </a:cubicBezTo>
                <a:cubicBezTo>
                  <a:pt x="553" y="1114"/>
                  <a:pt x="551" y="1119"/>
                  <a:pt x="547" y="1123"/>
                </a:cubicBezTo>
                <a:lnTo>
                  <a:pt x="411" y="1259"/>
                </a:lnTo>
                <a:cubicBezTo>
                  <a:pt x="422" y="1270"/>
                  <a:pt x="434" y="1279"/>
                  <a:pt x="445" y="1286"/>
                </a:cubicBezTo>
                <a:cubicBezTo>
                  <a:pt x="457" y="1293"/>
                  <a:pt x="469" y="1297"/>
                  <a:pt x="481" y="1298"/>
                </a:cubicBezTo>
                <a:cubicBezTo>
                  <a:pt x="493" y="1300"/>
                  <a:pt x="505" y="1298"/>
                  <a:pt x="517" y="1292"/>
                </a:cubicBezTo>
                <a:cubicBezTo>
                  <a:pt x="529" y="1287"/>
                  <a:pt x="541" y="1279"/>
                  <a:pt x="554" y="1266"/>
                </a:cubicBezTo>
                <a:cubicBezTo>
                  <a:pt x="563" y="1256"/>
                  <a:pt x="571" y="1247"/>
                  <a:pt x="577" y="1238"/>
                </a:cubicBezTo>
                <a:cubicBezTo>
                  <a:pt x="583" y="1228"/>
                  <a:pt x="588" y="1220"/>
                  <a:pt x="592" y="1212"/>
                </a:cubicBezTo>
                <a:cubicBezTo>
                  <a:pt x="596" y="1205"/>
                  <a:pt x="598" y="1198"/>
                  <a:pt x="600" y="1193"/>
                </a:cubicBezTo>
                <a:cubicBezTo>
                  <a:pt x="602" y="1188"/>
                  <a:pt x="604" y="1184"/>
                  <a:pt x="606" y="1182"/>
                </a:cubicBezTo>
                <a:cubicBezTo>
                  <a:pt x="607" y="1181"/>
                  <a:pt x="608" y="1181"/>
                  <a:pt x="610" y="1180"/>
                </a:cubicBezTo>
                <a:cubicBezTo>
                  <a:pt x="611" y="1180"/>
                  <a:pt x="613" y="1180"/>
                  <a:pt x="614" y="1181"/>
                </a:cubicBezTo>
                <a:cubicBezTo>
                  <a:pt x="616" y="1181"/>
                  <a:pt x="618" y="1183"/>
                  <a:pt x="620" y="1184"/>
                </a:cubicBezTo>
                <a:cubicBezTo>
                  <a:pt x="622" y="1186"/>
                  <a:pt x="624" y="1188"/>
                  <a:pt x="627" y="1191"/>
                </a:cubicBezTo>
                <a:cubicBezTo>
                  <a:pt x="629" y="1193"/>
                  <a:pt x="631" y="1195"/>
                  <a:pt x="632" y="1196"/>
                </a:cubicBezTo>
                <a:cubicBezTo>
                  <a:pt x="633" y="1198"/>
                  <a:pt x="634" y="1199"/>
                  <a:pt x="635" y="1201"/>
                </a:cubicBezTo>
                <a:cubicBezTo>
                  <a:pt x="636" y="1202"/>
                  <a:pt x="637" y="1204"/>
                  <a:pt x="637" y="1205"/>
                </a:cubicBezTo>
                <a:cubicBezTo>
                  <a:pt x="638" y="1206"/>
                  <a:pt x="638" y="1208"/>
                  <a:pt x="638" y="1210"/>
                </a:cubicBezTo>
                <a:cubicBezTo>
                  <a:pt x="638" y="1211"/>
                  <a:pt x="637" y="1215"/>
                  <a:pt x="634" y="1221"/>
                </a:cubicBezTo>
                <a:cubicBezTo>
                  <a:pt x="632" y="1227"/>
                  <a:pt x="629" y="1234"/>
                  <a:pt x="624" y="1243"/>
                </a:cubicBezTo>
                <a:cubicBezTo>
                  <a:pt x="619" y="1251"/>
                  <a:pt x="613" y="1261"/>
                  <a:pt x="606" y="1271"/>
                </a:cubicBezTo>
                <a:cubicBezTo>
                  <a:pt x="599" y="1281"/>
                  <a:pt x="590" y="1291"/>
                  <a:pt x="581" y="1300"/>
                </a:cubicBezTo>
                <a:cubicBezTo>
                  <a:pt x="564" y="1317"/>
                  <a:pt x="546" y="1330"/>
                  <a:pt x="529" y="1338"/>
                </a:cubicBezTo>
                <a:cubicBezTo>
                  <a:pt x="511" y="1346"/>
                  <a:pt x="494" y="1350"/>
                  <a:pt x="476" y="1349"/>
                </a:cubicBezTo>
                <a:cubicBezTo>
                  <a:pt x="458" y="1348"/>
                  <a:pt x="439" y="1343"/>
                  <a:pt x="421" y="1334"/>
                </a:cubicBezTo>
                <a:cubicBezTo>
                  <a:pt x="402" y="1324"/>
                  <a:pt x="384" y="1310"/>
                  <a:pt x="365" y="1291"/>
                </a:cubicBezTo>
                <a:cubicBezTo>
                  <a:pt x="347" y="1274"/>
                  <a:pt x="334" y="1255"/>
                  <a:pt x="324" y="1237"/>
                </a:cubicBezTo>
                <a:cubicBezTo>
                  <a:pt x="315" y="1218"/>
                  <a:pt x="309" y="1199"/>
                  <a:pt x="308" y="1181"/>
                </a:cubicBezTo>
                <a:cubicBezTo>
                  <a:pt x="307" y="1162"/>
                  <a:pt x="310" y="1144"/>
                  <a:pt x="317" y="1127"/>
                </a:cubicBezTo>
                <a:cubicBezTo>
                  <a:pt x="324" y="1109"/>
                  <a:pt x="335" y="1093"/>
                  <a:pt x="350" y="1078"/>
                </a:cubicBezTo>
                <a:cubicBezTo>
                  <a:pt x="366" y="1062"/>
                  <a:pt x="382" y="1050"/>
                  <a:pt x="399" y="1044"/>
                </a:cubicBezTo>
                <a:cubicBezTo>
                  <a:pt x="416" y="1038"/>
                  <a:pt x="432" y="1036"/>
                  <a:pt x="448" y="1037"/>
                </a:cubicBezTo>
                <a:cubicBezTo>
                  <a:pt x="464" y="1039"/>
                  <a:pt x="480" y="1044"/>
                  <a:pt x="495" y="1052"/>
                </a:cubicBezTo>
                <a:cubicBezTo>
                  <a:pt x="510" y="1060"/>
                  <a:pt x="525" y="1071"/>
                  <a:pt x="538" y="1085"/>
                </a:cubicBezTo>
                <a:lnTo>
                  <a:pt x="545" y="1092"/>
                </a:lnTo>
                <a:close/>
                <a:moveTo>
                  <a:pt x="496" y="1118"/>
                </a:moveTo>
                <a:cubicBezTo>
                  <a:pt x="476" y="1098"/>
                  <a:pt x="456" y="1087"/>
                  <a:pt x="436" y="1085"/>
                </a:cubicBezTo>
                <a:cubicBezTo>
                  <a:pt x="415" y="1083"/>
                  <a:pt x="396" y="1091"/>
                  <a:pt x="377" y="1109"/>
                </a:cubicBezTo>
                <a:cubicBezTo>
                  <a:pt x="368" y="1119"/>
                  <a:pt x="362" y="1129"/>
                  <a:pt x="358" y="1139"/>
                </a:cubicBezTo>
                <a:cubicBezTo>
                  <a:pt x="354" y="1150"/>
                  <a:pt x="353" y="1160"/>
                  <a:pt x="354" y="1171"/>
                </a:cubicBezTo>
                <a:cubicBezTo>
                  <a:pt x="355" y="1182"/>
                  <a:pt x="358" y="1192"/>
                  <a:pt x="363" y="1202"/>
                </a:cubicBezTo>
                <a:cubicBezTo>
                  <a:pt x="369" y="1213"/>
                  <a:pt x="375" y="1222"/>
                  <a:pt x="383" y="1231"/>
                </a:cubicBezTo>
                <a:lnTo>
                  <a:pt x="496" y="1118"/>
                </a:lnTo>
                <a:close/>
                <a:moveTo>
                  <a:pt x="896" y="965"/>
                </a:moveTo>
                <a:cubicBezTo>
                  <a:pt x="897" y="967"/>
                  <a:pt x="898" y="968"/>
                  <a:pt x="898" y="969"/>
                </a:cubicBezTo>
                <a:cubicBezTo>
                  <a:pt x="898" y="971"/>
                  <a:pt x="898" y="972"/>
                  <a:pt x="897" y="974"/>
                </a:cubicBezTo>
                <a:cubicBezTo>
                  <a:pt x="896" y="976"/>
                  <a:pt x="895" y="979"/>
                  <a:pt x="893" y="981"/>
                </a:cubicBezTo>
                <a:cubicBezTo>
                  <a:pt x="891" y="984"/>
                  <a:pt x="889" y="987"/>
                  <a:pt x="885" y="990"/>
                </a:cubicBezTo>
                <a:cubicBezTo>
                  <a:pt x="882" y="993"/>
                  <a:pt x="879" y="996"/>
                  <a:pt x="876" y="998"/>
                </a:cubicBezTo>
                <a:cubicBezTo>
                  <a:pt x="874" y="1000"/>
                  <a:pt x="872" y="1001"/>
                  <a:pt x="870" y="1002"/>
                </a:cubicBezTo>
                <a:cubicBezTo>
                  <a:pt x="868" y="1002"/>
                  <a:pt x="866" y="1003"/>
                  <a:pt x="865" y="1002"/>
                </a:cubicBezTo>
                <a:cubicBezTo>
                  <a:pt x="864" y="1002"/>
                  <a:pt x="862" y="1001"/>
                  <a:pt x="861" y="1000"/>
                </a:cubicBezTo>
                <a:lnTo>
                  <a:pt x="834" y="973"/>
                </a:lnTo>
                <a:cubicBezTo>
                  <a:pt x="835" y="997"/>
                  <a:pt x="833" y="1018"/>
                  <a:pt x="827" y="1036"/>
                </a:cubicBezTo>
                <a:cubicBezTo>
                  <a:pt x="822" y="1053"/>
                  <a:pt x="813" y="1068"/>
                  <a:pt x="802" y="1080"/>
                </a:cubicBezTo>
                <a:cubicBezTo>
                  <a:pt x="788" y="1093"/>
                  <a:pt x="774" y="1103"/>
                  <a:pt x="760" y="1107"/>
                </a:cubicBezTo>
                <a:cubicBezTo>
                  <a:pt x="746" y="1112"/>
                  <a:pt x="732" y="1114"/>
                  <a:pt x="718" y="1112"/>
                </a:cubicBezTo>
                <a:cubicBezTo>
                  <a:pt x="705" y="1110"/>
                  <a:pt x="691" y="1105"/>
                  <a:pt x="678" y="1097"/>
                </a:cubicBezTo>
                <a:cubicBezTo>
                  <a:pt x="665" y="1089"/>
                  <a:pt x="651" y="1077"/>
                  <a:pt x="636" y="1062"/>
                </a:cubicBezTo>
                <a:lnTo>
                  <a:pt x="511" y="937"/>
                </a:lnTo>
                <a:cubicBezTo>
                  <a:pt x="510" y="936"/>
                  <a:pt x="509" y="934"/>
                  <a:pt x="509" y="933"/>
                </a:cubicBezTo>
                <a:cubicBezTo>
                  <a:pt x="509" y="932"/>
                  <a:pt x="509" y="930"/>
                  <a:pt x="510" y="928"/>
                </a:cubicBezTo>
                <a:cubicBezTo>
                  <a:pt x="511" y="925"/>
                  <a:pt x="512" y="923"/>
                  <a:pt x="514" y="920"/>
                </a:cubicBezTo>
                <a:cubicBezTo>
                  <a:pt x="517" y="918"/>
                  <a:pt x="520" y="915"/>
                  <a:pt x="523" y="911"/>
                </a:cubicBezTo>
                <a:cubicBezTo>
                  <a:pt x="527" y="907"/>
                  <a:pt x="530" y="904"/>
                  <a:pt x="533" y="902"/>
                </a:cubicBezTo>
                <a:cubicBezTo>
                  <a:pt x="535" y="900"/>
                  <a:pt x="538" y="898"/>
                  <a:pt x="540" y="898"/>
                </a:cubicBezTo>
                <a:cubicBezTo>
                  <a:pt x="542" y="897"/>
                  <a:pt x="544" y="897"/>
                  <a:pt x="545" y="897"/>
                </a:cubicBezTo>
                <a:cubicBezTo>
                  <a:pt x="547" y="897"/>
                  <a:pt x="548" y="898"/>
                  <a:pt x="549" y="899"/>
                </a:cubicBezTo>
                <a:lnTo>
                  <a:pt x="669" y="1019"/>
                </a:lnTo>
                <a:cubicBezTo>
                  <a:pt x="682" y="1031"/>
                  <a:pt x="692" y="1040"/>
                  <a:pt x="701" y="1045"/>
                </a:cubicBezTo>
                <a:cubicBezTo>
                  <a:pt x="710" y="1051"/>
                  <a:pt x="719" y="1054"/>
                  <a:pt x="728" y="1056"/>
                </a:cubicBezTo>
                <a:cubicBezTo>
                  <a:pt x="736" y="1058"/>
                  <a:pt x="745" y="1057"/>
                  <a:pt x="753" y="1054"/>
                </a:cubicBezTo>
                <a:cubicBezTo>
                  <a:pt x="762" y="1052"/>
                  <a:pt x="769" y="1047"/>
                  <a:pt x="777" y="1039"/>
                </a:cubicBezTo>
                <a:cubicBezTo>
                  <a:pt x="786" y="1030"/>
                  <a:pt x="792" y="1017"/>
                  <a:pt x="795" y="1001"/>
                </a:cubicBezTo>
                <a:cubicBezTo>
                  <a:pt x="798" y="985"/>
                  <a:pt x="798" y="965"/>
                  <a:pt x="795" y="941"/>
                </a:cubicBezTo>
                <a:lnTo>
                  <a:pt x="651" y="797"/>
                </a:lnTo>
                <a:cubicBezTo>
                  <a:pt x="650" y="796"/>
                  <a:pt x="649" y="795"/>
                  <a:pt x="649" y="793"/>
                </a:cubicBezTo>
                <a:cubicBezTo>
                  <a:pt x="649" y="792"/>
                  <a:pt x="649" y="790"/>
                  <a:pt x="650" y="788"/>
                </a:cubicBezTo>
                <a:cubicBezTo>
                  <a:pt x="650" y="786"/>
                  <a:pt x="652" y="783"/>
                  <a:pt x="654" y="781"/>
                </a:cubicBezTo>
                <a:cubicBezTo>
                  <a:pt x="656" y="778"/>
                  <a:pt x="659" y="775"/>
                  <a:pt x="663" y="771"/>
                </a:cubicBezTo>
                <a:cubicBezTo>
                  <a:pt x="667" y="767"/>
                  <a:pt x="670" y="764"/>
                  <a:pt x="673" y="762"/>
                </a:cubicBezTo>
                <a:cubicBezTo>
                  <a:pt x="675" y="760"/>
                  <a:pt x="678" y="759"/>
                  <a:pt x="680" y="758"/>
                </a:cubicBezTo>
                <a:cubicBezTo>
                  <a:pt x="682" y="757"/>
                  <a:pt x="684" y="757"/>
                  <a:pt x="685" y="757"/>
                </a:cubicBezTo>
                <a:cubicBezTo>
                  <a:pt x="687" y="757"/>
                  <a:pt x="688" y="758"/>
                  <a:pt x="689" y="759"/>
                </a:cubicBezTo>
                <a:lnTo>
                  <a:pt x="896" y="965"/>
                </a:lnTo>
                <a:close/>
                <a:moveTo>
                  <a:pt x="1079" y="719"/>
                </a:moveTo>
                <a:cubicBezTo>
                  <a:pt x="1082" y="722"/>
                  <a:pt x="1084" y="724"/>
                  <a:pt x="1085" y="726"/>
                </a:cubicBezTo>
                <a:cubicBezTo>
                  <a:pt x="1087" y="728"/>
                  <a:pt x="1089" y="730"/>
                  <a:pt x="1089" y="732"/>
                </a:cubicBezTo>
                <a:cubicBezTo>
                  <a:pt x="1090" y="733"/>
                  <a:pt x="1091" y="735"/>
                  <a:pt x="1092" y="737"/>
                </a:cubicBezTo>
                <a:cubicBezTo>
                  <a:pt x="1092" y="738"/>
                  <a:pt x="1092" y="741"/>
                  <a:pt x="1092" y="745"/>
                </a:cubicBezTo>
                <a:cubicBezTo>
                  <a:pt x="1092" y="748"/>
                  <a:pt x="1091" y="754"/>
                  <a:pt x="1090" y="761"/>
                </a:cubicBezTo>
                <a:cubicBezTo>
                  <a:pt x="1088" y="769"/>
                  <a:pt x="1085" y="777"/>
                  <a:pt x="1082" y="785"/>
                </a:cubicBezTo>
                <a:cubicBezTo>
                  <a:pt x="1078" y="792"/>
                  <a:pt x="1074" y="801"/>
                  <a:pt x="1068" y="809"/>
                </a:cubicBezTo>
                <a:cubicBezTo>
                  <a:pt x="1063" y="817"/>
                  <a:pt x="1057" y="824"/>
                  <a:pt x="1050" y="832"/>
                </a:cubicBezTo>
                <a:cubicBezTo>
                  <a:pt x="1035" y="846"/>
                  <a:pt x="1019" y="857"/>
                  <a:pt x="1003" y="864"/>
                </a:cubicBezTo>
                <a:cubicBezTo>
                  <a:pt x="986" y="870"/>
                  <a:pt x="970" y="873"/>
                  <a:pt x="953" y="871"/>
                </a:cubicBezTo>
                <a:cubicBezTo>
                  <a:pt x="936" y="869"/>
                  <a:pt x="918" y="864"/>
                  <a:pt x="900" y="854"/>
                </a:cubicBezTo>
                <a:cubicBezTo>
                  <a:pt x="883" y="844"/>
                  <a:pt x="865" y="831"/>
                  <a:pt x="847" y="813"/>
                </a:cubicBezTo>
                <a:cubicBezTo>
                  <a:pt x="827" y="792"/>
                  <a:pt x="812" y="772"/>
                  <a:pt x="802" y="753"/>
                </a:cubicBezTo>
                <a:cubicBezTo>
                  <a:pt x="792" y="733"/>
                  <a:pt x="787" y="715"/>
                  <a:pt x="787" y="697"/>
                </a:cubicBezTo>
                <a:cubicBezTo>
                  <a:pt x="786" y="679"/>
                  <a:pt x="789" y="662"/>
                  <a:pt x="796" y="645"/>
                </a:cubicBezTo>
                <a:cubicBezTo>
                  <a:pt x="803" y="629"/>
                  <a:pt x="814" y="614"/>
                  <a:pt x="827" y="601"/>
                </a:cubicBezTo>
                <a:cubicBezTo>
                  <a:pt x="834" y="594"/>
                  <a:pt x="841" y="588"/>
                  <a:pt x="848" y="583"/>
                </a:cubicBezTo>
                <a:cubicBezTo>
                  <a:pt x="856" y="578"/>
                  <a:pt x="863" y="574"/>
                  <a:pt x="870" y="571"/>
                </a:cubicBezTo>
                <a:cubicBezTo>
                  <a:pt x="878" y="568"/>
                  <a:pt x="884" y="566"/>
                  <a:pt x="891" y="564"/>
                </a:cubicBezTo>
                <a:cubicBezTo>
                  <a:pt x="898" y="563"/>
                  <a:pt x="903" y="562"/>
                  <a:pt x="907" y="562"/>
                </a:cubicBezTo>
                <a:cubicBezTo>
                  <a:pt x="910" y="562"/>
                  <a:pt x="913" y="562"/>
                  <a:pt x="915" y="562"/>
                </a:cubicBezTo>
                <a:cubicBezTo>
                  <a:pt x="916" y="563"/>
                  <a:pt x="918" y="564"/>
                  <a:pt x="920" y="565"/>
                </a:cubicBezTo>
                <a:cubicBezTo>
                  <a:pt x="922" y="566"/>
                  <a:pt x="924" y="567"/>
                  <a:pt x="926" y="569"/>
                </a:cubicBezTo>
                <a:cubicBezTo>
                  <a:pt x="928" y="570"/>
                  <a:pt x="930" y="572"/>
                  <a:pt x="933" y="575"/>
                </a:cubicBezTo>
                <a:cubicBezTo>
                  <a:pt x="939" y="581"/>
                  <a:pt x="943" y="586"/>
                  <a:pt x="944" y="590"/>
                </a:cubicBezTo>
                <a:cubicBezTo>
                  <a:pt x="945" y="594"/>
                  <a:pt x="944" y="596"/>
                  <a:pt x="942" y="598"/>
                </a:cubicBezTo>
                <a:cubicBezTo>
                  <a:pt x="940" y="601"/>
                  <a:pt x="936" y="602"/>
                  <a:pt x="930" y="603"/>
                </a:cubicBezTo>
                <a:cubicBezTo>
                  <a:pt x="925" y="603"/>
                  <a:pt x="918" y="604"/>
                  <a:pt x="911" y="605"/>
                </a:cubicBezTo>
                <a:cubicBezTo>
                  <a:pt x="903" y="607"/>
                  <a:pt x="895" y="610"/>
                  <a:pt x="886" y="614"/>
                </a:cubicBezTo>
                <a:cubicBezTo>
                  <a:pt x="877" y="618"/>
                  <a:pt x="868" y="624"/>
                  <a:pt x="859" y="633"/>
                </a:cubicBezTo>
                <a:cubicBezTo>
                  <a:pt x="841" y="651"/>
                  <a:pt x="834" y="672"/>
                  <a:pt x="838" y="696"/>
                </a:cubicBezTo>
                <a:cubicBezTo>
                  <a:pt x="842" y="720"/>
                  <a:pt x="858" y="745"/>
                  <a:pt x="884" y="771"/>
                </a:cubicBezTo>
                <a:cubicBezTo>
                  <a:pt x="898" y="785"/>
                  <a:pt x="911" y="795"/>
                  <a:pt x="923" y="802"/>
                </a:cubicBezTo>
                <a:cubicBezTo>
                  <a:pt x="936" y="810"/>
                  <a:pt x="948" y="815"/>
                  <a:pt x="959" y="816"/>
                </a:cubicBezTo>
                <a:cubicBezTo>
                  <a:pt x="971" y="818"/>
                  <a:pt x="982" y="817"/>
                  <a:pt x="992" y="813"/>
                </a:cubicBezTo>
                <a:cubicBezTo>
                  <a:pt x="1003" y="810"/>
                  <a:pt x="1012" y="803"/>
                  <a:pt x="1022" y="794"/>
                </a:cubicBezTo>
                <a:cubicBezTo>
                  <a:pt x="1030" y="785"/>
                  <a:pt x="1037" y="776"/>
                  <a:pt x="1040" y="767"/>
                </a:cubicBezTo>
                <a:cubicBezTo>
                  <a:pt x="1044" y="758"/>
                  <a:pt x="1047" y="749"/>
                  <a:pt x="1048" y="741"/>
                </a:cubicBezTo>
                <a:cubicBezTo>
                  <a:pt x="1050" y="733"/>
                  <a:pt x="1051" y="726"/>
                  <a:pt x="1052" y="720"/>
                </a:cubicBezTo>
                <a:cubicBezTo>
                  <a:pt x="1052" y="714"/>
                  <a:pt x="1053" y="710"/>
                  <a:pt x="1055" y="708"/>
                </a:cubicBezTo>
                <a:cubicBezTo>
                  <a:pt x="1056" y="707"/>
                  <a:pt x="1058" y="706"/>
                  <a:pt x="1059" y="706"/>
                </a:cubicBezTo>
                <a:cubicBezTo>
                  <a:pt x="1060" y="706"/>
                  <a:pt x="1062" y="706"/>
                  <a:pt x="1064" y="707"/>
                </a:cubicBezTo>
                <a:cubicBezTo>
                  <a:pt x="1066" y="708"/>
                  <a:pt x="1068" y="710"/>
                  <a:pt x="1071" y="712"/>
                </a:cubicBezTo>
                <a:cubicBezTo>
                  <a:pt x="1073" y="714"/>
                  <a:pt x="1076" y="716"/>
                  <a:pt x="1079" y="719"/>
                </a:cubicBezTo>
                <a:close/>
                <a:moveTo>
                  <a:pt x="1203" y="657"/>
                </a:moveTo>
                <a:cubicBezTo>
                  <a:pt x="1205" y="659"/>
                  <a:pt x="1205" y="660"/>
                  <a:pt x="1206" y="661"/>
                </a:cubicBezTo>
                <a:cubicBezTo>
                  <a:pt x="1206" y="663"/>
                  <a:pt x="1206" y="665"/>
                  <a:pt x="1205" y="667"/>
                </a:cubicBezTo>
                <a:cubicBezTo>
                  <a:pt x="1204" y="669"/>
                  <a:pt x="1203" y="671"/>
                  <a:pt x="1201" y="674"/>
                </a:cubicBezTo>
                <a:cubicBezTo>
                  <a:pt x="1198" y="676"/>
                  <a:pt x="1195" y="680"/>
                  <a:pt x="1192" y="684"/>
                </a:cubicBezTo>
                <a:cubicBezTo>
                  <a:pt x="1188" y="687"/>
                  <a:pt x="1185" y="690"/>
                  <a:pt x="1182" y="692"/>
                </a:cubicBezTo>
                <a:cubicBezTo>
                  <a:pt x="1179" y="694"/>
                  <a:pt x="1177" y="696"/>
                  <a:pt x="1175" y="697"/>
                </a:cubicBezTo>
                <a:cubicBezTo>
                  <a:pt x="1173" y="698"/>
                  <a:pt x="1171" y="698"/>
                  <a:pt x="1170" y="698"/>
                </a:cubicBezTo>
                <a:cubicBezTo>
                  <a:pt x="1168" y="697"/>
                  <a:pt x="1167" y="697"/>
                  <a:pt x="1166" y="695"/>
                </a:cubicBezTo>
                <a:lnTo>
                  <a:pt x="959" y="489"/>
                </a:lnTo>
                <a:cubicBezTo>
                  <a:pt x="958" y="488"/>
                  <a:pt x="958" y="487"/>
                  <a:pt x="957" y="485"/>
                </a:cubicBezTo>
                <a:cubicBezTo>
                  <a:pt x="957" y="484"/>
                  <a:pt x="957" y="482"/>
                  <a:pt x="958" y="480"/>
                </a:cubicBezTo>
                <a:cubicBezTo>
                  <a:pt x="959" y="478"/>
                  <a:pt x="960" y="475"/>
                  <a:pt x="962" y="473"/>
                </a:cubicBezTo>
                <a:cubicBezTo>
                  <a:pt x="964" y="470"/>
                  <a:pt x="967" y="467"/>
                  <a:pt x="971" y="463"/>
                </a:cubicBezTo>
                <a:cubicBezTo>
                  <a:pt x="975" y="459"/>
                  <a:pt x="978" y="456"/>
                  <a:pt x="981" y="454"/>
                </a:cubicBezTo>
                <a:cubicBezTo>
                  <a:pt x="984" y="452"/>
                  <a:pt x="986" y="451"/>
                  <a:pt x="988" y="450"/>
                </a:cubicBezTo>
                <a:cubicBezTo>
                  <a:pt x="990" y="449"/>
                  <a:pt x="992" y="449"/>
                  <a:pt x="993" y="449"/>
                </a:cubicBezTo>
                <a:cubicBezTo>
                  <a:pt x="995" y="449"/>
                  <a:pt x="996" y="450"/>
                  <a:pt x="997" y="451"/>
                </a:cubicBezTo>
                <a:lnTo>
                  <a:pt x="1203" y="657"/>
                </a:lnTo>
                <a:close/>
                <a:moveTo>
                  <a:pt x="932" y="377"/>
                </a:moveTo>
                <a:cubicBezTo>
                  <a:pt x="941" y="386"/>
                  <a:pt x="945" y="394"/>
                  <a:pt x="945" y="400"/>
                </a:cubicBezTo>
                <a:cubicBezTo>
                  <a:pt x="945" y="407"/>
                  <a:pt x="940" y="415"/>
                  <a:pt x="931" y="424"/>
                </a:cubicBezTo>
                <a:cubicBezTo>
                  <a:pt x="922" y="432"/>
                  <a:pt x="915" y="437"/>
                  <a:pt x="908" y="437"/>
                </a:cubicBezTo>
                <a:cubicBezTo>
                  <a:pt x="902" y="437"/>
                  <a:pt x="894" y="433"/>
                  <a:pt x="886" y="424"/>
                </a:cubicBezTo>
                <a:cubicBezTo>
                  <a:pt x="877" y="415"/>
                  <a:pt x="872" y="408"/>
                  <a:pt x="872" y="401"/>
                </a:cubicBezTo>
                <a:cubicBezTo>
                  <a:pt x="873" y="395"/>
                  <a:pt x="877" y="387"/>
                  <a:pt x="886" y="378"/>
                </a:cubicBezTo>
                <a:cubicBezTo>
                  <a:pt x="895" y="369"/>
                  <a:pt x="903" y="364"/>
                  <a:pt x="909" y="364"/>
                </a:cubicBezTo>
                <a:cubicBezTo>
                  <a:pt x="916" y="364"/>
                  <a:pt x="923" y="368"/>
                  <a:pt x="932" y="377"/>
                </a:cubicBezTo>
                <a:close/>
                <a:moveTo>
                  <a:pt x="1451" y="410"/>
                </a:moveTo>
                <a:cubicBezTo>
                  <a:pt x="1452" y="411"/>
                  <a:pt x="1453" y="413"/>
                  <a:pt x="1453" y="414"/>
                </a:cubicBezTo>
                <a:cubicBezTo>
                  <a:pt x="1453" y="416"/>
                  <a:pt x="1453" y="417"/>
                  <a:pt x="1452" y="419"/>
                </a:cubicBezTo>
                <a:cubicBezTo>
                  <a:pt x="1451" y="421"/>
                  <a:pt x="1450" y="424"/>
                  <a:pt x="1448" y="426"/>
                </a:cubicBezTo>
                <a:cubicBezTo>
                  <a:pt x="1446" y="429"/>
                  <a:pt x="1443" y="432"/>
                  <a:pt x="1439" y="436"/>
                </a:cubicBezTo>
                <a:cubicBezTo>
                  <a:pt x="1435" y="440"/>
                  <a:pt x="1432" y="443"/>
                  <a:pt x="1429" y="445"/>
                </a:cubicBezTo>
                <a:cubicBezTo>
                  <a:pt x="1427" y="447"/>
                  <a:pt x="1424" y="449"/>
                  <a:pt x="1422" y="449"/>
                </a:cubicBezTo>
                <a:cubicBezTo>
                  <a:pt x="1420" y="450"/>
                  <a:pt x="1418" y="450"/>
                  <a:pt x="1417" y="450"/>
                </a:cubicBezTo>
                <a:cubicBezTo>
                  <a:pt x="1416" y="450"/>
                  <a:pt x="1414" y="449"/>
                  <a:pt x="1413" y="448"/>
                </a:cubicBezTo>
                <a:lnTo>
                  <a:pt x="1292" y="327"/>
                </a:lnTo>
                <a:cubicBezTo>
                  <a:pt x="1280" y="315"/>
                  <a:pt x="1270" y="307"/>
                  <a:pt x="1261" y="301"/>
                </a:cubicBezTo>
                <a:cubicBezTo>
                  <a:pt x="1252" y="296"/>
                  <a:pt x="1243" y="293"/>
                  <a:pt x="1234" y="291"/>
                </a:cubicBezTo>
                <a:cubicBezTo>
                  <a:pt x="1226" y="289"/>
                  <a:pt x="1217" y="290"/>
                  <a:pt x="1209" y="293"/>
                </a:cubicBezTo>
                <a:cubicBezTo>
                  <a:pt x="1201" y="295"/>
                  <a:pt x="1193" y="301"/>
                  <a:pt x="1185" y="308"/>
                </a:cubicBezTo>
                <a:cubicBezTo>
                  <a:pt x="1176" y="317"/>
                  <a:pt x="1170" y="330"/>
                  <a:pt x="1167" y="346"/>
                </a:cubicBezTo>
                <a:cubicBezTo>
                  <a:pt x="1164" y="363"/>
                  <a:pt x="1164" y="382"/>
                  <a:pt x="1167" y="406"/>
                </a:cubicBezTo>
                <a:lnTo>
                  <a:pt x="1311" y="550"/>
                </a:lnTo>
                <a:cubicBezTo>
                  <a:pt x="1312" y="551"/>
                  <a:pt x="1313" y="553"/>
                  <a:pt x="1313" y="554"/>
                </a:cubicBezTo>
                <a:cubicBezTo>
                  <a:pt x="1313" y="555"/>
                  <a:pt x="1313" y="557"/>
                  <a:pt x="1312" y="559"/>
                </a:cubicBezTo>
                <a:cubicBezTo>
                  <a:pt x="1312" y="561"/>
                  <a:pt x="1310" y="564"/>
                  <a:pt x="1308" y="566"/>
                </a:cubicBezTo>
                <a:cubicBezTo>
                  <a:pt x="1306" y="569"/>
                  <a:pt x="1303" y="572"/>
                  <a:pt x="1299" y="576"/>
                </a:cubicBezTo>
                <a:cubicBezTo>
                  <a:pt x="1295" y="580"/>
                  <a:pt x="1292" y="583"/>
                  <a:pt x="1289" y="585"/>
                </a:cubicBezTo>
                <a:cubicBezTo>
                  <a:pt x="1287" y="587"/>
                  <a:pt x="1284" y="588"/>
                  <a:pt x="1282" y="589"/>
                </a:cubicBezTo>
                <a:cubicBezTo>
                  <a:pt x="1280" y="590"/>
                  <a:pt x="1278" y="590"/>
                  <a:pt x="1277" y="590"/>
                </a:cubicBezTo>
                <a:cubicBezTo>
                  <a:pt x="1276" y="590"/>
                  <a:pt x="1274" y="589"/>
                  <a:pt x="1273" y="588"/>
                </a:cubicBezTo>
                <a:lnTo>
                  <a:pt x="1067" y="381"/>
                </a:lnTo>
                <a:cubicBezTo>
                  <a:pt x="1066" y="380"/>
                  <a:pt x="1065" y="379"/>
                  <a:pt x="1064" y="378"/>
                </a:cubicBezTo>
                <a:cubicBezTo>
                  <a:pt x="1064" y="376"/>
                  <a:pt x="1064" y="375"/>
                  <a:pt x="1065" y="373"/>
                </a:cubicBezTo>
                <a:cubicBezTo>
                  <a:pt x="1066" y="371"/>
                  <a:pt x="1067" y="368"/>
                  <a:pt x="1069" y="366"/>
                </a:cubicBezTo>
                <a:cubicBezTo>
                  <a:pt x="1071" y="364"/>
                  <a:pt x="1073" y="361"/>
                  <a:pt x="1077" y="357"/>
                </a:cubicBezTo>
                <a:cubicBezTo>
                  <a:pt x="1080" y="354"/>
                  <a:pt x="1083" y="351"/>
                  <a:pt x="1086" y="349"/>
                </a:cubicBezTo>
                <a:cubicBezTo>
                  <a:pt x="1088" y="347"/>
                  <a:pt x="1090" y="346"/>
                  <a:pt x="1092" y="345"/>
                </a:cubicBezTo>
                <a:cubicBezTo>
                  <a:pt x="1094" y="345"/>
                  <a:pt x="1096" y="345"/>
                  <a:pt x="1097" y="345"/>
                </a:cubicBezTo>
                <a:cubicBezTo>
                  <a:pt x="1098" y="345"/>
                  <a:pt x="1100" y="346"/>
                  <a:pt x="1101" y="347"/>
                </a:cubicBezTo>
                <a:lnTo>
                  <a:pt x="1128" y="375"/>
                </a:lnTo>
                <a:cubicBezTo>
                  <a:pt x="1127" y="350"/>
                  <a:pt x="1129" y="329"/>
                  <a:pt x="1134" y="311"/>
                </a:cubicBezTo>
                <a:cubicBezTo>
                  <a:pt x="1140" y="294"/>
                  <a:pt x="1149" y="279"/>
                  <a:pt x="1160" y="267"/>
                </a:cubicBezTo>
                <a:cubicBezTo>
                  <a:pt x="1174" y="254"/>
                  <a:pt x="1188" y="244"/>
                  <a:pt x="1202" y="240"/>
                </a:cubicBezTo>
                <a:cubicBezTo>
                  <a:pt x="1216" y="235"/>
                  <a:pt x="1230" y="233"/>
                  <a:pt x="1244" y="235"/>
                </a:cubicBezTo>
                <a:cubicBezTo>
                  <a:pt x="1257" y="237"/>
                  <a:pt x="1270" y="242"/>
                  <a:pt x="1283" y="250"/>
                </a:cubicBezTo>
                <a:cubicBezTo>
                  <a:pt x="1296" y="258"/>
                  <a:pt x="1310" y="270"/>
                  <a:pt x="1325" y="284"/>
                </a:cubicBezTo>
                <a:lnTo>
                  <a:pt x="1451" y="410"/>
                </a:lnTo>
                <a:close/>
                <a:moveTo>
                  <a:pt x="1580" y="56"/>
                </a:moveTo>
                <a:cubicBezTo>
                  <a:pt x="1586" y="62"/>
                  <a:pt x="1589" y="68"/>
                  <a:pt x="1589" y="74"/>
                </a:cubicBezTo>
                <a:cubicBezTo>
                  <a:pt x="1588" y="79"/>
                  <a:pt x="1586" y="84"/>
                  <a:pt x="1582" y="88"/>
                </a:cubicBezTo>
                <a:lnTo>
                  <a:pt x="1446" y="224"/>
                </a:lnTo>
                <a:cubicBezTo>
                  <a:pt x="1458" y="235"/>
                  <a:pt x="1469" y="244"/>
                  <a:pt x="1481" y="251"/>
                </a:cubicBezTo>
                <a:cubicBezTo>
                  <a:pt x="1492" y="258"/>
                  <a:pt x="1504" y="262"/>
                  <a:pt x="1516" y="263"/>
                </a:cubicBezTo>
                <a:cubicBezTo>
                  <a:pt x="1528" y="264"/>
                  <a:pt x="1540" y="262"/>
                  <a:pt x="1552" y="257"/>
                </a:cubicBezTo>
                <a:cubicBezTo>
                  <a:pt x="1564" y="252"/>
                  <a:pt x="1576" y="243"/>
                  <a:pt x="1589" y="231"/>
                </a:cubicBezTo>
                <a:cubicBezTo>
                  <a:pt x="1599" y="221"/>
                  <a:pt x="1606" y="212"/>
                  <a:pt x="1613" y="202"/>
                </a:cubicBezTo>
                <a:cubicBezTo>
                  <a:pt x="1619" y="193"/>
                  <a:pt x="1623" y="185"/>
                  <a:pt x="1627" y="177"/>
                </a:cubicBezTo>
                <a:cubicBezTo>
                  <a:pt x="1631" y="169"/>
                  <a:pt x="1634" y="163"/>
                  <a:pt x="1636" y="158"/>
                </a:cubicBezTo>
                <a:cubicBezTo>
                  <a:pt x="1638" y="153"/>
                  <a:pt x="1639" y="149"/>
                  <a:pt x="1641" y="147"/>
                </a:cubicBezTo>
                <a:cubicBezTo>
                  <a:pt x="1642" y="146"/>
                  <a:pt x="1644" y="145"/>
                  <a:pt x="1645" y="145"/>
                </a:cubicBezTo>
                <a:cubicBezTo>
                  <a:pt x="1646" y="145"/>
                  <a:pt x="1648" y="145"/>
                  <a:pt x="1649" y="146"/>
                </a:cubicBezTo>
                <a:cubicBezTo>
                  <a:pt x="1651" y="146"/>
                  <a:pt x="1653" y="147"/>
                  <a:pt x="1655" y="149"/>
                </a:cubicBezTo>
                <a:cubicBezTo>
                  <a:pt x="1657" y="151"/>
                  <a:pt x="1659" y="153"/>
                  <a:pt x="1662" y="156"/>
                </a:cubicBezTo>
                <a:cubicBezTo>
                  <a:pt x="1664" y="158"/>
                  <a:pt x="1666" y="159"/>
                  <a:pt x="1667" y="161"/>
                </a:cubicBezTo>
                <a:cubicBezTo>
                  <a:pt x="1668" y="163"/>
                  <a:pt x="1670" y="164"/>
                  <a:pt x="1670" y="166"/>
                </a:cubicBezTo>
                <a:cubicBezTo>
                  <a:pt x="1671" y="167"/>
                  <a:pt x="1672" y="168"/>
                  <a:pt x="1672" y="170"/>
                </a:cubicBezTo>
                <a:cubicBezTo>
                  <a:pt x="1673" y="171"/>
                  <a:pt x="1673" y="173"/>
                  <a:pt x="1673" y="174"/>
                </a:cubicBezTo>
                <a:cubicBezTo>
                  <a:pt x="1673" y="176"/>
                  <a:pt x="1672" y="180"/>
                  <a:pt x="1670" y="186"/>
                </a:cubicBezTo>
                <a:cubicBezTo>
                  <a:pt x="1667" y="192"/>
                  <a:pt x="1664" y="199"/>
                  <a:pt x="1659" y="208"/>
                </a:cubicBezTo>
                <a:cubicBezTo>
                  <a:pt x="1654" y="216"/>
                  <a:pt x="1649" y="225"/>
                  <a:pt x="1641" y="235"/>
                </a:cubicBezTo>
                <a:cubicBezTo>
                  <a:pt x="1634" y="246"/>
                  <a:pt x="1626" y="255"/>
                  <a:pt x="1616" y="265"/>
                </a:cubicBezTo>
                <a:cubicBezTo>
                  <a:pt x="1599" y="282"/>
                  <a:pt x="1582" y="295"/>
                  <a:pt x="1564" y="303"/>
                </a:cubicBezTo>
                <a:cubicBezTo>
                  <a:pt x="1547" y="311"/>
                  <a:pt x="1529" y="314"/>
                  <a:pt x="1511" y="314"/>
                </a:cubicBezTo>
                <a:cubicBezTo>
                  <a:pt x="1493" y="313"/>
                  <a:pt x="1475" y="308"/>
                  <a:pt x="1456" y="298"/>
                </a:cubicBezTo>
                <a:cubicBezTo>
                  <a:pt x="1438" y="289"/>
                  <a:pt x="1419" y="275"/>
                  <a:pt x="1400" y="256"/>
                </a:cubicBezTo>
                <a:cubicBezTo>
                  <a:pt x="1383" y="238"/>
                  <a:pt x="1369" y="220"/>
                  <a:pt x="1359" y="201"/>
                </a:cubicBezTo>
                <a:cubicBezTo>
                  <a:pt x="1350" y="183"/>
                  <a:pt x="1345" y="164"/>
                  <a:pt x="1343" y="146"/>
                </a:cubicBezTo>
                <a:cubicBezTo>
                  <a:pt x="1342" y="127"/>
                  <a:pt x="1345" y="109"/>
                  <a:pt x="1352" y="92"/>
                </a:cubicBezTo>
                <a:cubicBezTo>
                  <a:pt x="1359" y="74"/>
                  <a:pt x="1370" y="58"/>
                  <a:pt x="1385" y="43"/>
                </a:cubicBezTo>
                <a:cubicBezTo>
                  <a:pt x="1401" y="26"/>
                  <a:pt x="1418" y="15"/>
                  <a:pt x="1434" y="9"/>
                </a:cubicBezTo>
                <a:cubicBezTo>
                  <a:pt x="1451" y="3"/>
                  <a:pt x="1467" y="0"/>
                  <a:pt x="1483" y="2"/>
                </a:cubicBezTo>
                <a:cubicBezTo>
                  <a:pt x="1499" y="3"/>
                  <a:pt x="1515" y="8"/>
                  <a:pt x="1530" y="17"/>
                </a:cubicBezTo>
                <a:cubicBezTo>
                  <a:pt x="1546" y="25"/>
                  <a:pt x="1560" y="36"/>
                  <a:pt x="1573" y="50"/>
                </a:cubicBezTo>
                <a:lnTo>
                  <a:pt x="1580" y="56"/>
                </a:lnTo>
                <a:close/>
                <a:moveTo>
                  <a:pt x="1531" y="83"/>
                </a:moveTo>
                <a:cubicBezTo>
                  <a:pt x="1512" y="63"/>
                  <a:pt x="1492" y="52"/>
                  <a:pt x="1471" y="50"/>
                </a:cubicBezTo>
                <a:cubicBezTo>
                  <a:pt x="1450" y="48"/>
                  <a:pt x="1431" y="56"/>
                  <a:pt x="1413" y="74"/>
                </a:cubicBezTo>
                <a:cubicBezTo>
                  <a:pt x="1403" y="84"/>
                  <a:pt x="1397" y="94"/>
                  <a:pt x="1393" y="104"/>
                </a:cubicBezTo>
                <a:cubicBezTo>
                  <a:pt x="1390" y="115"/>
                  <a:pt x="1388" y="125"/>
                  <a:pt x="1389" y="136"/>
                </a:cubicBezTo>
                <a:cubicBezTo>
                  <a:pt x="1391" y="146"/>
                  <a:pt x="1394" y="157"/>
                  <a:pt x="1399" y="167"/>
                </a:cubicBezTo>
                <a:cubicBezTo>
                  <a:pt x="1404" y="178"/>
                  <a:pt x="1410" y="187"/>
                  <a:pt x="1418" y="196"/>
                </a:cubicBezTo>
                <a:lnTo>
                  <a:pt x="1531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7" name="Freeform 261"/>
          <p:cNvSpPr>
            <a:spLocks noEditPoints="1"/>
          </p:cNvSpPr>
          <p:nvPr/>
        </p:nvSpPr>
        <p:spPr bwMode="auto">
          <a:xfrm>
            <a:off x="4530767" y="4418880"/>
            <a:ext cx="339463" cy="387350"/>
          </a:xfrm>
          <a:custGeom>
            <a:avLst/>
            <a:gdLst>
              <a:gd name="T0" fmla="*/ 304 w 2137"/>
              <a:gd name="T1" fmla="*/ 2033 h 2040"/>
              <a:gd name="T2" fmla="*/ 2 w 2137"/>
              <a:gd name="T3" fmla="*/ 1742 h 2040"/>
              <a:gd name="T4" fmla="*/ 42 w 2137"/>
              <a:gd name="T5" fmla="*/ 1713 h 2040"/>
              <a:gd name="T6" fmla="*/ 461 w 2137"/>
              <a:gd name="T7" fmla="*/ 1884 h 2040"/>
              <a:gd name="T8" fmla="*/ 361 w 2137"/>
              <a:gd name="T9" fmla="*/ 1915 h 2040"/>
              <a:gd name="T10" fmla="*/ 381 w 2137"/>
              <a:gd name="T11" fmla="*/ 1883 h 2040"/>
              <a:gd name="T12" fmla="*/ 441 w 2137"/>
              <a:gd name="T13" fmla="*/ 1777 h 2040"/>
              <a:gd name="T14" fmla="*/ 292 w 2137"/>
              <a:gd name="T15" fmla="*/ 1803 h 2040"/>
              <a:gd name="T16" fmla="*/ 249 w 2137"/>
              <a:gd name="T17" fmla="*/ 1642 h 2040"/>
              <a:gd name="T18" fmla="*/ 323 w 2137"/>
              <a:gd name="T19" fmla="*/ 1608 h 2040"/>
              <a:gd name="T20" fmla="*/ 344 w 2137"/>
              <a:gd name="T21" fmla="*/ 1638 h 2040"/>
              <a:gd name="T22" fmla="*/ 257 w 2137"/>
              <a:gd name="T23" fmla="*/ 1709 h 2040"/>
              <a:gd name="T24" fmla="*/ 363 w 2137"/>
              <a:gd name="T25" fmla="*/ 1730 h 2040"/>
              <a:gd name="T26" fmla="*/ 715 w 2137"/>
              <a:gd name="T27" fmla="*/ 1492 h 2040"/>
              <a:gd name="T28" fmla="*/ 526 w 2137"/>
              <a:gd name="T29" fmla="*/ 1690 h 2040"/>
              <a:gd name="T30" fmla="*/ 515 w 2137"/>
              <a:gd name="T31" fmla="*/ 1392 h 2040"/>
              <a:gd name="T32" fmla="*/ 567 w 2137"/>
              <a:gd name="T33" fmla="*/ 1436 h 2040"/>
              <a:gd name="T34" fmla="*/ 510 w 2137"/>
              <a:gd name="T35" fmla="*/ 1607 h 2040"/>
              <a:gd name="T36" fmla="*/ 682 w 2137"/>
              <a:gd name="T37" fmla="*/ 1554 h 2040"/>
              <a:gd name="T38" fmla="*/ 872 w 2137"/>
              <a:gd name="T39" fmla="*/ 1466 h 2040"/>
              <a:gd name="T40" fmla="*/ 531 w 2137"/>
              <a:gd name="T41" fmla="*/ 1181 h 2040"/>
              <a:gd name="T42" fmla="*/ 560 w 2137"/>
              <a:gd name="T43" fmla="*/ 1141 h 2040"/>
              <a:gd name="T44" fmla="*/ 1011 w 2137"/>
              <a:gd name="T45" fmla="*/ 1123 h 2040"/>
              <a:gd name="T46" fmla="*/ 1041 w 2137"/>
              <a:gd name="T47" fmla="*/ 1237 h 2040"/>
              <a:gd name="T48" fmla="*/ 1084 w 2137"/>
              <a:gd name="T49" fmla="*/ 1184 h 2040"/>
              <a:gd name="T50" fmla="*/ 1098 w 2137"/>
              <a:gd name="T51" fmla="*/ 1221 h 2040"/>
              <a:gd name="T52" fmla="*/ 885 w 2137"/>
              <a:gd name="T53" fmla="*/ 1334 h 2040"/>
              <a:gd name="T54" fmla="*/ 863 w 2137"/>
              <a:gd name="T55" fmla="*/ 1044 h 2040"/>
              <a:gd name="T56" fmla="*/ 900 w 2137"/>
              <a:gd name="T57" fmla="*/ 1085 h 2040"/>
              <a:gd name="T58" fmla="*/ 960 w 2137"/>
              <a:gd name="T59" fmla="*/ 1118 h 2040"/>
              <a:gd name="T60" fmla="*/ 1335 w 2137"/>
              <a:gd name="T61" fmla="*/ 1003 h 2040"/>
              <a:gd name="T62" fmla="*/ 1260 w 2137"/>
              <a:gd name="T63" fmla="*/ 1085 h 2040"/>
              <a:gd name="T64" fmla="*/ 967 w 2137"/>
              <a:gd name="T65" fmla="*/ 939 h 2040"/>
              <a:gd name="T66" fmla="*/ 1004 w 2137"/>
              <a:gd name="T67" fmla="*/ 902 h 2040"/>
              <a:gd name="T68" fmla="*/ 1235 w 2137"/>
              <a:gd name="T69" fmla="*/ 1045 h 2040"/>
              <a:gd name="T70" fmla="*/ 1112 w 2137"/>
              <a:gd name="T71" fmla="*/ 786 h 2040"/>
              <a:gd name="T72" fmla="*/ 1354 w 2137"/>
              <a:gd name="T73" fmla="*/ 971 h 2040"/>
              <a:gd name="T74" fmla="*/ 1553 w 2137"/>
              <a:gd name="T75" fmla="*/ 761 h 2040"/>
              <a:gd name="T76" fmla="*/ 1364 w 2137"/>
              <a:gd name="T77" fmla="*/ 854 h 2040"/>
              <a:gd name="T78" fmla="*/ 1312 w 2137"/>
              <a:gd name="T79" fmla="*/ 583 h 2040"/>
              <a:gd name="T80" fmla="*/ 1390 w 2137"/>
              <a:gd name="T81" fmla="*/ 568 h 2040"/>
              <a:gd name="T82" fmla="*/ 1350 w 2137"/>
              <a:gd name="T83" fmla="*/ 614 h 2040"/>
              <a:gd name="T84" fmla="*/ 1456 w 2137"/>
              <a:gd name="T85" fmla="*/ 813 h 2040"/>
              <a:gd name="T86" fmla="*/ 1523 w 2137"/>
              <a:gd name="T87" fmla="*/ 706 h 2040"/>
              <a:gd name="T88" fmla="*/ 1663 w 2137"/>
              <a:gd name="T89" fmla="*/ 672 h 2040"/>
              <a:gd name="T90" fmla="*/ 1624 w 2137"/>
              <a:gd name="T91" fmla="*/ 701 h 2040"/>
              <a:gd name="T92" fmla="*/ 1439 w 2137"/>
              <a:gd name="T93" fmla="*/ 460 h 2040"/>
              <a:gd name="T94" fmla="*/ 1403 w 2137"/>
              <a:gd name="T95" fmla="*/ 406 h 2040"/>
              <a:gd name="T96" fmla="*/ 1367 w 2137"/>
              <a:gd name="T97" fmla="*/ 370 h 2040"/>
              <a:gd name="T98" fmla="*/ 1897 w 2137"/>
              <a:gd name="T99" fmla="*/ 442 h 2040"/>
              <a:gd name="T100" fmla="*/ 1719 w 2137"/>
              <a:gd name="T101" fmla="*/ 307 h 2040"/>
              <a:gd name="T102" fmla="*/ 1769 w 2137"/>
              <a:gd name="T103" fmla="*/ 556 h 2040"/>
              <a:gd name="T104" fmla="*/ 1740 w 2137"/>
              <a:gd name="T105" fmla="*/ 595 h 2040"/>
              <a:gd name="T106" fmla="*/ 1527 w 2137"/>
              <a:gd name="T107" fmla="*/ 372 h 2040"/>
              <a:gd name="T108" fmla="*/ 1586 w 2137"/>
              <a:gd name="T109" fmla="*/ 380 h 2040"/>
              <a:gd name="T110" fmla="*/ 1783 w 2137"/>
              <a:gd name="T111" fmla="*/ 290 h 2040"/>
              <a:gd name="T112" fmla="*/ 1945 w 2137"/>
              <a:gd name="T113" fmla="*/ 251 h 2040"/>
              <a:gd name="T114" fmla="*/ 2099 w 2137"/>
              <a:gd name="T115" fmla="*/ 158 h 2040"/>
              <a:gd name="T116" fmla="*/ 2131 w 2137"/>
              <a:gd name="T117" fmla="*/ 161 h 2040"/>
              <a:gd name="T118" fmla="*/ 2105 w 2137"/>
              <a:gd name="T119" fmla="*/ 235 h 2040"/>
              <a:gd name="T120" fmla="*/ 1823 w 2137"/>
              <a:gd name="T121" fmla="*/ 201 h 2040"/>
              <a:gd name="T122" fmla="*/ 1994 w 2137"/>
              <a:gd name="T123" fmla="*/ 17 h 2040"/>
              <a:gd name="T124" fmla="*/ 1857 w 2137"/>
              <a:gd name="T125" fmla="*/ 104 h 20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137" h="2040">
                <a:moveTo>
                  <a:pt x="327" y="1997"/>
                </a:moveTo>
                <a:cubicBezTo>
                  <a:pt x="328" y="1999"/>
                  <a:pt x="329" y="2000"/>
                  <a:pt x="329" y="2002"/>
                </a:cubicBezTo>
                <a:cubicBezTo>
                  <a:pt x="329" y="2003"/>
                  <a:pt x="329" y="2005"/>
                  <a:pt x="328" y="2007"/>
                </a:cubicBezTo>
                <a:cubicBezTo>
                  <a:pt x="327" y="2009"/>
                  <a:pt x="325" y="2012"/>
                  <a:pt x="323" y="2014"/>
                </a:cubicBezTo>
                <a:cubicBezTo>
                  <a:pt x="321" y="2017"/>
                  <a:pt x="318" y="2021"/>
                  <a:pt x="314" y="2025"/>
                </a:cubicBezTo>
                <a:cubicBezTo>
                  <a:pt x="311" y="2028"/>
                  <a:pt x="307" y="2031"/>
                  <a:pt x="304" y="2033"/>
                </a:cubicBezTo>
                <a:cubicBezTo>
                  <a:pt x="301" y="2036"/>
                  <a:pt x="299" y="2037"/>
                  <a:pt x="297" y="2038"/>
                </a:cubicBezTo>
                <a:cubicBezTo>
                  <a:pt x="295" y="2039"/>
                  <a:pt x="293" y="2040"/>
                  <a:pt x="291" y="2039"/>
                </a:cubicBezTo>
                <a:cubicBezTo>
                  <a:pt x="290" y="2039"/>
                  <a:pt x="289" y="2038"/>
                  <a:pt x="287" y="2037"/>
                </a:cubicBezTo>
                <a:lnTo>
                  <a:pt x="3" y="1752"/>
                </a:lnTo>
                <a:cubicBezTo>
                  <a:pt x="1" y="1751"/>
                  <a:pt x="1" y="1750"/>
                  <a:pt x="0" y="1748"/>
                </a:cubicBezTo>
                <a:cubicBezTo>
                  <a:pt x="0" y="1746"/>
                  <a:pt x="1" y="1744"/>
                  <a:pt x="2" y="1742"/>
                </a:cubicBezTo>
                <a:cubicBezTo>
                  <a:pt x="3" y="1740"/>
                  <a:pt x="4" y="1738"/>
                  <a:pt x="7" y="1735"/>
                </a:cubicBezTo>
                <a:cubicBezTo>
                  <a:pt x="9" y="1732"/>
                  <a:pt x="11" y="1729"/>
                  <a:pt x="15" y="1725"/>
                </a:cubicBezTo>
                <a:cubicBezTo>
                  <a:pt x="19" y="1721"/>
                  <a:pt x="22" y="1718"/>
                  <a:pt x="25" y="1716"/>
                </a:cubicBezTo>
                <a:cubicBezTo>
                  <a:pt x="28" y="1714"/>
                  <a:pt x="30" y="1712"/>
                  <a:pt x="33" y="1711"/>
                </a:cubicBezTo>
                <a:cubicBezTo>
                  <a:pt x="35" y="1710"/>
                  <a:pt x="36" y="1710"/>
                  <a:pt x="38" y="1710"/>
                </a:cubicBezTo>
                <a:cubicBezTo>
                  <a:pt x="39" y="1711"/>
                  <a:pt x="41" y="1712"/>
                  <a:pt x="42" y="1713"/>
                </a:cubicBezTo>
                <a:lnTo>
                  <a:pt x="327" y="1997"/>
                </a:lnTo>
                <a:close/>
                <a:moveTo>
                  <a:pt x="475" y="1737"/>
                </a:moveTo>
                <a:cubicBezTo>
                  <a:pt x="486" y="1748"/>
                  <a:pt x="493" y="1759"/>
                  <a:pt x="498" y="1771"/>
                </a:cubicBezTo>
                <a:cubicBezTo>
                  <a:pt x="502" y="1783"/>
                  <a:pt x="503" y="1796"/>
                  <a:pt x="502" y="1809"/>
                </a:cubicBezTo>
                <a:cubicBezTo>
                  <a:pt x="500" y="1821"/>
                  <a:pt x="496" y="1834"/>
                  <a:pt x="489" y="1847"/>
                </a:cubicBezTo>
                <a:cubicBezTo>
                  <a:pt x="482" y="1860"/>
                  <a:pt x="473" y="1872"/>
                  <a:pt x="461" y="1884"/>
                </a:cubicBezTo>
                <a:cubicBezTo>
                  <a:pt x="453" y="1892"/>
                  <a:pt x="446" y="1898"/>
                  <a:pt x="438" y="1903"/>
                </a:cubicBezTo>
                <a:cubicBezTo>
                  <a:pt x="430" y="1909"/>
                  <a:pt x="423" y="1913"/>
                  <a:pt x="416" y="1917"/>
                </a:cubicBezTo>
                <a:cubicBezTo>
                  <a:pt x="409" y="1920"/>
                  <a:pt x="402" y="1923"/>
                  <a:pt x="397" y="1925"/>
                </a:cubicBezTo>
                <a:cubicBezTo>
                  <a:pt x="391" y="1927"/>
                  <a:pt x="387" y="1928"/>
                  <a:pt x="384" y="1928"/>
                </a:cubicBezTo>
                <a:cubicBezTo>
                  <a:pt x="380" y="1928"/>
                  <a:pt x="377" y="1927"/>
                  <a:pt x="374" y="1925"/>
                </a:cubicBezTo>
                <a:cubicBezTo>
                  <a:pt x="370" y="1923"/>
                  <a:pt x="366" y="1920"/>
                  <a:pt x="361" y="1915"/>
                </a:cubicBezTo>
                <a:cubicBezTo>
                  <a:pt x="358" y="1912"/>
                  <a:pt x="356" y="1909"/>
                  <a:pt x="354" y="1907"/>
                </a:cubicBezTo>
                <a:cubicBezTo>
                  <a:pt x="353" y="1905"/>
                  <a:pt x="351" y="1903"/>
                  <a:pt x="351" y="1901"/>
                </a:cubicBezTo>
                <a:cubicBezTo>
                  <a:pt x="350" y="1899"/>
                  <a:pt x="350" y="1898"/>
                  <a:pt x="350" y="1897"/>
                </a:cubicBezTo>
                <a:cubicBezTo>
                  <a:pt x="350" y="1895"/>
                  <a:pt x="351" y="1894"/>
                  <a:pt x="352" y="1893"/>
                </a:cubicBezTo>
                <a:cubicBezTo>
                  <a:pt x="354" y="1891"/>
                  <a:pt x="357" y="1890"/>
                  <a:pt x="363" y="1889"/>
                </a:cubicBezTo>
                <a:cubicBezTo>
                  <a:pt x="368" y="1887"/>
                  <a:pt x="374" y="1886"/>
                  <a:pt x="381" y="1883"/>
                </a:cubicBezTo>
                <a:cubicBezTo>
                  <a:pt x="389" y="1881"/>
                  <a:pt x="397" y="1877"/>
                  <a:pt x="405" y="1873"/>
                </a:cubicBezTo>
                <a:cubicBezTo>
                  <a:pt x="414" y="1868"/>
                  <a:pt x="423" y="1862"/>
                  <a:pt x="431" y="1853"/>
                </a:cubicBezTo>
                <a:cubicBezTo>
                  <a:pt x="438" y="1847"/>
                  <a:pt x="443" y="1840"/>
                  <a:pt x="446" y="1834"/>
                </a:cubicBezTo>
                <a:cubicBezTo>
                  <a:pt x="450" y="1827"/>
                  <a:pt x="453" y="1821"/>
                  <a:pt x="454" y="1814"/>
                </a:cubicBezTo>
                <a:cubicBezTo>
                  <a:pt x="455" y="1808"/>
                  <a:pt x="455" y="1801"/>
                  <a:pt x="453" y="1795"/>
                </a:cubicBezTo>
                <a:cubicBezTo>
                  <a:pt x="451" y="1789"/>
                  <a:pt x="447" y="1783"/>
                  <a:pt x="441" y="1777"/>
                </a:cubicBezTo>
                <a:cubicBezTo>
                  <a:pt x="435" y="1772"/>
                  <a:pt x="429" y="1768"/>
                  <a:pt x="422" y="1767"/>
                </a:cubicBezTo>
                <a:cubicBezTo>
                  <a:pt x="415" y="1766"/>
                  <a:pt x="407" y="1767"/>
                  <a:pt x="399" y="1768"/>
                </a:cubicBezTo>
                <a:cubicBezTo>
                  <a:pt x="392" y="1770"/>
                  <a:pt x="383" y="1773"/>
                  <a:pt x="375" y="1777"/>
                </a:cubicBezTo>
                <a:cubicBezTo>
                  <a:pt x="366" y="1781"/>
                  <a:pt x="358" y="1784"/>
                  <a:pt x="348" y="1788"/>
                </a:cubicBezTo>
                <a:cubicBezTo>
                  <a:pt x="339" y="1792"/>
                  <a:pt x="330" y="1796"/>
                  <a:pt x="321" y="1798"/>
                </a:cubicBezTo>
                <a:cubicBezTo>
                  <a:pt x="311" y="1801"/>
                  <a:pt x="302" y="1803"/>
                  <a:pt x="292" y="1803"/>
                </a:cubicBezTo>
                <a:cubicBezTo>
                  <a:pt x="282" y="1803"/>
                  <a:pt x="273" y="1801"/>
                  <a:pt x="263" y="1798"/>
                </a:cubicBezTo>
                <a:cubicBezTo>
                  <a:pt x="254" y="1794"/>
                  <a:pt x="244" y="1788"/>
                  <a:pt x="235" y="1779"/>
                </a:cubicBezTo>
                <a:cubicBezTo>
                  <a:pt x="227" y="1771"/>
                  <a:pt x="221" y="1761"/>
                  <a:pt x="217" y="1751"/>
                </a:cubicBezTo>
                <a:cubicBezTo>
                  <a:pt x="212" y="1740"/>
                  <a:pt x="210" y="1729"/>
                  <a:pt x="211" y="1717"/>
                </a:cubicBezTo>
                <a:cubicBezTo>
                  <a:pt x="212" y="1705"/>
                  <a:pt x="215" y="1693"/>
                  <a:pt x="221" y="1680"/>
                </a:cubicBezTo>
                <a:cubicBezTo>
                  <a:pt x="227" y="1668"/>
                  <a:pt x="237" y="1655"/>
                  <a:pt x="249" y="1642"/>
                </a:cubicBezTo>
                <a:cubicBezTo>
                  <a:pt x="255" y="1637"/>
                  <a:pt x="261" y="1632"/>
                  <a:pt x="267" y="1627"/>
                </a:cubicBezTo>
                <a:cubicBezTo>
                  <a:pt x="273" y="1623"/>
                  <a:pt x="280" y="1619"/>
                  <a:pt x="285" y="1616"/>
                </a:cubicBezTo>
                <a:cubicBezTo>
                  <a:pt x="291" y="1613"/>
                  <a:pt x="296" y="1610"/>
                  <a:pt x="301" y="1609"/>
                </a:cubicBezTo>
                <a:cubicBezTo>
                  <a:pt x="306" y="1607"/>
                  <a:pt x="310" y="1606"/>
                  <a:pt x="312" y="1606"/>
                </a:cubicBezTo>
                <a:cubicBezTo>
                  <a:pt x="315" y="1606"/>
                  <a:pt x="317" y="1606"/>
                  <a:pt x="319" y="1606"/>
                </a:cubicBezTo>
                <a:cubicBezTo>
                  <a:pt x="320" y="1606"/>
                  <a:pt x="322" y="1607"/>
                  <a:pt x="323" y="1608"/>
                </a:cubicBezTo>
                <a:cubicBezTo>
                  <a:pt x="325" y="1609"/>
                  <a:pt x="326" y="1610"/>
                  <a:pt x="328" y="1611"/>
                </a:cubicBezTo>
                <a:cubicBezTo>
                  <a:pt x="330" y="1613"/>
                  <a:pt x="332" y="1615"/>
                  <a:pt x="335" y="1617"/>
                </a:cubicBezTo>
                <a:cubicBezTo>
                  <a:pt x="337" y="1620"/>
                  <a:pt x="339" y="1622"/>
                  <a:pt x="341" y="1624"/>
                </a:cubicBezTo>
                <a:cubicBezTo>
                  <a:pt x="343" y="1627"/>
                  <a:pt x="344" y="1629"/>
                  <a:pt x="345" y="1630"/>
                </a:cubicBezTo>
                <a:cubicBezTo>
                  <a:pt x="345" y="1632"/>
                  <a:pt x="346" y="1634"/>
                  <a:pt x="345" y="1635"/>
                </a:cubicBezTo>
                <a:cubicBezTo>
                  <a:pt x="345" y="1636"/>
                  <a:pt x="344" y="1637"/>
                  <a:pt x="344" y="1638"/>
                </a:cubicBezTo>
                <a:cubicBezTo>
                  <a:pt x="342" y="1640"/>
                  <a:pt x="339" y="1641"/>
                  <a:pt x="335" y="1642"/>
                </a:cubicBezTo>
                <a:cubicBezTo>
                  <a:pt x="331" y="1643"/>
                  <a:pt x="326" y="1644"/>
                  <a:pt x="320" y="1646"/>
                </a:cubicBezTo>
                <a:cubicBezTo>
                  <a:pt x="314" y="1649"/>
                  <a:pt x="307" y="1652"/>
                  <a:pt x="300" y="1656"/>
                </a:cubicBezTo>
                <a:cubicBezTo>
                  <a:pt x="292" y="1659"/>
                  <a:pt x="285" y="1665"/>
                  <a:pt x="278" y="1672"/>
                </a:cubicBezTo>
                <a:cubicBezTo>
                  <a:pt x="272" y="1679"/>
                  <a:pt x="267" y="1685"/>
                  <a:pt x="263" y="1691"/>
                </a:cubicBezTo>
                <a:cubicBezTo>
                  <a:pt x="260" y="1698"/>
                  <a:pt x="258" y="1704"/>
                  <a:pt x="257" y="1709"/>
                </a:cubicBezTo>
                <a:cubicBezTo>
                  <a:pt x="257" y="1715"/>
                  <a:pt x="258" y="1721"/>
                  <a:pt x="260" y="1726"/>
                </a:cubicBezTo>
                <a:cubicBezTo>
                  <a:pt x="262" y="1731"/>
                  <a:pt x="265" y="1736"/>
                  <a:pt x="269" y="1740"/>
                </a:cubicBezTo>
                <a:cubicBezTo>
                  <a:pt x="275" y="1746"/>
                  <a:pt x="282" y="1750"/>
                  <a:pt x="289" y="1751"/>
                </a:cubicBezTo>
                <a:cubicBezTo>
                  <a:pt x="296" y="1752"/>
                  <a:pt x="304" y="1751"/>
                  <a:pt x="311" y="1750"/>
                </a:cubicBezTo>
                <a:cubicBezTo>
                  <a:pt x="319" y="1748"/>
                  <a:pt x="328" y="1745"/>
                  <a:pt x="336" y="1741"/>
                </a:cubicBezTo>
                <a:cubicBezTo>
                  <a:pt x="345" y="1737"/>
                  <a:pt x="354" y="1733"/>
                  <a:pt x="363" y="1730"/>
                </a:cubicBezTo>
                <a:cubicBezTo>
                  <a:pt x="372" y="1726"/>
                  <a:pt x="382" y="1722"/>
                  <a:pt x="391" y="1719"/>
                </a:cubicBezTo>
                <a:cubicBezTo>
                  <a:pt x="401" y="1716"/>
                  <a:pt x="410" y="1714"/>
                  <a:pt x="420" y="1714"/>
                </a:cubicBezTo>
                <a:cubicBezTo>
                  <a:pt x="429" y="1714"/>
                  <a:pt x="439" y="1715"/>
                  <a:pt x="448" y="1719"/>
                </a:cubicBezTo>
                <a:cubicBezTo>
                  <a:pt x="457" y="1722"/>
                  <a:pt x="467" y="1728"/>
                  <a:pt x="475" y="1737"/>
                </a:cubicBezTo>
                <a:close/>
                <a:moveTo>
                  <a:pt x="675" y="1439"/>
                </a:moveTo>
                <a:cubicBezTo>
                  <a:pt x="692" y="1455"/>
                  <a:pt x="705" y="1473"/>
                  <a:pt x="715" y="1492"/>
                </a:cubicBezTo>
                <a:cubicBezTo>
                  <a:pt x="725" y="1510"/>
                  <a:pt x="730" y="1529"/>
                  <a:pt x="732" y="1548"/>
                </a:cubicBezTo>
                <a:cubicBezTo>
                  <a:pt x="733" y="1567"/>
                  <a:pt x="730" y="1586"/>
                  <a:pt x="723" y="1605"/>
                </a:cubicBezTo>
                <a:cubicBezTo>
                  <a:pt x="715" y="1624"/>
                  <a:pt x="703" y="1642"/>
                  <a:pt x="685" y="1660"/>
                </a:cubicBezTo>
                <a:cubicBezTo>
                  <a:pt x="668" y="1677"/>
                  <a:pt x="651" y="1689"/>
                  <a:pt x="633" y="1696"/>
                </a:cubicBezTo>
                <a:cubicBezTo>
                  <a:pt x="616" y="1704"/>
                  <a:pt x="598" y="1707"/>
                  <a:pt x="580" y="1706"/>
                </a:cubicBezTo>
                <a:cubicBezTo>
                  <a:pt x="562" y="1705"/>
                  <a:pt x="544" y="1699"/>
                  <a:pt x="526" y="1690"/>
                </a:cubicBezTo>
                <a:cubicBezTo>
                  <a:pt x="508" y="1680"/>
                  <a:pt x="490" y="1667"/>
                  <a:pt x="473" y="1649"/>
                </a:cubicBezTo>
                <a:cubicBezTo>
                  <a:pt x="456" y="1632"/>
                  <a:pt x="443" y="1615"/>
                  <a:pt x="433" y="1596"/>
                </a:cubicBezTo>
                <a:cubicBezTo>
                  <a:pt x="423" y="1578"/>
                  <a:pt x="418" y="1559"/>
                  <a:pt x="416" y="1540"/>
                </a:cubicBezTo>
                <a:cubicBezTo>
                  <a:pt x="415" y="1521"/>
                  <a:pt x="418" y="1502"/>
                  <a:pt x="425" y="1483"/>
                </a:cubicBezTo>
                <a:cubicBezTo>
                  <a:pt x="433" y="1464"/>
                  <a:pt x="445" y="1446"/>
                  <a:pt x="463" y="1429"/>
                </a:cubicBezTo>
                <a:cubicBezTo>
                  <a:pt x="480" y="1412"/>
                  <a:pt x="497" y="1399"/>
                  <a:pt x="515" y="1392"/>
                </a:cubicBezTo>
                <a:cubicBezTo>
                  <a:pt x="532" y="1384"/>
                  <a:pt x="550" y="1381"/>
                  <a:pt x="568" y="1382"/>
                </a:cubicBezTo>
                <a:cubicBezTo>
                  <a:pt x="586" y="1384"/>
                  <a:pt x="604" y="1389"/>
                  <a:pt x="622" y="1398"/>
                </a:cubicBezTo>
                <a:cubicBezTo>
                  <a:pt x="640" y="1408"/>
                  <a:pt x="658" y="1421"/>
                  <a:pt x="675" y="1439"/>
                </a:cubicBezTo>
                <a:close/>
                <a:moveTo>
                  <a:pt x="638" y="1480"/>
                </a:moveTo>
                <a:cubicBezTo>
                  <a:pt x="627" y="1469"/>
                  <a:pt x="616" y="1460"/>
                  <a:pt x="604" y="1452"/>
                </a:cubicBezTo>
                <a:cubicBezTo>
                  <a:pt x="592" y="1444"/>
                  <a:pt x="580" y="1439"/>
                  <a:pt x="567" y="1436"/>
                </a:cubicBezTo>
                <a:cubicBezTo>
                  <a:pt x="555" y="1433"/>
                  <a:pt x="543" y="1434"/>
                  <a:pt x="530" y="1438"/>
                </a:cubicBezTo>
                <a:cubicBezTo>
                  <a:pt x="518" y="1442"/>
                  <a:pt x="505" y="1450"/>
                  <a:pt x="493" y="1462"/>
                </a:cubicBezTo>
                <a:cubicBezTo>
                  <a:pt x="482" y="1473"/>
                  <a:pt x="474" y="1485"/>
                  <a:pt x="470" y="1497"/>
                </a:cubicBezTo>
                <a:cubicBezTo>
                  <a:pt x="466" y="1509"/>
                  <a:pt x="465" y="1521"/>
                  <a:pt x="467" y="1534"/>
                </a:cubicBezTo>
                <a:cubicBezTo>
                  <a:pt x="469" y="1546"/>
                  <a:pt x="473" y="1559"/>
                  <a:pt x="481" y="1571"/>
                </a:cubicBezTo>
                <a:cubicBezTo>
                  <a:pt x="488" y="1584"/>
                  <a:pt x="498" y="1596"/>
                  <a:pt x="510" y="1607"/>
                </a:cubicBezTo>
                <a:cubicBezTo>
                  <a:pt x="521" y="1619"/>
                  <a:pt x="533" y="1628"/>
                  <a:pt x="545" y="1636"/>
                </a:cubicBezTo>
                <a:cubicBezTo>
                  <a:pt x="557" y="1644"/>
                  <a:pt x="569" y="1649"/>
                  <a:pt x="581" y="1652"/>
                </a:cubicBezTo>
                <a:cubicBezTo>
                  <a:pt x="593" y="1654"/>
                  <a:pt x="606" y="1654"/>
                  <a:pt x="618" y="1650"/>
                </a:cubicBezTo>
                <a:cubicBezTo>
                  <a:pt x="631" y="1646"/>
                  <a:pt x="643" y="1638"/>
                  <a:pt x="655" y="1626"/>
                </a:cubicBezTo>
                <a:cubicBezTo>
                  <a:pt x="666" y="1615"/>
                  <a:pt x="674" y="1603"/>
                  <a:pt x="678" y="1591"/>
                </a:cubicBezTo>
                <a:cubicBezTo>
                  <a:pt x="682" y="1579"/>
                  <a:pt x="684" y="1567"/>
                  <a:pt x="682" y="1554"/>
                </a:cubicBezTo>
                <a:cubicBezTo>
                  <a:pt x="680" y="1542"/>
                  <a:pt x="675" y="1529"/>
                  <a:pt x="668" y="1517"/>
                </a:cubicBezTo>
                <a:cubicBezTo>
                  <a:pt x="660" y="1504"/>
                  <a:pt x="650" y="1492"/>
                  <a:pt x="638" y="1480"/>
                </a:cubicBezTo>
                <a:close/>
                <a:moveTo>
                  <a:pt x="875" y="1449"/>
                </a:moveTo>
                <a:cubicBezTo>
                  <a:pt x="877" y="1451"/>
                  <a:pt x="877" y="1452"/>
                  <a:pt x="878" y="1453"/>
                </a:cubicBezTo>
                <a:cubicBezTo>
                  <a:pt x="878" y="1455"/>
                  <a:pt x="878" y="1456"/>
                  <a:pt x="877" y="1458"/>
                </a:cubicBezTo>
                <a:cubicBezTo>
                  <a:pt x="876" y="1460"/>
                  <a:pt x="875" y="1463"/>
                  <a:pt x="872" y="1466"/>
                </a:cubicBezTo>
                <a:cubicBezTo>
                  <a:pt x="870" y="1468"/>
                  <a:pt x="867" y="1472"/>
                  <a:pt x="863" y="1475"/>
                </a:cubicBezTo>
                <a:cubicBezTo>
                  <a:pt x="860" y="1479"/>
                  <a:pt x="857" y="1482"/>
                  <a:pt x="854" y="1484"/>
                </a:cubicBezTo>
                <a:cubicBezTo>
                  <a:pt x="851" y="1486"/>
                  <a:pt x="849" y="1488"/>
                  <a:pt x="847" y="1489"/>
                </a:cubicBezTo>
                <a:cubicBezTo>
                  <a:pt x="845" y="1489"/>
                  <a:pt x="843" y="1490"/>
                  <a:pt x="841" y="1489"/>
                </a:cubicBezTo>
                <a:cubicBezTo>
                  <a:pt x="840" y="1489"/>
                  <a:pt x="839" y="1488"/>
                  <a:pt x="838" y="1487"/>
                </a:cubicBezTo>
                <a:lnTo>
                  <a:pt x="531" y="1181"/>
                </a:lnTo>
                <a:cubicBezTo>
                  <a:pt x="530" y="1180"/>
                  <a:pt x="529" y="1178"/>
                  <a:pt x="529" y="1177"/>
                </a:cubicBezTo>
                <a:cubicBezTo>
                  <a:pt x="529" y="1175"/>
                  <a:pt x="529" y="1174"/>
                  <a:pt x="530" y="1172"/>
                </a:cubicBezTo>
                <a:cubicBezTo>
                  <a:pt x="530" y="1169"/>
                  <a:pt x="532" y="1167"/>
                  <a:pt x="534" y="1164"/>
                </a:cubicBezTo>
                <a:cubicBezTo>
                  <a:pt x="536" y="1162"/>
                  <a:pt x="539" y="1158"/>
                  <a:pt x="543" y="1155"/>
                </a:cubicBezTo>
                <a:cubicBezTo>
                  <a:pt x="547" y="1151"/>
                  <a:pt x="550" y="1148"/>
                  <a:pt x="553" y="1146"/>
                </a:cubicBezTo>
                <a:cubicBezTo>
                  <a:pt x="555" y="1144"/>
                  <a:pt x="558" y="1142"/>
                  <a:pt x="560" y="1141"/>
                </a:cubicBezTo>
                <a:cubicBezTo>
                  <a:pt x="562" y="1141"/>
                  <a:pt x="563" y="1140"/>
                  <a:pt x="565" y="1141"/>
                </a:cubicBezTo>
                <a:cubicBezTo>
                  <a:pt x="567" y="1141"/>
                  <a:pt x="568" y="1142"/>
                  <a:pt x="569" y="1143"/>
                </a:cubicBezTo>
                <a:lnTo>
                  <a:pt x="875" y="1449"/>
                </a:lnTo>
                <a:close/>
                <a:moveTo>
                  <a:pt x="1009" y="1091"/>
                </a:moveTo>
                <a:cubicBezTo>
                  <a:pt x="1015" y="1097"/>
                  <a:pt x="1018" y="1103"/>
                  <a:pt x="1017" y="1109"/>
                </a:cubicBezTo>
                <a:cubicBezTo>
                  <a:pt x="1017" y="1114"/>
                  <a:pt x="1015" y="1119"/>
                  <a:pt x="1011" y="1123"/>
                </a:cubicBezTo>
                <a:lnTo>
                  <a:pt x="875" y="1259"/>
                </a:lnTo>
                <a:cubicBezTo>
                  <a:pt x="886" y="1270"/>
                  <a:pt x="898" y="1279"/>
                  <a:pt x="909" y="1286"/>
                </a:cubicBezTo>
                <a:cubicBezTo>
                  <a:pt x="921" y="1293"/>
                  <a:pt x="933" y="1297"/>
                  <a:pt x="944" y="1298"/>
                </a:cubicBezTo>
                <a:cubicBezTo>
                  <a:pt x="956" y="1299"/>
                  <a:pt x="968" y="1297"/>
                  <a:pt x="981" y="1292"/>
                </a:cubicBezTo>
                <a:cubicBezTo>
                  <a:pt x="993" y="1287"/>
                  <a:pt x="1005" y="1279"/>
                  <a:pt x="1017" y="1266"/>
                </a:cubicBezTo>
                <a:cubicBezTo>
                  <a:pt x="1027" y="1256"/>
                  <a:pt x="1035" y="1247"/>
                  <a:pt x="1041" y="1237"/>
                </a:cubicBezTo>
                <a:cubicBezTo>
                  <a:pt x="1047" y="1228"/>
                  <a:pt x="1052" y="1220"/>
                  <a:pt x="1056" y="1212"/>
                </a:cubicBezTo>
                <a:cubicBezTo>
                  <a:pt x="1059" y="1204"/>
                  <a:pt x="1062" y="1198"/>
                  <a:pt x="1064" y="1193"/>
                </a:cubicBezTo>
                <a:cubicBezTo>
                  <a:pt x="1066" y="1188"/>
                  <a:pt x="1068" y="1184"/>
                  <a:pt x="1070" y="1182"/>
                </a:cubicBezTo>
                <a:cubicBezTo>
                  <a:pt x="1071" y="1181"/>
                  <a:pt x="1072" y="1181"/>
                  <a:pt x="1074" y="1180"/>
                </a:cubicBezTo>
                <a:cubicBezTo>
                  <a:pt x="1075" y="1180"/>
                  <a:pt x="1077" y="1180"/>
                  <a:pt x="1078" y="1181"/>
                </a:cubicBezTo>
                <a:cubicBezTo>
                  <a:pt x="1080" y="1181"/>
                  <a:pt x="1081" y="1182"/>
                  <a:pt x="1084" y="1184"/>
                </a:cubicBezTo>
                <a:cubicBezTo>
                  <a:pt x="1086" y="1186"/>
                  <a:pt x="1088" y="1188"/>
                  <a:pt x="1091" y="1191"/>
                </a:cubicBezTo>
                <a:cubicBezTo>
                  <a:pt x="1093" y="1193"/>
                  <a:pt x="1095" y="1195"/>
                  <a:pt x="1096" y="1196"/>
                </a:cubicBezTo>
                <a:cubicBezTo>
                  <a:pt x="1097" y="1198"/>
                  <a:pt x="1098" y="1199"/>
                  <a:pt x="1099" y="1201"/>
                </a:cubicBezTo>
                <a:cubicBezTo>
                  <a:pt x="1100" y="1202"/>
                  <a:pt x="1101" y="1203"/>
                  <a:pt x="1101" y="1205"/>
                </a:cubicBezTo>
                <a:cubicBezTo>
                  <a:pt x="1101" y="1206"/>
                  <a:pt x="1102" y="1208"/>
                  <a:pt x="1102" y="1210"/>
                </a:cubicBezTo>
                <a:cubicBezTo>
                  <a:pt x="1102" y="1211"/>
                  <a:pt x="1101" y="1215"/>
                  <a:pt x="1098" y="1221"/>
                </a:cubicBezTo>
                <a:cubicBezTo>
                  <a:pt x="1096" y="1227"/>
                  <a:pt x="1093" y="1234"/>
                  <a:pt x="1088" y="1243"/>
                </a:cubicBezTo>
                <a:cubicBezTo>
                  <a:pt x="1083" y="1251"/>
                  <a:pt x="1077" y="1260"/>
                  <a:pt x="1070" y="1271"/>
                </a:cubicBezTo>
                <a:cubicBezTo>
                  <a:pt x="1063" y="1281"/>
                  <a:pt x="1054" y="1291"/>
                  <a:pt x="1045" y="1300"/>
                </a:cubicBezTo>
                <a:cubicBezTo>
                  <a:pt x="1028" y="1317"/>
                  <a:pt x="1010" y="1330"/>
                  <a:pt x="993" y="1338"/>
                </a:cubicBezTo>
                <a:cubicBezTo>
                  <a:pt x="975" y="1346"/>
                  <a:pt x="958" y="1350"/>
                  <a:pt x="940" y="1349"/>
                </a:cubicBezTo>
                <a:cubicBezTo>
                  <a:pt x="922" y="1348"/>
                  <a:pt x="903" y="1343"/>
                  <a:pt x="885" y="1334"/>
                </a:cubicBezTo>
                <a:cubicBezTo>
                  <a:pt x="866" y="1324"/>
                  <a:pt x="848" y="1310"/>
                  <a:pt x="829" y="1291"/>
                </a:cubicBezTo>
                <a:cubicBezTo>
                  <a:pt x="811" y="1273"/>
                  <a:pt x="798" y="1255"/>
                  <a:pt x="788" y="1236"/>
                </a:cubicBezTo>
                <a:cubicBezTo>
                  <a:pt x="779" y="1218"/>
                  <a:pt x="773" y="1199"/>
                  <a:pt x="772" y="1181"/>
                </a:cubicBezTo>
                <a:cubicBezTo>
                  <a:pt x="771" y="1162"/>
                  <a:pt x="774" y="1144"/>
                  <a:pt x="781" y="1127"/>
                </a:cubicBezTo>
                <a:cubicBezTo>
                  <a:pt x="788" y="1109"/>
                  <a:pt x="799" y="1093"/>
                  <a:pt x="814" y="1078"/>
                </a:cubicBezTo>
                <a:cubicBezTo>
                  <a:pt x="830" y="1062"/>
                  <a:pt x="846" y="1050"/>
                  <a:pt x="863" y="1044"/>
                </a:cubicBezTo>
                <a:cubicBezTo>
                  <a:pt x="879" y="1038"/>
                  <a:pt x="896" y="1036"/>
                  <a:pt x="912" y="1037"/>
                </a:cubicBezTo>
                <a:cubicBezTo>
                  <a:pt x="928" y="1038"/>
                  <a:pt x="944" y="1043"/>
                  <a:pt x="959" y="1052"/>
                </a:cubicBezTo>
                <a:cubicBezTo>
                  <a:pt x="974" y="1060"/>
                  <a:pt x="989" y="1071"/>
                  <a:pt x="1002" y="1085"/>
                </a:cubicBezTo>
                <a:lnTo>
                  <a:pt x="1009" y="1091"/>
                </a:lnTo>
                <a:close/>
                <a:moveTo>
                  <a:pt x="960" y="1118"/>
                </a:moveTo>
                <a:cubicBezTo>
                  <a:pt x="940" y="1098"/>
                  <a:pt x="920" y="1087"/>
                  <a:pt x="900" y="1085"/>
                </a:cubicBezTo>
                <a:cubicBezTo>
                  <a:pt x="879" y="1083"/>
                  <a:pt x="860" y="1091"/>
                  <a:pt x="841" y="1109"/>
                </a:cubicBezTo>
                <a:cubicBezTo>
                  <a:pt x="832" y="1119"/>
                  <a:pt x="825" y="1129"/>
                  <a:pt x="822" y="1139"/>
                </a:cubicBezTo>
                <a:cubicBezTo>
                  <a:pt x="818" y="1150"/>
                  <a:pt x="817" y="1160"/>
                  <a:pt x="818" y="1171"/>
                </a:cubicBezTo>
                <a:cubicBezTo>
                  <a:pt x="819" y="1182"/>
                  <a:pt x="822" y="1192"/>
                  <a:pt x="827" y="1202"/>
                </a:cubicBezTo>
                <a:cubicBezTo>
                  <a:pt x="832" y="1213"/>
                  <a:pt x="839" y="1222"/>
                  <a:pt x="847" y="1231"/>
                </a:cubicBezTo>
                <a:lnTo>
                  <a:pt x="960" y="1118"/>
                </a:lnTo>
                <a:close/>
                <a:moveTo>
                  <a:pt x="1354" y="971"/>
                </a:moveTo>
                <a:cubicBezTo>
                  <a:pt x="1355" y="972"/>
                  <a:pt x="1356" y="973"/>
                  <a:pt x="1356" y="975"/>
                </a:cubicBezTo>
                <a:cubicBezTo>
                  <a:pt x="1356" y="976"/>
                  <a:pt x="1356" y="978"/>
                  <a:pt x="1355" y="980"/>
                </a:cubicBezTo>
                <a:cubicBezTo>
                  <a:pt x="1355" y="982"/>
                  <a:pt x="1353" y="984"/>
                  <a:pt x="1351" y="987"/>
                </a:cubicBezTo>
                <a:cubicBezTo>
                  <a:pt x="1349" y="989"/>
                  <a:pt x="1347" y="992"/>
                  <a:pt x="1344" y="995"/>
                </a:cubicBezTo>
                <a:cubicBezTo>
                  <a:pt x="1340" y="999"/>
                  <a:pt x="1337" y="1001"/>
                  <a:pt x="1335" y="1003"/>
                </a:cubicBezTo>
                <a:cubicBezTo>
                  <a:pt x="1332" y="1005"/>
                  <a:pt x="1330" y="1007"/>
                  <a:pt x="1328" y="1007"/>
                </a:cubicBezTo>
                <a:cubicBezTo>
                  <a:pt x="1326" y="1008"/>
                  <a:pt x="1324" y="1008"/>
                  <a:pt x="1323" y="1008"/>
                </a:cubicBezTo>
                <a:cubicBezTo>
                  <a:pt x="1322" y="1007"/>
                  <a:pt x="1321" y="1007"/>
                  <a:pt x="1319" y="1005"/>
                </a:cubicBezTo>
                <a:lnTo>
                  <a:pt x="1292" y="978"/>
                </a:lnTo>
                <a:cubicBezTo>
                  <a:pt x="1293" y="1003"/>
                  <a:pt x="1291" y="1024"/>
                  <a:pt x="1286" y="1041"/>
                </a:cubicBezTo>
                <a:cubicBezTo>
                  <a:pt x="1280" y="1059"/>
                  <a:pt x="1272" y="1073"/>
                  <a:pt x="1260" y="1085"/>
                </a:cubicBezTo>
                <a:cubicBezTo>
                  <a:pt x="1246" y="1099"/>
                  <a:pt x="1232" y="1108"/>
                  <a:pt x="1218" y="1113"/>
                </a:cubicBezTo>
                <a:cubicBezTo>
                  <a:pt x="1204" y="1118"/>
                  <a:pt x="1190" y="1119"/>
                  <a:pt x="1177" y="1117"/>
                </a:cubicBezTo>
                <a:cubicBezTo>
                  <a:pt x="1163" y="1115"/>
                  <a:pt x="1150" y="1110"/>
                  <a:pt x="1137" y="1102"/>
                </a:cubicBezTo>
                <a:cubicBezTo>
                  <a:pt x="1124" y="1094"/>
                  <a:pt x="1110" y="1083"/>
                  <a:pt x="1095" y="1068"/>
                </a:cubicBezTo>
                <a:lnTo>
                  <a:pt x="970" y="943"/>
                </a:lnTo>
                <a:cubicBezTo>
                  <a:pt x="968" y="941"/>
                  <a:pt x="968" y="940"/>
                  <a:pt x="967" y="939"/>
                </a:cubicBezTo>
                <a:cubicBezTo>
                  <a:pt x="967" y="937"/>
                  <a:pt x="967" y="935"/>
                  <a:pt x="968" y="933"/>
                </a:cubicBezTo>
                <a:cubicBezTo>
                  <a:pt x="969" y="931"/>
                  <a:pt x="970" y="929"/>
                  <a:pt x="973" y="926"/>
                </a:cubicBezTo>
                <a:cubicBezTo>
                  <a:pt x="975" y="923"/>
                  <a:pt x="978" y="920"/>
                  <a:pt x="981" y="916"/>
                </a:cubicBezTo>
                <a:cubicBezTo>
                  <a:pt x="985" y="913"/>
                  <a:pt x="988" y="910"/>
                  <a:pt x="991" y="908"/>
                </a:cubicBezTo>
                <a:cubicBezTo>
                  <a:pt x="994" y="905"/>
                  <a:pt x="996" y="904"/>
                  <a:pt x="998" y="903"/>
                </a:cubicBezTo>
                <a:cubicBezTo>
                  <a:pt x="1000" y="902"/>
                  <a:pt x="1002" y="902"/>
                  <a:pt x="1004" y="902"/>
                </a:cubicBezTo>
                <a:cubicBezTo>
                  <a:pt x="1005" y="903"/>
                  <a:pt x="1006" y="903"/>
                  <a:pt x="1008" y="904"/>
                </a:cubicBezTo>
                <a:lnTo>
                  <a:pt x="1128" y="1025"/>
                </a:lnTo>
                <a:cubicBezTo>
                  <a:pt x="1140" y="1037"/>
                  <a:pt x="1150" y="1045"/>
                  <a:pt x="1159" y="1051"/>
                </a:cubicBezTo>
                <a:cubicBezTo>
                  <a:pt x="1168" y="1056"/>
                  <a:pt x="1177" y="1060"/>
                  <a:pt x="1186" y="1062"/>
                </a:cubicBezTo>
                <a:cubicBezTo>
                  <a:pt x="1195" y="1063"/>
                  <a:pt x="1203" y="1062"/>
                  <a:pt x="1212" y="1060"/>
                </a:cubicBezTo>
                <a:cubicBezTo>
                  <a:pt x="1220" y="1057"/>
                  <a:pt x="1228" y="1052"/>
                  <a:pt x="1235" y="1045"/>
                </a:cubicBezTo>
                <a:cubicBezTo>
                  <a:pt x="1244" y="1035"/>
                  <a:pt x="1251" y="1023"/>
                  <a:pt x="1253" y="1006"/>
                </a:cubicBezTo>
                <a:cubicBezTo>
                  <a:pt x="1256" y="990"/>
                  <a:pt x="1256" y="970"/>
                  <a:pt x="1254" y="947"/>
                </a:cubicBezTo>
                <a:lnTo>
                  <a:pt x="1109" y="803"/>
                </a:lnTo>
                <a:cubicBezTo>
                  <a:pt x="1108" y="801"/>
                  <a:pt x="1107" y="800"/>
                  <a:pt x="1107" y="799"/>
                </a:cubicBezTo>
                <a:cubicBezTo>
                  <a:pt x="1107" y="797"/>
                  <a:pt x="1107" y="796"/>
                  <a:pt x="1108" y="793"/>
                </a:cubicBezTo>
                <a:cubicBezTo>
                  <a:pt x="1109" y="791"/>
                  <a:pt x="1110" y="789"/>
                  <a:pt x="1112" y="786"/>
                </a:cubicBezTo>
                <a:cubicBezTo>
                  <a:pt x="1114" y="784"/>
                  <a:pt x="1117" y="780"/>
                  <a:pt x="1121" y="777"/>
                </a:cubicBezTo>
                <a:cubicBezTo>
                  <a:pt x="1125" y="773"/>
                  <a:pt x="1128" y="770"/>
                  <a:pt x="1131" y="768"/>
                </a:cubicBezTo>
                <a:cubicBezTo>
                  <a:pt x="1133" y="766"/>
                  <a:pt x="1136" y="764"/>
                  <a:pt x="1138" y="763"/>
                </a:cubicBezTo>
                <a:cubicBezTo>
                  <a:pt x="1140" y="763"/>
                  <a:pt x="1142" y="762"/>
                  <a:pt x="1143" y="763"/>
                </a:cubicBezTo>
                <a:cubicBezTo>
                  <a:pt x="1145" y="763"/>
                  <a:pt x="1146" y="763"/>
                  <a:pt x="1147" y="765"/>
                </a:cubicBezTo>
                <a:lnTo>
                  <a:pt x="1354" y="971"/>
                </a:lnTo>
                <a:close/>
                <a:moveTo>
                  <a:pt x="1543" y="719"/>
                </a:moveTo>
                <a:cubicBezTo>
                  <a:pt x="1545" y="722"/>
                  <a:pt x="1548" y="724"/>
                  <a:pt x="1549" y="726"/>
                </a:cubicBezTo>
                <a:cubicBezTo>
                  <a:pt x="1551" y="728"/>
                  <a:pt x="1552" y="730"/>
                  <a:pt x="1553" y="732"/>
                </a:cubicBezTo>
                <a:cubicBezTo>
                  <a:pt x="1554" y="733"/>
                  <a:pt x="1555" y="735"/>
                  <a:pt x="1555" y="737"/>
                </a:cubicBezTo>
                <a:cubicBezTo>
                  <a:pt x="1556" y="738"/>
                  <a:pt x="1556" y="741"/>
                  <a:pt x="1556" y="745"/>
                </a:cubicBezTo>
                <a:cubicBezTo>
                  <a:pt x="1556" y="748"/>
                  <a:pt x="1555" y="754"/>
                  <a:pt x="1553" y="761"/>
                </a:cubicBezTo>
                <a:cubicBezTo>
                  <a:pt x="1552" y="769"/>
                  <a:pt x="1549" y="776"/>
                  <a:pt x="1546" y="784"/>
                </a:cubicBezTo>
                <a:cubicBezTo>
                  <a:pt x="1542" y="792"/>
                  <a:pt x="1538" y="800"/>
                  <a:pt x="1532" y="808"/>
                </a:cubicBezTo>
                <a:cubicBezTo>
                  <a:pt x="1527" y="817"/>
                  <a:pt x="1521" y="824"/>
                  <a:pt x="1513" y="831"/>
                </a:cubicBezTo>
                <a:cubicBezTo>
                  <a:pt x="1499" y="846"/>
                  <a:pt x="1483" y="857"/>
                  <a:pt x="1467" y="864"/>
                </a:cubicBezTo>
                <a:cubicBezTo>
                  <a:pt x="1450" y="870"/>
                  <a:pt x="1434" y="873"/>
                  <a:pt x="1417" y="871"/>
                </a:cubicBezTo>
                <a:cubicBezTo>
                  <a:pt x="1399" y="869"/>
                  <a:pt x="1382" y="864"/>
                  <a:pt x="1364" y="854"/>
                </a:cubicBezTo>
                <a:cubicBezTo>
                  <a:pt x="1347" y="844"/>
                  <a:pt x="1329" y="830"/>
                  <a:pt x="1311" y="813"/>
                </a:cubicBezTo>
                <a:cubicBezTo>
                  <a:pt x="1290" y="792"/>
                  <a:pt x="1276" y="772"/>
                  <a:pt x="1266" y="753"/>
                </a:cubicBezTo>
                <a:cubicBezTo>
                  <a:pt x="1256" y="733"/>
                  <a:pt x="1251" y="714"/>
                  <a:pt x="1250" y="696"/>
                </a:cubicBezTo>
                <a:cubicBezTo>
                  <a:pt x="1250" y="679"/>
                  <a:pt x="1253" y="661"/>
                  <a:pt x="1260" y="645"/>
                </a:cubicBezTo>
                <a:cubicBezTo>
                  <a:pt x="1267" y="629"/>
                  <a:pt x="1278" y="614"/>
                  <a:pt x="1291" y="601"/>
                </a:cubicBezTo>
                <a:cubicBezTo>
                  <a:pt x="1298" y="594"/>
                  <a:pt x="1305" y="588"/>
                  <a:pt x="1312" y="583"/>
                </a:cubicBezTo>
                <a:cubicBezTo>
                  <a:pt x="1320" y="578"/>
                  <a:pt x="1327" y="574"/>
                  <a:pt x="1334" y="571"/>
                </a:cubicBezTo>
                <a:cubicBezTo>
                  <a:pt x="1341" y="568"/>
                  <a:pt x="1348" y="565"/>
                  <a:pt x="1355" y="564"/>
                </a:cubicBezTo>
                <a:cubicBezTo>
                  <a:pt x="1362" y="563"/>
                  <a:pt x="1367" y="562"/>
                  <a:pt x="1370" y="562"/>
                </a:cubicBezTo>
                <a:cubicBezTo>
                  <a:pt x="1374" y="562"/>
                  <a:pt x="1377" y="562"/>
                  <a:pt x="1379" y="562"/>
                </a:cubicBezTo>
                <a:cubicBezTo>
                  <a:pt x="1380" y="563"/>
                  <a:pt x="1382" y="563"/>
                  <a:pt x="1384" y="564"/>
                </a:cubicBezTo>
                <a:cubicBezTo>
                  <a:pt x="1386" y="565"/>
                  <a:pt x="1388" y="567"/>
                  <a:pt x="1390" y="568"/>
                </a:cubicBezTo>
                <a:cubicBezTo>
                  <a:pt x="1392" y="570"/>
                  <a:pt x="1394" y="572"/>
                  <a:pt x="1397" y="575"/>
                </a:cubicBezTo>
                <a:cubicBezTo>
                  <a:pt x="1403" y="581"/>
                  <a:pt x="1406" y="586"/>
                  <a:pt x="1407" y="590"/>
                </a:cubicBezTo>
                <a:cubicBezTo>
                  <a:pt x="1408" y="593"/>
                  <a:pt x="1408" y="596"/>
                  <a:pt x="1406" y="598"/>
                </a:cubicBezTo>
                <a:cubicBezTo>
                  <a:pt x="1404" y="601"/>
                  <a:pt x="1400" y="602"/>
                  <a:pt x="1394" y="602"/>
                </a:cubicBezTo>
                <a:cubicBezTo>
                  <a:pt x="1389" y="603"/>
                  <a:pt x="1382" y="604"/>
                  <a:pt x="1375" y="605"/>
                </a:cubicBezTo>
                <a:cubicBezTo>
                  <a:pt x="1367" y="607"/>
                  <a:pt x="1359" y="610"/>
                  <a:pt x="1350" y="614"/>
                </a:cubicBezTo>
                <a:cubicBezTo>
                  <a:pt x="1341" y="618"/>
                  <a:pt x="1332" y="624"/>
                  <a:pt x="1323" y="633"/>
                </a:cubicBezTo>
                <a:cubicBezTo>
                  <a:pt x="1305" y="651"/>
                  <a:pt x="1298" y="672"/>
                  <a:pt x="1302" y="696"/>
                </a:cubicBezTo>
                <a:cubicBezTo>
                  <a:pt x="1306" y="719"/>
                  <a:pt x="1322" y="745"/>
                  <a:pt x="1348" y="771"/>
                </a:cubicBezTo>
                <a:cubicBezTo>
                  <a:pt x="1361" y="784"/>
                  <a:pt x="1374" y="795"/>
                  <a:pt x="1387" y="802"/>
                </a:cubicBezTo>
                <a:cubicBezTo>
                  <a:pt x="1399" y="810"/>
                  <a:pt x="1412" y="814"/>
                  <a:pt x="1423" y="816"/>
                </a:cubicBezTo>
                <a:cubicBezTo>
                  <a:pt x="1435" y="818"/>
                  <a:pt x="1446" y="817"/>
                  <a:pt x="1456" y="813"/>
                </a:cubicBezTo>
                <a:cubicBezTo>
                  <a:pt x="1467" y="809"/>
                  <a:pt x="1476" y="803"/>
                  <a:pt x="1486" y="794"/>
                </a:cubicBezTo>
                <a:cubicBezTo>
                  <a:pt x="1494" y="785"/>
                  <a:pt x="1500" y="776"/>
                  <a:pt x="1504" y="767"/>
                </a:cubicBezTo>
                <a:cubicBezTo>
                  <a:pt x="1508" y="757"/>
                  <a:pt x="1511" y="749"/>
                  <a:pt x="1512" y="741"/>
                </a:cubicBezTo>
                <a:cubicBezTo>
                  <a:pt x="1514" y="733"/>
                  <a:pt x="1515" y="725"/>
                  <a:pt x="1516" y="720"/>
                </a:cubicBezTo>
                <a:cubicBezTo>
                  <a:pt x="1516" y="714"/>
                  <a:pt x="1517" y="710"/>
                  <a:pt x="1519" y="708"/>
                </a:cubicBezTo>
                <a:cubicBezTo>
                  <a:pt x="1520" y="707"/>
                  <a:pt x="1522" y="706"/>
                  <a:pt x="1523" y="706"/>
                </a:cubicBezTo>
                <a:cubicBezTo>
                  <a:pt x="1524" y="706"/>
                  <a:pt x="1526" y="706"/>
                  <a:pt x="1528" y="707"/>
                </a:cubicBezTo>
                <a:cubicBezTo>
                  <a:pt x="1530" y="708"/>
                  <a:pt x="1532" y="710"/>
                  <a:pt x="1535" y="712"/>
                </a:cubicBezTo>
                <a:cubicBezTo>
                  <a:pt x="1537" y="713"/>
                  <a:pt x="1540" y="716"/>
                  <a:pt x="1543" y="719"/>
                </a:cubicBezTo>
                <a:close/>
                <a:moveTo>
                  <a:pt x="1662" y="663"/>
                </a:moveTo>
                <a:cubicBezTo>
                  <a:pt x="1663" y="664"/>
                  <a:pt x="1664" y="666"/>
                  <a:pt x="1664" y="667"/>
                </a:cubicBezTo>
                <a:cubicBezTo>
                  <a:pt x="1664" y="668"/>
                  <a:pt x="1664" y="670"/>
                  <a:pt x="1663" y="672"/>
                </a:cubicBezTo>
                <a:cubicBezTo>
                  <a:pt x="1662" y="674"/>
                  <a:pt x="1661" y="677"/>
                  <a:pt x="1659" y="679"/>
                </a:cubicBezTo>
                <a:cubicBezTo>
                  <a:pt x="1657" y="682"/>
                  <a:pt x="1654" y="685"/>
                  <a:pt x="1650" y="689"/>
                </a:cubicBezTo>
                <a:cubicBezTo>
                  <a:pt x="1646" y="693"/>
                  <a:pt x="1643" y="696"/>
                  <a:pt x="1640" y="698"/>
                </a:cubicBezTo>
                <a:cubicBezTo>
                  <a:pt x="1637" y="700"/>
                  <a:pt x="1635" y="701"/>
                  <a:pt x="1633" y="702"/>
                </a:cubicBezTo>
                <a:cubicBezTo>
                  <a:pt x="1631" y="703"/>
                  <a:pt x="1629" y="703"/>
                  <a:pt x="1628" y="703"/>
                </a:cubicBezTo>
                <a:cubicBezTo>
                  <a:pt x="1626" y="703"/>
                  <a:pt x="1625" y="702"/>
                  <a:pt x="1624" y="701"/>
                </a:cubicBezTo>
                <a:lnTo>
                  <a:pt x="1418" y="494"/>
                </a:lnTo>
                <a:cubicBezTo>
                  <a:pt x="1416" y="493"/>
                  <a:pt x="1416" y="492"/>
                  <a:pt x="1415" y="491"/>
                </a:cubicBezTo>
                <a:cubicBezTo>
                  <a:pt x="1415" y="489"/>
                  <a:pt x="1415" y="488"/>
                  <a:pt x="1416" y="485"/>
                </a:cubicBezTo>
                <a:cubicBezTo>
                  <a:pt x="1417" y="483"/>
                  <a:pt x="1418" y="481"/>
                  <a:pt x="1421" y="478"/>
                </a:cubicBezTo>
                <a:cubicBezTo>
                  <a:pt x="1423" y="475"/>
                  <a:pt x="1426" y="472"/>
                  <a:pt x="1429" y="469"/>
                </a:cubicBezTo>
                <a:cubicBezTo>
                  <a:pt x="1433" y="465"/>
                  <a:pt x="1436" y="462"/>
                  <a:pt x="1439" y="460"/>
                </a:cubicBezTo>
                <a:cubicBezTo>
                  <a:pt x="1442" y="458"/>
                  <a:pt x="1444" y="456"/>
                  <a:pt x="1446" y="455"/>
                </a:cubicBezTo>
                <a:cubicBezTo>
                  <a:pt x="1448" y="455"/>
                  <a:pt x="1450" y="454"/>
                  <a:pt x="1451" y="455"/>
                </a:cubicBezTo>
                <a:cubicBezTo>
                  <a:pt x="1453" y="455"/>
                  <a:pt x="1454" y="456"/>
                  <a:pt x="1455" y="457"/>
                </a:cubicBezTo>
                <a:lnTo>
                  <a:pt x="1662" y="663"/>
                </a:lnTo>
                <a:close/>
                <a:moveTo>
                  <a:pt x="1390" y="383"/>
                </a:moveTo>
                <a:cubicBezTo>
                  <a:pt x="1399" y="391"/>
                  <a:pt x="1403" y="399"/>
                  <a:pt x="1403" y="406"/>
                </a:cubicBezTo>
                <a:cubicBezTo>
                  <a:pt x="1403" y="412"/>
                  <a:pt x="1398" y="420"/>
                  <a:pt x="1389" y="429"/>
                </a:cubicBezTo>
                <a:cubicBezTo>
                  <a:pt x="1380" y="438"/>
                  <a:pt x="1373" y="443"/>
                  <a:pt x="1366" y="443"/>
                </a:cubicBezTo>
                <a:cubicBezTo>
                  <a:pt x="1360" y="443"/>
                  <a:pt x="1352" y="439"/>
                  <a:pt x="1344" y="430"/>
                </a:cubicBezTo>
                <a:cubicBezTo>
                  <a:pt x="1335" y="421"/>
                  <a:pt x="1331" y="413"/>
                  <a:pt x="1331" y="407"/>
                </a:cubicBezTo>
                <a:cubicBezTo>
                  <a:pt x="1331" y="400"/>
                  <a:pt x="1335" y="392"/>
                  <a:pt x="1344" y="383"/>
                </a:cubicBezTo>
                <a:cubicBezTo>
                  <a:pt x="1353" y="374"/>
                  <a:pt x="1361" y="370"/>
                  <a:pt x="1367" y="370"/>
                </a:cubicBezTo>
                <a:cubicBezTo>
                  <a:pt x="1374" y="370"/>
                  <a:pt x="1381" y="374"/>
                  <a:pt x="1390" y="383"/>
                </a:cubicBezTo>
                <a:close/>
                <a:moveTo>
                  <a:pt x="1909" y="416"/>
                </a:moveTo>
                <a:cubicBezTo>
                  <a:pt x="1910" y="417"/>
                  <a:pt x="1911" y="418"/>
                  <a:pt x="1911" y="420"/>
                </a:cubicBezTo>
                <a:cubicBezTo>
                  <a:pt x="1911" y="421"/>
                  <a:pt x="1911" y="423"/>
                  <a:pt x="1910" y="425"/>
                </a:cubicBezTo>
                <a:cubicBezTo>
                  <a:pt x="1910" y="427"/>
                  <a:pt x="1908" y="429"/>
                  <a:pt x="1906" y="432"/>
                </a:cubicBezTo>
                <a:cubicBezTo>
                  <a:pt x="1904" y="435"/>
                  <a:pt x="1901" y="438"/>
                  <a:pt x="1897" y="442"/>
                </a:cubicBezTo>
                <a:cubicBezTo>
                  <a:pt x="1894" y="445"/>
                  <a:pt x="1890" y="448"/>
                  <a:pt x="1887" y="451"/>
                </a:cubicBezTo>
                <a:cubicBezTo>
                  <a:pt x="1885" y="453"/>
                  <a:pt x="1882" y="454"/>
                  <a:pt x="1880" y="455"/>
                </a:cubicBezTo>
                <a:cubicBezTo>
                  <a:pt x="1878" y="456"/>
                  <a:pt x="1877" y="456"/>
                  <a:pt x="1875" y="456"/>
                </a:cubicBezTo>
                <a:cubicBezTo>
                  <a:pt x="1874" y="455"/>
                  <a:pt x="1872" y="455"/>
                  <a:pt x="1871" y="453"/>
                </a:cubicBezTo>
                <a:lnTo>
                  <a:pt x="1750" y="333"/>
                </a:lnTo>
                <a:cubicBezTo>
                  <a:pt x="1739" y="321"/>
                  <a:pt x="1728" y="312"/>
                  <a:pt x="1719" y="307"/>
                </a:cubicBezTo>
                <a:cubicBezTo>
                  <a:pt x="1710" y="302"/>
                  <a:pt x="1701" y="298"/>
                  <a:pt x="1693" y="296"/>
                </a:cubicBezTo>
                <a:cubicBezTo>
                  <a:pt x="1684" y="295"/>
                  <a:pt x="1675" y="295"/>
                  <a:pt x="1667" y="298"/>
                </a:cubicBezTo>
                <a:cubicBezTo>
                  <a:pt x="1659" y="301"/>
                  <a:pt x="1651" y="306"/>
                  <a:pt x="1644" y="313"/>
                </a:cubicBezTo>
                <a:cubicBezTo>
                  <a:pt x="1634" y="323"/>
                  <a:pt x="1628" y="336"/>
                  <a:pt x="1625" y="352"/>
                </a:cubicBezTo>
                <a:cubicBezTo>
                  <a:pt x="1622" y="368"/>
                  <a:pt x="1622" y="388"/>
                  <a:pt x="1625" y="411"/>
                </a:cubicBezTo>
                <a:lnTo>
                  <a:pt x="1769" y="556"/>
                </a:lnTo>
                <a:cubicBezTo>
                  <a:pt x="1770" y="557"/>
                  <a:pt x="1771" y="558"/>
                  <a:pt x="1771" y="560"/>
                </a:cubicBezTo>
                <a:cubicBezTo>
                  <a:pt x="1772" y="561"/>
                  <a:pt x="1771" y="563"/>
                  <a:pt x="1771" y="565"/>
                </a:cubicBezTo>
                <a:cubicBezTo>
                  <a:pt x="1770" y="567"/>
                  <a:pt x="1768" y="569"/>
                  <a:pt x="1766" y="572"/>
                </a:cubicBezTo>
                <a:cubicBezTo>
                  <a:pt x="1764" y="575"/>
                  <a:pt x="1761" y="578"/>
                  <a:pt x="1757" y="582"/>
                </a:cubicBezTo>
                <a:cubicBezTo>
                  <a:pt x="1754" y="585"/>
                  <a:pt x="1750" y="588"/>
                  <a:pt x="1748" y="590"/>
                </a:cubicBezTo>
                <a:cubicBezTo>
                  <a:pt x="1745" y="593"/>
                  <a:pt x="1742" y="594"/>
                  <a:pt x="1740" y="595"/>
                </a:cubicBezTo>
                <a:cubicBezTo>
                  <a:pt x="1738" y="596"/>
                  <a:pt x="1737" y="596"/>
                  <a:pt x="1735" y="596"/>
                </a:cubicBezTo>
                <a:cubicBezTo>
                  <a:pt x="1734" y="595"/>
                  <a:pt x="1733" y="595"/>
                  <a:pt x="1731" y="593"/>
                </a:cubicBezTo>
                <a:lnTo>
                  <a:pt x="1525" y="387"/>
                </a:lnTo>
                <a:cubicBezTo>
                  <a:pt x="1524" y="386"/>
                  <a:pt x="1523" y="385"/>
                  <a:pt x="1523" y="383"/>
                </a:cubicBezTo>
                <a:cubicBezTo>
                  <a:pt x="1522" y="382"/>
                  <a:pt x="1522" y="380"/>
                  <a:pt x="1523" y="378"/>
                </a:cubicBezTo>
                <a:cubicBezTo>
                  <a:pt x="1524" y="376"/>
                  <a:pt x="1525" y="374"/>
                  <a:pt x="1527" y="372"/>
                </a:cubicBezTo>
                <a:cubicBezTo>
                  <a:pt x="1529" y="369"/>
                  <a:pt x="1532" y="366"/>
                  <a:pt x="1535" y="363"/>
                </a:cubicBezTo>
                <a:cubicBezTo>
                  <a:pt x="1538" y="359"/>
                  <a:pt x="1541" y="357"/>
                  <a:pt x="1544" y="355"/>
                </a:cubicBezTo>
                <a:cubicBezTo>
                  <a:pt x="1546" y="353"/>
                  <a:pt x="1548" y="351"/>
                  <a:pt x="1550" y="351"/>
                </a:cubicBezTo>
                <a:cubicBezTo>
                  <a:pt x="1552" y="350"/>
                  <a:pt x="1554" y="350"/>
                  <a:pt x="1555" y="351"/>
                </a:cubicBezTo>
                <a:cubicBezTo>
                  <a:pt x="1557" y="351"/>
                  <a:pt x="1558" y="352"/>
                  <a:pt x="1559" y="353"/>
                </a:cubicBezTo>
                <a:lnTo>
                  <a:pt x="1586" y="380"/>
                </a:lnTo>
                <a:cubicBezTo>
                  <a:pt x="1585" y="356"/>
                  <a:pt x="1587" y="334"/>
                  <a:pt x="1593" y="317"/>
                </a:cubicBezTo>
                <a:cubicBezTo>
                  <a:pt x="1598" y="299"/>
                  <a:pt x="1607" y="285"/>
                  <a:pt x="1619" y="273"/>
                </a:cubicBezTo>
                <a:cubicBezTo>
                  <a:pt x="1632" y="259"/>
                  <a:pt x="1646" y="250"/>
                  <a:pt x="1660" y="245"/>
                </a:cubicBezTo>
                <a:cubicBezTo>
                  <a:pt x="1674" y="240"/>
                  <a:pt x="1688" y="239"/>
                  <a:pt x="1702" y="241"/>
                </a:cubicBezTo>
                <a:cubicBezTo>
                  <a:pt x="1715" y="243"/>
                  <a:pt x="1729" y="248"/>
                  <a:pt x="1742" y="256"/>
                </a:cubicBezTo>
                <a:cubicBezTo>
                  <a:pt x="1755" y="264"/>
                  <a:pt x="1769" y="275"/>
                  <a:pt x="1783" y="290"/>
                </a:cubicBezTo>
                <a:lnTo>
                  <a:pt x="1909" y="416"/>
                </a:lnTo>
                <a:close/>
                <a:moveTo>
                  <a:pt x="2044" y="56"/>
                </a:moveTo>
                <a:cubicBezTo>
                  <a:pt x="2050" y="62"/>
                  <a:pt x="2053" y="68"/>
                  <a:pt x="2052" y="73"/>
                </a:cubicBezTo>
                <a:cubicBezTo>
                  <a:pt x="2052" y="79"/>
                  <a:pt x="2050" y="84"/>
                  <a:pt x="2046" y="88"/>
                </a:cubicBezTo>
                <a:lnTo>
                  <a:pt x="1910" y="223"/>
                </a:lnTo>
                <a:cubicBezTo>
                  <a:pt x="1922" y="235"/>
                  <a:pt x="1933" y="244"/>
                  <a:pt x="1945" y="251"/>
                </a:cubicBezTo>
                <a:cubicBezTo>
                  <a:pt x="1956" y="258"/>
                  <a:pt x="1968" y="262"/>
                  <a:pt x="1980" y="263"/>
                </a:cubicBezTo>
                <a:cubicBezTo>
                  <a:pt x="1992" y="264"/>
                  <a:pt x="2004" y="262"/>
                  <a:pt x="2016" y="257"/>
                </a:cubicBezTo>
                <a:cubicBezTo>
                  <a:pt x="2028" y="252"/>
                  <a:pt x="2040" y="243"/>
                  <a:pt x="2053" y="231"/>
                </a:cubicBezTo>
                <a:cubicBezTo>
                  <a:pt x="2062" y="221"/>
                  <a:pt x="2070" y="211"/>
                  <a:pt x="2076" y="202"/>
                </a:cubicBezTo>
                <a:cubicBezTo>
                  <a:pt x="2083" y="193"/>
                  <a:pt x="2087" y="184"/>
                  <a:pt x="2091" y="177"/>
                </a:cubicBezTo>
                <a:cubicBezTo>
                  <a:pt x="2095" y="169"/>
                  <a:pt x="2097" y="163"/>
                  <a:pt x="2099" y="158"/>
                </a:cubicBezTo>
                <a:cubicBezTo>
                  <a:pt x="2101" y="152"/>
                  <a:pt x="2103" y="149"/>
                  <a:pt x="2105" y="147"/>
                </a:cubicBezTo>
                <a:cubicBezTo>
                  <a:pt x="2106" y="146"/>
                  <a:pt x="2107" y="145"/>
                  <a:pt x="2109" y="145"/>
                </a:cubicBezTo>
                <a:cubicBezTo>
                  <a:pt x="2110" y="145"/>
                  <a:pt x="2112" y="145"/>
                  <a:pt x="2113" y="145"/>
                </a:cubicBezTo>
                <a:cubicBezTo>
                  <a:pt x="2115" y="146"/>
                  <a:pt x="2117" y="147"/>
                  <a:pt x="2119" y="149"/>
                </a:cubicBezTo>
                <a:cubicBezTo>
                  <a:pt x="2121" y="151"/>
                  <a:pt x="2123" y="153"/>
                  <a:pt x="2126" y="156"/>
                </a:cubicBezTo>
                <a:cubicBezTo>
                  <a:pt x="2128" y="158"/>
                  <a:pt x="2130" y="159"/>
                  <a:pt x="2131" y="161"/>
                </a:cubicBezTo>
                <a:cubicBezTo>
                  <a:pt x="2132" y="163"/>
                  <a:pt x="2133" y="164"/>
                  <a:pt x="2134" y="165"/>
                </a:cubicBezTo>
                <a:cubicBezTo>
                  <a:pt x="2135" y="167"/>
                  <a:pt x="2136" y="168"/>
                  <a:pt x="2136" y="170"/>
                </a:cubicBezTo>
                <a:cubicBezTo>
                  <a:pt x="2137" y="171"/>
                  <a:pt x="2137" y="173"/>
                  <a:pt x="2137" y="174"/>
                </a:cubicBezTo>
                <a:cubicBezTo>
                  <a:pt x="2137" y="176"/>
                  <a:pt x="2136" y="180"/>
                  <a:pt x="2134" y="186"/>
                </a:cubicBezTo>
                <a:cubicBezTo>
                  <a:pt x="2131" y="192"/>
                  <a:pt x="2128" y="199"/>
                  <a:pt x="2123" y="208"/>
                </a:cubicBezTo>
                <a:cubicBezTo>
                  <a:pt x="2118" y="216"/>
                  <a:pt x="2112" y="225"/>
                  <a:pt x="2105" y="235"/>
                </a:cubicBezTo>
                <a:cubicBezTo>
                  <a:pt x="2098" y="245"/>
                  <a:pt x="2090" y="255"/>
                  <a:pt x="2080" y="265"/>
                </a:cubicBezTo>
                <a:cubicBezTo>
                  <a:pt x="2063" y="282"/>
                  <a:pt x="2046" y="295"/>
                  <a:pt x="2028" y="303"/>
                </a:cubicBezTo>
                <a:cubicBezTo>
                  <a:pt x="2011" y="311"/>
                  <a:pt x="1993" y="314"/>
                  <a:pt x="1975" y="314"/>
                </a:cubicBezTo>
                <a:cubicBezTo>
                  <a:pt x="1957" y="313"/>
                  <a:pt x="1938" y="308"/>
                  <a:pt x="1920" y="298"/>
                </a:cubicBezTo>
                <a:cubicBezTo>
                  <a:pt x="1901" y="289"/>
                  <a:pt x="1883" y="275"/>
                  <a:pt x="1864" y="256"/>
                </a:cubicBezTo>
                <a:cubicBezTo>
                  <a:pt x="1847" y="238"/>
                  <a:pt x="1833" y="220"/>
                  <a:pt x="1823" y="201"/>
                </a:cubicBezTo>
                <a:cubicBezTo>
                  <a:pt x="1814" y="183"/>
                  <a:pt x="1808" y="164"/>
                  <a:pt x="1807" y="145"/>
                </a:cubicBezTo>
                <a:cubicBezTo>
                  <a:pt x="1806" y="127"/>
                  <a:pt x="1809" y="109"/>
                  <a:pt x="1816" y="91"/>
                </a:cubicBezTo>
                <a:cubicBezTo>
                  <a:pt x="1823" y="74"/>
                  <a:pt x="1834" y="58"/>
                  <a:pt x="1849" y="43"/>
                </a:cubicBezTo>
                <a:cubicBezTo>
                  <a:pt x="1865" y="26"/>
                  <a:pt x="1882" y="15"/>
                  <a:pt x="1898" y="9"/>
                </a:cubicBezTo>
                <a:cubicBezTo>
                  <a:pt x="1915" y="3"/>
                  <a:pt x="1931" y="0"/>
                  <a:pt x="1947" y="2"/>
                </a:cubicBezTo>
                <a:cubicBezTo>
                  <a:pt x="1963" y="3"/>
                  <a:pt x="1979" y="8"/>
                  <a:pt x="1994" y="17"/>
                </a:cubicBezTo>
                <a:cubicBezTo>
                  <a:pt x="2010" y="25"/>
                  <a:pt x="2024" y="36"/>
                  <a:pt x="2037" y="49"/>
                </a:cubicBezTo>
                <a:lnTo>
                  <a:pt x="2044" y="56"/>
                </a:lnTo>
                <a:close/>
                <a:moveTo>
                  <a:pt x="1995" y="83"/>
                </a:moveTo>
                <a:cubicBezTo>
                  <a:pt x="1976" y="63"/>
                  <a:pt x="1956" y="52"/>
                  <a:pt x="1935" y="50"/>
                </a:cubicBezTo>
                <a:cubicBezTo>
                  <a:pt x="1914" y="48"/>
                  <a:pt x="1895" y="56"/>
                  <a:pt x="1877" y="74"/>
                </a:cubicBezTo>
                <a:cubicBezTo>
                  <a:pt x="1867" y="83"/>
                  <a:pt x="1861" y="93"/>
                  <a:pt x="1857" y="104"/>
                </a:cubicBezTo>
                <a:cubicBezTo>
                  <a:pt x="1854" y="115"/>
                  <a:pt x="1852" y="125"/>
                  <a:pt x="1853" y="136"/>
                </a:cubicBezTo>
                <a:cubicBezTo>
                  <a:pt x="1854" y="146"/>
                  <a:pt x="1857" y="157"/>
                  <a:pt x="1863" y="167"/>
                </a:cubicBezTo>
                <a:cubicBezTo>
                  <a:pt x="1868" y="177"/>
                  <a:pt x="1874" y="187"/>
                  <a:pt x="1882" y="196"/>
                </a:cubicBezTo>
                <a:lnTo>
                  <a:pt x="1995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8" name="Freeform 262"/>
          <p:cNvSpPr>
            <a:spLocks noEditPoints="1"/>
          </p:cNvSpPr>
          <p:nvPr/>
        </p:nvSpPr>
        <p:spPr bwMode="auto">
          <a:xfrm>
            <a:off x="4894098" y="4412530"/>
            <a:ext cx="205534" cy="225425"/>
          </a:xfrm>
          <a:custGeom>
            <a:avLst/>
            <a:gdLst>
              <a:gd name="T0" fmla="*/ 215 w 1284"/>
              <a:gd name="T1" fmla="*/ 776 h 1184"/>
              <a:gd name="T2" fmla="*/ 200 w 1284"/>
              <a:gd name="T3" fmla="*/ 790 h 1184"/>
              <a:gd name="T4" fmla="*/ 98 w 1284"/>
              <a:gd name="T5" fmla="*/ 845 h 1184"/>
              <a:gd name="T6" fmla="*/ 71 w 1284"/>
              <a:gd name="T7" fmla="*/ 1014 h 1184"/>
              <a:gd name="T8" fmla="*/ 229 w 1284"/>
              <a:gd name="T9" fmla="*/ 1126 h 1184"/>
              <a:gd name="T10" fmla="*/ 360 w 1284"/>
              <a:gd name="T11" fmla="*/ 1050 h 1184"/>
              <a:gd name="T12" fmla="*/ 221 w 1284"/>
              <a:gd name="T13" fmla="*/ 996 h 1184"/>
              <a:gd name="T14" fmla="*/ 190 w 1284"/>
              <a:gd name="T15" fmla="*/ 980 h 1184"/>
              <a:gd name="T16" fmla="*/ 188 w 1284"/>
              <a:gd name="T17" fmla="*/ 964 h 1184"/>
              <a:gd name="T18" fmla="*/ 296 w 1284"/>
              <a:gd name="T19" fmla="*/ 864 h 1184"/>
              <a:gd name="T20" fmla="*/ 426 w 1284"/>
              <a:gd name="T21" fmla="*/ 985 h 1184"/>
              <a:gd name="T22" fmla="*/ 423 w 1284"/>
              <a:gd name="T23" fmla="*/ 1038 h 1184"/>
              <a:gd name="T24" fmla="*/ 368 w 1284"/>
              <a:gd name="T25" fmla="*/ 1117 h 1184"/>
              <a:gd name="T26" fmla="*/ 144 w 1284"/>
              <a:gd name="T27" fmla="*/ 1165 h 1184"/>
              <a:gd name="T28" fmla="*/ 1 w 1284"/>
              <a:gd name="T29" fmla="*/ 960 h 1184"/>
              <a:gd name="T30" fmla="*/ 100 w 1284"/>
              <a:gd name="T31" fmla="*/ 782 h 1184"/>
              <a:gd name="T32" fmla="*/ 180 w 1284"/>
              <a:gd name="T33" fmla="*/ 748 h 1184"/>
              <a:gd name="T34" fmla="*/ 745 w 1284"/>
              <a:gd name="T35" fmla="*/ 704 h 1184"/>
              <a:gd name="T36" fmla="*/ 754 w 1284"/>
              <a:gd name="T37" fmla="*/ 725 h 1184"/>
              <a:gd name="T38" fmla="*/ 724 w 1284"/>
              <a:gd name="T39" fmla="*/ 753 h 1184"/>
              <a:gd name="T40" fmla="*/ 615 w 1284"/>
              <a:gd name="T41" fmla="*/ 706 h 1184"/>
              <a:gd name="T42" fmla="*/ 541 w 1284"/>
              <a:gd name="T43" fmla="*/ 930 h 1184"/>
              <a:gd name="T44" fmla="*/ 525 w 1284"/>
              <a:gd name="T45" fmla="*/ 955 h 1184"/>
              <a:gd name="T46" fmla="*/ 499 w 1284"/>
              <a:gd name="T47" fmla="*/ 966 h 1184"/>
              <a:gd name="T48" fmla="*/ 315 w 1284"/>
              <a:gd name="T49" fmla="*/ 574 h 1184"/>
              <a:gd name="T50" fmla="*/ 334 w 1284"/>
              <a:gd name="T51" fmla="*/ 547 h 1184"/>
              <a:gd name="T52" fmla="*/ 363 w 1284"/>
              <a:gd name="T53" fmla="*/ 526 h 1184"/>
              <a:gd name="T54" fmla="*/ 374 w 1284"/>
              <a:gd name="T55" fmla="*/ 589 h 1184"/>
              <a:gd name="T56" fmla="*/ 574 w 1284"/>
              <a:gd name="T57" fmla="*/ 685 h 1184"/>
              <a:gd name="T58" fmla="*/ 941 w 1284"/>
              <a:gd name="T59" fmla="*/ 418 h 1184"/>
              <a:gd name="T60" fmla="*/ 945 w 1284"/>
              <a:gd name="T61" fmla="*/ 513 h 1184"/>
              <a:gd name="T62" fmla="*/ 823 w 1284"/>
              <a:gd name="T63" fmla="*/ 654 h 1184"/>
              <a:gd name="T64" fmla="*/ 528 w 1284"/>
              <a:gd name="T65" fmla="*/ 388 h 1184"/>
              <a:gd name="T66" fmla="*/ 594 w 1284"/>
              <a:gd name="T67" fmla="*/ 290 h 1184"/>
              <a:gd name="T68" fmla="*/ 726 w 1284"/>
              <a:gd name="T69" fmla="*/ 244 h 1184"/>
              <a:gd name="T70" fmla="*/ 791 w 1284"/>
              <a:gd name="T71" fmla="*/ 318 h 1184"/>
              <a:gd name="T72" fmla="*/ 818 w 1284"/>
              <a:gd name="T73" fmla="*/ 358 h 1184"/>
              <a:gd name="T74" fmla="*/ 919 w 1284"/>
              <a:gd name="T75" fmla="*/ 388 h 1184"/>
              <a:gd name="T76" fmla="*/ 680 w 1284"/>
              <a:gd name="T77" fmla="*/ 293 h 1184"/>
              <a:gd name="T78" fmla="*/ 583 w 1284"/>
              <a:gd name="T79" fmla="*/ 365 h 1184"/>
              <a:gd name="T80" fmla="*/ 744 w 1284"/>
              <a:gd name="T81" fmla="*/ 388 h 1184"/>
              <a:gd name="T82" fmla="*/ 727 w 1284"/>
              <a:gd name="T83" fmla="*/ 315 h 1184"/>
              <a:gd name="T84" fmla="*/ 823 w 1284"/>
              <a:gd name="T85" fmla="*/ 408 h 1184"/>
              <a:gd name="T86" fmla="*/ 710 w 1284"/>
              <a:gd name="T87" fmla="*/ 492 h 1184"/>
              <a:gd name="T88" fmla="*/ 892 w 1284"/>
              <a:gd name="T89" fmla="*/ 513 h 1184"/>
              <a:gd name="T90" fmla="*/ 879 w 1284"/>
              <a:gd name="T91" fmla="*/ 432 h 1184"/>
              <a:gd name="T92" fmla="*/ 1284 w 1284"/>
              <a:gd name="T93" fmla="*/ 191 h 1184"/>
              <a:gd name="T94" fmla="*/ 1257 w 1284"/>
              <a:gd name="T95" fmla="*/ 222 h 1184"/>
              <a:gd name="T96" fmla="*/ 1239 w 1284"/>
              <a:gd name="T97" fmla="*/ 226 h 1184"/>
              <a:gd name="T98" fmla="*/ 1065 w 1284"/>
              <a:gd name="T99" fmla="*/ 399 h 1184"/>
              <a:gd name="T100" fmla="*/ 1061 w 1284"/>
              <a:gd name="T101" fmla="*/ 418 h 1184"/>
              <a:gd name="T102" fmla="*/ 1032 w 1284"/>
              <a:gd name="T103" fmla="*/ 443 h 1184"/>
              <a:gd name="T104" fmla="*/ 843 w 1284"/>
              <a:gd name="T105" fmla="*/ 54 h 1184"/>
              <a:gd name="T106" fmla="*/ 849 w 1284"/>
              <a:gd name="T107" fmla="*/ 32 h 1184"/>
              <a:gd name="T108" fmla="*/ 882 w 1284"/>
              <a:gd name="T109" fmla="*/ 2 h 1184"/>
              <a:gd name="T110" fmla="*/ 1271 w 1284"/>
              <a:gd name="T111" fmla="*/ 178 h 1184"/>
              <a:gd name="T112" fmla="*/ 996 w 1284"/>
              <a:gd name="T113" fmla="*/ 262 h 1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</a:cxnLst>
            <a:rect l="0" t="0" r="r" b="b"/>
            <a:pathLst>
              <a:path w="1284" h="1184">
                <a:moveTo>
                  <a:pt x="203" y="761"/>
                </a:moveTo>
                <a:cubicBezTo>
                  <a:pt x="206" y="764"/>
                  <a:pt x="209" y="767"/>
                  <a:pt x="211" y="769"/>
                </a:cubicBezTo>
                <a:cubicBezTo>
                  <a:pt x="212" y="772"/>
                  <a:pt x="214" y="774"/>
                  <a:pt x="215" y="776"/>
                </a:cubicBezTo>
                <a:cubicBezTo>
                  <a:pt x="216" y="778"/>
                  <a:pt x="216" y="780"/>
                  <a:pt x="215" y="781"/>
                </a:cubicBezTo>
                <a:cubicBezTo>
                  <a:pt x="215" y="783"/>
                  <a:pt x="215" y="784"/>
                  <a:pt x="213" y="785"/>
                </a:cubicBezTo>
                <a:cubicBezTo>
                  <a:pt x="212" y="787"/>
                  <a:pt x="207" y="789"/>
                  <a:pt x="200" y="790"/>
                </a:cubicBezTo>
                <a:cubicBezTo>
                  <a:pt x="193" y="791"/>
                  <a:pt x="184" y="794"/>
                  <a:pt x="173" y="798"/>
                </a:cubicBezTo>
                <a:cubicBezTo>
                  <a:pt x="162" y="801"/>
                  <a:pt x="151" y="807"/>
                  <a:pt x="138" y="814"/>
                </a:cubicBezTo>
                <a:cubicBezTo>
                  <a:pt x="125" y="821"/>
                  <a:pt x="111" y="831"/>
                  <a:pt x="98" y="845"/>
                </a:cubicBezTo>
                <a:cubicBezTo>
                  <a:pt x="81" y="861"/>
                  <a:pt x="70" y="879"/>
                  <a:pt x="63" y="898"/>
                </a:cubicBezTo>
                <a:cubicBezTo>
                  <a:pt x="56" y="917"/>
                  <a:pt x="53" y="936"/>
                  <a:pt x="54" y="956"/>
                </a:cubicBezTo>
                <a:cubicBezTo>
                  <a:pt x="56" y="975"/>
                  <a:pt x="61" y="995"/>
                  <a:pt x="71" y="1014"/>
                </a:cubicBezTo>
                <a:cubicBezTo>
                  <a:pt x="81" y="1034"/>
                  <a:pt x="94" y="1052"/>
                  <a:pt x="111" y="1069"/>
                </a:cubicBezTo>
                <a:cubicBezTo>
                  <a:pt x="130" y="1088"/>
                  <a:pt x="150" y="1102"/>
                  <a:pt x="170" y="1111"/>
                </a:cubicBezTo>
                <a:cubicBezTo>
                  <a:pt x="189" y="1121"/>
                  <a:pt x="209" y="1126"/>
                  <a:pt x="229" y="1126"/>
                </a:cubicBezTo>
                <a:cubicBezTo>
                  <a:pt x="248" y="1127"/>
                  <a:pt x="267" y="1124"/>
                  <a:pt x="285" y="1116"/>
                </a:cubicBezTo>
                <a:cubicBezTo>
                  <a:pt x="303" y="1108"/>
                  <a:pt x="320" y="1097"/>
                  <a:pt x="335" y="1081"/>
                </a:cubicBezTo>
                <a:cubicBezTo>
                  <a:pt x="344" y="1072"/>
                  <a:pt x="353" y="1062"/>
                  <a:pt x="360" y="1050"/>
                </a:cubicBezTo>
                <a:cubicBezTo>
                  <a:pt x="367" y="1038"/>
                  <a:pt x="372" y="1026"/>
                  <a:pt x="376" y="1014"/>
                </a:cubicBezTo>
                <a:lnTo>
                  <a:pt x="290" y="927"/>
                </a:lnTo>
                <a:lnTo>
                  <a:pt x="221" y="996"/>
                </a:lnTo>
                <a:cubicBezTo>
                  <a:pt x="218" y="999"/>
                  <a:pt x="215" y="999"/>
                  <a:pt x="211" y="998"/>
                </a:cubicBezTo>
                <a:cubicBezTo>
                  <a:pt x="207" y="997"/>
                  <a:pt x="202" y="993"/>
                  <a:pt x="197" y="988"/>
                </a:cubicBezTo>
                <a:cubicBezTo>
                  <a:pt x="194" y="985"/>
                  <a:pt x="192" y="982"/>
                  <a:pt x="190" y="980"/>
                </a:cubicBezTo>
                <a:cubicBezTo>
                  <a:pt x="188" y="978"/>
                  <a:pt x="187" y="975"/>
                  <a:pt x="186" y="974"/>
                </a:cubicBezTo>
                <a:cubicBezTo>
                  <a:pt x="186" y="972"/>
                  <a:pt x="186" y="970"/>
                  <a:pt x="186" y="968"/>
                </a:cubicBezTo>
                <a:cubicBezTo>
                  <a:pt x="186" y="967"/>
                  <a:pt x="187" y="965"/>
                  <a:pt x="188" y="964"/>
                </a:cubicBezTo>
                <a:lnTo>
                  <a:pt x="283" y="870"/>
                </a:lnTo>
                <a:cubicBezTo>
                  <a:pt x="284" y="868"/>
                  <a:pt x="286" y="867"/>
                  <a:pt x="289" y="866"/>
                </a:cubicBezTo>
                <a:cubicBezTo>
                  <a:pt x="291" y="864"/>
                  <a:pt x="293" y="864"/>
                  <a:pt x="296" y="864"/>
                </a:cubicBezTo>
                <a:cubicBezTo>
                  <a:pt x="299" y="864"/>
                  <a:pt x="301" y="864"/>
                  <a:pt x="304" y="866"/>
                </a:cubicBezTo>
                <a:cubicBezTo>
                  <a:pt x="307" y="867"/>
                  <a:pt x="310" y="869"/>
                  <a:pt x="313" y="872"/>
                </a:cubicBezTo>
                <a:lnTo>
                  <a:pt x="426" y="985"/>
                </a:lnTo>
                <a:cubicBezTo>
                  <a:pt x="430" y="989"/>
                  <a:pt x="432" y="993"/>
                  <a:pt x="434" y="997"/>
                </a:cubicBezTo>
                <a:cubicBezTo>
                  <a:pt x="436" y="1001"/>
                  <a:pt x="435" y="1007"/>
                  <a:pt x="433" y="1014"/>
                </a:cubicBezTo>
                <a:cubicBezTo>
                  <a:pt x="431" y="1020"/>
                  <a:pt x="427" y="1028"/>
                  <a:pt x="423" y="1038"/>
                </a:cubicBezTo>
                <a:cubicBezTo>
                  <a:pt x="419" y="1048"/>
                  <a:pt x="414" y="1057"/>
                  <a:pt x="408" y="1066"/>
                </a:cubicBezTo>
                <a:cubicBezTo>
                  <a:pt x="402" y="1076"/>
                  <a:pt x="396" y="1085"/>
                  <a:pt x="389" y="1093"/>
                </a:cubicBezTo>
                <a:cubicBezTo>
                  <a:pt x="383" y="1102"/>
                  <a:pt x="375" y="1110"/>
                  <a:pt x="368" y="1117"/>
                </a:cubicBezTo>
                <a:cubicBezTo>
                  <a:pt x="345" y="1140"/>
                  <a:pt x="321" y="1157"/>
                  <a:pt x="296" y="1168"/>
                </a:cubicBezTo>
                <a:cubicBezTo>
                  <a:pt x="271" y="1179"/>
                  <a:pt x="245" y="1184"/>
                  <a:pt x="220" y="1183"/>
                </a:cubicBezTo>
                <a:cubicBezTo>
                  <a:pt x="194" y="1183"/>
                  <a:pt x="169" y="1176"/>
                  <a:pt x="144" y="1165"/>
                </a:cubicBezTo>
                <a:cubicBezTo>
                  <a:pt x="119" y="1153"/>
                  <a:pt x="95" y="1136"/>
                  <a:pt x="73" y="1113"/>
                </a:cubicBezTo>
                <a:cubicBezTo>
                  <a:pt x="49" y="1090"/>
                  <a:pt x="31" y="1065"/>
                  <a:pt x="19" y="1038"/>
                </a:cubicBezTo>
                <a:cubicBezTo>
                  <a:pt x="7" y="1012"/>
                  <a:pt x="1" y="986"/>
                  <a:pt x="1" y="960"/>
                </a:cubicBezTo>
                <a:cubicBezTo>
                  <a:pt x="0" y="933"/>
                  <a:pt x="5" y="907"/>
                  <a:pt x="16" y="882"/>
                </a:cubicBezTo>
                <a:cubicBezTo>
                  <a:pt x="27" y="856"/>
                  <a:pt x="43" y="833"/>
                  <a:pt x="65" y="811"/>
                </a:cubicBezTo>
                <a:cubicBezTo>
                  <a:pt x="76" y="799"/>
                  <a:pt x="88" y="790"/>
                  <a:pt x="100" y="782"/>
                </a:cubicBezTo>
                <a:cubicBezTo>
                  <a:pt x="112" y="774"/>
                  <a:pt x="123" y="767"/>
                  <a:pt x="133" y="762"/>
                </a:cubicBezTo>
                <a:cubicBezTo>
                  <a:pt x="144" y="757"/>
                  <a:pt x="153" y="753"/>
                  <a:pt x="161" y="751"/>
                </a:cubicBezTo>
                <a:cubicBezTo>
                  <a:pt x="170" y="749"/>
                  <a:pt x="176" y="748"/>
                  <a:pt x="180" y="748"/>
                </a:cubicBezTo>
                <a:cubicBezTo>
                  <a:pt x="184" y="748"/>
                  <a:pt x="188" y="749"/>
                  <a:pt x="191" y="751"/>
                </a:cubicBezTo>
                <a:cubicBezTo>
                  <a:pt x="194" y="753"/>
                  <a:pt x="198" y="756"/>
                  <a:pt x="203" y="761"/>
                </a:cubicBezTo>
                <a:close/>
                <a:moveTo>
                  <a:pt x="745" y="704"/>
                </a:moveTo>
                <a:cubicBezTo>
                  <a:pt x="749" y="706"/>
                  <a:pt x="753" y="708"/>
                  <a:pt x="755" y="710"/>
                </a:cubicBezTo>
                <a:cubicBezTo>
                  <a:pt x="757" y="712"/>
                  <a:pt x="758" y="714"/>
                  <a:pt x="758" y="717"/>
                </a:cubicBezTo>
                <a:cubicBezTo>
                  <a:pt x="758" y="719"/>
                  <a:pt x="756" y="722"/>
                  <a:pt x="754" y="725"/>
                </a:cubicBezTo>
                <a:cubicBezTo>
                  <a:pt x="751" y="728"/>
                  <a:pt x="748" y="732"/>
                  <a:pt x="743" y="737"/>
                </a:cubicBezTo>
                <a:cubicBezTo>
                  <a:pt x="738" y="741"/>
                  <a:pt x="734" y="745"/>
                  <a:pt x="731" y="748"/>
                </a:cubicBezTo>
                <a:cubicBezTo>
                  <a:pt x="728" y="750"/>
                  <a:pt x="726" y="752"/>
                  <a:pt x="724" y="753"/>
                </a:cubicBezTo>
                <a:cubicBezTo>
                  <a:pt x="722" y="754"/>
                  <a:pt x="720" y="754"/>
                  <a:pt x="718" y="754"/>
                </a:cubicBezTo>
                <a:cubicBezTo>
                  <a:pt x="717" y="754"/>
                  <a:pt x="715" y="753"/>
                  <a:pt x="713" y="753"/>
                </a:cubicBezTo>
                <a:lnTo>
                  <a:pt x="615" y="706"/>
                </a:lnTo>
                <a:lnTo>
                  <a:pt x="492" y="829"/>
                </a:lnTo>
                <a:lnTo>
                  <a:pt x="539" y="925"/>
                </a:lnTo>
                <a:cubicBezTo>
                  <a:pt x="540" y="927"/>
                  <a:pt x="540" y="928"/>
                  <a:pt x="541" y="930"/>
                </a:cubicBezTo>
                <a:cubicBezTo>
                  <a:pt x="541" y="932"/>
                  <a:pt x="541" y="934"/>
                  <a:pt x="540" y="936"/>
                </a:cubicBezTo>
                <a:cubicBezTo>
                  <a:pt x="539" y="938"/>
                  <a:pt x="538" y="941"/>
                  <a:pt x="535" y="944"/>
                </a:cubicBezTo>
                <a:cubicBezTo>
                  <a:pt x="533" y="947"/>
                  <a:pt x="529" y="950"/>
                  <a:pt x="525" y="955"/>
                </a:cubicBezTo>
                <a:cubicBezTo>
                  <a:pt x="521" y="959"/>
                  <a:pt x="517" y="962"/>
                  <a:pt x="514" y="965"/>
                </a:cubicBezTo>
                <a:cubicBezTo>
                  <a:pt x="510" y="967"/>
                  <a:pt x="508" y="969"/>
                  <a:pt x="506" y="969"/>
                </a:cubicBezTo>
                <a:cubicBezTo>
                  <a:pt x="503" y="969"/>
                  <a:pt x="501" y="968"/>
                  <a:pt x="499" y="966"/>
                </a:cubicBezTo>
                <a:cubicBezTo>
                  <a:pt x="497" y="963"/>
                  <a:pt x="495" y="960"/>
                  <a:pt x="493" y="955"/>
                </a:cubicBezTo>
                <a:lnTo>
                  <a:pt x="317" y="580"/>
                </a:lnTo>
                <a:cubicBezTo>
                  <a:pt x="316" y="578"/>
                  <a:pt x="315" y="576"/>
                  <a:pt x="315" y="574"/>
                </a:cubicBezTo>
                <a:cubicBezTo>
                  <a:pt x="315" y="572"/>
                  <a:pt x="316" y="569"/>
                  <a:pt x="317" y="567"/>
                </a:cubicBezTo>
                <a:cubicBezTo>
                  <a:pt x="318" y="564"/>
                  <a:pt x="320" y="562"/>
                  <a:pt x="323" y="558"/>
                </a:cubicBezTo>
                <a:cubicBezTo>
                  <a:pt x="326" y="555"/>
                  <a:pt x="330" y="551"/>
                  <a:pt x="334" y="547"/>
                </a:cubicBezTo>
                <a:cubicBezTo>
                  <a:pt x="339" y="542"/>
                  <a:pt x="343" y="538"/>
                  <a:pt x="347" y="535"/>
                </a:cubicBezTo>
                <a:cubicBezTo>
                  <a:pt x="350" y="532"/>
                  <a:pt x="353" y="530"/>
                  <a:pt x="356" y="528"/>
                </a:cubicBezTo>
                <a:cubicBezTo>
                  <a:pt x="358" y="527"/>
                  <a:pt x="361" y="526"/>
                  <a:pt x="363" y="526"/>
                </a:cubicBezTo>
                <a:cubicBezTo>
                  <a:pt x="365" y="526"/>
                  <a:pt x="367" y="527"/>
                  <a:pt x="370" y="528"/>
                </a:cubicBezTo>
                <a:lnTo>
                  <a:pt x="745" y="704"/>
                </a:lnTo>
                <a:close/>
                <a:moveTo>
                  <a:pt x="374" y="589"/>
                </a:moveTo>
                <a:lnTo>
                  <a:pt x="374" y="589"/>
                </a:lnTo>
                <a:lnTo>
                  <a:pt x="470" y="788"/>
                </a:lnTo>
                <a:lnTo>
                  <a:pt x="574" y="685"/>
                </a:lnTo>
                <a:lnTo>
                  <a:pt x="374" y="589"/>
                </a:lnTo>
                <a:close/>
                <a:moveTo>
                  <a:pt x="919" y="388"/>
                </a:moveTo>
                <a:cubicBezTo>
                  <a:pt x="928" y="398"/>
                  <a:pt x="935" y="407"/>
                  <a:pt x="941" y="418"/>
                </a:cubicBezTo>
                <a:cubicBezTo>
                  <a:pt x="946" y="428"/>
                  <a:pt x="950" y="438"/>
                  <a:pt x="952" y="449"/>
                </a:cubicBezTo>
                <a:cubicBezTo>
                  <a:pt x="954" y="459"/>
                  <a:pt x="954" y="470"/>
                  <a:pt x="953" y="481"/>
                </a:cubicBezTo>
                <a:cubicBezTo>
                  <a:pt x="952" y="491"/>
                  <a:pt x="949" y="502"/>
                  <a:pt x="945" y="513"/>
                </a:cubicBezTo>
                <a:cubicBezTo>
                  <a:pt x="940" y="524"/>
                  <a:pt x="935" y="534"/>
                  <a:pt x="928" y="545"/>
                </a:cubicBezTo>
                <a:cubicBezTo>
                  <a:pt x="921" y="555"/>
                  <a:pt x="911" y="565"/>
                  <a:pt x="900" y="577"/>
                </a:cubicBezTo>
                <a:lnTo>
                  <a:pt x="823" y="654"/>
                </a:lnTo>
                <a:cubicBezTo>
                  <a:pt x="819" y="658"/>
                  <a:pt x="815" y="660"/>
                  <a:pt x="809" y="661"/>
                </a:cubicBezTo>
                <a:cubicBezTo>
                  <a:pt x="804" y="661"/>
                  <a:pt x="798" y="659"/>
                  <a:pt x="792" y="653"/>
                </a:cubicBezTo>
                <a:lnTo>
                  <a:pt x="528" y="388"/>
                </a:lnTo>
                <a:cubicBezTo>
                  <a:pt x="522" y="382"/>
                  <a:pt x="519" y="376"/>
                  <a:pt x="520" y="371"/>
                </a:cubicBezTo>
                <a:cubicBezTo>
                  <a:pt x="521" y="365"/>
                  <a:pt x="523" y="361"/>
                  <a:pt x="526" y="357"/>
                </a:cubicBezTo>
                <a:lnTo>
                  <a:pt x="594" y="290"/>
                </a:lnTo>
                <a:cubicBezTo>
                  <a:pt x="611" y="272"/>
                  <a:pt x="628" y="259"/>
                  <a:pt x="642" y="252"/>
                </a:cubicBezTo>
                <a:cubicBezTo>
                  <a:pt x="657" y="244"/>
                  <a:pt x="671" y="239"/>
                  <a:pt x="685" y="238"/>
                </a:cubicBezTo>
                <a:cubicBezTo>
                  <a:pt x="699" y="237"/>
                  <a:pt x="713" y="239"/>
                  <a:pt x="726" y="244"/>
                </a:cubicBezTo>
                <a:cubicBezTo>
                  <a:pt x="739" y="250"/>
                  <a:pt x="751" y="259"/>
                  <a:pt x="763" y="270"/>
                </a:cubicBezTo>
                <a:cubicBezTo>
                  <a:pt x="770" y="277"/>
                  <a:pt x="776" y="285"/>
                  <a:pt x="781" y="293"/>
                </a:cubicBezTo>
                <a:cubicBezTo>
                  <a:pt x="786" y="301"/>
                  <a:pt x="789" y="310"/>
                  <a:pt x="791" y="318"/>
                </a:cubicBezTo>
                <a:cubicBezTo>
                  <a:pt x="793" y="327"/>
                  <a:pt x="794" y="336"/>
                  <a:pt x="793" y="345"/>
                </a:cubicBezTo>
                <a:cubicBezTo>
                  <a:pt x="793" y="354"/>
                  <a:pt x="791" y="364"/>
                  <a:pt x="787" y="373"/>
                </a:cubicBezTo>
                <a:cubicBezTo>
                  <a:pt x="796" y="366"/>
                  <a:pt x="807" y="361"/>
                  <a:pt x="818" y="358"/>
                </a:cubicBezTo>
                <a:cubicBezTo>
                  <a:pt x="829" y="356"/>
                  <a:pt x="840" y="355"/>
                  <a:pt x="852" y="356"/>
                </a:cubicBezTo>
                <a:cubicBezTo>
                  <a:pt x="863" y="357"/>
                  <a:pt x="875" y="360"/>
                  <a:pt x="886" y="365"/>
                </a:cubicBezTo>
                <a:cubicBezTo>
                  <a:pt x="898" y="370"/>
                  <a:pt x="909" y="378"/>
                  <a:pt x="919" y="388"/>
                </a:cubicBezTo>
                <a:close/>
                <a:moveTo>
                  <a:pt x="727" y="315"/>
                </a:moveTo>
                <a:cubicBezTo>
                  <a:pt x="719" y="308"/>
                  <a:pt x="712" y="302"/>
                  <a:pt x="704" y="298"/>
                </a:cubicBezTo>
                <a:cubicBezTo>
                  <a:pt x="696" y="294"/>
                  <a:pt x="688" y="293"/>
                  <a:pt x="680" y="293"/>
                </a:cubicBezTo>
                <a:cubicBezTo>
                  <a:pt x="672" y="293"/>
                  <a:pt x="663" y="296"/>
                  <a:pt x="654" y="300"/>
                </a:cubicBezTo>
                <a:cubicBezTo>
                  <a:pt x="645" y="305"/>
                  <a:pt x="635" y="313"/>
                  <a:pt x="624" y="324"/>
                </a:cubicBezTo>
                <a:lnTo>
                  <a:pt x="583" y="365"/>
                </a:lnTo>
                <a:lnTo>
                  <a:pt x="679" y="461"/>
                </a:lnTo>
                <a:lnTo>
                  <a:pt x="724" y="416"/>
                </a:lnTo>
                <a:cubicBezTo>
                  <a:pt x="734" y="406"/>
                  <a:pt x="741" y="396"/>
                  <a:pt x="744" y="388"/>
                </a:cubicBezTo>
                <a:cubicBezTo>
                  <a:pt x="748" y="379"/>
                  <a:pt x="750" y="370"/>
                  <a:pt x="749" y="361"/>
                </a:cubicBezTo>
                <a:cubicBezTo>
                  <a:pt x="749" y="353"/>
                  <a:pt x="747" y="344"/>
                  <a:pt x="742" y="336"/>
                </a:cubicBezTo>
                <a:cubicBezTo>
                  <a:pt x="738" y="328"/>
                  <a:pt x="733" y="321"/>
                  <a:pt x="727" y="315"/>
                </a:cubicBezTo>
                <a:close/>
                <a:moveTo>
                  <a:pt x="879" y="432"/>
                </a:moveTo>
                <a:cubicBezTo>
                  <a:pt x="871" y="423"/>
                  <a:pt x="861" y="417"/>
                  <a:pt x="852" y="413"/>
                </a:cubicBezTo>
                <a:cubicBezTo>
                  <a:pt x="842" y="409"/>
                  <a:pt x="833" y="407"/>
                  <a:pt x="823" y="408"/>
                </a:cubicBezTo>
                <a:cubicBezTo>
                  <a:pt x="813" y="409"/>
                  <a:pt x="802" y="412"/>
                  <a:pt x="792" y="418"/>
                </a:cubicBezTo>
                <a:cubicBezTo>
                  <a:pt x="781" y="424"/>
                  <a:pt x="770" y="433"/>
                  <a:pt x="757" y="445"/>
                </a:cubicBezTo>
                <a:lnTo>
                  <a:pt x="710" y="492"/>
                </a:lnTo>
                <a:lnTo>
                  <a:pt x="815" y="597"/>
                </a:lnTo>
                <a:lnTo>
                  <a:pt x="872" y="540"/>
                </a:lnTo>
                <a:cubicBezTo>
                  <a:pt x="881" y="531"/>
                  <a:pt x="888" y="522"/>
                  <a:pt x="892" y="513"/>
                </a:cubicBezTo>
                <a:cubicBezTo>
                  <a:pt x="897" y="504"/>
                  <a:pt x="900" y="495"/>
                  <a:pt x="901" y="486"/>
                </a:cubicBezTo>
                <a:cubicBezTo>
                  <a:pt x="901" y="476"/>
                  <a:pt x="900" y="467"/>
                  <a:pt x="897" y="458"/>
                </a:cubicBezTo>
                <a:cubicBezTo>
                  <a:pt x="894" y="449"/>
                  <a:pt x="888" y="440"/>
                  <a:pt x="879" y="432"/>
                </a:cubicBezTo>
                <a:close/>
                <a:moveTo>
                  <a:pt x="1271" y="178"/>
                </a:moveTo>
                <a:cubicBezTo>
                  <a:pt x="1275" y="180"/>
                  <a:pt x="1279" y="182"/>
                  <a:pt x="1281" y="184"/>
                </a:cubicBezTo>
                <a:cubicBezTo>
                  <a:pt x="1283" y="186"/>
                  <a:pt x="1284" y="188"/>
                  <a:pt x="1284" y="191"/>
                </a:cubicBezTo>
                <a:cubicBezTo>
                  <a:pt x="1284" y="193"/>
                  <a:pt x="1282" y="196"/>
                  <a:pt x="1280" y="199"/>
                </a:cubicBezTo>
                <a:cubicBezTo>
                  <a:pt x="1277" y="202"/>
                  <a:pt x="1274" y="206"/>
                  <a:pt x="1269" y="211"/>
                </a:cubicBezTo>
                <a:cubicBezTo>
                  <a:pt x="1264" y="215"/>
                  <a:pt x="1260" y="219"/>
                  <a:pt x="1257" y="222"/>
                </a:cubicBezTo>
                <a:cubicBezTo>
                  <a:pt x="1254" y="224"/>
                  <a:pt x="1252" y="226"/>
                  <a:pt x="1250" y="227"/>
                </a:cubicBezTo>
                <a:cubicBezTo>
                  <a:pt x="1248" y="228"/>
                  <a:pt x="1246" y="228"/>
                  <a:pt x="1244" y="228"/>
                </a:cubicBezTo>
                <a:cubicBezTo>
                  <a:pt x="1243" y="228"/>
                  <a:pt x="1241" y="227"/>
                  <a:pt x="1239" y="226"/>
                </a:cubicBezTo>
                <a:lnTo>
                  <a:pt x="1141" y="180"/>
                </a:lnTo>
                <a:lnTo>
                  <a:pt x="1018" y="303"/>
                </a:lnTo>
                <a:lnTo>
                  <a:pt x="1065" y="399"/>
                </a:lnTo>
                <a:cubicBezTo>
                  <a:pt x="1066" y="400"/>
                  <a:pt x="1067" y="402"/>
                  <a:pt x="1067" y="404"/>
                </a:cubicBezTo>
                <a:cubicBezTo>
                  <a:pt x="1067" y="406"/>
                  <a:pt x="1067" y="408"/>
                  <a:pt x="1066" y="410"/>
                </a:cubicBezTo>
                <a:cubicBezTo>
                  <a:pt x="1065" y="412"/>
                  <a:pt x="1064" y="415"/>
                  <a:pt x="1061" y="418"/>
                </a:cubicBezTo>
                <a:cubicBezTo>
                  <a:pt x="1059" y="421"/>
                  <a:pt x="1056" y="424"/>
                  <a:pt x="1051" y="428"/>
                </a:cubicBezTo>
                <a:cubicBezTo>
                  <a:pt x="1047" y="433"/>
                  <a:pt x="1043" y="436"/>
                  <a:pt x="1040" y="439"/>
                </a:cubicBezTo>
                <a:cubicBezTo>
                  <a:pt x="1037" y="441"/>
                  <a:pt x="1034" y="442"/>
                  <a:pt x="1032" y="443"/>
                </a:cubicBezTo>
                <a:cubicBezTo>
                  <a:pt x="1029" y="443"/>
                  <a:pt x="1027" y="442"/>
                  <a:pt x="1025" y="439"/>
                </a:cubicBezTo>
                <a:cubicBezTo>
                  <a:pt x="1023" y="437"/>
                  <a:pt x="1021" y="434"/>
                  <a:pt x="1019" y="429"/>
                </a:cubicBezTo>
                <a:lnTo>
                  <a:pt x="843" y="54"/>
                </a:lnTo>
                <a:cubicBezTo>
                  <a:pt x="842" y="52"/>
                  <a:pt x="841" y="50"/>
                  <a:pt x="841" y="48"/>
                </a:cubicBezTo>
                <a:cubicBezTo>
                  <a:pt x="841" y="46"/>
                  <a:pt x="842" y="43"/>
                  <a:pt x="843" y="41"/>
                </a:cubicBezTo>
                <a:cubicBezTo>
                  <a:pt x="845" y="38"/>
                  <a:pt x="847" y="35"/>
                  <a:pt x="849" y="32"/>
                </a:cubicBezTo>
                <a:cubicBezTo>
                  <a:pt x="852" y="29"/>
                  <a:pt x="856" y="25"/>
                  <a:pt x="860" y="21"/>
                </a:cubicBezTo>
                <a:cubicBezTo>
                  <a:pt x="865" y="16"/>
                  <a:pt x="869" y="12"/>
                  <a:pt x="873" y="9"/>
                </a:cubicBezTo>
                <a:cubicBezTo>
                  <a:pt x="876" y="6"/>
                  <a:pt x="879" y="4"/>
                  <a:pt x="882" y="2"/>
                </a:cubicBezTo>
                <a:cubicBezTo>
                  <a:pt x="884" y="1"/>
                  <a:pt x="887" y="0"/>
                  <a:pt x="889" y="0"/>
                </a:cubicBezTo>
                <a:cubicBezTo>
                  <a:pt x="891" y="0"/>
                  <a:pt x="894" y="1"/>
                  <a:pt x="896" y="2"/>
                </a:cubicBezTo>
                <a:lnTo>
                  <a:pt x="1271" y="178"/>
                </a:lnTo>
                <a:close/>
                <a:moveTo>
                  <a:pt x="900" y="63"/>
                </a:moveTo>
                <a:lnTo>
                  <a:pt x="900" y="63"/>
                </a:lnTo>
                <a:lnTo>
                  <a:pt x="996" y="262"/>
                </a:lnTo>
                <a:lnTo>
                  <a:pt x="1100" y="159"/>
                </a:lnTo>
                <a:lnTo>
                  <a:pt x="900" y="6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79" name="Freeform 263"/>
          <p:cNvSpPr>
            <a:spLocks noEditPoints="1"/>
          </p:cNvSpPr>
          <p:nvPr/>
        </p:nvSpPr>
        <p:spPr bwMode="auto">
          <a:xfrm>
            <a:off x="5038634" y="4418880"/>
            <a:ext cx="277140" cy="331788"/>
          </a:xfrm>
          <a:custGeom>
            <a:avLst/>
            <a:gdLst>
              <a:gd name="T0" fmla="*/ 416 w 1737"/>
              <a:gd name="T1" fmla="*/ 1521 h 1742"/>
              <a:gd name="T2" fmla="*/ 224 w 1737"/>
              <a:gd name="T3" fmla="*/ 1698 h 1742"/>
              <a:gd name="T4" fmla="*/ 191 w 1737"/>
              <a:gd name="T5" fmla="*/ 1742 h 1742"/>
              <a:gd name="T6" fmla="*/ 8 w 1737"/>
              <a:gd name="T7" fmla="*/ 1332 h 1742"/>
              <a:gd name="T8" fmla="*/ 430 w 1737"/>
              <a:gd name="T9" fmla="*/ 1478 h 1742"/>
              <a:gd name="T10" fmla="*/ 411 w 1737"/>
              <a:gd name="T11" fmla="*/ 1128 h 1742"/>
              <a:gd name="T12" fmla="*/ 410 w 1737"/>
              <a:gd name="T13" fmla="*/ 1159 h 1742"/>
              <a:gd name="T14" fmla="*/ 385 w 1737"/>
              <a:gd name="T15" fmla="*/ 1268 h 1742"/>
              <a:gd name="T16" fmla="*/ 499 w 1737"/>
              <a:gd name="T17" fmla="*/ 1438 h 1742"/>
              <a:gd name="T18" fmla="*/ 275 w 1737"/>
              <a:gd name="T19" fmla="*/ 1226 h 1742"/>
              <a:gd name="T20" fmla="*/ 311 w 1737"/>
              <a:gd name="T21" fmla="*/ 1201 h 1742"/>
              <a:gd name="T22" fmla="*/ 364 w 1737"/>
              <a:gd name="T23" fmla="*/ 1127 h 1742"/>
              <a:gd name="T24" fmla="*/ 403 w 1737"/>
              <a:gd name="T25" fmla="*/ 1119 h 1742"/>
              <a:gd name="T26" fmla="*/ 630 w 1737"/>
              <a:gd name="T27" fmla="*/ 967 h 1742"/>
              <a:gd name="T28" fmla="*/ 621 w 1737"/>
              <a:gd name="T29" fmla="*/ 1160 h 1742"/>
              <a:gd name="T30" fmla="*/ 710 w 1737"/>
              <a:gd name="T31" fmla="*/ 1140 h 1742"/>
              <a:gd name="T32" fmla="*/ 862 w 1737"/>
              <a:gd name="T33" fmla="*/ 1200 h 1742"/>
              <a:gd name="T34" fmla="*/ 658 w 1737"/>
              <a:gd name="T35" fmla="*/ 1334 h 1742"/>
              <a:gd name="T36" fmla="*/ 581 w 1737"/>
              <a:gd name="T37" fmla="*/ 1241 h 1742"/>
              <a:gd name="T38" fmla="*/ 463 w 1737"/>
              <a:gd name="T39" fmla="*/ 1069 h 1742"/>
              <a:gd name="T40" fmla="*/ 609 w 1737"/>
              <a:gd name="T41" fmla="*/ 898 h 1742"/>
              <a:gd name="T42" fmla="*/ 510 w 1737"/>
              <a:gd name="T43" fmla="*/ 1067 h 1742"/>
              <a:gd name="T44" fmla="*/ 639 w 1737"/>
              <a:gd name="T45" fmla="*/ 1064 h 1742"/>
              <a:gd name="T46" fmla="*/ 677 w 1737"/>
              <a:gd name="T47" fmla="*/ 1229 h 1742"/>
              <a:gd name="T48" fmla="*/ 779 w 1737"/>
              <a:gd name="T49" fmla="*/ 1266 h 1742"/>
              <a:gd name="T50" fmla="*/ 908 w 1737"/>
              <a:gd name="T51" fmla="*/ 1023 h 1742"/>
              <a:gd name="T52" fmla="*/ 872 w 1737"/>
              <a:gd name="T53" fmla="*/ 1059 h 1742"/>
              <a:gd name="T54" fmla="*/ 673 w 1737"/>
              <a:gd name="T55" fmla="*/ 824 h 1742"/>
              <a:gd name="T56" fmla="*/ 634 w 1737"/>
              <a:gd name="T57" fmla="*/ 738 h 1742"/>
              <a:gd name="T58" fmla="*/ 588 w 1737"/>
              <a:gd name="T59" fmla="*/ 739 h 1742"/>
              <a:gd name="T60" fmla="*/ 1156 w 1737"/>
              <a:gd name="T61" fmla="*/ 782 h 1742"/>
              <a:gd name="T62" fmla="*/ 1000 w 1737"/>
              <a:gd name="T63" fmla="*/ 683 h 1742"/>
              <a:gd name="T64" fmla="*/ 875 w 1737"/>
              <a:gd name="T65" fmla="*/ 761 h 1742"/>
              <a:gd name="T66" fmla="*/ 997 w 1737"/>
              <a:gd name="T67" fmla="*/ 940 h 1742"/>
              <a:gd name="T68" fmla="*/ 773 w 1737"/>
              <a:gd name="T69" fmla="*/ 728 h 1742"/>
              <a:gd name="T70" fmla="*/ 809 w 1737"/>
              <a:gd name="T71" fmla="*/ 703 h 1742"/>
              <a:gd name="T72" fmla="*/ 991 w 1737"/>
              <a:gd name="T73" fmla="*/ 606 h 1742"/>
              <a:gd name="T74" fmla="*/ 1259 w 1737"/>
              <a:gd name="T75" fmla="*/ 678 h 1742"/>
              <a:gd name="T76" fmla="*/ 1018 w 1737"/>
              <a:gd name="T77" fmla="*/ 494 h 1742"/>
              <a:gd name="T78" fmla="*/ 1047 w 1737"/>
              <a:gd name="T79" fmla="*/ 454 h 1742"/>
              <a:gd name="T80" fmla="*/ 990 w 1737"/>
              <a:gd name="T81" fmla="*/ 428 h 1742"/>
              <a:gd name="T82" fmla="*/ 990 w 1737"/>
              <a:gd name="T83" fmla="*/ 382 h 1742"/>
              <a:gd name="T84" fmla="*/ 1494 w 1737"/>
              <a:gd name="T85" fmla="*/ 444 h 1742"/>
              <a:gd name="T86" fmla="*/ 1299 w 1737"/>
              <a:gd name="T87" fmla="*/ 290 h 1742"/>
              <a:gd name="T88" fmla="*/ 1377 w 1737"/>
              <a:gd name="T89" fmla="*/ 553 h 1742"/>
              <a:gd name="T90" fmla="*/ 1341 w 1737"/>
              <a:gd name="T91" fmla="*/ 589 h 1742"/>
              <a:gd name="T92" fmla="*/ 1141 w 1737"/>
              <a:gd name="T93" fmla="*/ 356 h 1742"/>
              <a:gd name="T94" fmla="*/ 1199 w 1737"/>
              <a:gd name="T95" fmla="*/ 310 h 1742"/>
              <a:gd name="T96" fmla="*/ 1515 w 1737"/>
              <a:gd name="T97" fmla="*/ 409 h 1742"/>
              <a:gd name="T98" fmla="*/ 1580 w 1737"/>
              <a:gd name="T99" fmla="*/ 262 h 1742"/>
              <a:gd name="T100" fmla="*/ 1706 w 1737"/>
              <a:gd name="T101" fmla="*/ 146 h 1742"/>
              <a:gd name="T102" fmla="*/ 1735 w 1737"/>
              <a:gd name="T103" fmla="*/ 165 h 1742"/>
              <a:gd name="T104" fmla="*/ 1680 w 1737"/>
              <a:gd name="T105" fmla="*/ 264 h 1742"/>
              <a:gd name="T106" fmla="*/ 1408 w 1737"/>
              <a:gd name="T107" fmla="*/ 145 h 1742"/>
              <a:gd name="T108" fmla="*/ 1638 w 1737"/>
              <a:gd name="T109" fmla="*/ 49 h 1742"/>
              <a:gd name="T110" fmla="*/ 1454 w 1737"/>
              <a:gd name="T111" fmla="*/ 135 h 17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1737" h="1742">
                <a:moveTo>
                  <a:pt x="430" y="1478"/>
                </a:moveTo>
                <a:cubicBezTo>
                  <a:pt x="435" y="1480"/>
                  <a:pt x="438" y="1482"/>
                  <a:pt x="440" y="1484"/>
                </a:cubicBezTo>
                <a:cubicBezTo>
                  <a:pt x="442" y="1486"/>
                  <a:pt x="443" y="1488"/>
                  <a:pt x="443" y="1490"/>
                </a:cubicBezTo>
                <a:cubicBezTo>
                  <a:pt x="443" y="1493"/>
                  <a:pt x="442" y="1495"/>
                  <a:pt x="439" y="1499"/>
                </a:cubicBezTo>
                <a:cubicBezTo>
                  <a:pt x="436" y="1502"/>
                  <a:pt x="433" y="1506"/>
                  <a:pt x="428" y="1510"/>
                </a:cubicBezTo>
                <a:cubicBezTo>
                  <a:pt x="423" y="1515"/>
                  <a:pt x="419" y="1519"/>
                  <a:pt x="416" y="1521"/>
                </a:cubicBezTo>
                <a:cubicBezTo>
                  <a:pt x="413" y="1524"/>
                  <a:pt x="411" y="1526"/>
                  <a:pt x="409" y="1527"/>
                </a:cubicBezTo>
                <a:cubicBezTo>
                  <a:pt x="407" y="1528"/>
                  <a:pt x="405" y="1528"/>
                  <a:pt x="403" y="1528"/>
                </a:cubicBezTo>
                <a:cubicBezTo>
                  <a:pt x="402" y="1527"/>
                  <a:pt x="400" y="1527"/>
                  <a:pt x="398" y="1526"/>
                </a:cubicBezTo>
                <a:lnTo>
                  <a:pt x="300" y="1479"/>
                </a:lnTo>
                <a:lnTo>
                  <a:pt x="177" y="1603"/>
                </a:lnTo>
                <a:lnTo>
                  <a:pt x="224" y="1698"/>
                </a:lnTo>
                <a:cubicBezTo>
                  <a:pt x="225" y="1700"/>
                  <a:pt x="226" y="1702"/>
                  <a:pt x="226" y="1704"/>
                </a:cubicBezTo>
                <a:cubicBezTo>
                  <a:pt x="226" y="1706"/>
                  <a:pt x="226" y="1707"/>
                  <a:pt x="225" y="1710"/>
                </a:cubicBezTo>
                <a:cubicBezTo>
                  <a:pt x="224" y="1712"/>
                  <a:pt x="223" y="1714"/>
                  <a:pt x="220" y="1717"/>
                </a:cubicBezTo>
                <a:cubicBezTo>
                  <a:pt x="218" y="1720"/>
                  <a:pt x="215" y="1724"/>
                  <a:pt x="210" y="1728"/>
                </a:cubicBezTo>
                <a:cubicBezTo>
                  <a:pt x="206" y="1733"/>
                  <a:pt x="202" y="1736"/>
                  <a:pt x="199" y="1738"/>
                </a:cubicBezTo>
                <a:cubicBezTo>
                  <a:pt x="196" y="1741"/>
                  <a:pt x="193" y="1742"/>
                  <a:pt x="191" y="1742"/>
                </a:cubicBezTo>
                <a:cubicBezTo>
                  <a:pt x="188" y="1742"/>
                  <a:pt x="186" y="1741"/>
                  <a:pt x="184" y="1739"/>
                </a:cubicBezTo>
                <a:cubicBezTo>
                  <a:pt x="182" y="1737"/>
                  <a:pt x="180" y="1734"/>
                  <a:pt x="178" y="1729"/>
                </a:cubicBezTo>
                <a:lnTo>
                  <a:pt x="2" y="1354"/>
                </a:lnTo>
                <a:cubicBezTo>
                  <a:pt x="1" y="1352"/>
                  <a:pt x="0" y="1350"/>
                  <a:pt x="0" y="1347"/>
                </a:cubicBezTo>
                <a:cubicBezTo>
                  <a:pt x="0" y="1345"/>
                  <a:pt x="1" y="1343"/>
                  <a:pt x="2" y="1341"/>
                </a:cubicBezTo>
                <a:cubicBezTo>
                  <a:pt x="4" y="1338"/>
                  <a:pt x="6" y="1335"/>
                  <a:pt x="8" y="1332"/>
                </a:cubicBezTo>
                <a:cubicBezTo>
                  <a:pt x="11" y="1329"/>
                  <a:pt x="15" y="1325"/>
                  <a:pt x="19" y="1320"/>
                </a:cubicBezTo>
                <a:cubicBezTo>
                  <a:pt x="24" y="1315"/>
                  <a:pt x="28" y="1312"/>
                  <a:pt x="32" y="1309"/>
                </a:cubicBezTo>
                <a:cubicBezTo>
                  <a:pt x="35" y="1306"/>
                  <a:pt x="38" y="1303"/>
                  <a:pt x="41" y="1302"/>
                </a:cubicBezTo>
                <a:cubicBezTo>
                  <a:pt x="43" y="1301"/>
                  <a:pt x="46" y="1300"/>
                  <a:pt x="48" y="1300"/>
                </a:cubicBezTo>
                <a:cubicBezTo>
                  <a:pt x="50" y="1300"/>
                  <a:pt x="53" y="1301"/>
                  <a:pt x="55" y="1302"/>
                </a:cubicBezTo>
                <a:lnTo>
                  <a:pt x="430" y="1478"/>
                </a:lnTo>
                <a:close/>
                <a:moveTo>
                  <a:pt x="59" y="1362"/>
                </a:moveTo>
                <a:lnTo>
                  <a:pt x="59" y="1363"/>
                </a:lnTo>
                <a:lnTo>
                  <a:pt x="156" y="1562"/>
                </a:lnTo>
                <a:lnTo>
                  <a:pt x="259" y="1458"/>
                </a:lnTo>
                <a:lnTo>
                  <a:pt x="59" y="1362"/>
                </a:lnTo>
                <a:close/>
                <a:moveTo>
                  <a:pt x="411" y="1128"/>
                </a:moveTo>
                <a:cubicBezTo>
                  <a:pt x="414" y="1131"/>
                  <a:pt x="417" y="1134"/>
                  <a:pt x="419" y="1136"/>
                </a:cubicBezTo>
                <a:cubicBezTo>
                  <a:pt x="421" y="1139"/>
                  <a:pt x="423" y="1141"/>
                  <a:pt x="424" y="1143"/>
                </a:cubicBezTo>
                <a:cubicBezTo>
                  <a:pt x="425" y="1144"/>
                  <a:pt x="425" y="1146"/>
                  <a:pt x="425" y="1147"/>
                </a:cubicBezTo>
                <a:cubicBezTo>
                  <a:pt x="425" y="1149"/>
                  <a:pt x="424" y="1150"/>
                  <a:pt x="423" y="1151"/>
                </a:cubicBezTo>
                <a:cubicBezTo>
                  <a:pt x="422" y="1152"/>
                  <a:pt x="420" y="1154"/>
                  <a:pt x="418" y="1155"/>
                </a:cubicBezTo>
                <a:cubicBezTo>
                  <a:pt x="415" y="1156"/>
                  <a:pt x="413" y="1157"/>
                  <a:pt x="410" y="1159"/>
                </a:cubicBezTo>
                <a:cubicBezTo>
                  <a:pt x="407" y="1160"/>
                  <a:pt x="404" y="1162"/>
                  <a:pt x="400" y="1164"/>
                </a:cubicBezTo>
                <a:cubicBezTo>
                  <a:pt x="397" y="1166"/>
                  <a:pt x="394" y="1169"/>
                  <a:pt x="390" y="1172"/>
                </a:cubicBezTo>
                <a:cubicBezTo>
                  <a:pt x="387" y="1176"/>
                  <a:pt x="384" y="1180"/>
                  <a:pt x="381" y="1186"/>
                </a:cubicBezTo>
                <a:cubicBezTo>
                  <a:pt x="379" y="1191"/>
                  <a:pt x="378" y="1197"/>
                  <a:pt x="377" y="1205"/>
                </a:cubicBezTo>
                <a:cubicBezTo>
                  <a:pt x="377" y="1212"/>
                  <a:pt x="377" y="1221"/>
                  <a:pt x="379" y="1232"/>
                </a:cubicBezTo>
                <a:cubicBezTo>
                  <a:pt x="380" y="1242"/>
                  <a:pt x="382" y="1254"/>
                  <a:pt x="385" y="1268"/>
                </a:cubicBezTo>
                <a:lnTo>
                  <a:pt x="521" y="1403"/>
                </a:lnTo>
                <a:cubicBezTo>
                  <a:pt x="522" y="1404"/>
                  <a:pt x="523" y="1406"/>
                  <a:pt x="523" y="1407"/>
                </a:cubicBezTo>
                <a:cubicBezTo>
                  <a:pt x="523" y="1409"/>
                  <a:pt x="523" y="1410"/>
                  <a:pt x="522" y="1412"/>
                </a:cubicBezTo>
                <a:cubicBezTo>
                  <a:pt x="522" y="1414"/>
                  <a:pt x="520" y="1417"/>
                  <a:pt x="518" y="1420"/>
                </a:cubicBezTo>
                <a:cubicBezTo>
                  <a:pt x="516" y="1422"/>
                  <a:pt x="513" y="1426"/>
                  <a:pt x="509" y="1429"/>
                </a:cubicBezTo>
                <a:cubicBezTo>
                  <a:pt x="505" y="1433"/>
                  <a:pt x="502" y="1436"/>
                  <a:pt x="499" y="1438"/>
                </a:cubicBezTo>
                <a:cubicBezTo>
                  <a:pt x="497" y="1440"/>
                  <a:pt x="494" y="1442"/>
                  <a:pt x="492" y="1443"/>
                </a:cubicBezTo>
                <a:cubicBezTo>
                  <a:pt x="490" y="1443"/>
                  <a:pt x="488" y="1444"/>
                  <a:pt x="487" y="1443"/>
                </a:cubicBezTo>
                <a:cubicBezTo>
                  <a:pt x="486" y="1443"/>
                  <a:pt x="484" y="1442"/>
                  <a:pt x="483" y="1441"/>
                </a:cubicBezTo>
                <a:lnTo>
                  <a:pt x="277" y="1235"/>
                </a:lnTo>
                <a:cubicBezTo>
                  <a:pt x="276" y="1234"/>
                  <a:pt x="275" y="1232"/>
                  <a:pt x="274" y="1231"/>
                </a:cubicBezTo>
                <a:cubicBezTo>
                  <a:pt x="274" y="1230"/>
                  <a:pt x="274" y="1228"/>
                  <a:pt x="275" y="1226"/>
                </a:cubicBezTo>
                <a:cubicBezTo>
                  <a:pt x="276" y="1224"/>
                  <a:pt x="277" y="1222"/>
                  <a:pt x="279" y="1219"/>
                </a:cubicBezTo>
                <a:cubicBezTo>
                  <a:pt x="281" y="1217"/>
                  <a:pt x="283" y="1214"/>
                  <a:pt x="287" y="1210"/>
                </a:cubicBezTo>
                <a:cubicBezTo>
                  <a:pt x="290" y="1207"/>
                  <a:pt x="293" y="1204"/>
                  <a:pt x="296" y="1202"/>
                </a:cubicBezTo>
                <a:cubicBezTo>
                  <a:pt x="298" y="1200"/>
                  <a:pt x="300" y="1199"/>
                  <a:pt x="302" y="1199"/>
                </a:cubicBezTo>
                <a:cubicBezTo>
                  <a:pt x="304" y="1198"/>
                  <a:pt x="306" y="1198"/>
                  <a:pt x="307" y="1198"/>
                </a:cubicBezTo>
                <a:cubicBezTo>
                  <a:pt x="309" y="1199"/>
                  <a:pt x="310" y="1199"/>
                  <a:pt x="311" y="1201"/>
                </a:cubicBezTo>
                <a:lnTo>
                  <a:pt x="341" y="1231"/>
                </a:lnTo>
                <a:cubicBezTo>
                  <a:pt x="338" y="1217"/>
                  <a:pt x="337" y="1205"/>
                  <a:pt x="337" y="1194"/>
                </a:cubicBezTo>
                <a:cubicBezTo>
                  <a:pt x="337" y="1184"/>
                  <a:pt x="337" y="1176"/>
                  <a:pt x="339" y="1168"/>
                </a:cubicBezTo>
                <a:cubicBezTo>
                  <a:pt x="340" y="1161"/>
                  <a:pt x="342" y="1154"/>
                  <a:pt x="346" y="1149"/>
                </a:cubicBezTo>
                <a:cubicBezTo>
                  <a:pt x="349" y="1143"/>
                  <a:pt x="353" y="1138"/>
                  <a:pt x="357" y="1134"/>
                </a:cubicBezTo>
                <a:cubicBezTo>
                  <a:pt x="359" y="1132"/>
                  <a:pt x="361" y="1130"/>
                  <a:pt x="364" y="1127"/>
                </a:cubicBezTo>
                <a:cubicBezTo>
                  <a:pt x="367" y="1125"/>
                  <a:pt x="370" y="1123"/>
                  <a:pt x="373" y="1121"/>
                </a:cubicBezTo>
                <a:cubicBezTo>
                  <a:pt x="377" y="1119"/>
                  <a:pt x="380" y="1117"/>
                  <a:pt x="383" y="1115"/>
                </a:cubicBezTo>
                <a:cubicBezTo>
                  <a:pt x="386" y="1114"/>
                  <a:pt x="388" y="1113"/>
                  <a:pt x="390" y="1113"/>
                </a:cubicBezTo>
                <a:cubicBezTo>
                  <a:pt x="392" y="1113"/>
                  <a:pt x="393" y="1113"/>
                  <a:pt x="394" y="1113"/>
                </a:cubicBezTo>
                <a:cubicBezTo>
                  <a:pt x="395" y="1114"/>
                  <a:pt x="396" y="1114"/>
                  <a:pt x="397" y="1115"/>
                </a:cubicBezTo>
                <a:cubicBezTo>
                  <a:pt x="399" y="1116"/>
                  <a:pt x="400" y="1117"/>
                  <a:pt x="403" y="1119"/>
                </a:cubicBezTo>
                <a:cubicBezTo>
                  <a:pt x="405" y="1121"/>
                  <a:pt x="407" y="1124"/>
                  <a:pt x="411" y="1128"/>
                </a:cubicBezTo>
                <a:close/>
                <a:moveTo>
                  <a:pt x="623" y="908"/>
                </a:moveTo>
                <a:cubicBezTo>
                  <a:pt x="628" y="913"/>
                  <a:pt x="631" y="918"/>
                  <a:pt x="632" y="921"/>
                </a:cubicBezTo>
                <a:cubicBezTo>
                  <a:pt x="633" y="925"/>
                  <a:pt x="632" y="928"/>
                  <a:pt x="630" y="931"/>
                </a:cubicBezTo>
                <a:lnTo>
                  <a:pt x="600" y="960"/>
                </a:lnTo>
                <a:cubicBezTo>
                  <a:pt x="611" y="960"/>
                  <a:pt x="621" y="963"/>
                  <a:pt x="630" y="967"/>
                </a:cubicBezTo>
                <a:cubicBezTo>
                  <a:pt x="639" y="972"/>
                  <a:pt x="647" y="978"/>
                  <a:pt x="654" y="985"/>
                </a:cubicBezTo>
                <a:cubicBezTo>
                  <a:pt x="666" y="997"/>
                  <a:pt x="674" y="1009"/>
                  <a:pt x="680" y="1022"/>
                </a:cubicBezTo>
                <a:cubicBezTo>
                  <a:pt x="685" y="1035"/>
                  <a:pt x="687" y="1048"/>
                  <a:pt x="687" y="1062"/>
                </a:cubicBezTo>
                <a:cubicBezTo>
                  <a:pt x="686" y="1075"/>
                  <a:pt x="682" y="1088"/>
                  <a:pt x="676" y="1102"/>
                </a:cubicBezTo>
                <a:cubicBezTo>
                  <a:pt x="669" y="1115"/>
                  <a:pt x="660" y="1127"/>
                  <a:pt x="648" y="1139"/>
                </a:cubicBezTo>
                <a:cubicBezTo>
                  <a:pt x="640" y="1148"/>
                  <a:pt x="631" y="1155"/>
                  <a:pt x="621" y="1160"/>
                </a:cubicBezTo>
                <a:cubicBezTo>
                  <a:pt x="611" y="1165"/>
                  <a:pt x="603" y="1168"/>
                  <a:pt x="595" y="1169"/>
                </a:cubicBezTo>
                <a:cubicBezTo>
                  <a:pt x="595" y="1175"/>
                  <a:pt x="596" y="1180"/>
                  <a:pt x="598" y="1185"/>
                </a:cubicBezTo>
                <a:cubicBezTo>
                  <a:pt x="600" y="1190"/>
                  <a:pt x="603" y="1195"/>
                  <a:pt x="607" y="1200"/>
                </a:cubicBezTo>
                <a:cubicBezTo>
                  <a:pt x="613" y="1205"/>
                  <a:pt x="620" y="1207"/>
                  <a:pt x="628" y="1206"/>
                </a:cubicBezTo>
                <a:cubicBezTo>
                  <a:pt x="637" y="1204"/>
                  <a:pt x="645" y="1200"/>
                  <a:pt x="654" y="1192"/>
                </a:cubicBezTo>
                <a:lnTo>
                  <a:pt x="710" y="1140"/>
                </a:lnTo>
                <a:cubicBezTo>
                  <a:pt x="720" y="1130"/>
                  <a:pt x="731" y="1122"/>
                  <a:pt x="742" y="1116"/>
                </a:cubicBezTo>
                <a:cubicBezTo>
                  <a:pt x="753" y="1110"/>
                  <a:pt x="764" y="1106"/>
                  <a:pt x="775" y="1105"/>
                </a:cubicBezTo>
                <a:cubicBezTo>
                  <a:pt x="786" y="1103"/>
                  <a:pt x="797" y="1104"/>
                  <a:pt x="807" y="1107"/>
                </a:cubicBezTo>
                <a:cubicBezTo>
                  <a:pt x="817" y="1111"/>
                  <a:pt x="827" y="1117"/>
                  <a:pt x="836" y="1126"/>
                </a:cubicBezTo>
                <a:cubicBezTo>
                  <a:pt x="846" y="1135"/>
                  <a:pt x="853" y="1146"/>
                  <a:pt x="857" y="1159"/>
                </a:cubicBezTo>
                <a:cubicBezTo>
                  <a:pt x="862" y="1171"/>
                  <a:pt x="863" y="1185"/>
                  <a:pt x="862" y="1200"/>
                </a:cubicBezTo>
                <a:cubicBezTo>
                  <a:pt x="860" y="1214"/>
                  <a:pt x="855" y="1230"/>
                  <a:pt x="846" y="1246"/>
                </a:cubicBezTo>
                <a:cubicBezTo>
                  <a:pt x="837" y="1263"/>
                  <a:pt x="824" y="1279"/>
                  <a:pt x="806" y="1297"/>
                </a:cubicBezTo>
                <a:cubicBezTo>
                  <a:pt x="790" y="1313"/>
                  <a:pt x="774" y="1326"/>
                  <a:pt x="760" y="1335"/>
                </a:cubicBezTo>
                <a:cubicBezTo>
                  <a:pt x="745" y="1344"/>
                  <a:pt x="732" y="1350"/>
                  <a:pt x="719" y="1352"/>
                </a:cubicBezTo>
                <a:cubicBezTo>
                  <a:pt x="707" y="1355"/>
                  <a:pt x="696" y="1354"/>
                  <a:pt x="685" y="1351"/>
                </a:cubicBezTo>
                <a:cubicBezTo>
                  <a:pt x="675" y="1348"/>
                  <a:pt x="666" y="1342"/>
                  <a:pt x="658" y="1334"/>
                </a:cubicBezTo>
                <a:cubicBezTo>
                  <a:pt x="653" y="1329"/>
                  <a:pt x="649" y="1323"/>
                  <a:pt x="645" y="1317"/>
                </a:cubicBezTo>
                <a:cubicBezTo>
                  <a:pt x="642" y="1311"/>
                  <a:pt x="639" y="1305"/>
                  <a:pt x="638" y="1298"/>
                </a:cubicBezTo>
                <a:cubicBezTo>
                  <a:pt x="636" y="1291"/>
                  <a:pt x="635" y="1284"/>
                  <a:pt x="635" y="1277"/>
                </a:cubicBezTo>
                <a:cubicBezTo>
                  <a:pt x="634" y="1269"/>
                  <a:pt x="635" y="1261"/>
                  <a:pt x="636" y="1252"/>
                </a:cubicBezTo>
                <a:cubicBezTo>
                  <a:pt x="625" y="1256"/>
                  <a:pt x="614" y="1256"/>
                  <a:pt x="605" y="1254"/>
                </a:cubicBezTo>
                <a:cubicBezTo>
                  <a:pt x="596" y="1252"/>
                  <a:pt x="587" y="1248"/>
                  <a:pt x="581" y="1241"/>
                </a:cubicBezTo>
                <a:cubicBezTo>
                  <a:pt x="571" y="1231"/>
                  <a:pt x="565" y="1221"/>
                  <a:pt x="562" y="1210"/>
                </a:cubicBezTo>
                <a:cubicBezTo>
                  <a:pt x="558" y="1199"/>
                  <a:pt x="556" y="1188"/>
                  <a:pt x="556" y="1176"/>
                </a:cubicBezTo>
                <a:cubicBezTo>
                  <a:pt x="546" y="1175"/>
                  <a:pt x="535" y="1173"/>
                  <a:pt x="526" y="1168"/>
                </a:cubicBezTo>
                <a:cubicBezTo>
                  <a:pt x="516" y="1164"/>
                  <a:pt x="506" y="1157"/>
                  <a:pt x="496" y="1147"/>
                </a:cubicBezTo>
                <a:cubicBezTo>
                  <a:pt x="484" y="1135"/>
                  <a:pt x="475" y="1122"/>
                  <a:pt x="470" y="1109"/>
                </a:cubicBezTo>
                <a:cubicBezTo>
                  <a:pt x="465" y="1096"/>
                  <a:pt x="462" y="1082"/>
                  <a:pt x="463" y="1069"/>
                </a:cubicBezTo>
                <a:cubicBezTo>
                  <a:pt x="464" y="1055"/>
                  <a:pt x="467" y="1042"/>
                  <a:pt x="473" y="1029"/>
                </a:cubicBezTo>
                <a:cubicBezTo>
                  <a:pt x="480" y="1015"/>
                  <a:pt x="489" y="1003"/>
                  <a:pt x="501" y="991"/>
                </a:cubicBezTo>
                <a:cubicBezTo>
                  <a:pt x="507" y="985"/>
                  <a:pt x="513" y="980"/>
                  <a:pt x="519" y="975"/>
                </a:cubicBezTo>
                <a:cubicBezTo>
                  <a:pt x="525" y="970"/>
                  <a:pt x="531" y="966"/>
                  <a:pt x="537" y="962"/>
                </a:cubicBezTo>
                <a:lnTo>
                  <a:pt x="600" y="900"/>
                </a:lnTo>
                <a:cubicBezTo>
                  <a:pt x="602" y="898"/>
                  <a:pt x="605" y="897"/>
                  <a:pt x="609" y="898"/>
                </a:cubicBezTo>
                <a:cubicBezTo>
                  <a:pt x="613" y="899"/>
                  <a:pt x="618" y="902"/>
                  <a:pt x="623" y="908"/>
                </a:cubicBezTo>
                <a:close/>
                <a:moveTo>
                  <a:pt x="618" y="1021"/>
                </a:moveTo>
                <a:cubicBezTo>
                  <a:pt x="604" y="1007"/>
                  <a:pt x="589" y="1000"/>
                  <a:pt x="573" y="1000"/>
                </a:cubicBezTo>
                <a:cubicBezTo>
                  <a:pt x="558" y="1000"/>
                  <a:pt x="543" y="1007"/>
                  <a:pt x="529" y="1021"/>
                </a:cubicBezTo>
                <a:cubicBezTo>
                  <a:pt x="521" y="1028"/>
                  <a:pt x="516" y="1036"/>
                  <a:pt x="513" y="1044"/>
                </a:cubicBezTo>
                <a:cubicBezTo>
                  <a:pt x="510" y="1052"/>
                  <a:pt x="509" y="1059"/>
                  <a:pt x="510" y="1067"/>
                </a:cubicBezTo>
                <a:cubicBezTo>
                  <a:pt x="510" y="1075"/>
                  <a:pt x="513" y="1083"/>
                  <a:pt x="517" y="1090"/>
                </a:cubicBezTo>
                <a:cubicBezTo>
                  <a:pt x="520" y="1097"/>
                  <a:pt x="525" y="1104"/>
                  <a:pt x="531" y="1110"/>
                </a:cubicBezTo>
                <a:cubicBezTo>
                  <a:pt x="545" y="1124"/>
                  <a:pt x="560" y="1131"/>
                  <a:pt x="575" y="1131"/>
                </a:cubicBezTo>
                <a:cubicBezTo>
                  <a:pt x="591" y="1131"/>
                  <a:pt x="605" y="1124"/>
                  <a:pt x="619" y="1110"/>
                </a:cubicBezTo>
                <a:cubicBezTo>
                  <a:pt x="627" y="1103"/>
                  <a:pt x="632" y="1095"/>
                  <a:pt x="635" y="1087"/>
                </a:cubicBezTo>
                <a:cubicBezTo>
                  <a:pt x="638" y="1079"/>
                  <a:pt x="640" y="1071"/>
                  <a:pt x="639" y="1064"/>
                </a:cubicBezTo>
                <a:cubicBezTo>
                  <a:pt x="638" y="1056"/>
                  <a:pt x="636" y="1048"/>
                  <a:pt x="632" y="1041"/>
                </a:cubicBezTo>
                <a:cubicBezTo>
                  <a:pt x="629" y="1034"/>
                  <a:pt x="624" y="1027"/>
                  <a:pt x="618" y="1021"/>
                </a:cubicBezTo>
                <a:close/>
                <a:moveTo>
                  <a:pt x="800" y="1166"/>
                </a:moveTo>
                <a:cubicBezTo>
                  <a:pt x="792" y="1157"/>
                  <a:pt x="781" y="1154"/>
                  <a:pt x="769" y="1156"/>
                </a:cubicBezTo>
                <a:cubicBezTo>
                  <a:pt x="757" y="1158"/>
                  <a:pt x="745" y="1166"/>
                  <a:pt x="732" y="1178"/>
                </a:cubicBezTo>
                <a:lnTo>
                  <a:pt x="677" y="1229"/>
                </a:lnTo>
                <a:cubicBezTo>
                  <a:pt x="676" y="1238"/>
                  <a:pt x="675" y="1246"/>
                  <a:pt x="675" y="1252"/>
                </a:cubicBezTo>
                <a:cubicBezTo>
                  <a:pt x="676" y="1259"/>
                  <a:pt x="677" y="1265"/>
                  <a:pt x="678" y="1270"/>
                </a:cubicBezTo>
                <a:cubicBezTo>
                  <a:pt x="679" y="1275"/>
                  <a:pt x="681" y="1279"/>
                  <a:pt x="683" y="1283"/>
                </a:cubicBezTo>
                <a:cubicBezTo>
                  <a:pt x="686" y="1286"/>
                  <a:pt x="689" y="1290"/>
                  <a:pt x="692" y="1293"/>
                </a:cubicBezTo>
                <a:cubicBezTo>
                  <a:pt x="702" y="1303"/>
                  <a:pt x="714" y="1305"/>
                  <a:pt x="729" y="1301"/>
                </a:cubicBezTo>
                <a:cubicBezTo>
                  <a:pt x="745" y="1296"/>
                  <a:pt x="761" y="1284"/>
                  <a:pt x="779" y="1266"/>
                </a:cubicBezTo>
                <a:cubicBezTo>
                  <a:pt x="791" y="1255"/>
                  <a:pt x="799" y="1244"/>
                  <a:pt x="805" y="1234"/>
                </a:cubicBezTo>
                <a:cubicBezTo>
                  <a:pt x="810" y="1224"/>
                  <a:pt x="814" y="1215"/>
                  <a:pt x="815" y="1206"/>
                </a:cubicBezTo>
                <a:cubicBezTo>
                  <a:pt x="816" y="1198"/>
                  <a:pt x="815" y="1190"/>
                  <a:pt x="812" y="1184"/>
                </a:cubicBezTo>
                <a:cubicBezTo>
                  <a:pt x="810" y="1177"/>
                  <a:pt x="806" y="1171"/>
                  <a:pt x="800" y="1166"/>
                </a:cubicBezTo>
                <a:close/>
                <a:moveTo>
                  <a:pt x="906" y="1019"/>
                </a:moveTo>
                <a:cubicBezTo>
                  <a:pt x="907" y="1020"/>
                  <a:pt x="908" y="1021"/>
                  <a:pt x="908" y="1023"/>
                </a:cubicBezTo>
                <a:cubicBezTo>
                  <a:pt x="908" y="1024"/>
                  <a:pt x="908" y="1026"/>
                  <a:pt x="907" y="1028"/>
                </a:cubicBezTo>
                <a:cubicBezTo>
                  <a:pt x="906" y="1030"/>
                  <a:pt x="905" y="1032"/>
                  <a:pt x="903" y="1035"/>
                </a:cubicBezTo>
                <a:cubicBezTo>
                  <a:pt x="901" y="1038"/>
                  <a:pt x="898" y="1041"/>
                  <a:pt x="894" y="1045"/>
                </a:cubicBezTo>
                <a:cubicBezTo>
                  <a:pt x="890" y="1048"/>
                  <a:pt x="887" y="1051"/>
                  <a:pt x="884" y="1053"/>
                </a:cubicBezTo>
                <a:cubicBezTo>
                  <a:pt x="881" y="1056"/>
                  <a:pt x="879" y="1057"/>
                  <a:pt x="877" y="1058"/>
                </a:cubicBezTo>
                <a:cubicBezTo>
                  <a:pt x="875" y="1059"/>
                  <a:pt x="873" y="1059"/>
                  <a:pt x="872" y="1059"/>
                </a:cubicBezTo>
                <a:cubicBezTo>
                  <a:pt x="870" y="1058"/>
                  <a:pt x="869" y="1058"/>
                  <a:pt x="868" y="1056"/>
                </a:cubicBezTo>
                <a:lnTo>
                  <a:pt x="662" y="850"/>
                </a:lnTo>
                <a:cubicBezTo>
                  <a:pt x="660" y="849"/>
                  <a:pt x="660" y="848"/>
                  <a:pt x="659" y="846"/>
                </a:cubicBezTo>
                <a:cubicBezTo>
                  <a:pt x="659" y="845"/>
                  <a:pt x="659" y="843"/>
                  <a:pt x="660" y="841"/>
                </a:cubicBezTo>
                <a:cubicBezTo>
                  <a:pt x="661" y="839"/>
                  <a:pt x="662" y="837"/>
                  <a:pt x="665" y="834"/>
                </a:cubicBezTo>
                <a:cubicBezTo>
                  <a:pt x="667" y="831"/>
                  <a:pt x="670" y="828"/>
                  <a:pt x="673" y="824"/>
                </a:cubicBezTo>
                <a:cubicBezTo>
                  <a:pt x="677" y="820"/>
                  <a:pt x="680" y="817"/>
                  <a:pt x="683" y="815"/>
                </a:cubicBezTo>
                <a:cubicBezTo>
                  <a:pt x="686" y="813"/>
                  <a:pt x="688" y="812"/>
                  <a:pt x="690" y="811"/>
                </a:cubicBezTo>
                <a:cubicBezTo>
                  <a:pt x="692" y="810"/>
                  <a:pt x="694" y="810"/>
                  <a:pt x="695" y="810"/>
                </a:cubicBezTo>
                <a:cubicBezTo>
                  <a:pt x="697" y="810"/>
                  <a:pt x="698" y="811"/>
                  <a:pt x="699" y="812"/>
                </a:cubicBezTo>
                <a:lnTo>
                  <a:pt x="906" y="1019"/>
                </a:lnTo>
                <a:close/>
                <a:moveTo>
                  <a:pt x="634" y="738"/>
                </a:moveTo>
                <a:cubicBezTo>
                  <a:pt x="643" y="747"/>
                  <a:pt x="647" y="755"/>
                  <a:pt x="647" y="761"/>
                </a:cubicBezTo>
                <a:cubicBezTo>
                  <a:pt x="647" y="768"/>
                  <a:pt x="642" y="776"/>
                  <a:pt x="633" y="785"/>
                </a:cubicBezTo>
                <a:cubicBezTo>
                  <a:pt x="624" y="794"/>
                  <a:pt x="617" y="798"/>
                  <a:pt x="610" y="798"/>
                </a:cubicBezTo>
                <a:cubicBezTo>
                  <a:pt x="604" y="798"/>
                  <a:pt x="596" y="794"/>
                  <a:pt x="588" y="785"/>
                </a:cubicBezTo>
                <a:cubicBezTo>
                  <a:pt x="579" y="777"/>
                  <a:pt x="574" y="769"/>
                  <a:pt x="575" y="762"/>
                </a:cubicBezTo>
                <a:cubicBezTo>
                  <a:pt x="575" y="756"/>
                  <a:pt x="579" y="748"/>
                  <a:pt x="588" y="739"/>
                </a:cubicBezTo>
                <a:cubicBezTo>
                  <a:pt x="597" y="730"/>
                  <a:pt x="605" y="725"/>
                  <a:pt x="611" y="725"/>
                </a:cubicBezTo>
                <a:cubicBezTo>
                  <a:pt x="618" y="725"/>
                  <a:pt x="625" y="729"/>
                  <a:pt x="634" y="738"/>
                </a:cubicBezTo>
                <a:close/>
                <a:moveTo>
                  <a:pt x="1159" y="766"/>
                </a:moveTo>
                <a:cubicBezTo>
                  <a:pt x="1160" y="767"/>
                  <a:pt x="1161" y="768"/>
                  <a:pt x="1161" y="770"/>
                </a:cubicBezTo>
                <a:cubicBezTo>
                  <a:pt x="1161" y="771"/>
                  <a:pt x="1161" y="773"/>
                  <a:pt x="1160" y="775"/>
                </a:cubicBezTo>
                <a:cubicBezTo>
                  <a:pt x="1159" y="777"/>
                  <a:pt x="1158" y="779"/>
                  <a:pt x="1156" y="782"/>
                </a:cubicBezTo>
                <a:cubicBezTo>
                  <a:pt x="1154" y="785"/>
                  <a:pt x="1151" y="788"/>
                  <a:pt x="1147" y="791"/>
                </a:cubicBezTo>
                <a:cubicBezTo>
                  <a:pt x="1143" y="795"/>
                  <a:pt x="1140" y="798"/>
                  <a:pt x="1137" y="800"/>
                </a:cubicBezTo>
                <a:cubicBezTo>
                  <a:pt x="1134" y="803"/>
                  <a:pt x="1132" y="804"/>
                  <a:pt x="1130" y="805"/>
                </a:cubicBezTo>
                <a:cubicBezTo>
                  <a:pt x="1128" y="806"/>
                  <a:pt x="1126" y="806"/>
                  <a:pt x="1125" y="806"/>
                </a:cubicBezTo>
                <a:cubicBezTo>
                  <a:pt x="1123" y="805"/>
                  <a:pt x="1122" y="805"/>
                  <a:pt x="1121" y="803"/>
                </a:cubicBezTo>
                <a:lnTo>
                  <a:pt x="1000" y="683"/>
                </a:lnTo>
                <a:cubicBezTo>
                  <a:pt x="988" y="671"/>
                  <a:pt x="978" y="662"/>
                  <a:pt x="969" y="657"/>
                </a:cubicBezTo>
                <a:cubicBezTo>
                  <a:pt x="960" y="652"/>
                  <a:pt x="951" y="648"/>
                  <a:pt x="942" y="646"/>
                </a:cubicBezTo>
                <a:cubicBezTo>
                  <a:pt x="934" y="645"/>
                  <a:pt x="925" y="645"/>
                  <a:pt x="917" y="648"/>
                </a:cubicBezTo>
                <a:cubicBezTo>
                  <a:pt x="908" y="651"/>
                  <a:pt x="901" y="656"/>
                  <a:pt x="893" y="663"/>
                </a:cubicBezTo>
                <a:cubicBezTo>
                  <a:pt x="884" y="673"/>
                  <a:pt x="878" y="686"/>
                  <a:pt x="875" y="702"/>
                </a:cubicBezTo>
                <a:cubicBezTo>
                  <a:pt x="872" y="718"/>
                  <a:pt x="872" y="738"/>
                  <a:pt x="875" y="761"/>
                </a:cubicBezTo>
                <a:lnTo>
                  <a:pt x="1019" y="905"/>
                </a:lnTo>
                <a:cubicBezTo>
                  <a:pt x="1020" y="907"/>
                  <a:pt x="1021" y="908"/>
                  <a:pt x="1021" y="909"/>
                </a:cubicBezTo>
                <a:cubicBezTo>
                  <a:pt x="1021" y="911"/>
                  <a:pt x="1021" y="913"/>
                  <a:pt x="1020" y="915"/>
                </a:cubicBezTo>
                <a:cubicBezTo>
                  <a:pt x="1019" y="917"/>
                  <a:pt x="1018" y="919"/>
                  <a:pt x="1016" y="922"/>
                </a:cubicBezTo>
                <a:cubicBezTo>
                  <a:pt x="1014" y="924"/>
                  <a:pt x="1011" y="928"/>
                  <a:pt x="1007" y="932"/>
                </a:cubicBezTo>
                <a:cubicBezTo>
                  <a:pt x="1003" y="935"/>
                  <a:pt x="1000" y="938"/>
                  <a:pt x="997" y="940"/>
                </a:cubicBezTo>
                <a:cubicBezTo>
                  <a:pt x="995" y="942"/>
                  <a:pt x="992" y="944"/>
                  <a:pt x="990" y="945"/>
                </a:cubicBezTo>
                <a:cubicBezTo>
                  <a:pt x="988" y="946"/>
                  <a:pt x="986" y="946"/>
                  <a:pt x="985" y="946"/>
                </a:cubicBezTo>
                <a:cubicBezTo>
                  <a:pt x="984" y="945"/>
                  <a:pt x="982" y="944"/>
                  <a:pt x="981" y="943"/>
                </a:cubicBezTo>
                <a:lnTo>
                  <a:pt x="775" y="737"/>
                </a:lnTo>
                <a:cubicBezTo>
                  <a:pt x="773" y="736"/>
                  <a:pt x="773" y="734"/>
                  <a:pt x="772" y="733"/>
                </a:cubicBezTo>
                <a:cubicBezTo>
                  <a:pt x="772" y="732"/>
                  <a:pt x="772" y="730"/>
                  <a:pt x="773" y="728"/>
                </a:cubicBezTo>
                <a:cubicBezTo>
                  <a:pt x="773" y="726"/>
                  <a:pt x="775" y="724"/>
                  <a:pt x="777" y="721"/>
                </a:cubicBezTo>
                <a:cubicBezTo>
                  <a:pt x="779" y="719"/>
                  <a:pt x="781" y="716"/>
                  <a:pt x="785" y="713"/>
                </a:cubicBezTo>
                <a:cubicBezTo>
                  <a:pt x="788" y="709"/>
                  <a:pt x="791" y="707"/>
                  <a:pt x="793" y="705"/>
                </a:cubicBezTo>
                <a:cubicBezTo>
                  <a:pt x="796" y="703"/>
                  <a:pt x="798" y="701"/>
                  <a:pt x="800" y="701"/>
                </a:cubicBezTo>
                <a:cubicBezTo>
                  <a:pt x="802" y="700"/>
                  <a:pt x="804" y="700"/>
                  <a:pt x="805" y="700"/>
                </a:cubicBezTo>
                <a:cubicBezTo>
                  <a:pt x="806" y="701"/>
                  <a:pt x="808" y="702"/>
                  <a:pt x="809" y="703"/>
                </a:cubicBezTo>
                <a:lnTo>
                  <a:pt x="836" y="730"/>
                </a:lnTo>
                <a:cubicBezTo>
                  <a:pt x="835" y="705"/>
                  <a:pt x="837" y="684"/>
                  <a:pt x="842" y="667"/>
                </a:cubicBezTo>
                <a:cubicBezTo>
                  <a:pt x="848" y="649"/>
                  <a:pt x="856" y="635"/>
                  <a:pt x="868" y="623"/>
                </a:cubicBezTo>
                <a:cubicBezTo>
                  <a:pt x="882" y="609"/>
                  <a:pt x="896" y="600"/>
                  <a:pt x="910" y="595"/>
                </a:cubicBezTo>
                <a:cubicBezTo>
                  <a:pt x="924" y="590"/>
                  <a:pt x="938" y="589"/>
                  <a:pt x="951" y="591"/>
                </a:cubicBezTo>
                <a:cubicBezTo>
                  <a:pt x="965" y="593"/>
                  <a:pt x="978" y="598"/>
                  <a:pt x="991" y="606"/>
                </a:cubicBezTo>
                <a:cubicBezTo>
                  <a:pt x="1004" y="614"/>
                  <a:pt x="1018" y="625"/>
                  <a:pt x="1033" y="640"/>
                </a:cubicBezTo>
                <a:lnTo>
                  <a:pt x="1159" y="766"/>
                </a:lnTo>
                <a:close/>
                <a:moveTo>
                  <a:pt x="1262" y="662"/>
                </a:moveTo>
                <a:cubicBezTo>
                  <a:pt x="1263" y="663"/>
                  <a:pt x="1264" y="665"/>
                  <a:pt x="1264" y="666"/>
                </a:cubicBezTo>
                <a:cubicBezTo>
                  <a:pt x="1264" y="668"/>
                  <a:pt x="1264" y="669"/>
                  <a:pt x="1263" y="671"/>
                </a:cubicBezTo>
                <a:cubicBezTo>
                  <a:pt x="1263" y="673"/>
                  <a:pt x="1261" y="676"/>
                  <a:pt x="1259" y="678"/>
                </a:cubicBezTo>
                <a:cubicBezTo>
                  <a:pt x="1257" y="681"/>
                  <a:pt x="1254" y="684"/>
                  <a:pt x="1250" y="688"/>
                </a:cubicBezTo>
                <a:cubicBezTo>
                  <a:pt x="1246" y="692"/>
                  <a:pt x="1243" y="695"/>
                  <a:pt x="1241" y="697"/>
                </a:cubicBezTo>
                <a:cubicBezTo>
                  <a:pt x="1238" y="699"/>
                  <a:pt x="1235" y="701"/>
                  <a:pt x="1233" y="701"/>
                </a:cubicBezTo>
                <a:cubicBezTo>
                  <a:pt x="1231" y="702"/>
                  <a:pt x="1230" y="703"/>
                  <a:pt x="1228" y="702"/>
                </a:cubicBezTo>
                <a:cubicBezTo>
                  <a:pt x="1227" y="702"/>
                  <a:pt x="1225" y="701"/>
                  <a:pt x="1224" y="700"/>
                </a:cubicBezTo>
                <a:lnTo>
                  <a:pt x="1018" y="494"/>
                </a:lnTo>
                <a:cubicBezTo>
                  <a:pt x="1017" y="493"/>
                  <a:pt x="1016" y="491"/>
                  <a:pt x="1016" y="490"/>
                </a:cubicBezTo>
                <a:cubicBezTo>
                  <a:pt x="1015" y="488"/>
                  <a:pt x="1016" y="487"/>
                  <a:pt x="1016" y="485"/>
                </a:cubicBezTo>
                <a:cubicBezTo>
                  <a:pt x="1017" y="483"/>
                  <a:pt x="1019" y="480"/>
                  <a:pt x="1021" y="477"/>
                </a:cubicBezTo>
                <a:cubicBezTo>
                  <a:pt x="1023" y="475"/>
                  <a:pt x="1026" y="471"/>
                  <a:pt x="1030" y="468"/>
                </a:cubicBezTo>
                <a:cubicBezTo>
                  <a:pt x="1033" y="464"/>
                  <a:pt x="1037" y="461"/>
                  <a:pt x="1039" y="459"/>
                </a:cubicBezTo>
                <a:cubicBezTo>
                  <a:pt x="1042" y="457"/>
                  <a:pt x="1045" y="455"/>
                  <a:pt x="1047" y="454"/>
                </a:cubicBezTo>
                <a:cubicBezTo>
                  <a:pt x="1049" y="454"/>
                  <a:pt x="1050" y="453"/>
                  <a:pt x="1052" y="454"/>
                </a:cubicBezTo>
                <a:cubicBezTo>
                  <a:pt x="1053" y="454"/>
                  <a:pt x="1055" y="455"/>
                  <a:pt x="1056" y="456"/>
                </a:cubicBezTo>
                <a:lnTo>
                  <a:pt x="1262" y="662"/>
                </a:lnTo>
                <a:close/>
                <a:moveTo>
                  <a:pt x="990" y="382"/>
                </a:moveTo>
                <a:cubicBezTo>
                  <a:pt x="999" y="391"/>
                  <a:pt x="1004" y="398"/>
                  <a:pt x="1003" y="405"/>
                </a:cubicBezTo>
                <a:cubicBezTo>
                  <a:pt x="1003" y="412"/>
                  <a:pt x="999" y="419"/>
                  <a:pt x="990" y="428"/>
                </a:cubicBezTo>
                <a:cubicBezTo>
                  <a:pt x="981" y="437"/>
                  <a:pt x="973" y="442"/>
                  <a:pt x="967" y="442"/>
                </a:cubicBezTo>
                <a:cubicBezTo>
                  <a:pt x="960" y="442"/>
                  <a:pt x="953" y="438"/>
                  <a:pt x="944" y="429"/>
                </a:cubicBezTo>
                <a:cubicBezTo>
                  <a:pt x="935" y="420"/>
                  <a:pt x="931" y="412"/>
                  <a:pt x="931" y="406"/>
                </a:cubicBezTo>
                <a:cubicBezTo>
                  <a:pt x="931" y="399"/>
                  <a:pt x="936" y="392"/>
                  <a:pt x="945" y="382"/>
                </a:cubicBezTo>
                <a:cubicBezTo>
                  <a:pt x="954" y="374"/>
                  <a:pt x="961" y="369"/>
                  <a:pt x="968" y="369"/>
                </a:cubicBezTo>
                <a:cubicBezTo>
                  <a:pt x="974" y="369"/>
                  <a:pt x="982" y="373"/>
                  <a:pt x="990" y="382"/>
                </a:cubicBezTo>
                <a:close/>
                <a:moveTo>
                  <a:pt x="1515" y="409"/>
                </a:moveTo>
                <a:cubicBezTo>
                  <a:pt x="1516" y="410"/>
                  <a:pt x="1517" y="412"/>
                  <a:pt x="1517" y="413"/>
                </a:cubicBezTo>
                <a:cubicBezTo>
                  <a:pt x="1517" y="415"/>
                  <a:pt x="1517" y="416"/>
                  <a:pt x="1516" y="418"/>
                </a:cubicBezTo>
                <a:cubicBezTo>
                  <a:pt x="1516" y="420"/>
                  <a:pt x="1514" y="423"/>
                  <a:pt x="1512" y="425"/>
                </a:cubicBezTo>
                <a:cubicBezTo>
                  <a:pt x="1510" y="428"/>
                  <a:pt x="1507" y="431"/>
                  <a:pt x="1503" y="435"/>
                </a:cubicBezTo>
                <a:cubicBezTo>
                  <a:pt x="1500" y="439"/>
                  <a:pt x="1496" y="442"/>
                  <a:pt x="1494" y="444"/>
                </a:cubicBezTo>
                <a:cubicBezTo>
                  <a:pt x="1491" y="446"/>
                  <a:pt x="1488" y="448"/>
                  <a:pt x="1486" y="448"/>
                </a:cubicBezTo>
                <a:cubicBezTo>
                  <a:pt x="1484" y="449"/>
                  <a:pt x="1483" y="449"/>
                  <a:pt x="1481" y="449"/>
                </a:cubicBezTo>
                <a:cubicBezTo>
                  <a:pt x="1480" y="449"/>
                  <a:pt x="1478" y="448"/>
                  <a:pt x="1477" y="447"/>
                </a:cubicBezTo>
                <a:lnTo>
                  <a:pt x="1356" y="326"/>
                </a:lnTo>
                <a:cubicBezTo>
                  <a:pt x="1345" y="314"/>
                  <a:pt x="1334" y="306"/>
                  <a:pt x="1325" y="301"/>
                </a:cubicBezTo>
                <a:cubicBezTo>
                  <a:pt x="1316" y="295"/>
                  <a:pt x="1307" y="292"/>
                  <a:pt x="1299" y="290"/>
                </a:cubicBezTo>
                <a:cubicBezTo>
                  <a:pt x="1290" y="288"/>
                  <a:pt x="1281" y="289"/>
                  <a:pt x="1273" y="292"/>
                </a:cubicBezTo>
                <a:cubicBezTo>
                  <a:pt x="1265" y="295"/>
                  <a:pt x="1257" y="300"/>
                  <a:pt x="1250" y="307"/>
                </a:cubicBezTo>
                <a:cubicBezTo>
                  <a:pt x="1240" y="316"/>
                  <a:pt x="1234" y="329"/>
                  <a:pt x="1231" y="345"/>
                </a:cubicBezTo>
                <a:cubicBezTo>
                  <a:pt x="1228" y="362"/>
                  <a:pt x="1228" y="381"/>
                  <a:pt x="1231" y="405"/>
                </a:cubicBezTo>
                <a:lnTo>
                  <a:pt x="1375" y="549"/>
                </a:lnTo>
                <a:cubicBezTo>
                  <a:pt x="1376" y="550"/>
                  <a:pt x="1377" y="552"/>
                  <a:pt x="1377" y="553"/>
                </a:cubicBezTo>
                <a:cubicBezTo>
                  <a:pt x="1378" y="555"/>
                  <a:pt x="1377" y="556"/>
                  <a:pt x="1377" y="558"/>
                </a:cubicBezTo>
                <a:cubicBezTo>
                  <a:pt x="1376" y="560"/>
                  <a:pt x="1374" y="563"/>
                  <a:pt x="1372" y="565"/>
                </a:cubicBezTo>
                <a:cubicBezTo>
                  <a:pt x="1370" y="568"/>
                  <a:pt x="1367" y="571"/>
                  <a:pt x="1363" y="575"/>
                </a:cubicBezTo>
                <a:cubicBezTo>
                  <a:pt x="1360" y="579"/>
                  <a:pt x="1356" y="582"/>
                  <a:pt x="1354" y="584"/>
                </a:cubicBezTo>
                <a:cubicBezTo>
                  <a:pt x="1351" y="586"/>
                  <a:pt x="1349" y="588"/>
                  <a:pt x="1346" y="588"/>
                </a:cubicBezTo>
                <a:cubicBezTo>
                  <a:pt x="1344" y="589"/>
                  <a:pt x="1343" y="589"/>
                  <a:pt x="1341" y="589"/>
                </a:cubicBezTo>
                <a:cubicBezTo>
                  <a:pt x="1340" y="589"/>
                  <a:pt x="1339" y="588"/>
                  <a:pt x="1337" y="587"/>
                </a:cubicBezTo>
                <a:lnTo>
                  <a:pt x="1131" y="381"/>
                </a:lnTo>
                <a:cubicBezTo>
                  <a:pt x="1130" y="379"/>
                  <a:pt x="1129" y="378"/>
                  <a:pt x="1129" y="377"/>
                </a:cubicBezTo>
                <a:cubicBezTo>
                  <a:pt x="1128" y="375"/>
                  <a:pt x="1128" y="374"/>
                  <a:pt x="1129" y="372"/>
                </a:cubicBezTo>
                <a:cubicBezTo>
                  <a:pt x="1130" y="370"/>
                  <a:pt x="1131" y="367"/>
                  <a:pt x="1133" y="365"/>
                </a:cubicBezTo>
                <a:cubicBezTo>
                  <a:pt x="1135" y="363"/>
                  <a:pt x="1138" y="360"/>
                  <a:pt x="1141" y="356"/>
                </a:cubicBezTo>
                <a:cubicBezTo>
                  <a:pt x="1145" y="353"/>
                  <a:pt x="1147" y="350"/>
                  <a:pt x="1150" y="348"/>
                </a:cubicBezTo>
                <a:cubicBezTo>
                  <a:pt x="1152" y="346"/>
                  <a:pt x="1154" y="345"/>
                  <a:pt x="1156" y="344"/>
                </a:cubicBezTo>
                <a:cubicBezTo>
                  <a:pt x="1158" y="344"/>
                  <a:pt x="1160" y="344"/>
                  <a:pt x="1161" y="344"/>
                </a:cubicBezTo>
                <a:cubicBezTo>
                  <a:pt x="1163" y="344"/>
                  <a:pt x="1164" y="345"/>
                  <a:pt x="1165" y="346"/>
                </a:cubicBezTo>
                <a:lnTo>
                  <a:pt x="1192" y="374"/>
                </a:lnTo>
                <a:cubicBezTo>
                  <a:pt x="1191" y="349"/>
                  <a:pt x="1193" y="328"/>
                  <a:pt x="1199" y="310"/>
                </a:cubicBezTo>
                <a:cubicBezTo>
                  <a:pt x="1204" y="293"/>
                  <a:pt x="1213" y="278"/>
                  <a:pt x="1225" y="266"/>
                </a:cubicBezTo>
                <a:cubicBezTo>
                  <a:pt x="1238" y="253"/>
                  <a:pt x="1252" y="243"/>
                  <a:pt x="1266" y="239"/>
                </a:cubicBezTo>
                <a:cubicBezTo>
                  <a:pt x="1280" y="234"/>
                  <a:pt x="1294" y="233"/>
                  <a:pt x="1308" y="235"/>
                </a:cubicBezTo>
                <a:cubicBezTo>
                  <a:pt x="1321" y="236"/>
                  <a:pt x="1335" y="241"/>
                  <a:pt x="1348" y="249"/>
                </a:cubicBezTo>
                <a:cubicBezTo>
                  <a:pt x="1361" y="257"/>
                  <a:pt x="1375" y="269"/>
                  <a:pt x="1389" y="283"/>
                </a:cubicBezTo>
                <a:lnTo>
                  <a:pt x="1515" y="409"/>
                </a:lnTo>
                <a:close/>
                <a:moveTo>
                  <a:pt x="1645" y="55"/>
                </a:moveTo>
                <a:cubicBezTo>
                  <a:pt x="1651" y="61"/>
                  <a:pt x="1653" y="67"/>
                  <a:pt x="1653" y="73"/>
                </a:cubicBezTo>
                <a:cubicBezTo>
                  <a:pt x="1652" y="78"/>
                  <a:pt x="1650" y="83"/>
                  <a:pt x="1646" y="87"/>
                </a:cubicBezTo>
                <a:lnTo>
                  <a:pt x="1510" y="223"/>
                </a:lnTo>
                <a:cubicBezTo>
                  <a:pt x="1522" y="234"/>
                  <a:pt x="1533" y="243"/>
                  <a:pt x="1545" y="250"/>
                </a:cubicBezTo>
                <a:cubicBezTo>
                  <a:pt x="1556" y="257"/>
                  <a:pt x="1568" y="261"/>
                  <a:pt x="1580" y="262"/>
                </a:cubicBezTo>
                <a:cubicBezTo>
                  <a:pt x="1592" y="263"/>
                  <a:pt x="1604" y="261"/>
                  <a:pt x="1616" y="256"/>
                </a:cubicBezTo>
                <a:cubicBezTo>
                  <a:pt x="1628" y="251"/>
                  <a:pt x="1641" y="242"/>
                  <a:pt x="1653" y="230"/>
                </a:cubicBezTo>
                <a:cubicBezTo>
                  <a:pt x="1663" y="220"/>
                  <a:pt x="1671" y="211"/>
                  <a:pt x="1677" y="201"/>
                </a:cubicBezTo>
                <a:cubicBezTo>
                  <a:pt x="1683" y="192"/>
                  <a:pt x="1688" y="184"/>
                  <a:pt x="1691" y="176"/>
                </a:cubicBezTo>
                <a:cubicBezTo>
                  <a:pt x="1695" y="168"/>
                  <a:pt x="1698" y="162"/>
                  <a:pt x="1700" y="157"/>
                </a:cubicBezTo>
                <a:cubicBezTo>
                  <a:pt x="1702" y="152"/>
                  <a:pt x="1704" y="148"/>
                  <a:pt x="1706" y="146"/>
                </a:cubicBezTo>
                <a:cubicBezTo>
                  <a:pt x="1707" y="145"/>
                  <a:pt x="1708" y="144"/>
                  <a:pt x="1709" y="144"/>
                </a:cubicBezTo>
                <a:cubicBezTo>
                  <a:pt x="1711" y="144"/>
                  <a:pt x="1712" y="144"/>
                  <a:pt x="1714" y="145"/>
                </a:cubicBezTo>
                <a:cubicBezTo>
                  <a:pt x="1715" y="145"/>
                  <a:pt x="1717" y="146"/>
                  <a:pt x="1719" y="148"/>
                </a:cubicBezTo>
                <a:cubicBezTo>
                  <a:pt x="1721" y="150"/>
                  <a:pt x="1724" y="152"/>
                  <a:pt x="1726" y="155"/>
                </a:cubicBezTo>
                <a:cubicBezTo>
                  <a:pt x="1728" y="157"/>
                  <a:pt x="1730" y="159"/>
                  <a:pt x="1731" y="160"/>
                </a:cubicBezTo>
                <a:cubicBezTo>
                  <a:pt x="1733" y="162"/>
                  <a:pt x="1734" y="163"/>
                  <a:pt x="1735" y="165"/>
                </a:cubicBezTo>
                <a:cubicBezTo>
                  <a:pt x="1736" y="166"/>
                  <a:pt x="1736" y="167"/>
                  <a:pt x="1737" y="169"/>
                </a:cubicBezTo>
                <a:cubicBezTo>
                  <a:pt x="1737" y="170"/>
                  <a:pt x="1737" y="172"/>
                  <a:pt x="1737" y="174"/>
                </a:cubicBezTo>
                <a:cubicBezTo>
                  <a:pt x="1737" y="175"/>
                  <a:pt x="1736" y="179"/>
                  <a:pt x="1734" y="185"/>
                </a:cubicBezTo>
                <a:cubicBezTo>
                  <a:pt x="1732" y="191"/>
                  <a:pt x="1728" y="198"/>
                  <a:pt x="1723" y="207"/>
                </a:cubicBezTo>
                <a:cubicBezTo>
                  <a:pt x="1719" y="215"/>
                  <a:pt x="1713" y="224"/>
                  <a:pt x="1706" y="235"/>
                </a:cubicBezTo>
                <a:cubicBezTo>
                  <a:pt x="1698" y="245"/>
                  <a:pt x="1690" y="255"/>
                  <a:pt x="1680" y="264"/>
                </a:cubicBezTo>
                <a:cubicBezTo>
                  <a:pt x="1663" y="281"/>
                  <a:pt x="1646" y="294"/>
                  <a:pt x="1628" y="302"/>
                </a:cubicBezTo>
                <a:cubicBezTo>
                  <a:pt x="1611" y="310"/>
                  <a:pt x="1593" y="314"/>
                  <a:pt x="1575" y="313"/>
                </a:cubicBezTo>
                <a:cubicBezTo>
                  <a:pt x="1557" y="312"/>
                  <a:pt x="1539" y="307"/>
                  <a:pt x="1520" y="298"/>
                </a:cubicBezTo>
                <a:cubicBezTo>
                  <a:pt x="1502" y="288"/>
                  <a:pt x="1483" y="274"/>
                  <a:pt x="1465" y="255"/>
                </a:cubicBezTo>
                <a:cubicBezTo>
                  <a:pt x="1447" y="237"/>
                  <a:pt x="1433" y="219"/>
                  <a:pt x="1424" y="200"/>
                </a:cubicBezTo>
                <a:cubicBezTo>
                  <a:pt x="1414" y="182"/>
                  <a:pt x="1409" y="163"/>
                  <a:pt x="1408" y="145"/>
                </a:cubicBezTo>
                <a:cubicBezTo>
                  <a:pt x="1406" y="126"/>
                  <a:pt x="1409" y="108"/>
                  <a:pt x="1416" y="91"/>
                </a:cubicBezTo>
                <a:cubicBezTo>
                  <a:pt x="1423" y="73"/>
                  <a:pt x="1434" y="57"/>
                  <a:pt x="1449" y="42"/>
                </a:cubicBezTo>
                <a:cubicBezTo>
                  <a:pt x="1465" y="25"/>
                  <a:pt x="1482" y="14"/>
                  <a:pt x="1498" y="8"/>
                </a:cubicBezTo>
                <a:cubicBezTo>
                  <a:pt x="1515" y="2"/>
                  <a:pt x="1531" y="0"/>
                  <a:pt x="1548" y="1"/>
                </a:cubicBezTo>
                <a:cubicBezTo>
                  <a:pt x="1564" y="2"/>
                  <a:pt x="1579" y="7"/>
                  <a:pt x="1595" y="16"/>
                </a:cubicBezTo>
                <a:cubicBezTo>
                  <a:pt x="1610" y="24"/>
                  <a:pt x="1624" y="35"/>
                  <a:pt x="1638" y="49"/>
                </a:cubicBezTo>
                <a:lnTo>
                  <a:pt x="1645" y="55"/>
                </a:lnTo>
                <a:close/>
                <a:moveTo>
                  <a:pt x="1595" y="82"/>
                </a:moveTo>
                <a:cubicBezTo>
                  <a:pt x="1576" y="62"/>
                  <a:pt x="1556" y="51"/>
                  <a:pt x="1535" y="49"/>
                </a:cubicBezTo>
                <a:cubicBezTo>
                  <a:pt x="1515" y="47"/>
                  <a:pt x="1495" y="55"/>
                  <a:pt x="1477" y="73"/>
                </a:cubicBezTo>
                <a:cubicBezTo>
                  <a:pt x="1468" y="83"/>
                  <a:pt x="1461" y="93"/>
                  <a:pt x="1457" y="103"/>
                </a:cubicBezTo>
                <a:cubicBezTo>
                  <a:pt x="1454" y="114"/>
                  <a:pt x="1453" y="124"/>
                  <a:pt x="1454" y="135"/>
                </a:cubicBezTo>
                <a:cubicBezTo>
                  <a:pt x="1455" y="145"/>
                  <a:pt x="1458" y="156"/>
                  <a:pt x="1463" y="166"/>
                </a:cubicBezTo>
                <a:cubicBezTo>
                  <a:pt x="1468" y="177"/>
                  <a:pt x="1475" y="186"/>
                  <a:pt x="1483" y="195"/>
                </a:cubicBezTo>
                <a:lnTo>
                  <a:pt x="1595" y="82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80" name="Freeform 264"/>
          <p:cNvSpPr>
            <a:spLocks noEditPoints="1"/>
          </p:cNvSpPr>
          <p:nvPr/>
        </p:nvSpPr>
        <p:spPr bwMode="auto">
          <a:xfrm>
            <a:off x="5290579" y="4418880"/>
            <a:ext cx="247967" cy="277813"/>
          </a:xfrm>
          <a:custGeom>
            <a:avLst/>
            <a:gdLst>
              <a:gd name="T0" fmla="*/ 289 w 1555"/>
              <a:gd name="T1" fmla="*/ 1226 h 1463"/>
              <a:gd name="T2" fmla="*/ 324 w 1555"/>
              <a:gd name="T3" fmla="*/ 1425 h 1463"/>
              <a:gd name="T4" fmla="*/ 300 w 1555"/>
              <a:gd name="T5" fmla="*/ 1456 h 1463"/>
              <a:gd name="T6" fmla="*/ 9 w 1555"/>
              <a:gd name="T7" fmla="*/ 1186 h 1463"/>
              <a:gd name="T8" fmla="*/ 90 w 1555"/>
              <a:gd name="T9" fmla="*/ 1072 h 1463"/>
              <a:gd name="T10" fmla="*/ 226 w 1555"/>
              <a:gd name="T11" fmla="*/ 1048 h 1463"/>
              <a:gd name="T12" fmla="*/ 151 w 1555"/>
              <a:gd name="T13" fmla="*/ 1094 h 1463"/>
              <a:gd name="T14" fmla="*/ 183 w 1555"/>
              <a:gd name="T15" fmla="*/ 1281 h 1463"/>
              <a:gd name="T16" fmla="*/ 243 w 1555"/>
              <a:gd name="T17" fmla="*/ 1147 h 1463"/>
              <a:gd name="T18" fmla="*/ 462 w 1555"/>
              <a:gd name="T19" fmla="*/ 923 h 1463"/>
              <a:gd name="T20" fmla="*/ 448 w 1555"/>
              <a:gd name="T21" fmla="*/ 939 h 1463"/>
              <a:gd name="T22" fmla="*/ 416 w 1555"/>
              <a:gd name="T23" fmla="*/ 985 h 1463"/>
              <a:gd name="T24" fmla="*/ 562 w 1555"/>
              <a:gd name="T25" fmla="*/ 1187 h 1463"/>
              <a:gd name="T26" fmla="*/ 538 w 1555"/>
              <a:gd name="T27" fmla="*/ 1218 h 1463"/>
              <a:gd name="T28" fmla="*/ 315 w 1555"/>
              <a:gd name="T29" fmla="*/ 1015 h 1463"/>
              <a:gd name="T30" fmla="*/ 326 w 1555"/>
              <a:gd name="T31" fmla="*/ 991 h 1463"/>
              <a:gd name="T32" fmla="*/ 350 w 1555"/>
              <a:gd name="T33" fmla="*/ 981 h 1463"/>
              <a:gd name="T34" fmla="*/ 384 w 1555"/>
              <a:gd name="T35" fmla="*/ 929 h 1463"/>
              <a:gd name="T36" fmla="*/ 421 w 1555"/>
              <a:gd name="T37" fmla="*/ 896 h 1463"/>
              <a:gd name="T38" fmla="*/ 441 w 1555"/>
              <a:gd name="T39" fmla="*/ 900 h 1463"/>
              <a:gd name="T40" fmla="*/ 829 w 1555"/>
              <a:gd name="T41" fmla="*/ 869 h 1463"/>
              <a:gd name="T42" fmla="*/ 677 w 1555"/>
              <a:gd name="T43" fmla="*/ 1027 h 1463"/>
              <a:gd name="T44" fmla="*/ 513 w 1555"/>
              <a:gd name="T45" fmla="*/ 861 h 1463"/>
              <a:gd name="T46" fmla="*/ 665 w 1555"/>
              <a:gd name="T47" fmla="*/ 703 h 1463"/>
              <a:gd name="T48" fmla="*/ 701 w 1555"/>
              <a:gd name="T49" fmla="*/ 773 h 1463"/>
              <a:gd name="T50" fmla="*/ 567 w 1555"/>
              <a:gd name="T51" fmla="*/ 818 h 1463"/>
              <a:gd name="T52" fmla="*/ 642 w 1555"/>
              <a:gd name="T53" fmla="*/ 957 h 1463"/>
              <a:gd name="T54" fmla="*/ 775 w 1555"/>
              <a:gd name="T55" fmla="*/ 912 h 1463"/>
              <a:gd name="T56" fmla="*/ 973 w 1555"/>
              <a:gd name="T57" fmla="*/ 770 h 1463"/>
              <a:gd name="T58" fmla="*/ 961 w 1555"/>
              <a:gd name="T59" fmla="*/ 797 h 1463"/>
              <a:gd name="T60" fmla="*/ 935 w 1555"/>
              <a:gd name="T61" fmla="*/ 808 h 1463"/>
              <a:gd name="T62" fmla="*/ 631 w 1555"/>
              <a:gd name="T63" fmla="*/ 486 h 1463"/>
              <a:gd name="T64" fmla="*/ 662 w 1555"/>
              <a:gd name="T65" fmla="*/ 462 h 1463"/>
              <a:gd name="T66" fmla="*/ 1082 w 1555"/>
              <a:gd name="T67" fmla="*/ 667 h 1463"/>
              <a:gd name="T68" fmla="*/ 1058 w 1555"/>
              <a:gd name="T69" fmla="*/ 698 h 1463"/>
              <a:gd name="T70" fmla="*/ 836 w 1555"/>
              <a:gd name="T71" fmla="*/ 494 h 1463"/>
              <a:gd name="T72" fmla="*/ 848 w 1555"/>
              <a:gd name="T73" fmla="*/ 469 h 1463"/>
              <a:gd name="T74" fmla="*/ 874 w 1555"/>
              <a:gd name="T75" fmla="*/ 457 h 1463"/>
              <a:gd name="T76" fmla="*/ 808 w 1555"/>
              <a:gd name="T77" fmla="*/ 429 h 1463"/>
              <a:gd name="T78" fmla="*/ 763 w 1555"/>
              <a:gd name="T79" fmla="*/ 383 h 1463"/>
              <a:gd name="T80" fmla="*/ 1330 w 1555"/>
              <a:gd name="T81" fmla="*/ 420 h 1463"/>
              <a:gd name="T82" fmla="*/ 1306 w 1555"/>
              <a:gd name="T83" fmla="*/ 451 h 1463"/>
              <a:gd name="T84" fmla="*/ 1169 w 1555"/>
              <a:gd name="T85" fmla="*/ 333 h 1463"/>
              <a:gd name="T86" fmla="*/ 1062 w 1555"/>
              <a:gd name="T87" fmla="*/ 313 h 1463"/>
              <a:gd name="T88" fmla="*/ 1190 w 1555"/>
              <a:gd name="T89" fmla="*/ 560 h 1463"/>
              <a:gd name="T90" fmla="*/ 1166 w 1555"/>
              <a:gd name="T91" fmla="*/ 590 h 1463"/>
              <a:gd name="T92" fmla="*/ 943 w 1555"/>
              <a:gd name="T93" fmla="*/ 387 h 1463"/>
              <a:gd name="T94" fmla="*/ 953 w 1555"/>
              <a:gd name="T95" fmla="*/ 363 h 1463"/>
              <a:gd name="T96" fmla="*/ 978 w 1555"/>
              <a:gd name="T97" fmla="*/ 353 h 1463"/>
              <a:gd name="T98" fmla="*/ 1079 w 1555"/>
              <a:gd name="T99" fmla="*/ 245 h 1463"/>
              <a:gd name="T100" fmla="*/ 1327 w 1555"/>
              <a:gd name="T101" fmla="*/ 416 h 1463"/>
              <a:gd name="T102" fmla="*/ 1328 w 1555"/>
              <a:gd name="T103" fmla="*/ 223 h 1463"/>
              <a:gd name="T104" fmla="*/ 1471 w 1555"/>
              <a:gd name="T105" fmla="*/ 231 h 1463"/>
              <a:gd name="T106" fmla="*/ 1523 w 1555"/>
              <a:gd name="T107" fmla="*/ 147 h 1463"/>
              <a:gd name="T108" fmla="*/ 1544 w 1555"/>
              <a:gd name="T109" fmla="*/ 156 h 1463"/>
              <a:gd name="T110" fmla="*/ 1555 w 1555"/>
              <a:gd name="T111" fmla="*/ 174 h 1463"/>
              <a:gd name="T112" fmla="*/ 1498 w 1555"/>
              <a:gd name="T113" fmla="*/ 265 h 1463"/>
              <a:gd name="T114" fmla="*/ 1283 w 1555"/>
              <a:gd name="T115" fmla="*/ 256 h 1463"/>
              <a:gd name="T116" fmla="*/ 1267 w 1555"/>
              <a:gd name="T117" fmla="*/ 43 h 1463"/>
              <a:gd name="T118" fmla="*/ 1456 w 1555"/>
              <a:gd name="T119" fmla="*/ 49 h 1463"/>
              <a:gd name="T120" fmla="*/ 1295 w 1555"/>
              <a:gd name="T121" fmla="*/ 74 h 1463"/>
              <a:gd name="T122" fmla="*/ 1301 w 1555"/>
              <a:gd name="T123" fmla="*/ 196 h 14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1555" h="1463">
                <a:moveTo>
                  <a:pt x="261" y="1074"/>
                </a:moveTo>
                <a:cubicBezTo>
                  <a:pt x="276" y="1089"/>
                  <a:pt x="287" y="1104"/>
                  <a:pt x="294" y="1121"/>
                </a:cubicBezTo>
                <a:cubicBezTo>
                  <a:pt x="301" y="1138"/>
                  <a:pt x="304" y="1155"/>
                  <a:pt x="303" y="1173"/>
                </a:cubicBezTo>
                <a:cubicBezTo>
                  <a:pt x="303" y="1190"/>
                  <a:pt x="298" y="1208"/>
                  <a:pt x="289" y="1226"/>
                </a:cubicBezTo>
                <a:cubicBezTo>
                  <a:pt x="281" y="1244"/>
                  <a:pt x="267" y="1262"/>
                  <a:pt x="249" y="1280"/>
                </a:cubicBezTo>
                <a:lnTo>
                  <a:pt x="215" y="1314"/>
                </a:lnTo>
                <a:lnTo>
                  <a:pt x="322" y="1420"/>
                </a:lnTo>
                <a:cubicBezTo>
                  <a:pt x="323" y="1422"/>
                  <a:pt x="324" y="1423"/>
                  <a:pt x="324" y="1425"/>
                </a:cubicBezTo>
                <a:cubicBezTo>
                  <a:pt x="324" y="1426"/>
                  <a:pt x="324" y="1428"/>
                  <a:pt x="323" y="1430"/>
                </a:cubicBezTo>
                <a:cubicBezTo>
                  <a:pt x="322" y="1432"/>
                  <a:pt x="321" y="1435"/>
                  <a:pt x="319" y="1437"/>
                </a:cubicBezTo>
                <a:cubicBezTo>
                  <a:pt x="316" y="1440"/>
                  <a:pt x="314" y="1444"/>
                  <a:pt x="310" y="1448"/>
                </a:cubicBezTo>
                <a:cubicBezTo>
                  <a:pt x="306" y="1451"/>
                  <a:pt x="303" y="1454"/>
                  <a:pt x="300" y="1456"/>
                </a:cubicBezTo>
                <a:cubicBezTo>
                  <a:pt x="297" y="1459"/>
                  <a:pt x="294" y="1460"/>
                  <a:pt x="292" y="1461"/>
                </a:cubicBezTo>
                <a:cubicBezTo>
                  <a:pt x="290" y="1462"/>
                  <a:pt x="288" y="1463"/>
                  <a:pt x="287" y="1462"/>
                </a:cubicBezTo>
                <a:cubicBezTo>
                  <a:pt x="285" y="1462"/>
                  <a:pt x="284" y="1461"/>
                  <a:pt x="283" y="1460"/>
                </a:cubicBezTo>
                <a:lnTo>
                  <a:pt x="9" y="1186"/>
                </a:lnTo>
                <a:cubicBezTo>
                  <a:pt x="3" y="1180"/>
                  <a:pt x="0" y="1174"/>
                  <a:pt x="1" y="1168"/>
                </a:cubicBezTo>
                <a:cubicBezTo>
                  <a:pt x="1" y="1162"/>
                  <a:pt x="4" y="1158"/>
                  <a:pt x="8" y="1154"/>
                </a:cubicBezTo>
                <a:lnTo>
                  <a:pt x="71" y="1090"/>
                </a:lnTo>
                <a:cubicBezTo>
                  <a:pt x="77" y="1084"/>
                  <a:pt x="84" y="1078"/>
                  <a:pt x="90" y="1072"/>
                </a:cubicBezTo>
                <a:cubicBezTo>
                  <a:pt x="97" y="1067"/>
                  <a:pt x="105" y="1061"/>
                  <a:pt x="115" y="1055"/>
                </a:cubicBezTo>
                <a:cubicBezTo>
                  <a:pt x="124" y="1049"/>
                  <a:pt x="136" y="1044"/>
                  <a:pt x="149" y="1040"/>
                </a:cubicBezTo>
                <a:cubicBezTo>
                  <a:pt x="162" y="1037"/>
                  <a:pt x="175" y="1036"/>
                  <a:pt x="188" y="1037"/>
                </a:cubicBezTo>
                <a:cubicBezTo>
                  <a:pt x="201" y="1038"/>
                  <a:pt x="213" y="1042"/>
                  <a:pt x="226" y="1048"/>
                </a:cubicBezTo>
                <a:cubicBezTo>
                  <a:pt x="238" y="1054"/>
                  <a:pt x="250" y="1063"/>
                  <a:pt x="261" y="1074"/>
                </a:cubicBezTo>
                <a:close/>
                <a:moveTo>
                  <a:pt x="223" y="1119"/>
                </a:moveTo>
                <a:cubicBezTo>
                  <a:pt x="211" y="1106"/>
                  <a:pt x="198" y="1099"/>
                  <a:pt x="186" y="1095"/>
                </a:cubicBezTo>
                <a:cubicBezTo>
                  <a:pt x="173" y="1091"/>
                  <a:pt x="162" y="1091"/>
                  <a:pt x="151" y="1094"/>
                </a:cubicBezTo>
                <a:cubicBezTo>
                  <a:pt x="140" y="1096"/>
                  <a:pt x="131" y="1101"/>
                  <a:pt x="123" y="1107"/>
                </a:cubicBezTo>
                <a:cubicBezTo>
                  <a:pt x="115" y="1113"/>
                  <a:pt x="107" y="1119"/>
                  <a:pt x="100" y="1126"/>
                </a:cubicBezTo>
                <a:lnTo>
                  <a:pt x="64" y="1162"/>
                </a:lnTo>
                <a:lnTo>
                  <a:pt x="183" y="1281"/>
                </a:lnTo>
                <a:lnTo>
                  <a:pt x="218" y="1246"/>
                </a:lnTo>
                <a:cubicBezTo>
                  <a:pt x="230" y="1234"/>
                  <a:pt x="239" y="1222"/>
                  <a:pt x="244" y="1212"/>
                </a:cubicBezTo>
                <a:cubicBezTo>
                  <a:pt x="248" y="1201"/>
                  <a:pt x="251" y="1190"/>
                  <a:pt x="251" y="1179"/>
                </a:cubicBezTo>
                <a:cubicBezTo>
                  <a:pt x="251" y="1168"/>
                  <a:pt x="248" y="1158"/>
                  <a:pt x="243" y="1147"/>
                </a:cubicBezTo>
                <a:cubicBezTo>
                  <a:pt x="239" y="1137"/>
                  <a:pt x="232" y="1127"/>
                  <a:pt x="223" y="1119"/>
                </a:cubicBezTo>
                <a:close/>
                <a:moveTo>
                  <a:pt x="450" y="908"/>
                </a:moveTo>
                <a:cubicBezTo>
                  <a:pt x="453" y="911"/>
                  <a:pt x="456" y="914"/>
                  <a:pt x="458" y="917"/>
                </a:cubicBezTo>
                <a:cubicBezTo>
                  <a:pt x="460" y="919"/>
                  <a:pt x="461" y="921"/>
                  <a:pt x="462" y="923"/>
                </a:cubicBezTo>
                <a:cubicBezTo>
                  <a:pt x="463" y="925"/>
                  <a:pt x="464" y="926"/>
                  <a:pt x="464" y="928"/>
                </a:cubicBezTo>
                <a:cubicBezTo>
                  <a:pt x="464" y="929"/>
                  <a:pt x="463" y="930"/>
                  <a:pt x="462" y="931"/>
                </a:cubicBezTo>
                <a:cubicBezTo>
                  <a:pt x="460" y="933"/>
                  <a:pt x="459" y="934"/>
                  <a:pt x="456" y="935"/>
                </a:cubicBezTo>
                <a:cubicBezTo>
                  <a:pt x="454" y="936"/>
                  <a:pt x="451" y="937"/>
                  <a:pt x="448" y="939"/>
                </a:cubicBezTo>
                <a:cubicBezTo>
                  <a:pt x="445" y="940"/>
                  <a:pt x="442" y="942"/>
                  <a:pt x="439" y="944"/>
                </a:cubicBezTo>
                <a:cubicBezTo>
                  <a:pt x="435" y="946"/>
                  <a:pt x="432" y="949"/>
                  <a:pt x="429" y="952"/>
                </a:cubicBezTo>
                <a:cubicBezTo>
                  <a:pt x="425" y="956"/>
                  <a:pt x="422" y="961"/>
                  <a:pt x="420" y="966"/>
                </a:cubicBezTo>
                <a:cubicBezTo>
                  <a:pt x="418" y="971"/>
                  <a:pt x="416" y="977"/>
                  <a:pt x="416" y="985"/>
                </a:cubicBezTo>
                <a:cubicBezTo>
                  <a:pt x="415" y="993"/>
                  <a:pt x="416" y="1001"/>
                  <a:pt x="417" y="1012"/>
                </a:cubicBezTo>
                <a:cubicBezTo>
                  <a:pt x="419" y="1022"/>
                  <a:pt x="421" y="1034"/>
                  <a:pt x="424" y="1048"/>
                </a:cubicBezTo>
                <a:lnTo>
                  <a:pt x="560" y="1183"/>
                </a:lnTo>
                <a:cubicBezTo>
                  <a:pt x="561" y="1185"/>
                  <a:pt x="562" y="1186"/>
                  <a:pt x="562" y="1187"/>
                </a:cubicBezTo>
                <a:cubicBezTo>
                  <a:pt x="562" y="1189"/>
                  <a:pt x="562" y="1191"/>
                  <a:pt x="561" y="1193"/>
                </a:cubicBezTo>
                <a:cubicBezTo>
                  <a:pt x="560" y="1195"/>
                  <a:pt x="559" y="1197"/>
                  <a:pt x="557" y="1200"/>
                </a:cubicBezTo>
                <a:cubicBezTo>
                  <a:pt x="554" y="1202"/>
                  <a:pt x="551" y="1206"/>
                  <a:pt x="548" y="1210"/>
                </a:cubicBezTo>
                <a:cubicBezTo>
                  <a:pt x="544" y="1213"/>
                  <a:pt x="541" y="1216"/>
                  <a:pt x="538" y="1218"/>
                </a:cubicBezTo>
                <a:cubicBezTo>
                  <a:pt x="535" y="1220"/>
                  <a:pt x="533" y="1222"/>
                  <a:pt x="531" y="1223"/>
                </a:cubicBezTo>
                <a:cubicBezTo>
                  <a:pt x="529" y="1224"/>
                  <a:pt x="527" y="1224"/>
                  <a:pt x="526" y="1224"/>
                </a:cubicBezTo>
                <a:cubicBezTo>
                  <a:pt x="524" y="1223"/>
                  <a:pt x="523" y="1222"/>
                  <a:pt x="522" y="1221"/>
                </a:cubicBezTo>
                <a:lnTo>
                  <a:pt x="315" y="1015"/>
                </a:lnTo>
                <a:cubicBezTo>
                  <a:pt x="314" y="1014"/>
                  <a:pt x="313" y="1012"/>
                  <a:pt x="313" y="1011"/>
                </a:cubicBezTo>
                <a:cubicBezTo>
                  <a:pt x="313" y="1010"/>
                  <a:pt x="313" y="1008"/>
                  <a:pt x="313" y="1006"/>
                </a:cubicBezTo>
                <a:cubicBezTo>
                  <a:pt x="314" y="1004"/>
                  <a:pt x="315" y="1002"/>
                  <a:pt x="317" y="999"/>
                </a:cubicBezTo>
                <a:cubicBezTo>
                  <a:pt x="319" y="997"/>
                  <a:pt x="322" y="994"/>
                  <a:pt x="326" y="991"/>
                </a:cubicBezTo>
                <a:cubicBezTo>
                  <a:pt x="329" y="987"/>
                  <a:pt x="332" y="985"/>
                  <a:pt x="334" y="983"/>
                </a:cubicBezTo>
                <a:cubicBezTo>
                  <a:pt x="337" y="981"/>
                  <a:pt x="339" y="979"/>
                  <a:pt x="341" y="979"/>
                </a:cubicBezTo>
                <a:cubicBezTo>
                  <a:pt x="343" y="978"/>
                  <a:pt x="344" y="978"/>
                  <a:pt x="346" y="978"/>
                </a:cubicBezTo>
                <a:cubicBezTo>
                  <a:pt x="347" y="979"/>
                  <a:pt x="348" y="980"/>
                  <a:pt x="350" y="981"/>
                </a:cubicBezTo>
                <a:lnTo>
                  <a:pt x="380" y="1011"/>
                </a:lnTo>
                <a:cubicBezTo>
                  <a:pt x="377" y="997"/>
                  <a:pt x="376" y="985"/>
                  <a:pt x="375" y="975"/>
                </a:cubicBezTo>
                <a:cubicBezTo>
                  <a:pt x="375" y="965"/>
                  <a:pt x="376" y="956"/>
                  <a:pt x="377" y="948"/>
                </a:cubicBezTo>
                <a:cubicBezTo>
                  <a:pt x="379" y="941"/>
                  <a:pt x="381" y="934"/>
                  <a:pt x="384" y="929"/>
                </a:cubicBezTo>
                <a:cubicBezTo>
                  <a:pt x="387" y="923"/>
                  <a:pt x="391" y="918"/>
                  <a:pt x="396" y="914"/>
                </a:cubicBezTo>
                <a:cubicBezTo>
                  <a:pt x="398" y="912"/>
                  <a:pt x="400" y="910"/>
                  <a:pt x="403" y="908"/>
                </a:cubicBezTo>
                <a:cubicBezTo>
                  <a:pt x="406" y="905"/>
                  <a:pt x="409" y="903"/>
                  <a:pt x="412" y="901"/>
                </a:cubicBezTo>
                <a:cubicBezTo>
                  <a:pt x="415" y="899"/>
                  <a:pt x="418" y="897"/>
                  <a:pt x="421" y="896"/>
                </a:cubicBezTo>
                <a:cubicBezTo>
                  <a:pt x="424" y="894"/>
                  <a:pt x="427" y="893"/>
                  <a:pt x="428" y="893"/>
                </a:cubicBezTo>
                <a:cubicBezTo>
                  <a:pt x="430" y="893"/>
                  <a:pt x="431" y="893"/>
                  <a:pt x="432" y="894"/>
                </a:cubicBezTo>
                <a:cubicBezTo>
                  <a:pt x="433" y="894"/>
                  <a:pt x="435" y="895"/>
                  <a:pt x="436" y="895"/>
                </a:cubicBezTo>
                <a:cubicBezTo>
                  <a:pt x="437" y="896"/>
                  <a:pt x="439" y="898"/>
                  <a:pt x="441" y="900"/>
                </a:cubicBezTo>
                <a:cubicBezTo>
                  <a:pt x="443" y="902"/>
                  <a:pt x="446" y="904"/>
                  <a:pt x="450" y="908"/>
                </a:cubicBezTo>
                <a:close/>
                <a:moveTo>
                  <a:pt x="772" y="760"/>
                </a:moveTo>
                <a:cubicBezTo>
                  <a:pt x="789" y="777"/>
                  <a:pt x="802" y="794"/>
                  <a:pt x="812" y="813"/>
                </a:cubicBezTo>
                <a:cubicBezTo>
                  <a:pt x="822" y="832"/>
                  <a:pt x="827" y="850"/>
                  <a:pt x="829" y="869"/>
                </a:cubicBezTo>
                <a:cubicBezTo>
                  <a:pt x="830" y="888"/>
                  <a:pt x="827" y="907"/>
                  <a:pt x="820" y="926"/>
                </a:cubicBezTo>
                <a:cubicBezTo>
                  <a:pt x="812" y="945"/>
                  <a:pt x="800" y="963"/>
                  <a:pt x="782" y="981"/>
                </a:cubicBezTo>
                <a:cubicBezTo>
                  <a:pt x="765" y="998"/>
                  <a:pt x="748" y="1010"/>
                  <a:pt x="730" y="1018"/>
                </a:cubicBezTo>
                <a:cubicBezTo>
                  <a:pt x="713" y="1025"/>
                  <a:pt x="695" y="1028"/>
                  <a:pt x="677" y="1027"/>
                </a:cubicBezTo>
                <a:cubicBezTo>
                  <a:pt x="659" y="1026"/>
                  <a:pt x="641" y="1021"/>
                  <a:pt x="623" y="1011"/>
                </a:cubicBezTo>
                <a:cubicBezTo>
                  <a:pt x="605" y="1001"/>
                  <a:pt x="587" y="988"/>
                  <a:pt x="570" y="970"/>
                </a:cubicBezTo>
                <a:cubicBezTo>
                  <a:pt x="553" y="954"/>
                  <a:pt x="540" y="936"/>
                  <a:pt x="530" y="917"/>
                </a:cubicBezTo>
                <a:cubicBezTo>
                  <a:pt x="520" y="899"/>
                  <a:pt x="515" y="880"/>
                  <a:pt x="513" y="861"/>
                </a:cubicBezTo>
                <a:cubicBezTo>
                  <a:pt x="512" y="842"/>
                  <a:pt x="515" y="823"/>
                  <a:pt x="522" y="804"/>
                </a:cubicBezTo>
                <a:cubicBezTo>
                  <a:pt x="530" y="786"/>
                  <a:pt x="542" y="767"/>
                  <a:pt x="560" y="750"/>
                </a:cubicBezTo>
                <a:cubicBezTo>
                  <a:pt x="577" y="733"/>
                  <a:pt x="594" y="721"/>
                  <a:pt x="612" y="713"/>
                </a:cubicBezTo>
                <a:cubicBezTo>
                  <a:pt x="630" y="705"/>
                  <a:pt x="647" y="702"/>
                  <a:pt x="665" y="703"/>
                </a:cubicBezTo>
                <a:cubicBezTo>
                  <a:pt x="683" y="705"/>
                  <a:pt x="701" y="710"/>
                  <a:pt x="719" y="720"/>
                </a:cubicBezTo>
                <a:cubicBezTo>
                  <a:pt x="737" y="729"/>
                  <a:pt x="755" y="743"/>
                  <a:pt x="772" y="760"/>
                </a:cubicBezTo>
                <a:close/>
                <a:moveTo>
                  <a:pt x="736" y="802"/>
                </a:moveTo>
                <a:cubicBezTo>
                  <a:pt x="724" y="790"/>
                  <a:pt x="713" y="781"/>
                  <a:pt x="701" y="773"/>
                </a:cubicBezTo>
                <a:cubicBezTo>
                  <a:pt x="689" y="765"/>
                  <a:pt x="677" y="760"/>
                  <a:pt x="664" y="757"/>
                </a:cubicBezTo>
                <a:cubicBezTo>
                  <a:pt x="652" y="755"/>
                  <a:pt x="640" y="755"/>
                  <a:pt x="627" y="759"/>
                </a:cubicBezTo>
                <a:cubicBezTo>
                  <a:pt x="615" y="763"/>
                  <a:pt x="602" y="771"/>
                  <a:pt x="590" y="783"/>
                </a:cubicBezTo>
                <a:cubicBezTo>
                  <a:pt x="579" y="794"/>
                  <a:pt x="571" y="806"/>
                  <a:pt x="567" y="818"/>
                </a:cubicBezTo>
                <a:cubicBezTo>
                  <a:pt x="563" y="830"/>
                  <a:pt x="562" y="842"/>
                  <a:pt x="564" y="855"/>
                </a:cubicBezTo>
                <a:cubicBezTo>
                  <a:pt x="566" y="867"/>
                  <a:pt x="571" y="880"/>
                  <a:pt x="578" y="892"/>
                </a:cubicBezTo>
                <a:cubicBezTo>
                  <a:pt x="585" y="905"/>
                  <a:pt x="595" y="917"/>
                  <a:pt x="607" y="929"/>
                </a:cubicBezTo>
                <a:cubicBezTo>
                  <a:pt x="618" y="940"/>
                  <a:pt x="630" y="949"/>
                  <a:pt x="642" y="957"/>
                </a:cubicBezTo>
                <a:cubicBezTo>
                  <a:pt x="654" y="965"/>
                  <a:pt x="666" y="970"/>
                  <a:pt x="678" y="973"/>
                </a:cubicBezTo>
                <a:cubicBezTo>
                  <a:pt x="690" y="976"/>
                  <a:pt x="703" y="975"/>
                  <a:pt x="715" y="971"/>
                </a:cubicBezTo>
                <a:cubicBezTo>
                  <a:pt x="728" y="967"/>
                  <a:pt x="740" y="959"/>
                  <a:pt x="752" y="947"/>
                </a:cubicBezTo>
                <a:cubicBezTo>
                  <a:pt x="764" y="936"/>
                  <a:pt x="771" y="924"/>
                  <a:pt x="775" y="912"/>
                </a:cubicBezTo>
                <a:cubicBezTo>
                  <a:pt x="780" y="900"/>
                  <a:pt x="781" y="888"/>
                  <a:pt x="779" y="875"/>
                </a:cubicBezTo>
                <a:cubicBezTo>
                  <a:pt x="777" y="863"/>
                  <a:pt x="772" y="850"/>
                  <a:pt x="765" y="838"/>
                </a:cubicBezTo>
                <a:cubicBezTo>
                  <a:pt x="757" y="826"/>
                  <a:pt x="747" y="814"/>
                  <a:pt x="736" y="802"/>
                </a:cubicBezTo>
                <a:close/>
                <a:moveTo>
                  <a:pt x="973" y="770"/>
                </a:moveTo>
                <a:cubicBezTo>
                  <a:pt x="974" y="772"/>
                  <a:pt x="974" y="773"/>
                  <a:pt x="975" y="774"/>
                </a:cubicBezTo>
                <a:cubicBezTo>
                  <a:pt x="975" y="776"/>
                  <a:pt x="975" y="778"/>
                  <a:pt x="974" y="780"/>
                </a:cubicBezTo>
                <a:cubicBezTo>
                  <a:pt x="973" y="782"/>
                  <a:pt x="972" y="784"/>
                  <a:pt x="970" y="787"/>
                </a:cubicBezTo>
                <a:cubicBezTo>
                  <a:pt x="967" y="790"/>
                  <a:pt x="964" y="793"/>
                  <a:pt x="961" y="797"/>
                </a:cubicBezTo>
                <a:cubicBezTo>
                  <a:pt x="957" y="800"/>
                  <a:pt x="954" y="803"/>
                  <a:pt x="951" y="805"/>
                </a:cubicBezTo>
                <a:cubicBezTo>
                  <a:pt x="948" y="807"/>
                  <a:pt x="946" y="809"/>
                  <a:pt x="944" y="810"/>
                </a:cubicBezTo>
                <a:cubicBezTo>
                  <a:pt x="942" y="811"/>
                  <a:pt x="940" y="811"/>
                  <a:pt x="939" y="811"/>
                </a:cubicBezTo>
                <a:cubicBezTo>
                  <a:pt x="937" y="810"/>
                  <a:pt x="936" y="810"/>
                  <a:pt x="935" y="808"/>
                </a:cubicBezTo>
                <a:lnTo>
                  <a:pt x="628" y="502"/>
                </a:lnTo>
                <a:cubicBezTo>
                  <a:pt x="627" y="501"/>
                  <a:pt x="626" y="499"/>
                  <a:pt x="626" y="498"/>
                </a:cubicBezTo>
                <a:cubicBezTo>
                  <a:pt x="626" y="497"/>
                  <a:pt x="626" y="495"/>
                  <a:pt x="627" y="493"/>
                </a:cubicBezTo>
                <a:cubicBezTo>
                  <a:pt x="628" y="491"/>
                  <a:pt x="629" y="488"/>
                  <a:pt x="631" y="486"/>
                </a:cubicBezTo>
                <a:cubicBezTo>
                  <a:pt x="633" y="483"/>
                  <a:pt x="636" y="480"/>
                  <a:pt x="640" y="476"/>
                </a:cubicBezTo>
                <a:cubicBezTo>
                  <a:pt x="644" y="472"/>
                  <a:pt x="647" y="469"/>
                  <a:pt x="650" y="467"/>
                </a:cubicBezTo>
                <a:cubicBezTo>
                  <a:pt x="652" y="465"/>
                  <a:pt x="655" y="463"/>
                  <a:pt x="657" y="463"/>
                </a:cubicBezTo>
                <a:cubicBezTo>
                  <a:pt x="659" y="462"/>
                  <a:pt x="661" y="462"/>
                  <a:pt x="662" y="462"/>
                </a:cubicBezTo>
                <a:cubicBezTo>
                  <a:pt x="664" y="462"/>
                  <a:pt x="665" y="463"/>
                  <a:pt x="666" y="464"/>
                </a:cubicBezTo>
                <a:lnTo>
                  <a:pt x="973" y="770"/>
                </a:lnTo>
                <a:close/>
                <a:moveTo>
                  <a:pt x="1080" y="663"/>
                </a:moveTo>
                <a:cubicBezTo>
                  <a:pt x="1081" y="664"/>
                  <a:pt x="1082" y="666"/>
                  <a:pt x="1082" y="667"/>
                </a:cubicBezTo>
                <a:cubicBezTo>
                  <a:pt x="1082" y="668"/>
                  <a:pt x="1082" y="670"/>
                  <a:pt x="1081" y="672"/>
                </a:cubicBezTo>
                <a:cubicBezTo>
                  <a:pt x="1081" y="674"/>
                  <a:pt x="1079" y="677"/>
                  <a:pt x="1077" y="679"/>
                </a:cubicBezTo>
                <a:cubicBezTo>
                  <a:pt x="1075" y="682"/>
                  <a:pt x="1072" y="685"/>
                  <a:pt x="1068" y="689"/>
                </a:cubicBezTo>
                <a:cubicBezTo>
                  <a:pt x="1064" y="693"/>
                  <a:pt x="1061" y="696"/>
                  <a:pt x="1058" y="698"/>
                </a:cubicBezTo>
                <a:cubicBezTo>
                  <a:pt x="1056" y="700"/>
                  <a:pt x="1053" y="701"/>
                  <a:pt x="1051" y="702"/>
                </a:cubicBezTo>
                <a:cubicBezTo>
                  <a:pt x="1049" y="703"/>
                  <a:pt x="1047" y="703"/>
                  <a:pt x="1046" y="703"/>
                </a:cubicBezTo>
                <a:cubicBezTo>
                  <a:pt x="1045" y="703"/>
                  <a:pt x="1043" y="702"/>
                  <a:pt x="1042" y="701"/>
                </a:cubicBezTo>
                <a:lnTo>
                  <a:pt x="836" y="494"/>
                </a:lnTo>
                <a:cubicBezTo>
                  <a:pt x="835" y="493"/>
                  <a:pt x="834" y="492"/>
                  <a:pt x="834" y="491"/>
                </a:cubicBezTo>
                <a:cubicBezTo>
                  <a:pt x="833" y="489"/>
                  <a:pt x="834" y="488"/>
                  <a:pt x="834" y="485"/>
                </a:cubicBezTo>
                <a:cubicBezTo>
                  <a:pt x="835" y="483"/>
                  <a:pt x="837" y="481"/>
                  <a:pt x="839" y="478"/>
                </a:cubicBezTo>
                <a:cubicBezTo>
                  <a:pt x="841" y="475"/>
                  <a:pt x="844" y="472"/>
                  <a:pt x="848" y="469"/>
                </a:cubicBezTo>
                <a:cubicBezTo>
                  <a:pt x="851" y="465"/>
                  <a:pt x="855" y="462"/>
                  <a:pt x="857" y="460"/>
                </a:cubicBezTo>
                <a:cubicBezTo>
                  <a:pt x="860" y="458"/>
                  <a:pt x="863" y="456"/>
                  <a:pt x="865" y="455"/>
                </a:cubicBezTo>
                <a:cubicBezTo>
                  <a:pt x="867" y="455"/>
                  <a:pt x="868" y="454"/>
                  <a:pt x="870" y="455"/>
                </a:cubicBezTo>
                <a:cubicBezTo>
                  <a:pt x="871" y="455"/>
                  <a:pt x="873" y="456"/>
                  <a:pt x="874" y="457"/>
                </a:cubicBezTo>
                <a:lnTo>
                  <a:pt x="1080" y="663"/>
                </a:lnTo>
                <a:close/>
                <a:moveTo>
                  <a:pt x="808" y="383"/>
                </a:moveTo>
                <a:cubicBezTo>
                  <a:pt x="817" y="391"/>
                  <a:pt x="822" y="399"/>
                  <a:pt x="821" y="406"/>
                </a:cubicBezTo>
                <a:cubicBezTo>
                  <a:pt x="821" y="412"/>
                  <a:pt x="817" y="420"/>
                  <a:pt x="808" y="429"/>
                </a:cubicBezTo>
                <a:cubicBezTo>
                  <a:pt x="799" y="438"/>
                  <a:pt x="791" y="443"/>
                  <a:pt x="785" y="443"/>
                </a:cubicBezTo>
                <a:cubicBezTo>
                  <a:pt x="778" y="443"/>
                  <a:pt x="771" y="439"/>
                  <a:pt x="762" y="430"/>
                </a:cubicBezTo>
                <a:cubicBezTo>
                  <a:pt x="753" y="421"/>
                  <a:pt x="749" y="413"/>
                  <a:pt x="749" y="407"/>
                </a:cubicBezTo>
                <a:cubicBezTo>
                  <a:pt x="749" y="400"/>
                  <a:pt x="754" y="392"/>
                  <a:pt x="763" y="383"/>
                </a:cubicBezTo>
                <a:cubicBezTo>
                  <a:pt x="772" y="374"/>
                  <a:pt x="779" y="370"/>
                  <a:pt x="786" y="370"/>
                </a:cubicBezTo>
                <a:cubicBezTo>
                  <a:pt x="792" y="370"/>
                  <a:pt x="800" y="374"/>
                  <a:pt x="808" y="383"/>
                </a:cubicBezTo>
                <a:close/>
                <a:moveTo>
                  <a:pt x="1327" y="416"/>
                </a:moveTo>
                <a:cubicBezTo>
                  <a:pt x="1329" y="417"/>
                  <a:pt x="1329" y="418"/>
                  <a:pt x="1330" y="420"/>
                </a:cubicBezTo>
                <a:cubicBezTo>
                  <a:pt x="1330" y="421"/>
                  <a:pt x="1329" y="423"/>
                  <a:pt x="1329" y="425"/>
                </a:cubicBezTo>
                <a:cubicBezTo>
                  <a:pt x="1328" y="427"/>
                  <a:pt x="1327" y="429"/>
                  <a:pt x="1324" y="432"/>
                </a:cubicBezTo>
                <a:cubicBezTo>
                  <a:pt x="1322" y="435"/>
                  <a:pt x="1319" y="438"/>
                  <a:pt x="1316" y="442"/>
                </a:cubicBezTo>
                <a:cubicBezTo>
                  <a:pt x="1312" y="445"/>
                  <a:pt x="1309" y="448"/>
                  <a:pt x="1306" y="451"/>
                </a:cubicBezTo>
                <a:cubicBezTo>
                  <a:pt x="1303" y="453"/>
                  <a:pt x="1301" y="454"/>
                  <a:pt x="1299" y="455"/>
                </a:cubicBezTo>
                <a:cubicBezTo>
                  <a:pt x="1297" y="456"/>
                  <a:pt x="1295" y="456"/>
                  <a:pt x="1294" y="456"/>
                </a:cubicBezTo>
                <a:cubicBezTo>
                  <a:pt x="1292" y="455"/>
                  <a:pt x="1291" y="455"/>
                  <a:pt x="1290" y="453"/>
                </a:cubicBezTo>
                <a:lnTo>
                  <a:pt x="1169" y="333"/>
                </a:lnTo>
                <a:cubicBezTo>
                  <a:pt x="1157" y="321"/>
                  <a:pt x="1147" y="312"/>
                  <a:pt x="1138" y="307"/>
                </a:cubicBezTo>
                <a:cubicBezTo>
                  <a:pt x="1129" y="302"/>
                  <a:pt x="1120" y="298"/>
                  <a:pt x="1111" y="296"/>
                </a:cubicBezTo>
                <a:cubicBezTo>
                  <a:pt x="1102" y="295"/>
                  <a:pt x="1094" y="295"/>
                  <a:pt x="1085" y="298"/>
                </a:cubicBezTo>
                <a:cubicBezTo>
                  <a:pt x="1077" y="301"/>
                  <a:pt x="1069" y="306"/>
                  <a:pt x="1062" y="313"/>
                </a:cubicBezTo>
                <a:cubicBezTo>
                  <a:pt x="1052" y="323"/>
                  <a:pt x="1046" y="336"/>
                  <a:pt x="1044" y="352"/>
                </a:cubicBezTo>
                <a:cubicBezTo>
                  <a:pt x="1041" y="368"/>
                  <a:pt x="1041" y="388"/>
                  <a:pt x="1043" y="411"/>
                </a:cubicBezTo>
                <a:lnTo>
                  <a:pt x="1188" y="556"/>
                </a:lnTo>
                <a:cubicBezTo>
                  <a:pt x="1189" y="557"/>
                  <a:pt x="1189" y="558"/>
                  <a:pt x="1190" y="560"/>
                </a:cubicBezTo>
                <a:cubicBezTo>
                  <a:pt x="1190" y="561"/>
                  <a:pt x="1190" y="563"/>
                  <a:pt x="1189" y="565"/>
                </a:cubicBezTo>
                <a:cubicBezTo>
                  <a:pt x="1188" y="567"/>
                  <a:pt x="1187" y="569"/>
                  <a:pt x="1185" y="572"/>
                </a:cubicBezTo>
                <a:cubicBezTo>
                  <a:pt x="1182" y="575"/>
                  <a:pt x="1179" y="578"/>
                  <a:pt x="1176" y="582"/>
                </a:cubicBezTo>
                <a:cubicBezTo>
                  <a:pt x="1172" y="585"/>
                  <a:pt x="1169" y="588"/>
                  <a:pt x="1166" y="590"/>
                </a:cubicBezTo>
                <a:cubicBezTo>
                  <a:pt x="1163" y="593"/>
                  <a:pt x="1161" y="594"/>
                  <a:pt x="1159" y="595"/>
                </a:cubicBezTo>
                <a:cubicBezTo>
                  <a:pt x="1157" y="596"/>
                  <a:pt x="1155" y="596"/>
                  <a:pt x="1154" y="596"/>
                </a:cubicBezTo>
                <a:cubicBezTo>
                  <a:pt x="1152" y="595"/>
                  <a:pt x="1151" y="595"/>
                  <a:pt x="1150" y="593"/>
                </a:cubicBezTo>
                <a:lnTo>
                  <a:pt x="943" y="387"/>
                </a:lnTo>
                <a:cubicBezTo>
                  <a:pt x="942" y="386"/>
                  <a:pt x="941" y="385"/>
                  <a:pt x="941" y="383"/>
                </a:cubicBezTo>
                <a:cubicBezTo>
                  <a:pt x="941" y="382"/>
                  <a:pt x="941" y="380"/>
                  <a:pt x="941" y="378"/>
                </a:cubicBezTo>
                <a:cubicBezTo>
                  <a:pt x="942" y="376"/>
                  <a:pt x="943" y="374"/>
                  <a:pt x="945" y="372"/>
                </a:cubicBezTo>
                <a:cubicBezTo>
                  <a:pt x="947" y="369"/>
                  <a:pt x="950" y="366"/>
                  <a:pt x="953" y="363"/>
                </a:cubicBezTo>
                <a:cubicBezTo>
                  <a:pt x="957" y="359"/>
                  <a:pt x="960" y="357"/>
                  <a:pt x="962" y="355"/>
                </a:cubicBezTo>
                <a:cubicBezTo>
                  <a:pt x="965" y="353"/>
                  <a:pt x="967" y="351"/>
                  <a:pt x="969" y="351"/>
                </a:cubicBezTo>
                <a:cubicBezTo>
                  <a:pt x="971" y="350"/>
                  <a:pt x="972" y="350"/>
                  <a:pt x="974" y="351"/>
                </a:cubicBezTo>
                <a:cubicBezTo>
                  <a:pt x="975" y="351"/>
                  <a:pt x="976" y="352"/>
                  <a:pt x="978" y="353"/>
                </a:cubicBezTo>
                <a:lnTo>
                  <a:pt x="1005" y="380"/>
                </a:lnTo>
                <a:cubicBezTo>
                  <a:pt x="1003" y="356"/>
                  <a:pt x="1005" y="334"/>
                  <a:pt x="1011" y="317"/>
                </a:cubicBezTo>
                <a:cubicBezTo>
                  <a:pt x="1016" y="299"/>
                  <a:pt x="1025" y="285"/>
                  <a:pt x="1037" y="273"/>
                </a:cubicBezTo>
                <a:cubicBezTo>
                  <a:pt x="1051" y="259"/>
                  <a:pt x="1065" y="250"/>
                  <a:pt x="1079" y="245"/>
                </a:cubicBezTo>
                <a:cubicBezTo>
                  <a:pt x="1093" y="240"/>
                  <a:pt x="1106" y="239"/>
                  <a:pt x="1120" y="241"/>
                </a:cubicBezTo>
                <a:cubicBezTo>
                  <a:pt x="1134" y="243"/>
                  <a:pt x="1147" y="248"/>
                  <a:pt x="1160" y="256"/>
                </a:cubicBezTo>
                <a:cubicBezTo>
                  <a:pt x="1173" y="264"/>
                  <a:pt x="1187" y="275"/>
                  <a:pt x="1201" y="290"/>
                </a:cubicBezTo>
                <a:lnTo>
                  <a:pt x="1327" y="416"/>
                </a:lnTo>
                <a:close/>
                <a:moveTo>
                  <a:pt x="1463" y="56"/>
                </a:moveTo>
                <a:cubicBezTo>
                  <a:pt x="1468" y="62"/>
                  <a:pt x="1471" y="68"/>
                  <a:pt x="1471" y="73"/>
                </a:cubicBezTo>
                <a:cubicBezTo>
                  <a:pt x="1470" y="79"/>
                  <a:pt x="1468" y="84"/>
                  <a:pt x="1464" y="88"/>
                </a:cubicBezTo>
                <a:lnTo>
                  <a:pt x="1328" y="223"/>
                </a:lnTo>
                <a:cubicBezTo>
                  <a:pt x="1340" y="235"/>
                  <a:pt x="1351" y="244"/>
                  <a:pt x="1363" y="251"/>
                </a:cubicBezTo>
                <a:cubicBezTo>
                  <a:pt x="1374" y="258"/>
                  <a:pt x="1386" y="262"/>
                  <a:pt x="1398" y="263"/>
                </a:cubicBezTo>
                <a:cubicBezTo>
                  <a:pt x="1410" y="264"/>
                  <a:pt x="1422" y="262"/>
                  <a:pt x="1434" y="257"/>
                </a:cubicBezTo>
                <a:cubicBezTo>
                  <a:pt x="1446" y="252"/>
                  <a:pt x="1458" y="243"/>
                  <a:pt x="1471" y="231"/>
                </a:cubicBezTo>
                <a:cubicBezTo>
                  <a:pt x="1481" y="221"/>
                  <a:pt x="1489" y="211"/>
                  <a:pt x="1495" y="202"/>
                </a:cubicBezTo>
                <a:cubicBezTo>
                  <a:pt x="1501" y="193"/>
                  <a:pt x="1506" y="184"/>
                  <a:pt x="1509" y="177"/>
                </a:cubicBezTo>
                <a:cubicBezTo>
                  <a:pt x="1513" y="169"/>
                  <a:pt x="1516" y="163"/>
                  <a:pt x="1518" y="158"/>
                </a:cubicBezTo>
                <a:cubicBezTo>
                  <a:pt x="1520" y="152"/>
                  <a:pt x="1522" y="149"/>
                  <a:pt x="1523" y="147"/>
                </a:cubicBezTo>
                <a:cubicBezTo>
                  <a:pt x="1525" y="146"/>
                  <a:pt x="1526" y="145"/>
                  <a:pt x="1527" y="145"/>
                </a:cubicBezTo>
                <a:cubicBezTo>
                  <a:pt x="1529" y="145"/>
                  <a:pt x="1530" y="145"/>
                  <a:pt x="1532" y="145"/>
                </a:cubicBezTo>
                <a:cubicBezTo>
                  <a:pt x="1533" y="146"/>
                  <a:pt x="1535" y="147"/>
                  <a:pt x="1537" y="149"/>
                </a:cubicBezTo>
                <a:cubicBezTo>
                  <a:pt x="1539" y="151"/>
                  <a:pt x="1542" y="153"/>
                  <a:pt x="1544" y="156"/>
                </a:cubicBezTo>
                <a:cubicBezTo>
                  <a:pt x="1546" y="158"/>
                  <a:pt x="1548" y="159"/>
                  <a:pt x="1549" y="161"/>
                </a:cubicBezTo>
                <a:cubicBezTo>
                  <a:pt x="1551" y="163"/>
                  <a:pt x="1552" y="164"/>
                  <a:pt x="1553" y="165"/>
                </a:cubicBezTo>
                <a:cubicBezTo>
                  <a:pt x="1554" y="167"/>
                  <a:pt x="1554" y="168"/>
                  <a:pt x="1555" y="170"/>
                </a:cubicBezTo>
                <a:cubicBezTo>
                  <a:pt x="1555" y="171"/>
                  <a:pt x="1555" y="173"/>
                  <a:pt x="1555" y="174"/>
                </a:cubicBezTo>
                <a:cubicBezTo>
                  <a:pt x="1555" y="176"/>
                  <a:pt x="1554" y="180"/>
                  <a:pt x="1552" y="186"/>
                </a:cubicBezTo>
                <a:cubicBezTo>
                  <a:pt x="1550" y="192"/>
                  <a:pt x="1546" y="199"/>
                  <a:pt x="1541" y="208"/>
                </a:cubicBezTo>
                <a:cubicBezTo>
                  <a:pt x="1537" y="216"/>
                  <a:pt x="1531" y="225"/>
                  <a:pt x="1524" y="235"/>
                </a:cubicBezTo>
                <a:cubicBezTo>
                  <a:pt x="1516" y="245"/>
                  <a:pt x="1508" y="255"/>
                  <a:pt x="1498" y="265"/>
                </a:cubicBezTo>
                <a:cubicBezTo>
                  <a:pt x="1481" y="282"/>
                  <a:pt x="1464" y="295"/>
                  <a:pt x="1446" y="303"/>
                </a:cubicBezTo>
                <a:cubicBezTo>
                  <a:pt x="1429" y="311"/>
                  <a:pt x="1411" y="314"/>
                  <a:pt x="1393" y="314"/>
                </a:cubicBezTo>
                <a:cubicBezTo>
                  <a:pt x="1375" y="313"/>
                  <a:pt x="1357" y="308"/>
                  <a:pt x="1338" y="298"/>
                </a:cubicBezTo>
                <a:cubicBezTo>
                  <a:pt x="1320" y="289"/>
                  <a:pt x="1301" y="275"/>
                  <a:pt x="1283" y="256"/>
                </a:cubicBezTo>
                <a:cubicBezTo>
                  <a:pt x="1265" y="238"/>
                  <a:pt x="1251" y="220"/>
                  <a:pt x="1242" y="201"/>
                </a:cubicBezTo>
                <a:cubicBezTo>
                  <a:pt x="1232" y="183"/>
                  <a:pt x="1227" y="164"/>
                  <a:pt x="1225" y="145"/>
                </a:cubicBezTo>
                <a:cubicBezTo>
                  <a:pt x="1224" y="127"/>
                  <a:pt x="1227" y="109"/>
                  <a:pt x="1234" y="91"/>
                </a:cubicBezTo>
                <a:cubicBezTo>
                  <a:pt x="1241" y="74"/>
                  <a:pt x="1252" y="58"/>
                  <a:pt x="1267" y="43"/>
                </a:cubicBezTo>
                <a:cubicBezTo>
                  <a:pt x="1283" y="26"/>
                  <a:pt x="1300" y="15"/>
                  <a:pt x="1316" y="9"/>
                </a:cubicBezTo>
                <a:cubicBezTo>
                  <a:pt x="1333" y="3"/>
                  <a:pt x="1349" y="0"/>
                  <a:pt x="1365" y="2"/>
                </a:cubicBezTo>
                <a:cubicBezTo>
                  <a:pt x="1382" y="3"/>
                  <a:pt x="1397" y="8"/>
                  <a:pt x="1413" y="17"/>
                </a:cubicBezTo>
                <a:cubicBezTo>
                  <a:pt x="1428" y="25"/>
                  <a:pt x="1442" y="36"/>
                  <a:pt x="1456" y="49"/>
                </a:cubicBezTo>
                <a:lnTo>
                  <a:pt x="1463" y="56"/>
                </a:lnTo>
                <a:close/>
                <a:moveTo>
                  <a:pt x="1413" y="83"/>
                </a:moveTo>
                <a:cubicBezTo>
                  <a:pt x="1394" y="63"/>
                  <a:pt x="1374" y="52"/>
                  <a:pt x="1353" y="50"/>
                </a:cubicBezTo>
                <a:cubicBezTo>
                  <a:pt x="1333" y="48"/>
                  <a:pt x="1313" y="56"/>
                  <a:pt x="1295" y="74"/>
                </a:cubicBezTo>
                <a:cubicBezTo>
                  <a:pt x="1285" y="83"/>
                  <a:pt x="1279" y="93"/>
                  <a:pt x="1275" y="104"/>
                </a:cubicBezTo>
                <a:cubicBezTo>
                  <a:pt x="1272" y="115"/>
                  <a:pt x="1271" y="125"/>
                  <a:pt x="1272" y="136"/>
                </a:cubicBezTo>
                <a:cubicBezTo>
                  <a:pt x="1273" y="146"/>
                  <a:pt x="1276" y="157"/>
                  <a:pt x="1281" y="167"/>
                </a:cubicBezTo>
                <a:cubicBezTo>
                  <a:pt x="1286" y="177"/>
                  <a:pt x="1293" y="187"/>
                  <a:pt x="1301" y="196"/>
                </a:cubicBezTo>
                <a:lnTo>
                  <a:pt x="1413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81" name="Freeform 265"/>
          <p:cNvSpPr>
            <a:spLocks noEditPoints="1"/>
          </p:cNvSpPr>
          <p:nvPr/>
        </p:nvSpPr>
        <p:spPr bwMode="auto">
          <a:xfrm>
            <a:off x="5462963" y="4418880"/>
            <a:ext cx="297030" cy="320675"/>
          </a:xfrm>
          <a:custGeom>
            <a:avLst/>
            <a:gdLst>
              <a:gd name="T0" fmla="*/ 243 w 1871"/>
              <a:gd name="T1" fmla="*/ 1301 h 1684"/>
              <a:gd name="T2" fmla="*/ 413 w 1871"/>
              <a:gd name="T3" fmla="*/ 1659 h 1684"/>
              <a:gd name="T4" fmla="*/ 377 w 1871"/>
              <a:gd name="T5" fmla="*/ 1681 h 1684"/>
              <a:gd name="T6" fmla="*/ 20 w 1871"/>
              <a:gd name="T7" fmla="*/ 1506 h 1684"/>
              <a:gd name="T8" fmla="*/ 3 w 1871"/>
              <a:gd name="T9" fmla="*/ 1474 h 1684"/>
              <a:gd name="T10" fmla="*/ 234 w 1871"/>
              <a:gd name="T11" fmla="*/ 1277 h 1684"/>
              <a:gd name="T12" fmla="*/ 671 w 1871"/>
              <a:gd name="T13" fmla="*/ 1565 h 1684"/>
              <a:gd name="T14" fmla="*/ 603 w 1871"/>
              <a:gd name="T15" fmla="*/ 1461 h 1684"/>
              <a:gd name="T16" fmla="*/ 317 w 1871"/>
              <a:gd name="T17" fmla="*/ 1316 h 1684"/>
              <a:gd name="T18" fmla="*/ 359 w 1871"/>
              <a:gd name="T19" fmla="*/ 1291 h 1684"/>
              <a:gd name="T20" fmla="*/ 476 w 1871"/>
              <a:gd name="T21" fmla="*/ 1157 h 1684"/>
              <a:gd name="T22" fmla="*/ 518 w 1871"/>
              <a:gd name="T23" fmla="*/ 1142 h 1684"/>
              <a:gd name="T24" fmla="*/ 701 w 1871"/>
              <a:gd name="T25" fmla="*/ 1006 h 1684"/>
              <a:gd name="T26" fmla="*/ 666 w 1871"/>
              <a:gd name="T27" fmla="*/ 1031 h 1684"/>
              <a:gd name="T28" fmla="*/ 797 w 1871"/>
              <a:gd name="T29" fmla="*/ 1262 h 1684"/>
              <a:gd name="T30" fmla="*/ 775 w 1871"/>
              <a:gd name="T31" fmla="*/ 1297 h 1684"/>
              <a:gd name="T32" fmla="*/ 550 w 1871"/>
              <a:gd name="T33" fmla="*/ 1090 h 1684"/>
              <a:gd name="T34" fmla="*/ 578 w 1871"/>
              <a:gd name="T35" fmla="*/ 1058 h 1684"/>
              <a:gd name="T36" fmla="*/ 614 w 1871"/>
              <a:gd name="T37" fmla="*/ 1027 h 1684"/>
              <a:gd name="T38" fmla="*/ 658 w 1871"/>
              <a:gd name="T39" fmla="*/ 974 h 1684"/>
              <a:gd name="T40" fmla="*/ 687 w 1871"/>
              <a:gd name="T41" fmla="*/ 987 h 1684"/>
              <a:gd name="T42" fmla="*/ 1019 w 1871"/>
              <a:gd name="T43" fmla="*/ 1060 h 1684"/>
              <a:gd name="T44" fmla="*/ 767 w 1871"/>
              <a:gd name="T45" fmla="*/ 996 h 1684"/>
              <a:gd name="T46" fmla="*/ 902 w 1871"/>
              <a:gd name="T47" fmla="*/ 782 h 1684"/>
              <a:gd name="T48" fmla="*/ 901 w 1871"/>
              <a:gd name="T49" fmla="*/ 836 h 1684"/>
              <a:gd name="T50" fmla="*/ 815 w 1871"/>
              <a:gd name="T51" fmla="*/ 971 h 1684"/>
              <a:gd name="T52" fmla="*/ 989 w 1871"/>
              <a:gd name="T53" fmla="*/ 1026 h 1684"/>
              <a:gd name="T54" fmla="*/ 1245 w 1871"/>
              <a:gd name="T55" fmla="*/ 701 h 1684"/>
              <a:gd name="T56" fmla="*/ 1208 w 1871"/>
              <a:gd name="T57" fmla="*/ 868 h 1684"/>
              <a:gd name="T58" fmla="*/ 1131 w 1871"/>
              <a:gd name="T59" fmla="*/ 879 h 1684"/>
              <a:gd name="T60" fmla="*/ 1132 w 1871"/>
              <a:gd name="T61" fmla="*/ 853 h 1684"/>
              <a:gd name="T62" fmla="*/ 1224 w 1871"/>
              <a:gd name="T63" fmla="*/ 779 h 1684"/>
              <a:gd name="T64" fmla="*/ 1145 w 1871"/>
              <a:gd name="T65" fmla="*/ 741 h 1684"/>
              <a:gd name="T66" fmla="*/ 1005 w 1871"/>
              <a:gd name="T67" fmla="*/ 743 h 1684"/>
              <a:gd name="T68" fmla="*/ 1037 w 1871"/>
              <a:gd name="T69" fmla="*/ 592 h 1684"/>
              <a:gd name="T70" fmla="*/ 1093 w 1871"/>
              <a:gd name="T71" fmla="*/ 572 h 1684"/>
              <a:gd name="T72" fmla="*/ 1115 w 1871"/>
              <a:gd name="T73" fmla="*/ 599 h 1684"/>
              <a:gd name="T74" fmla="*/ 1048 w 1871"/>
              <a:gd name="T75" fmla="*/ 637 h 1684"/>
              <a:gd name="T76" fmla="*/ 1059 w 1871"/>
              <a:gd name="T77" fmla="*/ 715 h 1684"/>
              <a:gd name="T78" fmla="*/ 1189 w 1871"/>
              <a:gd name="T79" fmla="*/ 678 h 1684"/>
              <a:gd name="T80" fmla="*/ 1398 w 1871"/>
              <a:gd name="T81" fmla="*/ 672 h 1684"/>
              <a:gd name="T82" fmla="*/ 1362 w 1871"/>
              <a:gd name="T83" fmla="*/ 703 h 1684"/>
              <a:gd name="T84" fmla="*/ 1155 w 1871"/>
              <a:gd name="T85" fmla="*/ 478 h 1684"/>
              <a:gd name="T86" fmla="*/ 1190 w 1871"/>
              <a:gd name="T87" fmla="*/ 456 h 1684"/>
              <a:gd name="T88" fmla="*/ 1101 w 1871"/>
              <a:gd name="T89" fmla="*/ 442 h 1684"/>
              <a:gd name="T90" fmla="*/ 1125 w 1871"/>
              <a:gd name="T91" fmla="*/ 382 h 1684"/>
              <a:gd name="T92" fmla="*/ 1632 w 1871"/>
              <a:gd name="T93" fmla="*/ 441 h 1684"/>
              <a:gd name="T94" fmla="*/ 1485 w 1871"/>
              <a:gd name="T95" fmla="*/ 332 h 1684"/>
              <a:gd name="T96" fmla="*/ 1360 w 1871"/>
              <a:gd name="T97" fmla="*/ 352 h 1684"/>
              <a:gd name="T98" fmla="*/ 1501 w 1871"/>
              <a:gd name="T99" fmla="*/ 571 h 1684"/>
              <a:gd name="T100" fmla="*/ 1466 w 1871"/>
              <a:gd name="T101" fmla="*/ 593 h 1684"/>
              <a:gd name="T102" fmla="*/ 1270 w 1871"/>
              <a:gd name="T103" fmla="*/ 362 h 1684"/>
              <a:gd name="T104" fmla="*/ 1321 w 1871"/>
              <a:gd name="T105" fmla="*/ 380 h 1684"/>
              <a:gd name="T106" fmla="*/ 1476 w 1871"/>
              <a:gd name="T107" fmla="*/ 255 h 1684"/>
              <a:gd name="T108" fmla="*/ 1780 w 1871"/>
              <a:gd name="T109" fmla="*/ 87 h 1684"/>
              <a:gd name="T110" fmla="*/ 1787 w 1871"/>
              <a:gd name="T111" fmla="*/ 230 h 1684"/>
              <a:gd name="T112" fmla="*/ 1843 w 1871"/>
              <a:gd name="T113" fmla="*/ 145 h 1684"/>
              <a:gd name="T114" fmla="*/ 1869 w 1871"/>
              <a:gd name="T115" fmla="*/ 165 h 1684"/>
              <a:gd name="T116" fmla="*/ 1840 w 1871"/>
              <a:gd name="T117" fmla="*/ 235 h 1684"/>
              <a:gd name="T118" fmla="*/ 1599 w 1871"/>
              <a:gd name="T119" fmla="*/ 256 h 1684"/>
              <a:gd name="T120" fmla="*/ 1633 w 1871"/>
              <a:gd name="T121" fmla="*/ 9 h 1684"/>
              <a:gd name="T122" fmla="*/ 1729 w 1871"/>
              <a:gd name="T123" fmla="*/ 83 h 1684"/>
              <a:gd name="T124" fmla="*/ 1597 w 1871"/>
              <a:gd name="T125" fmla="*/ 167 h 16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1871" h="1684">
                <a:moveTo>
                  <a:pt x="234" y="1277"/>
                </a:moveTo>
                <a:cubicBezTo>
                  <a:pt x="237" y="1280"/>
                  <a:pt x="239" y="1283"/>
                  <a:pt x="241" y="1285"/>
                </a:cubicBezTo>
                <a:cubicBezTo>
                  <a:pt x="243" y="1287"/>
                  <a:pt x="244" y="1290"/>
                  <a:pt x="245" y="1292"/>
                </a:cubicBezTo>
                <a:cubicBezTo>
                  <a:pt x="245" y="1294"/>
                  <a:pt x="245" y="1295"/>
                  <a:pt x="245" y="1297"/>
                </a:cubicBezTo>
                <a:cubicBezTo>
                  <a:pt x="245" y="1299"/>
                  <a:pt x="244" y="1300"/>
                  <a:pt x="243" y="1301"/>
                </a:cubicBezTo>
                <a:lnTo>
                  <a:pt x="159" y="1385"/>
                </a:lnTo>
                <a:lnTo>
                  <a:pt x="416" y="1642"/>
                </a:lnTo>
                <a:cubicBezTo>
                  <a:pt x="418" y="1643"/>
                  <a:pt x="418" y="1645"/>
                  <a:pt x="419" y="1646"/>
                </a:cubicBezTo>
                <a:cubicBezTo>
                  <a:pt x="419" y="1648"/>
                  <a:pt x="419" y="1649"/>
                  <a:pt x="418" y="1652"/>
                </a:cubicBezTo>
                <a:cubicBezTo>
                  <a:pt x="417" y="1654"/>
                  <a:pt x="415" y="1656"/>
                  <a:pt x="413" y="1659"/>
                </a:cubicBezTo>
                <a:cubicBezTo>
                  <a:pt x="411" y="1662"/>
                  <a:pt x="408" y="1665"/>
                  <a:pt x="404" y="1669"/>
                </a:cubicBezTo>
                <a:cubicBezTo>
                  <a:pt x="400" y="1673"/>
                  <a:pt x="397" y="1676"/>
                  <a:pt x="394" y="1678"/>
                </a:cubicBezTo>
                <a:cubicBezTo>
                  <a:pt x="391" y="1680"/>
                  <a:pt x="388" y="1682"/>
                  <a:pt x="386" y="1683"/>
                </a:cubicBezTo>
                <a:cubicBezTo>
                  <a:pt x="384" y="1684"/>
                  <a:pt x="383" y="1684"/>
                  <a:pt x="381" y="1684"/>
                </a:cubicBezTo>
                <a:cubicBezTo>
                  <a:pt x="379" y="1683"/>
                  <a:pt x="378" y="1683"/>
                  <a:pt x="377" y="1681"/>
                </a:cubicBezTo>
                <a:lnTo>
                  <a:pt x="120" y="1424"/>
                </a:lnTo>
                <a:lnTo>
                  <a:pt x="36" y="1508"/>
                </a:lnTo>
                <a:cubicBezTo>
                  <a:pt x="35" y="1509"/>
                  <a:pt x="34" y="1510"/>
                  <a:pt x="32" y="1510"/>
                </a:cubicBezTo>
                <a:cubicBezTo>
                  <a:pt x="30" y="1510"/>
                  <a:pt x="29" y="1510"/>
                  <a:pt x="27" y="1510"/>
                </a:cubicBezTo>
                <a:cubicBezTo>
                  <a:pt x="25" y="1509"/>
                  <a:pt x="23" y="1508"/>
                  <a:pt x="20" y="1506"/>
                </a:cubicBezTo>
                <a:cubicBezTo>
                  <a:pt x="18" y="1504"/>
                  <a:pt x="15" y="1502"/>
                  <a:pt x="12" y="1499"/>
                </a:cubicBezTo>
                <a:cubicBezTo>
                  <a:pt x="9" y="1496"/>
                  <a:pt x="7" y="1493"/>
                  <a:pt x="5" y="1491"/>
                </a:cubicBezTo>
                <a:cubicBezTo>
                  <a:pt x="3" y="1488"/>
                  <a:pt x="2" y="1486"/>
                  <a:pt x="1" y="1484"/>
                </a:cubicBezTo>
                <a:cubicBezTo>
                  <a:pt x="0" y="1482"/>
                  <a:pt x="0" y="1480"/>
                  <a:pt x="0" y="1478"/>
                </a:cubicBezTo>
                <a:cubicBezTo>
                  <a:pt x="1" y="1477"/>
                  <a:pt x="2" y="1475"/>
                  <a:pt x="3" y="1474"/>
                </a:cubicBezTo>
                <a:lnTo>
                  <a:pt x="209" y="1268"/>
                </a:lnTo>
                <a:cubicBezTo>
                  <a:pt x="210" y="1267"/>
                  <a:pt x="212" y="1266"/>
                  <a:pt x="213" y="1265"/>
                </a:cubicBezTo>
                <a:cubicBezTo>
                  <a:pt x="215" y="1265"/>
                  <a:pt x="217" y="1265"/>
                  <a:pt x="219" y="1266"/>
                </a:cubicBezTo>
                <a:cubicBezTo>
                  <a:pt x="221" y="1267"/>
                  <a:pt x="223" y="1268"/>
                  <a:pt x="226" y="1270"/>
                </a:cubicBezTo>
                <a:cubicBezTo>
                  <a:pt x="228" y="1272"/>
                  <a:pt x="231" y="1274"/>
                  <a:pt x="234" y="1277"/>
                </a:cubicBezTo>
                <a:close/>
                <a:moveTo>
                  <a:pt x="649" y="1421"/>
                </a:moveTo>
                <a:lnTo>
                  <a:pt x="698" y="1524"/>
                </a:lnTo>
                <a:cubicBezTo>
                  <a:pt x="699" y="1528"/>
                  <a:pt x="699" y="1532"/>
                  <a:pt x="696" y="1537"/>
                </a:cubicBezTo>
                <a:cubicBezTo>
                  <a:pt x="694" y="1542"/>
                  <a:pt x="689" y="1548"/>
                  <a:pt x="681" y="1556"/>
                </a:cubicBezTo>
                <a:cubicBezTo>
                  <a:pt x="677" y="1560"/>
                  <a:pt x="674" y="1563"/>
                  <a:pt x="671" y="1565"/>
                </a:cubicBezTo>
                <a:cubicBezTo>
                  <a:pt x="668" y="1567"/>
                  <a:pt x="665" y="1568"/>
                  <a:pt x="663" y="1569"/>
                </a:cubicBezTo>
                <a:cubicBezTo>
                  <a:pt x="661" y="1569"/>
                  <a:pt x="659" y="1569"/>
                  <a:pt x="657" y="1567"/>
                </a:cubicBezTo>
                <a:cubicBezTo>
                  <a:pt x="656" y="1566"/>
                  <a:pt x="654" y="1564"/>
                  <a:pt x="653" y="1561"/>
                </a:cubicBezTo>
                <a:lnTo>
                  <a:pt x="610" y="1461"/>
                </a:lnTo>
                <a:cubicBezTo>
                  <a:pt x="608" y="1461"/>
                  <a:pt x="605" y="1462"/>
                  <a:pt x="603" y="1461"/>
                </a:cubicBezTo>
                <a:cubicBezTo>
                  <a:pt x="600" y="1461"/>
                  <a:pt x="598" y="1461"/>
                  <a:pt x="596" y="1460"/>
                </a:cubicBezTo>
                <a:lnTo>
                  <a:pt x="325" y="1336"/>
                </a:lnTo>
                <a:cubicBezTo>
                  <a:pt x="321" y="1334"/>
                  <a:pt x="318" y="1332"/>
                  <a:pt x="316" y="1330"/>
                </a:cubicBezTo>
                <a:cubicBezTo>
                  <a:pt x="314" y="1328"/>
                  <a:pt x="313" y="1326"/>
                  <a:pt x="313" y="1324"/>
                </a:cubicBezTo>
                <a:cubicBezTo>
                  <a:pt x="313" y="1322"/>
                  <a:pt x="315" y="1319"/>
                  <a:pt x="317" y="1316"/>
                </a:cubicBezTo>
                <a:cubicBezTo>
                  <a:pt x="319" y="1313"/>
                  <a:pt x="323" y="1309"/>
                  <a:pt x="328" y="1304"/>
                </a:cubicBezTo>
                <a:cubicBezTo>
                  <a:pt x="332" y="1300"/>
                  <a:pt x="336" y="1296"/>
                  <a:pt x="339" y="1294"/>
                </a:cubicBezTo>
                <a:cubicBezTo>
                  <a:pt x="341" y="1292"/>
                  <a:pt x="344" y="1290"/>
                  <a:pt x="346" y="1289"/>
                </a:cubicBezTo>
                <a:cubicBezTo>
                  <a:pt x="348" y="1288"/>
                  <a:pt x="350" y="1288"/>
                  <a:pt x="352" y="1288"/>
                </a:cubicBezTo>
                <a:cubicBezTo>
                  <a:pt x="354" y="1289"/>
                  <a:pt x="356" y="1290"/>
                  <a:pt x="359" y="1291"/>
                </a:cubicBezTo>
                <a:lnTo>
                  <a:pt x="583" y="1397"/>
                </a:lnTo>
                <a:lnTo>
                  <a:pt x="584" y="1397"/>
                </a:lnTo>
                <a:lnTo>
                  <a:pt x="474" y="1173"/>
                </a:lnTo>
                <a:cubicBezTo>
                  <a:pt x="472" y="1170"/>
                  <a:pt x="472" y="1167"/>
                  <a:pt x="472" y="1165"/>
                </a:cubicBezTo>
                <a:cubicBezTo>
                  <a:pt x="473" y="1162"/>
                  <a:pt x="474" y="1160"/>
                  <a:pt x="476" y="1157"/>
                </a:cubicBezTo>
                <a:cubicBezTo>
                  <a:pt x="478" y="1154"/>
                  <a:pt x="482" y="1150"/>
                  <a:pt x="487" y="1145"/>
                </a:cubicBezTo>
                <a:cubicBezTo>
                  <a:pt x="491" y="1141"/>
                  <a:pt x="495" y="1137"/>
                  <a:pt x="498" y="1135"/>
                </a:cubicBezTo>
                <a:cubicBezTo>
                  <a:pt x="501" y="1133"/>
                  <a:pt x="504" y="1131"/>
                  <a:pt x="506" y="1131"/>
                </a:cubicBezTo>
                <a:cubicBezTo>
                  <a:pt x="509" y="1131"/>
                  <a:pt x="511" y="1132"/>
                  <a:pt x="513" y="1134"/>
                </a:cubicBezTo>
                <a:cubicBezTo>
                  <a:pt x="514" y="1135"/>
                  <a:pt x="516" y="1138"/>
                  <a:pt x="518" y="1142"/>
                </a:cubicBezTo>
                <a:lnTo>
                  <a:pt x="649" y="1421"/>
                </a:lnTo>
                <a:close/>
                <a:moveTo>
                  <a:pt x="687" y="987"/>
                </a:moveTo>
                <a:cubicBezTo>
                  <a:pt x="690" y="990"/>
                  <a:pt x="693" y="993"/>
                  <a:pt x="695" y="995"/>
                </a:cubicBezTo>
                <a:cubicBezTo>
                  <a:pt x="697" y="998"/>
                  <a:pt x="698" y="1000"/>
                  <a:pt x="699" y="1002"/>
                </a:cubicBezTo>
                <a:cubicBezTo>
                  <a:pt x="700" y="1003"/>
                  <a:pt x="701" y="1005"/>
                  <a:pt x="701" y="1006"/>
                </a:cubicBezTo>
                <a:cubicBezTo>
                  <a:pt x="701" y="1008"/>
                  <a:pt x="700" y="1009"/>
                  <a:pt x="699" y="1010"/>
                </a:cubicBezTo>
                <a:cubicBezTo>
                  <a:pt x="697" y="1011"/>
                  <a:pt x="696" y="1013"/>
                  <a:pt x="693" y="1014"/>
                </a:cubicBezTo>
                <a:cubicBezTo>
                  <a:pt x="691" y="1015"/>
                  <a:pt x="688" y="1016"/>
                  <a:pt x="685" y="1018"/>
                </a:cubicBezTo>
                <a:cubicBezTo>
                  <a:pt x="682" y="1019"/>
                  <a:pt x="679" y="1021"/>
                  <a:pt x="676" y="1023"/>
                </a:cubicBezTo>
                <a:cubicBezTo>
                  <a:pt x="672" y="1025"/>
                  <a:pt x="669" y="1028"/>
                  <a:pt x="666" y="1031"/>
                </a:cubicBezTo>
                <a:cubicBezTo>
                  <a:pt x="662" y="1035"/>
                  <a:pt x="659" y="1039"/>
                  <a:pt x="657" y="1045"/>
                </a:cubicBezTo>
                <a:cubicBezTo>
                  <a:pt x="655" y="1050"/>
                  <a:pt x="653" y="1056"/>
                  <a:pt x="653" y="1064"/>
                </a:cubicBezTo>
                <a:cubicBezTo>
                  <a:pt x="652" y="1071"/>
                  <a:pt x="653" y="1080"/>
                  <a:pt x="654" y="1090"/>
                </a:cubicBezTo>
                <a:cubicBezTo>
                  <a:pt x="656" y="1101"/>
                  <a:pt x="658" y="1113"/>
                  <a:pt x="661" y="1126"/>
                </a:cubicBezTo>
                <a:lnTo>
                  <a:pt x="797" y="1262"/>
                </a:lnTo>
                <a:cubicBezTo>
                  <a:pt x="798" y="1263"/>
                  <a:pt x="799" y="1265"/>
                  <a:pt x="799" y="1266"/>
                </a:cubicBezTo>
                <a:cubicBezTo>
                  <a:pt x="799" y="1268"/>
                  <a:pt x="799" y="1269"/>
                  <a:pt x="798" y="1271"/>
                </a:cubicBezTo>
                <a:cubicBezTo>
                  <a:pt x="797" y="1273"/>
                  <a:pt x="796" y="1276"/>
                  <a:pt x="794" y="1278"/>
                </a:cubicBezTo>
                <a:cubicBezTo>
                  <a:pt x="791" y="1281"/>
                  <a:pt x="788" y="1285"/>
                  <a:pt x="785" y="1288"/>
                </a:cubicBezTo>
                <a:cubicBezTo>
                  <a:pt x="781" y="1292"/>
                  <a:pt x="778" y="1295"/>
                  <a:pt x="775" y="1297"/>
                </a:cubicBezTo>
                <a:cubicBezTo>
                  <a:pt x="772" y="1299"/>
                  <a:pt x="770" y="1301"/>
                  <a:pt x="768" y="1302"/>
                </a:cubicBezTo>
                <a:cubicBezTo>
                  <a:pt x="766" y="1302"/>
                  <a:pt x="764" y="1303"/>
                  <a:pt x="763" y="1302"/>
                </a:cubicBezTo>
                <a:cubicBezTo>
                  <a:pt x="761" y="1302"/>
                  <a:pt x="760" y="1301"/>
                  <a:pt x="759" y="1300"/>
                </a:cubicBezTo>
                <a:lnTo>
                  <a:pt x="552" y="1094"/>
                </a:lnTo>
                <a:cubicBezTo>
                  <a:pt x="551" y="1092"/>
                  <a:pt x="550" y="1091"/>
                  <a:pt x="550" y="1090"/>
                </a:cubicBezTo>
                <a:cubicBezTo>
                  <a:pt x="550" y="1089"/>
                  <a:pt x="550" y="1087"/>
                  <a:pt x="550" y="1085"/>
                </a:cubicBezTo>
                <a:cubicBezTo>
                  <a:pt x="551" y="1083"/>
                  <a:pt x="552" y="1081"/>
                  <a:pt x="554" y="1078"/>
                </a:cubicBezTo>
                <a:cubicBezTo>
                  <a:pt x="556" y="1076"/>
                  <a:pt x="559" y="1073"/>
                  <a:pt x="563" y="1069"/>
                </a:cubicBezTo>
                <a:cubicBezTo>
                  <a:pt x="566" y="1066"/>
                  <a:pt x="569" y="1063"/>
                  <a:pt x="571" y="1061"/>
                </a:cubicBezTo>
                <a:cubicBezTo>
                  <a:pt x="574" y="1059"/>
                  <a:pt x="576" y="1058"/>
                  <a:pt x="578" y="1058"/>
                </a:cubicBezTo>
                <a:cubicBezTo>
                  <a:pt x="580" y="1057"/>
                  <a:pt x="581" y="1057"/>
                  <a:pt x="583" y="1057"/>
                </a:cubicBezTo>
                <a:cubicBezTo>
                  <a:pt x="584" y="1058"/>
                  <a:pt x="585" y="1058"/>
                  <a:pt x="587" y="1060"/>
                </a:cubicBezTo>
                <a:lnTo>
                  <a:pt x="617" y="1090"/>
                </a:lnTo>
                <a:cubicBezTo>
                  <a:pt x="614" y="1076"/>
                  <a:pt x="613" y="1064"/>
                  <a:pt x="612" y="1053"/>
                </a:cubicBezTo>
                <a:cubicBezTo>
                  <a:pt x="612" y="1043"/>
                  <a:pt x="613" y="1035"/>
                  <a:pt x="614" y="1027"/>
                </a:cubicBezTo>
                <a:cubicBezTo>
                  <a:pt x="616" y="1020"/>
                  <a:pt x="618" y="1013"/>
                  <a:pt x="621" y="1008"/>
                </a:cubicBezTo>
                <a:cubicBezTo>
                  <a:pt x="624" y="1002"/>
                  <a:pt x="628" y="997"/>
                  <a:pt x="633" y="993"/>
                </a:cubicBezTo>
                <a:cubicBezTo>
                  <a:pt x="635" y="991"/>
                  <a:pt x="637" y="989"/>
                  <a:pt x="640" y="986"/>
                </a:cubicBezTo>
                <a:cubicBezTo>
                  <a:pt x="643" y="984"/>
                  <a:pt x="646" y="982"/>
                  <a:pt x="649" y="980"/>
                </a:cubicBezTo>
                <a:cubicBezTo>
                  <a:pt x="652" y="978"/>
                  <a:pt x="655" y="976"/>
                  <a:pt x="658" y="974"/>
                </a:cubicBezTo>
                <a:cubicBezTo>
                  <a:pt x="661" y="973"/>
                  <a:pt x="664" y="972"/>
                  <a:pt x="665" y="972"/>
                </a:cubicBezTo>
                <a:cubicBezTo>
                  <a:pt x="667" y="972"/>
                  <a:pt x="668" y="972"/>
                  <a:pt x="669" y="972"/>
                </a:cubicBezTo>
                <a:cubicBezTo>
                  <a:pt x="670" y="973"/>
                  <a:pt x="672" y="973"/>
                  <a:pt x="673" y="974"/>
                </a:cubicBezTo>
                <a:cubicBezTo>
                  <a:pt x="674" y="975"/>
                  <a:pt x="676" y="976"/>
                  <a:pt x="678" y="978"/>
                </a:cubicBezTo>
                <a:cubicBezTo>
                  <a:pt x="680" y="980"/>
                  <a:pt x="683" y="983"/>
                  <a:pt x="687" y="987"/>
                </a:cubicBezTo>
                <a:close/>
                <a:moveTo>
                  <a:pt x="1009" y="839"/>
                </a:moveTo>
                <a:cubicBezTo>
                  <a:pt x="1026" y="855"/>
                  <a:pt x="1039" y="873"/>
                  <a:pt x="1049" y="892"/>
                </a:cubicBezTo>
                <a:cubicBezTo>
                  <a:pt x="1059" y="910"/>
                  <a:pt x="1064" y="929"/>
                  <a:pt x="1066" y="948"/>
                </a:cubicBezTo>
                <a:cubicBezTo>
                  <a:pt x="1067" y="967"/>
                  <a:pt x="1064" y="986"/>
                  <a:pt x="1057" y="1005"/>
                </a:cubicBezTo>
                <a:cubicBezTo>
                  <a:pt x="1049" y="1024"/>
                  <a:pt x="1037" y="1042"/>
                  <a:pt x="1019" y="1060"/>
                </a:cubicBezTo>
                <a:cubicBezTo>
                  <a:pt x="1002" y="1077"/>
                  <a:pt x="985" y="1089"/>
                  <a:pt x="967" y="1096"/>
                </a:cubicBezTo>
                <a:cubicBezTo>
                  <a:pt x="950" y="1104"/>
                  <a:pt x="932" y="1107"/>
                  <a:pt x="914" y="1106"/>
                </a:cubicBezTo>
                <a:cubicBezTo>
                  <a:pt x="896" y="1105"/>
                  <a:pt x="878" y="1099"/>
                  <a:pt x="860" y="1090"/>
                </a:cubicBezTo>
                <a:cubicBezTo>
                  <a:pt x="842" y="1080"/>
                  <a:pt x="824" y="1067"/>
                  <a:pt x="807" y="1049"/>
                </a:cubicBezTo>
                <a:cubicBezTo>
                  <a:pt x="790" y="1032"/>
                  <a:pt x="777" y="1015"/>
                  <a:pt x="767" y="996"/>
                </a:cubicBezTo>
                <a:cubicBezTo>
                  <a:pt x="757" y="978"/>
                  <a:pt x="752" y="959"/>
                  <a:pt x="750" y="940"/>
                </a:cubicBezTo>
                <a:cubicBezTo>
                  <a:pt x="749" y="921"/>
                  <a:pt x="752" y="902"/>
                  <a:pt x="759" y="883"/>
                </a:cubicBezTo>
                <a:cubicBezTo>
                  <a:pt x="767" y="864"/>
                  <a:pt x="779" y="846"/>
                  <a:pt x="797" y="829"/>
                </a:cubicBezTo>
                <a:cubicBezTo>
                  <a:pt x="814" y="812"/>
                  <a:pt x="831" y="799"/>
                  <a:pt x="849" y="792"/>
                </a:cubicBezTo>
                <a:cubicBezTo>
                  <a:pt x="867" y="784"/>
                  <a:pt x="884" y="781"/>
                  <a:pt x="902" y="782"/>
                </a:cubicBezTo>
                <a:cubicBezTo>
                  <a:pt x="920" y="783"/>
                  <a:pt x="938" y="789"/>
                  <a:pt x="956" y="798"/>
                </a:cubicBezTo>
                <a:cubicBezTo>
                  <a:pt x="974" y="808"/>
                  <a:pt x="992" y="821"/>
                  <a:pt x="1009" y="839"/>
                </a:cubicBezTo>
                <a:close/>
                <a:moveTo>
                  <a:pt x="973" y="880"/>
                </a:moveTo>
                <a:cubicBezTo>
                  <a:pt x="961" y="869"/>
                  <a:pt x="950" y="860"/>
                  <a:pt x="938" y="852"/>
                </a:cubicBezTo>
                <a:cubicBezTo>
                  <a:pt x="926" y="844"/>
                  <a:pt x="914" y="839"/>
                  <a:pt x="901" y="836"/>
                </a:cubicBezTo>
                <a:cubicBezTo>
                  <a:pt x="889" y="833"/>
                  <a:pt x="877" y="834"/>
                  <a:pt x="864" y="838"/>
                </a:cubicBezTo>
                <a:cubicBezTo>
                  <a:pt x="852" y="841"/>
                  <a:pt x="839" y="849"/>
                  <a:pt x="827" y="862"/>
                </a:cubicBezTo>
                <a:cubicBezTo>
                  <a:pt x="816" y="873"/>
                  <a:pt x="808" y="885"/>
                  <a:pt x="804" y="897"/>
                </a:cubicBezTo>
                <a:cubicBezTo>
                  <a:pt x="800" y="909"/>
                  <a:pt x="799" y="921"/>
                  <a:pt x="801" y="934"/>
                </a:cubicBezTo>
                <a:cubicBezTo>
                  <a:pt x="803" y="946"/>
                  <a:pt x="808" y="959"/>
                  <a:pt x="815" y="971"/>
                </a:cubicBezTo>
                <a:cubicBezTo>
                  <a:pt x="822" y="983"/>
                  <a:pt x="832" y="996"/>
                  <a:pt x="844" y="1007"/>
                </a:cubicBezTo>
                <a:cubicBezTo>
                  <a:pt x="855" y="1019"/>
                  <a:pt x="867" y="1028"/>
                  <a:pt x="879" y="1036"/>
                </a:cubicBezTo>
                <a:cubicBezTo>
                  <a:pt x="891" y="1044"/>
                  <a:pt x="903" y="1049"/>
                  <a:pt x="915" y="1052"/>
                </a:cubicBezTo>
                <a:cubicBezTo>
                  <a:pt x="927" y="1054"/>
                  <a:pt x="940" y="1054"/>
                  <a:pt x="952" y="1050"/>
                </a:cubicBezTo>
                <a:cubicBezTo>
                  <a:pt x="965" y="1046"/>
                  <a:pt x="977" y="1038"/>
                  <a:pt x="989" y="1026"/>
                </a:cubicBezTo>
                <a:cubicBezTo>
                  <a:pt x="1001" y="1015"/>
                  <a:pt x="1008" y="1003"/>
                  <a:pt x="1012" y="991"/>
                </a:cubicBezTo>
                <a:cubicBezTo>
                  <a:pt x="1017" y="979"/>
                  <a:pt x="1018" y="967"/>
                  <a:pt x="1016" y="954"/>
                </a:cubicBezTo>
                <a:cubicBezTo>
                  <a:pt x="1014" y="942"/>
                  <a:pt x="1009" y="929"/>
                  <a:pt x="1002" y="917"/>
                </a:cubicBezTo>
                <a:cubicBezTo>
                  <a:pt x="994" y="904"/>
                  <a:pt x="984" y="892"/>
                  <a:pt x="973" y="880"/>
                </a:cubicBezTo>
                <a:close/>
                <a:moveTo>
                  <a:pt x="1245" y="701"/>
                </a:moveTo>
                <a:cubicBezTo>
                  <a:pt x="1256" y="712"/>
                  <a:pt x="1263" y="723"/>
                  <a:pt x="1267" y="735"/>
                </a:cubicBezTo>
                <a:cubicBezTo>
                  <a:pt x="1272" y="748"/>
                  <a:pt x="1273" y="760"/>
                  <a:pt x="1272" y="773"/>
                </a:cubicBezTo>
                <a:cubicBezTo>
                  <a:pt x="1270" y="786"/>
                  <a:pt x="1266" y="799"/>
                  <a:pt x="1259" y="811"/>
                </a:cubicBezTo>
                <a:cubicBezTo>
                  <a:pt x="1252" y="824"/>
                  <a:pt x="1242" y="837"/>
                  <a:pt x="1230" y="849"/>
                </a:cubicBezTo>
                <a:cubicBezTo>
                  <a:pt x="1223" y="856"/>
                  <a:pt x="1215" y="862"/>
                  <a:pt x="1208" y="868"/>
                </a:cubicBezTo>
                <a:cubicBezTo>
                  <a:pt x="1200" y="873"/>
                  <a:pt x="1192" y="878"/>
                  <a:pt x="1185" y="881"/>
                </a:cubicBezTo>
                <a:cubicBezTo>
                  <a:pt x="1178" y="885"/>
                  <a:pt x="1172" y="888"/>
                  <a:pt x="1167" y="889"/>
                </a:cubicBezTo>
                <a:cubicBezTo>
                  <a:pt x="1161" y="891"/>
                  <a:pt x="1157" y="892"/>
                  <a:pt x="1153" y="892"/>
                </a:cubicBezTo>
                <a:cubicBezTo>
                  <a:pt x="1150" y="892"/>
                  <a:pt x="1147" y="891"/>
                  <a:pt x="1143" y="889"/>
                </a:cubicBezTo>
                <a:cubicBezTo>
                  <a:pt x="1140" y="887"/>
                  <a:pt x="1136" y="884"/>
                  <a:pt x="1131" y="879"/>
                </a:cubicBezTo>
                <a:cubicBezTo>
                  <a:pt x="1128" y="876"/>
                  <a:pt x="1126" y="874"/>
                  <a:pt x="1124" y="871"/>
                </a:cubicBezTo>
                <a:cubicBezTo>
                  <a:pt x="1122" y="869"/>
                  <a:pt x="1121" y="867"/>
                  <a:pt x="1120" y="866"/>
                </a:cubicBezTo>
                <a:cubicBezTo>
                  <a:pt x="1120" y="864"/>
                  <a:pt x="1119" y="862"/>
                  <a:pt x="1120" y="861"/>
                </a:cubicBezTo>
                <a:cubicBezTo>
                  <a:pt x="1120" y="860"/>
                  <a:pt x="1121" y="858"/>
                  <a:pt x="1122" y="857"/>
                </a:cubicBezTo>
                <a:cubicBezTo>
                  <a:pt x="1123" y="856"/>
                  <a:pt x="1127" y="854"/>
                  <a:pt x="1132" y="853"/>
                </a:cubicBezTo>
                <a:cubicBezTo>
                  <a:pt x="1138" y="852"/>
                  <a:pt x="1144" y="850"/>
                  <a:pt x="1151" y="848"/>
                </a:cubicBezTo>
                <a:cubicBezTo>
                  <a:pt x="1158" y="845"/>
                  <a:pt x="1166" y="842"/>
                  <a:pt x="1175" y="837"/>
                </a:cubicBezTo>
                <a:cubicBezTo>
                  <a:pt x="1184" y="833"/>
                  <a:pt x="1192" y="826"/>
                  <a:pt x="1201" y="818"/>
                </a:cubicBezTo>
                <a:cubicBezTo>
                  <a:pt x="1207" y="811"/>
                  <a:pt x="1212" y="805"/>
                  <a:pt x="1216" y="798"/>
                </a:cubicBezTo>
                <a:cubicBezTo>
                  <a:pt x="1220" y="792"/>
                  <a:pt x="1222" y="785"/>
                  <a:pt x="1224" y="779"/>
                </a:cubicBezTo>
                <a:cubicBezTo>
                  <a:pt x="1225" y="772"/>
                  <a:pt x="1224" y="766"/>
                  <a:pt x="1222" y="760"/>
                </a:cubicBezTo>
                <a:cubicBezTo>
                  <a:pt x="1220" y="753"/>
                  <a:pt x="1216" y="747"/>
                  <a:pt x="1211" y="742"/>
                </a:cubicBezTo>
                <a:cubicBezTo>
                  <a:pt x="1205" y="736"/>
                  <a:pt x="1198" y="733"/>
                  <a:pt x="1192" y="732"/>
                </a:cubicBezTo>
                <a:cubicBezTo>
                  <a:pt x="1185" y="731"/>
                  <a:pt x="1177" y="731"/>
                  <a:pt x="1169" y="733"/>
                </a:cubicBezTo>
                <a:cubicBezTo>
                  <a:pt x="1161" y="735"/>
                  <a:pt x="1153" y="737"/>
                  <a:pt x="1145" y="741"/>
                </a:cubicBezTo>
                <a:cubicBezTo>
                  <a:pt x="1136" y="745"/>
                  <a:pt x="1127" y="749"/>
                  <a:pt x="1118" y="753"/>
                </a:cubicBezTo>
                <a:cubicBezTo>
                  <a:pt x="1109" y="757"/>
                  <a:pt x="1100" y="760"/>
                  <a:pt x="1090" y="763"/>
                </a:cubicBezTo>
                <a:cubicBezTo>
                  <a:pt x="1081" y="766"/>
                  <a:pt x="1071" y="767"/>
                  <a:pt x="1062" y="767"/>
                </a:cubicBezTo>
                <a:cubicBezTo>
                  <a:pt x="1052" y="768"/>
                  <a:pt x="1042" y="766"/>
                  <a:pt x="1033" y="762"/>
                </a:cubicBezTo>
                <a:cubicBezTo>
                  <a:pt x="1023" y="759"/>
                  <a:pt x="1014" y="752"/>
                  <a:pt x="1005" y="743"/>
                </a:cubicBezTo>
                <a:cubicBezTo>
                  <a:pt x="997" y="735"/>
                  <a:pt x="991" y="726"/>
                  <a:pt x="986" y="715"/>
                </a:cubicBezTo>
                <a:cubicBezTo>
                  <a:pt x="982" y="705"/>
                  <a:pt x="980" y="693"/>
                  <a:pt x="981" y="682"/>
                </a:cubicBezTo>
                <a:cubicBezTo>
                  <a:pt x="982" y="670"/>
                  <a:pt x="985" y="657"/>
                  <a:pt x="991" y="645"/>
                </a:cubicBezTo>
                <a:cubicBezTo>
                  <a:pt x="997" y="632"/>
                  <a:pt x="1006" y="619"/>
                  <a:pt x="1019" y="607"/>
                </a:cubicBezTo>
                <a:cubicBezTo>
                  <a:pt x="1024" y="601"/>
                  <a:pt x="1030" y="596"/>
                  <a:pt x="1037" y="592"/>
                </a:cubicBezTo>
                <a:cubicBezTo>
                  <a:pt x="1043" y="587"/>
                  <a:pt x="1049" y="583"/>
                  <a:pt x="1055" y="580"/>
                </a:cubicBezTo>
                <a:cubicBezTo>
                  <a:pt x="1061" y="577"/>
                  <a:pt x="1066" y="575"/>
                  <a:pt x="1071" y="573"/>
                </a:cubicBezTo>
                <a:cubicBezTo>
                  <a:pt x="1076" y="572"/>
                  <a:pt x="1079" y="571"/>
                  <a:pt x="1082" y="570"/>
                </a:cubicBezTo>
                <a:cubicBezTo>
                  <a:pt x="1085" y="570"/>
                  <a:pt x="1087" y="570"/>
                  <a:pt x="1089" y="570"/>
                </a:cubicBezTo>
                <a:cubicBezTo>
                  <a:pt x="1090" y="571"/>
                  <a:pt x="1091" y="571"/>
                  <a:pt x="1093" y="572"/>
                </a:cubicBezTo>
                <a:cubicBezTo>
                  <a:pt x="1094" y="573"/>
                  <a:pt x="1096" y="574"/>
                  <a:pt x="1098" y="576"/>
                </a:cubicBezTo>
                <a:cubicBezTo>
                  <a:pt x="1100" y="577"/>
                  <a:pt x="1102" y="579"/>
                  <a:pt x="1104" y="582"/>
                </a:cubicBezTo>
                <a:cubicBezTo>
                  <a:pt x="1107" y="584"/>
                  <a:pt x="1109" y="587"/>
                  <a:pt x="1111" y="589"/>
                </a:cubicBezTo>
                <a:cubicBezTo>
                  <a:pt x="1112" y="591"/>
                  <a:pt x="1114" y="593"/>
                  <a:pt x="1114" y="595"/>
                </a:cubicBezTo>
                <a:cubicBezTo>
                  <a:pt x="1115" y="596"/>
                  <a:pt x="1115" y="598"/>
                  <a:pt x="1115" y="599"/>
                </a:cubicBezTo>
                <a:cubicBezTo>
                  <a:pt x="1115" y="601"/>
                  <a:pt x="1114" y="602"/>
                  <a:pt x="1113" y="603"/>
                </a:cubicBezTo>
                <a:cubicBezTo>
                  <a:pt x="1112" y="604"/>
                  <a:pt x="1109" y="605"/>
                  <a:pt x="1105" y="606"/>
                </a:cubicBezTo>
                <a:cubicBezTo>
                  <a:pt x="1100" y="607"/>
                  <a:pt x="1095" y="609"/>
                  <a:pt x="1089" y="611"/>
                </a:cubicBezTo>
                <a:cubicBezTo>
                  <a:pt x="1083" y="613"/>
                  <a:pt x="1077" y="616"/>
                  <a:pt x="1069" y="620"/>
                </a:cubicBezTo>
                <a:cubicBezTo>
                  <a:pt x="1062" y="624"/>
                  <a:pt x="1055" y="629"/>
                  <a:pt x="1048" y="637"/>
                </a:cubicBezTo>
                <a:cubicBezTo>
                  <a:pt x="1041" y="643"/>
                  <a:pt x="1036" y="649"/>
                  <a:pt x="1033" y="656"/>
                </a:cubicBezTo>
                <a:cubicBezTo>
                  <a:pt x="1029" y="662"/>
                  <a:pt x="1027" y="668"/>
                  <a:pt x="1027" y="674"/>
                </a:cubicBezTo>
                <a:cubicBezTo>
                  <a:pt x="1027" y="680"/>
                  <a:pt x="1027" y="685"/>
                  <a:pt x="1029" y="690"/>
                </a:cubicBezTo>
                <a:cubicBezTo>
                  <a:pt x="1032" y="696"/>
                  <a:pt x="1035" y="701"/>
                  <a:pt x="1039" y="705"/>
                </a:cubicBezTo>
                <a:cubicBezTo>
                  <a:pt x="1045" y="711"/>
                  <a:pt x="1051" y="714"/>
                  <a:pt x="1059" y="715"/>
                </a:cubicBezTo>
                <a:cubicBezTo>
                  <a:pt x="1066" y="716"/>
                  <a:pt x="1073" y="716"/>
                  <a:pt x="1081" y="714"/>
                </a:cubicBezTo>
                <a:cubicBezTo>
                  <a:pt x="1089" y="712"/>
                  <a:pt x="1097" y="709"/>
                  <a:pt x="1106" y="706"/>
                </a:cubicBezTo>
                <a:cubicBezTo>
                  <a:pt x="1115" y="702"/>
                  <a:pt x="1124" y="698"/>
                  <a:pt x="1133" y="694"/>
                </a:cubicBezTo>
                <a:cubicBezTo>
                  <a:pt x="1142" y="690"/>
                  <a:pt x="1151" y="687"/>
                  <a:pt x="1161" y="683"/>
                </a:cubicBezTo>
                <a:cubicBezTo>
                  <a:pt x="1170" y="680"/>
                  <a:pt x="1180" y="679"/>
                  <a:pt x="1189" y="678"/>
                </a:cubicBezTo>
                <a:cubicBezTo>
                  <a:pt x="1199" y="678"/>
                  <a:pt x="1208" y="679"/>
                  <a:pt x="1218" y="683"/>
                </a:cubicBezTo>
                <a:cubicBezTo>
                  <a:pt x="1227" y="686"/>
                  <a:pt x="1236" y="693"/>
                  <a:pt x="1245" y="701"/>
                </a:cubicBezTo>
                <a:close/>
                <a:moveTo>
                  <a:pt x="1396" y="663"/>
                </a:moveTo>
                <a:cubicBezTo>
                  <a:pt x="1397" y="664"/>
                  <a:pt x="1398" y="665"/>
                  <a:pt x="1398" y="667"/>
                </a:cubicBezTo>
                <a:cubicBezTo>
                  <a:pt x="1399" y="668"/>
                  <a:pt x="1398" y="670"/>
                  <a:pt x="1398" y="672"/>
                </a:cubicBezTo>
                <a:cubicBezTo>
                  <a:pt x="1397" y="674"/>
                  <a:pt x="1395" y="676"/>
                  <a:pt x="1393" y="679"/>
                </a:cubicBezTo>
                <a:cubicBezTo>
                  <a:pt x="1391" y="682"/>
                  <a:pt x="1388" y="685"/>
                  <a:pt x="1384" y="689"/>
                </a:cubicBezTo>
                <a:cubicBezTo>
                  <a:pt x="1381" y="692"/>
                  <a:pt x="1377" y="695"/>
                  <a:pt x="1375" y="697"/>
                </a:cubicBezTo>
                <a:cubicBezTo>
                  <a:pt x="1372" y="700"/>
                  <a:pt x="1369" y="701"/>
                  <a:pt x="1367" y="702"/>
                </a:cubicBezTo>
                <a:cubicBezTo>
                  <a:pt x="1365" y="703"/>
                  <a:pt x="1364" y="703"/>
                  <a:pt x="1362" y="703"/>
                </a:cubicBezTo>
                <a:cubicBezTo>
                  <a:pt x="1361" y="702"/>
                  <a:pt x="1360" y="702"/>
                  <a:pt x="1358" y="700"/>
                </a:cubicBezTo>
                <a:lnTo>
                  <a:pt x="1152" y="494"/>
                </a:lnTo>
                <a:cubicBezTo>
                  <a:pt x="1151" y="493"/>
                  <a:pt x="1150" y="492"/>
                  <a:pt x="1150" y="490"/>
                </a:cubicBezTo>
                <a:cubicBezTo>
                  <a:pt x="1149" y="489"/>
                  <a:pt x="1150" y="487"/>
                  <a:pt x="1151" y="485"/>
                </a:cubicBezTo>
                <a:cubicBezTo>
                  <a:pt x="1151" y="483"/>
                  <a:pt x="1153" y="481"/>
                  <a:pt x="1155" y="478"/>
                </a:cubicBezTo>
                <a:cubicBezTo>
                  <a:pt x="1157" y="475"/>
                  <a:pt x="1160" y="472"/>
                  <a:pt x="1164" y="468"/>
                </a:cubicBezTo>
                <a:cubicBezTo>
                  <a:pt x="1168" y="464"/>
                  <a:pt x="1171" y="461"/>
                  <a:pt x="1174" y="459"/>
                </a:cubicBezTo>
                <a:cubicBezTo>
                  <a:pt x="1176" y="457"/>
                  <a:pt x="1179" y="456"/>
                  <a:pt x="1181" y="455"/>
                </a:cubicBezTo>
                <a:cubicBezTo>
                  <a:pt x="1183" y="454"/>
                  <a:pt x="1184" y="454"/>
                  <a:pt x="1186" y="454"/>
                </a:cubicBezTo>
                <a:cubicBezTo>
                  <a:pt x="1188" y="454"/>
                  <a:pt x="1189" y="455"/>
                  <a:pt x="1190" y="456"/>
                </a:cubicBezTo>
                <a:lnTo>
                  <a:pt x="1396" y="663"/>
                </a:lnTo>
                <a:close/>
                <a:moveTo>
                  <a:pt x="1125" y="382"/>
                </a:moveTo>
                <a:cubicBezTo>
                  <a:pt x="1133" y="391"/>
                  <a:pt x="1138" y="399"/>
                  <a:pt x="1138" y="405"/>
                </a:cubicBezTo>
                <a:cubicBezTo>
                  <a:pt x="1137" y="412"/>
                  <a:pt x="1133" y="420"/>
                  <a:pt x="1124" y="429"/>
                </a:cubicBezTo>
                <a:cubicBezTo>
                  <a:pt x="1115" y="438"/>
                  <a:pt x="1107" y="442"/>
                  <a:pt x="1101" y="442"/>
                </a:cubicBezTo>
                <a:cubicBezTo>
                  <a:pt x="1095" y="442"/>
                  <a:pt x="1087" y="438"/>
                  <a:pt x="1078" y="429"/>
                </a:cubicBezTo>
                <a:cubicBezTo>
                  <a:pt x="1069" y="421"/>
                  <a:pt x="1065" y="413"/>
                  <a:pt x="1065" y="406"/>
                </a:cubicBezTo>
                <a:cubicBezTo>
                  <a:pt x="1065" y="400"/>
                  <a:pt x="1070" y="392"/>
                  <a:pt x="1079" y="383"/>
                </a:cubicBezTo>
                <a:cubicBezTo>
                  <a:pt x="1088" y="374"/>
                  <a:pt x="1095" y="370"/>
                  <a:pt x="1102" y="369"/>
                </a:cubicBezTo>
                <a:cubicBezTo>
                  <a:pt x="1108" y="369"/>
                  <a:pt x="1116" y="373"/>
                  <a:pt x="1125" y="382"/>
                </a:cubicBezTo>
                <a:close/>
                <a:moveTo>
                  <a:pt x="1644" y="415"/>
                </a:moveTo>
                <a:cubicBezTo>
                  <a:pt x="1645" y="416"/>
                  <a:pt x="1645" y="418"/>
                  <a:pt x="1646" y="419"/>
                </a:cubicBezTo>
                <a:cubicBezTo>
                  <a:pt x="1646" y="421"/>
                  <a:pt x="1646" y="422"/>
                  <a:pt x="1645" y="424"/>
                </a:cubicBezTo>
                <a:cubicBezTo>
                  <a:pt x="1644" y="426"/>
                  <a:pt x="1643" y="429"/>
                  <a:pt x="1641" y="432"/>
                </a:cubicBezTo>
                <a:cubicBezTo>
                  <a:pt x="1638" y="434"/>
                  <a:pt x="1636" y="437"/>
                  <a:pt x="1632" y="441"/>
                </a:cubicBezTo>
                <a:cubicBezTo>
                  <a:pt x="1628" y="445"/>
                  <a:pt x="1625" y="448"/>
                  <a:pt x="1622" y="450"/>
                </a:cubicBezTo>
                <a:cubicBezTo>
                  <a:pt x="1619" y="452"/>
                  <a:pt x="1617" y="454"/>
                  <a:pt x="1615" y="454"/>
                </a:cubicBezTo>
                <a:cubicBezTo>
                  <a:pt x="1613" y="455"/>
                  <a:pt x="1611" y="455"/>
                  <a:pt x="1610" y="455"/>
                </a:cubicBezTo>
                <a:cubicBezTo>
                  <a:pt x="1608" y="455"/>
                  <a:pt x="1607" y="454"/>
                  <a:pt x="1606" y="453"/>
                </a:cubicBezTo>
                <a:lnTo>
                  <a:pt x="1485" y="332"/>
                </a:lnTo>
                <a:cubicBezTo>
                  <a:pt x="1473" y="320"/>
                  <a:pt x="1463" y="312"/>
                  <a:pt x="1454" y="307"/>
                </a:cubicBezTo>
                <a:cubicBezTo>
                  <a:pt x="1445" y="301"/>
                  <a:pt x="1436" y="298"/>
                  <a:pt x="1427" y="296"/>
                </a:cubicBezTo>
                <a:cubicBezTo>
                  <a:pt x="1418" y="294"/>
                  <a:pt x="1410" y="295"/>
                  <a:pt x="1402" y="298"/>
                </a:cubicBezTo>
                <a:cubicBezTo>
                  <a:pt x="1393" y="301"/>
                  <a:pt x="1385" y="306"/>
                  <a:pt x="1378" y="313"/>
                </a:cubicBezTo>
                <a:cubicBezTo>
                  <a:pt x="1369" y="322"/>
                  <a:pt x="1362" y="335"/>
                  <a:pt x="1360" y="352"/>
                </a:cubicBezTo>
                <a:cubicBezTo>
                  <a:pt x="1357" y="368"/>
                  <a:pt x="1357" y="388"/>
                  <a:pt x="1359" y="411"/>
                </a:cubicBezTo>
                <a:lnTo>
                  <a:pt x="1504" y="555"/>
                </a:lnTo>
                <a:cubicBezTo>
                  <a:pt x="1505" y="556"/>
                  <a:pt x="1506" y="558"/>
                  <a:pt x="1506" y="559"/>
                </a:cubicBezTo>
                <a:cubicBezTo>
                  <a:pt x="1506" y="561"/>
                  <a:pt x="1506" y="562"/>
                  <a:pt x="1505" y="564"/>
                </a:cubicBezTo>
                <a:cubicBezTo>
                  <a:pt x="1504" y="566"/>
                  <a:pt x="1503" y="569"/>
                  <a:pt x="1501" y="571"/>
                </a:cubicBezTo>
                <a:cubicBezTo>
                  <a:pt x="1499" y="574"/>
                  <a:pt x="1496" y="577"/>
                  <a:pt x="1492" y="581"/>
                </a:cubicBezTo>
                <a:cubicBezTo>
                  <a:pt x="1488" y="585"/>
                  <a:pt x="1485" y="588"/>
                  <a:pt x="1482" y="590"/>
                </a:cubicBezTo>
                <a:cubicBezTo>
                  <a:pt x="1479" y="592"/>
                  <a:pt x="1477" y="594"/>
                  <a:pt x="1475" y="594"/>
                </a:cubicBezTo>
                <a:cubicBezTo>
                  <a:pt x="1473" y="595"/>
                  <a:pt x="1471" y="596"/>
                  <a:pt x="1470" y="595"/>
                </a:cubicBezTo>
                <a:cubicBezTo>
                  <a:pt x="1468" y="595"/>
                  <a:pt x="1467" y="594"/>
                  <a:pt x="1466" y="593"/>
                </a:cubicBezTo>
                <a:lnTo>
                  <a:pt x="1260" y="387"/>
                </a:lnTo>
                <a:cubicBezTo>
                  <a:pt x="1258" y="385"/>
                  <a:pt x="1258" y="384"/>
                  <a:pt x="1257" y="383"/>
                </a:cubicBezTo>
                <a:cubicBezTo>
                  <a:pt x="1257" y="382"/>
                  <a:pt x="1257" y="380"/>
                  <a:pt x="1258" y="378"/>
                </a:cubicBezTo>
                <a:cubicBezTo>
                  <a:pt x="1258" y="376"/>
                  <a:pt x="1260" y="373"/>
                  <a:pt x="1261" y="371"/>
                </a:cubicBezTo>
                <a:cubicBezTo>
                  <a:pt x="1263" y="369"/>
                  <a:pt x="1266" y="366"/>
                  <a:pt x="1270" y="362"/>
                </a:cubicBezTo>
                <a:cubicBezTo>
                  <a:pt x="1273" y="359"/>
                  <a:pt x="1276" y="356"/>
                  <a:pt x="1278" y="354"/>
                </a:cubicBezTo>
                <a:cubicBezTo>
                  <a:pt x="1281" y="352"/>
                  <a:pt x="1283" y="351"/>
                  <a:pt x="1285" y="350"/>
                </a:cubicBezTo>
                <a:cubicBezTo>
                  <a:pt x="1287" y="350"/>
                  <a:pt x="1288" y="350"/>
                  <a:pt x="1290" y="350"/>
                </a:cubicBezTo>
                <a:cubicBezTo>
                  <a:pt x="1291" y="350"/>
                  <a:pt x="1292" y="351"/>
                  <a:pt x="1294" y="352"/>
                </a:cubicBezTo>
                <a:lnTo>
                  <a:pt x="1321" y="380"/>
                </a:lnTo>
                <a:cubicBezTo>
                  <a:pt x="1320" y="355"/>
                  <a:pt x="1322" y="334"/>
                  <a:pt x="1327" y="316"/>
                </a:cubicBezTo>
                <a:cubicBezTo>
                  <a:pt x="1333" y="299"/>
                  <a:pt x="1341" y="284"/>
                  <a:pt x="1353" y="272"/>
                </a:cubicBezTo>
                <a:cubicBezTo>
                  <a:pt x="1367" y="259"/>
                  <a:pt x="1381" y="249"/>
                  <a:pt x="1395" y="245"/>
                </a:cubicBezTo>
                <a:cubicBezTo>
                  <a:pt x="1409" y="240"/>
                  <a:pt x="1423" y="239"/>
                  <a:pt x="1436" y="241"/>
                </a:cubicBezTo>
                <a:cubicBezTo>
                  <a:pt x="1450" y="243"/>
                  <a:pt x="1463" y="248"/>
                  <a:pt x="1476" y="255"/>
                </a:cubicBezTo>
                <a:cubicBezTo>
                  <a:pt x="1489" y="263"/>
                  <a:pt x="1503" y="275"/>
                  <a:pt x="1518" y="289"/>
                </a:cubicBezTo>
                <a:lnTo>
                  <a:pt x="1644" y="415"/>
                </a:lnTo>
                <a:close/>
                <a:moveTo>
                  <a:pt x="1779" y="56"/>
                </a:moveTo>
                <a:cubicBezTo>
                  <a:pt x="1785" y="62"/>
                  <a:pt x="1787" y="68"/>
                  <a:pt x="1787" y="73"/>
                </a:cubicBezTo>
                <a:cubicBezTo>
                  <a:pt x="1786" y="79"/>
                  <a:pt x="1784" y="83"/>
                  <a:pt x="1780" y="87"/>
                </a:cubicBezTo>
                <a:lnTo>
                  <a:pt x="1645" y="223"/>
                </a:lnTo>
                <a:cubicBezTo>
                  <a:pt x="1656" y="234"/>
                  <a:pt x="1668" y="244"/>
                  <a:pt x="1679" y="250"/>
                </a:cubicBezTo>
                <a:cubicBezTo>
                  <a:pt x="1690" y="257"/>
                  <a:pt x="1702" y="261"/>
                  <a:pt x="1714" y="263"/>
                </a:cubicBezTo>
                <a:cubicBezTo>
                  <a:pt x="1726" y="264"/>
                  <a:pt x="1738" y="262"/>
                  <a:pt x="1750" y="257"/>
                </a:cubicBezTo>
                <a:cubicBezTo>
                  <a:pt x="1762" y="252"/>
                  <a:pt x="1775" y="243"/>
                  <a:pt x="1787" y="230"/>
                </a:cubicBezTo>
                <a:cubicBezTo>
                  <a:pt x="1797" y="221"/>
                  <a:pt x="1805" y="211"/>
                  <a:pt x="1811" y="202"/>
                </a:cubicBezTo>
                <a:cubicBezTo>
                  <a:pt x="1817" y="192"/>
                  <a:pt x="1822" y="184"/>
                  <a:pt x="1825" y="176"/>
                </a:cubicBezTo>
                <a:cubicBezTo>
                  <a:pt x="1829" y="169"/>
                  <a:pt x="1832" y="162"/>
                  <a:pt x="1834" y="157"/>
                </a:cubicBezTo>
                <a:cubicBezTo>
                  <a:pt x="1836" y="152"/>
                  <a:pt x="1838" y="149"/>
                  <a:pt x="1840" y="147"/>
                </a:cubicBezTo>
                <a:cubicBezTo>
                  <a:pt x="1841" y="146"/>
                  <a:pt x="1842" y="145"/>
                  <a:pt x="1843" y="145"/>
                </a:cubicBezTo>
                <a:cubicBezTo>
                  <a:pt x="1845" y="144"/>
                  <a:pt x="1846" y="144"/>
                  <a:pt x="1848" y="145"/>
                </a:cubicBezTo>
                <a:cubicBezTo>
                  <a:pt x="1849" y="146"/>
                  <a:pt x="1851" y="147"/>
                  <a:pt x="1853" y="148"/>
                </a:cubicBezTo>
                <a:cubicBezTo>
                  <a:pt x="1855" y="150"/>
                  <a:pt x="1858" y="152"/>
                  <a:pt x="1861" y="155"/>
                </a:cubicBezTo>
                <a:cubicBezTo>
                  <a:pt x="1863" y="157"/>
                  <a:pt x="1864" y="159"/>
                  <a:pt x="1865" y="161"/>
                </a:cubicBezTo>
                <a:cubicBezTo>
                  <a:pt x="1867" y="162"/>
                  <a:pt x="1868" y="164"/>
                  <a:pt x="1869" y="165"/>
                </a:cubicBezTo>
                <a:cubicBezTo>
                  <a:pt x="1870" y="166"/>
                  <a:pt x="1870" y="168"/>
                  <a:pt x="1871" y="169"/>
                </a:cubicBezTo>
                <a:cubicBezTo>
                  <a:pt x="1871" y="171"/>
                  <a:pt x="1871" y="172"/>
                  <a:pt x="1871" y="174"/>
                </a:cubicBezTo>
                <a:cubicBezTo>
                  <a:pt x="1871" y="176"/>
                  <a:pt x="1870" y="179"/>
                  <a:pt x="1868" y="185"/>
                </a:cubicBezTo>
                <a:cubicBezTo>
                  <a:pt x="1866" y="192"/>
                  <a:pt x="1862" y="199"/>
                  <a:pt x="1858" y="207"/>
                </a:cubicBezTo>
                <a:cubicBezTo>
                  <a:pt x="1853" y="216"/>
                  <a:pt x="1847" y="225"/>
                  <a:pt x="1840" y="235"/>
                </a:cubicBezTo>
                <a:cubicBezTo>
                  <a:pt x="1833" y="245"/>
                  <a:pt x="1824" y="255"/>
                  <a:pt x="1814" y="265"/>
                </a:cubicBezTo>
                <a:cubicBezTo>
                  <a:pt x="1797" y="282"/>
                  <a:pt x="1780" y="294"/>
                  <a:pt x="1763" y="302"/>
                </a:cubicBezTo>
                <a:cubicBezTo>
                  <a:pt x="1745" y="310"/>
                  <a:pt x="1727" y="314"/>
                  <a:pt x="1709" y="313"/>
                </a:cubicBezTo>
                <a:cubicBezTo>
                  <a:pt x="1691" y="313"/>
                  <a:pt x="1673" y="308"/>
                  <a:pt x="1654" y="298"/>
                </a:cubicBezTo>
                <a:cubicBezTo>
                  <a:pt x="1636" y="288"/>
                  <a:pt x="1617" y="274"/>
                  <a:pt x="1599" y="256"/>
                </a:cubicBezTo>
                <a:cubicBezTo>
                  <a:pt x="1581" y="238"/>
                  <a:pt x="1567" y="220"/>
                  <a:pt x="1558" y="201"/>
                </a:cubicBezTo>
                <a:cubicBezTo>
                  <a:pt x="1548" y="182"/>
                  <a:pt x="1543" y="164"/>
                  <a:pt x="1542" y="145"/>
                </a:cubicBezTo>
                <a:cubicBezTo>
                  <a:pt x="1540" y="127"/>
                  <a:pt x="1543" y="109"/>
                  <a:pt x="1550" y="91"/>
                </a:cubicBezTo>
                <a:cubicBezTo>
                  <a:pt x="1557" y="74"/>
                  <a:pt x="1568" y="57"/>
                  <a:pt x="1583" y="42"/>
                </a:cubicBezTo>
                <a:cubicBezTo>
                  <a:pt x="1600" y="26"/>
                  <a:pt x="1616" y="15"/>
                  <a:pt x="1633" y="9"/>
                </a:cubicBezTo>
                <a:cubicBezTo>
                  <a:pt x="1649" y="2"/>
                  <a:pt x="1666" y="0"/>
                  <a:pt x="1682" y="1"/>
                </a:cubicBezTo>
                <a:cubicBezTo>
                  <a:pt x="1698" y="3"/>
                  <a:pt x="1713" y="8"/>
                  <a:pt x="1729" y="16"/>
                </a:cubicBezTo>
                <a:cubicBezTo>
                  <a:pt x="1744" y="25"/>
                  <a:pt x="1758" y="36"/>
                  <a:pt x="1772" y="49"/>
                </a:cubicBezTo>
                <a:lnTo>
                  <a:pt x="1779" y="56"/>
                </a:lnTo>
                <a:close/>
                <a:moveTo>
                  <a:pt x="1729" y="83"/>
                </a:moveTo>
                <a:cubicBezTo>
                  <a:pt x="1710" y="62"/>
                  <a:pt x="1690" y="51"/>
                  <a:pt x="1669" y="49"/>
                </a:cubicBezTo>
                <a:cubicBezTo>
                  <a:pt x="1649" y="47"/>
                  <a:pt x="1629" y="55"/>
                  <a:pt x="1611" y="74"/>
                </a:cubicBezTo>
                <a:cubicBezTo>
                  <a:pt x="1602" y="83"/>
                  <a:pt x="1595" y="93"/>
                  <a:pt x="1592" y="104"/>
                </a:cubicBezTo>
                <a:cubicBezTo>
                  <a:pt x="1588" y="114"/>
                  <a:pt x="1587" y="125"/>
                  <a:pt x="1588" y="135"/>
                </a:cubicBezTo>
                <a:cubicBezTo>
                  <a:pt x="1589" y="146"/>
                  <a:pt x="1592" y="156"/>
                  <a:pt x="1597" y="167"/>
                </a:cubicBezTo>
                <a:cubicBezTo>
                  <a:pt x="1602" y="177"/>
                  <a:pt x="1609" y="187"/>
                  <a:pt x="1617" y="195"/>
                </a:cubicBezTo>
                <a:lnTo>
                  <a:pt x="1729" y="83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382" name="Freeform 266"/>
          <p:cNvSpPr>
            <a:spLocks noEditPoints="1"/>
          </p:cNvSpPr>
          <p:nvPr/>
        </p:nvSpPr>
        <p:spPr bwMode="auto">
          <a:xfrm>
            <a:off x="5553133" y="4418880"/>
            <a:ext cx="429632" cy="479425"/>
          </a:xfrm>
          <a:custGeom>
            <a:avLst/>
            <a:gdLst>
              <a:gd name="T0" fmla="*/ 210 w 1352"/>
              <a:gd name="T1" fmla="*/ 1239 h 1258"/>
              <a:gd name="T2" fmla="*/ 60 w 1352"/>
              <a:gd name="T3" fmla="*/ 1128 h 1258"/>
              <a:gd name="T4" fmla="*/ 1 w 1352"/>
              <a:gd name="T5" fmla="*/ 1155 h 1258"/>
              <a:gd name="T6" fmla="*/ 243 w 1352"/>
              <a:gd name="T7" fmla="*/ 1018 h 1258"/>
              <a:gd name="T8" fmla="*/ 224 w 1352"/>
              <a:gd name="T9" fmla="*/ 1043 h 1258"/>
              <a:gd name="T10" fmla="*/ 288 w 1352"/>
              <a:gd name="T11" fmla="*/ 1165 h 1258"/>
              <a:gd name="T12" fmla="*/ 173 w 1352"/>
              <a:gd name="T13" fmla="*/ 1060 h 1258"/>
              <a:gd name="T14" fmla="*/ 203 w 1352"/>
              <a:gd name="T15" fmla="*/ 1034 h 1258"/>
              <a:gd name="T16" fmla="*/ 232 w 1352"/>
              <a:gd name="T17" fmla="*/ 1008 h 1258"/>
              <a:gd name="T18" fmla="*/ 414 w 1352"/>
              <a:gd name="T19" fmla="*/ 1118 h 1258"/>
              <a:gd name="T20" fmla="*/ 239 w 1352"/>
              <a:gd name="T21" fmla="*/ 996 h 1258"/>
              <a:gd name="T22" fmla="*/ 374 w 1352"/>
              <a:gd name="T23" fmla="*/ 1032 h 1258"/>
              <a:gd name="T24" fmla="*/ 341 w 1352"/>
              <a:gd name="T25" fmla="*/ 905 h 1258"/>
              <a:gd name="T26" fmla="*/ 497 w 1352"/>
              <a:gd name="T27" fmla="*/ 951 h 1258"/>
              <a:gd name="T28" fmla="*/ 511 w 1352"/>
              <a:gd name="T29" fmla="*/ 1023 h 1258"/>
              <a:gd name="T30" fmla="*/ 363 w 1352"/>
              <a:gd name="T31" fmla="*/ 869 h 1258"/>
              <a:gd name="T32" fmla="*/ 398 w 1352"/>
              <a:gd name="T33" fmla="*/ 833 h 1258"/>
              <a:gd name="T34" fmla="*/ 452 w 1352"/>
              <a:gd name="T35" fmla="*/ 835 h 1258"/>
              <a:gd name="T36" fmla="*/ 479 w 1352"/>
              <a:gd name="T37" fmla="*/ 934 h 1258"/>
              <a:gd name="T38" fmla="*/ 639 w 1352"/>
              <a:gd name="T39" fmla="*/ 808 h 1258"/>
              <a:gd name="T40" fmla="*/ 561 w 1352"/>
              <a:gd name="T41" fmla="*/ 825 h 1258"/>
              <a:gd name="T42" fmla="*/ 470 w 1352"/>
              <a:gd name="T43" fmla="*/ 763 h 1258"/>
              <a:gd name="T44" fmla="*/ 474 w 1352"/>
              <a:gd name="T45" fmla="*/ 705 h 1258"/>
              <a:gd name="T46" fmla="*/ 542 w 1352"/>
              <a:gd name="T47" fmla="*/ 708 h 1258"/>
              <a:gd name="T48" fmla="*/ 620 w 1352"/>
              <a:gd name="T49" fmla="*/ 800 h 1258"/>
              <a:gd name="T50" fmla="*/ 729 w 1352"/>
              <a:gd name="T51" fmla="*/ 658 h 1258"/>
              <a:gd name="T52" fmla="*/ 588 w 1352"/>
              <a:gd name="T53" fmla="*/ 710 h 1258"/>
              <a:gd name="T54" fmla="*/ 690 w 1352"/>
              <a:gd name="T55" fmla="*/ 652 h 1258"/>
              <a:gd name="T56" fmla="*/ 626 w 1352"/>
              <a:gd name="T57" fmla="*/ 716 h 1258"/>
              <a:gd name="T58" fmla="*/ 690 w 1352"/>
              <a:gd name="T59" fmla="*/ 652 h 1258"/>
              <a:gd name="T60" fmla="*/ 813 w 1352"/>
              <a:gd name="T61" fmla="*/ 625 h 1258"/>
              <a:gd name="T62" fmla="*/ 835 w 1352"/>
              <a:gd name="T63" fmla="*/ 698 h 1258"/>
              <a:gd name="T64" fmla="*/ 696 w 1352"/>
              <a:gd name="T65" fmla="*/ 537 h 1258"/>
              <a:gd name="T66" fmla="*/ 735 w 1352"/>
              <a:gd name="T67" fmla="*/ 494 h 1258"/>
              <a:gd name="T68" fmla="*/ 763 w 1352"/>
              <a:gd name="T69" fmla="*/ 505 h 1258"/>
              <a:gd name="T70" fmla="*/ 827 w 1352"/>
              <a:gd name="T71" fmla="*/ 596 h 1258"/>
              <a:gd name="T72" fmla="*/ 1002 w 1352"/>
              <a:gd name="T73" fmla="*/ 451 h 1258"/>
              <a:gd name="T74" fmla="*/ 895 w 1352"/>
              <a:gd name="T75" fmla="*/ 383 h 1258"/>
              <a:gd name="T76" fmla="*/ 932 w 1352"/>
              <a:gd name="T77" fmla="*/ 521 h 1258"/>
              <a:gd name="T78" fmla="*/ 760 w 1352"/>
              <a:gd name="T79" fmla="*/ 374 h 1258"/>
              <a:gd name="T80" fmla="*/ 846 w 1352"/>
              <a:gd name="T81" fmla="*/ 392 h 1258"/>
              <a:gd name="T82" fmla="*/ 1118 w 1352"/>
              <a:gd name="T83" fmla="*/ 332 h 1258"/>
              <a:gd name="T84" fmla="*/ 1073 w 1352"/>
              <a:gd name="T85" fmla="*/ 383 h 1258"/>
              <a:gd name="T86" fmla="*/ 1023 w 1352"/>
              <a:gd name="T87" fmla="*/ 302 h 1258"/>
              <a:gd name="T88" fmla="*/ 964 w 1352"/>
              <a:gd name="T89" fmla="*/ 306 h 1258"/>
              <a:gd name="T90" fmla="*/ 942 w 1352"/>
              <a:gd name="T91" fmla="*/ 309 h 1258"/>
              <a:gd name="T92" fmla="*/ 1047 w 1352"/>
              <a:gd name="T93" fmla="*/ 260 h 1258"/>
              <a:gd name="T94" fmla="*/ 1042 w 1352"/>
              <a:gd name="T95" fmla="*/ 375 h 1258"/>
              <a:gd name="T96" fmla="*/ 1239 w 1352"/>
              <a:gd name="T97" fmla="*/ 213 h 1258"/>
              <a:gd name="T98" fmla="*/ 1133 w 1352"/>
              <a:gd name="T99" fmla="*/ 145 h 1258"/>
              <a:gd name="T100" fmla="*/ 1169 w 1352"/>
              <a:gd name="T101" fmla="*/ 283 h 1258"/>
              <a:gd name="T102" fmla="*/ 1048 w 1352"/>
              <a:gd name="T103" fmla="*/ 186 h 1258"/>
              <a:gd name="T104" fmla="*/ 1083 w 1352"/>
              <a:gd name="T105" fmla="*/ 156 h 1258"/>
              <a:gd name="T106" fmla="*/ 1310 w 1352"/>
              <a:gd name="T107" fmla="*/ 37 h 1258"/>
              <a:gd name="T108" fmla="*/ 1329 w 1352"/>
              <a:gd name="T109" fmla="*/ 88 h 1258"/>
              <a:gd name="T110" fmla="*/ 1351 w 1352"/>
              <a:gd name="T111" fmla="*/ 83 h 1258"/>
              <a:gd name="T112" fmla="*/ 1271 w 1352"/>
              <a:gd name="T113" fmla="*/ 157 h 1258"/>
              <a:gd name="T114" fmla="*/ 1257 w 1352"/>
              <a:gd name="T115" fmla="*/ 1 h 1258"/>
              <a:gd name="T116" fmla="*/ 1210 w 1352"/>
              <a:gd name="T117" fmla="*/ 68 h 12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1352" h="1258">
                <a:moveTo>
                  <a:pt x="117" y="1054"/>
                </a:moveTo>
                <a:cubicBezTo>
                  <a:pt x="119" y="1056"/>
                  <a:pt x="120" y="1057"/>
                  <a:pt x="121" y="1058"/>
                </a:cubicBezTo>
                <a:cubicBezTo>
                  <a:pt x="122" y="1060"/>
                  <a:pt x="122" y="1061"/>
                  <a:pt x="123" y="1062"/>
                </a:cubicBezTo>
                <a:cubicBezTo>
                  <a:pt x="123" y="1063"/>
                  <a:pt x="123" y="1064"/>
                  <a:pt x="123" y="1064"/>
                </a:cubicBezTo>
                <a:cubicBezTo>
                  <a:pt x="123" y="1065"/>
                  <a:pt x="122" y="1066"/>
                  <a:pt x="122" y="1067"/>
                </a:cubicBezTo>
                <a:lnTo>
                  <a:pt x="80" y="1108"/>
                </a:lnTo>
                <a:lnTo>
                  <a:pt x="209" y="1237"/>
                </a:lnTo>
                <a:cubicBezTo>
                  <a:pt x="209" y="1238"/>
                  <a:pt x="210" y="1238"/>
                  <a:pt x="210" y="1239"/>
                </a:cubicBezTo>
                <a:cubicBezTo>
                  <a:pt x="210" y="1240"/>
                  <a:pt x="210" y="1241"/>
                  <a:pt x="209" y="1242"/>
                </a:cubicBezTo>
                <a:cubicBezTo>
                  <a:pt x="209" y="1243"/>
                  <a:pt x="208" y="1244"/>
                  <a:pt x="207" y="1245"/>
                </a:cubicBezTo>
                <a:cubicBezTo>
                  <a:pt x="206" y="1247"/>
                  <a:pt x="204" y="1249"/>
                  <a:pt x="202" y="1250"/>
                </a:cubicBezTo>
                <a:cubicBezTo>
                  <a:pt x="201" y="1252"/>
                  <a:pt x="199" y="1254"/>
                  <a:pt x="197" y="1255"/>
                </a:cubicBezTo>
                <a:cubicBezTo>
                  <a:pt x="196" y="1256"/>
                  <a:pt x="195" y="1257"/>
                  <a:pt x="194" y="1257"/>
                </a:cubicBezTo>
                <a:cubicBezTo>
                  <a:pt x="193" y="1258"/>
                  <a:pt x="192" y="1258"/>
                  <a:pt x="191" y="1258"/>
                </a:cubicBezTo>
                <a:cubicBezTo>
                  <a:pt x="190" y="1258"/>
                  <a:pt x="189" y="1257"/>
                  <a:pt x="189" y="1257"/>
                </a:cubicBezTo>
                <a:lnTo>
                  <a:pt x="60" y="1128"/>
                </a:lnTo>
                <a:lnTo>
                  <a:pt x="19" y="1170"/>
                </a:lnTo>
                <a:cubicBezTo>
                  <a:pt x="18" y="1170"/>
                  <a:pt x="17" y="1171"/>
                  <a:pt x="16" y="1171"/>
                </a:cubicBezTo>
                <a:cubicBezTo>
                  <a:pt x="16" y="1171"/>
                  <a:pt x="15" y="1171"/>
                  <a:pt x="14" y="1171"/>
                </a:cubicBezTo>
                <a:cubicBezTo>
                  <a:pt x="13" y="1170"/>
                  <a:pt x="12" y="1170"/>
                  <a:pt x="10" y="1169"/>
                </a:cubicBezTo>
                <a:cubicBezTo>
                  <a:pt x="9" y="1168"/>
                  <a:pt x="8" y="1167"/>
                  <a:pt x="6" y="1165"/>
                </a:cubicBezTo>
                <a:cubicBezTo>
                  <a:pt x="5" y="1164"/>
                  <a:pt x="4" y="1163"/>
                  <a:pt x="3" y="1161"/>
                </a:cubicBezTo>
                <a:cubicBezTo>
                  <a:pt x="2" y="1160"/>
                  <a:pt x="1" y="1159"/>
                  <a:pt x="1" y="1158"/>
                </a:cubicBezTo>
                <a:cubicBezTo>
                  <a:pt x="0" y="1157"/>
                  <a:pt x="0" y="1156"/>
                  <a:pt x="1" y="1155"/>
                </a:cubicBezTo>
                <a:cubicBezTo>
                  <a:pt x="1" y="1154"/>
                  <a:pt x="1" y="1154"/>
                  <a:pt x="2" y="1153"/>
                </a:cubicBezTo>
                <a:lnTo>
                  <a:pt x="105" y="1050"/>
                </a:lnTo>
                <a:cubicBezTo>
                  <a:pt x="106" y="1049"/>
                  <a:pt x="106" y="1049"/>
                  <a:pt x="107" y="1049"/>
                </a:cubicBezTo>
                <a:cubicBezTo>
                  <a:pt x="108" y="1048"/>
                  <a:pt x="109" y="1049"/>
                  <a:pt x="110" y="1049"/>
                </a:cubicBezTo>
                <a:cubicBezTo>
                  <a:pt x="111" y="1049"/>
                  <a:pt x="112" y="1050"/>
                  <a:pt x="113" y="1051"/>
                </a:cubicBezTo>
                <a:cubicBezTo>
                  <a:pt x="115" y="1052"/>
                  <a:pt x="116" y="1053"/>
                  <a:pt x="117" y="1054"/>
                </a:cubicBezTo>
                <a:close/>
                <a:moveTo>
                  <a:pt x="239" y="1014"/>
                </a:moveTo>
                <a:cubicBezTo>
                  <a:pt x="241" y="1016"/>
                  <a:pt x="242" y="1017"/>
                  <a:pt x="243" y="1018"/>
                </a:cubicBezTo>
                <a:cubicBezTo>
                  <a:pt x="244" y="1019"/>
                  <a:pt x="245" y="1021"/>
                  <a:pt x="245" y="1021"/>
                </a:cubicBezTo>
                <a:cubicBezTo>
                  <a:pt x="246" y="1022"/>
                  <a:pt x="246" y="1023"/>
                  <a:pt x="246" y="1024"/>
                </a:cubicBezTo>
                <a:cubicBezTo>
                  <a:pt x="246" y="1024"/>
                  <a:pt x="246" y="1025"/>
                  <a:pt x="245" y="1026"/>
                </a:cubicBezTo>
                <a:cubicBezTo>
                  <a:pt x="245" y="1026"/>
                  <a:pt x="244" y="1027"/>
                  <a:pt x="242" y="1027"/>
                </a:cubicBezTo>
                <a:cubicBezTo>
                  <a:pt x="241" y="1028"/>
                  <a:pt x="240" y="1029"/>
                  <a:pt x="238" y="1029"/>
                </a:cubicBezTo>
                <a:cubicBezTo>
                  <a:pt x="237" y="1030"/>
                  <a:pt x="235" y="1031"/>
                  <a:pt x="234" y="1032"/>
                </a:cubicBezTo>
                <a:cubicBezTo>
                  <a:pt x="232" y="1033"/>
                  <a:pt x="230" y="1035"/>
                  <a:pt x="229" y="1036"/>
                </a:cubicBezTo>
                <a:cubicBezTo>
                  <a:pt x="227" y="1038"/>
                  <a:pt x="225" y="1040"/>
                  <a:pt x="224" y="1043"/>
                </a:cubicBezTo>
                <a:cubicBezTo>
                  <a:pt x="223" y="1046"/>
                  <a:pt x="223" y="1049"/>
                  <a:pt x="222" y="1052"/>
                </a:cubicBezTo>
                <a:cubicBezTo>
                  <a:pt x="222" y="1056"/>
                  <a:pt x="222" y="1061"/>
                  <a:pt x="223" y="1066"/>
                </a:cubicBezTo>
                <a:cubicBezTo>
                  <a:pt x="224" y="1071"/>
                  <a:pt x="225" y="1077"/>
                  <a:pt x="226" y="1084"/>
                </a:cubicBezTo>
                <a:lnTo>
                  <a:pt x="294" y="1152"/>
                </a:lnTo>
                <a:cubicBezTo>
                  <a:pt x="295" y="1152"/>
                  <a:pt x="295" y="1153"/>
                  <a:pt x="295" y="1154"/>
                </a:cubicBezTo>
                <a:cubicBezTo>
                  <a:pt x="295" y="1154"/>
                  <a:pt x="295" y="1155"/>
                  <a:pt x="295" y="1156"/>
                </a:cubicBezTo>
                <a:cubicBezTo>
                  <a:pt x="294" y="1157"/>
                  <a:pt x="294" y="1158"/>
                  <a:pt x="293" y="1160"/>
                </a:cubicBezTo>
                <a:cubicBezTo>
                  <a:pt x="291" y="1161"/>
                  <a:pt x="290" y="1163"/>
                  <a:pt x="288" y="1165"/>
                </a:cubicBezTo>
                <a:cubicBezTo>
                  <a:pt x="286" y="1167"/>
                  <a:pt x="285" y="1168"/>
                  <a:pt x="283" y="1169"/>
                </a:cubicBezTo>
                <a:cubicBezTo>
                  <a:pt x="282" y="1170"/>
                  <a:pt x="281" y="1171"/>
                  <a:pt x="280" y="1171"/>
                </a:cubicBezTo>
                <a:cubicBezTo>
                  <a:pt x="279" y="1172"/>
                  <a:pt x="278" y="1172"/>
                  <a:pt x="277" y="1172"/>
                </a:cubicBezTo>
                <a:cubicBezTo>
                  <a:pt x="276" y="1172"/>
                  <a:pt x="276" y="1171"/>
                  <a:pt x="275" y="1171"/>
                </a:cubicBezTo>
                <a:lnTo>
                  <a:pt x="172" y="1067"/>
                </a:lnTo>
                <a:cubicBezTo>
                  <a:pt x="171" y="1067"/>
                  <a:pt x="171" y="1066"/>
                  <a:pt x="171" y="1066"/>
                </a:cubicBezTo>
                <a:cubicBezTo>
                  <a:pt x="171" y="1065"/>
                  <a:pt x="171" y="1064"/>
                  <a:pt x="171" y="1063"/>
                </a:cubicBezTo>
                <a:cubicBezTo>
                  <a:pt x="171" y="1062"/>
                  <a:pt x="172" y="1061"/>
                  <a:pt x="173" y="1060"/>
                </a:cubicBezTo>
                <a:cubicBezTo>
                  <a:pt x="174" y="1059"/>
                  <a:pt x="175" y="1057"/>
                  <a:pt x="177" y="1055"/>
                </a:cubicBezTo>
                <a:cubicBezTo>
                  <a:pt x="179" y="1054"/>
                  <a:pt x="180" y="1052"/>
                  <a:pt x="181" y="1051"/>
                </a:cubicBezTo>
                <a:cubicBezTo>
                  <a:pt x="183" y="1050"/>
                  <a:pt x="184" y="1050"/>
                  <a:pt x="185" y="1049"/>
                </a:cubicBezTo>
                <a:cubicBezTo>
                  <a:pt x="186" y="1049"/>
                  <a:pt x="186" y="1049"/>
                  <a:pt x="187" y="1049"/>
                </a:cubicBezTo>
                <a:cubicBezTo>
                  <a:pt x="188" y="1049"/>
                  <a:pt x="188" y="1050"/>
                  <a:pt x="189" y="1050"/>
                </a:cubicBezTo>
                <a:lnTo>
                  <a:pt x="204" y="1065"/>
                </a:lnTo>
                <a:cubicBezTo>
                  <a:pt x="203" y="1058"/>
                  <a:pt x="202" y="1052"/>
                  <a:pt x="202" y="1047"/>
                </a:cubicBezTo>
                <a:cubicBezTo>
                  <a:pt x="202" y="1042"/>
                  <a:pt x="202" y="1038"/>
                  <a:pt x="203" y="1034"/>
                </a:cubicBezTo>
                <a:cubicBezTo>
                  <a:pt x="204" y="1030"/>
                  <a:pt x="205" y="1027"/>
                  <a:pt x="206" y="1024"/>
                </a:cubicBezTo>
                <a:cubicBezTo>
                  <a:pt x="208" y="1022"/>
                  <a:pt x="210" y="1019"/>
                  <a:pt x="212" y="1017"/>
                </a:cubicBezTo>
                <a:cubicBezTo>
                  <a:pt x="213" y="1016"/>
                  <a:pt x="214" y="1015"/>
                  <a:pt x="216" y="1014"/>
                </a:cubicBezTo>
                <a:cubicBezTo>
                  <a:pt x="217" y="1013"/>
                  <a:pt x="219" y="1012"/>
                  <a:pt x="220" y="1010"/>
                </a:cubicBezTo>
                <a:cubicBezTo>
                  <a:pt x="222" y="1009"/>
                  <a:pt x="224" y="1008"/>
                  <a:pt x="225" y="1008"/>
                </a:cubicBezTo>
                <a:cubicBezTo>
                  <a:pt x="226" y="1007"/>
                  <a:pt x="228" y="1007"/>
                  <a:pt x="228" y="1007"/>
                </a:cubicBezTo>
                <a:cubicBezTo>
                  <a:pt x="229" y="1006"/>
                  <a:pt x="230" y="1007"/>
                  <a:pt x="230" y="1007"/>
                </a:cubicBezTo>
                <a:cubicBezTo>
                  <a:pt x="231" y="1007"/>
                  <a:pt x="232" y="1007"/>
                  <a:pt x="232" y="1008"/>
                </a:cubicBezTo>
                <a:cubicBezTo>
                  <a:pt x="233" y="1008"/>
                  <a:pt x="234" y="1009"/>
                  <a:pt x="235" y="1010"/>
                </a:cubicBezTo>
                <a:cubicBezTo>
                  <a:pt x="236" y="1011"/>
                  <a:pt x="237" y="1012"/>
                  <a:pt x="239" y="1014"/>
                </a:cubicBezTo>
                <a:close/>
                <a:moveTo>
                  <a:pt x="407" y="1044"/>
                </a:moveTo>
                <a:lnTo>
                  <a:pt x="431" y="1096"/>
                </a:lnTo>
                <a:cubicBezTo>
                  <a:pt x="432" y="1098"/>
                  <a:pt x="432" y="1100"/>
                  <a:pt x="431" y="1102"/>
                </a:cubicBezTo>
                <a:cubicBezTo>
                  <a:pt x="429" y="1105"/>
                  <a:pt x="427" y="1108"/>
                  <a:pt x="423" y="1112"/>
                </a:cubicBezTo>
                <a:cubicBezTo>
                  <a:pt x="421" y="1114"/>
                  <a:pt x="419" y="1115"/>
                  <a:pt x="418" y="1116"/>
                </a:cubicBezTo>
                <a:cubicBezTo>
                  <a:pt x="416" y="1118"/>
                  <a:pt x="415" y="1118"/>
                  <a:pt x="414" y="1118"/>
                </a:cubicBezTo>
                <a:cubicBezTo>
                  <a:pt x="413" y="1119"/>
                  <a:pt x="412" y="1118"/>
                  <a:pt x="411" y="1118"/>
                </a:cubicBezTo>
                <a:cubicBezTo>
                  <a:pt x="410" y="1117"/>
                  <a:pt x="410" y="1116"/>
                  <a:pt x="409" y="1114"/>
                </a:cubicBezTo>
                <a:lnTo>
                  <a:pt x="387" y="1064"/>
                </a:lnTo>
                <a:cubicBezTo>
                  <a:pt x="386" y="1065"/>
                  <a:pt x="385" y="1065"/>
                  <a:pt x="384" y="1065"/>
                </a:cubicBezTo>
                <a:cubicBezTo>
                  <a:pt x="383" y="1065"/>
                  <a:pt x="381" y="1064"/>
                  <a:pt x="380" y="1064"/>
                </a:cubicBezTo>
                <a:lnTo>
                  <a:pt x="245" y="1002"/>
                </a:lnTo>
                <a:cubicBezTo>
                  <a:pt x="243" y="1001"/>
                  <a:pt x="241" y="1000"/>
                  <a:pt x="240" y="999"/>
                </a:cubicBezTo>
                <a:cubicBezTo>
                  <a:pt x="239" y="998"/>
                  <a:pt x="239" y="997"/>
                  <a:pt x="239" y="996"/>
                </a:cubicBezTo>
                <a:cubicBezTo>
                  <a:pt x="239" y="995"/>
                  <a:pt x="240" y="993"/>
                  <a:pt x="241" y="992"/>
                </a:cubicBezTo>
                <a:cubicBezTo>
                  <a:pt x="242" y="990"/>
                  <a:pt x="244" y="988"/>
                  <a:pt x="246" y="986"/>
                </a:cubicBezTo>
                <a:cubicBezTo>
                  <a:pt x="249" y="984"/>
                  <a:pt x="250" y="982"/>
                  <a:pt x="252" y="981"/>
                </a:cubicBezTo>
                <a:cubicBezTo>
                  <a:pt x="253" y="980"/>
                  <a:pt x="254" y="979"/>
                  <a:pt x="255" y="978"/>
                </a:cubicBezTo>
                <a:cubicBezTo>
                  <a:pt x="257" y="978"/>
                  <a:pt x="258" y="978"/>
                  <a:pt x="258" y="978"/>
                </a:cubicBezTo>
                <a:cubicBezTo>
                  <a:pt x="259" y="978"/>
                  <a:pt x="261" y="979"/>
                  <a:pt x="262" y="979"/>
                </a:cubicBezTo>
                <a:lnTo>
                  <a:pt x="374" y="1033"/>
                </a:lnTo>
                <a:lnTo>
                  <a:pt x="374" y="1032"/>
                </a:lnTo>
                <a:lnTo>
                  <a:pt x="320" y="921"/>
                </a:lnTo>
                <a:cubicBezTo>
                  <a:pt x="319" y="919"/>
                  <a:pt x="318" y="917"/>
                  <a:pt x="319" y="916"/>
                </a:cubicBezTo>
                <a:cubicBezTo>
                  <a:pt x="319" y="915"/>
                  <a:pt x="319" y="914"/>
                  <a:pt x="321" y="912"/>
                </a:cubicBezTo>
                <a:cubicBezTo>
                  <a:pt x="322" y="911"/>
                  <a:pt x="323" y="909"/>
                  <a:pt x="326" y="906"/>
                </a:cubicBezTo>
                <a:cubicBezTo>
                  <a:pt x="328" y="904"/>
                  <a:pt x="330" y="903"/>
                  <a:pt x="331" y="901"/>
                </a:cubicBezTo>
                <a:cubicBezTo>
                  <a:pt x="333" y="900"/>
                  <a:pt x="334" y="900"/>
                  <a:pt x="336" y="899"/>
                </a:cubicBezTo>
                <a:cubicBezTo>
                  <a:pt x="337" y="899"/>
                  <a:pt x="338" y="900"/>
                  <a:pt x="339" y="901"/>
                </a:cubicBezTo>
                <a:cubicBezTo>
                  <a:pt x="340" y="902"/>
                  <a:pt x="341" y="903"/>
                  <a:pt x="341" y="905"/>
                </a:cubicBezTo>
                <a:lnTo>
                  <a:pt x="407" y="1044"/>
                </a:lnTo>
                <a:close/>
                <a:moveTo>
                  <a:pt x="504" y="836"/>
                </a:moveTo>
                <a:cubicBezTo>
                  <a:pt x="513" y="845"/>
                  <a:pt x="520" y="854"/>
                  <a:pt x="525" y="863"/>
                </a:cubicBezTo>
                <a:cubicBezTo>
                  <a:pt x="530" y="872"/>
                  <a:pt x="533" y="881"/>
                  <a:pt x="535" y="890"/>
                </a:cubicBezTo>
                <a:cubicBezTo>
                  <a:pt x="536" y="899"/>
                  <a:pt x="535" y="907"/>
                  <a:pt x="532" y="916"/>
                </a:cubicBezTo>
                <a:cubicBezTo>
                  <a:pt x="529" y="924"/>
                  <a:pt x="524" y="932"/>
                  <a:pt x="517" y="939"/>
                </a:cubicBezTo>
                <a:cubicBezTo>
                  <a:pt x="514" y="942"/>
                  <a:pt x="511" y="944"/>
                  <a:pt x="508" y="946"/>
                </a:cubicBezTo>
                <a:cubicBezTo>
                  <a:pt x="504" y="948"/>
                  <a:pt x="501" y="950"/>
                  <a:pt x="497" y="951"/>
                </a:cubicBezTo>
                <a:cubicBezTo>
                  <a:pt x="493" y="952"/>
                  <a:pt x="489" y="953"/>
                  <a:pt x="485" y="954"/>
                </a:cubicBezTo>
                <a:cubicBezTo>
                  <a:pt x="480" y="954"/>
                  <a:pt x="476" y="954"/>
                  <a:pt x="470" y="954"/>
                </a:cubicBezTo>
                <a:lnTo>
                  <a:pt x="522" y="1006"/>
                </a:lnTo>
                <a:cubicBezTo>
                  <a:pt x="522" y="1007"/>
                  <a:pt x="523" y="1007"/>
                  <a:pt x="523" y="1008"/>
                </a:cubicBezTo>
                <a:cubicBezTo>
                  <a:pt x="523" y="1009"/>
                  <a:pt x="523" y="1010"/>
                  <a:pt x="522" y="1011"/>
                </a:cubicBezTo>
                <a:cubicBezTo>
                  <a:pt x="522" y="1012"/>
                  <a:pt x="521" y="1013"/>
                  <a:pt x="520" y="1014"/>
                </a:cubicBezTo>
                <a:cubicBezTo>
                  <a:pt x="519" y="1016"/>
                  <a:pt x="518" y="1017"/>
                  <a:pt x="516" y="1019"/>
                </a:cubicBezTo>
                <a:cubicBezTo>
                  <a:pt x="514" y="1021"/>
                  <a:pt x="512" y="1022"/>
                  <a:pt x="511" y="1023"/>
                </a:cubicBezTo>
                <a:cubicBezTo>
                  <a:pt x="510" y="1025"/>
                  <a:pt x="508" y="1025"/>
                  <a:pt x="507" y="1026"/>
                </a:cubicBezTo>
                <a:cubicBezTo>
                  <a:pt x="506" y="1026"/>
                  <a:pt x="505" y="1026"/>
                  <a:pt x="505" y="1026"/>
                </a:cubicBezTo>
                <a:cubicBezTo>
                  <a:pt x="504" y="1026"/>
                  <a:pt x="503" y="1025"/>
                  <a:pt x="503" y="1025"/>
                </a:cubicBezTo>
                <a:lnTo>
                  <a:pt x="359" y="881"/>
                </a:lnTo>
                <a:cubicBezTo>
                  <a:pt x="358" y="880"/>
                  <a:pt x="358" y="879"/>
                  <a:pt x="357" y="879"/>
                </a:cubicBezTo>
                <a:cubicBezTo>
                  <a:pt x="357" y="878"/>
                  <a:pt x="357" y="877"/>
                  <a:pt x="358" y="876"/>
                </a:cubicBezTo>
                <a:cubicBezTo>
                  <a:pt x="358" y="875"/>
                  <a:pt x="359" y="874"/>
                  <a:pt x="360" y="873"/>
                </a:cubicBezTo>
                <a:cubicBezTo>
                  <a:pt x="361" y="872"/>
                  <a:pt x="362" y="870"/>
                  <a:pt x="363" y="869"/>
                </a:cubicBezTo>
                <a:cubicBezTo>
                  <a:pt x="365" y="867"/>
                  <a:pt x="366" y="866"/>
                  <a:pt x="367" y="865"/>
                </a:cubicBezTo>
                <a:cubicBezTo>
                  <a:pt x="369" y="864"/>
                  <a:pt x="370" y="864"/>
                  <a:pt x="371" y="863"/>
                </a:cubicBezTo>
                <a:cubicBezTo>
                  <a:pt x="372" y="863"/>
                  <a:pt x="373" y="863"/>
                  <a:pt x="373" y="863"/>
                </a:cubicBezTo>
                <a:cubicBezTo>
                  <a:pt x="374" y="863"/>
                  <a:pt x="375" y="863"/>
                  <a:pt x="375" y="864"/>
                </a:cubicBezTo>
                <a:lnTo>
                  <a:pt x="389" y="878"/>
                </a:lnTo>
                <a:cubicBezTo>
                  <a:pt x="389" y="872"/>
                  <a:pt x="389" y="866"/>
                  <a:pt x="390" y="861"/>
                </a:cubicBezTo>
                <a:cubicBezTo>
                  <a:pt x="390" y="855"/>
                  <a:pt x="391" y="850"/>
                  <a:pt x="393" y="846"/>
                </a:cubicBezTo>
                <a:cubicBezTo>
                  <a:pt x="394" y="841"/>
                  <a:pt x="396" y="837"/>
                  <a:pt x="398" y="833"/>
                </a:cubicBezTo>
                <a:cubicBezTo>
                  <a:pt x="400" y="829"/>
                  <a:pt x="403" y="826"/>
                  <a:pt x="407" y="822"/>
                </a:cubicBezTo>
                <a:cubicBezTo>
                  <a:pt x="414" y="815"/>
                  <a:pt x="422" y="810"/>
                  <a:pt x="430" y="808"/>
                </a:cubicBezTo>
                <a:cubicBezTo>
                  <a:pt x="438" y="805"/>
                  <a:pt x="447" y="805"/>
                  <a:pt x="455" y="807"/>
                </a:cubicBezTo>
                <a:cubicBezTo>
                  <a:pt x="463" y="808"/>
                  <a:pt x="472" y="812"/>
                  <a:pt x="480" y="817"/>
                </a:cubicBezTo>
                <a:cubicBezTo>
                  <a:pt x="488" y="822"/>
                  <a:pt x="496" y="828"/>
                  <a:pt x="504" y="836"/>
                </a:cubicBezTo>
                <a:close/>
                <a:moveTo>
                  <a:pt x="486" y="858"/>
                </a:moveTo>
                <a:cubicBezTo>
                  <a:pt x="481" y="852"/>
                  <a:pt x="475" y="848"/>
                  <a:pt x="470" y="844"/>
                </a:cubicBezTo>
                <a:cubicBezTo>
                  <a:pt x="464" y="839"/>
                  <a:pt x="458" y="836"/>
                  <a:pt x="452" y="835"/>
                </a:cubicBezTo>
                <a:cubicBezTo>
                  <a:pt x="447" y="833"/>
                  <a:pt x="441" y="832"/>
                  <a:pt x="435" y="833"/>
                </a:cubicBezTo>
                <a:cubicBezTo>
                  <a:pt x="430" y="834"/>
                  <a:pt x="424" y="837"/>
                  <a:pt x="419" y="842"/>
                </a:cubicBezTo>
                <a:cubicBezTo>
                  <a:pt x="417" y="845"/>
                  <a:pt x="415" y="847"/>
                  <a:pt x="413" y="851"/>
                </a:cubicBezTo>
                <a:cubicBezTo>
                  <a:pt x="412" y="854"/>
                  <a:pt x="410" y="857"/>
                  <a:pt x="409" y="861"/>
                </a:cubicBezTo>
                <a:cubicBezTo>
                  <a:pt x="409" y="865"/>
                  <a:pt x="408" y="870"/>
                  <a:pt x="408" y="875"/>
                </a:cubicBezTo>
                <a:cubicBezTo>
                  <a:pt x="408" y="880"/>
                  <a:pt x="408" y="886"/>
                  <a:pt x="409" y="893"/>
                </a:cubicBezTo>
                <a:lnTo>
                  <a:pt x="450" y="934"/>
                </a:lnTo>
                <a:cubicBezTo>
                  <a:pt x="461" y="935"/>
                  <a:pt x="471" y="935"/>
                  <a:pt x="479" y="934"/>
                </a:cubicBezTo>
                <a:cubicBezTo>
                  <a:pt x="487" y="933"/>
                  <a:pt x="494" y="929"/>
                  <a:pt x="499" y="924"/>
                </a:cubicBezTo>
                <a:cubicBezTo>
                  <a:pt x="504" y="919"/>
                  <a:pt x="507" y="914"/>
                  <a:pt x="508" y="908"/>
                </a:cubicBezTo>
                <a:cubicBezTo>
                  <a:pt x="509" y="903"/>
                  <a:pt x="509" y="897"/>
                  <a:pt x="507" y="891"/>
                </a:cubicBezTo>
                <a:cubicBezTo>
                  <a:pt x="505" y="885"/>
                  <a:pt x="503" y="879"/>
                  <a:pt x="499" y="873"/>
                </a:cubicBezTo>
                <a:cubicBezTo>
                  <a:pt x="495" y="868"/>
                  <a:pt x="491" y="862"/>
                  <a:pt x="486" y="858"/>
                </a:cubicBezTo>
                <a:close/>
                <a:moveTo>
                  <a:pt x="632" y="798"/>
                </a:moveTo>
                <a:cubicBezTo>
                  <a:pt x="635" y="800"/>
                  <a:pt x="636" y="802"/>
                  <a:pt x="637" y="804"/>
                </a:cubicBezTo>
                <a:cubicBezTo>
                  <a:pt x="638" y="806"/>
                  <a:pt x="639" y="807"/>
                  <a:pt x="639" y="808"/>
                </a:cubicBezTo>
                <a:cubicBezTo>
                  <a:pt x="639" y="809"/>
                  <a:pt x="638" y="811"/>
                  <a:pt x="638" y="813"/>
                </a:cubicBezTo>
                <a:cubicBezTo>
                  <a:pt x="637" y="814"/>
                  <a:pt x="636" y="816"/>
                  <a:pt x="635" y="818"/>
                </a:cubicBezTo>
                <a:cubicBezTo>
                  <a:pt x="634" y="820"/>
                  <a:pt x="632" y="822"/>
                  <a:pt x="631" y="824"/>
                </a:cubicBezTo>
                <a:cubicBezTo>
                  <a:pt x="629" y="826"/>
                  <a:pt x="627" y="828"/>
                  <a:pt x="626" y="830"/>
                </a:cubicBezTo>
                <a:cubicBezTo>
                  <a:pt x="620" y="835"/>
                  <a:pt x="615" y="839"/>
                  <a:pt x="610" y="841"/>
                </a:cubicBezTo>
                <a:cubicBezTo>
                  <a:pt x="605" y="844"/>
                  <a:pt x="599" y="845"/>
                  <a:pt x="594" y="844"/>
                </a:cubicBezTo>
                <a:cubicBezTo>
                  <a:pt x="589" y="844"/>
                  <a:pt x="583" y="842"/>
                  <a:pt x="578" y="839"/>
                </a:cubicBezTo>
                <a:cubicBezTo>
                  <a:pt x="572" y="835"/>
                  <a:pt x="567" y="831"/>
                  <a:pt x="561" y="825"/>
                </a:cubicBezTo>
                <a:lnTo>
                  <a:pt x="500" y="765"/>
                </a:lnTo>
                <a:lnTo>
                  <a:pt x="486" y="779"/>
                </a:lnTo>
                <a:cubicBezTo>
                  <a:pt x="485" y="780"/>
                  <a:pt x="483" y="780"/>
                  <a:pt x="481" y="780"/>
                </a:cubicBezTo>
                <a:cubicBezTo>
                  <a:pt x="479" y="779"/>
                  <a:pt x="477" y="778"/>
                  <a:pt x="474" y="775"/>
                </a:cubicBezTo>
                <a:cubicBezTo>
                  <a:pt x="473" y="774"/>
                  <a:pt x="472" y="772"/>
                  <a:pt x="471" y="771"/>
                </a:cubicBezTo>
                <a:cubicBezTo>
                  <a:pt x="470" y="770"/>
                  <a:pt x="470" y="769"/>
                  <a:pt x="469" y="768"/>
                </a:cubicBezTo>
                <a:cubicBezTo>
                  <a:pt x="469" y="767"/>
                  <a:pt x="469" y="766"/>
                  <a:pt x="469" y="765"/>
                </a:cubicBezTo>
                <a:cubicBezTo>
                  <a:pt x="469" y="764"/>
                  <a:pt x="470" y="764"/>
                  <a:pt x="470" y="763"/>
                </a:cubicBezTo>
                <a:lnTo>
                  <a:pt x="485" y="749"/>
                </a:lnTo>
                <a:lnTo>
                  <a:pt x="460" y="724"/>
                </a:lnTo>
                <a:cubicBezTo>
                  <a:pt x="460" y="724"/>
                  <a:pt x="459" y="723"/>
                  <a:pt x="459" y="722"/>
                </a:cubicBezTo>
                <a:cubicBezTo>
                  <a:pt x="459" y="722"/>
                  <a:pt x="459" y="721"/>
                  <a:pt x="459" y="720"/>
                </a:cubicBezTo>
                <a:cubicBezTo>
                  <a:pt x="460" y="719"/>
                  <a:pt x="460" y="717"/>
                  <a:pt x="461" y="716"/>
                </a:cubicBezTo>
                <a:cubicBezTo>
                  <a:pt x="463" y="715"/>
                  <a:pt x="464" y="713"/>
                  <a:pt x="466" y="711"/>
                </a:cubicBezTo>
                <a:cubicBezTo>
                  <a:pt x="468" y="709"/>
                  <a:pt x="469" y="708"/>
                  <a:pt x="471" y="707"/>
                </a:cubicBezTo>
                <a:cubicBezTo>
                  <a:pt x="472" y="706"/>
                  <a:pt x="473" y="705"/>
                  <a:pt x="474" y="705"/>
                </a:cubicBezTo>
                <a:cubicBezTo>
                  <a:pt x="475" y="704"/>
                  <a:pt x="476" y="704"/>
                  <a:pt x="477" y="704"/>
                </a:cubicBezTo>
                <a:cubicBezTo>
                  <a:pt x="478" y="705"/>
                  <a:pt x="478" y="705"/>
                  <a:pt x="479" y="705"/>
                </a:cubicBezTo>
                <a:lnTo>
                  <a:pt x="504" y="730"/>
                </a:lnTo>
                <a:lnTo>
                  <a:pt x="530" y="703"/>
                </a:lnTo>
                <a:cubicBezTo>
                  <a:pt x="531" y="703"/>
                  <a:pt x="531" y="702"/>
                  <a:pt x="532" y="702"/>
                </a:cubicBezTo>
                <a:cubicBezTo>
                  <a:pt x="533" y="702"/>
                  <a:pt x="534" y="702"/>
                  <a:pt x="535" y="702"/>
                </a:cubicBezTo>
                <a:cubicBezTo>
                  <a:pt x="536" y="703"/>
                  <a:pt x="537" y="703"/>
                  <a:pt x="538" y="704"/>
                </a:cubicBezTo>
                <a:cubicBezTo>
                  <a:pt x="539" y="705"/>
                  <a:pt x="540" y="706"/>
                  <a:pt x="542" y="708"/>
                </a:cubicBezTo>
                <a:cubicBezTo>
                  <a:pt x="544" y="710"/>
                  <a:pt x="546" y="713"/>
                  <a:pt x="547" y="715"/>
                </a:cubicBezTo>
                <a:cubicBezTo>
                  <a:pt x="547" y="716"/>
                  <a:pt x="547" y="718"/>
                  <a:pt x="546" y="719"/>
                </a:cubicBezTo>
                <a:lnTo>
                  <a:pt x="519" y="746"/>
                </a:lnTo>
                <a:lnTo>
                  <a:pt x="577" y="803"/>
                </a:lnTo>
                <a:cubicBezTo>
                  <a:pt x="584" y="810"/>
                  <a:pt x="590" y="815"/>
                  <a:pt x="596" y="816"/>
                </a:cubicBezTo>
                <a:cubicBezTo>
                  <a:pt x="602" y="818"/>
                  <a:pt x="607" y="816"/>
                  <a:pt x="613" y="810"/>
                </a:cubicBezTo>
                <a:cubicBezTo>
                  <a:pt x="615" y="809"/>
                  <a:pt x="616" y="807"/>
                  <a:pt x="617" y="805"/>
                </a:cubicBezTo>
                <a:cubicBezTo>
                  <a:pt x="618" y="803"/>
                  <a:pt x="619" y="802"/>
                  <a:pt x="620" y="800"/>
                </a:cubicBezTo>
                <a:cubicBezTo>
                  <a:pt x="620" y="799"/>
                  <a:pt x="621" y="798"/>
                  <a:pt x="621" y="796"/>
                </a:cubicBezTo>
                <a:cubicBezTo>
                  <a:pt x="622" y="795"/>
                  <a:pt x="622" y="795"/>
                  <a:pt x="623" y="794"/>
                </a:cubicBezTo>
                <a:cubicBezTo>
                  <a:pt x="623" y="794"/>
                  <a:pt x="624" y="793"/>
                  <a:pt x="624" y="793"/>
                </a:cubicBezTo>
                <a:cubicBezTo>
                  <a:pt x="625" y="793"/>
                  <a:pt x="625" y="793"/>
                  <a:pt x="626" y="793"/>
                </a:cubicBezTo>
                <a:cubicBezTo>
                  <a:pt x="627" y="794"/>
                  <a:pt x="628" y="794"/>
                  <a:pt x="629" y="795"/>
                </a:cubicBezTo>
                <a:cubicBezTo>
                  <a:pt x="630" y="796"/>
                  <a:pt x="631" y="797"/>
                  <a:pt x="632" y="798"/>
                </a:cubicBezTo>
                <a:close/>
                <a:moveTo>
                  <a:pt x="709" y="632"/>
                </a:moveTo>
                <a:cubicBezTo>
                  <a:pt x="717" y="640"/>
                  <a:pt x="724" y="649"/>
                  <a:pt x="729" y="658"/>
                </a:cubicBezTo>
                <a:cubicBezTo>
                  <a:pt x="733" y="667"/>
                  <a:pt x="736" y="677"/>
                  <a:pt x="737" y="686"/>
                </a:cubicBezTo>
                <a:cubicBezTo>
                  <a:pt x="738" y="696"/>
                  <a:pt x="736" y="705"/>
                  <a:pt x="732" y="715"/>
                </a:cubicBezTo>
                <a:cubicBezTo>
                  <a:pt x="729" y="724"/>
                  <a:pt x="722" y="733"/>
                  <a:pt x="714" y="742"/>
                </a:cubicBezTo>
                <a:cubicBezTo>
                  <a:pt x="705" y="751"/>
                  <a:pt x="697" y="757"/>
                  <a:pt x="688" y="761"/>
                </a:cubicBezTo>
                <a:cubicBezTo>
                  <a:pt x="679" y="764"/>
                  <a:pt x="670" y="766"/>
                  <a:pt x="661" y="765"/>
                </a:cubicBezTo>
                <a:cubicBezTo>
                  <a:pt x="652" y="765"/>
                  <a:pt x="643" y="762"/>
                  <a:pt x="634" y="757"/>
                </a:cubicBezTo>
                <a:cubicBezTo>
                  <a:pt x="625" y="752"/>
                  <a:pt x="616" y="746"/>
                  <a:pt x="608" y="737"/>
                </a:cubicBezTo>
                <a:cubicBezTo>
                  <a:pt x="599" y="728"/>
                  <a:pt x="593" y="720"/>
                  <a:pt x="588" y="710"/>
                </a:cubicBezTo>
                <a:cubicBezTo>
                  <a:pt x="583" y="701"/>
                  <a:pt x="580" y="692"/>
                  <a:pt x="579" y="682"/>
                </a:cubicBezTo>
                <a:cubicBezTo>
                  <a:pt x="578" y="673"/>
                  <a:pt x="580" y="663"/>
                  <a:pt x="584" y="654"/>
                </a:cubicBezTo>
                <a:cubicBezTo>
                  <a:pt x="587" y="644"/>
                  <a:pt x="594" y="635"/>
                  <a:pt x="603" y="627"/>
                </a:cubicBezTo>
                <a:cubicBezTo>
                  <a:pt x="611" y="618"/>
                  <a:pt x="620" y="612"/>
                  <a:pt x="629" y="608"/>
                </a:cubicBezTo>
                <a:cubicBezTo>
                  <a:pt x="637" y="604"/>
                  <a:pt x="646" y="603"/>
                  <a:pt x="655" y="603"/>
                </a:cubicBezTo>
                <a:cubicBezTo>
                  <a:pt x="664" y="604"/>
                  <a:pt x="673" y="607"/>
                  <a:pt x="682" y="611"/>
                </a:cubicBezTo>
                <a:cubicBezTo>
                  <a:pt x="691" y="616"/>
                  <a:pt x="700" y="623"/>
                  <a:pt x="709" y="632"/>
                </a:cubicBezTo>
                <a:close/>
                <a:moveTo>
                  <a:pt x="690" y="652"/>
                </a:moveTo>
                <a:cubicBezTo>
                  <a:pt x="685" y="647"/>
                  <a:pt x="679" y="642"/>
                  <a:pt x="673" y="638"/>
                </a:cubicBezTo>
                <a:cubicBezTo>
                  <a:pt x="667" y="634"/>
                  <a:pt x="661" y="632"/>
                  <a:pt x="655" y="630"/>
                </a:cubicBezTo>
                <a:cubicBezTo>
                  <a:pt x="649" y="629"/>
                  <a:pt x="642" y="629"/>
                  <a:pt x="636" y="631"/>
                </a:cubicBezTo>
                <a:cubicBezTo>
                  <a:pt x="630" y="633"/>
                  <a:pt x="624" y="637"/>
                  <a:pt x="618" y="643"/>
                </a:cubicBezTo>
                <a:cubicBezTo>
                  <a:pt x="612" y="649"/>
                  <a:pt x="608" y="655"/>
                  <a:pt x="606" y="661"/>
                </a:cubicBezTo>
                <a:cubicBezTo>
                  <a:pt x="604" y="667"/>
                  <a:pt x="603" y="673"/>
                  <a:pt x="604" y="679"/>
                </a:cubicBezTo>
                <a:cubicBezTo>
                  <a:pt x="606" y="685"/>
                  <a:pt x="608" y="692"/>
                  <a:pt x="612" y="698"/>
                </a:cubicBezTo>
                <a:cubicBezTo>
                  <a:pt x="615" y="704"/>
                  <a:pt x="620" y="710"/>
                  <a:pt x="626" y="716"/>
                </a:cubicBezTo>
                <a:cubicBezTo>
                  <a:pt x="632" y="722"/>
                  <a:pt x="637" y="726"/>
                  <a:pt x="643" y="730"/>
                </a:cubicBezTo>
                <a:cubicBezTo>
                  <a:pt x="649" y="734"/>
                  <a:pt x="655" y="737"/>
                  <a:pt x="662" y="738"/>
                </a:cubicBezTo>
                <a:cubicBezTo>
                  <a:pt x="668" y="739"/>
                  <a:pt x="674" y="739"/>
                  <a:pt x="680" y="737"/>
                </a:cubicBezTo>
                <a:cubicBezTo>
                  <a:pt x="686" y="735"/>
                  <a:pt x="693" y="731"/>
                  <a:pt x="699" y="725"/>
                </a:cubicBezTo>
                <a:cubicBezTo>
                  <a:pt x="704" y="720"/>
                  <a:pt x="708" y="714"/>
                  <a:pt x="710" y="708"/>
                </a:cubicBezTo>
                <a:cubicBezTo>
                  <a:pt x="712" y="702"/>
                  <a:pt x="713" y="696"/>
                  <a:pt x="712" y="689"/>
                </a:cubicBezTo>
                <a:cubicBezTo>
                  <a:pt x="711" y="683"/>
                  <a:pt x="709" y="677"/>
                  <a:pt x="705" y="671"/>
                </a:cubicBezTo>
                <a:cubicBezTo>
                  <a:pt x="701" y="665"/>
                  <a:pt x="696" y="658"/>
                  <a:pt x="690" y="652"/>
                </a:cubicBezTo>
                <a:close/>
                <a:moveTo>
                  <a:pt x="832" y="508"/>
                </a:moveTo>
                <a:cubicBezTo>
                  <a:pt x="841" y="517"/>
                  <a:pt x="848" y="526"/>
                  <a:pt x="853" y="535"/>
                </a:cubicBezTo>
                <a:cubicBezTo>
                  <a:pt x="858" y="544"/>
                  <a:pt x="861" y="553"/>
                  <a:pt x="863" y="562"/>
                </a:cubicBezTo>
                <a:cubicBezTo>
                  <a:pt x="864" y="571"/>
                  <a:pt x="863" y="579"/>
                  <a:pt x="860" y="587"/>
                </a:cubicBezTo>
                <a:cubicBezTo>
                  <a:pt x="857" y="596"/>
                  <a:pt x="852" y="603"/>
                  <a:pt x="845" y="611"/>
                </a:cubicBezTo>
                <a:cubicBezTo>
                  <a:pt x="842" y="614"/>
                  <a:pt x="839" y="616"/>
                  <a:pt x="836" y="618"/>
                </a:cubicBezTo>
                <a:cubicBezTo>
                  <a:pt x="833" y="620"/>
                  <a:pt x="829" y="622"/>
                  <a:pt x="825" y="623"/>
                </a:cubicBezTo>
                <a:cubicBezTo>
                  <a:pt x="822" y="624"/>
                  <a:pt x="817" y="625"/>
                  <a:pt x="813" y="625"/>
                </a:cubicBezTo>
                <a:cubicBezTo>
                  <a:pt x="809" y="626"/>
                  <a:pt x="804" y="626"/>
                  <a:pt x="798" y="626"/>
                </a:cubicBezTo>
                <a:lnTo>
                  <a:pt x="850" y="678"/>
                </a:lnTo>
                <a:cubicBezTo>
                  <a:pt x="850" y="678"/>
                  <a:pt x="851" y="679"/>
                  <a:pt x="851" y="680"/>
                </a:cubicBezTo>
                <a:cubicBezTo>
                  <a:pt x="851" y="681"/>
                  <a:pt x="851" y="682"/>
                  <a:pt x="851" y="683"/>
                </a:cubicBezTo>
                <a:cubicBezTo>
                  <a:pt x="850" y="684"/>
                  <a:pt x="849" y="685"/>
                  <a:pt x="848" y="686"/>
                </a:cubicBezTo>
                <a:cubicBezTo>
                  <a:pt x="847" y="687"/>
                  <a:pt x="846" y="689"/>
                  <a:pt x="844" y="691"/>
                </a:cubicBezTo>
                <a:cubicBezTo>
                  <a:pt x="842" y="693"/>
                  <a:pt x="840" y="694"/>
                  <a:pt x="839" y="695"/>
                </a:cubicBezTo>
                <a:cubicBezTo>
                  <a:pt x="838" y="696"/>
                  <a:pt x="837" y="697"/>
                  <a:pt x="835" y="698"/>
                </a:cubicBezTo>
                <a:cubicBezTo>
                  <a:pt x="834" y="698"/>
                  <a:pt x="834" y="698"/>
                  <a:pt x="833" y="698"/>
                </a:cubicBezTo>
                <a:cubicBezTo>
                  <a:pt x="832" y="698"/>
                  <a:pt x="831" y="697"/>
                  <a:pt x="831" y="697"/>
                </a:cubicBezTo>
                <a:lnTo>
                  <a:pt x="687" y="553"/>
                </a:lnTo>
                <a:cubicBezTo>
                  <a:pt x="686" y="552"/>
                  <a:pt x="686" y="551"/>
                  <a:pt x="685" y="551"/>
                </a:cubicBezTo>
                <a:cubicBezTo>
                  <a:pt x="685" y="550"/>
                  <a:pt x="685" y="549"/>
                  <a:pt x="686" y="548"/>
                </a:cubicBezTo>
                <a:cubicBezTo>
                  <a:pt x="686" y="547"/>
                  <a:pt x="687" y="546"/>
                  <a:pt x="688" y="545"/>
                </a:cubicBezTo>
                <a:cubicBezTo>
                  <a:pt x="689" y="544"/>
                  <a:pt x="690" y="542"/>
                  <a:pt x="691" y="541"/>
                </a:cubicBezTo>
                <a:cubicBezTo>
                  <a:pt x="693" y="539"/>
                  <a:pt x="694" y="538"/>
                  <a:pt x="696" y="537"/>
                </a:cubicBezTo>
                <a:cubicBezTo>
                  <a:pt x="697" y="536"/>
                  <a:pt x="698" y="536"/>
                  <a:pt x="699" y="535"/>
                </a:cubicBezTo>
                <a:cubicBezTo>
                  <a:pt x="700" y="535"/>
                  <a:pt x="701" y="535"/>
                  <a:pt x="701" y="535"/>
                </a:cubicBezTo>
                <a:cubicBezTo>
                  <a:pt x="702" y="535"/>
                  <a:pt x="703" y="535"/>
                  <a:pt x="703" y="536"/>
                </a:cubicBezTo>
                <a:lnTo>
                  <a:pt x="717" y="550"/>
                </a:lnTo>
                <a:cubicBezTo>
                  <a:pt x="717" y="544"/>
                  <a:pt x="717" y="538"/>
                  <a:pt x="718" y="532"/>
                </a:cubicBezTo>
                <a:cubicBezTo>
                  <a:pt x="718" y="527"/>
                  <a:pt x="719" y="522"/>
                  <a:pt x="721" y="518"/>
                </a:cubicBezTo>
                <a:cubicBezTo>
                  <a:pt x="722" y="513"/>
                  <a:pt x="724" y="509"/>
                  <a:pt x="726" y="505"/>
                </a:cubicBezTo>
                <a:cubicBezTo>
                  <a:pt x="729" y="501"/>
                  <a:pt x="731" y="498"/>
                  <a:pt x="735" y="494"/>
                </a:cubicBezTo>
                <a:cubicBezTo>
                  <a:pt x="742" y="487"/>
                  <a:pt x="750" y="482"/>
                  <a:pt x="758" y="479"/>
                </a:cubicBezTo>
                <a:cubicBezTo>
                  <a:pt x="767" y="477"/>
                  <a:pt x="775" y="477"/>
                  <a:pt x="783" y="478"/>
                </a:cubicBezTo>
                <a:cubicBezTo>
                  <a:pt x="792" y="480"/>
                  <a:pt x="800" y="484"/>
                  <a:pt x="808" y="489"/>
                </a:cubicBezTo>
                <a:cubicBezTo>
                  <a:pt x="816" y="494"/>
                  <a:pt x="824" y="500"/>
                  <a:pt x="832" y="508"/>
                </a:cubicBezTo>
                <a:close/>
                <a:moveTo>
                  <a:pt x="814" y="530"/>
                </a:moveTo>
                <a:cubicBezTo>
                  <a:pt x="809" y="524"/>
                  <a:pt x="803" y="520"/>
                  <a:pt x="798" y="515"/>
                </a:cubicBezTo>
                <a:cubicBezTo>
                  <a:pt x="792" y="511"/>
                  <a:pt x="786" y="508"/>
                  <a:pt x="780" y="506"/>
                </a:cubicBezTo>
                <a:cubicBezTo>
                  <a:pt x="775" y="505"/>
                  <a:pt x="769" y="504"/>
                  <a:pt x="763" y="505"/>
                </a:cubicBezTo>
                <a:cubicBezTo>
                  <a:pt x="758" y="506"/>
                  <a:pt x="753" y="509"/>
                  <a:pt x="748" y="514"/>
                </a:cubicBezTo>
                <a:cubicBezTo>
                  <a:pt x="745" y="517"/>
                  <a:pt x="743" y="519"/>
                  <a:pt x="741" y="522"/>
                </a:cubicBezTo>
                <a:cubicBezTo>
                  <a:pt x="740" y="526"/>
                  <a:pt x="738" y="529"/>
                  <a:pt x="738" y="533"/>
                </a:cubicBezTo>
                <a:cubicBezTo>
                  <a:pt x="737" y="537"/>
                  <a:pt x="736" y="542"/>
                  <a:pt x="736" y="547"/>
                </a:cubicBezTo>
                <a:cubicBezTo>
                  <a:pt x="736" y="552"/>
                  <a:pt x="736" y="558"/>
                  <a:pt x="737" y="565"/>
                </a:cubicBezTo>
                <a:lnTo>
                  <a:pt x="778" y="606"/>
                </a:lnTo>
                <a:cubicBezTo>
                  <a:pt x="790" y="607"/>
                  <a:pt x="799" y="607"/>
                  <a:pt x="807" y="606"/>
                </a:cubicBezTo>
                <a:cubicBezTo>
                  <a:pt x="815" y="604"/>
                  <a:pt x="822" y="601"/>
                  <a:pt x="827" y="596"/>
                </a:cubicBezTo>
                <a:cubicBezTo>
                  <a:pt x="832" y="591"/>
                  <a:pt x="835" y="586"/>
                  <a:pt x="836" y="580"/>
                </a:cubicBezTo>
                <a:cubicBezTo>
                  <a:pt x="837" y="575"/>
                  <a:pt x="837" y="569"/>
                  <a:pt x="835" y="563"/>
                </a:cubicBezTo>
                <a:cubicBezTo>
                  <a:pt x="834" y="557"/>
                  <a:pt x="831" y="551"/>
                  <a:pt x="827" y="545"/>
                </a:cubicBezTo>
                <a:cubicBezTo>
                  <a:pt x="823" y="540"/>
                  <a:pt x="819" y="534"/>
                  <a:pt x="814" y="530"/>
                </a:cubicBezTo>
                <a:close/>
                <a:moveTo>
                  <a:pt x="1003" y="443"/>
                </a:moveTo>
                <a:cubicBezTo>
                  <a:pt x="1004" y="443"/>
                  <a:pt x="1004" y="444"/>
                  <a:pt x="1004" y="445"/>
                </a:cubicBezTo>
                <a:cubicBezTo>
                  <a:pt x="1004" y="445"/>
                  <a:pt x="1004" y="446"/>
                  <a:pt x="1004" y="447"/>
                </a:cubicBezTo>
                <a:cubicBezTo>
                  <a:pt x="1004" y="448"/>
                  <a:pt x="1003" y="449"/>
                  <a:pt x="1002" y="451"/>
                </a:cubicBezTo>
                <a:cubicBezTo>
                  <a:pt x="1001" y="452"/>
                  <a:pt x="999" y="454"/>
                  <a:pt x="997" y="455"/>
                </a:cubicBezTo>
                <a:cubicBezTo>
                  <a:pt x="995" y="457"/>
                  <a:pt x="994" y="459"/>
                  <a:pt x="992" y="460"/>
                </a:cubicBezTo>
                <a:cubicBezTo>
                  <a:pt x="991" y="461"/>
                  <a:pt x="990" y="462"/>
                  <a:pt x="989" y="462"/>
                </a:cubicBezTo>
                <a:cubicBezTo>
                  <a:pt x="988" y="463"/>
                  <a:pt x="987" y="463"/>
                  <a:pt x="986" y="463"/>
                </a:cubicBezTo>
                <a:cubicBezTo>
                  <a:pt x="986" y="462"/>
                  <a:pt x="985" y="462"/>
                  <a:pt x="984" y="461"/>
                </a:cubicBezTo>
                <a:lnTo>
                  <a:pt x="924" y="401"/>
                </a:lnTo>
                <a:cubicBezTo>
                  <a:pt x="918" y="395"/>
                  <a:pt x="913" y="391"/>
                  <a:pt x="908" y="388"/>
                </a:cubicBezTo>
                <a:cubicBezTo>
                  <a:pt x="904" y="386"/>
                  <a:pt x="899" y="384"/>
                  <a:pt x="895" y="383"/>
                </a:cubicBezTo>
                <a:cubicBezTo>
                  <a:pt x="891" y="382"/>
                  <a:pt x="886" y="382"/>
                  <a:pt x="882" y="384"/>
                </a:cubicBezTo>
                <a:cubicBezTo>
                  <a:pt x="878" y="385"/>
                  <a:pt x="874" y="388"/>
                  <a:pt x="870" y="391"/>
                </a:cubicBezTo>
                <a:cubicBezTo>
                  <a:pt x="866" y="396"/>
                  <a:pt x="863" y="403"/>
                  <a:pt x="861" y="411"/>
                </a:cubicBezTo>
                <a:cubicBezTo>
                  <a:pt x="860" y="419"/>
                  <a:pt x="860" y="429"/>
                  <a:pt x="861" y="440"/>
                </a:cubicBezTo>
                <a:lnTo>
                  <a:pt x="933" y="512"/>
                </a:lnTo>
                <a:cubicBezTo>
                  <a:pt x="934" y="513"/>
                  <a:pt x="934" y="514"/>
                  <a:pt x="934" y="514"/>
                </a:cubicBezTo>
                <a:cubicBezTo>
                  <a:pt x="934" y="515"/>
                  <a:pt x="934" y="516"/>
                  <a:pt x="934" y="517"/>
                </a:cubicBezTo>
                <a:cubicBezTo>
                  <a:pt x="934" y="518"/>
                  <a:pt x="933" y="519"/>
                  <a:pt x="932" y="521"/>
                </a:cubicBezTo>
                <a:cubicBezTo>
                  <a:pt x="931" y="522"/>
                  <a:pt x="929" y="524"/>
                  <a:pt x="927" y="526"/>
                </a:cubicBezTo>
                <a:cubicBezTo>
                  <a:pt x="925" y="527"/>
                  <a:pt x="924" y="529"/>
                  <a:pt x="923" y="530"/>
                </a:cubicBezTo>
                <a:cubicBezTo>
                  <a:pt x="921" y="531"/>
                  <a:pt x="920" y="532"/>
                  <a:pt x="919" y="532"/>
                </a:cubicBezTo>
                <a:cubicBezTo>
                  <a:pt x="918" y="533"/>
                  <a:pt x="917" y="533"/>
                  <a:pt x="916" y="533"/>
                </a:cubicBezTo>
                <a:cubicBezTo>
                  <a:pt x="916" y="532"/>
                  <a:pt x="915" y="532"/>
                  <a:pt x="914" y="531"/>
                </a:cubicBezTo>
                <a:lnTo>
                  <a:pt x="761" y="378"/>
                </a:lnTo>
                <a:cubicBezTo>
                  <a:pt x="761" y="378"/>
                  <a:pt x="760" y="377"/>
                  <a:pt x="760" y="376"/>
                </a:cubicBezTo>
                <a:cubicBezTo>
                  <a:pt x="760" y="376"/>
                  <a:pt x="760" y="375"/>
                  <a:pt x="760" y="374"/>
                </a:cubicBezTo>
                <a:cubicBezTo>
                  <a:pt x="761" y="373"/>
                  <a:pt x="762" y="371"/>
                  <a:pt x="763" y="370"/>
                </a:cubicBezTo>
                <a:cubicBezTo>
                  <a:pt x="764" y="369"/>
                  <a:pt x="765" y="367"/>
                  <a:pt x="767" y="365"/>
                </a:cubicBezTo>
                <a:cubicBezTo>
                  <a:pt x="769" y="363"/>
                  <a:pt x="771" y="362"/>
                  <a:pt x="772" y="361"/>
                </a:cubicBezTo>
                <a:cubicBezTo>
                  <a:pt x="773" y="360"/>
                  <a:pt x="774" y="359"/>
                  <a:pt x="775" y="359"/>
                </a:cubicBezTo>
                <a:cubicBezTo>
                  <a:pt x="776" y="358"/>
                  <a:pt x="777" y="358"/>
                  <a:pt x="778" y="358"/>
                </a:cubicBezTo>
                <a:cubicBezTo>
                  <a:pt x="779" y="358"/>
                  <a:pt x="780" y="359"/>
                  <a:pt x="780" y="359"/>
                </a:cubicBezTo>
                <a:lnTo>
                  <a:pt x="842" y="421"/>
                </a:lnTo>
                <a:cubicBezTo>
                  <a:pt x="842" y="410"/>
                  <a:pt x="843" y="400"/>
                  <a:pt x="846" y="392"/>
                </a:cubicBezTo>
                <a:cubicBezTo>
                  <a:pt x="848" y="384"/>
                  <a:pt x="852" y="377"/>
                  <a:pt x="858" y="371"/>
                </a:cubicBezTo>
                <a:cubicBezTo>
                  <a:pt x="865" y="364"/>
                  <a:pt x="872" y="360"/>
                  <a:pt x="879" y="357"/>
                </a:cubicBezTo>
                <a:cubicBezTo>
                  <a:pt x="886" y="355"/>
                  <a:pt x="893" y="354"/>
                  <a:pt x="900" y="355"/>
                </a:cubicBezTo>
                <a:cubicBezTo>
                  <a:pt x="906" y="356"/>
                  <a:pt x="913" y="359"/>
                  <a:pt x="920" y="363"/>
                </a:cubicBezTo>
                <a:cubicBezTo>
                  <a:pt x="926" y="367"/>
                  <a:pt x="933" y="372"/>
                  <a:pt x="940" y="380"/>
                </a:cubicBezTo>
                <a:lnTo>
                  <a:pt x="1003" y="443"/>
                </a:lnTo>
                <a:close/>
                <a:moveTo>
                  <a:pt x="1117" y="329"/>
                </a:moveTo>
                <a:cubicBezTo>
                  <a:pt x="1118" y="330"/>
                  <a:pt x="1118" y="331"/>
                  <a:pt x="1118" y="332"/>
                </a:cubicBezTo>
                <a:cubicBezTo>
                  <a:pt x="1118" y="333"/>
                  <a:pt x="1117" y="335"/>
                  <a:pt x="1116" y="336"/>
                </a:cubicBezTo>
                <a:cubicBezTo>
                  <a:pt x="1115" y="337"/>
                  <a:pt x="1114" y="339"/>
                  <a:pt x="1112" y="341"/>
                </a:cubicBezTo>
                <a:cubicBezTo>
                  <a:pt x="1110" y="343"/>
                  <a:pt x="1108" y="344"/>
                  <a:pt x="1107" y="345"/>
                </a:cubicBezTo>
                <a:cubicBezTo>
                  <a:pt x="1105" y="346"/>
                  <a:pt x="1104" y="347"/>
                  <a:pt x="1103" y="347"/>
                </a:cubicBezTo>
                <a:cubicBezTo>
                  <a:pt x="1102" y="347"/>
                  <a:pt x="1101" y="347"/>
                  <a:pt x="1100" y="346"/>
                </a:cubicBezTo>
                <a:lnTo>
                  <a:pt x="1090" y="335"/>
                </a:lnTo>
                <a:cubicBezTo>
                  <a:pt x="1090" y="345"/>
                  <a:pt x="1089" y="353"/>
                  <a:pt x="1086" y="362"/>
                </a:cubicBezTo>
                <a:cubicBezTo>
                  <a:pt x="1083" y="370"/>
                  <a:pt x="1079" y="377"/>
                  <a:pt x="1073" y="383"/>
                </a:cubicBezTo>
                <a:cubicBezTo>
                  <a:pt x="1067" y="389"/>
                  <a:pt x="1062" y="393"/>
                  <a:pt x="1056" y="396"/>
                </a:cubicBezTo>
                <a:cubicBezTo>
                  <a:pt x="1050" y="399"/>
                  <a:pt x="1044" y="400"/>
                  <a:pt x="1038" y="401"/>
                </a:cubicBezTo>
                <a:cubicBezTo>
                  <a:pt x="1033" y="401"/>
                  <a:pt x="1027" y="400"/>
                  <a:pt x="1021" y="398"/>
                </a:cubicBezTo>
                <a:cubicBezTo>
                  <a:pt x="1016" y="396"/>
                  <a:pt x="1010" y="393"/>
                  <a:pt x="1005" y="388"/>
                </a:cubicBezTo>
                <a:cubicBezTo>
                  <a:pt x="1000" y="382"/>
                  <a:pt x="996" y="376"/>
                  <a:pt x="994" y="369"/>
                </a:cubicBezTo>
                <a:cubicBezTo>
                  <a:pt x="992" y="362"/>
                  <a:pt x="992" y="355"/>
                  <a:pt x="993" y="348"/>
                </a:cubicBezTo>
                <a:cubicBezTo>
                  <a:pt x="995" y="341"/>
                  <a:pt x="998" y="333"/>
                  <a:pt x="1003" y="325"/>
                </a:cubicBezTo>
                <a:cubicBezTo>
                  <a:pt x="1008" y="318"/>
                  <a:pt x="1015" y="310"/>
                  <a:pt x="1023" y="302"/>
                </a:cubicBezTo>
                <a:lnTo>
                  <a:pt x="1037" y="287"/>
                </a:lnTo>
                <a:lnTo>
                  <a:pt x="1029" y="279"/>
                </a:lnTo>
                <a:cubicBezTo>
                  <a:pt x="1025" y="275"/>
                  <a:pt x="1021" y="272"/>
                  <a:pt x="1017" y="270"/>
                </a:cubicBezTo>
                <a:cubicBezTo>
                  <a:pt x="1013" y="268"/>
                  <a:pt x="1009" y="267"/>
                  <a:pt x="1006" y="267"/>
                </a:cubicBezTo>
                <a:cubicBezTo>
                  <a:pt x="1002" y="266"/>
                  <a:pt x="998" y="267"/>
                  <a:pt x="994" y="269"/>
                </a:cubicBezTo>
                <a:cubicBezTo>
                  <a:pt x="990" y="271"/>
                  <a:pt x="986" y="274"/>
                  <a:pt x="981" y="279"/>
                </a:cubicBezTo>
                <a:cubicBezTo>
                  <a:pt x="977" y="283"/>
                  <a:pt x="973" y="288"/>
                  <a:pt x="970" y="293"/>
                </a:cubicBezTo>
                <a:cubicBezTo>
                  <a:pt x="968" y="298"/>
                  <a:pt x="966" y="302"/>
                  <a:pt x="964" y="306"/>
                </a:cubicBezTo>
                <a:cubicBezTo>
                  <a:pt x="963" y="310"/>
                  <a:pt x="962" y="314"/>
                  <a:pt x="961" y="317"/>
                </a:cubicBezTo>
                <a:cubicBezTo>
                  <a:pt x="960" y="320"/>
                  <a:pt x="959" y="322"/>
                  <a:pt x="958" y="323"/>
                </a:cubicBezTo>
                <a:cubicBezTo>
                  <a:pt x="958" y="323"/>
                  <a:pt x="957" y="324"/>
                  <a:pt x="956" y="324"/>
                </a:cubicBezTo>
                <a:cubicBezTo>
                  <a:pt x="956" y="324"/>
                  <a:pt x="955" y="324"/>
                  <a:pt x="954" y="324"/>
                </a:cubicBezTo>
                <a:cubicBezTo>
                  <a:pt x="953" y="323"/>
                  <a:pt x="952" y="323"/>
                  <a:pt x="951" y="322"/>
                </a:cubicBezTo>
                <a:cubicBezTo>
                  <a:pt x="950" y="321"/>
                  <a:pt x="948" y="320"/>
                  <a:pt x="947" y="319"/>
                </a:cubicBezTo>
                <a:cubicBezTo>
                  <a:pt x="945" y="317"/>
                  <a:pt x="944" y="316"/>
                  <a:pt x="943" y="314"/>
                </a:cubicBezTo>
                <a:cubicBezTo>
                  <a:pt x="942" y="313"/>
                  <a:pt x="942" y="311"/>
                  <a:pt x="942" y="309"/>
                </a:cubicBezTo>
                <a:cubicBezTo>
                  <a:pt x="942" y="307"/>
                  <a:pt x="943" y="304"/>
                  <a:pt x="944" y="300"/>
                </a:cubicBezTo>
                <a:cubicBezTo>
                  <a:pt x="945" y="297"/>
                  <a:pt x="947" y="292"/>
                  <a:pt x="949" y="288"/>
                </a:cubicBezTo>
                <a:cubicBezTo>
                  <a:pt x="951" y="284"/>
                  <a:pt x="954" y="279"/>
                  <a:pt x="957" y="274"/>
                </a:cubicBezTo>
                <a:cubicBezTo>
                  <a:pt x="960" y="270"/>
                  <a:pt x="964" y="266"/>
                  <a:pt x="968" y="262"/>
                </a:cubicBezTo>
                <a:cubicBezTo>
                  <a:pt x="975" y="254"/>
                  <a:pt x="982" y="249"/>
                  <a:pt x="989" y="245"/>
                </a:cubicBezTo>
                <a:cubicBezTo>
                  <a:pt x="996" y="242"/>
                  <a:pt x="1003" y="240"/>
                  <a:pt x="1009" y="240"/>
                </a:cubicBezTo>
                <a:cubicBezTo>
                  <a:pt x="1015" y="240"/>
                  <a:pt x="1022" y="242"/>
                  <a:pt x="1028" y="245"/>
                </a:cubicBezTo>
                <a:cubicBezTo>
                  <a:pt x="1034" y="248"/>
                  <a:pt x="1041" y="253"/>
                  <a:pt x="1047" y="260"/>
                </a:cubicBezTo>
                <a:lnTo>
                  <a:pt x="1117" y="329"/>
                </a:lnTo>
                <a:close/>
                <a:moveTo>
                  <a:pt x="1051" y="301"/>
                </a:moveTo>
                <a:lnTo>
                  <a:pt x="1035" y="317"/>
                </a:lnTo>
                <a:cubicBezTo>
                  <a:pt x="1029" y="322"/>
                  <a:pt x="1025" y="327"/>
                  <a:pt x="1022" y="332"/>
                </a:cubicBezTo>
                <a:cubicBezTo>
                  <a:pt x="1019" y="337"/>
                  <a:pt x="1018" y="341"/>
                  <a:pt x="1017" y="345"/>
                </a:cubicBezTo>
                <a:cubicBezTo>
                  <a:pt x="1016" y="350"/>
                  <a:pt x="1016" y="354"/>
                  <a:pt x="1017" y="357"/>
                </a:cubicBezTo>
                <a:cubicBezTo>
                  <a:pt x="1019" y="361"/>
                  <a:pt x="1021" y="364"/>
                  <a:pt x="1024" y="367"/>
                </a:cubicBezTo>
                <a:cubicBezTo>
                  <a:pt x="1029" y="373"/>
                  <a:pt x="1035" y="375"/>
                  <a:pt x="1042" y="375"/>
                </a:cubicBezTo>
                <a:cubicBezTo>
                  <a:pt x="1048" y="375"/>
                  <a:pt x="1055" y="372"/>
                  <a:pt x="1061" y="365"/>
                </a:cubicBezTo>
                <a:cubicBezTo>
                  <a:pt x="1066" y="360"/>
                  <a:pt x="1069" y="355"/>
                  <a:pt x="1071" y="348"/>
                </a:cubicBezTo>
                <a:cubicBezTo>
                  <a:pt x="1073" y="341"/>
                  <a:pt x="1073" y="333"/>
                  <a:pt x="1073" y="323"/>
                </a:cubicBezTo>
                <a:lnTo>
                  <a:pt x="1051" y="301"/>
                </a:lnTo>
                <a:close/>
                <a:moveTo>
                  <a:pt x="1241" y="205"/>
                </a:moveTo>
                <a:cubicBezTo>
                  <a:pt x="1241" y="206"/>
                  <a:pt x="1242" y="206"/>
                  <a:pt x="1242" y="207"/>
                </a:cubicBezTo>
                <a:cubicBezTo>
                  <a:pt x="1242" y="208"/>
                  <a:pt x="1242" y="209"/>
                  <a:pt x="1241" y="210"/>
                </a:cubicBezTo>
                <a:cubicBezTo>
                  <a:pt x="1241" y="211"/>
                  <a:pt x="1240" y="212"/>
                  <a:pt x="1239" y="213"/>
                </a:cubicBezTo>
                <a:cubicBezTo>
                  <a:pt x="1238" y="214"/>
                  <a:pt x="1237" y="216"/>
                  <a:pt x="1235" y="218"/>
                </a:cubicBezTo>
                <a:cubicBezTo>
                  <a:pt x="1233" y="220"/>
                  <a:pt x="1231" y="221"/>
                  <a:pt x="1230" y="222"/>
                </a:cubicBezTo>
                <a:cubicBezTo>
                  <a:pt x="1229" y="223"/>
                  <a:pt x="1227" y="224"/>
                  <a:pt x="1226" y="225"/>
                </a:cubicBezTo>
                <a:cubicBezTo>
                  <a:pt x="1225" y="225"/>
                  <a:pt x="1225" y="225"/>
                  <a:pt x="1224" y="225"/>
                </a:cubicBezTo>
                <a:cubicBezTo>
                  <a:pt x="1223" y="225"/>
                  <a:pt x="1222" y="224"/>
                  <a:pt x="1222" y="224"/>
                </a:cubicBezTo>
                <a:lnTo>
                  <a:pt x="1161" y="163"/>
                </a:lnTo>
                <a:cubicBezTo>
                  <a:pt x="1156" y="158"/>
                  <a:pt x="1150" y="153"/>
                  <a:pt x="1146" y="151"/>
                </a:cubicBezTo>
                <a:cubicBezTo>
                  <a:pt x="1141" y="148"/>
                  <a:pt x="1137" y="146"/>
                  <a:pt x="1133" y="145"/>
                </a:cubicBezTo>
                <a:cubicBezTo>
                  <a:pt x="1128" y="145"/>
                  <a:pt x="1124" y="145"/>
                  <a:pt x="1120" y="146"/>
                </a:cubicBezTo>
                <a:cubicBezTo>
                  <a:pt x="1116" y="148"/>
                  <a:pt x="1112" y="150"/>
                  <a:pt x="1108" y="154"/>
                </a:cubicBezTo>
                <a:cubicBezTo>
                  <a:pt x="1103" y="159"/>
                  <a:pt x="1100" y="165"/>
                  <a:pt x="1099" y="173"/>
                </a:cubicBezTo>
                <a:cubicBezTo>
                  <a:pt x="1098" y="181"/>
                  <a:pt x="1097" y="191"/>
                  <a:pt x="1099" y="203"/>
                </a:cubicBezTo>
                <a:lnTo>
                  <a:pt x="1171" y="275"/>
                </a:lnTo>
                <a:cubicBezTo>
                  <a:pt x="1171" y="275"/>
                  <a:pt x="1172" y="276"/>
                  <a:pt x="1172" y="277"/>
                </a:cubicBezTo>
                <a:cubicBezTo>
                  <a:pt x="1172" y="278"/>
                  <a:pt x="1172" y="278"/>
                  <a:pt x="1172" y="279"/>
                </a:cubicBezTo>
                <a:cubicBezTo>
                  <a:pt x="1171" y="280"/>
                  <a:pt x="1170" y="282"/>
                  <a:pt x="1169" y="283"/>
                </a:cubicBezTo>
                <a:cubicBezTo>
                  <a:pt x="1168" y="284"/>
                  <a:pt x="1167" y="286"/>
                  <a:pt x="1165" y="288"/>
                </a:cubicBezTo>
                <a:cubicBezTo>
                  <a:pt x="1163" y="290"/>
                  <a:pt x="1161" y="291"/>
                  <a:pt x="1160" y="292"/>
                </a:cubicBezTo>
                <a:cubicBezTo>
                  <a:pt x="1159" y="293"/>
                  <a:pt x="1158" y="294"/>
                  <a:pt x="1156" y="295"/>
                </a:cubicBezTo>
                <a:cubicBezTo>
                  <a:pt x="1155" y="295"/>
                  <a:pt x="1155" y="295"/>
                  <a:pt x="1154" y="295"/>
                </a:cubicBezTo>
                <a:cubicBezTo>
                  <a:pt x="1153" y="295"/>
                  <a:pt x="1153" y="294"/>
                  <a:pt x="1152" y="294"/>
                </a:cubicBezTo>
                <a:lnTo>
                  <a:pt x="1049" y="191"/>
                </a:lnTo>
                <a:cubicBezTo>
                  <a:pt x="1048" y="190"/>
                  <a:pt x="1048" y="189"/>
                  <a:pt x="1048" y="189"/>
                </a:cubicBezTo>
                <a:cubicBezTo>
                  <a:pt x="1047" y="188"/>
                  <a:pt x="1047" y="187"/>
                  <a:pt x="1048" y="186"/>
                </a:cubicBezTo>
                <a:cubicBezTo>
                  <a:pt x="1048" y="185"/>
                  <a:pt x="1049" y="184"/>
                  <a:pt x="1050" y="183"/>
                </a:cubicBezTo>
                <a:cubicBezTo>
                  <a:pt x="1051" y="182"/>
                  <a:pt x="1052" y="180"/>
                  <a:pt x="1054" y="178"/>
                </a:cubicBezTo>
                <a:cubicBezTo>
                  <a:pt x="1056" y="177"/>
                  <a:pt x="1057" y="175"/>
                  <a:pt x="1058" y="174"/>
                </a:cubicBezTo>
                <a:cubicBezTo>
                  <a:pt x="1059" y="173"/>
                  <a:pt x="1061" y="173"/>
                  <a:pt x="1061" y="173"/>
                </a:cubicBezTo>
                <a:cubicBezTo>
                  <a:pt x="1062" y="172"/>
                  <a:pt x="1063" y="172"/>
                  <a:pt x="1064" y="172"/>
                </a:cubicBezTo>
                <a:cubicBezTo>
                  <a:pt x="1065" y="173"/>
                  <a:pt x="1065" y="173"/>
                  <a:pt x="1066" y="174"/>
                </a:cubicBezTo>
                <a:lnTo>
                  <a:pt x="1080" y="187"/>
                </a:lnTo>
                <a:cubicBezTo>
                  <a:pt x="1079" y="175"/>
                  <a:pt x="1080" y="164"/>
                  <a:pt x="1083" y="156"/>
                </a:cubicBezTo>
                <a:cubicBezTo>
                  <a:pt x="1085" y="147"/>
                  <a:pt x="1090" y="139"/>
                  <a:pt x="1096" y="134"/>
                </a:cubicBezTo>
                <a:cubicBezTo>
                  <a:pt x="1102" y="127"/>
                  <a:pt x="1109" y="122"/>
                  <a:pt x="1116" y="120"/>
                </a:cubicBezTo>
                <a:cubicBezTo>
                  <a:pt x="1123" y="117"/>
                  <a:pt x="1130" y="117"/>
                  <a:pt x="1137" y="118"/>
                </a:cubicBezTo>
                <a:cubicBezTo>
                  <a:pt x="1144" y="119"/>
                  <a:pt x="1151" y="121"/>
                  <a:pt x="1157" y="125"/>
                </a:cubicBezTo>
                <a:cubicBezTo>
                  <a:pt x="1164" y="129"/>
                  <a:pt x="1171" y="135"/>
                  <a:pt x="1178" y="142"/>
                </a:cubicBezTo>
                <a:lnTo>
                  <a:pt x="1241" y="205"/>
                </a:lnTo>
                <a:close/>
                <a:moveTo>
                  <a:pt x="1306" y="28"/>
                </a:moveTo>
                <a:cubicBezTo>
                  <a:pt x="1309" y="31"/>
                  <a:pt x="1310" y="34"/>
                  <a:pt x="1310" y="37"/>
                </a:cubicBezTo>
                <a:cubicBezTo>
                  <a:pt x="1309" y="39"/>
                  <a:pt x="1308" y="42"/>
                  <a:pt x="1306" y="44"/>
                </a:cubicBezTo>
                <a:lnTo>
                  <a:pt x="1239" y="112"/>
                </a:lnTo>
                <a:cubicBezTo>
                  <a:pt x="1244" y="117"/>
                  <a:pt x="1250" y="122"/>
                  <a:pt x="1256" y="125"/>
                </a:cubicBezTo>
                <a:cubicBezTo>
                  <a:pt x="1261" y="129"/>
                  <a:pt x="1267" y="131"/>
                  <a:pt x="1273" y="131"/>
                </a:cubicBezTo>
                <a:cubicBezTo>
                  <a:pt x="1279" y="132"/>
                  <a:pt x="1285" y="131"/>
                  <a:pt x="1291" y="129"/>
                </a:cubicBezTo>
                <a:cubicBezTo>
                  <a:pt x="1297" y="126"/>
                  <a:pt x="1304" y="122"/>
                  <a:pt x="1310" y="115"/>
                </a:cubicBezTo>
                <a:cubicBezTo>
                  <a:pt x="1315" y="110"/>
                  <a:pt x="1319" y="106"/>
                  <a:pt x="1322" y="101"/>
                </a:cubicBezTo>
                <a:cubicBezTo>
                  <a:pt x="1325" y="96"/>
                  <a:pt x="1327" y="92"/>
                  <a:pt x="1329" y="88"/>
                </a:cubicBezTo>
                <a:cubicBezTo>
                  <a:pt x="1331" y="85"/>
                  <a:pt x="1332" y="81"/>
                  <a:pt x="1333" y="79"/>
                </a:cubicBezTo>
                <a:cubicBezTo>
                  <a:pt x="1334" y="76"/>
                  <a:pt x="1335" y="74"/>
                  <a:pt x="1336" y="73"/>
                </a:cubicBezTo>
                <a:cubicBezTo>
                  <a:pt x="1337" y="73"/>
                  <a:pt x="1337" y="73"/>
                  <a:pt x="1338" y="72"/>
                </a:cubicBezTo>
                <a:cubicBezTo>
                  <a:pt x="1339" y="72"/>
                  <a:pt x="1339" y="72"/>
                  <a:pt x="1340" y="73"/>
                </a:cubicBezTo>
                <a:cubicBezTo>
                  <a:pt x="1341" y="73"/>
                  <a:pt x="1342" y="74"/>
                  <a:pt x="1343" y="74"/>
                </a:cubicBezTo>
                <a:cubicBezTo>
                  <a:pt x="1344" y="75"/>
                  <a:pt x="1345" y="76"/>
                  <a:pt x="1346" y="78"/>
                </a:cubicBezTo>
                <a:cubicBezTo>
                  <a:pt x="1347" y="79"/>
                  <a:pt x="1348" y="80"/>
                  <a:pt x="1349" y="80"/>
                </a:cubicBezTo>
                <a:cubicBezTo>
                  <a:pt x="1350" y="81"/>
                  <a:pt x="1350" y="82"/>
                  <a:pt x="1351" y="83"/>
                </a:cubicBezTo>
                <a:cubicBezTo>
                  <a:pt x="1351" y="83"/>
                  <a:pt x="1351" y="84"/>
                  <a:pt x="1352" y="85"/>
                </a:cubicBezTo>
                <a:cubicBezTo>
                  <a:pt x="1352" y="85"/>
                  <a:pt x="1352" y="86"/>
                  <a:pt x="1352" y="87"/>
                </a:cubicBezTo>
                <a:cubicBezTo>
                  <a:pt x="1352" y="88"/>
                  <a:pt x="1351" y="90"/>
                  <a:pt x="1350" y="93"/>
                </a:cubicBezTo>
                <a:cubicBezTo>
                  <a:pt x="1349" y="96"/>
                  <a:pt x="1347" y="100"/>
                  <a:pt x="1345" y="104"/>
                </a:cubicBezTo>
                <a:cubicBezTo>
                  <a:pt x="1343" y="108"/>
                  <a:pt x="1340" y="113"/>
                  <a:pt x="1336" y="118"/>
                </a:cubicBezTo>
                <a:cubicBezTo>
                  <a:pt x="1332" y="123"/>
                  <a:pt x="1328" y="128"/>
                  <a:pt x="1323" y="133"/>
                </a:cubicBezTo>
                <a:cubicBezTo>
                  <a:pt x="1315" y="141"/>
                  <a:pt x="1306" y="147"/>
                  <a:pt x="1297" y="151"/>
                </a:cubicBezTo>
                <a:cubicBezTo>
                  <a:pt x="1289" y="155"/>
                  <a:pt x="1280" y="157"/>
                  <a:pt x="1271" y="157"/>
                </a:cubicBezTo>
                <a:cubicBezTo>
                  <a:pt x="1262" y="157"/>
                  <a:pt x="1253" y="154"/>
                  <a:pt x="1243" y="149"/>
                </a:cubicBezTo>
                <a:cubicBezTo>
                  <a:pt x="1234" y="144"/>
                  <a:pt x="1225" y="137"/>
                  <a:pt x="1216" y="128"/>
                </a:cubicBezTo>
                <a:cubicBezTo>
                  <a:pt x="1207" y="119"/>
                  <a:pt x="1200" y="110"/>
                  <a:pt x="1195" y="101"/>
                </a:cubicBezTo>
                <a:cubicBezTo>
                  <a:pt x="1190" y="91"/>
                  <a:pt x="1188" y="82"/>
                  <a:pt x="1187" y="73"/>
                </a:cubicBezTo>
                <a:cubicBezTo>
                  <a:pt x="1186" y="63"/>
                  <a:pt x="1188" y="54"/>
                  <a:pt x="1191" y="46"/>
                </a:cubicBezTo>
                <a:cubicBezTo>
                  <a:pt x="1195" y="37"/>
                  <a:pt x="1200" y="29"/>
                  <a:pt x="1208" y="21"/>
                </a:cubicBezTo>
                <a:cubicBezTo>
                  <a:pt x="1216" y="13"/>
                  <a:pt x="1224" y="8"/>
                  <a:pt x="1232" y="4"/>
                </a:cubicBezTo>
                <a:cubicBezTo>
                  <a:pt x="1241" y="1"/>
                  <a:pt x="1249" y="0"/>
                  <a:pt x="1257" y="1"/>
                </a:cubicBezTo>
                <a:cubicBezTo>
                  <a:pt x="1265" y="2"/>
                  <a:pt x="1273" y="4"/>
                  <a:pt x="1281" y="8"/>
                </a:cubicBezTo>
                <a:cubicBezTo>
                  <a:pt x="1288" y="12"/>
                  <a:pt x="1295" y="18"/>
                  <a:pt x="1302" y="25"/>
                </a:cubicBezTo>
                <a:lnTo>
                  <a:pt x="1306" y="28"/>
                </a:lnTo>
                <a:close/>
                <a:moveTo>
                  <a:pt x="1281" y="41"/>
                </a:moveTo>
                <a:cubicBezTo>
                  <a:pt x="1271" y="31"/>
                  <a:pt x="1261" y="26"/>
                  <a:pt x="1251" y="25"/>
                </a:cubicBezTo>
                <a:cubicBezTo>
                  <a:pt x="1241" y="24"/>
                  <a:pt x="1231" y="28"/>
                  <a:pt x="1222" y="37"/>
                </a:cubicBezTo>
                <a:cubicBezTo>
                  <a:pt x="1217" y="42"/>
                  <a:pt x="1214" y="47"/>
                  <a:pt x="1212" y="52"/>
                </a:cubicBezTo>
                <a:cubicBezTo>
                  <a:pt x="1210" y="57"/>
                  <a:pt x="1210" y="63"/>
                  <a:pt x="1210" y="68"/>
                </a:cubicBezTo>
                <a:cubicBezTo>
                  <a:pt x="1211" y="73"/>
                  <a:pt x="1212" y="78"/>
                  <a:pt x="1215" y="83"/>
                </a:cubicBezTo>
                <a:cubicBezTo>
                  <a:pt x="1217" y="89"/>
                  <a:pt x="1221" y="93"/>
                  <a:pt x="1225" y="98"/>
                </a:cubicBezTo>
                <a:lnTo>
                  <a:pt x="1281" y="41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200">
              <a:latin typeface="Times New Roman"/>
              <a:cs typeface="Times New Roman"/>
            </a:endParaRPr>
          </a:p>
        </p:txBody>
      </p:sp>
      <p:sp>
        <p:nvSpPr>
          <p:cNvPr id="131" name="Rectangle 278"/>
          <p:cNvSpPr>
            <a:spLocks noChangeArrowheads="1"/>
          </p:cNvSpPr>
          <p:nvPr/>
        </p:nvSpPr>
        <p:spPr bwMode="auto">
          <a:xfrm rot="16200000">
            <a:off x="-373168" y="3142979"/>
            <a:ext cx="218246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Free </a:t>
            </a:r>
            <a:r>
              <a:rPr lang="fr-FR" alt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</a:t>
            </a:r>
            <a:r>
              <a:rPr lang="en-US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ino</a:t>
            </a:r>
            <a:r>
              <a:rPr 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acid contents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(</a:t>
            </a:r>
            <a:r>
              <a:rPr kumimoji="0" lang="en-US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Symbol" charset="2"/>
                <a:cs typeface="Symbol" charset="2"/>
              </a:rPr>
              <a:t>m</a:t>
            </a:r>
            <a:r>
              <a:rPr lang="en-US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</a:t>
            </a:r>
            <a:r>
              <a:rPr kumimoji="0" lang="en-US" sz="12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oles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root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 DW</a:t>
            </a:r>
            <a:r>
              <a:rPr kumimoji="0" lang="en-US" sz="120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-1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/>
                <a:cs typeface="Times New Roman"/>
              </a:rPr>
              <a:t>)</a:t>
            </a:r>
            <a:endParaRPr kumimoji="0" 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/>
              <a:cs typeface="Times New Roman"/>
            </a:endParaRPr>
          </a:p>
        </p:txBody>
      </p:sp>
      <p:sp>
        <p:nvSpPr>
          <p:cNvPr id="137" name="Freeform 338"/>
          <p:cNvSpPr>
            <a:spLocks noEditPoints="1"/>
          </p:cNvSpPr>
          <p:nvPr/>
        </p:nvSpPr>
        <p:spPr bwMode="auto">
          <a:xfrm>
            <a:off x="1214268" y="2372400"/>
            <a:ext cx="4878000" cy="1958806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15128" y="0"/>
              </a:cxn>
              <a:cxn ang="0">
                <a:pos x="15136" y="8"/>
              </a:cxn>
              <a:cxn ang="0">
                <a:pos x="15136" y="3592"/>
              </a:cxn>
              <a:cxn ang="0">
                <a:pos x="15128" y="3600"/>
              </a:cxn>
              <a:cxn ang="0">
                <a:pos x="8" y="3600"/>
              </a:cxn>
              <a:cxn ang="0">
                <a:pos x="0" y="3592"/>
              </a:cxn>
              <a:cxn ang="0">
                <a:pos x="0" y="8"/>
              </a:cxn>
              <a:cxn ang="0">
                <a:pos x="16" y="3592"/>
              </a:cxn>
              <a:cxn ang="0">
                <a:pos x="8" y="3584"/>
              </a:cxn>
              <a:cxn ang="0">
                <a:pos x="15128" y="3584"/>
              </a:cxn>
              <a:cxn ang="0">
                <a:pos x="15120" y="3592"/>
              </a:cxn>
              <a:cxn ang="0">
                <a:pos x="15120" y="8"/>
              </a:cxn>
              <a:cxn ang="0">
                <a:pos x="15128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592"/>
              </a:cxn>
            </a:cxnLst>
            <a:rect l="0" t="0" r="r" b="b"/>
            <a:pathLst>
              <a:path w="15136" h="360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15128" y="0"/>
                </a:lnTo>
                <a:cubicBezTo>
                  <a:pt x="15133" y="0"/>
                  <a:pt x="15136" y="4"/>
                  <a:pt x="15136" y="8"/>
                </a:cubicBezTo>
                <a:lnTo>
                  <a:pt x="15136" y="3592"/>
                </a:lnTo>
                <a:cubicBezTo>
                  <a:pt x="15136" y="3597"/>
                  <a:pt x="15133" y="3600"/>
                  <a:pt x="15128" y="3600"/>
                </a:cubicBezTo>
                <a:lnTo>
                  <a:pt x="8" y="3600"/>
                </a:lnTo>
                <a:cubicBezTo>
                  <a:pt x="4" y="3600"/>
                  <a:pt x="0" y="3597"/>
                  <a:pt x="0" y="3592"/>
                </a:cubicBezTo>
                <a:lnTo>
                  <a:pt x="0" y="8"/>
                </a:lnTo>
                <a:close/>
                <a:moveTo>
                  <a:pt x="16" y="3592"/>
                </a:moveTo>
                <a:lnTo>
                  <a:pt x="8" y="3584"/>
                </a:lnTo>
                <a:lnTo>
                  <a:pt x="15128" y="3584"/>
                </a:lnTo>
                <a:lnTo>
                  <a:pt x="15120" y="3592"/>
                </a:lnTo>
                <a:lnTo>
                  <a:pt x="15120" y="8"/>
                </a:lnTo>
                <a:lnTo>
                  <a:pt x="15128" y="16"/>
                </a:lnTo>
                <a:lnTo>
                  <a:pt x="8" y="16"/>
                </a:lnTo>
                <a:lnTo>
                  <a:pt x="16" y="8"/>
                </a:lnTo>
                <a:lnTo>
                  <a:pt x="16" y="3592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/>
              <a:cs typeface="Times New Roman"/>
            </a:endParaRPr>
          </a:p>
        </p:txBody>
      </p:sp>
      <p:cxnSp>
        <p:nvCxnSpPr>
          <p:cNvPr id="141" name="Connecteur droit 140"/>
          <p:cNvCxnSpPr/>
          <p:nvPr/>
        </p:nvCxnSpPr>
        <p:spPr>
          <a:xfrm>
            <a:off x="1210796" y="3675600"/>
            <a:ext cx="4876200" cy="1588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2" name="Freeform 235"/>
          <p:cNvSpPr>
            <a:spLocks noEditPoints="1"/>
          </p:cNvSpPr>
          <p:nvPr/>
        </p:nvSpPr>
        <p:spPr bwMode="auto">
          <a:xfrm>
            <a:off x="6093964" y="2376277"/>
            <a:ext cx="34304" cy="1951492"/>
          </a:xfrm>
          <a:custGeom>
            <a:avLst/>
            <a:gdLst>
              <a:gd name="T0" fmla="*/ 0 w 26"/>
              <a:gd name="T1" fmla="*/ 1639 h 1641"/>
              <a:gd name="T2" fmla="*/ 26 w 26"/>
              <a:gd name="T3" fmla="*/ 1639 h 1641"/>
              <a:gd name="T4" fmla="*/ 26 w 26"/>
              <a:gd name="T5" fmla="*/ 1641 h 1641"/>
              <a:gd name="T6" fmla="*/ 0 w 26"/>
              <a:gd name="T7" fmla="*/ 1641 h 1641"/>
              <a:gd name="T8" fmla="*/ 0 w 26"/>
              <a:gd name="T9" fmla="*/ 1639 h 1641"/>
              <a:gd name="T10" fmla="*/ 0 w 26"/>
              <a:gd name="T11" fmla="*/ 1366 h 1641"/>
              <a:gd name="T12" fmla="*/ 26 w 26"/>
              <a:gd name="T13" fmla="*/ 1366 h 1641"/>
              <a:gd name="T14" fmla="*/ 26 w 26"/>
              <a:gd name="T15" fmla="*/ 1368 h 1641"/>
              <a:gd name="T16" fmla="*/ 0 w 26"/>
              <a:gd name="T17" fmla="*/ 1368 h 1641"/>
              <a:gd name="T18" fmla="*/ 0 w 26"/>
              <a:gd name="T19" fmla="*/ 1366 h 1641"/>
              <a:gd name="T20" fmla="*/ 0 w 26"/>
              <a:gd name="T21" fmla="*/ 1093 h 1641"/>
              <a:gd name="T22" fmla="*/ 26 w 26"/>
              <a:gd name="T23" fmla="*/ 1093 h 1641"/>
              <a:gd name="T24" fmla="*/ 26 w 26"/>
              <a:gd name="T25" fmla="*/ 1095 h 1641"/>
              <a:gd name="T26" fmla="*/ 0 w 26"/>
              <a:gd name="T27" fmla="*/ 1095 h 1641"/>
              <a:gd name="T28" fmla="*/ 0 w 26"/>
              <a:gd name="T29" fmla="*/ 1093 h 1641"/>
              <a:gd name="T30" fmla="*/ 0 w 26"/>
              <a:gd name="T31" fmla="*/ 820 h 1641"/>
              <a:gd name="T32" fmla="*/ 26 w 26"/>
              <a:gd name="T33" fmla="*/ 820 h 1641"/>
              <a:gd name="T34" fmla="*/ 26 w 26"/>
              <a:gd name="T35" fmla="*/ 822 h 1641"/>
              <a:gd name="T36" fmla="*/ 0 w 26"/>
              <a:gd name="T37" fmla="*/ 822 h 1641"/>
              <a:gd name="T38" fmla="*/ 0 w 26"/>
              <a:gd name="T39" fmla="*/ 820 h 1641"/>
              <a:gd name="T40" fmla="*/ 0 w 26"/>
              <a:gd name="T41" fmla="*/ 546 h 1641"/>
              <a:gd name="T42" fmla="*/ 26 w 26"/>
              <a:gd name="T43" fmla="*/ 546 h 1641"/>
              <a:gd name="T44" fmla="*/ 26 w 26"/>
              <a:gd name="T45" fmla="*/ 548 h 1641"/>
              <a:gd name="T46" fmla="*/ 0 w 26"/>
              <a:gd name="T47" fmla="*/ 548 h 1641"/>
              <a:gd name="T48" fmla="*/ 0 w 26"/>
              <a:gd name="T49" fmla="*/ 546 h 1641"/>
              <a:gd name="T50" fmla="*/ 0 w 26"/>
              <a:gd name="T51" fmla="*/ 274 h 1641"/>
              <a:gd name="T52" fmla="*/ 26 w 26"/>
              <a:gd name="T53" fmla="*/ 274 h 1641"/>
              <a:gd name="T54" fmla="*/ 26 w 26"/>
              <a:gd name="T55" fmla="*/ 275 h 1641"/>
              <a:gd name="T56" fmla="*/ 0 w 26"/>
              <a:gd name="T57" fmla="*/ 275 h 1641"/>
              <a:gd name="T58" fmla="*/ 0 w 26"/>
              <a:gd name="T59" fmla="*/ 274 h 1641"/>
              <a:gd name="T60" fmla="*/ 0 w 26"/>
              <a:gd name="T61" fmla="*/ 0 h 1641"/>
              <a:gd name="T62" fmla="*/ 26 w 26"/>
              <a:gd name="T63" fmla="*/ 0 h 1641"/>
              <a:gd name="T64" fmla="*/ 26 w 26"/>
              <a:gd name="T65" fmla="*/ 2 h 1641"/>
              <a:gd name="T66" fmla="*/ 0 w 26"/>
              <a:gd name="T67" fmla="*/ 2 h 1641"/>
              <a:gd name="T68" fmla="*/ 0 w 26"/>
              <a:gd name="T69" fmla="*/ 0 h 16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26" h="1641">
                <a:moveTo>
                  <a:pt x="0" y="1639"/>
                </a:moveTo>
                <a:lnTo>
                  <a:pt x="26" y="1639"/>
                </a:lnTo>
                <a:lnTo>
                  <a:pt x="26" y="1641"/>
                </a:lnTo>
                <a:lnTo>
                  <a:pt x="0" y="1641"/>
                </a:lnTo>
                <a:lnTo>
                  <a:pt x="0" y="1639"/>
                </a:lnTo>
                <a:close/>
                <a:moveTo>
                  <a:pt x="0" y="1366"/>
                </a:moveTo>
                <a:lnTo>
                  <a:pt x="26" y="1366"/>
                </a:lnTo>
                <a:lnTo>
                  <a:pt x="26" y="1368"/>
                </a:lnTo>
                <a:lnTo>
                  <a:pt x="0" y="1368"/>
                </a:lnTo>
                <a:lnTo>
                  <a:pt x="0" y="1366"/>
                </a:lnTo>
                <a:close/>
                <a:moveTo>
                  <a:pt x="0" y="1093"/>
                </a:moveTo>
                <a:lnTo>
                  <a:pt x="26" y="1093"/>
                </a:lnTo>
                <a:lnTo>
                  <a:pt x="26" y="1095"/>
                </a:lnTo>
                <a:lnTo>
                  <a:pt x="0" y="1095"/>
                </a:lnTo>
                <a:lnTo>
                  <a:pt x="0" y="1093"/>
                </a:lnTo>
                <a:close/>
                <a:moveTo>
                  <a:pt x="0" y="820"/>
                </a:moveTo>
                <a:lnTo>
                  <a:pt x="26" y="820"/>
                </a:lnTo>
                <a:lnTo>
                  <a:pt x="26" y="822"/>
                </a:lnTo>
                <a:lnTo>
                  <a:pt x="0" y="822"/>
                </a:lnTo>
                <a:lnTo>
                  <a:pt x="0" y="820"/>
                </a:lnTo>
                <a:close/>
                <a:moveTo>
                  <a:pt x="0" y="546"/>
                </a:moveTo>
                <a:lnTo>
                  <a:pt x="26" y="546"/>
                </a:lnTo>
                <a:lnTo>
                  <a:pt x="26" y="548"/>
                </a:lnTo>
                <a:lnTo>
                  <a:pt x="0" y="548"/>
                </a:lnTo>
                <a:lnTo>
                  <a:pt x="0" y="546"/>
                </a:lnTo>
                <a:close/>
                <a:moveTo>
                  <a:pt x="0" y="274"/>
                </a:moveTo>
                <a:lnTo>
                  <a:pt x="26" y="274"/>
                </a:lnTo>
                <a:lnTo>
                  <a:pt x="26" y="275"/>
                </a:lnTo>
                <a:lnTo>
                  <a:pt x="0" y="275"/>
                </a:lnTo>
                <a:lnTo>
                  <a:pt x="0" y="274"/>
                </a:lnTo>
                <a:close/>
                <a:moveTo>
                  <a:pt x="0" y="0"/>
                </a:moveTo>
                <a:lnTo>
                  <a:pt x="26" y="0"/>
                </a:lnTo>
                <a:lnTo>
                  <a:pt x="26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15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5" name="Grouper 142"/>
          <p:cNvGrpSpPr/>
          <p:nvPr/>
        </p:nvGrpSpPr>
        <p:grpSpPr>
          <a:xfrm>
            <a:off x="6164508" y="2291400"/>
            <a:ext cx="192360" cy="2052000"/>
            <a:chOff x="434974" y="2262186"/>
            <a:chExt cx="192360" cy="2786578"/>
          </a:xfrm>
        </p:grpSpPr>
        <p:sp>
          <p:nvSpPr>
            <p:cNvPr id="144" name="Rectangle 238"/>
            <p:cNvSpPr>
              <a:spLocks noChangeArrowheads="1"/>
            </p:cNvSpPr>
            <p:nvPr/>
          </p:nvSpPr>
          <p:spPr bwMode="auto">
            <a:xfrm>
              <a:off x="434974" y="486409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5" name="Rectangle 239"/>
            <p:cNvSpPr>
              <a:spLocks noChangeArrowheads="1"/>
            </p:cNvSpPr>
            <p:nvPr/>
          </p:nvSpPr>
          <p:spPr bwMode="auto">
            <a:xfrm>
              <a:off x="434974" y="442912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0.5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6" name="Rectangle 240"/>
            <p:cNvSpPr>
              <a:spLocks noChangeArrowheads="1"/>
            </p:cNvSpPr>
            <p:nvPr/>
          </p:nvSpPr>
          <p:spPr bwMode="auto">
            <a:xfrm>
              <a:off x="434974" y="399573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0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7" name="Rectangle 241"/>
            <p:cNvSpPr>
              <a:spLocks noChangeArrowheads="1"/>
            </p:cNvSpPr>
            <p:nvPr/>
          </p:nvSpPr>
          <p:spPr bwMode="auto">
            <a:xfrm>
              <a:off x="434974" y="356234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1.5</a:t>
              </a:r>
              <a:endParaRPr kumimoji="0" lang="fr-FR" altLang="fr-FR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8" name="Rectangle 242"/>
            <p:cNvSpPr>
              <a:spLocks noChangeArrowheads="1"/>
            </p:cNvSpPr>
            <p:nvPr/>
          </p:nvSpPr>
          <p:spPr bwMode="auto">
            <a:xfrm>
              <a:off x="434974" y="312896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49" name="Rectangle 243"/>
            <p:cNvSpPr>
              <a:spLocks noChangeArrowheads="1"/>
            </p:cNvSpPr>
            <p:nvPr/>
          </p:nvSpPr>
          <p:spPr bwMode="auto">
            <a:xfrm>
              <a:off x="434974" y="269557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2.5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50" name="Rectangle 244"/>
            <p:cNvSpPr>
              <a:spLocks noChangeArrowheads="1"/>
            </p:cNvSpPr>
            <p:nvPr/>
          </p:nvSpPr>
          <p:spPr bwMode="auto">
            <a:xfrm>
              <a:off x="434974" y="226218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3.0</a:t>
              </a:r>
              <a:endParaRPr kumimoji="0" lang="fr-FR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sp>
        <p:nvSpPr>
          <p:cNvPr id="151" name="Rectangle 150"/>
          <p:cNvSpPr/>
          <p:nvPr/>
        </p:nvSpPr>
        <p:spPr>
          <a:xfrm>
            <a:off x="1173600" y="23580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2" name="Rectangle 151"/>
          <p:cNvSpPr/>
          <p:nvPr/>
        </p:nvSpPr>
        <p:spPr>
          <a:xfrm>
            <a:off x="1371600" y="24384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3" name="Rectangle 152"/>
          <p:cNvSpPr/>
          <p:nvPr/>
        </p:nvSpPr>
        <p:spPr>
          <a:xfrm>
            <a:off x="1606657" y="26186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4" name="Rectangle 153"/>
          <p:cNvSpPr/>
          <p:nvPr/>
        </p:nvSpPr>
        <p:spPr>
          <a:xfrm>
            <a:off x="1828800" y="28472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5" name="Rectangle 154"/>
          <p:cNvSpPr/>
          <p:nvPr/>
        </p:nvSpPr>
        <p:spPr>
          <a:xfrm>
            <a:off x="2491200" y="30758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6" name="Rectangle 155"/>
          <p:cNvSpPr/>
          <p:nvPr/>
        </p:nvSpPr>
        <p:spPr>
          <a:xfrm>
            <a:off x="2057400" y="28956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7" name="Rectangle 156"/>
          <p:cNvSpPr/>
          <p:nvPr/>
        </p:nvSpPr>
        <p:spPr>
          <a:xfrm>
            <a:off x="2268000" y="29088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8" name="Rectangle 157"/>
          <p:cNvSpPr/>
          <p:nvPr/>
        </p:nvSpPr>
        <p:spPr>
          <a:xfrm>
            <a:off x="2712005" y="30758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59" name="Rectangle 158"/>
          <p:cNvSpPr/>
          <p:nvPr/>
        </p:nvSpPr>
        <p:spPr>
          <a:xfrm>
            <a:off x="3139200" y="32004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0" name="Rectangle 159"/>
          <p:cNvSpPr/>
          <p:nvPr/>
        </p:nvSpPr>
        <p:spPr>
          <a:xfrm>
            <a:off x="2938790" y="31242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1" name="Rectangle 160"/>
          <p:cNvSpPr/>
          <p:nvPr/>
        </p:nvSpPr>
        <p:spPr>
          <a:xfrm>
            <a:off x="3014990" y="32766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2" name="Rectangle 161"/>
          <p:cNvSpPr/>
          <p:nvPr/>
        </p:nvSpPr>
        <p:spPr>
          <a:xfrm>
            <a:off x="3214800" y="30480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3" name="Rectangle 162"/>
          <p:cNvSpPr/>
          <p:nvPr/>
        </p:nvSpPr>
        <p:spPr>
          <a:xfrm>
            <a:off x="2133600" y="30480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4" name="Rectangle 163"/>
          <p:cNvSpPr/>
          <p:nvPr/>
        </p:nvSpPr>
        <p:spPr>
          <a:xfrm>
            <a:off x="2786390" y="35052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5" name="Rectangle 164"/>
          <p:cNvSpPr/>
          <p:nvPr/>
        </p:nvSpPr>
        <p:spPr>
          <a:xfrm>
            <a:off x="3909600" y="35052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6" name="Rectangle 165"/>
          <p:cNvSpPr/>
          <p:nvPr/>
        </p:nvSpPr>
        <p:spPr>
          <a:xfrm>
            <a:off x="2347200" y="36092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7" name="Rectangle 166"/>
          <p:cNvSpPr/>
          <p:nvPr/>
        </p:nvSpPr>
        <p:spPr>
          <a:xfrm>
            <a:off x="5224790" y="360920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8" name="Rectangle 167"/>
          <p:cNvSpPr/>
          <p:nvPr/>
        </p:nvSpPr>
        <p:spPr>
          <a:xfrm>
            <a:off x="3456000" y="35814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69" name="Rectangle 168"/>
          <p:cNvSpPr/>
          <p:nvPr/>
        </p:nvSpPr>
        <p:spPr>
          <a:xfrm>
            <a:off x="1245600" y="3048000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Times New Roman"/>
                <a:cs typeface="Times New Roman"/>
              </a:rPr>
              <a:t>*</a:t>
            </a:r>
            <a:endParaRPr lang="fr-FR" sz="1200" dirty="0"/>
          </a:p>
        </p:txBody>
      </p:sp>
      <p:sp>
        <p:nvSpPr>
          <p:cNvPr id="170" name="Rectangle 169"/>
          <p:cNvSpPr/>
          <p:nvPr/>
        </p:nvSpPr>
        <p:spPr>
          <a:xfrm>
            <a:off x="3733724" y="2477869"/>
            <a:ext cx="7488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latin typeface="Times New Roman"/>
                <a:cs typeface="Times New Roman"/>
              </a:rPr>
              <a:t>Roots </a:t>
            </a:r>
            <a:endParaRPr lang="fr-FR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57</Words>
  <Application>Microsoft Macintosh PowerPoint</Application>
  <PresentationFormat>Présentation à l'écra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Universite de Ca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rwan Le Deunff</dc:creator>
  <cp:lastModifiedBy>Erwan Le Deunff</cp:lastModifiedBy>
  <cp:revision>3</cp:revision>
  <dcterms:created xsi:type="dcterms:W3CDTF">2019-09-27T17:35:57Z</dcterms:created>
  <dcterms:modified xsi:type="dcterms:W3CDTF">2019-09-27T17:36:22Z</dcterms:modified>
</cp:coreProperties>
</file>